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png" ContentType="image/png"/>
  <Default Extension="rels" ContentType="application/vnd.openxmlformats-package.relationships+xml"/>
  <Default Extension="tiff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8"/>
  </p:notesMasterIdLst>
  <p:sldIdLst>
    <p:sldId id="256" r:id="rId2"/>
    <p:sldId id="257" r:id="rId3"/>
    <p:sldId id="258" r:id="rId4"/>
    <p:sldId id="259" r:id="rId5"/>
    <p:sldId id="260" r:id="rId6"/>
    <p:sldId id="261" r:id="rId7"/>
  </p:sldIdLst>
  <p:sldSz cx="23317200" cy="301752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9F009F"/>
    <a:srgbClr val="DEA900"/>
    <a:srgbClr val="CCCC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793D81CF-94F2-401A-BA57-92F5A7B2D0C5}" styleName="Medium Style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1394" autoAdjust="0"/>
    <p:restoredTop sz="92584" autoAdjust="0"/>
  </p:normalViewPr>
  <p:slideViewPr>
    <p:cSldViewPr snapToGrid="0">
      <p:cViewPr>
        <p:scale>
          <a:sx n="68" d="100"/>
          <a:sy n="68" d="100"/>
        </p:scale>
        <p:origin x="66" y="-7176"/>
      </p:cViewPr>
      <p:guideLst/>
    </p:cSldViewPr>
  </p:slideViewPr>
  <p:notesTextViewPr>
    <p:cViewPr>
      <p:scale>
        <a:sx n="3" d="2"/>
        <a:sy n="3" d="2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08C8D68-626D-4CDC-A8EA-5A4C8F4B7049}" type="datetimeFigureOut">
              <a:rPr lang="en-US" smtClean="0"/>
              <a:t>5/27/20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36788" y="1143000"/>
            <a:ext cx="23844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28558B0-BF24-4CC5-B88D-437B77C262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2871536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2567197" rtl="0" eaLnBrk="1" latinLnBrk="0" hangingPunct="1">
      <a:defRPr sz="3370" kern="1200">
        <a:solidFill>
          <a:schemeClr val="tx1"/>
        </a:solidFill>
        <a:latin typeface="+mn-lt"/>
        <a:ea typeface="+mn-ea"/>
        <a:cs typeface="+mn-cs"/>
      </a:defRPr>
    </a:lvl1pPr>
    <a:lvl2pPr marL="1283596" algn="l" defTabSz="2567197" rtl="0" eaLnBrk="1" latinLnBrk="0" hangingPunct="1">
      <a:defRPr sz="3370" kern="1200">
        <a:solidFill>
          <a:schemeClr val="tx1"/>
        </a:solidFill>
        <a:latin typeface="+mn-lt"/>
        <a:ea typeface="+mn-ea"/>
        <a:cs typeface="+mn-cs"/>
      </a:defRPr>
    </a:lvl2pPr>
    <a:lvl3pPr marL="2567197" algn="l" defTabSz="2567197" rtl="0" eaLnBrk="1" latinLnBrk="0" hangingPunct="1">
      <a:defRPr sz="3370" kern="1200">
        <a:solidFill>
          <a:schemeClr val="tx1"/>
        </a:solidFill>
        <a:latin typeface="+mn-lt"/>
        <a:ea typeface="+mn-ea"/>
        <a:cs typeface="+mn-cs"/>
      </a:defRPr>
    </a:lvl3pPr>
    <a:lvl4pPr marL="3850793" algn="l" defTabSz="2567197" rtl="0" eaLnBrk="1" latinLnBrk="0" hangingPunct="1">
      <a:defRPr sz="3370" kern="1200">
        <a:solidFill>
          <a:schemeClr val="tx1"/>
        </a:solidFill>
        <a:latin typeface="+mn-lt"/>
        <a:ea typeface="+mn-ea"/>
        <a:cs typeface="+mn-cs"/>
      </a:defRPr>
    </a:lvl4pPr>
    <a:lvl5pPr marL="5134391" algn="l" defTabSz="2567197" rtl="0" eaLnBrk="1" latinLnBrk="0" hangingPunct="1">
      <a:defRPr sz="3370" kern="1200">
        <a:solidFill>
          <a:schemeClr val="tx1"/>
        </a:solidFill>
        <a:latin typeface="+mn-lt"/>
        <a:ea typeface="+mn-ea"/>
        <a:cs typeface="+mn-cs"/>
      </a:defRPr>
    </a:lvl5pPr>
    <a:lvl6pPr marL="6417987" algn="l" defTabSz="2567197" rtl="0" eaLnBrk="1" latinLnBrk="0" hangingPunct="1">
      <a:defRPr sz="3370" kern="1200">
        <a:solidFill>
          <a:schemeClr val="tx1"/>
        </a:solidFill>
        <a:latin typeface="+mn-lt"/>
        <a:ea typeface="+mn-ea"/>
        <a:cs typeface="+mn-cs"/>
      </a:defRPr>
    </a:lvl6pPr>
    <a:lvl7pPr marL="7701589" algn="l" defTabSz="2567197" rtl="0" eaLnBrk="1" latinLnBrk="0" hangingPunct="1">
      <a:defRPr sz="3370" kern="1200">
        <a:solidFill>
          <a:schemeClr val="tx1"/>
        </a:solidFill>
        <a:latin typeface="+mn-lt"/>
        <a:ea typeface="+mn-ea"/>
        <a:cs typeface="+mn-cs"/>
      </a:defRPr>
    </a:lvl7pPr>
    <a:lvl8pPr marL="8985184" algn="l" defTabSz="2567197" rtl="0" eaLnBrk="1" latinLnBrk="0" hangingPunct="1">
      <a:defRPr sz="3370" kern="1200">
        <a:solidFill>
          <a:schemeClr val="tx1"/>
        </a:solidFill>
        <a:latin typeface="+mn-lt"/>
        <a:ea typeface="+mn-ea"/>
        <a:cs typeface="+mn-cs"/>
      </a:defRPr>
    </a:lvl8pPr>
    <a:lvl9pPr marL="10268783" algn="l" defTabSz="2567197" rtl="0" eaLnBrk="1" latinLnBrk="0" hangingPunct="1">
      <a:defRPr sz="337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28558B0-BF24-4CC5-B88D-437B77C26274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6168012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236788" y="1143000"/>
            <a:ext cx="2384425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Big scale = 200 um</a:t>
            </a:r>
          </a:p>
          <a:p>
            <a:endParaRPr lang="en-US" dirty="0"/>
          </a:p>
          <a:p>
            <a:r>
              <a:rPr lang="en-US" dirty="0"/>
              <a:t>Small scale=</a:t>
            </a:r>
            <a:r>
              <a:rPr lang="en-US" baseline="0" dirty="0"/>
              <a:t> 50 um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B56E822-34B9-42A3-8743-590FCA82559C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3592942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236788" y="1143000"/>
            <a:ext cx="2384425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Scale= 200 um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28558B0-BF24-4CC5-B88D-437B77C26274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53823760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236788" y="1143000"/>
            <a:ext cx="2384425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28558B0-BF24-4CC5-B88D-437B77C26274}" type="slidenum">
              <a:rPr lang="en-US" smtClean="0"/>
              <a:t>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6395714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748790" y="4938397"/>
            <a:ext cx="19819620" cy="10505440"/>
          </a:xfrm>
        </p:spPr>
        <p:txBody>
          <a:bodyPr anchor="b"/>
          <a:lstStyle>
            <a:lvl1pPr algn="ctr">
              <a:defRPr sz="153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2914650" y="15848967"/>
            <a:ext cx="17487900" cy="7285353"/>
          </a:xfrm>
        </p:spPr>
        <p:txBody>
          <a:bodyPr/>
          <a:lstStyle>
            <a:lvl1pPr marL="0" indent="0" algn="ctr">
              <a:buNone/>
              <a:defRPr sz="6120"/>
            </a:lvl1pPr>
            <a:lvl2pPr marL="1165860" indent="0" algn="ctr">
              <a:buNone/>
              <a:defRPr sz="5100"/>
            </a:lvl2pPr>
            <a:lvl3pPr marL="2331720" indent="0" algn="ctr">
              <a:buNone/>
              <a:defRPr sz="4590"/>
            </a:lvl3pPr>
            <a:lvl4pPr marL="3497580" indent="0" algn="ctr">
              <a:buNone/>
              <a:defRPr sz="4080"/>
            </a:lvl4pPr>
            <a:lvl5pPr marL="4663440" indent="0" algn="ctr">
              <a:buNone/>
              <a:defRPr sz="4080"/>
            </a:lvl5pPr>
            <a:lvl6pPr marL="5829300" indent="0" algn="ctr">
              <a:buNone/>
              <a:defRPr sz="4080"/>
            </a:lvl6pPr>
            <a:lvl7pPr marL="6995160" indent="0" algn="ctr">
              <a:buNone/>
              <a:defRPr sz="4080"/>
            </a:lvl7pPr>
            <a:lvl8pPr marL="8161020" indent="0" algn="ctr">
              <a:buNone/>
              <a:defRPr sz="4080"/>
            </a:lvl8pPr>
            <a:lvl9pPr marL="9326880" indent="0" algn="ctr">
              <a:buNone/>
              <a:defRPr sz="408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5953D8-4E48-4584-AFF3-B86EF26ED28F}" type="datetimeFigureOut">
              <a:rPr lang="en-US" smtClean="0"/>
              <a:t>5/27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26B93E-5D45-4879-ADFF-4AFFDC6A61C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8365208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5953D8-4E48-4584-AFF3-B86EF26ED28F}" type="datetimeFigureOut">
              <a:rPr lang="en-US" smtClean="0"/>
              <a:t>5/27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26B93E-5D45-4879-ADFF-4AFFDC6A61C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1699529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6686373" y="1606550"/>
            <a:ext cx="5027771" cy="2557208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603059" y="1606550"/>
            <a:ext cx="14791849" cy="2557208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5953D8-4E48-4584-AFF3-B86EF26ED28F}" type="datetimeFigureOut">
              <a:rPr lang="en-US" smtClean="0"/>
              <a:t>5/27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26B93E-5D45-4879-ADFF-4AFFDC6A61C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1605403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5953D8-4E48-4584-AFF3-B86EF26ED28F}" type="datetimeFigureOut">
              <a:rPr lang="en-US" smtClean="0"/>
              <a:t>5/27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26B93E-5D45-4879-ADFF-4AFFDC6A61C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990591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590914" y="7522854"/>
            <a:ext cx="20111085" cy="12552043"/>
          </a:xfrm>
        </p:spPr>
        <p:txBody>
          <a:bodyPr anchor="b"/>
          <a:lstStyle>
            <a:lvl1pPr>
              <a:defRPr sz="153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590914" y="20193644"/>
            <a:ext cx="20111085" cy="6600823"/>
          </a:xfrm>
        </p:spPr>
        <p:txBody>
          <a:bodyPr/>
          <a:lstStyle>
            <a:lvl1pPr marL="0" indent="0">
              <a:buNone/>
              <a:defRPr sz="6120">
                <a:solidFill>
                  <a:schemeClr val="tx1"/>
                </a:solidFill>
              </a:defRPr>
            </a:lvl1pPr>
            <a:lvl2pPr marL="1165860" indent="0">
              <a:buNone/>
              <a:defRPr sz="5100">
                <a:solidFill>
                  <a:schemeClr val="tx1">
                    <a:tint val="75000"/>
                  </a:schemeClr>
                </a:solidFill>
              </a:defRPr>
            </a:lvl2pPr>
            <a:lvl3pPr marL="2331720" indent="0">
              <a:buNone/>
              <a:defRPr sz="4590">
                <a:solidFill>
                  <a:schemeClr val="tx1">
                    <a:tint val="75000"/>
                  </a:schemeClr>
                </a:solidFill>
              </a:defRPr>
            </a:lvl3pPr>
            <a:lvl4pPr marL="3497580" indent="0">
              <a:buNone/>
              <a:defRPr sz="4080">
                <a:solidFill>
                  <a:schemeClr val="tx1">
                    <a:tint val="75000"/>
                  </a:schemeClr>
                </a:solidFill>
              </a:defRPr>
            </a:lvl4pPr>
            <a:lvl5pPr marL="4663440" indent="0">
              <a:buNone/>
              <a:defRPr sz="4080">
                <a:solidFill>
                  <a:schemeClr val="tx1">
                    <a:tint val="75000"/>
                  </a:schemeClr>
                </a:solidFill>
              </a:defRPr>
            </a:lvl5pPr>
            <a:lvl6pPr marL="5829300" indent="0">
              <a:buNone/>
              <a:defRPr sz="4080">
                <a:solidFill>
                  <a:schemeClr val="tx1">
                    <a:tint val="75000"/>
                  </a:schemeClr>
                </a:solidFill>
              </a:defRPr>
            </a:lvl6pPr>
            <a:lvl7pPr marL="6995160" indent="0">
              <a:buNone/>
              <a:defRPr sz="4080">
                <a:solidFill>
                  <a:schemeClr val="tx1">
                    <a:tint val="75000"/>
                  </a:schemeClr>
                </a:solidFill>
              </a:defRPr>
            </a:lvl7pPr>
            <a:lvl8pPr marL="8161020" indent="0">
              <a:buNone/>
              <a:defRPr sz="4080">
                <a:solidFill>
                  <a:schemeClr val="tx1">
                    <a:tint val="75000"/>
                  </a:schemeClr>
                </a:solidFill>
              </a:defRPr>
            </a:lvl8pPr>
            <a:lvl9pPr marL="9326880" indent="0">
              <a:buNone/>
              <a:defRPr sz="408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5953D8-4E48-4584-AFF3-B86EF26ED28F}" type="datetimeFigureOut">
              <a:rPr lang="en-US" smtClean="0"/>
              <a:t>5/27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26B93E-5D45-4879-ADFF-4AFFDC6A61C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4116829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603058" y="8032750"/>
            <a:ext cx="9909810" cy="19145887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1804333" y="8032750"/>
            <a:ext cx="9909810" cy="19145887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5953D8-4E48-4584-AFF3-B86EF26ED28F}" type="datetimeFigureOut">
              <a:rPr lang="en-US" smtClean="0"/>
              <a:t>5/27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26B93E-5D45-4879-ADFF-4AFFDC6A61C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7500083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606095" y="1606557"/>
            <a:ext cx="20111085" cy="583247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606097" y="7397117"/>
            <a:ext cx="9864267" cy="3625213"/>
          </a:xfrm>
        </p:spPr>
        <p:txBody>
          <a:bodyPr anchor="b"/>
          <a:lstStyle>
            <a:lvl1pPr marL="0" indent="0">
              <a:buNone/>
              <a:defRPr sz="6120" b="1"/>
            </a:lvl1pPr>
            <a:lvl2pPr marL="1165860" indent="0">
              <a:buNone/>
              <a:defRPr sz="5100" b="1"/>
            </a:lvl2pPr>
            <a:lvl3pPr marL="2331720" indent="0">
              <a:buNone/>
              <a:defRPr sz="4590" b="1"/>
            </a:lvl3pPr>
            <a:lvl4pPr marL="3497580" indent="0">
              <a:buNone/>
              <a:defRPr sz="4080" b="1"/>
            </a:lvl4pPr>
            <a:lvl5pPr marL="4663440" indent="0">
              <a:buNone/>
              <a:defRPr sz="4080" b="1"/>
            </a:lvl5pPr>
            <a:lvl6pPr marL="5829300" indent="0">
              <a:buNone/>
              <a:defRPr sz="4080" b="1"/>
            </a:lvl6pPr>
            <a:lvl7pPr marL="6995160" indent="0">
              <a:buNone/>
              <a:defRPr sz="4080" b="1"/>
            </a:lvl7pPr>
            <a:lvl8pPr marL="8161020" indent="0">
              <a:buNone/>
              <a:defRPr sz="4080" b="1"/>
            </a:lvl8pPr>
            <a:lvl9pPr marL="9326880" indent="0">
              <a:buNone/>
              <a:defRPr sz="408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606097" y="11022330"/>
            <a:ext cx="9864267" cy="16212187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11804334" y="7397117"/>
            <a:ext cx="9912847" cy="3625213"/>
          </a:xfrm>
        </p:spPr>
        <p:txBody>
          <a:bodyPr anchor="b"/>
          <a:lstStyle>
            <a:lvl1pPr marL="0" indent="0">
              <a:buNone/>
              <a:defRPr sz="6120" b="1"/>
            </a:lvl1pPr>
            <a:lvl2pPr marL="1165860" indent="0">
              <a:buNone/>
              <a:defRPr sz="5100" b="1"/>
            </a:lvl2pPr>
            <a:lvl3pPr marL="2331720" indent="0">
              <a:buNone/>
              <a:defRPr sz="4590" b="1"/>
            </a:lvl3pPr>
            <a:lvl4pPr marL="3497580" indent="0">
              <a:buNone/>
              <a:defRPr sz="4080" b="1"/>
            </a:lvl4pPr>
            <a:lvl5pPr marL="4663440" indent="0">
              <a:buNone/>
              <a:defRPr sz="4080" b="1"/>
            </a:lvl5pPr>
            <a:lvl6pPr marL="5829300" indent="0">
              <a:buNone/>
              <a:defRPr sz="4080" b="1"/>
            </a:lvl6pPr>
            <a:lvl7pPr marL="6995160" indent="0">
              <a:buNone/>
              <a:defRPr sz="4080" b="1"/>
            </a:lvl7pPr>
            <a:lvl8pPr marL="8161020" indent="0">
              <a:buNone/>
              <a:defRPr sz="4080" b="1"/>
            </a:lvl8pPr>
            <a:lvl9pPr marL="9326880" indent="0">
              <a:buNone/>
              <a:defRPr sz="408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11804334" y="11022330"/>
            <a:ext cx="9912847" cy="16212187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5953D8-4E48-4584-AFF3-B86EF26ED28F}" type="datetimeFigureOut">
              <a:rPr lang="en-US" smtClean="0"/>
              <a:t>5/27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26B93E-5D45-4879-ADFF-4AFFDC6A61C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894737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5953D8-4E48-4584-AFF3-B86EF26ED28F}" type="datetimeFigureOut">
              <a:rPr lang="en-US" smtClean="0"/>
              <a:t>5/27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26B93E-5D45-4879-ADFF-4AFFDC6A61C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9991332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5953D8-4E48-4584-AFF3-B86EF26ED28F}" type="datetimeFigureOut">
              <a:rPr lang="en-US" smtClean="0"/>
              <a:t>5/27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26B93E-5D45-4879-ADFF-4AFFDC6A61C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5273219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606095" y="2011680"/>
            <a:ext cx="7520404" cy="7040880"/>
          </a:xfrm>
        </p:spPr>
        <p:txBody>
          <a:bodyPr anchor="b"/>
          <a:lstStyle>
            <a:lvl1pPr>
              <a:defRPr sz="816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9912847" y="4344677"/>
            <a:ext cx="11804333" cy="21443950"/>
          </a:xfrm>
        </p:spPr>
        <p:txBody>
          <a:bodyPr/>
          <a:lstStyle>
            <a:lvl1pPr>
              <a:defRPr sz="8160"/>
            </a:lvl1pPr>
            <a:lvl2pPr>
              <a:defRPr sz="7140"/>
            </a:lvl2pPr>
            <a:lvl3pPr>
              <a:defRPr sz="6120"/>
            </a:lvl3pPr>
            <a:lvl4pPr>
              <a:defRPr sz="5100"/>
            </a:lvl4pPr>
            <a:lvl5pPr>
              <a:defRPr sz="5100"/>
            </a:lvl5pPr>
            <a:lvl6pPr>
              <a:defRPr sz="5100"/>
            </a:lvl6pPr>
            <a:lvl7pPr>
              <a:defRPr sz="5100"/>
            </a:lvl7pPr>
            <a:lvl8pPr>
              <a:defRPr sz="5100"/>
            </a:lvl8pPr>
            <a:lvl9pPr>
              <a:defRPr sz="51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606095" y="9052560"/>
            <a:ext cx="7520404" cy="16770987"/>
          </a:xfrm>
        </p:spPr>
        <p:txBody>
          <a:bodyPr/>
          <a:lstStyle>
            <a:lvl1pPr marL="0" indent="0">
              <a:buNone/>
              <a:defRPr sz="4080"/>
            </a:lvl1pPr>
            <a:lvl2pPr marL="1165860" indent="0">
              <a:buNone/>
              <a:defRPr sz="3570"/>
            </a:lvl2pPr>
            <a:lvl3pPr marL="2331720" indent="0">
              <a:buNone/>
              <a:defRPr sz="3060"/>
            </a:lvl3pPr>
            <a:lvl4pPr marL="3497580" indent="0">
              <a:buNone/>
              <a:defRPr sz="2550"/>
            </a:lvl4pPr>
            <a:lvl5pPr marL="4663440" indent="0">
              <a:buNone/>
              <a:defRPr sz="2550"/>
            </a:lvl5pPr>
            <a:lvl6pPr marL="5829300" indent="0">
              <a:buNone/>
              <a:defRPr sz="2550"/>
            </a:lvl6pPr>
            <a:lvl7pPr marL="6995160" indent="0">
              <a:buNone/>
              <a:defRPr sz="2550"/>
            </a:lvl7pPr>
            <a:lvl8pPr marL="8161020" indent="0">
              <a:buNone/>
              <a:defRPr sz="2550"/>
            </a:lvl8pPr>
            <a:lvl9pPr marL="9326880" indent="0">
              <a:buNone/>
              <a:defRPr sz="25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5953D8-4E48-4584-AFF3-B86EF26ED28F}" type="datetimeFigureOut">
              <a:rPr lang="en-US" smtClean="0"/>
              <a:t>5/27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26B93E-5D45-4879-ADFF-4AFFDC6A61C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4855827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606095" y="2011680"/>
            <a:ext cx="7520404" cy="7040880"/>
          </a:xfrm>
        </p:spPr>
        <p:txBody>
          <a:bodyPr anchor="b"/>
          <a:lstStyle>
            <a:lvl1pPr>
              <a:defRPr sz="816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9912847" y="4344677"/>
            <a:ext cx="11804333" cy="21443950"/>
          </a:xfrm>
        </p:spPr>
        <p:txBody>
          <a:bodyPr anchor="t"/>
          <a:lstStyle>
            <a:lvl1pPr marL="0" indent="0">
              <a:buNone/>
              <a:defRPr sz="8160"/>
            </a:lvl1pPr>
            <a:lvl2pPr marL="1165860" indent="0">
              <a:buNone/>
              <a:defRPr sz="7140"/>
            </a:lvl2pPr>
            <a:lvl3pPr marL="2331720" indent="0">
              <a:buNone/>
              <a:defRPr sz="6120"/>
            </a:lvl3pPr>
            <a:lvl4pPr marL="3497580" indent="0">
              <a:buNone/>
              <a:defRPr sz="5100"/>
            </a:lvl4pPr>
            <a:lvl5pPr marL="4663440" indent="0">
              <a:buNone/>
              <a:defRPr sz="5100"/>
            </a:lvl5pPr>
            <a:lvl6pPr marL="5829300" indent="0">
              <a:buNone/>
              <a:defRPr sz="5100"/>
            </a:lvl6pPr>
            <a:lvl7pPr marL="6995160" indent="0">
              <a:buNone/>
              <a:defRPr sz="5100"/>
            </a:lvl7pPr>
            <a:lvl8pPr marL="8161020" indent="0">
              <a:buNone/>
              <a:defRPr sz="5100"/>
            </a:lvl8pPr>
            <a:lvl9pPr marL="9326880" indent="0">
              <a:buNone/>
              <a:defRPr sz="51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606095" y="9052560"/>
            <a:ext cx="7520404" cy="16770987"/>
          </a:xfrm>
        </p:spPr>
        <p:txBody>
          <a:bodyPr/>
          <a:lstStyle>
            <a:lvl1pPr marL="0" indent="0">
              <a:buNone/>
              <a:defRPr sz="4080"/>
            </a:lvl1pPr>
            <a:lvl2pPr marL="1165860" indent="0">
              <a:buNone/>
              <a:defRPr sz="3570"/>
            </a:lvl2pPr>
            <a:lvl3pPr marL="2331720" indent="0">
              <a:buNone/>
              <a:defRPr sz="3060"/>
            </a:lvl3pPr>
            <a:lvl4pPr marL="3497580" indent="0">
              <a:buNone/>
              <a:defRPr sz="2550"/>
            </a:lvl4pPr>
            <a:lvl5pPr marL="4663440" indent="0">
              <a:buNone/>
              <a:defRPr sz="2550"/>
            </a:lvl5pPr>
            <a:lvl6pPr marL="5829300" indent="0">
              <a:buNone/>
              <a:defRPr sz="2550"/>
            </a:lvl6pPr>
            <a:lvl7pPr marL="6995160" indent="0">
              <a:buNone/>
              <a:defRPr sz="2550"/>
            </a:lvl7pPr>
            <a:lvl8pPr marL="8161020" indent="0">
              <a:buNone/>
              <a:defRPr sz="2550"/>
            </a:lvl8pPr>
            <a:lvl9pPr marL="9326880" indent="0">
              <a:buNone/>
              <a:defRPr sz="25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5953D8-4E48-4584-AFF3-B86EF26ED28F}" type="datetimeFigureOut">
              <a:rPr lang="en-US" smtClean="0"/>
              <a:t>5/27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26B93E-5D45-4879-ADFF-4AFFDC6A61C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3650202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603058" y="1606557"/>
            <a:ext cx="20111085" cy="583247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603058" y="8032750"/>
            <a:ext cx="20111085" cy="1914588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603058" y="27967947"/>
            <a:ext cx="5246370" cy="16065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30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D5953D8-4E48-4584-AFF3-B86EF26ED28F}" type="datetimeFigureOut">
              <a:rPr lang="en-US" smtClean="0"/>
              <a:t>5/27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7723823" y="27967947"/>
            <a:ext cx="7869555" cy="16065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30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6467773" y="27967947"/>
            <a:ext cx="5246370" cy="16065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30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526B93E-5D45-4879-ADFF-4AFFDC6A61C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2499029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2331720" rtl="0" eaLnBrk="1" latinLnBrk="0" hangingPunct="1">
        <a:lnSpc>
          <a:spcPct val="90000"/>
        </a:lnSpc>
        <a:spcBef>
          <a:spcPct val="0"/>
        </a:spcBef>
        <a:buNone/>
        <a:defRPr sz="1122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582930" indent="-582930" algn="l" defTabSz="2331720" rtl="0" eaLnBrk="1" latinLnBrk="0" hangingPunct="1">
        <a:lnSpc>
          <a:spcPct val="90000"/>
        </a:lnSpc>
        <a:spcBef>
          <a:spcPts val="2550"/>
        </a:spcBef>
        <a:buFont typeface="Arial" panose="020B0604020202020204" pitchFamily="34" charset="0"/>
        <a:buChar char="•"/>
        <a:defRPr sz="7140" kern="1200">
          <a:solidFill>
            <a:schemeClr val="tx1"/>
          </a:solidFill>
          <a:latin typeface="+mn-lt"/>
          <a:ea typeface="+mn-ea"/>
          <a:cs typeface="+mn-cs"/>
        </a:defRPr>
      </a:lvl1pPr>
      <a:lvl2pPr marL="1748790" indent="-582930" algn="l" defTabSz="2331720" rtl="0" eaLnBrk="1" latinLnBrk="0" hangingPunct="1">
        <a:lnSpc>
          <a:spcPct val="90000"/>
        </a:lnSpc>
        <a:spcBef>
          <a:spcPts val="1275"/>
        </a:spcBef>
        <a:buFont typeface="Arial" panose="020B0604020202020204" pitchFamily="34" charset="0"/>
        <a:buChar char="•"/>
        <a:defRPr sz="6120" kern="1200">
          <a:solidFill>
            <a:schemeClr val="tx1"/>
          </a:solidFill>
          <a:latin typeface="+mn-lt"/>
          <a:ea typeface="+mn-ea"/>
          <a:cs typeface="+mn-cs"/>
        </a:defRPr>
      </a:lvl2pPr>
      <a:lvl3pPr marL="2914650" indent="-582930" algn="l" defTabSz="2331720" rtl="0" eaLnBrk="1" latinLnBrk="0" hangingPunct="1">
        <a:lnSpc>
          <a:spcPct val="90000"/>
        </a:lnSpc>
        <a:spcBef>
          <a:spcPts val="1275"/>
        </a:spcBef>
        <a:buFont typeface="Arial" panose="020B0604020202020204" pitchFamily="34" charset="0"/>
        <a:buChar char="•"/>
        <a:defRPr sz="5100" kern="1200">
          <a:solidFill>
            <a:schemeClr val="tx1"/>
          </a:solidFill>
          <a:latin typeface="+mn-lt"/>
          <a:ea typeface="+mn-ea"/>
          <a:cs typeface="+mn-cs"/>
        </a:defRPr>
      </a:lvl3pPr>
      <a:lvl4pPr marL="4080510" indent="-582930" algn="l" defTabSz="2331720" rtl="0" eaLnBrk="1" latinLnBrk="0" hangingPunct="1">
        <a:lnSpc>
          <a:spcPct val="90000"/>
        </a:lnSpc>
        <a:spcBef>
          <a:spcPts val="1275"/>
        </a:spcBef>
        <a:buFont typeface="Arial" panose="020B0604020202020204" pitchFamily="34" charset="0"/>
        <a:buChar char="•"/>
        <a:defRPr sz="4590" kern="1200">
          <a:solidFill>
            <a:schemeClr val="tx1"/>
          </a:solidFill>
          <a:latin typeface="+mn-lt"/>
          <a:ea typeface="+mn-ea"/>
          <a:cs typeface="+mn-cs"/>
        </a:defRPr>
      </a:lvl4pPr>
      <a:lvl5pPr marL="5246370" indent="-582930" algn="l" defTabSz="2331720" rtl="0" eaLnBrk="1" latinLnBrk="0" hangingPunct="1">
        <a:lnSpc>
          <a:spcPct val="90000"/>
        </a:lnSpc>
        <a:spcBef>
          <a:spcPts val="1275"/>
        </a:spcBef>
        <a:buFont typeface="Arial" panose="020B0604020202020204" pitchFamily="34" charset="0"/>
        <a:buChar char="•"/>
        <a:defRPr sz="4590" kern="1200">
          <a:solidFill>
            <a:schemeClr val="tx1"/>
          </a:solidFill>
          <a:latin typeface="+mn-lt"/>
          <a:ea typeface="+mn-ea"/>
          <a:cs typeface="+mn-cs"/>
        </a:defRPr>
      </a:lvl5pPr>
      <a:lvl6pPr marL="6412230" indent="-582930" algn="l" defTabSz="2331720" rtl="0" eaLnBrk="1" latinLnBrk="0" hangingPunct="1">
        <a:lnSpc>
          <a:spcPct val="90000"/>
        </a:lnSpc>
        <a:spcBef>
          <a:spcPts val="1275"/>
        </a:spcBef>
        <a:buFont typeface="Arial" panose="020B0604020202020204" pitchFamily="34" charset="0"/>
        <a:buChar char="•"/>
        <a:defRPr sz="4590" kern="1200">
          <a:solidFill>
            <a:schemeClr val="tx1"/>
          </a:solidFill>
          <a:latin typeface="+mn-lt"/>
          <a:ea typeface="+mn-ea"/>
          <a:cs typeface="+mn-cs"/>
        </a:defRPr>
      </a:lvl6pPr>
      <a:lvl7pPr marL="7578090" indent="-582930" algn="l" defTabSz="2331720" rtl="0" eaLnBrk="1" latinLnBrk="0" hangingPunct="1">
        <a:lnSpc>
          <a:spcPct val="90000"/>
        </a:lnSpc>
        <a:spcBef>
          <a:spcPts val="1275"/>
        </a:spcBef>
        <a:buFont typeface="Arial" panose="020B0604020202020204" pitchFamily="34" charset="0"/>
        <a:buChar char="•"/>
        <a:defRPr sz="4590" kern="1200">
          <a:solidFill>
            <a:schemeClr val="tx1"/>
          </a:solidFill>
          <a:latin typeface="+mn-lt"/>
          <a:ea typeface="+mn-ea"/>
          <a:cs typeface="+mn-cs"/>
        </a:defRPr>
      </a:lvl7pPr>
      <a:lvl8pPr marL="8743950" indent="-582930" algn="l" defTabSz="2331720" rtl="0" eaLnBrk="1" latinLnBrk="0" hangingPunct="1">
        <a:lnSpc>
          <a:spcPct val="90000"/>
        </a:lnSpc>
        <a:spcBef>
          <a:spcPts val="1275"/>
        </a:spcBef>
        <a:buFont typeface="Arial" panose="020B0604020202020204" pitchFamily="34" charset="0"/>
        <a:buChar char="•"/>
        <a:defRPr sz="4590" kern="1200">
          <a:solidFill>
            <a:schemeClr val="tx1"/>
          </a:solidFill>
          <a:latin typeface="+mn-lt"/>
          <a:ea typeface="+mn-ea"/>
          <a:cs typeface="+mn-cs"/>
        </a:defRPr>
      </a:lvl8pPr>
      <a:lvl9pPr marL="9909810" indent="-582930" algn="l" defTabSz="2331720" rtl="0" eaLnBrk="1" latinLnBrk="0" hangingPunct="1">
        <a:lnSpc>
          <a:spcPct val="90000"/>
        </a:lnSpc>
        <a:spcBef>
          <a:spcPts val="1275"/>
        </a:spcBef>
        <a:buFont typeface="Arial" panose="020B0604020202020204" pitchFamily="34" charset="0"/>
        <a:buChar char="•"/>
        <a:defRPr sz="459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2331720" rtl="0" eaLnBrk="1" latinLnBrk="0" hangingPunct="1">
        <a:defRPr sz="4590" kern="1200">
          <a:solidFill>
            <a:schemeClr val="tx1"/>
          </a:solidFill>
          <a:latin typeface="+mn-lt"/>
          <a:ea typeface="+mn-ea"/>
          <a:cs typeface="+mn-cs"/>
        </a:defRPr>
      </a:lvl1pPr>
      <a:lvl2pPr marL="1165860" algn="l" defTabSz="2331720" rtl="0" eaLnBrk="1" latinLnBrk="0" hangingPunct="1">
        <a:defRPr sz="4590" kern="1200">
          <a:solidFill>
            <a:schemeClr val="tx1"/>
          </a:solidFill>
          <a:latin typeface="+mn-lt"/>
          <a:ea typeface="+mn-ea"/>
          <a:cs typeface="+mn-cs"/>
        </a:defRPr>
      </a:lvl2pPr>
      <a:lvl3pPr marL="2331720" algn="l" defTabSz="2331720" rtl="0" eaLnBrk="1" latinLnBrk="0" hangingPunct="1">
        <a:defRPr sz="4590" kern="1200">
          <a:solidFill>
            <a:schemeClr val="tx1"/>
          </a:solidFill>
          <a:latin typeface="+mn-lt"/>
          <a:ea typeface="+mn-ea"/>
          <a:cs typeface="+mn-cs"/>
        </a:defRPr>
      </a:lvl3pPr>
      <a:lvl4pPr marL="3497580" algn="l" defTabSz="2331720" rtl="0" eaLnBrk="1" latinLnBrk="0" hangingPunct="1">
        <a:defRPr sz="4590" kern="1200">
          <a:solidFill>
            <a:schemeClr val="tx1"/>
          </a:solidFill>
          <a:latin typeface="+mn-lt"/>
          <a:ea typeface="+mn-ea"/>
          <a:cs typeface="+mn-cs"/>
        </a:defRPr>
      </a:lvl4pPr>
      <a:lvl5pPr marL="4663440" algn="l" defTabSz="2331720" rtl="0" eaLnBrk="1" latinLnBrk="0" hangingPunct="1">
        <a:defRPr sz="4590" kern="1200">
          <a:solidFill>
            <a:schemeClr val="tx1"/>
          </a:solidFill>
          <a:latin typeface="+mn-lt"/>
          <a:ea typeface="+mn-ea"/>
          <a:cs typeface="+mn-cs"/>
        </a:defRPr>
      </a:lvl5pPr>
      <a:lvl6pPr marL="5829300" algn="l" defTabSz="2331720" rtl="0" eaLnBrk="1" latinLnBrk="0" hangingPunct="1">
        <a:defRPr sz="4590" kern="1200">
          <a:solidFill>
            <a:schemeClr val="tx1"/>
          </a:solidFill>
          <a:latin typeface="+mn-lt"/>
          <a:ea typeface="+mn-ea"/>
          <a:cs typeface="+mn-cs"/>
        </a:defRPr>
      </a:lvl6pPr>
      <a:lvl7pPr marL="6995160" algn="l" defTabSz="2331720" rtl="0" eaLnBrk="1" latinLnBrk="0" hangingPunct="1">
        <a:defRPr sz="4590" kern="1200">
          <a:solidFill>
            <a:schemeClr val="tx1"/>
          </a:solidFill>
          <a:latin typeface="+mn-lt"/>
          <a:ea typeface="+mn-ea"/>
          <a:cs typeface="+mn-cs"/>
        </a:defRPr>
      </a:lvl7pPr>
      <a:lvl8pPr marL="8161020" algn="l" defTabSz="2331720" rtl="0" eaLnBrk="1" latinLnBrk="0" hangingPunct="1">
        <a:defRPr sz="4590" kern="1200">
          <a:solidFill>
            <a:schemeClr val="tx1"/>
          </a:solidFill>
          <a:latin typeface="+mn-lt"/>
          <a:ea typeface="+mn-ea"/>
          <a:cs typeface="+mn-cs"/>
        </a:defRPr>
      </a:lvl8pPr>
      <a:lvl9pPr marL="9326880" algn="l" defTabSz="2331720" rtl="0" eaLnBrk="1" latinLnBrk="0" hangingPunct="1">
        <a:defRPr sz="459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3" Type="http://schemas.openxmlformats.org/officeDocument/2006/relationships/image" Target="../media/image6.emf"/><Relationship Id="rId18" Type="http://schemas.openxmlformats.org/officeDocument/2006/relationships/oleObject" Target="../embeddings/oleObject8.bin"/><Relationship Id="rId26" Type="http://schemas.openxmlformats.org/officeDocument/2006/relationships/oleObject" Target="../embeddings/oleObject12.bin"/><Relationship Id="rId39" Type="http://schemas.openxmlformats.org/officeDocument/2006/relationships/image" Target="../media/image19.emf"/><Relationship Id="rId21" Type="http://schemas.openxmlformats.org/officeDocument/2006/relationships/image" Target="../media/image10.emf"/><Relationship Id="rId34" Type="http://schemas.openxmlformats.org/officeDocument/2006/relationships/oleObject" Target="../embeddings/oleObject16.bin"/><Relationship Id="rId42" Type="http://schemas.openxmlformats.org/officeDocument/2006/relationships/oleObject" Target="../embeddings/oleObject20.bin"/><Relationship Id="rId47" Type="http://schemas.openxmlformats.org/officeDocument/2006/relationships/image" Target="../media/image23.emf"/><Relationship Id="rId50" Type="http://schemas.openxmlformats.org/officeDocument/2006/relationships/oleObject" Target="../embeddings/oleObject24.bin"/><Relationship Id="rId55" Type="http://schemas.openxmlformats.org/officeDocument/2006/relationships/image" Target="../media/image27.emf"/><Relationship Id="rId7" Type="http://schemas.openxmlformats.org/officeDocument/2006/relationships/image" Target="../media/image3.emf"/><Relationship Id="rId2" Type="http://schemas.openxmlformats.org/officeDocument/2006/relationships/notesSlide" Target="../notesSlides/notesSlide1.xml"/><Relationship Id="rId16" Type="http://schemas.openxmlformats.org/officeDocument/2006/relationships/oleObject" Target="../embeddings/oleObject7.bin"/><Relationship Id="rId29" Type="http://schemas.openxmlformats.org/officeDocument/2006/relationships/image" Target="../media/image14.emf"/><Relationship Id="rId11" Type="http://schemas.openxmlformats.org/officeDocument/2006/relationships/image" Target="../media/image5.emf"/><Relationship Id="rId24" Type="http://schemas.openxmlformats.org/officeDocument/2006/relationships/oleObject" Target="../embeddings/oleObject11.bin"/><Relationship Id="rId32" Type="http://schemas.openxmlformats.org/officeDocument/2006/relationships/oleObject" Target="../embeddings/oleObject15.bin"/><Relationship Id="rId37" Type="http://schemas.openxmlformats.org/officeDocument/2006/relationships/image" Target="../media/image18.emf"/><Relationship Id="rId40" Type="http://schemas.openxmlformats.org/officeDocument/2006/relationships/oleObject" Target="../embeddings/oleObject19.bin"/><Relationship Id="rId45" Type="http://schemas.openxmlformats.org/officeDocument/2006/relationships/image" Target="../media/image22.emf"/><Relationship Id="rId53" Type="http://schemas.openxmlformats.org/officeDocument/2006/relationships/image" Target="../media/image26.emf"/><Relationship Id="rId5" Type="http://schemas.openxmlformats.org/officeDocument/2006/relationships/image" Target="../media/image2.emf"/><Relationship Id="rId19" Type="http://schemas.openxmlformats.org/officeDocument/2006/relationships/image" Target="../media/image9.emf"/><Relationship Id="rId4" Type="http://schemas.openxmlformats.org/officeDocument/2006/relationships/oleObject" Target="../embeddings/oleObject1.bin"/><Relationship Id="rId9" Type="http://schemas.openxmlformats.org/officeDocument/2006/relationships/image" Target="../media/image4.emf"/><Relationship Id="rId14" Type="http://schemas.openxmlformats.org/officeDocument/2006/relationships/oleObject" Target="../embeddings/oleObject6.bin"/><Relationship Id="rId22" Type="http://schemas.openxmlformats.org/officeDocument/2006/relationships/oleObject" Target="../embeddings/oleObject10.bin"/><Relationship Id="rId27" Type="http://schemas.openxmlformats.org/officeDocument/2006/relationships/image" Target="../media/image13.emf"/><Relationship Id="rId30" Type="http://schemas.openxmlformats.org/officeDocument/2006/relationships/oleObject" Target="../embeddings/oleObject14.bin"/><Relationship Id="rId35" Type="http://schemas.openxmlformats.org/officeDocument/2006/relationships/image" Target="../media/image17.emf"/><Relationship Id="rId43" Type="http://schemas.openxmlformats.org/officeDocument/2006/relationships/image" Target="../media/image21.emf"/><Relationship Id="rId48" Type="http://schemas.openxmlformats.org/officeDocument/2006/relationships/oleObject" Target="../embeddings/oleObject23.bin"/><Relationship Id="rId56" Type="http://schemas.openxmlformats.org/officeDocument/2006/relationships/oleObject" Target="../embeddings/oleObject27.bin"/><Relationship Id="rId8" Type="http://schemas.openxmlformats.org/officeDocument/2006/relationships/oleObject" Target="../embeddings/oleObject3.bin"/><Relationship Id="rId51" Type="http://schemas.openxmlformats.org/officeDocument/2006/relationships/image" Target="../media/image25.emf"/><Relationship Id="rId3" Type="http://schemas.openxmlformats.org/officeDocument/2006/relationships/image" Target="../media/image1.png"/><Relationship Id="rId12" Type="http://schemas.openxmlformats.org/officeDocument/2006/relationships/oleObject" Target="../embeddings/oleObject5.bin"/><Relationship Id="rId17" Type="http://schemas.openxmlformats.org/officeDocument/2006/relationships/image" Target="../media/image8.emf"/><Relationship Id="rId25" Type="http://schemas.openxmlformats.org/officeDocument/2006/relationships/image" Target="../media/image12.emf"/><Relationship Id="rId33" Type="http://schemas.openxmlformats.org/officeDocument/2006/relationships/image" Target="../media/image16.emf"/><Relationship Id="rId38" Type="http://schemas.openxmlformats.org/officeDocument/2006/relationships/oleObject" Target="../embeddings/oleObject18.bin"/><Relationship Id="rId46" Type="http://schemas.openxmlformats.org/officeDocument/2006/relationships/oleObject" Target="../embeddings/oleObject22.bin"/><Relationship Id="rId20" Type="http://schemas.openxmlformats.org/officeDocument/2006/relationships/oleObject" Target="../embeddings/oleObject9.bin"/><Relationship Id="rId41" Type="http://schemas.openxmlformats.org/officeDocument/2006/relationships/image" Target="../media/image20.emf"/><Relationship Id="rId54" Type="http://schemas.openxmlformats.org/officeDocument/2006/relationships/oleObject" Target="../embeddings/oleObject26.bin"/><Relationship Id="rId1" Type="http://schemas.openxmlformats.org/officeDocument/2006/relationships/slideLayout" Target="../slideLayouts/slideLayout2.xml"/><Relationship Id="rId6" Type="http://schemas.openxmlformats.org/officeDocument/2006/relationships/oleObject" Target="../embeddings/oleObject2.bin"/><Relationship Id="rId15" Type="http://schemas.openxmlformats.org/officeDocument/2006/relationships/image" Target="../media/image7.emf"/><Relationship Id="rId23" Type="http://schemas.openxmlformats.org/officeDocument/2006/relationships/image" Target="../media/image11.emf"/><Relationship Id="rId28" Type="http://schemas.openxmlformats.org/officeDocument/2006/relationships/oleObject" Target="../embeddings/oleObject13.bin"/><Relationship Id="rId36" Type="http://schemas.openxmlformats.org/officeDocument/2006/relationships/oleObject" Target="../embeddings/oleObject17.bin"/><Relationship Id="rId49" Type="http://schemas.openxmlformats.org/officeDocument/2006/relationships/image" Target="../media/image24.emf"/><Relationship Id="rId57" Type="http://schemas.openxmlformats.org/officeDocument/2006/relationships/image" Target="../media/image28.emf"/><Relationship Id="rId10" Type="http://schemas.openxmlformats.org/officeDocument/2006/relationships/oleObject" Target="../embeddings/oleObject4.bin"/><Relationship Id="rId31" Type="http://schemas.openxmlformats.org/officeDocument/2006/relationships/image" Target="../media/image15.emf"/><Relationship Id="rId44" Type="http://schemas.openxmlformats.org/officeDocument/2006/relationships/oleObject" Target="../embeddings/oleObject21.bin"/><Relationship Id="rId52" Type="http://schemas.openxmlformats.org/officeDocument/2006/relationships/oleObject" Target="../embeddings/oleObject25.bin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31.bin"/><Relationship Id="rId13" Type="http://schemas.openxmlformats.org/officeDocument/2006/relationships/image" Target="../media/image34.emf"/><Relationship Id="rId18" Type="http://schemas.openxmlformats.org/officeDocument/2006/relationships/oleObject" Target="../embeddings/oleObject36.bin"/><Relationship Id="rId3" Type="http://schemas.openxmlformats.org/officeDocument/2006/relationships/image" Target="../media/image29.emf"/><Relationship Id="rId7" Type="http://schemas.openxmlformats.org/officeDocument/2006/relationships/image" Target="../media/image31.emf"/><Relationship Id="rId12" Type="http://schemas.openxmlformats.org/officeDocument/2006/relationships/oleObject" Target="../embeddings/oleObject33.bin"/><Relationship Id="rId17" Type="http://schemas.openxmlformats.org/officeDocument/2006/relationships/image" Target="../media/image36.emf"/><Relationship Id="rId2" Type="http://schemas.openxmlformats.org/officeDocument/2006/relationships/oleObject" Target="../embeddings/oleObject28.bin"/><Relationship Id="rId16" Type="http://schemas.openxmlformats.org/officeDocument/2006/relationships/oleObject" Target="../embeddings/oleObject35.bin"/><Relationship Id="rId20" Type="http://schemas.openxmlformats.org/officeDocument/2006/relationships/image" Target="../media/image38.png"/><Relationship Id="rId1" Type="http://schemas.openxmlformats.org/officeDocument/2006/relationships/slideLayout" Target="../slideLayouts/slideLayout2.xml"/><Relationship Id="rId6" Type="http://schemas.openxmlformats.org/officeDocument/2006/relationships/oleObject" Target="../embeddings/oleObject30.bin"/><Relationship Id="rId11" Type="http://schemas.openxmlformats.org/officeDocument/2006/relationships/image" Target="../media/image33.emf"/><Relationship Id="rId5" Type="http://schemas.openxmlformats.org/officeDocument/2006/relationships/image" Target="../media/image30.emf"/><Relationship Id="rId15" Type="http://schemas.openxmlformats.org/officeDocument/2006/relationships/image" Target="../media/image35.emf"/><Relationship Id="rId10" Type="http://schemas.openxmlformats.org/officeDocument/2006/relationships/oleObject" Target="../embeddings/oleObject32.bin"/><Relationship Id="rId19" Type="http://schemas.openxmlformats.org/officeDocument/2006/relationships/image" Target="../media/image37.emf"/><Relationship Id="rId4" Type="http://schemas.openxmlformats.org/officeDocument/2006/relationships/oleObject" Target="../embeddings/oleObject29.bin"/><Relationship Id="rId9" Type="http://schemas.openxmlformats.org/officeDocument/2006/relationships/image" Target="../media/image32.emf"/><Relationship Id="rId14" Type="http://schemas.openxmlformats.org/officeDocument/2006/relationships/oleObject" Target="../embeddings/oleObject34.bin"/></Relationships>
</file>

<file path=ppt/slides/_rels/slide3.xml.rels><?xml version="1.0" encoding="UTF-8" standalone="yes"?>
<Relationships xmlns="http://schemas.openxmlformats.org/package/2006/relationships"><Relationship Id="rId13" Type="http://schemas.openxmlformats.org/officeDocument/2006/relationships/oleObject" Target="../embeddings/oleObject42.bin"/><Relationship Id="rId18" Type="http://schemas.openxmlformats.org/officeDocument/2006/relationships/image" Target="../media/image47.tiff"/><Relationship Id="rId26" Type="http://schemas.openxmlformats.org/officeDocument/2006/relationships/image" Target="../media/image53.emf"/><Relationship Id="rId3" Type="http://schemas.openxmlformats.org/officeDocument/2006/relationships/oleObject" Target="../embeddings/oleObject37.bin"/><Relationship Id="rId21" Type="http://schemas.openxmlformats.org/officeDocument/2006/relationships/image" Target="../media/image50.tiff"/><Relationship Id="rId34" Type="http://schemas.openxmlformats.org/officeDocument/2006/relationships/image" Target="../media/image57.emf"/><Relationship Id="rId7" Type="http://schemas.openxmlformats.org/officeDocument/2006/relationships/oleObject" Target="../embeddings/oleObject39.bin"/><Relationship Id="rId12" Type="http://schemas.openxmlformats.org/officeDocument/2006/relationships/image" Target="../media/image43.emf"/><Relationship Id="rId17" Type="http://schemas.openxmlformats.org/officeDocument/2006/relationships/image" Target="../media/image46.tiff"/><Relationship Id="rId25" Type="http://schemas.openxmlformats.org/officeDocument/2006/relationships/oleObject" Target="../embeddings/oleObject45.bin"/><Relationship Id="rId33" Type="http://schemas.openxmlformats.org/officeDocument/2006/relationships/oleObject" Target="../embeddings/oleObject49.bin"/><Relationship Id="rId2" Type="http://schemas.openxmlformats.org/officeDocument/2006/relationships/notesSlide" Target="../notesSlides/notesSlide2.xml"/><Relationship Id="rId16" Type="http://schemas.openxmlformats.org/officeDocument/2006/relationships/image" Target="../media/image45.emf"/><Relationship Id="rId20" Type="http://schemas.openxmlformats.org/officeDocument/2006/relationships/image" Target="../media/image49.tiff"/><Relationship Id="rId29" Type="http://schemas.openxmlformats.org/officeDocument/2006/relationships/oleObject" Target="../embeddings/oleObject47.bin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0.emf"/><Relationship Id="rId11" Type="http://schemas.openxmlformats.org/officeDocument/2006/relationships/oleObject" Target="../embeddings/oleObject41.bin"/><Relationship Id="rId24" Type="http://schemas.openxmlformats.org/officeDocument/2006/relationships/image" Target="../media/image52.emf"/><Relationship Id="rId32" Type="http://schemas.openxmlformats.org/officeDocument/2006/relationships/image" Target="../media/image56.emf"/><Relationship Id="rId5" Type="http://schemas.openxmlformats.org/officeDocument/2006/relationships/oleObject" Target="../embeddings/oleObject38.bin"/><Relationship Id="rId15" Type="http://schemas.openxmlformats.org/officeDocument/2006/relationships/oleObject" Target="../embeddings/oleObject43.bin"/><Relationship Id="rId23" Type="http://schemas.openxmlformats.org/officeDocument/2006/relationships/oleObject" Target="../embeddings/oleObject44.bin"/><Relationship Id="rId28" Type="http://schemas.openxmlformats.org/officeDocument/2006/relationships/image" Target="../media/image54.emf"/><Relationship Id="rId10" Type="http://schemas.openxmlformats.org/officeDocument/2006/relationships/image" Target="../media/image42.emf"/><Relationship Id="rId19" Type="http://schemas.openxmlformats.org/officeDocument/2006/relationships/image" Target="../media/image48.tiff"/><Relationship Id="rId31" Type="http://schemas.openxmlformats.org/officeDocument/2006/relationships/oleObject" Target="../embeddings/oleObject48.bin"/><Relationship Id="rId4" Type="http://schemas.openxmlformats.org/officeDocument/2006/relationships/image" Target="../media/image39.emf"/><Relationship Id="rId9" Type="http://schemas.openxmlformats.org/officeDocument/2006/relationships/oleObject" Target="../embeddings/oleObject40.bin"/><Relationship Id="rId14" Type="http://schemas.openxmlformats.org/officeDocument/2006/relationships/image" Target="../media/image44.emf"/><Relationship Id="rId22" Type="http://schemas.openxmlformats.org/officeDocument/2006/relationships/image" Target="../media/image51.tiff"/><Relationship Id="rId27" Type="http://schemas.openxmlformats.org/officeDocument/2006/relationships/oleObject" Target="../embeddings/oleObject46.bin"/><Relationship Id="rId30" Type="http://schemas.openxmlformats.org/officeDocument/2006/relationships/image" Target="../media/image55.emf"/><Relationship Id="rId8" Type="http://schemas.openxmlformats.org/officeDocument/2006/relationships/image" Target="../media/image41.emf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60.emf"/><Relationship Id="rId13" Type="http://schemas.openxmlformats.org/officeDocument/2006/relationships/oleObject" Target="../embeddings/oleObject55.bin"/><Relationship Id="rId18" Type="http://schemas.openxmlformats.org/officeDocument/2006/relationships/image" Target="../media/image65.emf"/><Relationship Id="rId3" Type="http://schemas.openxmlformats.org/officeDocument/2006/relationships/oleObject" Target="../embeddings/oleObject50.bin"/><Relationship Id="rId21" Type="http://schemas.openxmlformats.org/officeDocument/2006/relationships/image" Target="../media/image67.png"/><Relationship Id="rId7" Type="http://schemas.openxmlformats.org/officeDocument/2006/relationships/oleObject" Target="../embeddings/oleObject52.bin"/><Relationship Id="rId12" Type="http://schemas.openxmlformats.org/officeDocument/2006/relationships/image" Target="../media/image62.emf"/><Relationship Id="rId17" Type="http://schemas.openxmlformats.org/officeDocument/2006/relationships/oleObject" Target="../embeddings/oleObject57.bin"/><Relationship Id="rId2" Type="http://schemas.openxmlformats.org/officeDocument/2006/relationships/notesSlide" Target="../notesSlides/notesSlide3.xml"/><Relationship Id="rId16" Type="http://schemas.openxmlformats.org/officeDocument/2006/relationships/image" Target="../media/image64.emf"/><Relationship Id="rId20" Type="http://schemas.openxmlformats.org/officeDocument/2006/relationships/image" Target="../media/image66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9.emf"/><Relationship Id="rId11" Type="http://schemas.openxmlformats.org/officeDocument/2006/relationships/oleObject" Target="../embeddings/oleObject54.bin"/><Relationship Id="rId5" Type="http://schemas.openxmlformats.org/officeDocument/2006/relationships/oleObject" Target="../embeddings/oleObject51.bin"/><Relationship Id="rId15" Type="http://schemas.openxmlformats.org/officeDocument/2006/relationships/oleObject" Target="../embeddings/oleObject56.bin"/><Relationship Id="rId23" Type="http://schemas.openxmlformats.org/officeDocument/2006/relationships/image" Target="../media/image68.tiff"/><Relationship Id="rId10" Type="http://schemas.openxmlformats.org/officeDocument/2006/relationships/image" Target="../media/image61.emf"/><Relationship Id="rId19" Type="http://schemas.openxmlformats.org/officeDocument/2006/relationships/oleObject" Target="../embeddings/oleObject58.bin"/><Relationship Id="rId4" Type="http://schemas.openxmlformats.org/officeDocument/2006/relationships/image" Target="../media/image58.emf"/><Relationship Id="rId9" Type="http://schemas.openxmlformats.org/officeDocument/2006/relationships/oleObject" Target="../embeddings/oleObject53.bin"/><Relationship Id="rId14" Type="http://schemas.openxmlformats.org/officeDocument/2006/relationships/image" Target="../media/image63.emf"/><Relationship Id="rId22" Type="http://schemas.microsoft.com/office/2007/relationships/hdphoto" Target="../media/hdphoto1.wdp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62.bin"/><Relationship Id="rId3" Type="http://schemas.openxmlformats.org/officeDocument/2006/relationships/image" Target="../media/image69.emf"/><Relationship Id="rId7" Type="http://schemas.openxmlformats.org/officeDocument/2006/relationships/image" Target="../media/image71.emf"/><Relationship Id="rId2" Type="http://schemas.openxmlformats.org/officeDocument/2006/relationships/oleObject" Target="../embeddings/oleObject59.bin"/><Relationship Id="rId1" Type="http://schemas.openxmlformats.org/officeDocument/2006/relationships/slideLayout" Target="../slideLayouts/slideLayout2.xml"/><Relationship Id="rId6" Type="http://schemas.openxmlformats.org/officeDocument/2006/relationships/oleObject" Target="../embeddings/oleObject61.bin"/><Relationship Id="rId5" Type="http://schemas.openxmlformats.org/officeDocument/2006/relationships/image" Target="../media/image70.emf"/><Relationship Id="rId4" Type="http://schemas.openxmlformats.org/officeDocument/2006/relationships/oleObject" Target="../embeddings/oleObject60.bin"/><Relationship Id="rId9" Type="http://schemas.openxmlformats.org/officeDocument/2006/relationships/image" Target="../media/image72.emf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5" name="Group 14"/>
          <p:cNvGrpSpPr/>
          <p:nvPr/>
        </p:nvGrpSpPr>
        <p:grpSpPr>
          <a:xfrm>
            <a:off x="12622872" y="18310606"/>
            <a:ext cx="9546757" cy="5218532"/>
            <a:chOff x="1604018" y="1466850"/>
            <a:chExt cx="9780246" cy="5865496"/>
          </a:xfrm>
        </p:grpSpPr>
        <p:sp>
          <p:nvSpPr>
            <p:cNvPr id="5" name="TextBox 4"/>
            <p:cNvSpPr txBox="1"/>
            <p:nvPr/>
          </p:nvSpPr>
          <p:spPr>
            <a:xfrm>
              <a:off x="1933142" y="1893237"/>
              <a:ext cx="1170401" cy="876511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2200" b="1" dirty="0" err="1">
                  <a:solidFill>
                    <a:srgbClr val="9B0000"/>
                  </a:solidFill>
                </a:rPr>
                <a:t>TxRed</a:t>
              </a:r>
              <a:endParaRPr lang="en-US" sz="2200" b="1" dirty="0">
                <a:solidFill>
                  <a:srgbClr val="9B0000"/>
                </a:solidFill>
              </a:endParaRPr>
            </a:p>
            <a:p>
              <a:pPr algn="ctr"/>
              <a:r>
                <a:rPr lang="en-US" sz="2200" b="1" dirty="0">
                  <a:solidFill>
                    <a:srgbClr val="9B0000"/>
                  </a:solidFill>
                </a:rPr>
                <a:t>70 </a:t>
              </a:r>
              <a:r>
                <a:rPr lang="en-US" sz="2200" b="1" dirty="0" err="1">
                  <a:solidFill>
                    <a:srgbClr val="9B0000"/>
                  </a:solidFill>
                </a:rPr>
                <a:t>KDa</a:t>
              </a:r>
              <a:endParaRPr lang="en-US" sz="2200" b="1" dirty="0">
                <a:solidFill>
                  <a:srgbClr val="9B0000"/>
                </a:solidFill>
              </a:endParaRPr>
            </a:p>
          </p:txBody>
        </p:sp>
        <p:sp>
          <p:nvSpPr>
            <p:cNvPr id="6" name="TextBox 5"/>
            <p:cNvSpPr txBox="1"/>
            <p:nvPr/>
          </p:nvSpPr>
          <p:spPr>
            <a:xfrm>
              <a:off x="1728985" y="3581855"/>
              <a:ext cx="1443142" cy="861554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2200" b="1" dirty="0">
                  <a:solidFill>
                    <a:srgbClr val="9F009F"/>
                  </a:solidFill>
                </a:rPr>
                <a:t>Cy5</a:t>
              </a:r>
            </a:p>
            <a:p>
              <a:pPr algn="ctr"/>
              <a:r>
                <a:rPr lang="en-US" sz="2200" b="1" dirty="0">
                  <a:solidFill>
                    <a:srgbClr val="9F009F"/>
                  </a:solidFill>
                </a:rPr>
                <a:t>250 </a:t>
              </a:r>
              <a:r>
                <a:rPr lang="en-US" sz="2200" b="1" dirty="0" err="1">
                  <a:solidFill>
                    <a:srgbClr val="9F009F"/>
                  </a:solidFill>
                </a:rPr>
                <a:t>KDa</a:t>
              </a:r>
              <a:endParaRPr lang="en-US" sz="2200" b="1" dirty="0">
                <a:solidFill>
                  <a:srgbClr val="9F009F"/>
                </a:solidFill>
              </a:endParaRPr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1697414" y="5272872"/>
              <a:ext cx="1724463" cy="861554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2200" b="1" dirty="0">
                  <a:solidFill>
                    <a:srgbClr val="00B050"/>
                  </a:solidFill>
                </a:rPr>
                <a:t>Fluorescein</a:t>
              </a:r>
            </a:p>
            <a:p>
              <a:pPr algn="ctr"/>
              <a:r>
                <a:rPr lang="en-US" sz="2200" b="1" dirty="0">
                  <a:solidFill>
                    <a:srgbClr val="00B050"/>
                  </a:solidFill>
                </a:rPr>
                <a:t>500 </a:t>
              </a:r>
              <a:r>
                <a:rPr lang="en-US" sz="2200" b="1" dirty="0" err="1">
                  <a:solidFill>
                    <a:srgbClr val="00B050"/>
                  </a:solidFill>
                </a:rPr>
                <a:t>KDa</a:t>
              </a:r>
              <a:endParaRPr lang="en-US" sz="2200" b="1" dirty="0">
                <a:solidFill>
                  <a:srgbClr val="00B050"/>
                </a:solidFill>
              </a:endParaRPr>
            </a:p>
          </p:txBody>
        </p:sp>
        <p:sp>
          <p:nvSpPr>
            <p:cNvPr id="8" name="Rectangle 7"/>
            <p:cNvSpPr/>
            <p:nvPr/>
          </p:nvSpPr>
          <p:spPr>
            <a:xfrm>
              <a:off x="3561418" y="6385716"/>
              <a:ext cx="794822" cy="525906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2400" b="1" dirty="0" err="1"/>
                <a:t>n.c.</a:t>
              </a:r>
              <a:r>
                <a:rPr lang="en-US" sz="2400" b="1" dirty="0"/>
                <a:t>  </a:t>
              </a:r>
            </a:p>
          </p:txBody>
        </p:sp>
        <p:sp>
          <p:nvSpPr>
            <p:cNvPr id="9" name="Rectangle 8"/>
            <p:cNvSpPr/>
            <p:nvPr/>
          </p:nvSpPr>
          <p:spPr>
            <a:xfrm>
              <a:off x="6519335" y="6385713"/>
              <a:ext cx="1221494" cy="525906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2400" b="1" dirty="0"/>
                <a:t> Sample</a:t>
              </a:r>
            </a:p>
          </p:txBody>
        </p:sp>
        <p:sp>
          <p:nvSpPr>
            <p:cNvPr id="10" name="Rectangle 9"/>
            <p:cNvSpPr/>
            <p:nvPr/>
          </p:nvSpPr>
          <p:spPr>
            <a:xfrm>
              <a:off x="8691487" y="6385713"/>
              <a:ext cx="2692777" cy="946633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2400" b="1" dirty="0"/>
                <a:t> Sample minus </a:t>
              </a:r>
              <a:r>
                <a:rPr lang="en-US" sz="2400" b="1" dirty="0" err="1"/>
                <a:t>n.c.</a:t>
              </a:r>
              <a:r>
                <a:rPr lang="en-US" sz="2400" b="1" dirty="0"/>
                <a:t> </a:t>
              </a:r>
            </a:p>
            <a:p>
              <a:r>
                <a:rPr lang="en-US" sz="2400" b="1" dirty="0"/>
                <a:t> </a:t>
              </a:r>
            </a:p>
          </p:txBody>
        </p:sp>
        <p:sp>
          <p:nvSpPr>
            <p:cNvPr id="11" name="Rectangle 10"/>
            <p:cNvSpPr/>
            <p:nvPr/>
          </p:nvSpPr>
          <p:spPr>
            <a:xfrm>
              <a:off x="1604018" y="6385716"/>
              <a:ext cx="1442187" cy="525906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2400" b="1" dirty="0"/>
                <a:t>MFI/mm</a:t>
              </a:r>
              <a:r>
                <a:rPr lang="en-US" sz="2400" b="1" baseline="30000" dirty="0"/>
                <a:t>2</a:t>
              </a:r>
              <a:endParaRPr lang="en-US" sz="2400" b="1" dirty="0"/>
            </a:p>
          </p:txBody>
        </p:sp>
        <p:pic>
          <p:nvPicPr>
            <p:cNvPr id="14" name="Picture 13"/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6675" t="9524" b="16667"/>
            <a:stretch/>
          </p:blipFill>
          <p:spPr>
            <a:xfrm>
              <a:off x="3226610" y="1466850"/>
              <a:ext cx="7806367" cy="5048250"/>
            </a:xfrm>
            <a:prstGeom prst="rect">
              <a:avLst/>
            </a:prstGeom>
          </p:spPr>
        </p:pic>
      </p:grpSp>
      <p:sp>
        <p:nvSpPr>
          <p:cNvPr id="19" name="TextBox 18"/>
          <p:cNvSpPr txBox="1"/>
          <p:nvPr/>
        </p:nvSpPr>
        <p:spPr>
          <a:xfrm>
            <a:off x="5654102" y="1189941"/>
            <a:ext cx="1992148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800" b="1" dirty="0"/>
              <a:t>Whole fetus</a:t>
            </a:r>
          </a:p>
        </p:txBody>
      </p:sp>
      <p:sp>
        <p:nvSpPr>
          <p:cNvPr id="24" name="TextBox 23"/>
          <p:cNvSpPr txBox="1"/>
          <p:nvPr/>
        </p:nvSpPr>
        <p:spPr>
          <a:xfrm>
            <a:off x="6203448" y="18175193"/>
            <a:ext cx="901081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800" b="1" dirty="0"/>
              <a:t>Liver</a:t>
            </a:r>
          </a:p>
        </p:txBody>
      </p:sp>
      <p:graphicFrame>
        <p:nvGraphicFramePr>
          <p:cNvPr id="25" name="Object 2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319028213"/>
              </p:ext>
            </p:extLst>
          </p:nvPr>
        </p:nvGraphicFramePr>
        <p:xfrm>
          <a:off x="8409178" y="18893843"/>
          <a:ext cx="3513138" cy="38147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4" imgW="3512764" imgH="3689778" progId="Prism10.Document">
                  <p:embed/>
                </p:oleObj>
              </mc:Choice>
              <mc:Fallback>
                <p:oleObj name="Prism 10" r:id="rId4" imgW="3512764" imgH="3689778" progId="Prism10.Document">
                  <p:embed/>
                  <p:pic>
                    <p:nvPicPr>
                      <p:cNvPr id="25" name="Object 24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8409178" y="18893843"/>
                        <a:ext cx="3513138" cy="38147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6" name="Object 2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983438189"/>
              </p:ext>
            </p:extLst>
          </p:nvPr>
        </p:nvGraphicFramePr>
        <p:xfrm>
          <a:off x="4867983" y="18858712"/>
          <a:ext cx="3680895" cy="389151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6" imgW="3491156" imgH="3689778" progId="Prism10.Document">
                  <p:embed/>
                </p:oleObj>
              </mc:Choice>
              <mc:Fallback>
                <p:oleObj name="Prism 10" r:id="rId6" imgW="3491156" imgH="3689778" progId="Prism10.Document">
                  <p:embed/>
                  <p:pic>
                    <p:nvPicPr>
                      <p:cNvPr id="26" name="Object 25"/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4867983" y="18858712"/>
                        <a:ext cx="3680895" cy="389151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7" name="Object 2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90773283"/>
              </p:ext>
            </p:extLst>
          </p:nvPr>
        </p:nvGraphicFramePr>
        <p:xfrm>
          <a:off x="1189038" y="18905538"/>
          <a:ext cx="3679825" cy="38052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8" imgW="3512764" imgH="3689778" progId="Prism10.Document">
                  <p:embed/>
                </p:oleObj>
              </mc:Choice>
              <mc:Fallback>
                <p:oleObj name="Prism 10" r:id="rId8" imgW="3512764" imgH="3689778" progId="Prism10.Document">
                  <p:embed/>
                  <p:pic>
                    <p:nvPicPr>
                      <p:cNvPr id="27" name="Object 26"/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1189038" y="18905538"/>
                        <a:ext cx="3679825" cy="38052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cxnSp>
        <p:nvCxnSpPr>
          <p:cNvPr id="55" name="Straight Connector 54"/>
          <p:cNvCxnSpPr/>
          <p:nvPr/>
        </p:nvCxnSpPr>
        <p:spPr>
          <a:xfrm flipV="1">
            <a:off x="12993939" y="10263135"/>
            <a:ext cx="8790039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" name="TextBox 27"/>
          <p:cNvSpPr txBox="1"/>
          <p:nvPr/>
        </p:nvSpPr>
        <p:spPr>
          <a:xfrm>
            <a:off x="16823863" y="1245282"/>
            <a:ext cx="1461810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800" b="1" dirty="0"/>
              <a:t>Placenta</a:t>
            </a:r>
          </a:p>
        </p:txBody>
      </p:sp>
      <p:graphicFrame>
        <p:nvGraphicFramePr>
          <p:cNvPr id="29" name="Object 28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122839949"/>
              </p:ext>
            </p:extLst>
          </p:nvPr>
        </p:nvGraphicFramePr>
        <p:xfrm>
          <a:off x="19297372" y="1999532"/>
          <a:ext cx="3494088" cy="36957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10" imgW="3494397" imgH="3695901" progId="Prism10.Document">
                  <p:embed/>
                </p:oleObj>
              </mc:Choice>
              <mc:Fallback>
                <p:oleObj name="Prism 10" r:id="rId10" imgW="3494397" imgH="3695901" progId="Prism10.Document">
                  <p:embed/>
                  <p:pic>
                    <p:nvPicPr>
                      <p:cNvPr id="29" name="Object 28"/>
                      <p:cNvPicPr/>
                      <p:nvPr/>
                    </p:nvPicPr>
                    <p:blipFill>
                      <a:blip r:embed="rId11"/>
                      <a:stretch>
                        <a:fillRect/>
                      </a:stretch>
                    </p:blipFill>
                    <p:spPr>
                      <a:xfrm>
                        <a:off x="19297372" y="1999532"/>
                        <a:ext cx="3494088" cy="36957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0" name="Object 29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833638665"/>
              </p:ext>
            </p:extLst>
          </p:nvPr>
        </p:nvGraphicFramePr>
        <p:xfrm>
          <a:off x="15755660" y="1988419"/>
          <a:ext cx="3656012" cy="368848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12" imgW="3538694" imgH="3726154" progId="Prism10.Document">
                  <p:embed/>
                </p:oleObj>
              </mc:Choice>
              <mc:Fallback>
                <p:oleObj name="Prism 10" r:id="rId12" imgW="3538694" imgH="3726154" progId="Prism10.Document">
                  <p:embed/>
                  <p:pic>
                    <p:nvPicPr>
                      <p:cNvPr id="30" name="Object 29"/>
                      <p:cNvPicPr/>
                      <p:nvPr/>
                    </p:nvPicPr>
                    <p:blipFill>
                      <a:blip r:embed="rId13"/>
                      <a:stretch>
                        <a:fillRect/>
                      </a:stretch>
                    </p:blipFill>
                    <p:spPr>
                      <a:xfrm>
                        <a:off x="15755660" y="1988419"/>
                        <a:ext cx="3656012" cy="368848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1" name="Object 30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107722536"/>
              </p:ext>
            </p:extLst>
          </p:nvPr>
        </p:nvGraphicFramePr>
        <p:xfrm>
          <a:off x="12077700" y="1993900"/>
          <a:ext cx="3717925" cy="3683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14" imgW="3549137" imgH="3689778" progId="Prism10.Document">
                  <p:embed/>
                </p:oleObj>
              </mc:Choice>
              <mc:Fallback>
                <p:oleObj name="Prism 10" r:id="rId14" imgW="3549137" imgH="3689778" progId="Prism10.Document">
                  <p:embed/>
                  <p:pic>
                    <p:nvPicPr>
                      <p:cNvPr id="31" name="Object 30"/>
                      <p:cNvPicPr/>
                      <p:nvPr/>
                    </p:nvPicPr>
                    <p:blipFill>
                      <a:blip r:embed="rId15"/>
                      <a:stretch>
                        <a:fillRect/>
                      </a:stretch>
                    </p:blipFill>
                    <p:spPr>
                      <a:xfrm>
                        <a:off x="12077700" y="1993900"/>
                        <a:ext cx="3717925" cy="3683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cxnSp>
        <p:nvCxnSpPr>
          <p:cNvPr id="57" name="Straight Connector 56"/>
          <p:cNvCxnSpPr/>
          <p:nvPr/>
        </p:nvCxnSpPr>
        <p:spPr>
          <a:xfrm flipV="1">
            <a:off x="13217555" y="1706154"/>
            <a:ext cx="8790039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8" name="Straight Connector 57"/>
          <p:cNvCxnSpPr/>
          <p:nvPr/>
        </p:nvCxnSpPr>
        <p:spPr>
          <a:xfrm flipV="1">
            <a:off x="2310311" y="18694125"/>
            <a:ext cx="8790039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16" name="Object 1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39904575"/>
              </p:ext>
            </p:extLst>
          </p:nvPr>
        </p:nvGraphicFramePr>
        <p:xfrm>
          <a:off x="8272463" y="1987550"/>
          <a:ext cx="3594100" cy="36893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16" imgW="3594875" imgH="3689778" progId="Prism10.Document">
                  <p:embed/>
                </p:oleObj>
              </mc:Choice>
              <mc:Fallback>
                <p:oleObj name="Prism 10" r:id="rId16" imgW="3594875" imgH="3689778" progId="Prism10.Document">
                  <p:embed/>
                  <p:pic>
                    <p:nvPicPr>
                      <p:cNvPr id="16" name="Object 15"/>
                      <p:cNvPicPr/>
                      <p:nvPr/>
                    </p:nvPicPr>
                    <p:blipFill>
                      <a:blip r:embed="rId17"/>
                      <a:stretch>
                        <a:fillRect/>
                      </a:stretch>
                    </p:blipFill>
                    <p:spPr>
                      <a:xfrm>
                        <a:off x="8272463" y="1987550"/>
                        <a:ext cx="3594100" cy="36893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7" name="Object 1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234795534"/>
              </p:ext>
            </p:extLst>
          </p:nvPr>
        </p:nvGraphicFramePr>
        <p:xfrm>
          <a:off x="4757738" y="1989139"/>
          <a:ext cx="3630612" cy="370046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18" imgW="3630168" imgH="3689778" progId="Prism10.Document">
                  <p:embed/>
                </p:oleObj>
              </mc:Choice>
              <mc:Fallback>
                <p:oleObj name="Prism 10" r:id="rId18" imgW="3630168" imgH="3689778" progId="Prism10.Document">
                  <p:embed/>
                  <p:pic>
                    <p:nvPicPr>
                      <p:cNvPr id="17" name="Object 16"/>
                      <p:cNvPicPr/>
                      <p:nvPr/>
                    </p:nvPicPr>
                    <p:blipFill>
                      <a:blip r:embed="rId19"/>
                      <a:stretch>
                        <a:fillRect/>
                      </a:stretch>
                    </p:blipFill>
                    <p:spPr>
                      <a:xfrm>
                        <a:off x="4757738" y="1989139"/>
                        <a:ext cx="3630612" cy="370046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8" name="Object 17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459226878"/>
              </p:ext>
            </p:extLst>
          </p:nvPr>
        </p:nvGraphicFramePr>
        <p:xfrm>
          <a:off x="1079500" y="1970088"/>
          <a:ext cx="3706813" cy="371951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20" imgW="3707597" imgH="3689778" progId="Prism10.Document">
                  <p:embed/>
                </p:oleObj>
              </mc:Choice>
              <mc:Fallback>
                <p:oleObj name="Prism 10" r:id="rId20" imgW="3707597" imgH="3689778" progId="Prism10.Document">
                  <p:embed/>
                  <p:pic>
                    <p:nvPicPr>
                      <p:cNvPr id="18" name="Object 17"/>
                      <p:cNvPicPr/>
                      <p:nvPr/>
                    </p:nvPicPr>
                    <p:blipFill>
                      <a:blip r:embed="rId21"/>
                      <a:stretch>
                        <a:fillRect/>
                      </a:stretch>
                    </p:blipFill>
                    <p:spPr>
                      <a:xfrm>
                        <a:off x="1079500" y="1970088"/>
                        <a:ext cx="3706813" cy="371951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cxnSp>
        <p:nvCxnSpPr>
          <p:cNvPr id="52" name="Straight Connector 51"/>
          <p:cNvCxnSpPr/>
          <p:nvPr/>
        </p:nvCxnSpPr>
        <p:spPr>
          <a:xfrm flipV="1">
            <a:off x="2252817" y="1706154"/>
            <a:ext cx="8790039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0" name="TextBox 59"/>
          <p:cNvSpPr txBox="1"/>
          <p:nvPr/>
        </p:nvSpPr>
        <p:spPr>
          <a:xfrm>
            <a:off x="1171891" y="1676336"/>
            <a:ext cx="465192" cy="646331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sz="3600" b="1" dirty="0"/>
              <a:t>A</a:t>
            </a:r>
          </a:p>
        </p:txBody>
      </p:sp>
      <p:sp>
        <p:nvSpPr>
          <p:cNvPr id="61" name="TextBox 60"/>
          <p:cNvSpPr txBox="1"/>
          <p:nvPr/>
        </p:nvSpPr>
        <p:spPr>
          <a:xfrm>
            <a:off x="4828027" y="1676336"/>
            <a:ext cx="442750" cy="646331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sz="3600" b="1" dirty="0"/>
              <a:t>B</a:t>
            </a:r>
          </a:p>
        </p:txBody>
      </p:sp>
      <p:sp>
        <p:nvSpPr>
          <p:cNvPr id="62" name="TextBox 61"/>
          <p:cNvSpPr txBox="1"/>
          <p:nvPr/>
        </p:nvSpPr>
        <p:spPr>
          <a:xfrm>
            <a:off x="8388008" y="1676336"/>
            <a:ext cx="428322" cy="646331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sz="3600" b="1" dirty="0"/>
              <a:t>C</a:t>
            </a:r>
          </a:p>
        </p:txBody>
      </p:sp>
      <p:graphicFrame>
        <p:nvGraphicFramePr>
          <p:cNvPr id="20" name="Object 19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155915043"/>
              </p:ext>
            </p:extLst>
          </p:nvPr>
        </p:nvGraphicFramePr>
        <p:xfrm>
          <a:off x="8299450" y="6225457"/>
          <a:ext cx="3495675" cy="371951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22" imgW="3495837" imgH="3720031" progId="Prism10.Document">
                  <p:embed/>
                </p:oleObj>
              </mc:Choice>
              <mc:Fallback>
                <p:oleObj name="Prism 10" r:id="rId22" imgW="3495837" imgH="3720031" progId="Prism10.Document">
                  <p:embed/>
                  <p:pic>
                    <p:nvPicPr>
                      <p:cNvPr id="20" name="Object 19"/>
                      <p:cNvPicPr/>
                      <p:nvPr/>
                    </p:nvPicPr>
                    <p:blipFill>
                      <a:blip r:embed="rId23"/>
                      <a:stretch>
                        <a:fillRect/>
                      </a:stretch>
                    </p:blipFill>
                    <p:spPr>
                      <a:xfrm>
                        <a:off x="8299450" y="6225457"/>
                        <a:ext cx="3495675" cy="371951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1" name="TextBox 20"/>
          <p:cNvSpPr txBox="1"/>
          <p:nvPr/>
        </p:nvSpPr>
        <p:spPr>
          <a:xfrm>
            <a:off x="5718688" y="5547801"/>
            <a:ext cx="1763753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800" b="1" dirty="0"/>
              <a:t>Fetal brain</a:t>
            </a:r>
          </a:p>
        </p:txBody>
      </p:sp>
      <p:graphicFrame>
        <p:nvGraphicFramePr>
          <p:cNvPr id="22" name="Object 2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27392747"/>
              </p:ext>
            </p:extLst>
          </p:nvPr>
        </p:nvGraphicFramePr>
        <p:xfrm>
          <a:off x="4757738" y="6227045"/>
          <a:ext cx="3625850" cy="370435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24" imgW="3509523" imgH="3756767" progId="Prism10.Document">
                  <p:embed/>
                </p:oleObj>
              </mc:Choice>
              <mc:Fallback>
                <p:oleObj name="Prism 10" r:id="rId24" imgW="3509523" imgH="3756767" progId="Prism10.Document">
                  <p:embed/>
                  <p:pic>
                    <p:nvPicPr>
                      <p:cNvPr id="22" name="Object 21"/>
                      <p:cNvPicPr/>
                      <p:nvPr/>
                    </p:nvPicPr>
                    <p:blipFill>
                      <a:blip r:embed="rId25"/>
                      <a:stretch>
                        <a:fillRect/>
                      </a:stretch>
                    </p:blipFill>
                    <p:spPr>
                      <a:xfrm>
                        <a:off x="4757738" y="6227045"/>
                        <a:ext cx="3625850" cy="370435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3" name="Object 2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014684652"/>
              </p:ext>
            </p:extLst>
          </p:nvPr>
        </p:nvGraphicFramePr>
        <p:xfrm>
          <a:off x="1079500" y="6223869"/>
          <a:ext cx="3721100" cy="372023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26" imgW="3552379" imgH="3762889" progId="Prism10.Document">
                  <p:embed/>
                </p:oleObj>
              </mc:Choice>
              <mc:Fallback>
                <p:oleObj name="Prism 10" r:id="rId26" imgW="3552379" imgH="3762889" progId="Prism10.Document">
                  <p:embed/>
                  <p:pic>
                    <p:nvPicPr>
                      <p:cNvPr id="23" name="Object 22"/>
                      <p:cNvPicPr/>
                      <p:nvPr/>
                    </p:nvPicPr>
                    <p:blipFill>
                      <a:blip r:embed="rId27"/>
                      <a:stretch>
                        <a:fillRect/>
                      </a:stretch>
                    </p:blipFill>
                    <p:spPr>
                      <a:xfrm>
                        <a:off x="1079500" y="6223869"/>
                        <a:ext cx="3721100" cy="372023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cxnSp>
        <p:nvCxnSpPr>
          <p:cNvPr id="54" name="Straight Connector 53"/>
          <p:cNvCxnSpPr/>
          <p:nvPr/>
        </p:nvCxnSpPr>
        <p:spPr>
          <a:xfrm flipV="1">
            <a:off x="2200583" y="6048192"/>
            <a:ext cx="8790039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3" name="TextBox 62"/>
          <p:cNvSpPr txBox="1"/>
          <p:nvPr/>
        </p:nvSpPr>
        <p:spPr>
          <a:xfrm>
            <a:off x="1164634" y="6048587"/>
            <a:ext cx="476412" cy="646331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sz="3600" b="1" dirty="0"/>
              <a:t>D</a:t>
            </a:r>
          </a:p>
        </p:txBody>
      </p:sp>
      <p:sp>
        <p:nvSpPr>
          <p:cNvPr id="64" name="TextBox 63"/>
          <p:cNvSpPr txBox="1"/>
          <p:nvPr/>
        </p:nvSpPr>
        <p:spPr>
          <a:xfrm>
            <a:off x="4820770" y="6048587"/>
            <a:ext cx="409086" cy="646331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sz="3600" b="1" dirty="0"/>
              <a:t>E</a:t>
            </a:r>
          </a:p>
        </p:txBody>
      </p:sp>
      <p:sp>
        <p:nvSpPr>
          <p:cNvPr id="65" name="TextBox 64"/>
          <p:cNvSpPr txBox="1"/>
          <p:nvPr/>
        </p:nvSpPr>
        <p:spPr>
          <a:xfrm>
            <a:off x="8380751" y="6048587"/>
            <a:ext cx="396262" cy="646331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sz="3600" b="1" dirty="0"/>
              <a:t>F</a:t>
            </a:r>
          </a:p>
        </p:txBody>
      </p:sp>
      <p:sp>
        <p:nvSpPr>
          <p:cNvPr id="66" name="TextBox 65"/>
          <p:cNvSpPr txBox="1"/>
          <p:nvPr/>
        </p:nvSpPr>
        <p:spPr>
          <a:xfrm>
            <a:off x="1142863" y="10241464"/>
            <a:ext cx="479618" cy="646331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sz="3600" b="1" dirty="0"/>
              <a:t>G</a:t>
            </a:r>
          </a:p>
        </p:txBody>
      </p:sp>
      <p:sp>
        <p:nvSpPr>
          <p:cNvPr id="67" name="TextBox 66"/>
          <p:cNvSpPr txBox="1"/>
          <p:nvPr/>
        </p:nvSpPr>
        <p:spPr>
          <a:xfrm>
            <a:off x="4798999" y="10241464"/>
            <a:ext cx="476412" cy="646331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sz="3600" b="1" dirty="0"/>
              <a:t>H</a:t>
            </a:r>
          </a:p>
        </p:txBody>
      </p:sp>
      <p:sp>
        <p:nvSpPr>
          <p:cNvPr id="68" name="TextBox 67"/>
          <p:cNvSpPr txBox="1"/>
          <p:nvPr/>
        </p:nvSpPr>
        <p:spPr>
          <a:xfrm>
            <a:off x="8358980" y="10241464"/>
            <a:ext cx="308098" cy="646331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sz="3600" b="1" dirty="0"/>
              <a:t>I</a:t>
            </a:r>
          </a:p>
        </p:txBody>
      </p:sp>
      <p:sp>
        <p:nvSpPr>
          <p:cNvPr id="69" name="TextBox 68"/>
          <p:cNvSpPr txBox="1"/>
          <p:nvPr/>
        </p:nvSpPr>
        <p:spPr>
          <a:xfrm>
            <a:off x="1256358" y="18705002"/>
            <a:ext cx="552630" cy="646331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sz="3600" b="1" dirty="0"/>
              <a:t>M</a:t>
            </a:r>
          </a:p>
        </p:txBody>
      </p:sp>
      <p:sp>
        <p:nvSpPr>
          <p:cNvPr id="70" name="TextBox 69"/>
          <p:cNvSpPr txBox="1"/>
          <p:nvPr/>
        </p:nvSpPr>
        <p:spPr>
          <a:xfrm>
            <a:off x="4908727" y="18705002"/>
            <a:ext cx="489236" cy="646331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sz="3600" b="1" dirty="0"/>
              <a:t>N</a:t>
            </a:r>
          </a:p>
        </p:txBody>
      </p:sp>
      <p:sp>
        <p:nvSpPr>
          <p:cNvPr id="71" name="TextBox 70"/>
          <p:cNvSpPr txBox="1"/>
          <p:nvPr/>
        </p:nvSpPr>
        <p:spPr>
          <a:xfrm>
            <a:off x="8396574" y="18705002"/>
            <a:ext cx="497252" cy="646331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sz="3600" b="1" dirty="0"/>
              <a:t>O</a:t>
            </a:r>
          </a:p>
        </p:txBody>
      </p:sp>
      <p:sp>
        <p:nvSpPr>
          <p:cNvPr id="72" name="TextBox 71"/>
          <p:cNvSpPr txBox="1"/>
          <p:nvPr/>
        </p:nvSpPr>
        <p:spPr>
          <a:xfrm>
            <a:off x="12106452" y="1676336"/>
            <a:ext cx="429926" cy="646331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sz="3600" b="1" dirty="0"/>
              <a:t>P</a:t>
            </a:r>
          </a:p>
        </p:txBody>
      </p:sp>
      <p:sp>
        <p:nvSpPr>
          <p:cNvPr id="73" name="TextBox 72"/>
          <p:cNvSpPr txBox="1"/>
          <p:nvPr/>
        </p:nvSpPr>
        <p:spPr>
          <a:xfrm>
            <a:off x="15699509" y="1676336"/>
            <a:ext cx="502061" cy="646331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sz="3600" b="1" dirty="0"/>
              <a:t>Q</a:t>
            </a:r>
          </a:p>
        </p:txBody>
      </p:sp>
      <p:sp>
        <p:nvSpPr>
          <p:cNvPr id="74" name="TextBox 73"/>
          <p:cNvSpPr txBox="1"/>
          <p:nvPr/>
        </p:nvSpPr>
        <p:spPr>
          <a:xfrm>
            <a:off x="19196974" y="1676336"/>
            <a:ext cx="444352" cy="646331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sz="3600" b="1" dirty="0"/>
              <a:t>R</a:t>
            </a:r>
          </a:p>
        </p:txBody>
      </p:sp>
      <p:graphicFrame>
        <p:nvGraphicFramePr>
          <p:cNvPr id="2" name="Object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85318450"/>
              </p:ext>
            </p:extLst>
          </p:nvPr>
        </p:nvGraphicFramePr>
        <p:xfrm>
          <a:off x="18818328" y="6234148"/>
          <a:ext cx="3487738" cy="370995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28" imgW="3488275" imgH="3744522" progId="Prism10.Document">
                  <p:embed/>
                </p:oleObj>
              </mc:Choice>
              <mc:Fallback>
                <p:oleObj name="Prism 10" r:id="rId28" imgW="3488275" imgH="3744522" progId="Prism10.Document">
                  <p:embed/>
                  <p:pic>
                    <p:nvPicPr>
                      <p:cNvPr id="2" name="Object 1"/>
                      <p:cNvPicPr/>
                      <p:nvPr/>
                    </p:nvPicPr>
                    <p:blipFill>
                      <a:blip r:embed="rId29"/>
                      <a:stretch>
                        <a:fillRect/>
                      </a:stretch>
                    </p:blipFill>
                    <p:spPr>
                      <a:xfrm>
                        <a:off x="18818328" y="6234148"/>
                        <a:ext cx="3487738" cy="370995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" name="Object 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220107103"/>
              </p:ext>
            </p:extLst>
          </p:nvPr>
        </p:nvGraphicFramePr>
        <p:xfrm>
          <a:off x="15444891" y="6237264"/>
          <a:ext cx="3584575" cy="369413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30" imgW="3427412" imgH="3707786" progId="Prism10.Document">
                  <p:embed/>
                </p:oleObj>
              </mc:Choice>
              <mc:Fallback>
                <p:oleObj name="Prism 10" r:id="rId30" imgW="3427412" imgH="3707786" progId="Prism10.Document">
                  <p:embed/>
                  <p:pic>
                    <p:nvPicPr>
                      <p:cNvPr id="3" name="Object 2"/>
                      <p:cNvPicPr/>
                      <p:nvPr/>
                    </p:nvPicPr>
                    <p:blipFill>
                      <a:blip r:embed="rId31"/>
                      <a:stretch>
                        <a:fillRect/>
                      </a:stretch>
                    </p:blipFill>
                    <p:spPr>
                      <a:xfrm>
                        <a:off x="15444891" y="6237264"/>
                        <a:ext cx="3584575" cy="369413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" name="Object 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76575699"/>
              </p:ext>
            </p:extLst>
          </p:nvPr>
        </p:nvGraphicFramePr>
        <p:xfrm>
          <a:off x="12301641" y="6234148"/>
          <a:ext cx="3427412" cy="370186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32" imgW="3427412" imgH="3744522" progId="Prism10.Document">
                  <p:embed/>
                </p:oleObj>
              </mc:Choice>
              <mc:Fallback>
                <p:oleObj name="Prism 10" r:id="rId32" imgW="3427412" imgH="3744522" progId="Prism10.Document">
                  <p:embed/>
                  <p:pic>
                    <p:nvPicPr>
                      <p:cNvPr id="4" name="Object 3"/>
                      <p:cNvPicPr/>
                      <p:nvPr/>
                    </p:nvPicPr>
                    <p:blipFill>
                      <a:blip r:embed="rId33"/>
                      <a:stretch>
                        <a:fillRect/>
                      </a:stretch>
                    </p:blipFill>
                    <p:spPr>
                      <a:xfrm>
                        <a:off x="12301641" y="6234148"/>
                        <a:ext cx="3427412" cy="370186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2" name="TextBox 31"/>
          <p:cNvSpPr txBox="1"/>
          <p:nvPr/>
        </p:nvSpPr>
        <p:spPr>
          <a:xfrm>
            <a:off x="16867631" y="5524047"/>
            <a:ext cx="1393330" cy="5135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800" b="1" dirty="0"/>
              <a:t>Decidua</a:t>
            </a:r>
          </a:p>
        </p:txBody>
      </p:sp>
      <p:cxnSp>
        <p:nvCxnSpPr>
          <p:cNvPr id="53" name="Straight Connector 52"/>
          <p:cNvCxnSpPr/>
          <p:nvPr/>
        </p:nvCxnSpPr>
        <p:spPr>
          <a:xfrm flipV="1">
            <a:off x="13018438" y="6041517"/>
            <a:ext cx="8790039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5" name="TextBox 74"/>
          <p:cNvSpPr txBox="1"/>
          <p:nvPr/>
        </p:nvSpPr>
        <p:spPr>
          <a:xfrm>
            <a:off x="12300808" y="6060498"/>
            <a:ext cx="402674" cy="646331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sz="3600" b="1" dirty="0"/>
              <a:t>S</a:t>
            </a:r>
          </a:p>
        </p:txBody>
      </p:sp>
      <p:sp>
        <p:nvSpPr>
          <p:cNvPr id="76" name="TextBox 75"/>
          <p:cNvSpPr txBox="1"/>
          <p:nvPr/>
        </p:nvSpPr>
        <p:spPr>
          <a:xfrm>
            <a:off x="15518794" y="6060498"/>
            <a:ext cx="413896" cy="646331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sz="3600" b="1" dirty="0"/>
              <a:t>T</a:t>
            </a:r>
          </a:p>
        </p:txBody>
      </p:sp>
      <p:sp>
        <p:nvSpPr>
          <p:cNvPr id="77" name="TextBox 76"/>
          <p:cNvSpPr txBox="1"/>
          <p:nvPr/>
        </p:nvSpPr>
        <p:spPr>
          <a:xfrm>
            <a:off x="18888275" y="6060498"/>
            <a:ext cx="486030" cy="646331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sz="3600" b="1" dirty="0"/>
              <a:t>U</a:t>
            </a:r>
          </a:p>
        </p:txBody>
      </p:sp>
      <p:graphicFrame>
        <p:nvGraphicFramePr>
          <p:cNvPr id="12" name="Object 1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843097946"/>
              </p:ext>
            </p:extLst>
          </p:nvPr>
        </p:nvGraphicFramePr>
        <p:xfrm>
          <a:off x="18818225" y="10436225"/>
          <a:ext cx="3438525" cy="37877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34" imgW="3439296" imgH="3750644" progId="Prism10.Document">
                  <p:embed/>
                </p:oleObj>
              </mc:Choice>
              <mc:Fallback>
                <p:oleObj name="Prism 10" r:id="rId34" imgW="3439296" imgH="3750644" progId="Prism10.Document">
                  <p:embed/>
                  <p:pic>
                    <p:nvPicPr>
                      <p:cNvPr id="12" name="Object 11"/>
                      <p:cNvPicPr/>
                      <p:nvPr/>
                    </p:nvPicPr>
                    <p:blipFill>
                      <a:blip r:embed="rId35"/>
                      <a:stretch>
                        <a:fillRect/>
                      </a:stretch>
                    </p:blipFill>
                    <p:spPr>
                      <a:xfrm>
                        <a:off x="18818225" y="10436225"/>
                        <a:ext cx="3438525" cy="37877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3" name="Object 1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849316971"/>
              </p:ext>
            </p:extLst>
          </p:nvPr>
        </p:nvGraphicFramePr>
        <p:xfrm>
          <a:off x="15457591" y="10427060"/>
          <a:ext cx="3586162" cy="37687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36" imgW="3585871" imgH="3769012" progId="Prism10.Document">
                  <p:embed/>
                </p:oleObj>
              </mc:Choice>
              <mc:Fallback>
                <p:oleObj name="Prism 10" r:id="rId36" imgW="3585871" imgH="3769012" progId="Prism10.Document">
                  <p:embed/>
                  <p:pic>
                    <p:nvPicPr>
                      <p:cNvPr id="13" name="Object 12"/>
                      <p:cNvPicPr/>
                      <p:nvPr/>
                    </p:nvPicPr>
                    <p:blipFill>
                      <a:blip r:embed="rId37"/>
                      <a:stretch>
                        <a:fillRect/>
                      </a:stretch>
                    </p:blipFill>
                    <p:spPr>
                      <a:xfrm>
                        <a:off x="15457591" y="10427060"/>
                        <a:ext cx="3586162" cy="37687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3" name="Object 3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360617410"/>
              </p:ext>
            </p:extLst>
          </p:nvPr>
        </p:nvGraphicFramePr>
        <p:xfrm>
          <a:off x="12287250" y="10447338"/>
          <a:ext cx="3467100" cy="37687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38" imgW="3431733" imgH="3769012" progId="Prism10.Document">
                  <p:embed/>
                </p:oleObj>
              </mc:Choice>
              <mc:Fallback>
                <p:oleObj name="Prism 10" r:id="rId38" imgW="3431733" imgH="3769012" progId="Prism10.Document">
                  <p:embed/>
                  <p:pic>
                    <p:nvPicPr>
                      <p:cNvPr id="33" name="Object 32"/>
                      <p:cNvPicPr/>
                      <p:nvPr/>
                    </p:nvPicPr>
                    <p:blipFill>
                      <a:blip r:embed="rId39"/>
                      <a:stretch>
                        <a:fillRect/>
                      </a:stretch>
                    </p:blipFill>
                    <p:spPr>
                      <a:xfrm>
                        <a:off x="12287250" y="10447338"/>
                        <a:ext cx="3467100" cy="37687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5" name="TextBox 34"/>
          <p:cNvSpPr txBox="1"/>
          <p:nvPr/>
        </p:nvSpPr>
        <p:spPr>
          <a:xfrm>
            <a:off x="16298628" y="9764994"/>
            <a:ext cx="2517292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800" b="1" dirty="0"/>
              <a:t>Junctional Zone</a:t>
            </a:r>
          </a:p>
        </p:txBody>
      </p:sp>
      <p:sp>
        <p:nvSpPr>
          <p:cNvPr id="78" name="TextBox 77"/>
          <p:cNvSpPr txBox="1"/>
          <p:nvPr/>
        </p:nvSpPr>
        <p:spPr>
          <a:xfrm>
            <a:off x="12388973" y="10241464"/>
            <a:ext cx="457176" cy="646331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sz="3600" b="1" dirty="0"/>
              <a:t>V</a:t>
            </a:r>
          </a:p>
        </p:txBody>
      </p:sp>
      <p:sp>
        <p:nvSpPr>
          <p:cNvPr id="79" name="TextBox 78"/>
          <p:cNvSpPr txBox="1"/>
          <p:nvPr/>
        </p:nvSpPr>
        <p:spPr>
          <a:xfrm>
            <a:off x="15518794" y="10241464"/>
            <a:ext cx="603050" cy="646331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sz="3600" b="1" dirty="0"/>
              <a:t>W</a:t>
            </a:r>
          </a:p>
        </p:txBody>
      </p:sp>
      <p:sp>
        <p:nvSpPr>
          <p:cNvPr id="80" name="TextBox 79"/>
          <p:cNvSpPr txBox="1"/>
          <p:nvPr/>
        </p:nvSpPr>
        <p:spPr>
          <a:xfrm>
            <a:off x="18888275" y="10241464"/>
            <a:ext cx="439544" cy="646331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sz="3600" b="1" dirty="0"/>
              <a:t>X</a:t>
            </a:r>
          </a:p>
        </p:txBody>
      </p:sp>
      <p:sp>
        <p:nvSpPr>
          <p:cNvPr id="81" name="TextBox 80"/>
          <p:cNvSpPr txBox="1"/>
          <p:nvPr/>
        </p:nvSpPr>
        <p:spPr>
          <a:xfrm>
            <a:off x="12155007" y="18578288"/>
            <a:ext cx="633507" cy="646331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sz="3600" b="1" dirty="0" err="1"/>
              <a:t>Zii</a:t>
            </a:r>
            <a:endParaRPr lang="en-US" sz="3600" b="1" dirty="0"/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2F526661-E125-B3E2-8E22-8253DFF8F89D}"/>
              </a:ext>
            </a:extLst>
          </p:cNvPr>
          <p:cNvSpPr txBox="1"/>
          <p:nvPr/>
        </p:nvSpPr>
        <p:spPr>
          <a:xfrm>
            <a:off x="414177" y="457969"/>
            <a:ext cx="4532587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200" b="1" dirty="0"/>
              <a:t>Supplementary Figure S1.</a:t>
            </a:r>
          </a:p>
        </p:txBody>
      </p:sp>
      <p:sp>
        <p:nvSpPr>
          <p:cNvPr id="40" name="Rectangle 39"/>
          <p:cNvSpPr/>
          <p:nvPr/>
        </p:nvSpPr>
        <p:spPr>
          <a:xfrm>
            <a:off x="899663" y="23560424"/>
            <a:ext cx="21189745" cy="618630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buSzPts val="1100"/>
            </a:pPr>
            <a:r>
              <a:rPr lang="en-US" sz="36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1. Autofluorescence was statistically different in fetal liver only across treatments.</a:t>
            </a:r>
            <a:r>
              <a:rPr lang="en-US" sz="36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en-US" sz="36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US" sz="36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en-US" sz="36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US" sz="36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) Whole fetus, (</a:t>
            </a:r>
            <a:r>
              <a:rPr lang="en-US" sz="36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r>
              <a:rPr lang="en-US" sz="36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en-US" sz="36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r>
              <a:rPr lang="en-US" sz="36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) fetal brain, (</a:t>
            </a:r>
            <a:r>
              <a:rPr lang="en-US" sz="36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r>
              <a:rPr lang="en-US" sz="36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en-US" sz="36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  <a:r>
              <a:rPr lang="en-US" sz="36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) subventricular zone, (</a:t>
            </a:r>
            <a:r>
              <a:rPr lang="en-US" sz="36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J</a:t>
            </a:r>
            <a:r>
              <a:rPr lang="en-US" sz="36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en-US" sz="36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</a:t>
            </a:r>
            <a:r>
              <a:rPr lang="en-US" sz="36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) choroid plexus (</a:t>
            </a:r>
            <a:r>
              <a:rPr lang="en-US" sz="3600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hP</a:t>
            </a:r>
            <a:r>
              <a:rPr lang="en-US" sz="36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), (</a:t>
            </a:r>
            <a:r>
              <a:rPr lang="en-US" sz="36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sz="36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en-US" sz="36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</a:t>
            </a:r>
            <a:r>
              <a:rPr lang="en-US" sz="36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) placenta, (</a:t>
            </a:r>
            <a:r>
              <a:rPr lang="en-US" sz="36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  <a:r>
              <a:rPr lang="en-US" sz="36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en-US" sz="36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U</a:t>
            </a:r>
            <a:r>
              <a:rPr lang="en-US" sz="36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) decidua, (</a:t>
            </a:r>
            <a:r>
              <a:rPr lang="en-US" sz="36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V</a:t>
            </a:r>
            <a:r>
              <a:rPr lang="en-US" sz="36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en-US" sz="36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X</a:t>
            </a:r>
            <a:r>
              <a:rPr lang="en-US" sz="36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) junctional zone, and (</a:t>
            </a:r>
            <a:r>
              <a:rPr lang="en-US" sz="36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Y</a:t>
            </a:r>
            <a:r>
              <a:rPr lang="en-US" sz="36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en-US" sz="36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Zi</a:t>
            </a:r>
            <a:r>
              <a:rPr lang="en-US" sz="36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) labyrinth showed no differences on autofluorescence baseline</a:t>
            </a:r>
            <a:r>
              <a:rPr lang="en-US" sz="3600" baseline="30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36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cross treatment groups. However, an increase on (</a:t>
            </a:r>
            <a:r>
              <a:rPr lang="en-US" sz="36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r>
              <a:rPr lang="en-US" sz="36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en-US" sz="36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</a:t>
            </a:r>
            <a:r>
              <a:rPr lang="en-US" sz="36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) liver autofluorescence for was detected in 2 of the 3 channels when dams exposed to IAV. </a:t>
            </a:r>
            <a:r>
              <a:rPr lang="en-US" sz="3600" dirty="0">
                <a:latin typeface="Arial" panose="020B0604020202020204" pitchFamily="34" charset="0"/>
                <a:cs typeface="Arial" panose="020B0604020202020204" pitchFamily="34" charset="0"/>
              </a:rPr>
              <a:t>Based on these findings and for consistency, liver autofluorescence was subtracted from each sample in all channels, as demonstrated in </a:t>
            </a:r>
            <a:r>
              <a:rPr lang="en-US" sz="36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sz="3600" b="1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Zii</a:t>
            </a:r>
            <a:r>
              <a:rPr lang="en-US" sz="36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). </a:t>
            </a:r>
            <a:r>
              <a:rPr lang="en-US" sz="3600" dirty="0">
                <a:latin typeface="Arial" panose="020B0604020202020204" pitchFamily="34" charset="0"/>
                <a:cs typeface="Arial" panose="020B0604020202020204" pitchFamily="34" charset="0"/>
              </a:rPr>
              <a:t>Group comparisons were analyzed using one-way ANOVA followed by Tukey's post hoc test for multiple comparisons;</a:t>
            </a:r>
            <a:r>
              <a:rPr lang="en-US" sz="3600" dirty="0">
                <a:solidFill>
                  <a:srgbClr val="131F33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** = p &lt; 0.01.</a:t>
            </a:r>
            <a:r>
              <a:rPr lang="en-US" sz="3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3600" dirty="0">
                <a:solidFill>
                  <a:srgbClr val="131F33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ata are expressed as means ± SEM; a</a:t>
            </a:r>
            <a:r>
              <a:rPr lang="en-US" sz="3600" dirty="0">
                <a:latin typeface="Arial" panose="020B0604020202020204" pitchFamily="34" charset="0"/>
                <a:cs typeface="Arial" panose="020B0604020202020204" pitchFamily="34" charset="0"/>
              </a:rPr>
              <a:t> single dam per group served as a negative control for autofluorescence base line quantification. Each circle represents an individual fetus from one dam; n = 5 fetuses per dam were included.</a:t>
            </a:r>
            <a:r>
              <a:rPr lang="en-US" sz="3600" dirty="0">
                <a:solidFill>
                  <a:srgbClr val="131F33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3600" dirty="0" err="1">
                <a:solidFill>
                  <a:srgbClr val="131F33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.c.</a:t>
            </a:r>
            <a:r>
              <a:rPr lang="en-US" sz="3600" dirty="0">
                <a:solidFill>
                  <a:srgbClr val="131F33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= negative control.</a:t>
            </a:r>
            <a:endParaRPr lang="en-US" sz="3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41" name="Object 40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883372733"/>
              </p:ext>
            </p:extLst>
          </p:nvPr>
        </p:nvGraphicFramePr>
        <p:xfrm>
          <a:off x="8413750" y="10299700"/>
          <a:ext cx="3513138" cy="3937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40" imgW="3512764" imgH="3689778" progId="Prism10.Document">
                  <p:embed/>
                </p:oleObj>
              </mc:Choice>
              <mc:Fallback>
                <p:oleObj name="Prism 10" r:id="rId40" imgW="3512764" imgH="3689778" progId="Prism10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1"/>
                      <a:stretch>
                        <a:fillRect/>
                      </a:stretch>
                    </p:blipFill>
                    <p:spPr>
                      <a:xfrm>
                        <a:off x="8413750" y="10299700"/>
                        <a:ext cx="3513138" cy="3937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1" name="Object 50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188009426"/>
              </p:ext>
            </p:extLst>
          </p:nvPr>
        </p:nvGraphicFramePr>
        <p:xfrm>
          <a:off x="4921250" y="10287000"/>
          <a:ext cx="3633788" cy="3937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42" imgW="3491156" imgH="3689778" progId="Prism10.Document">
                  <p:embed/>
                </p:oleObj>
              </mc:Choice>
              <mc:Fallback>
                <p:oleObj name="Prism 10" r:id="rId42" imgW="3491156" imgH="3689778" progId="Prism10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3"/>
                      <a:stretch>
                        <a:fillRect/>
                      </a:stretch>
                    </p:blipFill>
                    <p:spPr>
                      <a:xfrm>
                        <a:off x="4921250" y="10287000"/>
                        <a:ext cx="3633788" cy="3937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9" name="Object 58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740785804"/>
              </p:ext>
            </p:extLst>
          </p:nvPr>
        </p:nvGraphicFramePr>
        <p:xfrm>
          <a:off x="1125538" y="10274301"/>
          <a:ext cx="3748087" cy="39497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44" imgW="3543015" imgH="3689778" progId="Prism10.Document">
                  <p:embed/>
                </p:oleObj>
              </mc:Choice>
              <mc:Fallback>
                <p:oleObj name="Prism 10" r:id="rId44" imgW="3543015" imgH="3689778" progId="Prism10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5"/>
                      <a:stretch>
                        <a:fillRect/>
                      </a:stretch>
                    </p:blipFill>
                    <p:spPr>
                      <a:xfrm>
                        <a:off x="1125538" y="10274301"/>
                        <a:ext cx="3748087" cy="39497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91" name="TextBox 90"/>
          <p:cNvSpPr txBox="1"/>
          <p:nvPr/>
        </p:nvSpPr>
        <p:spPr>
          <a:xfrm>
            <a:off x="4590438" y="9764994"/>
            <a:ext cx="4074577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800" b="1" dirty="0"/>
              <a:t>Subventricular zone (SVZ) </a:t>
            </a:r>
          </a:p>
        </p:txBody>
      </p:sp>
      <p:cxnSp>
        <p:nvCxnSpPr>
          <p:cNvPr id="92" name="Straight Connector 91"/>
          <p:cNvCxnSpPr/>
          <p:nvPr/>
        </p:nvCxnSpPr>
        <p:spPr>
          <a:xfrm flipV="1">
            <a:off x="2314883" y="10287583"/>
            <a:ext cx="8790039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36" name="Object 3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591209497"/>
              </p:ext>
            </p:extLst>
          </p:nvPr>
        </p:nvGraphicFramePr>
        <p:xfrm>
          <a:off x="18818225" y="14701838"/>
          <a:ext cx="3414713" cy="36893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46" imgW="3415167" imgH="3689778" progId="Prism10.Document">
                  <p:embed/>
                </p:oleObj>
              </mc:Choice>
              <mc:Fallback>
                <p:oleObj name="Prism 10" r:id="rId46" imgW="3415167" imgH="3689778" progId="Prism10.Document">
                  <p:embed/>
                  <p:pic>
                    <p:nvPicPr>
                      <p:cNvPr id="36" name="Object 35"/>
                      <p:cNvPicPr/>
                      <p:nvPr/>
                    </p:nvPicPr>
                    <p:blipFill>
                      <a:blip r:embed="rId47"/>
                      <a:stretch>
                        <a:fillRect/>
                      </a:stretch>
                    </p:blipFill>
                    <p:spPr>
                      <a:xfrm>
                        <a:off x="18818225" y="14701838"/>
                        <a:ext cx="3414713" cy="36893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7" name="Object 3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988148706"/>
              </p:ext>
            </p:extLst>
          </p:nvPr>
        </p:nvGraphicFramePr>
        <p:xfrm>
          <a:off x="15444788" y="14711363"/>
          <a:ext cx="3505200" cy="36893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48" imgW="3504841" imgH="3689778" progId="Prism10.Document">
                  <p:embed/>
                </p:oleObj>
              </mc:Choice>
              <mc:Fallback>
                <p:oleObj name="Prism 10" r:id="rId48" imgW="3504841" imgH="3689778" progId="Prism10.Document">
                  <p:embed/>
                  <p:pic>
                    <p:nvPicPr>
                      <p:cNvPr id="37" name="Object 36"/>
                      <p:cNvPicPr/>
                      <p:nvPr/>
                    </p:nvPicPr>
                    <p:blipFill>
                      <a:blip r:embed="rId49"/>
                      <a:stretch>
                        <a:fillRect/>
                      </a:stretch>
                    </p:blipFill>
                    <p:spPr>
                      <a:xfrm>
                        <a:off x="15444788" y="14711363"/>
                        <a:ext cx="3505200" cy="36893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8" name="Object 37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713322080"/>
              </p:ext>
            </p:extLst>
          </p:nvPr>
        </p:nvGraphicFramePr>
        <p:xfrm>
          <a:off x="12301538" y="14709775"/>
          <a:ext cx="3451225" cy="36893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50" imgW="3549137" imgH="3689778" progId="Prism10.Document">
                  <p:embed/>
                </p:oleObj>
              </mc:Choice>
              <mc:Fallback>
                <p:oleObj name="Prism 10" r:id="rId50" imgW="3549137" imgH="3689778" progId="Prism10.Document">
                  <p:embed/>
                  <p:pic>
                    <p:nvPicPr>
                      <p:cNvPr id="38" name="Object 37"/>
                      <p:cNvPicPr/>
                      <p:nvPr/>
                    </p:nvPicPr>
                    <p:blipFill>
                      <a:blip r:embed="rId51"/>
                      <a:stretch>
                        <a:fillRect/>
                      </a:stretch>
                    </p:blipFill>
                    <p:spPr>
                      <a:xfrm>
                        <a:off x="12301538" y="14709775"/>
                        <a:ext cx="3451225" cy="36893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9" name="TextBox 38"/>
          <p:cNvSpPr txBox="1"/>
          <p:nvPr/>
        </p:nvSpPr>
        <p:spPr>
          <a:xfrm>
            <a:off x="16596290" y="13966614"/>
            <a:ext cx="1598066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800" b="1" dirty="0"/>
              <a:t>Labyrinth</a:t>
            </a:r>
          </a:p>
        </p:txBody>
      </p:sp>
      <p:cxnSp>
        <p:nvCxnSpPr>
          <p:cNvPr id="56" name="Straight Connector 55"/>
          <p:cNvCxnSpPr/>
          <p:nvPr/>
        </p:nvCxnSpPr>
        <p:spPr>
          <a:xfrm flipV="1">
            <a:off x="13012995" y="14479631"/>
            <a:ext cx="8790039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3" name="TextBox 92"/>
          <p:cNvSpPr txBox="1"/>
          <p:nvPr/>
        </p:nvSpPr>
        <p:spPr>
          <a:xfrm>
            <a:off x="12199819" y="14481599"/>
            <a:ext cx="425116" cy="646331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sz="3600" b="1" dirty="0"/>
              <a:t>Y</a:t>
            </a:r>
          </a:p>
        </p:txBody>
      </p:sp>
      <p:sp>
        <p:nvSpPr>
          <p:cNvPr id="94" name="TextBox 93"/>
          <p:cNvSpPr txBox="1"/>
          <p:nvPr/>
        </p:nvSpPr>
        <p:spPr>
          <a:xfrm>
            <a:off x="15518794" y="14481599"/>
            <a:ext cx="405880" cy="646331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sz="3600" b="1" dirty="0"/>
              <a:t>Z</a:t>
            </a:r>
          </a:p>
        </p:txBody>
      </p:sp>
      <p:sp>
        <p:nvSpPr>
          <p:cNvPr id="95" name="TextBox 94"/>
          <p:cNvSpPr txBox="1"/>
          <p:nvPr/>
        </p:nvSpPr>
        <p:spPr>
          <a:xfrm>
            <a:off x="18888275" y="14494299"/>
            <a:ext cx="519694" cy="646331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sz="3600" b="1" dirty="0" err="1"/>
              <a:t>Zi</a:t>
            </a:r>
            <a:endParaRPr lang="en-US" sz="3600" b="1" dirty="0"/>
          </a:p>
        </p:txBody>
      </p:sp>
      <p:sp>
        <p:nvSpPr>
          <p:cNvPr id="103" name="TextBox 102"/>
          <p:cNvSpPr txBox="1"/>
          <p:nvPr/>
        </p:nvSpPr>
        <p:spPr>
          <a:xfrm>
            <a:off x="5107941" y="13966614"/>
            <a:ext cx="3271345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800" b="1" dirty="0"/>
              <a:t>Choroid plexus (</a:t>
            </a:r>
            <a:r>
              <a:rPr lang="en-US" sz="2800" b="1" dirty="0" err="1"/>
              <a:t>ChP</a:t>
            </a:r>
            <a:r>
              <a:rPr lang="en-US" sz="2800" b="1" dirty="0"/>
              <a:t>)</a:t>
            </a:r>
          </a:p>
        </p:txBody>
      </p:sp>
      <p:cxnSp>
        <p:nvCxnSpPr>
          <p:cNvPr id="104" name="Straight Connector 103"/>
          <p:cNvCxnSpPr/>
          <p:nvPr/>
        </p:nvCxnSpPr>
        <p:spPr>
          <a:xfrm flipV="1">
            <a:off x="2197240" y="14479631"/>
            <a:ext cx="8790039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5" name="TextBox 104"/>
          <p:cNvSpPr txBox="1"/>
          <p:nvPr/>
        </p:nvSpPr>
        <p:spPr>
          <a:xfrm>
            <a:off x="1142863" y="14614779"/>
            <a:ext cx="552630" cy="646331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sz="3600" b="1" dirty="0"/>
              <a:t>J</a:t>
            </a:r>
          </a:p>
        </p:txBody>
      </p:sp>
      <p:sp>
        <p:nvSpPr>
          <p:cNvPr id="106" name="TextBox 105"/>
          <p:cNvSpPr txBox="1"/>
          <p:nvPr/>
        </p:nvSpPr>
        <p:spPr>
          <a:xfrm>
            <a:off x="4798999" y="14614779"/>
            <a:ext cx="437940" cy="646331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sz="3600" b="1" dirty="0"/>
              <a:t>K</a:t>
            </a:r>
          </a:p>
        </p:txBody>
      </p:sp>
      <p:sp>
        <p:nvSpPr>
          <p:cNvPr id="107" name="TextBox 106"/>
          <p:cNvSpPr txBox="1"/>
          <p:nvPr/>
        </p:nvSpPr>
        <p:spPr>
          <a:xfrm>
            <a:off x="8358980" y="14614779"/>
            <a:ext cx="380232" cy="646331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sz="3600" b="1" dirty="0"/>
              <a:t>L</a:t>
            </a:r>
          </a:p>
        </p:txBody>
      </p:sp>
      <p:graphicFrame>
        <p:nvGraphicFramePr>
          <p:cNvPr id="47" name="Object 4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925666145"/>
              </p:ext>
            </p:extLst>
          </p:nvPr>
        </p:nvGraphicFramePr>
        <p:xfrm>
          <a:off x="8343900" y="14721529"/>
          <a:ext cx="3543300" cy="36893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52" imgW="3613242" imgH="3689778" progId="Prism10.Document">
                  <p:embed/>
                </p:oleObj>
              </mc:Choice>
              <mc:Fallback>
                <p:oleObj name="Prism 10" r:id="rId52" imgW="3613242" imgH="3689778" progId="Prism10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3"/>
                      <a:stretch>
                        <a:fillRect/>
                      </a:stretch>
                    </p:blipFill>
                    <p:spPr>
                      <a:xfrm>
                        <a:off x="8343900" y="14721529"/>
                        <a:ext cx="3543300" cy="36893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8" name="Object 47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651096347"/>
              </p:ext>
            </p:extLst>
          </p:nvPr>
        </p:nvGraphicFramePr>
        <p:xfrm>
          <a:off x="4820378" y="14721529"/>
          <a:ext cx="3616325" cy="36893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54" imgW="3616123" imgH="3689778" progId="Prism10.Document">
                  <p:embed/>
                </p:oleObj>
              </mc:Choice>
              <mc:Fallback>
                <p:oleObj name="Prism 10" r:id="rId54" imgW="3616123" imgH="3689778" progId="Prism10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5"/>
                      <a:stretch>
                        <a:fillRect/>
                      </a:stretch>
                    </p:blipFill>
                    <p:spPr>
                      <a:xfrm>
                        <a:off x="4820378" y="14721529"/>
                        <a:ext cx="3616325" cy="36893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9" name="Object 48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772944185"/>
              </p:ext>
            </p:extLst>
          </p:nvPr>
        </p:nvGraphicFramePr>
        <p:xfrm>
          <a:off x="1193991" y="14721529"/>
          <a:ext cx="3644709" cy="36893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56" imgW="3506641" imgH="3689778" progId="Prism10.Document">
                  <p:embed/>
                </p:oleObj>
              </mc:Choice>
              <mc:Fallback>
                <p:oleObj name="Prism 10" r:id="rId56" imgW="3506641" imgH="3689778" progId="Prism10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7"/>
                      <a:stretch>
                        <a:fillRect/>
                      </a:stretch>
                    </p:blipFill>
                    <p:spPr>
                      <a:xfrm>
                        <a:off x="1193991" y="14721529"/>
                        <a:ext cx="3644709" cy="36893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pSp>
        <p:nvGrpSpPr>
          <p:cNvPr id="117" name="Group 116"/>
          <p:cNvGrpSpPr/>
          <p:nvPr/>
        </p:nvGrpSpPr>
        <p:grpSpPr>
          <a:xfrm>
            <a:off x="3647547" y="22571683"/>
            <a:ext cx="6292890" cy="590527"/>
            <a:chOff x="15433678" y="7986862"/>
            <a:chExt cx="6292890" cy="590527"/>
          </a:xfrm>
        </p:grpSpPr>
        <p:sp>
          <p:nvSpPr>
            <p:cNvPr id="118" name="TextBox 117">
              <a:extLst>
                <a:ext uri="{FF2B5EF4-FFF2-40B4-BE49-F238E27FC236}">
                  <a16:creationId xmlns:a16="http://schemas.microsoft.com/office/drawing/2014/main" id="{AF1BBFB5-F136-74A5-EC62-385A26239619}"/>
                </a:ext>
              </a:extLst>
            </p:cNvPr>
            <p:cNvSpPr txBox="1"/>
            <p:nvPr/>
          </p:nvSpPr>
          <p:spPr>
            <a:xfrm>
              <a:off x="15641124" y="7988301"/>
              <a:ext cx="1331071" cy="58846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2800" dirty="0">
                  <a:cs typeface="Arial" panose="020B0604020202020204" pitchFamily="34" charset="0"/>
                </a:rPr>
                <a:t>Legend:</a:t>
              </a:r>
            </a:p>
          </p:txBody>
        </p:sp>
        <p:sp>
          <p:nvSpPr>
            <p:cNvPr id="119" name="TextBox 118">
              <a:extLst>
                <a:ext uri="{FF2B5EF4-FFF2-40B4-BE49-F238E27FC236}">
                  <a16:creationId xmlns:a16="http://schemas.microsoft.com/office/drawing/2014/main" id="{3B9872B2-9D1A-EB02-54AB-9FF97973659E}"/>
                </a:ext>
              </a:extLst>
            </p:cNvPr>
            <p:cNvSpPr txBox="1"/>
            <p:nvPr/>
          </p:nvSpPr>
          <p:spPr>
            <a:xfrm>
              <a:off x="17536228" y="7988924"/>
              <a:ext cx="753731" cy="5884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2800" dirty="0">
                  <a:cs typeface="Arial" panose="020B0604020202020204" pitchFamily="34" charset="0"/>
                </a:rPr>
                <a:t>Con</a:t>
              </a:r>
            </a:p>
          </p:txBody>
        </p:sp>
        <p:sp>
          <p:nvSpPr>
            <p:cNvPr id="120" name="TextBox 119">
              <a:extLst>
                <a:ext uri="{FF2B5EF4-FFF2-40B4-BE49-F238E27FC236}">
                  <a16:creationId xmlns:a16="http://schemas.microsoft.com/office/drawing/2014/main" id="{2B696D2C-658E-0F65-BAA3-0FAA9CA6BEDC}"/>
                </a:ext>
              </a:extLst>
            </p:cNvPr>
            <p:cNvSpPr txBox="1"/>
            <p:nvPr/>
          </p:nvSpPr>
          <p:spPr>
            <a:xfrm>
              <a:off x="18877142" y="7988913"/>
              <a:ext cx="1178527" cy="5884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2800" dirty="0">
                  <a:cs typeface="Arial" panose="020B0604020202020204" pitchFamily="34" charset="0"/>
                </a:rPr>
                <a:t>X31</a:t>
              </a:r>
              <a:r>
                <a:rPr lang="en-US" sz="2800" baseline="-25000" dirty="0">
                  <a:cs typeface="Arial" panose="020B0604020202020204" pitchFamily="34" charset="0"/>
                </a:rPr>
                <a:t>mod</a:t>
              </a:r>
            </a:p>
          </p:txBody>
        </p:sp>
        <p:sp>
          <p:nvSpPr>
            <p:cNvPr id="121" name="TextBox 120">
              <a:extLst>
                <a:ext uri="{FF2B5EF4-FFF2-40B4-BE49-F238E27FC236}">
                  <a16:creationId xmlns:a16="http://schemas.microsoft.com/office/drawing/2014/main" id="{9AB4959C-3B6C-CA70-04B7-A0075AB99D90}"/>
                </a:ext>
              </a:extLst>
            </p:cNvPr>
            <p:cNvSpPr txBox="1"/>
            <p:nvPr/>
          </p:nvSpPr>
          <p:spPr>
            <a:xfrm>
              <a:off x="20593250" y="7988906"/>
              <a:ext cx="915635" cy="5884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2800" dirty="0">
                  <a:cs typeface="Arial" panose="020B0604020202020204" pitchFamily="34" charset="0"/>
                </a:rPr>
                <a:t>X31</a:t>
              </a:r>
              <a:r>
                <a:rPr lang="en-US" sz="2800" baseline="-25000" dirty="0">
                  <a:cs typeface="Arial" panose="020B0604020202020204" pitchFamily="34" charset="0"/>
                </a:rPr>
                <a:t>hi</a:t>
              </a:r>
            </a:p>
          </p:txBody>
        </p:sp>
        <p:sp>
          <p:nvSpPr>
            <p:cNvPr id="122" name="Rectangle 121">
              <a:extLst>
                <a:ext uri="{FF2B5EF4-FFF2-40B4-BE49-F238E27FC236}">
                  <a16:creationId xmlns:a16="http://schemas.microsoft.com/office/drawing/2014/main" id="{7A2596D0-46BE-4279-A5B3-59C91930BE65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15433678" y="7986862"/>
              <a:ext cx="6292890" cy="566588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800">
                <a:cs typeface="Arial" panose="020B0604020202020204" pitchFamily="34" charset="0"/>
              </a:endParaRPr>
            </a:p>
          </p:txBody>
        </p:sp>
        <p:sp>
          <p:nvSpPr>
            <p:cNvPr id="123" name="Rectangle 122">
              <a:extLst>
                <a:ext uri="{FF2B5EF4-FFF2-40B4-BE49-F238E27FC236}">
                  <a16:creationId xmlns:a16="http://schemas.microsoft.com/office/drawing/2014/main" id="{0AD6776F-8AD9-CE0E-45CB-9A4DFFD09A92}"/>
                </a:ext>
              </a:extLst>
            </p:cNvPr>
            <p:cNvSpPr/>
            <p:nvPr/>
          </p:nvSpPr>
          <p:spPr>
            <a:xfrm>
              <a:off x="18469774" y="8124545"/>
              <a:ext cx="326017" cy="300659"/>
            </a:xfrm>
            <a:prstGeom prst="rect">
              <a:avLst/>
            </a:prstGeom>
            <a:solidFill>
              <a:srgbClr val="FF0000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800">
                <a:cs typeface="Arial" panose="020B0604020202020204" pitchFamily="34" charset="0"/>
              </a:endParaRPr>
            </a:p>
          </p:txBody>
        </p:sp>
        <p:sp>
          <p:nvSpPr>
            <p:cNvPr id="124" name="Rectangle 123">
              <a:extLst>
                <a:ext uri="{FF2B5EF4-FFF2-40B4-BE49-F238E27FC236}">
                  <a16:creationId xmlns:a16="http://schemas.microsoft.com/office/drawing/2014/main" id="{3259DBA0-AD77-8F85-227B-E980D6C79335}"/>
                </a:ext>
              </a:extLst>
            </p:cNvPr>
            <p:cNvSpPr/>
            <p:nvPr/>
          </p:nvSpPr>
          <p:spPr>
            <a:xfrm>
              <a:off x="20178825" y="8124545"/>
              <a:ext cx="326017" cy="300659"/>
            </a:xfrm>
            <a:prstGeom prst="rect">
              <a:avLst/>
            </a:prstGeom>
            <a:solidFill>
              <a:srgbClr val="C00000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800">
                <a:cs typeface="Arial" panose="020B0604020202020204" pitchFamily="34" charset="0"/>
              </a:endParaRPr>
            </a:p>
          </p:txBody>
        </p:sp>
        <p:sp>
          <p:nvSpPr>
            <p:cNvPr id="125" name="Rectangle 124">
              <a:extLst>
                <a:ext uri="{FF2B5EF4-FFF2-40B4-BE49-F238E27FC236}">
                  <a16:creationId xmlns:a16="http://schemas.microsoft.com/office/drawing/2014/main" id="{D8BFDBB0-710E-C27A-78EE-DF914C34E7F7}"/>
                </a:ext>
              </a:extLst>
            </p:cNvPr>
            <p:cNvSpPr/>
            <p:nvPr/>
          </p:nvSpPr>
          <p:spPr>
            <a:xfrm>
              <a:off x="17158247" y="8124545"/>
              <a:ext cx="326017" cy="300659"/>
            </a:xfrm>
            <a:prstGeom prst="rect">
              <a:avLst/>
            </a:prstGeom>
            <a:solidFill>
              <a:schemeClr val="bg2">
                <a:lumMod val="90000"/>
              </a:schemeClr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800"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63613823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8" name="Object 27"/>
          <p:cNvGraphicFramePr>
            <a:graphicFrameLocks noChangeAspect="1"/>
          </p:cNvGraphicFramePr>
          <p:nvPr/>
        </p:nvGraphicFramePr>
        <p:xfrm>
          <a:off x="5516562" y="6602660"/>
          <a:ext cx="4552489" cy="559397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2" imgW="3007853" imgH="3707786" progId="Prism10.Document">
                  <p:embed/>
                </p:oleObj>
              </mc:Choice>
              <mc:Fallback>
                <p:oleObj name="Prism 10" r:id="rId2" imgW="3007853" imgH="3707786" progId="Prism10.Document">
                  <p:embed/>
                  <p:pic>
                    <p:nvPicPr>
                      <p:cNvPr id="28" name="Object 27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5516562" y="6602660"/>
                        <a:ext cx="4552489" cy="559397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4" name="Object 33"/>
          <p:cNvGraphicFramePr>
            <a:graphicFrameLocks noChangeAspect="1"/>
          </p:cNvGraphicFramePr>
          <p:nvPr/>
        </p:nvGraphicFramePr>
        <p:xfrm>
          <a:off x="14787563" y="6708179"/>
          <a:ext cx="4556351" cy="550657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4" imgW="3007853" imgH="3707786" progId="Prism10.Document">
                  <p:embed/>
                </p:oleObj>
              </mc:Choice>
              <mc:Fallback>
                <p:oleObj name="Prism 10" r:id="rId4" imgW="3007853" imgH="3707786" progId="Prism10.Document">
                  <p:embed/>
                  <p:pic>
                    <p:nvPicPr>
                      <p:cNvPr id="34" name="Object 33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14787563" y="6708179"/>
                        <a:ext cx="4556351" cy="550657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1" name="Object 30"/>
          <p:cNvGraphicFramePr>
            <a:graphicFrameLocks noChangeAspect="1"/>
          </p:cNvGraphicFramePr>
          <p:nvPr/>
        </p:nvGraphicFramePr>
        <p:xfrm>
          <a:off x="10151097" y="6637784"/>
          <a:ext cx="4554420" cy="558044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6" imgW="3007853" imgH="3759648" progId="Prism10.Document">
                  <p:embed/>
                </p:oleObj>
              </mc:Choice>
              <mc:Fallback>
                <p:oleObj name="Prism 10" r:id="rId6" imgW="3007853" imgH="3759648" progId="Prism10.Document">
                  <p:embed/>
                  <p:pic>
                    <p:nvPicPr>
                      <p:cNvPr id="31" name="Object 30"/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10151097" y="6637784"/>
                        <a:ext cx="4554420" cy="558044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2" name="Object 31"/>
          <p:cNvGraphicFramePr>
            <a:graphicFrameLocks noChangeAspect="1"/>
          </p:cNvGraphicFramePr>
          <p:nvPr/>
        </p:nvGraphicFramePr>
        <p:xfrm>
          <a:off x="10151096" y="1458835"/>
          <a:ext cx="4558283" cy="557855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8" imgW="3007853" imgH="3689778" progId="Prism10.Document">
                  <p:embed/>
                </p:oleObj>
              </mc:Choice>
              <mc:Fallback>
                <p:oleObj name="Prism 10" r:id="rId8" imgW="3007853" imgH="3689778" progId="Prism10.Document">
                  <p:embed/>
                  <p:pic>
                    <p:nvPicPr>
                      <p:cNvPr id="32" name="Object 31"/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10151096" y="1458835"/>
                        <a:ext cx="4558283" cy="557855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7" name="Object 26"/>
          <p:cNvGraphicFramePr>
            <a:graphicFrameLocks noChangeAspect="1"/>
          </p:cNvGraphicFramePr>
          <p:nvPr/>
        </p:nvGraphicFramePr>
        <p:xfrm>
          <a:off x="5575555" y="11814296"/>
          <a:ext cx="4556351" cy="553742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10" imgW="3007853" imgH="3689778" progId="Prism10.Document">
                  <p:embed/>
                </p:oleObj>
              </mc:Choice>
              <mc:Fallback>
                <p:oleObj name="Prism 10" r:id="rId10" imgW="3007853" imgH="3689778" progId="Prism10.Document">
                  <p:embed/>
                  <p:pic>
                    <p:nvPicPr>
                      <p:cNvPr id="27" name="Object 26"/>
                      <p:cNvPicPr/>
                      <p:nvPr/>
                    </p:nvPicPr>
                    <p:blipFill>
                      <a:blip r:embed="rId11"/>
                      <a:stretch>
                        <a:fillRect/>
                      </a:stretch>
                    </p:blipFill>
                    <p:spPr>
                      <a:xfrm>
                        <a:off x="5575555" y="11814296"/>
                        <a:ext cx="4556351" cy="553742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9" name="Object 28"/>
          <p:cNvGraphicFramePr>
            <a:graphicFrameLocks noChangeAspect="1"/>
          </p:cNvGraphicFramePr>
          <p:nvPr/>
        </p:nvGraphicFramePr>
        <p:xfrm>
          <a:off x="5516562" y="1504950"/>
          <a:ext cx="4556351" cy="548005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12" imgW="3007853" imgH="3689778" progId="Prism10.Document">
                  <p:embed/>
                </p:oleObj>
              </mc:Choice>
              <mc:Fallback>
                <p:oleObj name="Prism 10" r:id="rId12" imgW="3007853" imgH="3689778" progId="Prism10.Document">
                  <p:embed/>
                  <p:pic>
                    <p:nvPicPr>
                      <p:cNvPr id="29" name="Object 28"/>
                      <p:cNvPicPr/>
                      <p:nvPr/>
                    </p:nvPicPr>
                    <p:blipFill>
                      <a:blip r:embed="rId13"/>
                      <a:stretch>
                        <a:fillRect/>
                      </a:stretch>
                    </p:blipFill>
                    <p:spPr>
                      <a:xfrm>
                        <a:off x="5516562" y="1504950"/>
                        <a:ext cx="4556351" cy="548005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0" name="Object 29"/>
          <p:cNvGraphicFramePr>
            <a:graphicFrameLocks noChangeAspect="1"/>
          </p:cNvGraphicFramePr>
          <p:nvPr/>
        </p:nvGraphicFramePr>
        <p:xfrm>
          <a:off x="10180593" y="11818627"/>
          <a:ext cx="4558283" cy="553309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14" imgW="3007853" imgH="3724713" progId="Prism10.Document">
                  <p:embed/>
                </p:oleObj>
              </mc:Choice>
              <mc:Fallback>
                <p:oleObj name="Prism 10" r:id="rId14" imgW="3007853" imgH="3724713" progId="Prism10.Document">
                  <p:embed/>
                  <p:pic>
                    <p:nvPicPr>
                      <p:cNvPr id="30" name="Object 29"/>
                      <p:cNvPicPr/>
                      <p:nvPr/>
                    </p:nvPicPr>
                    <p:blipFill>
                      <a:blip r:embed="rId15"/>
                      <a:stretch>
                        <a:fillRect/>
                      </a:stretch>
                    </p:blipFill>
                    <p:spPr>
                      <a:xfrm>
                        <a:off x="10180593" y="11818627"/>
                        <a:ext cx="4558283" cy="553309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3" name="Object 32"/>
          <p:cNvGraphicFramePr>
            <a:graphicFrameLocks noChangeAspect="1"/>
          </p:cNvGraphicFramePr>
          <p:nvPr/>
        </p:nvGraphicFramePr>
        <p:xfrm>
          <a:off x="14787563" y="11856512"/>
          <a:ext cx="4556352" cy="549520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16" imgW="3007853" imgH="3698782" progId="Prism10.Document">
                  <p:embed/>
                </p:oleObj>
              </mc:Choice>
              <mc:Fallback>
                <p:oleObj name="Prism 10" r:id="rId16" imgW="3007853" imgH="3698782" progId="Prism10.Document">
                  <p:embed/>
                  <p:pic>
                    <p:nvPicPr>
                      <p:cNvPr id="33" name="Object 32"/>
                      <p:cNvPicPr/>
                      <p:nvPr/>
                    </p:nvPicPr>
                    <p:blipFill>
                      <a:blip r:embed="rId17"/>
                      <a:stretch>
                        <a:fillRect/>
                      </a:stretch>
                    </p:blipFill>
                    <p:spPr>
                      <a:xfrm>
                        <a:off x="14787563" y="11856512"/>
                        <a:ext cx="4556352" cy="549520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5" name="Object 34"/>
          <p:cNvGraphicFramePr>
            <a:graphicFrameLocks noChangeAspect="1"/>
          </p:cNvGraphicFramePr>
          <p:nvPr/>
        </p:nvGraphicFramePr>
        <p:xfrm>
          <a:off x="14787563" y="1482181"/>
          <a:ext cx="4585324" cy="558423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18" imgW="3027661" imgH="3689778" progId="Prism10.Document">
                  <p:embed/>
                </p:oleObj>
              </mc:Choice>
              <mc:Fallback>
                <p:oleObj name="Prism 10" r:id="rId18" imgW="3027661" imgH="3689778" progId="Prism10.Document">
                  <p:embed/>
                  <p:pic>
                    <p:nvPicPr>
                      <p:cNvPr id="35" name="Object 34"/>
                      <p:cNvPicPr/>
                      <p:nvPr/>
                    </p:nvPicPr>
                    <p:blipFill>
                      <a:blip r:embed="rId19"/>
                      <a:stretch>
                        <a:fillRect/>
                      </a:stretch>
                    </p:blipFill>
                    <p:spPr>
                      <a:xfrm>
                        <a:off x="14787563" y="1482181"/>
                        <a:ext cx="4585324" cy="558423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4" name="TextBox 13"/>
          <p:cNvSpPr txBox="1"/>
          <p:nvPr/>
        </p:nvSpPr>
        <p:spPr>
          <a:xfrm>
            <a:off x="6925228" y="1154836"/>
            <a:ext cx="11325601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200" b="1" dirty="0"/>
              <a:t> Decidua                            Junctional Zone                            Labyrinth</a:t>
            </a:r>
          </a:p>
        </p:txBody>
      </p:sp>
      <p:sp>
        <p:nvSpPr>
          <p:cNvPr id="36" name="TextBox 35"/>
          <p:cNvSpPr txBox="1"/>
          <p:nvPr/>
        </p:nvSpPr>
        <p:spPr>
          <a:xfrm>
            <a:off x="9906799" y="1029682"/>
            <a:ext cx="311016" cy="646331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sz="3600" b="1" dirty="0"/>
              <a:t>D</a:t>
            </a:r>
          </a:p>
        </p:txBody>
      </p:sp>
      <p:sp>
        <p:nvSpPr>
          <p:cNvPr id="37" name="TextBox 36"/>
          <p:cNvSpPr txBox="1"/>
          <p:nvPr/>
        </p:nvSpPr>
        <p:spPr>
          <a:xfrm>
            <a:off x="14442486" y="1029682"/>
            <a:ext cx="295738" cy="646331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sz="3600" b="1" dirty="0"/>
              <a:t>G</a:t>
            </a:r>
          </a:p>
        </p:txBody>
      </p:sp>
      <p:sp>
        <p:nvSpPr>
          <p:cNvPr id="38" name="TextBox 37"/>
          <p:cNvSpPr txBox="1"/>
          <p:nvPr/>
        </p:nvSpPr>
        <p:spPr>
          <a:xfrm>
            <a:off x="5187382" y="6534170"/>
            <a:ext cx="316109" cy="646331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sz="3600" b="1" dirty="0"/>
              <a:t>B</a:t>
            </a:r>
          </a:p>
        </p:txBody>
      </p:sp>
      <p:sp>
        <p:nvSpPr>
          <p:cNvPr id="39" name="TextBox 38"/>
          <p:cNvSpPr txBox="1"/>
          <p:nvPr/>
        </p:nvSpPr>
        <p:spPr>
          <a:xfrm>
            <a:off x="9969746" y="6534170"/>
            <a:ext cx="288948" cy="646331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sz="3600" b="1" dirty="0"/>
              <a:t>E</a:t>
            </a:r>
          </a:p>
        </p:txBody>
      </p:sp>
      <p:sp>
        <p:nvSpPr>
          <p:cNvPr id="40" name="TextBox 39"/>
          <p:cNvSpPr txBox="1"/>
          <p:nvPr/>
        </p:nvSpPr>
        <p:spPr>
          <a:xfrm>
            <a:off x="14339285" y="6534170"/>
            <a:ext cx="398939" cy="646331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sz="3600" b="1" dirty="0"/>
              <a:t>H</a:t>
            </a:r>
          </a:p>
        </p:txBody>
      </p:sp>
      <p:sp>
        <p:nvSpPr>
          <p:cNvPr id="41" name="TextBox 40"/>
          <p:cNvSpPr txBox="1"/>
          <p:nvPr/>
        </p:nvSpPr>
        <p:spPr>
          <a:xfrm>
            <a:off x="5157885" y="11750698"/>
            <a:ext cx="444629" cy="646331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sz="3600" b="1" dirty="0"/>
              <a:t>C</a:t>
            </a:r>
          </a:p>
        </p:txBody>
      </p:sp>
      <p:sp>
        <p:nvSpPr>
          <p:cNvPr id="45" name="TextBox 44"/>
          <p:cNvSpPr txBox="1"/>
          <p:nvPr/>
        </p:nvSpPr>
        <p:spPr>
          <a:xfrm>
            <a:off x="9940249" y="11750698"/>
            <a:ext cx="288948" cy="646331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sz="3600" b="1" dirty="0"/>
              <a:t>F</a:t>
            </a:r>
          </a:p>
        </p:txBody>
      </p:sp>
      <p:sp>
        <p:nvSpPr>
          <p:cNvPr id="46" name="TextBox 45"/>
          <p:cNvSpPr txBox="1"/>
          <p:nvPr/>
        </p:nvSpPr>
        <p:spPr>
          <a:xfrm>
            <a:off x="14358335" y="11750698"/>
            <a:ext cx="379889" cy="646331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sz="3600" b="1" dirty="0"/>
              <a:t>I</a:t>
            </a:r>
          </a:p>
        </p:txBody>
      </p:sp>
      <p:sp>
        <p:nvSpPr>
          <p:cNvPr id="48" name="TextBox 47"/>
          <p:cNvSpPr txBox="1"/>
          <p:nvPr/>
        </p:nvSpPr>
        <p:spPr>
          <a:xfrm>
            <a:off x="5124435" y="1029682"/>
            <a:ext cx="311016" cy="646331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sz="3600" b="1" dirty="0"/>
              <a:t>A</a:t>
            </a:r>
          </a:p>
        </p:txBody>
      </p:sp>
      <p:pic>
        <p:nvPicPr>
          <p:cNvPr id="42" name="Picture 41"/>
          <p:cNvPicPr>
            <a:picLocks noChangeAspect="1"/>
          </p:cNvPicPr>
          <p:nvPr/>
        </p:nvPicPr>
        <p:blipFill>
          <a:blip r:embed="rId20"/>
          <a:stretch>
            <a:fillRect/>
          </a:stretch>
        </p:blipFill>
        <p:spPr>
          <a:xfrm>
            <a:off x="8220915" y="16951669"/>
            <a:ext cx="7698659" cy="922352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 rot="16200000">
            <a:off x="3361207" y="3750604"/>
            <a:ext cx="3860737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800" dirty="0" err="1"/>
              <a:t>TxRed</a:t>
            </a:r>
            <a:r>
              <a:rPr lang="en-US" sz="2800" dirty="0"/>
              <a:t> (</a:t>
            </a:r>
            <a:r>
              <a:rPr lang="en-US" sz="2800" b="1" dirty="0">
                <a:solidFill>
                  <a:srgbClr val="C00000"/>
                </a:solidFill>
              </a:rPr>
              <a:t>70 </a:t>
            </a:r>
            <a:r>
              <a:rPr lang="en-US" sz="2800" b="1" dirty="0" err="1">
                <a:solidFill>
                  <a:srgbClr val="C00000"/>
                </a:solidFill>
              </a:rPr>
              <a:t>KDa</a:t>
            </a:r>
            <a:r>
              <a:rPr lang="en-US" sz="2800" dirty="0"/>
              <a:t>) MFI/mm</a:t>
            </a:r>
            <a:r>
              <a:rPr lang="en-US" sz="2800" baseline="30000" dirty="0"/>
              <a:t>2</a:t>
            </a:r>
            <a:endParaRPr lang="en-US" sz="2800" dirty="0"/>
          </a:p>
        </p:txBody>
      </p:sp>
      <p:sp>
        <p:nvSpPr>
          <p:cNvPr id="24" name="TextBox 23"/>
          <p:cNvSpPr txBox="1"/>
          <p:nvPr/>
        </p:nvSpPr>
        <p:spPr>
          <a:xfrm rot="16200000">
            <a:off x="2872451" y="14271868"/>
            <a:ext cx="4838248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800" dirty="0"/>
              <a:t>Fluorescein (</a:t>
            </a:r>
            <a:r>
              <a:rPr lang="en-US" sz="2800" b="1" dirty="0">
                <a:solidFill>
                  <a:srgbClr val="00B050"/>
                </a:solidFill>
              </a:rPr>
              <a:t>500 </a:t>
            </a:r>
            <a:r>
              <a:rPr lang="en-US" sz="2800" b="1" dirty="0" err="1">
                <a:solidFill>
                  <a:srgbClr val="00B050"/>
                </a:solidFill>
              </a:rPr>
              <a:t>KDa</a:t>
            </a:r>
            <a:r>
              <a:rPr lang="en-US" sz="2800" dirty="0"/>
              <a:t>) MFI/mm</a:t>
            </a:r>
            <a:r>
              <a:rPr lang="en-US" sz="2800" baseline="30000" dirty="0"/>
              <a:t>2</a:t>
            </a:r>
            <a:endParaRPr lang="en-US" sz="2800" dirty="0"/>
          </a:p>
        </p:txBody>
      </p:sp>
      <p:sp>
        <p:nvSpPr>
          <p:cNvPr id="25" name="TextBox 24"/>
          <p:cNvSpPr txBox="1"/>
          <p:nvPr/>
        </p:nvSpPr>
        <p:spPr>
          <a:xfrm rot="16200000">
            <a:off x="3437542" y="9051960"/>
            <a:ext cx="3708066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800" dirty="0"/>
              <a:t>Cy5 (</a:t>
            </a:r>
            <a:r>
              <a:rPr lang="en-US" sz="2800" b="1" dirty="0">
                <a:solidFill>
                  <a:srgbClr val="9F009F"/>
                </a:solidFill>
              </a:rPr>
              <a:t>250 </a:t>
            </a:r>
            <a:r>
              <a:rPr lang="en-US" sz="2800" b="1" dirty="0" err="1">
                <a:solidFill>
                  <a:srgbClr val="9F009F"/>
                </a:solidFill>
              </a:rPr>
              <a:t>KDa</a:t>
            </a:r>
            <a:r>
              <a:rPr lang="en-US" sz="2800" dirty="0"/>
              <a:t>) MFI/mm</a:t>
            </a:r>
            <a:r>
              <a:rPr lang="en-US" sz="2800" baseline="30000" dirty="0"/>
              <a:t>2</a:t>
            </a:r>
            <a:endParaRPr lang="en-US" sz="2800" dirty="0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F2CAD939-6648-2AD3-9318-823921D17371}"/>
              </a:ext>
            </a:extLst>
          </p:cNvPr>
          <p:cNvSpPr txBox="1"/>
          <p:nvPr/>
        </p:nvSpPr>
        <p:spPr>
          <a:xfrm>
            <a:off x="1020597" y="318835"/>
            <a:ext cx="4532587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200" b="1" dirty="0"/>
              <a:t>Supplementary Figure S2.</a:t>
            </a:r>
          </a:p>
        </p:txBody>
      </p:sp>
      <p:sp>
        <p:nvSpPr>
          <p:cNvPr id="4" name="Rectangle 3">
            <a:extLst>
              <a:ext uri="{FF2B5EF4-FFF2-40B4-BE49-F238E27FC236}">
                <a16:creationId xmlns:a16="http://schemas.microsoft.com/office/drawing/2014/main" id="{DE481DAF-5C01-1802-C86F-D9EEF80F3EA5}"/>
              </a:ext>
            </a:extLst>
          </p:cNvPr>
          <p:cNvSpPr/>
          <p:nvPr/>
        </p:nvSpPr>
        <p:spPr>
          <a:xfrm>
            <a:off x="1907464" y="18145074"/>
            <a:ext cx="20325560" cy="784830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buSzPts val="1100"/>
            </a:pPr>
            <a:r>
              <a:rPr lang="en-US" sz="36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2. Exposure to IAV induces a complex pattern of tracer distribution in the placenta, which is distinct to each tissue layer</a:t>
            </a:r>
            <a:r>
              <a:rPr lang="en-US" sz="3600" dirty="0">
                <a:latin typeface="Arial" panose="020B0604020202020204" pitchFamily="34" charset="0"/>
                <a:cs typeface="Arial" panose="020B0604020202020204" pitchFamily="34" charset="0"/>
              </a:rPr>
              <a:t>. (</a:t>
            </a:r>
            <a:r>
              <a:rPr lang="en-US" sz="36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US" sz="36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en-US" sz="36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US" sz="3600" dirty="0">
                <a:latin typeface="Arial" panose="020B0604020202020204" pitchFamily="34" charset="0"/>
                <a:cs typeface="Arial" panose="020B0604020202020204" pitchFamily="34" charset="0"/>
              </a:rPr>
              <a:t>) For the outermost placental layer, the decidua, no differences in tracer distribution were detected across groups. However, a rise on (</a:t>
            </a:r>
            <a:r>
              <a:rPr lang="en-US" sz="36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r>
              <a:rPr lang="en-US" sz="3600" dirty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r>
              <a:rPr lang="en-US" sz="3600" dirty="0" err="1">
                <a:latin typeface="Arial" panose="020B0604020202020204" pitchFamily="34" charset="0"/>
                <a:cs typeface="Arial" panose="020B0604020202020204" pitchFamily="34" charset="0"/>
              </a:rPr>
              <a:t>TxRed</a:t>
            </a:r>
            <a:r>
              <a:rPr lang="en-US" sz="3600" dirty="0">
                <a:latin typeface="Arial" panose="020B0604020202020204" pitchFamily="34" charset="0"/>
                <a:cs typeface="Arial" panose="020B0604020202020204" pitchFamily="34" charset="0"/>
              </a:rPr>
              <a:t> and (</a:t>
            </a:r>
            <a:r>
              <a:rPr lang="en-US" sz="3600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r>
              <a:rPr lang="en-US" sz="3600" dirty="0">
                <a:latin typeface="Arial" panose="020B0604020202020204" pitchFamily="34" charset="0"/>
                <a:cs typeface="Arial" panose="020B0604020202020204" pitchFamily="34" charset="0"/>
              </a:rPr>
              <a:t>) Fluorescein MFI</a:t>
            </a:r>
            <a:r>
              <a:rPr lang="en-US" sz="3600" baseline="30000" dirty="0"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r>
              <a:rPr lang="en-US" sz="3600" dirty="0">
                <a:latin typeface="Arial" panose="020B0604020202020204" pitchFamily="34" charset="0"/>
                <a:cs typeface="Arial" panose="020B0604020202020204" pitchFamily="34" charset="0"/>
              </a:rPr>
              <a:t>was observed under the X31</a:t>
            </a:r>
            <a:r>
              <a:rPr lang="en-US" sz="3600" baseline="-25000" dirty="0">
                <a:latin typeface="Arial" panose="020B0604020202020204" pitchFamily="34" charset="0"/>
                <a:cs typeface="Arial" panose="020B0604020202020204" pitchFamily="34" charset="0"/>
              </a:rPr>
              <a:t>hi </a:t>
            </a:r>
            <a:r>
              <a:rPr lang="en-US" sz="3600" dirty="0">
                <a:latin typeface="Arial" panose="020B0604020202020204" pitchFamily="34" charset="0"/>
                <a:cs typeface="Arial" panose="020B0604020202020204" pitchFamily="34" charset="0"/>
              </a:rPr>
              <a:t>treatment, while no changes on (</a:t>
            </a:r>
            <a:r>
              <a:rPr lang="en-US" sz="36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r>
              <a:rPr lang="en-US" sz="3600" dirty="0">
                <a:latin typeface="Arial" panose="020B0604020202020204" pitchFamily="34" charset="0"/>
                <a:cs typeface="Arial" panose="020B0604020202020204" pitchFamily="34" charset="0"/>
              </a:rPr>
              <a:t>) Cy5 intensity among groups was seen at the junctional zone of the placenta. At the innermost placental layer, the highly vascularized labyrinth where maternal-fetal crosstalk occurs, no significant changes in (</a:t>
            </a:r>
            <a:r>
              <a:rPr lang="en-US" sz="3600" b="1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r>
              <a:rPr lang="en-US" sz="3600" dirty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r>
              <a:rPr lang="en-US" sz="3600" dirty="0" err="1">
                <a:latin typeface="Arial" panose="020B0604020202020204" pitchFamily="34" charset="0"/>
                <a:cs typeface="Arial" panose="020B0604020202020204" pitchFamily="34" charset="0"/>
              </a:rPr>
              <a:t>TxRed</a:t>
            </a:r>
            <a:r>
              <a:rPr lang="en-US" sz="3600" dirty="0">
                <a:latin typeface="Arial" panose="020B0604020202020204" pitchFamily="34" charset="0"/>
                <a:cs typeface="Arial" panose="020B0604020202020204" pitchFamily="34" charset="0"/>
              </a:rPr>
              <a:t> accumulation were observed. This was accompanied by a decrease in (</a:t>
            </a:r>
            <a:r>
              <a:rPr lang="en-US" sz="3600" b="1" dirty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  <a:r>
              <a:rPr lang="en-US" sz="3600" dirty="0">
                <a:latin typeface="Arial" panose="020B0604020202020204" pitchFamily="34" charset="0"/>
                <a:cs typeface="Arial" panose="020B0604020202020204" pitchFamily="34" charset="0"/>
              </a:rPr>
              <a:t>) Cy5 and (</a:t>
            </a:r>
            <a:r>
              <a:rPr lang="en-US" sz="3600" b="1" dirty="0"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  <a:r>
              <a:rPr lang="en-US" sz="3600" dirty="0">
                <a:latin typeface="Arial" panose="020B0604020202020204" pitchFamily="34" charset="0"/>
                <a:cs typeface="Arial" panose="020B0604020202020204" pitchFamily="34" charset="0"/>
              </a:rPr>
              <a:t>) Fluorescein MFI/mm² following exposure of dams to the moderate dose of IAV. Data underwent logarithmic transformation (log(x + 2)) before analysis as detailed in the methods section. Statistical comparisons were performed using a mixed-effects model fitted with the ‘</a:t>
            </a:r>
            <a:r>
              <a:rPr lang="en-US" sz="3600" dirty="0" err="1">
                <a:latin typeface="Arial" panose="020B0604020202020204" pitchFamily="34" charset="0"/>
                <a:cs typeface="Arial" panose="020B0604020202020204" pitchFamily="34" charset="0"/>
              </a:rPr>
              <a:t>nlme</a:t>
            </a:r>
            <a:r>
              <a:rPr lang="en-US" sz="3600" dirty="0">
                <a:latin typeface="Arial" panose="020B0604020202020204" pitchFamily="34" charset="0"/>
                <a:cs typeface="Arial" panose="020B0604020202020204" pitchFamily="34" charset="0"/>
              </a:rPr>
              <a:t>’ package in R, where 'litter' was treated as a random effect</a:t>
            </a:r>
            <a:r>
              <a:rPr lang="en-US" sz="36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.</a:t>
            </a:r>
            <a:r>
              <a:rPr lang="en-US" sz="36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3600" dirty="0">
                <a:solidFill>
                  <a:srgbClr val="131F33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ata are expressed as means ± SEM;</a:t>
            </a:r>
            <a:r>
              <a:rPr lang="en-US" sz="36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C</a:t>
            </a:r>
            <a:r>
              <a:rPr lang="en-US" sz="3600" dirty="0">
                <a:latin typeface="Arial" panose="020B0604020202020204" pitchFamily="34" charset="0"/>
                <a:cs typeface="Arial" panose="020B0604020202020204" pitchFamily="34" charset="0"/>
              </a:rPr>
              <a:t>ircles represent individual fetuses.</a:t>
            </a:r>
            <a:r>
              <a:rPr lang="en-US" sz="3600" dirty="0">
                <a:solidFill>
                  <a:srgbClr val="131F33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n per group: </a:t>
            </a:r>
            <a:r>
              <a:rPr lang="en-US" sz="3600" dirty="0">
                <a:latin typeface="Arial" panose="020B0604020202020204" pitchFamily="34" charset="0"/>
                <a:cs typeface="Arial" panose="020B0604020202020204" pitchFamily="34" charset="0"/>
              </a:rPr>
              <a:t>Con = 12-16, X31</a:t>
            </a:r>
            <a:r>
              <a:rPr lang="en-US" sz="3600" baseline="-25000" dirty="0">
                <a:latin typeface="Arial" panose="020B0604020202020204" pitchFamily="34" charset="0"/>
                <a:cs typeface="Arial" panose="020B0604020202020204" pitchFamily="34" charset="0"/>
              </a:rPr>
              <a:t>mod</a:t>
            </a:r>
            <a:r>
              <a:rPr lang="en-US" sz="3600" dirty="0">
                <a:latin typeface="Arial" panose="020B0604020202020204" pitchFamily="34" charset="0"/>
                <a:cs typeface="Arial" panose="020B0604020202020204" pitchFamily="34" charset="0"/>
              </a:rPr>
              <a:t> = 13-16, X31</a:t>
            </a:r>
            <a:r>
              <a:rPr lang="en-US" sz="3600" baseline="-25000" dirty="0">
                <a:latin typeface="Arial" panose="020B0604020202020204" pitchFamily="34" charset="0"/>
                <a:cs typeface="Arial" panose="020B0604020202020204" pitchFamily="34" charset="0"/>
              </a:rPr>
              <a:t>hi </a:t>
            </a:r>
            <a:r>
              <a:rPr lang="en-US" sz="3600" dirty="0">
                <a:latin typeface="Arial" panose="020B0604020202020204" pitchFamily="34" charset="0"/>
                <a:cs typeface="Arial" panose="020B0604020202020204" pitchFamily="34" charset="0"/>
              </a:rPr>
              <a:t>= 15-17. Non-significant p-values shown for the comparison of X31</a:t>
            </a:r>
            <a:r>
              <a:rPr lang="en-US" sz="3600" baseline="-25000" dirty="0">
                <a:latin typeface="Arial" panose="020B0604020202020204" pitchFamily="34" charset="0"/>
                <a:cs typeface="Arial" panose="020B0604020202020204" pitchFamily="34" charset="0"/>
              </a:rPr>
              <a:t>hi </a:t>
            </a:r>
            <a:r>
              <a:rPr lang="en-US" sz="3600" dirty="0">
                <a:latin typeface="Arial" panose="020B0604020202020204" pitchFamily="34" charset="0"/>
                <a:cs typeface="Arial" panose="020B0604020202020204" pitchFamily="34" charset="0"/>
              </a:rPr>
              <a:t>versus Con.</a:t>
            </a:r>
          </a:p>
          <a:p>
            <a:pPr algn="just">
              <a:buSzPts val="1100"/>
            </a:pPr>
            <a:endParaRPr lang="en-US" sz="3600" dirty="0"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5231703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6" name="TextBox 125"/>
          <p:cNvSpPr txBox="1"/>
          <p:nvPr/>
        </p:nvSpPr>
        <p:spPr>
          <a:xfrm>
            <a:off x="2082596" y="12416419"/>
            <a:ext cx="2091690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800" dirty="0"/>
              <a:t>   Decidua                           JZ                          Labyrinth                                    Decidua                           JZ                          Labyrinth          </a:t>
            </a:r>
          </a:p>
        </p:txBody>
      </p:sp>
      <p:graphicFrame>
        <p:nvGraphicFramePr>
          <p:cNvPr id="9" name="Object 8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532841404"/>
              </p:ext>
            </p:extLst>
          </p:nvPr>
        </p:nvGraphicFramePr>
        <p:xfrm>
          <a:off x="1247898" y="17950597"/>
          <a:ext cx="3014540" cy="41814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3" imgW="2820583" imgH="3735518" progId="Prism10.Document">
                  <p:embed/>
                </p:oleObj>
              </mc:Choice>
              <mc:Fallback>
                <p:oleObj name="Prism 10" r:id="rId3" imgW="2820583" imgH="3735518" progId="Prism10.Document">
                  <p:embed/>
                  <p:pic>
                    <p:nvPicPr>
                      <p:cNvPr id="9" name="Object 8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247898" y="17950597"/>
                        <a:ext cx="3014540" cy="41814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1" name="Object 10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771573612"/>
              </p:ext>
            </p:extLst>
          </p:nvPr>
        </p:nvGraphicFramePr>
        <p:xfrm>
          <a:off x="4249738" y="18082360"/>
          <a:ext cx="3197225" cy="404971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5" imgW="2822023" imgH="3645479" progId="Prism10.Document">
                  <p:embed/>
                </p:oleObj>
              </mc:Choice>
              <mc:Fallback>
                <p:oleObj name="Prism 10" r:id="rId5" imgW="2822023" imgH="3645479" progId="Prism10.Document">
                  <p:embed/>
                  <p:pic>
                    <p:nvPicPr>
                      <p:cNvPr id="11" name="Object 10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4249738" y="18082360"/>
                        <a:ext cx="3197225" cy="404971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2" name="Object 1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81839515"/>
              </p:ext>
            </p:extLst>
          </p:nvPr>
        </p:nvGraphicFramePr>
        <p:xfrm>
          <a:off x="7435326" y="17975661"/>
          <a:ext cx="3163610" cy="415641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7" imgW="2822023" imgH="3645479" progId="Prism10.Document">
                  <p:embed/>
                </p:oleObj>
              </mc:Choice>
              <mc:Fallback>
                <p:oleObj name="Prism 10" r:id="rId7" imgW="2822023" imgH="3645479" progId="Prism10.Document">
                  <p:embed/>
                  <p:pic>
                    <p:nvPicPr>
                      <p:cNvPr id="12" name="Object 11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7435326" y="17975661"/>
                        <a:ext cx="3163610" cy="415641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5" name="Object 1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042268438"/>
              </p:ext>
            </p:extLst>
          </p:nvPr>
        </p:nvGraphicFramePr>
        <p:xfrm>
          <a:off x="10586876" y="17977584"/>
          <a:ext cx="3148428" cy="41544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9" imgW="2822023" imgH="3645479" progId="Prism10.Document">
                  <p:embed/>
                </p:oleObj>
              </mc:Choice>
              <mc:Fallback>
                <p:oleObj name="Prism 10" r:id="rId9" imgW="2822023" imgH="3645479" progId="Prism10.Document">
                  <p:embed/>
                  <p:pic>
                    <p:nvPicPr>
                      <p:cNvPr id="15" name="Object 14"/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10586876" y="17977584"/>
                        <a:ext cx="3148428" cy="415448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8" name="Object 17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535767427"/>
              </p:ext>
            </p:extLst>
          </p:nvPr>
        </p:nvGraphicFramePr>
        <p:xfrm>
          <a:off x="13723244" y="17964884"/>
          <a:ext cx="3151465" cy="41671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11" imgW="2822023" imgH="3645479" progId="Prism10.Document">
                  <p:embed/>
                </p:oleObj>
              </mc:Choice>
              <mc:Fallback>
                <p:oleObj name="Prism 10" r:id="rId11" imgW="2822023" imgH="3645479" progId="Prism10.Document">
                  <p:embed/>
                  <p:pic>
                    <p:nvPicPr>
                      <p:cNvPr id="18" name="Object 17"/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13723244" y="17964884"/>
                        <a:ext cx="3151465" cy="416718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2" name="Object 3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803662945"/>
              </p:ext>
            </p:extLst>
          </p:nvPr>
        </p:nvGraphicFramePr>
        <p:xfrm>
          <a:off x="16862649" y="17964884"/>
          <a:ext cx="3148428" cy="41671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13" imgW="2822023" imgH="3645479" progId="Prism10.Document">
                  <p:embed/>
                </p:oleObj>
              </mc:Choice>
              <mc:Fallback>
                <p:oleObj name="Prism 10" r:id="rId13" imgW="2822023" imgH="3645479" progId="Prism10.Document">
                  <p:embed/>
                  <p:pic>
                    <p:nvPicPr>
                      <p:cNvPr id="32" name="Object 31"/>
                      <p:cNvPicPr/>
                      <p:nvPr/>
                    </p:nvPicPr>
                    <p:blipFill>
                      <a:blip r:embed="rId14"/>
                      <a:stretch>
                        <a:fillRect/>
                      </a:stretch>
                    </p:blipFill>
                    <p:spPr>
                      <a:xfrm>
                        <a:off x="16862649" y="17964884"/>
                        <a:ext cx="3148428" cy="416718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3" name="Object 3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990204688"/>
              </p:ext>
            </p:extLst>
          </p:nvPr>
        </p:nvGraphicFramePr>
        <p:xfrm>
          <a:off x="19999016" y="17951372"/>
          <a:ext cx="3148430" cy="41807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15" imgW="2822023" imgH="3645479" progId="Prism10.Document">
                  <p:embed/>
                </p:oleObj>
              </mc:Choice>
              <mc:Fallback>
                <p:oleObj name="Prism 10" r:id="rId15" imgW="2822023" imgH="3645479" progId="Prism10.Document">
                  <p:embed/>
                  <p:pic>
                    <p:nvPicPr>
                      <p:cNvPr id="33" name="Object 32"/>
                      <p:cNvPicPr/>
                      <p:nvPr/>
                    </p:nvPicPr>
                    <p:blipFill>
                      <a:blip r:embed="rId16"/>
                      <a:stretch>
                        <a:fillRect/>
                      </a:stretch>
                    </p:blipFill>
                    <p:spPr>
                      <a:xfrm>
                        <a:off x="19999016" y="17951372"/>
                        <a:ext cx="3148430" cy="41807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00" name="TextBox 99"/>
          <p:cNvSpPr txBox="1"/>
          <p:nvPr/>
        </p:nvSpPr>
        <p:spPr>
          <a:xfrm>
            <a:off x="739669" y="17013218"/>
            <a:ext cx="476412" cy="646331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sz="3600" b="1" dirty="0"/>
              <a:t>H</a:t>
            </a:r>
          </a:p>
        </p:txBody>
      </p:sp>
      <p:sp>
        <p:nvSpPr>
          <p:cNvPr id="101" name="TextBox 100"/>
          <p:cNvSpPr txBox="1"/>
          <p:nvPr/>
        </p:nvSpPr>
        <p:spPr>
          <a:xfrm>
            <a:off x="4063109" y="17013218"/>
            <a:ext cx="308098" cy="646331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sz="3600" b="1" dirty="0"/>
              <a:t>I</a:t>
            </a:r>
          </a:p>
        </p:txBody>
      </p:sp>
      <p:sp>
        <p:nvSpPr>
          <p:cNvPr id="102" name="TextBox 101"/>
          <p:cNvSpPr txBox="1"/>
          <p:nvPr/>
        </p:nvSpPr>
        <p:spPr>
          <a:xfrm>
            <a:off x="7198015" y="17013222"/>
            <a:ext cx="336952" cy="646331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sz="3600" b="1" dirty="0"/>
              <a:t>J</a:t>
            </a:r>
          </a:p>
        </p:txBody>
      </p:sp>
      <p:sp>
        <p:nvSpPr>
          <p:cNvPr id="103" name="TextBox 102"/>
          <p:cNvSpPr txBox="1"/>
          <p:nvPr/>
        </p:nvSpPr>
        <p:spPr>
          <a:xfrm>
            <a:off x="10304228" y="17013222"/>
            <a:ext cx="437940" cy="646331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sz="3600" b="1" dirty="0"/>
              <a:t>K</a:t>
            </a:r>
          </a:p>
        </p:txBody>
      </p:sp>
      <p:sp>
        <p:nvSpPr>
          <p:cNvPr id="104" name="TextBox 103"/>
          <p:cNvSpPr txBox="1"/>
          <p:nvPr/>
        </p:nvSpPr>
        <p:spPr>
          <a:xfrm>
            <a:off x="13472816" y="17013222"/>
            <a:ext cx="380232" cy="646331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sz="3600" b="1" dirty="0"/>
              <a:t>L</a:t>
            </a:r>
          </a:p>
        </p:txBody>
      </p:sp>
      <p:sp>
        <p:nvSpPr>
          <p:cNvPr id="105" name="TextBox 104"/>
          <p:cNvSpPr txBox="1"/>
          <p:nvPr/>
        </p:nvSpPr>
        <p:spPr>
          <a:xfrm>
            <a:off x="16433959" y="17013218"/>
            <a:ext cx="588623" cy="646331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sz="3600" b="1" dirty="0"/>
              <a:t>M</a:t>
            </a:r>
          </a:p>
        </p:txBody>
      </p:sp>
      <p:sp>
        <p:nvSpPr>
          <p:cNvPr id="106" name="TextBox 105"/>
          <p:cNvSpPr txBox="1"/>
          <p:nvPr/>
        </p:nvSpPr>
        <p:spPr>
          <a:xfrm>
            <a:off x="19669973" y="17013218"/>
            <a:ext cx="489236" cy="646331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sz="3600" b="1" dirty="0"/>
              <a:t>N</a:t>
            </a:r>
          </a:p>
        </p:txBody>
      </p:sp>
      <p:sp>
        <p:nvSpPr>
          <p:cNvPr id="34" name="TextBox 33"/>
          <p:cNvSpPr txBox="1"/>
          <p:nvPr/>
        </p:nvSpPr>
        <p:spPr>
          <a:xfrm>
            <a:off x="1428750" y="17425957"/>
            <a:ext cx="2091690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800" i="1" dirty="0"/>
              <a:t>          Cldn1                             Cldn2                             Cldn4                              </a:t>
            </a:r>
            <a:r>
              <a:rPr lang="en-US" sz="2800" i="1" dirty="0" err="1"/>
              <a:t>Ocln</a:t>
            </a:r>
            <a:r>
              <a:rPr lang="en-US" sz="2800" i="1" dirty="0"/>
              <a:t>                              Zo-1                              Nos-2                           Cox-2                  </a:t>
            </a:r>
          </a:p>
        </p:txBody>
      </p:sp>
      <p:pic>
        <p:nvPicPr>
          <p:cNvPr id="188" name="Picture 187"/>
          <p:cNvPicPr>
            <a:picLocks noChangeAspect="1"/>
          </p:cNvPicPr>
          <p:nvPr/>
        </p:nvPicPr>
        <p:blipFill>
          <a:blip r:embed="rId1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16200000">
            <a:off x="13100627" y="2079723"/>
            <a:ext cx="5046939" cy="4630248"/>
          </a:xfrm>
          <a:prstGeom prst="rect">
            <a:avLst/>
          </a:prstGeom>
        </p:spPr>
      </p:pic>
      <p:pic>
        <p:nvPicPr>
          <p:cNvPr id="189" name="Picture 188"/>
          <p:cNvPicPr>
            <a:picLocks noChangeAspect="1"/>
          </p:cNvPicPr>
          <p:nvPr/>
        </p:nvPicPr>
        <p:blipFill>
          <a:blip r:embed="rId1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16200000">
            <a:off x="4700600" y="-1476329"/>
            <a:ext cx="5062047" cy="11750821"/>
          </a:xfrm>
          <a:prstGeom prst="rect">
            <a:avLst/>
          </a:prstGeom>
          <a:ln>
            <a:solidFill>
              <a:schemeClr val="bg1"/>
            </a:solidFill>
          </a:ln>
        </p:spPr>
      </p:pic>
      <p:sp>
        <p:nvSpPr>
          <p:cNvPr id="190" name="TextBox 189"/>
          <p:cNvSpPr txBox="1"/>
          <p:nvPr/>
        </p:nvSpPr>
        <p:spPr>
          <a:xfrm>
            <a:off x="11006925" y="2001994"/>
            <a:ext cx="1953331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800" b="1" dirty="0">
                <a:solidFill>
                  <a:schemeClr val="bg1"/>
                </a:solidFill>
              </a:rPr>
              <a:t>Decidua</a:t>
            </a:r>
          </a:p>
        </p:txBody>
      </p:sp>
      <p:sp>
        <p:nvSpPr>
          <p:cNvPr id="191" name="TextBox 190"/>
          <p:cNvSpPr txBox="1"/>
          <p:nvPr/>
        </p:nvSpPr>
        <p:spPr>
          <a:xfrm>
            <a:off x="12309924" y="3949077"/>
            <a:ext cx="1298069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800" b="1" dirty="0">
                <a:solidFill>
                  <a:schemeClr val="bg1"/>
                </a:solidFill>
              </a:rPr>
              <a:t>JZ</a:t>
            </a:r>
          </a:p>
        </p:txBody>
      </p:sp>
      <p:sp>
        <p:nvSpPr>
          <p:cNvPr id="192" name="TextBox 191"/>
          <p:cNvSpPr txBox="1"/>
          <p:nvPr/>
        </p:nvSpPr>
        <p:spPr>
          <a:xfrm>
            <a:off x="10905021" y="4935950"/>
            <a:ext cx="213878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800" b="1" dirty="0">
                <a:solidFill>
                  <a:schemeClr val="bg1"/>
                </a:solidFill>
              </a:rPr>
              <a:t>Labyrinth</a:t>
            </a:r>
          </a:p>
        </p:txBody>
      </p:sp>
      <p:sp>
        <p:nvSpPr>
          <p:cNvPr id="193" name="Freeform 192"/>
          <p:cNvSpPr/>
          <p:nvPr/>
        </p:nvSpPr>
        <p:spPr>
          <a:xfrm>
            <a:off x="2134392" y="2058872"/>
            <a:ext cx="9893841" cy="3314634"/>
          </a:xfrm>
          <a:custGeom>
            <a:avLst/>
            <a:gdLst>
              <a:gd name="connsiteX0" fmla="*/ 10 w 4793251"/>
              <a:gd name="connsiteY0" fmla="*/ 1541568 h 1544812"/>
              <a:gd name="connsiteX1" fmla="*/ 66685 w 4793251"/>
              <a:gd name="connsiteY1" fmla="*/ 1517755 h 1544812"/>
              <a:gd name="connsiteX2" fmla="*/ 152410 w 4793251"/>
              <a:gd name="connsiteY2" fmla="*/ 1470130 h 1544812"/>
              <a:gd name="connsiteX3" fmla="*/ 238135 w 4793251"/>
              <a:gd name="connsiteY3" fmla="*/ 1417743 h 1544812"/>
              <a:gd name="connsiteX4" fmla="*/ 328622 w 4793251"/>
              <a:gd name="connsiteY4" fmla="*/ 1374880 h 1544812"/>
              <a:gd name="connsiteX5" fmla="*/ 376247 w 4793251"/>
              <a:gd name="connsiteY5" fmla="*/ 1312968 h 1544812"/>
              <a:gd name="connsiteX6" fmla="*/ 438160 w 4793251"/>
              <a:gd name="connsiteY6" fmla="*/ 1265343 h 1544812"/>
              <a:gd name="connsiteX7" fmla="*/ 528647 w 4793251"/>
              <a:gd name="connsiteY7" fmla="*/ 1189143 h 1544812"/>
              <a:gd name="connsiteX8" fmla="*/ 609610 w 4793251"/>
              <a:gd name="connsiteY8" fmla="*/ 1131993 h 1544812"/>
              <a:gd name="connsiteX9" fmla="*/ 671522 w 4793251"/>
              <a:gd name="connsiteY9" fmla="*/ 1089130 h 1544812"/>
              <a:gd name="connsiteX10" fmla="*/ 776297 w 4793251"/>
              <a:gd name="connsiteY10" fmla="*/ 1041505 h 1544812"/>
              <a:gd name="connsiteX11" fmla="*/ 866785 w 4793251"/>
              <a:gd name="connsiteY11" fmla="*/ 989118 h 1544812"/>
              <a:gd name="connsiteX12" fmla="*/ 966797 w 4793251"/>
              <a:gd name="connsiteY12" fmla="*/ 927205 h 1544812"/>
              <a:gd name="connsiteX13" fmla="*/ 1062047 w 4793251"/>
              <a:gd name="connsiteY13" fmla="*/ 874818 h 1544812"/>
              <a:gd name="connsiteX14" fmla="*/ 1204922 w 4793251"/>
              <a:gd name="connsiteY14" fmla="*/ 789093 h 1544812"/>
              <a:gd name="connsiteX15" fmla="*/ 1366847 w 4793251"/>
              <a:gd name="connsiteY15" fmla="*/ 712893 h 1544812"/>
              <a:gd name="connsiteX16" fmla="*/ 1509722 w 4793251"/>
              <a:gd name="connsiteY16" fmla="*/ 655743 h 1544812"/>
              <a:gd name="connsiteX17" fmla="*/ 1643072 w 4793251"/>
              <a:gd name="connsiteY17" fmla="*/ 612880 h 1544812"/>
              <a:gd name="connsiteX18" fmla="*/ 1728797 w 4793251"/>
              <a:gd name="connsiteY18" fmla="*/ 593830 h 1544812"/>
              <a:gd name="connsiteX19" fmla="*/ 1852622 w 4793251"/>
              <a:gd name="connsiteY19" fmla="*/ 560493 h 1544812"/>
              <a:gd name="connsiteX20" fmla="*/ 1981210 w 4793251"/>
              <a:gd name="connsiteY20" fmla="*/ 517630 h 1544812"/>
              <a:gd name="connsiteX21" fmla="*/ 2095510 w 4793251"/>
              <a:gd name="connsiteY21" fmla="*/ 489055 h 1544812"/>
              <a:gd name="connsiteX22" fmla="*/ 2200285 w 4793251"/>
              <a:gd name="connsiteY22" fmla="*/ 455718 h 1544812"/>
              <a:gd name="connsiteX23" fmla="*/ 2357447 w 4793251"/>
              <a:gd name="connsiteY23" fmla="*/ 408093 h 1544812"/>
              <a:gd name="connsiteX24" fmla="*/ 2514610 w 4793251"/>
              <a:gd name="connsiteY24" fmla="*/ 374755 h 1544812"/>
              <a:gd name="connsiteX25" fmla="*/ 2657485 w 4793251"/>
              <a:gd name="connsiteY25" fmla="*/ 355705 h 1544812"/>
              <a:gd name="connsiteX26" fmla="*/ 2805122 w 4793251"/>
              <a:gd name="connsiteY26" fmla="*/ 341418 h 1544812"/>
              <a:gd name="connsiteX27" fmla="*/ 2971810 w 4793251"/>
              <a:gd name="connsiteY27" fmla="*/ 336655 h 1544812"/>
              <a:gd name="connsiteX28" fmla="*/ 3095635 w 4793251"/>
              <a:gd name="connsiteY28" fmla="*/ 331893 h 1544812"/>
              <a:gd name="connsiteX29" fmla="*/ 3209935 w 4793251"/>
              <a:gd name="connsiteY29" fmla="*/ 317605 h 1544812"/>
              <a:gd name="connsiteX30" fmla="*/ 3357572 w 4793251"/>
              <a:gd name="connsiteY30" fmla="*/ 317605 h 1544812"/>
              <a:gd name="connsiteX31" fmla="*/ 3519497 w 4793251"/>
              <a:gd name="connsiteY31" fmla="*/ 331893 h 1544812"/>
              <a:gd name="connsiteX32" fmla="*/ 3676660 w 4793251"/>
              <a:gd name="connsiteY32" fmla="*/ 327130 h 1544812"/>
              <a:gd name="connsiteX33" fmla="*/ 3786197 w 4793251"/>
              <a:gd name="connsiteY33" fmla="*/ 279505 h 1544812"/>
              <a:gd name="connsiteX34" fmla="*/ 3933835 w 4793251"/>
              <a:gd name="connsiteY34" fmla="*/ 308080 h 1544812"/>
              <a:gd name="connsiteX35" fmla="*/ 4029085 w 4793251"/>
              <a:gd name="connsiteY35" fmla="*/ 355705 h 1544812"/>
              <a:gd name="connsiteX36" fmla="*/ 4124335 w 4793251"/>
              <a:gd name="connsiteY36" fmla="*/ 369993 h 1544812"/>
              <a:gd name="connsiteX37" fmla="*/ 4181485 w 4793251"/>
              <a:gd name="connsiteY37" fmla="*/ 369993 h 1544812"/>
              <a:gd name="connsiteX38" fmla="*/ 4219585 w 4793251"/>
              <a:gd name="connsiteY38" fmla="*/ 384280 h 1544812"/>
              <a:gd name="connsiteX39" fmla="*/ 4319597 w 4793251"/>
              <a:gd name="connsiteY39" fmla="*/ 431905 h 1544812"/>
              <a:gd name="connsiteX40" fmla="*/ 4410085 w 4793251"/>
              <a:gd name="connsiteY40" fmla="*/ 450955 h 1544812"/>
              <a:gd name="connsiteX41" fmla="*/ 4495810 w 4793251"/>
              <a:gd name="connsiteY41" fmla="*/ 450955 h 1544812"/>
              <a:gd name="connsiteX42" fmla="*/ 4581535 w 4793251"/>
              <a:gd name="connsiteY42" fmla="*/ 446193 h 1544812"/>
              <a:gd name="connsiteX43" fmla="*/ 4686310 w 4793251"/>
              <a:gd name="connsiteY43" fmla="*/ 460480 h 1544812"/>
              <a:gd name="connsiteX44" fmla="*/ 4748222 w 4793251"/>
              <a:gd name="connsiteY44" fmla="*/ 474768 h 1544812"/>
              <a:gd name="connsiteX45" fmla="*/ 4791085 w 4793251"/>
              <a:gd name="connsiteY45" fmla="*/ 465243 h 1544812"/>
              <a:gd name="connsiteX46" fmla="*/ 4776797 w 4793251"/>
              <a:gd name="connsiteY46" fmla="*/ 427143 h 1544812"/>
              <a:gd name="connsiteX47" fmla="*/ 4691072 w 4793251"/>
              <a:gd name="connsiteY47" fmla="*/ 389043 h 1544812"/>
              <a:gd name="connsiteX48" fmla="*/ 4586297 w 4793251"/>
              <a:gd name="connsiteY48" fmla="*/ 350943 h 1544812"/>
              <a:gd name="connsiteX49" fmla="*/ 4457710 w 4793251"/>
              <a:gd name="connsiteY49" fmla="*/ 327130 h 1544812"/>
              <a:gd name="connsiteX50" fmla="*/ 4376747 w 4793251"/>
              <a:gd name="connsiteY50" fmla="*/ 341418 h 1544812"/>
              <a:gd name="connsiteX51" fmla="*/ 4271972 w 4793251"/>
              <a:gd name="connsiteY51" fmla="*/ 355705 h 1544812"/>
              <a:gd name="connsiteX52" fmla="*/ 4191010 w 4793251"/>
              <a:gd name="connsiteY52" fmla="*/ 293793 h 1544812"/>
              <a:gd name="connsiteX53" fmla="*/ 4071947 w 4793251"/>
              <a:gd name="connsiteY53" fmla="*/ 203305 h 1544812"/>
              <a:gd name="connsiteX54" fmla="*/ 3929072 w 4793251"/>
              <a:gd name="connsiteY54" fmla="*/ 108055 h 1544812"/>
              <a:gd name="connsiteX55" fmla="*/ 3824297 w 4793251"/>
              <a:gd name="connsiteY55" fmla="*/ 65193 h 1544812"/>
              <a:gd name="connsiteX56" fmla="*/ 3652847 w 4793251"/>
              <a:gd name="connsiteY56" fmla="*/ 27093 h 1544812"/>
              <a:gd name="connsiteX57" fmla="*/ 3457585 w 4793251"/>
              <a:gd name="connsiteY57" fmla="*/ 3280 h 1544812"/>
              <a:gd name="connsiteX58" fmla="*/ 3352810 w 4793251"/>
              <a:gd name="connsiteY58" fmla="*/ 3280 h 1544812"/>
              <a:gd name="connsiteX59" fmla="*/ 3186122 w 4793251"/>
              <a:gd name="connsiteY59" fmla="*/ 31855 h 1544812"/>
              <a:gd name="connsiteX60" fmla="*/ 3009910 w 4793251"/>
              <a:gd name="connsiteY60" fmla="*/ 27093 h 1544812"/>
              <a:gd name="connsiteX61" fmla="*/ 2890847 w 4793251"/>
              <a:gd name="connsiteY61" fmla="*/ 17568 h 1544812"/>
              <a:gd name="connsiteX62" fmla="*/ 2852747 w 4793251"/>
              <a:gd name="connsiteY62" fmla="*/ 27093 h 1544812"/>
              <a:gd name="connsiteX63" fmla="*/ 2814647 w 4793251"/>
              <a:gd name="connsiteY63" fmla="*/ 79480 h 1544812"/>
              <a:gd name="connsiteX64" fmla="*/ 2767022 w 4793251"/>
              <a:gd name="connsiteY64" fmla="*/ 131868 h 1544812"/>
              <a:gd name="connsiteX65" fmla="*/ 2562235 w 4793251"/>
              <a:gd name="connsiteY65" fmla="*/ 108055 h 1544812"/>
              <a:gd name="connsiteX66" fmla="*/ 2419360 w 4793251"/>
              <a:gd name="connsiteY66" fmla="*/ 108055 h 1544812"/>
              <a:gd name="connsiteX67" fmla="*/ 2319347 w 4793251"/>
              <a:gd name="connsiteY67" fmla="*/ 122343 h 1544812"/>
              <a:gd name="connsiteX68" fmla="*/ 2171710 w 4793251"/>
              <a:gd name="connsiteY68" fmla="*/ 122343 h 1544812"/>
              <a:gd name="connsiteX69" fmla="*/ 2033597 w 4793251"/>
              <a:gd name="connsiteY69" fmla="*/ 112818 h 1544812"/>
              <a:gd name="connsiteX70" fmla="*/ 1957397 w 4793251"/>
              <a:gd name="connsiteY70" fmla="*/ 108055 h 1544812"/>
              <a:gd name="connsiteX71" fmla="*/ 1966922 w 4793251"/>
              <a:gd name="connsiteY71" fmla="*/ 141393 h 1544812"/>
              <a:gd name="connsiteX72" fmla="*/ 2024072 w 4793251"/>
              <a:gd name="connsiteY72" fmla="*/ 160443 h 1544812"/>
              <a:gd name="connsiteX73" fmla="*/ 2024072 w 4793251"/>
              <a:gd name="connsiteY73" fmla="*/ 217593 h 1544812"/>
              <a:gd name="connsiteX74" fmla="*/ 1995497 w 4793251"/>
              <a:gd name="connsiteY74" fmla="*/ 265218 h 1544812"/>
              <a:gd name="connsiteX75" fmla="*/ 1962160 w 4793251"/>
              <a:gd name="connsiteY75" fmla="*/ 293793 h 1544812"/>
              <a:gd name="connsiteX76" fmla="*/ 1881197 w 4793251"/>
              <a:gd name="connsiteY76" fmla="*/ 312843 h 1544812"/>
              <a:gd name="connsiteX77" fmla="*/ 1790710 w 4793251"/>
              <a:gd name="connsiteY77" fmla="*/ 317605 h 1544812"/>
              <a:gd name="connsiteX78" fmla="*/ 1728797 w 4793251"/>
              <a:gd name="connsiteY78" fmla="*/ 293793 h 1544812"/>
              <a:gd name="connsiteX79" fmla="*/ 1714510 w 4793251"/>
              <a:gd name="connsiteY79" fmla="*/ 279505 h 1544812"/>
              <a:gd name="connsiteX80" fmla="*/ 1766897 w 4793251"/>
              <a:gd name="connsiteY80" fmla="*/ 246168 h 1544812"/>
              <a:gd name="connsiteX81" fmla="*/ 1662122 w 4793251"/>
              <a:gd name="connsiteY81" fmla="*/ 246168 h 1544812"/>
              <a:gd name="connsiteX82" fmla="*/ 1552585 w 4793251"/>
              <a:gd name="connsiteY82" fmla="*/ 250930 h 1544812"/>
              <a:gd name="connsiteX83" fmla="*/ 1462097 w 4793251"/>
              <a:gd name="connsiteY83" fmla="*/ 293793 h 1544812"/>
              <a:gd name="connsiteX84" fmla="*/ 1362085 w 4793251"/>
              <a:gd name="connsiteY84" fmla="*/ 341418 h 1544812"/>
              <a:gd name="connsiteX85" fmla="*/ 1281122 w 4793251"/>
              <a:gd name="connsiteY85" fmla="*/ 355705 h 1544812"/>
              <a:gd name="connsiteX86" fmla="*/ 1223972 w 4793251"/>
              <a:gd name="connsiteY86" fmla="*/ 398568 h 1544812"/>
              <a:gd name="connsiteX87" fmla="*/ 1166822 w 4793251"/>
              <a:gd name="connsiteY87" fmla="*/ 441430 h 1544812"/>
              <a:gd name="connsiteX88" fmla="*/ 1066810 w 4793251"/>
              <a:gd name="connsiteY88" fmla="*/ 498580 h 1544812"/>
              <a:gd name="connsiteX89" fmla="*/ 985847 w 4793251"/>
              <a:gd name="connsiteY89" fmla="*/ 593830 h 1544812"/>
              <a:gd name="connsiteX90" fmla="*/ 909647 w 4793251"/>
              <a:gd name="connsiteY90" fmla="*/ 674793 h 1544812"/>
              <a:gd name="connsiteX91" fmla="*/ 828685 w 4793251"/>
              <a:gd name="connsiteY91" fmla="*/ 765280 h 1544812"/>
              <a:gd name="connsiteX92" fmla="*/ 766772 w 4793251"/>
              <a:gd name="connsiteY92" fmla="*/ 822430 h 1544812"/>
              <a:gd name="connsiteX93" fmla="*/ 681047 w 4793251"/>
              <a:gd name="connsiteY93" fmla="*/ 860530 h 1544812"/>
              <a:gd name="connsiteX94" fmla="*/ 585797 w 4793251"/>
              <a:gd name="connsiteY94" fmla="*/ 893868 h 1544812"/>
              <a:gd name="connsiteX95" fmla="*/ 504835 w 4793251"/>
              <a:gd name="connsiteY95" fmla="*/ 998643 h 1544812"/>
              <a:gd name="connsiteX96" fmla="*/ 466735 w 4793251"/>
              <a:gd name="connsiteY96" fmla="*/ 1065318 h 1544812"/>
              <a:gd name="connsiteX97" fmla="*/ 414347 w 4793251"/>
              <a:gd name="connsiteY97" fmla="*/ 1141518 h 1544812"/>
              <a:gd name="connsiteX98" fmla="*/ 342910 w 4793251"/>
              <a:gd name="connsiteY98" fmla="*/ 1189143 h 1544812"/>
              <a:gd name="connsiteX99" fmla="*/ 257185 w 4793251"/>
              <a:gd name="connsiteY99" fmla="*/ 1232005 h 1544812"/>
              <a:gd name="connsiteX100" fmla="*/ 176222 w 4793251"/>
              <a:gd name="connsiteY100" fmla="*/ 1308205 h 1544812"/>
              <a:gd name="connsiteX101" fmla="*/ 123835 w 4793251"/>
              <a:gd name="connsiteY101" fmla="*/ 1379643 h 1544812"/>
              <a:gd name="connsiteX102" fmla="*/ 61922 w 4793251"/>
              <a:gd name="connsiteY102" fmla="*/ 1446318 h 1544812"/>
              <a:gd name="connsiteX103" fmla="*/ 10 w 4793251"/>
              <a:gd name="connsiteY103" fmla="*/ 1541568 h 1544812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  <a:cxn ang="0">
                <a:pos x="connsiteX31" y="connsiteY31"/>
              </a:cxn>
              <a:cxn ang="0">
                <a:pos x="connsiteX32" y="connsiteY32"/>
              </a:cxn>
              <a:cxn ang="0">
                <a:pos x="connsiteX33" y="connsiteY33"/>
              </a:cxn>
              <a:cxn ang="0">
                <a:pos x="connsiteX34" y="connsiteY34"/>
              </a:cxn>
              <a:cxn ang="0">
                <a:pos x="connsiteX35" y="connsiteY35"/>
              </a:cxn>
              <a:cxn ang="0">
                <a:pos x="connsiteX36" y="connsiteY36"/>
              </a:cxn>
              <a:cxn ang="0">
                <a:pos x="connsiteX37" y="connsiteY37"/>
              </a:cxn>
              <a:cxn ang="0">
                <a:pos x="connsiteX38" y="connsiteY38"/>
              </a:cxn>
              <a:cxn ang="0">
                <a:pos x="connsiteX39" y="connsiteY39"/>
              </a:cxn>
              <a:cxn ang="0">
                <a:pos x="connsiteX40" y="connsiteY40"/>
              </a:cxn>
              <a:cxn ang="0">
                <a:pos x="connsiteX41" y="connsiteY41"/>
              </a:cxn>
              <a:cxn ang="0">
                <a:pos x="connsiteX42" y="connsiteY42"/>
              </a:cxn>
              <a:cxn ang="0">
                <a:pos x="connsiteX43" y="connsiteY43"/>
              </a:cxn>
              <a:cxn ang="0">
                <a:pos x="connsiteX44" y="connsiteY44"/>
              </a:cxn>
              <a:cxn ang="0">
                <a:pos x="connsiteX45" y="connsiteY45"/>
              </a:cxn>
              <a:cxn ang="0">
                <a:pos x="connsiteX46" y="connsiteY46"/>
              </a:cxn>
              <a:cxn ang="0">
                <a:pos x="connsiteX47" y="connsiteY47"/>
              </a:cxn>
              <a:cxn ang="0">
                <a:pos x="connsiteX48" y="connsiteY48"/>
              </a:cxn>
              <a:cxn ang="0">
                <a:pos x="connsiteX49" y="connsiteY49"/>
              </a:cxn>
              <a:cxn ang="0">
                <a:pos x="connsiteX50" y="connsiteY50"/>
              </a:cxn>
              <a:cxn ang="0">
                <a:pos x="connsiteX51" y="connsiteY51"/>
              </a:cxn>
              <a:cxn ang="0">
                <a:pos x="connsiteX52" y="connsiteY52"/>
              </a:cxn>
              <a:cxn ang="0">
                <a:pos x="connsiteX53" y="connsiteY53"/>
              </a:cxn>
              <a:cxn ang="0">
                <a:pos x="connsiteX54" y="connsiteY54"/>
              </a:cxn>
              <a:cxn ang="0">
                <a:pos x="connsiteX55" y="connsiteY55"/>
              </a:cxn>
              <a:cxn ang="0">
                <a:pos x="connsiteX56" y="connsiteY56"/>
              </a:cxn>
              <a:cxn ang="0">
                <a:pos x="connsiteX57" y="connsiteY57"/>
              </a:cxn>
              <a:cxn ang="0">
                <a:pos x="connsiteX58" y="connsiteY58"/>
              </a:cxn>
              <a:cxn ang="0">
                <a:pos x="connsiteX59" y="connsiteY59"/>
              </a:cxn>
              <a:cxn ang="0">
                <a:pos x="connsiteX60" y="connsiteY60"/>
              </a:cxn>
              <a:cxn ang="0">
                <a:pos x="connsiteX61" y="connsiteY61"/>
              </a:cxn>
              <a:cxn ang="0">
                <a:pos x="connsiteX62" y="connsiteY62"/>
              </a:cxn>
              <a:cxn ang="0">
                <a:pos x="connsiteX63" y="connsiteY63"/>
              </a:cxn>
              <a:cxn ang="0">
                <a:pos x="connsiteX64" y="connsiteY64"/>
              </a:cxn>
              <a:cxn ang="0">
                <a:pos x="connsiteX65" y="connsiteY65"/>
              </a:cxn>
              <a:cxn ang="0">
                <a:pos x="connsiteX66" y="connsiteY66"/>
              </a:cxn>
              <a:cxn ang="0">
                <a:pos x="connsiteX67" y="connsiteY67"/>
              </a:cxn>
              <a:cxn ang="0">
                <a:pos x="connsiteX68" y="connsiteY68"/>
              </a:cxn>
              <a:cxn ang="0">
                <a:pos x="connsiteX69" y="connsiteY69"/>
              </a:cxn>
              <a:cxn ang="0">
                <a:pos x="connsiteX70" y="connsiteY70"/>
              </a:cxn>
              <a:cxn ang="0">
                <a:pos x="connsiteX71" y="connsiteY71"/>
              </a:cxn>
              <a:cxn ang="0">
                <a:pos x="connsiteX72" y="connsiteY72"/>
              </a:cxn>
              <a:cxn ang="0">
                <a:pos x="connsiteX73" y="connsiteY73"/>
              </a:cxn>
              <a:cxn ang="0">
                <a:pos x="connsiteX74" y="connsiteY74"/>
              </a:cxn>
              <a:cxn ang="0">
                <a:pos x="connsiteX75" y="connsiteY75"/>
              </a:cxn>
              <a:cxn ang="0">
                <a:pos x="connsiteX76" y="connsiteY76"/>
              </a:cxn>
              <a:cxn ang="0">
                <a:pos x="connsiteX77" y="connsiteY77"/>
              </a:cxn>
              <a:cxn ang="0">
                <a:pos x="connsiteX78" y="connsiteY78"/>
              </a:cxn>
              <a:cxn ang="0">
                <a:pos x="connsiteX79" y="connsiteY79"/>
              </a:cxn>
              <a:cxn ang="0">
                <a:pos x="connsiteX80" y="connsiteY80"/>
              </a:cxn>
              <a:cxn ang="0">
                <a:pos x="connsiteX81" y="connsiteY81"/>
              </a:cxn>
              <a:cxn ang="0">
                <a:pos x="connsiteX82" y="connsiteY82"/>
              </a:cxn>
              <a:cxn ang="0">
                <a:pos x="connsiteX83" y="connsiteY83"/>
              </a:cxn>
              <a:cxn ang="0">
                <a:pos x="connsiteX84" y="connsiteY84"/>
              </a:cxn>
              <a:cxn ang="0">
                <a:pos x="connsiteX85" y="connsiteY85"/>
              </a:cxn>
              <a:cxn ang="0">
                <a:pos x="connsiteX86" y="connsiteY86"/>
              </a:cxn>
              <a:cxn ang="0">
                <a:pos x="connsiteX87" y="connsiteY87"/>
              </a:cxn>
              <a:cxn ang="0">
                <a:pos x="connsiteX88" y="connsiteY88"/>
              </a:cxn>
              <a:cxn ang="0">
                <a:pos x="connsiteX89" y="connsiteY89"/>
              </a:cxn>
              <a:cxn ang="0">
                <a:pos x="connsiteX90" y="connsiteY90"/>
              </a:cxn>
              <a:cxn ang="0">
                <a:pos x="connsiteX91" y="connsiteY91"/>
              </a:cxn>
              <a:cxn ang="0">
                <a:pos x="connsiteX92" y="connsiteY92"/>
              </a:cxn>
              <a:cxn ang="0">
                <a:pos x="connsiteX93" y="connsiteY93"/>
              </a:cxn>
              <a:cxn ang="0">
                <a:pos x="connsiteX94" y="connsiteY94"/>
              </a:cxn>
              <a:cxn ang="0">
                <a:pos x="connsiteX95" y="connsiteY95"/>
              </a:cxn>
              <a:cxn ang="0">
                <a:pos x="connsiteX96" y="connsiteY96"/>
              </a:cxn>
              <a:cxn ang="0">
                <a:pos x="connsiteX97" y="connsiteY97"/>
              </a:cxn>
              <a:cxn ang="0">
                <a:pos x="connsiteX98" y="connsiteY98"/>
              </a:cxn>
              <a:cxn ang="0">
                <a:pos x="connsiteX99" y="connsiteY99"/>
              </a:cxn>
              <a:cxn ang="0">
                <a:pos x="connsiteX100" y="connsiteY100"/>
              </a:cxn>
              <a:cxn ang="0">
                <a:pos x="connsiteX101" y="connsiteY101"/>
              </a:cxn>
              <a:cxn ang="0">
                <a:pos x="connsiteX102" y="connsiteY102"/>
              </a:cxn>
              <a:cxn ang="0">
                <a:pos x="connsiteX103" y="connsiteY103"/>
              </a:cxn>
            </a:cxnLst>
            <a:rect l="l" t="t" r="r" b="b"/>
            <a:pathLst>
              <a:path w="4793251" h="1544812">
                <a:moveTo>
                  <a:pt x="10" y="1541568"/>
                </a:moveTo>
                <a:cubicBezTo>
                  <a:pt x="804" y="1553474"/>
                  <a:pt x="41285" y="1529661"/>
                  <a:pt x="66685" y="1517755"/>
                </a:cubicBezTo>
                <a:cubicBezTo>
                  <a:pt x="92085" y="1505849"/>
                  <a:pt x="123835" y="1486799"/>
                  <a:pt x="152410" y="1470130"/>
                </a:cubicBezTo>
                <a:cubicBezTo>
                  <a:pt x="180985" y="1453461"/>
                  <a:pt x="208766" y="1433618"/>
                  <a:pt x="238135" y="1417743"/>
                </a:cubicBezTo>
                <a:cubicBezTo>
                  <a:pt x="267504" y="1401868"/>
                  <a:pt x="305603" y="1392343"/>
                  <a:pt x="328622" y="1374880"/>
                </a:cubicBezTo>
                <a:cubicBezTo>
                  <a:pt x="351641" y="1357417"/>
                  <a:pt x="357991" y="1331224"/>
                  <a:pt x="376247" y="1312968"/>
                </a:cubicBezTo>
                <a:cubicBezTo>
                  <a:pt x="394503" y="1294712"/>
                  <a:pt x="412760" y="1285981"/>
                  <a:pt x="438160" y="1265343"/>
                </a:cubicBezTo>
                <a:cubicBezTo>
                  <a:pt x="463560" y="1244705"/>
                  <a:pt x="500072" y="1211368"/>
                  <a:pt x="528647" y="1189143"/>
                </a:cubicBezTo>
                <a:cubicBezTo>
                  <a:pt x="557222" y="1166918"/>
                  <a:pt x="609610" y="1131993"/>
                  <a:pt x="609610" y="1131993"/>
                </a:cubicBezTo>
                <a:cubicBezTo>
                  <a:pt x="633423" y="1115324"/>
                  <a:pt x="643741" y="1104211"/>
                  <a:pt x="671522" y="1089130"/>
                </a:cubicBezTo>
                <a:cubicBezTo>
                  <a:pt x="699303" y="1074049"/>
                  <a:pt x="743753" y="1058174"/>
                  <a:pt x="776297" y="1041505"/>
                </a:cubicBezTo>
                <a:cubicBezTo>
                  <a:pt x="808841" y="1024836"/>
                  <a:pt x="835035" y="1008168"/>
                  <a:pt x="866785" y="989118"/>
                </a:cubicBezTo>
                <a:cubicBezTo>
                  <a:pt x="898535" y="970068"/>
                  <a:pt x="934253" y="946255"/>
                  <a:pt x="966797" y="927205"/>
                </a:cubicBezTo>
                <a:cubicBezTo>
                  <a:pt x="999341" y="908155"/>
                  <a:pt x="1022360" y="897837"/>
                  <a:pt x="1062047" y="874818"/>
                </a:cubicBezTo>
                <a:cubicBezTo>
                  <a:pt x="1101734" y="851799"/>
                  <a:pt x="1154122" y="816080"/>
                  <a:pt x="1204922" y="789093"/>
                </a:cubicBezTo>
                <a:cubicBezTo>
                  <a:pt x="1255722" y="762106"/>
                  <a:pt x="1316047" y="735118"/>
                  <a:pt x="1366847" y="712893"/>
                </a:cubicBezTo>
                <a:cubicBezTo>
                  <a:pt x="1417647" y="690668"/>
                  <a:pt x="1463685" y="672412"/>
                  <a:pt x="1509722" y="655743"/>
                </a:cubicBezTo>
                <a:cubicBezTo>
                  <a:pt x="1555760" y="639074"/>
                  <a:pt x="1606559" y="623199"/>
                  <a:pt x="1643072" y="612880"/>
                </a:cubicBezTo>
                <a:cubicBezTo>
                  <a:pt x="1679585" y="602561"/>
                  <a:pt x="1693872" y="602561"/>
                  <a:pt x="1728797" y="593830"/>
                </a:cubicBezTo>
                <a:cubicBezTo>
                  <a:pt x="1763722" y="585099"/>
                  <a:pt x="1810553" y="573193"/>
                  <a:pt x="1852622" y="560493"/>
                </a:cubicBezTo>
                <a:cubicBezTo>
                  <a:pt x="1894691" y="547793"/>
                  <a:pt x="1940729" y="529536"/>
                  <a:pt x="1981210" y="517630"/>
                </a:cubicBezTo>
                <a:cubicBezTo>
                  <a:pt x="2021691" y="505724"/>
                  <a:pt x="2058998" y="499374"/>
                  <a:pt x="2095510" y="489055"/>
                </a:cubicBezTo>
                <a:cubicBezTo>
                  <a:pt x="2132022" y="478736"/>
                  <a:pt x="2200285" y="455718"/>
                  <a:pt x="2200285" y="455718"/>
                </a:cubicBezTo>
                <a:cubicBezTo>
                  <a:pt x="2243941" y="442224"/>
                  <a:pt x="2305060" y="421587"/>
                  <a:pt x="2357447" y="408093"/>
                </a:cubicBezTo>
                <a:cubicBezTo>
                  <a:pt x="2409834" y="394599"/>
                  <a:pt x="2464604" y="383486"/>
                  <a:pt x="2514610" y="374755"/>
                </a:cubicBezTo>
                <a:cubicBezTo>
                  <a:pt x="2564616" y="366024"/>
                  <a:pt x="2609066" y="361261"/>
                  <a:pt x="2657485" y="355705"/>
                </a:cubicBezTo>
                <a:cubicBezTo>
                  <a:pt x="2705904" y="350149"/>
                  <a:pt x="2752735" y="344593"/>
                  <a:pt x="2805122" y="341418"/>
                </a:cubicBezTo>
                <a:cubicBezTo>
                  <a:pt x="2857509" y="338243"/>
                  <a:pt x="2971810" y="336655"/>
                  <a:pt x="2971810" y="336655"/>
                </a:cubicBezTo>
                <a:cubicBezTo>
                  <a:pt x="3020229" y="335068"/>
                  <a:pt x="3055948" y="335068"/>
                  <a:pt x="3095635" y="331893"/>
                </a:cubicBezTo>
                <a:cubicBezTo>
                  <a:pt x="3135322" y="328718"/>
                  <a:pt x="3166279" y="319986"/>
                  <a:pt x="3209935" y="317605"/>
                </a:cubicBezTo>
                <a:cubicBezTo>
                  <a:pt x="3253591" y="315224"/>
                  <a:pt x="3305979" y="315224"/>
                  <a:pt x="3357572" y="317605"/>
                </a:cubicBezTo>
                <a:cubicBezTo>
                  <a:pt x="3409165" y="319986"/>
                  <a:pt x="3466316" y="330305"/>
                  <a:pt x="3519497" y="331893"/>
                </a:cubicBezTo>
                <a:lnTo>
                  <a:pt x="3676660" y="327130"/>
                </a:lnTo>
                <a:cubicBezTo>
                  <a:pt x="3721110" y="318399"/>
                  <a:pt x="3743335" y="282680"/>
                  <a:pt x="3786197" y="279505"/>
                </a:cubicBezTo>
                <a:cubicBezTo>
                  <a:pt x="3829059" y="276330"/>
                  <a:pt x="3893354" y="295380"/>
                  <a:pt x="3933835" y="308080"/>
                </a:cubicBezTo>
                <a:cubicBezTo>
                  <a:pt x="3974316" y="320780"/>
                  <a:pt x="3997335" y="345386"/>
                  <a:pt x="4029085" y="355705"/>
                </a:cubicBezTo>
                <a:cubicBezTo>
                  <a:pt x="4060835" y="366024"/>
                  <a:pt x="4098935" y="367612"/>
                  <a:pt x="4124335" y="369993"/>
                </a:cubicBezTo>
                <a:cubicBezTo>
                  <a:pt x="4149735" y="372374"/>
                  <a:pt x="4165610" y="367612"/>
                  <a:pt x="4181485" y="369993"/>
                </a:cubicBezTo>
                <a:cubicBezTo>
                  <a:pt x="4197360" y="372374"/>
                  <a:pt x="4196566" y="373961"/>
                  <a:pt x="4219585" y="384280"/>
                </a:cubicBezTo>
                <a:cubicBezTo>
                  <a:pt x="4242604" y="394599"/>
                  <a:pt x="4287847" y="420793"/>
                  <a:pt x="4319597" y="431905"/>
                </a:cubicBezTo>
                <a:cubicBezTo>
                  <a:pt x="4351347" y="443017"/>
                  <a:pt x="4380716" y="447780"/>
                  <a:pt x="4410085" y="450955"/>
                </a:cubicBezTo>
                <a:cubicBezTo>
                  <a:pt x="4439454" y="454130"/>
                  <a:pt x="4467235" y="451749"/>
                  <a:pt x="4495810" y="450955"/>
                </a:cubicBezTo>
                <a:cubicBezTo>
                  <a:pt x="4524385" y="450161"/>
                  <a:pt x="4549785" y="444605"/>
                  <a:pt x="4581535" y="446193"/>
                </a:cubicBezTo>
                <a:cubicBezTo>
                  <a:pt x="4613285" y="447781"/>
                  <a:pt x="4658529" y="455717"/>
                  <a:pt x="4686310" y="460480"/>
                </a:cubicBezTo>
                <a:cubicBezTo>
                  <a:pt x="4714091" y="465242"/>
                  <a:pt x="4730760" y="473974"/>
                  <a:pt x="4748222" y="474768"/>
                </a:cubicBezTo>
                <a:cubicBezTo>
                  <a:pt x="4765684" y="475562"/>
                  <a:pt x="4786323" y="473180"/>
                  <a:pt x="4791085" y="465243"/>
                </a:cubicBezTo>
                <a:cubicBezTo>
                  <a:pt x="4795848" y="457305"/>
                  <a:pt x="4793466" y="439843"/>
                  <a:pt x="4776797" y="427143"/>
                </a:cubicBezTo>
                <a:cubicBezTo>
                  <a:pt x="4760128" y="414443"/>
                  <a:pt x="4722822" y="401743"/>
                  <a:pt x="4691072" y="389043"/>
                </a:cubicBezTo>
                <a:cubicBezTo>
                  <a:pt x="4659322" y="376343"/>
                  <a:pt x="4625191" y="361262"/>
                  <a:pt x="4586297" y="350943"/>
                </a:cubicBezTo>
                <a:cubicBezTo>
                  <a:pt x="4547403" y="340624"/>
                  <a:pt x="4492635" y="328718"/>
                  <a:pt x="4457710" y="327130"/>
                </a:cubicBezTo>
                <a:cubicBezTo>
                  <a:pt x="4422785" y="325542"/>
                  <a:pt x="4407703" y="336655"/>
                  <a:pt x="4376747" y="341418"/>
                </a:cubicBezTo>
                <a:cubicBezTo>
                  <a:pt x="4345791" y="346181"/>
                  <a:pt x="4302928" y="363642"/>
                  <a:pt x="4271972" y="355705"/>
                </a:cubicBezTo>
                <a:cubicBezTo>
                  <a:pt x="4241016" y="347768"/>
                  <a:pt x="4191010" y="293793"/>
                  <a:pt x="4191010" y="293793"/>
                </a:cubicBezTo>
                <a:cubicBezTo>
                  <a:pt x="4157673" y="268393"/>
                  <a:pt x="4115603" y="234261"/>
                  <a:pt x="4071947" y="203305"/>
                </a:cubicBezTo>
                <a:cubicBezTo>
                  <a:pt x="4028291" y="172349"/>
                  <a:pt x="3970347" y="131074"/>
                  <a:pt x="3929072" y="108055"/>
                </a:cubicBezTo>
                <a:cubicBezTo>
                  <a:pt x="3887797" y="85036"/>
                  <a:pt x="3870334" y="78687"/>
                  <a:pt x="3824297" y="65193"/>
                </a:cubicBezTo>
                <a:cubicBezTo>
                  <a:pt x="3778260" y="51699"/>
                  <a:pt x="3713966" y="37412"/>
                  <a:pt x="3652847" y="27093"/>
                </a:cubicBezTo>
                <a:cubicBezTo>
                  <a:pt x="3591728" y="16774"/>
                  <a:pt x="3507591" y="7249"/>
                  <a:pt x="3457585" y="3280"/>
                </a:cubicBezTo>
                <a:cubicBezTo>
                  <a:pt x="3407579" y="-689"/>
                  <a:pt x="3398054" y="-1482"/>
                  <a:pt x="3352810" y="3280"/>
                </a:cubicBezTo>
                <a:cubicBezTo>
                  <a:pt x="3307566" y="8042"/>
                  <a:pt x="3243272" y="27886"/>
                  <a:pt x="3186122" y="31855"/>
                </a:cubicBezTo>
                <a:cubicBezTo>
                  <a:pt x="3128972" y="35824"/>
                  <a:pt x="3059122" y="29474"/>
                  <a:pt x="3009910" y="27093"/>
                </a:cubicBezTo>
                <a:cubicBezTo>
                  <a:pt x="2960698" y="24712"/>
                  <a:pt x="2917041" y="17568"/>
                  <a:pt x="2890847" y="17568"/>
                </a:cubicBezTo>
                <a:cubicBezTo>
                  <a:pt x="2864653" y="17568"/>
                  <a:pt x="2865447" y="16774"/>
                  <a:pt x="2852747" y="27093"/>
                </a:cubicBezTo>
                <a:cubicBezTo>
                  <a:pt x="2840047" y="37412"/>
                  <a:pt x="2828934" y="62018"/>
                  <a:pt x="2814647" y="79480"/>
                </a:cubicBezTo>
                <a:cubicBezTo>
                  <a:pt x="2800360" y="96942"/>
                  <a:pt x="2809091" y="127106"/>
                  <a:pt x="2767022" y="131868"/>
                </a:cubicBezTo>
                <a:cubicBezTo>
                  <a:pt x="2724953" y="136630"/>
                  <a:pt x="2620179" y="112024"/>
                  <a:pt x="2562235" y="108055"/>
                </a:cubicBezTo>
                <a:cubicBezTo>
                  <a:pt x="2504291" y="104086"/>
                  <a:pt x="2459841" y="105674"/>
                  <a:pt x="2419360" y="108055"/>
                </a:cubicBezTo>
                <a:cubicBezTo>
                  <a:pt x="2378879" y="110436"/>
                  <a:pt x="2360622" y="119962"/>
                  <a:pt x="2319347" y="122343"/>
                </a:cubicBezTo>
                <a:cubicBezTo>
                  <a:pt x="2278072" y="124724"/>
                  <a:pt x="2219335" y="123930"/>
                  <a:pt x="2171710" y="122343"/>
                </a:cubicBezTo>
                <a:cubicBezTo>
                  <a:pt x="2124085" y="120756"/>
                  <a:pt x="2033597" y="112818"/>
                  <a:pt x="2033597" y="112818"/>
                </a:cubicBezTo>
                <a:cubicBezTo>
                  <a:pt x="1997878" y="110437"/>
                  <a:pt x="1968509" y="103293"/>
                  <a:pt x="1957397" y="108055"/>
                </a:cubicBezTo>
                <a:cubicBezTo>
                  <a:pt x="1946285" y="112817"/>
                  <a:pt x="1955810" y="132662"/>
                  <a:pt x="1966922" y="141393"/>
                </a:cubicBezTo>
                <a:cubicBezTo>
                  <a:pt x="1978034" y="150124"/>
                  <a:pt x="2014547" y="147743"/>
                  <a:pt x="2024072" y="160443"/>
                </a:cubicBezTo>
                <a:cubicBezTo>
                  <a:pt x="2033597" y="173143"/>
                  <a:pt x="2028835" y="200130"/>
                  <a:pt x="2024072" y="217593"/>
                </a:cubicBezTo>
                <a:cubicBezTo>
                  <a:pt x="2019309" y="235056"/>
                  <a:pt x="2005816" y="252518"/>
                  <a:pt x="1995497" y="265218"/>
                </a:cubicBezTo>
                <a:cubicBezTo>
                  <a:pt x="1985178" y="277918"/>
                  <a:pt x="1981210" y="285856"/>
                  <a:pt x="1962160" y="293793"/>
                </a:cubicBezTo>
                <a:cubicBezTo>
                  <a:pt x="1943110" y="301730"/>
                  <a:pt x="1909772" y="308874"/>
                  <a:pt x="1881197" y="312843"/>
                </a:cubicBezTo>
                <a:cubicBezTo>
                  <a:pt x="1852622" y="316812"/>
                  <a:pt x="1816110" y="320780"/>
                  <a:pt x="1790710" y="317605"/>
                </a:cubicBezTo>
                <a:cubicBezTo>
                  <a:pt x="1765310" y="314430"/>
                  <a:pt x="1741497" y="300143"/>
                  <a:pt x="1728797" y="293793"/>
                </a:cubicBezTo>
                <a:cubicBezTo>
                  <a:pt x="1716097" y="287443"/>
                  <a:pt x="1708160" y="287442"/>
                  <a:pt x="1714510" y="279505"/>
                </a:cubicBezTo>
                <a:cubicBezTo>
                  <a:pt x="1720860" y="271568"/>
                  <a:pt x="1775628" y="251724"/>
                  <a:pt x="1766897" y="246168"/>
                </a:cubicBezTo>
                <a:cubicBezTo>
                  <a:pt x="1758166" y="240612"/>
                  <a:pt x="1697841" y="245374"/>
                  <a:pt x="1662122" y="246168"/>
                </a:cubicBezTo>
                <a:cubicBezTo>
                  <a:pt x="1626403" y="246962"/>
                  <a:pt x="1585922" y="242993"/>
                  <a:pt x="1552585" y="250930"/>
                </a:cubicBezTo>
                <a:cubicBezTo>
                  <a:pt x="1519248" y="258867"/>
                  <a:pt x="1462097" y="293793"/>
                  <a:pt x="1462097" y="293793"/>
                </a:cubicBezTo>
                <a:cubicBezTo>
                  <a:pt x="1430347" y="308874"/>
                  <a:pt x="1392247" y="331099"/>
                  <a:pt x="1362085" y="341418"/>
                </a:cubicBezTo>
                <a:cubicBezTo>
                  <a:pt x="1331923" y="351737"/>
                  <a:pt x="1304141" y="346180"/>
                  <a:pt x="1281122" y="355705"/>
                </a:cubicBezTo>
                <a:cubicBezTo>
                  <a:pt x="1258103" y="365230"/>
                  <a:pt x="1223972" y="398568"/>
                  <a:pt x="1223972" y="398568"/>
                </a:cubicBezTo>
                <a:cubicBezTo>
                  <a:pt x="1204922" y="412855"/>
                  <a:pt x="1193016" y="424761"/>
                  <a:pt x="1166822" y="441430"/>
                </a:cubicBezTo>
                <a:cubicBezTo>
                  <a:pt x="1140628" y="458099"/>
                  <a:pt x="1096973" y="473180"/>
                  <a:pt x="1066810" y="498580"/>
                </a:cubicBezTo>
                <a:cubicBezTo>
                  <a:pt x="1036647" y="523980"/>
                  <a:pt x="1012041" y="564461"/>
                  <a:pt x="985847" y="593830"/>
                </a:cubicBezTo>
                <a:cubicBezTo>
                  <a:pt x="959653" y="623199"/>
                  <a:pt x="935841" y="646218"/>
                  <a:pt x="909647" y="674793"/>
                </a:cubicBezTo>
                <a:cubicBezTo>
                  <a:pt x="883453" y="703368"/>
                  <a:pt x="852497" y="740674"/>
                  <a:pt x="828685" y="765280"/>
                </a:cubicBezTo>
                <a:cubicBezTo>
                  <a:pt x="804873" y="789886"/>
                  <a:pt x="791378" y="806555"/>
                  <a:pt x="766772" y="822430"/>
                </a:cubicBezTo>
                <a:cubicBezTo>
                  <a:pt x="742166" y="838305"/>
                  <a:pt x="711209" y="848624"/>
                  <a:pt x="681047" y="860530"/>
                </a:cubicBezTo>
                <a:cubicBezTo>
                  <a:pt x="650885" y="872436"/>
                  <a:pt x="615166" y="870849"/>
                  <a:pt x="585797" y="893868"/>
                </a:cubicBezTo>
                <a:cubicBezTo>
                  <a:pt x="556428" y="916887"/>
                  <a:pt x="524679" y="970068"/>
                  <a:pt x="504835" y="998643"/>
                </a:cubicBezTo>
                <a:cubicBezTo>
                  <a:pt x="484991" y="1027218"/>
                  <a:pt x="481816" y="1041505"/>
                  <a:pt x="466735" y="1065318"/>
                </a:cubicBezTo>
                <a:cubicBezTo>
                  <a:pt x="451654" y="1089131"/>
                  <a:pt x="434984" y="1120881"/>
                  <a:pt x="414347" y="1141518"/>
                </a:cubicBezTo>
                <a:cubicBezTo>
                  <a:pt x="393710" y="1162155"/>
                  <a:pt x="369104" y="1174062"/>
                  <a:pt x="342910" y="1189143"/>
                </a:cubicBezTo>
                <a:cubicBezTo>
                  <a:pt x="316716" y="1204224"/>
                  <a:pt x="284966" y="1212161"/>
                  <a:pt x="257185" y="1232005"/>
                </a:cubicBezTo>
                <a:cubicBezTo>
                  <a:pt x="229404" y="1251849"/>
                  <a:pt x="198447" y="1283599"/>
                  <a:pt x="176222" y="1308205"/>
                </a:cubicBezTo>
                <a:cubicBezTo>
                  <a:pt x="153997" y="1332811"/>
                  <a:pt x="142885" y="1356624"/>
                  <a:pt x="123835" y="1379643"/>
                </a:cubicBezTo>
                <a:cubicBezTo>
                  <a:pt x="104785" y="1402662"/>
                  <a:pt x="79384" y="1424093"/>
                  <a:pt x="61922" y="1446318"/>
                </a:cubicBezTo>
                <a:cubicBezTo>
                  <a:pt x="44460" y="1468543"/>
                  <a:pt x="-784" y="1529662"/>
                  <a:pt x="10" y="1541568"/>
                </a:cubicBezTo>
                <a:close/>
              </a:path>
            </a:pathLst>
          </a:custGeom>
          <a:noFill/>
          <a:ln w="38100">
            <a:solidFill>
              <a:schemeClr val="bg1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9666"/>
          </a:p>
        </p:txBody>
      </p:sp>
      <p:sp>
        <p:nvSpPr>
          <p:cNvPr id="194" name="Freeform 193"/>
          <p:cNvSpPr/>
          <p:nvPr/>
        </p:nvSpPr>
        <p:spPr>
          <a:xfrm>
            <a:off x="1975015" y="2765274"/>
            <a:ext cx="10337849" cy="3526614"/>
          </a:xfrm>
          <a:custGeom>
            <a:avLst/>
            <a:gdLst>
              <a:gd name="connsiteX0" fmla="*/ 225670 w 5004046"/>
              <a:gd name="connsiteY0" fmla="*/ 1588910 h 1588910"/>
              <a:gd name="connsiteX1" fmla="*/ 282820 w 5004046"/>
              <a:gd name="connsiteY1" fmla="*/ 1560335 h 1588910"/>
              <a:gd name="connsiteX2" fmla="*/ 316157 w 5004046"/>
              <a:gd name="connsiteY2" fmla="*/ 1469848 h 1588910"/>
              <a:gd name="connsiteX3" fmla="*/ 349495 w 5004046"/>
              <a:gd name="connsiteY3" fmla="*/ 1355548 h 1588910"/>
              <a:gd name="connsiteX4" fmla="*/ 430457 w 5004046"/>
              <a:gd name="connsiteY4" fmla="*/ 1231723 h 1588910"/>
              <a:gd name="connsiteX5" fmla="*/ 544757 w 5004046"/>
              <a:gd name="connsiteY5" fmla="*/ 1188860 h 1588910"/>
              <a:gd name="connsiteX6" fmla="*/ 659057 w 5004046"/>
              <a:gd name="connsiteY6" fmla="*/ 1122185 h 1588910"/>
              <a:gd name="connsiteX7" fmla="*/ 725732 w 5004046"/>
              <a:gd name="connsiteY7" fmla="*/ 1007885 h 1588910"/>
              <a:gd name="connsiteX8" fmla="*/ 820982 w 5004046"/>
              <a:gd name="connsiteY8" fmla="*/ 893585 h 1588910"/>
              <a:gd name="connsiteX9" fmla="*/ 1006720 w 5004046"/>
              <a:gd name="connsiteY9" fmla="*/ 798335 h 1588910"/>
              <a:gd name="connsiteX10" fmla="*/ 1111495 w 5004046"/>
              <a:gd name="connsiteY10" fmla="*/ 731660 h 1588910"/>
              <a:gd name="connsiteX11" fmla="*/ 1230557 w 5004046"/>
              <a:gd name="connsiteY11" fmla="*/ 612598 h 1588910"/>
              <a:gd name="connsiteX12" fmla="*/ 1421057 w 5004046"/>
              <a:gd name="connsiteY12" fmla="*/ 536398 h 1588910"/>
              <a:gd name="connsiteX13" fmla="*/ 1540120 w 5004046"/>
              <a:gd name="connsiteY13" fmla="*/ 550685 h 1588910"/>
              <a:gd name="connsiteX14" fmla="*/ 1678232 w 5004046"/>
              <a:gd name="connsiteY14" fmla="*/ 450673 h 1588910"/>
              <a:gd name="connsiteX15" fmla="*/ 1821107 w 5004046"/>
              <a:gd name="connsiteY15" fmla="*/ 398285 h 1588910"/>
              <a:gd name="connsiteX16" fmla="*/ 1963982 w 5004046"/>
              <a:gd name="connsiteY16" fmla="*/ 293510 h 1588910"/>
              <a:gd name="connsiteX17" fmla="*/ 2121145 w 5004046"/>
              <a:gd name="connsiteY17" fmla="*/ 274460 h 1588910"/>
              <a:gd name="connsiteX18" fmla="*/ 2283070 w 5004046"/>
              <a:gd name="connsiteY18" fmla="*/ 274460 h 1588910"/>
              <a:gd name="connsiteX19" fmla="*/ 2435470 w 5004046"/>
              <a:gd name="connsiteY19" fmla="*/ 241123 h 1588910"/>
              <a:gd name="connsiteX20" fmla="*/ 2611682 w 5004046"/>
              <a:gd name="connsiteY20" fmla="*/ 183973 h 1588910"/>
              <a:gd name="connsiteX21" fmla="*/ 2764082 w 5004046"/>
              <a:gd name="connsiteY21" fmla="*/ 169685 h 1588910"/>
              <a:gd name="connsiteX22" fmla="*/ 2854570 w 5004046"/>
              <a:gd name="connsiteY22" fmla="*/ 169685 h 1588910"/>
              <a:gd name="connsiteX23" fmla="*/ 2973632 w 5004046"/>
              <a:gd name="connsiteY23" fmla="*/ 145873 h 1588910"/>
              <a:gd name="connsiteX24" fmla="*/ 3154607 w 5004046"/>
              <a:gd name="connsiteY24" fmla="*/ 160160 h 1588910"/>
              <a:gd name="connsiteX25" fmla="*/ 3307007 w 5004046"/>
              <a:gd name="connsiteY25" fmla="*/ 169685 h 1588910"/>
              <a:gd name="connsiteX26" fmla="*/ 3454645 w 5004046"/>
              <a:gd name="connsiteY26" fmla="*/ 203023 h 1588910"/>
              <a:gd name="connsiteX27" fmla="*/ 3659432 w 5004046"/>
              <a:gd name="connsiteY27" fmla="*/ 183973 h 1588910"/>
              <a:gd name="connsiteX28" fmla="*/ 3773732 w 5004046"/>
              <a:gd name="connsiteY28" fmla="*/ 241123 h 1588910"/>
              <a:gd name="connsiteX29" fmla="*/ 3854695 w 5004046"/>
              <a:gd name="connsiteY29" fmla="*/ 303035 h 1588910"/>
              <a:gd name="connsiteX30" fmla="*/ 3964232 w 5004046"/>
              <a:gd name="connsiteY30" fmla="*/ 293510 h 1588910"/>
              <a:gd name="connsiteX31" fmla="*/ 4111870 w 5004046"/>
              <a:gd name="connsiteY31" fmla="*/ 274460 h 1588910"/>
              <a:gd name="connsiteX32" fmla="*/ 4264270 w 5004046"/>
              <a:gd name="connsiteY32" fmla="*/ 303035 h 1588910"/>
              <a:gd name="connsiteX33" fmla="*/ 4392857 w 5004046"/>
              <a:gd name="connsiteY33" fmla="*/ 360185 h 1588910"/>
              <a:gd name="connsiteX34" fmla="*/ 4535732 w 5004046"/>
              <a:gd name="connsiteY34" fmla="*/ 417335 h 1588910"/>
              <a:gd name="connsiteX35" fmla="*/ 4630982 w 5004046"/>
              <a:gd name="connsiteY35" fmla="*/ 488773 h 1588910"/>
              <a:gd name="connsiteX36" fmla="*/ 4711945 w 5004046"/>
              <a:gd name="connsiteY36" fmla="*/ 564973 h 1588910"/>
              <a:gd name="connsiteX37" fmla="*/ 4807195 w 5004046"/>
              <a:gd name="connsiteY37" fmla="*/ 645935 h 1588910"/>
              <a:gd name="connsiteX38" fmla="*/ 4888157 w 5004046"/>
              <a:gd name="connsiteY38" fmla="*/ 712610 h 1588910"/>
              <a:gd name="connsiteX39" fmla="*/ 4940545 w 5004046"/>
              <a:gd name="connsiteY39" fmla="*/ 655460 h 1588910"/>
              <a:gd name="connsiteX40" fmla="*/ 4997695 w 5004046"/>
              <a:gd name="connsiteY40" fmla="*/ 536398 h 1588910"/>
              <a:gd name="connsiteX41" fmla="*/ 4988170 w 5004046"/>
              <a:gd name="connsiteY41" fmla="*/ 398285 h 1588910"/>
              <a:gd name="connsiteX42" fmla="*/ 4869107 w 5004046"/>
              <a:gd name="connsiteY42" fmla="*/ 264935 h 1588910"/>
              <a:gd name="connsiteX43" fmla="*/ 4778620 w 5004046"/>
              <a:gd name="connsiteY43" fmla="*/ 193498 h 1588910"/>
              <a:gd name="connsiteX44" fmla="*/ 4654795 w 5004046"/>
              <a:gd name="connsiteY44" fmla="*/ 174448 h 1588910"/>
              <a:gd name="connsiteX45" fmla="*/ 4516682 w 5004046"/>
              <a:gd name="connsiteY45" fmla="*/ 160160 h 1588910"/>
              <a:gd name="connsiteX46" fmla="*/ 4378570 w 5004046"/>
              <a:gd name="connsiteY46" fmla="*/ 145873 h 1588910"/>
              <a:gd name="connsiteX47" fmla="*/ 4235695 w 5004046"/>
              <a:gd name="connsiteY47" fmla="*/ 103010 h 1588910"/>
              <a:gd name="connsiteX48" fmla="*/ 4135682 w 5004046"/>
              <a:gd name="connsiteY48" fmla="*/ 69673 h 1588910"/>
              <a:gd name="connsiteX49" fmla="*/ 3992807 w 5004046"/>
              <a:gd name="connsiteY49" fmla="*/ 45860 h 1588910"/>
              <a:gd name="connsiteX50" fmla="*/ 3916607 w 5004046"/>
              <a:gd name="connsiteY50" fmla="*/ 2998 h 1588910"/>
              <a:gd name="connsiteX51" fmla="*/ 3792782 w 5004046"/>
              <a:gd name="connsiteY51" fmla="*/ 7760 h 1588910"/>
              <a:gd name="connsiteX52" fmla="*/ 3683245 w 5004046"/>
              <a:gd name="connsiteY52" fmla="*/ 41098 h 1588910"/>
              <a:gd name="connsiteX53" fmla="*/ 3554657 w 5004046"/>
              <a:gd name="connsiteY53" fmla="*/ 41098 h 1588910"/>
              <a:gd name="connsiteX54" fmla="*/ 3435595 w 5004046"/>
              <a:gd name="connsiteY54" fmla="*/ 31573 h 1588910"/>
              <a:gd name="connsiteX55" fmla="*/ 3278432 w 5004046"/>
              <a:gd name="connsiteY55" fmla="*/ 31573 h 1588910"/>
              <a:gd name="connsiteX56" fmla="*/ 3168895 w 5004046"/>
              <a:gd name="connsiteY56" fmla="*/ 31573 h 1588910"/>
              <a:gd name="connsiteX57" fmla="*/ 3064120 w 5004046"/>
              <a:gd name="connsiteY57" fmla="*/ 41098 h 1588910"/>
              <a:gd name="connsiteX58" fmla="*/ 2954582 w 5004046"/>
              <a:gd name="connsiteY58" fmla="*/ 50623 h 1588910"/>
              <a:gd name="connsiteX59" fmla="*/ 2806945 w 5004046"/>
              <a:gd name="connsiteY59" fmla="*/ 55385 h 1588910"/>
              <a:gd name="connsiteX60" fmla="*/ 2687882 w 5004046"/>
              <a:gd name="connsiteY60" fmla="*/ 55385 h 1588910"/>
              <a:gd name="connsiteX61" fmla="*/ 2530720 w 5004046"/>
              <a:gd name="connsiteY61" fmla="*/ 88723 h 1588910"/>
              <a:gd name="connsiteX62" fmla="*/ 2368795 w 5004046"/>
              <a:gd name="connsiteY62" fmla="*/ 122060 h 1588910"/>
              <a:gd name="connsiteX63" fmla="*/ 2264020 w 5004046"/>
              <a:gd name="connsiteY63" fmla="*/ 145873 h 1588910"/>
              <a:gd name="connsiteX64" fmla="*/ 2111620 w 5004046"/>
              <a:gd name="connsiteY64" fmla="*/ 198260 h 1588910"/>
              <a:gd name="connsiteX65" fmla="*/ 2006845 w 5004046"/>
              <a:gd name="connsiteY65" fmla="*/ 226835 h 1588910"/>
              <a:gd name="connsiteX66" fmla="*/ 1863970 w 5004046"/>
              <a:gd name="connsiteY66" fmla="*/ 274460 h 1588910"/>
              <a:gd name="connsiteX67" fmla="*/ 1730620 w 5004046"/>
              <a:gd name="connsiteY67" fmla="*/ 307798 h 1588910"/>
              <a:gd name="connsiteX68" fmla="*/ 1592507 w 5004046"/>
              <a:gd name="connsiteY68" fmla="*/ 350660 h 1588910"/>
              <a:gd name="connsiteX69" fmla="*/ 1387720 w 5004046"/>
              <a:gd name="connsiteY69" fmla="*/ 441148 h 1588910"/>
              <a:gd name="connsiteX70" fmla="*/ 1254370 w 5004046"/>
              <a:gd name="connsiteY70" fmla="*/ 498298 h 1588910"/>
              <a:gd name="connsiteX71" fmla="*/ 1111495 w 5004046"/>
              <a:gd name="connsiteY71" fmla="*/ 569735 h 1588910"/>
              <a:gd name="connsiteX72" fmla="*/ 997195 w 5004046"/>
              <a:gd name="connsiteY72" fmla="*/ 636410 h 1588910"/>
              <a:gd name="connsiteX73" fmla="*/ 882895 w 5004046"/>
              <a:gd name="connsiteY73" fmla="*/ 703085 h 1588910"/>
              <a:gd name="connsiteX74" fmla="*/ 773357 w 5004046"/>
              <a:gd name="connsiteY74" fmla="*/ 788810 h 1588910"/>
              <a:gd name="connsiteX75" fmla="*/ 635245 w 5004046"/>
              <a:gd name="connsiteY75" fmla="*/ 874535 h 1588910"/>
              <a:gd name="connsiteX76" fmla="*/ 468557 w 5004046"/>
              <a:gd name="connsiteY76" fmla="*/ 993598 h 1588910"/>
              <a:gd name="connsiteX77" fmla="*/ 373307 w 5004046"/>
              <a:gd name="connsiteY77" fmla="*/ 1074560 h 1588910"/>
              <a:gd name="connsiteX78" fmla="*/ 249482 w 5004046"/>
              <a:gd name="connsiteY78" fmla="*/ 1169810 h 1588910"/>
              <a:gd name="connsiteX79" fmla="*/ 106607 w 5004046"/>
              <a:gd name="connsiteY79" fmla="*/ 1260298 h 1588910"/>
              <a:gd name="connsiteX80" fmla="*/ 11357 w 5004046"/>
              <a:gd name="connsiteY80" fmla="*/ 1326973 h 1588910"/>
              <a:gd name="connsiteX81" fmla="*/ 1832 w 5004046"/>
              <a:gd name="connsiteY81" fmla="*/ 1374598 h 1588910"/>
              <a:gd name="connsiteX82" fmla="*/ 1832 w 5004046"/>
              <a:gd name="connsiteY82" fmla="*/ 1460323 h 1588910"/>
              <a:gd name="connsiteX83" fmla="*/ 20882 w 5004046"/>
              <a:gd name="connsiteY83" fmla="*/ 1555573 h 1588910"/>
              <a:gd name="connsiteX84" fmla="*/ 97082 w 5004046"/>
              <a:gd name="connsiteY84" fmla="*/ 1569860 h 1588910"/>
              <a:gd name="connsiteX85" fmla="*/ 225670 w 5004046"/>
              <a:gd name="connsiteY85" fmla="*/ 1588910 h 158891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  <a:cxn ang="0">
                <a:pos x="connsiteX31" y="connsiteY31"/>
              </a:cxn>
              <a:cxn ang="0">
                <a:pos x="connsiteX32" y="connsiteY32"/>
              </a:cxn>
              <a:cxn ang="0">
                <a:pos x="connsiteX33" y="connsiteY33"/>
              </a:cxn>
              <a:cxn ang="0">
                <a:pos x="connsiteX34" y="connsiteY34"/>
              </a:cxn>
              <a:cxn ang="0">
                <a:pos x="connsiteX35" y="connsiteY35"/>
              </a:cxn>
              <a:cxn ang="0">
                <a:pos x="connsiteX36" y="connsiteY36"/>
              </a:cxn>
              <a:cxn ang="0">
                <a:pos x="connsiteX37" y="connsiteY37"/>
              </a:cxn>
              <a:cxn ang="0">
                <a:pos x="connsiteX38" y="connsiteY38"/>
              </a:cxn>
              <a:cxn ang="0">
                <a:pos x="connsiteX39" y="connsiteY39"/>
              </a:cxn>
              <a:cxn ang="0">
                <a:pos x="connsiteX40" y="connsiteY40"/>
              </a:cxn>
              <a:cxn ang="0">
                <a:pos x="connsiteX41" y="connsiteY41"/>
              </a:cxn>
              <a:cxn ang="0">
                <a:pos x="connsiteX42" y="connsiteY42"/>
              </a:cxn>
              <a:cxn ang="0">
                <a:pos x="connsiteX43" y="connsiteY43"/>
              </a:cxn>
              <a:cxn ang="0">
                <a:pos x="connsiteX44" y="connsiteY44"/>
              </a:cxn>
              <a:cxn ang="0">
                <a:pos x="connsiteX45" y="connsiteY45"/>
              </a:cxn>
              <a:cxn ang="0">
                <a:pos x="connsiteX46" y="connsiteY46"/>
              </a:cxn>
              <a:cxn ang="0">
                <a:pos x="connsiteX47" y="connsiteY47"/>
              </a:cxn>
              <a:cxn ang="0">
                <a:pos x="connsiteX48" y="connsiteY48"/>
              </a:cxn>
              <a:cxn ang="0">
                <a:pos x="connsiteX49" y="connsiteY49"/>
              </a:cxn>
              <a:cxn ang="0">
                <a:pos x="connsiteX50" y="connsiteY50"/>
              </a:cxn>
              <a:cxn ang="0">
                <a:pos x="connsiteX51" y="connsiteY51"/>
              </a:cxn>
              <a:cxn ang="0">
                <a:pos x="connsiteX52" y="connsiteY52"/>
              </a:cxn>
              <a:cxn ang="0">
                <a:pos x="connsiteX53" y="connsiteY53"/>
              </a:cxn>
              <a:cxn ang="0">
                <a:pos x="connsiteX54" y="connsiteY54"/>
              </a:cxn>
              <a:cxn ang="0">
                <a:pos x="connsiteX55" y="connsiteY55"/>
              </a:cxn>
              <a:cxn ang="0">
                <a:pos x="connsiteX56" y="connsiteY56"/>
              </a:cxn>
              <a:cxn ang="0">
                <a:pos x="connsiteX57" y="connsiteY57"/>
              </a:cxn>
              <a:cxn ang="0">
                <a:pos x="connsiteX58" y="connsiteY58"/>
              </a:cxn>
              <a:cxn ang="0">
                <a:pos x="connsiteX59" y="connsiteY59"/>
              </a:cxn>
              <a:cxn ang="0">
                <a:pos x="connsiteX60" y="connsiteY60"/>
              </a:cxn>
              <a:cxn ang="0">
                <a:pos x="connsiteX61" y="connsiteY61"/>
              </a:cxn>
              <a:cxn ang="0">
                <a:pos x="connsiteX62" y="connsiteY62"/>
              </a:cxn>
              <a:cxn ang="0">
                <a:pos x="connsiteX63" y="connsiteY63"/>
              </a:cxn>
              <a:cxn ang="0">
                <a:pos x="connsiteX64" y="connsiteY64"/>
              </a:cxn>
              <a:cxn ang="0">
                <a:pos x="connsiteX65" y="connsiteY65"/>
              </a:cxn>
              <a:cxn ang="0">
                <a:pos x="connsiteX66" y="connsiteY66"/>
              </a:cxn>
              <a:cxn ang="0">
                <a:pos x="connsiteX67" y="connsiteY67"/>
              </a:cxn>
              <a:cxn ang="0">
                <a:pos x="connsiteX68" y="connsiteY68"/>
              </a:cxn>
              <a:cxn ang="0">
                <a:pos x="connsiteX69" y="connsiteY69"/>
              </a:cxn>
              <a:cxn ang="0">
                <a:pos x="connsiteX70" y="connsiteY70"/>
              </a:cxn>
              <a:cxn ang="0">
                <a:pos x="connsiteX71" y="connsiteY71"/>
              </a:cxn>
              <a:cxn ang="0">
                <a:pos x="connsiteX72" y="connsiteY72"/>
              </a:cxn>
              <a:cxn ang="0">
                <a:pos x="connsiteX73" y="connsiteY73"/>
              </a:cxn>
              <a:cxn ang="0">
                <a:pos x="connsiteX74" y="connsiteY74"/>
              </a:cxn>
              <a:cxn ang="0">
                <a:pos x="connsiteX75" y="connsiteY75"/>
              </a:cxn>
              <a:cxn ang="0">
                <a:pos x="connsiteX76" y="connsiteY76"/>
              </a:cxn>
              <a:cxn ang="0">
                <a:pos x="connsiteX77" y="connsiteY77"/>
              </a:cxn>
              <a:cxn ang="0">
                <a:pos x="connsiteX78" y="connsiteY78"/>
              </a:cxn>
              <a:cxn ang="0">
                <a:pos x="connsiteX79" y="connsiteY79"/>
              </a:cxn>
              <a:cxn ang="0">
                <a:pos x="connsiteX80" y="connsiteY80"/>
              </a:cxn>
              <a:cxn ang="0">
                <a:pos x="connsiteX81" y="connsiteY81"/>
              </a:cxn>
              <a:cxn ang="0">
                <a:pos x="connsiteX82" y="connsiteY82"/>
              </a:cxn>
              <a:cxn ang="0">
                <a:pos x="connsiteX83" y="connsiteY83"/>
              </a:cxn>
              <a:cxn ang="0">
                <a:pos x="connsiteX84" y="connsiteY84"/>
              </a:cxn>
              <a:cxn ang="0">
                <a:pos x="connsiteX85" y="connsiteY85"/>
              </a:cxn>
            </a:cxnLst>
            <a:rect l="l" t="t" r="r" b="b"/>
            <a:pathLst>
              <a:path w="5004046" h="1588910">
                <a:moveTo>
                  <a:pt x="225670" y="1588910"/>
                </a:moveTo>
                <a:cubicBezTo>
                  <a:pt x="246704" y="1584544"/>
                  <a:pt x="267739" y="1580179"/>
                  <a:pt x="282820" y="1560335"/>
                </a:cubicBezTo>
                <a:cubicBezTo>
                  <a:pt x="297901" y="1540491"/>
                  <a:pt x="305044" y="1503979"/>
                  <a:pt x="316157" y="1469848"/>
                </a:cubicBezTo>
                <a:cubicBezTo>
                  <a:pt x="327270" y="1435717"/>
                  <a:pt x="330445" y="1395236"/>
                  <a:pt x="349495" y="1355548"/>
                </a:cubicBezTo>
                <a:cubicBezTo>
                  <a:pt x="368545" y="1315860"/>
                  <a:pt x="397913" y="1259504"/>
                  <a:pt x="430457" y="1231723"/>
                </a:cubicBezTo>
                <a:cubicBezTo>
                  <a:pt x="463001" y="1203942"/>
                  <a:pt x="506657" y="1207116"/>
                  <a:pt x="544757" y="1188860"/>
                </a:cubicBezTo>
                <a:cubicBezTo>
                  <a:pt x="582857" y="1170604"/>
                  <a:pt x="628895" y="1152347"/>
                  <a:pt x="659057" y="1122185"/>
                </a:cubicBezTo>
                <a:cubicBezTo>
                  <a:pt x="689219" y="1092023"/>
                  <a:pt x="698745" y="1045985"/>
                  <a:pt x="725732" y="1007885"/>
                </a:cubicBezTo>
                <a:cubicBezTo>
                  <a:pt x="752719" y="969785"/>
                  <a:pt x="774151" y="928510"/>
                  <a:pt x="820982" y="893585"/>
                </a:cubicBezTo>
                <a:cubicBezTo>
                  <a:pt x="867813" y="858660"/>
                  <a:pt x="958301" y="825322"/>
                  <a:pt x="1006720" y="798335"/>
                </a:cubicBezTo>
                <a:cubicBezTo>
                  <a:pt x="1055139" y="771347"/>
                  <a:pt x="1074189" y="762616"/>
                  <a:pt x="1111495" y="731660"/>
                </a:cubicBezTo>
                <a:cubicBezTo>
                  <a:pt x="1148801" y="700704"/>
                  <a:pt x="1178963" y="645142"/>
                  <a:pt x="1230557" y="612598"/>
                </a:cubicBezTo>
                <a:cubicBezTo>
                  <a:pt x="1282151" y="580054"/>
                  <a:pt x="1369463" y="546717"/>
                  <a:pt x="1421057" y="536398"/>
                </a:cubicBezTo>
                <a:cubicBezTo>
                  <a:pt x="1472651" y="526079"/>
                  <a:pt x="1497258" y="564972"/>
                  <a:pt x="1540120" y="550685"/>
                </a:cubicBezTo>
                <a:cubicBezTo>
                  <a:pt x="1582982" y="536398"/>
                  <a:pt x="1631401" y="476073"/>
                  <a:pt x="1678232" y="450673"/>
                </a:cubicBezTo>
                <a:cubicBezTo>
                  <a:pt x="1725063" y="425273"/>
                  <a:pt x="1773482" y="424479"/>
                  <a:pt x="1821107" y="398285"/>
                </a:cubicBezTo>
                <a:cubicBezTo>
                  <a:pt x="1868732" y="372091"/>
                  <a:pt x="1913976" y="314147"/>
                  <a:pt x="1963982" y="293510"/>
                </a:cubicBezTo>
                <a:cubicBezTo>
                  <a:pt x="2013988" y="272873"/>
                  <a:pt x="2067964" y="277635"/>
                  <a:pt x="2121145" y="274460"/>
                </a:cubicBezTo>
                <a:cubicBezTo>
                  <a:pt x="2174326" y="271285"/>
                  <a:pt x="2230682" y="280016"/>
                  <a:pt x="2283070" y="274460"/>
                </a:cubicBezTo>
                <a:cubicBezTo>
                  <a:pt x="2335458" y="268904"/>
                  <a:pt x="2380701" y="256204"/>
                  <a:pt x="2435470" y="241123"/>
                </a:cubicBezTo>
                <a:cubicBezTo>
                  <a:pt x="2490239" y="226042"/>
                  <a:pt x="2556913" y="195879"/>
                  <a:pt x="2611682" y="183973"/>
                </a:cubicBezTo>
                <a:cubicBezTo>
                  <a:pt x="2666451" y="172067"/>
                  <a:pt x="2723601" y="172066"/>
                  <a:pt x="2764082" y="169685"/>
                </a:cubicBezTo>
                <a:cubicBezTo>
                  <a:pt x="2804563" y="167304"/>
                  <a:pt x="2819645" y="173654"/>
                  <a:pt x="2854570" y="169685"/>
                </a:cubicBezTo>
                <a:cubicBezTo>
                  <a:pt x="2889495" y="165716"/>
                  <a:pt x="2923626" y="147460"/>
                  <a:pt x="2973632" y="145873"/>
                </a:cubicBezTo>
                <a:cubicBezTo>
                  <a:pt x="3023638" y="144286"/>
                  <a:pt x="3154607" y="160160"/>
                  <a:pt x="3154607" y="160160"/>
                </a:cubicBezTo>
                <a:cubicBezTo>
                  <a:pt x="3210170" y="164129"/>
                  <a:pt x="3257001" y="162541"/>
                  <a:pt x="3307007" y="169685"/>
                </a:cubicBezTo>
                <a:cubicBezTo>
                  <a:pt x="3357013" y="176829"/>
                  <a:pt x="3395908" y="200642"/>
                  <a:pt x="3454645" y="203023"/>
                </a:cubicBezTo>
                <a:cubicBezTo>
                  <a:pt x="3513382" y="205404"/>
                  <a:pt x="3606251" y="177623"/>
                  <a:pt x="3659432" y="183973"/>
                </a:cubicBezTo>
                <a:cubicBezTo>
                  <a:pt x="3712613" y="190323"/>
                  <a:pt x="3741188" y="221279"/>
                  <a:pt x="3773732" y="241123"/>
                </a:cubicBezTo>
                <a:cubicBezTo>
                  <a:pt x="3806276" y="260967"/>
                  <a:pt x="3822945" y="294304"/>
                  <a:pt x="3854695" y="303035"/>
                </a:cubicBezTo>
                <a:cubicBezTo>
                  <a:pt x="3886445" y="311766"/>
                  <a:pt x="3921370" y="298272"/>
                  <a:pt x="3964232" y="293510"/>
                </a:cubicBezTo>
                <a:cubicBezTo>
                  <a:pt x="4007095" y="288747"/>
                  <a:pt x="4061864" y="272873"/>
                  <a:pt x="4111870" y="274460"/>
                </a:cubicBezTo>
                <a:cubicBezTo>
                  <a:pt x="4161876" y="276047"/>
                  <a:pt x="4217439" y="288748"/>
                  <a:pt x="4264270" y="303035"/>
                </a:cubicBezTo>
                <a:cubicBezTo>
                  <a:pt x="4311101" y="317322"/>
                  <a:pt x="4347613" y="341135"/>
                  <a:pt x="4392857" y="360185"/>
                </a:cubicBezTo>
                <a:cubicBezTo>
                  <a:pt x="4438101" y="379235"/>
                  <a:pt x="4496045" y="395904"/>
                  <a:pt x="4535732" y="417335"/>
                </a:cubicBezTo>
                <a:cubicBezTo>
                  <a:pt x="4575419" y="438766"/>
                  <a:pt x="4601613" y="464167"/>
                  <a:pt x="4630982" y="488773"/>
                </a:cubicBezTo>
                <a:cubicBezTo>
                  <a:pt x="4660351" y="513379"/>
                  <a:pt x="4682576" y="538779"/>
                  <a:pt x="4711945" y="564973"/>
                </a:cubicBezTo>
                <a:cubicBezTo>
                  <a:pt x="4741314" y="591167"/>
                  <a:pt x="4777826" y="621329"/>
                  <a:pt x="4807195" y="645935"/>
                </a:cubicBezTo>
                <a:cubicBezTo>
                  <a:pt x="4836564" y="670541"/>
                  <a:pt x="4865932" y="711023"/>
                  <a:pt x="4888157" y="712610"/>
                </a:cubicBezTo>
                <a:cubicBezTo>
                  <a:pt x="4910382" y="714197"/>
                  <a:pt x="4922289" y="684829"/>
                  <a:pt x="4940545" y="655460"/>
                </a:cubicBezTo>
                <a:cubicBezTo>
                  <a:pt x="4958801" y="626091"/>
                  <a:pt x="4989758" y="579260"/>
                  <a:pt x="4997695" y="536398"/>
                </a:cubicBezTo>
                <a:cubicBezTo>
                  <a:pt x="5005632" y="493536"/>
                  <a:pt x="5009601" y="443529"/>
                  <a:pt x="4988170" y="398285"/>
                </a:cubicBezTo>
                <a:cubicBezTo>
                  <a:pt x="4966739" y="353041"/>
                  <a:pt x="4904032" y="299066"/>
                  <a:pt x="4869107" y="264935"/>
                </a:cubicBezTo>
                <a:cubicBezTo>
                  <a:pt x="4834182" y="230804"/>
                  <a:pt x="4814339" y="208579"/>
                  <a:pt x="4778620" y="193498"/>
                </a:cubicBezTo>
                <a:cubicBezTo>
                  <a:pt x="4742901" y="178417"/>
                  <a:pt x="4698451" y="180004"/>
                  <a:pt x="4654795" y="174448"/>
                </a:cubicBezTo>
                <a:cubicBezTo>
                  <a:pt x="4611139" y="168892"/>
                  <a:pt x="4516682" y="160160"/>
                  <a:pt x="4516682" y="160160"/>
                </a:cubicBezTo>
                <a:cubicBezTo>
                  <a:pt x="4470645" y="155397"/>
                  <a:pt x="4425401" y="155398"/>
                  <a:pt x="4378570" y="145873"/>
                </a:cubicBezTo>
                <a:cubicBezTo>
                  <a:pt x="4331739" y="136348"/>
                  <a:pt x="4276176" y="115710"/>
                  <a:pt x="4235695" y="103010"/>
                </a:cubicBezTo>
                <a:cubicBezTo>
                  <a:pt x="4195214" y="90310"/>
                  <a:pt x="4176163" y="79198"/>
                  <a:pt x="4135682" y="69673"/>
                </a:cubicBezTo>
                <a:cubicBezTo>
                  <a:pt x="4095201" y="60148"/>
                  <a:pt x="4029319" y="56972"/>
                  <a:pt x="3992807" y="45860"/>
                </a:cubicBezTo>
                <a:cubicBezTo>
                  <a:pt x="3956295" y="34748"/>
                  <a:pt x="3949945" y="9348"/>
                  <a:pt x="3916607" y="2998"/>
                </a:cubicBezTo>
                <a:cubicBezTo>
                  <a:pt x="3883270" y="-3352"/>
                  <a:pt x="3831676" y="1410"/>
                  <a:pt x="3792782" y="7760"/>
                </a:cubicBezTo>
                <a:cubicBezTo>
                  <a:pt x="3753888" y="14110"/>
                  <a:pt x="3722933" y="35542"/>
                  <a:pt x="3683245" y="41098"/>
                </a:cubicBezTo>
                <a:cubicBezTo>
                  <a:pt x="3643558" y="46654"/>
                  <a:pt x="3595932" y="42685"/>
                  <a:pt x="3554657" y="41098"/>
                </a:cubicBezTo>
                <a:cubicBezTo>
                  <a:pt x="3513382" y="39511"/>
                  <a:pt x="3481632" y="33160"/>
                  <a:pt x="3435595" y="31573"/>
                </a:cubicBezTo>
                <a:cubicBezTo>
                  <a:pt x="3389558" y="29986"/>
                  <a:pt x="3278432" y="31573"/>
                  <a:pt x="3278432" y="31573"/>
                </a:cubicBezTo>
                <a:cubicBezTo>
                  <a:pt x="3233982" y="31573"/>
                  <a:pt x="3204614" y="29986"/>
                  <a:pt x="3168895" y="31573"/>
                </a:cubicBezTo>
                <a:cubicBezTo>
                  <a:pt x="3133176" y="33160"/>
                  <a:pt x="3064120" y="41098"/>
                  <a:pt x="3064120" y="41098"/>
                </a:cubicBezTo>
                <a:cubicBezTo>
                  <a:pt x="3028401" y="44273"/>
                  <a:pt x="2997445" y="48242"/>
                  <a:pt x="2954582" y="50623"/>
                </a:cubicBezTo>
                <a:cubicBezTo>
                  <a:pt x="2911720" y="53004"/>
                  <a:pt x="2851395" y="54591"/>
                  <a:pt x="2806945" y="55385"/>
                </a:cubicBezTo>
                <a:cubicBezTo>
                  <a:pt x="2762495" y="56179"/>
                  <a:pt x="2733920" y="49829"/>
                  <a:pt x="2687882" y="55385"/>
                </a:cubicBezTo>
                <a:cubicBezTo>
                  <a:pt x="2641845" y="60941"/>
                  <a:pt x="2530720" y="88723"/>
                  <a:pt x="2530720" y="88723"/>
                </a:cubicBezTo>
                <a:lnTo>
                  <a:pt x="2368795" y="122060"/>
                </a:lnTo>
                <a:cubicBezTo>
                  <a:pt x="2324345" y="131585"/>
                  <a:pt x="2306883" y="133173"/>
                  <a:pt x="2264020" y="145873"/>
                </a:cubicBezTo>
                <a:cubicBezTo>
                  <a:pt x="2221158" y="158573"/>
                  <a:pt x="2154483" y="184766"/>
                  <a:pt x="2111620" y="198260"/>
                </a:cubicBezTo>
                <a:cubicBezTo>
                  <a:pt x="2068757" y="211754"/>
                  <a:pt x="2048120" y="214135"/>
                  <a:pt x="2006845" y="226835"/>
                </a:cubicBezTo>
                <a:cubicBezTo>
                  <a:pt x="1965570" y="239535"/>
                  <a:pt x="1910007" y="260966"/>
                  <a:pt x="1863970" y="274460"/>
                </a:cubicBezTo>
                <a:cubicBezTo>
                  <a:pt x="1817933" y="287954"/>
                  <a:pt x="1775864" y="295098"/>
                  <a:pt x="1730620" y="307798"/>
                </a:cubicBezTo>
                <a:cubicBezTo>
                  <a:pt x="1685376" y="320498"/>
                  <a:pt x="1649657" y="328435"/>
                  <a:pt x="1592507" y="350660"/>
                </a:cubicBezTo>
                <a:cubicBezTo>
                  <a:pt x="1535357" y="372885"/>
                  <a:pt x="1387720" y="441148"/>
                  <a:pt x="1387720" y="441148"/>
                </a:cubicBezTo>
                <a:cubicBezTo>
                  <a:pt x="1331364" y="465754"/>
                  <a:pt x="1300408" y="476867"/>
                  <a:pt x="1254370" y="498298"/>
                </a:cubicBezTo>
                <a:cubicBezTo>
                  <a:pt x="1208333" y="519729"/>
                  <a:pt x="1154358" y="546716"/>
                  <a:pt x="1111495" y="569735"/>
                </a:cubicBezTo>
                <a:cubicBezTo>
                  <a:pt x="1068633" y="592754"/>
                  <a:pt x="997195" y="636410"/>
                  <a:pt x="997195" y="636410"/>
                </a:cubicBezTo>
                <a:cubicBezTo>
                  <a:pt x="959095" y="658635"/>
                  <a:pt x="920201" y="677685"/>
                  <a:pt x="882895" y="703085"/>
                </a:cubicBezTo>
                <a:cubicBezTo>
                  <a:pt x="845589" y="728485"/>
                  <a:pt x="814632" y="760235"/>
                  <a:pt x="773357" y="788810"/>
                </a:cubicBezTo>
                <a:cubicBezTo>
                  <a:pt x="732082" y="817385"/>
                  <a:pt x="686045" y="840404"/>
                  <a:pt x="635245" y="874535"/>
                </a:cubicBezTo>
                <a:cubicBezTo>
                  <a:pt x="584445" y="908666"/>
                  <a:pt x="512213" y="960261"/>
                  <a:pt x="468557" y="993598"/>
                </a:cubicBezTo>
                <a:cubicBezTo>
                  <a:pt x="424901" y="1026935"/>
                  <a:pt x="409819" y="1045191"/>
                  <a:pt x="373307" y="1074560"/>
                </a:cubicBezTo>
                <a:cubicBezTo>
                  <a:pt x="336795" y="1103929"/>
                  <a:pt x="293932" y="1138854"/>
                  <a:pt x="249482" y="1169810"/>
                </a:cubicBezTo>
                <a:cubicBezTo>
                  <a:pt x="205032" y="1200766"/>
                  <a:pt x="146294" y="1234104"/>
                  <a:pt x="106607" y="1260298"/>
                </a:cubicBezTo>
                <a:cubicBezTo>
                  <a:pt x="66920" y="1286492"/>
                  <a:pt x="28819" y="1307923"/>
                  <a:pt x="11357" y="1326973"/>
                </a:cubicBezTo>
                <a:cubicBezTo>
                  <a:pt x="-6105" y="1346023"/>
                  <a:pt x="3419" y="1352373"/>
                  <a:pt x="1832" y="1374598"/>
                </a:cubicBezTo>
                <a:cubicBezTo>
                  <a:pt x="245" y="1396823"/>
                  <a:pt x="-1343" y="1430160"/>
                  <a:pt x="1832" y="1460323"/>
                </a:cubicBezTo>
                <a:cubicBezTo>
                  <a:pt x="5007" y="1490486"/>
                  <a:pt x="5007" y="1537317"/>
                  <a:pt x="20882" y="1555573"/>
                </a:cubicBezTo>
                <a:cubicBezTo>
                  <a:pt x="36757" y="1573829"/>
                  <a:pt x="97082" y="1569860"/>
                  <a:pt x="97082" y="1569860"/>
                </a:cubicBezTo>
                <a:lnTo>
                  <a:pt x="225670" y="1588910"/>
                </a:lnTo>
                <a:close/>
              </a:path>
            </a:pathLst>
          </a:custGeom>
          <a:noFill/>
          <a:ln w="38100">
            <a:solidFill>
              <a:schemeClr val="bg1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9666"/>
          </a:p>
        </p:txBody>
      </p:sp>
      <p:sp>
        <p:nvSpPr>
          <p:cNvPr id="195" name="Freeform 194"/>
          <p:cNvSpPr/>
          <p:nvPr/>
        </p:nvSpPr>
        <p:spPr>
          <a:xfrm>
            <a:off x="2510127" y="3132636"/>
            <a:ext cx="9426963" cy="3404163"/>
          </a:xfrm>
          <a:custGeom>
            <a:avLst/>
            <a:gdLst>
              <a:gd name="connsiteX0" fmla="*/ 3435 w 4434732"/>
              <a:gd name="connsiteY0" fmla="*/ 1431755 h 1469905"/>
              <a:gd name="connsiteX1" fmla="*/ 98685 w 4434732"/>
              <a:gd name="connsiteY1" fmla="*/ 1455567 h 1469905"/>
              <a:gd name="connsiteX2" fmla="*/ 217747 w 4434732"/>
              <a:gd name="connsiteY2" fmla="*/ 1469855 h 1469905"/>
              <a:gd name="connsiteX3" fmla="*/ 398722 w 4434732"/>
              <a:gd name="connsiteY3" fmla="*/ 1450805 h 1469905"/>
              <a:gd name="connsiteX4" fmla="*/ 608272 w 4434732"/>
              <a:gd name="connsiteY4" fmla="*/ 1412705 h 1469905"/>
              <a:gd name="connsiteX5" fmla="*/ 751147 w 4434732"/>
              <a:gd name="connsiteY5" fmla="*/ 1384130 h 1469905"/>
              <a:gd name="connsiteX6" fmla="*/ 846397 w 4434732"/>
              <a:gd name="connsiteY6" fmla="*/ 1303167 h 1469905"/>
              <a:gd name="connsiteX7" fmla="*/ 908310 w 4434732"/>
              <a:gd name="connsiteY7" fmla="*/ 1231730 h 1469905"/>
              <a:gd name="connsiteX8" fmla="*/ 1017847 w 4434732"/>
              <a:gd name="connsiteY8" fmla="*/ 1126955 h 1469905"/>
              <a:gd name="connsiteX9" fmla="*/ 1141672 w 4434732"/>
              <a:gd name="connsiteY9" fmla="*/ 1069805 h 1469905"/>
              <a:gd name="connsiteX10" fmla="*/ 1270260 w 4434732"/>
              <a:gd name="connsiteY10" fmla="*/ 1041230 h 1469905"/>
              <a:gd name="connsiteX11" fmla="*/ 1360747 w 4434732"/>
              <a:gd name="connsiteY11" fmla="*/ 974555 h 1469905"/>
              <a:gd name="connsiteX12" fmla="*/ 1527435 w 4434732"/>
              <a:gd name="connsiteY12" fmla="*/ 1003130 h 1469905"/>
              <a:gd name="connsiteX13" fmla="*/ 1684597 w 4434732"/>
              <a:gd name="connsiteY13" fmla="*/ 965030 h 1469905"/>
              <a:gd name="connsiteX14" fmla="*/ 1775085 w 4434732"/>
              <a:gd name="connsiteY14" fmla="*/ 869780 h 1469905"/>
              <a:gd name="connsiteX15" fmla="*/ 1913197 w 4434732"/>
              <a:gd name="connsiteY15" fmla="*/ 798342 h 1469905"/>
              <a:gd name="connsiteX16" fmla="*/ 2037022 w 4434732"/>
              <a:gd name="connsiteY16" fmla="*/ 855492 h 1469905"/>
              <a:gd name="connsiteX17" fmla="*/ 2037022 w 4434732"/>
              <a:gd name="connsiteY17" fmla="*/ 731667 h 1469905"/>
              <a:gd name="connsiteX18" fmla="*/ 2227522 w 4434732"/>
              <a:gd name="connsiteY18" fmla="*/ 669755 h 1469905"/>
              <a:gd name="connsiteX19" fmla="*/ 2270385 w 4434732"/>
              <a:gd name="connsiteY19" fmla="*/ 784055 h 1469905"/>
              <a:gd name="connsiteX20" fmla="*/ 2418022 w 4434732"/>
              <a:gd name="connsiteY20" fmla="*/ 760242 h 1469905"/>
              <a:gd name="connsiteX21" fmla="*/ 2527560 w 4434732"/>
              <a:gd name="connsiteY21" fmla="*/ 698330 h 1469905"/>
              <a:gd name="connsiteX22" fmla="*/ 2598997 w 4434732"/>
              <a:gd name="connsiteY22" fmla="*/ 674517 h 1469905"/>
              <a:gd name="connsiteX23" fmla="*/ 2656147 w 4434732"/>
              <a:gd name="connsiteY23" fmla="*/ 722142 h 1469905"/>
              <a:gd name="connsiteX24" fmla="*/ 2770447 w 4434732"/>
              <a:gd name="connsiteY24" fmla="*/ 641180 h 1469905"/>
              <a:gd name="connsiteX25" fmla="*/ 2894272 w 4434732"/>
              <a:gd name="connsiteY25" fmla="*/ 684042 h 1469905"/>
              <a:gd name="connsiteX26" fmla="*/ 3027622 w 4434732"/>
              <a:gd name="connsiteY26" fmla="*/ 826917 h 1469905"/>
              <a:gd name="connsiteX27" fmla="*/ 3108585 w 4434732"/>
              <a:gd name="connsiteY27" fmla="*/ 745955 h 1469905"/>
              <a:gd name="connsiteX28" fmla="*/ 3184785 w 4434732"/>
              <a:gd name="connsiteY28" fmla="*/ 693567 h 1469905"/>
              <a:gd name="connsiteX29" fmla="*/ 3365760 w 4434732"/>
              <a:gd name="connsiteY29" fmla="*/ 688805 h 1469905"/>
              <a:gd name="connsiteX30" fmla="*/ 3503872 w 4434732"/>
              <a:gd name="connsiteY30" fmla="*/ 664992 h 1469905"/>
              <a:gd name="connsiteX31" fmla="*/ 3618172 w 4434732"/>
              <a:gd name="connsiteY31" fmla="*/ 626892 h 1469905"/>
              <a:gd name="connsiteX32" fmla="*/ 3661035 w 4434732"/>
              <a:gd name="connsiteY32" fmla="*/ 593555 h 1469905"/>
              <a:gd name="connsiteX33" fmla="*/ 3756285 w 4434732"/>
              <a:gd name="connsiteY33" fmla="*/ 664992 h 1469905"/>
              <a:gd name="connsiteX34" fmla="*/ 3822960 w 4434732"/>
              <a:gd name="connsiteY34" fmla="*/ 788817 h 1469905"/>
              <a:gd name="connsiteX35" fmla="*/ 3937260 w 4434732"/>
              <a:gd name="connsiteY35" fmla="*/ 798342 h 1469905"/>
              <a:gd name="connsiteX36" fmla="*/ 4051560 w 4434732"/>
              <a:gd name="connsiteY36" fmla="*/ 755480 h 1469905"/>
              <a:gd name="connsiteX37" fmla="*/ 4194435 w 4434732"/>
              <a:gd name="connsiteY37" fmla="*/ 712617 h 1469905"/>
              <a:gd name="connsiteX38" fmla="*/ 4303972 w 4434732"/>
              <a:gd name="connsiteY38" fmla="*/ 684042 h 1469905"/>
              <a:gd name="connsiteX39" fmla="*/ 4375410 w 4434732"/>
              <a:gd name="connsiteY39" fmla="*/ 622130 h 1469905"/>
              <a:gd name="connsiteX40" fmla="*/ 4432560 w 4434732"/>
              <a:gd name="connsiteY40" fmla="*/ 555455 h 1469905"/>
              <a:gd name="connsiteX41" fmla="*/ 4413510 w 4434732"/>
              <a:gd name="connsiteY41" fmla="*/ 474492 h 1469905"/>
              <a:gd name="connsiteX42" fmla="*/ 4327785 w 4434732"/>
              <a:gd name="connsiteY42" fmla="*/ 436392 h 1469905"/>
              <a:gd name="connsiteX43" fmla="*/ 4242060 w 4434732"/>
              <a:gd name="connsiteY43" fmla="*/ 336380 h 1469905"/>
              <a:gd name="connsiteX44" fmla="*/ 4084897 w 4434732"/>
              <a:gd name="connsiteY44" fmla="*/ 222080 h 1469905"/>
              <a:gd name="connsiteX45" fmla="*/ 3942022 w 4434732"/>
              <a:gd name="connsiteY45" fmla="*/ 145880 h 1469905"/>
              <a:gd name="connsiteX46" fmla="*/ 3775335 w 4434732"/>
              <a:gd name="connsiteY46" fmla="*/ 112542 h 1469905"/>
              <a:gd name="connsiteX47" fmla="*/ 3622935 w 4434732"/>
              <a:gd name="connsiteY47" fmla="*/ 150642 h 1469905"/>
              <a:gd name="connsiteX48" fmla="*/ 3456247 w 4434732"/>
              <a:gd name="connsiteY48" fmla="*/ 117305 h 1469905"/>
              <a:gd name="connsiteX49" fmla="*/ 3389572 w 4434732"/>
              <a:gd name="connsiteY49" fmla="*/ 98255 h 1469905"/>
              <a:gd name="connsiteX50" fmla="*/ 3246697 w 4434732"/>
              <a:gd name="connsiteY50" fmla="*/ 31580 h 1469905"/>
              <a:gd name="connsiteX51" fmla="*/ 3156210 w 4434732"/>
              <a:gd name="connsiteY51" fmla="*/ 45867 h 1469905"/>
              <a:gd name="connsiteX52" fmla="*/ 3008572 w 4434732"/>
              <a:gd name="connsiteY52" fmla="*/ 45867 h 1469905"/>
              <a:gd name="connsiteX53" fmla="*/ 2903797 w 4434732"/>
              <a:gd name="connsiteY53" fmla="*/ 31580 h 1469905"/>
              <a:gd name="connsiteX54" fmla="*/ 2756160 w 4434732"/>
              <a:gd name="connsiteY54" fmla="*/ 3005 h 1469905"/>
              <a:gd name="connsiteX55" fmla="*/ 2651385 w 4434732"/>
              <a:gd name="connsiteY55" fmla="*/ 3005 h 1469905"/>
              <a:gd name="connsiteX56" fmla="*/ 2508510 w 4434732"/>
              <a:gd name="connsiteY56" fmla="*/ 22055 h 1469905"/>
              <a:gd name="connsiteX57" fmla="*/ 2398972 w 4434732"/>
              <a:gd name="connsiteY57" fmla="*/ 60155 h 1469905"/>
              <a:gd name="connsiteX58" fmla="*/ 2227522 w 4434732"/>
              <a:gd name="connsiteY58" fmla="*/ 64917 h 1469905"/>
              <a:gd name="connsiteX59" fmla="*/ 2160847 w 4434732"/>
              <a:gd name="connsiteY59" fmla="*/ 83967 h 1469905"/>
              <a:gd name="connsiteX60" fmla="*/ 2027497 w 4434732"/>
              <a:gd name="connsiteY60" fmla="*/ 155405 h 1469905"/>
              <a:gd name="connsiteX61" fmla="*/ 1894147 w 4434732"/>
              <a:gd name="connsiteY61" fmla="*/ 160167 h 1469905"/>
              <a:gd name="connsiteX62" fmla="*/ 1698885 w 4434732"/>
              <a:gd name="connsiteY62" fmla="*/ 155405 h 1469905"/>
              <a:gd name="connsiteX63" fmla="*/ 1489335 w 4434732"/>
              <a:gd name="connsiteY63" fmla="*/ 250655 h 1469905"/>
              <a:gd name="connsiteX64" fmla="*/ 1446472 w 4434732"/>
              <a:gd name="connsiteY64" fmla="*/ 274467 h 1469905"/>
              <a:gd name="connsiteX65" fmla="*/ 1336935 w 4434732"/>
              <a:gd name="connsiteY65" fmla="*/ 341142 h 1469905"/>
              <a:gd name="connsiteX66" fmla="*/ 1255972 w 4434732"/>
              <a:gd name="connsiteY66" fmla="*/ 403055 h 1469905"/>
              <a:gd name="connsiteX67" fmla="*/ 1170247 w 4434732"/>
              <a:gd name="connsiteY67" fmla="*/ 417342 h 1469905"/>
              <a:gd name="connsiteX68" fmla="*/ 1070235 w 4434732"/>
              <a:gd name="connsiteY68" fmla="*/ 422105 h 1469905"/>
              <a:gd name="connsiteX69" fmla="*/ 994035 w 4434732"/>
              <a:gd name="connsiteY69" fmla="*/ 455442 h 1469905"/>
              <a:gd name="connsiteX70" fmla="*/ 898785 w 4434732"/>
              <a:gd name="connsiteY70" fmla="*/ 550692 h 1469905"/>
              <a:gd name="connsiteX71" fmla="*/ 808297 w 4434732"/>
              <a:gd name="connsiteY71" fmla="*/ 617367 h 1469905"/>
              <a:gd name="connsiteX72" fmla="*/ 660660 w 4434732"/>
              <a:gd name="connsiteY72" fmla="*/ 693567 h 1469905"/>
              <a:gd name="connsiteX73" fmla="*/ 603510 w 4434732"/>
              <a:gd name="connsiteY73" fmla="*/ 731667 h 1469905"/>
              <a:gd name="connsiteX74" fmla="*/ 522547 w 4434732"/>
              <a:gd name="connsiteY74" fmla="*/ 807867 h 1469905"/>
              <a:gd name="connsiteX75" fmla="*/ 460635 w 4434732"/>
              <a:gd name="connsiteY75" fmla="*/ 865017 h 1469905"/>
              <a:gd name="connsiteX76" fmla="*/ 422535 w 4434732"/>
              <a:gd name="connsiteY76" fmla="*/ 912642 h 1469905"/>
              <a:gd name="connsiteX77" fmla="*/ 332047 w 4434732"/>
              <a:gd name="connsiteY77" fmla="*/ 1022180 h 1469905"/>
              <a:gd name="connsiteX78" fmla="*/ 189172 w 4434732"/>
              <a:gd name="connsiteY78" fmla="*/ 1093617 h 1469905"/>
              <a:gd name="connsiteX79" fmla="*/ 127260 w 4434732"/>
              <a:gd name="connsiteY79" fmla="*/ 1131717 h 1469905"/>
              <a:gd name="connsiteX80" fmla="*/ 93922 w 4434732"/>
              <a:gd name="connsiteY80" fmla="*/ 1203155 h 1469905"/>
              <a:gd name="connsiteX81" fmla="*/ 46297 w 4434732"/>
              <a:gd name="connsiteY81" fmla="*/ 1288880 h 1469905"/>
              <a:gd name="connsiteX82" fmla="*/ 22485 w 4434732"/>
              <a:gd name="connsiteY82" fmla="*/ 1369842 h 1469905"/>
              <a:gd name="connsiteX83" fmla="*/ 3435 w 4434732"/>
              <a:gd name="connsiteY83" fmla="*/ 1431755 h 146990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  <a:cxn ang="0">
                <a:pos x="connsiteX31" y="connsiteY31"/>
              </a:cxn>
              <a:cxn ang="0">
                <a:pos x="connsiteX32" y="connsiteY32"/>
              </a:cxn>
              <a:cxn ang="0">
                <a:pos x="connsiteX33" y="connsiteY33"/>
              </a:cxn>
              <a:cxn ang="0">
                <a:pos x="connsiteX34" y="connsiteY34"/>
              </a:cxn>
              <a:cxn ang="0">
                <a:pos x="connsiteX35" y="connsiteY35"/>
              </a:cxn>
              <a:cxn ang="0">
                <a:pos x="connsiteX36" y="connsiteY36"/>
              </a:cxn>
              <a:cxn ang="0">
                <a:pos x="connsiteX37" y="connsiteY37"/>
              </a:cxn>
              <a:cxn ang="0">
                <a:pos x="connsiteX38" y="connsiteY38"/>
              </a:cxn>
              <a:cxn ang="0">
                <a:pos x="connsiteX39" y="connsiteY39"/>
              </a:cxn>
              <a:cxn ang="0">
                <a:pos x="connsiteX40" y="connsiteY40"/>
              </a:cxn>
              <a:cxn ang="0">
                <a:pos x="connsiteX41" y="connsiteY41"/>
              </a:cxn>
              <a:cxn ang="0">
                <a:pos x="connsiteX42" y="connsiteY42"/>
              </a:cxn>
              <a:cxn ang="0">
                <a:pos x="connsiteX43" y="connsiteY43"/>
              </a:cxn>
              <a:cxn ang="0">
                <a:pos x="connsiteX44" y="connsiteY44"/>
              </a:cxn>
              <a:cxn ang="0">
                <a:pos x="connsiteX45" y="connsiteY45"/>
              </a:cxn>
              <a:cxn ang="0">
                <a:pos x="connsiteX46" y="connsiteY46"/>
              </a:cxn>
              <a:cxn ang="0">
                <a:pos x="connsiteX47" y="connsiteY47"/>
              </a:cxn>
              <a:cxn ang="0">
                <a:pos x="connsiteX48" y="connsiteY48"/>
              </a:cxn>
              <a:cxn ang="0">
                <a:pos x="connsiteX49" y="connsiteY49"/>
              </a:cxn>
              <a:cxn ang="0">
                <a:pos x="connsiteX50" y="connsiteY50"/>
              </a:cxn>
              <a:cxn ang="0">
                <a:pos x="connsiteX51" y="connsiteY51"/>
              </a:cxn>
              <a:cxn ang="0">
                <a:pos x="connsiteX52" y="connsiteY52"/>
              </a:cxn>
              <a:cxn ang="0">
                <a:pos x="connsiteX53" y="connsiteY53"/>
              </a:cxn>
              <a:cxn ang="0">
                <a:pos x="connsiteX54" y="connsiteY54"/>
              </a:cxn>
              <a:cxn ang="0">
                <a:pos x="connsiteX55" y="connsiteY55"/>
              </a:cxn>
              <a:cxn ang="0">
                <a:pos x="connsiteX56" y="connsiteY56"/>
              </a:cxn>
              <a:cxn ang="0">
                <a:pos x="connsiteX57" y="connsiteY57"/>
              </a:cxn>
              <a:cxn ang="0">
                <a:pos x="connsiteX58" y="connsiteY58"/>
              </a:cxn>
              <a:cxn ang="0">
                <a:pos x="connsiteX59" y="connsiteY59"/>
              </a:cxn>
              <a:cxn ang="0">
                <a:pos x="connsiteX60" y="connsiteY60"/>
              </a:cxn>
              <a:cxn ang="0">
                <a:pos x="connsiteX61" y="connsiteY61"/>
              </a:cxn>
              <a:cxn ang="0">
                <a:pos x="connsiteX62" y="connsiteY62"/>
              </a:cxn>
              <a:cxn ang="0">
                <a:pos x="connsiteX63" y="connsiteY63"/>
              </a:cxn>
              <a:cxn ang="0">
                <a:pos x="connsiteX64" y="connsiteY64"/>
              </a:cxn>
              <a:cxn ang="0">
                <a:pos x="connsiteX65" y="connsiteY65"/>
              </a:cxn>
              <a:cxn ang="0">
                <a:pos x="connsiteX66" y="connsiteY66"/>
              </a:cxn>
              <a:cxn ang="0">
                <a:pos x="connsiteX67" y="connsiteY67"/>
              </a:cxn>
              <a:cxn ang="0">
                <a:pos x="connsiteX68" y="connsiteY68"/>
              </a:cxn>
              <a:cxn ang="0">
                <a:pos x="connsiteX69" y="connsiteY69"/>
              </a:cxn>
              <a:cxn ang="0">
                <a:pos x="connsiteX70" y="connsiteY70"/>
              </a:cxn>
              <a:cxn ang="0">
                <a:pos x="connsiteX71" y="connsiteY71"/>
              </a:cxn>
              <a:cxn ang="0">
                <a:pos x="connsiteX72" y="connsiteY72"/>
              </a:cxn>
              <a:cxn ang="0">
                <a:pos x="connsiteX73" y="connsiteY73"/>
              </a:cxn>
              <a:cxn ang="0">
                <a:pos x="connsiteX74" y="connsiteY74"/>
              </a:cxn>
              <a:cxn ang="0">
                <a:pos x="connsiteX75" y="connsiteY75"/>
              </a:cxn>
              <a:cxn ang="0">
                <a:pos x="connsiteX76" y="connsiteY76"/>
              </a:cxn>
              <a:cxn ang="0">
                <a:pos x="connsiteX77" y="connsiteY77"/>
              </a:cxn>
              <a:cxn ang="0">
                <a:pos x="connsiteX78" y="connsiteY78"/>
              </a:cxn>
              <a:cxn ang="0">
                <a:pos x="connsiteX79" y="connsiteY79"/>
              </a:cxn>
              <a:cxn ang="0">
                <a:pos x="connsiteX80" y="connsiteY80"/>
              </a:cxn>
              <a:cxn ang="0">
                <a:pos x="connsiteX81" y="connsiteY81"/>
              </a:cxn>
              <a:cxn ang="0">
                <a:pos x="connsiteX82" y="connsiteY82"/>
              </a:cxn>
              <a:cxn ang="0">
                <a:pos x="connsiteX83" y="connsiteY83"/>
              </a:cxn>
            </a:cxnLst>
            <a:rect l="l" t="t" r="r" b="b"/>
            <a:pathLst>
              <a:path w="4434732" h="1469905">
                <a:moveTo>
                  <a:pt x="3435" y="1431755"/>
                </a:moveTo>
                <a:cubicBezTo>
                  <a:pt x="16135" y="1446043"/>
                  <a:pt x="62966" y="1449217"/>
                  <a:pt x="98685" y="1455567"/>
                </a:cubicBezTo>
                <a:cubicBezTo>
                  <a:pt x="134404" y="1461917"/>
                  <a:pt x="167741" y="1470649"/>
                  <a:pt x="217747" y="1469855"/>
                </a:cubicBezTo>
                <a:cubicBezTo>
                  <a:pt x="267753" y="1469061"/>
                  <a:pt x="333635" y="1460330"/>
                  <a:pt x="398722" y="1450805"/>
                </a:cubicBezTo>
                <a:cubicBezTo>
                  <a:pt x="463809" y="1441280"/>
                  <a:pt x="549535" y="1423817"/>
                  <a:pt x="608272" y="1412705"/>
                </a:cubicBezTo>
                <a:cubicBezTo>
                  <a:pt x="667009" y="1401593"/>
                  <a:pt x="711460" y="1402386"/>
                  <a:pt x="751147" y="1384130"/>
                </a:cubicBezTo>
                <a:cubicBezTo>
                  <a:pt x="790834" y="1365874"/>
                  <a:pt x="820203" y="1328567"/>
                  <a:pt x="846397" y="1303167"/>
                </a:cubicBezTo>
                <a:cubicBezTo>
                  <a:pt x="872591" y="1277767"/>
                  <a:pt x="879735" y="1261099"/>
                  <a:pt x="908310" y="1231730"/>
                </a:cubicBezTo>
                <a:cubicBezTo>
                  <a:pt x="936885" y="1202361"/>
                  <a:pt x="978953" y="1153942"/>
                  <a:pt x="1017847" y="1126955"/>
                </a:cubicBezTo>
                <a:cubicBezTo>
                  <a:pt x="1056741" y="1099967"/>
                  <a:pt x="1099603" y="1084092"/>
                  <a:pt x="1141672" y="1069805"/>
                </a:cubicBezTo>
                <a:cubicBezTo>
                  <a:pt x="1183741" y="1055518"/>
                  <a:pt x="1233748" y="1057105"/>
                  <a:pt x="1270260" y="1041230"/>
                </a:cubicBezTo>
                <a:cubicBezTo>
                  <a:pt x="1306773" y="1025355"/>
                  <a:pt x="1317885" y="980905"/>
                  <a:pt x="1360747" y="974555"/>
                </a:cubicBezTo>
                <a:cubicBezTo>
                  <a:pt x="1403609" y="968205"/>
                  <a:pt x="1473460" y="1004717"/>
                  <a:pt x="1527435" y="1003130"/>
                </a:cubicBezTo>
                <a:cubicBezTo>
                  <a:pt x="1581410" y="1001542"/>
                  <a:pt x="1643322" y="987255"/>
                  <a:pt x="1684597" y="965030"/>
                </a:cubicBezTo>
                <a:cubicBezTo>
                  <a:pt x="1725872" y="942805"/>
                  <a:pt x="1736985" y="897561"/>
                  <a:pt x="1775085" y="869780"/>
                </a:cubicBezTo>
                <a:cubicBezTo>
                  <a:pt x="1813185" y="841999"/>
                  <a:pt x="1869541" y="800723"/>
                  <a:pt x="1913197" y="798342"/>
                </a:cubicBezTo>
                <a:cubicBezTo>
                  <a:pt x="1956853" y="795961"/>
                  <a:pt x="2016385" y="866604"/>
                  <a:pt x="2037022" y="855492"/>
                </a:cubicBezTo>
                <a:cubicBezTo>
                  <a:pt x="2057659" y="844380"/>
                  <a:pt x="2005272" y="762623"/>
                  <a:pt x="2037022" y="731667"/>
                </a:cubicBezTo>
                <a:cubicBezTo>
                  <a:pt x="2068772" y="700711"/>
                  <a:pt x="2188628" y="661024"/>
                  <a:pt x="2227522" y="669755"/>
                </a:cubicBezTo>
                <a:cubicBezTo>
                  <a:pt x="2266416" y="678486"/>
                  <a:pt x="2238635" y="768974"/>
                  <a:pt x="2270385" y="784055"/>
                </a:cubicBezTo>
                <a:cubicBezTo>
                  <a:pt x="2302135" y="799136"/>
                  <a:pt x="2375160" y="774529"/>
                  <a:pt x="2418022" y="760242"/>
                </a:cubicBezTo>
                <a:cubicBezTo>
                  <a:pt x="2460884" y="745955"/>
                  <a:pt x="2497398" y="712617"/>
                  <a:pt x="2527560" y="698330"/>
                </a:cubicBezTo>
                <a:cubicBezTo>
                  <a:pt x="2557722" y="684043"/>
                  <a:pt x="2577566" y="670548"/>
                  <a:pt x="2598997" y="674517"/>
                </a:cubicBezTo>
                <a:cubicBezTo>
                  <a:pt x="2620428" y="678486"/>
                  <a:pt x="2627572" y="727698"/>
                  <a:pt x="2656147" y="722142"/>
                </a:cubicBezTo>
                <a:cubicBezTo>
                  <a:pt x="2684722" y="716586"/>
                  <a:pt x="2730760" y="647530"/>
                  <a:pt x="2770447" y="641180"/>
                </a:cubicBezTo>
                <a:cubicBezTo>
                  <a:pt x="2810134" y="634830"/>
                  <a:pt x="2851410" y="653086"/>
                  <a:pt x="2894272" y="684042"/>
                </a:cubicBezTo>
                <a:cubicBezTo>
                  <a:pt x="2937135" y="714998"/>
                  <a:pt x="2991903" y="816598"/>
                  <a:pt x="3027622" y="826917"/>
                </a:cubicBezTo>
                <a:cubicBezTo>
                  <a:pt x="3063341" y="837236"/>
                  <a:pt x="3082391" y="768180"/>
                  <a:pt x="3108585" y="745955"/>
                </a:cubicBezTo>
                <a:cubicBezTo>
                  <a:pt x="3134779" y="723730"/>
                  <a:pt x="3141923" y="703092"/>
                  <a:pt x="3184785" y="693567"/>
                </a:cubicBezTo>
                <a:cubicBezTo>
                  <a:pt x="3227647" y="684042"/>
                  <a:pt x="3312579" y="693567"/>
                  <a:pt x="3365760" y="688805"/>
                </a:cubicBezTo>
                <a:cubicBezTo>
                  <a:pt x="3418941" y="684042"/>
                  <a:pt x="3461803" y="675311"/>
                  <a:pt x="3503872" y="664992"/>
                </a:cubicBezTo>
                <a:cubicBezTo>
                  <a:pt x="3545941" y="654673"/>
                  <a:pt x="3591978" y="638798"/>
                  <a:pt x="3618172" y="626892"/>
                </a:cubicBezTo>
                <a:cubicBezTo>
                  <a:pt x="3644366" y="614986"/>
                  <a:pt x="3638016" y="587205"/>
                  <a:pt x="3661035" y="593555"/>
                </a:cubicBezTo>
                <a:cubicBezTo>
                  <a:pt x="3684054" y="599905"/>
                  <a:pt x="3729298" y="632448"/>
                  <a:pt x="3756285" y="664992"/>
                </a:cubicBezTo>
                <a:cubicBezTo>
                  <a:pt x="3783273" y="697536"/>
                  <a:pt x="3792798" y="766592"/>
                  <a:pt x="3822960" y="788817"/>
                </a:cubicBezTo>
                <a:cubicBezTo>
                  <a:pt x="3853122" y="811042"/>
                  <a:pt x="3899160" y="803898"/>
                  <a:pt x="3937260" y="798342"/>
                </a:cubicBezTo>
                <a:cubicBezTo>
                  <a:pt x="3975360" y="792786"/>
                  <a:pt x="4008698" y="769767"/>
                  <a:pt x="4051560" y="755480"/>
                </a:cubicBezTo>
                <a:cubicBezTo>
                  <a:pt x="4094422" y="741193"/>
                  <a:pt x="4152366" y="724523"/>
                  <a:pt x="4194435" y="712617"/>
                </a:cubicBezTo>
                <a:cubicBezTo>
                  <a:pt x="4236504" y="700711"/>
                  <a:pt x="4273810" y="699123"/>
                  <a:pt x="4303972" y="684042"/>
                </a:cubicBezTo>
                <a:cubicBezTo>
                  <a:pt x="4334134" y="668961"/>
                  <a:pt x="4353979" y="643561"/>
                  <a:pt x="4375410" y="622130"/>
                </a:cubicBezTo>
                <a:cubicBezTo>
                  <a:pt x="4396841" y="600699"/>
                  <a:pt x="4426210" y="580061"/>
                  <a:pt x="4432560" y="555455"/>
                </a:cubicBezTo>
                <a:cubicBezTo>
                  <a:pt x="4438910" y="530849"/>
                  <a:pt x="4430972" y="494336"/>
                  <a:pt x="4413510" y="474492"/>
                </a:cubicBezTo>
                <a:cubicBezTo>
                  <a:pt x="4396048" y="454648"/>
                  <a:pt x="4356360" y="459411"/>
                  <a:pt x="4327785" y="436392"/>
                </a:cubicBezTo>
                <a:cubicBezTo>
                  <a:pt x="4299210" y="413373"/>
                  <a:pt x="4282541" y="372099"/>
                  <a:pt x="4242060" y="336380"/>
                </a:cubicBezTo>
                <a:cubicBezTo>
                  <a:pt x="4201579" y="300661"/>
                  <a:pt x="4134903" y="253830"/>
                  <a:pt x="4084897" y="222080"/>
                </a:cubicBezTo>
                <a:cubicBezTo>
                  <a:pt x="4034891" y="190330"/>
                  <a:pt x="3993616" y="164136"/>
                  <a:pt x="3942022" y="145880"/>
                </a:cubicBezTo>
                <a:cubicBezTo>
                  <a:pt x="3890428" y="127624"/>
                  <a:pt x="3828516" y="111748"/>
                  <a:pt x="3775335" y="112542"/>
                </a:cubicBezTo>
                <a:cubicBezTo>
                  <a:pt x="3722154" y="113336"/>
                  <a:pt x="3676116" y="149848"/>
                  <a:pt x="3622935" y="150642"/>
                </a:cubicBezTo>
                <a:cubicBezTo>
                  <a:pt x="3569754" y="151436"/>
                  <a:pt x="3495141" y="126036"/>
                  <a:pt x="3456247" y="117305"/>
                </a:cubicBezTo>
                <a:cubicBezTo>
                  <a:pt x="3417353" y="108574"/>
                  <a:pt x="3424497" y="112542"/>
                  <a:pt x="3389572" y="98255"/>
                </a:cubicBezTo>
                <a:cubicBezTo>
                  <a:pt x="3354647" y="83967"/>
                  <a:pt x="3285591" y="40311"/>
                  <a:pt x="3246697" y="31580"/>
                </a:cubicBezTo>
                <a:cubicBezTo>
                  <a:pt x="3207803" y="22849"/>
                  <a:pt x="3195898" y="43486"/>
                  <a:pt x="3156210" y="45867"/>
                </a:cubicBezTo>
                <a:cubicBezTo>
                  <a:pt x="3116522" y="48248"/>
                  <a:pt x="3050641" y="48248"/>
                  <a:pt x="3008572" y="45867"/>
                </a:cubicBezTo>
                <a:cubicBezTo>
                  <a:pt x="2966503" y="43486"/>
                  <a:pt x="2945866" y="38724"/>
                  <a:pt x="2903797" y="31580"/>
                </a:cubicBezTo>
                <a:cubicBezTo>
                  <a:pt x="2861728" y="24436"/>
                  <a:pt x="2798229" y="7767"/>
                  <a:pt x="2756160" y="3005"/>
                </a:cubicBezTo>
                <a:cubicBezTo>
                  <a:pt x="2714091" y="-1757"/>
                  <a:pt x="2692660" y="-170"/>
                  <a:pt x="2651385" y="3005"/>
                </a:cubicBezTo>
                <a:cubicBezTo>
                  <a:pt x="2610110" y="6180"/>
                  <a:pt x="2550579" y="12530"/>
                  <a:pt x="2508510" y="22055"/>
                </a:cubicBezTo>
                <a:cubicBezTo>
                  <a:pt x="2466441" y="31580"/>
                  <a:pt x="2445803" y="53011"/>
                  <a:pt x="2398972" y="60155"/>
                </a:cubicBezTo>
                <a:cubicBezTo>
                  <a:pt x="2352141" y="67299"/>
                  <a:pt x="2267210" y="60948"/>
                  <a:pt x="2227522" y="64917"/>
                </a:cubicBezTo>
                <a:cubicBezTo>
                  <a:pt x="2187835" y="68886"/>
                  <a:pt x="2194185" y="68886"/>
                  <a:pt x="2160847" y="83967"/>
                </a:cubicBezTo>
                <a:cubicBezTo>
                  <a:pt x="2127510" y="99048"/>
                  <a:pt x="2071947" y="142705"/>
                  <a:pt x="2027497" y="155405"/>
                </a:cubicBezTo>
                <a:cubicBezTo>
                  <a:pt x="1983047" y="168105"/>
                  <a:pt x="1948916" y="160167"/>
                  <a:pt x="1894147" y="160167"/>
                </a:cubicBezTo>
                <a:cubicBezTo>
                  <a:pt x="1839378" y="160167"/>
                  <a:pt x="1766354" y="140324"/>
                  <a:pt x="1698885" y="155405"/>
                </a:cubicBezTo>
                <a:cubicBezTo>
                  <a:pt x="1631416" y="170486"/>
                  <a:pt x="1531404" y="230811"/>
                  <a:pt x="1489335" y="250655"/>
                </a:cubicBezTo>
                <a:cubicBezTo>
                  <a:pt x="1447266" y="270499"/>
                  <a:pt x="1471872" y="259386"/>
                  <a:pt x="1446472" y="274467"/>
                </a:cubicBezTo>
                <a:cubicBezTo>
                  <a:pt x="1421072" y="289548"/>
                  <a:pt x="1368685" y="319711"/>
                  <a:pt x="1336935" y="341142"/>
                </a:cubicBezTo>
                <a:cubicBezTo>
                  <a:pt x="1305185" y="362573"/>
                  <a:pt x="1283753" y="390355"/>
                  <a:pt x="1255972" y="403055"/>
                </a:cubicBezTo>
                <a:cubicBezTo>
                  <a:pt x="1228191" y="415755"/>
                  <a:pt x="1201203" y="414167"/>
                  <a:pt x="1170247" y="417342"/>
                </a:cubicBezTo>
                <a:cubicBezTo>
                  <a:pt x="1139291" y="420517"/>
                  <a:pt x="1099604" y="415755"/>
                  <a:pt x="1070235" y="422105"/>
                </a:cubicBezTo>
                <a:cubicBezTo>
                  <a:pt x="1040866" y="428455"/>
                  <a:pt x="1022610" y="434011"/>
                  <a:pt x="994035" y="455442"/>
                </a:cubicBezTo>
                <a:cubicBezTo>
                  <a:pt x="965460" y="476873"/>
                  <a:pt x="929741" y="523704"/>
                  <a:pt x="898785" y="550692"/>
                </a:cubicBezTo>
                <a:cubicBezTo>
                  <a:pt x="867829" y="577680"/>
                  <a:pt x="847985" y="593554"/>
                  <a:pt x="808297" y="617367"/>
                </a:cubicBezTo>
                <a:cubicBezTo>
                  <a:pt x="768610" y="641179"/>
                  <a:pt x="694791" y="674517"/>
                  <a:pt x="660660" y="693567"/>
                </a:cubicBezTo>
                <a:cubicBezTo>
                  <a:pt x="626529" y="712617"/>
                  <a:pt x="626529" y="712617"/>
                  <a:pt x="603510" y="731667"/>
                </a:cubicBezTo>
                <a:cubicBezTo>
                  <a:pt x="580491" y="750717"/>
                  <a:pt x="546359" y="785642"/>
                  <a:pt x="522547" y="807867"/>
                </a:cubicBezTo>
                <a:cubicBezTo>
                  <a:pt x="498735" y="830092"/>
                  <a:pt x="477304" y="847555"/>
                  <a:pt x="460635" y="865017"/>
                </a:cubicBezTo>
                <a:cubicBezTo>
                  <a:pt x="443966" y="882479"/>
                  <a:pt x="443966" y="886448"/>
                  <a:pt x="422535" y="912642"/>
                </a:cubicBezTo>
                <a:cubicBezTo>
                  <a:pt x="401104" y="938836"/>
                  <a:pt x="370941" y="992018"/>
                  <a:pt x="332047" y="1022180"/>
                </a:cubicBezTo>
                <a:cubicBezTo>
                  <a:pt x="293153" y="1052342"/>
                  <a:pt x="223303" y="1075361"/>
                  <a:pt x="189172" y="1093617"/>
                </a:cubicBezTo>
                <a:cubicBezTo>
                  <a:pt x="155041" y="1111873"/>
                  <a:pt x="143135" y="1113461"/>
                  <a:pt x="127260" y="1131717"/>
                </a:cubicBezTo>
                <a:cubicBezTo>
                  <a:pt x="111385" y="1149973"/>
                  <a:pt x="107416" y="1176961"/>
                  <a:pt x="93922" y="1203155"/>
                </a:cubicBezTo>
                <a:cubicBezTo>
                  <a:pt x="80428" y="1229349"/>
                  <a:pt x="58203" y="1261099"/>
                  <a:pt x="46297" y="1288880"/>
                </a:cubicBezTo>
                <a:cubicBezTo>
                  <a:pt x="34391" y="1316661"/>
                  <a:pt x="28041" y="1347617"/>
                  <a:pt x="22485" y="1369842"/>
                </a:cubicBezTo>
                <a:cubicBezTo>
                  <a:pt x="16929" y="1392067"/>
                  <a:pt x="-9265" y="1417467"/>
                  <a:pt x="3435" y="1431755"/>
                </a:cubicBezTo>
                <a:close/>
              </a:path>
            </a:pathLst>
          </a:custGeom>
          <a:noFill/>
          <a:ln w="38100">
            <a:solidFill>
              <a:schemeClr val="bg1"/>
            </a:solidFill>
            <a:prstDash val="solid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9666"/>
          </a:p>
        </p:txBody>
      </p:sp>
      <p:sp>
        <p:nvSpPr>
          <p:cNvPr id="197" name="Rectangle 196"/>
          <p:cNvSpPr/>
          <p:nvPr/>
        </p:nvSpPr>
        <p:spPr>
          <a:xfrm>
            <a:off x="8169378" y="2277220"/>
            <a:ext cx="1310058" cy="1391759"/>
          </a:xfrm>
          <a:prstGeom prst="rect">
            <a:avLst/>
          </a:prstGeom>
          <a:noFill/>
          <a:ln w="38100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9666"/>
          </a:p>
        </p:txBody>
      </p:sp>
      <p:cxnSp>
        <p:nvCxnSpPr>
          <p:cNvPr id="198" name="Straight Connector 197"/>
          <p:cNvCxnSpPr/>
          <p:nvPr/>
        </p:nvCxnSpPr>
        <p:spPr>
          <a:xfrm flipV="1">
            <a:off x="12021584" y="6628221"/>
            <a:ext cx="876669" cy="0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199" name="Group 198"/>
          <p:cNvGrpSpPr/>
          <p:nvPr/>
        </p:nvGrpSpPr>
        <p:grpSpPr>
          <a:xfrm>
            <a:off x="1344444" y="7007183"/>
            <a:ext cx="11771091" cy="5072723"/>
            <a:chOff x="36283" y="2006984"/>
            <a:chExt cx="4926243" cy="1972925"/>
          </a:xfrm>
        </p:grpSpPr>
        <p:cxnSp>
          <p:nvCxnSpPr>
            <p:cNvPr id="200" name="Straight Connector 199"/>
            <p:cNvCxnSpPr/>
            <p:nvPr/>
          </p:nvCxnSpPr>
          <p:spPr>
            <a:xfrm>
              <a:off x="4838869" y="2073299"/>
              <a:ext cx="1419" cy="0"/>
            </a:xfrm>
            <a:prstGeom prst="line">
              <a:avLst/>
            </a:prstGeom>
            <a:ln w="2857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201" name="Picture 200"/>
            <p:cNvPicPr>
              <a:picLocks noChangeAspect="1"/>
            </p:cNvPicPr>
            <p:nvPr/>
          </p:nvPicPr>
          <p:blipFill>
            <a:blip r:embed="rId1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 rot="16200000">
              <a:off x="1512942" y="530325"/>
              <a:ext cx="1972925" cy="4926243"/>
            </a:xfrm>
            <a:prstGeom prst="rect">
              <a:avLst/>
            </a:prstGeom>
            <a:ln>
              <a:solidFill>
                <a:schemeClr val="bg1"/>
              </a:solidFill>
            </a:ln>
          </p:spPr>
        </p:pic>
        <p:sp>
          <p:nvSpPr>
            <p:cNvPr id="202" name="Rectangle 201"/>
            <p:cNvSpPr/>
            <p:nvPr/>
          </p:nvSpPr>
          <p:spPr>
            <a:xfrm>
              <a:off x="2746375" y="2136580"/>
              <a:ext cx="548001" cy="579393"/>
            </a:xfrm>
            <a:prstGeom prst="rect">
              <a:avLst/>
            </a:prstGeom>
            <a:noFill/>
            <a:ln w="38100"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9666"/>
            </a:p>
          </p:txBody>
        </p:sp>
        <p:sp>
          <p:nvSpPr>
            <p:cNvPr id="203" name="Freeform 202"/>
            <p:cNvSpPr/>
            <p:nvPr/>
          </p:nvSpPr>
          <p:spPr>
            <a:xfrm>
              <a:off x="444500" y="2086688"/>
              <a:ext cx="3927475" cy="1177925"/>
            </a:xfrm>
            <a:custGeom>
              <a:avLst/>
              <a:gdLst>
                <a:gd name="connsiteX0" fmla="*/ 2001 w 4476825"/>
                <a:gd name="connsiteY0" fmla="*/ 1289154 h 1291454"/>
                <a:gd name="connsiteX1" fmla="*/ 90901 w 4476825"/>
                <a:gd name="connsiteY1" fmla="*/ 1247879 h 1291454"/>
                <a:gd name="connsiteX2" fmla="*/ 186151 w 4476825"/>
                <a:gd name="connsiteY2" fmla="*/ 1184379 h 1291454"/>
                <a:gd name="connsiteX3" fmla="*/ 275051 w 4476825"/>
                <a:gd name="connsiteY3" fmla="*/ 1130404 h 1291454"/>
                <a:gd name="connsiteX4" fmla="*/ 367126 w 4476825"/>
                <a:gd name="connsiteY4" fmla="*/ 1085954 h 1291454"/>
                <a:gd name="connsiteX5" fmla="*/ 456026 w 4476825"/>
                <a:gd name="connsiteY5" fmla="*/ 1038329 h 1291454"/>
                <a:gd name="connsiteX6" fmla="*/ 525876 w 4476825"/>
                <a:gd name="connsiteY6" fmla="*/ 990704 h 1291454"/>
                <a:gd name="connsiteX7" fmla="*/ 646526 w 4476825"/>
                <a:gd name="connsiteY7" fmla="*/ 908154 h 1291454"/>
                <a:gd name="connsiteX8" fmla="*/ 754476 w 4476825"/>
                <a:gd name="connsiteY8" fmla="*/ 841479 h 1291454"/>
                <a:gd name="connsiteX9" fmla="*/ 868776 w 4476825"/>
                <a:gd name="connsiteY9" fmla="*/ 774804 h 1291454"/>
                <a:gd name="connsiteX10" fmla="*/ 951326 w 4476825"/>
                <a:gd name="connsiteY10" fmla="*/ 736704 h 1291454"/>
                <a:gd name="connsiteX11" fmla="*/ 1068801 w 4476825"/>
                <a:gd name="connsiteY11" fmla="*/ 676379 h 1291454"/>
                <a:gd name="connsiteX12" fmla="*/ 1179926 w 4476825"/>
                <a:gd name="connsiteY12" fmla="*/ 628754 h 1291454"/>
                <a:gd name="connsiteX13" fmla="*/ 1322801 w 4476825"/>
                <a:gd name="connsiteY13" fmla="*/ 574779 h 1291454"/>
                <a:gd name="connsiteX14" fmla="*/ 1443451 w 4476825"/>
                <a:gd name="connsiteY14" fmla="*/ 546204 h 1291454"/>
                <a:gd name="connsiteX15" fmla="*/ 1554576 w 4476825"/>
                <a:gd name="connsiteY15" fmla="*/ 536679 h 1291454"/>
                <a:gd name="connsiteX16" fmla="*/ 1684751 w 4476825"/>
                <a:gd name="connsiteY16" fmla="*/ 498579 h 1291454"/>
                <a:gd name="connsiteX17" fmla="*/ 1773651 w 4476825"/>
                <a:gd name="connsiteY17" fmla="*/ 485879 h 1291454"/>
                <a:gd name="connsiteX18" fmla="*/ 1865726 w 4476825"/>
                <a:gd name="connsiteY18" fmla="*/ 466829 h 1291454"/>
                <a:gd name="connsiteX19" fmla="*/ 1938751 w 4476825"/>
                <a:gd name="connsiteY19" fmla="*/ 435079 h 1291454"/>
                <a:gd name="connsiteX20" fmla="*/ 2065751 w 4476825"/>
                <a:gd name="connsiteY20" fmla="*/ 400154 h 1291454"/>
                <a:gd name="connsiteX21" fmla="*/ 2205451 w 4476825"/>
                <a:gd name="connsiteY21" fmla="*/ 400154 h 1291454"/>
                <a:gd name="connsiteX22" fmla="*/ 2316576 w 4476825"/>
                <a:gd name="connsiteY22" fmla="*/ 390629 h 1291454"/>
                <a:gd name="connsiteX23" fmla="*/ 2421351 w 4476825"/>
                <a:gd name="connsiteY23" fmla="*/ 358879 h 1291454"/>
                <a:gd name="connsiteX24" fmla="*/ 2526126 w 4476825"/>
                <a:gd name="connsiteY24" fmla="*/ 311254 h 1291454"/>
                <a:gd name="connsiteX25" fmla="*/ 2659476 w 4476825"/>
                <a:gd name="connsiteY25" fmla="*/ 304904 h 1291454"/>
                <a:gd name="connsiteX26" fmla="*/ 2783301 w 4476825"/>
                <a:gd name="connsiteY26" fmla="*/ 333479 h 1291454"/>
                <a:gd name="connsiteX27" fmla="*/ 2913476 w 4476825"/>
                <a:gd name="connsiteY27" fmla="*/ 349354 h 1291454"/>
                <a:gd name="connsiteX28" fmla="*/ 3005551 w 4476825"/>
                <a:gd name="connsiteY28" fmla="*/ 362054 h 1291454"/>
                <a:gd name="connsiteX29" fmla="*/ 3113501 w 4476825"/>
                <a:gd name="connsiteY29" fmla="*/ 355704 h 1291454"/>
                <a:gd name="connsiteX30" fmla="*/ 3246851 w 4476825"/>
                <a:gd name="connsiteY30" fmla="*/ 362054 h 1291454"/>
                <a:gd name="connsiteX31" fmla="*/ 3316701 w 4476825"/>
                <a:gd name="connsiteY31" fmla="*/ 374754 h 1291454"/>
                <a:gd name="connsiteX32" fmla="*/ 3424651 w 4476825"/>
                <a:gd name="connsiteY32" fmla="*/ 387454 h 1291454"/>
                <a:gd name="connsiteX33" fmla="*/ 3526251 w 4476825"/>
                <a:gd name="connsiteY33" fmla="*/ 387454 h 1291454"/>
                <a:gd name="connsiteX34" fmla="*/ 3618326 w 4476825"/>
                <a:gd name="connsiteY34" fmla="*/ 403329 h 1291454"/>
                <a:gd name="connsiteX35" fmla="*/ 3707226 w 4476825"/>
                <a:gd name="connsiteY35" fmla="*/ 422379 h 1291454"/>
                <a:gd name="connsiteX36" fmla="*/ 3815176 w 4476825"/>
                <a:gd name="connsiteY36" fmla="*/ 457304 h 1291454"/>
                <a:gd name="connsiteX37" fmla="*/ 3900901 w 4476825"/>
                <a:gd name="connsiteY37" fmla="*/ 482704 h 1291454"/>
                <a:gd name="connsiteX38" fmla="*/ 4015201 w 4476825"/>
                <a:gd name="connsiteY38" fmla="*/ 520804 h 1291454"/>
                <a:gd name="connsiteX39" fmla="*/ 4091401 w 4476825"/>
                <a:gd name="connsiteY39" fmla="*/ 571604 h 1291454"/>
                <a:gd name="connsiteX40" fmla="*/ 4142201 w 4476825"/>
                <a:gd name="connsiteY40" fmla="*/ 609704 h 1291454"/>
                <a:gd name="connsiteX41" fmla="*/ 4135851 w 4476825"/>
                <a:gd name="connsiteY41" fmla="*/ 568429 h 1291454"/>
                <a:gd name="connsiteX42" fmla="*/ 4129501 w 4476825"/>
                <a:gd name="connsiteY42" fmla="*/ 520804 h 1291454"/>
                <a:gd name="connsiteX43" fmla="*/ 4196176 w 4476825"/>
                <a:gd name="connsiteY43" fmla="*/ 571604 h 1291454"/>
                <a:gd name="connsiteX44" fmla="*/ 4256501 w 4476825"/>
                <a:gd name="connsiteY44" fmla="*/ 625579 h 1291454"/>
                <a:gd name="connsiteX45" fmla="*/ 4316826 w 4476825"/>
                <a:gd name="connsiteY45" fmla="*/ 673204 h 1291454"/>
                <a:gd name="connsiteX46" fmla="*/ 4383501 w 4476825"/>
                <a:gd name="connsiteY46" fmla="*/ 701779 h 1291454"/>
                <a:gd name="connsiteX47" fmla="*/ 4462876 w 4476825"/>
                <a:gd name="connsiteY47" fmla="*/ 730354 h 1291454"/>
                <a:gd name="connsiteX48" fmla="*/ 4475576 w 4476825"/>
                <a:gd name="connsiteY48" fmla="*/ 685904 h 1291454"/>
                <a:gd name="connsiteX49" fmla="*/ 4472401 w 4476825"/>
                <a:gd name="connsiteY49" fmla="*/ 641454 h 1291454"/>
                <a:gd name="connsiteX50" fmla="*/ 4440651 w 4476825"/>
                <a:gd name="connsiteY50" fmla="*/ 635104 h 1291454"/>
                <a:gd name="connsiteX51" fmla="*/ 4367626 w 4476825"/>
                <a:gd name="connsiteY51" fmla="*/ 590654 h 1291454"/>
                <a:gd name="connsiteX52" fmla="*/ 4304126 w 4476825"/>
                <a:gd name="connsiteY52" fmla="*/ 558904 h 1291454"/>
                <a:gd name="connsiteX53" fmla="*/ 4250151 w 4476825"/>
                <a:gd name="connsiteY53" fmla="*/ 536679 h 1291454"/>
                <a:gd name="connsiteX54" fmla="*/ 4243801 w 4476825"/>
                <a:gd name="connsiteY54" fmla="*/ 511279 h 1291454"/>
                <a:gd name="connsiteX55" fmla="*/ 4183476 w 4476825"/>
                <a:gd name="connsiteY55" fmla="*/ 460479 h 1291454"/>
                <a:gd name="connsiteX56" fmla="*/ 4129501 w 4476825"/>
                <a:gd name="connsiteY56" fmla="*/ 416029 h 1291454"/>
                <a:gd name="connsiteX57" fmla="*/ 4081876 w 4476825"/>
                <a:gd name="connsiteY57" fmla="*/ 358879 h 1291454"/>
                <a:gd name="connsiteX58" fmla="*/ 3989801 w 4476825"/>
                <a:gd name="connsiteY58" fmla="*/ 308079 h 1291454"/>
                <a:gd name="connsiteX59" fmla="*/ 3907251 w 4476825"/>
                <a:gd name="connsiteY59" fmla="*/ 260454 h 1291454"/>
                <a:gd name="connsiteX60" fmla="*/ 3837401 w 4476825"/>
                <a:gd name="connsiteY60" fmla="*/ 181079 h 1291454"/>
                <a:gd name="connsiteX61" fmla="*/ 3716751 w 4476825"/>
                <a:gd name="connsiteY61" fmla="*/ 120754 h 1291454"/>
                <a:gd name="connsiteX62" fmla="*/ 3618326 w 4476825"/>
                <a:gd name="connsiteY62" fmla="*/ 101704 h 1291454"/>
                <a:gd name="connsiteX63" fmla="*/ 3500851 w 4476825"/>
                <a:gd name="connsiteY63" fmla="*/ 76304 h 1291454"/>
                <a:gd name="connsiteX64" fmla="*/ 3351626 w 4476825"/>
                <a:gd name="connsiteY64" fmla="*/ 63604 h 1291454"/>
                <a:gd name="connsiteX65" fmla="*/ 3224626 w 4476825"/>
                <a:gd name="connsiteY65" fmla="*/ 41379 h 1291454"/>
                <a:gd name="connsiteX66" fmla="*/ 3084926 w 4476825"/>
                <a:gd name="connsiteY66" fmla="*/ 25504 h 1291454"/>
                <a:gd name="connsiteX67" fmla="*/ 2926176 w 4476825"/>
                <a:gd name="connsiteY67" fmla="*/ 6454 h 1291454"/>
                <a:gd name="connsiteX68" fmla="*/ 2824576 w 4476825"/>
                <a:gd name="connsiteY68" fmla="*/ 44554 h 1291454"/>
                <a:gd name="connsiteX69" fmla="*/ 2700751 w 4476825"/>
                <a:gd name="connsiteY69" fmla="*/ 44554 h 1291454"/>
                <a:gd name="connsiteX70" fmla="*/ 2592801 w 4476825"/>
                <a:gd name="connsiteY70" fmla="*/ 41379 h 1291454"/>
                <a:gd name="connsiteX71" fmla="*/ 2449926 w 4476825"/>
                <a:gd name="connsiteY71" fmla="*/ 54079 h 1291454"/>
                <a:gd name="connsiteX72" fmla="*/ 2335626 w 4476825"/>
                <a:gd name="connsiteY72" fmla="*/ 41379 h 1291454"/>
                <a:gd name="connsiteX73" fmla="*/ 2259426 w 4476825"/>
                <a:gd name="connsiteY73" fmla="*/ 25504 h 1291454"/>
                <a:gd name="connsiteX74" fmla="*/ 2202276 w 4476825"/>
                <a:gd name="connsiteY74" fmla="*/ 19154 h 1291454"/>
                <a:gd name="connsiteX75" fmla="*/ 2129251 w 4476825"/>
                <a:gd name="connsiteY75" fmla="*/ 3279 h 1291454"/>
                <a:gd name="connsiteX76" fmla="*/ 2072101 w 4476825"/>
                <a:gd name="connsiteY76" fmla="*/ 3279 h 1291454"/>
                <a:gd name="connsiteX77" fmla="*/ 2068926 w 4476825"/>
                <a:gd name="connsiteY77" fmla="*/ 38204 h 1291454"/>
                <a:gd name="connsiteX78" fmla="*/ 2040351 w 4476825"/>
                <a:gd name="connsiteY78" fmla="*/ 120754 h 1291454"/>
                <a:gd name="connsiteX79" fmla="*/ 2021301 w 4476825"/>
                <a:gd name="connsiteY79" fmla="*/ 165204 h 1291454"/>
                <a:gd name="connsiteX80" fmla="*/ 1941926 w 4476825"/>
                <a:gd name="connsiteY80" fmla="*/ 165204 h 1291454"/>
                <a:gd name="connsiteX81" fmla="*/ 1907001 w 4476825"/>
                <a:gd name="connsiteY81" fmla="*/ 184254 h 1291454"/>
                <a:gd name="connsiteX82" fmla="*/ 1881601 w 4476825"/>
                <a:gd name="connsiteY82" fmla="*/ 184254 h 1291454"/>
                <a:gd name="connsiteX83" fmla="*/ 1837151 w 4476825"/>
                <a:gd name="connsiteY83" fmla="*/ 152504 h 1291454"/>
                <a:gd name="connsiteX84" fmla="*/ 1795876 w 4476825"/>
                <a:gd name="connsiteY84" fmla="*/ 136629 h 1291454"/>
                <a:gd name="connsiteX85" fmla="*/ 1760951 w 4476825"/>
                <a:gd name="connsiteY85" fmla="*/ 92179 h 1291454"/>
                <a:gd name="connsiteX86" fmla="*/ 1694276 w 4476825"/>
                <a:gd name="connsiteY86" fmla="*/ 92179 h 1291454"/>
                <a:gd name="connsiteX87" fmla="*/ 1605376 w 4476825"/>
                <a:gd name="connsiteY87" fmla="*/ 123929 h 1291454"/>
                <a:gd name="connsiteX88" fmla="*/ 1532351 w 4476825"/>
                <a:gd name="connsiteY88" fmla="*/ 155679 h 1291454"/>
                <a:gd name="connsiteX89" fmla="*/ 1459326 w 4476825"/>
                <a:gd name="connsiteY89" fmla="*/ 181079 h 1291454"/>
                <a:gd name="connsiteX90" fmla="*/ 1392651 w 4476825"/>
                <a:gd name="connsiteY90" fmla="*/ 200129 h 1291454"/>
                <a:gd name="connsiteX91" fmla="*/ 1310101 w 4476825"/>
                <a:gd name="connsiteY91" fmla="*/ 241404 h 1291454"/>
                <a:gd name="connsiteX92" fmla="*/ 1211676 w 4476825"/>
                <a:gd name="connsiteY92" fmla="*/ 289029 h 1291454"/>
                <a:gd name="connsiteX93" fmla="*/ 1119601 w 4476825"/>
                <a:gd name="connsiteY93" fmla="*/ 336654 h 1291454"/>
                <a:gd name="connsiteX94" fmla="*/ 1052926 w 4476825"/>
                <a:gd name="connsiteY94" fmla="*/ 381104 h 1291454"/>
                <a:gd name="connsiteX95" fmla="*/ 1008476 w 4476825"/>
                <a:gd name="connsiteY95" fmla="*/ 412854 h 1291454"/>
                <a:gd name="connsiteX96" fmla="*/ 948151 w 4476825"/>
                <a:gd name="connsiteY96" fmla="*/ 454129 h 1291454"/>
                <a:gd name="connsiteX97" fmla="*/ 862426 w 4476825"/>
                <a:gd name="connsiteY97" fmla="*/ 511279 h 1291454"/>
                <a:gd name="connsiteX98" fmla="*/ 808451 w 4476825"/>
                <a:gd name="connsiteY98" fmla="*/ 546204 h 1291454"/>
                <a:gd name="connsiteX99" fmla="*/ 732251 w 4476825"/>
                <a:gd name="connsiteY99" fmla="*/ 581129 h 1291454"/>
                <a:gd name="connsiteX100" fmla="*/ 671926 w 4476825"/>
                <a:gd name="connsiteY100" fmla="*/ 609704 h 1291454"/>
                <a:gd name="connsiteX101" fmla="*/ 605251 w 4476825"/>
                <a:gd name="connsiteY101" fmla="*/ 657329 h 1291454"/>
                <a:gd name="connsiteX102" fmla="*/ 548101 w 4476825"/>
                <a:gd name="connsiteY102" fmla="*/ 711304 h 1291454"/>
                <a:gd name="connsiteX103" fmla="*/ 516351 w 4476825"/>
                <a:gd name="connsiteY103" fmla="*/ 758929 h 1291454"/>
                <a:gd name="connsiteX104" fmla="*/ 481426 w 4476825"/>
                <a:gd name="connsiteY104" fmla="*/ 819254 h 1291454"/>
                <a:gd name="connsiteX105" fmla="*/ 433801 w 4476825"/>
                <a:gd name="connsiteY105" fmla="*/ 870054 h 1291454"/>
                <a:gd name="connsiteX106" fmla="*/ 363951 w 4476825"/>
                <a:gd name="connsiteY106" fmla="*/ 911329 h 1291454"/>
                <a:gd name="connsiteX107" fmla="*/ 287751 w 4476825"/>
                <a:gd name="connsiteY107" fmla="*/ 952604 h 1291454"/>
                <a:gd name="connsiteX108" fmla="*/ 224251 w 4476825"/>
                <a:gd name="connsiteY108" fmla="*/ 990704 h 1291454"/>
                <a:gd name="connsiteX109" fmla="*/ 176626 w 4476825"/>
                <a:gd name="connsiteY109" fmla="*/ 1041504 h 1291454"/>
                <a:gd name="connsiteX110" fmla="*/ 125826 w 4476825"/>
                <a:gd name="connsiteY110" fmla="*/ 1082779 h 1291454"/>
                <a:gd name="connsiteX111" fmla="*/ 49626 w 4476825"/>
                <a:gd name="connsiteY111" fmla="*/ 1152629 h 1291454"/>
                <a:gd name="connsiteX112" fmla="*/ 30576 w 4476825"/>
                <a:gd name="connsiteY112" fmla="*/ 1178029 h 1291454"/>
                <a:gd name="connsiteX113" fmla="*/ 2001 w 4476825"/>
                <a:gd name="connsiteY113" fmla="*/ 1289154 h 1291454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  <a:cxn ang="0">
                  <a:pos x="connsiteX29" y="connsiteY29"/>
                </a:cxn>
                <a:cxn ang="0">
                  <a:pos x="connsiteX30" y="connsiteY30"/>
                </a:cxn>
                <a:cxn ang="0">
                  <a:pos x="connsiteX31" y="connsiteY31"/>
                </a:cxn>
                <a:cxn ang="0">
                  <a:pos x="connsiteX32" y="connsiteY32"/>
                </a:cxn>
                <a:cxn ang="0">
                  <a:pos x="connsiteX33" y="connsiteY33"/>
                </a:cxn>
                <a:cxn ang="0">
                  <a:pos x="connsiteX34" y="connsiteY34"/>
                </a:cxn>
                <a:cxn ang="0">
                  <a:pos x="connsiteX35" y="connsiteY35"/>
                </a:cxn>
                <a:cxn ang="0">
                  <a:pos x="connsiteX36" y="connsiteY36"/>
                </a:cxn>
                <a:cxn ang="0">
                  <a:pos x="connsiteX37" y="connsiteY37"/>
                </a:cxn>
                <a:cxn ang="0">
                  <a:pos x="connsiteX38" y="connsiteY38"/>
                </a:cxn>
                <a:cxn ang="0">
                  <a:pos x="connsiteX39" y="connsiteY39"/>
                </a:cxn>
                <a:cxn ang="0">
                  <a:pos x="connsiteX40" y="connsiteY40"/>
                </a:cxn>
                <a:cxn ang="0">
                  <a:pos x="connsiteX41" y="connsiteY41"/>
                </a:cxn>
                <a:cxn ang="0">
                  <a:pos x="connsiteX42" y="connsiteY42"/>
                </a:cxn>
                <a:cxn ang="0">
                  <a:pos x="connsiteX43" y="connsiteY43"/>
                </a:cxn>
                <a:cxn ang="0">
                  <a:pos x="connsiteX44" y="connsiteY44"/>
                </a:cxn>
                <a:cxn ang="0">
                  <a:pos x="connsiteX45" y="connsiteY45"/>
                </a:cxn>
                <a:cxn ang="0">
                  <a:pos x="connsiteX46" y="connsiteY46"/>
                </a:cxn>
                <a:cxn ang="0">
                  <a:pos x="connsiteX47" y="connsiteY47"/>
                </a:cxn>
                <a:cxn ang="0">
                  <a:pos x="connsiteX48" y="connsiteY48"/>
                </a:cxn>
                <a:cxn ang="0">
                  <a:pos x="connsiteX49" y="connsiteY49"/>
                </a:cxn>
                <a:cxn ang="0">
                  <a:pos x="connsiteX50" y="connsiteY50"/>
                </a:cxn>
                <a:cxn ang="0">
                  <a:pos x="connsiteX51" y="connsiteY51"/>
                </a:cxn>
                <a:cxn ang="0">
                  <a:pos x="connsiteX52" y="connsiteY52"/>
                </a:cxn>
                <a:cxn ang="0">
                  <a:pos x="connsiteX53" y="connsiteY53"/>
                </a:cxn>
                <a:cxn ang="0">
                  <a:pos x="connsiteX54" y="connsiteY54"/>
                </a:cxn>
                <a:cxn ang="0">
                  <a:pos x="connsiteX55" y="connsiteY55"/>
                </a:cxn>
                <a:cxn ang="0">
                  <a:pos x="connsiteX56" y="connsiteY56"/>
                </a:cxn>
                <a:cxn ang="0">
                  <a:pos x="connsiteX57" y="connsiteY57"/>
                </a:cxn>
                <a:cxn ang="0">
                  <a:pos x="connsiteX58" y="connsiteY58"/>
                </a:cxn>
                <a:cxn ang="0">
                  <a:pos x="connsiteX59" y="connsiteY59"/>
                </a:cxn>
                <a:cxn ang="0">
                  <a:pos x="connsiteX60" y="connsiteY60"/>
                </a:cxn>
                <a:cxn ang="0">
                  <a:pos x="connsiteX61" y="connsiteY61"/>
                </a:cxn>
                <a:cxn ang="0">
                  <a:pos x="connsiteX62" y="connsiteY62"/>
                </a:cxn>
                <a:cxn ang="0">
                  <a:pos x="connsiteX63" y="connsiteY63"/>
                </a:cxn>
                <a:cxn ang="0">
                  <a:pos x="connsiteX64" y="connsiteY64"/>
                </a:cxn>
                <a:cxn ang="0">
                  <a:pos x="connsiteX65" y="connsiteY65"/>
                </a:cxn>
                <a:cxn ang="0">
                  <a:pos x="connsiteX66" y="connsiteY66"/>
                </a:cxn>
                <a:cxn ang="0">
                  <a:pos x="connsiteX67" y="connsiteY67"/>
                </a:cxn>
                <a:cxn ang="0">
                  <a:pos x="connsiteX68" y="connsiteY68"/>
                </a:cxn>
                <a:cxn ang="0">
                  <a:pos x="connsiteX69" y="connsiteY69"/>
                </a:cxn>
                <a:cxn ang="0">
                  <a:pos x="connsiteX70" y="connsiteY70"/>
                </a:cxn>
                <a:cxn ang="0">
                  <a:pos x="connsiteX71" y="connsiteY71"/>
                </a:cxn>
                <a:cxn ang="0">
                  <a:pos x="connsiteX72" y="connsiteY72"/>
                </a:cxn>
                <a:cxn ang="0">
                  <a:pos x="connsiteX73" y="connsiteY73"/>
                </a:cxn>
                <a:cxn ang="0">
                  <a:pos x="connsiteX74" y="connsiteY74"/>
                </a:cxn>
                <a:cxn ang="0">
                  <a:pos x="connsiteX75" y="connsiteY75"/>
                </a:cxn>
                <a:cxn ang="0">
                  <a:pos x="connsiteX76" y="connsiteY76"/>
                </a:cxn>
                <a:cxn ang="0">
                  <a:pos x="connsiteX77" y="connsiteY77"/>
                </a:cxn>
                <a:cxn ang="0">
                  <a:pos x="connsiteX78" y="connsiteY78"/>
                </a:cxn>
                <a:cxn ang="0">
                  <a:pos x="connsiteX79" y="connsiteY79"/>
                </a:cxn>
                <a:cxn ang="0">
                  <a:pos x="connsiteX80" y="connsiteY80"/>
                </a:cxn>
                <a:cxn ang="0">
                  <a:pos x="connsiteX81" y="connsiteY81"/>
                </a:cxn>
                <a:cxn ang="0">
                  <a:pos x="connsiteX82" y="connsiteY82"/>
                </a:cxn>
                <a:cxn ang="0">
                  <a:pos x="connsiteX83" y="connsiteY83"/>
                </a:cxn>
                <a:cxn ang="0">
                  <a:pos x="connsiteX84" y="connsiteY84"/>
                </a:cxn>
                <a:cxn ang="0">
                  <a:pos x="connsiteX85" y="connsiteY85"/>
                </a:cxn>
                <a:cxn ang="0">
                  <a:pos x="connsiteX86" y="connsiteY86"/>
                </a:cxn>
                <a:cxn ang="0">
                  <a:pos x="connsiteX87" y="connsiteY87"/>
                </a:cxn>
                <a:cxn ang="0">
                  <a:pos x="connsiteX88" y="connsiteY88"/>
                </a:cxn>
                <a:cxn ang="0">
                  <a:pos x="connsiteX89" y="connsiteY89"/>
                </a:cxn>
                <a:cxn ang="0">
                  <a:pos x="connsiteX90" y="connsiteY90"/>
                </a:cxn>
                <a:cxn ang="0">
                  <a:pos x="connsiteX91" y="connsiteY91"/>
                </a:cxn>
                <a:cxn ang="0">
                  <a:pos x="connsiteX92" y="connsiteY92"/>
                </a:cxn>
                <a:cxn ang="0">
                  <a:pos x="connsiteX93" y="connsiteY93"/>
                </a:cxn>
                <a:cxn ang="0">
                  <a:pos x="connsiteX94" y="connsiteY94"/>
                </a:cxn>
                <a:cxn ang="0">
                  <a:pos x="connsiteX95" y="connsiteY95"/>
                </a:cxn>
                <a:cxn ang="0">
                  <a:pos x="connsiteX96" y="connsiteY96"/>
                </a:cxn>
                <a:cxn ang="0">
                  <a:pos x="connsiteX97" y="connsiteY97"/>
                </a:cxn>
                <a:cxn ang="0">
                  <a:pos x="connsiteX98" y="connsiteY98"/>
                </a:cxn>
                <a:cxn ang="0">
                  <a:pos x="connsiteX99" y="connsiteY99"/>
                </a:cxn>
                <a:cxn ang="0">
                  <a:pos x="connsiteX100" y="connsiteY100"/>
                </a:cxn>
                <a:cxn ang="0">
                  <a:pos x="connsiteX101" y="connsiteY101"/>
                </a:cxn>
                <a:cxn ang="0">
                  <a:pos x="connsiteX102" y="connsiteY102"/>
                </a:cxn>
                <a:cxn ang="0">
                  <a:pos x="connsiteX103" y="connsiteY103"/>
                </a:cxn>
                <a:cxn ang="0">
                  <a:pos x="connsiteX104" y="connsiteY104"/>
                </a:cxn>
                <a:cxn ang="0">
                  <a:pos x="connsiteX105" y="connsiteY105"/>
                </a:cxn>
                <a:cxn ang="0">
                  <a:pos x="connsiteX106" y="connsiteY106"/>
                </a:cxn>
                <a:cxn ang="0">
                  <a:pos x="connsiteX107" y="connsiteY107"/>
                </a:cxn>
                <a:cxn ang="0">
                  <a:pos x="connsiteX108" y="connsiteY108"/>
                </a:cxn>
                <a:cxn ang="0">
                  <a:pos x="connsiteX109" y="connsiteY109"/>
                </a:cxn>
                <a:cxn ang="0">
                  <a:pos x="connsiteX110" y="connsiteY110"/>
                </a:cxn>
                <a:cxn ang="0">
                  <a:pos x="connsiteX111" y="connsiteY111"/>
                </a:cxn>
                <a:cxn ang="0">
                  <a:pos x="connsiteX112" y="connsiteY112"/>
                </a:cxn>
                <a:cxn ang="0">
                  <a:pos x="connsiteX113" y="connsiteY113"/>
                </a:cxn>
              </a:cxnLst>
              <a:rect l="l" t="t" r="r" b="b"/>
              <a:pathLst>
                <a:path w="4476825" h="1291454">
                  <a:moveTo>
                    <a:pt x="2001" y="1289154"/>
                  </a:moveTo>
                  <a:cubicBezTo>
                    <a:pt x="12055" y="1300796"/>
                    <a:pt x="60209" y="1265341"/>
                    <a:pt x="90901" y="1247879"/>
                  </a:cubicBezTo>
                  <a:cubicBezTo>
                    <a:pt x="121593" y="1230416"/>
                    <a:pt x="155459" y="1203958"/>
                    <a:pt x="186151" y="1184379"/>
                  </a:cubicBezTo>
                  <a:cubicBezTo>
                    <a:pt x="216843" y="1164800"/>
                    <a:pt x="244889" y="1146808"/>
                    <a:pt x="275051" y="1130404"/>
                  </a:cubicBezTo>
                  <a:cubicBezTo>
                    <a:pt x="305213" y="1114000"/>
                    <a:pt x="336964" y="1101300"/>
                    <a:pt x="367126" y="1085954"/>
                  </a:cubicBezTo>
                  <a:cubicBezTo>
                    <a:pt x="397289" y="1070608"/>
                    <a:pt x="429568" y="1054204"/>
                    <a:pt x="456026" y="1038329"/>
                  </a:cubicBezTo>
                  <a:cubicBezTo>
                    <a:pt x="482484" y="1022454"/>
                    <a:pt x="525876" y="990704"/>
                    <a:pt x="525876" y="990704"/>
                  </a:cubicBezTo>
                  <a:cubicBezTo>
                    <a:pt x="557626" y="969008"/>
                    <a:pt x="608426" y="933025"/>
                    <a:pt x="646526" y="908154"/>
                  </a:cubicBezTo>
                  <a:cubicBezTo>
                    <a:pt x="684626" y="883283"/>
                    <a:pt x="717435" y="863704"/>
                    <a:pt x="754476" y="841479"/>
                  </a:cubicBezTo>
                  <a:cubicBezTo>
                    <a:pt x="791517" y="819254"/>
                    <a:pt x="835968" y="792266"/>
                    <a:pt x="868776" y="774804"/>
                  </a:cubicBezTo>
                  <a:cubicBezTo>
                    <a:pt x="901584" y="757342"/>
                    <a:pt x="917988" y="753108"/>
                    <a:pt x="951326" y="736704"/>
                  </a:cubicBezTo>
                  <a:cubicBezTo>
                    <a:pt x="984664" y="720300"/>
                    <a:pt x="1030701" y="694371"/>
                    <a:pt x="1068801" y="676379"/>
                  </a:cubicBezTo>
                  <a:cubicBezTo>
                    <a:pt x="1106901" y="658387"/>
                    <a:pt x="1137593" y="645687"/>
                    <a:pt x="1179926" y="628754"/>
                  </a:cubicBezTo>
                  <a:cubicBezTo>
                    <a:pt x="1222259" y="611821"/>
                    <a:pt x="1278880" y="588537"/>
                    <a:pt x="1322801" y="574779"/>
                  </a:cubicBezTo>
                  <a:cubicBezTo>
                    <a:pt x="1366722" y="561021"/>
                    <a:pt x="1404822" y="552554"/>
                    <a:pt x="1443451" y="546204"/>
                  </a:cubicBezTo>
                  <a:cubicBezTo>
                    <a:pt x="1482080" y="539854"/>
                    <a:pt x="1514359" y="544617"/>
                    <a:pt x="1554576" y="536679"/>
                  </a:cubicBezTo>
                  <a:cubicBezTo>
                    <a:pt x="1594793" y="528741"/>
                    <a:pt x="1648239" y="507046"/>
                    <a:pt x="1684751" y="498579"/>
                  </a:cubicBezTo>
                  <a:cubicBezTo>
                    <a:pt x="1721264" y="490112"/>
                    <a:pt x="1743489" y="491171"/>
                    <a:pt x="1773651" y="485879"/>
                  </a:cubicBezTo>
                  <a:cubicBezTo>
                    <a:pt x="1803813" y="480587"/>
                    <a:pt x="1838209" y="475296"/>
                    <a:pt x="1865726" y="466829"/>
                  </a:cubicBezTo>
                  <a:cubicBezTo>
                    <a:pt x="1893243" y="458362"/>
                    <a:pt x="1905414" y="446191"/>
                    <a:pt x="1938751" y="435079"/>
                  </a:cubicBezTo>
                  <a:cubicBezTo>
                    <a:pt x="1972088" y="423967"/>
                    <a:pt x="2021301" y="405975"/>
                    <a:pt x="2065751" y="400154"/>
                  </a:cubicBezTo>
                  <a:cubicBezTo>
                    <a:pt x="2110201" y="394333"/>
                    <a:pt x="2163647" y="401741"/>
                    <a:pt x="2205451" y="400154"/>
                  </a:cubicBezTo>
                  <a:cubicBezTo>
                    <a:pt x="2247255" y="398567"/>
                    <a:pt x="2280593" y="397508"/>
                    <a:pt x="2316576" y="390629"/>
                  </a:cubicBezTo>
                  <a:cubicBezTo>
                    <a:pt x="2352559" y="383750"/>
                    <a:pt x="2386426" y="372108"/>
                    <a:pt x="2421351" y="358879"/>
                  </a:cubicBezTo>
                  <a:cubicBezTo>
                    <a:pt x="2456276" y="345650"/>
                    <a:pt x="2486439" y="320250"/>
                    <a:pt x="2526126" y="311254"/>
                  </a:cubicBezTo>
                  <a:cubicBezTo>
                    <a:pt x="2565813" y="302258"/>
                    <a:pt x="2616613" y="301200"/>
                    <a:pt x="2659476" y="304904"/>
                  </a:cubicBezTo>
                  <a:cubicBezTo>
                    <a:pt x="2702339" y="308608"/>
                    <a:pt x="2740968" y="326071"/>
                    <a:pt x="2783301" y="333479"/>
                  </a:cubicBezTo>
                  <a:cubicBezTo>
                    <a:pt x="2825634" y="340887"/>
                    <a:pt x="2913476" y="349354"/>
                    <a:pt x="2913476" y="349354"/>
                  </a:cubicBezTo>
                  <a:cubicBezTo>
                    <a:pt x="2950518" y="354116"/>
                    <a:pt x="2972214" y="360996"/>
                    <a:pt x="3005551" y="362054"/>
                  </a:cubicBezTo>
                  <a:cubicBezTo>
                    <a:pt x="3038888" y="363112"/>
                    <a:pt x="3073284" y="355704"/>
                    <a:pt x="3113501" y="355704"/>
                  </a:cubicBezTo>
                  <a:cubicBezTo>
                    <a:pt x="3153718" y="355704"/>
                    <a:pt x="3212984" y="358879"/>
                    <a:pt x="3246851" y="362054"/>
                  </a:cubicBezTo>
                  <a:cubicBezTo>
                    <a:pt x="3280718" y="365229"/>
                    <a:pt x="3287068" y="370521"/>
                    <a:pt x="3316701" y="374754"/>
                  </a:cubicBezTo>
                  <a:cubicBezTo>
                    <a:pt x="3346334" y="378987"/>
                    <a:pt x="3389726" y="385337"/>
                    <a:pt x="3424651" y="387454"/>
                  </a:cubicBezTo>
                  <a:cubicBezTo>
                    <a:pt x="3459576" y="389571"/>
                    <a:pt x="3493972" y="384808"/>
                    <a:pt x="3526251" y="387454"/>
                  </a:cubicBezTo>
                  <a:cubicBezTo>
                    <a:pt x="3558530" y="390100"/>
                    <a:pt x="3588163" y="397508"/>
                    <a:pt x="3618326" y="403329"/>
                  </a:cubicBezTo>
                  <a:cubicBezTo>
                    <a:pt x="3648489" y="409150"/>
                    <a:pt x="3674418" y="413383"/>
                    <a:pt x="3707226" y="422379"/>
                  </a:cubicBezTo>
                  <a:cubicBezTo>
                    <a:pt x="3740034" y="431375"/>
                    <a:pt x="3782897" y="447250"/>
                    <a:pt x="3815176" y="457304"/>
                  </a:cubicBezTo>
                  <a:cubicBezTo>
                    <a:pt x="3847455" y="467358"/>
                    <a:pt x="3867564" y="472121"/>
                    <a:pt x="3900901" y="482704"/>
                  </a:cubicBezTo>
                  <a:cubicBezTo>
                    <a:pt x="3934239" y="493287"/>
                    <a:pt x="3983451" y="505987"/>
                    <a:pt x="4015201" y="520804"/>
                  </a:cubicBezTo>
                  <a:cubicBezTo>
                    <a:pt x="4046951" y="535621"/>
                    <a:pt x="4070234" y="556787"/>
                    <a:pt x="4091401" y="571604"/>
                  </a:cubicBezTo>
                  <a:cubicBezTo>
                    <a:pt x="4112568" y="586421"/>
                    <a:pt x="4134793" y="610233"/>
                    <a:pt x="4142201" y="609704"/>
                  </a:cubicBezTo>
                  <a:cubicBezTo>
                    <a:pt x="4149609" y="609175"/>
                    <a:pt x="4137968" y="583246"/>
                    <a:pt x="4135851" y="568429"/>
                  </a:cubicBezTo>
                  <a:cubicBezTo>
                    <a:pt x="4133734" y="553612"/>
                    <a:pt x="4119447" y="520275"/>
                    <a:pt x="4129501" y="520804"/>
                  </a:cubicBezTo>
                  <a:cubicBezTo>
                    <a:pt x="4139555" y="521333"/>
                    <a:pt x="4175009" y="554142"/>
                    <a:pt x="4196176" y="571604"/>
                  </a:cubicBezTo>
                  <a:cubicBezTo>
                    <a:pt x="4217343" y="589066"/>
                    <a:pt x="4236393" y="608646"/>
                    <a:pt x="4256501" y="625579"/>
                  </a:cubicBezTo>
                  <a:cubicBezTo>
                    <a:pt x="4276609" y="642512"/>
                    <a:pt x="4295659" y="660504"/>
                    <a:pt x="4316826" y="673204"/>
                  </a:cubicBezTo>
                  <a:cubicBezTo>
                    <a:pt x="4337993" y="685904"/>
                    <a:pt x="4359159" y="692254"/>
                    <a:pt x="4383501" y="701779"/>
                  </a:cubicBezTo>
                  <a:cubicBezTo>
                    <a:pt x="4407843" y="711304"/>
                    <a:pt x="4447530" y="733000"/>
                    <a:pt x="4462876" y="730354"/>
                  </a:cubicBezTo>
                  <a:cubicBezTo>
                    <a:pt x="4478222" y="727708"/>
                    <a:pt x="4473989" y="700721"/>
                    <a:pt x="4475576" y="685904"/>
                  </a:cubicBezTo>
                  <a:cubicBezTo>
                    <a:pt x="4477163" y="671087"/>
                    <a:pt x="4478222" y="649921"/>
                    <a:pt x="4472401" y="641454"/>
                  </a:cubicBezTo>
                  <a:cubicBezTo>
                    <a:pt x="4466580" y="632987"/>
                    <a:pt x="4458113" y="643571"/>
                    <a:pt x="4440651" y="635104"/>
                  </a:cubicBezTo>
                  <a:cubicBezTo>
                    <a:pt x="4423189" y="626637"/>
                    <a:pt x="4390380" y="603354"/>
                    <a:pt x="4367626" y="590654"/>
                  </a:cubicBezTo>
                  <a:cubicBezTo>
                    <a:pt x="4344872" y="577954"/>
                    <a:pt x="4323705" y="567900"/>
                    <a:pt x="4304126" y="558904"/>
                  </a:cubicBezTo>
                  <a:cubicBezTo>
                    <a:pt x="4284547" y="549908"/>
                    <a:pt x="4260205" y="544616"/>
                    <a:pt x="4250151" y="536679"/>
                  </a:cubicBezTo>
                  <a:cubicBezTo>
                    <a:pt x="4240097" y="528742"/>
                    <a:pt x="4254913" y="523979"/>
                    <a:pt x="4243801" y="511279"/>
                  </a:cubicBezTo>
                  <a:cubicBezTo>
                    <a:pt x="4232689" y="498579"/>
                    <a:pt x="4183476" y="460479"/>
                    <a:pt x="4183476" y="460479"/>
                  </a:cubicBezTo>
                  <a:cubicBezTo>
                    <a:pt x="4164426" y="444604"/>
                    <a:pt x="4146434" y="432962"/>
                    <a:pt x="4129501" y="416029"/>
                  </a:cubicBezTo>
                  <a:cubicBezTo>
                    <a:pt x="4112568" y="399096"/>
                    <a:pt x="4105159" y="376871"/>
                    <a:pt x="4081876" y="358879"/>
                  </a:cubicBezTo>
                  <a:cubicBezTo>
                    <a:pt x="4058593" y="340887"/>
                    <a:pt x="4018905" y="324483"/>
                    <a:pt x="3989801" y="308079"/>
                  </a:cubicBezTo>
                  <a:cubicBezTo>
                    <a:pt x="3960697" y="291675"/>
                    <a:pt x="3932651" y="281621"/>
                    <a:pt x="3907251" y="260454"/>
                  </a:cubicBezTo>
                  <a:cubicBezTo>
                    <a:pt x="3881851" y="239287"/>
                    <a:pt x="3869151" y="204362"/>
                    <a:pt x="3837401" y="181079"/>
                  </a:cubicBezTo>
                  <a:cubicBezTo>
                    <a:pt x="3805651" y="157796"/>
                    <a:pt x="3753264" y="133983"/>
                    <a:pt x="3716751" y="120754"/>
                  </a:cubicBezTo>
                  <a:cubicBezTo>
                    <a:pt x="3680239" y="107525"/>
                    <a:pt x="3654309" y="109112"/>
                    <a:pt x="3618326" y="101704"/>
                  </a:cubicBezTo>
                  <a:cubicBezTo>
                    <a:pt x="3582343" y="94296"/>
                    <a:pt x="3545301" y="82654"/>
                    <a:pt x="3500851" y="76304"/>
                  </a:cubicBezTo>
                  <a:cubicBezTo>
                    <a:pt x="3456401" y="69954"/>
                    <a:pt x="3397663" y="69425"/>
                    <a:pt x="3351626" y="63604"/>
                  </a:cubicBezTo>
                  <a:cubicBezTo>
                    <a:pt x="3305589" y="57783"/>
                    <a:pt x="3269076" y="47729"/>
                    <a:pt x="3224626" y="41379"/>
                  </a:cubicBezTo>
                  <a:cubicBezTo>
                    <a:pt x="3180176" y="35029"/>
                    <a:pt x="3084926" y="25504"/>
                    <a:pt x="3084926" y="25504"/>
                  </a:cubicBezTo>
                  <a:cubicBezTo>
                    <a:pt x="3035184" y="19683"/>
                    <a:pt x="2969568" y="3279"/>
                    <a:pt x="2926176" y="6454"/>
                  </a:cubicBezTo>
                  <a:cubicBezTo>
                    <a:pt x="2882784" y="9629"/>
                    <a:pt x="2862147" y="38204"/>
                    <a:pt x="2824576" y="44554"/>
                  </a:cubicBezTo>
                  <a:cubicBezTo>
                    <a:pt x="2787005" y="50904"/>
                    <a:pt x="2739380" y="45083"/>
                    <a:pt x="2700751" y="44554"/>
                  </a:cubicBezTo>
                  <a:cubicBezTo>
                    <a:pt x="2662122" y="44025"/>
                    <a:pt x="2634605" y="39792"/>
                    <a:pt x="2592801" y="41379"/>
                  </a:cubicBezTo>
                  <a:cubicBezTo>
                    <a:pt x="2550997" y="42966"/>
                    <a:pt x="2492788" y="54079"/>
                    <a:pt x="2449926" y="54079"/>
                  </a:cubicBezTo>
                  <a:cubicBezTo>
                    <a:pt x="2407064" y="54079"/>
                    <a:pt x="2367376" y="46141"/>
                    <a:pt x="2335626" y="41379"/>
                  </a:cubicBezTo>
                  <a:cubicBezTo>
                    <a:pt x="2303876" y="36617"/>
                    <a:pt x="2281651" y="29208"/>
                    <a:pt x="2259426" y="25504"/>
                  </a:cubicBezTo>
                  <a:cubicBezTo>
                    <a:pt x="2237201" y="21800"/>
                    <a:pt x="2223972" y="22858"/>
                    <a:pt x="2202276" y="19154"/>
                  </a:cubicBezTo>
                  <a:cubicBezTo>
                    <a:pt x="2180580" y="15450"/>
                    <a:pt x="2150947" y="5925"/>
                    <a:pt x="2129251" y="3279"/>
                  </a:cubicBezTo>
                  <a:cubicBezTo>
                    <a:pt x="2107555" y="633"/>
                    <a:pt x="2082155" y="-2542"/>
                    <a:pt x="2072101" y="3279"/>
                  </a:cubicBezTo>
                  <a:cubicBezTo>
                    <a:pt x="2062047" y="9100"/>
                    <a:pt x="2074218" y="18625"/>
                    <a:pt x="2068926" y="38204"/>
                  </a:cubicBezTo>
                  <a:cubicBezTo>
                    <a:pt x="2063634" y="57783"/>
                    <a:pt x="2048289" y="99587"/>
                    <a:pt x="2040351" y="120754"/>
                  </a:cubicBezTo>
                  <a:cubicBezTo>
                    <a:pt x="2032414" y="141921"/>
                    <a:pt x="2037705" y="157796"/>
                    <a:pt x="2021301" y="165204"/>
                  </a:cubicBezTo>
                  <a:cubicBezTo>
                    <a:pt x="2004897" y="172612"/>
                    <a:pt x="1960976" y="162029"/>
                    <a:pt x="1941926" y="165204"/>
                  </a:cubicBezTo>
                  <a:cubicBezTo>
                    <a:pt x="1922876" y="168379"/>
                    <a:pt x="1917055" y="181079"/>
                    <a:pt x="1907001" y="184254"/>
                  </a:cubicBezTo>
                  <a:cubicBezTo>
                    <a:pt x="1896947" y="187429"/>
                    <a:pt x="1893243" y="189546"/>
                    <a:pt x="1881601" y="184254"/>
                  </a:cubicBezTo>
                  <a:cubicBezTo>
                    <a:pt x="1869959" y="178962"/>
                    <a:pt x="1851438" y="160441"/>
                    <a:pt x="1837151" y="152504"/>
                  </a:cubicBezTo>
                  <a:cubicBezTo>
                    <a:pt x="1822864" y="144567"/>
                    <a:pt x="1808576" y="146683"/>
                    <a:pt x="1795876" y="136629"/>
                  </a:cubicBezTo>
                  <a:cubicBezTo>
                    <a:pt x="1783176" y="126575"/>
                    <a:pt x="1777884" y="99587"/>
                    <a:pt x="1760951" y="92179"/>
                  </a:cubicBezTo>
                  <a:cubicBezTo>
                    <a:pt x="1744018" y="84771"/>
                    <a:pt x="1720205" y="86887"/>
                    <a:pt x="1694276" y="92179"/>
                  </a:cubicBezTo>
                  <a:cubicBezTo>
                    <a:pt x="1668347" y="97471"/>
                    <a:pt x="1632363" y="113346"/>
                    <a:pt x="1605376" y="123929"/>
                  </a:cubicBezTo>
                  <a:cubicBezTo>
                    <a:pt x="1578389" y="134512"/>
                    <a:pt x="1556693" y="146154"/>
                    <a:pt x="1532351" y="155679"/>
                  </a:cubicBezTo>
                  <a:cubicBezTo>
                    <a:pt x="1508009" y="165204"/>
                    <a:pt x="1482609" y="173671"/>
                    <a:pt x="1459326" y="181079"/>
                  </a:cubicBezTo>
                  <a:cubicBezTo>
                    <a:pt x="1436043" y="188487"/>
                    <a:pt x="1417522" y="190075"/>
                    <a:pt x="1392651" y="200129"/>
                  </a:cubicBezTo>
                  <a:cubicBezTo>
                    <a:pt x="1367780" y="210183"/>
                    <a:pt x="1310101" y="241404"/>
                    <a:pt x="1310101" y="241404"/>
                  </a:cubicBezTo>
                  <a:lnTo>
                    <a:pt x="1211676" y="289029"/>
                  </a:lnTo>
                  <a:cubicBezTo>
                    <a:pt x="1179926" y="304904"/>
                    <a:pt x="1146059" y="321308"/>
                    <a:pt x="1119601" y="336654"/>
                  </a:cubicBezTo>
                  <a:cubicBezTo>
                    <a:pt x="1093143" y="352000"/>
                    <a:pt x="1071447" y="368404"/>
                    <a:pt x="1052926" y="381104"/>
                  </a:cubicBezTo>
                  <a:cubicBezTo>
                    <a:pt x="1034405" y="393804"/>
                    <a:pt x="1025938" y="400683"/>
                    <a:pt x="1008476" y="412854"/>
                  </a:cubicBezTo>
                  <a:cubicBezTo>
                    <a:pt x="991014" y="425025"/>
                    <a:pt x="948151" y="454129"/>
                    <a:pt x="948151" y="454129"/>
                  </a:cubicBezTo>
                  <a:lnTo>
                    <a:pt x="862426" y="511279"/>
                  </a:lnTo>
                  <a:cubicBezTo>
                    <a:pt x="839143" y="526625"/>
                    <a:pt x="830147" y="534562"/>
                    <a:pt x="808451" y="546204"/>
                  </a:cubicBezTo>
                  <a:cubicBezTo>
                    <a:pt x="786755" y="557846"/>
                    <a:pt x="732251" y="581129"/>
                    <a:pt x="732251" y="581129"/>
                  </a:cubicBezTo>
                  <a:cubicBezTo>
                    <a:pt x="709497" y="591712"/>
                    <a:pt x="693093" y="597004"/>
                    <a:pt x="671926" y="609704"/>
                  </a:cubicBezTo>
                  <a:cubicBezTo>
                    <a:pt x="650759" y="622404"/>
                    <a:pt x="625889" y="640396"/>
                    <a:pt x="605251" y="657329"/>
                  </a:cubicBezTo>
                  <a:cubicBezTo>
                    <a:pt x="584614" y="674262"/>
                    <a:pt x="562918" y="694371"/>
                    <a:pt x="548101" y="711304"/>
                  </a:cubicBezTo>
                  <a:cubicBezTo>
                    <a:pt x="533284" y="728237"/>
                    <a:pt x="527463" y="740938"/>
                    <a:pt x="516351" y="758929"/>
                  </a:cubicBezTo>
                  <a:cubicBezTo>
                    <a:pt x="505239" y="776920"/>
                    <a:pt x="495184" y="800733"/>
                    <a:pt x="481426" y="819254"/>
                  </a:cubicBezTo>
                  <a:cubicBezTo>
                    <a:pt x="467668" y="837775"/>
                    <a:pt x="453380" y="854708"/>
                    <a:pt x="433801" y="870054"/>
                  </a:cubicBezTo>
                  <a:cubicBezTo>
                    <a:pt x="414222" y="885400"/>
                    <a:pt x="388293" y="897571"/>
                    <a:pt x="363951" y="911329"/>
                  </a:cubicBezTo>
                  <a:cubicBezTo>
                    <a:pt x="339609" y="925087"/>
                    <a:pt x="311034" y="939375"/>
                    <a:pt x="287751" y="952604"/>
                  </a:cubicBezTo>
                  <a:cubicBezTo>
                    <a:pt x="264468" y="965833"/>
                    <a:pt x="242772" y="975887"/>
                    <a:pt x="224251" y="990704"/>
                  </a:cubicBezTo>
                  <a:cubicBezTo>
                    <a:pt x="205730" y="1005521"/>
                    <a:pt x="193030" y="1026158"/>
                    <a:pt x="176626" y="1041504"/>
                  </a:cubicBezTo>
                  <a:cubicBezTo>
                    <a:pt x="160222" y="1056850"/>
                    <a:pt x="146993" y="1064258"/>
                    <a:pt x="125826" y="1082779"/>
                  </a:cubicBezTo>
                  <a:cubicBezTo>
                    <a:pt x="104659" y="1101300"/>
                    <a:pt x="65501" y="1136754"/>
                    <a:pt x="49626" y="1152629"/>
                  </a:cubicBezTo>
                  <a:cubicBezTo>
                    <a:pt x="33751" y="1168504"/>
                    <a:pt x="38514" y="1163212"/>
                    <a:pt x="30576" y="1178029"/>
                  </a:cubicBezTo>
                  <a:cubicBezTo>
                    <a:pt x="22639" y="1192846"/>
                    <a:pt x="-8053" y="1277512"/>
                    <a:pt x="2001" y="1289154"/>
                  </a:cubicBezTo>
                  <a:close/>
                </a:path>
              </a:pathLst>
            </a:custGeom>
            <a:noFill/>
            <a:ln w="38100">
              <a:solidFill>
                <a:schemeClr val="bg1"/>
              </a:solidFill>
              <a:prstDash val="sysDot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9666"/>
            </a:p>
          </p:txBody>
        </p:sp>
        <p:sp>
          <p:nvSpPr>
            <p:cNvPr id="204" name="Freeform 203"/>
            <p:cNvSpPr/>
            <p:nvPr/>
          </p:nvSpPr>
          <p:spPr>
            <a:xfrm>
              <a:off x="504825" y="2402603"/>
              <a:ext cx="4105275" cy="1185862"/>
            </a:xfrm>
            <a:custGeom>
              <a:avLst/>
              <a:gdLst>
                <a:gd name="connsiteX0" fmla="*/ 85770 w 4726800"/>
                <a:gd name="connsiteY0" fmla="*/ 1390983 h 1404165"/>
                <a:gd name="connsiteX1" fmla="*/ 200070 w 4726800"/>
                <a:gd name="connsiteY1" fmla="*/ 1324308 h 1404165"/>
                <a:gd name="connsiteX2" fmla="*/ 279445 w 4726800"/>
                <a:gd name="connsiteY2" fmla="*/ 1219533 h 1404165"/>
                <a:gd name="connsiteX3" fmla="*/ 323895 w 4726800"/>
                <a:gd name="connsiteY3" fmla="*/ 1117933 h 1404165"/>
                <a:gd name="connsiteX4" fmla="*/ 425495 w 4726800"/>
                <a:gd name="connsiteY4" fmla="*/ 987758 h 1404165"/>
                <a:gd name="connsiteX5" fmla="*/ 514395 w 4726800"/>
                <a:gd name="connsiteY5" fmla="*/ 921083 h 1404165"/>
                <a:gd name="connsiteX6" fmla="*/ 663620 w 4726800"/>
                <a:gd name="connsiteY6" fmla="*/ 806783 h 1404165"/>
                <a:gd name="connsiteX7" fmla="*/ 787445 w 4726800"/>
                <a:gd name="connsiteY7" fmla="*/ 714708 h 1404165"/>
                <a:gd name="connsiteX8" fmla="*/ 927145 w 4726800"/>
                <a:gd name="connsiteY8" fmla="*/ 648033 h 1404165"/>
                <a:gd name="connsiteX9" fmla="*/ 1057320 w 4726800"/>
                <a:gd name="connsiteY9" fmla="*/ 587708 h 1404165"/>
                <a:gd name="connsiteX10" fmla="*/ 1228770 w 4726800"/>
                <a:gd name="connsiteY10" fmla="*/ 479758 h 1404165"/>
                <a:gd name="connsiteX11" fmla="*/ 1355770 w 4726800"/>
                <a:gd name="connsiteY11" fmla="*/ 432133 h 1404165"/>
                <a:gd name="connsiteX12" fmla="*/ 1504995 w 4726800"/>
                <a:gd name="connsiteY12" fmla="*/ 416258 h 1404165"/>
                <a:gd name="connsiteX13" fmla="*/ 1571670 w 4726800"/>
                <a:gd name="connsiteY13" fmla="*/ 397208 h 1404165"/>
                <a:gd name="connsiteX14" fmla="*/ 1651045 w 4726800"/>
                <a:gd name="connsiteY14" fmla="*/ 352758 h 1404165"/>
                <a:gd name="connsiteX15" fmla="*/ 1752645 w 4726800"/>
                <a:gd name="connsiteY15" fmla="*/ 321008 h 1404165"/>
                <a:gd name="connsiteX16" fmla="*/ 1822495 w 4726800"/>
                <a:gd name="connsiteY16" fmla="*/ 282908 h 1404165"/>
                <a:gd name="connsiteX17" fmla="*/ 1920920 w 4726800"/>
                <a:gd name="connsiteY17" fmla="*/ 254333 h 1404165"/>
                <a:gd name="connsiteX18" fmla="*/ 2025695 w 4726800"/>
                <a:gd name="connsiteY18" fmla="*/ 238458 h 1404165"/>
                <a:gd name="connsiteX19" fmla="*/ 2114595 w 4726800"/>
                <a:gd name="connsiteY19" fmla="*/ 216233 h 1404165"/>
                <a:gd name="connsiteX20" fmla="*/ 2232070 w 4726800"/>
                <a:gd name="connsiteY20" fmla="*/ 213058 h 1404165"/>
                <a:gd name="connsiteX21" fmla="*/ 2320970 w 4726800"/>
                <a:gd name="connsiteY21" fmla="*/ 213058 h 1404165"/>
                <a:gd name="connsiteX22" fmla="*/ 2403520 w 4726800"/>
                <a:gd name="connsiteY22" fmla="*/ 187658 h 1404165"/>
                <a:gd name="connsiteX23" fmla="*/ 2501945 w 4726800"/>
                <a:gd name="connsiteY23" fmla="*/ 159083 h 1404165"/>
                <a:gd name="connsiteX24" fmla="*/ 2584495 w 4726800"/>
                <a:gd name="connsiteY24" fmla="*/ 146383 h 1404165"/>
                <a:gd name="connsiteX25" fmla="*/ 2657520 w 4726800"/>
                <a:gd name="connsiteY25" fmla="*/ 168608 h 1404165"/>
                <a:gd name="connsiteX26" fmla="*/ 2759120 w 4726800"/>
                <a:gd name="connsiteY26" fmla="*/ 174958 h 1404165"/>
                <a:gd name="connsiteX27" fmla="*/ 2838495 w 4726800"/>
                <a:gd name="connsiteY27" fmla="*/ 162258 h 1404165"/>
                <a:gd name="connsiteX28" fmla="*/ 2911520 w 4726800"/>
                <a:gd name="connsiteY28" fmla="*/ 155908 h 1404165"/>
                <a:gd name="connsiteX29" fmla="*/ 2987720 w 4726800"/>
                <a:gd name="connsiteY29" fmla="*/ 168608 h 1404165"/>
                <a:gd name="connsiteX30" fmla="*/ 3089320 w 4726800"/>
                <a:gd name="connsiteY30" fmla="*/ 187658 h 1404165"/>
                <a:gd name="connsiteX31" fmla="*/ 3181395 w 4726800"/>
                <a:gd name="connsiteY31" fmla="*/ 225758 h 1404165"/>
                <a:gd name="connsiteX32" fmla="*/ 3273470 w 4726800"/>
                <a:gd name="connsiteY32" fmla="*/ 254333 h 1404165"/>
                <a:gd name="connsiteX33" fmla="*/ 3336970 w 4726800"/>
                <a:gd name="connsiteY33" fmla="*/ 276558 h 1404165"/>
                <a:gd name="connsiteX34" fmla="*/ 3438570 w 4726800"/>
                <a:gd name="connsiteY34" fmla="*/ 301958 h 1404165"/>
                <a:gd name="connsiteX35" fmla="*/ 3524295 w 4726800"/>
                <a:gd name="connsiteY35" fmla="*/ 279733 h 1404165"/>
                <a:gd name="connsiteX36" fmla="*/ 3581445 w 4726800"/>
                <a:gd name="connsiteY36" fmla="*/ 295608 h 1404165"/>
                <a:gd name="connsiteX37" fmla="*/ 3619545 w 4726800"/>
                <a:gd name="connsiteY37" fmla="*/ 340058 h 1404165"/>
                <a:gd name="connsiteX38" fmla="*/ 3686220 w 4726800"/>
                <a:gd name="connsiteY38" fmla="*/ 413083 h 1404165"/>
                <a:gd name="connsiteX39" fmla="*/ 3737020 w 4726800"/>
                <a:gd name="connsiteY39" fmla="*/ 467058 h 1404165"/>
                <a:gd name="connsiteX40" fmla="*/ 3787820 w 4726800"/>
                <a:gd name="connsiteY40" fmla="*/ 482933 h 1404165"/>
                <a:gd name="connsiteX41" fmla="*/ 3898945 w 4726800"/>
                <a:gd name="connsiteY41" fmla="*/ 473408 h 1404165"/>
                <a:gd name="connsiteX42" fmla="*/ 4000545 w 4726800"/>
                <a:gd name="connsiteY42" fmla="*/ 473408 h 1404165"/>
                <a:gd name="connsiteX43" fmla="*/ 4105320 w 4726800"/>
                <a:gd name="connsiteY43" fmla="*/ 489283 h 1404165"/>
                <a:gd name="connsiteX44" fmla="*/ 4210095 w 4726800"/>
                <a:gd name="connsiteY44" fmla="*/ 568658 h 1404165"/>
                <a:gd name="connsiteX45" fmla="*/ 4302170 w 4726800"/>
                <a:gd name="connsiteY45" fmla="*/ 609933 h 1404165"/>
                <a:gd name="connsiteX46" fmla="*/ 4381545 w 4726800"/>
                <a:gd name="connsiteY46" fmla="*/ 660733 h 1404165"/>
                <a:gd name="connsiteX47" fmla="*/ 4451395 w 4726800"/>
                <a:gd name="connsiteY47" fmla="*/ 736933 h 1404165"/>
                <a:gd name="connsiteX48" fmla="*/ 4505370 w 4726800"/>
                <a:gd name="connsiteY48" fmla="*/ 800433 h 1404165"/>
                <a:gd name="connsiteX49" fmla="*/ 4562520 w 4726800"/>
                <a:gd name="connsiteY49" fmla="*/ 870283 h 1404165"/>
                <a:gd name="connsiteX50" fmla="*/ 4603795 w 4726800"/>
                <a:gd name="connsiteY50" fmla="*/ 936958 h 1404165"/>
                <a:gd name="connsiteX51" fmla="*/ 4657770 w 4726800"/>
                <a:gd name="connsiteY51" fmla="*/ 1006808 h 1404165"/>
                <a:gd name="connsiteX52" fmla="*/ 4702220 w 4726800"/>
                <a:gd name="connsiteY52" fmla="*/ 1009983 h 1404165"/>
                <a:gd name="connsiteX53" fmla="*/ 4721270 w 4726800"/>
                <a:gd name="connsiteY53" fmla="*/ 978233 h 1404165"/>
                <a:gd name="connsiteX54" fmla="*/ 4724445 w 4726800"/>
                <a:gd name="connsiteY54" fmla="*/ 841708 h 1404165"/>
                <a:gd name="connsiteX55" fmla="*/ 4689520 w 4726800"/>
                <a:gd name="connsiteY55" fmla="*/ 822658 h 1404165"/>
                <a:gd name="connsiteX56" fmla="*/ 4660945 w 4726800"/>
                <a:gd name="connsiteY56" fmla="*/ 867108 h 1404165"/>
                <a:gd name="connsiteX57" fmla="*/ 4610145 w 4726800"/>
                <a:gd name="connsiteY57" fmla="*/ 800433 h 1404165"/>
                <a:gd name="connsiteX58" fmla="*/ 4575220 w 4726800"/>
                <a:gd name="connsiteY58" fmla="*/ 654383 h 1404165"/>
                <a:gd name="connsiteX59" fmla="*/ 4572045 w 4726800"/>
                <a:gd name="connsiteY59" fmla="*/ 543258 h 1404165"/>
                <a:gd name="connsiteX60" fmla="*/ 4572045 w 4726800"/>
                <a:gd name="connsiteY60" fmla="*/ 454358 h 1404165"/>
                <a:gd name="connsiteX61" fmla="*/ 4530770 w 4726800"/>
                <a:gd name="connsiteY61" fmla="*/ 425783 h 1404165"/>
                <a:gd name="connsiteX62" fmla="*/ 4454570 w 4726800"/>
                <a:gd name="connsiteY62" fmla="*/ 413083 h 1404165"/>
                <a:gd name="connsiteX63" fmla="*/ 4470445 w 4726800"/>
                <a:gd name="connsiteY63" fmla="*/ 489283 h 1404165"/>
                <a:gd name="connsiteX64" fmla="*/ 4476795 w 4726800"/>
                <a:gd name="connsiteY64" fmla="*/ 536908 h 1404165"/>
                <a:gd name="connsiteX65" fmla="*/ 4327570 w 4726800"/>
                <a:gd name="connsiteY65" fmla="*/ 486108 h 1404165"/>
                <a:gd name="connsiteX66" fmla="*/ 4302170 w 4726800"/>
                <a:gd name="connsiteY66" fmla="*/ 479758 h 1404165"/>
                <a:gd name="connsiteX67" fmla="*/ 4273595 w 4726800"/>
                <a:gd name="connsiteY67" fmla="*/ 374983 h 1404165"/>
                <a:gd name="connsiteX68" fmla="*/ 4184695 w 4726800"/>
                <a:gd name="connsiteY68" fmla="*/ 317833 h 1404165"/>
                <a:gd name="connsiteX69" fmla="*/ 4105320 w 4726800"/>
                <a:gd name="connsiteY69" fmla="*/ 289258 h 1404165"/>
                <a:gd name="connsiteX70" fmla="*/ 4016420 w 4726800"/>
                <a:gd name="connsiteY70" fmla="*/ 241633 h 1404165"/>
                <a:gd name="connsiteX71" fmla="*/ 3895770 w 4726800"/>
                <a:gd name="connsiteY71" fmla="*/ 174958 h 1404165"/>
                <a:gd name="connsiteX72" fmla="*/ 3787820 w 4726800"/>
                <a:gd name="connsiteY72" fmla="*/ 149558 h 1404165"/>
                <a:gd name="connsiteX73" fmla="*/ 3689395 w 4726800"/>
                <a:gd name="connsiteY73" fmla="*/ 130508 h 1404165"/>
                <a:gd name="connsiteX74" fmla="*/ 3517945 w 4726800"/>
                <a:gd name="connsiteY74" fmla="*/ 79708 h 1404165"/>
                <a:gd name="connsiteX75" fmla="*/ 3429045 w 4726800"/>
                <a:gd name="connsiteY75" fmla="*/ 73358 h 1404165"/>
                <a:gd name="connsiteX76" fmla="*/ 3289345 w 4726800"/>
                <a:gd name="connsiteY76" fmla="*/ 54308 h 1404165"/>
                <a:gd name="connsiteX77" fmla="*/ 3209970 w 4726800"/>
                <a:gd name="connsiteY77" fmla="*/ 57483 h 1404165"/>
                <a:gd name="connsiteX78" fmla="*/ 3105195 w 4726800"/>
                <a:gd name="connsiteY78" fmla="*/ 41608 h 1404165"/>
                <a:gd name="connsiteX79" fmla="*/ 2978195 w 4726800"/>
                <a:gd name="connsiteY79" fmla="*/ 47958 h 1404165"/>
                <a:gd name="connsiteX80" fmla="*/ 2848020 w 4726800"/>
                <a:gd name="connsiteY80" fmla="*/ 41608 h 1404165"/>
                <a:gd name="connsiteX81" fmla="*/ 2667045 w 4726800"/>
                <a:gd name="connsiteY81" fmla="*/ 9858 h 1404165"/>
                <a:gd name="connsiteX82" fmla="*/ 2590845 w 4726800"/>
                <a:gd name="connsiteY82" fmla="*/ 333 h 1404165"/>
                <a:gd name="connsiteX83" fmla="*/ 2482895 w 4726800"/>
                <a:gd name="connsiteY83" fmla="*/ 19383 h 1404165"/>
                <a:gd name="connsiteX84" fmla="*/ 2359070 w 4726800"/>
                <a:gd name="connsiteY84" fmla="*/ 67008 h 1404165"/>
                <a:gd name="connsiteX85" fmla="*/ 2232070 w 4726800"/>
                <a:gd name="connsiteY85" fmla="*/ 101933 h 1404165"/>
                <a:gd name="connsiteX86" fmla="*/ 2133645 w 4726800"/>
                <a:gd name="connsiteY86" fmla="*/ 117808 h 1404165"/>
                <a:gd name="connsiteX87" fmla="*/ 2025695 w 4726800"/>
                <a:gd name="connsiteY87" fmla="*/ 143208 h 1404165"/>
                <a:gd name="connsiteX88" fmla="*/ 1920920 w 4726800"/>
                <a:gd name="connsiteY88" fmla="*/ 124158 h 1404165"/>
                <a:gd name="connsiteX89" fmla="*/ 1800270 w 4726800"/>
                <a:gd name="connsiteY89" fmla="*/ 168608 h 1404165"/>
                <a:gd name="connsiteX90" fmla="*/ 1670095 w 4726800"/>
                <a:gd name="connsiteY90" fmla="*/ 209883 h 1404165"/>
                <a:gd name="connsiteX91" fmla="*/ 1571670 w 4726800"/>
                <a:gd name="connsiteY91" fmla="*/ 222583 h 1404165"/>
                <a:gd name="connsiteX92" fmla="*/ 1447845 w 4726800"/>
                <a:gd name="connsiteY92" fmla="*/ 238458 h 1404165"/>
                <a:gd name="connsiteX93" fmla="*/ 1308145 w 4726800"/>
                <a:gd name="connsiteY93" fmla="*/ 270208 h 1404165"/>
                <a:gd name="connsiteX94" fmla="*/ 1174795 w 4726800"/>
                <a:gd name="connsiteY94" fmla="*/ 330533 h 1404165"/>
                <a:gd name="connsiteX95" fmla="*/ 1050970 w 4726800"/>
                <a:gd name="connsiteY95" fmla="*/ 381333 h 1404165"/>
                <a:gd name="connsiteX96" fmla="*/ 943020 w 4726800"/>
                <a:gd name="connsiteY96" fmla="*/ 425783 h 1404165"/>
                <a:gd name="connsiteX97" fmla="*/ 844595 w 4726800"/>
                <a:gd name="connsiteY97" fmla="*/ 476583 h 1404165"/>
                <a:gd name="connsiteX98" fmla="*/ 739820 w 4726800"/>
                <a:gd name="connsiteY98" fmla="*/ 533733 h 1404165"/>
                <a:gd name="connsiteX99" fmla="*/ 660445 w 4726800"/>
                <a:gd name="connsiteY99" fmla="*/ 594058 h 1404165"/>
                <a:gd name="connsiteX100" fmla="*/ 555670 w 4726800"/>
                <a:gd name="connsiteY100" fmla="*/ 654383 h 1404165"/>
                <a:gd name="connsiteX101" fmla="*/ 412795 w 4726800"/>
                <a:gd name="connsiteY101" fmla="*/ 743283 h 1404165"/>
                <a:gd name="connsiteX102" fmla="*/ 365170 w 4726800"/>
                <a:gd name="connsiteY102" fmla="*/ 784558 h 1404165"/>
                <a:gd name="connsiteX103" fmla="*/ 288970 w 4726800"/>
                <a:gd name="connsiteY103" fmla="*/ 819483 h 1404165"/>
                <a:gd name="connsiteX104" fmla="*/ 190545 w 4726800"/>
                <a:gd name="connsiteY104" fmla="*/ 870283 h 1404165"/>
                <a:gd name="connsiteX105" fmla="*/ 92120 w 4726800"/>
                <a:gd name="connsiteY105" fmla="*/ 933783 h 1404165"/>
                <a:gd name="connsiteX106" fmla="*/ 15920 w 4726800"/>
                <a:gd name="connsiteY106" fmla="*/ 1063958 h 1404165"/>
                <a:gd name="connsiteX107" fmla="*/ 15920 w 4726800"/>
                <a:gd name="connsiteY107" fmla="*/ 1168733 h 1404165"/>
                <a:gd name="connsiteX108" fmla="*/ 6395 w 4726800"/>
                <a:gd name="connsiteY108" fmla="*/ 1206833 h 1404165"/>
                <a:gd name="connsiteX109" fmla="*/ 45 w 4726800"/>
                <a:gd name="connsiteY109" fmla="*/ 1302083 h 1404165"/>
                <a:gd name="connsiteX110" fmla="*/ 9570 w 4726800"/>
                <a:gd name="connsiteY110" fmla="*/ 1394158 h 1404165"/>
                <a:gd name="connsiteX111" fmla="*/ 85770 w 4726800"/>
                <a:gd name="connsiteY111" fmla="*/ 1390983 h 140416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  <a:cxn ang="0">
                  <a:pos x="connsiteX29" y="connsiteY29"/>
                </a:cxn>
                <a:cxn ang="0">
                  <a:pos x="connsiteX30" y="connsiteY30"/>
                </a:cxn>
                <a:cxn ang="0">
                  <a:pos x="connsiteX31" y="connsiteY31"/>
                </a:cxn>
                <a:cxn ang="0">
                  <a:pos x="connsiteX32" y="connsiteY32"/>
                </a:cxn>
                <a:cxn ang="0">
                  <a:pos x="connsiteX33" y="connsiteY33"/>
                </a:cxn>
                <a:cxn ang="0">
                  <a:pos x="connsiteX34" y="connsiteY34"/>
                </a:cxn>
                <a:cxn ang="0">
                  <a:pos x="connsiteX35" y="connsiteY35"/>
                </a:cxn>
                <a:cxn ang="0">
                  <a:pos x="connsiteX36" y="connsiteY36"/>
                </a:cxn>
                <a:cxn ang="0">
                  <a:pos x="connsiteX37" y="connsiteY37"/>
                </a:cxn>
                <a:cxn ang="0">
                  <a:pos x="connsiteX38" y="connsiteY38"/>
                </a:cxn>
                <a:cxn ang="0">
                  <a:pos x="connsiteX39" y="connsiteY39"/>
                </a:cxn>
                <a:cxn ang="0">
                  <a:pos x="connsiteX40" y="connsiteY40"/>
                </a:cxn>
                <a:cxn ang="0">
                  <a:pos x="connsiteX41" y="connsiteY41"/>
                </a:cxn>
                <a:cxn ang="0">
                  <a:pos x="connsiteX42" y="connsiteY42"/>
                </a:cxn>
                <a:cxn ang="0">
                  <a:pos x="connsiteX43" y="connsiteY43"/>
                </a:cxn>
                <a:cxn ang="0">
                  <a:pos x="connsiteX44" y="connsiteY44"/>
                </a:cxn>
                <a:cxn ang="0">
                  <a:pos x="connsiteX45" y="connsiteY45"/>
                </a:cxn>
                <a:cxn ang="0">
                  <a:pos x="connsiteX46" y="connsiteY46"/>
                </a:cxn>
                <a:cxn ang="0">
                  <a:pos x="connsiteX47" y="connsiteY47"/>
                </a:cxn>
                <a:cxn ang="0">
                  <a:pos x="connsiteX48" y="connsiteY48"/>
                </a:cxn>
                <a:cxn ang="0">
                  <a:pos x="connsiteX49" y="connsiteY49"/>
                </a:cxn>
                <a:cxn ang="0">
                  <a:pos x="connsiteX50" y="connsiteY50"/>
                </a:cxn>
                <a:cxn ang="0">
                  <a:pos x="connsiteX51" y="connsiteY51"/>
                </a:cxn>
                <a:cxn ang="0">
                  <a:pos x="connsiteX52" y="connsiteY52"/>
                </a:cxn>
                <a:cxn ang="0">
                  <a:pos x="connsiteX53" y="connsiteY53"/>
                </a:cxn>
                <a:cxn ang="0">
                  <a:pos x="connsiteX54" y="connsiteY54"/>
                </a:cxn>
                <a:cxn ang="0">
                  <a:pos x="connsiteX55" y="connsiteY55"/>
                </a:cxn>
                <a:cxn ang="0">
                  <a:pos x="connsiteX56" y="connsiteY56"/>
                </a:cxn>
                <a:cxn ang="0">
                  <a:pos x="connsiteX57" y="connsiteY57"/>
                </a:cxn>
                <a:cxn ang="0">
                  <a:pos x="connsiteX58" y="connsiteY58"/>
                </a:cxn>
                <a:cxn ang="0">
                  <a:pos x="connsiteX59" y="connsiteY59"/>
                </a:cxn>
                <a:cxn ang="0">
                  <a:pos x="connsiteX60" y="connsiteY60"/>
                </a:cxn>
                <a:cxn ang="0">
                  <a:pos x="connsiteX61" y="connsiteY61"/>
                </a:cxn>
                <a:cxn ang="0">
                  <a:pos x="connsiteX62" y="connsiteY62"/>
                </a:cxn>
                <a:cxn ang="0">
                  <a:pos x="connsiteX63" y="connsiteY63"/>
                </a:cxn>
                <a:cxn ang="0">
                  <a:pos x="connsiteX64" y="connsiteY64"/>
                </a:cxn>
                <a:cxn ang="0">
                  <a:pos x="connsiteX65" y="connsiteY65"/>
                </a:cxn>
                <a:cxn ang="0">
                  <a:pos x="connsiteX66" y="connsiteY66"/>
                </a:cxn>
                <a:cxn ang="0">
                  <a:pos x="connsiteX67" y="connsiteY67"/>
                </a:cxn>
                <a:cxn ang="0">
                  <a:pos x="connsiteX68" y="connsiteY68"/>
                </a:cxn>
                <a:cxn ang="0">
                  <a:pos x="connsiteX69" y="connsiteY69"/>
                </a:cxn>
                <a:cxn ang="0">
                  <a:pos x="connsiteX70" y="connsiteY70"/>
                </a:cxn>
                <a:cxn ang="0">
                  <a:pos x="connsiteX71" y="connsiteY71"/>
                </a:cxn>
                <a:cxn ang="0">
                  <a:pos x="connsiteX72" y="connsiteY72"/>
                </a:cxn>
                <a:cxn ang="0">
                  <a:pos x="connsiteX73" y="connsiteY73"/>
                </a:cxn>
                <a:cxn ang="0">
                  <a:pos x="connsiteX74" y="connsiteY74"/>
                </a:cxn>
                <a:cxn ang="0">
                  <a:pos x="connsiteX75" y="connsiteY75"/>
                </a:cxn>
                <a:cxn ang="0">
                  <a:pos x="connsiteX76" y="connsiteY76"/>
                </a:cxn>
                <a:cxn ang="0">
                  <a:pos x="connsiteX77" y="connsiteY77"/>
                </a:cxn>
                <a:cxn ang="0">
                  <a:pos x="connsiteX78" y="connsiteY78"/>
                </a:cxn>
                <a:cxn ang="0">
                  <a:pos x="connsiteX79" y="connsiteY79"/>
                </a:cxn>
                <a:cxn ang="0">
                  <a:pos x="connsiteX80" y="connsiteY80"/>
                </a:cxn>
                <a:cxn ang="0">
                  <a:pos x="connsiteX81" y="connsiteY81"/>
                </a:cxn>
                <a:cxn ang="0">
                  <a:pos x="connsiteX82" y="connsiteY82"/>
                </a:cxn>
                <a:cxn ang="0">
                  <a:pos x="connsiteX83" y="connsiteY83"/>
                </a:cxn>
                <a:cxn ang="0">
                  <a:pos x="connsiteX84" y="connsiteY84"/>
                </a:cxn>
                <a:cxn ang="0">
                  <a:pos x="connsiteX85" y="connsiteY85"/>
                </a:cxn>
                <a:cxn ang="0">
                  <a:pos x="connsiteX86" y="connsiteY86"/>
                </a:cxn>
                <a:cxn ang="0">
                  <a:pos x="connsiteX87" y="connsiteY87"/>
                </a:cxn>
                <a:cxn ang="0">
                  <a:pos x="connsiteX88" y="connsiteY88"/>
                </a:cxn>
                <a:cxn ang="0">
                  <a:pos x="connsiteX89" y="connsiteY89"/>
                </a:cxn>
                <a:cxn ang="0">
                  <a:pos x="connsiteX90" y="connsiteY90"/>
                </a:cxn>
                <a:cxn ang="0">
                  <a:pos x="connsiteX91" y="connsiteY91"/>
                </a:cxn>
                <a:cxn ang="0">
                  <a:pos x="connsiteX92" y="connsiteY92"/>
                </a:cxn>
                <a:cxn ang="0">
                  <a:pos x="connsiteX93" y="connsiteY93"/>
                </a:cxn>
                <a:cxn ang="0">
                  <a:pos x="connsiteX94" y="connsiteY94"/>
                </a:cxn>
                <a:cxn ang="0">
                  <a:pos x="connsiteX95" y="connsiteY95"/>
                </a:cxn>
                <a:cxn ang="0">
                  <a:pos x="connsiteX96" y="connsiteY96"/>
                </a:cxn>
                <a:cxn ang="0">
                  <a:pos x="connsiteX97" y="connsiteY97"/>
                </a:cxn>
                <a:cxn ang="0">
                  <a:pos x="connsiteX98" y="connsiteY98"/>
                </a:cxn>
                <a:cxn ang="0">
                  <a:pos x="connsiteX99" y="connsiteY99"/>
                </a:cxn>
                <a:cxn ang="0">
                  <a:pos x="connsiteX100" y="connsiteY100"/>
                </a:cxn>
                <a:cxn ang="0">
                  <a:pos x="connsiteX101" y="connsiteY101"/>
                </a:cxn>
                <a:cxn ang="0">
                  <a:pos x="connsiteX102" y="connsiteY102"/>
                </a:cxn>
                <a:cxn ang="0">
                  <a:pos x="connsiteX103" y="connsiteY103"/>
                </a:cxn>
                <a:cxn ang="0">
                  <a:pos x="connsiteX104" y="connsiteY104"/>
                </a:cxn>
                <a:cxn ang="0">
                  <a:pos x="connsiteX105" y="connsiteY105"/>
                </a:cxn>
                <a:cxn ang="0">
                  <a:pos x="connsiteX106" y="connsiteY106"/>
                </a:cxn>
                <a:cxn ang="0">
                  <a:pos x="connsiteX107" y="connsiteY107"/>
                </a:cxn>
                <a:cxn ang="0">
                  <a:pos x="connsiteX108" y="connsiteY108"/>
                </a:cxn>
                <a:cxn ang="0">
                  <a:pos x="connsiteX109" y="connsiteY109"/>
                </a:cxn>
                <a:cxn ang="0">
                  <a:pos x="connsiteX110" y="connsiteY110"/>
                </a:cxn>
                <a:cxn ang="0">
                  <a:pos x="connsiteX111" y="connsiteY111"/>
                </a:cxn>
              </a:cxnLst>
              <a:rect l="l" t="t" r="r" b="b"/>
              <a:pathLst>
                <a:path w="4726800" h="1404165">
                  <a:moveTo>
                    <a:pt x="85770" y="1390983"/>
                  </a:moveTo>
                  <a:cubicBezTo>
                    <a:pt x="117520" y="1379341"/>
                    <a:pt x="167791" y="1352883"/>
                    <a:pt x="200070" y="1324308"/>
                  </a:cubicBezTo>
                  <a:cubicBezTo>
                    <a:pt x="232349" y="1295733"/>
                    <a:pt x="258808" y="1253929"/>
                    <a:pt x="279445" y="1219533"/>
                  </a:cubicBezTo>
                  <a:cubicBezTo>
                    <a:pt x="300082" y="1185137"/>
                    <a:pt x="299553" y="1156562"/>
                    <a:pt x="323895" y="1117933"/>
                  </a:cubicBezTo>
                  <a:cubicBezTo>
                    <a:pt x="348237" y="1079304"/>
                    <a:pt x="393745" y="1020566"/>
                    <a:pt x="425495" y="987758"/>
                  </a:cubicBezTo>
                  <a:cubicBezTo>
                    <a:pt x="457245" y="954950"/>
                    <a:pt x="514395" y="921083"/>
                    <a:pt x="514395" y="921083"/>
                  </a:cubicBezTo>
                  <a:lnTo>
                    <a:pt x="663620" y="806783"/>
                  </a:lnTo>
                  <a:cubicBezTo>
                    <a:pt x="709128" y="772387"/>
                    <a:pt x="743524" y="741166"/>
                    <a:pt x="787445" y="714708"/>
                  </a:cubicBezTo>
                  <a:cubicBezTo>
                    <a:pt x="831366" y="688250"/>
                    <a:pt x="927145" y="648033"/>
                    <a:pt x="927145" y="648033"/>
                  </a:cubicBezTo>
                  <a:cubicBezTo>
                    <a:pt x="972124" y="626866"/>
                    <a:pt x="1007049" y="615754"/>
                    <a:pt x="1057320" y="587708"/>
                  </a:cubicBezTo>
                  <a:cubicBezTo>
                    <a:pt x="1107591" y="559662"/>
                    <a:pt x="1179028" y="505687"/>
                    <a:pt x="1228770" y="479758"/>
                  </a:cubicBezTo>
                  <a:cubicBezTo>
                    <a:pt x="1278512" y="453829"/>
                    <a:pt x="1309733" y="442716"/>
                    <a:pt x="1355770" y="432133"/>
                  </a:cubicBezTo>
                  <a:cubicBezTo>
                    <a:pt x="1401807" y="421550"/>
                    <a:pt x="1469012" y="422079"/>
                    <a:pt x="1504995" y="416258"/>
                  </a:cubicBezTo>
                  <a:cubicBezTo>
                    <a:pt x="1540978" y="410437"/>
                    <a:pt x="1547328" y="407791"/>
                    <a:pt x="1571670" y="397208"/>
                  </a:cubicBezTo>
                  <a:cubicBezTo>
                    <a:pt x="1596012" y="386625"/>
                    <a:pt x="1620883" y="365458"/>
                    <a:pt x="1651045" y="352758"/>
                  </a:cubicBezTo>
                  <a:cubicBezTo>
                    <a:pt x="1681208" y="340058"/>
                    <a:pt x="1724070" y="332650"/>
                    <a:pt x="1752645" y="321008"/>
                  </a:cubicBezTo>
                  <a:cubicBezTo>
                    <a:pt x="1781220" y="309366"/>
                    <a:pt x="1794449" y="294020"/>
                    <a:pt x="1822495" y="282908"/>
                  </a:cubicBezTo>
                  <a:cubicBezTo>
                    <a:pt x="1850541" y="271795"/>
                    <a:pt x="1887053" y="261741"/>
                    <a:pt x="1920920" y="254333"/>
                  </a:cubicBezTo>
                  <a:cubicBezTo>
                    <a:pt x="1954787" y="246925"/>
                    <a:pt x="1993416" y="244808"/>
                    <a:pt x="2025695" y="238458"/>
                  </a:cubicBezTo>
                  <a:cubicBezTo>
                    <a:pt x="2057974" y="232108"/>
                    <a:pt x="2080199" y="220466"/>
                    <a:pt x="2114595" y="216233"/>
                  </a:cubicBezTo>
                  <a:cubicBezTo>
                    <a:pt x="2148991" y="212000"/>
                    <a:pt x="2197674" y="213587"/>
                    <a:pt x="2232070" y="213058"/>
                  </a:cubicBezTo>
                  <a:cubicBezTo>
                    <a:pt x="2266466" y="212529"/>
                    <a:pt x="2292395" y="217291"/>
                    <a:pt x="2320970" y="213058"/>
                  </a:cubicBezTo>
                  <a:cubicBezTo>
                    <a:pt x="2349545" y="208825"/>
                    <a:pt x="2403520" y="187658"/>
                    <a:pt x="2403520" y="187658"/>
                  </a:cubicBezTo>
                  <a:cubicBezTo>
                    <a:pt x="2433683" y="178662"/>
                    <a:pt x="2471783" y="165962"/>
                    <a:pt x="2501945" y="159083"/>
                  </a:cubicBezTo>
                  <a:cubicBezTo>
                    <a:pt x="2532107" y="152204"/>
                    <a:pt x="2558566" y="144795"/>
                    <a:pt x="2584495" y="146383"/>
                  </a:cubicBezTo>
                  <a:cubicBezTo>
                    <a:pt x="2610424" y="147970"/>
                    <a:pt x="2628416" y="163846"/>
                    <a:pt x="2657520" y="168608"/>
                  </a:cubicBezTo>
                  <a:cubicBezTo>
                    <a:pt x="2686624" y="173370"/>
                    <a:pt x="2728958" y="176016"/>
                    <a:pt x="2759120" y="174958"/>
                  </a:cubicBezTo>
                  <a:cubicBezTo>
                    <a:pt x="2789282" y="173900"/>
                    <a:pt x="2813095" y="165433"/>
                    <a:pt x="2838495" y="162258"/>
                  </a:cubicBezTo>
                  <a:cubicBezTo>
                    <a:pt x="2863895" y="159083"/>
                    <a:pt x="2886649" y="154850"/>
                    <a:pt x="2911520" y="155908"/>
                  </a:cubicBezTo>
                  <a:cubicBezTo>
                    <a:pt x="2936391" y="156966"/>
                    <a:pt x="2987720" y="168608"/>
                    <a:pt x="2987720" y="168608"/>
                  </a:cubicBezTo>
                  <a:cubicBezTo>
                    <a:pt x="3017353" y="173900"/>
                    <a:pt x="3057041" y="178133"/>
                    <a:pt x="3089320" y="187658"/>
                  </a:cubicBezTo>
                  <a:cubicBezTo>
                    <a:pt x="3121599" y="197183"/>
                    <a:pt x="3150703" y="214645"/>
                    <a:pt x="3181395" y="225758"/>
                  </a:cubicBezTo>
                  <a:cubicBezTo>
                    <a:pt x="3212087" y="236870"/>
                    <a:pt x="3247541" y="245866"/>
                    <a:pt x="3273470" y="254333"/>
                  </a:cubicBezTo>
                  <a:cubicBezTo>
                    <a:pt x="3299399" y="262800"/>
                    <a:pt x="3309454" y="268621"/>
                    <a:pt x="3336970" y="276558"/>
                  </a:cubicBezTo>
                  <a:cubicBezTo>
                    <a:pt x="3364486" y="284495"/>
                    <a:pt x="3407349" y="301429"/>
                    <a:pt x="3438570" y="301958"/>
                  </a:cubicBezTo>
                  <a:cubicBezTo>
                    <a:pt x="3469791" y="302487"/>
                    <a:pt x="3500483" y="280791"/>
                    <a:pt x="3524295" y="279733"/>
                  </a:cubicBezTo>
                  <a:cubicBezTo>
                    <a:pt x="3548107" y="278675"/>
                    <a:pt x="3565570" y="285554"/>
                    <a:pt x="3581445" y="295608"/>
                  </a:cubicBezTo>
                  <a:cubicBezTo>
                    <a:pt x="3597320" y="305662"/>
                    <a:pt x="3602083" y="320479"/>
                    <a:pt x="3619545" y="340058"/>
                  </a:cubicBezTo>
                  <a:cubicBezTo>
                    <a:pt x="3637007" y="359637"/>
                    <a:pt x="3666641" y="391916"/>
                    <a:pt x="3686220" y="413083"/>
                  </a:cubicBezTo>
                  <a:cubicBezTo>
                    <a:pt x="3705799" y="434250"/>
                    <a:pt x="3720087" y="455416"/>
                    <a:pt x="3737020" y="467058"/>
                  </a:cubicBezTo>
                  <a:cubicBezTo>
                    <a:pt x="3753953" y="478700"/>
                    <a:pt x="3760833" y="481875"/>
                    <a:pt x="3787820" y="482933"/>
                  </a:cubicBezTo>
                  <a:cubicBezTo>
                    <a:pt x="3814807" y="483991"/>
                    <a:pt x="3863491" y="474995"/>
                    <a:pt x="3898945" y="473408"/>
                  </a:cubicBezTo>
                  <a:cubicBezTo>
                    <a:pt x="3934399" y="471821"/>
                    <a:pt x="3966149" y="470762"/>
                    <a:pt x="4000545" y="473408"/>
                  </a:cubicBezTo>
                  <a:cubicBezTo>
                    <a:pt x="4034941" y="476054"/>
                    <a:pt x="4070395" y="473408"/>
                    <a:pt x="4105320" y="489283"/>
                  </a:cubicBezTo>
                  <a:cubicBezTo>
                    <a:pt x="4140245" y="505158"/>
                    <a:pt x="4177287" y="548550"/>
                    <a:pt x="4210095" y="568658"/>
                  </a:cubicBezTo>
                  <a:cubicBezTo>
                    <a:pt x="4242903" y="588766"/>
                    <a:pt x="4273595" y="594587"/>
                    <a:pt x="4302170" y="609933"/>
                  </a:cubicBezTo>
                  <a:cubicBezTo>
                    <a:pt x="4330745" y="625279"/>
                    <a:pt x="4356674" y="639566"/>
                    <a:pt x="4381545" y="660733"/>
                  </a:cubicBezTo>
                  <a:cubicBezTo>
                    <a:pt x="4406416" y="681900"/>
                    <a:pt x="4430758" y="713650"/>
                    <a:pt x="4451395" y="736933"/>
                  </a:cubicBezTo>
                  <a:cubicBezTo>
                    <a:pt x="4472032" y="760216"/>
                    <a:pt x="4486849" y="778208"/>
                    <a:pt x="4505370" y="800433"/>
                  </a:cubicBezTo>
                  <a:cubicBezTo>
                    <a:pt x="4523891" y="822658"/>
                    <a:pt x="4546116" y="847529"/>
                    <a:pt x="4562520" y="870283"/>
                  </a:cubicBezTo>
                  <a:cubicBezTo>
                    <a:pt x="4578924" y="893037"/>
                    <a:pt x="4587920" y="914204"/>
                    <a:pt x="4603795" y="936958"/>
                  </a:cubicBezTo>
                  <a:cubicBezTo>
                    <a:pt x="4619670" y="959712"/>
                    <a:pt x="4641366" y="994637"/>
                    <a:pt x="4657770" y="1006808"/>
                  </a:cubicBezTo>
                  <a:cubicBezTo>
                    <a:pt x="4674174" y="1018979"/>
                    <a:pt x="4691637" y="1014745"/>
                    <a:pt x="4702220" y="1009983"/>
                  </a:cubicBezTo>
                  <a:cubicBezTo>
                    <a:pt x="4712803" y="1005220"/>
                    <a:pt x="4717566" y="1006279"/>
                    <a:pt x="4721270" y="978233"/>
                  </a:cubicBezTo>
                  <a:cubicBezTo>
                    <a:pt x="4724974" y="950187"/>
                    <a:pt x="4729737" y="867637"/>
                    <a:pt x="4724445" y="841708"/>
                  </a:cubicBezTo>
                  <a:cubicBezTo>
                    <a:pt x="4719153" y="815779"/>
                    <a:pt x="4700103" y="818425"/>
                    <a:pt x="4689520" y="822658"/>
                  </a:cubicBezTo>
                  <a:cubicBezTo>
                    <a:pt x="4678937" y="826891"/>
                    <a:pt x="4674174" y="870812"/>
                    <a:pt x="4660945" y="867108"/>
                  </a:cubicBezTo>
                  <a:cubicBezTo>
                    <a:pt x="4647716" y="863404"/>
                    <a:pt x="4624433" y="835887"/>
                    <a:pt x="4610145" y="800433"/>
                  </a:cubicBezTo>
                  <a:cubicBezTo>
                    <a:pt x="4595858" y="764979"/>
                    <a:pt x="4581570" y="697245"/>
                    <a:pt x="4575220" y="654383"/>
                  </a:cubicBezTo>
                  <a:cubicBezTo>
                    <a:pt x="4568870" y="611521"/>
                    <a:pt x="4572574" y="576595"/>
                    <a:pt x="4572045" y="543258"/>
                  </a:cubicBezTo>
                  <a:cubicBezTo>
                    <a:pt x="4571516" y="509921"/>
                    <a:pt x="4578924" y="473937"/>
                    <a:pt x="4572045" y="454358"/>
                  </a:cubicBezTo>
                  <a:cubicBezTo>
                    <a:pt x="4565166" y="434779"/>
                    <a:pt x="4550349" y="432662"/>
                    <a:pt x="4530770" y="425783"/>
                  </a:cubicBezTo>
                  <a:cubicBezTo>
                    <a:pt x="4511191" y="418904"/>
                    <a:pt x="4464624" y="402500"/>
                    <a:pt x="4454570" y="413083"/>
                  </a:cubicBezTo>
                  <a:cubicBezTo>
                    <a:pt x="4444516" y="423666"/>
                    <a:pt x="4466741" y="468645"/>
                    <a:pt x="4470445" y="489283"/>
                  </a:cubicBezTo>
                  <a:cubicBezTo>
                    <a:pt x="4474149" y="509921"/>
                    <a:pt x="4500607" y="537437"/>
                    <a:pt x="4476795" y="536908"/>
                  </a:cubicBezTo>
                  <a:cubicBezTo>
                    <a:pt x="4452983" y="536379"/>
                    <a:pt x="4356674" y="495633"/>
                    <a:pt x="4327570" y="486108"/>
                  </a:cubicBezTo>
                  <a:cubicBezTo>
                    <a:pt x="4298466" y="476583"/>
                    <a:pt x="4311166" y="498279"/>
                    <a:pt x="4302170" y="479758"/>
                  </a:cubicBezTo>
                  <a:cubicBezTo>
                    <a:pt x="4293174" y="461237"/>
                    <a:pt x="4293174" y="401970"/>
                    <a:pt x="4273595" y="374983"/>
                  </a:cubicBezTo>
                  <a:cubicBezTo>
                    <a:pt x="4254016" y="347996"/>
                    <a:pt x="4212741" y="332120"/>
                    <a:pt x="4184695" y="317833"/>
                  </a:cubicBezTo>
                  <a:cubicBezTo>
                    <a:pt x="4156649" y="303545"/>
                    <a:pt x="4133366" y="301958"/>
                    <a:pt x="4105320" y="289258"/>
                  </a:cubicBezTo>
                  <a:cubicBezTo>
                    <a:pt x="4077274" y="276558"/>
                    <a:pt x="4016420" y="241633"/>
                    <a:pt x="4016420" y="241633"/>
                  </a:cubicBezTo>
                  <a:cubicBezTo>
                    <a:pt x="3981495" y="222583"/>
                    <a:pt x="3933870" y="190304"/>
                    <a:pt x="3895770" y="174958"/>
                  </a:cubicBezTo>
                  <a:cubicBezTo>
                    <a:pt x="3857670" y="159612"/>
                    <a:pt x="3822216" y="156966"/>
                    <a:pt x="3787820" y="149558"/>
                  </a:cubicBezTo>
                  <a:cubicBezTo>
                    <a:pt x="3753424" y="142150"/>
                    <a:pt x="3734374" y="142150"/>
                    <a:pt x="3689395" y="130508"/>
                  </a:cubicBezTo>
                  <a:cubicBezTo>
                    <a:pt x="3644416" y="118866"/>
                    <a:pt x="3561337" y="89233"/>
                    <a:pt x="3517945" y="79708"/>
                  </a:cubicBezTo>
                  <a:cubicBezTo>
                    <a:pt x="3474553" y="70183"/>
                    <a:pt x="3467145" y="77591"/>
                    <a:pt x="3429045" y="73358"/>
                  </a:cubicBezTo>
                  <a:cubicBezTo>
                    <a:pt x="3390945" y="69125"/>
                    <a:pt x="3325857" y="56954"/>
                    <a:pt x="3289345" y="54308"/>
                  </a:cubicBezTo>
                  <a:cubicBezTo>
                    <a:pt x="3252833" y="51662"/>
                    <a:pt x="3240662" y="59600"/>
                    <a:pt x="3209970" y="57483"/>
                  </a:cubicBezTo>
                  <a:cubicBezTo>
                    <a:pt x="3179278" y="55366"/>
                    <a:pt x="3143824" y="43195"/>
                    <a:pt x="3105195" y="41608"/>
                  </a:cubicBezTo>
                  <a:cubicBezTo>
                    <a:pt x="3066566" y="40021"/>
                    <a:pt x="3021057" y="47958"/>
                    <a:pt x="2978195" y="47958"/>
                  </a:cubicBezTo>
                  <a:cubicBezTo>
                    <a:pt x="2935333" y="47958"/>
                    <a:pt x="2899878" y="47958"/>
                    <a:pt x="2848020" y="41608"/>
                  </a:cubicBezTo>
                  <a:cubicBezTo>
                    <a:pt x="2796162" y="35258"/>
                    <a:pt x="2709908" y="16737"/>
                    <a:pt x="2667045" y="9858"/>
                  </a:cubicBezTo>
                  <a:cubicBezTo>
                    <a:pt x="2624183" y="2979"/>
                    <a:pt x="2621537" y="-1255"/>
                    <a:pt x="2590845" y="333"/>
                  </a:cubicBezTo>
                  <a:cubicBezTo>
                    <a:pt x="2560153" y="1920"/>
                    <a:pt x="2521524" y="8271"/>
                    <a:pt x="2482895" y="19383"/>
                  </a:cubicBezTo>
                  <a:cubicBezTo>
                    <a:pt x="2444266" y="30495"/>
                    <a:pt x="2400874" y="53250"/>
                    <a:pt x="2359070" y="67008"/>
                  </a:cubicBezTo>
                  <a:cubicBezTo>
                    <a:pt x="2317266" y="80766"/>
                    <a:pt x="2269641" y="93466"/>
                    <a:pt x="2232070" y="101933"/>
                  </a:cubicBezTo>
                  <a:cubicBezTo>
                    <a:pt x="2194499" y="110400"/>
                    <a:pt x="2168041" y="110929"/>
                    <a:pt x="2133645" y="117808"/>
                  </a:cubicBezTo>
                  <a:cubicBezTo>
                    <a:pt x="2099249" y="124687"/>
                    <a:pt x="2061149" y="142150"/>
                    <a:pt x="2025695" y="143208"/>
                  </a:cubicBezTo>
                  <a:cubicBezTo>
                    <a:pt x="1990241" y="144266"/>
                    <a:pt x="1958491" y="119925"/>
                    <a:pt x="1920920" y="124158"/>
                  </a:cubicBezTo>
                  <a:cubicBezTo>
                    <a:pt x="1883349" y="128391"/>
                    <a:pt x="1842074" y="154321"/>
                    <a:pt x="1800270" y="168608"/>
                  </a:cubicBezTo>
                  <a:cubicBezTo>
                    <a:pt x="1758466" y="182895"/>
                    <a:pt x="1708195" y="200887"/>
                    <a:pt x="1670095" y="209883"/>
                  </a:cubicBezTo>
                  <a:cubicBezTo>
                    <a:pt x="1631995" y="218879"/>
                    <a:pt x="1571670" y="222583"/>
                    <a:pt x="1571670" y="222583"/>
                  </a:cubicBezTo>
                  <a:cubicBezTo>
                    <a:pt x="1534628" y="227345"/>
                    <a:pt x="1491766" y="230520"/>
                    <a:pt x="1447845" y="238458"/>
                  </a:cubicBezTo>
                  <a:cubicBezTo>
                    <a:pt x="1403924" y="246395"/>
                    <a:pt x="1353653" y="254862"/>
                    <a:pt x="1308145" y="270208"/>
                  </a:cubicBezTo>
                  <a:cubicBezTo>
                    <a:pt x="1262637" y="285554"/>
                    <a:pt x="1217658" y="312012"/>
                    <a:pt x="1174795" y="330533"/>
                  </a:cubicBezTo>
                  <a:cubicBezTo>
                    <a:pt x="1131933" y="349054"/>
                    <a:pt x="1050970" y="381333"/>
                    <a:pt x="1050970" y="381333"/>
                  </a:cubicBezTo>
                  <a:cubicBezTo>
                    <a:pt x="1012341" y="397208"/>
                    <a:pt x="977416" y="409908"/>
                    <a:pt x="943020" y="425783"/>
                  </a:cubicBezTo>
                  <a:cubicBezTo>
                    <a:pt x="908624" y="441658"/>
                    <a:pt x="878462" y="458591"/>
                    <a:pt x="844595" y="476583"/>
                  </a:cubicBezTo>
                  <a:cubicBezTo>
                    <a:pt x="810728" y="494575"/>
                    <a:pt x="770512" y="514154"/>
                    <a:pt x="739820" y="533733"/>
                  </a:cubicBezTo>
                  <a:cubicBezTo>
                    <a:pt x="709128" y="553312"/>
                    <a:pt x="691137" y="573950"/>
                    <a:pt x="660445" y="594058"/>
                  </a:cubicBezTo>
                  <a:cubicBezTo>
                    <a:pt x="629753" y="614166"/>
                    <a:pt x="596945" y="629512"/>
                    <a:pt x="555670" y="654383"/>
                  </a:cubicBezTo>
                  <a:cubicBezTo>
                    <a:pt x="514395" y="679254"/>
                    <a:pt x="444545" y="721587"/>
                    <a:pt x="412795" y="743283"/>
                  </a:cubicBezTo>
                  <a:cubicBezTo>
                    <a:pt x="381045" y="764979"/>
                    <a:pt x="385807" y="771858"/>
                    <a:pt x="365170" y="784558"/>
                  </a:cubicBezTo>
                  <a:cubicBezTo>
                    <a:pt x="344533" y="797258"/>
                    <a:pt x="318074" y="805196"/>
                    <a:pt x="288970" y="819483"/>
                  </a:cubicBezTo>
                  <a:cubicBezTo>
                    <a:pt x="259866" y="833770"/>
                    <a:pt x="223353" y="851233"/>
                    <a:pt x="190545" y="870283"/>
                  </a:cubicBezTo>
                  <a:cubicBezTo>
                    <a:pt x="157737" y="889333"/>
                    <a:pt x="121224" y="901504"/>
                    <a:pt x="92120" y="933783"/>
                  </a:cubicBezTo>
                  <a:cubicBezTo>
                    <a:pt x="63016" y="966062"/>
                    <a:pt x="28620" y="1024800"/>
                    <a:pt x="15920" y="1063958"/>
                  </a:cubicBezTo>
                  <a:cubicBezTo>
                    <a:pt x="3220" y="1103116"/>
                    <a:pt x="17508" y="1144920"/>
                    <a:pt x="15920" y="1168733"/>
                  </a:cubicBezTo>
                  <a:cubicBezTo>
                    <a:pt x="14332" y="1192546"/>
                    <a:pt x="9041" y="1184608"/>
                    <a:pt x="6395" y="1206833"/>
                  </a:cubicBezTo>
                  <a:cubicBezTo>
                    <a:pt x="3749" y="1229058"/>
                    <a:pt x="-484" y="1270862"/>
                    <a:pt x="45" y="1302083"/>
                  </a:cubicBezTo>
                  <a:cubicBezTo>
                    <a:pt x="574" y="1333304"/>
                    <a:pt x="-2072" y="1376166"/>
                    <a:pt x="9570" y="1394158"/>
                  </a:cubicBezTo>
                  <a:cubicBezTo>
                    <a:pt x="21212" y="1412150"/>
                    <a:pt x="54020" y="1402625"/>
                    <a:pt x="85770" y="1390983"/>
                  </a:cubicBezTo>
                  <a:close/>
                </a:path>
              </a:pathLst>
            </a:custGeom>
            <a:noFill/>
            <a:ln w="38100">
              <a:solidFill>
                <a:schemeClr val="bg1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9666"/>
            </a:p>
          </p:txBody>
        </p:sp>
        <p:sp>
          <p:nvSpPr>
            <p:cNvPr id="205" name="Freeform 204"/>
            <p:cNvSpPr/>
            <p:nvPr/>
          </p:nvSpPr>
          <p:spPr>
            <a:xfrm>
              <a:off x="642938" y="2555002"/>
              <a:ext cx="3867150" cy="1157287"/>
            </a:xfrm>
            <a:custGeom>
              <a:avLst/>
              <a:gdLst>
                <a:gd name="connsiteX0" fmla="*/ 33 w 4458307"/>
                <a:gd name="connsiteY0" fmla="*/ 1238646 h 1320799"/>
                <a:gd name="connsiteX1" fmla="*/ 76233 w 4458307"/>
                <a:gd name="connsiteY1" fmla="*/ 1273571 h 1320799"/>
                <a:gd name="connsiteX2" fmla="*/ 133383 w 4458307"/>
                <a:gd name="connsiteY2" fmla="*/ 1276746 h 1320799"/>
                <a:gd name="connsiteX3" fmla="*/ 206408 w 4458307"/>
                <a:gd name="connsiteY3" fmla="*/ 1295796 h 1320799"/>
                <a:gd name="connsiteX4" fmla="*/ 342933 w 4458307"/>
                <a:gd name="connsiteY4" fmla="*/ 1298971 h 1320799"/>
                <a:gd name="connsiteX5" fmla="*/ 492158 w 4458307"/>
                <a:gd name="connsiteY5" fmla="*/ 1318021 h 1320799"/>
                <a:gd name="connsiteX6" fmla="*/ 663608 w 4458307"/>
                <a:gd name="connsiteY6" fmla="*/ 1314846 h 1320799"/>
                <a:gd name="connsiteX7" fmla="*/ 809658 w 4458307"/>
                <a:gd name="connsiteY7" fmla="*/ 1264046 h 1320799"/>
                <a:gd name="connsiteX8" fmla="*/ 943008 w 4458307"/>
                <a:gd name="connsiteY8" fmla="*/ 1175146 h 1320799"/>
                <a:gd name="connsiteX9" fmla="*/ 1000158 w 4458307"/>
                <a:gd name="connsiteY9" fmla="*/ 1130696 h 1320799"/>
                <a:gd name="connsiteX10" fmla="*/ 1111283 w 4458307"/>
                <a:gd name="connsiteY10" fmla="*/ 1051321 h 1320799"/>
                <a:gd name="connsiteX11" fmla="*/ 1197008 w 4458307"/>
                <a:gd name="connsiteY11" fmla="*/ 1048146 h 1320799"/>
                <a:gd name="connsiteX12" fmla="*/ 1228758 w 4458307"/>
                <a:gd name="connsiteY12" fmla="*/ 1054496 h 1320799"/>
                <a:gd name="connsiteX13" fmla="*/ 1270033 w 4458307"/>
                <a:gd name="connsiteY13" fmla="*/ 997346 h 1320799"/>
                <a:gd name="connsiteX14" fmla="*/ 1349408 w 4458307"/>
                <a:gd name="connsiteY14" fmla="*/ 1029096 h 1320799"/>
                <a:gd name="connsiteX15" fmla="*/ 1441483 w 4458307"/>
                <a:gd name="connsiteY15" fmla="*/ 984646 h 1320799"/>
                <a:gd name="connsiteX16" fmla="*/ 1492283 w 4458307"/>
                <a:gd name="connsiteY16" fmla="*/ 952896 h 1320799"/>
                <a:gd name="connsiteX17" fmla="*/ 1565308 w 4458307"/>
                <a:gd name="connsiteY17" fmla="*/ 1010046 h 1320799"/>
                <a:gd name="connsiteX18" fmla="*/ 1654208 w 4458307"/>
                <a:gd name="connsiteY18" fmla="*/ 994171 h 1320799"/>
                <a:gd name="connsiteX19" fmla="*/ 1736758 w 4458307"/>
                <a:gd name="connsiteY19" fmla="*/ 1019571 h 1320799"/>
                <a:gd name="connsiteX20" fmla="*/ 1781208 w 4458307"/>
                <a:gd name="connsiteY20" fmla="*/ 1003696 h 1320799"/>
                <a:gd name="connsiteX21" fmla="*/ 1819308 w 4458307"/>
                <a:gd name="connsiteY21" fmla="*/ 908446 h 1320799"/>
                <a:gd name="connsiteX22" fmla="*/ 1885983 w 4458307"/>
                <a:gd name="connsiteY22" fmla="*/ 832246 h 1320799"/>
                <a:gd name="connsiteX23" fmla="*/ 1984408 w 4458307"/>
                <a:gd name="connsiteY23" fmla="*/ 835421 h 1320799"/>
                <a:gd name="connsiteX24" fmla="*/ 2047908 w 4458307"/>
                <a:gd name="connsiteY24" fmla="*/ 921146 h 1320799"/>
                <a:gd name="connsiteX25" fmla="*/ 2086008 w 4458307"/>
                <a:gd name="connsiteY25" fmla="*/ 908446 h 1320799"/>
                <a:gd name="connsiteX26" fmla="*/ 2089183 w 4458307"/>
                <a:gd name="connsiteY26" fmla="*/ 819546 h 1320799"/>
                <a:gd name="connsiteX27" fmla="*/ 2152683 w 4458307"/>
                <a:gd name="connsiteY27" fmla="*/ 860821 h 1320799"/>
                <a:gd name="connsiteX28" fmla="*/ 2193958 w 4458307"/>
                <a:gd name="connsiteY28" fmla="*/ 886221 h 1320799"/>
                <a:gd name="connsiteX29" fmla="*/ 2251108 w 4458307"/>
                <a:gd name="connsiteY29" fmla="*/ 873521 h 1320799"/>
                <a:gd name="connsiteX30" fmla="*/ 2305083 w 4458307"/>
                <a:gd name="connsiteY30" fmla="*/ 848121 h 1320799"/>
                <a:gd name="connsiteX31" fmla="*/ 2374933 w 4458307"/>
                <a:gd name="connsiteY31" fmla="*/ 806846 h 1320799"/>
                <a:gd name="connsiteX32" fmla="*/ 2432083 w 4458307"/>
                <a:gd name="connsiteY32" fmla="*/ 844946 h 1320799"/>
                <a:gd name="connsiteX33" fmla="*/ 2501933 w 4458307"/>
                <a:gd name="connsiteY33" fmla="*/ 838596 h 1320799"/>
                <a:gd name="connsiteX34" fmla="*/ 2562258 w 4458307"/>
                <a:gd name="connsiteY34" fmla="*/ 857646 h 1320799"/>
                <a:gd name="connsiteX35" fmla="*/ 2622583 w 4458307"/>
                <a:gd name="connsiteY35" fmla="*/ 816371 h 1320799"/>
                <a:gd name="connsiteX36" fmla="*/ 2660683 w 4458307"/>
                <a:gd name="connsiteY36" fmla="*/ 790971 h 1320799"/>
                <a:gd name="connsiteX37" fmla="*/ 2689258 w 4458307"/>
                <a:gd name="connsiteY37" fmla="*/ 822721 h 1320799"/>
                <a:gd name="connsiteX38" fmla="*/ 2765458 w 4458307"/>
                <a:gd name="connsiteY38" fmla="*/ 851296 h 1320799"/>
                <a:gd name="connsiteX39" fmla="*/ 2844833 w 4458307"/>
                <a:gd name="connsiteY39" fmla="*/ 863996 h 1320799"/>
                <a:gd name="connsiteX40" fmla="*/ 2860708 w 4458307"/>
                <a:gd name="connsiteY40" fmla="*/ 781446 h 1320799"/>
                <a:gd name="connsiteX41" fmla="*/ 2959133 w 4458307"/>
                <a:gd name="connsiteY41" fmla="*/ 794146 h 1320799"/>
                <a:gd name="connsiteX42" fmla="*/ 2943258 w 4458307"/>
                <a:gd name="connsiteY42" fmla="*/ 863996 h 1320799"/>
                <a:gd name="connsiteX43" fmla="*/ 2975008 w 4458307"/>
                <a:gd name="connsiteY43" fmla="*/ 927496 h 1320799"/>
                <a:gd name="connsiteX44" fmla="*/ 3111533 w 4458307"/>
                <a:gd name="connsiteY44" fmla="*/ 876696 h 1320799"/>
                <a:gd name="connsiteX45" fmla="*/ 3171858 w 4458307"/>
                <a:gd name="connsiteY45" fmla="*/ 902096 h 1320799"/>
                <a:gd name="connsiteX46" fmla="*/ 3200433 w 4458307"/>
                <a:gd name="connsiteY46" fmla="*/ 937021 h 1320799"/>
                <a:gd name="connsiteX47" fmla="*/ 3254408 w 4458307"/>
                <a:gd name="connsiteY47" fmla="*/ 940196 h 1320799"/>
                <a:gd name="connsiteX48" fmla="*/ 3314733 w 4458307"/>
                <a:gd name="connsiteY48" fmla="*/ 892571 h 1320799"/>
                <a:gd name="connsiteX49" fmla="*/ 3400458 w 4458307"/>
                <a:gd name="connsiteY49" fmla="*/ 902096 h 1320799"/>
                <a:gd name="connsiteX50" fmla="*/ 3495708 w 4458307"/>
                <a:gd name="connsiteY50" fmla="*/ 902096 h 1320799"/>
                <a:gd name="connsiteX51" fmla="*/ 3530633 w 4458307"/>
                <a:gd name="connsiteY51" fmla="*/ 902096 h 1320799"/>
                <a:gd name="connsiteX52" fmla="*/ 3600483 w 4458307"/>
                <a:gd name="connsiteY52" fmla="*/ 867171 h 1320799"/>
                <a:gd name="connsiteX53" fmla="*/ 3695733 w 4458307"/>
                <a:gd name="connsiteY53" fmla="*/ 841771 h 1320799"/>
                <a:gd name="connsiteX54" fmla="*/ 3800508 w 4458307"/>
                <a:gd name="connsiteY54" fmla="*/ 848121 h 1320799"/>
                <a:gd name="connsiteX55" fmla="*/ 3835433 w 4458307"/>
                <a:gd name="connsiteY55" fmla="*/ 889396 h 1320799"/>
                <a:gd name="connsiteX56" fmla="*/ 3771933 w 4458307"/>
                <a:gd name="connsiteY56" fmla="*/ 952896 h 1320799"/>
                <a:gd name="connsiteX57" fmla="*/ 3752883 w 4458307"/>
                <a:gd name="connsiteY57" fmla="*/ 981471 h 1320799"/>
                <a:gd name="connsiteX58" fmla="*/ 3832258 w 4458307"/>
                <a:gd name="connsiteY58" fmla="*/ 981471 h 1320799"/>
                <a:gd name="connsiteX59" fmla="*/ 3784633 w 4458307"/>
                <a:gd name="connsiteY59" fmla="*/ 1070371 h 1320799"/>
                <a:gd name="connsiteX60" fmla="*/ 3771933 w 4458307"/>
                <a:gd name="connsiteY60" fmla="*/ 1098946 h 1320799"/>
                <a:gd name="connsiteX61" fmla="*/ 3825908 w 4458307"/>
                <a:gd name="connsiteY61" fmla="*/ 1124346 h 1320799"/>
                <a:gd name="connsiteX62" fmla="*/ 3937033 w 4458307"/>
                <a:gd name="connsiteY62" fmla="*/ 1121171 h 1320799"/>
                <a:gd name="connsiteX63" fmla="*/ 4010058 w 4458307"/>
                <a:gd name="connsiteY63" fmla="*/ 1098946 h 1320799"/>
                <a:gd name="connsiteX64" fmla="*/ 4108483 w 4458307"/>
                <a:gd name="connsiteY64" fmla="*/ 1079896 h 1320799"/>
                <a:gd name="connsiteX65" fmla="*/ 4238658 w 4458307"/>
                <a:gd name="connsiteY65" fmla="*/ 1048146 h 1320799"/>
                <a:gd name="connsiteX66" fmla="*/ 4311683 w 4458307"/>
                <a:gd name="connsiteY66" fmla="*/ 1032271 h 1320799"/>
                <a:gd name="connsiteX67" fmla="*/ 4406933 w 4458307"/>
                <a:gd name="connsiteY67" fmla="*/ 984646 h 1320799"/>
                <a:gd name="connsiteX68" fmla="*/ 4445033 w 4458307"/>
                <a:gd name="connsiteY68" fmla="*/ 952896 h 1320799"/>
                <a:gd name="connsiteX69" fmla="*/ 4457733 w 4458307"/>
                <a:gd name="connsiteY69" fmla="*/ 879871 h 1320799"/>
                <a:gd name="connsiteX70" fmla="*/ 4429158 w 4458307"/>
                <a:gd name="connsiteY70" fmla="*/ 800496 h 1320799"/>
                <a:gd name="connsiteX71" fmla="*/ 4375183 w 4458307"/>
                <a:gd name="connsiteY71" fmla="*/ 714771 h 1320799"/>
                <a:gd name="connsiteX72" fmla="*/ 4321208 w 4458307"/>
                <a:gd name="connsiteY72" fmla="*/ 635396 h 1320799"/>
                <a:gd name="connsiteX73" fmla="*/ 4241833 w 4458307"/>
                <a:gd name="connsiteY73" fmla="*/ 559196 h 1320799"/>
                <a:gd name="connsiteX74" fmla="*/ 4181508 w 4458307"/>
                <a:gd name="connsiteY74" fmla="*/ 505221 h 1320799"/>
                <a:gd name="connsiteX75" fmla="*/ 4064033 w 4458307"/>
                <a:gd name="connsiteY75" fmla="*/ 425846 h 1320799"/>
                <a:gd name="connsiteX76" fmla="*/ 3962433 w 4458307"/>
                <a:gd name="connsiteY76" fmla="*/ 365521 h 1320799"/>
                <a:gd name="connsiteX77" fmla="*/ 3864008 w 4458307"/>
                <a:gd name="connsiteY77" fmla="*/ 343296 h 1320799"/>
                <a:gd name="connsiteX78" fmla="*/ 3708433 w 4458307"/>
                <a:gd name="connsiteY78" fmla="*/ 327421 h 1320799"/>
                <a:gd name="connsiteX79" fmla="*/ 3613183 w 4458307"/>
                <a:gd name="connsiteY79" fmla="*/ 324246 h 1320799"/>
                <a:gd name="connsiteX80" fmla="*/ 3457608 w 4458307"/>
                <a:gd name="connsiteY80" fmla="*/ 244871 h 1320799"/>
                <a:gd name="connsiteX81" fmla="*/ 3371883 w 4458307"/>
                <a:gd name="connsiteY81" fmla="*/ 162321 h 1320799"/>
                <a:gd name="connsiteX82" fmla="*/ 3308383 w 4458307"/>
                <a:gd name="connsiteY82" fmla="*/ 127396 h 1320799"/>
                <a:gd name="connsiteX83" fmla="*/ 3200433 w 4458307"/>
                <a:gd name="connsiteY83" fmla="*/ 133746 h 1320799"/>
                <a:gd name="connsiteX84" fmla="*/ 3105183 w 4458307"/>
                <a:gd name="connsiteY84" fmla="*/ 108346 h 1320799"/>
                <a:gd name="connsiteX85" fmla="*/ 3003583 w 4458307"/>
                <a:gd name="connsiteY85" fmla="*/ 70246 h 1320799"/>
                <a:gd name="connsiteX86" fmla="*/ 2838483 w 4458307"/>
                <a:gd name="connsiteY86" fmla="*/ 19446 h 1320799"/>
                <a:gd name="connsiteX87" fmla="*/ 2705133 w 4458307"/>
                <a:gd name="connsiteY87" fmla="*/ 3571 h 1320799"/>
                <a:gd name="connsiteX88" fmla="*/ 2632108 w 4458307"/>
                <a:gd name="connsiteY88" fmla="*/ 396 h 1320799"/>
                <a:gd name="connsiteX89" fmla="*/ 2501933 w 4458307"/>
                <a:gd name="connsiteY89" fmla="*/ 9921 h 1320799"/>
                <a:gd name="connsiteX90" fmla="*/ 2419383 w 4458307"/>
                <a:gd name="connsiteY90" fmla="*/ 13096 h 1320799"/>
                <a:gd name="connsiteX91" fmla="*/ 2336833 w 4458307"/>
                <a:gd name="connsiteY91" fmla="*/ 3571 h 1320799"/>
                <a:gd name="connsiteX92" fmla="*/ 2251108 w 4458307"/>
                <a:gd name="connsiteY92" fmla="*/ 25796 h 1320799"/>
                <a:gd name="connsiteX93" fmla="*/ 2133633 w 4458307"/>
                <a:gd name="connsiteY93" fmla="*/ 57546 h 1320799"/>
                <a:gd name="connsiteX94" fmla="*/ 2038383 w 4458307"/>
                <a:gd name="connsiteY94" fmla="*/ 67071 h 1320799"/>
                <a:gd name="connsiteX95" fmla="*/ 1946308 w 4458307"/>
                <a:gd name="connsiteY95" fmla="*/ 76596 h 1320799"/>
                <a:gd name="connsiteX96" fmla="*/ 1854233 w 4458307"/>
                <a:gd name="connsiteY96" fmla="*/ 86121 h 1320799"/>
                <a:gd name="connsiteX97" fmla="*/ 1746283 w 4458307"/>
                <a:gd name="connsiteY97" fmla="*/ 114696 h 1320799"/>
                <a:gd name="connsiteX98" fmla="*/ 1654208 w 4458307"/>
                <a:gd name="connsiteY98" fmla="*/ 136921 h 1320799"/>
                <a:gd name="connsiteX99" fmla="*/ 1593883 w 4458307"/>
                <a:gd name="connsiteY99" fmla="*/ 155971 h 1320799"/>
                <a:gd name="connsiteX100" fmla="*/ 1514508 w 4458307"/>
                <a:gd name="connsiteY100" fmla="*/ 190896 h 1320799"/>
                <a:gd name="connsiteX101" fmla="*/ 1441483 w 4458307"/>
                <a:gd name="connsiteY101" fmla="*/ 225821 h 1320799"/>
                <a:gd name="connsiteX102" fmla="*/ 1355758 w 4458307"/>
                <a:gd name="connsiteY102" fmla="*/ 257571 h 1320799"/>
                <a:gd name="connsiteX103" fmla="*/ 1317658 w 4458307"/>
                <a:gd name="connsiteY103" fmla="*/ 267096 h 1320799"/>
                <a:gd name="connsiteX104" fmla="*/ 1209708 w 4458307"/>
                <a:gd name="connsiteY104" fmla="*/ 292496 h 1320799"/>
                <a:gd name="connsiteX105" fmla="*/ 1104933 w 4458307"/>
                <a:gd name="connsiteY105" fmla="*/ 314721 h 1320799"/>
                <a:gd name="connsiteX106" fmla="*/ 1022383 w 4458307"/>
                <a:gd name="connsiteY106" fmla="*/ 343296 h 1320799"/>
                <a:gd name="connsiteX107" fmla="*/ 949358 w 4458307"/>
                <a:gd name="connsiteY107" fmla="*/ 390921 h 1320799"/>
                <a:gd name="connsiteX108" fmla="*/ 885858 w 4458307"/>
                <a:gd name="connsiteY108" fmla="*/ 444896 h 1320799"/>
                <a:gd name="connsiteX109" fmla="*/ 796958 w 4458307"/>
                <a:gd name="connsiteY109" fmla="*/ 495696 h 1320799"/>
                <a:gd name="connsiteX110" fmla="*/ 717583 w 4458307"/>
                <a:gd name="connsiteY110" fmla="*/ 527446 h 1320799"/>
                <a:gd name="connsiteX111" fmla="*/ 644558 w 4458307"/>
                <a:gd name="connsiteY111" fmla="*/ 571896 h 1320799"/>
                <a:gd name="connsiteX112" fmla="*/ 568358 w 4458307"/>
                <a:gd name="connsiteY112" fmla="*/ 616346 h 1320799"/>
                <a:gd name="connsiteX113" fmla="*/ 469933 w 4458307"/>
                <a:gd name="connsiteY113" fmla="*/ 679846 h 1320799"/>
                <a:gd name="connsiteX114" fmla="*/ 412783 w 4458307"/>
                <a:gd name="connsiteY114" fmla="*/ 727471 h 1320799"/>
                <a:gd name="connsiteX115" fmla="*/ 333408 w 4458307"/>
                <a:gd name="connsiteY115" fmla="*/ 784621 h 1320799"/>
                <a:gd name="connsiteX116" fmla="*/ 295308 w 4458307"/>
                <a:gd name="connsiteY116" fmla="*/ 822721 h 1320799"/>
                <a:gd name="connsiteX117" fmla="*/ 215933 w 4458307"/>
                <a:gd name="connsiteY117" fmla="*/ 883046 h 1320799"/>
                <a:gd name="connsiteX118" fmla="*/ 171483 w 4458307"/>
                <a:gd name="connsiteY118" fmla="*/ 940196 h 1320799"/>
                <a:gd name="connsiteX119" fmla="*/ 149258 w 4458307"/>
                <a:gd name="connsiteY119" fmla="*/ 990996 h 1320799"/>
                <a:gd name="connsiteX120" fmla="*/ 130208 w 4458307"/>
                <a:gd name="connsiteY120" fmla="*/ 1041796 h 1320799"/>
                <a:gd name="connsiteX121" fmla="*/ 101633 w 4458307"/>
                <a:gd name="connsiteY121" fmla="*/ 1117996 h 1320799"/>
                <a:gd name="connsiteX122" fmla="*/ 85758 w 4458307"/>
                <a:gd name="connsiteY122" fmla="*/ 1187846 h 1320799"/>
                <a:gd name="connsiteX123" fmla="*/ 33 w 4458307"/>
                <a:gd name="connsiteY123" fmla="*/ 1238646 h 13207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  <a:cxn ang="0">
                  <a:pos x="connsiteX29" y="connsiteY29"/>
                </a:cxn>
                <a:cxn ang="0">
                  <a:pos x="connsiteX30" y="connsiteY30"/>
                </a:cxn>
                <a:cxn ang="0">
                  <a:pos x="connsiteX31" y="connsiteY31"/>
                </a:cxn>
                <a:cxn ang="0">
                  <a:pos x="connsiteX32" y="connsiteY32"/>
                </a:cxn>
                <a:cxn ang="0">
                  <a:pos x="connsiteX33" y="connsiteY33"/>
                </a:cxn>
                <a:cxn ang="0">
                  <a:pos x="connsiteX34" y="connsiteY34"/>
                </a:cxn>
                <a:cxn ang="0">
                  <a:pos x="connsiteX35" y="connsiteY35"/>
                </a:cxn>
                <a:cxn ang="0">
                  <a:pos x="connsiteX36" y="connsiteY36"/>
                </a:cxn>
                <a:cxn ang="0">
                  <a:pos x="connsiteX37" y="connsiteY37"/>
                </a:cxn>
                <a:cxn ang="0">
                  <a:pos x="connsiteX38" y="connsiteY38"/>
                </a:cxn>
                <a:cxn ang="0">
                  <a:pos x="connsiteX39" y="connsiteY39"/>
                </a:cxn>
                <a:cxn ang="0">
                  <a:pos x="connsiteX40" y="connsiteY40"/>
                </a:cxn>
                <a:cxn ang="0">
                  <a:pos x="connsiteX41" y="connsiteY41"/>
                </a:cxn>
                <a:cxn ang="0">
                  <a:pos x="connsiteX42" y="connsiteY42"/>
                </a:cxn>
                <a:cxn ang="0">
                  <a:pos x="connsiteX43" y="connsiteY43"/>
                </a:cxn>
                <a:cxn ang="0">
                  <a:pos x="connsiteX44" y="connsiteY44"/>
                </a:cxn>
                <a:cxn ang="0">
                  <a:pos x="connsiteX45" y="connsiteY45"/>
                </a:cxn>
                <a:cxn ang="0">
                  <a:pos x="connsiteX46" y="connsiteY46"/>
                </a:cxn>
                <a:cxn ang="0">
                  <a:pos x="connsiteX47" y="connsiteY47"/>
                </a:cxn>
                <a:cxn ang="0">
                  <a:pos x="connsiteX48" y="connsiteY48"/>
                </a:cxn>
                <a:cxn ang="0">
                  <a:pos x="connsiteX49" y="connsiteY49"/>
                </a:cxn>
                <a:cxn ang="0">
                  <a:pos x="connsiteX50" y="connsiteY50"/>
                </a:cxn>
                <a:cxn ang="0">
                  <a:pos x="connsiteX51" y="connsiteY51"/>
                </a:cxn>
                <a:cxn ang="0">
                  <a:pos x="connsiteX52" y="connsiteY52"/>
                </a:cxn>
                <a:cxn ang="0">
                  <a:pos x="connsiteX53" y="connsiteY53"/>
                </a:cxn>
                <a:cxn ang="0">
                  <a:pos x="connsiteX54" y="connsiteY54"/>
                </a:cxn>
                <a:cxn ang="0">
                  <a:pos x="connsiteX55" y="connsiteY55"/>
                </a:cxn>
                <a:cxn ang="0">
                  <a:pos x="connsiteX56" y="connsiteY56"/>
                </a:cxn>
                <a:cxn ang="0">
                  <a:pos x="connsiteX57" y="connsiteY57"/>
                </a:cxn>
                <a:cxn ang="0">
                  <a:pos x="connsiteX58" y="connsiteY58"/>
                </a:cxn>
                <a:cxn ang="0">
                  <a:pos x="connsiteX59" y="connsiteY59"/>
                </a:cxn>
                <a:cxn ang="0">
                  <a:pos x="connsiteX60" y="connsiteY60"/>
                </a:cxn>
                <a:cxn ang="0">
                  <a:pos x="connsiteX61" y="connsiteY61"/>
                </a:cxn>
                <a:cxn ang="0">
                  <a:pos x="connsiteX62" y="connsiteY62"/>
                </a:cxn>
                <a:cxn ang="0">
                  <a:pos x="connsiteX63" y="connsiteY63"/>
                </a:cxn>
                <a:cxn ang="0">
                  <a:pos x="connsiteX64" y="connsiteY64"/>
                </a:cxn>
                <a:cxn ang="0">
                  <a:pos x="connsiteX65" y="connsiteY65"/>
                </a:cxn>
                <a:cxn ang="0">
                  <a:pos x="connsiteX66" y="connsiteY66"/>
                </a:cxn>
                <a:cxn ang="0">
                  <a:pos x="connsiteX67" y="connsiteY67"/>
                </a:cxn>
                <a:cxn ang="0">
                  <a:pos x="connsiteX68" y="connsiteY68"/>
                </a:cxn>
                <a:cxn ang="0">
                  <a:pos x="connsiteX69" y="connsiteY69"/>
                </a:cxn>
                <a:cxn ang="0">
                  <a:pos x="connsiteX70" y="connsiteY70"/>
                </a:cxn>
                <a:cxn ang="0">
                  <a:pos x="connsiteX71" y="connsiteY71"/>
                </a:cxn>
                <a:cxn ang="0">
                  <a:pos x="connsiteX72" y="connsiteY72"/>
                </a:cxn>
                <a:cxn ang="0">
                  <a:pos x="connsiteX73" y="connsiteY73"/>
                </a:cxn>
                <a:cxn ang="0">
                  <a:pos x="connsiteX74" y="connsiteY74"/>
                </a:cxn>
                <a:cxn ang="0">
                  <a:pos x="connsiteX75" y="connsiteY75"/>
                </a:cxn>
                <a:cxn ang="0">
                  <a:pos x="connsiteX76" y="connsiteY76"/>
                </a:cxn>
                <a:cxn ang="0">
                  <a:pos x="connsiteX77" y="connsiteY77"/>
                </a:cxn>
                <a:cxn ang="0">
                  <a:pos x="connsiteX78" y="connsiteY78"/>
                </a:cxn>
                <a:cxn ang="0">
                  <a:pos x="connsiteX79" y="connsiteY79"/>
                </a:cxn>
                <a:cxn ang="0">
                  <a:pos x="connsiteX80" y="connsiteY80"/>
                </a:cxn>
                <a:cxn ang="0">
                  <a:pos x="connsiteX81" y="connsiteY81"/>
                </a:cxn>
                <a:cxn ang="0">
                  <a:pos x="connsiteX82" y="connsiteY82"/>
                </a:cxn>
                <a:cxn ang="0">
                  <a:pos x="connsiteX83" y="connsiteY83"/>
                </a:cxn>
                <a:cxn ang="0">
                  <a:pos x="connsiteX84" y="connsiteY84"/>
                </a:cxn>
                <a:cxn ang="0">
                  <a:pos x="connsiteX85" y="connsiteY85"/>
                </a:cxn>
                <a:cxn ang="0">
                  <a:pos x="connsiteX86" y="connsiteY86"/>
                </a:cxn>
                <a:cxn ang="0">
                  <a:pos x="connsiteX87" y="connsiteY87"/>
                </a:cxn>
                <a:cxn ang="0">
                  <a:pos x="connsiteX88" y="connsiteY88"/>
                </a:cxn>
                <a:cxn ang="0">
                  <a:pos x="connsiteX89" y="connsiteY89"/>
                </a:cxn>
                <a:cxn ang="0">
                  <a:pos x="connsiteX90" y="connsiteY90"/>
                </a:cxn>
                <a:cxn ang="0">
                  <a:pos x="connsiteX91" y="connsiteY91"/>
                </a:cxn>
                <a:cxn ang="0">
                  <a:pos x="connsiteX92" y="connsiteY92"/>
                </a:cxn>
                <a:cxn ang="0">
                  <a:pos x="connsiteX93" y="connsiteY93"/>
                </a:cxn>
                <a:cxn ang="0">
                  <a:pos x="connsiteX94" y="connsiteY94"/>
                </a:cxn>
                <a:cxn ang="0">
                  <a:pos x="connsiteX95" y="connsiteY95"/>
                </a:cxn>
                <a:cxn ang="0">
                  <a:pos x="connsiteX96" y="connsiteY96"/>
                </a:cxn>
                <a:cxn ang="0">
                  <a:pos x="connsiteX97" y="connsiteY97"/>
                </a:cxn>
                <a:cxn ang="0">
                  <a:pos x="connsiteX98" y="connsiteY98"/>
                </a:cxn>
                <a:cxn ang="0">
                  <a:pos x="connsiteX99" y="connsiteY99"/>
                </a:cxn>
                <a:cxn ang="0">
                  <a:pos x="connsiteX100" y="connsiteY100"/>
                </a:cxn>
                <a:cxn ang="0">
                  <a:pos x="connsiteX101" y="connsiteY101"/>
                </a:cxn>
                <a:cxn ang="0">
                  <a:pos x="connsiteX102" y="connsiteY102"/>
                </a:cxn>
                <a:cxn ang="0">
                  <a:pos x="connsiteX103" y="connsiteY103"/>
                </a:cxn>
                <a:cxn ang="0">
                  <a:pos x="connsiteX104" y="connsiteY104"/>
                </a:cxn>
                <a:cxn ang="0">
                  <a:pos x="connsiteX105" y="connsiteY105"/>
                </a:cxn>
                <a:cxn ang="0">
                  <a:pos x="connsiteX106" y="connsiteY106"/>
                </a:cxn>
                <a:cxn ang="0">
                  <a:pos x="connsiteX107" y="connsiteY107"/>
                </a:cxn>
                <a:cxn ang="0">
                  <a:pos x="connsiteX108" y="connsiteY108"/>
                </a:cxn>
                <a:cxn ang="0">
                  <a:pos x="connsiteX109" y="connsiteY109"/>
                </a:cxn>
                <a:cxn ang="0">
                  <a:pos x="connsiteX110" y="connsiteY110"/>
                </a:cxn>
                <a:cxn ang="0">
                  <a:pos x="connsiteX111" y="connsiteY111"/>
                </a:cxn>
                <a:cxn ang="0">
                  <a:pos x="connsiteX112" y="connsiteY112"/>
                </a:cxn>
                <a:cxn ang="0">
                  <a:pos x="connsiteX113" y="connsiteY113"/>
                </a:cxn>
                <a:cxn ang="0">
                  <a:pos x="connsiteX114" y="connsiteY114"/>
                </a:cxn>
                <a:cxn ang="0">
                  <a:pos x="connsiteX115" y="connsiteY115"/>
                </a:cxn>
                <a:cxn ang="0">
                  <a:pos x="connsiteX116" y="connsiteY116"/>
                </a:cxn>
                <a:cxn ang="0">
                  <a:pos x="connsiteX117" y="connsiteY117"/>
                </a:cxn>
                <a:cxn ang="0">
                  <a:pos x="connsiteX118" y="connsiteY118"/>
                </a:cxn>
                <a:cxn ang="0">
                  <a:pos x="connsiteX119" y="connsiteY119"/>
                </a:cxn>
                <a:cxn ang="0">
                  <a:pos x="connsiteX120" y="connsiteY120"/>
                </a:cxn>
                <a:cxn ang="0">
                  <a:pos x="connsiteX121" y="connsiteY121"/>
                </a:cxn>
                <a:cxn ang="0">
                  <a:pos x="connsiteX122" y="connsiteY122"/>
                </a:cxn>
                <a:cxn ang="0">
                  <a:pos x="connsiteX123" y="connsiteY123"/>
                </a:cxn>
              </a:cxnLst>
              <a:rect l="l" t="t" r="r" b="b"/>
              <a:pathLst>
                <a:path w="4458307" h="1320799">
                  <a:moveTo>
                    <a:pt x="33" y="1238646"/>
                  </a:moveTo>
                  <a:cubicBezTo>
                    <a:pt x="-1554" y="1252933"/>
                    <a:pt x="54008" y="1267221"/>
                    <a:pt x="76233" y="1273571"/>
                  </a:cubicBezTo>
                  <a:cubicBezTo>
                    <a:pt x="98458" y="1279921"/>
                    <a:pt x="111687" y="1273042"/>
                    <a:pt x="133383" y="1276746"/>
                  </a:cubicBezTo>
                  <a:cubicBezTo>
                    <a:pt x="155079" y="1280450"/>
                    <a:pt x="171483" y="1292092"/>
                    <a:pt x="206408" y="1295796"/>
                  </a:cubicBezTo>
                  <a:cubicBezTo>
                    <a:pt x="241333" y="1299500"/>
                    <a:pt x="295308" y="1295267"/>
                    <a:pt x="342933" y="1298971"/>
                  </a:cubicBezTo>
                  <a:cubicBezTo>
                    <a:pt x="390558" y="1302675"/>
                    <a:pt x="438712" y="1315375"/>
                    <a:pt x="492158" y="1318021"/>
                  </a:cubicBezTo>
                  <a:cubicBezTo>
                    <a:pt x="545604" y="1320667"/>
                    <a:pt x="610691" y="1323842"/>
                    <a:pt x="663608" y="1314846"/>
                  </a:cubicBezTo>
                  <a:cubicBezTo>
                    <a:pt x="716525" y="1305850"/>
                    <a:pt x="763091" y="1287329"/>
                    <a:pt x="809658" y="1264046"/>
                  </a:cubicBezTo>
                  <a:cubicBezTo>
                    <a:pt x="856225" y="1240763"/>
                    <a:pt x="911258" y="1197371"/>
                    <a:pt x="943008" y="1175146"/>
                  </a:cubicBezTo>
                  <a:cubicBezTo>
                    <a:pt x="974758" y="1152921"/>
                    <a:pt x="972112" y="1151333"/>
                    <a:pt x="1000158" y="1130696"/>
                  </a:cubicBezTo>
                  <a:cubicBezTo>
                    <a:pt x="1028204" y="1110058"/>
                    <a:pt x="1078475" y="1065079"/>
                    <a:pt x="1111283" y="1051321"/>
                  </a:cubicBezTo>
                  <a:cubicBezTo>
                    <a:pt x="1144091" y="1037563"/>
                    <a:pt x="1177429" y="1047617"/>
                    <a:pt x="1197008" y="1048146"/>
                  </a:cubicBezTo>
                  <a:cubicBezTo>
                    <a:pt x="1216587" y="1048675"/>
                    <a:pt x="1216587" y="1062963"/>
                    <a:pt x="1228758" y="1054496"/>
                  </a:cubicBezTo>
                  <a:cubicBezTo>
                    <a:pt x="1240929" y="1046029"/>
                    <a:pt x="1249925" y="1001579"/>
                    <a:pt x="1270033" y="997346"/>
                  </a:cubicBezTo>
                  <a:cubicBezTo>
                    <a:pt x="1290141" y="993113"/>
                    <a:pt x="1320833" y="1031213"/>
                    <a:pt x="1349408" y="1029096"/>
                  </a:cubicBezTo>
                  <a:cubicBezTo>
                    <a:pt x="1377983" y="1026979"/>
                    <a:pt x="1417671" y="997346"/>
                    <a:pt x="1441483" y="984646"/>
                  </a:cubicBezTo>
                  <a:cubicBezTo>
                    <a:pt x="1465296" y="971946"/>
                    <a:pt x="1471646" y="948663"/>
                    <a:pt x="1492283" y="952896"/>
                  </a:cubicBezTo>
                  <a:cubicBezTo>
                    <a:pt x="1512920" y="957129"/>
                    <a:pt x="1538321" y="1003167"/>
                    <a:pt x="1565308" y="1010046"/>
                  </a:cubicBezTo>
                  <a:cubicBezTo>
                    <a:pt x="1592295" y="1016925"/>
                    <a:pt x="1625633" y="992583"/>
                    <a:pt x="1654208" y="994171"/>
                  </a:cubicBezTo>
                  <a:cubicBezTo>
                    <a:pt x="1682783" y="995758"/>
                    <a:pt x="1715591" y="1017984"/>
                    <a:pt x="1736758" y="1019571"/>
                  </a:cubicBezTo>
                  <a:cubicBezTo>
                    <a:pt x="1757925" y="1021158"/>
                    <a:pt x="1767450" y="1022217"/>
                    <a:pt x="1781208" y="1003696"/>
                  </a:cubicBezTo>
                  <a:cubicBezTo>
                    <a:pt x="1794966" y="985175"/>
                    <a:pt x="1801846" y="937021"/>
                    <a:pt x="1819308" y="908446"/>
                  </a:cubicBezTo>
                  <a:cubicBezTo>
                    <a:pt x="1836770" y="879871"/>
                    <a:pt x="1858466" y="844417"/>
                    <a:pt x="1885983" y="832246"/>
                  </a:cubicBezTo>
                  <a:cubicBezTo>
                    <a:pt x="1913500" y="820075"/>
                    <a:pt x="1957420" y="820604"/>
                    <a:pt x="1984408" y="835421"/>
                  </a:cubicBezTo>
                  <a:cubicBezTo>
                    <a:pt x="2011396" y="850238"/>
                    <a:pt x="2030975" y="908975"/>
                    <a:pt x="2047908" y="921146"/>
                  </a:cubicBezTo>
                  <a:cubicBezTo>
                    <a:pt x="2064841" y="933317"/>
                    <a:pt x="2079129" y="925379"/>
                    <a:pt x="2086008" y="908446"/>
                  </a:cubicBezTo>
                  <a:cubicBezTo>
                    <a:pt x="2092887" y="891513"/>
                    <a:pt x="2078071" y="827483"/>
                    <a:pt x="2089183" y="819546"/>
                  </a:cubicBezTo>
                  <a:cubicBezTo>
                    <a:pt x="2100296" y="811608"/>
                    <a:pt x="2135221" y="849709"/>
                    <a:pt x="2152683" y="860821"/>
                  </a:cubicBezTo>
                  <a:cubicBezTo>
                    <a:pt x="2170145" y="871933"/>
                    <a:pt x="2177554" y="884104"/>
                    <a:pt x="2193958" y="886221"/>
                  </a:cubicBezTo>
                  <a:cubicBezTo>
                    <a:pt x="2210362" y="888338"/>
                    <a:pt x="2232587" y="879871"/>
                    <a:pt x="2251108" y="873521"/>
                  </a:cubicBezTo>
                  <a:cubicBezTo>
                    <a:pt x="2269629" y="867171"/>
                    <a:pt x="2284446" y="859233"/>
                    <a:pt x="2305083" y="848121"/>
                  </a:cubicBezTo>
                  <a:cubicBezTo>
                    <a:pt x="2325720" y="837009"/>
                    <a:pt x="2353766" y="807375"/>
                    <a:pt x="2374933" y="806846"/>
                  </a:cubicBezTo>
                  <a:cubicBezTo>
                    <a:pt x="2396100" y="806317"/>
                    <a:pt x="2410917" y="839654"/>
                    <a:pt x="2432083" y="844946"/>
                  </a:cubicBezTo>
                  <a:cubicBezTo>
                    <a:pt x="2453249" y="850238"/>
                    <a:pt x="2480237" y="836479"/>
                    <a:pt x="2501933" y="838596"/>
                  </a:cubicBezTo>
                  <a:cubicBezTo>
                    <a:pt x="2523629" y="840713"/>
                    <a:pt x="2542150" y="861350"/>
                    <a:pt x="2562258" y="857646"/>
                  </a:cubicBezTo>
                  <a:cubicBezTo>
                    <a:pt x="2582366" y="853942"/>
                    <a:pt x="2606179" y="827483"/>
                    <a:pt x="2622583" y="816371"/>
                  </a:cubicBezTo>
                  <a:cubicBezTo>
                    <a:pt x="2638987" y="805259"/>
                    <a:pt x="2649571" y="789913"/>
                    <a:pt x="2660683" y="790971"/>
                  </a:cubicBezTo>
                  <a:cubicBezTo>
                    <a:pt x="2671795" y="792029"/>
                    <a:pt x="2671796" y="812667"/>
                    <a:pt x="2689258" y="822721"/>
                  </a:cubicBezTo>
                  <a:cubicBezTo>
                    <a:pt x="2706720" y="832775"/>
                    <a:pt x="2739529" y="844417"/>
                    <a:pt x="2765458" y="851296"/>
                  </a:cubicBezTo>
                  <a:cubicBezTo>
                    <a:pt x="2791387" y="858175"/>
                    <a:pt x="2828958" y="875638"/>
                    <a:pt x="2844833" y="863996"/>
                  </a:cubicBezTo>
                  <a:cubicBezTo>
                    <a:pt x="2860708" y="852354"/>
                    <a:pt x="2841658" y="793088"/>
                    <a:pt x="2860708" y="781446"/>
                  </a:cubicBezTo>
                  <a:cubicBezTo>
                    <a:pt x="2879758" y="769804"/>
                    <a:pt x="2945375" y="780388"/>
                    <a:pt x="2959133" y="794146"/>
                  </a:cubicBezTo>
                  <a:cubicBezTo>
                    <a:pt x="2972891" y="807904"/>
                    <a:pt x="2940612" y="841771"/>
                    <a:pt x="2943258" y="863996"/>
                  </a:cubicBezTo>
                  <a:cubicBezTo>
                    <a:pt x="2945904" y="886221"/>
                    <a:pt x="2946962" y="925379"/>
                    <a:pt x="2975008" y="927496"/>
                  </a:cubicBezTo>
                  <a:cubicBezTo>
                    <a:pt x="3003054" y="929613"/>
                    <a:pt x="3078725" y="880929"/>
                    <a:pt x="3111533" y="876696"/>
                  </a:cubicBezTo>
                  <a:cubicBezTo>
                    <a:pt x="3144341" y="872463"/>
                    <a:pt x="3157041" y="892042"/>
                    <a:pt x="3171858" y="902096"/>
                  </a:cubicBezTo>
                  <a:cubicBezTo>
                    <a:pt x="3186675" y="912150"/>
                    <a:pt x="3186675" y="930671"/>
                    <a:pt x="3200433" y="937021"/>
                  </a:cubicBezTo>
                  <a:cubicBezTo>
                    <a:pt x="3214191" y="943371"/>
                    <a:pt x="3235358" y="947604"/>
                    <a:pt x="3254408" y="940196"/>
                  </a:cubicBezTo>
                  <a:cubicBezTo>
                    <a:pt x="3273458" y="932788"/>
                    <a:pt x="3290391" y="898921"/>
                    <a:pt x="3314733" y="892571"/>
                  </a:cubicBezTo>
                  <a:cubicBezTo>
                    <a:pt x="3339075" y="886221"/>
                    <a:pt x="3370296" y="900509"/>
                    <a:pt x="3400458" y="902096"/>
                  </a:cubicBezTo>
                  <a:cubicBezTo>
                    <a:pt x="3430620" y="903683"/>
                    <a:pt x="3495708" y="902096"/>
                    <a:pt x="3495708" y="902096"/>
                  </a:cubicBezTo>
                  <a:cubicBezTo>
                    <a:pt x="3517404" y="902096"/>
                    <a:pt x="3513171" y="907917"/>
                    <a:pt x="3530633" y="902096"/>
                  </a:cubicBezTo>
                  <a:cubicBezTo>
                    <a:pt x="3548095" y="896275"/>
                    <a:pt x="3572966" y="877225"/>
                    <a:pt x="3600483" y="867171"/>
                  </a:cubicBezTo>
                  <a:cubicBezTo>
                    <a:pt x="3628000" y="857117"/>
                    <a:pt x="3662396" y="844946"/>
                    <a:pt x="3695733" y="841771"/>
                  </a:cubicBezTo>
                  <a:cubicBezTo>
                    <a:pt x="3729070" y="838596"/>
                    <a:pt x="3777225" y="840183"/>
                    <a:pt x="3800508" y="848121"/>
                  </a:cubicBezTo>
                  <a:cubicBezTo>
                    <a:pt x="3823791" y="856058"/>
                    <a:pt x="3840196" y="871933"/>
                    <a:pt x="3835433" y="889396"/>
                  </a:cubicBezTo>
                  <a:cubicBezTo>
                    <a:pt x="3830670" y="906859"/>
                    <a:pt x="3785691" y="937550"/>
                    <a:pt x="3771933" y="952896"/>
                  </a:cubicBezTo>
                  <a:cubicBezTo>
                    <a:pt x="3758175" y="968242"/>
                    <a:pt x="3742829" y="976708"/>
                    <a:pt x="3752883" y="981471"/>
                  </a:cubicBezTo>
                  <a:cubicBezTo>
                    <a:pt x="3762937" y="986233"/>
                    <a:pt x="3826966" y="966654"/>
                    <a:pt x="3832258" y="981471"/>
                  </a:cubicBezTo>
                  <a:cubicBezTo>
                    <a:pt x="3837550" y="996288"/>
                    <a:pt x="3794687" y="1050792"/>
                    <a:pt x="3784633" y="1070371"/>
                  </a:cubicBezTo>
                  <a:cubicBezTo>
                    <a:pt x="3774579" y="1089950"/>
                    <a:pt x="3765054" y="1089950"/>
                    <a:pt x="3771933" y="1098946"/>
                  </a:cubicBezTo>
                  <a:cubicBezTo>
                    <a:pt x="3778812" y="1107942"/>
                    <a:pt x="3798391" y="1120642"/>
                    <a:pt x="3825908" y="1124346"/>
                  </a:cubicBezTo>
                  <a:cubicBezTo>
                    <a:pt x="3853425" y="1128050"/>
                    <a:pt x="3906341" y="1125404"/>
                    <a:pt x="3937033" y="1121171"/>
                  </a:cubicBezTo>
                  <a:cubicBezTo>
                    <a:pt x="3967725" y="1116938"/>
                    <a:pt x="3981483" y="1105825"/>
                    <a:pt x="4010058" y="1098946"/>
                  </a:cubicBezTo>
                  <a:cubicBezTo>
                    <a:pt x="4038633" y="1092067"/>
                    <a:pt x="4070383" y="1088363"/>
                    <a:pt x="4108483" y="1079896"/>
                  </a:cubicBezTo>
                  <a:cubicBezTo>
                    <a:pt x="4146583" y="1071429"/>
                    <a:pt x="4204791" y="1056083"/>
                    <a:pt x="4238658" y="1048146"/>
                  </a:cubicBezTo>
                  <a:cubicBezTo>
                    <a:pt x="4272525" y="1040208"/>
                    <a:pt x="4283637" y="1042854"/>
                    <a:pt x="4311683" y="1032271"/>
                  </a:cubicBezTo>
                  <a:cubicBezTo>
                    <a:pt x="4339729" y="1021688"/>
                    <a:pt x="4384708" y="997875"/>
                    <a:pt x="4406933" y="984646"/>
                  </a:cubicBezTo>
                  <a:cubicBezTo>
                    <a:pt x="4429158" y="971417"/>
                    <a:pt x="4436566" y="970358"/>
                    <a:pt x="4445033" y="952896"/>
                  </a:cubicBezTo>
                  <a:cubicBezTo>
                    <a:pt x="4453500" y="935434"/>
                    <a:pt x="4460379" y="905271"/>
                    <a:pt x="4457733" y="879871"/>
                  </a:cubicBezTo>
                  <a:cubicBezTo>
                    <a:pt x="4455087" y="854471"/>
                    <a:pt x="4442916" y="828013"/>
                    <a:pt x="4429158" y="800496"/>
                  </a:cubicBezTo>
                  <a:cubicBezTo>
                    <a:pt x="4415400" y="772979"/>
                    <a:pt x="4393175" y="742288"/>
                    <a:pt x="4375183" y="714771"/>
                  </a:cubicBezTo>
                  <a:cubicBezTo>
                    <a:pt x="4357191" y="687254"/>
                    <a:pt x="4343433" y="661325"/>
                    <a:pt x="4321208" y="635396"/>
                  </a:cubicBezTo>
                  <a:cubicBezTo>
                    <a:pt x="4298983" y="609467"/>
                    <a:pt x="4265116" y="580892"/>
                    <a:pt x="4241833" y="559196"/>
                  </a:cubicBezTo>
                  <a:cubicBezTo>
                    <a:pt x="4218550" y="537500"/>
                    <a:pt x="4211141" y="527446"/>
                    <a:pt x="4181508" y="505221"/>
                  </a:cubicBezTo>
                  <a:cubicBezTo>
                    <a:pt x="4151875" y="482996"/>
                    <a:pt x="4100546" y="449129"/>
                    <a:pt x="4064033" y="425846"/>
                  </a:cubicBezTo>
                  <a:cubicBezTo>
                    <a:pt x="4027521" y="402563"/>
                    <a:pt x="3995770" y="379279"/>
                    <a:pt x="3962433" y="365521"/>
                  </a:cubicBezTo>
                  <a:cubicBezTo>
                    <a:pt x="3929096" y="351763"/>
                    <a:pt x="3906341" y="349646"/>
                    <a:pt x="3864008" y="343296"/>
                  </a:cubicBezTo>
                  <a:cubicBezTo>
                    <a:pt x="3821675" y="336946"/>
                    <a:pt x="3750237" y="330596"/>
                    <a:pt x="3708433" y="327421"/>
                  </a:cubicBezTo>
                  <a:cubicBezTo>
                    <a:pt x="3666629" y="324246"/>
                    <a:pt x="3654987" y="338004"/>
                    <a:pt x="3613183" y="324246"/>
                  </a:cubicBezTo>
                  <a:cubicBezTo>
                    <a:pt x="3571379" y="310488"/>
                    <a:pt x="3497825" y="271858"/>
                    <a:pt x="3457608" y="244871"/>
                  </a:cubicBezTo>
                  <a:cubicBezTo>
                    <a:pt x="3417391" y="217884"/>
                    <a:pt x="3396754" y="181900"/>
                    <a:pt x="3371883" y="162321"/>
                  </a:cubicBezTo>
                  <a:cubicBezTo>
                    <a:pt x="3347012" y="142742"/>
                    <a:pt x="3336958" y="132158"/>
                    <a:pt x="3308383" y="127396"/>
                  </a:cubicBezTo>
                  <a:cubicBezTo>
                    <a:pt x="3279808" y="122634"/>
                    <a:pt x="3234300" y="136921"/>
                    <a:pt x="3200433" y="133746"/>
                  </a:cubicBezTo>
                  <a:cubicBezTo>
                    <a:pt x="3166566" y="130571"/>
                    <a:pt x="3137991" y="118929"/>
                    <a:pt x="3105183" y="108346"/>
                  </a:cubicBezTo>
                  <a:cubicBezTo>
                    <a:pt x="3072375" y="97763"/>
                    <a:pt x="3048033" y="85063"/>
                    <a:pt x="3003583" y="70246"/>
                  </a:cubicBezTo>
                  <a:cubicBezTo>
                    <a:pt x="2959133" y="55429"/>
                    <a:pt x="2888225" y="30558"/>
                    <a:pt x="2838483" y="19446"/>
                  </a:cubicBezTo>
                  <a:cubicBezTo>
                    <a:pt x="2788741" y="8334"/>
                    <a:pt x="2739529" y="6746"/>
                    <a:pt x="2705133" y="3571"/>
                  </a:cubicBezTo>
                  <a:cubicBezTo>
                    <a:pt x="2670737" y="396"/>
                    <a:pt x="2665975" y="-662"/>
                    <a:pt x="2632108" y="396"/>
                  </a:cubicBezTo>
                  <a:cubicBezTo>
                    <a:pt x="2598241" y="1454"/>
                    <a:pt x="2537387" y="7804"/>
                    <a:pt x="2501933" y="9921"/>
                  </a:cubicBezTo>
                  <a:cubicBezTo>
                    <a:pt x="2466479" y="12038"/>
                    <a:pt x="2446900" y="14154"/>
                    <a:pt x="2419383" y="13096"/>
                  </a:cubicBezTo>
                  <a:cubicBezTo>
                    <a:pt x="2391866" y="12038"/>
                    <a:pt x="2364879" y="1454"/>
                    <a:pt x="2336833" y="3571"/>
                  </a:cubicBezTo>
                  <a:cubicBezTo>
                    <a:pt x="2308787" y="5688"/>
                    <a:pt x="2251108" y="25796"/>
                    <a:pt x="2251108" y="25796"/>
                  </a:cubicBezTo>
                  <a:cubicBezTo>
                    <a:pt x="2217241" y="34792"/>
                    <a:pt x="2169087" y="50667"/>
                    <a:pt x="2133633" y="57546"/>
                  </a:cubicBezTo>
                  <a:cubicBezTo>
                    <a:pt x="2098179" y="64425"/>
                    <a:pt x="2038383" y="67071"/>
                    <a:pt x="2038383" y="67071"/>
                  </a:cubicBezTo>
                  <a:lnTo>
                    <a:pt x="1946308" y="76596"/>
                  </a:lnTo>
                  <a:cubicBezTo>
                    <a:pt x="1915616" y="79771"/>
                    <a:pt x="1887571" y="79771"/>
                    <a:pt x="1854233" y="86121"/>
                  </a:cubicBezTo>
                  <a:cubicBezTo>
                    <a:pt x="1820896" y="92471"/>
                    <a:pt x="1779620" y="106229"/>
                    <a:pt x="1746283" y="114696"/>
                  </a:cubicBezTo>
                  <a:cubicBezTo>
                    <a:pt x="1712946" y="123163"/>
                    <a:pt x="1679608" y="130042"/>
                    <a:pt x="1654208" y="136921"/>
                  </a:cubicBezTo>
                  <a:cubicBezTo>
                    <a:pt x="1628808" y="143800"/>
                    <a:pt x="1617166" y="146975"/>
                    <a:pt x="1593883" y="155971"/>
                  </a:cubicBezTo>
                  <a:cubicBezTo>
                    <a:pt x="1570600" y="164967"/>
                    <a:pt x="1539908" y="179254"/>
                    <a:pt x="1514508" y="190896"/>
                  </a:cubicBezTo>
                  <a:cubicBezTo>
                    <a:pt x="1489108" y="202538"/>
                    <a:pt x="1467941" y="214708"/>
                    <a:pt x="1441483" y="225821"/>
                  </a:cubicBezTo>
                  <a:cubicBezTo>
                    <a:pt x="1415025" y="236933"/>
                    <a:pt x="1376395" y="250692"/>
                    <a:pt x="1355758" y="257571"/>
                  </a:cubicBezTo>
                  <a:cubicBezTo>
                    <a:pt x="1335121" y="264450"/>
                    <a:pt x="1317658" y="267096"/>
                    <a:pt x="1317658" y="267096"/>
                  </a:cubicBezTo>
                  <a:lnTo>
                    <a:pt x="1209708" y="292496"/>
                  </a:lnTo>
                  <a:cubicBezTo>
                    <a:pt x="1174254" y="300433"/>
                    <a:pt x="1136154" y="306254"/>
                    <a:pt x="1104933" y="314721"/>
                  </a:cubicBezTo>
                  <a:cubicBezTo>
                    <a:pt x="1073712" y="323188"/>
                    <a:pt x="1048312" y="330596"/>
                    <a:pt x="1022383" y="343296"/>
                  </a:cubicBezTo>
                  <a:cubicBezTo>
                    <a:pt x="996454" y="355996"/>
                    <a:pt x="972112" y="373988"/>
                    <a:pt x="949358" y="390921"/>
                  </a:cubicBezTo>
                  <a:cubicBezTo>
                    <a:pt x="926604" y="407854"/>
                    <a:pt x="911258" y="427433"/>
                    <a:pt x="885858" y="444896"/>
                  </a:cubicBezTo>
                  <a:cubicBezTo>
                    <a:pt x="860458" y="462359"/>
                    <a:pt x="825004" y="481938"/>
                    <a:pt x="796958" y="495696"/>
                  </a:cubicBezTo>
                  <a:cubicBezTo>
                    <a:pt x="768912" y="509454"/>
                    <a:pt x="742983" y="514746"/>
                    <a:pt x="717583" y="527446"/>
                  </a:cubicBezTo>
                  <a:cubicBezTo>
                    <a:pt x="692183" y="540146"/>
                    <a:pt x="669429" y="557079"/>
                    <a:pt x="644558" y="571896"/>
                  </a:cubicBezTo>
                  <a:cubicBezTo>
                    <a:pt x="619687" y="586713"/>
                    <a:pt x="597462" y="598354"/>
                    <a:pt x="568358" y="616346"/>
                  </a:cubicBezTo>
                  <a:cubicBezTo>
                    <a:pt x="539254" y="634338"/>
                    <a:pt x="495862" y="661325"/>
                    <a:pt x="469933" y="679846"/>
                  </a:cubicBezTo>
                  <a:cubicBezTo>
                    <a:pt x="444004" y="698367"/>
                    <a:pt x="435537" y="710008"/>
                    <a:pt x="412783" y="727471"/>
                  </a:cubicBezTo>
                  <a:cubicBezTo>
                    <a:pt x="390029" y="744933"/>
                    <a:pt x="352987" y="768746"/>
                    <a:pt x="333408" y="784621"/>
                  </a:cubicBezTo>
                  <a:cubicBezTo>
                    <a:pt x="313829" y="800496"/>
                    <a:pt x="314887" y="806317"/>
                    <a:pt x="295308" y="822721"/>
                  </a:cubicBezTo>
                  <a:cubicBezTo>
                    <a:pt x="275729" y="839125"/>
                    <a:pt x="236570" y="863467"/>
                    <a:pt x="215933" y="883046"/>
                  </a:cubicBezTo>
                  <a:cubicBezTo>
                    <a:pt x="195296" y="902625"/>
                    <a:pt x="182595" y="922205"/>
                    <a:pt x="171483" y="940196"/>
                  </a:cubicBezTo>
                  <a:cubicBezTo>
                    <a:pt x="160371" y="958187"/>
                    <a:pt x="156137" y="974063"/>
                    <a:pt x="149258" y="990996"/>
                  </a:cubicBezTo>
                  <a:cubicBezTo>
                    <a:pt x="142379" y="1007929"/>
                    <a:pt x="130208" y="1041796"/>
                    <a:pt x="130208" y="1041796"/>
                  </a:cubicBezTo>
                  <a:cubicBezTo>
                    <a:pt x="122271" y="1062963"/>
                    <a:pt x="109041" y="1093654"/>
                    <a:pt x="101633" y="1117996"/>
                  </a:cubicBezTo>
                  <a:cubicBezTo>
                    <a:pt x="94225" y="1142338"/>
                    <a:pt x="98987" y="1169854"/>
                    <a:pt x="85758" y="1187846"/>
                  </a:cubicBezTo>
                  <a:cubicBezTo>
                    <a:pt x="72529" y="1205838"/>
                    <a:pt x="1620" y="1224359"/>
                    <a:pt x="33" y="1238646"/>
                  </a:cubicBezTo>
                  <a:close/>
                </a:path>
              </a:pathLst>
            </a:custGeom>
            <a:noFill/>
            <a:ln w="38100"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9666"/>
            </a:p>
          </p:txBody>
        </p:sp>
      </p:grpSp>
      <p:sp>
        <p:nvSpPr>
          <p:cNvPr id="206" name="TextBox 205"/>
          <p:cNvSpPr txBox="1"/>
          <p:nvPr/>
        </p:nvSpPr>
        <p:spPr>
          <a:xfrm>
            <a:off x="13317624" y="1858425"/>
            <a:ext cx="2427949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800" b="1" dirty="0">
                <a:solidFill>
                  <a:schemeClr val="bg1"/>
                </a:solidFill>
              </a:rPr>
              <a:t>Decidua</a:t>
            </a:r>
          </a:p>
        </p:txBody>
      </p:sp>
      <p:sp>
        <p:nvSpPr>
          <p:cNvPr id="207" name="TextBox 206"/>
          <p:cNvSpPr txBox="1"/>
          <p:nvPr/>
        </p:nvSpPr>
        <p:spPr>
          <a:xfrm>
            <a:off x="13317627" y="4048211"/>
            <a:ext cx="126020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800" b="1" dirty="0">
                <a:solidFill>
                  <a:schemeClr val="bg1"/>
                </a:solidFill>
              </a:rPr>
              <a:t>JZ</a:t>
            </a:r>
          </a:p>
        </p:txBody>
      </p:sp>
      <p:sp>
        <p:nvSpPr>
          <p:cNvPr id="208" name="TextBox 207"/>
          <p:cNvSpPr txBox="1"/>
          <p:nvPr/>
        </p:nvSpPr>
        <p:spPr>
          <a:xfrm>
            <a:off x="13317630" y="6047071"/>
            <a:ext cx="2427949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800" b="1" dirty="0">
                <a:solidFill>
                  <a:schemeClr val="bg1"/>
                </a:solidFill>
              </a:rPr>
              <a:t>Labyrinth</a:t>
            </a:r>
          </a:p>
        </p:txBody>
      </p:sp>
      <p:cxnSp>
        <p:nvCxnSpPr>
          <p:cNvPr id="209" name="Straight Connector 208"/>
          <p:cNvCxnSpPr/>
          <p:nvPr/>
        </p:nvCxnSpPr>
        <p:spPr>
          <a:xfrm flipV="1">
            <a:off x="16948187" y="6645480"/>
            <a:ext cx="889694" cy="0"/>
          </a:xfrm>
          <a:prstGeom prst="line">
            <a:avLst/>
          </a:prstGeom>
          <a:ln w="762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0" name="Freeform 209"/>
          <p:cNvSpPr/>
          <p:nvPr/>
        </p:nvSpPr>
        <p:spPr>
          <a:xfrm>
            <a:off x="13373448" y="3288577"/>
            <a:ext cx="4592902" cy="540787"/>
          </a:xfrm>
          <a:custGeom>
            <a:avLst/>
            <a:gdLst>
              <a:gd name="connsiteX0" fmla="*/ 0 w 1893094"/>
              <a:gd name="connsiteY0" fmla="*/ 209550 h 209550"/>
              <a:gd name="connsiteX1" fmla="*/ 42862 w 1893094"/>
              <a:gd name="connsiteY1" fmla="*/ 202407 h 209550"/>
              <a:gd name="connsiteX2" fmla="*/ 71437 w 1893094"/>
              <a:gd name="connsiteY2" fmla="*/ 195263 h 209550"/>
              <a:gd name="connsiteX3" fmla="*/ 83344 w 1893094"/>
              <a:gd name="connsiteY3" fmla="*/ 192882 h 209550"/>
              <a:gd name="connsiteX4" fmla="*/ 185737 w 1893094"/>
              <a:gd name="connsiteY4" fmla="*/ 190500 h 209550"/>
              <a:gd name="connsiteX5" fmla="*/ 207169 w 1893094"/>
              <a:gd name="connsiteY5" fmla="*/ 185738 h 209550"/>
              <a:gd name="connsiteX6" fmla="*/ 221456 w 1893094"/>
              <a:gd name="connsiteY6" fmla="*/ 180975 h 209550"/>
              <a:gd name="connsiteX7" fmla="*/ 228600 w 1893094"/>
              <a:gd name="connsiteY7" fmla="*/ 178594 h 209550"/>
              <a:gd name="connsiteX8" fmla="*/ 235744 w 1893094"/>
              <a:gd name="connsiteY8" fmla="*/ 176213 h 209550"/>
              <a:gd name="connsiteX9" fmla="*/ 257175 w 1893094"/>
              <a:gd name="connsiteY9" fmla="*/ 164307 h 209550"/>
              <a:gd name="connsiteX10" fmla="*/ 278606 w 1893094"/>
              <a:gd name="connsiteY10" fmla="*/ 154782 h 209550"/>
              <a:gd name="connsiteX11" fmla="*/ 285750 w 1893094"/>
              <a:gd name="connsiteY11" fmla="*/ 152400 h 209550"/>
              <a:gd name="connsiteX12" fmla="*/ 323850 w 1893094"/>
              <a:gd name="connsiteY12" fmla="*/ 147638 h 209550"/>
              <a:gd name="connsiteX13" fmla="*/ 338137 w 1893094"/>
              <a:gd name="connsiteY13" fmla="*/ 142875 h 209550"/>
              <a:gd name="connsiteX14" fmla="*/ 345281 w 1893094"/>
              <a:gd name="connsiteY14" fmla="*/ 138113 h 209550"/>
              <a:gd name="connsiteX15" fmla="*/ 357187 w 1893094"/>
              <a:gd name="connsiteY15" fmla="*/ 135732 h 209550"/>
              <a:gd name="connsiteX16" fmla="*/ 378619 w 1893094"/>
              <a:gd name="connsiteY16" fmla="*/ 126207 h 209550"/>
              <a:gd name="connsiteX17" fmla="*/ 385762 w 1893094"/>
              <a:gd name="connsiteY17" fmla="*/ 123825 h 209550"/>
              <a:gd name="connsiteX18" fmla="*/ 400050 w 1893094"/>
              <a:gd name="connsiteY18" fmla="*/ 116682 h 209550"/>
              <a:gd name="connsiteX19" fmla="*/ 423862 w 1893094"/>
              <a:gd name="connsiteY19" fmla="*/ 111919 h 209550"/>
              <a:gd name="connsiteX20" fmla="*/ 450056 w 1893094"/>
              <a:gd name="connsiteY20" fmla="*/ 104775 h 209550"/>
              <a:gd name="connsiteX21" fmla="*/ 464344 w 1893094"/>
              <a:gd name="connsiteY21" fmla="*/ 100013 h 209550"/>
              <a:gd name="connsiteX22" fmla="*/ 471487 w 1893094"/>
              <a:gd name="connsiteY22" fmla="*/ 97632 h 209550"/>
              <a:gd name="connsiteX23" fmla="*/ 495300 w 1893094"/>
              <a:gd name="connsiteY23" fmla="*/ 95250 h 209550"/>
              <a:gd name="connsiteX24" fmla="*/ 507206 w 1893094"/>
              <a:gd name="connsiteY24" fmla="*/ 92869 h 209550"/>
              <a:gd name="connsiteX25" fmla="*/ 542925 w 1893094"/>
              <a:gd name="connsiteY25" fmla="*/ 90488 h 209550"/>
              <a:gd name="connsiteX26" fmla="*/ 702469 w 1893094"/>
              <a:gd name="connsiteY26" fmla="*/ 92869 h 209550"/>
              <a:gd name="connsiteX27" fmla="*/ 709612 w 1893094"/>
              <a:gd name="connsiteY27" fmla="*/ 95250 h 209550"/>
              <a:gd name="connsiteX28" fmla="*/ 719137 w 1893094"/>
              <a:gd name="connsiteY28" fmla="*/ 97632 h 209550"/>
              <a:gd name="connsiteX29" fmla="*/ 726281 w 1893094"/>
              <a:gd name="connsiteY29" fmla="*/ 100013 h 209550"/>
              <a:gd name="connsiteX30" fmla="*/ 738187 w 1893094"/>
              <a:gd name="connsiteY30" fmla="*/ 102394 h 209550"/>
              <a:gd name="connsiteX31" fmla="*/ 745331 w 1893094"/>
              <a:gd name="connsiteY31" fmla="*/ 104775 h 209550"/>
              <a:gd name="connsiteX32" fmla="*/ 757237 w 1893094"/>
              <a:gd name="connsiteY32" fmla="*/ 107157 h 209550"/>
              <a:gd name="connsiteX33" fmla="*/ 773906 w 1893094"/>
              <a:gd name="connsiteY33" fmla="*/ 111919 h 209550"/>
              <a:gd name="connsiteX34" fmla="*/ 788194 w 1893094"/>
              <a:gd name="connsiteY34" fmla="*/ 119063 h 209550"/>
              <a:gd name="connsiteX35" fmla="*/ 802481 w 1893094"/>
              <a:gd name="connsiteY35" fmla="*/ 126207 h 209550"/>
              <a:gd name="connsiteX36" fmla="*/ 862012 w 1893094"/>
              <a:gd name="connsiteY36" fmla="*/ 128588 h 209550"/>
              <a:gd name="connsiteX37" fmla="*/ 869156 w 1893094"/>
              <a:gd name="connsiteY37" fmla="*/ 133350 h 209550"/>
              <a:gd name="connsiteX38" fmla="*/ 881062 w 1893094"/>
              <a:gd name="connsiteY38" fmla="*/ 145257 h 209550"/>
              <a:gd name="connsiteX39" fmla="*/ 892969 w 1893094"/>
              <a:gd name="connsiteY39" fmla="*/ 154782 h 209550"/>
              <a:gd name="connsiteX40" fmla="*/ 900112 w 1893094"/>
              <a:gd name="connsiteY40" fmla="*/ 159544 h 209550"/>
              <a:gd name="connsiteX41" fmla="*/ 933450 w 1893094"/>
              <a:gd name="connsiteY41" fmla="*/ 166688 h 209550"/>
              <a:gd name="connsiteX42" fmla="*/ 973931 w 1893094"/>
              <a:gd name="connsiteY42" fmla="*/ 161925 h 209550"/>
              <a:gd name="connsiteX43" fmla="*/ 988219 w 1893094"/>
              <a:gd name="connsiteY43" fmla="*/ 157163 h 209550"/>
              <a:gd name="connsiteX44" fmla="*/ 1012031 w 1893094"/>
              <a:gd name="connsiteY44" fmla="*/ 150019 h 209550"/>
              <a:gd name="connsiteX45" fmla="*/ 1019175 w 1893094"/>
              <a:gd name="connsiteY45" fmla="*/ 145257 h 209550"/>
              <a:gd name="connsiteX46" fmla="*/ 1040606 w 1893094"/>
              <a:gd name="connsiteY46" fmla="*/ 138113 h 209550"/>
              <a:gd name="connsiteX47" fmla="*/ 1047750 w 1893094"/>
              <a:gd name="connsiteY47" fmla="*/ 135732 h 209550"/>
              <a:gd name="connsiteX48" fmla="*/ 1054894 w 1893094"/>
              <a:gd name="connsiteY48" fmla="*/ 133350 h 209550"/>
              <a:gd name="connsiteX49" fmla="*/ 1066800 w 1893094"/>
              <a:gd name="connsiteY49" fmla="*/ 130969 h 209550"/>
              <a:gd name="connsiteX50" fmla="*/ 1102519 w 1893094"/>
              <a:gd name="connsiteY50" fmla="*/ 123825 h 209550"/>
              <a:gd name="connsiteX51" fmla="*/ 1116806 w 1893094"/>
              <a:gd name="connsiteY51" fmla="*/ 119063 h 209550"/>
              <a:gd name="connsiteX52" fmla="*/ 1123950 w 1893094"/>
              <a:gd name="connsiteY52" fmla="*/ 116682 h 209550"/>
              <a:gd name="connsiteX53" fmla="*/ 1152525 w 1893094"/>
              <a:gd name="connsiteY53" fmla="*/ 92869 h 209550"/>
              <a:gd name="connsiteX54" fmla="*/ 1171575 w 1893094"/>
              <a:gd name="connsiteY54" fmla="*/ 71438 h 209550"/>
              <a:gd name="connsiteX55" fmla="*/ 1185862 w 1893094"/>
              <a:gd name="connsiteY55" fmla="*/ 61913 h 209550"/>
              <a:gd name="connsiteX56" fmla="*/ 1204912 w 1893094"/>
              <a:gd name="connsiteY56" fmla="*/ 52388 h 209550"/>
              <a:gd name="connsiteX57" fmla="*/ 1219200 w 1893094"/>
              <a:gd name="connsiteY57" fmla="*/ 40482 h 209550"/>
              <a:gd name="connsiteX58" fmla="*/ 1226344 w 1893094"/>
              <a:gd name="connsiteY58" fmla="*/ 35719 h 209550"/>
              <a:gd name="connsiteX59" fmla="*/ 1233487 w 1893094"/>
              <a:gd name="connsiteY59" fmla="*/ 28575 h 209550"/>
              <a:gd name="connsiteX60" fmla="*/ 1247775 w 1893094"/>
              <a:gd name="connsiteY60" fmla="*/ 19050 h 209550"/>
              <a:gd name="connsiteX61" fmla="*/ 1259681 w 1893094"/>
              <a:gd name="connsiteY61" fmla="*/ 9525 h 209550"/>
              <a:gd name="connsiteX62" fmla="*/ 1271587 w 1893094"/>
              <a:gd name="connsiteY62" fmla="*/ 0 h 209550"/>
              <a:gd name="connsiteX63" fmla="*/ 1316831 w 1893094"/>
              <a:gd name="connsiteY63" fmla="*/ 2382 h 209550"/>
              <a:gd name="connsiteX64" fmla="*/ 1381125 w 1893094"/>
              <a:gd name="connsiteY64" fmla="*/ 4763 h 209550"/>
              <a:gd name="connsiteX65" fmla="*/ 1402556 w 1893094"/>
              <a:gd name="connsiteY65" fmla="*/ 7144 h 209550"/>
              <a:gd name="connsiteX66" fmla="*/ 1426369 w 1893094"/>
              <a:gd name="connsiteY66" fmla="*/ 9525 h 209550"/>
              <a:gd name="connsiteX67" fmla="*/ 1504950 w 1893094"/>
              <a:gd name="connsiteY67" fmla="*/ 14288 h 209550"/>
              <a:gd name="connsiteX68" fmla="*/ 1521619 w 1893094"/>
              <a:gd name="connsiteY68" fmla="*/ 16669 h 209550"/>
              <a:gd name="connsiteX69" fmla="*/ 1547812 w 1893094"/>
              <a:gd name="connsiteY69" fmla="*/ 21432 h 209550"/>
              <a:gd name="connsiteX70" fmla="*/ 1554956 w 1893094"/>
              <a:gd name="connsiteY70" fmla="*/ 23813 h 209550"/>
              <a:gd name="connsiteX71" fmla="*/ 1564481 w 1893094"/>
              <a:gd name="connsiteY71" fmla="*/ 26194 h 209550"/>
              <a:gd name="connsiteX72" fmla="*/ 1583531 w 1893094"/>
              <a:gd name="connsiteY72" fmla="*/ 33338 h 209550"/>
              <a:gd name="connsiteX73" fmla="*/ 1645444 w 1893094"/>
              <a:gd name="connsiteY73" fmla="*/ 38100 h 209550"/>
              <a:gd name="connsiteX74" fmla="*/ 1728787 w 1893094"/>
              <a:gd name="connsiteY74" fmla="*/ 42863 h 209550"/>
              <a:gd name="connsiteX75" fmla="*/ 1759744 w 1893094"/>
              <a:gd name="connsiteY75" fmla="*/ 50007 h 209550"/>
              <a:gd name="connsiteX76" fmla="*/ 1771650 w 1893094"/>
              <a:gd name="connsiteY76" fmla="*/ 52388 h 209550"/>
              <a:gd name="connsiteX77" fmla="*/ 1781175 w 1893094"/>
              <a:gd name="connsiteY77" fmla="*/ 54769 h 209550"/>
              <a:gd name="connsiteX78" fmla="*/ 1793081 w 1893094"/>
              <a:gd name="connsiteY78" fmla="*/ 57150 h 209550"/>
              <a:gd name="connsiteX79" fmla="*/ 1800225 w 1893094"/>
              <a:gd name="connsiteY79" fmla="*/ 59532 h 209550"/>
              <a:gd name="connsiteX80" fmla="*/ 1826419 w 1893094"/>
              <a:gd name="connsiteY80" fmla="*/ 64294 h 209550"/>
              <a:gd name="connsiteX81" fmla="*/ 1840706 w 1893094"/>
              <a:gd name="connsiteY81" fmla="*/ 69057 h 209550"/>
              <a:gd name="connsiteX82" fmla="*/ 1850231 w 1893094"/>
              <a:gd name="connsiteY82" fmla="*/ 71438 h 209550"/>
              <a:gd name="connsiteX83" fmla="*/ 1862137 w 1893094"/>
              <a:gd name="connsiteY83" fmla="*/ 73819 h 209550"/>
              <a:gd name="connsiteX84" fmla="*/ 1869281 w 1893094"/>
              <a:gd name="connsiteY84" fmla="*/ 76200 h 209550"/>
              <a:gd name="connsiteX85" fmla="*/ 1893094 w 1893094"/>
              <a:gd name="connsiteY85" fmla="*/ 76200 h 20955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  <a:cxn ang="0">
                <a:pos x="connsiteX31" y="connsiteY31"/>
              </a:cxn>
              <a:cxn ang="0">
                <a:pos x="connsiteX32" y="connsiteY32"/>
              </a:cxn>
              <a:cxn ang="0">
                <a:pos x="connsiteX33" y="connsiteY33"/>
              </a:cxn>
              <a:cxn ang="0">
                <a:pos x="connsiteX34" y="connsiteY34"/>
              </a:cxn>
              <a:cxn ang="0">
                <a:pos x="connsiteX35" y="connsiteY35"/>
              </a:cxn>
              <a:cxn ang="0">
                <a:pos x="connsiteX36" y="connsiteY36"/>
              </a:cxn>
              <a:cxn ang="0">
                <a:pos x="connsiteX37" y="connsiteY37"/>
              </a:cxn>
              <a:cxn ang="0">
                <a:pos x="connsiteX38" y="connsiteY38"/>
              </a:cxn>
              <a:cxn ang="0">
                <a:pos x="connsiteX39" y="connsiteY39"/>
              </a:cxn>
              <a:cxn ang="0">
                <a:pos x="connsiteX40" y="connsiteY40"/>
              </a:cxn>
              <a:cxn ang="0">
                <a:pos x="connsiteX41" y="connsiteY41"/>
              </a:cxn>
              <a:cxn ang="0">
                <a:pos x="connsiteX42" y="connsiteY42"/>
              </a:cxn>
              <a:cxn ang="0">
                <a:pos x="connsiteX43" y="connsiteY43"/>
              </a:cxn>
              <a:cxn ang="0">
                <a:pos x="connsiteX44" y="connsiteY44"/>
              </a:cxn>
              <a:cxn ang="0">
                <a:pos x="connsiteX45" y="connsiteY45"/>
              </a:cxn>
              <a:cxn ang="0">
                <a:pos x="connsiteX46" y="connsiteY46"/>
              </a:cxn>
              <a:cxn ang="0">
                <a:pos x="connsiteX47" y="connsiteY47"/>
              </a:cxn>
              <a:cxn ang="0">
                <a:pos x="connsiteX48" y="connsiteY48"/>
              </a:cxn>
              <a:cxn ang="0">
                <a:pos x="connsiteX49" y="connsiteY49"/>
              </a:cxn>
              <a:cxn ang="0">
                <a:pos x="connsiteX50" y="connsiteY50"/>
              </a:cxn>
              <a:cxn ang="0">
                <a:pos x="connsiteX51" y="connsiteY51"/>
              </a:cxn>
              <a:cxn ang="0">
                <a:pos x="connsiteX52" y="connsiteY52"/>
              </a:cxn>
              <a:cxn ang="0">
                <a:pos x="connsiteX53" y="connsiteY53"/>
              </a:cxn>
              <a:cxn ang="0">
                <a:pos x="connsiteX54" y="connsiteY54"/>
              </a:cxn>
              <a:cxn ang="0">
                <a:pos x="connsiteX55" y="connsiteY55"/>
              </a:cxn>
              <a:cxn ang="0">
                <a:pos x="connsiteX56" y="connsiteY56"/>
              </a:cxn>
              <a:cxn ang="0">
                <a:pos x="connsiteX57" y="connsiteY57"/>
              </a:cxn>
              <a:cxn ang="0">
                <a:pos x="connsiteX58" y="connsiteY58"/>
              </a:cxn>
              <a:cxn ang="0">
                <a:pos x="connsiteX59" y="connsiteY59"/>
              </a:cxn>
              <a:cxn ang="0">
                <a:pos x="connsiteX60" y="connsiteY60"/>
              </a:cxn>
              <a:cxn ang="0">
                <a:pos x="connsiteX61" y="connsiteY61"/>
              </a:cxn>
              <a:cxn ang="0">
                <a:pos x="connsiteX62" y="connsiteY62"/>
              </a:cxn>
              <a:cxn ang="0">
                <a:pos x="connsiteX63" y="connsiteY63"/>
              </a:cxn>
              <a:cxn ang="0">
                <a:pos x="connsiteX64" y="connsiteY64"/>
              </a:cxn>
              <a:cxn ang="0">
                <a:pos x="connsiteX65" y="connsiteY65"/>
              </a:cxn>
              <a:cxn ang="0">
                <a:pos x="connsiteX66" y="connsiteY66"/>
              </a:cxn>
              <a:cxn ang="0">
                <a:pos x="connsiteX67" y="connsiteY67"/>
              </a:cxn>
              <a:cxn ang="0">
                <a:pos x="connsiteX68" y="connsiteY68"/>
              </a:cxn>
              <a:cxn ang="0">
                <a:pos x="connsiteX69" y="connsiteY69"/>
              </a:cxn>
              <a:cxn ang="0">
                <a:pos x="connsiteX70" y="connsiteY70"/>
              </a:cxn>
              <a:cxn ang="0">
                <a:pos x="connsiteX71" y="connsiteY71"/>
              </a:cxn>
              <a:cxn ang="0">
                <a:pos x="connsiteX72" y="connsiteY72"/>
              </a:cxn>
              <a:cxn ang="0">
                <a:pos x="connsiteX73" y="connsiteY73"/>
              </a:cxn>
              <a:cxn ang="0">
                <a:pos x="connsiteX74" y="connsiteY74"/>
              </a:cxn>
              <a:cxn ang="0">
                <a:pos x="connsiteX75" y="connsiteY75"/>
              </a:cxn>
              <a:cxn ang="0">
                <a:pos x="connsiteX76" y="connsiteY76"/>
              </a:cxn>
              <a:cxn ang="0">
                <a:pos x="connsiteX77" y="connsiteY77"/>
              </a:cxn>
              <a:cxn ang="0">
                <a:pos x="connsiteX78" y="connsiteY78"/>
              </a:cxn>
              <a:cxn ang="0">
                <a:pos x="connsiteX79" y="connsiteY79"/>
              </a:cxn>
              <a:cxn ang="0">
                <a:pos x="connsiteX80" y="connsiteY80"/>
              </a:cxn>
              <a:cxn ang="0">
                <a:pos x="connsiteX81" y="connsiteY81"/>
              </a:cxn>
              <a:cxn ang="0">
                <a:pos x="connsiteX82" y="connsiteY82"/>
              </a:cxn>
              <a:cxn ang="0">
                <a:pos x="connsiteX83" y="connsiteY83"/>
              </a:cxn>
              <a:cxn ang="0">
                <a:pos x="connsiteX84" y="connsiteY84"/>
              </a:cxn>
              <a:cxn ang="0">
                <a:pos x="connsiteX85" y="connsiteY85"/>
              </a:cxn>
            </a:cxnLst>
            <a:rect l="l" t="t" r="r" b="b"/>
            <a:pathLst>
              <a:path w="1893094" h="209550">
                <a:moveTo>
                  <a:pt x="0" y="209550"/>
                </a:moveTo>
                <a:cubicBezTo>
                  <a:pt x="11857" y="208068"/>
                  <a:pt x="32033" y="206017"/>
                  <a:pt x="42862" y="202407"/>
                </a:cubicBezTo>
                <a:cubicBezTo>
                  <a:pt x="63729" y="195451"/>
                  <a:pt x="50276" y="199110"/>
                  <a:pt x="71437" y="195263"/>
                </a:cubicBezTo>
                <a:cubicBezTo>
                  <a:pt x="75419" y="194539"/>
                  <a:pt x="79300" y="193051"/>
                  <a:pt x="83344" y="192882"/>
                </a:cubicBezTo>
                <a:cubicBezTo>
                  <a:pt x="117455" y="191461"/>
                  <a:pt x="151606" y="191294"/>
                  <a:pt x="185737" y="190500"/>
                </a:cubicBezTo>
                <a:cubicBezTo>
                  <a:pt x="192532" y="189141"/>
                  <a:pt x="200446" y="187755"/>
                  <a:pt x="207169" y="185738"/>
                </a:cubicBezTo>
                <a:cubicBezTo>
                  <a:pt x="211977" y="184295"/>
                  <a:pt x="216694" y="182563"/>
                  <a:pt x="221456" y="180975"/>
                </a:cubicBezTo>
                <a:lnTo>
                  <a:pt x="228600" y="178594"/>
                </a:lnTo>
                <a:lnTo>
                  <a:pt x="235744" y="176213"/>
                </a:lnTo>
                <a:cubicBezTo>
                  <a:pt x="252120" y="165296"/>
                  <a:pt x="244601" y="168498"/>
                  <a:pt x="257175" y="164307"/>
                </a:cubicBezTo>
                <a:cubicBezTo>
                  <a:pt x="268497" y="156759"/>
                  <a:pt x="261602" y="160450"/>
                  <a:pt x="278606" y="154782"/>
                </a:cubicBezTo>
                <a:cubicBezTo>
                  <a:pt x="280987" y="153988"/>
                  <a:pt x="283259" y="152711"/>
                  <a:pt x="285750" y="152400"/>
                </a:cubicBezTo>
                <a:lnTo>
                  <a:pt x="323850" y="147638"/>
                </a:lnTo>
                <a:cubicBezTo>
                  <a:pt x="328612" y="146050"/>
                  <a:pt x="333960" y="145659"/>
                  <a:pt x="338137" y="142875"/>
                </a:cubicBezTo>
                <a:cubicBezTo>
                  <a:pt x="340518" y="141288"/>
                  <a:pt x="342601" y="139118"/>
                  <a:pt x="345281" y="138113"/>
                </a:cubicBezTo>
                <a:cubicBezTo>
                  <a:pt x="349071" y="136692"/>
                  <a:pt x="353218" y="136526"/>
                  <a:pt x="357187" y="135732"/>
                </a:cubicBezTo>
                <a:cubicBezTo>
                  <a:pt x="368510" y="128183"/>
                  <a:pt x="361613" y="131876"/>
                  <a:pt x="378619" y="126207"/>
                </a:cubicBezTo>
                <a:cubicBezTo>
                  <a:pt x="381000" y="125413"/>
                  <a:pt x="383674" y="125217"/>
                  <a:pt x="385762" y="123825"/>
                </a:cubicBezTo>
                <a:cubicBezTo>
                  <a:pt x="392351" y="119433"/>
                  <a:pt x="392510" y="118422"/>
                  <a:pt x="400050" y="116682"/>
                </a:cubicBezTo>
                <a:cubicBezTo>
                  <a:pt x="407937" y="114862"/>
                  <a:pt x="416183" y="114478"/>
                  <a:pt x="423862" y="111919"/>
                </a:cubicBezTo>
                <a:cubicBezTo>
                  <a:pt x="467040" y="97528"/>
                  <a:pt x="413032" y="114873"/>
                  <a:pt x="450056" y="104775"/>
                </a:cubicBezTo>
                <a:cubicBezTo>
                  <a:pt x="454899" y="103454"/>
                  <a:pt x="459581" y="101600"/>
                  <a:pt x="464344" y="100013"/>
                </a:cubicBezTo>
                <a:cubicBezTo>
                  <a:pt x="466725" y="99219"/>
                  <a:pt x="468990" y="97882"/>
                  <a:pt x="471487" y="97632"/>
                </a:cubicBezTo>
                <a:cubicBezTo>
                  <a:pt x="479425" y="96838"/>
                  <a:pt x="487393" y="96304"/>
                  <a:pt x="495300" y="95250"/>
                </a:cubicBezTo>
                <a:cubicBezTo>
                  <a:pt x="499312" y="94715"/>
                  <a:pt x="503179" y="93272"/>
                  <a:pt x="507206" y="92869"/>
                </a:cubicBezTo>
                <a:cubicBezTo>
                  <a:pt x="519080" y="91682"/>
                  <a:pt x="531019" y="91282"/>
                  <a:pt x="542925" y="90488"/>
                </a:cubicBezTo>
                <a:lnTo>
                  <a:pt x="702469" y="92869"/>
                </a:lnTo>
                <a:cubicBezTo>
                  <a:pt x="704978" y="92941"/>
                  <a:pt x="707199" y="94560"/>
                  <a:pt x="709612" y="95250"/>
                </a:cubicBezTo>
                <a:cubicBezTo>
                  <a:pt x="712759" y="96149"/>
                  <a:pt x="715990" y="96733"/>
                  <a:pt x="719137" y="97632"/>
                </a:cubicBezTo>
                <a:cubicBezTo>
                  <a:pt x="721551" y="98322"/>
                  <a:pt x="723846" y="99404"/>
                  <a:pt x="726281" y="100013"/>
                </a:cubicBezTo>
                <a:cubicBezTo>
                  <a:pt x="730207" y="100995"/>
                  <a:pt x="734261" y="101412"/>
                  <a:pt x="738187" y="102394"/>
                </a:cubicBezTo>
                <a:cubicBezTo>
                  <a:pt x="740622" y="103003"/>
                  <a:pt x="742896" y="104166"/>
                  <a:pt x="745331" y="104775"/>
                </a:cubicBezTo>
                <a:cubicBezTo>
                  <a:pt x="749257" y="105757"/>
                  <a:pt x="753286" y="106279"/>
                  <a:pt x="757237" y="107157"/>
                </a:cubicBezTo>
                <a:cubicBezTo>
                  <a:pt x="766211" y="109151"/>
                  <a:pt x="765948" y="109267"/>
                  <a:pt x="773906" y="111919"/>
                </a:cubicBezTo>
                <a:cubicBezTo>
                  <a:pt x="794375" y="125566"/>
                  <a:pt x="768480" y="109207"/>
                  <a:pt x="788194" y="119063"/>
                </a:cubicBezTo>
                <a:cubicBezTo>
                  <a:pt x="794146" y="122039"/>
                  <a:pt x="795499" y="125708"/>
                  <a:pt x="802481" y="126207"/>
                </a:cubicBezTo>
                <a:cubicBezTo>
                  <a:pt x="822290" y="127622"/>
                  <a:pt x="842168" y="127794"/>
                  <a:pt x="862012" y="128588"/>
                </a:cubicBezTo>
                <a:cubicBezTo>
                  <a:pt x="864393" y="130175"/>
                  <a:pt x="867132" y="131326"/>
                  <a:pt x="869156" y="133350"/>
                </a:cubicBezTo>
                <a:cubicBezTo>
                  <a:pt x="885038" y="149231"/>
                  <a:pt x="862007" y="132551"/>
                  <a:pt x="881062" y="145257"/>
                </a:cubicBezTo>
                <a:cubicBezTo>
                  <a:pt x="889091" y="157298"/>
                  <a:pt x="881467" y="149031"/>
                  <a:pt x="892969" y="154782"/>
                </a:cubicBezTo>
                <a:cubicBezTo>
                  <a:pt x="895528" y="156062"/>
                  <a:pt x="897497" y="158382"/>
                  <a:pt x="900112" y="159544"/>
                </a:cubicBezTo>
                <a:cubicBezTo>
                  <a:pt x="913391" y="165446"/>
                  <a:pt x="918443" y="164812"/>
                  <a:pt x="933450" y="166688"/>
                </a:cubicBezTo>
                <a:cubicBezTo>
                  <a:pt x="946780" y="165577"/>
                  <a:pt x="960816" y="165502"/>
                  <a:pt x="973931" y="161925"/>
                </a:cubicBezTo>
                <a:cubicBezTo>
                  <a:pt x="978774" y="160604"/>
                  <a:pt x="983349" y="158380"/>
                  <a:pt x="988219" y="157163"/>
                </a:cubicBezTo>
                <a:cubicBezTo>
                  <a:pt x="993546" y="155831"/>
                  <a:pt x="1008549" y="152340"/>
                  <a:pt x="1012031" y="150019"/>
                </a:cubicBezTo>
                <a:cubicBezTo>
                  <a:pt x="1014412" y="148432"/>
                  <a:pt x="1016560" y="146419"/>
                  <a:pt x="1019175" y="145257"/>
                </a:cubicBezTo>
                <a:cubicBezTo>
                  <a:pt x="1019189" y="145251"/>
                  <a:pt x="1037027" y="139306"/>
                  <a:pt x="1040606" y="138113"/>
                </a:cubicBezTo>
                <a:lnTo>
                  <a:pt x="1047750" y="135732"/>
                </a:lnTo>
                <a:cubicBezTo>
                  <a:pt x="1050131" y="134938"/>
                  <a:pt x="1052433" y="133842"/>
                  <a:pt x="1054894" y="133350"/>
                </a:cubicBezTo>
                <a:cubicBezTo>
                  <a:pt x="1058863" y="132556"/>
                  <a:pt x="1062808" y="131634"/>
                  <a:pt x="1066800" y="130969"/>
                </a:cubicBezTo>
                <a:cubicBezTo>
                  <a:pt x="1082759" y="128309"/>
                  <a:pt x="1086408" y="129195"/>
                  <a:pt x="1102519" y="123825"/>
                </a:cubicBezTo>
                <a:lnTo>
                  <a:pt x="1116806" y="119063"/>
                </a:lnTo>
                <a:lnTo>
                  <a:pt x="1123950" y="116682"/>
                </a:lnTo>
                <a:cubicBezTo>
                  <a:pt x="1134491" y="109655"/>
                  <a:pt x="1145193" y="103868"/>
                  <a:pt x="1152525" y="92869"/>
                </a:cubicBezTo>
                <a:cubicBezTo>
                  <a:pt x="1158252" y="84278"/>
                  <a:pt x="1161785" y="77965"/>
                  <a:pt x="1171575" y="71438"/>
                </a:cubicBezTo>
                <a:cubicBezTo>
                  <a:pt x="1176337" y="68263"/>
                  <a:pt x="1180743" y="64473"/>
                  <a:pt x="1185862" y="61913"/>
                </a:cubicBezTo>
                <a:cubicBezTo>
                  <a:pt x="1192212" y="58738"/>
                  <a:pt x="1199005" y="56326"/>
                  <a:pt x="1204912" y="52388"/>
                </a:cubicBezTo>
                <a:cubicBezTo>
                  <a:pt x="1222650" y="40562"/>
                  <a:pt x="1200864" y="55761"/>
                  <a:pt x="1219200" y="40482"/>
                </a:cubicBezTo>
                <a:cubicBezTo>
                  <a:pt x="1221399" y="38650"/>
                  <a:pt x="1224145" y="37551"/>
                  <a:pt x="1226344" y="35719"/>
                </a:cubicBezTo>
                <a:cubicBezTo>
                  <a:pt x="1228931" y="33563"/>
                  <a:pt x="1230829" y="30642"/>
                  <a:pt x="1233487" y="28575"/>
                </a:cubicBezTo>
                <a:cubicBezTo>
                  <a:pt x="1238005" y="25061"/>
                  <a:pt x="1247775" y="19050"/>
                  <a:pt x="1247775" y="19050"/>
                </a:cubicBezTo>
                <a:cubicBezTo>
                  <a:pt x="1261419" y="-1416"/>
                  <a:pt x="1243252" y="22667"/>
                  <a:pt x="1259681" y="9525"/>
                </a:cubicBezTo>
                <a:cubicBezTo>
                  <a:pt x="1275070" y="-2785"/>
                  <a:pt x="1253631" y="5988"/>
                  <a:pt x="1271587" y="0"/>
                </a:cubicBezTo>
                <a:lnTo>
                  <a:pt x="1316831" y="2382"/>
                </a:lnTo>
                <a:lnTo>
                  <a:pt x="1381125" y="4763"/>
                </a:lnTo>
                <a:cubicBezTo>
                  <a:pt x="1388302" y="5162"/>
                  <a:pt x="1395408" y="6392"/>
                  <a:pt x="1402556" y="7144"/>
                </a:cubicBezTo>
                <a:lnTo>
                  <a:pt x="1426369" y="9525"/>
                </a:lnTo>
                <a:cubicBezTo>
                  <a:pt x="1462011" y="16656"/>
                  <a:pt x="1423629" y="9642"/>
                  <a:pt x="1504950" y="14288"/>
                </a:cubicBezTo>
                <a:cubicBezTo>
                  <a:pt x="1510554" y="14608"/>
                  <a:pt x="1516072" y="15816"/>
                  <a:pt x="1521619" y="16669"/>
                </a:cubicBezTo>
                <a:cubicBezTo>
                  <a:pt x="1527152" y="17520"/>
                  <a:pt x="1541857" y="19943"/>
                  <a:pt x="1547812" y="21432"/>
                </a:cubicBezTo>
                <a:cubicBezTo>
                  <a:pt x="1550247" y="22041"/>
                  <a:pt x="1552542" y="23123"/>
                  <a:pt x="1554956" y="23813"/>
                </a:cubicBezTo>
                <a:cubicBezTo>
                  <a:pt x="1558103" y="24712"/>
                  <a:pt x="1561376" y="25159"/>
                  <a:pt x="1564481" y="26194"/>
                </a:cubicBezTo>
                <a:cubicBezTo>
                  <a:pt x="1564943" y="26348"/>
                  <a:pt x="1580421" y="32860"/>
                  <a:pt x="1583531" y="33338"/>
                </a:cubicBezTo>
                <a:cubicBezTo>
                  <a:pt x="1598505" y="35641"/>
                  <a:pt x="1633679" y="37365"/>
                  <a:pt x="1645444" y="38100"/>
                </a:cubicBezTo>
                <a:cubicBezTo>
                  <a:pt x="1689767" y="45490"/>
                  <a:pt x="1619997" y="34495"/>
                  <a:pt x="1728787" y="42863"/>
                </a:cubicBezTo>
                <a:cubicBezTo>
                  <a:pt x="1759413" y="45219"/>
                  <a:pt x="1743571" y="45963"/>
                  <a:pt x="1759744" y="50007"/>
                </a:cubicBezTo>
                <a:cubicBezTo>
                  <a:pt x="1763670" y="50989"/>
                  <a:pt x="1767699" y="51510"/>
                  <a:pt x="1771650" y="52388"/>
                </a:cubicBezTo>
                <a:cubicBezTo>
                  <a:pt x="1774845" y="53098"/>
                  <a:pt x="1777980" y="54059"/>
                  <a:pt x="1781175" y="54769"/>
                </a:cubicBezTo>
                <a:cubicBezTo>
                  <a:pt x="1785126" y="55647"/>
                  <a:pt x="1789155" y="56168"/>
                  <a:pt x="1793081" y="57150"/>
                </a:cubicBezTo>
                <a:cubicBezTo>
                  <a:pt x="1795516" y="57759"/>
                  <a:pt x="1797775" y="58987"/>
                  <a:pt x="1800225" y="59532"/>
                </a:cubicBezTo>
                <a:cubicBezTo>
                  <a:pt x="1810022" y="61709"/>
                  <a:pt x="1816889" y="61695"/>
                  <a:pt x="1826419" y="64294"/>
                </a:cubicBezTo>
                <a:cubicBezTo>
                  <a:pt x="1831262" y="65615"/>
                  <a:pt x="1835836" y="67840"/>
                  <a:pt x="1840706" y="69057"/>
                </a:cubicBezTo>
                <a:cubicBezTo>
                  <a:pt x="1843881" y="69851"/>
                  <a:pt x="1847036" y="70728"/>
                  <a:pt x="1850231" y="71438"/>
                </a:cubicBezTo>
                <a:cubicBezTo>
                  <a:pt x="1854182" y="72316"/>
                  <a:pt x="1858211" y="72837"/>
                  <a:pt x="1862137" y="73819"/>
                </a:cubicBezTo>
                <a:cubicBezTo>
                  <a:pt x="1864572" y="74428"/>
                  <a:pt x="1866778" y="76008"/>
                  <a:pt x="1869281" y="76200"/>
                </a:cubicBezTo>
                <a:cubicBezTo>
                  <a:pt x="1877195" y="76809"/>
                  <a:pt x="1885156" y="76200"/>
                  <a:pt x="1893094" y="76200"/>
                </a:cubicBezTo>
              </a:path>
            </a:pathLst>
          </a:custGeom>
          <a:noFill/>
          <a:ln w="38100">
            <a:solidFill>
              <a:schemeClr val="bg1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9666"/>
          </a:p>
        </p:txBody>
      </p:sp>
      <p:sp>
        <p:nvSpPr>
          <p:cNvPr id="211" name="Freeform 210"/>
          <p:cNvSpPr/>
          <p:nvPr/>
        </p:nvSpPr>
        <p:spPr>
          <a:xfrm>
            <a:off x="13361889" y="3325447"/>
            <a:ext cx="4598681" cy="571513"/>
          </a:xfrm>
          <a:custGeom>
            <a:avLst/>
            <a:gdLst>
              <a:gd name="connsiteX0" fmla="*/ 0 w 1895475"/>
              <a:gd name="connsiteY0" fmla="*/ 221456 h 221456"/>
              <a:gd name="connsiteX1" fmla="*/ 11907 w 1895475"/>
              <a:gd name="connsiteY1" fmla="*/ 219075 h 221456"/>
              <a:gd name="connsiteX2" fmla="*/ 33338 w 1895475"/>
              <a:gd name="connsiteY2" fmla="*/ 211931 h 221456"/>
              <a:gd name="connsiteX3" fmla="*/ 40482 w 1895475"/>
              <a:gd name="connsiteY3" fmla="*/ 209550 h 221456"/>
              <a:gd name="connsiteX4" fmla="*/ 59532 w 1895475"/>
              <a:gd name="connsiteY4" fmla="*/ 207169 h 221456"/>
              <a:gd name="connsiteX5" fmla="*/ 150019 w 1895475"/>
              <a:gd name="connsiteY5" fmla="*/ 204787 h 221456"/>
              <a:gd name="connsiteX6" fmla="*/ 161925 w 1895475"/>
              <a:gd name="connsiteY6" fmla="*/ 202406 h 221456"/>
              <a:gd name="connsiteX7" fmla="*/ 180975 w 1895475"/>
              <a:gd name="connsiteY7" fmla="*/ 200025 h 221456"/>
              <a:gd name="connsiteX8" fmla="*/ 195263 w 1895475"/>
              <a:gd name="connsiteY8" fmla="*/ 197644 h 221456"/>
              <a:gd name="connsiteX9" fmla="*/ 216694 w 1895475"/>
              <a:gd name="connsiteY9" fmla="*/ 190500 h 221456"/>
              <a:gd name="connsiteX10" fmla="*/ 223838 w 1895475"/>
              <a:gd name="connsiteY10" fmla="*/ 188119 h 221456"/>
              <a:gd name="connsiteX11" fmla="*/ 230982 w 1895475"/>
              <a:gd name="connsiteY11" fmla="*/ 183356 h 221456"/>
              <a:gd name="connsiteX12" fmla="*/ 254794 w 1895475"/>
              <a:gd name="connsiteY12" fmla="*/ 176212 h 221456"/>
              <a:gd name="connsiteX13" fmla="*/ 269082 w 1895475"/>
              <a:gd name="connsiteY13" fmla="*/ 171450 h 221456"/>
              <a:gd name="connsiteX14" fmla="*/ 276225 w 1895475"/>
              <a:gd name="connsiteY14" fmla="*/ 169069 h 221456"/>
              <a:gd name="connsiteX15" fmla="*/ 283369 w 1895475"/>
              <a:gd name="connsiteY15" fmla="*/ 164306 h 221456"/>
              <a:gd name="connsiteX16" fmla="*/ 295275 w 1895475"/>
              <a:gd name="connsiteY16" fmla="*/ 161925 h 221456"/>
              <a:gd name="connsiteX17" fmla="*/ 326232 w 1895475"/>
              <a:gd name="connsiteY17" fmla="*/ 157162 h 221456"/>
              <a:gd name="connsiteX18" fmla="*/ 333375 w 1895475"/>
              <a:gd name="connsiteY18" fmla="*/ 154781 h 221456"/>
              <a:gd name="connsiteX19" fmla="*/ 350044 w 1895475"/>
              <a:gd name="connsiteY19" fmla="*/ 150019 h 221456"/>
              <a:gd name="connsiteX20" fmla="*/ 357188 w 1895475"/>
              <a:gd name="connsiteY20" fmla="*/ 145256 h 221456"/>
              <a:gd name="connsiteX21" fmla="*/ 371475 w 1895475"/>
              <a:gd name="connsiteY21" fmla="*/ 140494 h 221456"/>
              <a:gd name="connsiteX22" fmla="*/ 378619 w 1895475"/>
              <a:gd name="connsiteY22" fmla="*/ 135731 h 221456"/>
              <a:gd name="connsiteX23" fmla="*/ 392907 w 1895475"/>
              <a:gd name="connsiteY23" fmla="*/ 130969 h 221456"/>
              <a:gd name="connsiteX24" fmla="*/ 407194 w 1895475"/>
              <a:gd name="connsiteY24" fmla="*/ 123825 h 221456"/>
              <a:gd name="connsiteX25" fmla="*/ 435769 w 1895475"/>
              <a:gd name="connsiteY25" fmla="*/ 109537 h 221456"/>
              <a:gd name="connsiteX26" fmla="*/ 442913 w 1895475"/>
              <a:gd name="connsiteY26" fmla="*/ 107156 h 221456"/>
              <a:gd name="connsiteX27" fmla="*/ 459582 w 1895475"/>
              <a:gd name="connsiteY27" fmla="*/ 104775 h 221456"/>
              <a:gd name="connsiteX28" fmla="*/ 485775 w 1895475"/>
              <a:gd name="connsiteY28" fmla="*/ 102394 h 221456"/>
              <a:gd name="connsiteX29" fmla="*/ 507207 w 1895475"/>
              <a:gd name="connsiteY29" fmla="*/ 100012 h 221456"/>
              <a:gd name="connsiteX30" fmla="*/ 514350 w 1895475"/>
              <a:gd name="connsiteY30" fmla="*/ 97631 h 221456"/>
              <a:gd name="connsiteX31" fmla="*/ 631032 w 1895475"/>
              <a:gd name="connsiteY31" fmla="*/ 97631 h 221456"/>
              <a:gd name="connsiteX32" fmla="*/ 638175 w 1895475"/>
              <a:gd name="connsiteY32" fmla="*/ 100012 h 221456"/>
              <a:gd name="connsiteX33" fmla="*/ 673894 w 1895475"/>
              <a:gd name="connsiteY33" fmla="*/ 104775 h 221456"/>
              <a:gd name="connsiteX34" fmla="*/ 688182 w 1895475"/>
              <a:gd name="connsiteY34" fmla="*/ 107156 h 221456"/>
              <a:gd name="connsiteX35" fmla="*/ 697707 w 1895475"/>
              <a:gd name="connsiteY35" fmla="*/ 109537 h 221456"/>
              <a:gd name="connsiteX36" fmla="*/ 731044 w 1895475"/>
              <a:gd name="connsiteY36" fmla="*/ 114300 h 221456"/>
              <a:gd name="connsiteX37" fmla="*/ 742950 w 1895475"/>
              <a:gd name="connsiteY37" fmla="*/ 116681 h 221456"/>
              <a:gd name="connsiteX38" fmla="*/ 750094 w 1895475"/>
              <a:gd name="connsiteY38" fmla="*/ 119062 h 221456"/>
              <a:gd name="connsiteX39" fmla="*/ 764382 w 1895475"/>
              <a:gd name="connsiteY39" fmla="*/ 121444 h 221456"/>
              <a:gd name="connsiteX40" fmla="*/ 783432 w 1895475"/>
              <a:gd name="connsiteY40" fmla="*/ 126206 h 221456"/>
              <a:gd name="connsiteX41" fmla="*/ 797719 w 1895475"/>
              <a:gd name="connsiteY41" fmla="*/ 130969 h 221456"/>
              <a:gd name="connsiteX42" fmla="*/ 804863 w 1895475"/>
              <a:gd name="connsiteY42" fmla="*/ 133350 h 221456"/>
              <a:gd name="connsiteX43" fmla="*/ 814388 w 1895475"/>
              <a:gd name="connsiteY43" fmla="*/ 135731 h 221456"/>
              <a:gd name="connsiteX44" fmla="*/ 828675 w 1895475"/>
              <a:gd name="connsiteY44" fmla="*/ 140494 h 221456"/>
              <a:gd name="connsiteX45" fmla="*/ 850107 w 1895475"/>
              <a:gd name="connsiteY45" fmla="*/ 147637 h 221456"/>
              <a:gd name="connsiteX46" fmla="*/ 871538 w 1895475"/>
              <a:gd name="connsiteY46" fmla="*/ 154781 h 221456"/>
              <a:gd name="connsiteX47" fmla="*/ 878682 w 1895475"/>
              <a:gd name="connsiteY47" fmla="*/ 157162 h 221456"/>
              <a:gd name="connsiteX48" fmla="*/ 885825 w 1895475"/>
              <a:gd name="connsiteY48" fmla="*/ 159544 h 221456"/>
              <a:gd name="connsiteX49" fmla="*/ 926307 w 1895475"/>
              <a:gd name="connsiteY49" fmla="*/ 166687 h 221456"/>
              <a:gd name="connsiteX50" fmla="*/ 1007269 w 1895475"/>
              <a:gd name="connsiteY50" fmla="*/ 164306 h 221456"/>
              <a:gd name="connsiteX51" fmla="*/ 1019175 w 1895475"/>
              <a:gd name="connsiteY51" fmla="*/ 161925 h 221456"/>
              <a:gd name="connsiteX52" fmla="*/ 1052513 w 1895475"/>
              <a:gd name="connsiteY52" fmla="*/ 152400 h 221456"/>
              <a:gd name="connsiteX53" fmla="*/ 1071563 w 1895475"/>
              <a:gd name="connsiteY53" fmla="*/ 147637 h 221456"/>
              <a:gd name="connsiteX54" fmla="*/ 1085850 w 1895475"/>
              <a:gd name="connsiteY54" fmla="*/ 142875 h 221456"/>
              <a:gd name="connsiteX55" fmla="*/ 1100138 w 1895475"/>
              <a:gd name="connsiteY55" fmla="*/ 138112 h 221456"/>
              <a:gd name="connsiteX56" fmla="*/ 1114425 w 1895475"/>
              <a:gd name="connsiteY56" fmla="*/ 130969 h 221456"/>
              <a:gd name="connsiteX57" fmla="*/ 1121569 w 1895475"/>
              <a:gd name="connsiteY57" fmla="*/ 126206 h 221456"/>
              <a:gd name="connsiteX58" fmla="*/ 1128713 w 1895475"/>
              <a:gd name="connsiteY58" fmla="*/ 123825 h 221456"/>
              <a:gd name="connsiteX59" fmla="*/ 1150144 w 1895475"/>
              <a:gd name="connsiteY59" fmla="*/ 111919 h 221456"/>
              <a:gd name="connsiteX60" fmla="*/ 1171575 w 1895475"/>
              <a:gd name="connsiteY60" fmla="*/ 97631 h 221456"/>
              <a:gd name="connsiteX61" fmla="*/ 1178719 w 1895475"/>
              <a:gd name="connsiteY61" fmla="*/ 92869 h 221456"/>
              <a:gd name="connsiteX62" fmla="*/ 1185863 w 1895475"/>
              <a:gd name="connsiteY62" fmla="*/ 85725 h 221456"/>
              <a:gd name="connsiteX63" fmla="*/ 1190625 w 1895475"/>
              <a:gd name="connsiteY63" fmla="*/ 78581 h 221456"/>
              <a:gd name="connsiteX64" fmla="*/ 1197769 w 1895475"/>
              <a:gd name="connsiteY64" fmla="*/ 73819 h 221456"/>
              <a:gd name="connsiteX65" fmla="*/ 1202532 w 1895475"/>
              <a:gd name="connsiteY65" fmla="*/ 66675 h 221456"/>
              <a:gd name="connsiteX66" fmla="*/ 1209675 w 1895475"/>
              <a:gd name="connsiteY66" fmla="*/ 61912 h 221456"/>
              <a:gd name="connsiteX67" fmla="*/ 1219200 w 1895475"/>
              <a:gd name="connsiteY67" fmla="*/ 47625 h 221456"/>
              <a:gd name="connsiteX68" fmla="*/ 1233488 w 1895475"/>
              <a:gd name="connsiteY68" fmla="*/ 35719 h 221456"/>
              <a:gd name="connsiteX69" fmla="*/ 1247775 w 1895475"/>
              <a:gd name="connsiteY69" fmla="*/ 26194 h 221456"/>
              <a:gd name="connsiteX70" fmla="*/ 1262063 w 1895475"/>
              <a:gd name="connsiteY70" fmla="*/ 16669 h 221456"/>
              <a:gd name="connsiteX71" fmla="*/ 1269207 w 1895475"/>
              <a:gd name="connsiteY71" fmla="*/ 11906 h 221456"/>
              <a:gd name="connsiteX72" fmla="*/ 1283494 w 1895475"/>
              <a:gd name="connsiteY72" fmla="*/ 7144 h 221456"/>
              <a:gd name="connsiteX73" fmla="*/ 1290638 w 1895475"/>
              <a:gd name="connsiteY73" fmla="*/ 2381 h 221456"/>
              <a:gd name="connsiteX74" fmla="*/ 1297782 w 1895475"/>
              <a:gd name="connsiteY74" fmla="*/ 0 h 221456"/>
              <a:gd name="connsiteX75" fmla="*/ 1364457 w 1895475"/>
              <a:gd name="connsiteY75" fmla="*/ 2381 h 221456"/>
              <a:gd name="connsiteX76" fmla="*/ 1388269 w 1895475"/>
              <a:gd name="connsiteY76" fmla="*/ 7144 h 221456"/>
              <a:gd name="connsiteX77" fmla="*/ 1414463 w 1895475"/>
              <a:gd name="connsiteY77" fmla="*/ 11906 h 221456"/>
              <a:gd name="connsiteX78" fmla="*/ 1464469 w 1895475"/>
              <a:gd name="connsiteY78" fmla="*/ 16669 h 221456"/>
              <a:gd name="connsiteX79" fmla="*/ 1471613 w 1895475"/>
              <a:gd name="connsiteY79" fmla="*/ 19050 h 221456"/>
              <a:gd name="connsiteX80" fmla="*/ 1524000 w 1895475"/>
              <a:gd name="connsiteY80" fmla="*/ 26194 h 221456"/>
              <a:gd name="connsiteX81" fmla="*/ 1531144 w 1895475"/>
              <a:gd name="connsiteY81" fmla="*/ 28575 h 221456"/>
              <a:gd name="connsiteX82" fmla="*/ 1540669 w 1895475"/>
              <a:gd name="connsiteY82" fmla="*/ 30956 h 221456"/>
              <a:gd name="connsiteX83" fmla="*/ 1562100 w 1895475"/>
              <a:gd name="connsiteY83" fmla="*/ 35719 h 221456"/>
              <a:gd name="connsiteX84" fmla="*/ 1569244 w 1895475"/>
              <a:gd name="connsiteY84" fmla="*/ 38100 h 221456"/>
              <a:gd name="connsiteX85" fmla="*/ 1607344 w 1895475"/>
              <a:gd name="connsiteY85" fmla="*/ 42862 h 221456"/>
              <a:gd name="connsiteX86" fmla="*/ 1619250 w 1895475"/>
              <a:gd name="connsiteY86" fmla="*/ 45244 h 221456"/>
              <a:gd name="connsiteX87" fmla="*/ 1628775 w 1895475"/>
              <a:gd name="connsiteY87" fmla="*/ 47625 h 221456"/>
              <a:gd name="connsiteX88" fmla="*/ 1650207 w 1895475"/>
              <a:gd name="connsiteY88" fmla="*/ 50006 h 221456"/>
              <a:gd name="connsiteX89" fmla="*/ 1702594 w 1895475"/>
              <a:gd name="connsiteY89" fmla="*/ 54769 h 221456"/>
              <a:gd name="connsiteX90" fmla="*/ 1714500 w 1895475"/>
              <a:gd name="connsiteY90" fmla="*/ 57150 h 221456"/>
              <a:gd name="connsiteX91" fmla="*/ 1762125 w 1895475"/>
              <a:gd name="connsiteY91" fmla="*/ 61912 h 221456"/>
              <a:gd name="connsiteX92" fmla="*/ 1781175 w 1895475"/>
              <a:gd name="connsiteY92" fmla="*/ 66675 h 221456"/>
              <a:gd name="connsiteX93" fmla="*/ 1819275 w 1895475"/>
              <a:gd name="connsiteY93" fmla="*/ 71437 h 221456"/>
              <a:gd name="connsiteX94" fmla="*/ 1852613 w 1895475"/>
              <a:gd name="connsiteY94" fmla="*/ 76200 h 221456"/>
              <a:gd name="connsiteX95" fmla="*/ 1871663 w 1895475"/>
              <a:gd name="connsiteY95" fmla="*/ 78581 h 221456"/>
              <a:gd name="connsiteX96" fmla="*/ 1883569 w 1895475"/>
              <a:gd name="connsiteY96" fmla="*/ 80962 h 221456"/>
              <a:gd name="connsiteX97" fmla="*/ 1895475 w 1895475"/>
              <a:gd name="connsiteY97" fmla="*/ 80962 h 221456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  <a:cxn ang="0">
                <a:pos x="connsiteX31" y="connsiteY31"/>
              </a:cxn>
              <a:cxn ang="0">
                <a:pos x="connsiteX32" y="connsiteY32"/>
              </a:cxn>
              <a:cxn ang="0">
                <a:pos x="connsiteX33" y="connsiteY33"/>
              </a:cxn>
              <a:cxn ang="0">
                <a:pos x="connsiteX34" y="connsiteY34"/>
              </a:cxn>
              <a:cxn ang="0">
                <a:pos x="connsiteX35" y="connsiteY35"/>
              </a:cxn>
              <a:cxn ang="0">
                <a:pos x="connsiteX36" y="connsiteY36"/>
              </a:cxn>
              <a:cxn ang="0">
                <a:pos x="connsiteX37" y="connsiteY37"/>
              </a:cxn>
              <a:cxn ang="0">
                <a:pos x="connsiteX38" y="connsiteY38"/>
              </a:cxn>
              <a:cxn ang="0">
                <a:pos x="connsiteX39" y="connsiteY39"/>
              </a:cxn>
              <a:cxn ang="0">
                <a:pos x="connsiteX40" y="connsiteY40"/>
              </a:cxn>
              <a:cxn ang="0">
                <a:pos x="connsiteX41" y="connsiteY41"/>
              </a:cxn>
              <a:cxn ang="0">
                <a:pos x="connsiteX42" y="connsiteY42"/>
              </a:cxn>
              <a:cxn ang="0">
                <a:pos x="connsiteX43" y="connsiteY43"/>
              </a:cxn>
              <a:cxn ang="0">
                <a:pos x="connsiteX44" y="connsiteY44"/>
              </a:cxn>
              <a:cxn ang="0">
                <a:pos x="connsiteX45" y="connsiteY45"/>
              </a:cxn>
              <a:cxn ang="0">
                <a:pos x="connsiteX46" y="connsiteY46"/>
              </a:cxn>
              <a:cxn ang="0">
                <a:pos x="connsiteX47" y="connsiteY47"/>
              </a:cxn>
              <a:cxn ang="0">
                <a:pos x="connsiteX48" y="connsiteY48"/>
              </a:cxn>
              <a:cxn ang="0">
                <a:pos x="connsiteX49" y="connsiteY49"/>
              </a:cxn>
              <a:cxn ang="0">
                <a:pos x="connsiteX50" y="connsiteY50"/>
              </a:cxn>
              <a:cxn ang="0">
                <a:pos x="connsiteX51" y="connsiteY51"/>
              </a:cxn>
              <a:cxn ang="0">
                <a:pos x="connsiteX52" y="connsiteY52"/>
              </a:cxn>
              <a:cxn ang="0">
                <a:pos x="connsiteX53" y="connsiteY53"/>
              </a:cxn>
              <a:cxn ang="0">
                <a:pos x="connsiteX54" y="connsiteY54"/>
              </a:cxn>
              <a:cxn ang="0">
                <a:pos x="connsiteX55" y="connsiteY55"/>
              </a:cxn>
              <a:cxn ang="0">
                <a:pos x="connsiteX56" y="connsiteY56"/>
              </a:cxn>
              <a:cxn ang="0">
                <a:pos x="connsiteX57" y="connsiteY57"/>
              </a:cxn>
              <a:cxn ang="0">
                <a:pos x="connsiteX58" y="connsiteY58"/>
              </a:cxn>
              <a:cxn ang="0">
                <a:pos x="connsiteX59" y="connsiteY59"/>
              </a:cxn>
              <a:cxn ang="0">
                <a:pos x="connsiteX60" y="connsiteY60"/>
              </a:cxn>
              <a:cxn ang="0">
                <a:pos x="connsiteX61" y="connsiteY61"/>
              </a:cxn>
              <a:cxn ang="0">
                <a:pos x="connsiteX62" y="connsiteY62"/>
              </a:cxn>
              <a:cxn ang="0">
                <a:pos x="connsiteX63" y="connsiteY63"/>
              </a:cxn>
              <a:cxn ang="0">
                <a:pos x="connsiteX64" y="connsiteY64"/>
              </a:cxn>
              <a:cxn ang="0">
                <a:pos x="connsiteX65" y="connsiteY65"/>
              </a:cxn>
              <a:cxn ang="0">
                <a:pos x="connsiteX66" y="connsiteY66"/>
              </a:cxn>
              <a:cxn ang="0">
                <a:pos x="connsiteX67" y="connsiteY67"/>
              </a:cxn>
              <a:cxn ang="0">
                <a:pos x="connsiteX68" y="connsiteY68"/>
              </a:cxn>
              <a:cxn ang="0">
                <a:pos x="connsiteX69" y="connsiteY69"/>
              </a:cxn>
              <a:cxn ang="0">
                <a:pos x="connsiteX70" y="connsiteY70"/>
              </a:cxn>
              <a:cxn ang="0">
                <a:pos x="connsiteX71" y="connsiteY71"/>
              </a:cxn>
              <a:cxn ang="0">
                <a:pos x="connsiteX72" y="connsiteY72"/>
              </a:cxn>
              <a:cxn ang="0">
                <a:pos x="connsiteX73" y="connsiteY73"/>
              </a:cxn>
              <a:cxn ang="0">
                <a:pos x="connsiteX74" y="connsiteY74"/>
              </a:cxn>
              <a:cxn ang="0">
                <a:pos x="connsiteX75" y="connsiteY75"/>
              </a:cxn>
              <a:cxn ang="0">
                <a:pos x="connsiteX76" y="connsiteY76"/>
              </a:cxn>
              <a:cxn ang="0">
                <a:pos x="connsiteX77" y="connsiteY77"/>
              </a:cxn>
              <a:cxn ang="0">
                <a:pos x="connsiteX78" y="connsiteY78"/>
              </a:cxn>
              <a:cxn ang="0">
                <a:pos x="connsiteX79" y="connsiteY79"/>
              </a:cxn>
              <a:cxn ang="0">
                <a:pos x="connsiteX80" y="connsiteY80"/>
              </a:cxn>
              <a:cxn ang="0">
                <a:pos x="connsiteX81" y="connsiteY81"/>
              </a:cxn>
              <a:cxn ang="0">
                <a:pos x="connsiteX82" y="connsiteY82"/>
              </a:cxn>
              <a:cxn ang="0">
                <a:pos x="connsiteX83" y="connsiteY83"/>
              </a:cxn>
              <a:cxn ang="0">
                <a:pos x="connsiteX84" y="connsiteY84"/>
              </a:cxn>
              <a:cxn ang="0">
                <a:pos x="connsiteX85" y="connsiteY85"/>
              </a:cxn>
              <a:cxn ang="0">
                <a:pos x="connsiteX86" y="connsiteY86"/>
              </a:cxn>
              <a:cxn ang="0">
                <a:pos x="connsiteX87" y="connsiteY87"/>
              </a:cxn>
              <a:cxn ang="0">
                <a:pos x="connsiteX88" y="connsiteY88"/>
              </a:cxn>
              <a:cxn ang="0">
                <a:pos x="connsiteX89" y="connsiteY89"/>
              </a:cxn>
              <a:cxn ang="0">
                <a:pos x="connsiteX90" y="connsiteY90"/>
              </a:cxn>
              <a:cxn ang="0">
                <a:pos x="connsiteX91" y="connsiteY91"/>
              </a:cxn>
              <a:cxn ang="0">
                <a:pos x="connsiteX92" y="connsiteY92"/>
              </a:cxn>
              <a:cxn ang="0">
                <a:pos x="connsiteX93" y="connsiteY93"/>
              </a:cxn>
              <a:cxn ang="0">
                <a:pos x="connsiteX94" y="connsiteY94"/>
              </a:cxn>
              <a:cxn ang="0">
                <a:pos x="connsiteX95" y="connsiteY95"/>
              </a:cxn>
              <a:cxn ang="0">
                <a:pos x="connsiteX96" y="connsiteY96"/>
              </a:cxn>
              <a:cxn ang="0">
                <a:pos x="connsiteX97" y="connsiteY97"/>
              </a:cxn>
            </a:cxnLst>
            <a:rect l="l" t="t" r="r" b="b"/>
            <a:pathLst>
              <a:path w="1895475" h="221456">
                <a:moveTo>
                  <a:pt x="0" y="221456"/>
                </a:moveTo>
                <a:cubicBezTo>
                  <a:pt x="3969" y="220662"/>
                  <a:pt x="8002" y="220140"/>
                  <a:pt x="11907" y="219075"/>
                </a:cubicBezTo>
                <a:cubicBezTo>
                  <a:pt x="19172" y="217094"/>
                  <a:pt x="26194" y="214312"/>
                  <a:pt x="33338" y="211931"/>
                </a:cubicBezTo>
                <a:cubicBezTo>
                  <a:pt x="35719" y="211137"/>
                  <a:pt x="37991" y="209861"/>
                  <a:pt x="40482" y="209550"/>
                </a:cubicBezTo>
                <a:cubicBezTo>
                  <a:pt x="46832" y="208756"/>
                  <a:pt x="53139" y="207447"/>
                  <a:pt x="59532" y="207169"/>
                </a:cubicBezTo>
                <a:cubicBezTo>
                  <a:pt x="89676" y="205858"/>
                  <a:pt x="119857" y="205581"/>
                  <a:pt x="150019" y="204787"/>
                </a:cubicBezTo>
                <a:cubicBezTo>
                  <a:pt x="153988" y="203993"/>
                  <a:pt x="157925" y="203021"/>
                  <a:pt x="161925" y="202406"/>
                </a:cubicBezTo>
                <a:cubicBezTo>
                  <a:pt x="168250" y="201433"/>
                  <a:pt x="174640" y="200930"/>
                  <a:pt x="180975" y="200025"/>
                </a:cubicBezTo>
                <a:cubicBezTo>
                  <a:pt x="185755" y="199342"/>
                  <a:pt x="190500" y="198438"/>
                  <a:pt x="195263" y="197644"/>
                </a:cubicBezTo>
                <a:lnTo>
                  <a:pt x="216694" y="190500"/>
                </a:lnTo>
                <a:lnTo>
                  <a:pt x="223838" y="188119"/>
                </a:lnTo>
                <a:cubicBezTo>
                  <a:pt x="226219" y="186531"/>
                  <a:pt x="228367" y="184518"/>
                  <a:pt x="230982" y="183356"/>
                </a:cubicBezTo>
                <a:cubicBezTo>
                  <a:pt x="242624" y="178182"/>
                  <a:pt x="244148" y="179406"/>
                  <a:pt x="254794" y="176212"/>
                </a:cubicBezTo>
                <a:cubicBezTo>
                  <a:pt x="259602" y="174769"/>
                  <a:pt x="264319" y="173037"/>
                  <a:pt x="269082" y="171450"/>
                </a:cubicBezTo>
                <a:lnTo>
                  <a:pt x="276225" y="169069"/>
                </a:lnTo>
                <a:cubicBezTo>
                  <a:pt x="278606" y="167481"/>
                  <a:pt x="280689" y="165311"/>
                  <a:pt x="283369" y="164306"/>
                </a:cubicBezTo>
                <a:cubicBezTo>
                  <a:pt x="287159" y="162885"/>
                  <a:pt x="291293" y="162649"/>
                  <a:pt x="295275" y="161925"/>
                </a:cubicBezTo>
                <a:cubicBezTo>
                  <a:pt x="307376" y="159725"/>
                  <a:pt x="313761" y="158944"/>
                  <a:pt x="326232" y="157162"/>
                </a:cubicBezTo>
                <a:cubicBezTo>
                  <a:pt x="328613" y="156368"/>
                  <a:pt x="330962" y="155470"/>
                  <a:pt x="333375" y="154781"/>
                </a:cubicBezTo>
                <a:cubicBezTo>
                  <a:pt x="354313" y="148799"/>
                  <a:pt x="332909" y="155730"/>
                  <a:pt x="350044" y="150019"/>
                </a:cubicBezTo>
                <a:cubicBezTo>
                  <a:pt x="352425" y="148431"/>
                  <a:pt x="354573" y="146418"/>
                  <a:pt x="357188" y="145256"/>
                </a:cubicBezTo>
                <a:cubicBezTo>
                  <a:pt x="361775" y="143217"/>
                  <a:pt x="371475" y="140494"/>
                  <a:pt x="371475" y="140494"/>
                </a:cubicBezTo>
                <a:cubicBezTo>
                  <a:pt x="373856" y="138906"/>
                  <a:pt x="376004" y="136893"/>
                  <a:pt x="378619" y="135731"/>
                </a:cubicBezTo>
                <a:cubicBezTo>
                  <a:pt x="383207" y="133692"/>
                  <a:pt x="392907" y="130969"/>
                  <a:pt x="392907" y="130969"/>
                </a:cubicBezTo>
                <a:cubicBezTo>
                  <a:pt x="424586" y="109845"/>
                  <a:pt x="377646" y="140240"/>
                  <a:pt x="407194" y="123825"/>
                </a:cubicBezTo>
                <a:cubicBezTo>
                  <a:pt x="434891" y="108439"/>
                  <a:pt x="407955" y="118809"/>
                  <a:pt x="435769" y="109537"/>
                </a:cubicBezTo>
                <a:cubicBezTo>
                  <a:pt x="438150" y="108743"/>
                  <a:pt x="440428" y="107511"/>
                  <a:pt x="442913" y="107156"/>
                </a:cubicBezTo>
                <a:cubicBezTo>
                  <a:pt x="448469" y="106362"/>
                  <a:pt x="454004" y="105395"/>
                  <a:pt x="459582" y="104775"/>
                </a:cubicBezTo>
                <a:cubicBezTo>
                  <a:pt x="468295" y="103807"/>
                  <a:pt x="477052" y="103266"/>
                  <a:pt x="485775" y="102394"/>
                </a:cubicBezTo>
                <a:cubicBezTo>
                  <a:pt x="492927" y="101679"/>
                  <a:pt x="500063" y="100806"/>
                  <a:pt x="507207" y="100012"/>
                </a:cubicBezTo>
                <a:cubicBezTo>
                  <a:pt x="509588" y="99218"/>
                  <a:pt x="511900" y="98175"/>
                  <a:pt x="514350" y="97631"/>
                </a:cubicBezTo>
                <a:cubicBezTo>
                  <a:pt x="551458" y="89386"/>
                  <a:pt x="600576" y="96923"/>
                  <a:pt x="631032" y="97631"/>
                </a:cubicBezTo>
                <a:cubicBezTo>
                  <a:pt x="633413" y="98425"/>
                  <a:pt x="635725" y="99467"/>
                  <a:pt x="638175" y="100012"/>
                </a:cubicBezTo>
                <a:cubicBezTo>
                  <a:pt x="650605" y="102775"/>
                  <a:pt x="660984" y="103054"/>
                  <a:pt x="673894" y="104775"/>
                </a:cubicBezTo>
                <a:cubicBezTo>
                  <a:pt x="678680" y="105413"/>
                  <a:pt x="683447" y="106209"/>
                  <a:pt x="688182" y="107156"/>
                </a:cubicBezTo>
                <a:cubicBezTo>
                  <a:pt x="691391" y="107798"/>
                  <a:pt x="694479" y="108999"/>
                  <a:pt x="697707" y="109537"/>
                </a:cubicBezTo>
                <a:cubicBezTo>
                  <a:pt x="708779" y="111382"/>
                  <a:pt x="720037" y="112099"/>
                  <a:pt x="731044" y="114300"/>
                </a:cubicBezTo>
                <a:cubicBezTo>
                  <a:pt x="735013" y="115094"/>
                  <a:pt x="739024" y="115699"/>
                  <a:pt x="742950" y="116681"/>
                </a:cubicBezTo>
                <a:cubicBezTo>
                  <a:pt x="745385" y="117290"/>
                  <a:pt x="747644" y="118517"/>
                  <a:pt x="750094" y="119062"/>
                </a:cubicBezTo>
                <a:cubicBezTo>
                  <a:pt x="754807" y="120109"/>
                  <a:pt x="759661" y="120432"/>
                  <a:pt x="764382" y="121444"/>
                </a:cubicBezTo>
                <a:cubicBezTo>
                  <a:pt x="770782" y="122815"/>
                  <a:pt x="777223" y="124136"/>
                  <a:pt x="783432" y="126206"/>
                </a:cubicBezTo>
                <a:lnTo>
                  <a:pt x="797719" y="130969"/>
                </a:lnTo>
                <a:cubicBezTo>
                  <a:pt x="800100" y="131763"/>
                  <a:pt x="802428" y="132741"/>
                  <a:pt x="804863" y="133350"/>
                </a:cubicBezTo>
                <a:cubicBezTo>
                  <a:pt x="808038" y="134144"/>
                  <a:pt x="811253" y="134791"/>
                  <a:pt x="814388" y="135731"/>
                </a:cubicBezTo>
                <a:cubicBezTo>
                  <a:pt x="819196" y="137174"/>
                  <a:pt x="823913" y="138906"/>
                  <a:pt x="828675" y="140494"/>
                </a:cubicBezTo>
                <a:lnTo>
                  <a:pt x="850107" y="147637"/>
                </a:lnTo>
                <a:lnTo>
                  <a:pt x="871538" y="154781"/>
                </a:lnTo>
                <a:lnTo>
                  <a:pt x="878682" y="157162"/>
                </a:lnTo>
                <a:cubicBezTo>
                  <a:pt x="881063" y="157956"/>
                  <a:pt x="883349" y="159131"/>
                  <a:pt x="885825" y="159544"/>
                </a:cubicBezTo>
                <a:cubicBezTo>
                  <a:pt x="918393" y="164971"/>
                  <a:pt x="904931" y="162413"/>
                  <a:pt x="926307" y="166687"/>
                </a:cubicBezTo>
                <a:cubicBezTo>
                  <a:pt x="953294" y="165893"/>
                  <a:pt x="980305" y="165689"/>
                  <a:pt x="1007269" y="164306"/>
                </a:cubicBezTo>
                <a:cubicBezTo>
                  <a:pt x="1011311" y="164099"/>
                  <a:pt x="1015231" y="162835"/>
                  <a:pt x="1019175" y="161925"/>
                </a:cubicBezTo>
                <a:cubicBezTo>
                  <a:pt x="1038604" y="157441"/>
                  <a:pt x="1035460" y="158084"/>
                  <a:pt x="1052513" y="152400"/>
                </a:cubicBezTo>
                <a:cubicBezTo>
                  <a:pt x="1074193" y="145174"/>
                  <a:pt x="1039948" y="156260"/>
                  <a:pt x="1071563" y="147637"/>
                </a:cubicBezTo>
                <a:cubicBezTo>
                  <a:pt x="1076406" y="146316"/>
                  <a:pt x="1081088" y="144462"/>
                  <a:pt x="1085850" y="142875"/>
                </a:cubicBezTo>
                <a:cubicBezTo>
                  <a:pt x="1085855" y="142873"/>
                  <a:pt x="1100134" y="138115"/>
                  <a:pt x="1100138" y="138112"/>
                </a:cubicBezTo>
                <a:cubicBezTo>
                  <a:pt x="1109370" y="131958"/>
                  <a:pt x="1104567" y="134255"/>
                  <a:pt x="1114425" y="130969"/>
                </a:cubicBezTo>
                <a:cubicBezTo>
                  <a:pt x="1116806" y="129381"/>
                  <a:pt x="1119009" y="127486"/>
                  <a:pt x="1121569" y="126206"/>
                </a:cubicBezTo>
                <a:cubicBezTo>
                  <a:pt x="1123814" y="125083"/>
                  <a:pt x="1126519" y="125044"/>
                  <a:pt x="1128713" y="123825"/>
                </a:cubicBezTo>
                <a:cubicBezTo>
                  <a:pt x="1153277" y="110179"/>
                  <a:pt x="1133979" y="117307"/>
                  <a:pt x="1150144" y="111919"/>
                </a:cubicBezTo>
                <a:lnTo>
                  <a:pt x="1171575" y="97631"/>
                </a:lnTo>
                <a:cubicBezTo>
                  <a:pt x="1173956" y="96043"/>
                  <a:pt x="1176695" y="94893"/>
                  <a:pt x="1178719" y="92869"/>
                </a:cubicBezTo>
                <a:cubicBezTo>
                  <a:pt x="1181100" y="90488"/>
                  <a:pt x="1183707" y="88312"/>
                  <a:pt x="1185863" y="85725"/>
                </a:cubicBezTo>
                <a:cubicBezTo>
                  <a:pt x="1187695" y="83526"/>
                  <a:pt x="1188601" y="80605"/>
                  <a:pt x="1190625" y="78581"/>
                </a:cubicBezTo>
                <a:cubicBezTo>
                  <a:pt x="1192649" y="76557"/>
                  <a:pt x="1195388" y="75406"/>
                  <a:pt x="1197769" y="73819"/>
                </a:cubicBezTo>
                <a:cubicBezTo>
                  <a:pt x="1199357" y="71438"/>
                  <a:pt x="1200508" y="68699"/>
                  <a:pt x="1202532" y="66675"/>
                </a:cubicBezTo>
                <a:cubicBezTo>
                  <a:pt x="1204556" y="64651"/>
                  <a:pt x="1207791" y="64066"/>
                  <a:pt x="1209675" y="61912"/>
                </a:cubicBezTo>
                <a:cubicBezTo>
                  <a:pt x="1213444" y="57604"/>
                  <a:pt x="1215153" y="51672"/>
                  <a:pt x="1219200" y="47625"/>
                </a:cubicBezTo>
                <a:cubicBezTo>
                  <a:pt x="1240072" y="26753"/>
                  <a:pt x="1213596" y="52295"/>
                  <a:pt x="1233488" y="35719"/>
                </a:cubicBezTo>
                <a:cubicBezTo>
                  <a:pt x="1245381" y="25809"/>
                  <a:pt x="1235221" y="30379"/>
                  <a:pt x="1247775" y="26194"/>
                </a:cubicBezTo>
                <a:lnTo>
                  <a:pt x="1262063" y="16669"/>
                </a:lnTo>
                <a:cubicBezTo>
                  <a:pt x="1264444" y="15081"/>
                  <a:pt x="1266492" y="12811"/>
                  <a:pt x="1269207" y="11906"/>
                </a:cubicBezTo>
                <a:lnTo>
                  <a:pt x="1283494" y="7144"/>
                </a:lnTo>
                <a:cubicBezTo>
                  <a:pt x="1285875" y="5556"/>
                  <a:pt x="1288078" y="3661"/>
                  <a:pt x="1290638" y="2381"/>
                </a:cubicBezTo>
                <a:cubicBezTo>
                  <a:pt x="1292883" y="1258"/>
                  <a:pt x="1295272" y="0"/>
                  <a:pt x="1297782" y="0"/>
                </a:cubicBezTo>
                <a:cubicBezTo>
                  <a:pt x="1320021" y="0"/>
                  <a:pt x="1342232" y="1587"/>
                  <a:pt x="1364457" y="2381"/>
                </a:cubicBezTo>
                <a:cubicBezTo>
                  <a:pt x="1372394" y="3969"/>
                  <a:pt x="1380416" y="5181"/>
                  <a:pt x="1388269" y="7144"/>
                </a:cubicBezTo>
                <a:cubicBezTo>
                  <a:pt x="1399923" y="10057"/>
                  <a:pt x="1400242" y="10484"/>
                  <a:pt x="1414463" y="11906"/>
                </a:cubicBezTo>
                <a:cubicBezTo>
                  <a:pt x="1486191" y="19078"/>
                  <a:pt x="1413884" y="10344"/>
                  <a:pt x="1464469" y="16669"/>
                </a:cubicBezTo>
                <a:cubicBezTo>
                  <a:pt x="1466850" y="17463"/>
                  <a:pt x="1469134" y="18659"/>
                  <a:pt x="1471613" y="19050"/>
                </a:cubicBezTo>
                <a:cubicBezTo>
                  <a:pt x="1474884" y="19566"/>
                  <a:pt x="1512034" y="23535"/>
                  <a:pt x="1524000" y="26194"/>
                </a:cubicBezTo>
                <a:cubicBezTo>
                  <a:pt x="1526450" y="26739"/>
                  <a:pt x="1528730" y="27885"/>
                  <a:pt x="1531144" y="28575"/>
                </a:cubicBezTo>
                <a:cubicBezTo>
                  <a:pt x="1534291" y="29474"/>
                  <a:pt x="1537474" y="30246"/>
                  <a:pt x="1540669" y="30956"/>
                </a:cubicBezTo>
                <a:cubicBezTo>
                  <a:pt x="1551734" y="33415"/>
                  <a:pt x="1551924" y="32811"/>
                  <a:pt x="1562100" y="35719"/>
                </a:cubicBezTo>
                <a:cubicBezTo>
                  <a:pt x="1564514" y="36409"/>
                  <a:pt x="1566783" y="37608"/>
                  <a:pt x="1569244" y="38100"/>
                </a:cubicBezTo>
                <a:cubicBezTo>
                  <a:pt x="1580966" y="40444"/>
                  <a:pt x="1595782" y="41210"/>
                  <a:pt x="1607344" y="42862"/>
                </a:cubicBezTo>
                <a:cubicBezTo>
                  <a:pt x="1611351" y="43434"/>
                  <a:pt x="1615299" y="44366"/>
                  <a:pt x="1619250" y="45244"/>
                </a:cubicBezTo>
                <a:cubicBezTo>
                  <a:pt x="1622445" y="45954"/>
                  <a:pt x="1625540" y="47127"/>
                  <a:pt x="1628775" y="47625"/>
                </a:cubicBezTo>
                <a:cubicBezTo>
                  <a:pt x="1635879" y="48718"/>
                  <a:pt x="1643075" y="49115"/>
                  <a:pt x="1650207" y="50006"/>
                </a:cubicBezTo>
                <a:cubicBezTo>
                  <a:pt x="1687414" y="54656"/>
                  <a:pt x="1642723" y="50776"/>
                  <a:pt x="1702594" y="54769"/>
                </a:cubicBezTo>
                <a:cubicBezTo>
                  <a:pt x="1706563" y="55563"/>
                  <a:pt x="1710482" y="56668"/>
                  <a:pt x="1714500" y="57150"/>
                </a:cubicBezTo>
                <a:cubicBezTo>
                  <a:pt x="1730341" y="59051"/>
                  <a:pt x="1762125" y="61912"/>
                  <a:pt x="1762125" y="61912"/>
                </a:cubicBezTo>
                <a:cubicBezTo>
                  <a:pt x="1768475" y="63500"/>
                  <a:pt x="1774719" y="65599"/>
                  <a:pt x="1781175" y="66675"/>
                </a:cubicBezTo>
                <a:cubicBezTo>
                  <a:pt x="1803331" y="70367"/>
                  <a:pt x="1790659" y="68576"/>
                  <a:pt x="1819275" y="71437"/>
                </a:cubicBezTo>
                <a:cubicBezTo>
                  <a:pt x="1837427" y="75976"/>
                  <a:pt x="1823379" y="72952"/>
                  <a:pt x="1852613" y="76200"/>
                </a:cubicBezTo>
                <a:cubicBezTo>
                  <a:pt x="1858973" y="76907"/>
                  <a:pt x="1865338" y="77608"/>
                  <a:pt x="1871663" y="78581"/>
                </a:cubicBezTo>
                <a:cubicBezTo>
                  <a:pt x="1875663" y="79196"/>
                  <a:pt x="1879542" y="80559"/>
                  <a:pt x="1883569" y="80962"/>
                </a:cubicBezTo>
                <a:cubicBezTo>
                  <a:pt x="1887518" y="81357"/>
                  <a:pt x="1891506" y="80962"/>
                  <a:pt x="1895475" y="80962"/>
                </a:cubicBezTo>
              </a:path>
            </a:pathLst>
          </a:custGeom>
          <a:noFill/>
          <a:ln w="38100">
            <a:solidFill>
              <a:schemeClr val="bg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9666"/>
          </a:p>
        </p:txBody>
      </p:sp>
      <p:sp>
        <p:nvSpPr>
          <p:cNvPr id="212" name="Freeform 211"/>
          <p:cNvSpPr/>
          <p:nvPr/>
        </p:nvSpPr>
        <p:spPr>
          <a:xfrm>
            <a:off x="13338786" y="5015406"/>
            <a:ext cx="4644898" cy="577655"/>
          </a:xfrm>
          <a:custGeom>
            <a:avLst/>
            <a:gdLst>
              <a:gd name="connsiteX0" fmla="*/ 0 w 1914525"/>
              <a:gd name="connsiteY0" fmla="*/ 0 h 223837"/>
              <a:gd name="connsiteX1" fmla="*/ 47625 w 1914525"/>
              <a:gd name="connsiteY1" fmla="*/ 7143 h 223837"/>
              <a:gd name="connsiteX2" fmla="*/ 69057 w 1914525"/>
              <a:gd name="connsiteY2" fmla="*/ 14287 h 223837"/>
              <a:gd name="connsiteX3" fmla="*/ 76200 w 1914525"/>
              <a:gd name="connsiteY3" fmla="*/ 16668 h 223837"/>
              <a:gd name="connsiteX4" fmla="*/ 83344 w 1914525"/>
              <a:gd name="connsiteY4" fmla="*/ 23812 h 223837"/>
              <a:gd name="connsiteX5" fmla="*/ 90488 w 1914525"/>
              <a:gd name="connsiteY5" fmla="*/ 28575 h 223837"/>
              <a:gd name="connsiteX6" fmla="*/ 119063 w 1914525"/>
              <a:gd name="connsiteY6" fmla="*/ 52387 h 223837"/>
              <a:gd name="connsiteX7" fmla="*/ 133350 w 1914525"/>
              <a:gd name="connsiteY7" fmla="*/ 57150 h 223837"/>
              <a:gd name="connsiteX8" fmla="*/ 147638 w 1914525"/>
              <a:gd name="connsiteY8" fmla="*/ 64293 h 223837"/>
              <a:gd name="connsiteX9" fmla="*/ 200025 w 1914525"/>
              <a:gd name="connsiteY9" fmla="*/ 61912 h 223837"/>
              <a:gd name="connsiteX10" fmla="*/ 221457 w 1914525"/>
              <a:gd name="connsiteY10" fmla="*/ 54768 h 223837"/>
              <a:gd name="connsiteX11" fmla="*/ 242888 w 1914525"/>
              <a:gd name="connsiteY11" fmla="*/ 47625 h 223837"/>
              <a:gd name="connsiteX12" fmla="*/ 250032 w 1914525"/>
              <a:gd name="connsiteY12" fmla="*/ 45243 h 223837"/>
              <a:gd name="connsiteX13" fmla="*/ 257175 w 1914525"/>
              <a:gd name="connsiteY13" fmla="*/ 40481 h 223837"/>
              <a:gd name="connsiteX14" fmla="*/ 271463 w 1914525"/>
              <a:gd name="connsiteY14" fmla="*/ 35718 h 223837"/>
              <a:gd name="connsiteX15" fmla="*/ 278607 w 1914525"/>
              <a:gd name="connsiteY15" fmla="*/ 30956 h 223837"/>
              <a:gd name="connsiteX16" fmla="*/ 300038 w 1914525"/>
              <a:gd name="connsiteY16" fmla="*/ 26193 h 223837"/>
              <a:gd name="connsiteX17" fmla="*/ 333375 w 1914525"/>
              <a:gd name="connsiteY17" fmla="*/ 23812 h 223837"/>
              <a:gd name="connsiteX18" fmla="*/ 400050 w 1914525"/>
              <a:gd name="connsiteY18" fmla="*/ 28575 h 223837"/>
              <a:gd name="connsiteX19" fmla="*/ 409575 w 1914525"/>
              <a:gd name="connsiteY19" fmla="*/ 30956 h 223837"/>
              <a:gd name="connsiteX20" fmla="*/ 433388 w 1914525"/>
              <a:gd name="connsiteY20" fmla="*/ 35718 h 223837"/>
              <a:gd name="connsiteX21" fmla="*/ 450057 w 1914525"/>
              <a:gd name="connsiteY21" fmla="*/ 40481 h 223837"/>
              <a:gd name="connsiteX22" fmla="*/ 481013 w 1914525"/>
              <a:gd name="connsiteY22" fmla="*/ 45243 h 223837"/>
              <a:gd name="connsiteX23" fmla="*/ 500063 w 1914525"/>
              <a:gd name="connsiteY23" fmla="*/ 47625 h 223837"/>
              <a:gd name="connsiteX24" fmla="*/ 528638 w 1914525"/>
              <a:gd name="connsiteY24" fmla="*/ 52387 h 223837"/>
              <a:gd name="connsiteX25" fmla="*/ 538163 w 1914525"/>
              <a:gd name="connsiteY25" fmla="*/ 54768 h 223837"/>
              <a:gd name="connsiteX26" fmla="*/ 583407 w 1914525"/>
              <a:gd name="connsiteY26" fmla="*/ 61912 h 223837"/>
              <a:gd name="connsiteX27" fmla="*/ 604838 w 1914525"/>
              <a:gd name="connsiteY27" fmla="*/ 69056 h 223837"/>
              <a:gd name="connsiteX28" fmla="*/ 611982 w 1914525"/>
              <a:gd name="connsiteY28" fmla="*/ 71437 h 223837"/>
              <a:gd name="connsiteX29" fmla="*/ 619125 w 1914525"/>
              <a:gd name="connsiteY29" fmla="*/ 73818 h 223837"/>
              <a:gd name="connsiteX30" fmla="*/ 626269 w 1914525"/>
              <a:gd name="connsiteY30" fmla="*/ 78581 h 223837"/>
              <a:gd name="connsiteX31" fmla="*/ 631032 w 1914525"/>
              <a:gd name="connsiteY31" fmla="*/ 85725 h 223837"/>
              <a:gd name="connsiteX32" fmla="*/ 638175 w 1914525"/>
              <a:gd name="connsiteY32" fmla="*/ 88106 h 223837"/>
              <a:gd name="connsiteX33" fmla="*/ 642938 w 1914525"/>
              <a:gd name="connsiteY33" fmla="*/ 95250 h 223837"/>
              <a:gd name="connsiteX34" fmla="*/ 664369 w 1914525"/>
              <a:gd name="connsiteY34" fmla="*/ 107156 h 223837"/>
              <a:gd name="connsiteX35" fmla="*/ 671513 w 1914525"/>
              <a:gd name="connsiteY35" fmla="*/ 111918 h 223837"/>
              <a:gd name="connsiteX36" fmla="*/ 707232 w 1914525"/>
              <a:gd name="connsiteY36" fmla="*/ 109537 h 223837"/>
              <a:gd name="connsiteX37" fmla="*/ 721519 w 1914525"/>
              <a:gd name="connsiteY37" fmla="*/ 102393 h 223837"/>
              <a:gd name="connsiteX38" fmla="*/ 728663 w 1914525"/>
              <a:gd name="connsiteY38" fmla="*/ 95250 h 223837"/>
              <a:gd name="connsiteX39" fmla="*/ 735807 w 1914525"/>
              <a:gd name="connsiteY39" fmla="*/ 92868 h 223837"/>
              <a:gd name="connsiteX40" fmla="*/ 742950 w 1914525"/>
              <a:gd name="connsiteY40" fmla="*/ 88106 h 223837"/>
              <a:gd name="connsiteX41" fmla="*/ 750094 w 1914525"/>
              <a:gd name="connsiteY41" fmla="*/ 85725 h 223837"/>
              <a:gd name="connsiteX42" fmla="*/ 776288 w 1914525"/>
              <a:gd name="connsiteY42" fmla="*/ 78581 h 223837"/>
              <a:gd name="connsiteX43" fmla="*/ 816769 w 1914525"/>
              <a:gd name="connsiteY43" fmla="*/ 80962 h 223837"/>
              <a:gd name="connsiteX44" fmla="*/ 845344 w 1914525"/>
              <a:gd name="connsiteY44" fmla="*/ 95250 h 223837"/>
              <a:gd name="connsiteX45" fmla="*/ 852488 w 1914525"/>
              <a:gd name="connsiteY45" fmla="*/ 100012 h 223837"/>
              <a:gd name="connsiteX46" fmla="*/ 866775 w 1914525"/>
              <a:gd name="connsiteY46" fmla="*/ 107156 h 223837"/>
              <a:gd name="connsiteX47" fmla="*/ 873919 w 1914525"/>
              <a:gd name="connsiteY47" fmla="*/ 111918 h 223837"/>
              <a:gd name="connsiteX48" fmla="*/ 888207 w 1914525"/>
              <a:gd name="connsiteY48" fmla="*/ 116681 h 223837"/>
              <a:gd name="connsiteX49" fmla="*/ 902494 w 1914525"/>
              <a:gd name="connsiteY49" fmla="*/ 126206 h 223837"/>
              <a:gd name="connsiteX50" fmla="*/ 909638 w 1914525"/>
              <a:gd name="connsiteY50" fmla="*/ 130968 h 223837"/>
              <a:gd name="connsiteX51" fmla="*/ 916782 w 1914525"/>
              <a:gd name="connsiteY51" fmla="*/ 133350 h 223837"/>
              <a:gd name="connsiteX52" fmla="*/ 923925 w 1914525"/>
              <a:gd name="connsiteY52" fmla="*/ 140493 h 223837"/>
              <a:gd name="connsiteX53" fmla="*/ 931069 w 1914525"/>
              <a:gd name="connsiteY53" fmla="*/ 142875 h 223837"/>
              <a:gd name="connsiteX54" fmla="*/ 966788 w 1914525"/>
              <a:gd name="connsiteY54" fmla="*/ 145256 h 223837"/>
              <a:gd name="connsiteX55" fmla="*/ 981075 w 1914525"/>
              <a:gd name="connsiteY55" fmla="*/ 166687 h 223837"/>
              <a:gd name="connsiteX56" fmla="*/ 985838 w 1914525"/>
              <a:gd name="connsiteY56" fmla="*/ 173831 h 223837"/>
              <a:gd name="connsiteX57" fmla="*/ 1000125 w 1914525"/>
              <a:gd name="connsiteY57" fmla="*/ 180975 h 223837"/>
              <a:gd name="connsiteX58" fmla="*/ 1007269 w 1914525"/>
              <a:gd name="connsiteY58" fmla="*/ 185737 h 223837"/>
              <a:gd name="connsiteX59" fmla="*/ 1028700 w 1914525"/>
              <a:gd name="connsiteY59" fmla="*/ 192881 h 223837"/>
              <a:gd name="connsiteX60" fmla="*/ 1042988 w 1914525"/>
              <a:gd name="connsiteY60" fmla="*/ 197643 h 223837"/>
              <a:gd name="connsiteX61" fmla="*/ 1050132 w 1914525"/>
              <a:gd name="connsiteY61" fmla="*/ 200025 h 223837"/>
              <a:gd name="connsiteX62" fmla="*/ 1064419 w 1914525"/>
              <a:gd name="connsiteY62" fmla="*/ 207168 h 223837"/>
              <a:gd name="connsiteX63" fmla="*/ 1071563 w 1914525"/>
              <a:gd name="connsiteY63" fmla="*/ 211931 h 223837"/>
              <a:gd name="connsiteX64" fmla="*/ 1085850 w 1914525"/>
              <a:gd name="connsiteY64" fmla="*/ 216693 h 223837"/>
              <a:gd name="connsiteX65" fmla="*/ 1092994 w 1914525"/>
              <a:gd name="connsiteY65" fmla="*/ 219075 h 223837"/>
              <a:gd name="connsiteX66" fmla="*/ 1100138 w 1914525"/>
              <a:gd name="connsiteY66" fmla="*/ 221456 h 223837"/>
              <a:gd name="connsiteX67" fmla="*/ 1107282 w 1914525"/>
              <a:gd name="connsiteY67" fmla="*/ 223837 h 223837"/>
              <a:gd name="connsiteX68" fmla="*/ 1135857 w 1914525"/>
              <a:gd name="connsiteY68" fmla="*/ 219075 h 223837"/>
              <a:gd name="connsiteX69" fmla="*/ 1150144 w 1914525"/>
              <a:gd name="connsiteY69" fmla="*/ 209550 h 223837"/>
              <a:gd name="connsiteX70" fmla="*/ 1166813 w 1914525"/>
              <a:gd name="connsiteY70" fmla="*/ 188118 h 223837"/>
              <a:gd name="connsiteX71" fmla="*/ 1173957 w 1914525"/>
              <a:gd name="connsiteY71" fmla="*/ 183356 h 223837"/>
              <a:gd name="connsiteX72" fmla="*/ 1183482 w 1914525"/>
              <a:gd name="connsiteY72" fmla="*/ 169068 h 223837"/>
              <a:gd name="connsiteX73" fmla="*/ 1185863 w 1914525"/>
              <a:gd name="connsiteY73" fmla="*/ 161925 h 223837"/>
              <a:gd name="connsiteX74" fmla="*/ 1200150 w 1914525"/>
              <a:gd name="connsiteY74" fmla="*/ 154781 h 223837"/>
              <a:gd name="connsiteX75" fmla="*/ 1300163 w 1914525"/>
              <a:gd name="connsiteY75" fmla="*/ 157162 h 223837"/>
              <a:gd name="connsiteX76" fmla="*/ 1321594 w 1914525"/>
              <a:gd name="connsiteY76" fmla="*/ 166687 h 223837"/>
              <a:gd name="connsiteX77" fmla="*/ 1335882 w 1914525"/>
              <a:gd name="connsiteY77" fmla="*/ 171450 h 223837"/>
              <a:gd name="connsiteX78" fmla="*/ 1343025 w 1914525"/>
              <a:gd name="connsiteY78" fmla="*/ 173831 h 223837"/>
              <a:gd name="connsiteX79" fmla="*/ 1357313 w 1914525"/>
              <a:gd name="connsiteY79" fmla="*/ 180975 h 223837"/>
              <a:gd name="connsiteX80" fmla="*/ 1371600 w 1914525"/>
              <a:gd name="connsiteY80" fmla="*/ 188118 h 223837"/>
              <a:gd name="connsiteX81" fmla="*/ 1385888 w 1914525"/>
              <a:gd name="connsiteY81" fmla="*/ 197643 h 223837"/>
              <a:gd name="connsiteX82" fmla="*/ 1402557 w 1914525"/>
              <a:gd name="connsiteY82" fmla="*/ 214312 h 223837"/>
              <a:gd name="connsiteX83" fmla="*/ 1416844 w 1914525"/>
              <a:gd name="connsiteY83" fmla="*/ 219075 h 223837"/>
              <a:gd name="connsiteX84" fmla="*/ 1459707 w 1914525"/>
              <a:gd name="connsiteY84" fmla="*/ 214312 h 223837"/>
              <a:gd name="connsiteX85" fmla="*/ 1469232 w 1914525"/>
              <a:gd name="connsiteY85" fmla="*/ 211931 h 223837"/>
              <a:gd name="connsiteX86" fmla="*/ 1500188 w 1914525"/>
              <a:gd name="connsiteY86" fmla="*/ 204787 h 223837"/>
              <a:gd name="connsiteX87" fmla="*/ 1507332 w 1914525"/>
              <a:gd name="connsiteY87" fmla="*/ 202406 h 223837"/>
              <a:gd name="connsiteX88" fmla="*/ 1528763 w 1914525"/>
              <a:gd name="connsiteY88" fmla="*/ 200025 h 223837"/>
              <a:gd name="connsiteX89" fmla="*/ 1557338 w 1914525"/>
              <a:gd name="connsiteY89" fmla="*/ 195262 h 223837"/>
              <a:gd name="connsiteX90" fmla="*/ 1564482 w 1914525"/>
              <a:gd name="connsiteY90" fmla="*/ 192881 h 223837"/>
              <a:gd name="connsiteX91" fmla="*/ 1583532 w 1914525"/>
              <a:gd name="connsiteY91" fmla="*/ 188118 h 223837"/>
              <a:gd name="connsiteX92" fmla="*/ 1590675 w 1914525"/>
              <a:gd name="connsiteY92" fmla="*/ 185737 h 223837"/>
              <a:gd name="connsiteX93" fmla="*/ 1597819 w 1914525"/>
              <a:gd name="connsiteY93" fmla="*/ 180975 h 223837"/>
              <a:gd name="connsiteX94" fmla="*/ 1612107 w 1914525"/>
              <a:gd name="connsiteY94" fmla="*/ 176212 h 223837"/>
              <a:gd name="connsiteX95" fmla="*/ 1619250 w 1914525"/>
              <a:gd name="connsiteY95" fmla="*/ 173831 h 223837"/>
              <a:gd name="connsiteX96" fmla="*/ 1626394 w 1914525"/>
              <a:gd name="connsiteY96" fmla="*/ 169068 h 223837"/>
              <a:gd name="connsiteX97" fmla="*/ 1633538 w 1914525"/>
              <a:gd name="connsiteY97" fmla="*/ 166687 h 223837"/>
              <a:gd name="connsiteX98" fmla="*/ 1647825 w 1914525"/>
              <a:gd name="connsiteY98" fmla="*/ 157162 h 223837"/>
              <a:gd name="connsiteX99" fmla="*/ 1662113 w 1914525"/>
              <a:gd name="connsiteY99" fmla="*/ 145256 h 223837"/>
              <a:gd name="connsiteX100" fmla="*/ 1676400 w 1914525"/>
              <a:gd name="connsiteY100" fmla="*/ 123825 h 223837"/>
              <a:gd name="connsiteX101" fmla="*/ 1681163 w 1914525"/>
              <a:gd name="connsiteY101" fmla="*/ 116681 h 223837"/>
              <a:gd name="connsiteX102" fmla="*/ 1695450 w 1914525"/>
              <a:gd name="connsiteY102" fmla="*/ 107156 h 223837"/>
              <a:gd name="connsiteX103" fmla="*/ 1702594 w 1914525"/>
              <a:gd name="connsiteY103" fmla="*/ 102393 h 223837"/>
              <a:gd name="connsiteX104" fmla="*/ 1716882 w 1914525"/>
              <a:gd name="connsiteY104" fmla="*/ 92868 h 223837"/>
              <a:gd name="connsiteX105" fmla="*/ 1738313 w 1914525"/>
              <a:gd name="connsiteY105" fmla="*/ 80962 h 223837"/>
              <a:gd name="connsiteX106" fmla="*/ 1745457 w 1914525"/>
              <a:gd name="connsiteY106" fmla="*/ 76200 h 223837"/>
              <a:gd name="connsiteX107" fmla="*/ 1759744 w 1914525"/>
              <a:gd name="connsiteY107" fmla="*/ 71437 h 223837"/>
              <a:gd name="connsiteX108" fmla="*/ 1774032 w 1914525"/>
              <a:gd name="connsiteY108" fmla="*/ 66675 h 223837"/>
              <a:gd name="connsiteX109" fmla="*/ 1788319 w 1914525"/>
              <a:gd name="connsiteY109" fmla="*/ 61912 h 223837"/>
              <a:gd name="connsiteX110" fmla="*/ 1800225 w 1914525"/>
              <a:gd name="connsiteY110" fmla="*/ 59531 h 223837"/>
              <a:gd name="connsiteX111" fmla="*/ 1814513 w 1914525"/>
              <a:gd name="connsiteY111" fmla="*/ 54768 h 223837"/>
              <a:gd name="connsiteX112" fmla="*/ 1857375 w 1914525"/>
              <a:gd name="connsiteY112" fmla="*/ 50006 h 223837"/>
              <a:gd name="connsiteX113" fmla="*/ 1914525 w 1914525"/>
              <a:gd name="connsiteY113" fmla="*/ 50006 h 223837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  <a:cxn ang="0">
                <a:pos x="connsiteX31" y="connsiteY31"/>
              </a:cxn>
              <a:cxn ang="0">
                <a:pos x="connsiteX32" y="connsiteY32"/>
              </a:cxn>
              <a:cxn ang="0">
                <a:pos x="connsiteX33" y="connsiteY33"/>
              </a:cxn>
              <a:cxn ang="0">
                <a:pos x="connsiteX34" y="connsiteY34"/>
              </a:cxn>
              <a:cxn ang="0">
                <a:pos x="connsiteX35" y="connsiteY35"/>
              </a:cxn>
              <a:cxn ang="0">
                <a:pos x="connsiteX36" y="connsiteY36"/>
              </a:cxn>
              <a:cxn ang="0">
                <a:pos x="connsiteX37" y="connsiteY37"/>
              </a:cxn>
              <a:cxn ang="0">
                <a:pos x="connsiteX38" y="connsiteY38"/>
              </a:cxn>
              <a:cxn ang="0">
                <a:pos x="connsiteX39" y="connsiteY39"/>
              </a:cxn>
              <a:cxn ang="0">
                <a:pos x="connsiteX40" y="connsiteY40"/>
              </a:cxn>
              <a:cxn ang="0">
                <a:pos x="connsiteX41" y="connsiteY41"/>
              </a:cxn>
              <a:cxn ang="0">
                <a:pos x="connsiteX42" y="connsiteY42"/>
              </a:cxn>
              <a:cxn ang="0">
                <a:pos x="connsiteX43" y="connsiteY43"/>
              </a:cxn>
              <a:cxn ang="0">
                <a:pos x="connsiteX44" y="connsiteY44"/>
              </a:cxn>
              <a:cxn ang="0">
                <a:pos x="connsiteX45" y="connsiteY45"/>
              </a:cxn>
              <a:cxn ang="0">
                <a:pos x="connsiteX46" y="connsiteY46"/>
              </a:cxn>
              <a:cxn ang="0">
                <a:pos x="connsiteX47" y="connsiteY47"/>
              </a:cxn>
              <a:cxn ang="0">
                <a:pos x="connsiteX48" y="connsiteY48"/>
              </a:cxn>
              <a:cxn ang="0">
                <a:pos x="connsiteX49" y="connsiteY49"/>
              </a:cxn>
              <a:cxn ang="0">
                <a:pos x="connsiteX50" y="connsiteY50"/>
              </a:cxn>
              <a:cxn ang="0">
                <a:pos x="connsiteX51" y="connsiteY51"/>
              </a:cxn>
              <a:cxn ang="0">
                <a:pos x="connsiteX52" y="connsiteY52"/>
              </a:cxn>
              <a:cxn ang="0">
                <a:pos x="connsiteX53" y="connsiteY53"/>
              </a:cxn>
              <a:cxn ang="0">
                <a:pos x="connsiteX54" y="connsiteY54"/>
              </a:cxn>
              <a:cxn ang="0">
                <a:pos x="connsiteX55" y="connsiteY55"/>
              </a:cxn>
              <a:cxn ang="0">
                <a:pos x="connsiteX56" y="connsiteY56"/>
              </a:cxn>
              <a:cxn ang="0">
                <a:pos x="connsiteX57" y="connsiteY57"/>
              </a:cxn>
              <a:cxn ang="0">
                <a:pos x="connsiteX58" y="connsiteY58"/>
              </a:cxn>
              <a:cxn ang="0">
                <a:pos x="connsiteX59" y="connsiteY59"/>
              </a:cxn>
              <a:cxn ang="0">
                <a:pos x="connsiteX60" y="connsiteY60"/>
              </a:cxn>
              <a:cxn ang="0">
                <a:pos x="connsiteX61" y="connsiteY61"/>
              </a:cxn>
              <a:cxn ang="0">
                <a:pos x="connsiteX62" y="connsiteY62"/>
              </a:cxn>
              <a:cxn ang="0">
                <a:pos x="connsiteX63" y="connsiteY63"/>
              </a:cxn>
              <a:cxn ang="0">
                <a:pos x="connsiteX64" y="connsiteY64"/>
              </a:cxn>
              <a:cxn ang="0">
                <a:pos x="connsiteX65" y="connsiteY65"/>
              </a:cxn>
              <a:cxn ang="0">
                <a:pos x="connsiteX66" y="connsiteY66"/>
              </a:cxn>
              <a:cxn ang="0">
                <a:pos x="connsiteX67" y="connsiteY67"/>
              </a:cxn>
              <a:cxn ang="0">
                <a:pos x="connsiteX68" y="connsiteY68"/>
              </a:cxn>
              <a:cxn ang="0">
                <a:pos x="connsiteX69" y="connsiteY69"/>
              </a:cxn>
              <a:cxn ang="0">
                <a:pos x="connsiteX70" y="connsiteY70"/>
              </a:cxn>
              <a:cxn ang="0">
                <a:pos x="connsiteX71" y="connsiteY71"/>
              </a:cxn>
              <a:cxn ang="0">
                <a:pos x="connsiteX72" y="connsiteY72"/>
              </a:cxn>
              <a:cxn ang="0">
                <a:pos x="connsiteX73" y="connsiteY73"/>
              </a:cxn>
              <a:cxn ang="0">
                <a:pos x="connsiteX74" y="connsiteY74"/>
              </a:cxn>
              <a:cxn ang="0">
                <a:pos x="connsiteX75" y="connsiteY75"/>
              </a:cxn>
              <a:cxn ang="0">
                <a:pos x="connsiteX76" y="connsiteY76"/>
              </a:cxn>
              <a:cxn ang="0">
                <a:pos x="connsiteX77" y="connsiteY77"/>
              </a:cxn>
              <a:cxn ang="0">
                <a:pos x="connsiteX78" y="connsiteY78"/>
              </a:cxn>
              <a:cxn ang="0">
                <a:pos x="connsiteX79" y="connsiteY79"/>
              </a:cxn>
              <a:cxn ang="0">
                <a:pos x="connsiteX80" y="connsiteY80"/>
              </a:cxn>
              <a:cxn ang="0">
                <a:pos x="connsiteX81" y="connsiteY81"/>
              </a:cxn>
              <a:cxn ang="0">
                <a:pos x="connsiteX82" y="connsiteY82"/>
              </a:cxn>
              <a:cxn ang="0">
                <a:pos x="connsiteX83" y="connsiteY83"/>
              </a:cxn>
              <a:cxn ang="0">
                <a:pos x="connsiteX84" y="connsiteY84"/>
              </a:cxn>
              <a:cxn ang="0">
                <a:pos x="connsiteX85" y="connsiteY85"/>
              </a:cxn>
              <a:cxn ang="0">
                <a:pos x="connsiteX86" y="connsiteY86"/>
              </a:cxn>
              <a:cxn ang="0">
                <a:pos x="connsiteX87" y="connsiteY87"/>
              </a:cxn>
              <a:cxn ang="0">
                <a:pos x="connsiteX88" y="connsiteY88"/>
              </a:cxn>
              <a:cxn ang="0">
                <a:pos x="connsiteX89" y="connsiteY89"/>
              </a:cxn>
              <a:cxn ang="0">
                <a:pos x="connsiteX90" y="connsiteY90"/>
              </a:cxn>
              <a:cxn ang="0">
                <a:pos x="connsiteX91" y="connsiteY91"/>
              </a:cxn>
              <a:cxn ang="0">
                <a:pos x="connsiteX92" y="connsiteY92"/>
              </a:cxn>
              <a:cxn ang="0">
                <a:pos x="connsiteX93" y="connsiteY93"/>
              </a:cxn>
              <a:cxn ang="0">
                <a:pos x="connsiteX94" y="connsiteY94"/>
              </a:cxn>
              <a:cxn ang="0">
                <a:pos x="connsiteX95" y="connsiteY95"/>
              </a:cxn>
              <a:cxn ang="0">
                <a:pos x="connsiteX96" y="connsiteY96"/>
              </a:cxn>
              <a:cxn ang="0">
                <a:pos x="connsiteX97" y="connsiteY97"/>
              </a:cxn>
              <a:cxn ang="0">
                <a:pos x="connsiteX98" y="connsiteY98"/>
              </a:cxn>
              <a:cxn ang="0">
                <a:pos x="connsiteX99" y="connsiteY99"/>
              </a:cxn>
              <a:cxn ang="0">
                <a:pos x="connsiteX100" y="connsiteY100"/>
              </a:cxn>
              <a:cxn ang="0">
                <a:pos x="connsiteX101" y="connsiteY101"/>
              </a:cxn>
              <a:cxn ang="0">
                <a:pos x="connsiteX102" y="connsiteY102"/>
              </a:cxn>
              <a:cxn ang="0">
                <a:pos x="connsiteX103" y="connsiteY103"/>
              </a:cxn>
              <a:cxn ang="0">
                <a:pos x="connsiteX104" y="connsiteY104"/>
              </a:cxn>
              <a:cxn ang="0">
                <a:pos x="connsiteX105" y="connsiteY105"/>
              </a:cxn>
              <a:cxn ang="0">
                <a:pos x="connsiteX106" y="connsiteY106"/>
              </a:cxn>
              <a:cxn ang="0">
                <a:pos x="connsiteX107" y="connsiteY107"/>
              </a:cxn>
              <a:cxn ang="0">
                <a:pos x="connsiteX108" y="connsiteY108"/>
              </a:cxn>
              <a:cxn ang="0">
                <a:pos x="connsiteX109" y="connsiteY109"/>
              </a:cxn>
              <a:cxn ang="0">
                <a:pos x="connsiteX110" y="connsiteY110"/>
              </a:cxn>
              <a:cxn ang="0">
                <a:pos x="connsiteX111" y="connsiteY111"/>
              </a:cxn>
              <a:cxn ang="0">
                <a:pos x="connsiteX112" y="connsiteY112"/>
              </a:cxn>
              <a:cxn ang="0">
                <a:pos x="connsiteX113" y="connsiteY113"/>
              </a:cxn>
            </a:cxnLst>
            <a:rect l="l" t="t" r="r" b="b"/>
            <a:pathLst>
              <a:path w="1914525" h="223837">
                <a:moveTo>
                  <a:pt x="0" y="0"/>
                </a:moveTo>
                <a:cubicBezTo>
                  <a:pt x="38337" y="2738"/>
                  <a:pt x="22772" y="-1142"/>
                  <a:pt x="47625" y="7143"/>
                </a:cubicBezTo>
                <a:lnTo>
                  <a:pt x="69057" y="14287"/>
                </a:lnTo>
                <a:lnTo>
                  <a:pt x="76200" y="16668"/>
                </a:lnTo>
                <a:cubicBezTo>
                  <a:pt x="78581" y="19049"/>
                  <a:pt x="80757" y="21656"/>
                  <a:pt x="83344" y="23812"/>
                </a:cubicBezTo>
                <a:cubicBezTo>
                  <a:pt x="85543" y="25644"/>
                  <a:pt x="88349" y="26674"/>
                  <a:pt x="90488" y="28575"/>
                </a:cubicBezTo>
                <a:cubicBezTo>
                  <a:pt x="98448" y="35651"/>
                  <a:pt x="107988" y="48695"/>
                  <a:pt x="119063" y="52387"/>
                </a:cubicBezTo>
                <a:cubicBezTo>
                  <a:pt x="123825" y="53975"/>
                  <a:pt x="129173" y="54366"/>
                  <a:pt x="133350" y="57150"/>
                </a:cubicBezTo>
                <a:cubicBezTo>
                  <a:pt x="142583" y="63304"/>
                  <a:pt x="137779" y="61007"/>
                  <a:pt x="147638" y="64293"/>
                </a:cubicBezTo>
                <a:cubicBezTo>
                  <a:pt x="165100" y="63499"/>
                  <a:pt x="182644" y="63774"/>
                  <a:pt x="200025" y="61912"/>
                </a:cubicBezTo>
                <a:cubicBezTo>
                  <a:pt x="200037" y="61911"/>
                  <a:pt x="217880" y="55961"/>
                  <a:pt x="221457" y="54768"/>
                </a:cubicBezTo>
                <a:lnTo>
                  <a:pt x="242888" y="47625"/>
                </a:lnTo>
                <a:cubicBezTo>
                  <a:pt x="245269" y="46831"/>
                  <a:pt x="247943" y="46635"/>
                  <a:pt x="250032" y="45243"/>
                </a:cubicBezTo>
                <a:cubicBezTo>
                  <a:pt x="252413" y="43656"/>
                  <a:pt x="254560" y="41643"/>
                  <a:pt x="257175" y="40481"/>
                </a:cubicBezTo>
                <a:cubicBezTo>
                  <a:pt x="261763" y="38442"/>
                  <a:pt x="267286" y="38503"/>
                  <a:pt x="271463" y="35718"/>
                </a:cubicBezTo>
                <a:cubicBezTo>
                  <a:pt x="273844" y="34131"/>
                  <a:pt x="276047" y="32236"/>
                  <a:pt x="278607" y="30956"/>
                </a:cubicBezTo>
                <a:cubicBezTo>
                  <a:pt x="283993" y="28263"/>
                  <a:pt x="295467" y="26650"/>
                  <a:pt x="300038" y="26193"/>
                </a:cubicBezTo>
                <a:cubicBezTo>
                  <a:pt x="311123" y="25084"/>
                  <a:pt x="322263" y="24606"/>
                  <a:pt x="333375" y="23812"/>
                </a:cubicBezTo>
                <a:cubicBezTo>
                  <a:pt x="360365" y="25097"/>
                  <a:pt x="376488" y="24290"/>
                  <a:pt x="400050" y="28575"/>
                </a:cubicBezTo>
                <a:cubicBezTo>
                  <a:pt x="403270" y="29161"/>
                  <a:pt x="406375" y="30270"/>
                  <a:pt x="409575" y="30956"/>
                </a:cubicBezTo>
                <a:cubicBezTo>
                  <a:pt x="417490" y="32652"/>
                  <a:pt x="425709" y="33158"/>
                  <a:pt x="433388" y="35718"/>
                </a:cubicBezTo>
                <a:cubicBezTo>
                  <a:pt x="440200" y="37989"/>
                  <a:pt x="442577" y="38985"/>
                  <a:pt x="450057" y="40481"/>
                </a:cubicBezTo>
                <a:cubicBezTo>
                  <a:pt x="457337" y="41937"/>
                  <a:pt x="474146" y="44327"/>
                  <a:pt x="481013" y="45243"/>
                </a:cubicBezTo>
                <a:cubicBezTo>
                  <a:pt x="487356" y="46089"/>
                  <a:pt x="493734" y="46676"/>
                  <a:pt x="500063" y="47625"/>
                </a:cubicBezTo>
                <a:cubicBezTo>
                  <a:pt x="509613" y="49057"/>
                  <a:pt x="519270" y="50045"/>
                  <a:pt x="528638" y="52387"/>
                </a:cubicBezTo>
                <a:cubicBezTo>
                  <a:pt x="531813" y="53181"/>
                  <a:pt x="534928" y="54270"/>
                  <a:pt x="538163" y="54768"/>
                </a:cubicBezTo>
                <a:cubicBezTo>
                  <a:pt x="554289" y="57249"/>
                  <a:pt x="567581" y="56636"/>
                  <a:pt x="583407" y="61912"/>
                </a:cubicBezTo>
                <a:lnTo>
                  <a:pt x="604838" y="69056"/>
                </a:lnTo>
                <a:lnTo>
                  <a:pt x="611982" y="71437"/>
                </a:lnTo>
                <a:lnTo>
                  <a:pt x="619125" y="73818"/>
                </a:lnTo>
                <a:cubicBezTo>
                  <a:pt x="621506" y="75406"/>
                  <a:pt x="624245" y="76557"/>
                  <a:pt x="626269" y="78581"/>
                </a:cubicBezTo>
                <a:cubicBezTo>
                  <a:pt x="628293" y="80605"/>
                  <a:pt x="628797" y="83937"/>
                  <a:pt x="631032" y="85725"/>
                </a:cubicBezTo>
                <a:cubicBezTo>
                  <a:pt x="632992" y="87293"/>
                  <a:pt x="635794" y="87312"/>
                  <a:pt x="638175" y="88106"/>
                </a:cubicBezTo>
                <a:cubicBezTo>
                  <a:pt x="639763" y="90487"/>
                  <a:pt x="640784" y="93365"/>
                  <a:pt x="642938" y="95250"/>
                </a:cubicBezTo>
                <a:cubicBezTo>
                  <a:pt x="662957" y="112767"/>
                  <a:pt x="650197" y="100071"/>
                  <a:pt x="664369" y="107156"/>
                </a:cubicBezTo>
                <a:cubicBezTo>
                  <a:pt x="666929" y="108436"/>
                  <a:pt x="669132" y="110331"/>
                  <a:pt x="671513" y="111918"/>
                </a:cubicBezTo>
                <a:cubicBezTo>
                  <a:pt x="683419" y="111124"/>
                  <a:pt x="695372" y="110855"/>
                  <a:pt x="707232" y="109537"/>
                </a:cubicBezTo>
                <a:cubicBezTo>
                  <a:pt x="712189" y="108986"/>
                  <a:pt x="717876" y="105429"/>
                  <a:pt x="721519" y="102393"/>
                </a:cubicBezTo>
                <a:cubicBezTo>
                  <a:pt x="724106" y="100237"/>
                  <a:pt x="725861" y="97118"/>
                  <a:pt x="728663" y="95250"/>
                </a:cubicBezTo>
                <a:cubicBezTo>
                  <a:pt x="730752" y="93858"/>
                  <a:pt x="733562" y="93991"/>
                  <a:pt x="735807" y="92868"/>
                </a:cubicBezTo>
                <a:cubicBezTo>
                  <a:pt x="738366" y="91588"/>
                  <a:pt x="740390" y="89386"/>
                  <a:pt x="742950" y="88106"/>
                </a:cubicBezTo>
                <a:cubicBezTo>
                  <a:pt x="745195" y="86984"/>
                  <a:pt x="747672" y="86385"/>
                  <a:pt x="750094" y="85725"/>
                </a:cubicBezTo>
                <a:cubicBezTo>
                  <a:pt x="779636" y="77668"/>
                  <a:pt x="759844" y="84061"/>
                  <a:pt x="776288" y="78581"/>
                </a:cubicBezTo>
                <a:cubicBezTo>
                  <a:pt x="789782" y="79375"/>
                  <a:pt x="803366" y="79214"/>
                  <a:pt x="816769" y="80962"/>
                </a:cubicBezTo>
                <a:cubicBezTo>
                  <a:pt x="829026" y="82561"/>
                  <a:pt x="835386" y="88611"/>
                  <a:pt x="845344" y="95250"/>
                </a:cubicBezTo>
                <a:lnTo>
                  <a:pt x="852488" y="100012"/>
                </a:lnTo>
                <a:cubicBezTo>
                  <a:pt x="872963" y="113661"/>
                  <a:pt x="847058" y="97298"/>
                  <a:pt x="866775" y="107156"/>
                </a:cubicBezTo>
                <a:cubicBezTo>
                  <a:pt x="869335" y="108436"/>
                  <a:pt x="871304" y="110756"/>
                  <a:pt x="873919" y="111918"/>
                </a:cubicBezTo>
                <a:cubicBezTo>
                  <a:pt x="878507" y="113957"/>
                  <a:pt x="888207" y="116681"/>
                  <a:pt x="888207" y="116681"/>
                </a:cubicBezTo>
                <a:lnTo>
                  <a:pt x="902494" y="126206"/>
                </a:lnTo>
                <a:cubicBezTo>
                  <a:pt x="904875" y="127793"/>
                  <a:pt x="906923" y="130063"/>
                  <a:pt x="909638" y="130968"/>
                </a:cubicBezTo>
                <a:lnTo>
                  <a:pt x="916782" y="133350"/>
                </a:lnTo>
                <a:cubicBezTo>
                  <a:pt x="919163" y="135731"/>
                  <a:pt x="921123" y="138625"/>
                  <a:pt x="923925" y="140493"/>
                </a:cubicBezTo>
                <a:cubicBezTo>
                  <a:pt x="926014" y="141885"/>
                  <a:pt x="928574" y="142598"/>
                  <a:pt x="931069" y="142875"/>
                </a:cubicBezTo>
                <a:cubicBezTo>
                  <a:pt x="942929" y="144193"/>
                  <a:pt x="954882" y="144462"/>
                  <a:pt x="966788" y="145256"/>
                </a:cubicBezTo>
                <a:lnTo>
                  <a:pt x="981075" y="166687"/>
                </a:lnTo>
                <a:cubicBezTo>
                  <a:pt x="982663" y="169068"/>
                  <a:pt x="983457" y="172244"/>
                  <a:pt x="985838" y="173831"/>
                </a:cubicBezTo>
                <a:cubicBezTo>
                  <a:pt x="1006312" y="187479"/>
                  <a:pt x="980408" y="171116"/>
                  <a:pt x="1000125" y="180975"/>
                </a:cubicBezTo>
                <a:cubicBezTo>
                  <a:pt x="1002685" y="182255"/>
                  <a:pt x="1004654" y="184575"/>
                  <a:pt x="1007269" y="185737"/>
                </a:cubicBezTo>
                <a:cubicBezTo>
                  <a:pt x="1007271" y="185738"/>
                  <a:pt x="1025127" y="191690"/>
                  <a:pt x="1028700" y="192881"/>
                </a:cubicBezTo>
                <a:lnTo>
                  <a:pt x="1042988" y="197643"/>
                </a:lnTo>
                <a:cubicBezTo>
                  <a:pt x="1045369" y="198437"/>
                  <a:pt x="1048043" y="198633"/>
                  <a:pt x="1050132" y="200025"/>
                </a:cubicBezTo>
                <a:cubicBezTo>
                  <a:pt x="1059364" y="206179"/>
                  <a:pt x="1054560" y="203882"/>
                  <a:pt x="1064419" y="207168"/>
                </a:cubicBezTo>
                <a:cubicBezTo>
                  <a:pt x="1066800" y="208756"/>
                  <a:pt x="1068948" y="210769"/>
                  <a:pt x="1071563" y="211931"/>
                </a:cubicBezTo>
                <a:cubicBezTo>
                  <a:pt x="1076150" y="213970"/>
                  <a:pt x="1081088" y="215106"/>
                  <a:pt x="1085850" y="216693"/>
                </a:cubicBezTo>
                <a:lnTo>
                  <a:pt x="1092994" y="219075"/>
                </a:lnTo>
                <a:lnTo>
                  <a:pt x="1100138" y="221456"/>
                </a:lnTo>
                <a:lnTo>
                  <a:pt x="1107282" y="223837"/>
                </a:lnTo>
                <a:cubicBezTo>
                  <a:pt x="1111213" y="223400"/>
                  <a:pt x="1128877" y="222953"/>
                  <a:pt x="1135857" y="219075"/>
                </a:cubicBezTo>
                <a:cubicBezTo>
                  <a:pt x="1140860" y="216295"/>
                  <a:pt x="1150144" y="209550"/>
                  <a:pt x="1150144" y="209550"/>
                </a:cubicBezTo>
                <a:cubicBezTo>
                  <a:pt x="1156781" y="199594"/>
                  <a:pt x="1158420" y="195112"/>
                  <a:pt x="1166813" y="188118"/>
                </a:cubicBezTo>
                <a:cubicBezTo>
                  <a:pt x="1169012" y="186286"/>
                  <a:pt x="1171576" y="184943"/>
                  <a:pt x="1173957" y="183356"/>
                </a:cubicBezTo>
                <a:cubicBezTo>
                  <a:pt x="1179618" y="166371"/>
                  <a:pt x="1171591" y="186903"/>
                  <a:pt x="1183482" y="169068"/>
                </a:cubicBezTo>
                <a:cubicBezTo>
                  <a:pt x="1184874" y="166980"/>
                  <a:pt x="1184295" y="163885"/>
                  <a:pt x="1185863" y="161925"/>
                </a:cubicBezTo>
                <a:cubicBezTo>
                  <a:pt x="1189221" y="157728"/>
                  <a:pt x="1195443" y="156350"/>
                  <a:pt x="1200150" y="154781"/>
                </a:cubicBezTo>
                <a:cubicBezTo>
                  <a:pt x="1233488" y="155575"/>
                  <a:pt x="1266881" y="155082"/>
                  <a:pt x="1300163" y="157162"/>
                </a:cubicBezTo>
                <a:cubicBezTo>
                  <a:pt x="1316657" y="158193"/>
                  <a:pt x="1310563" y="161784"/>
                  <a:pt x="1321594" y="166687"/>
                </a:cubicBezTo>
                <a:cubicBezTo>
                  <a:pt x="1326182" y="168726"/>
                  <a:pt x="1331119" y="169862"/>
                  <a:pt x="1335882" y="171450"/>
                </a:cubicBezTo>
                <a:cubicBezTo>
                  <a:pt x="1338263" y="172244"/>
                  <a:pt x="1340937" y="172439"/>
                  <a:pt x="1343025" y="173831"/>
                </a:cubicBezTo>
                <a:cubicBezTo>
                  <a:pt x="1363498" y="187478"/>
                  <a:pt x="1337595" y="171116"/>
                  <a:pt x="1357313" y="180975"/>
                </a:cubicBezTo>
                <a:cubicBezTo>
                  <a:pt x="1375773" y="190205"/>
                  <a:pt x="1353650" y="182135"/>
                  <a:pt x="1371600" y="188118"/>
                </a:cubicBezTo>
                <a:cubicBezTo>
                  <a:pt x="1376363" y="191293"/>
                  <a:pt x="1384078" y="192213"/>
                  <a:pt x="1385888" y="197643"/>
                </a:cubicBezTo>
                <a:cubicBezTo>
                  <a:pt x="1389181" y="207525"/>
                  <a:pt x="1388227" y="209535"/>
                  <a:pt x="1402557" y="214312"/>
                </a:cubicBezTo>
                <a:lnTo>
                  <a:pt x="1416844" y="219075"/>
                </a:lnTo>
                <a:cubicBezTo>
                  <a:pt x="1431651" y="217729"/>
                  <a:pt x="1445227" y="216944"/>
                  <a:pt x="1459707" y="214312"/>
                </a:cubicBezTo>
                <a:cubicBezTo>
                  <a:pt x="1462927" y="213727"/>
                  <a:pt x="1466037" y="212641"/>
                  <a:pt x="1469232" y="211931"/>
                </a:cubicBezTo>
                <a:cubicBezTo>
                  <a:pt x="1480573" y="209411"/>
                  <a:pt x="1488505" y="208681"/>
                  <a:pt x="1500188" y="204787"/>
                </a:cubicBezTo>
                <a:cubicBezTo>
                  <a:pt x="1502569" y="203993"/>
                  <a:pt x="1504856" y="202819"/>
                  <a:pt x="1507332" y="202406"/>
                </a:cubicBezTo>
                <a:cubicBezTo>
                  <a:pt x="1514422" y="201224"/>
                  <a:pt x="1521631" y="200917"/>
                  <a:pt x="1528763" y="200025"/>
                </a:cubicBezTo>
                <a:cubicBezTo>
                  <a:pt x="1536820" y="199018"/>
                  <a:pt x="1549027" y="197340"/>
                  <a:pt x="1557338" y="195262"/>
                </a:cubicBezTo>
                <a:cubicBezTo>
                  <a:pt x="1559773" y="194653"/>
                  <a:pt x="1562060" y="193541"/>
                  <a:pt x="1564482" y="192881"/>
                </a:cubicBezTo>
                <a:cubicBezTo>
                  <a:pt x="1570797" y="191159"/>
                  <a:pt x="1577322" y="190188"/>
                  <a:pt x="1583532" y="188118"/>
                </a:cubicBezTo>
                <a:cubicBezTo>
                  <a:pt x="1585913" y="187324"/>
                  <a:pt x="1588430" y="186859"/>
                  <a:pt x="1590675" y="185737"/>
                </a:cubicBezTo>
                <a:cubicBezTo>
                  <a:pt x="1593235" y="184457"/>
                  <a:pt x="1595204" y="182137"/>
                  <a:pt x="1597819" y="180975"/>
                </a:cubicBezTo>
                <a:cubicBezTo>
                  <a:pt x="1602407" y="178936"/>
                  <a:pt x="1607344" y="177800"/>
                  <a:pt x="1612107" y="176212"/>
                </a:cubicBezTo>
                <a:lnTo>
                  <a:pt x="1619250" y="173831"/>
                </a:lnTo>
                <a:cubicBezTo>
                  <a:pt x="1621631" y="172243"/>
                  <a:pt x="1623834" y="170348"/>
                  <a:pt x="1626394" y="169068"/>
                </a:cubicBezTo>
                <a:cubicBezTo>
                  <a:pt x="1628639" y="167945"/>
                  <a:pt x="1631344" y="167906"/>
                  <a:pt x="1633538" y="166687"/>
                </a:cubicBezTo>
                <a:cubicBezTo>
                  <a:pt x="1638541" y="163907"/>
                  <a:pt x="1643778" y="161209"/>
                  <a:pt x="1647825" y="157162"/>
                </a:cubicBezTo>
                <a:cubicBezTo>
                  <a:pt x="1656993" y="147994"/>
                  <a:pt x="1652167" y="151886"/>
                  <a:pt x="1662113" y="145256"/>
                </a:cubicBezTo>
                <a:lnTo>
                  <a:pt x="1676400" y="123825"/>
                </a:lnTo>
                <a:cubicBezTo>
                  <a:pt x="1677988" y="121444"/>
                  <a:pt x="1678782" y="118269"/>
                  <a:pt x="1681163" y="116681"/>
                </a:cubicBezTo>
                <a:lnTo>
                  <a:pt x="1695450" y="107156"/>
                </a:lnTo>
                <a:cubicBezTo>
                  <a:pt x="1697831" y="105568"/>
                  <a:pt x="1700570" y="104417"/>
                  <a:pt x="1702594" y="102393"/>
                </a:cubicBezTo>
                <a:cubicBezTo>
                  <a:pt x="1711513" y="93475"/>
                  <a:pt x="1706543" y="96315"/>
                  <a:pt x="1716882" y="92868"/>
                </a:cubicBezTo>
                <a:cubicBezTo>
                  <a:pt x="1739293" y="70457"/>
                  <a:pt x="1703359" y="104261"/>
                  <a:pt x="1738313" y="80962"/>
                </a:cubicBezTo>
                <a:cubicBezTo>
                  <a:pt x="1740694" y="79375"/>
                  <a:pt x="1742842" y="77362"/>
                  <a:pt x="1745457" y="76200"/>
                </a:cubicBezTo>
                <a:cubicBezTo>
                  <a:pt x="1750044" y="74161"/>
                  <a:pt x="1754982" y="73025"/>
                  <a:pt x="1759744" y="71437"/>
                </a:cubicBezTo>
                <a:lnTo>
                  <a:pt x="1774032" y="66675"/>
                </a:lnTo>
                <a:cubicBezTo>
                  <a:pt x="1774045" y="66671"/>
                  <a:pt x="1788306" y="61915"/>
                  <a:pt x="1788319" y="61912"/>
                </a:cubicBezTo>
                <a:cubicBezTo>
                  <a:pt x="1792288" y="61118"/>
                  <a:pt x="1796320" y="60596"/>
                  <a:pt x="1800225" y="59531"/>
                </a:cubicBezTo>
                <a:cubicBezTo>
                  <a:pt x="1805068" y="58210"/>
                  <a:pt x="1809561" y="55593"/>
                  <a:pt x="1814513" y="54768"/>
                </a:cubicBezTo>
                <a:cubicBezTo>
                  <a:pt x="1831483" y="51940"/>
                  <a:pt x="1837343" y="50562"/>
                  <a:pt x="1857375" y="50006"/>
                </a:cubicBezTo>
                <a:cubicBezTo>
                  <a:pt x="1876418" y="49477"/>
                  <a:pt x="1895475" y="50006"/>
                  <a:pt x="1914525" y="50006"/>
                </a:cubicBezTo>
              </a:path>
            </a:pathLst>
          </a:custGeom>
          <a:noFill/>
          <a:ln w="38100">
            <a:solidFill>
              <a:schemeClr val="bg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9666"/>
          </a:p>
        </p:txBody>
      </p:sp>
      <p:sp>
        <p:nvSpPr>
          <p:cNvPr id="213" name="Freeform 212"/>
          <p:cNvSpPr/>
          <p:nvPr/>
        </p:nvSpPr>
        <p:spPr>
          <a:xfrm>
            <a:off x="13344552" y="5107587"/>
            <a:ext cx="4639118" cy="528498"/>
          </a:xfrm>
          <a:custGeom>
            <a:avLst/>
            <a:gdLst>
              <a:gd name="connsiteX0" fmla="*/ 0 w 1912143"/>
              <a:gd name="connsiteY0" fmla="*/ 0 h 204788"/>
              <a:gd name="connsiteX1" fmla="*/ 47625 w 1912143"/>
              <a:gd name="connsiteY1" fmla="*/ 2382 h 204788"/>
              <a:gd name="connsiteX2" fmla="*/ 61912 w 1912143"/>
              <a:gd name="connsiteY2" fmla="*/ 9525 h 204788"/>
              <a:gd name="connsiteX3" fmla="*/ 69056 w 1912143"/>
              <a:gd name="connsiteY3" fmla="*/ 11907 h 204788"/>
              <a:gd name="connsiteX4" fmla="*/ 83343 w 1912143"/>
              <a:gd name="connsiteY4" fmla="*/ 21432 h 204788"/>
              <a:gd name="connsiteX5" fmla="*/ 104775 w 1912143"/>
              <a:gd name="connsiteY5" fmla="*/ 33338 h 204788"/>
              <a:gd name="connsiteX6" fmla="*/ 119062 w 1912143"/>
              <a:gd name="connsiteY6" fmla="*/ 40482 h 204788"/>
              <a:gd name="connsiteX7" fmla="*/ 140493 w 1912143"/>
              <a:gd name="connsiteY7" fmla="*/ 50007 h 204788"/>
              <a:gd name="connsiteX8" fmla="*/ 147637 w 1912143"/>
              <a:gd name="connsiteY8" fmla="*/ 52388 h 204788"/>
              <a:gd name="connsiteX9" fmla="*/ 154781 w 1912143"/>
              <a:gd name="connsiteY9" fmla="*/ 54769 h 204788"/>
              <a:gd name="connsiteX10" fmla="*/ 204787 w 1912143"/>
              <a:gd name="connsiteY10" fmla="*/ 47625 h 204788"/>
              <a:gd name="connsiteX11" fmla="*/ 254793 w 1912143"/>
              <a:gd name="connsiteY11" fmla="*/ 30957 h 204788"/>
              <a:gd name="connsiteX12" fmla="*/ 269081 w 1912143"/>
              <a:gd name="connsiteY12" fmla="*/ 26194 h 204788"/>
              <a:gd name="connsiteX13" fmla="*/ 276225 w 1912143"/>
              <a:gd name="connsiteY13" fmla="*/ 23813 h 204788"/>
              <a:gd name="connsiteX14" fmla="*/ 311943 w 1912143"/>
              <a:gd name="connsiteY14" fmla="*/ 19050 h 204788"/>
              <a:gd name="connsiteX15" fmla="*/ 326231 w 1912143"/>
              <a:gd name="connsiteY15" fmla="*/ 16669 h 204788"/>
              <a:gd name="connsiteX16" fmla="*/ 350043 w 1912143"/>
              <a:gd name="connsiteY16" fmla="*/ 14288 h 204788"/>
              <a:gd name="connsiteX17" fmla="*/ 416718 w 1912143"/>
              <a:gd name="connsiteY17" fmla="*/ 16669 h 204788"/>
              <a:gd name="connsiteX18" fmla="*/ 423862 w 1912143"/>
              <a:gd name="connsiteY18" fmla="*/ 19050 h 204788"/>
              <a:gd name="connsiteX19" fmla="*/ 447675 w 1912143"/>
              <a:gd name="connsiteY19" fmla="*/ 23813 h 204788"/>
              <a:gd name="connsiteX20" fmla="*/ 454818 w 1912143"/>
              <a:gd name="connsiteY20" fmla="*/ 26194 h 204788"/>
              <a:gd name="connsiteX21" fmla="*/ 485775 w 1912143"/>
              <a:gd name="connsiteY21" fmla="*/ 30957 h 204788"/>
              <a:gd name="connsiteX22" fmla="*/ 509587 w 1912143"/>
              <a:gd name="connsiteY22" fmla="*/ 35719 h 204788"/>
              <a:gd name="connsiteX23" fmla="*/ 526256 w 1912143"/>
              <a:gd name="connsiteY23" fmla="*/ 40482 h 204788"/>
              <a:gd name="connsiteX24" fmla="*/ 538162 w 1912143"/>
              <a:gd name="connsiteY24" fmla="*/ 42863 h 204788"/>
              <a:gd name="connsiteX25" fmla="*/ 559593 w 1912143"/>
              <a:gd name="connsiteY25" fmla="*/ 47625 h 204788"/>
              <a:gd name="connsiteX26" fmla="*/ 573881 w 1912143"/>
              <a:gd name="connsiteY26" fmla="*/ 50007 h 204788"/>
              <a:gd name="connsiteX27" fmla="*/ 581025 w 1912143"/>
              <a:gd name="connsiteY27" fmla="*/ 52388 h 204788"/>
              <a:gd name="connsiteX28" fmla="*/ 602456 w 1912143"/>
              <a:gd name="connsiteY28" fmla="*/ 57150 h 204788"/>
              <a:gd name="connsiteX29" fmla="*/ 616743 w 1912143"/>
              <a:gd name="connsiteY29" fmla="*/ 61913 h 204788"/>
              <a:gd name="connsiteX30" fmla="*/ 631031 w 1912143"/>
              <a:gd name="connsiteY30" fmla="*/ 71438 h 204788"/>
              <a:gd name="connsiteX31" fmla="*/ 642937 w 1912143"/>
              <a:gd name="connsiteY31" fmla="*/ 80963 h 204788"/>
              <a:gd name="connsiteX32" fmla="*/ 647700 w 1912143"/>
              <a:gd name="connsiteY32" fmla="*/ 88107 h 204788"/>
              <a:gd name="connsiteX33" fmla="*/ 661987 w 1912143"/>
              <a:gd name="connsiteY33" fmla="*/ 92869 h 204788"/>
              <a:gd name="connsiteX34" fmla="*/ 669131 w 1912143"/>
              <a:gd name="connsiteY34" fmla="*/ 97632 h 204788"/>
              <a:gd name="connsiteX35" fmla="*/ 709612 w 1912143"/>
              <a:gd name="connsiteY35" fmla="*/ 95250 h 204788"/>
              <a:gd name="connsiteX36" fmla="*/ 716756 w 1912143"/>
              <a:gd name="connsiteY36" fmla="*/ 92869 h 204788"/>
              <a:gd name="connsiteX37" fmla="*/ 750093 w 1912143"/>
              <a:gd name="connsiteY37" fmla="*/ 85725 h 204788"/>
              <a:gd name="connsiteX38" fmla="*/ 835818 w 1912143"/>
              <a:gd name="connsiteY38" fmla="*/ 88107 h 204788"/>
              <a:gd name="connsiteX39" fmla="*/ 847725 w 1912143"/>
              <a:gd name="connsiteY39" fmla="*/ 90488 h 204788"/>
              <a:gd name="connsiteX40" fmla="*/ 862012 w 1912143"/>
              <a:gd name="connsiteY40" fmla="*/ 95250 h 204788"/>
              <a:gd name="connsiteX41" fmla="*/ 876300 w 1912143"/>
              <a:gd name="connsiteY41" fmla="*/ 104775 h 204788"/>
              <a:gd name="connsiteX42" fmla="*/ 883443 w 1912143"/>
              <a:gd name="connsiteY42" fmla="*/ 109538 h 204788"/>
              <a:gd name="connsiteX43" fmla="*/ 890587 w 1912143"/>
              <a:gd name="connsiteY43" fmla="*/ 111919 h 204788"/>
              <a:gd name="connsiteX44" fmla="*/ 897731 w 1912143"/>
              <a:gd name="connsiteY44" fmla="*/ 116682 h 204788"/>
              <a:gd name="connsiteX45" fmla="*/ 909637 w 1912143"/>
              <a:gd name="connsiteY45" fmla="*/ 119063 h 204788"/>
              <a:gd name="connsiteX46" fmla="*/ 923925 w 1912143"/>
              <a:gd name="connsiteY46" fmla="*/ 123825 h 204788"/>
              <a:gd name="connsiteX47" fmla="*/ 938212 w 1912143"/>
              <a:gd name="connsiteY47" fmla="*/ 128588 h 204788"/>
              <a:gd name="connsiteX48" fmla="*/ 945356 w 1912143"/>
              <a:gd name="connsiteY48" fmla="*/ 130969 h 204788"/>
              <a:gd name="connsiteX49" fmla="*/ 966787 w 1912143"/>
              <a:gd name="connsiteY49" fmla="*/ 142875 h 204788"/>
              <a:gd name="connsiteX50" fmla="*/ 973931 w 1912143"/>
              <a:gd name="connsiteY50" fmla="*/ 147638 h 204788"/>
              <a:gd name="connsiteX51" fmla="*/ 978693 w 1912143"/>
              <a:gd name="connsiteY51" fmla="*/ 154782 h 204788"/>
              <a:gd name="connsiteX52" fmla="*/ 985837 w 1912143"/>
              <a:gd name="connsiteY52" fmla="*/ 157163 h 204788"/>
              <a:gd name="connsiteX53" fmla="*/ 992981 w 1912143"/>
              <a:gd name="connsiteY53" fmla="*/ 161925 h 204788"/>
              <a:gd name="connsiteX54" fmla="*/ 1000125 w 1912143"/>
              <a:gd name="connsiteY54" fmla="*/ 169069 h 204788"/>
              <a:gd name="connsiteX55" fmla="*/ 1014412 w 1912143"/>
              <a:gd name="connsiteY55" fmla="*/ 173832 h 204788"/>
              <a:gd name="connsiteX56" fmla="*/ 1019175 w 1912143"/>
              <a:gd name="connsiteY56" fmla="*/ 180975 h 204788"/>
              <a:gd name="connsiteX57" fmla="*/ 1026318 w 1912143"/>
              <a:gd name="connsiteY57" fmla="*/ 183357 h 204788"/>
              <a:gd name="connsiteX58" fmla="*/ 1033462 w 1912143"/>
              <a:gd name="connsiteY58" fmla="*/ 188119 h 204788"/>
              <a:gd name="connsiteX59" fmla="*/ 1050131 w 1912143"/>
              <a:gd name="connsiteY59" fmla="*/ 192882 h 204788"/>
              <a:gd name="connsiteX60" fmla="*/ 1059656 w 1912143"/>
              <a:gd name="connsiteY60" fmla="*/ 197644 h 204788"/>
              <a:gd name="connsiteX61" fmla="*/ 1073943 w 1912143"/>
              <a:gd name="connsiteY61" fmla="*/ 202407 h 204788"/>
              <a:gd name="connsiteX62" fmla="*/ 1081087 w 1912143"/>
              <a:gd name="connsiteY62" fmla="*/ 204788 h 204788"/>
              <a:gd name="connsiteX63" fmla="*/ 1150143 w 1912143"/>
              <a:gd name="connsiteY63" fmla="*/ 202407 h 204788"/>
              <a:gd name="connsiteX64" fmla="*/ 1166812 w 1912143"/>
              <a:gd name="connsiteY64" fmla="*/ 197644 h 204788"/>
              <a:gd name="connsiteX65" fmla="*/ 1173956 w 1912143"/>
              <a:gd name="connsiteY65" fmla="*/ 192882 h 204788"/>
              <a:gd name="connsiteX66" fmla="*/ 1181100 w 1912143"/>
              <a:gd name="connsiteY66" fmla="*/ 190500 h 204788"/>
              <a:gd name="connsiteX67" fmla="*/ 1195387 w 1912143"/>
              <a:gd name="connsiteY67" fmla="*/ 183357 h 204788"/>
              <a:gd name="connsiteX68" fmla="*/ 1202531 w 1912143"/>
              <a:gd name="connsiteY68" fmla="*/ 176213 h 204788"/>
              <a:gd name="connsiteX69" fmla="*/ 1209675 w 1912143"/>
              <a:gd name="connsiteY69" fmla="*/ 171450 h 204788"/>
              <a:gd name="connsiteX70" fmla="*/ 1221581 w 1912143"/>
              <a:gd name="connsiteY70" fmla="*/ 159544 h 204788"/>
              <a:gd name="connsiteX71" fmla="*/ 1226343 w 1912143"/>
              <a:gd name="connsiteY71" fmla="*/ 152400 h 204788"/>
              <a:gd name="connsiteX72" fmla="*/ 1233487 w 1912143"/>
              <a:gd name="connsiteY72" fmla="*/ 150019 h 204788"/>
              <a:gd name="connsiteX73" fmla="*/ 1240631 w 1912143"/>
              <a:gd name="connsiteY73" fmla="*/ 145257 h 204788"/>
              <a:gd name="connsiteX74" fmla="*/ 1278731 w 1912143"/>
              <a:gd name="connsiteY74" fmla="*/ 147638 h 204788"/>
              <a:gd name="connsiteX75" fmla="*/ 1288256 w 1912143"/>
              <a:gd name="connsiteY75" fmla="*/ 150019 h 204788"/>
              <a:gd name="connsiteX76" fmla="*/ 1314450 w 1912143"/>
              <a:gd name="connsiteY76" fmla="*/ 157163 h 204788"/>
              <a:gd name="connsiteX77" fmla="*/ 1335881 w 1912143"/>
              <a:gd name="connsiteY77" fmla="*/ 164307 h 204788"/>
              <a:gd name="connsiteX78" fmla="*/ 1343025 w 1912143"/>
              <a:gd name="connsiteY78" fmla="*/ 166688 h 204788"/>
              <a:gd name="connsiteX79" fmla="*/ 1350168 w 1912143"/>
              <a:gd name="connsiteY79" fmla="*/ 171450 h 204788"/>
              <a:gd name="connsiteX80" fmla="*/ 1364456 w 1912143"/>
              <a:gd name="connsiteY80" fmla="*/ 176213 h 204788"/>
              <a:gd name="connsiteX81" fmla="*/ 1381125 w 1912143"/>
              <a:gd name="connsiteY81" fmla="*/ 183357 h 204788"/>
              <a:gd name="connsiteX82" fmla="*/ 1402556 w 1912143"/>
              <a:gd name="connsiteY82" fmla="*/ 192882 h 204788"/>
              <a:gd name="connsiteX83" fmla="*/ 1409700 w 1912143"/>
              <a:gd name="connsiteY83" fmla="*/ 195263 h 204788"/>
              <a:gd name="connsiteX84" fmla="*/ 1516856 w 1912143"/>
              <a:gd name="connsiteY84" fmla="*/ 192882 h 204788"/>
              <a:gd name="connsiteX85" fmla="*/ 1533525 w 1912143"/>
              <a:gd name="connsiteY85" fmla="*/ 188119 h 204788"/>
              <a:gd name="connsiteX86" fmla="*/ 1557337 w 1912143"/>
              <a:gd name="connsiteY86" fmla="*/ 183357 h 204788"/>
              <a:gd name="connsiteX87" fmla="*/ 1569243 w 1912143"/>
              <a:gd name="connsiteY87" fmla="*/ 180975 h 204788"/>
              <a:gd name="connsiteX88" fmla="*/ 1585912 w 1912143"/>
              <a:gd name="connsiteY88" fmla="*/ 176213 h 204788"/>
              <a:gd name="connsiteX89" fmla="*/ 1597818 w 1912143"/>
              <a:gd name="connsiteY89" fmla="*/ 173832 h 204788"/>
              <a:gd name="connsiteX90" fmla="*/ 1614487 w 1912143"/>
              <a:gd name="connsiteY90" fmla="*/ 169069 h 204788"/>
              <a:gd name="connsiteX91" fmla="*/ 1631156 w 1912143"/>
              <a:gd name="connsiteY91" fmla="*/ 164307 h 204788"/>
              <a:gd name="connsiteX92" fmla="*/ 1652587 w 1912143"/>
              <a:gd name="connsiteY92" fmla="*/ 150019 h 204788"/>
              <a:gd name="connsiteX93" fmla="*/ 1659731 w 1912143"/>
              <a:gd name="connsiteY93" fmla="*/ 145257 h 204788"/>
              <a:gd name="connsiteX94" fmla="*/ 1671637 w 1912143"/>
              <a:gd name="connsiteY94" fmla="*/ 130969 h 204788"/>
              <a:gd name="connsiteX95" fmla="*/ 1678781 w 1912143"/>
              <a:gd name="connsiteY95" fmla="*/ 126207 h 204788"/>
              <a:gd name="connsiteX96" fmla="*/ 1688306 w 1912143"/>
              <a:gd name="connsiteY96" fmla="*/ 116682 h 204788"/>
              <a:gd name="connsiteX97" fmla="*/ 1693068 w 1912143"/>
              <a:gd name="connsiteY97" fmla="*/ 109538 h 204788"/>
              <a:gd name="connsiteX98" fmla="*/ 1700212 w 1912143"/>
              <a:gd name="connsiteY98" fmla="*/ 104775 h 204788"/>
              <a:gd name="connsiteX99" fmla="*/ 1707356 w 1912143"/>
              <a:gd name="connsiteY99" fmla="*/ 97632 h 204788"/>
              <a:gd name="connsiteX100" fmla="*/ 1714500 w 1912143"/>
              <a:gd name="connsiteY100" fmla="*/ 92869 h 204788"/>
              <a:gd name="connsiteX101" fmla="*/ 1721643 w 1912143"/>
              <a:gd name="connsiteY101" fmla="*/ 85725 h 204788"/>
              <a:gd name="connsiteX102" fmla="*/ 1743075 w 1912143"/>
              <a:gd name="connsiteY102" fmla="*/ 73819 h 204788"/>
              <a:gd name="connsiteX103" fmla="*/ 1750218 w 1912143"/>
              <a:gd name="connsiteY103" fmla="*/ 69057 h 204788"/>
              <a:gd name="connsiteX104" fmla="*/ 1764506 w 1912143"/>
              <a:gd name="connsiteY104" fmla="*/ 64294 h 204788"/>
              <a:gd name="connsiteX105" fmla="*/ 1778793 w 1912143"/>
              <a:gd name="connsiteY105" fmla="*/ 59532 h 204788"/>
              <a:gd name="connsiteX106" fmla="*/ 1793081 w 1912143"/>
              <a:gd name="connsiteY106" fmla="*/ 54769 h 204788"/>
              <a:gd name="connsiteX107" fmla="*/ 1809750 w 1912143"/>
              <a:gd name="connsiteY107" fmla="*/ 50007 h 204788"/>
              <a:gd name="connsiteX108" fmla="*/ 1838325 w 1912143"/>
              <a:gd name="connsiteY108" fmla="*/ 45244 h 204788"/>
              <a:gd name="connsiteX109" fmla="*/ 1850231 w 1912143"/>
              <a:gd name="connsiteY109" fmla="*/ 42863 h 204788"/>
              <a:gd name="connsiteX110" fmla="*/ 1912143 w 1912143"/>
              <a:gd name="connsiteY110" fmla="*/ 42863 h 20478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  <a:cxn ang="0">
                <a:pos x="connsiteX31" y="connsiteY31"/>
              </a:cxn>
              <a:cxn ang="0">
                <a:pos x="connsiteX32" y="connsiteY32"/>
              </a:cxn>
              <a:cxn ang="0">
                <a:pos x="connsiteX33" y="connsiteY33"/>
              </a:cxn>
              <a:cxn ang="0">
                <a:pos x="connsiteX34" y="connsiteY34"/>
              </a:cxn>
              <a:cxn ang="0">
                <a:pos x="connsiteX35" y="connsiteY35"/>
              </a:cxn>
              <a:cxn ang="0">
                <a:pos x="connsiteX36" y="connsiteY36"/>
              </a:cxn>
              <a:cxn ang="0">
                <a:pos x="connsiteX37" y="connsiteY37"/>
              </a:cxn>
              <a:cxn ang="0">
                <a:pos x="connsiteX38" y="connsiteY38"/>
              </a:cxn>
              <a:cxn ang="0">
                <a:pos x="connsiteX39" y="connsiteY39"/>
              </a:cxn>
              <a:cxn ang="0">
                <a:pos x="connsiteX40" y="connsiteY40"/>
              </a:cxn>
              <a:cxn ang="0">
                <a:pos x="connsiteX41" y="connsiteY41"/>
              </a:cxn>
              <a:cxn ang="0">
                <a:pos x="connsiteX42" y="connsiteY42"/>
              </a:cxn>
              <a:cxn ang="0">
                <a:pos x="connsiteX43" y="connsiteY43"/>
              </a:cxn>
              <a:cxn ang="0">
                <a:pos x="connsiteX44" y="connsiteY44"/>
              </a:cxn>
              <a:cxn ang="0">
                <a:pos x="connsiteX45" y="connsiteY45"/>
              </a:cxn>
              <a:cxn ang="0">
                <a:pos x="connsiteX46" y="connsiteY46"/>
              </a:cxn>
              <a:cxn ang="0">
                <a:pos x="connsiteX47" y="connsiteY47"/>
              </a:cxn>
              <a:cxn ang="0">
                <a:pos x="connsiteX48" y="connsiteY48"/>
              </a:cxn>
              <a:cxn ang="0">
                <a:pos x="connsiteX49" y="connsiteY49"/>
              </a:cxn>
              <a:cxn ang="0">
                <a:pos x="connsiteX50" y="connsiteY50"/>
              </a:cxn>
              <a:cxn ang="0">
                <a:pos x="connsiteX51" y="connsiteY51"/>
              </a:cxn>
              <a:cxn ang="0">
                <a:pos x="connsiteX52" y="connsiteY52"/>
              </a:cxn>
              <a:cxn ang="0">
                <a:pos x="connsiteX53" y="connsiteY53"/>
              </a:cxn>
              <a:cxn ang="0">
                <a:pos x="connsiteX54" y="connsiteY54"/>
              </a:cxn>
              <a:cxn ang="0">
                <a:pos x="connsiteX55" y="connsiteY55"/>
              </a:cxn>
              <a:cxn ang="0">
                <a:pos x="connsiteX56" y="connsiteY56"/>
              </a:cxn>
              <a:cxn ang="0">
                <a:pos x="connsiteX57" y="connsiteY57"/>
              </a:cxn>
              <a:cxn ang="0">
                <a:pos x="connsiteX58" y="connsiteY58"/>
              </a:cxn>
              <a:cxn ang="0">
                <a:pos x="connsiteX59" y="connsiteY59"/>
              </a:cxn>
              <a:cxn ang="0">
                <a:pos x="connsiteX60" y="connsiteY60"/>
              </a:cxn>
              <a:cxn ang="0">
                <a:pos x="connsiteX61" y="connsiteY61"/>
              </a:cxn>
              <a:cxn ang="0">
                <a:pos x="connsiteX62" y="connsiteY62"/>
              </a:cxn>
              <a:cxn ang="0">
                <a:pos x="connsiteX63" y="connsiteY63"/>
              </a:cxn>
              <a:cxn ang="0">
                <a:pos x="connsiteX64" y="connsiteY64"/>
              </a:cxn>
              <a:cxn ang="0">
                <a:pos x="connsiteX65" y="connsiteY65"/>
              </a:cxn>
              <a:cxn ang="0">
                <a:pos x="connsiteX66" y="connsiteY66"/>
              </a:cxn>
              <a:cxn ang="0">
                <a:pos x="connsiteX67" y="connsiteY67"/>
              </a:cxn>
              <a:cxn ang="0">
                <a:pos x="connsiteX68" y="connsiteY68"/>
              </a:cxn>
              <a:cxn ang="0">
                <a:pos x="connsiteX69" y="connsiteY69"/>
              </a:cxn>
              <a:cxn ang="0">
                <a:pos x="connsiteX70" y="connsiteY70"/>
              </a:cxn>
              <a:cxn ang="0">
                <a:pos x="connsiteX71" y="connsiteY71"/>
              </a:cxn>
              <a:cxn ang="0">
                <a:pos x="connsiteX72" y="connsiteY72"/>
              </a:cxn>
              <a:cxn ang="0">
                <a:pos x="connsiteX73" y="connsiteY73"/>
              </a:cxn>
              <a:cxn ang="0">
                <a:pos x="connsiteX74" y="connsiteY74"/>
              </a:cxn>
              <a:cxn ang="0">
                <a:pos x="connsiteX75" y="connsiteY75"/>
              </a:cxn>
              <a:cxn ang="0">
                <a:pos x="connsiteX76" y="connsiteY76"/>
              </a:cxn>
              <a:cxn ang="0">
                <a:pos x="connsiteX77" y="connsiteY77"/>
              </a:cxn>
              <a:cxn ang="0">
                <a:pos x="connsiteX78" y="connsiteY78"/>
              </a:cxn>
              <a:cxn ang="0">
                <a:pos x="connsiteX79" y="connsiteY79"/>
              </a:cxn>
              <a:cxn ang="0">
                <a:pos x="connsiteX80" y="connsiteY80"/>
              </a:cxn>
              <a:cxn ang="0">
                <a:pos x="connsiteX81" y="connsiteY81"/>
              </a:cxn>
              <a:cxn ang="0">
                <a:pos x="connsiteX82" y="connsiteY82"/>
              </a:cxn>
              <a:cxn ang="0">
                <a:pos x="connsiteX83" y="connsiteY83"/>
              </a:cxn>
              <a:cxn ang="0">
                <a:pos x="connsiteX84" y="connsiteY84"/>
              </a:cxn>
              <a:cxn ang="0">
                <a:pos x="connsiteX85" y="connsiteY85"/>
              </a:cxn>
              <a:cxn ang="0">
                <a:pos x="connsiteX86" y="connsiteY86"/>
              </a:cxn>
              <a:cxn ang="0">
                <a:pos x="connsiteX87" y="connsiteY87"/>
              </a:cxn>
              <a:cxn ang="0">
                <a:pos x="connsiteX88" y="connsiteY88"/>
              </a:cxn>
              <a:cxn ang="0">
                <a:pos x="connsiteX89" y="connsiteY89"/>
              </a:cxn>
              <a:cxn ang="0">
                <a:pos x="connsiteX90" y="connsiteY90"/>
              </a:cxn>
              <a:cxn ang="0">
                <a:pos x="connsiteX91" y="connsiteY91"/>
              </a:cxn>
              <a:cxn ang="0">
                <a:pos x="connsiteX92" y="connsiteY92"/>
              </a:cxn>
              <a:cxn ang="0">
                <a:pos x="connsiteX93" y="connsiteY93"/>
              </a:cxn>
              <a:cxn ang="0">
                <a:pos x="connsiteX94" y="connsiteY94"/>
              </a:cxn>
              <a:cxn ang="0">
                <a:pos x="connsiteX95" y="connsiteY95"/>
              </a:cxn>
              <a:cxn ang="0">
                <a:pos x="connsiteX96" y="connsiteY96"/>
              </a:cxn>
              <a:cxn ang="0">
                <a:pos x="connsiteX97" y="connsiteY97"/>
              </a:cxn>
              <a:cxn ang="0">
                <a:pos x="connsiteX98" y="connsiteY98"/>
              </a:cxn>
              <a:cxn ang="0">
                <a:pos x="connsiteX99" y="connsiteY99"/>
              </a:cxn>
              <a:cxn ang="0">
                <a:pos x="connsiteX100" y="connsiteY100"/>
              </a:cxn>
              <a:cxn ang="0">
                <a:pos x="connsiteX101" y="connsiteY101"/>
              </a:cxn>
              <a:cxn ang="0">
                <a:pos x="connsiteX102" y="connsiteY102"/>
              </a:cxn>
              <a:cxn ang="0">
                <a:pos x="connsiteX103" y="connsiteY103"/>
              </a:cxn>
              <a:cxn ang="0">
                <a:pos x="connsiteX104" y="connsiteY104"/>
              </a:cxn>
              <a:cxn ang="0">
                <a:pos x="connsiteX105" y="connsiteY105"/>
              </a:cxn>
              <a:cxn ang="0">
                <a:pos x="connsiteX106" y="connsiteY106"/>
              </a:cxn>
              <a:cxn ang="0">
                <a:pos x="connsiteX107" y="connsiteY107"/>
              </a:cxn>
              <a:cxn ang="0">
                <a:pos x="connsiteX108" y="connsiteY108"/>
              </a:cxn>
              <a:cxn ang="0">
                <a:pos x="connsiteX109" y="connsiteY109"/>
              </a:cxn>
              <a:cxn ang="0">
                <a:pos x="connsiteX110" y="connsiteY110"/>
              </a:cxn>
            </a:cxnLst>
            <a:rect l="l" t="t" r="r" b="b"/>
            <a:pathLst>
              <a:path w="1912143" h="204788">
                <a:moveTo>
                  <a:pt x="0" y="0"/>
                </a:moveTo>
                <a:cubicBezTo>
                  <a:pt x="15875" y="794"/>
                  <a:pt x="31790" y="1005"/>
                  <a:pt x="47625" y="2382"/>
                </a:cubicBezTo>
                <a:cubicBezTo>
                  <a:pt x="54868" y="3012"/>
                  <a:pt x="55661" y="6400"/>
                  <a:pt x="61912" y="9525"/>
                </a:cubicBezTo>
                <a:cubicBezTo>
                  <a:pt x="64157" y="10648"/>
                  <a:pt x="66862" y="10688"/>
                  <a:pt x="69056" y="11907"/>
                </a:cubicBezTo>
                <a:cubicBezTo>
                  <a:pt x="74059" y="14687"/>
                  <a:pt x="77913" y="19622"/>
                  <a:pt x="83343" y="21432"/>
                </a:cubicBezTo>
                <a:cubicBezTo>
                  <a:pt x="95917" y="25623"/>
                  <a:pt x="88399" y="22421"/>
                  <a:pt x="104775" y="33338"/>
                </a:cubicBezTo>
                <a:cubicBezTo>
                  <a:pt x="125241" y="46982"/>
                  <a:pt x="99348" y="30625"/>
                  <a:pt x="119062" y="40482"/>
                </a:cubicBezTo>
                <a:cubicBezTo>
                  <a:pt x="141697" y="51800"/>
                  <a:pt x="103645" y="37724"/>
                  <a:pt x="140493" y="50007"/>
                </a:cubicBezTo>
                <a:lnTo>
                  <a:pt x="147637" y="52388"/>
                </a:lnTo>
                <a:lnTo>
                  <a:pt x="154781" y="54769"/>
                </a:lnTo>
                <a:cubicBezTo>
                  <a:pt x="169737" y="53409"/>
                  <a:pt x="190196" y="52488"/>
                  <a:pt x="204787" y="47625"/>
                </a:cubicBezTo>
                <a:lnTo>
                  <a:pt x="254793" y="30957"/>
                </a:lnTo>
                <a:lnTo>
                  <a:pt x="269081" y="26194"/>
                </a:lnTo>
                <a:cubicBezTo>
                  <a:pt x="271462" y="25400"/>
                  <a:pt x="273749" y="24226"/>
                  <a:pt x="276225" y="23813"/>
                </a:cubicBezTo>
                <a:cubicBezTo>
                  <a:pt x="309344" y="18294"/>
                  <a:pt x="268233" y="24879"/>
                  <a:pt x="311943" y="19050"/>
                </a:cubicBezTo>
                <a:cubicBezTo>
                  <a:pt x="316729" y="18412"/>
                  <a:pt x="321440" y="17268"/>
                  <a:pt x="326231" y="16669"/>
                </a:cubicBezTo>
                <a:cubicBezTo>
                  <a:pt x="334146" y="15680"/>
                  <a:pt x="342106" y="15082"/>
                  <a:pt x="350043" y="14288"/>
                </a:cubicBezTo>
                <a:cubicBezTo>
                  <a:pt x="372268" y="15082"/>
                  <a:pt x="394525" y="15237"/>
                  <a:pt x="416718" y="16669"/>
                </a:cubicBezTo>
                <a:cubicBezTo>
                  <a:pt x="419223" y="16831"/>
                  <a:pt x="421416" y="18486"/>
                  <a:pt x="423862" y="19050"/>
                </a:cubicBezTo>
                <a:cubicBezTo>
                  <a:pt x="431750" y="20870"/>
                  <a:pt x="439996" y="21253"/>
                  <a:pt x="447675" y="23813"/>
                </a:cubicBezTo>
                <a:cubicBezTo>
                  <a:pt x="450056" y="24607"/>
                  <a:pt x="452368" y="25650"/>
                  <a:pt x="454818" y="26194"/>
                </a:cubicBezTo>
                <a:cubicBezTo>
                  <a:pt x="464104" y="28257"/>
                  <a:pt x="476577" y="29334"/>
                  <a:pt x="485775" y="30957"/>
                </a:cubicBezTo>
                <a:cubicBezTo>
                  <a:pt x="493746" y="32364"/>
                  <a:pt x="501908" y="33160"/>
                  <a:pt x="509587" y="35719"/>
                </a:cubicBezTo>
                <a:cubicBezTo>
                  <a:pt x="517537" y="38369"/>
                  <a:pt x="517294" y="38490"/>
                  <a:pt x="526256" y="40482"/>
                </a:cubicBezTo>
                <a:cubicBezTo>
                  <a:pt x="530207" y="41360"/>
                  <a:pt x="534211" y="41985"/>
                  <a:pt x="538162" y="42863"/>
                </a:cubicBezTo>
                <a:cubicBezTo>
                  <a:pt x="555373" y="46687"/>
                  <a:pt x="539828" y="44031"/>
                  <a:pt x="559593" y="47625"/>
                </a:cubicBezTo>
                <a:cubicBezTo>
                  <a:pt x="564344" y="48489"/>
                  <a:pt x="569168" y="48960"/>
                  <a:pt x="573881" y="50007"/>
                </a:cubicBezTo>
                <a:cubicBezTo>
                  <a:pt x="576331" y="50552"/>
                  <a:pt x="578590" y="51779"/>
                  <a:pt x="581025" y="52388"/>
                </a:cubicBezTo>
                <a:cubicBezTo>
                  <a:pt x="594604" y="55783"/>
                  <a:pt x="590246" y="53487"/>
                  <a:pt x="602456" y="57150"/>
                </a:cubicBezTo>
                <a:cubicBezTo>
                  <a:pt x="607264" y="58593"/>
                  <a:pt x="612566" y="59128"/>
                  <a:pt x="616743" y="61913"/>
                </a:cubicBezTo>
                <a:lnTo>
                  <a:pt x="631031" y="71438"/>
                </a:lnTo>
                <a:cubicBezTo>
                  <a:pt x="644676" y="91909"/>
                  <a:pt x="626508" y="67820"/>
                  <a:pt x="642937" y="80963"/>
                </a:cubicBezTo>
                <a:cubicBezTo>
                  <a:pt x="645172" y="82751"/>
                  <a:pt x="645273" y="86590"/>
                  <a:pt x="647700" y="88107"/>
                </a:cubicBezTo>
                <a:cubicBezTo>
                  <a:pt x="651957" y="90768"/>
                  <a:pt x="661987" y="92869"/>
                  <a:pt x="661987" y="92869"/>
                </a:cubicBezTo>
                <a:cubicBezTo>
                  <a:pt x="664368" y="94457"/>
                  <a:pt x="666273" y="97489"/>
                  <a:pt x="669131" y="97632"/>
                </a:cubicBezTo>
                <a:cubicBezTo>
                  <a:pt x="682631" y="98307"/>
                  <a:pt x="696162" y="96595"/>
                  <a:pt x="709612" y="95250"/>
                </a:cubicBezTo>
                <a:cubicBezTo>
                  <a:pt x="712110" y="95000"/>
                  <a:pt x="714334" y="93529"/>
                  <a:pt x="716756" y="92869"/>
                </a:cubicBezTo>
                <a:cubicBezTo>
                  <a:pt x="735401" y="87785"/>
                  <a:pt x="733104" y="88558"/>
                  <a:pt x="750093" y="85725"/>
                </a:cubicBezTo>
                <a:cubicBezTo>
                  <a:pt x="778668" y="86519"/>
                  <a:pt x="807266" y="86714"/>
                  <a:pt x="835818" y="88107"/>
                </a:cubicBezTo>
                <a:cubicBezTo>
                  <a:pt x="839861" y="88304"/>
                  <a:pt x="843820" y="89423"/>
                  <a:pt x="847725" y="90488"/>
                </a:cubicBezTo>
                <a:cubicBezTo>
                  <a:pt x="852568" y="91809"/>
                  <a:pt x="862012" y="95250"/>
                  <a:pt x="862012" y="95250"/>
                </a:cubicBezTo>
                <a:lnTo>
                  <a:pt x="876300" y="104775"/>
                </a:lnTo>
                <a:cubicBezTo>
                  <a:pt x="878681" y="106362"/>
                  <a:pt x="880728" y="108633"/>
                  <a:pt x="883443" y="109538"/>
                </a:cubicBezTo>
                <a:lnTo>
                  <a:pt x="890587" y="111919"/>
                </a:lnTo>
                <a:cubicBezTo>
                  <a:pt x="892968" y="113507"/>
                  <a:pt x="895051" y="115677"/>
                  <a:pt x="897731" y="116682"/>
                </a:cubicBezTo>
                <a:cubicBezTo>
                  <a:pt x="901521" y="118103"/>
                  <a:pt x="905732" y="117998"/>
                  <a:pt x="909637" y="119063"/>
                </a:cubicBezTo>
                <a:cubicBezTo>
                  <a:pt x="914480" y="120384"/>
                  <a:pt x="919162" y="122237"/>
                  <a:pt x="923925" y="123825"/>
                </a:cubicBezTo>
                <a:lnTo>
                  <a:pt x="938212" y="128588"/>
                </a:lnTo>
                <a:lnTo>
                  <a:pt x="945356" y="130969"/>
                </a:lnTo>
                <a:cubicBezTo>
                  <a:pt x="961732" y="141886"/>
                  <a:pt x="954213" y="138684"/>
                  <a:pt x="966787" y="142875"/>
                </a:cubicBezTo>
                <a:cubicBezTo>
                  <a:pt x="969168" y="144463"/>
                  <a:pt x="971907" y="145614"/>
                  <a:pt x="973931" y="147638"/>
                </a:cubicBezTo>
                <a:cubicBezTo>
                  <a:pt x="975955" y="149662"/>
                  <a:pt x="976458" y="152994"/>
                  <a:pt x="978693" y="154782"/>
                </a:cubicBezTo>
                <a:cubicBezTo>
                  <a:pt x="980653" y="156350"/>
                  <a:pt x="983592" y="156041"/>
                  <a:pt x="985837" y="157163"/>
                </a:cubicBezTo>
                <a:cubicBezTo>
                  <a:pt x="988397" y="158443"/>
                  <a:pt x="990782" y="160093"/>
                  <a:pt x="992981" y="161925"/>
                </a:cubicBezTo>
                <a:cubicBezTo>
                  <a:pt x="995568" y="164081"/>
                  <a:pt x="997181" y="167433"/>
                  <a:pt x="1000125" y="169069"/>
                </a:cubicBezTo>
                <a:cubicBezTo>
                  <a:pt x="1004513" y="171507"/>
                  <a:pt x="1014412" y="173832"/>
                  <a:pt x="1014412" y="173832"/>
                </a:cubicBezTo>
                <a:cubicBezTo>
                  <a:pt x="1016000" y="176213"/>
                  <a:pt x="1016940" y="179187"/>
                  <a:pt x="1019175" y="180975"/>
                </a:cubicBezTo>
                <a:cubicBezTo>
                  <a:pt x="1021135" y="182543"/>
                  <a:pt x="1024073" y="182234"/>
                  <a:pt x="1026318" y="183357"/>
                </a:cubicBezTo>
                <a:cubicBezTo>
                  <a:pt x="1028878" y="184637"/>
                  <a:pt x="1030902" y="186839"/>
                  <a:pt x="1033462" y="188119"/>
                </a:cubicBezTo>
                <a:cubicBezTo>
                  <a:pt x="1039213" y="190994"/>
                  <a:pt x="1044036" y="190596"/>
                  <a:pt x="1050131" y="192882"/>
                </a:cubicBezTo>
                <a:cubicBezTo>
                  <a:pt x="1053455" y="194128"/>
                  <a:pt x="1056360" y="196326"/>
                  <a:pt x="1059656" y="197644"/>
                </a:cubicBezTo>
                <a:cubicBezTo>
                  <a:pt x="1064317" y="199508"/>
                  <a:pt x="1069181" y="200819"/>
                  <a:pt x="1073943" y="202407"/>
                </a:cubicBezTo>
                <a:lnTo>
                  <a:pt x="1081087" y="204788"/>
                </a:lnTo>
                <a:cubicBezTo>
                  <a:pt x="1104106" y="203994"/>
                  <a:pt x="1127153" y="203800"/>
                  <a:pt x="1150143" y="202407"/>
                </a:cubicBezTo>
                <a:cubicBezTo>
                  <a:pt x="1151876" y="202302"/>
                  <a:pt x="1164407" y="198846"/>
                  <a:pt x="1166812" y="197644"/>
                </a:cubicBezTo>
                <a:cubicBezTo>
                  <a:pt x="1169372" y="196364"/>
                  <a:pt x="1171396" y="194162"/>
                  <a:pt x="1173956" y="192882"/>
                </a:cubicBezTo>
                <a:cubicBezTo>
                  <a:pt x="1176201" y="191759"/>
                  <a:pt x="1178855" y="191623"/>
                  <a:pt x="1181100" y="190500"/>
                </a:cubicBezTo>
                <a:cubicBezTo>
                  <a:pt x="1199557" y="181271"/>
                  <a:pt x="1177436" y="189340"/>
                  <a:pt x="1195387" y="183357"/>
                </a:cubicBezTo>
                <a:cubicBezTo>
                  <a:pt x="1197768" y="180976"/>
                  <a:pt x="1199944" y="178369"/>
                  <a:pt x="1202531" y="176213"/>
                </a:cubicBezTo>
                <a:cubicBezTo>
                  <a:pt x="1204730" y="174381"/>
                  <a:pt x="1207651" y="173474"/>
                  <a:pt x="1209675" y="171450"/>
                </a:cubicBezTo>
                <a:cubicBezTo>
                  <a:pt x="1225550" y="155575"/>
                  <a:pt x="1202529" y="172246"/>
                  <a:pt x="1221581" y="159544"/>
                </a:cubicBezTo>
                <a:cubicBezTo>
                  <a:pt x="1223168" y="157163"/>
                  <a:pt x="1224108" y="154188"/>
                  <a:pt x="1226343" y="152400"/>
                </a:cubicBezTo>
                <a:cubicBezTo>
                  <a:pt x="1228303" y="150832"/>
                  <a:pt x="1231242" y="151141"/>
                  <a:pt x="1233487" y="150019"/>
                </a:cubicBezTo>
                <a:cubicBezTo>
                  <a:pt x="1236047" y="148739"/>
                  <a:pt x="1238250" y="146844"/>
                  <a:pt x="1240631" y="145257"/>
                </a:cubicBezTo>
                <a:cubicBezTo>
                  <a:pt x="1253331" y="146051"/>
                  <a:pt x="1266069" y="146372"/>
                  <a:pt x="1278731" y="147638"/>
                </a:cubicBezTo>
                <a:cubicBezTo>
                  <a:pt x="1281987" y="147964"/>
                  <a:pt x="1285061" y="149309"/>
                  <a:pt x="1288256" y="150019"/>
                </a:cubicBezTo>
                <a:cubicBezTo>
                  <a:pt x="1308450" y="154506"/>
                  <a:pt x="1292148" y="149729"/>
                  <a:pt x="1314450" y="157163"/>
                </a:cubicBezTo>
                <a:lnTo>
                  <a:pt x="1335881" y="164307"/>
                </a:lnTo>
                <a:lnTo>
                  <a:pt x="1343025" y="166688"/>
                </a:lnTo>
                <a:cubicBezTo>
                  <a:pt x="1345406" y="168275"/>
                  <a:pt x="1347553" y="170288"/>
                  <a:pt x="1350168" y="171450"/>
                </a:cubicBezTo>
                <a:cubicBezTo>
                  <a:pt x="1354756" y="173489"/>
                  <a:pt x="1360279" y="173428"/>
                  <a:pt x="1364456" y="176213"/>
                </a:cubicBezTo>
                <a:cubicBezTo>
                  <a:pt x="1374323" y="182790"/>
                  <a:pt x="1368824" y="180281"/>
                  <a:pt x="1381125" y="183357"/>
                </a:cubicBezTo>
                <a:cubicBezTo>
                  <a:pt x="1392444" y="190903"/>
                  <a:pt x="1385554" y="187215"/>
                  <a:pt x="1402556" y="192882"/>
                </a:cubicBezTo>
                <a:lnTo>
                  <a:pt x="1409700" y="195263"/>
                </a:lnTo>
                <a:lnTo>
                  <a:pt x="1516856" y="192882"/>
                </a:lnTo>
                <a:cubicBezTo>
                  <a:pt x="1522853" y="192637"/>
                  <a:pt x="1527850" y="189429"/>
                  <a:pt x="1533525" y="188119"/>
                </a:cubicBezTo>
                <a:cubicBezTo>
                  <a:pt x="1541412" y="186299"/>
                  <a:pt x="1549400" y="184945"/>
                  <a:pt x="1557337" y="183357"/>
                </a:cubicBezTo>
                <a:cubicBezTo>
                  <a:pt x="1561306" y="182563"/>
                  <a:pt x="1565403" y="182255"/>
                  <a:pt x="1569243" y="180975"/>
                </a:cubicBezTo>
                <a:cubicBezTo>
                  <a:pt x="1577198" y="178324"/>
                  <a:pt x="1576942" y="178206"/>
                  <a:pt x="1585912" y="176213"/>
                </a:cubicBezTo>
                <a:cubicBezTo>
                  <a:pt x="1589863" y="175335"/>
                  <a:pt x="1593867" y="174710"/>
                  <a:pt x="1597818" y="173832"/>
                </a:cubicBezTo>
                <a:cubicBezTo>
                  <a:pt x="1614560" y="170111"/>
                  <a:pt x="1600571" y="173045"/>
                  <a:pt x="1614487" y="169069"/>
                </a:cubicBezTo>
                <a:cubicBezTo>
                  <a:pt x="1635418" y="163090"/>
                  <a:pt x="1614027" y="170016"/>
                  <a:pt x="1631156" y="164307"/>
                </a:cubicBezTo>
                <a:lnTo>
                  <a:pt x="1652587" y="150019"/>
                </a:lnTo>
                <a:lnTo>
                  <a:pt x="1659731" y="145257"/>
                </a:lnTo>
                <a:cubicBezTo>
                  <a:pt x="1664413" y="138232"/>
                  <a:pt x="1664761" y="136699"/>
                  <a:pt x="1671637" y="130969"/>
                </a:cubicBezTo>
                <a:cubicBezTo>
                  <a:pt x="1673836" y="129137"/>
                  <a:pt x="1676400" y="127794"/>
                  <a:pt x="1678781" y="126207"/>
                </a:cubicBezTo>
                <a:cubicBezTo>
                  <a:pt x="1683976" y="110620"/>
                  <a:pt x="1676760" y="125919"/>
                  <a:pt x="1688306" y="116682"/>
                </a:cubicBezTo>
                <a:cubicBezTo>
                  <a:pt x="1690541" y="114894"/>
                  <a:pt x="1691044" y="111562"/>
                  <a:pt x="1693068" y="109538"/>
                </a:cubicBezTo>
                <a:cubicBezTo>
                  <a:pt x="1695092" y="107514"/>
                  <a:pt x="1698013" y="106607"/>
                  <a:pt x="1700212" y="104775"/>
                </a:cubicBezTo>
                <a:cubicBezTo>
                  <a:pt x="1702799" y="102619"/>
                  <a:pt x="1704769" y="99788"/>
                  <a:pt x="1707356" y="97632"/>
                </a:cubicBezTo>
                <a:cubicBezTo>
                  <a:pt x="1709555" y="95800"/>
                  <a:pt x="1712301" y="94701"/>
                  <a:pt x="1714500" y="92869"/>
                </a:cubicBezTo>
                <a:cubicBezTo>
                  <a:pt x="1717087" y="90713"/>
                  <a:pt x="1718985" y="87792"/>
                  <a:pt x="1721643" y="85725"/>
                </a:cubicBezTo>
                <a:cubicBezTo>
                  <a:pt x="1733924" y="76173"/>
                  <a:pt x="1732297" y="77411"/>
                  <a:pt x="1743075" y="73819"/>
                </a:cubicBezTo>
                <a:cubicBezTo>
                  <a:pt x="1745456" y="72232"/>
                  <a:pt x="1747603" y="70219"/>
                  <a:pt x="1750218" y="69057"/>
                </a:cubicBezTo>
                <a:cubicBezTo>
                  <a:pt x="1754806" y="67018"/>
                  <a:pt x="1759743" y="65882"/>
                  <a:pt x="1764506" y="64294"/>
                </a:cubicBezTo>
                <a:lnTo>
                  <a:pt x="1778793" y="59532"/>
                </a:lnTo>
                <a:lnTo>
                  <a:pt x="1793081" y="54769"/>
                </a:lnTo>
                <a:cubicBezTo>
                  <a:pt x="1799399" y="52663"/>
                  <a:pt x="1802915" y="51289"/>
                  <a:pt x="1809750" y="50007"/>
                </a:cubicBezTo>
                <a:cubicBezTo>
                  <a:pt x="1819241" y="48227"/>
                  <a:pt x="1828856" y="47138"/>
                  <a:pt x="1838325" y="45244"/>
                </a:cubicBezTo>
                <a:cubicBezTo>
                  <a:pt x="1842294" y="44450"/>
                  <a:pt x="1846186" y="42993"/>
                  <a:pt x="1850231" y="42863"/>
                </a:cubicBezTo>
                <a:cubicBezTo>
                  <a:pt x="1870858" y="42198"/>
                  <a:pt x="1891506" y="42863"/>
                  <a:pt x="1912143" y="42863"/>
                </a:cubicBezTo>
              </a:path>
            </a:pathLst>
          </a:custGeom>
          <a:noFill/>
          <a:ln w="38100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9666"/>
          </a:p>
        </p:txBody>
      </p:sp>
      <p:sp>
        <p:nvSpPr>
          <p:cNvPr id="215" name="Rectangle 214"/>
          <p:cNvSpPr/>
          <p:nvPr/>
        </p:nvSpPr>
        <p:spPr>
          <a:xfrm flipH="1">
            <a:off x="638531" y="7018198"/>
            <a:ext cx="598567" cy="5043601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9666"/>
          </a:p>
        </p:txBody>
      </p:sp>
      <p:sp>
        <p:nvSpPr>
          <p:cNvPr id="216" name="TextBox 215"/>
          <p:cNvSpPr txBox="1"/>
          <p:nvPr/>
        </p:nvSpPr>
        <p:spPr>
          <a:xfrm>
            <a:off x="739944" y="1102134"/>
            <a:ext cx="465192" cy="646331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sz="3600" b="1" dirty="0"/>
              <a:t>A</a:t>
            </a:r>
          </a:p>
        </p:txBody>
      </p:sp>
      <p:grpSp>
        <p:nvGrpSpPr>
          <p:cNvPr id="217" name="Group 216"/>
          <p:cNvGrpSpPr/>
          <p:nvPr/>
        </p:nvGrpSpPr>
        <p:grpSpPr>
          <a:xfrm>
            <a:off x="703622" y="2277574"/>
            <a:ext cx="523286" cy="8615723"/>
            <a:chOff x="246564" y="481967"/>
            <a:chExt cx="2171" cy="3108580"/>
          </a:xfrm>
        </p:grpSpPr>
        <p:sp>
          <p:nvSpPr>
            <p:cNvPr id="218" name="TextBox 217"/>
            <p:cNvSpPr txBox="1"/>
            <p:nvPr/>
          </p:nvSpPr>
          <p:spPr>
            <a:xfrm rot="16200000">
              <a:off x="-38442" y="2928772"/>
              <a:ext cx="572183" cy="2171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sz="2800" b="1" dirty="0">
                  <a:solidFill>
                    <a:srgbClr val="00B050"/>
                  </a:solidFill>
                </a:rPr>
                <a:t>CD31</a:t>
              </a:r>
            </a:p>
          </p:txBody>
        </p:sp>
        <p:sp>
          <p:nvSpPr>
            <p:cNvPr id="219" name="TextBox 218"/>
            <p:cNvSpPr txBox="1"/>
            <p:nvPr/>
          </p:nvSpPr>
          <p:spPr>
            <a:xfrm rot="16200000">
              <a:off x="1489" y="1591909"/>
              <a:ext cx="492322" cy="2171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sz="2800" b="1" dirty="0">
                  <a:solidFill>
                    <a:srgbClr val="00B0F0"/>
                  </a:solidFill>
                </a:rPr>
                <a:t>DAPI</a:t>
              </a:r>
            </a:p>
          </p:txBody>
        </p:sp>
        <p:sp>
          <p:nvSpPr>
            <p:cNvPr id="220" name="TextBox 219"/>
            <p:cNvSpPr txBox="1"/>
            <p:nvPr/>
          </p:nvSpPr>
          <p:spPr>
            <a:xfrm rot="16200000">
              <a:off x="-56242" y="784773"/>
              <a:ext cx="607784" cy="2171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sz="2800" b="1" dirty="0">
                  <a:solidFill>
                    <a:srgbClr val="FF0000"/>
                  </a:solidFill>
                </a:rPr>
                <a:t>CLDN1</a:t>
              </a:r>
            </a:p>
          </p:txBody>
        </p:sp>
        <p:sp>
          <p:nvSpPr>
            <p:cNvPr id="221" name="TextBox 220"/>
            <p:cNvSpPr txBox="1"/>
            <p:nvPr/>
          </p:nvSpPr>
          <p:spPr>
            <a:xfrm rot="16200000">
              <a:off x="-13577" y="1222164"/>
              <a:ext cx="522453" cy="2171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sz="2800" b="1" dirty="0">
                  <a:solidFill>
                    <a:srgbClr val="00B050"/>
                  </a:solidFill>
                </a:rPr>
                <a:t>CD31</a:t>
              </a:r>
            </a:p>
          </p:txBody>
        </p:sp>
        <p:sp>
          <p:nvSpPr>
            <p:cNvPr id="222" name="TextBox 221"/>
            <p:cNvSpPr txBox="1"/>
            <p:nvPr/>
          </p:nvSpPr>
          <p:spPr>
            <a:xfrm rot="16200000">
              <a:off x="-11904" y="3329908"/>
              <a:ext cx="519107" cy="2171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sz="2800" b="1" dirty="0">
                  <a:solidFill>
                    <a:srgbClr val="00B0F0"/>
                  </a:solidFill>
                </a:rPr>
                <a:t>DAPI</a:t>
              </a:r>
            </a:p>
          </p:txBody>
        </p:sp>
        <p:sp>
          <p:nvSpPr>
            <p:cNvPr id="223" name="TextBox 222"/>
            <p:cNvSpPr txBox="1"/>
            <p:nvPr/>
          </p:nvSpPr>
          <p:spPr>
            <a:xfrm rot="16200000">
              <a:off x="-29905" y="2542733"/>
              <a:ext cx="555110" cy="2171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sz="2800" b="1" dirty="0">
                  <a:solidFill>
                    <a:srgbClr val="FF0000"/>
                  </a:solidFill>
                </a:rPr>
                <a:t>OCLN</a:t>
              </a:r>
            </a:p>
          </p:txBody>
        </p:sp>
      </p:grpSp>
      <p:sp>
        <p:nvSpPr>
          <p:cNvPr id="224" name="Rectangle 223"/>
          <p:cNvSpPr/>
          <p:nvPr/>
        </p:nvSpPr>
        <p:spPr>
          <a:xfrm flipH="1" flipV="1">
            <a:off x="638537" y="1874697"/>
            <a:ext cx="596502" cy="5048250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9666"/>
          </a:p>
        </p:txBody>
      </p:sp>
      <p:sp>
        <p:nvSpPr>
          <p:cNvPr id="225" name="Rectangle 224"/>
          <p:cNvSpPr/>
          <p:nvPr/>
        </p:nvSpPr>
        <p:spPr>
          <a:xfrm flipV="1">
            <a:off x="1394693" y="1146207"/>
            <a:ext cx="21278142" cy="622228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t"/>
          <a:lstStyle/>
          <a:p>
            <a:pPr algn="ctr"/>
            <a:endParaRPr lang="en-US" sz="9666"/>
          </a:p>
        </p:txBody>
      </p:sp>
      <p:sp>
        <p:nvSpPr>
          <p:cNvPr id="226" name="TextBox 225"/>
          <p:cNvSpPr txBox="1"/>
          <p:nvPr/>
        </p:nvSpPr>
        <p:spPr>
          <a:xfrm>
            <a:off x="10934588" y="1220949"/>
            <a:ext cx="2444452" cy="523220"/>
          </a:xfrm>
          <a:prstGeom prst="rect">
            <a:avLst/>
          </a:prstGeom>
          <a:noFill/>
        </p:spPr>
        <p:txBody>
          <a:bodyPr wrap="none" rtlCol="0" anchor="t">
            <a:spAutoFit/>
          </a:bodyPr>
          <a:lstStyle/>
          <a:p>
            <a:pPr algn="ctr"/>
            <a:r>
              <a:rPr lang="en-US" sz="2800" b="1" dirty="0"/>
              <a:t>Placenta  E16.5</a:t>
            </a:r>
          </a:p>
        </p:txBody>
      </p:sp>
      <p:pic>
        <p:nvPicPr>
          <p:cNvPr id="227" name="Picture 226"/>
          <p:cNvPicPr>
            <a:picLocks noChangeAspect="1"/>
          </p:cNvPicPr>
          <p:nvPr/>
        </p:nvPicPr>
        <p:blipFill>
          <a:blip r:embed="rId2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16200000">
            <a:off x="17825195" y="2077653"/>
            <a:ext cx="5046942" cy="4634375"/>
          </a:xfrm>
          <a:prstGeom prst="rect">
            <a:avLst/>
          </a:prstGeom>
        </p:spPr>
      </p:pic>
      <p:sp>
        <p:nvSpPr>
          <p:cNvPr id="228" name="Freeform 227"/>
          <p:cNvSpPr/>
          <p:nvPr/>
        </p:nvSpPr>
        <p:spPr>
          <a:xfrm>
            <a:off x="18109154" y="3309696"/>
            <a:ext cx="4592902" cy="540787"/>
          </a:xfrm>
          <a:custGeom>
            <a:avLst/>
            <a:gdLst>
              <a:gd name="connsiteX0" fmla="*/ 0 w 1893094"/>
              <a:gd name="connsiteY0" fmla="*/ 209550 h 209550"/>
              <a:gd name="connsiteX1" fmla="*/ 42862 w 1893094"/>
              <a:gd name="connsiteY1" fmla="*/ 202407 h 209550"/>
              <a:gd name="connsiteX2" fmla="*/ 71437 w 1893094"/>
              <a:gd name="connsiteY2" fmla="*/ 195263 h 209550"/>
              <a:gd name="connsiteX3" fmla="*/ 83344 w 1893094"/>
              <a:gd name="connsiteY3" fmla="*/ 192882 h 209550"/>
              <a:gd name="connsiteX4" fmla="*/ 185737 w 1893094"/>
              <a:gd name="connsiteY4" fmla="*/ 190500 h 209550"/>
              <a:gd name="connsiteX5" fmla="*/ 207169 w 1893094"/>
              <a:gd name="connsiteY5" fmla="*/ 185738 h 209550"/>
              <a:gd name="connsiteX6" fmla="*/ 221456 w 1893094"/>
              <a:gd name="connsiteY6" fmla="*/ 180975 h 209550"/>
              <a:gd name="connsiteX7" fmla="*/ 228600 w 1893094"/>
              <a:gd name="connsiteY7" fmla="*/ 178594 h 209550"/>
              <a:gd name="connsiteX8" fmla="*/ 235744 w 1893094"/>
              <a:gd name="connsiteY8" fmla="*/ 176213 h 209550"/>
              <a:gd name="connsiteX9" fmla="*/ 257175 w 1893094"/>
              <a:gd name="connsiteY9" fmla="*/ 164307 h 209550"/>
              <a:gd name="connsiteX10" fmla="*/ 278606 w 1893094"/>
              <a:gd name="connsiteY10" fmla="*/ 154782 h 209550"/>
              <a:gd name="connsiteX11" fmla="*/ 285750 w 1893094"/>
              <a:gd name="connsiteY11" fmla="*/ 152400 h 209550"/>
              <a:gd name="connsiteX12" fmla="*/ 323850 w 1893094"/>
              <a:gd name="connsiteY12" fmla="*/ 147638 h 209550"/>
              <a:gd name="connsiteX13" fmla="*/ 338137 w 1893094"/>
              <a:gd name="connsiteY13" fmla="*/ 142875 h 209550"/>
              <a:gd name="connsiteX14" fmla="*/ 345281 w 1893094"/>
              <a:gd name="connsiteY14" fmla="*/ 138113 h 209550"/>
              <a:gd name="connsiteX15" fmla="*/ 357187 w 1893094"/>
              <a:gd name="connsiteY15" fmla="*/ 135732 h 209550"/>
              <a:gd name="connsiteX16" fmla="*/ 378619 w 1893094"/>
              <a:gd name="connsiteY16" fmla="*/ 126207 h 209550"/>
              <a:gd name="connsiteX17" fmla="*/ 385762 w 1893094"/>
              <a:gd name="connsiteY17" fmla="*/ 123825 h 209550"/>
              <a:gd name="connsiteX18" fmla="*/ 400050 w 1893094"/>
              <a:gd name="connsiteY18" fmla="*/ 116682 h 209550"/>
              <a:gd name="connsiteX19" fmla="*/ 423862 w 1893094"/>
              <a:gd name="connsiteY19" fmla="*/ 111919 h 209550"/>
              <a:gd name="connsiteX20" fmla="*/ 450056 w 1893094"/>
              <a:gd name="connsiteY20" fmla="*/ 104775 h 209550"/>
              <a:gd name="connsiteX21" fmla="*/ 464344 w 1893094"/>
              <a:gd name="connsiteY21" fmla="*/ 100013 h 209550"/>
              <a:gd name="connsiteX22" fmla="*/ 471487 w 1893094"/>
              <a:gd name="connsiteY22" fmla="*/ 97632 h 209550"/>
              <a:gd name="connsiteX23" fmla="*/ 495300 w 1893094"/>
              <a:gd name="connsiteY23" fmla="*/ 95250 h 209550"/>
              <a:gd name="connsiteX24" fmla="*/ 507206 w 1893094"/>
              <a:gd name="connsiteY24" fmla="*/ 92869 h 209550"/>
              <a:gd name="connsiteX25" fmla="*/ 542925 w 1893094"/>
              <a:gd name="connsiteY25" fmla="*/ 90488 h 209550"/>
              <a:gd name="connsiteX26" fmla="*/ 702469 w 1893094"/>
              <a:gd name="connsiteY26" fmla="*/ 92869 h 209550"/>
              <a:gd name="connsiteX27" fmla="*/ 709612 w 1893094"/>
              <a:gd name="connsiteY27" fmla="*/ 95250 h 209550"/>
              <a:gd name="connsiteX28" fmla="*/ 719137 w 1893094"/>
              <a:gd name="connsiteY28" fmla="*/ 97632 h 209550"/>
              <a:gd name="connsiteX29" fmla="*/ 726281 w 1893094"/>
              <a:gd name="connsiteY29" fmla="*/ 100013 h 209550"/>
              <a:gd name="connsiteX30" fmla="*/ 738187 w 1893094"/>
              <a:gd name="connsiteY30" fmla="*/ 102394 h 209550"/>
              <a:gd name="connsiteX31" fmla="*/ 745331 w 1893094"/>
              <a:gd name="connsiteY31" fmla="*/ 104775 h 209550"/>
              <a:gd name="connsiteX32" fmla="*/ 757237 w 1893094"/>
              <a:gd name="connsiteY32" fmla="*/ 107157 h 209550"/>
              <a:gd name="connsiteX33" fmla="*/ 773906 w 1893094"/>
              <a:gd name="connsiteY33" fmla="*/ 111919 h 209550"/>
              <a:gd name="connsiteX34" fmla="*/ 788194 w 1893094"/>
              <a:gd name="connsiteY34" fmla="*/ 119063 h 209550"/>
              <a:gd name="connsiteX35" fmla="*/ 802481 w 1893094"/>
              <a:gd name="connsiteY35" fmla="*/ 126207 h 209550"/>
              <a:gd name="connsiteX36" fmla="*/ 862012 w 1893094"/>
              <a:gd name="connsiteY36" fmla="*/ 128588 h 209550"/>
              <a:gd name="connsiteX37" fmla="*/ 869156 w 1893094"/>
              <a:gd name="connsiteY37" fmla="*/ 133350 h 209550"/>
              <a:gd name="connsiteX38" fmla="*/ 881062 w 1893094"/>
              <a:gd name="connsiteY38" fmla="*/ 145257 h 209550"/>
              <a:gd name="connsiteX39" fmla="*/ 892969 w 1893094"/>
              <a:gd name="connsiteY39" fmla="*/ 154782 h 209550"/>
              <a:gd name="connsiteX40" fmla="*/ 900112 w 1893094"/>
              <a:gd name="connsiteY40" fmla="*/ 159544 h 209550"/>
              <a:gd name="connsiteX41" fmla="*/ 933450 w 1893094"/>
              <a:gd name="connsiteY41" fmla="*/ 166688 h 209550"/>
              <a:gd name="connsiteX42" fmla="*/ 973931 w 1893094"/>
              <a:gd name="connsiteY42" fmla="*/ 161925 h 209550"/>
              <a:gd name="connsiteX43" fmla="*/ 988219 w 1893094"/>
              <a:gd name="connsiteY43" fmla="*/ 157163 h 209550"/>
              <a:gd name="connsiteX44" fmla="*/ 1012031 w 1893094"/>
              <a:gd name="connsiteY44" fmla="*/ 150019 h 209550"/>
              <a:gd name="connsiteX45" fmla="*/ 1019175 w 1893094"/>
              <a:gd name="connsiteY45" fmla="*/ 145257 h 209550"/>
              <a:gd name="connsiteX46" fmla="*/ 1040606 w 1893094"/>
              <a:gd name="connsiteY46" fmla="*/ 138113 h 209550"/>
              <a:gd name="connsiteX47" fmla="*/ 1047750 w 1893094"/>
              <a:gd name="connsiteY47" fmla="*/ 135732 h 209550"/>
              <a:gd name="connsiteX48" fmla="*/ 1054894 w 1893094"/>
              <a:gd name="connsiteY48" fmla="*/ 133350 h 209550"/>
              <a:gd name="connsiteX49" fmla="*/ 1066800 w 1893094"/>
              <a:gd name="connsiteY49" fmla="*/ 130969 h 209550"/>
              <a:gd name="connsiteX50" fmla="*/ 1102519 w 1893094"/>
              <a:gd name="connsiteY50" fmla="*/ 123825 h 209550"/>
              <a:gd name="connsiteX51" fmla="*/ 1116806 w 1893094"/>
              <a:gd name="connsiteY51" fmla="*/ 119063 h 209550"/>
              <a:gd name="connsiteX52" fmla="*/ 1123950 w 1893094"/>
              <a:gd name="connsiteY52" fmla="*/ 116682 h 209550"/>
              <a:gd name="connsiteX53" fmla="*/ 1152525 w 1893094"/>
              <a:gd name="connsiteY53" fmla="*/ 92869 h 209550"/>
              <a:gd name="connsiteX54" fmla="*/ 1171575 w 1893094"/>
              <a:gd name="connsiteY54" fmla="*/ 71438 h 209550"/>
              <a:gd name="connsiteX55" fmla="*/ 1185862 w 1893094"/>
              <a:gd name="connsiteY55" fmla="*/ 61913 h 209550"/>
              <a:gd name="connsiteX56" fmla="*/ 1204912 w 1893094"/>
              <a:gd name="connsiteY56" fmla="*/ 52388 h 209550"/>
              <a:gd name="connsiteX57" fmla="*/ 1219200 w 1893094"/>
              <a:gd name="connsiteY57" fmla="*/ 40482 h 209550"/>
              <a:gd name="connsiteX58" fmla="*/ 1226344 w 1893094"/>
              <a:gd name="connsiteY58" fmla="*/ 35719 h 209550"/>
              <a:gd name="connsiteX59" fmla="*/ 1233487 w 1893094"/>
              <a:gd name="connsiteY59" fmla="*/ 28575 h 209550"/>
              <a:gd name="connsiteX60" fmla="*/ 1247775 w 1893094"/>
              <a:gd name="connsiteY60" fmla="*/ 19050 h 209550"/>
              <a:gd name="connsiteX61" fmla="*/ 1259681 w 1893094"/>
              <a:gd name="connsiteY61" fmla="*/ 9525 h 209550"/>
              <a:gd name="connsiteX62" fmla="*/ 1271587 w 1893094"/>
              <a:gd name="connsiteY62" fmla="*/ 0 h 209550"/>
              <a:gd name="connsiteX63" fmla="*/ 1316831 w 1893094"/>
              <a:gd name="connsiteY63" fmla="*/ 2382 h 209550"/>
              <a:gd name="connsiteX64" fmla="*/ 1381125 w 1893094"/>
              <a:gd name="connsiteY64" fmla="*/ 4763 h 209550"/>
              <a:gd name="connsiteX65" fmla="*/ 1402556 w 1893094"/>
              <a:gd name="connsiteY65" fmla="*/ 7144 h 209550"/>
              <a:gd name="connsiteX66" fmla="*/ 1426369 w 1893094"/>
              <a:gd name="connsiteY66" fmla="*/ 9525 h 209550"/>
              <a:gd name="connsiteX67" fmla="*/ 1504950 w 1893094"/>
              <a:gd name="connsiteY67" fmla="*/ 14288 h 209550"/>
              <a:gd name="connsiteX68" fmla="*/ 1521619 w 1893094"/>
              <a:gd name="connsiteY68" fmla="*/ 16669 h 209550"/>
              <a:gd name="connsiteX69" fmla="*/ 1547812 w 1893094"/>
              <a:gd name="connsiteY69" fmla="*/ 21432 h 209550"/>
              <a:gd name="connsiteX70" fmla="*/ 1554956 w 1893094"/>
              <a:gd name="connsiteY70" fmla="*/ 23813 h 209550"/>
              <a:gd name="connsiteX71" fmla="*/ 1564481 w 1893094"/>
              <a:gd name="connsiteY71" fmla="*/ 26194 h 209550"/>
              <a:gd name="connsiteX72" fmla="*/ 1583531 w 1893094"/>
              <a:gd name="connsiteY72" fmla="*/ 33338 h 209550"/>
              <a:gd name="connsiteX73" fmla="*/ 1645444 w 1893094"/>
              <a:gd name="connsiteY73" fmla="*/ 38100 h 209550"/>
              <a:gd name="connsiteX74" fmla="*/ 1728787 w 1893094"/>
              <a:gd name="connsiteY74" fmla="*/ 42863 h 209550"/>
              <a:gd name="connsiteX75" fmla="*/ 1759744 w 1893094"/>
              <a:gd name="connsiteY75" fmla="*/ 50007 h 209550"/>
              <a:gd name="connsiteX76" fmla="*/ 1771650 w 1893094"/>
              <a:gd name="connsiteY76" fmla="*/ 52388 h 209550"/>
              <a:gd name="connsiteX77" fmla="*/ 1781175 w 1893094"/>
              <a:gd name="connsiteY77" fmla="*/ 54769 h 209550"/>
              <a:gd name="connsiteX78" fmla="*/ 1793081 w 1893094"/>
              <a:gd name="connsiteY78" fmla="*/ 57150 h 209550"/>
              <a:gd name="connsiteX79" fmla="*/ 1800225 w 1893094"/>
              <a:gd name="connsiteY79" fmla="*/ 59532 h 209550"/>
              <a:gd name="connsiteX80" fmla="*/ 1826419 w 1893094"/>
              <a:gd name="connsiteY80" fmla="*/ 64294 h 209550"/>
              <a:gd name="connsiteX81" fmla="*/ 1840706 w 1893094"/>
              <a:gd name="connsiteY81" fmla="*/ 69057 h 209550"/>
              <a:gd name="connsiteX82" fmla="*/ 1850231 w 1893094"/>
              <a:gd name="connsiteY82" fmla="*/ 71438 h 209550"/>
              <a:gd name="connsiteX83" fmla="*/ 1862137 w 1893094"/>
              <a:gd name="connsiteY83" fmla="*/ 73819 h 209550"/>
              <a:gd name="connsiteX84" fmla="*/ 1869281 w 1893094"/>
              <a:gd name="connsiteY84" fmla="*/ 76200 h 209550"/>
              <a:gd name="connsiteX85" fmla="*/ 1893094 w 1893094"/>
              <a:gd name="connsiteY85" fmla="*/ 76200 h 20955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  <a:cxn ang="0">
                <a:pos x="connsiteX31" y="connsiteY31"/>
              </a:cxn>
              <a:cxn ang="0">
                <a:pos x="connsiteX32" y="connsiteY32"/>
              </a:cxn>
              <a:cxn ang="0">
                <a:pos x="connsiteX33" y="connsiteY33"/>
              </a:cxn>
              <a:cxn ang="0">
                <a:pos x="connsiteX34" y="connsiteY34"/>
              </a:cxn>
              <a:cxn ang="0">
                <a:pos x="connsiteX35" y="connsiteY35"/>
              </a:cxn>
              <a:cxn ang="0">
                <a:pos x="connsiteX36" y="connsiteY36"/>
              </a:cxn>
              <a:cxn ang="0">
                <a:pos x="connsiteX37" y="connsiteY37"/>
              </a:cxn>
              <a:cxn ang="0">
                <a:pos x="connsiteX38" y="connsiteY38"/>
              </a:cxn>
              <a:cxn ang="0">
                <a:pos x="connsiteX39" y="connsiteY39"/>
              </a:cxn>
              <a:cxn ang="0">
                <a:pos x="connsiteX40" y="connsiteY40"/>
              </a:cxn>
              <a:cxn ang="0">
                <a:pos x="connsiteX41" y="connsiteY41"/>
              </a:cxn>
              <a:cxn ang="0">
                <a:pos x="connsiteX42" y="connsiteY42"/>
              </a:cxn>
              <a:cxn ang="0">
                <a:pos x="connsiteX43" y="connsiteY43"/>
              </a:cxn>
              <a:cxn ang="0">
                <a:pos x="connsiteX44" y="connsiteY44"/>
              </a:cxn>
              <a:cxn ang="0">
                <a:pos x="connsiteX45" y="connsiteY45"/>
              </a:cxn>
              <a:cxn ang="0">
                <a:pos x="connsiteX46" y="connsiteY46"/>
              </a:cxn>
              <a:cxn ang="0">
                <a:pos x="connsiteX47" y="connsiteY47"/>
              </a:cxn>
              <a:cxn ang="0">
                <a:pos x="connsiteX48" y="connsiteY48"/>
              </a:cxn>
              <a:cxn ang="0">
                <a:pos x="connsiteX49" y="connsiteY49"/>
              </a:cxn>
              <a:cxn ang="0">
                <a:pos x="connsiteX50" y="connsiteY50"/>
              </a:cxn>
              <a:cxn ang="0">
                <a:pos x="connsiteX51" y="connsiteY51"/>
              </a:cxn>
              <a:cxn ang="0">
                <a:pos x="connsiteX52" y="connsiteY52"/>
              </a:cxn>
              <a:cxn ang="0">
                <a:pos x="connsiteX53" y="connsiteY53"/>
              </a:cxn>
              <a:cxn ang="0">
                <a:pos x="connsiteX54" y="connsiteY54"/>
              </a:cxn>
              <a:cxn ang="0">
                <a:pos x="connsiteX55" y="connsiteY55"/>
              </a:cxn>
              <a:cxn ang="0">
                <a:pos x="connsiteX56" y="connsiteY56"/>
              </a:cxn>
              <a:cxn ang="0">
                <a:pos x="connsiteX57" y="connsiteY57"/>
              </a:cxn>
              <a:cxn ang="0">
                <a:pos x="connsiteX58" y="connsiteY58"/>
              </a:cxn>
              <a:cxn ang="0">
                <a:pos x="connsiteX59" y="connsiteY59"/>
              </a:cxn>
              <a:cxn ang="0">
                <a:pos x="connsiteX60" y="connsiteY60"/>
              </a:cxn>
              <a:cxn ang="0">
                <a:pos x="connsiteX61" y="connsiteY61"/>
              </a:cxn>
              <a:cxn ang="0">
                <a:pos x="connsiteX62" y="connsiteY62"/>
              </a:cxn>
              <a:cxn ang="0">
                <a:pos x="connsiteX63" y="connsiteY63"/>
              </a:cxn>
              <a:cxn ang="0">
                <a:pos x="connsiteX64" y="connsiteY64"/>
              </a:cxn>
              <a:cxn ang="0">
                <a:pos x="connsiteX65" y="connsiteY65"/>
              </a:cxn>
              <a:cxn ang="0">
                <a:pos x="connsiteX66" y="connsiteY66"/>
              </a:cxn>
              <a:cxn ang="0">
                <a:pos x="connsiteX67" y="connsiteY67"/>
              </a:cxn>
              <a:cxn ang="0">
                <a:pos x="connsiteX68" y="connsiteY68"/>
              </a:cxn>
              <a:cxn ang="0">
                <a:pos x="connsiteX69" y="connsiteY69"/>
              </a:cxn>
              <a:cxn ang="0">
                <a:pos x="connsiteX70" y="connsiteY70"/>
              </a:cxn>
              <a:cxn ang="0">
                <a:pos x="connsiteX71" y="connsiteY71"/>
              </a:cxn>
              <a:cxn ang="0">
                <a:pos x="connsiteX72" y="connsiteY72"/>
              </a:cxn>
              <a:cxn ang="0">
                <a:pos x="connsiteX73" y="connsiteY73"/>
              </a:cxn>
              <a:cxn ang="0">
                <a:pos x="connsiteX74" y="connsiteY74"/>
              </a:cxn>
              <a:cxn ang="0">
                <a:pos x="connsiteX75" y="connsiteY75"/>
              </a:cxn>
              <a:cxn ang="0">
                <a:pos x="connsiteX76" y="connsiteY76"/>
              </a:cxn>
              <a:cxn ang="0">
                <a:pos x="connsiteX77" y="connsiteY77"/>
              </a:cxn>
              <a:cxn ang="0">
                <a:pos x="connsiteX78" y="connsiteY78"/>
              </a:cxn>
              <a:cxn ang="0">
                <a:pos x="connsiteX79" y="connsiteY79"/>
              </a:cxn>
              <a:cxn ang="0">
                <a:pos x="connsiteX80" y="connsiteY80"/>
              </a:cxn>
              <a:cxn ang="0">
                <a:pos x="connsiteX81" y="connsiteY81"/>
              </a:cxn>
              <a:cxn ang="0">
                <a:pos x="connsiteX82" y="connsiteY82"/>
              </a:cxn>
              <a:cxn ang="0">
                <a:pos x="connsiteX83" y="connsiteY83"/>
              </a:cxn>
              <a:cxn ang="0">
                <a:pos x="connsiteX84" y="connsiteY84"/>
              </a:cxn>
              <a:cxn ang="0">
                <a:pos x="connsiteX85" y="connsiteY85"/>
              </a:cxn>
            </a:cxnLst>
            <a:rect l="l" t="t" r="r" b="b"/>
            <a:pathLst>
              <a:path w="1893094" h="209550">
                <a:moveTo>
                  <a:pt x="0" y="209550"/>
                </a:moveTo>
                <a:cubicBezTo>
                  <a:pt x="11857" y="208068"/>
                  <a:pt x="32033" y="206017"/>
                  <a:pt x="42862" y="202407"/>
                </a:cubicBezTo>
                <a:cubicBezTo>
                  <a:pt x="63729" y="195451"/>
                  <a:pt x="50276" y="199110"/>
                  <a:pt x="71437" y="195263"/>
                </a:cubicBezTo>
                <a:cubicBezTo>
                  <a:pt x="75419" y="194539"/>
                  <a:pt x="79300" y="193051"/>
                  <a:pt x="83344" y="192882"/>
                </a:cubicBezTo>
                <a:cubicBezTo>
                  <a:pt x="117455" y="191461"/>
                  <a:pt x="151606" y="191294"/>
                  <a:pt x="185737" y="190500"/>
                </a:cubicBezTo>
                <a:cubicBezTo>
                  <a:pt x="192532" y="189141"/>
                  <a:pt x="200446" y="187755"/>
                  <a:pt x="207169" y="185738"/>
                </a:cubicBezTo>
                <a:cubicBezTo>
                  <a:pt x="211977" y="184295"/>
                  <a:pt x="216694" y="182563"/>
                  <a:pt x="221456" y="180975"/>
                </a:cubicBezTo>
                <a:lnTo>
                  <a:pt x="228600" y="178594"/>
                </a:lnTo>
                <a:lnTo>
                  <a:pt x="235744" y="176213"/>
                </a:lnTo>
                <a:cubicBezTo>
                  <a:pt x="252120" y="165296"/>
                  <a:pt x="244601" y="168498"/>
                  <a:pt x="257175" y="164307"/>
                </a:cubicBezTo>
                <a:cubicBezTo>
                  <a:pt x="268497" y="156759"/>
                  <a:pt x="261602" y="160450"/>
                  <a:pt x="278606" y="154782"/>
                </a:cubicBezTo>
                <a:cubicBezTo>
                  <a:pt x="280987" y="153988"/>
                  <a:pt x="283259" y="152711"/>
                  <a:pt x="285750" y="152400"/>
                </a:cubicBezTo>
                <a:lnTo>
                  <a:pt x="323850" y="147638"/>
                </a:lnTo>
                <a:cubicBezTo>
                  <a:pt x="328612" y="146050"/>
                  <a:pt x="333960" y="145659"/>
                  <a:pt x="338137" y="142875"/>
                </a:cubicBezTo>
                <a:cubicBezTo>
                  <a:pt x="340518" y="141288"/>
                  <a:pt x="342601" y="139118"/>
                  <a:pt x="345281" y="138113"/>
                </a:cubicBezTo>
                <a:cubicBezTo>
                  <a:pt x="349071" y="136692"/>
                  <a:pt x="353218" y="136526"/>
                  <a:pt x="357187" y="135732"/>
                </a:cubicBezTo>
                <a:cubicBezTo>
                  <a:pt x="368510" y="128183"/>
                  <a:pt x="361613" y="131876"/>
                  <a:pt x="378619" y="126207"/>
                </a:cubicBezTo>
                <a:cubicBezTo>
                  <a:pt x="381000" y="125413"/>
                  <a:pt x="383674" y="125217"/>
                  <a:pt x="385762" y="123825"/>
                </a:cubicBezTo>
                <a:cubicBezTo>
                  <a:pt x="392351" y="119433"/>
                  <a:pt x="392510" y="118422"/>
                  <a:pt x="400050" y="116682"/>
                </a:cubicBezTo>
                <a:cubicBezTo>
                  <a:pt x="407937" y="114862"/>
                  <a:pt x="416183" y="114478"/>
                  <a:pt x="423862" y="111919"/>
                </a:cubicBezTo>
                <a:cubicBezTo>
                  <a:pt x="467040" y="97528"/>
                  <a:pt x="413032" y="114873"/>
                  <a:pt x="450056" y="104775"/>
                </a:cubicBezTo>
                <a:cubicBezTo>
                  <a:pt x="454899" y="103454"/>
                  <a:pt x="459581" y="101600"/>
                  <a:pt x="464344" y="100013"/>
                </a:cubicBezTo>
                <a:cubicBezTo>
                  <a:pt x="466725" y="99219"/>
                  <a:pt x="468990" y="97882"/>
                  <a:pt x="471487" y="97632"/>
                </a:cubicBezTo>
                <a:cubicBezTo>
                  <a:pt x="479425" y="96838"/>
                  <a:pt x="487393" y="96304"/>
                  <a:pt x="495300" y="95250"/>
                </a:cubicBezTo>
                <a:cubicBezTo>
                  <a:pt x="499312" y="94715"/>
                  <a:pt x="503179" y="93272"/>
                  <a:pt x="507206" y="92869"/>
                </a:cubicBezTo>
                <a:cubicBezTo>
                  <a:pt x="519080" y="91682"/>
                  <a:pt x="531019" y="91282"/>
                  <a:pt x="542925" y="90488"/>
                </a:cubicBezTo>
                <a:lnTo>
                  <a:pt x="702469" y="92869"/>
                </a:lnTo>
                <a:cubicBezTo>
                  <a:pt x="704978" y="92941"/>
                  <a:pt x="707199" y="94560"/>
                  <a:pt x="709612" y="95250"/>
                </a:cubicBezTo>
                <a:cubicBezTo>
                  <a:pt x="712759" y="96149"/>
                  <a:pt x="715990" y="96733"/>
                  <a:pt x="719137" y="97632"/>
                </a:cubicBezTo>
                <a:cubicBezTo>
                  <a:pt x="721551" y="98322"/>
                  <a:pt x="723846" y="99404"/>
                  <a:pt x="726281" y="100013"/>
                </a:cubicBezTo>
                <a:cubicBezTo>
                  <a:pt x="730207" y="100995"/>
                  <a:pt x="734261" y="101412"/>
                  <a:pt x="738187" y="102394"/>
                </a:cubicBezTo>
                <a:cubicBezTo>
                  <a:pt x="740622" y="103003"/>
                  <a:pt x="742896" y="104166"/>
                  <a:pt x="745331" y="104775"/>
                </a:cubicBezTo>
                <a:cubicBezTo>
                  <a:pt x="749257" y="105757"/>
                  <a:pt x="753286" y="106279"/>
                  <a:pt x="757237" y="107157"/>
                </a:cubicBezTo>
                <a:cubicBezTo>
                  <a:pt x="766211" y="109151"/>
                  <a:pt x="765948" y="109267"/>
                  <a:pt x="773906" y="111919"/>
                </a:cubicBezTo>
                <a:cubicBezTo>
                  <a:pt x="794375" y="125566"/>
                  <a:pt x="768480" y="109207"/>
                  <a:pt x="788194" y="119063"/>
                </a:cubicBezTo>
                <a:cubicBezTo>
                  <a:pt x="794146" y="122039"/>
                  <a:pt x="795499" y="125708"/>
                  <a:pt x="802481" y="126207"/>
                </a:cubicBezTo>
                <a:cubicBezTo>
                  <a:pt x="822290" y="127622"/>
                  <a:pt x="842168" y="127794"/>
                  <a:pt x="862012" y="128588"/>
                </a:cubicBezTo>
                <a:cubicBezTo>
                  <a:pt x="864393" y="130175"/>
                  <a:pt x="867132" y="131326"/>
                  <a:pt x="869156" y="133350"/>
                </a:cubicBezTo>
                <a:cubicBezTo>
                  <a:pt x="885038" y="149231"/>
                  <a:pt x="862007" y="132551"/>
                  <a:pt x="881062" y="145257"/>
                </a:cubicBezTo>
                <a:cubicBezTo>
                  <a:pt x="889091" y="157298"/>
                  <a:pt x="881467" y="149031"/>
                  <a:pt x="892969" y="154782"/>
                </a:cubicBezTo>
                <a:cubicBezTo>
                  <a:pt x="895528" y="156062"/>
                  <a:pt x="897497" y="158382"/>
                  <a:pt x="900112" y="159544"/>
                </a:cubicBezTo>
                <a:cubicBezTo>
                  <a:pt x="913391" y="165446"/>
                  <a:pt x="918443" y="164812"/>
                  <a:pt x="933450" y="166688"/>
                </a:cubicBezTo>
                <a:cubicBezTo>
                  <a:pt x="946780" y="165577"/>
                  <a:pt x="960816" y="165502"/>
                  <a:pt x="973931" y="161925"/>
                </a:cubicBezTo>
                <a:cubicBezTo>
                  <a:pt x="978774" y="160604"/>
                  <a:pt x="983349" y="158380"/>
                  <a:pt x="988219" y="157163"/>
                </a:cubicBezTo>
                <a:cubicBezTo>
                  <a:pt x="993546" y="155831"/>
                  <a:pt x="1008549" y="152340"/>
                  <a:pt x="1012031" y="150019"/>
                </a:cubicBezTo>
                <a:cubicBezTo>
                  <a:pt x="1014412" y="148432"/>
                  <a:pt x="1016560" y="146419"/>
                  <a:pt x="1019175" y="145257"/>
                </a:cubicBezTo>
                <a:cubicBezTo>
                  <a:pt x="1019189" y="145251"/>
                  <a:pt x="1037027" y="139306"/>
                  <a:pt x="1040606" y="138113"/>
                </a:cubicBezTo>
                <a:lnTo>
                  <a:pt x="1047750" y="135732"/>
                </a:lnTo>
                <a:cubicBezTo>
                  <a:pt x="1050131" y="134938"/>
                  <a:pt x="1052433" y="133842"/>
                  <a:pt x="1054894" y="133350"/>
                </a:cubicBezTo>
                <a:cubicBezTo>
                  <a:pt x="1058863" y="132556"/>
                  <a:pt x="1062808" y="131634"/>
                  <a:pt x="1066800" y="130969"/>
                </a:cubicBezTo>
                <a:cubicBezTo>
                  <a:pt x="1082759" y="128309"/>
                  <a:pt x="1086408" y="129195"/>
                  <a:pt x="1102519" y="123825"/>
                </a:cubicBezTo>
                <a:lnTo>
                  <a:pt x="1116806" y="119063"/>
                </a:lnTo>
                <a:lnTo>
                  <a:pt x="1123950" y="116682"/>
                </a:lnTo>
                <a:cubicBezTo>
                  <a:pt x="1134491" y="109655"/>
                  <a:pt x="1145193" y="103868"/>
                  <a:pt x="1152525" y="92869"/>
                </a:cubicBezTo>
                <a:cubicBezTo>
                  <a:pt x="1158252" y="84278"/>
                  <a:pt x="1161785" y="77965"/>
                  <a:pt x="1171575" y="71438"/>
                </a:cubicBezTo>
                <a:cubicBezTo>
                  <a:pt x="1176337" y="68263"/>
                  <a:pt x="1180743" y="64473"/>
                  <a:pt x="1185862" y="61913"/>
                </a:cubicBezTo>
                <a:cubicBezTo>
                  <a:pt x="1192212" y="58738"/>
                  <a:pt x="1199005" y="56326"/>
                  <a:pt x="1204912" y="52388"/>
                </a:cubicBezTo>
                <a:cubicBezTo>
                  <a:pt x="1222650" y="40562"/>
                  <a:pt x="1200864" y="55761"/>
                  <a:pt x="1219200" y="40482"/>
                </a:cubicBezTo>
                <a:cubicBezTo>
                  <a:pt x="1221399" y="38650"/>
                  <a:pt x="1224145" y="37551"/>
                  <a:pt x="1226344" y="35719"/>
                </a:cubicBezTo>
                <a:cubicBezTo>
                  <a:pt x="1228931" y="33563"/>
                  <a:pt x="1230829" y="30642"/>
                  <a:pt x="1233487" y="28575"/>
                </a:cubicBezTo>
                <a:cubicBezTo>
                  <a:pt x="1238005" y="25061"/>
                  <a:pt x="1247775" y="19050"/>
                  <a:pt x="1247775" y="19050"/>
                </a:cubicBezTo>
                <a:cubicBezTo>
                  <a:pt x="1261419" y="-1416"/>
                  <a:pt x="1243252" y="22667"/>
                  <a:pt x="1259681" y="9525"/>
                </a:cubicBezTo>
                <a:cubicBezTo>
                  <a:pt x="1275070" y="-2785"/>
                  <a:pt x="1253631" y="5988"/>
                  <a:pt x="1271587" y="0"/>
                </a:cubicBezTo>
                <a:lnTo>
                  <a:pt x="1316831" y="2382"/>
                </a:lnTo>
                <a:lnTo>
                  <a:pt x="1381125" y="4763"/>
                </a:lnTo>
                <a:cubicBezTo>
                  <a:pt x="1388302" y="5162"/>
                  <a:pt x="1395408" y="6392"/>
                  <a:pt x="1402556" y="7144"/>
                </a:cubicBezTo>
                <a:lnTo>
                  <a:pt x="1426369" y="9525"/>
                </a:lnTo>
                <a:cubicBezTo>
                  <a:pt x="1462011" y="16656"/>
                  <a:pt x="1423629" y="9642"/>
                  <a:pt x="1504950" y="14288"/>
                </a:cubicBezTo>
                <a:cubicBezTo>
                  <a:pt x="1510554" y="14608"/>
                  <a:pt x="1516072" y="15816"/>
                  <a:pt x="1521619" y="16669"/>
                </a:cubicBezTo>
                <a:cubicBezTo>
                  <a:pt x="1527152" y="17520"/>
                  <a:pt x="1541857" y="19943"/>
                  <a:pt x="1547812" y="21432"/>
                </a:cubicBezTo>
                <a:cubicBezTo>
                  <a:pt x="1550247" y="22041"/>
                  <a:pt x="1552542" y="23123"/>
                  <a:pt x="1554956" y="23813"/>
                </a:cubicBezTo>
                <a:cubicBezTo>
                  <a:pt x="1558103" y="24712"/>
                  <a:pt x="1561376" y="25159"/>
                  <a:pt x="1564481" y="26194"/>
                </a:cubicBezTo>
                <a:cubicBezTo>
                  <a:pt x="1564943" y="26348"/>
                  <a:pt x="1580421" y="32860"/>
                  <a:pt x="1583531" y="33338"/>
                </a:cubicBezTo>
                <a:cubicBezTo>
                  <a:pt x="1598505" y="35641"/>
                  <a:pt x="1633679" y="37365"/>
                  <a:pt x="1645444" y="38100"/>
                </a:cubicBezTo>
                <a:cubicBezTo>
                  <a:pt x="1689767" y="45490"/>
                  <a:pt x="1619997" y="34495"/>
                  <a:pt x="1728787" y="42863"/>
                </a:cubicBezTo>
                <a:cubicBezTo>
                  <a:pt x="1759413" y="45219"/>
                  <a:pt x="1743571" y="45963"/>
                  <a:pt x="1759744" y="50007"/>
                </a:cubicBezTo>
                <a:cubicBezTo>
                  <a:pt x="1763670" y="50989"/>
                  <a:pt x="1767699" y="51510"/>
                  <a:pt x="1771650" y="52388"/>
                </a:cubicBezTo>
                <a:cubicBezTo>
                  <a:pt x="1774845" y="53098"/>
                  <a:pt x="1777980" y="54059"/>
                  <a:pt x="1781175" y="54769"/>
                </a:cubicBezTo>
                <a:cubicBezTo>
                  <a:pt x="1785126" y="55647"/>
                  <a:pt x="1789155" y="56168"/>
                  <a:pt x="1793081" y="57150"/>
                </a:cubicBezTo>
                <a:cubicBezTo>
                  <a:pt x="1795516" y="57759"/>
                  <a:pt x="1797775" y="58987"/>
                  <a:pt x="1800225" y="59532"/>
                </a:cubicBezTo>
                <a:cubicBezTo>
                  <a:pt x="1810022" y="61709"/>
                  <a:pt x="1816889" y="61695"/>
                  <a:pt x="1826419" y="64294"/>
                </a:cubicBezTo>
                <a:cubicBezTo>
                  <a:pt x="1831262" y="65615"/>
                  <a:pt x="1835836" y="67840"/>
                  <a:pt x="1840706" y="69057"/>
                </a:cubicBezTo>
                <a:cubicBezTo>
                  <a:pt x="1843881" y="69851"/>
                  <a:pt x="1847036" y="70728"/>
                  <a:pt x="1850231" y="71438"/>
                </a:cubicBezTo>
                <a:cubicBezTo>
                  <a:pt x="1854182" y="72316"/>
                  <a:pt x="1858211" y="72837"/>
                  <a:pt x="1862137" y="73819"/>
                </a:cubicBezTo>
                <a:cubicBezTo>
                  <a:pt x="1864572" y="74428"/>
                  <a:pt x="1866778" y="76008"/>
                  <a:pt x="1869281" y="76200"/>
                </a:cubicBezTo>
                <a:cubicBezTo>
                  <a:pt x="1877195" y="76809"/>
                  <a:pt x="1885156" y="76200"/>
                  <a:pt x="1893094" y="76200"/>
                </a:cubicBezTo>
              </a:path>
            </a:pathLst>
          </a:custGeom>
          <a:noFill/>
          <a:ln w="38100">
            <a:solidFill>
              <a:schemeClr val="bg1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9666"/>
          </a:p>
        </p:txBody>
      </p:sp>
      <p:sp>
        <p:nvSpPr>
          <p:cNvPr id="229" name="Freeform 228"/>
          <p:cNvSpPr/>
          <p:nvPr/>
        </p:nvSpPr>
        <p:spPr>
          <a:xfrm>
            <a:off x="18097595" y="3346567"/>
            <a:ext cx="4598681" cy="571513"/>
          </a:xfrm>
          <a:custGeom>
            <a:avLst/>
            <a:gdLst>
              <a:gd name="connsiteX0" fmla="*/ 0 w 1895475"/>
              <a:gd name="connsiteY0" fmla="*/ 221456 h 221456"/>
              <a:gd name="connsiteX1" fmla="*/ 11907 w 1895475"/>
              <a:gd name="connsiteY1" fmla="*/ 219075 h 221456"/>
              <a:gd name="connsiteX2" fmla="*/ 33338 w 1895475"/>
              <a:gd name="connsiteY2" fmla="*/ 211931 h 221456"/>
              <a:gd name="connsiteX3" fmla="*/ 40482 w 1895475"/>
              <a:gd name="connsiteY3" fmla="*/ 209550 h 221456"/>
              <a:gd name="connsiteX4" fmla="*/ 59532 w 1895475"/>
              <a:gd name="connsiteY4" fmla="*/ 207169 h 221456"/>
              <a:gd name="connsiteX5" fmla="*/ 150019 w 1895475"/>
              <a:gd name="connsiteY5" fmla="*/ 204787 h 221456"/>
              <a:gd name="connsiteX6" fmla="*/ 161925 w 1895475"/>
              <a:gd name="connsiteY6" fmla="*/ 202406 h 221456"/>
              <a:gd name="connsiteX7" fmla="*/ 180975 w 1895475"/>
              <a:gd name="connsiteY7" fmla="*/ 200025 h 221456"/>
              <a:gd name="connsiteX8" fmla="*/ 195263 w 1895475"/>
              <a:gd name="connsiteY8" fmla="*/ 197644 h 221456"/>
              <a:gd name="connsiteX9" fmla="*/ 216694 w 1895475"/>
              <a:gd name="connsiteY9" fmla="*/ 190500 h 221456"/>
              <a:gd name="connsiteX10" fmla="*/ 223838 w 1895475"/>
              <a:gd name="connsiteY10" fmla="*/ 188119 h 221456"/>
              <a:gd name="connsiteX11" fmla="*/ 230982 w 1895475"/>
              <a:gd name="connsiteY11" fmla="*/ 183356 h 221456"/>
              <a:gd name="connsiteX12" fmla="*/ 254794 w 1895475"/>
              <a:gd name="connsiteY12" fmla="*/ 176212 h 221456"/>
              <a:gd name="connsiteX13" fmla="*/ 269082 w 1895475"/>
              <a:gd name="connsiteY13" fmla="*/ 171450 h 221456"/>
              <a:gd name="connsiteX14" fmla="*/ 276225 w 1895475"/>
              <a:gd name="connsiteY14" fmla="*/ 169069 h 221456"/>
              <a:gd name="connsiteX15" fmla="*/ 283369 w 1895475"/>
              <a:gd name="connsiteY15" fmla="*/ 164306 h 221456"/>
              <a:gd name="connsiteX16" fmla="*/ 295275 w 1895475"/>
              <a:gd name="connsiteY16" fmla="*/ 161925 h 221456"/>
              <a:gd name="connsiteX17" fmla="*/ 326232 w 1895475"/>
              <a:gd name="connsiteY17" fmla="*/ 157162 h 221456"/>
              <a:gd name="connsiteX18" fmla="*/ 333375 w 1895475"/>
              <a:gd name="connsiteY18" fmla="*/ 154781 h 221456"/>
              <a:gd name="connsiteX19" fmla="*/ 350044 w 1895475"/>
              <a:gd name="connsiteY19" fmla="*/ 150019 h 221456"/>
              <a:gd name="connsiteX20" fmla="*/ 357188 w 1895475"/>
              <a:gd name="connsiteY20" fmla="*/ 145256 h 221456"/>
              <a:gd name="connsiteX21" fmla="*/ 371475 w 1895475"/>
              <a:gd name="connsiteY21" fmla="*/ 140494 h 221456"/>
              <a:gd name="connsiteX22" fmla="*/ 378619 w 1895475"/>
              <a:gd name="connsiteY22" fmla="*/ 135731 h 221456"/>
              <a:gd name="connsiteX23" fmla="*/ 392907 w 1895475"/>
              <a:gd name="connsiteY23" fmla="*/ 130969 h 221456"/>
              <a:gd name="connsiteX24" fmla="*/ 407194 w 1895475"/>
              <a:gd name="connsiteY24" fmla="*/ 123825 h 221456"/>
              <a:gd name="connsiteX25" fmla="*/ 435769 w 1895475"/>
              <a:gd name="connsiteY25" fmla="*/ 109537 h 221456"/>
              <a:gd name="connsiteX26" fmla="*/ 442913 w 1895475"/>
              <a:gd name="connsiteY26" fmla="*/ 107156 h 221456"/>
              <a:gd name="connsiteX27" fmla="*/ 459582 w 1895475"/>
              <a:gd name="connsiteY27" fmla="*/ 104775 h 221456"/>
              <a:gd name="connsiteX28" fmla="*/ 485775 w 1895475"/>
              <a:gd name="connsiteY28" fmla="*/ 102394 h 221456"/>
              <a:gd name="connsiteX29" fmla="*/ 507207 w 1895475"/>
              <a:gd name="connsiteY29" fmla="*/ 100012 h 221456"/>
              <a:gd name="connsiteX30" fmla="*/ 514350 w 1895475"/>
              <a:gd name="connsiteY30" fmla="*/ 97631 h 221456"/>
              <a:gd name="connsiteX31" fmla="*/ 631032 w 1895475"/>
              <a:gd name="connsiteY31" fmla="*/ 97631 h 221456"/>
              <a:gd name="connsiteX32" fmla="*/ 638175 w 1895475"/>
              <a:gd name="connsiteY32" fmla="*/ 100012 h 221456"/>
              <a:gd name="connsiteX33" fmla="*/ 673894 w 1895475"/>
              <a:gd name="connsiteY33" fmla="*/ 104775 h 221456"/>
              <a:gd name="connsiteX34" fmla="*/ 688182 w 1895475"/>
              <a:gd name="connsiteY34" fmla="*/ 107156 h 221456"/>
              <a:gd name="connsiteX35" fmla="*/ 697707 w 1895475"/>
              <a:gd name="connsiteY35" fmla="*/ 109537 h 221456"/>
              <a:gd name="connsiteX36" fmla="*/ 731044 w 1895475"/>
              <a:gd name="connsiteY36" fmla="*/ 114300 h 221456"/>
              <a:gd name="connsiteX37" fmla="*/ 742950 w 1895475"/>
              <a:gd name="connsiteY37" fmla="*/ 116681 h 221456"/>
              <a:gd name="connsiteX38" fmla="*/ 750094 w 1895475"/>
              <a:gd name="connsiteY38" fmla="*/ 119062 h 221456"/>
              <a:gd name="connsiteX39" fmla="*/ 764382 w 1895475"/>
              <a:gd name="connsiteY39" fmla="*/ 121444 h 221456"/>
              <a:gd name="connsiteX40" fmla="*/ 783432 w 1895475"/>
              <a:gd name="connsiteY40" fmla="*/ 126206 h 221456"/>
              <a:gd name="connsiteX41" fmla="*/ 797719 w 1895475"/>
              <a:gd name="connsiteY41" fmla="*/ 130969 h 221456"/>
              <a:gd name="connsiteX42" fmla="*/ 804863 w 1895475"/>
              <a:gd name="connsiteY42" fmla="*/ 133350 h 221456"/>
              <a:gd name="connsiteX43" fmla="*/ 814388 w 1895475"/>
              <a:gd name="connsiteY43" fmla="*/ 135731 h 221456"/>
              <a:gd name="connsiteX44" fmla="*/ 828675 w 1895475"/>
              <a:gd name="connsiteY44" fmla="*/ 140494 h 221456"/>
              <a:gd name="connsiteX45" fmla="*/ 850107 w 1895475"/>
              <a:gd name="connsiteY45" fmla="*/ 147637 h 221456"/>
              <a:gd name="connsiteX46" fmla="*/ 871538 w 1895475"/>
              <a:gd name="connsiteY46" fmla="*/ 154781 h 221456"/>
              <a:gd name="connsiteX47" fmla="*/ 878682 w 1895475"/>
              <a:gd name="connsiteY47" fmla="*/ 157162 h 221456"/>
              <a:gd name="connsiteX48" fmla="*/ 885825 w 1895475"/>
              <a:gd name="connsiteY48" fmla="*/ 159544 h 221456"/>
              <a:gd name="connsiteX49" fmla="*/ 926307 w 1895475"/>
              <a:gd name="connsiteY49" fmla="*/ 166687 h 221456"/>
              <a:gd name="connsiteX50" fmla="*/ 1007269 w 1895475"/>
              <a:gd name="connsiteY50" fmla="*/ 164306 h 221456"/>
              <a:gd name="connsiteX51" fmla="*/ 1019175 w 1895475"/>
              <a:gd name="connsiteY51" fmla="*/ 161925 h 221456"/>
              <a:gd name="connsiteX52" fmla="*/ 1052513 w 1895475"/>
              <a:gd name="connsiteY52" fmla="*/ 152400 h 221456"/>
              <a:gd name="connsiteX53" fmla="*/ 1071563 w 1895475"/>
              <a:gd name="connsiteY53" fmla="*/ 147637 h 221456"/>
              <a:gd name="connsiteX54" fmla="*/ 1085850 w 1895475"/>
              <a:gd name="connsiteY54" fmla="*/ 142875 h 221456"/>
              <a:gd name="connsiteX55" fmla="*/ 1100138 w 1895475"/>
              <a:gd name="connsiteY55" fmla="*/ 138112 h 221456"/>
              <a:gd name="connsiteX56" fmla="*/ 1114425 w 1895475"/>
              <a:gd name="connsiteY56" fmla="*/ 130969 h 221456"/>
              <a:gd name="connsiteX57" fmla="*/ 1121569 w 1895475"/>
              <a:gd name="connsiteY57" fmla="*/ 126206 h 221456"/>
              <a:gd name="connsiteX58" fmla="*/ 1128713 w 1895475"/>
              <a:gd name="connsiteY58" fmla="*/ 123825 h 221456"/>
              <a:gd name="connsiteX59" fmla="*/ 1150144 w 1895475"/>
              <a:gd name="connsiteY59" fmla="*/ 111919 h 221456"/>
              <a:gd name="connsiteX60" fmla="*/ 1171575 w 1895475"/>
              <a:gd name="connsiteY60" fmla="*/ 97631 h 221456"/>
              <a:gd name="connsiteX61" fmla="*/ 1178719 w 1895475"/>
              <a:gd name="connsiteY61" fmla="*/ 92869 h 221456"/>
              <a:gd name="connsiteX62" fmla="*/ 1185863 w 1895475"/>
              <a:gd name="connsiteY62" fmla="*/ 85725 h 221456"/>
              <a:gd name="connsiteX63" fmla="*/ 1190625 w 1895475"/>
              <a:gd name="connsiteY63" fmla="*/ 78581 h 221456"/>
              <a:gd name="connsiteX64" fmla="*/ 1197769 w 1895475"/>
              <a:gd name="connsiteY64" fmla="*/ 73819 h 221456"/>
              <a:gd name="connsiteX65" fmla="*/ 1202532 w 1895475"/>
              <a:gd name="connsiteY65" fmla="*/ 66675 h 221456"/>
              <a:gd name="connsiteX66" fmla="*/ 1209675 w 1895475"/>
              <a:gd name="connsiteY66" fmla="*/ 61912 h 221456"/>
              <a:gd name="connsiteX67" fmla="*/ 1219200 w 1895475"/>
              <a:gd name="connsiteY67" fmla="*/ 47625 h 221456"/>
              <a:gd name="connsiteX68" fmla="*/ 1233488 w 1895475"/>
              <a:gd name="connsiteY68" fmla="*/ 35719 h 221456"/>
              <a:gd name="connsiteX69" fmla="*/ 1247775 w 1895475"/>
              <a:gd name="connsiteY69" fmla="*/ 26194 h 221456"/>
              <a:gd name="connsiteX70" fmla="*/ 1262063 w 1895475"/>
              <a:gd name="connsiteY70" fmla="*/ 16669 h 221456"/>
              <a:gd name="connsiteX71" fmla="*/ 1269207 w 1895475"/>
              <a:gd name="connsiteY71" fmla="*/ 11906 h 221456"/>
              <a:gd name="connsiteX72" fmla="*/ 1283494 w 1895475"/>
              <a:gd name="connsiteY72" fmla="*/ 7144 h 221456"/>
              <a:gd name="connsiteX73" fmla="*/ 1290638 w 1895475"/>
              <a:gd name="connsiteY73" fmla="*/ 2381 h 221456"/>
              <a:gd name="connsiteX74" fmla="*/ 1297782 w 1895475"/>
              <a:gd name="connsiteY74" fmla="*/ 0 h 221456"/>
              <a:gd name="connsiteX75" fmla="*/ 1364457 w 1895475"/>
              <a:gd name="connsiteY75" fmla="*/ 2381 h 221456"/>
              <a:gd name="connsiteX76" fmla="*/ 1388269 w 1895475"/>
              <a:gd name="connsiteY76" fmla="*/ 7144 h 221456"/>
              <a:gd name="connsiteX77" fmla="*/ 1414463 w 1895475"/>
              <a:gd name="connsiteY77" fmla="*/ 11906 h 221456"/>
              <a:gd name="connsiteX78" fmla="*/ 1464469 w 1895475"/>
              <a:gd name="connsiteY78" fmla="*/ 16669 h 221456"/>
              <a:gd name="connsiteX79" fmla="*/ 1471613 w 1895475"/>
              <a:gd name="connsiteY79" fmla="*/ 19050 h 221456"/>
              <a:gd name="connsiteX80" fmla="*/ 1524000 w 1895475"/>
              <a:gd name="connsiteY80" fmla="*/ 26194 h 221456"/>
              <a:gd name="connsiteX81" fmla="*/ 1531144 w 1895475"/>
              <a:gd name="connsiteY81" fmla="*/ 28575 h 221456"/>
              <a:gd name="connsiteX82" fmla="*/ 1540669 w 1895475"/>
              <a:gd name="connsiteY82" fmla="*/ 30956 h 221456"/>
              <a:gd name="connsiteX83" fmla="*/ 1562100 w 1895475"/>
              <a:gd name="connsiteY83" fmla="*/ 35719 h 221456"/>
              <a:gd name="connsiteX84" fmla="*/ 1569244 w 1895475"/>
              <a:gd name="connsiteY84" fmla="*/ 38100 h 221456"/>
              <a:gd name="connsiteX85" fmla="*/ 1607344 w 1895475"/>
              <a:gd name="connsiteY85" fmla="*/ 42862 h 221456"/>
              <a:gd name="connsiteX86" fmla="*/ 1619250 w 1895475"/>
              <a:gd name="connsiteY86" fmla="*/ 45244 h 221456"/>
              <a:gd name="connsiteX87" fmla="*/ 1628775 w 1895475"/>
              <a:gd name="connsiteY87" fmla="*/ 47625 h 221456"/>
              <a:gd name="connsiteX88" fmla="*/ 1650207 w 1895475"/>
              <a:gd name="connsiteY88" fmla="*/ 50006 h 221456"/>
              <a:gd name="connsiteX89" fmla="*/ 1702594 w 1895475"/>
              <a:gd name="connsiteY89" fmla="*/ 54769 h 221456"/>
              <a:gd name="connsiteX90" fmla="*/ 1714500 w 1895475"/>
              <a:gd name="connsiteY90" fmla="*/ 57150 h 221456"/>
              <a:gd name="connsiteX91" fmla="*/ 1762125 w 1895475"/>
              <a:gd name="connsiteY91" fmla="*/ 61912 h 221456"/>
              <a:gd name="connsiteX92" fmla="*/ 1781175 w 1895475"/>
              <a:gd name="connsiteY92" fmla="*/ 66675 h 221456"/>
              <a:gd name="connsiteX93" fmla="*/ 1819275 w 1895475"/>
              <a:gd name="connsiteY93" fmla="*/ 71437 h 221456"/>
              <a:gd name="connsiteX94" fmla="*/ 1852613 w 1895475"/>
              <a:gd name="connsiteY94" fmla="*/ 76200 h 221456"/>
              <a:gd name="connsiteX95" fmla="*/ 1871663 w 1895475"/>
              <a:gd name="connsiteY95" fmla="*/ 78581 h 221456"/>
              <a:gd name="connsiteX96" fmla="*/ 1883569 w 1895475"/>
              <a:gd name="connsiteY96" fmla="*/ 80962 h 221456"/>
              <a:gd name="connsiteX97" fmla="*/ 1895475 w 1895475"/>
              <a:gd name="connsiteY97" fmla="*/ 80962 h 221456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  <a:cxn ang="0">
                <a:pos x="connsiteX31" y="connsiteY31"/>
              </a:cxn>
              <a:cxn ang="0">
                <a:pos x="connsiteX32" y="connsiteY32"/>
              </a:cxn>
              <a:cxn ang="0">
                <a:pos x="connsiteX33" y="connsiteY33"/>
              </a:cxn>
              <a:cxn ang="0">
                <a:pos x="connsiteX34" y="connsiteY34"/>
              </a:cxn>
              <a:cxn ang="0">
                <a:pos x="connsiteX35" y="connsiteY35"/>
              </a:cxn>
              <a:cxn ang="0">
                <a:pos x="connsiteX36" y="connsiteY36"/>
              </a:cxn>
              <a:cxn ang="0">
                <a:pos x="connsiteX37" y="connsiteY37"/>
              </a:cxn>
              <a:cxn ang="0">
                <a:pos x="connsiteX38" y="connsiteY38"/>
              </a:cxn>
              <a:cxn ang="0">
                <a:pos x="connsiteX39" y="connsiteY39"/>
              </a:cxn>
              <a:cxn ang="0">
                <a:pos x="connsiteX40" y="connsiteY40"/>
              </a:cxn>
              <a:cxn ang="0">
                <a:pos x="connsiteX41" y="connsiteY41"/>
              </a:cxn>
              <a:cxn ang="0">
                <a:pos x="connsiteX42" y="connsiteY42"/>
              </a:cxn>
              <a:cxn ang="0">
                <a:pos x="connsiteX43" y="connsiteY43"/>
              </a:cxn>
              <a:cxn ang="0">
                <a:pos x="connsiteX44" y="connsiteY44"/>
              </a:cxn>
              <a:cxn ang="0">
                <a:pos x="connsiteX45" y="connsiteY45"/>
              </a:cxn>
              <a:cxn ang="0">
                <a:pos x="connsiteX46" y="connsiteY46"/>
              </a:cxn>
              <a:cxn ang="0">
                <a:pos x="connsiteX47" y="connsiteY47"/>
              </a:cxn>
              <a:cxn ang="0">
                <a:pos x="connsiteX48" y="connsiteY48"/>
              </a:cxn>
              <a:cxn ang="0">
                <a:pos x="connsiteX49" y="connsiteY49"/>
              </a:cxn>
              <a:cxn ang="0">
                <a:pos x="connsiteX50" y="connsiteY50"/>
              </a:cxn>
              <a:cxn ang="0">
                <a:pos x="connsiteX51" y="connsiteY51"/>
              </a:cxn>
              <a:cxn ang="0">
                <a:pos x="connsiteX52" y="connsiteY52"/>
              </a:cxn>
              <a:cxn ang="0">
                <a:pos x="connsiteX53" y="connsiteY53"/>
              </a:cxn>
              <a:cxn ang="0">
                <a:pos x="connsiteX54" y="connsiteY54"/>
              </a:cxn>
              <a:cxn ang="0">
                <a:pos x="connsiteX55" y="connsiteY55"/>
              </a:cxn>
              <a:cxn ang="0">
                <a:pos x="connsiteX56" y="connsiteY56"/>
              </a:cxn>
              <a:cxn ang="0">
                <a:pos x="connsiteX57" y="connsiteY57"/>
              </a:cxn>
              <a:cxn ang="0">
                <a:pos x="connsiteX58" y="connsiteY58"/>
              </a:cxn>
              <a:cxn ang="0">
                <a:pos x="connsiteX59" y="connsiteY59"/>
              </a:cxn>
              <a:cxn ang="0">
                <a:pos x="connsiteX60" y="connsiteY60"/>
              </a:cxn>
              <a:cxn ang="0">
                <a:pos x="connsiteX61" y="connsiteY61"/>
              </a:cxn>
              <a:cxn ang="0">
                <a:pos x="connsiteX62" y="connsiteY62"/>
              </a:cxn>
              <a:cxn ang="0">
                <a:pos x="connsiteX63" y="connsiteY63"/>
              </a:cxn>
              <a:cxn ang="0">
                <a:pos x="connsiteX64" y="connsiteY64"/>
              </a:cxn>
              <a:cxn ang="0">
                <a:pos x="connsiteX65" y="connsiteY65"/>
              </a:cxn>
              <a:cxn ang="0">
                <a:pos x="connsiteX66" y="connsiteY66"/>
              </a:cxn>
              <a:cxn ang="0">
                <a:pos x="connsiteX67" y="connsiteY67"/>
              </a:cxn>
              <a:cxn ang="0">
                <a:pos x="connsiteX68" y="connsiteY68"/>
              </a:cxn>
              <a:cxn ang="0">
                <a:pos x="connsiteX69" y="connsiteY69"/>
              </a:cxn>
              <a:cxn ang="0">
                <a:pos x="connsiteX70" y="connsiteY70"/>
              </a:cxn>
              <a:cxn ang="0">
                <a:pos x="connsiteX71" y="connsiteY71"/>
              </a:cxn>
              <a:cxn ang="0">
                <a:pos x="connsiteX72" y="connsiteY72"/>
              </a:cxn>
              <a:cxn ang="0">
                <a:pos x="connsiteX73" y="connsiteY73"/>
              </a:cxn>
              <a:cxn ang="0">
                <a:pos x="connsiteX74" y="connsiteY74"/>
              </a:cxn>
              <a:cxn ang="0">
                <a:pos x="connsiteX75" y="connsiteY75"/>
              </a:cxn>
              <a:cxn ang="0">
                <a:pos x="connsiteX76" y="connsiteY76"/>
              </a:cxn>
              <a:cxn ang="0">
                <a:pos x="connsiteX77" y="connsiteY77"/>
              </a:cxn>
              <a:cxn ang="0">
                <a:pos x="connsiteX78" y="connsiteY78"/>
              </a:cxn>
              <a:cxn ang="0">
                <a:pos x="connsiteX79" y="connsiteY79"/>
              </a:cxn>
              <a:cxn ang="0">
                <a:pos x="connsiteX80" y="connsiteY80"/>
              </a:cxn>
              <a:cxn ang="0">
                <a:pos x="connsiteX81" y="connsiteY81"/>
              </a:cxn>
              <a:cxn ang="0">
                <a:pos x="connsiteX82" y="connsiteY82"/>
              </a:cxn>
              <a:cxn ang="0">
                <a:pos x="connsiteX83" y="connsiteY83"/>
              </a:cxn>
              <a:cxn ang="0">
                <a:pos x="connsiteX84" y="connsiteY84"/>
              </a:cxn>
              <a:cxn ang="0">
                <a:pos x="connsiteX85" y="connsiteY85"/>
              </a:cxn>
              <a:cxn ang="0">
                <a:pos x="connsiteX86" y="connsiteY86"/>
              </a:cxn>
              <a:cxn ang="0">
                <a:pos x="connsiteX87" y="connsiteY87"/>
              </a:cxn>
              <a:cxn ang="0">
                <a:pos x="connsiteX88" y="connsiteY88"/>
              </a:cxn>
              <a:cxn ang="0">
                <a:pos x="connsiteX89" y="connsiteY89"/>
              </a:cxn>
              <a:cxn ang="0">
                <a:pos x="connsiteX90" y="connsiteY90"/>
              </a:cxn>
              <a:cxn ang="0">
                <a:pos x="connsiteX91" y="connsiteY91"/>
              </a:cxn>
              <a:cxn ang="0">
                <a:pos x="connsiteX92" y="connsiteY92"/>
              </a:cxn>
              <a:cxn ang="0">
                <a:pos x="connsiteX93" y="connsiteY93"/>
              </a:cxn>
              <a:cxn ang="0">
                <a:pos x="connsiteX94" y="connsiteY94"/>
              </a:cxn>
              <a:cxn ang="0">
                <a:pos x="connsiteX95" y="connsiteY95"/>
              </a:cxn>
              <a:cxn ang="0">
                <a:pos x="connsiteX96" y="connsiteY96"/>
              </a:cxn>
              <a:cxn ang="0">
                <a:pos x="connsiteX97" y="connsiteY97"/>
              </a:cxn>
            </a:cxnLst>
            <a:rect l="l" t="t" r="r" b="b"/>
            <a:pathLst>
              <a:path w="1895475" h="221456">
                <a:moveTo>
                  <a:pt x="0" y="221456"/>
                </a:moveTo>
                <a:cubicBezTo>
                  <a:pt x="3969" y="220662"/>
                  <a:pt x="8002" y="220140"/>
                  <a:pt x="11907" y="219075"/>
                </a:cubicBezTo>
                <a:cubicBezTo>
                  <a:pt x="19172" y="217094"/>
                  <a:pt x="26194" y="214312"/>
                  <a:pt x="33338" y="211931"/>
                </a:cubicBezTo>
                <a:cubicBezTo>
                  <a:pt x="35719" y="211137"/>
                  <a:pt x="37991" y="209861"/>
                  <a:pt x="40482" y="209550"/>
                </a:cubicBezTo>
                <a:cubicBezTo>
                  <a:pt x="46832" y="208756"/>
                  <a:pt x="53139" y="207447"/>
                  <a:pt x="59532" y="207169"/>
                </a:cubicBezTo>
                <a:cubicBezTo>
                  <a:pt x="89676" y="205858"/>
                  <a:pt x="119857" y="205581"/>
                  <a:pt x="150019" y="204787"/>
                </a:cubicBezTo>
                <a:cubicBezTo>
                  <a:pt x="153988" y="203993"/>
                  <a:pt x="157925" y="203021"/>
                  <a:pt x="161925" y="202406"/>
                </a:cubicBezTo>
                <a:cubicBezTo>
                  <a:pt x="168250" y="201433"/>
                  <a:pt x="174640" y="200930"/>
                  <a:pt x="180975" y="200025"/>
                </a:cubicBezTo>
                <a:cubicBezTo>
                  <a:pt x="185755" y="199342"/>
                  <a:pt x="190500" y="198438"/>
                  <a:pt x="195263" y="197644"/>
                </a:cubicBezTo>
                <a:lnTo>
                  <a:pt x="216694" y="190500"/>
                </a:lnTo>
                <a:lnTo>
                  <a:pt x="223838" y="188119"/>
                </a:lnTo>
                <a:cubicBezTo>
                  <a:pt x="226219" y="186531"/>
                  <a:pt x="228367" y="184518"/>
                  <a:pt x="230982" y="183356"/>
                </a:cubicBezTo>
                <a:cubicBezTo>
                  <a:pt x="242624" y="178182"/>
                  <a:pt x="244148" y="179406"/>
                  <a:pt x="254794" y="176212"/>
                </a:cubicBezTo>
                <a:cubicBezTo>
                  <a:pt x="259602" y="174769"/>
                  <a:pt x="264319" y="173037"/>
                  <a:pt x="269082" y="171450"/>
                </a:cubicBezTo>
                <a:lnTo>
                  <a:pt x="276225" y="169069"/>
                </a:lnTo>
                <a:cubicBezTo>
                  <a:pt x="278606" y="167481"/>
                  <a:pt x="280689" y="165311"/>
                  <a:pt x="283369" y="164306"/>
                </a:cubicBezTo>
                <a:cubicBezTo>
                  <a:pt x="287159" y="162885"/>
                  <a:pt x="291293" y="162649"/>
                  <a:pt x="295275" y="161925"/>
                </a:cubicBezTo>
                <a:cubicBezTo>
                  <a:pt x="307376" y="159725"/>
                  <a:pt x="313761" y="158944"/>
                  <a:pt x="326232" y="157162"/>
                </a:cubicBezTo>
                <a:cubicBezTo>
                  <a:pt x="328613" y="156368"/>
                  <a:pt x="330962" y="155470"/>
                  <a:pt x="333375" y="154781"/>
                </a:cubicBezTo>
                <a:cubicBezTo>
                  <a:pt x="354313" y="148799"/>
                  <a:pt x="332909" y="155730"/>
                  <a:pt x="350044" y="150019"/>
                </a:cubicBezTo>
                <a:cubicBezTo>
                  <a:pt x="352425" y="148431"/>
                  <a:pt x="354573" y="146418"/>
                  <a:pt x="357188" y="145256"/>
                </a:cubicBezTo>
                <a:cubicBezTo>
                  <a:pt x="361775" y="143217"/>
                  <a:pt x="371475" y="140494"/>
                  <a:pt x="371475" y="140494"/>
                </a:cubicBezTo>
                <a:cubicBezTo>
                  <a:pt x="373856" y="138906"/>
                  <a:pt x="376004" y="136893"/>
                  <a:pt x="378619" y="135731"/>
                </a:cubicBezTo>
                <a:cubicBezTo>
                  <a:pt x="383207" y="133692"/>
                  <a:pt x="392907" y="130969"/>
                  <a:pt x="392907" y="130969"/>
                </a:cubicBezTo>
                <a:cubicBezTo>
                  <a:pt x="424586" y="109845"/>
                  <a:pt x="377646" y="140240"/>
                  <a:pt x="407194" y="123825"/>
                </a:cubicBezTo>
                <a:cubicBezTo>
                  <a:pt x="434891" y="108439"/>
                  <a:pt x="407955" y="118809"/>
                  <a:pt x="435769" y="109537"/>
                </a:cubicBezTo>
                <a:cubicBezTo>
                  <a:pt x="438150" y="108743"/>
                  <a:pt x="440428" y="107511"/>
                  <a:pt x="442913" y="107156"/>
                </a:cubicBezTo>
                <a:cubicBezTo>
                  <a:pt x="448469" y="106362"/>
                  <a:pt x="454004" y="105395"/>
                  <a:pt x="459582" y="104775"/>
                </a:cubicBezTo>
                <a:cubicBezTo>
                  <a:pt x="468295" y="103807"/>
                  <a:pt x="477052" y="103266"/>
                  <a:pt x="485775" y="102394"/>
                </a:cubicBezTo>
                <a:cubicBezTo>
                  <a:pt x="492927" y="101679"/>
                  <a:pt x="500063" y="100806"/>
                  <a:pt x="507207" y="100012"/>
                </a:cubicBezTo>
                <a:cubicBezTo>
                  <a:pt x="509588" y="99218"/>
                  <a:pt x="511900" y="98175"/>
                  <a:pt x="514350" y="97631"/>
                </a:cubicBezTo>
                <a:cubicBezTo>
                  <a:pt x="551458" y="89386"/>
                  <a:pt x="600576" y="96923"/>
                  <a:pt x="631032" y="97631"/>
                </a:cubicBezTo>
                <a:cubicBezTo>
                  <a:pt x="633413" y="98425"/>
                  <a:pt x="635725" y="99467"/>
                  <a:pt x="638175" y="100012"/>
                </a:cubicBezTo>
                <a:cubicBezTo>
                  <a:pt x="650605" y="102775"/>
                  <a:pt x="660984" y="103054"/>
                  <a:pt x="673894" y="104775"/>
                </a:cubicBezTo>
                <a:cubicBezTo>
                  <a:pt x="678680" y="105413"/>
                  <a:pt x="683447" y="106209"/>
                  <a:pt x="688182" y="107156"/>
                </a:cubicBezTo>
                <a:cubicBezTo>
                  <a:pt x="691391" y="107798"/>
                  <a:pt x="694479" y="108999"/>
                  <a:pt x="697707" y="109537"/>
                </a:cubicBezTo>
                <a:cubicBezTo>
                  <a:pt x="708779" y="111382"/>
                  <a:pt x="720037" y="112099"/>
                  <a:pt x="731044" y="114300"/>
                </a:cubicBezTo>
                <a:cubicBezTo>
                  <a:pt x="735013" y="115094"/>
                  <a:pt x="739024" y="115699"/>
                  <a:pt x="742950" y="116681"/>
                </a:cubicBezTo>
                <a:cubicBezTo>
                  <a:pt x="745385" y="117290"/>
                  <a:pt x="747644" y="118517"/>
                  <a:pt x="750094" y="119062"/>
                </a:cubicBezTo>
                <a:cubicBezTo>
                  <a:pt x="754807" y="120109"/>
                  <a:pt x="759661" y="120432"/>
                  <a:pt x="764382" y="121444"/>
                </a:cubicBezTo>
                <a:cubicBezTo>
                  <a:pt x="770782" y="122815"/>
                  <a:pt x="777223" y="124136"/>
                  <a:pt x="783432" y="126206"/>
                </a:cubicBezTo>
                <a:lnTo>
                  <a:pt x="797719" y="130969"/>
                </a:lnTo>
                <a:cubicBezTo>
                  <a:pt x="800100" y="131763"/>
                  <a:pt x="802428" y="132741"/>
                  <a:pt x="804863" y="133350"/>
                </a:cubicBezTo>
                <a:cubicBezTo>
                  <a:pt x="808038" y="134144"/>
                  <a:pt x="811253" y="134791"/>
                  <a:pt x="814388" y="135731"/>
                </a:cubicBezTo>
                <a:cubicBezTo>
                  <a:pt x="819196" y="137174"/>
                  <a:pt x="823913" y="138906"/>
                  <a:pt x="828675" y="140494"/>
                </a:cubicBezTo>
                <a:lnTo>
                  <a:pt x="850107" y="147637"/>
                </a:lnTo>
                <a:lnTo>
                  <a:pt x="871538" y="154781"/>
                </a:lnTo>
                <a:lnTo>
                  <a:pt x="878682" y="157162"/>
                </a:lnTo>
                <a:cubicBezTo>
                  <a:pt x="881063" y="157956"/>
                  <a:pt x="883349" y="159131"/>
                  <a:pt x="885825" y="159544"/>
                </a:cubicBezTo>
                <a:cubicBezTo>
                  <a:pt x="918393" y="164971"/>
                  <a:pt x="904931" y="162413"/>
                  <a:pt x="926307" y="166687"/>
                </a:cubicBezTo>
                <a:cubicBezTo>
                  <a:pt x="953294" y="165893"/>
                  <a:pt x="980305" y="165689"/>
                  <a:pt x="1007269" y="164306"/>
                </a:cubicBezTo>
                <a:cubicBezTo>
                  <a:pt x="1011311" y="164099"/>
                  <a:pt x="1015231" y="162835"/>
                  <a:pt x="1019175" y="161925"/>
                </a:cubicBezTo>
                <a:cubicBezTo>
                  <a:pt x="1038604" y="157441"/>
                  <a:pt x="1035460" y="158084"/>
                  <a:pt x="1052513" y="152400"/>
                </a:cubicBezTo>
                <a:cubicBezTo>
                  <a:pt x="1074193" y="145174"/>
                  <a:pt x="1039948" y="156260"/>
                  <a:pt x="1071563" y="147637"/>
                </a:cubicBezTo>
                <a:cubicBezTo>
                  <a:pt x="1076406" y="146316"/>
                  <a:pt x="1081088" y="144462"/>
                  <a:pt x="1085850" y="142875"/>
                </a:cubicBezTo>
                <a:cubicBezTo>
                  <a:pt x="1085855" y="142873"/>
                  <a:pt x="1100134" y="138115"/>
                  <a:pt x="1100138" y="138112"/>
                </a:cubicBezTo>
                <a:cubicBezTo>
                  <a:pt x="1109370" y="131958"/>
                  <a:pt x="1104567" y="134255"/>
                  <a:pt x="1114425" y="130969"/>
                </a:cubicBezTo>
                <a:cubicBezTo>
                  <a:pt x="1116806" y="129381"/>
                  <a:pt x="1119009" y="127486"/>
                  <a:pt x="1121569" y="126206"/>
                </a:cubicBezTo>
                <a:cubicBezTo>
                  <a:pt x="1123814" y="125083"/>
                  <a:pt x="1126519" y="125044"/>
                  <a:pt x="1128713" y="123825"/>
                </a:cubicBezTo>
                <a:cubicBezTo>
                  <a:pt x="1153277" y="110179"/>
                  <a:pt x="1133979" y="117307"/>
                  <a:pt x="1150144" y="111919"/>
                </a:cubicBezTo>
                <a:lnTo>
                  <a:pt x="1171575" y="97631"/>
                </a:lnTo>
                <a:cubicBezTo>
                  <a:pt x="1173956" y="96043"/>
                  <a:pt x="1176695" y="94893"/>
                  <a:pt x="1178719" y="92869"/>
                </a:cubicBezTo>
                <a:cubicBezTo>
                  <a:pt x="1181100" y="90488"/>
                  <a:pt x="1183707" y="88312"/>
                  <a:pt x="1185863" y="85725"/>
                </a:cubicBezTo>
                <a:cubicBezTo>
                  <a:pt x="1187695" y="83526"/>
                  <a:pt x="1188601" y="80605"/>
                  <a:pt x="1190625" y="78581"/>
                </a:cubicBezTo>
                <a:cubicBezTo>
                  <a:pt x="1192649" y="76557"/>
                  <a:pt x="1195388" y="75406"/>
                  <a:pt x="1197769" y="73819"/>
                </a:cubicBezTo>
                <a:cubicBezTo>
                  <a:pt x="1199357" y="71438"/>
                  <a:pt x="1200508" y="68699"/>
                  <a:pt x="1202532" y="66675"/>
                </a:cubicBezTo>
                <a:cubicBezTo>
                  <a:pt x="1204556" y="64651"/>
                  <a:pt x="1207791" y="64066"/>
                  <a:pt x="1209675" y="61912"/>
                </a:cubicBezTo>
                <a:cubicBezTo>
                  <a:pt x="1213444" y="57604"/>
                  <a:pt x="1215153" y="51672"/>
                  <a:pt x="1219200" y="47625"/>
                </a:cubicBezTo>
                <a:cubicBezTo>
                  <a:pt x="1240072" y="26753"/>
                  <a:pt x="1213596" y="52295"/>
                  <a:pt x="1233488" y="35719"/>
                </a:cubicBezTo>
                <a:cubicBezTo>
                  <a:pt x="1245381" y="25809"/>
                  <a:pt x="1235221" y="30379"/>
                  <a:pt x="1247775" y="26194"/>
                </a:cubicBezTo>
                <a:lnTo>
                  <a:pt x="1262063" y="16669"/>
                </a:lnTo>
                <a:cubicBezTo>
                  <a:pt x="1264444" y="15081"/>
                  <a:pt x="1266492" y="12811"/>
                  <a:pt x="1269207" y="11906"/>
                </a:cubicBezTo>
                <a:lnTo>
                  <a:pt x="1283494" y="7144"/>
                </a:lnTo>
                <a:cubicBezTo>
                  <a:pt x="1285875" y="5556"/>
                  <a:pt x="1288078" y="3661"/>
                  <a:pt x="1290638" y="2381"/>
                </a:cubicBezTo>
                <a:cubicBezTo>
                  <a:pt x="1292883" y="1258"/>
                  <a:pt x="1295272" y="0"/>
                  <a:pt x="1297782" y="0"/>
                </a:cubicBezTo>
                <a:cubicBezTo>
                  <a:pt x="1320021" y="0"/>
                  <a:pt x="1342232" y="1587"/>
                  <a:pt x="1364457" y="2381"/>
                </a:cubicBezTo>
                <a:cubicBezTo>
                  <a:pt x="1372394" y="3969"/>
                  <a:pt x="1380416" y="5181"/>
                  <a:pt x="1388269" y="7144"/>
                </a:cubicBezTo>
                <a:cubicBezTo>
                  <a:pt x="1399923" y="10057"/>
                  <a:pt x="1400242" y="10484"/>
                  <a:pt x="1414463" y="11906"/>
                </a:cubicBezTo>
                <a:cubicBezTo>
                  <a:pt x="1486191" y="19078"/>
                  <a:pt x="1413884" y="10344"/>
                  <a:pt x="1464469" y="16669"/>
                </a:cubicBezTo>
                <a:cubicBezTo>
                  <a:pt x="1466850" y="17463"/>
                  <a:pt x="1469134" y="18659"/>
                  <a:pt x="1471613" y="19050"/>
                </a:cubicBezTo>
                <a:cubicBezTo>
                  <a:pt x="1474884" y="19566"/>
                  <a:pt x="1512034" y="23535"/>
                  <a:pt x="1524000" y="26194"/>
                </a:cubicBezTo>
                <a:cubicBezTo>
                  <a:pt x="1526450" y="26739"/>
                  <a:pt x="1528730" y="27885"/>
                  <a:pt x="1531144" y="28575"/>
                </a:cubicBezTo>
                <a:cubicBezTo>
                  <a:pt x="1534291" y="29474"/>
                  <a:pt x="1537474" y="30246"/>
                  <a:pt x="1540669" y="30956"/>
                </a:cubicBezTo>
                <a:cubicBezTo>
                  <a:pt x="1551734" y="33415"/>
                  <a:pt x="1551924" y="32811"/>
                  <a:pt x="1562100" y="35719"/>
                </a:cubicBezTo>
                <a:cubicBezTo>
                  <a:pt x="1564514" y="36409"/>
                  <a:pt x="1566783" y="37608"/>
                  <a:pt x="1569244" y="38100"/>
                </a:cubicBezTo>
                <a:cubicBezTo>
                  <a:pt x="1580966" y="40444"/>
                  <a:pt x="1595782" y="41210"/>
                  <a:pt x="1607344" y="42862"/>
                </a:cubicBezTo>
                <a:cubicBezTo>
                  <a:pt x="1611351" y="43434"/>
                  <a:pt x="1615299" y="44366"/>
                  <a:pt x="1619250" y="45244"/>
                </a:cubicBezTo>
                <a:cubicBezTo>
                  <a:pt x="1622445" y="45954"/>
                  <a:pt x="1625540" y="47127"/>
                  <a:pt x="1628775" y="47625"/>
                </a:cubicBezTo>
                <a:cubicBezTo>
                  <a:pt x="1635879" y="48718"/>
                  <a:pt x="1643075" y="49115"/>
                  <a:pt x="1650207" y="50006"/>
                </a:cubicBezTo>
                <a:cubicBezTo>
                  <a:pt x="1687414" y="54656"/>
                  <a:pt x="1642723" y="50776"/>
                  <a:pt x="1702594" y="54769"/>
                </a:cubicBezTo>
                <a:cubicBezTo>
                  <a:pt x="1706563" y="55563"/>
                  <a:pt x="1710482" y="56668"/>
                  <a:pt x="1714500" y="57150"/>
                </a:cubicBezTo>
                <a:cubicBezTo>
                  <a:pt x="1730341" y="59051"/>
                  <a:pt x="1762125" y="61912"/>
                  <a:pt x="1762125" y="61912"/>
                </a:cubicBezTo>
                <a:cubicBezTo>
                  <a:pt x="1768475" y="63500"/>
                  <a:pt x="1774719" y="65599"/>
                  <a:pt x="1781175" y="66675"/>
                </a:cubicBezTo>
                <a:cubicBezTo>
                  <a:pt x="1803331" y="70367"/>
                  <a:pt x="1790659" y="68576"/>
                  <a:pt x="1819275" y="71437"/>
                </a:cubicBezTo>
                <a:cubicBezTo>
                  <a:pt x="1837427" y="75976"/>
                  <a:pt x="1823379" y="72952"/>
                  <a:pt x="1852613" y="76200"/>
                </a:cubicBezTo>
                <a:cubicBezTo>
                  <a:pt x="1858973" y="76907"/>
                  <a:pt x="1865338" y="77608"/>
                  <a:pt x="1871663" y="78581"/>
                </a:cubicBezTo>
                <a:cubicBezTo>
                  <a:pt x="1875663" y="79196"/>
                  <a:pt x="1879542" y="80559"/>
                  <a:pt x="1883569" y="80962"/>
                </a:cubicBezTo>
                <a:cubicBezTo>
                  <a:pt x="1887518" y="81357"/>
                  <a:pt x="1891506" y="80962"/>
                  <a:pt x="1895475" y="80962"/>
                </a:cubicBezTo>
              </a:path>
            </a:pathLst>
          </a:custGeom>
          <a:noFill/>
          <a:ln w="38100">
            <a:solidFill>
              <a:schemeClr val="bg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9666"/>
          </a:p>
        </p:txBody>
      </p:sp>
      <p:sp>
        <p:nvSpPr>
          <p:cNvPr id="230" name="Freeform 229"/>
          <p:cNvSpPr/>
          <p:nvPr/>
        </p:nvSpPr>
        <p:spPr>
          <a:xfrm>
            <a:off x="18074492" y="5036525"/>
            <a:ext cx="4644898" cy="577655"/>
          </a:xfrm>
          <a:custGeom>
            <a:avLst/>
            <a:gdLst>
              <a:gd name="connsiteX0" fmla="*/ 0 w 1914525"/>
              <a:gd name="connsiteY0" fmla="*/ 0 h 223837"/>
              <a:gd name="connsiteX1" fmla="*/ 47625 w 1914525"/>
              <a:gd name="connsiteY1" fmla="*/ 7143 h 223837"/>
              <a:gd name="connsiteX2" fmla="*/ 69057 w 1914525"/>
              <a:gd name="connsiteY2" fmla="*/ 14287 h 223837"/>
              <a:gd name="connsiteX3" fmla="*/ 76200 w 1914525"/>
              <a:gd name="connsiteY3" fmla="*/ 16668 h 223837"/>
              <a:gd name="connsiteX4" fmla="*/ 83344 w 1914525"/>
              <a:gd name="connsiteY4" fmla="*/ 23812 h 223837"/>
              <a:gd name="connsiteX5" fmla="*/ 90488 w 1914525"/>
              <a:gd name="connsiteY5" fmla="*/ 28575 h 223837"/>
              <a:gd name="connsiteX6" fmla="*/ 119063 w 1914525"/>
              <a:gd name="connsiteY6" fmla="*/ 52387 h 223837"/>
              <a:gd name="connsiteX7" fmla="*/ 133350 w 1914525"/>
              <a:gd name="connsiteY7" fmla="*/ 57150 h 223837"/>
              <a:gd name="connsiteX8" fmla="*/ 147638 w 1914525"/>
              <a:gd name="connsiteY8" fmla="*/ 64293 h 223837"/>
              <a:gd name="connsiteX9" fmla="*/ 200025 w 1914525"/>
              <a:gd name="connsiteY9" fmla="*/ 61912 h 223837"/>
              <a:gd name="connsiteX10" fmla="*/ 221457 w 1914525"/>
              <a:gd name="connsiteY10" fmla="*/ 54768 h 223837"/>
              <a:gd name="connsiteX11" fmla="*/ 242888 w 1914525"/>
              <a:gd name="connsiteY11" fmla="*/ 47625 h 223837"/>
              <a:gd name="connsiteX12" fmla="*/ 250032 w 1914525"/>
              <a:gd name="connsiteY12" fmla="*/ 45243 h 223837"/>
              <a:gd name="connsiteX13" fmla="*/ 257175 w 1914525"/>
              <a:gd name="connsiteY13" fmla="*/ 40481 h 223837"/>
              <a:gd name="connsiteX14" fmla="*/ 271463 w 1914525"/>
              <a:gd name="connsiteY14" fmla="*/ 35718 h 223837"/>
              <a:gd name="connsiteX15" fmla="*/ 278607 w 1914525"/>
              <a:gd name="connsiteY15" fmla="*/ 30956 h 223837"/>
              <a:gd name="connsiteX16" fmla="*/ 300038 w 1914525"/>
              <a:gd name="connsiteY16" fmla="*/ 26193 h 223837"/>
              <a:gd name="connsiteX17" fmla="*/ 333375 w 1914525"/>
              <a:gd name="connsiteY17" fmla="*/ 23812 h 223837"/>
              <a:gd name="connsiteX18" fmla="*/ 400050 w 1914525"/>
              <a:gd name="connsiteY18" fmla="*/ 28575 h 223837"/>
              <a:gd name="connsiteX19" fmla="*/ 409575 w 1914525"/>
              <a:gd name="connsiteY19" fmla="*/ 30956 h 223837"/>
              <a:gd name="connsiteX20" fmla="*/ 433388 w 1914525"/>
              <a:gd name="connsiteY20" fmla="*/ 35718 h 223837"/>
              <a:gd name="connsiteX21" fmla="*/ 450057 w 1914525"/>
              <a:gd name="connsiteY21" fmla="*/ 40481 h 223837"/>
              <a:gd name="connsiteX22" fmla="*/ 481013 w 1914525"/>
              <a:gd name="connsiteY22" fmla="*/ 45243 h 223837"/>
              <a:gd name="connsiteX23" fmla="*/ 500063 w 1914525"/>
              <a:gd name="connsiteY23" fmla="*/ 47625 h 223837"/>
              <a:gd name="connsiteX24" fmla="*/ 528638 w 1914525"/>
              <a:gd name="connsiteY24" fmla="*/ 52387 h 223837"/>
              <a:gd name="connsiteX25" fmla="*/ 538163 w 1914525"/>
              <a:gd name="connsiteY25" fmla="*/ 54768 h 223837"/>
              <a:gd name="connsiteX26" fmla="*/ 583407 w 1914525"/>
              <a:gd name="connsiteY26" fmla="*/ 61912 h 223837"/>
              <a:gd name="connsiteX27" fmla="*/ 604838 w 1914525"/>
              <a:gd name="connsiteY27" fmla="*/ 69056 h 223837"/>
              <a:gd name="connsiteX28" fmla="*/ 611982 w 1914525"/>
              <a:gd name="connsiteY28" fmla="*/ 71437 h 223837"/>
              <a:gd name="connsiteX29" fmla="*/ 619125 w 1914525"/>
              <a:gd name="connsiteY29" fmla="*/ 73818 h 223837"/>
              <a:gd name="connsiteX30" fmla="*/ 626269 w 1914525"/>
              <a:gd name="connsiteY30" fmla="*/ 78581 h 223837"/>
              <a:gd name="connsiteX31" fmla="*/ 631032 w 1914525"/>
              <a:gd name="connsiteY31" fmla="*/ 85725 h 223837"/>
              <a:gd name="connsiteX32" fmla="*/ 638175 w 1914525"/>
              <a:gd name="connsiteY32" fmla="*/ 88106 h 223837"/>
              <a:gd name="connsiteX33" fmla="*/ 642938 w 1914525"/>
              <a:gd name="connsiteY33" fmla="*/ 95250 h 223837"/>
              <a:gd name="connsiteX34" fmla="*/ 664369 w 1914525"/>
              <a:gd name="connsiteY34" fmla="*/ 107156 h 223837"/>
              <a:gd name="connsiteX35" fmla="*/ 671513 w 1914525"/>
              <a:gd name="connsiteY35" fmla="*/ 111918 h 223837"/>
              <a:gd name="connsiteX36" fmla="*/ 707232 w 1914525"/>
              <a:gd name="connsiteY36" fmla="*/ 109537 h 223837"/>
              <a:gd name="connsiteX37" fmla="*/ 721519 w 1914525"/>
              <a:gd name="connsiteY37" fmla="*/ 102393 h 223837"/>
              <a:gd name="connsiteX38" fmla="*/ 728663 w 1914525"/>
              <a:gd name="connsiteY38" fmla="*/ 95250 h 223837"/>
              <a:gd name="connsiteX39" fmla="*/ 735807 w 1914525"/>
              <a:gd name="connsiteY39" fmla="*/ 92868 h 223837"/>
              <a:gd name="connsiteX40" fmla="*/ 742950 w 1914525"/>
              <a:gd name="connsiteY40" fmla="*/ 88106 h 223837"/>
              <a:gd name="connsiteX41" fmla="*/ 750094 w 1914525"/>
              <a:gd name="connsiteY41" fmla="*/ 85725 h 223837"/>
              <a:gd name="connsiteX42" fmla="*/ 776288 w 1914525"/>
              <a:gd name="connsiteY42" fmla="*/ 78581 h 223837"/>
              <a:gd name="connsiteX43" fmla="*/ 816769 w 1914525"/>
              <a:gd name="connsiteY43" fmla="*/ 80962 h 223837"/>
              <a:gd name="connsiteX44" fmla="*/ 845344 w 1914525"/>
              <a:gd name="connsiteY44" fmla="*/ 95250 h 223837"/>
              <a:gd name="connsiteX45" fmla="*/ 852488 w 1914525"/>
              <a:gd name="connsiteY45" fmla="*/ 100012 h 223837"/>
              <a:gd name="connsiteX46" fmla="*/ 866775 w 1914525"/>
              <a:gd name="connsiteY46" fmla="*/ 107156 h 223837"/>
              <a:gd name="connsiteX47" fmla="*/ 873919 w 1914525"/>
              <a:gd name="connsiteY47" fmla="*/ 111918 h 223837"/>
              <a:gd name="connsiteX48" fmla="*/ 888207 w 1914525"/>
              <a:gd name="connsiteY48" fmla="*/ 116681 h 223837"/>
              <a:gd name="connsiteX49" fmla="*/ 902494 w 1914525"/>
              <a:gd name="connsiteY49" fmla="*/ 126206 h 223837"/>
              <a:gd name="connsiteX50" fmla="*/ 909638 w 1914525"/>
              <a:gd name="connsiteY50" fmla="*/ 130968 h 223837"/>
              <a:gd name="connsiteX51" fmla="*/ 916782 w 1914525"/>
              <a:gd name="connsiteY51" fmla="*/ 133350 h 223837"/>
              <a:gd name="connsiteX52" fmla="*/ 923925 w 1914525"/>
              <a:gd name="connsiteY52" fmla="*/ 140493 h 223837"/>
              <a:gd name="connsiteX53" fmla="*/ 931069 w 1914525"/>
              <a:gd name="connsiteY53" fmla="*/ 142875 h 223837"/>
              <a:gd name="connsiteX54" fmla="*/ 966788 w 1914525"/>
              <a:gd name="connsiteY54" fmla="*/ 145256 h 223837"/>
              <a:gd name="connsiteX55" fmla="*/ 981075 w 1914525"/>
              <a:gd name="connsiteY55" fmla="*/ 166687 h 223837"/>
              <a:gd name="connsiteX56" fmla="*/ 985838 w 1914525"/>
              <a:gd name="connsiteY56" fmla="*/ 173831 h 223837"/>
              <a:gd name="connsiteX57" fmla="*/ 1000125 w 1914525"/>
              <a:gd name="connsiteY57" fmla="*/ 180975 h 223837"/>
              <a:gd name="connsiteX58" fmla="*/ 1007269 w 1914525"/>
              <a:gd name="connsiteY58" fmla="*/ 185737 h 223837"/>
              <a:gd name="connsiteX59" fmla="*/ 1028700 w 1914525"/>
              <a:gd name="connsiteY59" fmla="*/ 192881 h 223837"/>
              <a:gd name="connsiteX60" fmla="*/ 1042988 w 1914525"/>
              <a:gd name="connsiteY60" fmla="*/ 197643 h 223837"/>
              <a:gd name="connsiteX61" fmla="*/ 1050132 w 1914525"/>
              <a:gd name="connsiteY61" fmla="*/ 200025 h 223837"/>
              <a:gd name="connsiteX62" fmla="*/ 1064419 w 1914525"/>
              <a:gd name="connsiteY62" fmla="*/ 207168 h 223837"/>
              <a:gd name="connsiteX63" fmla="*/ 1071563 w 1914525"/>
              <a:gd name="connsiteY63" fmla="*/ 211931 h 223837"/>
              <a:gd name="connsiteX64" fmla="*/ 1085850 w 1914525"/>
              <a:gd name="connsiteY64" fmla="*/ 216693 h 223837"/>
              <a:gd name="connsiteX65" fmla="*/ 1092994 w 1914525"/>
              <a:gd name="connsiteY65" fmla="*/ 219075 h 223837"/>
              <a:gd name="connsiteX66" fmla="*/ 1100138 w 1914525"/>
              <a:gd name="connsiteY66" fmla="*/ 221456 h 223837"/>
              <a:gd name="connsiteX67" fmla="*/ 1107282 w 1914525"/>
              <a:gd name="connsiteY67" fmla="*/ 223837 h 223837"/>
              <a:gd name="connsiteX68" fmla="*/ 1135857 w 1914525"/>
              <a:gd name="connsiteY68" fmla="*/ 219075 h 223837"/>
              <a:gd name="connsiteX69" fmla="*/ 1150144 w 1914525"/>
              <a:gd name="connsiteY69" fmla="*/ 209550 h 223837"/>
              <a:gd name="connsiteX70" fmla="*/ 1166813 w 1914525"/>
              <a:gd name="connsiteY70" fmla="*/ 188118 h 223837"/>
              <a:gd name="connsiteX71" fmla="*/ 1173957 w 1914525"/>
              <a:gd name="connsiteY71" fmla="*/ 183356 h 223837"/>
              <a:gd name="connsiteX72" fmla="*/ 1183482 w 1914525"/>
              <a:gd name="connsiteY72" fmla="*/ 169068 h 223837"/>
              <a:gd name="connsiteX73" fmla="*/ 1185863 w 1914525"/>
              <a:gd name="connsiteY73" fmla="*/ 161925 h 223837"/>
              <a:gd name="connsiteX74" fmla="*/ 1200150 w 1914525"/>
              <a:gd name="connsiteY74" fmla="*/ 154781 h 223837"/>
              <a:gd name="connsiteX75" fmla="*/ 1300163 w 1914525"/>
              <a:gd name="connsiteY75" fmla="*/ 157162 h 223837"/>
              <a:gd name="connsiteX76" fmla="*/ 1321594 w 1914525"/>
              <a:gd name="connsiteY76" fmla="*/ 166687 h 223837"/>
              <a:gd name="connsiteX77" fmla="*/ 1335882 w 1914525"/>
              <a:gd name="connsiteY77" fmla="*/ 171450 h 223837"/>
              <a:gd name="connsiteX78" fmla="*/ 1343025 w 1914525"/>
              <a:gd name="connsiteY78" fmla="*/ 173831 h 223837"/>
              <a:gd name="connsiteX79" fmla="*/ 1357313 w 1914525"/>
              <a:gd name="connsiteY79" fmla="*/ 180975 h 223837"/>
              <a:gd name="connsiteX80" fmla="*/ 1371600 w 1914525"/>
              <a:gd name="connsiteY80" fmla="*/ 188118 h 223837"/>
              <a:gd name="connsiteX81" fmla="*/ 1385888 w 1914525"/>
              <a:gd name="connsiteY81" fmla="*/ 197643 h 223837"/>
              <a:gd name="connsiteX82" fmla="*/ 1402557 w 1914525"/>
              <a:gd name="connsiteY82" fmla="*/ 214312 h 223837"/>
              <a:gd name="connsiteX83" fmla="*/ 1416844 w 1914525"/>
              <a:gd name="connsiteY83" fmla="*/ 219075 h 223837"/>
              <a:gd name="connsiteX84" fmla="*/ 1459707 w 1914525"/>
              <a:gd name="connsiteY84" fmla="*/ 214312 h 223837"/>
              <a:gd name="connsiteX85" fmla="*/ 1469232 w 1914525"/>
              <a:gd name="connsiteY85" fmla="*/ 211931 h 223837"/>
              <a:gd name="connsiteX86" fmla="*/ 1500188 w 1914525"/>
              <a:gd name="connsiteY86" fmla="*/ 204787 h 223837"/>
              <a:gd name="connsiteX87" fmla="*/ 1507332 w 1914525"/>
              <a:gd name="connsiteY87" fmla="*/ 202406 h 223837"/>
              <a:gd name="connsiteX88" fmla="*/ 1528763 w 1914525"/>
              <a:gd name="connsiteY88" fmla="*/ 200025 h 223837"/>
              <a:gd name="connsiteX89" fmla="*/ 1557338 w 1914525"/>
              <a:gd name="connsiteY89" fmla="*/ 195262 h 223837"/>
              <a:gd name="connsiteX90" fmla="*/ 1564482 w 1914525"/>
              <a:gd name="connsiteY90" fmla="*/ 192881 h 223837"/>
              <a:gd name="connsiteX91" fmla="*/ 1583532 w 1914525"/>
              <a:gd name="connsiteY91" fmla="*/ 188118 h 223837"/>
              <a:gd name="connsiteX92" fmla="*/ 1590675 w 1914525"/>
              <a:gd name="connsiteY92" fmla="*/ 185737 h 223837"/>
              <a:gd name="connsiteX93" fmla="*/ 1597819 w 1914525"/>
              <a:gd name="connsiteY93" fmla="*/ 180975 h 223837"/>
              <a:gd name="connsiteX94" fmla="*/ 1612107 w 1914525"/>
              <a:gd name="connsiteY94" fmla="*/ 176212 h 223837"/>
              <a:gd name="connsiteX95" fmla="*/ 1619250 w 1914525"/>
              <a:gd name="connsiteY95" fmla="*/ 173831 h 223837"/>
              <a:gd name="connsiteX96" fmla="*/ 1626394 w 1914525"/>
              <a:gd name="connsiteY96" fmla="*/ 169068 h 223837"/>
              <a:gd name="connsiteX97" fmla="*/ 1633538 w 1914525"/>
              <a:gd name="connsiteY97" fmla="*/ 166687 h 223837"/>
              <a:gd name="connsiteX98" fmla="*/ 1647825 w 1914525"/>
              <a:gd name="connsiteY98" fmla="*/ 157162 h 223837"/>
              <a:gd name="connsiteX99" fmla="*/ 1662113 w 1914525"/>
              <a:gd name="connsiteY99" fmla="*/ 145256 h 223837"/>
              <a:gd name="connsiteX100" fmla="*/ 1676400 w 1914525"/>
              <a:gd name="connsiteY100" fmla="*/ 123825 h 223837"/>
              <a:gd name="connsiteX101" fmla="*/ 1681163 w 1914525"/>
              <a:gd name="connsiteY101" fmla="*/ 116681 h 223837"/>
              <a:gd name="connsiteX102" fmla="*/ 1695450 w 1914525"/>
              <a:gd name="connsiteY102" fmla="*/ 107156 h 223837"/>
              <a:gd name="connsiteX103" fmla="*/ 1702594 w 1914525"/>
              <a:gd name="connsiteY103" fmla="*/ 102393 h 223837"/>
              <a:gd name="connsiteX104" fmla="*/ 1716882 w 1914525"/>
              <a:gd name="connsiteY104" fmla="*/ 92868 h 223837"/>
              <a:gd name="connsiteX105" fmla="*/ 1738313 w 1914525"/>
              <a:gd name="connsiteY105" fmla="*/ 80962 h 223837"/>
              <a:gd name="connsiteX106" fmla="*/ 1745457 w 1914525"/>
              <a:gd name="connsiteY106" fmla="*/ 76200 h 223837"/>
              <a:gd name="connsiteX107" fmla="*/ 1759744 w 1914525"/>
              <a:gd name="connsiteY107" fmla="*/ 71437 h 223837"/>
              <a:gd name="connsiteX108" fmla="*/ 1774032 w 1914525"/>
              <a:gd name="connsiteY108" fmla="*/ 66675 h 223837"/>
              <a:gd name="connsiteX109" fmla="*/ 1788319 w 1914525"/>
              <a:gd name="connsiteY109" fmla="*/ 61912 h 223837"/>
              <a:gd name="connsiteX110" fmla="*/ 1800225 w 1914525"/>
              <a:gd name="connsiteY110" fmla="*/ 59531 h 223837"/>
              <a:gd name="connsiteX111" fmla="*/ 1814513 w 1914525"/>
              <a:gd name="connsiteY111" fmla="*/ 54768 h 223837"/>
              <a:gd name="connsiteX112" fmla="*/ 1857375 w 1914525"/>
              <a:gd name="connsiteY112" fmla="*/ 50006 h 223837"/>
              <a:gd name="connsiteX113" fmla="*/ 1914525 w 1914525"/>
              <a:gd name="connsiteY113" fmla="*/ 50006 h 223837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  <a:cxn ang="0">
                <a:pos x="connsiteX31" y="connsiteY31"/>
              </a:cxn>
              <a:cxn ang="0">
                <a:pos x="connsiteX32" y="connsiteY32"/>
              </a:cxn>
              <a:cxn ang="0">
                <a:pos x="connsiteX33" y="connsiteY33"/>
              </a:cxn>
              <a:cxn ang="0">
                <a:pos x="connsiteX34" y="connsiteY34"/>
              </a:cxn>
              <a:cxn ang="0">
                <a:pos x="connsiteX35" y="connsiteY35"/>
              </a:cxn>
              <a:cxn ang="0">
                <a:pos x="connsiteX36" y="connsiteY36"/>
              </a:cxn>
              <a:cxn ang="0">
                <a:pos x="connsiteX37" y="connsiteY37"/>
              </a:cxn>
              <a:cxn ang="0">
                <a:pos x="connsiteX38" y="connsiteY38"/>
              </a:cxn>
              <a:cxn ang="0">
                <a:pos x="connsiteX39" y="connsiteY39"/>
              </a:cxn>
              <a:cxn ang="0">
                <a:pos x="connsiteX40" y="connsiteY40"/>
              </a:cxn>
              <a:cxn ang="0">
                <a:pos x="connsiteX41" y="connsiteY41"/>
              </a:cxn>
              <a:cxn ang="0">
                <a:pos x="connsiteX42" y="connsiteY42"/>
              </a:cxn>
              <a:cxn ang="0">
                <a:pos x="connsiteX43" y="connsiteY43"/>
              </a:cxn>
              <a:cxn ang="0">
                <a:pos x="connsiteX44" y="connsiteY44"/>
              </a:cxn>
              <a:cxn ang="0">
                <a:pos x="connsiteX45" y="connsiteY45"/>
              </a:cxn>
              <a:cxn ang="0">
                <a:pos x="connsiteX46" y="connsiteY46"/>
              </a:cxn>
              <a:cxn ang="0">
                <a:pos x="connsiteX47" y="connsiteY47"/>
              </a:cxn>
              <a:cxn ang="0">
                <a:pos x="connsiteX48" y="connsiteY48"/>
              </a:cxn>
              <a:cxn ang="0">
                <a:pos x="connsiteX49" y="connsiteY49"/>
              </a:cxn>
              <a:cxn ang="0">
                <a:pos x="connsiteX50" y="connsiteY50"/>
              </a:cxn>
              <a:cxn ang="0">
                <a:pos x="connsiteX51" y="connsiteY51"/>
              </a:cxn>
              <a:cxn ang="0">
                <a:pos x="connsiteX52" y="connsiteY52"/>
              </a:cxn>
              <a:cxn ang="0">
                <a:pos x="connsiteX53" y="connsiteY53"/>
              </a:cxn>
              <a:cxn ang="0">
                <a:pos x="connsiteX54" y="connsiteY54"/>
              </a:cxn>
              <a:cxn ang="0">
                <a:pos x="connsiteX55" y="connsiteY55"/>
              </a:cxn>
              <a:cxn ang="0">
                <a:pos x="connsiteX56" y="connsiteY56"/>
              </a:cxn>
              <a:cxn ang="0">
                <a:pos x="connsiteX57" y="connsiteY57"/>
              </a:cxn>
              <a:cxn ang="0">
                <a:pos x="connsiteX58" y="connsiteY58"/>
              </a:cxn>
              <a:cxn ang="0">
                <a:pos x="connsiteX59" y="connsiteY59"/>
              </a:cxn>
              <a:cxn ang="0">
                <a:pos x="connsiteX60" y="connsiteY60"/>
              </a:cxn>
              <a:cxn ang="0">
                <a:pos x="connsiteX61" y="connsiteY61"/>
              </a:cxn>
              <a:cxn ang="0">
                <a:pos x="connsiteX62" y="connsiteY62"/>
              </a:cxn>
              <a:cxn ang="0">
                <a:pos x="connsiteX63" y="connsiteY63"/>
              </a:cxn>
              <a:cxn ang="0">
                <a:pos x="connsiteX64" y="connsiteY64"/>
              </a:cxn>
              <a:cxn ang="0">
                <a:pos x="connsiteX65" y="connsiteY65"/>
              </a:cxn>
              <a:cxn ang="0">
                <a:pos x="connsiteX66" y="connsiteY66"/>
              </a:cxn>
              <a:cxn ang="0">
                <a:pos x="connsiteX67" y="connsiteY67"/>
              </a:cxn>
              <a:cxn ang="0">
                <a:pos x="connsiteX68" y="connsiteY68"/>
              </a:cxn>
              <a:cxn ang="0">
                <a:pos x="connsiteX69" y="connsiteY69"/>
              </a:cxn>
              <a:cxn ang="0">
                <a:pos x="connsiteX70" y="connsiteY70"/>
              </a:cxn>
              <a:cxn ang="0">
                <a:pos x="connsiteX71" y="connsiteY71"/>
              </a:cxn>
              <a:cxn ang="0">
                <a:pos x="connsiteX72" y="connsiteY72"/>
              </a:cxn>
              <a:cxn ang="0">
                <a:pos x="connsiteX73" y="connsiteY73"/>
              </a:cxn>
              <a:cxn ang="0">
                <a:pos x="connsiteX74" y="connsiteY74"/>
              </a:cxn>
              <a:cxn ang="0">
                <a:pos x="connsiteX75" y="connsiteY75"/>
              </a:cxn>
              <a:cxn ang="0">
                <a:pos x="connsiteX76" y="connsiteY76"/>
              </a:cxn>
              <a:cxn ang="0">
                <a:pos x="connsiteX77" y="connsiteY77"/>
              </a:cxn>
              <a:cxn ang="0">
                <a:pos x="connsiteX78" y="connsiteY78"/>
              </a:cxn>
              <a:cxn ang="0">
                <a:pos x="connsiteX79" y="connsiteY79"/>
              </a:cxn>
              <a:cxn ang="0">
                <a:pos x="connsiteX80" y="connsiteY80"/>
              </a:cxn>
              <a:cxn ang="0">
                <a:pos x="connsiteX81" y="connsiteY81"/>
              </a:cxn>
              <a:cxn ang="0">
                <a:pos x="connsiteX82" y="connsiteY82"/>
              </a:cxn>
              <a:cxn ang="0">
                <a:pos x="connsiteX83" y="connsiteY83"/>
              </a:cxn>
              <a:cxn ang="0">
                <a:pos x="connsiteX84" y="connsiteY84"/>
              </a:cxn>
              <a:cxn ang="0">
                <a:pos x="connsiteX85" y="connsiteY85"/>
              </a:cxn>
              <a:cxn ang="0">
                <a:pos x="connsiteX86" y="connsiteY86"/>
              </a:cxn>
              <a:cxn ang="0">
                <a:pos x="connsiteX87" y="connsiteY87"/>
              </a:cxn>
              <a:cxn ang="0">
                <a:pos x="connsiteX88" y="connsiteY88"/>
              </a:cxn>
              <a:cxn ang="0">
                <a:pos x="connsiteX89" y="connsiteY89"/>
              </a:cxn>
              <a:cxn ang="0">
                <a:pos x="connsiteX90" y="connsiteY90"/>
              </a:cxn>
              <a:cxn ang="0">
                <a:pos x="connsiteX91" y="connsiteY91"/>
              </a:cxn>
              <a:cxn ang="0">
                <a:pos x="connsiteX92" y="connsiteY92"/>
              </a:cxn>
              <a:cxn ang="0">
                <a:pos x="connsiteX93" y="connsiteY93"/>
              </a:cxn>
              <a:cxn ang="0">
                <a:pos x="connsiteX94" y="connsiteY94"/>
              </a:cxn>
              <a:cxn ang="0">
                <a:pos x="connsiteX95" y="connsiteY95"/>
              </a:cxn>
              <a:cxn ang="0">
                <a:pos x="connsiteX96" y="connsiteY96"/>
              </a:cxn>
              <a:cxn ang="0">
                <a:pos x="connsiteX97" y="connsiteY97"/>
              </a:cxn>
              <a:cxn ang="0">
                <a:pos x="connsiteX98" y="connsiteY98"/>
              </a:cxn>
              <a:cxn ang="0">
                <a:pos x="connsiteX99" y="connsiteY99"/>
              </a:cxn>
              <a:cxn ang="0">
                <a:pos x="connsiteX100" y="connsiteY100"/>
              </a:cxn>
              <a:cxn ang="0">
                <a:pos x="connsiteX101" y="connsiteY101"/>
              </a:cxn>
              <a:cxn ang="0">
                <a:pos x="connsiteX102" y="connsiteY102"/>
              </a:cxn>
              <a:cxn ang="0">
                <a:pos x="connsiteX103" y="connsiteY103"/>
              </a:cxn>
              <a:cxn ang="0">
                <a:pos x="connsiteX104" y="connsiteY104"/>
              </a:cxn>
              <a:cxn ang="0">
                <a:pos x="connsiteX105" y="connsiteY105"/>
              </a:cxn>
              <a:cxn ang="0">
                <a:pos x="connsiteX106" y="connsiteY106"/>
              </a:cxn>
              <a:cxn ang="0">
                <a:pos x="connsiteX107" y="connsiteY107"/>
              </a:cxn>
              <a:cxn ang="0">
                <a:pos x="connsiteX108" y="connsiteY108"/>
              </a:cxn>
              <a:cxn ang="0">
                <a:pos x="connsiteX109" y="connsiteY109"/>
              </a:cxn>
              <a:cxn ang="0">
                <a:pos x="connsiteX110" y="connsiteY110"/>
              </a:cxn>
              <a:cxn ang="0">
                <a:pos x="connsiteX111" y="connsiteY111"/>
              </a:cxn>
              <a:cxn ang="0">
                <a:pos x="connsiteX112" y="connsiteY112"/>
              </a:cxn>
              <a:cxn ang="0">
                <a:pos x="connsiteX113" y="connsiteY113"/>
              </a:cxn>
            </a:cxnLst>
            <a:rect l="l" t="t" r="r" b="b"/>
            <a:pathLst>
              <a:path w="1914525" h="223837">
                <a:moveTo>
                  <a:pt x="0" y="0"/>
                </a:moveTo>
                <a:cubicBezTo>
                  <a:pt x="38337" y="2738"/>
                  <a:pt x="22772" y="-1142"/>
                  <a:pt x="47625" y="7143"/>
                </a:cubicBezTo>
                <a:lnTo>
                  <a:pt x="69057" y="14287"/>
                </a:lnTo>
                <a:lnTo>
                  <a:pt x="76200" y="16668"/>
                </a:lnTo>
                <a:cubicBezTo>
                  <a:pt x="78581" y="19049"/>
                  <a:pt x="80757" y="21656"/>
                  <a:pt x="83344" y="23812"/>
                </a:cubicBezTo>
                <a:cubicBezTo>
                  <a:pt x="85543" y="25644"/>
                  <a:pt x="88349" y="26674"/>
                  <a:pt x="90488" y="28575"/>
                </a:cubicBezTo>
                <a:cubicBezTo>
                  <a:pt x="98448" y="35651"/>
                  <a:pt x="107988" y="48695"/>
                  <a:pt x="119063" y="52387"/>
                </a:cubicBezTo>
                <a:cubicBezTo>
                  <a:pt x="123825" y="53975"/>
                  <a:pt x="129173" y="54366"/>
                  <a:pt x="133350" y="57150"/>
                </a:cubicBezTo>
                <a:cubicBezTo>
                  <a:pt x="142583" y="63304"/>
                  <a:pt x="137779" y="61007"/>
                  <a:pt x="147638" y="64293"/>
                </a:cubicBezTo>
                <a:cubicBezTo>
                  <a:pt x="165100" y="63499"/>
                  <a:pt x="182644" y="63774"/>
                  <a:pt x="200025" y="61912"/>
                </a:cubicBezTo>
                <a:cubicBezTo>
                  <a:pt x="200037" y="61911"/>
                  <a:pt x="217880" y="55961"/>
                  <a:pt x="221457" y="54768"/>
                </a:cubicBezTo>
                <a:lnTo>
                  <a:pt x="242888" y="47625"/>
                </a:lnTo>
                <a:cubicBezTo>
                  <a:pt x="245269" y="46831"/>
                  <a:pt x="247943" y="46635"/>
                  <a:pt x="250032" y="45243"/>
                </a:cubicBezTo>
                <a:cubicBezTo>
                  <a:pt x="252413" y="43656"/>
                  <a:pt x="254560" y="41643"/>
                  <a:pt x="257175" y="40481"/>
                </a:cubicBezTo>
                <a:cubicBezTo>
                  <a:pt x="261763" y="38442"/>
                  <a:pt x="267286" y="38503"/>
                  <a:pt x="271463" y="35718"/>
                </a:cubicBezTo>
                <a:cubicBezTo>
                  <a:pt x="273844" y="34131"/>
                  <a:pt x="276047" y="32236"/>
                  <a:pt x="278607" y="30956"/>
                </a:cubicBezTo>
                <a:cubicBezTo>
                  <a:pt x="283993" y="28263"/>
                  <a:pt x="295467" y="26650"/>
                  <a:pt x="300038" y="26193"/>
                </a:cubicBezTo>
                <a:cubicBezTo>
                  <a:pt x="311123" y="25084"/>
                  <a:pt x="322263" y="24606"/>
                  <a:pt x="333375" y="23812"/>
                </a:cubicBezTo>
                <a:cubicBezTo>
                  <a:pt x="360365" y="25097"/>
                  <a:pt x="376488" y="24290"/>
                  <a:pt x="400050" y="28575"/>
                </a:cubicBezTo>
                <a:cubicBezTo>
                  <a:pt x="403270" y="29161"/>
                  <a:pt x="406375" y="30270"/>
                  <a:pt x="409575" y="30956"/>
                </a:cubicBezTo>
                <a:cubicBezTo>
                  <a:pt x="417490" y="32652"/>
                  <a:pt x="425709" y="33158"/>
                  <a:pt x="433388" y="35718"/>
                </a:cubicBezTo>
                <a:cubicBezTo>
                  <a:pt x="440200" y="37989"/>
                  <a:pt x="442577" y="38985"/>
                  <a:pt x="450057" y="40481"/>
                </a:cubicBezTo>
                <a:cubicBezTo>
                  <a:pt x="457337" y="41937"/>
                  <a:pt x="474146" y="44327"/>
                  <a:pt x="481013" y="45243"/>
                </a:cubicBezTo>
                <a:cubicBezTo>
                  <a:pt x="487356" y="46089"/>
                  <a:pt x="493734" y="46676"/>
                  <a:pt x="500063" y="47625"/>
                </a:cubicBezTo>
                <a:cubicBezTo>
                  <a:pt x="509613" y="49057"/>
                  <a:pt x="519270" y="50045"/>
                  <a:pt x="528638" y="52387"/>
                </a:cubicBezTo>
                <a:cubicBezTo>
                  <a:pt x="531813" y="53181"/>
                  <a:pt x="534928" y="54270"/>
                  <a:pt x="538163" y="54768"/>
                </a:cubicBezTo>
                <a:cubicBezTo>
                  <a:pt x="554289" y="57249"/>
                  <a:pt x="567581" y="56636"/>
                  <a:pt x="583407" y="61912"/>
                </a:cubicBezTo>
                <a:lnTo>
                  <a:pt x="604838" y="69056"/>
                </a:lnTo>
                <a:lnTo>
                  <a:pt x="611982" y="71437"/>
                </a:lnTo>
                <a:lnTo>
                  <a:pt x="619125" y="73818"/>
                </a:lnTo>
                <a:cubicBezTo>
                  <a:pt x="621506" y="75406"/>
                  <a:pt x="624245" y="76557"/>
                  <a:pt x="626269" y="78581"/>
                </a:cubicBezTo>
                <a:cubicBezTo>
                  <a:pt x="628293" y="80605"/>
                  <a:pt x="628797" y="83937"/>
                  <a:pt x="631032" y="85725"/>
                </a:cubicBezTo>
                <a:cubicBezTo>
                  <a:pt x="632992" y="87293"/>
                  <a:pt x="635794" y="87312"/>
                  <a:pt x="638175" y="88106"/>
                </a:cubicBezTo>
                <a:cubicBezTo>
                  <a:pt x="639763" y="90487"/>
                  <a:pt x="640784" y="93365"/>
                  <a:pt x="642938" y="95250"/>
                </a:cubicBezTo>
                <a:cubicBezTo>
                  <a:pt x="662957" y="112767"/>
                  <a:pt x="650197" y="100071"/>
                  <a:pt x="664369" y="107156"/>
                </a:cubicBezTo>
                <a:cubicBezTo>
                  <a:pt x="666929" y="108436"/>
                  <a:pt x="669132" y="110331"/>
                  <a:pt x="671513" y="111918"/>
                </a:cubicBezTo>
                <a:cubicBezTo>
                  <a:pt x="683419" y="111124"/>
                  <a:pt x="695372" y="110855"/>
                  <a:pt x="707232" y="109537"/>
                </a:cubicBezTo>
                <a:cubicBezTo>
                  <a:pt x="712189" y="108986"/>
                  <a:pt x="717876" y="105429"/>
                  <a:pt x="721519" y="102393"/>
                </a:cubicBezTo>
                <a:cubicBezTo>
                  <a:pt x="724106" y="100237"/>
                  <a:pt x="725861" y="97118"/>
                  <a:pt x="728663" y="95250"/>
                </a:cubicBezTo>
                <a:cubicBezTo>
                  <a:pt x="730752" y="93858"/>
                  <a:pt x="733562" y="93991"/>
                  <a:pt x="735807" y="92868"/>
                </a:cubicBezTo>
                <a:cubicBezTo>
                  <a:pt x="738366" y="91588"/>
                  <a:pt x="740390" y="89386"/>
                  <a:pt x="742950" y="88106"/>
                </a:cubicBezTo>
                <a:cubicBezTo>
                  <a:pt x="745195" y="86984"/>
                  <a:pt x="747672" y="86385"/>
                  <a:pt x="750094" y="85725"/>
                </a:cubicBezTo>
                <a:cubicBezTo>
                  <a:pt x="779636" y="77668"/>
                  <a:pt x="759844" y="84061"/>
                  <a:pt x="776288" y="78581"/>
                </a:cubicBezTo>
                <a:cubicBezTo>
                  <a:pt x="789782" y="79375"/>
                  <a:pt x="803366" y="79214"/>
                  <a:pt x="816769" y="80962"/>
                </a:cubicBezTo>
                <a:cubicBezTo>
                  <a:pt x="829026" y="82561"/>
                  <a:pt x="835386" y="88611"/>
                  <a:pt x="845344" y="95250"/>
                </a:cubicBezTo>
                <a:lnTo>
                  <a:pt x="852488" y="100012"/>
                </a:lnTo>
                <a:cubicBezTo>
                  <a:pt x="872963" y="113661"/>
                  <a:pt x="847058" y="97298"/>
                  <a:pt x="866775" y="107156"/>
                </a:cubicBezTo>
                <a:cubicBezTo>
                  <a:pt x="869335" y="108436"/>
                  <a:pt x="871304" y="110756"/>
                  <a:pt x="873919" y="111918"/>
                </a:cubicBezTo>
                <a:cubicBezTo>
                  <a:pt x="878507" y="113957"/>
                  <a:pt x="888207" y="116681"/>
                  <a:pt x="888207" y="116681"/>
                </a:cubicBezTo>
                <a:lnTo>
                  <a:pt x="902494" y="126206"/>
                </a:lnTo>
                <a:cubicBezTo>
                  <a:pt x="904875" y="127793"/>
                  <a:pt x="906923" y="130063"/>
                  <a:pt x="909638" y="130968"/>
                </a:cubicBezTo>
                <a:lnTo>
                  <a:pt x="916782" y="133350"/>
                </a:lnTo>
                <a:cubicBezTo>
                  <a:pt x="919163" y="135731"/>
                  <a:pt x="921123" y="138625"/>
                  <a:pt x="923925" y="140493"/>
                </a:cubicBezTo>
                <a:cubicBezTo>
                  <a:pt x="926014" y="141885"/>
                  <a:pt x="928574" y="142598"/>
                  <a:pt x="931069" y="142875"/>
                </a:cubicBezTo>
                <a:cubicBezTo>
                  <a:pt x="942929" y="144193"/>
                  <a:pt x="954882" y="144462"/>
                  <a:pt x="966788" y="145256"/>
                </a:cubicBezTo>
                <a:lnTo>
                  <a:pt x="981075" y="166687"/>
                </a:lnTo>
                <a:cubicBezTo>
                  <a:pt x="982663" y="169068"/>
                  <a:pt x="983457" y="172244"/>
                  <a:pt x="985838" y="173831"/>
                </a:cubicBezTo>
                <a:cubicBezTo>
                  <a:pt x="1006312" y="187479"/>
                  <a:pt x="980408" y="171116"/>
                  <a:pt x="1000125" y="180975"/>
                </a:cubicBezTo>
                <a:cubicBezTo>
                  <a:pt x="1002685" y="182255"/>
                  <a:pt x="1004654" y="184575"/>
                  <a:pt x="1007269" y="185737"/>
                </a:cubicBezTo>
                <a:cubicBezTo>
                  <a:pt x="1007271" y="185738"/>
                  <a:pt x="1025127" y="191690"/>
                  <a:pt x="1028700" y="192881"/>
                </a:cubicBezTo>
                <a:lnTo>
                  <a:pt x="1042988" y="197643"/>
                </a:lnTo>
                <a:cubicBezTo>
                  <a:pt x="1045369" y="198437"/>
                  <a:pt x="1048043" y="198633"/>
                  <a:pt x="1050132" y="200025"/>
                </a:cubicBezTo>
                <a:cubicBezTo>
                  <a:pt x="1059364" y="206179"/>
                  <a:pt x="1054560" y="203882"/>
                  <a:pt x="1064419" y="207168"/>
                </a:cubicBezTo>
                <a:cubicBezTo>
                  <a:pt x="1066800" y="208756"/>
                  <a:pt x="1068948" y="210769"/>
                  <a:pt x="1071563" y="211931"/>
                </a:cubicBezTo>
                <a:cubicBezTo>
                  <a:pt x="1076150" y="213970"/>
                  <a:pt x="1081088" y="215106"/>
                  <a:pt x="1085850" y="216693"/>
                </a:cubicBezTo>
                <a:lnTo>
                  <a:pt x="1092994" y="219075"/>
                </a:lnTo>
                <a:lnTo>
                  <a:pt x="1100138" y="221456"/>
                </a:lnTo>
                <a:lnTo>
                  <a:pt x="1107282" y="223837"/>
                </a:lnTo>
                <a:cubicBezTo>
                  <a:pt x="1111213" y="223400"/>
                  <a:pt x="1128877" y="222953"/>
                  <a:pt x="1135857" y="219075"/>
                </a:cubicBezTo>
                <a:cubicBezTo>
                  <a:pt x="1140860" y="216295"/>
                  <a:pt x="1150144" y="209550"/>
                  <a:pt x="1150144" y="209550"/>
                </a:cubicBezTo>
                <a:cubicBezTo>
                  <a:pt x="1156781" y="199594"/>
                  <a:pt x="1158420" y="195112"/>
                  <a:pt x="1166813" y="188118"/>
                </a:cubicBezTo>
                <a:cubicBezTo>
                  <a:pt x="1169012" y="186286"/>
                  <a:pt x="1171576" y="184943"/>
                  <a:pt x="1173957" y="183356"/>
                </a:cubicBezTo>
                <a:cubicBezTo>
                  <a:pt x="1179618" y="166371"/>
                  <a:pt x="1171591" y="186903"/>
                  <a:pt x="1183482" y="169068"/>
                </a:cubicBezTo>
                <a:cubicBezTo>
                  <a:pt x="1184874" y="166980"/>
                  <a:pt x="1184295" y="163885"/>
                  <a:pt x="1185863" y="161925"/>
                </a:cubicBezTo>
                <a:cubicBezTo>
                  <a:pt x="1189221" y="157728"/>
                  <a:pt x="1195443" y="156350"/>
                  <a:pt x="1200150" y="154781"/>
                </a:cubicBezTo>
                <a:cubicBezTo>
                  <a:pt x="1233488" y="155575"/>
                  <a:pt x="1266881" y="155082"/>
                  <a:pt x="1300163" y="157162"/>
                </a:cubicBezTo>
                <a:cubicBezTo>
                  <a:pt x="1316657" y="158193"/>
                  <a:pt x="1310563" y="161784"/>
                  <a:pt x="1321594" y="166687"/>
                </a:cubicBezTo>
                <a:cubicBezTo>
                  <a:pt x="1326182" y="168726"/>
                  <a:pt x="1331119" y="169862"/>
                  <a:pt x="1335882" y="171450"/>
                </a:cubicBezTo>
                <a:cubicBezTo>
                  <a:pt x="1338263" y="172244"/>
                  <a:pt x="1340937" y="172439"/>
                  <a:pt x="1343025" y="173831"/>
                </a:cubicBezTo>
                <a:cubicBezTo>
                  <a:pt x="1363498" y="187478"/>
                  <a:pt x="1337595" y="171116"/>
                  <a:pt x="1357313" y="180975"/>
                </a:cubicBezTo>
                <a:cubicBezTo>
                  <a:pt x="1375773" y="190205"/>
                  <a:pt x="1353650" y="182135"/>
                  <a:pt x="1371600" y="188118"/>
                </a:cubicBezTo>
                <a:cubicBezTo>
                  <a:pt x="1376363" y="191293"/>
                  <a:pt x="1384078" y="192213"/>
                  <a:pt x="1385888" y="197643"/>
                </a:cubicBezTo>
                <a:cubicBezTo>
                  <a:pt x="1389181" y="207525"/>
                  <a:pt x="1388227" y="209535"/>
                  <a:pt x="1402557" y="214312"/>
                </a:cubicBezTo>
                <a:lnTo>
                  <a:pt x="1416844" y="219075"/>
                </a:lnTo>
                <a:cubicBezTo>
                  <a:pt x="1431651" y="217729"/>
                  <a:pt x="1445227" y="216944"/>
                  <a:pt x="1459707" y="214312"/>
                </a:cubicBezTo>
                <a:cubicBezTo>
                  <a:pt x="1462927" y="213727"/>
                  <a:pt x="1466037" y="212641"/>
                  <a:pt x="1469232" y="211931"/>
                </a:cubicBezTo>
                <a:cubicBezTo>
                  <a:pt x="1480573" y="209411"/>
                  <a:pt x="1488505" y="208681"/>
                  <a:pt x="1500188" y="204787"/>
                </a:cubicBezTo>
                <a:cubicBezTo>
                  <a:pt x="1502569" y="203993"/>
                  <a:pt x="1504856" y="202819"/>
                  <a:pt x="1507332" y="202406"/>
                </a:cubicBezTo>
                <a:cubicBezTo>
                  <a:pt x="1514422" y="201224"/>
                  <a:pt x="1521631" y="200917"/>
                  <a:pt x="1528763" y="200025"/>
                </a:cubicBezTo>
                <a:cubicBezTo>
                  <a:pt x="1536820" y="199018"/>
                  <a:pt x="1549027" y="197340"/>
                  <a:pt x="1557338" y="195262"/>
                </a:cubicBezTo>
                <a:cubicBezTo>
                  <a:pt x="1559773" y="194653"/>
                  <a:pt x="1562060" y="193541"/>
                  <a:pt x="1564482" y="192881"/>
                </a:cubicBezTo>
                <a:cubicBezTo>
                  <a:pt x="1570797" y="191159"/>
                  <a:pt x="1577322" y="190188"/>
                  <a:pt x="1583532" y="188118"/>
                </a:cubicBezTo>
                <a:cubicBezTo>
                  <a:pt x="1585913" y="187324"/>
                  <a:pt x="1588430" y="186859"/>
                  <a:pt x="1590675" y="185737"/>
                </a:cubicBezTo>
                <a:cubicBezTo>
                  <a:pt x="1593235" y="184457"/>
                  <a:pt x="1595204" y="182137"/>
                  <a:pt x="1597819" y="180975"/>
                </a:cubicBezTo>
                <a:cubicBezTo>
                  <a:pt x="1602407" y="178936"/>
                  <a:pt x="1607344" y="177800"/>
                  <a:pt x="1612107" y="176212"/>
                </a:cubicBezTo>
                <a:lnTo>
                  <a:pt x="1619250" y="173831"/>
                </a:lnTo>
                <a:cubicBezTo>
                  <a:pt x="1621631" y="172243"/>
                  <a:pt x="1623834" y="170348"/>
                  <a:pt x="1626394" y="169068"/>
                </a:cubicBezTo>
                <a:cubicBezTo>
                  <a:pt x="1628639" y="167945"/>
                  <a:pt x="1631344" y="167906"/>
                  <a:pt x="1633538" y="166687"/>
                </a:cubicBezTo>
                <a:cubicBezTo>
                  <a:pt x="1638541" y="163907"/>
                  <a:pt x="1643778" y="161209"/>
                  <a:pt x="1647825" y="157162"/>
                </a:cubicBezTo>
                <a:cubicBezTo>
                  <a:pt x="1656993" y="147994"/>
                  <a:pt x="1652167" y="151886"/>
                  <a:pt x="1662113" y="145256"/>
                </a:cubicBezTo>
                <a:lnTo>
                  <a:pt x="1676400" y="123825"/>
                </a:lnTo>
                <a:cubicBezTo>
                  <a:pt x="1677988" y="121444"/>
                  <a:pt x="1678782" y="118269"/>
                  <a:pt x="1681163" y="116681"/>
                </a:cubicBezTo>
                <a:lnTo>
                  <a:pt x="1695450" y="107156"/>
                </a:lnTo>
                <a:cubicBezTo>
                  <a:pt x="1697831" y="105568"/>
                  <a:pt x="1700570" y="104417"/>
                  <a:pt x="1702594" y="102393"/>
                </a:cubicBezTo>
                <a:cubicBezTo>
                  <a:pt x="1711513" y="93475"/>
                  <a:pt x="1706543" y="96315"/>
                  <a:pt x="1716882" y="92868"/>
                </a:cubicBezTo>
                <a:cubicBezTo>
                  <a:pt x="1739293" y="70457"/>
                  <a:pt x="1703359" y="104261"/>
                  <a:pt x="1738313" y="80962"/>
                </a:cubicBezTo>
                <a:cubicBezTo>
                  <a:pt x="1740694" y="79375"/>
                  <a:pt x="1742842" y="77362"/>
                  <a:pt x="1745457" y="76200"/>
                </a:cubicBezTo>
                <a:cubicBezTo>
                  <a:pt x="1750044" y="74161"/>
                  <a:pt x="1754982" y="73025"/>
                  <a:pt x="1759744" y="71437"/>
                </a:cubicBezTo>
                <a:lnTo>
                  <a:pt x="1774032" y="66675"/>
                </a:lnTo>
                <a:cubicBezTo>
                  <a:pt x="1774045" y="66671"/>
                  <a:pt x="1788306" y="61915"/>
                  <a:pt x="1788319" y="61912"/>
                </a:cubicBezTo>
                <a:cubicBezTo>
                  <a:pt x="1792288" y="61118"/>
                  <a:pt x="1796320" y="60596"/>
                  <a:pt x="1800225" y="59531"/>
                </a:cubicBezTo>
                <a:cubicBezTo>
                  <a:pt x="1805068" y="58210"/>
                  <a:pt x="1809561" y="55593"/>
                  <a:pt x="1814513" y="54768"/>
                </a:cubicBezTo>
                <a:cubicBezTo>
                  <a:pt x="1831483" y="51940"/>
                  <a:pt x="1837343" y="50562"/>
                  <a:pt x="1857375" y="50006"/>
                </a:cubicBezTo>
                <a:cubicBezTo>
                  <a:pt x="1876418" y="49477"/>
                  <a:pt x="1895475" y="50006"/>
                  <a:pt x="1914525" y="50006"/>
                </a:cubicBezTo>
              </a:path>
            </a:pathLst>
          </a:custGeom>
          <a:noFill/>
          <a:ln w="38100">
            <a:solidFill>
              <a:schemeClr val="bg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9666"/>
          </a:p>
        </p:txBody>
      </p:sp>
      <p:sp>
        <p:nvSpPr>
          <p:cNvPr id="231" name="Freeform 230"/>
          <p:cNvSpPr/>
          <p:nvPr/>
        </p:nvSpPr>
        <p:spPr>
          <a:xfrm>
            <a:off x="18080257" y="5128706"/>
            <a:ext cx="4639118" cy="528498"/>
          </a:xfrm>
          <a:custGeom>
            <a:avLst/>
            <a:gdLst>
              <a:gd name="connsiteX0" fmla="*/ 0 w 1912143"/>
              <a:gd name="connsiteY0" fmla="*/ 0 h 204788"/>
              <a:gd name="connsiteX1" fmla="*/ 47625 w 1912143"/>
              <a:gd name="connsiteY1" fmla="*/ 2382 h 204788"/>
              <a:gd name="connsiteX2" fmla="*/ 61912 w 1912143"/>
              <a:gd name="connsiteY2" fmla="*/ 9525 h 204788"/>
              <a:gd name="connsiteX3" fmla="*/ 69056 w 1912143"/>
              <a:gd name="connsiteY3" fmla="*/ 11907 h 204788"/>
              <a:gd name="connsiteX4" fmla="*/ 83343 w 1912143"/>
              <a:gd name="connsiteY4" fmla="*/ 21432 h 204788"/>
              <a:gd name="connsiteX5" fmla="*/ 104775 w 1912143"/>
              <a:gd name="connsiteY5" fmla="*/ 33338 h 204788"/>
              <a:gd name="connsiteX6" fmla="*/ 119062 w 1912143"/>
              <a:gd name="connsiteY6" fmla="*/ 40482 h 204788"/>
              <a:gd name="connsiteX7" fmla="*/ 140493 w 1912143"/>
              <a:gd name="connsiteY7" fmla="*/ 50007 h 204788"/>
              <a:gd name="connsiteX8" fmla="*/ 147637 w 1912143"/>
              <a:gd name="connsiteY8" fmla="*/ 52388 h 204788"/>
              <a:gd name="connsiteX9" fmla="*/ 154781 w 1912143"/>
              <a:gd name="connsiteY9" fmla="*/ 54769 h 204788"/>
              <a:gd name="connsiteX10" fmla="*/ 204787 w 1912143"/>
              <a:gd name="connsiteY10" fmla="*/ 47625 h 204788"/>
              <a:gd name="connsiteX11" fmla="*/ 254793 w 1912143"/>
              <a:gd name="connsiteY11" fmla="*/ 30957 h 204788"/>
              <a:gd name="connsiteX12" fmla="*/ 269081 w 1912143"/>
              <a:gd name="connsiteY12" fmla="*/ 26194 h 204788"/>
              <a:gd name="connsiteX13" fmla="*/ 276225 w 1912143"/>
              <a:gd name="connsiteY13" fmla="*/ 23813 h 204788"/>
              <a:gd name="connsiteX14" fmla="*/ 311943 w 1912143"/>
              <a:gd name="connsiteY14" fmla="*/ 19050 h 204788"/>
              <a:gd name="connsiteX15" fmla="*/ 326231 w 1912143"/>
              <a:gd name="connsiteY15" fmla="*/ 16669 h 204788"/>
              <a:gd name="connsiteX16" fmla="*/ 350043 w 1912143"/>
              <a:gd name="connsiteY16" fmla="*/ 14288 h 204788"/>
              <a:gd name="connsiteX17" fmla="*/ 416718 w 1912143"/>
              <a:gd name="connsiteY17" fmla="*/ 16669 h 204788"/>
              <a:gd name="connsiteX18" fmla="*/ 423862 w 1912143"/>
              <a:gd name="connsiteY18" fmla="*/ 19050 h 204788"/>
              <a:gd name="connsiteX19" fmla="*/ 447675 w 1912143"/>
              <a:gd name="connsiteY19" fmla="*/ 23813 h 204788"/>
              <a:gd name="connsiteX20" fmla="*/ 454818 w 1912143"/>
              <a:gd name="connsiteY20" fmla="*/ 26194 h 204788"/>
              <a:gd name="connsiteX21" fmla="*/ 485775 w 1912143"/>
              <a:gd name="connsiteY21" fmla="*/ 30957 h 204788"/>
              <a:gd name="connsiteX22" fmla="*/ 509587 w 1912143"/>
              <a:gd name="connsiteY22" fmla="*/ 35719 h 204788"/>
              <a:gd name="connsiteX23" fmla="*/ 526256 w 1912143"/>
              <a:gd name="connsiteY23" fmla="*/ 40482 h 204788"/>
              <a:gd name="connsiteX24" fmla="*/ 538162 w 1912143"/>
              <a:gd name="connsiteY24" fmla="*/ 42863 h 204788"/>
              <a:gd name="connsiteX25" fmla="*/ 559593 w 1912143"/>
              <a:gd name="connsiteY25" fmla="*/ 47625 h 204788"/>
              <a:gd name="connsiteX26" fmla="*/ 573881 w 1912143"/>
              <a:gd name="connsiteY26" fmla="*/ 50007 h 204788"/>
              <a:gd name="connsiteX27" fmla="*/ 581025 w 1912143"/>
              <a:gd name="connsiteY27" fmla="*/ 52388 h 204788"/>
              <a:gd name="connsiteX28" fmla="*/ 602456 w 1912143"/>
              <a:gd name="connsiteY28" fmla="*/ 57150 h 204788"/>
              <a:gd name="connsiteX29" fmla="*/ 616743 w 1912143"/>
              <a:gd name="connsiteY29" fmla="*/ 61913 h 204788"/>
              <a:gd name="connsiteX30" fmla="*/ 631031 w 1912143"/>
              <a:gd name="connsiteY30" fmla="*/ 71438 h 204788"/>
              <a:gd name="connsiteX31" fmla="*/ 642937 w 1912143"/>
              <a:gd name="connsiteY31" fmla="*/ 80963 h 204788"/>
              <a:gd name="connsiteX32" fmla="*/ 647700 w 1912143"/>
              <a:gd name="connsiteY32" fmla="*/ 88107 h 204788"/>
              <a:gd name="connsiteX33" fmla="*/ 661987 w 1912143"/>
              <a:gd name="connsiteY33" fmla="*/ 92869 h 204788"/>
              <a:gd name="connsiteX34" fmla="*/ 669131 w 1912143"/>
              <a:gd name="connsiteY34" fmla="*/ 97632 h 204788"/>
              <a:gd name="connsiteX35" fmla="*/ 709612 w 1912143"/>
              <a:gd name="connsiteY35" fmla="*/ 95250 h 204788"/>
              <a:gd name="connsiteX36" fmla="*/ 716756 w 1912143"/>
              <a:gd name="connsiteY36" fmla="*/ 92869 h 204788"/>
              <a:gd name="connsiteX37" fmla="*/ 750093 w 1912143"/>
              <a:gd name="connsiteY37" fmla="*/ 85725 h 204788"/>
              <a:gd name="connsiteX38" fmla="*/ 835818 w 1912143"/>
              <a:gd name="connsiteY38" fmla="*/ 88107 h 204788"/>
              <a:gd name="connsiteX39" fmla="*/ 847725 w 1912143"/>
              <a:gd name="connsiteY39" fmla="*/ 90488 h 204788"/>
              <a:gd name="connsiteX40" fmla="*/ 862012 w 1912143"/>
              <a:gd name="connsiteY40" fmla="*/ 95250 h 204788"/>
              <a:gd name="connsiteX41" fmla="*/ 876300 w 1912143"/>
              <a:gd name="connsiteY41" fmla="*/ 104775 h 204788"/>
              <a:gd name="connsiteX42" fmla="*/ 883443 w 1912143"/>
              <a:gd name="connsiteY42" fmla="*/ 109538 h 204788"/>
              <a:gd name="connsiteX43" fmla="*/ 890587 w 1912143"/>
              <a:gd name="connsiteY43" fmla="*/ 111919 h 204788"/>
              <a:gd name="connsiteX44" fmla="*/ 897731 w 1912143"/>
              <a:gd name="connsiteY44" fmla="*/ 116682 h 204788"/>
              <a:gd name="connsiteX45" fmla="*/ 909637 w 1912143"/>
              <a:gd name="connsiteY45" fmla="*/ 119063 h 204788"/>
              <a:gd name="connsiteX46" fmla="*/ 923925 w 1912143"/>
              <a:gd name="connsiteY46" fmla="*/ 123825 h 204788"/>
              <a:gd name="connsiteX47" fmla="*/ 938212 w 1912143"/>
              <a:gd name="connsiteY47" fmla="*/ 128588 h 204788"/>
              <a:gd name="connsiteX48" fmla="*/ 945356 w 1912143"/>
              <a:gd name="connsiteY48" fmla="*/ 130969 h 204788"/>
              <a:gd name="connsiteX49" fmla="*/ 966787 w 1912143"/>
              <a:gd name="connsiteY49" fmla="*/ 142875 h 204788"/>
              <a:gd name="connsiteX50" fmla="*/ 973931 w 1912143"/>
              <a:gd name="connsiteY50" fmla="*/ 147638 h 204788"/>
              <a:gd name="connsiteX51" fmla="*/ 978693 w 1912143"/>
              <a:gd name="connsiteY51" fmla="*/ 154782 h 204788"/>
              <a:gd name="connsiteX52" fmla="*/ 985837 w 1912143"/>
              <a:gd name="connsiteY52" fmla="*/ 157163 h 204788"/>
              <a:gd name="connsiteX53" fmla="*/ 992981 w 1912143"/>
              <a:gd name="connsiteY53" fmla="*/ 161925 h 204788"/>
              <a:gd name="connsiteX54" fmla="*/ 1000125 w 1912143"/>
              <a:gd name="connsiteY54" fmla="*/ 169069 h 204788"/>
              <a:gd name="connsiteX55" fmla="*/ 1014412 w 1912143"/>
              <a:gd name="connsiteY55" fmla="*/ 173832 h 204788"/>
              <a:gd name="connsiteX56" fmla="*/ 1019175 w 1912143"/>
              <a:gd name="connsiteY56" fmla="*/ 180975 h 204788"/>
              <a:gd name="connsiteX57" fmla="*/ 1026318 w 1912143"/>
              <a:gd name="connsiteY57" fmla="*/ 183357 h 204788"/>
              <a:gd name="connsiteX58" fmla="*/ 1033462 w 1912143"/>
              <a:gd name="connsiteY58" fmla="*/ 188119 h 204788"/>
              <a:gd name="connsiteX59" fmla="*/ 1050131 w 1912143"/>
              <a:gd name="connsiteY59" fmla="*/ 192882 h 204788"/>
              <a:gd name="connsiteX60" fmla="*/ 1059656 w 1912143"/>
              <a:gd name="connsiteY60" fmla="*/ 197644 h 204788"/>
              <a:gd name="connsiteX61" fmla="*/ 1073943 w 1912143"/>
              <a:gd name="connsiteY61" fmla="*/ 202407 h 204788"/>
              <a:gd name="connsiteX62" fmla="*/ 1081087 w 1912143"/>
              <a:gd name="connsiteY62" fmla="*/ 204788 h 204788"/>
              <a:gd name="connsiteX63" fmla="*/ 1150143 w 1912143"/>
              <a:gd name="connsiteY63" fmla="*/ 202407 h 204788"/>
              <a:gd name="connsiteX64" fmla="*/ 1166812 w 1912143"/>
              <a:gd name="connsiteY64" fmla="*/ 197644 h 204788"/>
              <a:gd name="connsiteX65" fmla="*/ 1173956 w 1912143"/>
              <a:gd name="connsiteY65" fmla="*/ 192882 h 204788"/>
              <a:gd name="connsiteX66" fmla="*/ 1181100 w 1912143"/>
              <a:gd name="connsiteY66" fmla="*/ 190500 h 204788"/>
              <a:gd name="connsiteX67" fmla="*/ 1195387 w 1912143"/>
              <a:gd name="connsiteY67" fmla="*/ 183357 h 204788"/>
              <a:gd name="connsiteX68" fmla="*/ 1202531 w 1912143"/>
              <a:gd name="connsiteY68" fmla="*/ 176213 h 204788"/>
              <a:gd name="connsiteX69" fmla="*/ 1209675 w 1912143"/>
              <a:gd name="connsiteY69" fmla="*/ 171450 h 204788"/>
              <a:gd name="connsiteX70" fmla="*/ 1221581 w 1912143"/>
              <a:gd name="connsiteY70" fmla="*/ 159544 h 204788"/>
              <a:gd name="connsiteX71" fmla="*/ 1226343 w 1912143"/>
              <a:gd name="connsiteY71" fmla="*/ 152400 h 204788"/>
              <a:gd name="connsiteX72" fmla="*/ 1233487 w 1912143"/>
              <a:gd name="connsiteY72" fmla="*/ 150019 h 204788"/>
              <a:gd name="connsiteX73" fmla="*/ 1240631 w 1912143"/>
              <a:gd name="connsiteY73" fmla="*/ 145257 h 204788"/>
              <a:gd name="connsiteX74" fmla="*/ 1278731 w 1912143"/>
              <a:gd name="connsiteY74" fmla="*/ 147638 h 204788"/>
              <a:gd name="connsiteX75" fmla="*/ 1288256 w 1912143"/>
              <a:gd name="connsiteY75" fmla="*/ 150019 h 204788"/>
              <a:gd name="connsiteX76" fmla="*/ 1314450 w 1912143"/>
              <a:gd name="connsiteY76" fmla="*/ 157163 h 204788"/>
              <a:gd name="connsiteX77" fmla="*/ 1335881 w 1912143"/>
              <a:gd name="connsiteY77" fmla="*/ 164307 h 204788"/>
              <a:gd name="connsiteX78" fmla="*/ 1343025 w 1912143"/>
              <a:gd name="connsiteY78" fmla="*/ 166688 h 204788"/>
              <a:gd name="connsiteX79" fmla="*/ 1350168 w 1912143"/>
              <a:gd name="connsiteY79" fmla="*/ 171450 h 204788"/>
              <a:gd name="connsiteX80" fmla="*/ 1364456 w 1912143"/>
              <a:gd name="connsiteY80" fmla="*/ 176213 h 204788"/>
              <a:gd name="connsiteX81" fmla="*/ 1381125 w 1912143"/>
              <a:gd name="connsiteY81" fmla="*/ 183357 h 204788"/>
              <a:gd name="connsiteX82" fmla="*/ 1402556 w 1912143"/>
              <a:gd name="connsiteY82" fmla="*/ 192882 h 204788"/>
              <a:gd name="connsiteX83" fmla="*/ 1409700 w 1912143"/>
              <a:gd name="connsiteY83" fmla="*/ 195263 h 204788"/>
              <a:gd name="connsiteX84" fmla="*/ 1516856 w 1912143"/>
              <a:gd name="connsiteY84" fmla="*/ 192882 h 204788"/>
              <a:gd name="connsiteX85" fmla="*/ 1533525 w 1912143"/>
              <a:gd name="connsiteY85" fmla="*/ 188119 h 204788"/>
              <a:gd name="connsiteX86" fmla="*/ 1557337 w 1912143"/>
              <a:gd name="connsiteY86" fmla="*/ 183357 h 204788"/>
              <a:gd name="connsiteX87" fmla="*/ 1569243 w 1912143"/>
              <a:gd name="connsiteY87" fmla="*/ 180975 h 204788"/>
              <a:gd name="connsiteX88" fmla="*/ 1585912 w 1912143"/>
              <a:gd name="connsiteY88" fmla="*/ 176213 h 204788"/>
              <a:gd name="connsiteX89" fmla="*/ 1597818 w 1912143"/>
              <a:gd name="connsiteY89" fmla="*/ 173832 h 204788"/>
              <a:gd name="connsiteX90" fmla="*/ 1614487 w 1912143"/>
              <a:gd name="connsiteY90" fmla="*/ 169069 h 204788"/>
              <a:gd name="connsiteX91" fmla="*/ 1631156 w 1912143"/>
              <a:gd name="connsiteY91" fmla="*/ 164307 h 204788"/>
              <a:gd name="connsiteX92" fmla="*/ 1652587 w 1912143"/>
              <a:gd name="connsiteY92" fmla="*/ 150019 h 204788"/>
              <a:gd name="connsiteX93" fmla="*/ 1659731 w 1912143"/>
              <a:gd name="connsiteY93" fmla="*/ 145257 h 204788"/>
              <a:gd name="connsiteX94" fmla="*/ 1671637 w 1912143"/>
              <a:gd name="connsiteY94" fmla="*/ 130969 h 204788"/>
              <a:gd name="connsiteX95" fmla="*/ 1678781 w 1912143"/>
              <a:gd name="connsiteY95" fmla="*/ 126207 h 204788"/>
              <a:gd name="connsiteX96" fmla="*/ 1688306 w 1912143"/>
              <a:gd name="connsiteY96" fmla="*/ 116682 h 204788"/>
              <a:gd name="connsiteX97" fmla="*/ 1693068 w 1912143"/>
              <a:gd name="connsiteY97" fmla="*/ 109538 h 204788"/>
              <a:gd name="connsiteX98" fmla="*/ 1700212 w 1912143"/>
              <a:gd name="connsiteY98" fmla="*/ 104775 h 204788"/>
              <a:gd name="connsiteX99" fmla="*/ 1707356 w 1912143"/>
              <a:gd name="connsiteY99" fmla="*/ 97632 h 204788"/>
              <a:gd name="connsiteX100" fmla="*/ 1714500 w 1912143"/>
              <a:gd name="connsiteY100" fmla="*/ 92869 h 204788"/>
              <a:gd name="connsiteX101" fmla="*/ 1721643 w 1912143"/>
              <a:gd name="connsiteY101" fmla="*/ 85725 h 204788"/>
              <a:gd name="connsiteX102" fmla="*/ 1743075 w 1912143"/>
              <a:gd name="connsiteY102" fmla="*/ 73819 h 204788"/>
              <a:gd name="connsiteX103" fmla="*/ 1750218 w 1912143"/>
              <a:gd name="connsiteY103" fmla="*/ 69057 h 204788"/>
              <a:gd name="connsiteX104" fmla="*/ 1764506 w 1912143"/>
              <a:gd name="connsiteY104" fmla="*/ 64294 h 204788"/>
              <a:gd name="connsiteX105" fmla="*/ 1778793 w 1912143"/>
              <a:gd name="connsiteY105" fmla="*/ 59532 h 204788"/>
              <a:gd name="connsiteX106" fmla="*/ 1793081 w 1912143"/>
              <a:gd name="connsiteY106" fmla="*/ 54769 h 204788"/>
              <a:gd name="connsiteX107" fmla="*/ 1809750 w 1912143"/>
              <a:gd name="connsiteY107" fmla="*/ 50007 h 204788"/>
              <a:gd name="connsiteX108" fmla="*/ 1838325 w 1912143"/>
              <a:gd name="connsiteY108" fmla="*/ 45244 h 204788"/>
              <a:gd name="connsiteX109" fmla="*/ 1850231 w 1912143"/>
              <a:gd name="connsiteY109" fmla="*/ 42863 h 204788"/>
              <a:gd name="connsiteX110" fmla="*/ 1912143 w 1912143"/>
              <a:gd name="connsiteY110" fmla="*/ 42863 h 20478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  <a:cxn ang="0">
                <a:pos x="connsiteX31" y="connsiteY31"/>
              </a:cxn>
              <a:cxn ang="0">
                <a:pos x="connsiteX32" y="connsiteY32"/>
              </a:cxn>
              <a:cxn ang="0">
                <a:pos x="connsiteX33" y="connsiteY33"/>
              </a:cxn>
              <a:cxn ang="0">
                <a:pos x="connsiteX34" y="connsiteY34"/>
              </a:cxn>
              <a:cxn ang="0">
                <a:pos x="connsiteX35" y="connsiteY35"/>
              </a:cxn>
              <a:cxn ang="0">
                <a:pos x="connsiteX36" y="connsiteY36"/>
              </a:cxn>
              <a:cxn ang="0">
                <a:pos x="connsiteX37" y="connsiteY37"/>
              </a:cxn>
              <a:cxn ang="0">
                <a:pos x="connsiteX38" y="connsiteY38"/>
              </a:cxn>
              <a:cxn ang="0">
                <a:pos x="connsiteX39" y="connsiteY39"/>
              </a:cxn>
              <a:cxn ang="0">
                <a:pos x="connsiteX40" y="connsiteY40"/>
              </a:cxn>
              <a:cxn ang="0">
                <a:pos x="connsiteX41" y="connsiteY41"/>
              </a:cxn>
              <a:cxn ang="0">
                <a:pos x="connsiteX42" y="connsiteY42"/>
              </a:cxn>
              <a:cxn ang="0">
                <a:pos x="connsiteX43" y="connsiteY43"/>
              </a:cxn>
              <a:cxn ang="0">
                <a:pos x="connsiteX44" y="connsiteY44"/>
              </a:cxn>
              <a:cxn ang="0">
                <a:pos x="connsiteX45" y="connsiteY45"/>
              </a:cxn>
              <a:cxn ang="0">
                <a:pos x="connsiteX46" y="connsiteY46"/>
              </a:cxn>
              <a:cxn ang="0">
                <a:pos x="connsiteX47" y="connsiteY47"/>
              </a:cxn>
              <a:cxn ang="0">
                <a:pos x="connsiteX48" y="connsiteY48"/>
              </a:cxn>
              <a:cxn ang="0">
                <a:pos x="connsiteX49" y="connsiteY49"/>
              </a:cxn>
              <a:cxn ang="0">
                <a:pos x="connsiteX50" y="connsiteY50"/>
              </a:cxn>
              <a:cxn ang="0">
                <a:pos x="connsiteX51" y="connsiteY51"/>
              </a:cxn>
              <a:cxn ang="0">
                <a:pos x="connsiteX52" y="connsiteY52"/>
              </a:cxn>
              <a:cxn ang="0">
                <a:pos x="connsiteX53" y="connsiteY53"/>
              </a:cxn>
              <a:cxn ang="0">
                <a:pos x="connsiteX54" y="connsiteY54"/>
              </a:cxn>
              <a:cxn ang="0">
                <a:pos x="connsiteX55" y="connsiteY55"/>
              </a:cxn>
              <a:cxn ang="0">
                <a:pos x="connsiteX56" y="connsiteY56"/>
              </a:cxn>
              <a:cxn ang="0">
                <a:pos x="connsiteX57" y="connsiteY57"/>
              </a:cxn>
              <a:cxn ang="0">
                <a:pos x="connsiteX58" y="connsiteY58"/>
              </a:cxn>
              <a:cxn ang="0">
                <a:pos x="connsiteX59" y="connsiteY59"/>
              </a:cxn>
              <a:cxn ang="0">
                <a:pos x="connsiteX60" y="connsiteY60"/>
              </a:cxn>
              <a:cxn ang="0">
                <a:pos x="connsiteX61" y="connsiteY61"/>
              </a:cxn>
              <a:cxn ang="0">
                <a:pos x="connsiteX62" y="connsiteY62"/>
              </a:cxn>
              <a:cxn ang="0">
                <a:pos x="connsiteX63" y="connsiteY63"/>
              </a:cxn>
              <a:cxn ang="0">
                <a:pos x="connsiteX64" y="connsiteY64"/>
              </a:cxn>
              <a:cxn ang="0">
                <a:pos x="connsiteX65" y="connsiteY65"/>
              </a:cxn>
              <a:cxn ang="0">
                <a:pos x="connsiteX66" y="connsiteY66"/>
              </a:cxn>
              <a:cxn ang="0">
                <a:pos x="connsiteX67" y="connsiteY67"/>
              </a:cxn>
              <a:cxn ang="0">
                <a:pos x="connsiteX68" y="connsiteY68"/>
              </a:cxn>
              <a:cxn ang="0">
                <a:pos x="connsiteX69" y="connsiteY69"/>
              </a:cxn>
              <a:cxn ang="0">
                <a:pos x="connsiteX70" y="connsiteY70"/>
              </a:cxn>
              <a:cxn ang="0">
                <a:pos x="connsiteX71" y="connsiteY71"/>
              </a:cxn>
              <a:cxn ang="0">
                <a:pos x="connsiteX72" y="connsiteY72"/>
              </a:cxn>
              <a:cxn ang="0">
                <a:pos x="connsiteX73" y="connsiteY73"/>
              </a:cxn>
              <a:cxn ang="0">
                <a:pos x="connsiteX74" y="connsiteY74"/>
              </a:cxn>
              <a:cxn ang="0">
                <a:pos x="connsiteX75" y="connsiteY75"/>
              </a:cxn>
              <a:cxn ang="0">
                <a:pos x="connsiteX76" y="connsiteY76"/>
              </a:cxn>
              <a:cxn ang="0">
                <a:pos x="connsiteX77" y="connsiteY77"/>
              </a:cxn>
              <a:cxn ang="0">
                <a:pos x="connsiteX78" y="connsiteY78"/>
              </a:cxn>
              <a:cxn ang="0">
                <a:pos x="connsiteX79" y="connsiteY79"/>
              </a:cxn>
              <a:cxn ang="0">
                <a:pos x="connsiteX80" y="connsiteY80"/>
              </a:cxn>
              <a:cxn ang="0">
                <a:pos x="connsiteX81" y="connsiteY81"/>
              </a:cxn>
              <a:cxn ang="0">
                <a:pos x="connsiteX82" y="connsiteY82"/>
              </a:cxn>
              <a:cxn ang="0">
                <a:pos x="connsiteX83" y="connsiteY83"/>
              </a:cxn>
              <a:cxn ang="0">
                <a:pos x="connsiteX84" y="connsiteY84"/>
              </a:cxn>
              <a:cxn ang="0">
                <a:pos x="connsiteX85" y="connsiteY85"/>
              </a:cxn>
              <a:cxn ang="0">
                <a:pos x="connsiteX86" y="connsiteY86"/>
              </a:cxn>
              <a:cxn ang="0">
                <a:pos x="connsiteX87" y="connsiteY87"/>
              </a:cxn>
              <a:cxn ang="0">
                <a:pos x="connsiteX88" y="connsiteY88"/>
              </a:cxn>
              <a:cxn ang="0">
                <a:pos x="connsiteX89" y="connsiteY89"/>
              </a:cxn>
              <a:cxn ang="0">
                <a:pos x="connsiteX90" y="connsiteY90"/>
              </a:cxn>
              <a:cxn ang="0">
                <a:pos x="connsiteX91" y="connsiteY91"/>
              </a:cxn>
              <a:cxn ang="0">
                <a:pos x="connsiteX92" y="connsiteY92"/>
              </a:cxn>
              <a:cxn ang="0">
                <a:pos x="connsiteX93" y="connsiteY93"/>
              </a:cxn>
              <a:cxn ang="0">
                <a:pos x="connsiteX94" y="connsiteY94"/>
              </a:cxn>
              <a:cxn ang="0">
                <a:pos x="connsiteX95" y="connsiteY95"/>
              </a:cxn>
              <a:cxn ang="0">
                <a:pos x="connsiteX96" y="connsiteY96"/>
              </a:cxn>
              <a:cxn ang="0">
                <a:pos x="connsiteX97" y="connsiteY97"/>
              </a:cxn>
              <a:cxn ang="0">
                <a:pos x="connsiteX98" y="connsiteY98"/>
              </a:cxn>
              <a:cxn ang="0">
                <a:pos x="connsiteX99" y="connsiteY99"/>
              </a:cxn>
              <a:cxn ang="0">
                <a:pos x="connsiteX100" y="connsiteY100"/>
              </a:cxn>
              <a:cxn ang="0">
                <a:pos x="connsiteX101" y="connsiteY101"/>
              </a:cxn>
              <a:cxn ang="0">
                <a:pos x="connsiteX102" y="connsiteY102"/>
              </a:cxn>
              <a:cxn ang="0">
                <a:pos x="connsiteX103" y="connsiteY103"/>
              </a:cxn>
              <a:cxn ang="0">
                <a:pos x="connsiteX104" y="connsiteY104"/>
              </a:cxn>
              <a:cxn ang="0">
                <a:pos x="connsiteX105" y="connsiteY105"/>
              </a:cxn>
              <a:cxn ang="0">
                <a:pos x="connsiteX106" y="connsiteY106"/>
              </a:cxn>
              <a:cxn ang="0">
                <a:pos x="connsiteX107" y="connsiteY107"/>
              </a:cxn>
              <a:cxn ang="0">
                <a:pos x="connsiteX108" y="connsiteY108"/>
              </a:cxn>
              <a:cxn ang="0">
                <a:pos x="connsiteX109" y="connsiteY109"/>
              </a:cxn>
              <a:cxn ang="0">
                <a:pos x="connsiteX110" y="connsiteY110"/>
              </a:cxn>
            </a:cxnLst>
            <a:rect l="l" t="t" r="r" b="b"/>
            <a:pathLst>
              <a:path w="1912143" h="204788">
                <a:moveTo>
                  <a:pt x="0" y="0"/>
                </a:moveTo>
                <a:cubicBezTo>
                  <a:pt x="15875" y="794"/>
                  <a:pt x="31790" y="1005"/>
                  <a:pt x="47625" y="2382"/>
                </a:cubicBezTo>
                <a:cubicBezTo>
                  <a:pt x="54868" y="3012"/>
                  <a:pt x="55661" y="6400"/>
                  <a:pt x="61912" y="9525"/>
                </a:cubicBezTo>
                <a:cubicBezTo>
                  <a:pt x="64157" y="10648"/>
                  <a:pt x="66862" y="10688"/>
                  <a:pt x="69056" y="11907"/>
                </a:cubicBezTo>
                <a:cubicBezTo>
                  <a:pt x="74059" y="14687"/>
                  <a:pt x="77913" y="19622"/>
                  <a:pt x="83343" y="21432"/>
                </a:cubicBezTo>
                <a:cubicBezTo>
                  <a:pt x="95917" y="25623"/>
                  <a:pt x="88399" y="22421"/>
                  <a:pt x="104775" y="33338"/>
                </a:cubicBezTo>
                <a:cubicBezTo>
                  <a:pt x="125241" y="46982"/>
                  <a:pt x="99348" y="30625"/>
                  <a:pt x="119062" y="40482"/>
                </a:cubicBezTo>
                <a:cubicBezTo>
                  <a:pt x="141697" y="51800"/>
                  <a:pt x="103645" y="37724"/>
                  <a:pt x="140493" y="50007"/>
                </a:cubicBezTo>
                <a:lnTo>
                  <a:pt x="147637" y="52388"/>
                </a:lnTo>
                <a:lnTo>
                  <a:pt x="154781" y="54769"/>
                </a:lnTo>
                <a:cubicBezTo>
                  <a:pt x="169737" y="53409"/>
                  <a:pt x="190196" y="52488"/>
                  <a:pt x="204787" y="47625"/>
                </a:cubicBezTo>
                <a:lnTo>
                  <a:pt x="254793" y="30957"/>
                </a:lnTo>
                <a:lnTo>
                  <a:pt x="269081" y="26194"/>
                </a:lnTo>
                <a:cubicBezTo>
                  <a:pt x="271462" y="25400"/>
                  <a:pt x="273749" y="24226"/>
                  <a:pt x="276225" y="23813"/>
                </a:cubicBezTo>
                <a:cubicBezTo>
                  <a:pt x="309344" y="18294"/>
                  <a:pt x="268233" y="24879"/>
                  <a:pt x="311943" y="19050"/>
                </a:cubicBezTo>
                <a:cubicBezTo>
                  <a:pt x="316729" y="18412"/>
                  <a:pt x="321440" y="17268"/>
                  <a:pt x="326231" y="16669"/>
                </a:cubicBezTo>
                <a:cubicBezTo>
                  <a:pt x="334146" y="15680"/>
                  <a:pt x="342106" y="15082"/>
                  <a:pt x="350043" y="14288"/>
                </a:cubicBezTo>
                <a:cubicBezTo>
                  <a:pt x="372268" y="15082"/>
                  <a:pt x="394525" y="15237"/>
                  <a:pt x="416718" y="16669"/>
                </a:cubicBezTo>
                <a:cubicBezTo>
                  <a:pt x="419223" y="16831"/>
                  <a:pt x="421416" y="18486"/>
                  <a:pt x="423862" y="19050"/>
                </a:cubicBezTo>
                <a:cubicBezTo>
                  <a:pt x="431750" y="20870"/>
                  <a:pt x="439996" y="21253"/>
                  <a:pt x="447675" y="23813"/>
                </a:cubicBezTo>
                <a:cubicBezTo>
                  <a:pt x="450056" y="24607"/>
                  <a:pt x="452368" y="25650"/>
                  <a:pt x="454818" y="26194"/>
                </a:cubicBezTo>
                <a:cubicBezTo>
                  <a:pt x="464104" y="28257"/>
                  <a:pt x="476577" y="29334"/>
                  <a:pt x="485775" y="30957"/>
                </a:cubicBezTo>
                <a:cubicBezTo>
                  <a:pt x="493746" y="32364"/>
                  <a:pt x="501908" y="33160"/>
                  <a:pt x="509587" y="35719"/>
                </a:cubicBezTo>
                <a:cubicBezTo>
                  <a:pt x="517537" y="38369"/>
                  <a:pt x="517294" y="38490"/>
                  <a:pt x="526256" y="40482"/>
                </a:cubicBezTo>
                <a:cubicBezTo>
                  <a:pt x="530207" y="41360"/>
                  <a:pt x="534211" y="41985"/>
                  <a:pt x="538162" y="42863"/>
                </a:cubicBezTo>
                <a:cubicBezTo>
                  <a:pt x="555373" y="46687"/>
                  <a:pt x="539828" y="44031"/>
                  <a:pt x="559593" y="47625"/>
                </a:cubicBezTo>
                <a:cubicBezTo>
                  <a:pt x="564344" y="48489"/>
                  <a:pt x="569168" y="48960"/>
                  <a:pt x="573881" y="50007"/>
                </a:cubicBezTo>
                <a:cubicBezTo>
                  <a:pt x="576331" y="50552"/>
                  <a:pt x="578590" y="51779"/>
                  <a:pt x="581025" y="52388"/>
                </a:cubicBezTo>
                <a:cubicBezTo>
                  <a:pt x="594604" y="55783"/>
                  <a:pt x="590246" y="53487"/>
                  <a:pt x="602456" y="57150"/>
                </a:cubicBezTo>
                <a:cubicBezTo>
                  <a:pt x="607264" y="58593"/>
                  <a:pt x="612566" y="59128"/>
                  <a:pt x="616743" y="61913"/>
                </a:cubicBezTo>
                <a:lnTo>
                  <a:pt x="631031" y="71438"/>
                </a:lnTo>
                <a:cubicBezTo>
                  <a:pt x="644676" y="91909"/>
                  <a:pt x="626508" y="67820"/>
                  <a:pt x="642937" y="80963"/>
                </a:cubicBezTo>
                <a:cubicBezTo>
                  <a:pt x="645172" y="82751"/>
                  <a:pt x="645273" y="86590"/>
                  <a:pt x="647700" y="88107"/>
                </a:cubicBezTo>
                <a:cubicBezTo>
                  <a:pt x="651957" y="90768"/>
                  <a:pt x="661987" y="92869"/>
                  <a:pt x="661987" y="92869"/>
                </a:cubicBezTo>
                <a:cubicBezTo>
                  <a:pt x="664368" y="94457"/>
                  <a:pt x="666273" y="97489"/>
                  <a:pt x="669131" y="97632"/>
                </a:cubicBezTo>
                <a:cubicBezTo>
                  <a:pt x="682631" y="98307"/>
                  <a:pt x="696162" y="96595"/>
                  <a:pt x="709612" y="95250"/>
                </a:cubicBezTo>
                <a:cubicBezTo>
                  <a:pt x="712110" y="95000"/>
                  <a:pt x="714334" y="93529"/>
                  <a:pt x="716756" y="92869"/>
                </a:cubicBezTo>
                <a:cubicBezTo>
                  <a:pt x="735401" y="87785"/>
                  <a:pt x="733104" y="88558"/>
                  <a:pt x="750093" y="85725"/>
                </a:cubicBezTo>
                <a:cubicBezTo>
                  <a:pt x="778668" y="86519"/>
                  <a:pt x="807266" y="86714"/>
                  <a:pt x="835818" y="88107"/>
                </a:cubicBezTo>
                <a:cubicBezTo>
                  <a:pt x="839861" y="88304"/>
                  <a:pt x="843820" y="89423"/>
                  <a:pt x="847725" y="90488"/>
                </a:cubicBezTo>
                <a:cubicBezTo>
                  <a:pt x="852568" y="91809"/>
                  <a:pt x="862012" y="95250"/>
                  <a:pt x="862012" y="95250"/>
                </a:cubicBezTo>
                <a:lnTo>
                  <a:pt x="876300" y="104775"/>
                </a:lnTo>
                <a:cubicBezTo>
                  <a:pt x="878681" y="106362"/>
                  <a:pt x="880728" y="108633"/>
                  <a:pt x="883443" y="109538"/>
                </a:cubicBezTo>
                <a:lnTo>
                  <a:pt x="890587" y="111919"/>
                </a:lnTo>
                <a:cubicBezTo>
                  <a:pt x="892968" y="113507"/>
                  <a:pt x="895051" y="115677"/>
                  <a:pt x="897731" y="116682"/>
                </a:cubicBezTo>
                <a:cubicBezTo>
                  <a:pt x="901521" y="118103"/>
                  <a:pt x="905732" y="117998"/>
                  <a:pt x="909637" y="119063"/>
                </a:cubicBezTo>
                <a:cubicBezTo>
                  <a:pt x="914480" y="120384"/>
                  <a:pt x="919162" y="122237"/>
                  <a:pt x="923925" y="123825"/>
                </a:cubicBezTo>
                <a:lnTo>
                  <a:pt x="938212" y="128588"/>
                </a:lnTo>
                <a:lnTo>
                  <a:pt x="945356" y="130969"/>
                </a:lnTo>
                <a:cubicBezTo>
                  <a:pt x="961732" y="141886"/>
                  <a:pt x="954213" y="138684"/>
                  <a:pt x="966787" y="142875"/>
                </a:cubicBezTo>
                <a:cubicBezTo>
                  <a:pt x="969168" y="144463"/>
                  <a:pt x="971907" y="145614"/>
                  <a:pt x="973931" y="147638"/>
                </a:cubicBezTo>
                <a:cubicBezTo>
                  <a:pt x="975955" y="149662"/>
                  <a:pt x="976458" y="152994"/>
                  <a:pt x="978693" y="154782"/>
                </a:cubicBezTo>
                <a:cubicBezTo>
                  <a:pt x="980653" y="156350"/>
                  <a:pt x="983592" y="156041"/>
                  <a:pt x="985837" y="157163"/>
                </a:cubicBezTo>
                <a:cubicBezTo>
                  <a:pt x="988397" y="158443"/>
                  <a:pt x="990782" y="160093"/>
                  <a:pt x="992981" y="161925"/>
                </a:cubicBezTo>
                <a:cubicBezTo>
                  <a:pt x="995568" y="164081"/>
                  <a:pt x="997181" y="167433"/>
                  <a:pt x="1000125" y="169069"/>
                </a:cubicBezTo>
                <a:cubicBezTo>
                  <a:pt x="1004513" y="171507"/>
                  <a:pt x="1014412" y="173832"/>
                  <a:pt x="1014412" y="173832"/>
                </a:cubicBezTo>
                <a:cubicBezTo>
                  <a:pt x="1016000" y="176213"/>
                  <a:pt x="1016940" y="179187"/>
                  <a:pt x="1019175" y="180975"/>
                </a:cubicBezTo>
                <a:cubicBezTo>
                  <a:pt x="1021135" y="182543"/>
                  <a:pt x="1024073" y="182234"/>
                  <a:pt x="1026318" y="183357"/>
                </a:cubicBezTo>
                <a:cubicBezTo>
                  <a:pt x="1028878" y="184637"/>
                  <a:pt x="1030902" y="186839"/>
                  <a:pt x="1033462" y="188119"/>
                </a:cubicBezTo>
                <a:cubicBezTo>
                  <a:pt x="1039213" y="190994"/>
                  <a:pt x="1044036" y="190596"/>
                  <a:pt x="1050131" y="192882"/>
                </a:cubicBezTo>
                <a:cubicBezTo>
                  <a:pt x="1053455" y="194128"/>
                  <a:pt x="1056360" y="196326"/>
                  <a:pt x="1059656" y="197644"/>
                </a:cubicBezTo>
                <a:cubicBezTo>
                  <a:pt x="1064317" y="199508"/>
                  <a:pt x="1069181" y="200819"/>
                  <a:pt x="1073943" y="202407"/>
                </a:cubicBezTo>
                <a:lnTo>
                  <a:pt x="1081087" y="204788"/>
                </a:lnTo>
                <a:cubicBezTo>
                  <a:pt x="1104106" y="203994"/>
                  <a:pt x="1127153" y="203800"/>
                  <a:pt x="1150143" y="202407"/>
                </a:cubicBezTo>
                <a:cubicBezTo>
                  <a:pt x="1151876" y="202302"/>
                  <a:pt x="1164407" y="198846"/>
                  <a:pt x="1166812" y="197644"/>
                </a:cubicBezTo>
                <a:cubicBezTo>
                  <a:pt x="1169372" y="196364"/>
                  <a:pt x="1171396" y="194162"/>
                  <a:pt x="1173956" y="192882"/>
                </a:cubicBezTo>
                <a:cubicBezTo>
                  <a:pt x="1176201" y="191759"/>
                  <a:pt x="1178855" y="191623"/>
                  <a:pt x="1181100" y="190500"/>
                </a:cubicBezTo>
                <a:cubicBezTo>
                  <a:pt x="1199557" y="181271"/>
                  <a:pt x="1177436" y="189340"/>
                  <a:pt x="1195387" y="183357"/>
                </a:cubicBezTo>
                <a:cubicBezTo>
                  <a:pt x="1197768" y="180976"/>
                  <a:pt x="1199944" y="178369"/>
                  <a:pt x="1202531" y="176213"/>
                </a:cubicBezTo>
                <a:cubicBezTo>
                  <a:pt x="1204730" y="174381"/>
                  <a:pt x="1207651" y="173474"/>
                  <a:pt x="1209675" y="171450"/>
                </a:cubicBezTo>
                <a:cubicBezTo>
                  <a:pt x="1225550" y="155575"/>
                  <a:pt x="1202529" y="172246"/>
                  <a:pt x="1221581" y="159544"/>
                </a:cubicBezTo>
                <a:cubicBezTo>
                  <a:pt x="1223168" y="157163"/>
                  <a:pt x="1224108" y="154188"/>
                  <a:pt x="1226343" y="152400"/>
                </a:cubicBezTo>
                <a:cubicBezTo>
                  <a:pt x="1228303" y="150832"/>
                  <a:pt x="1231242" y="151141"/>
                  <a:pt x="1233487" y="150019"/>
                </a:cubicBezTo>
                <a:cubicBezTo>
                  <a:pt x="1236047" y="148739"/>
                  <a:pt x="1238250" y="146844"/>
                  <a:pt x="1240631" y="145257"/>
                </a:cubicBezTo>
                <a:cubicBezTo>
                  <a:pt x="1253331" y="146051"/>
                  <a:pt x="1266069" y="146372"/>
                  <a:pt x="1278731" y="147638"/>
                </a:cubicBezTo>
                <a:cubicBezTo>
                  <a:pt x="1281987" y="147964"/>
                  <a:pt x="1285061" y="149309"/>
                  <a:pt x="1288256" y="150019"/>
                </a:cubicBezTo>
                <a:cubicBezTo>
                  <a:pt x="1308450" y="154506"/>
                  <a:pt x="1292148" y="149729"/>
                  <a:pt x="1314450" y="157163"/>
                </a:cubicBezTo>
                <a:lnTo>
                  <a:pt x="1335881" y="164307"/>
                </a:lnTo>
                <a:lnTo>
                  <a:pt x="1343025" y="166688"/>
                </a:lnTo>
                <a:cubicBezTo>
                  <a:pt x="1345406" y="168275"/>
                  <a:pt x="1347553" y="170288"/>
                  <a:pt x="1350168" y="171450"/>
                </a:cubicBezTo>
                <a:cubicBezTo>
                  <a:pt x="1354756" y="173489"/>
                  <a:pt x="1360279" y="173428"/>
                  <a:pt x="1364456" y="176213"/>
                </a:cubicBezTo>
                <a:cubicBezTo>
                  <a:pt x="1374323" y="182790"/>
                  <a:pt x="1368824" y="180281"/>
                  <a:pt x="1381125" y="183357"/>
                </a:cubicBezTo>
                <a:cubicBezTo>
                  <a:pt x="1392444" y="190903"/>
                  <a:pt x="1385554" y="187215"/>
                  <a:pt x="1402556" y="192882"/>
                </a:cubicBezTo>
                <a:lnTo>
                  <a:pt x="1409700" y="195263"/>
                </a:lnTo>
                <a:lnTo>
                  <a:pt x="1516856" y="192882"/>
                </a:lnTo>
                <a:cubicBezTo>
                  <a:pt x="1522853" y="192637"/>
                  <a:pt x="1527850" y="189429"/>
                  <a:pt x="1533525" y="188119"/>
                </a:cubicBezTo>
                <a:cubicBezTo>
                  <a:pt x="1541412" y="186299"/>
                  <a:pt x="1549400" y="184945"/>
                  <a:pt x="1557337" y="183357"/>
                </a:cubicBezTo>
                <a:cubicBezTo>
                  <a:pt x="1561306" y="182563"/>
                  <a:pt x="1565403" y="182255"/>
                  <a:pt x="1569243" y="180975"/>
                </a:cubicBezTo>
                <a:cubicBezTo>
                  <a:pt x="1577198" y="178324"/>
                  <a:pt x="1576942" y="178206"/>
                  <a:pt x="1585912" y="176213"/>
                </a:cubicBezTo>
                <a:cubicBezTo>
                  <a:pt x="1589863" y="175335"/>
                  <a:pt x="1593867" y="174710"/>
                  <a:pt x="1597818" y="173832"/>
                </a:cubicBezTo>
                <a:cubicBezTo>
                  <a:pt x="1614560" y="170111"/>
                  <a:pt x="1600571" y="173045"/>
                  <a:pt x="1614487" y="169069"/>
                </a:cubicBezTo>
                <a:cubicBezTo>
                  <a:pt x="1635418" y="163090"/>
                  <a:pt x="1614027" y="170016"/>
                  <a:pt x="1631156" y="164307"/>
                </a:cubicBezTo>
                <a:lnTo>
                  <a:pt x="1652587" y="150019"/>
                </a:lnTo>
                <a:lnTo>
                  <a:pt x="1659731" y="145257"/>
                </a:lnTo>
                <a:cubicBezTo>
                  <a:pt x="1664413" y="138232"/>
                  <a:pt x="1664761" y="136699"/>
                  <a:pt x="1671637" y="130969"/>
                </a:cubicBezTo>
                <a:cubicBezTo>
                  <a:pt x="1673836" y="129137"/>
                  <a:pt x="1676400" y="127794"/>
                  <a:pt x="1678781" y="126207"/>
                </a:cubicBezTo>
                <a:cubicBezTo>
                  <a:pt x="1683976" y="110620"/>
                  <a:pt x="1676760" y="125919"/>
                  <a:pt x="1688306" y="116682"/>
                </a:cubicBezTo>
                <a:cubicBezTo>
                  <a:pt x="1690541" y="114894"/>
                  <a:pt x="1691044" y="111562"/>
                  <a:pt x="1693068" y="109538"/>
                </a:cubicBezTo>
                <a:cubicBezTo>
                  <a:pt x="1695092" y="107514"/>
                  <a:pt x="1698013" y="106607"/>
                  <a:pt x="1700212" y="104775"/>
                </a:cubicBezTo>
                <a:cubicBezTo>
                  <a:pt x="1702799" y="102619"/>
                  <a:pt x="1704769" y="99788"/>
                  <a:pt x="1707356" y="97632"/>
                </a:cubicBezTo>
                <a:cubicBezTo>
                  <a:pt x="1709555" y="95800"/>
                  <a:pt x="1712301" y="94701"/>
                  <a:pt x="1714500" y="92869"/>
                </a:cubicBezTo>
                <a:cubicBezTo>
                  <a:pt x="1717087" y="90713"/>
                  <a:pt x="1718985" y="87792"/>
                  <a:pt x="1721643" y="85725"/>
                </a:cubicBezTo>
                <a:cubicBezTo>
                  <a:pt x="1733924" y="76173"/>
                  <a:pt x="1732297" y="77411"/>
                  <a:pt x="1743075" y="73819"/>
                </a:cubicBezTo>
                <a:cubicBezTo>
                  <a:pt x="1745456" y="72232"/>
                  <a:pt x="1747603" y="70219"/>
                  <a:pt x="1750218" y="69057"/>
                </a:cubicBezTo>
                <a:cubicBezTo>
                  <a:pt x="1754806" y="67018"/>
                  <a:pt x="1759743" y="65882"/>
                  <a:pt x="1764506" y="64294"/>
                </a:cubicBezTo>
                <a:lnTo>
                  <a:pt x="1778793" y="59532"/>
                </a:lnTo>
                <a:lnTo>
                  <a:pt x="1793081" y="54769"/>
                </a:lnTo>
                <a:cubicBezTo>
                  <a:pt x="1799399" y="52663"/>
                  <a:pt x="1802915" y="51289"/>
                  <a:pt x="1809750" y="50007"/>
                </a:cubicBezTo>
                <a:cubicBezTo>
                  <a:pt x="1819241" y="48227"/>
                  <a:pt x="1828856" y="47138"/>
                  <a:pt x="1838325" y="45244"/>
                </a:cubicBezTo>
                <a:cubicBezTo>
                  <a:pt x="1842294" y="44450"/>
                  <a:pt x="1846186" y="42993"/>
                  <a:pt x="1850231" y="42863"/>
                </a:cubicBezTo>
                <a:cubicBezTo>
                  <a:pt x="1870858" y="42198"/>
                  <a:pt x="1891506" y="42863"/>
                  <a:pt x="1912143" y="42863"/>
                </a:cubicBezTo>
              </a:path>
            </a:pathLst>
          </a:custGeom>
          <a:noFill/>
          <a:ln w="38100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9666"/>
          </a:p>
        </p:txBody>
      </p:sp>
      <p:grpSp>
        <p:nvGrpSpPr>
          <p:cNvPr id="232" name="Group 231"/>
          <p:cNvGrpSpPr/>
          <p:nvPr/>
        </p:nvGrpSpPr>
        <p:grpSpPr>
          <a:xfrm>
            <a:off x="13147085" y="7007178"/>
            <a:ext cx="4788017" cy="5073097"/>
            <a:chOff x="4953204" y="2276790"/>
            <a:chExt cx="1841297" cy="1830390"/>
          </a:xfrm>
        </p:grpSpPr>
        <p:pic>
          <p:nvPicPr>
            <p:cNvPr id="233" name="Picture 232"/>
            <p:cNvPicPr>
              <a:picLocks noChangeAspect="1"/>
            </p:cNvPicPr>
            <p:nvPr/>
          </p:nvPicPr>
          <p:blipFill>
            <a:blip r:embed="rId2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 rot="16200000">
              <a:off x="4989788" y="2302466"/>
              <a:ext cx="1830390" cy="1779037"/>
            </a:xfrm>
            <a:prstGeom prst="rect">
              <a:avLst/>
            </a:prstGeom>
          </p:spPr>
        </p:pic>
        <p:sp>
          <p:nvSpPr>
            <p:cNvPr id="234" name="Freeform 233"/>
            <p:cNvSpPr/>
            <p:nvPr/>
          </p:nvSpPr>
          <p:spPr>
            <a:xfrm>
              <a:off x="4957607" y="2754536"/>
              <a:ext cx="1787994" cy="294791"/>
            </a:xfrm>
            <a:custGeom>
              <a:avLst/>
              <a:gdLst>
                <a:gd name="connsiteX0" fmla="*/ 0 w 1933764"/>
                <a:gd name="connsiteY0" fmla="*/ 0 h 317770"/>
                <a:gd name="connsiteX1" fmla="*/ 30956 w 1933764"/>
                <a:gd name="connsiteY1" fmla="*/ 9525 h 317770"/>
                <a:gd name="connsiteX2" fmla="*/ 52388 w 1933764"/>
                <a:gd name="connsiteY2" fmla="*/ 11906 h 317770"/>
                <a:gd name="connsiteX3" fmla="*/ 66675 w 1933764"/>
                <a:gd name="connsiteY3" fmla="*/ 14287 h 317770"/>
                <a:gd name="connsiteX4" fmla="*/ 85725 w 1933764"/>
                <a:gd name="connsiteY4" fmla="*/ 16668 h 317770"/>
                <a:gd name="connsiteX5" fmla="*/ 102394 w 1933764"/>
                <a:gd name="connsiteY5" fmla="*/ 21431 h 317770"/>
                <a:gd name="connsiteX6" fmla="*/ 123825 w 1933764"/>
                <a:gd name="connsiteY6" fmla="*/ 26193 h 317770"/>
                <a:gd name="connsiteX7" fmla="*/ 145256 w 1933764"/>
                <a:gd name="connsiteY7" fmla="*/ 33337 h 317770"/>
                <a:gd name="connsiteX8" fmla="*/ 152400 w 1933764"/>
                <a:gd name="connsiteY8" fmla="*/ 35718 h 317770"/>
                <a:gd name="connsiteX9" fmla="*/ 166688 w 1933764"/>
                <a:gd name="connsiteY9" fmla="*/ 42862 h 317770"/>
                <a:gd name="connsiteX10" fmla="*/ 185738 w 1933764"/>
                <a:gd name="connsiteY10" fmla="*/ 52387 h 317770"/>
                <a:gd name="connsiteX11" fmla="*/ 195263 w 1933764"/>
                <a:gd name="connsiteY11" fmla="*/ 57150 h 317770"/>
                <a:gd name="connsiteX12" fmla="*/ 211931 w 1933764"/>
                <a:gd name="connsiteY12" fmla="*/ 66675 h 317770"/>
                <a:gd name="connsiteX13" fmla="*/ 226219 w 1933764"/>
                <a:gd name="connsiteY13" fmla="*/ 71437 h 317770"/>
                <a:gd name="connsiteX14" fmla="*/ 240506 w 1933764"/>
                <a:gd name="connsiteY14" fmla="*/ 76200 h 317770"/>
                <a:gd name="connsiteX15" fmla="*/ 247650 w 1933764"/>
                <a:gd name="connsiteY15" fmla="*/ 78581 h 317770"/>
                <a:gd name="connsiteX16" fmla="*/ 254794 w 1933764"/>
                <a:gd name="connsiteY16" fmla="*/ 83343 h 317770"/>
                <a:gd name="connsiteX17" fmla="*/ 269081 w 1933764"/>
                <a:gd name="connsiteY17" fmla="*/ 88106 h 317770"/>
                <a:gd name="connsiteX18" fmla="*/ 283369 w 1933764"/>
                <a:gd name="connsiteY18" fmla="*/ 92868 h 317770"/>
                <a:gd name="connsiteX19" fmla="*/ 290513 w 1933764"/>
                <a:gd name="connsiteY19" fmla="*/ 95250 h 317770"/>
                <a:gd name="connsiteX20" fmla="*/ 297656 w 1933764"/>
                <a:gd name="connsiteY20" fmla="*/ 97631 h 317770"/>
                <a:gd name="connsiteX21" fmla="*/ 307181 w 1933764"/>
                <a:gd name="connsiteY21" fmla="*/ 102393 h 317770"/>
                <a:gd name="connsiteX22" fmla="*/ 328613 w 1933764"/>
                <a:gd name="connsiteY22" fmla="*/ 109537 h 317770"/>
                <a:gd name="connsiteX23" fmla="*/ 350044 w 1933764"/>
                <a:gd name="connsiteY23" fmla="*/ 116681 h 317770"/>
                <a:gd name="connsiteX24" fmla="*/ 357188 w 1933764"/>
                <a:gd name="connsiteY24" fmla="*/ 119062 h 317770"/>
                <a:gd name="connsiteX25" fmla="*/ 364331 w 1933764"/>
                <a:gd name="connsiteY25" fmla="*/ 121443 h 317770"/>
                <a:gd name="connsiteX26" fmla="*/ 388144 w 1933764"/>
                <a:gd name="connsiteY26" fmla="*/ 128587 h 317770"/>
                <a:gd name="connsiteX27" fmla="*/ 416719 w 1933764"/>
                <a:gd name="connsiteY27" fmla="*/ 138112 h 317770"/>
                <a:gd name="connsiteX28" fmla="*/ 431006 w 1933764"/>
                <a:gd name="connsiteY28" fmla="*/ 142875 h 317770"/>
                <a:gd name="connsiteX29" fmla="*/ 438150 w 1933764"/>
                <a:gd name="connsiteY29" fmla="*/ 147637 h 317770"/>
                <a:gd name="connsiteX30" fmla="*/ 452438 w 1933764"/>
                <a:gd name="connsiteY30" fmla="*/ 152400 h 317770"/>
                <a:gd name="connsiteX31" fmla="*/ 466725 w 1933764"/>
                <a:gd name="connsiteY31" fmla="*/ 157162 h 317770"/>
                <a:gd name="connsiteX32" fmla="*/ 488156 w 1933764"/>
                <a:gd name="connsiteY32" fmla="*/ 164306 h 317770"/>
                <a:gd name="connsiteX33" fmla="*/ 495300 w 1933764"/>
                <a:gd name="connsiteY33" fmla="*/ 166687 h 317770"/>
                <a:gd name="connsiteX34" fmla="*/ 502444 w 1933764"/>
                <a:gd name="connsiteY34" fmla="*/ 169068 h 317770"/>
                <a:gd name="connsiteX35" fmla="*/ 509588 w 1933764"/>
                <a:gd name="connsiteY35" fmla="*/ 173831 h 317770"/>
                <a:gd name="connsiteX36" fmla="*/ 526256 w 1933764"/>
                <a:gd name="connsiteY36" fmla="*/ 178593 h 317770"/>
                <a:gd name="connsiteX37" fmla="*/ 559594 w 1933764"/>
                <a:gd name="connsiteY37" fmla="*/ 188118 h 317770"/>
                <a:gd name="connsiteX38" fmla="*/ 576263 w 1933764"/>
                <a:gd name="connsiteY38" fmla="*/ 190500 h 317770"/>
                <a:gd name="connsiteX39" fmla="*/ 592931 w 1933764"/>
                <a:gd name="connsiteY39" fmla="*/ 195262 h 317770"/>
                <a:gd name="connsiteX40" fmla="*/ 607219 w 1933764"/>
                <a:gd name="connsiteY40" fmla="*/ 197643 h 317770"/>
                <a:gd name="connsiteX41" fmla="*/ 635794 w 1933764"/>
                <a:gd name="connsiteY41" fmla="*/ 202406 h 317770"/>
                <a:gd name="connsiteX42" fmla="*/ 654844 w 1933764"/>
                <a:gd name="connsiteY42" fmla="*/ 204787 h 317770"/>
                <a:gd name="connsiteX43" fmla="*/ 676275 w 1933764"/>
                <a:gd name="connsiteY43" fmla="*/ 209550 h 317770"/>
                <a:gd name="connsiteX44" fmla="*/ 688181 w 1933764"/>
                <a:gd name="connsiteY44" fmla="*/ 211931 h 317770"/>
                <a:gd name="connsiteX45" fmla="*/ 702469 w 1933764"/>
                <a:gd name="connsiteY45" fmla="*/ 214312 h 317770"/>
                <a:gd name="connsiteX46" fmla="*/ 711994 w 1933764"/>
                <a:gd name="connsiteY46" fmla="*/ 216693 h 317770"/>
                <a:gd name="connsiteX47" fmla="*/ 757238 w 1933764"/>
                <a:gd name="connsiteY47" fmla="*/ 223837 h 317770"/>
                <a:gd name="connsiteX48" fmla="*/ 764381 w 1933764"/>
                <a:gd name="connsiteY48" fmla="*/ 226218 h 317770"/>
                <a:gd name="connsiteX49" fmla="*/ 828675 w 1933764"/>
                <a:gd name="connsiteY49" fmla="*/ 233362 h 317770"/>
                <a:gd name="connsiteX50" fmla="*/ 835819 w 1933764"/>
                <a:gd name="connsiteY50" fmla="*/ 235743 h 317770"/>
                <a:gd name="connsiteX51" fmla="*/ 854869 w 1933764"/>
                <a:gd name="connsiteY51" fmla="*/ 240506 h 317770"/>
                <a:gd name="connsiteX52" fmla="*/ 869156 w 1933764"/>
                <a:gd name="connsiteY52" fmla="*/ 245268 h 317770"/>
                <a:gd name="connsiteX53" fmla="*/ 890588 w 1933764"/>
                <a:gd name="connsiteY53" fmla="*/ 252412 h 317770"/>
                <a:gd name="connsiteX54" fmla="*/ 897731 w 1933764"/>
                <a:gd name="connsiteY54" fmla="*/ 254793 h 317770"/>
                <a:gd name="connsiteX55" fmla="*/ 904875 w 1933764"/>
                <a:gd name="connsiteY55" fmla="*/ 257175 h 317770"/>
                <a:gd name="connsiteX56" fmla="*/ 916781 w 1933764"/>
                <a:gd name="connsiteY56" fmla="*/ 259556 h 317770"/>
                <a:gd name="connsiteX57" fmla="*/ 935831 w 1933764"/>
                <a:gd name="connsiteY57" fmla="*/ 261937 h 317770"/>
                <a:gd name="connsiteX58" fmla="*/ 945356 w 1933764"/>
                <a:gd name="connsiteY58" fmla="*/ 264318 h 317770"/>
                <a:gd name="connsiteX59" fmla="*/ 971550 w 1933764"/>
                <a:gd name="connsiteY59" fmla="*/ 269081 h 317770"/>
                <a:gd name="connsiteX60" fmla="*/ 978694 w 1933764"/>
                <a:gd name="connsiteY60" fmla="*/ 273843 h 317770"/>
                <a:gd name="connsiteX61" fmla="*/ 988219 w 1933764"/>
                <a:gd name="connsiteY61" fmla="*/ 276225 h 317770"/>
                <a:gd name="connsiteX62" fmla="*/ 995363 w 1933764"/>
                <a:gd name="connsiteY62" fmla="*/ 278606 h 317770"/>
                <a:gd name="connsiteX63" fmla="*/ 1002506 w 1933764"/>
                <a:gd name="connsiteY63" fmla="*/ 283368 h 317770"/>
                <a:gd name="connsiteX64" fmla="*/ 1016794 w 1933764"/>
                <a:gd name="connsiteY64" fmla="*/ 288131 h 317770"/>
                <a:gd name="connsiteX65" fmla="*/ 1038225 w 1933764"/>
                <a:gd name="connsiteY65" fmla="*/ 297656 h 317770"/>
                <a:gd name="connsiteX66" fmla="*/ 1045369 w 1933764"/>
                <a:gd name="connsiteY66" fmla="*/ 300037 h 317770"/>
                <a:gd name="connsiteX67" fmla="*/ 1078706 w 1933764"/>
                <a:gd name="connsiteY67" fmla="*/ 304800 h 317770"/>
                <a:gd name="connsiteX68" fmla="*/ 1169194 w 1933764"/>
                <a:gd name="connsiteY68" fmla="*/ 307181 h 317770"/>
                <a:gd name="connsiteX69" fmla="*/ 1226344 w 1933764"/>
                <a:gd name="connsiteY69" fmla="*/ 311943 h 317770"/>
                <a:gd name="connsiteX70" fmla="*/ 1307306 w 1933764"/>
                <a:gd name="connsiteY70" fmla="*/ 314325 h 317770"/>
                <a:gd name="connsiteX71" fmla="*/ 1423988 w 1933764"/>
                <a:gd name="connsiteY71" fmla="*/ 314325 h 317770"/>
                <a:gd name="connsiteX72" fmla="*/ 1431131 w 1933764"/>
                <a:gd name="connsiteY72" fmla="*/ 311943 h 317770"/>
                <a:gd name="connsiteX73" fmla="*/ 1440656 w 1933764"/>
                <a:gd name="connsiteY73" fmla="*/ 309562 h 317770"/>
                <a:gd name="connsiteX74" fmla="*/ 1454944 w 1933764"/>
                <a:gd name="connsiteY74" fmla="*/ 304800 h 317770"/>
                <a:gd name="connsiteX75" fmla="*/ 1464469 w 1933764"/>
                <a:gd name="connsiteY75" fmla="*/ 302418 h 317770"/>
                <a:gd name="connsiteX76" fmla="*/ 1485900 w 1933764"/>
                <a:gd name="connsiteY76" fmla="*/ 295275 h 317770"/>
                <a:gd name="connsiteX77" fmla="*/ 1502569 w 1933764"/>
                <a:gd name="connsiteY77" fmla="*/ 290512 h 317770"/>
                <a:gd name="connsiteX78" fmla="*/ 1516856 w 1933764"/>
                <a:gd name="connsiteY78" fmla="*/ 285750 h 317770"/>
                <a:gd name="connsiteX79" fmla="*/ 1564481 w 1933764"/>
                <a:gd name="connsiteY79" fmla="*/ 278606 h 317770"/>
                <a:gd name="connsiteX80" fmla="*/ 1571625 w 1933764"/>
                <a:gd name="connsiteY80" fmla="*/ 276225 h 317770"/>
                <a:gd name="connsiteX81" fmla="*/ 1590675 w 1933764"/>
                <a:gd name="connsiteY81" fmla="*/ 273843 h 317770"/>
                <a:gd name="connsiteX82" fmla="*/ 1607344 w 1933764"/>
                <a:gd name="connsiteY82" fmla="*/ 271462 h 317770"/>
                <a:gd name="connsiteX83" fmla="*/ 1633538 w 1933764"/>
                <a:gd name="connsiteY83" fmla="*/ 266700 h 317770"/>
                <a:gd name="connsiteX84" fmla="*/ 1678781 w 1933764"/>
                <a:gd name="connsiteY84" fmla="*/ 261937 h 317770"/>
                <a:gd name="connsiteX85" fmla="*/ 1707356 w 1933764"/>
                <a:gd name="connsiteY85" fmla="*/ 257175 h 317770"/>
                <a:gd name="connsiteX86" fmla="*/ 1724025 w 1933764"/>
                <a:gd name="connsiteY86" fmla="*/ 254793 h 317770"/>
                <a:gd name="connsiteX87" fmla="*/ 1769269 w 1933764"/>
                <a:gd name="connsiteY87" fmla="*/ 247650 h 317770"/>
                <a:gd name="connsiteX88" fmla="*/ 1816894 w 1933764"/>
                <a:gd name="connsiteY88" fmla="*/ 242887 h 317770"/>
                <a:gd name="connsiteX89" fmla="*/ 1909763 w 1933764"/>
                <a:gd name="connsiteY89" fmla="*/ 245268 h 317770"/>
                <a:gd name="connsiteX90" fmla="*/ 1921669 w 1933764"/>
                <a:gd name="connsiteY90" fmla="*/ 247650 h 31777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  <a:cxn ang="0">
                  <a:pos x="connsiteX29" y="connsiteY29"/>
                </a:cxn>
                <a:cxn ang="0">
                  <a:pos x="connsiteX30" y="connsiteY30"/>
                </a:cxn>
                <a:cxn ang="0">
                  <a:pos x="connsiteX31" y="connsiteY31"/>
                </a:cxn>
                <a:cxn ang="0">
                  <a:pos x="connsiteX32" y="connsiteY32"/>
                </a:cxn>
                <a:cxn ang="0">
                  <a:pos x="connsiteX33" y="connsiteY33"/>
                </a:cxn>
                <a:cxn ang="0">
                  <a:pos x="connsiteX34" y="connsiteY34"/>
                </a:cxn>
                <a:cxn ang="0">
                  <a:pos x="connsiteX35" y="connsiteY35"/>
                </a:cxn>
                <a:cxn ang="0">
                  <a:pos x="connsiteX36" y="connsiteY36"/>
                </a:cxn>
                <a:cxn ang="0">
                  <a:pos x="connsiteX37" y="connsiteY37"/>
                </a:cxn>
                <a:cxn ang="0">
                  <a:pos x="connsiteX38" y="connsiteY38"/>
                </a:cxn>
                <a:cxn ang="0">
                  <a:pos x="connsiteX39" y="connsiteY39"/>
                </a:cxn>
                <a:cxn ang="0">
                  <a:pos x="connsiteX40" y="connsiteY40"/>
                </a:cxn>
                <a:cxn ang="0">
                  <a:pos x="connsiteX41" y="connsiteY41"/>
                </a:cxn>
                <a:cxn ang="0">
                  <a:pos x="connsiteX42" y="connsiteY42"/>
                </a:cxn>
                <a:cxn ang="0">
                  <a:pos x="connsiteX43" y="connsiteY43"/>
                </a:cxn>
                <a:cxn ang="0">
                  <a:pos x="connsiteX44" y="connsiteY44"/>
                </a:cxn>
                <a:cxn ang="0">
                  <a:pos x="connsiteX45" y="connsiteY45"/>
                </a:cxn>
                <a:cxn ang="0">
                  <a:pos x="connsiteX46" y="connsiteY46"/>
                </a:cxn>
                <a:cxn ang="0">
                  <a:pos x="connsiteX47" y="connsiteY47"/>
                </a:cxn>
                <a:cxn ang="0">
                  <a:pos x="connsiteX48" y="connsiteY48"/>
                </a:cxn>
                <a:cxn ang="0">
                  <a:pos x="connsiteX49" y="connsiteY49"/>
                </a:cxn>
                <a:cxn ang="0">
                  <a:pos x="connsiteX50" y="connsiteY50"/>
                </a:cxn>
                <a:cxn ang="0">
                  <a:pos x="connsiteX51" y="connsiteY51"/>
                </a:cxn>
                <a:cxn ang="0">
                  <a:pos x="connsiteX52" y="connsiteY52"/>
                </a:cxn>
                <a:cxn ang="0">
                  <a:pos x="connsiteX53" y="connsiteY53"/>
                </a:cxn>
                <a:cxn ang="0">
                  <a:pos x="connsiteX54" y="connsiteY54"/>
                </a:cxn>
                <a:cxn ang="0">
                  <a:pos x="connsiteX55" y="connsiteY55"/>
                </a:cxn>
                <a:cxn ang="0">
                  <a:pos x="connsiteX56" y="connsiteY56"/>
                </a:cxn>
                <a:cxn ang="0">
                  <a:pos x="connsiteX57" y="connsiteY57"/>
                </a:cxn>
                <a:cxn ang="0">
                  <a:pos x="connsiteX58" y="connsiteY58"/>
                </a:cxn>
                <a:cxn ang="0">
                  <a:pos x="connsiteX59" y="connsiteY59"/>
                </a:cxn>
                <a:cxn ang="0">
                  <a:pos x="connsiteX60" y="connsiteY60"/>
                </a:cxn>
                <a:cxn ang="0">
                  <a:pos x="connsiteX61" y="connsiteY61"/>
                </a:cxn>
                <a:cxn ang="0">
                  <a:pos x="connsiteX62" y="connsiteY62"/>
                </a:cxn>
                <a:cxn ang="0">
                  <a:pos x="connsiteX63" y="connsiteY63"/>
                </a:cxn>
                <a:cxn ang="0">
                  <a:pos x="connsiteX64" y="connsiteY64"/>
                </a:cxn>
                <a:cxn ang="0">
                  <a:pos x="connsiteX65" y="connsiteY65"/>
                </a:cxn>
                <a:cxn ang="0">
                  <a:pos x="connsiteX66" y="connsiteY66"/>
                </a:cxn>
                <a:cxn ang="0">
                  <a:pos x="connsiteX67" y="connsiteY67"/>
                </a:cxn>
                <a:cxn ang="0">
                  <a:pos x="connsiteX68" y="connsiteY68"/>
                </a:cxn>
                <a:cxn ang="0">
                  <a:pos x="connsiteX69" y="connsiteY69"/>
                </a:cxn>
                <a:cxn ang="0">
                  <a:pos x="connsiteX70" y="connsiteY70"/>
                </a:cxn>
                <a:cxn ang="0">
                  <a:pos x="connsiteX71" y="connsiteY71"/>
                </a:cxn>
                <a:cxn ang="0">
                  <a:pos x="connsiteX72" y="connsiteY72"/>
                </a:cxn>
                <a:cxn ang="0">
                  <a:pos x="connsiteX73" y="connsiteY73"/>
                </a:cxn>
                <a:cxn ang="0">
                  <a:pos x="connsiteX74" y="connsiteY74"/>
                </a:cxn>
                <a:cxn ang="0">
                  <a:pos x="connsiteX75" y="connsiteY75"/>
                </a:cxn>
                <a:cxn ang="0">
                  <a:pos x="connsiteX76" y="connsiteY76"/>
                </a:cxn>
                <a:cxn ang="0">
                  <a:pos x="connsiteX77" y="connsiteY77"/>
                </a:cxn>
                <a:cxn ang="0">
                  <a:pos x="connsiteX78" y="connsiteY78"/>
                </a:cxn>
                <a:cxn ang="0">
                  <a:pos x="connsiteX79" y="connsiteY79"/>
                </a:cxn>
                <a:cxn ang="0">
                  <a:pos x="connsiteX80" y="connsiteY80"/>
                </a:cxn>
                <a:cxn ang="0">
                  <a:pos x="connsiteX81" y="connsiteY81"/>
                </a:cxn>
                <a:cxn ang="0">
                  <a:pos x="connsiteX82" y="connsiteY82"/>
                </a:cxn>
                <a:cxn ang="0">
                  <a:pos x="connsiteX83" y="connsiteY83"/>
                </a:cxn>
                <a:cxn ang="0">
                  <a:pos x="connsiteX84" y="connsiteY84"/>
                </a:cxn>
                <a:cxn ang="0">
                  <a:pos x="connsiteX85" y="connsiteY85"/>
                </a:cxn>
                <a:cxn ang="0">
                  <a:pos x="connsiteX86" y="connsiteY86"/>
                </a:cxn>
                <a:cxn ang="0">
                  <a:pos x="connsiteX87" y="connsiteY87"/>
                </a:cxn>
                <a:cxn ang="0">
                  <a:pos x="connsiteX88" y="connsiteY88"/>
                </a:cxn>
                <a:cxn ang="0">
                  <a:pos x="connsiteX89" y="connsiteY89"/>
                </a:cxn>
                <a:cxn ang="0">
                  <a:pos x="connsiteX90" y="connsiteY90"/>
                </a:cxn>
              </a:cxnLst>
              <a:rect l="l" t="t" r="r" b="b"/>
              <a:pathLst>
                <a:path w="1933764" h="317770">
                  <a:moveTo>
                    <a:pt x="0" y="0"/>
                  </a:moveTo>
                  <a:cubicBezTo>
                    <a:pt x="10698" y="4279"/>
                    <a:pt x="18916" y="8187"/>
                    <a:pt x="30956" y="9525"/>
                  </a:cubicBezTo>
                  <a:cubicBezTo>
                    <a:pt x="38100" y="10319"/>
                    <a:pt x="45263" y="10956"/>
                    <a:pt x="52388" y="11906"/>
                  </a:cubicBezTo>
                  <a:cubicBezTo>
                    <a:pt x="57174" y="12544"/>
                    <a:pt x="61896" y="13604"/>
                    <a:pt x="66675" y="14287"/>
                  </a:cubicBezTo>
                  <a:cubicBezTo>
                    <a:pt x="73010" y="15192"/>
                    <a:pt x="79375" y="15874"/>
                    <a:pt x="85725" y="16668"/>
                  </a:cubicBezTo>
                  <a:cubicBezTo>
                    <a:pt x="93683" y="19321"/>
                    <a:pt x="93420" y="19437"/>
                    <a:pt x="102394" y="21431"/>
                  </a:cubicBezTo>
                  <a:cubicBezTo>
                    <a:pt x="111129" y="23372"/>
                    <a:pt x="115533" y="23705"/>
                    <a:pt x="123825" y="26193"/>
                  </a:cubicBezTo>
                  <a:cubicBezTo>
                    <a:pt x="131038" y="28357"/>
                    <a:pt x="138112" y="30956"/>
                    <a:pt x="145256" y="33337"/>
                  </a:cubicBezTo>
                  <a:lnTo>
                    <a:pt x="152400" y="35718"/>
                  </a:lnTo>
                  <a:cubicBezTo>
                    <a:pt x="168056" y="46156"/>
                    <a:pt x="151195" y="35820"/>
                    <a:pt x="166688" y="42862"/>
                  </a:cubicBezTo>
                  <a:cubicBezTo>
                    <a:pt x="173151" y="45800"/>
                    <a:pt x="179388" y="49212"/>
                    <a:pt x="185738" y="52387"/>
                  </a:cubicBezTo>
                  <a:cubicBezTo>
                    <a:pt x="188913" y="53975"/>
                    <a:pt x="192309" y="55181"/>
                    <a:pt x="195263" y="57150"/>
                  </a:cubicBezTo>
                  <a:cubicBezTo>
                    <a:pt x="201704" y="61444"/>
                    <a:pt x="204381" y="63655"/>
                    <a:pt x="211931" y="66675"/>
                  </a:cubicBezTo>
                  <a:cubicBezTo>
                    <a:pt x="216592" y="68539"/>
                    <a:pt x="221456" y="69850"/>
                    <a:pt x="226219" y="71437"/>
                  </a:cubicBezTo>
                  <a:lnTo>
                    <a:pt x="240506" y="76200"/>
                  </a:lnTo>
                  <a:cubicBezTo>
                    <a:pt x="242887" y="76994"/>
                    <a:pt x="245561" y="77189"/>
                    <a:pt x="247650" y="78581"/>
                  </a:cubicBezTo>
                  <a:cubicBezTo>
                    <a:pt x="250031" y="80168"/>
                    <a:pt x="252179" y="82181"/>
                    <a:pt x="254794" y="83343"/>
                  </a:cubicBezTo>
                  <a:cubicBezTo>
                    <a:pt x="259381" y="85382"/>
                    <a:pt x="264319" y="86518"/>
                    <a:pt x="269081" y="88106"/>
                  </a:cubicBezTo>
                  <a:lnTo>
                    <a:pt x="283369" y="92868"/>
                  </a:lnTo>
                  <a:lnTo>
                    <a:pt x="290513" y="95250"/>
                  </a:lnTo>
                  <a:cubicBezTo>
                    <a:pt x="292894" y="96044"/>
                    <a:pt x="295411" y="96509"/>
                    <a:pt x="297656" y="97631"/>
                  </a:cubicBezTo>
                  <a:cubicBezTo>
                    <a:pt x="300831" y="99218"/>
                    <a:pt x="303885" y="101075"/>
                    <a:pt x="307181" y="102393"/>
                  </a:cubicBezTo>
                  <a:cubicBezTo>
                    <a:pt x="307201" y="102401"/>
                    <a:pt x="325031" y="108343"/>
                    <a:pt x="328613" y="109537"/>
                  </a:cubicBezTo>
                  <a:lnTo>
                    <a:pt x="350044" y="116681"/>
                  </a:lnTo>
                  <a:lnTo>
                    <a:pt x="357188" y="119062"/>
                  </a:lnTo>
                  <a:cubicBezTo>
                    <a:pt x="359569" y="119856"/>
                    <a:pt x="361896" y="120834"/>
                    <a:pt x="364331" y="121443"/>
                  </a:cubicBezTo>
                  <a:cubicBezTo>
                    <a:pt x="378726" y="125043"/>
                    <a:pt x="370751" y="122790"/>
                    <a:pt x="388144" y="128587"/>
                  </a:cubicBezTo>
                  <a:lnTo>
                    <a:pt x="416719" y="138112"/>
                  </a:lnTo>
                  <a:cubicBezTo>
                    <a:pt x="416724" y="138114"/>
                    <a:pt x="431001" y="142871"/>
                    <a:pt x="431006" y="142875"/>
                  </a:cubicBezTo>
                  <a:cubicBezTo>
                    <a:pt x="433387" y="144462"/>
                    <a:pt x="435535" y="146475"/>
                    <a:pt x="438150" y="147637"/>
                  </a:cubicBezTo>
                  <a:cubicBezTo>
                    <a:pt x="442738" y="149676"/>
                    <a:pt x="447675" y="150812"/>
                    <a:pt x="452438" y="152400"/>
                  </a:cubicBezTo>
                  <a:lnTo>
                    <a:pt x="466725" y="157162"/>
                  </a:lnTo>
                  <a:lnTo>
                    <a:pt x="488156" y="164306"/>
                  </a:lnTo>
                  <a:lnTo>
                    <a:pt x="495300" y="166687"/>
                  </a:lnTo>
                  <a:lnTo>
                    <a:pt x="502444" y="169068"/>
                  </a:lnTo>
                  <a:cubicBezTo>
                    <a:pt x="504825" y="170656"/>
                    <a:pt x="507028" y="172551"/>
                    <a:pt x="509588" y="173831"/>
                  </a:cubicBezTo>
                  <a:cubicBezTo>
                    <a:pt x="513589" y="175832"/>
                    <a:pt x="522441" y="177448"/>
                    <a:pt x="526256" y="178593"/>
                  </a:cubicBezTo>
                  <a:cubicBezTo>
                    <a:pt x="538601" y="182296"/>
                    <a:pt x="546303" y="186219"/>
                    <a:pt x="559594" y="188118"/>
                  </a:cubicBezTo>
                  <a:lnTo>
                    <a:pt x="576263" y="190500"/>
                  </a:lnTo>
                  <a:cubicBezTo>
                    <a:pt x="583072" y="192770"/>
                    <a:pt x="585455" y="193767"/>
                    <a:pt x="592931" y="195262"/>
                  </a:cubicBezTo>
                  <a:cubicBezTo>
                    <a:pt x="597666" y="196209"/>
                    <a:pt x="602456" y="196849"/>
                    <a:pt x="607219" y="197643"/>
                  </a:cubicBezTo>
                  <a:cubicBezTo>
                    <a:pt x="621435" y="202383"/>
                    <a:pt x="611144" y="199506"/>
                    <a:pt x="635794" y="202406"/>
                  </a:cubicBezTo>
                  <a:lnTo>
                    <a:pt x="654844" y="204787"/>
                  </a:lnTo>
                  <a:cubicBezTo>
                    <a:pt x="667438" y="208985"/>
                    <a:pt x="657839" y="206198"/>
                    <a:pt x="676275" y="209550"/>
                  </a:cubicBezTo>
                  <a:cubicBezTo>
                    <a:pt x="680257" y="210274"/>
                    <a:pt x="684199" y="211207"/>
                    <a:pt x="688181" y="211931"/>
                  </a:cubicBezTo>
                  <a:cubicBezTo>
                    <a:pt x="692931" y="212795"/>
                    <a:pt x="697734" y="213365"/>
                    <a:pt x="702469" y="214312"/>
                  </a:cubicBezTo>
                  <a:cubicBezTo>
                    <a:pt x="705678" y="214954"/>
                    <a:pt x="708777" y="216090"/>
                    <a:pt x="711994" y="216693"/>
                  </a:cubicBezTo>
                  <a:cubicBezTo>
                    <a:pt x="730204" y="220107"/>
                    <a:pt x="740252" y="221411"/>
                    <a:pt x="757238" y="223837"/>
                  </a:cubicBezTo>
                  <a:cubicBezTo>
                    <a:pt x="759619" y="224631"/>
                    <a:pt x="761920" y="225726"/>
                    <a:pt x="764381" y="226218"/>
                  </a:cubicBezTo>
                  <a:cubicBezTo>
                    <a:pt x="794643" y="232271"/>
                    <a:pt x="795781" y="231169"/>
                    <a:pt x="828675" y="233362"/>
                  </a:cubicBezTo>
                  <a:cubicBezTo>
                    <a:pt x="831056" y="234156"/>
                    <a:pt x="833397" y="235083"/>
                    <a:pt x="835819" y="235743"/>
                  </a:cubicBezTo>
                  <a:cubicBezTo>
                    <a:pt x="842134" y="237465"/>
                    <a:pt x="848659" y="238436"/>
                    <a:pt x="854869" y="240506"/>
                  </a:cubicBezTo>
                  <a:lnTo>
                    <a:pt x="869156" y="245268"/>
                  </a:lnTo>
                  <a:lnTo>
                    <a:pt x="890588" y="252412"/>
                  </a:lnTo>
                  <a:lnTo>
                    <a:pt x="897731" y="254793"/>
                  </a:lnTo>
                  <a:cubicBezTo>
                    <a:pt x="900112" y="255587"/>
                    <a:pt x="902414" y="256683"/>
                    <a:pt x="904875" y="257175"/>
                  </a:cubicBezTo>
                  <a:cubicBezTo>
                    <a:pt x="908844" y="257969"/>
                    <a:pt x="912781" y="258941"/>
                    <a:pt x="916781" y="259556"/>
                  </a:cubicBezTo>
                  <a:cubicBezTo>
                    <a:pt x="923106" y="260529"/>
                    <a:pt x="929519" y="260885"/>
                    <a:pt x="935831" y="261937"/>
                  </a:cubicBezTo>
                  <a:cubicBezTo>
                    <a:pt x="939059" y="262475"/>
                    <a:pt x="942136" y="263733"/>
                    <a:pt x="945356" y="264318"/>
                  </a:cubicBezTo>
                  <a:cubicBezTo>
                    <a:pt x="976641" y="270007"/>
                    <a:pt x="949946" y="263681"/>
                    <a:pt x="971550" y="269081"/>
                  </a:cubicBezTo>
                  <a:cubicBezTo>
                    <a:pt x="973931" y="270668"/>
                    <a:pt x="976064" y="272716"/>
                    <a:pt x="978694" y="273843"/>
                  </a:cubicBezTo>
                  <a:cubicBezTo>
                    <a:pt x="981702" y="275132"/>
                    <a:pt x="985072" y="275326"/>
                    <a:pt x="988219" y="276225"/>
                  </a:cubicBezTo>
                  <a:cubicBezTo>
                    <a:pt x="990633" y="276915"/>
                    <a:pt x="992982" y="277812"/>
                    <a:pt x="995363" y="278606"/>
                  </a:cubicBezTo>
                  <a:cubicBezTo>
                    <a:pt x="997744" y="280193"/>
                    <a:pt x="999891" y="282206"/>
                    <a:pt x="1002506" y="283368"/>
                  </a:cubicBezTo>
                  <a:cubicBezTo>
                    <a:pt x="1007094" y="285407"/>
                    <a:pt x="1012617" y="285346"/>
                    <a:pt x="1016794" y="288131"/>
                  </a:cubicBezTo>
                  <a:cubicBezTo>
                    <a:pt x="1028114" y="295677"/>
                    <a:pt x="1021225" y="291989"/>
                    <a:pt x="1038225" y="297656"/>
                  </a:cubicBezTo>
                  <a:lnTo>
                    <a:pt x="1045369" y="300037"/>
                  </a:lnTo>
                  <a:cubicBezTo>
                    <a:pt x="1059422" y="304721"/>
                    <a:pt x="1054930" y="303829"/>
                    <a:pt x="1078706" y="304800"/>
                  </a:cubicBezTo>
                  <a:cubicBezTo>
                    <a:pt x="1108854" y="306031"/>
                    <a:pt x="1139031" y="306387"/>
                    <a:pt x="1169194" y="307181"/>
                  </a:cubicBezTo>
                  <a:cubicBezTo>
                    <a:pt x="1192987" y="309824"/>
                    <a:pt x="1199222" y="310836"/>
                    <a:pt x="1226344" y="311943"/>
                  </a:cubicBezTo>
                  <a:cubicBezTo>
                    <a:pt x="1253321" y="313044"/>
                    <a:pt x="1280319" y="313531"/>
                    <a:pt x="1307306" y="314325"/>
                  </a:cubicBezTo>
                  <a:cubicBezTo>
                    <a:pt x="1358063" y="319400"/>
                    <a:pt x="1338165" y="318412"/>
                    <a:pt x="1423988" y="314325"/>
                  </a:cubicBezTo>
                  <a:cubicBezTo>
                    <a:pt x="1426495" y="314206"/>
                    <a:pt x="1428718" y="312633"/>
                    <a:pt x="1431131" y="311943"/>
                  </a:cubicBezTo>
                  <a:cubicBezTo>
                    <a:pt x="1434278" y="311044"/>
                    <a:pt x="1437521" y="310502"/>
                    <a:pt x="1440656" y="309562"/>
                  </a:cubicBezTo>
                  <a:cubicBezTo>
                    <a:pt x="1445465" y="308120"/>
                    <a:pt x="1450074" y="306018"/>
                    <a:pt x="1454944" y="304800"/>
                  </a:cubicBezTo>
                  <a:cubicBezTo>
                    <a:pt x="1458119" y="304006"/>
                    <a:pt x="1461334" y="303358"/>
                    <a:pt x="1464469" y="302418"/>
                  </a:cubicBezTo>
                  <a:cubicBezTo>
                    <a:pt x="1471681" y="300254"/>
                    <a:pt x="1478756" y="297656"/>
                    <a:pt x="1485900" y="295275"/>
                  </a:cubicBezTo>
                  <a:cubicBezTo>
                    <a:pt x="1509911" y="287271"/>
                    <a:pt x="1472666" y="299482"/>
                    <a:pt x="1502569" y="290512"/>
                  </a:cubicBezTo>
                  <a:cubicBezTo>
                    <a:pt x="1507377" y="289070"/>
                    <a:pt x="1511887" y="286460"/>
                    <a:pt x="1516856" y="285750"/>
                  </a:cubicBezTo>
                  <a:lnTo>
                    <a:pt x="1564481" y="278606"/>
                  </a:lnTo>
                  <a:cubicBezTo>
                    <a:pt x="1566862" y="277812"/>
                    <a:pt x="1569155" y="276674"/>
                    <a:pt x="1571625" y="276225"/>
                  </a:cubicBezTo>
                  <a:cubicBezTo>
                    <a:pt x="1577921" y="275080"/>
                    <a:pt x="1584332" y="274689"/>
                    <a:pt x="1590675" y="273843"/>
                  </a:cubicBezTo>
                  <a:cubicBezTo>
                    <a:pt x="1596238" y="273101"/>
                    <a:pt x="1601822" y="272466"/>
                    <a:pt x="1607344" y="271462"/>
                  </a:cubicBezTo>
                  <a:lnTo>
                    <a:pt x="1633538" y="266700"/>
                  </a:lnTo>
                  <a:cubicBezTo>
                    <a:pt x="1687633" y="261005"/>
                    <a:pt x="1640950" y="267341"/>
                    <a:pt x="1678781" y="261937"/>
                  </a:cubicBezTo>
                  <a:cubicBezTo>
                    <a:pt x="1693302" y="257097"/>
                    <a:pt x="1681832" y="260366"/>
                    <a:pt x="1707356" y="257175"/>
                  </a:cubicBezTo>
                  <a:cubicBezTo>
                    <a:pt x="1712925" y="256479"/>
                    <a:pt x="1718469" y="255587"/>
                    <a:pt x="1724025" y="254793"/>
                  </a:cubicBezTo>
                  <a:cubicBezTo>
                    <a:pt x="1741819" y="248862"/>
                    <a:pt x="1736285" y="250188"/>
                    <a:pt x="1769269" y="247650"/>
                  </a:cubicBezTo>
                  <a:cubicBezTo>
                    <a:pt x="1805821" y="244837"/>
                    <a:pt x="1789980" y="246731"/>
                    <a:pt x="1816894" y="242887"/>
                  </a:cubicBezTo>
                  <a:cubicBezTo>
                    <a:pt x="1847850" y="243681"/>
                    <a:pt x="1878830" y="243829"/>
                    <a:pt x="1909763" y="245268"/>
                  </a:cubicBezTo>
                  <a:cubicBezTo>
                    <a:pt x="1965110" y="247843"/>
                    <a:pt x="1905090" y="247650"/>
                    <a:pt x="1921669" y="247650"/>
                  </a:cubicBezTo>
                </a:path>
              </a:pathLst>
            </a:custGeom>
            <a:noFill/>
            <a:ln w="38100">
              <a:solidFill>
                <a:schemeClr val="bg1"/>
              </a:solidFill>
              <a:prstDash val="sysDot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9666"/>
            </a:p>
          </p:txBody>
        </p:sp>
        <p:sp>
          <p:nvSpPr>
            <p:cNvPr id="235" name="Freeform 234"/>
            <p:cNvSpPr/>
            <p:nvPr/>
          </p:nvSpPr>
          <p:spPr>
            <a:xfrm>
              <a:off x="4955406" y="2776626"/>
              <a:ext cx="1779012" cy="300431"/>
            </a:xfrm>
            <a:custGeom>
              <a:avLst/>
              <a:gdLst>
                <a:gd name="connsiteX0" fmla="*/ 0 w 1924050"/>
                <a:gd name="connsiteY0" fmla="*/ 0 h 323850"/>
                <a:gd name="connsiteX1" fmla="*/ 26194 w 1924050"/>
                <a:gd name="connsiteY1" fmla="*/ 2381 h 323850"/>
                <a:gd name="connsiteX2" fmla="*/ 33337 w 1924050"/>
                <a:gd name="connsiteY2" fmla="*/ 4763 h 323850"/>
                <a:gd name="connsiteX3" fmla="*/ 59531 w 1924050"/>
                <a:gd name="connsiteY3" fmla="*/ 9525 h 323850"/>
                <a:gd name="connsiteX4" fmla="*/ 83344 w 1924050"/>
                <a:gd name="connsiteY4" fmla="*/ 16669 h 323850"/>
                <a:gd name="connsiteX5" fmla="*/ 90487 w 1924050"/>
                <a:gd name="connsiteY5" fmla="*/ 19050 h 323850"/>
                <a:gd name="connsiteX6" fmla="*/ 97631 w 1924050"/>
                <a:gd name="connsiteY6" fmla="*/ 23813 h 323850"/>
                <a:gd name="connsiteX7" fmla="*/ 114300 w 1924050"/>
                <a:gd name="connsiteY7" fmla="*/ 28575 h 323850"/>
                <a:gd name="connsiteX8" fmla="*/ 128587 w 1924050"/>
                <a:gd name="connsiteY8" fmla="*/ 33338 h 323850"/>
                <a:gd name="connsiteX9" fmla="*/ 142875 w 1924050"/>
                <a:gd name="connsiteY9" fmla="*/ 38100 h 323850"/>
                <a:gd name="connsiteX10" fmla="*/ 150019 w 1924050"/>
                <a:gd name="connsiteY10" fmla="*/ 40481 h 323850"/>
                <a:gd name="connsiteX11" fmla="*/ 171450 w 1924050"/>
                <a:gd name="connsiteY11" fmla="*/ 50006 h 323850"/>
                <a:gd name="connsiteX12" fmla="*/ 178594 w 1924050"/>
                <a:gd name="connsiteY12" fmla="*/ 52388 h 323850"/>
                <a:gd name="connsiteX13" fmla="*/ 200025 w 1924050"/>
                <a:gd name="connsiteY13" fmla="*/ 61913 h 323850"/>
                <a:gd name="connsiteX14" fmla="*/ 214312 w 1924050"/>
                <a:gd name="connsiteY14" fmla="*/ 66675 h 323850"/>
                <a:gd name="connsiteX15" fmla="*/ 221456 w 1924050"/>
                <a:gd name="connsiteY15" fmla="*/ 69056 h 323850"/>
                <a:gd name="connsiteX16" fmla="*/ 235744 w 1924050"/>
                <a:gd name="connsiteY16" fmla="*/ 76200 h 323850"/>
                <a:gd name="connsiteX17" fmla="*/ 254794 w 1924050"/>
                <a:gd name="connsiteY17" fmla="*/ 80963 h 323850"/>
                <a:gd name="connsiteX18" fmla="*/ 269081 w 1924050"/>
                <a:gd name="connsiteY18" fmla="*/ 88106 h 323850"/>
                <a:gd name="connsiteX19" fmla="*/ 283369 w 1924050"/>
                <a:gd name="connsiteY19" fmla="*/ 95250 h 323850"/>
                <a:gd name="connsiteX20" fmla="*/ 290512 w 1924050"/>
                <a:gd name="connsiteY20" fmla="*/ 100013 h 323850"/>
                <a:gd name="connsiteX21" fmla="*/ 304800 w 1924050"/>
                <a:gd name="connsiteY21" fmla="*/ 104775 h 323850"/>
                <a:gd name="connsiteX22" fmla="*/ 311944 w 1924050"/>
                <a:gd name="connsiteY22" fmla="*/ 107156 h 323850"/>
                <a:gd name="connsiteX23" fmla="*/ 330994 w 1924050"/>
                <a:gd name="connsiteY23" fmla="*/ 116681 h 323850"/>
                <a:gd name="connsiteX24" fmla="*/ 352425 w 1924050"/>
                <a:gd name="connsiteY24" fmla="*/ 123825 h 323850"/>
                <a:gd name="connsiteX25" fmla="*/ 359569 w 1924050"/>
                <a:gd name="connsiteY25" fmla="*/ 126206 h 323850"/>
                <a:gd name="connsiteX26" fmla="*/ 366712 w 1924050"/>
                <a:gd name="connsiteY26" fmla="*/ 130969 h 323850"/>
                <a:gd name="connsiteX27" fmla="*/ 381000 w 1924050"/>
                <a:gd name="connsiteY27" fmla="*/ 135731 h 323850"/>
                <a:gd name="connsiteX28" fmla="*/ 388144 w 1924050"/>
                <a:gd name="connsiteY28" fmla="*/ 138113 h 323850"/>
                <a:gd name="connsiteX29" fmla="*/ 395287 w 1924050"/>
                <a:gd name="connsiteY29" fmla="*/ 140494 h 323850"/>
                <a:gd name="connsiteX30" fmla="*/ 402431 w 1924050"/>
                <a:gd name="connsiteY30" fmla="*/ 142875 h 323850"/>
                <a:gd name="connsiteX31" fmla="*/ 419100 w 1924050"/>
                <a:gd name="connsiteY31" fmla="*/ 150019 h 323850"/>
                <a:gd name="connsiteX32" fmla="*/ 433387 w 1924050"/>
                <a:gd name="connsiteY32" fmla="*/ 154781 h 323850"/>
                <a:gd name="connsiteX33" fmla="*/ 447675 w 1924050"/>
                <a:gd name="connsiteY33" fmla="*/ 159544 h 323850"/>
                <a:gd name="connsiteX34" fmla="*/ 454819 w 1924050"/>
                <a:gd name="connsiteY34" fmla="*/ 161925 h 323850"/>
                <a:gd name="connsiteX35" fmla="*/ 466725 w 1924050"/>
                <a:gd name="connsiteY35" fmla="*/ 164306 h 323850"/>
                <a:gd name="connsiteX36" fmla="*/ 481012 w 1924050"/>
                <a:gd name="connsiteY36" fmla="*/ 169069 h 323850"/>
                <a:gd name="connsiteX37" fmla="*/ 490537 w 1924050"/>
                <a:gd name="connsiteY37" fmla="*/ 171450 h 323850"/>
                <a:gd name="connsiteX38" fmla="*/ 497681 w 1924050"/>
                <a:gd name="connsiteY38" fmla="*/ 173831 h 323850"/>
                <a:gd name="connsiteX39" fmla="*/ 521494 w 1924050"/>
                <a:gd name="connsiteY39" fmla="*/ 178594 h 323850"/>
                <a:gd name="connsiteX40" fmla="*/ 528637 w 1924050"/>
                <a:gd name="connsiteY40" fmla="*/ 180975 h 323850"/>
                <a:gd name="connsiteX41" fmla="*/ 552450 w 1924050"/>
                <a:gd name="connsiteY41" fmla="*/ 185738 h 323850"/>
                <a:gd name="connsiteX42" fmla="*/ 576262 w 1924050"/>
                <a:gd name="connsiteY42" fmla="*/ 192881 h 323850"/>
                <a:gd name="connsiteX43" fmla="*/ 590550 w 1924050"/>
                <a:gd name="connsiteY43" fmla="*/ 197644 h 323850"/>
                <a:gd name="connsiteX44" fmla="*/ 609600 w 1924050"/>
                <a:gd name="connsiteY44" fmla="*/ 202406 h 323850"/>
                <a:gd name="connsiteX45" fmla="*/ 626269 w 1924050"/>
                <a:gd name="connsiteY45" fmla="*/ 207169 h 323850"/>
                <a:gd name="connsiteX46" fmla="*/ 652462 w 1924050"/>
                <a:gd name="connsiteY46" fmla="*/ 211931 h 323850"/>
                <a:gd name="connsiteX47" fmla="*/ 666750 w 1924050"/>
                <a:gd name="connsiteY47" fmla="*/ 216694 h 323850"/>
                <a:gd name="connsiteX48" fmla="*/ 676275 w 1924050"/>
                <a:gd name="connsiteY48" fmla="*/ 219075 h 323850"/>
                <a:gd name="connsiteX49" fmla="*/ 683419 w 1924050"/>
                <a:gd name="connsiteY49" fmla="*/ 221456 h 323850"/>
                <a:gd name="connsiteX50" fmla="*/ 695325 w 1924050"/>
                <a:gd name="connsiteY50" fmla="*/ 223838 h 323850"/>
                <a:gd name="connsiteX51" fmla="*/ 714375 w 1924050"/>
                <a:gd name="connsiteY51" fmla="*/ 228600 h 323850"/>
                <a:gd name="connsiteX52" fmla="*/ 723900 w 1924050"/>
                <a:gd name="connsiteY52" fmla="*/ 230981 h 323850"/>
                <a:gd name="connsiteX53" fmla="*/ 735806 w 1924050"/>
                <a:gd name="connsiteY53" fmla="*/ 233363 h 323850"/>
                <a:gd name="connsiteX54" fmla="*/ 745331 w 1924050"/>
                <a:gd name="connsiteY54" fmla="*/ 235744 h 323850"/>
                <a:gd name="connsiteX55" fmla="*/ 752475 w 1924050"/>
                <a:gd name="connsiteY55" fmla="*/ 238125 h 323850"/>
                <a:gd name="connsiteX56" fmla="*/ 764381 w 1924050"/>
                <a:gd name="connsiteY56" fmla="*/ 240506 h 323850"/>
                <a:gd name="connsiteX57" fmla="*/ 773906 w 1924050"/>
                <a:gd name="connsiteY57" fmla="*/ 242888 h 323850"/>
                <a:gd name="connsiteX58" fmla="*/ 819150 w 1924050"/>
                <a:gd name="connsiteY58" fmla="*/ 247650 h 323850"/>
                <a:gd name="connsiteX59" fmla="*/ 866775 w 1924050"/>
                <a:gd name="connsiteY59" fmla="*/ 252413 h 323850"/>
                <a:gd name="connsiteX60" fmla="*/ 897731 w 1924050"/>
                <a:gd name="connsiteY60" fmla="*/ 257175 h 323850"/>
                <a:gd name="connsiteX61" fmla="*/ 926306 w 1924050"/>
                <a:gd name="connsiteY61" fmla="*/ 261938 h 323850"/>
                <a:gd name="connsiteX62" fmla="*/ 952500 w 1924050"/>
                <a:gd name="connsiteY62" fmla="*/ 269081 h 323850"/>
                <a:gd name="connsiteX63" fmla="*/ 964406 w 1924050"/>
                <a:gd name="connsiteY63" fmla="*/ 271463 h 323850"/>
                <a:gd name="connsiteX64" fmla="*/ 971550 w 1924050"/>
                <a:gd name="connsiteY64" fmla="*/ 273844 h 323850"/>
                <a:gd name="connsiteX65" fmla="*/ 981075 w 1924050"/>
                <a:gd name="connsiteY65" fmla="*/ 276225 h 323850"/>
                <a:gd name="connsiteX66" fmla="*/ 988219 w 1924050"/>
                <a:gd name="connsiteY66" fmla="*/ 278606 h 323850"/>
                <a:gd name="connsiteX67" fmla="*/ 1000125 w 1924050"/>
                <a:gd name="connsiteY67" fmla="*/ 280988 h 323850"/>
                <a:gd name="connsiteX68" fmla="*/ 1014412 w 1924050"/>
                <a:gd name="connsiteY68" fmla="*/ 285750 h 323850"/>
                <a:gd name="connsiteX69" fmla="*/ 1042987 w 1924050"/>
                <a:gd name="connsiteY69" fmla="*/ 295275 h 323850"/>
                <a:gd name="connsiteX70" fmla="*/ 1057275 w 1924050"/>
                <a:gd name="connsiteY70" fmla="*/ 300038 h 323850"/>
                <a:gd name="connsiteX71" fmla="*/ 1064419 w 1924050"/>
                <a:gd name="connsiteY71" fmla="*/ 302419 h 323850"/>
                <a:gd name="connsiteX72" fmla="*/ 1071562 w 1924050"/>
                <a:gd name="connsiteY72" fmla="*/ 307181 h 323850"/>
                <a:gd name="connsiteX73" fmla="*/ 1097756 w 1924050"/>
                <a:gd name="connsiteY73" fmla="*/ 311944 h 323850"/>
                <a:gd name="connsiteX74" fmla="*/ 1107281 w 1924050"/>
                <a:gd name="connsiteY74" fmla="*/ 314325 h 323850"/>
                <a:gd name="connsiteX75" fmla="*/ 1171575 w 1924050"/>
                <a:gd name="connsiteY75" fmla="*/ 319088 h 323850"/>
                <a:gd name="connsiteX76" fmla="*/ 1209675 w 1924050"/>
                <a:gd name="connsiteY76" fmla="*/ 323850 h 323850"/>
                <a:gd name="connsiteX77" fmla="*/ 1307306 w 1924050"/>
                <a:gd name="connsiteY77" fmla="*/ 321469 h 323850"/>
                <a:gd name="connsiteX78" fmla="*/ 1343025 w 1924050"/>
                <a:gd name="connsiteY78" fmla="*/ 319088 h 323850"/>
                <a:gd name="connsiteX79" fmla="*/ 1352550 w 1924050"/>
                <a:gd name="connsiteY79" fmla="*/ 316706 h 323850"/>
                <a:gd name="connsiteX80" fmla="*/ 1373981 w 1924050"/>
                <a:gd name="connsiteY80" fmla="*/ 311944 h 323850"/>
                <a:gd name="connsiteX81" fmla="*/ 1381125 w 1924050"/>
                <a:gd name="connsiteY81" fmla="*/ 309563 h 323850"/>
                <a:gd name="connsiteX82" fmla="*/ 1409700 w 1924050"/>
                <a:gd name="connsiteY82" fmla="*/ 307181 h 323850"/>
                <a:gd name="connsiteX83" fmla="*/ 1431131 w 1924050"/>
                <a:gd name="connsiteY83" fmla="*/ 304800 h 323850"/>
                <a:gd name="connsiteX84" fmla="*/ 1459706 w 1924050"/>
                <a:gd name="connsiteY84" fmla="*/ 300038 h 323850"/>
                <a:gd name="connsiteX85" fmla="*/ 1495425 w 1924050"/>
                <a:gd name="connsiteY85" fmla="*/ 297656 h 323850"/>
                <a:gd name="connsiteX86" fmla="*/ 1507331 w 1924050"/>
                <a:gd name="connsiteY86" fmla="*/ 295275 h 323850"/>
                <a:gd name="connsiteX87" fmla="*/ 1514475 w 1924050"/>
                <a:gd name="connsiteY87" fmla="*/ 292894 h 323850"/>
                <a:gd name="connsiteX88" fmla="*/ 1540669 w 1924050"/>
                <a:gd name="connsiteY88" fmla="*/ 288131 h 323850"/>
                <a:gd name="connsiteX89" fmla="*/ 1547812 w 1924050"/>
                <a:gd name="connsiteY89" fmla="*/ 285750 h 323850"/>
                <a:gd name="connsiteX90" fmla="*/ 1566862 w 1924050"/>
                <a:gd name="connsiteY90" fmla="*/ 283369 h 323850"/>
                <a:gd name="connsiteX91" fmla="*/ 1581150 w 1924050"/>
                <a:gd name="connsiteY91" fmla="*/ 280988 h 323850"/>
                <a:gd name="connsiteX92" fmla="*/ 1609725 w 1924050"/>
                <a:gd name="connsiteY92" fmla="*/ 271463 h 323850"/>
                <a:gd name="connsiteX93" fmla="*/ 1624012 w 1924050"/>
                <a:gd name="connsiteY93" fmla="*/ 266700 h 323850"/>
                <a:gd name="connsiteX94" fmla="*/ 1654969 w 1924050"/>
                <a:gd name="connsiteY94" fmla="*/ 264319 h 323850"/>
                <a:gd name="connsiteX95" fmla="*/ 1678781 w 1924050"/>
                <a:gd name="connsiteY95" fmla="*/ 259556 h 323850"/>
                <a:gd name="connsiteX96" fmla="*/ 1685925 w 1924050"/>
                <a:gd name="connsiteY96" fmla="*/ 257175 h 323850"/>
                <a:gd name="connsiteX97" fmla="*/ 1724025 w 1924050"/>
                <a:gd name="connsiteY97" fmla="*/ 252413 h 323850"/>
                <a:gd name="connsiteX98" fmla="*/ 1731169 w 1924050"/>
                <a:gd name="connsiteY98" fmla="*/ 250031 h 323850"/>
                <a:gd name="connsiteX99" fmla="*/ 1771650 w 1924050"/>
                <a:gd name="connsiteY99" fmla="*/ 242888 h 323850"/>
                <a:gd name="connsiteX100" fmla="*/ 1924050 w 1924050"/>
                <a:gd name="connsiteY100" fmla="*/ 240506 h 32385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  <a:cxn ang="0">
                  <a:pos x="connsiteX29" y="connsiteY29"/>
                </a:cxn>
                <a:cxn ang="0">
                  <a:pos x="connsiteX30" y="connsiteY30"/>
                </a:cxn>
                <a:cxn ang="0">
                  <a:pos x="connsiteX31" y="connsiteY31"/>
                </a:cxn>
                <a:cxn ang="0">
                  <a:pos x="connsiteX32" y="connsiteY32"/>
                </a:cxn>
                <a:cxn ang="0">
                  <a:pos x="connsiteX33" y="connsiteY33"/>
                </a:cxn>
                <a:cxn ang="0">
                  <a:pos x="connsiteX34" y="connsiteY34"/>
                </a:cxn>
                <a:cxn ang="0">
                  <a:pos x="connsiteX35" y="connsiteY35"/>
                </a:cxn>
                <a:cxn ang="0">
                  <a:pos x="connsiteX36" y="connsiteY36"/>
                </a:cxn>
                <a:cxn ang="0">
                  <a:pos x="connsiteX37" y="connsiteY37"/>
                </a:cxn>
                <a:cxn ang="0">
                  <a:pos x="connsiteX38" y="connsiteY38"/>
                </a:cxn>
                <a:cxn ang="0">
                  <a:pos x="connsiteX39" y="connsiteY39"/>
                </a:cxn>
                <a:cxn ang="0">
                  <a:pos x="connsiteX40" y="connsiteY40"/>
                </a:cxn>
                <a:cxn ang="0">
                  <a:pos x="connsiteX41" y="connsiteY41"/>
                </a:cxn>
                <a:cxn ang="0">
                  <a:pos x="connsiteX42" y="connsiteY42"/>
                </a:cxn>
                <a:cxn ang="0">
                  <a:pos x="connsiteX43" y="connsiteY43"/>
                </a:cxn>
                <a:cxn ang="0">
                  <a:pos x="connsiteX44" y="connsiteY44"/>
                </a:cxn>
                <a:cxn ang="0">
                  <a:pos x="connsiteX45" y="connsiteY45"/>
                </a:cxn>
                <a:cxn ang="0">
                  <a:pos x="connsiteX46" y="connsiteY46"/>
                </a:cxn>
                <a:cxn ang="0">
                  <a:pos x="connsiteX47" y="connsiteY47"/>
                </a:cxn>
                <a:cxn ang="0">
                  <a:pos x="connsiteX48" y="connsiteY48"/>
                </a:cxn>
                <a:cxn ang="0">
                  <a:pos x="connsiteX49" y="connsiteY49"/>
                </a:cxn>
                <a:cxn ang="0">
                  <a:pos x="connsiteX50" y="connsiteY50"/>
                </a:cxn>
                <a:cxn ang="0">
                  <a:pos x="connsiteX51" y="connsiteY51"/>
                </a:cxn>
                <a:cxn ang="0">
                  <a:pos x="connsiteX52" y="connsiteY52"/>
                </a:cxn>
                <a:cxn ang="0">
                  <a:pos x="connsiteX53" y="connsiteY53"/>
                </a:cxn>
                <a:cxn ang="0">
                  <a:pos x="connsiteX54" y="connsiteY54"/>
                </a:cxn>
                <a:cxn ang="0">
                  <a:pos x="connsiteX55" y="connsiteY55"/>
                </a:cxn>
                <a:cxn ang="0">
                  <a:pos x="connsiteX56" y="connsiteY56"/>
                </a:cxn>
                <a:cxn ang="0">
                  <a:pos x="connsiteX57" y="connsiteY57"/>
                </a:cxn>
                <a:cxn ang="0">
                  <a:pos x="connsiteX58" y="connsiteY58"/>
                </a:cxn>
                <a:cxn ang="0">
                  <a:pos x="connsiteX59" y="connsiteY59"/>
                </a:cxn>
                <a:cxn ang="0">
                  <a:pos x="connsiteX60" y="connsiteY60"/>
                </a:cxn>
                <a:cxn ang="0">
                  <a:pos x="connsiteX61" y="connsiteY61"/>
                </a:cxn>
                <a:cxn ang="0">
                  <a:pos x="connsiteX62" y="connsiteY62"/>
                </a:cxn>
                <a:cxn ang="0">
                  <a:pos x="connsiteX63" y="connsiteY63"/>
                </a:cxn>
                <a:cxn ang="0">
                  <a:pos x="connsiteX64" y="connsiteY64"/>
                </a:cxn>
                <a:cxn ang="0">
                  <a:pos x="connsiteX65" y="connsiteY65"/>
                </a:cxn>
                <a:cxn ang="0">
                  <a:pos x="connsiteX66" y="connsiteY66"/>
                </a:cxn>
                <a:cxn ang="0">
                  <a:pos x="connsiteX67" y="connsiteY67"/>
                </a:cxn>
                <a:cxn ang="0">
                  <a:pos x="connsiteX68" y="connsiteY68"/>
                </a:cxn>
                <a:cxn ang="0">
                  <a:pos x="connsiteX69" y="connsiteY69"/>
                </a:cxn>
                <a:cxn ang="0">
                  <a:pos x="connsiteX70" y="connsiteY70"/>
                </a:cxn>
                <a:cxn ang="0">
                  <a:pos x="connsiteX71" y="connsiteY71"/>
                </a:cxn>
                <a:cxn ang="0">
                  <a:pos x="connsiteX72" y="connsiteY72"/>
                </a:cxn>
                <a:cxn ang="0">
                  <a:pos x="connsiteX73" y="connsiteY73"/>
                </a:cxn>
                <a:cxn ang="0">
                  <a:pos x="connsiteX74" y="connsiteY74"/>
                </a:cxn>
                <a:cxn ang="0">
                  <a:pos x="connsiteX75" y="connsiteY75"/>
                </a:cxn>
                <a:cxn ang="0">
                  <a:pos x="connsiteX76" y="connsiteY76"/>
                </a:cxn>
                <a:cxn ang="0">
                  <a:pos x="connsiteX77" y="connsiteY77"/>
                </a:cxn>
                <a:cxn ang="0">
                  <a:pos x="connsiteX78" y="connsiteY78"/>
                </a:cxn>
                <a:cxn ang="0">
                  <a:pos x="connsiteX79" y="connsiteY79"/>
                </a:cxn>
                <a:cxn ang="0">
                  <a:pos x="connsiteX80" y="connsiteY80"/>
                </a:cxn>
                <a:cxn ang="0">
                  <a:pos x="connsiteX81" y="connsiteY81"/>
                </a:cxn>
                <a:cxn ang="0">
                  <a:pos x="connsiteX82" y="connsiteY82"/>
                </a:cxn>
                <a:cxn ang="0">
                  <a:pos x="connsiteX83" y="connsiteY83"/>
                </a:cxn>
                <a:cxn ang="0">
                  <a:pos x="connsiteX84" y="connsiteY84"/>
                </a:cxn>
                <a:cxn ang="0">
                  <a:pos x="connsiteX85" y="connsiteY85"/>
                </a:cxn>
                <a:cxn ang="0">
                  <a:pos x="connsiteX86" y="connsiteY86"/>
                </a:cxn>
                <a:cxn ang="0">
                  <a:pos x="connsiteX87" y="connsiteY87"/>
                </a:cxn>
                <a:cxn ang="0">
                  <a:pos x="connsiteX88" y="connsiteY88"/>
                </a:cxn>
                <a:cxn ang="0">
                  <a:pos x="connsiteX89" y="connsiteY89"/>
                </a:cxn>
                <a:cxn ang="0">
                  <a:pos x="connsiteX90" y="connsiteY90"/>
                </a:cxn>
                <a:cxn ang="0">
                  <a:pos x="connsiteX91" y="connsiteY91"/>
                </a:cxn>
                <a:cxn ang="0">
                  <a:pos x="connsiteX92" y="connsiteY92"/>
                </a:cxn>
                <a:cxn ang="0">
                  <a:pos x="connsiteX93" y="connsiteY93"/>
                </a:cxn>
                <a:cxn ang="0">
                  <a:pos x="connsiteX94" y="connsiteY94"/>
                </a:cxn>
                <a:cxn ang="0">
                  <a:pos x="connsiteX95" y="connsiteY95"/>
                </a:cxn>
                <a:cxn ang="0">
                  <a:pos x="connsiteX96" y="connsiteY96"/>
                </a:cxn>
                <a:cxn ang="0">
                  <a:pos x="connsiteX97" y="connsiteY97"/>
                </a:cxn>
                <a:cxn ang="0">
                  <a:pos x="connsiteX98" y="connsiteY98"/>
                </a:cxn>
                <a:cxn ang="0">
                  <a:pos x="connsiteX99" y="connsiteY99"/>
                </a:cxn>
                <a:cxn ang="0">
                  <a:pos x="connsiteX100" y="connsiteY100"/>
                </a:cxn>
              </a:cxnLst>
              <a:rect l="l" t="t" r="r" b="b"/>
              <a:pathLst>
                <a:path w="1924050" h="323850">
                  <a:moveTo>
                    <a:pt x="0" y="0"/>
                  </a:moveTo>
                  <a:cubicBezTo>
                    <a:pt x="8731" y="794"/>
                    <a:pt x="17515" y="1141"/>
                    <a:pt x="26194" y="2381"/>
                  </a:cubicBezTo>
                  <a:cubicBezTo>
                    <a:pt x="28679" y="2736"/>
                    <a:pt x="30902" y="4154"/>
                    <a:pt x="33337" y="4763"/>
                  </a:cubicBezTo>
                  <a:cubicBezTo>
                    <a:pt x="43537" y="7313"/>
                    <a:pt x="48934" y="7406"/>
                    <a:pt x="59531" y="9525"/>
                  </a:cubicBezTo>
                  <a:cubicBezTo>
                    <a:pt x="68531" y="11325"/>
                    <a:pt x="74228" y="13630"/>
                    <a:pt x="83344" y="16669"/>
                  </a:cubicBezTo>
                  <a:lnTo>
                    <a:pt x="90487" y="19050"/>
                  </a:lnTo>
                  <a:cubicBezTo>
                    <a:pt x="92868" y="20638"/>
                    <a:pt x="95071" y="22533"/>
                    <a:pt x="97631" y="23813"/>
                  </a:cubicBezTo>
                  <a:cubicBezTo>
                    <a:pt x="101632" y="25813"/>
                    <a:pt x="110486" y="27431"/>
                    <a:pt x="114300" y="28575"/>
                  </a:cubicBezTo>
                  <a:cubicBezTo>
                    <a:pt x="119108" y="30018"/>
                    <a:pt x="123825" y="31750"/>
                    <a:pt x="128587" y="33338"/>
                  </a:cubicBezTo>
                  <a:lnTo>
                    <a:pt x="142875" y="38100"/>
                  </a:lnTo>
                  <a:lnTo>
                    <a:pt x="150019" y="40481"/>
                  </a:lnTo>
                  <a:cubicBezTo>
                    <a:pt x="161340" y="48030"/>
                    <a:pt x="154445" y="44338"/>
                    <a:pt x="171450" y="50006"/>
                  </a:cubicBezTo>
                  <a:cubicBezTo>
                    <a:pt x="173831" y="50800"/>
                    <a:pt x="176505" y="50996"/>
                    <a:pt x="178594" y="52388"/>
                  </a:cubicBezTo>
                  <a:cubicBezTo>
                    <a:pt x="189913" y="59934"/>
                    <a:pt x="183023" y="56246"/>
                    <a:pt x="200025" y="61913"/>
                  </a:cubicBezTo>
                  <a:lnTo>
                    <a:pt x="214312" y="66675"/>
                  </a:lnTo>
                  <a:lnTo>
                    <a:pt x="221456" y="69056"/>
                  </a:lnTo>
                  <a:cubicBezTo>
                    <a:pt x="228961" y="74059"/>
                    <a:pt x="227400" y="73924"/>
                    <a:pt x="235744" y="76200"/>
                  </a:cubicBezTo>
                  <a:cubicBezTo>
                    <a:pt x="242059" y="77922"/>
                    <a:pt x="254794" y="80963"/>
                    <a:pt x="254794" y="80963"/>
                  </a:cubicBezTo>
                  <a:cubicBezTo>
                    <a:pt x="275268" y="94612"/>
                    <a:pt x="249361" y="78246"/>
                    <a:pt x="269081" y="88106"/>
                  </a:cubicBezTo>
                  <a:cubicBezTo>
                    <a:pt x="287546" y="97338"/>
                    <a:pt x="265413" y="89265"/>
                    <a:pt x="283369" y="95250"/>
                  </a:cubicBezTo>
                  <a:cubicBezTo>
                    <a:pt x="285750" y="96838"/>
                    <a:pt x="287897" y="98851"/>
                    <a:pt x="290512" y="100013"/>
                  </a:cubicBezTo>
                  <a:cubicBezTo>
                    <a:pt x="295100" y="102052"/>
                    <a:pt x="300037" y="103188"/>
                    <a:pt x="304800" y="104775"/>
                  </a:cubicBezTo>
                  <a:cubicBezTo>
                    <a:pt x="307181" y="105569"/>
                    <a:pt x="309699" y="106033"/>
                    <a:pt x="311944" y="107156"/>
                  </a:cubicBezTo>
                  <a:cubicBezTo>
                    <a:pt x="318294" y="110331"/>
                    <a:pt x="324259" y="114436"/>
                    <a:pt x="330994" y="116681"/>
                  </a:cubicBezTo>
                  <a:lnTo>
                    <a:pt x="352425" y="123825"/>
                  </a:lnTo>
                  <a:lnTo>
                    <a:pt x="359569" y="126206"/>
                  </a:lnTo>
                  <a:cubicBezTo>
                    <a:pt x="361950" y="127794"/>
                    <a:pt x="364097" y="129807"/>
                    <a:pt x="366712" y="130969"/>
                  </a:cubicBezTo>
                  <a:cubicBezTo>
                    <a:pt x="371300" y="133008"/>
                    <a:pt x="376237" y="134143"/>
                    <a:pt x="381000" y="135731"/>
                  </a:cubicBezTo>
                  <a:lnTo>
                    <a:pt x="388144" y="138113"/>
                  </a:lnTo>
                  <a:lnTo>
                    <a:pt x="395287" y="140494"/>
                  </a:lnTo>
                  <a:lnTo>
                    <a:pt x="402431" y="142875"/>
                  </a:lnTo>
                  <a:cubicBezTo>
                    <a:pt x="413765" y="150431"/>
                    <a:pt x="405121" y="145826"/>
                    <a:pt x="419100" y="150019"/>
                  </a:cubicBezTo>
                  <a:cubicBezTo>
                    <a:pt x="423908" y="151461"/>
                    <a:pt x="428625" y="153194"/>
                    <a:pt x="433387" y="154781"/>
                  </a:cubicBezTo>
                  <a:lnTo>
                    <a:pt x="447675" y="159544"/>
                  </a:lnTo>
                  <a:cubicBezTo>
                    <a:pt x="450056" y="160338"/>
                    <a:pt x="452358" y="161433"/>
                    <a:pt x="454819" y="161925"/>
                  </a:cubicBezTo>
                  <a:cubicBezTo>
                    <a:pt x="458788" y="162719"/>
                    <a:pt x="462820" y="163241"/>
                    <a:pt x="466725" y="164306"/>
                  </a:cubicBezTo>
                  <a:cubicBezTo>
                    <a:pt x="471568" y="165627"/>
                    <a:pt x="476142" y="167852"/>
                    <a:pt x="481012" y="169069"/>
                  </a:cubicBezTo>
                  <a:cubicBezTo>
                    <a:pt x="484187" y="169863"/>
                    <a:pt x="487390" y="170551"/>
                    <a:pt x="490537" y="171450"/>
                  </a:cubicBezTo>
                  <a:cubicBezTo>
                    <a:pt x="492951" y="172140"/>
                    <a:pt x="495235" y="173267"/>
                    <a:pt x="497681" y="173831"/>
                  </a:cubicBezTo>
                  <a:cubicBezTo>
                    <a:pt x="505569" y="175651"/>
                    <a:pt x="513815" y="176034"/>
                    <a:pt x="521494" y="178594"/>
                  </a:cubicBezTo>
                  <a:cubicBezTo>
                    <a:pt x="523875" y="179388"/>
                    <a:pt x="526191" y="180411"/>
                    <a:pt x="528637" y="180975"/>
                  </a:cubicBezTo>
                  <a:cubicBezTo>
                    <a:pt x="536525" y="182795"/>
                    <a:pt x="544597" y="183775"/>
                    <a:pt x="552450" y="185738"/>
                  </a:cubicBezTo>
                  <a:cubicBezTo>
                    <a:pt x="566840" y="189335"/>
                    <a:pt x="558878" y="187086"/>
                    <a:pt x="576262" y="192881"/>
                  </a:cubicBezTo>
                  <a:lnTo>
                    <a:pt x="590550" y="197644"/>
                  </a:lnTo>
                  <a:cubicBezTo>
                    <a:pt x="596900" y="199231"/>
                    <a:pt x="603391" y="200336"/>
                    <a:pt x="609600" y="202406"/>
                  </a:cubicBezTo>
                  <a:cubicBezTo>
                    <a:pt x="615724" y="204448"/>
                    <a:pt x="619686" y="205972"/>
                    <a:pt x="626269" y="207169"/>
                  </a:cubicBezTo>
                  <a:cubicBezTo>
                    <a:pt x="641872" y="210006"/>
                    <a:pt x="640003" y="208193"/>
                    <a:pt x="652462" y="211931"/>
                  </a:cubicBezTo>
                  <a:cubicBezTo>
                    <a:pt x="657271" y="213374"/>
                    <a:pt x="661880" y="215477"/>
                    <a:pt x="666750" y="216694"/>
                  </a:cubicBezTo>
                  <a:cubicBezTo>
                    <a:pt x="669925" y="217488"/>
                    <a:pt x="673128" y="218176"/>
                    <a:pt x="676275" y="219075"/>
                  </a:cubicBezTo>
                  <a:cubicBezTo>
                    <a:pt x="678689" y="219765"/>
                    <a:pt x="680984" y="220847"/>
                    <a:pt x="683419" y="221456"/>
                  </a:cubicBezTo>
                  <a:cubicBezTo>
                    <a:pt x="687345" y="222438"/>
                    <a:pt x="691381" y="222928"/>
                    <a:pt x="695325" y="223838"/>
                  </a:cubicBezTo>
                  <a:cubicBezTo>
                    <a:pt x="701703" y="225310"/>
                    <a:pt x="708025" y="227013"/>
                    <a:pt x="714375" y="228600"/>
                  </a:cubicBezTo>
                  <a:cubicBezTo>
                    <a:pt x="717550" y="229394"/>
                    <a:pt x="720691" y="230339"/>
                    <a:pt x="723900" y="230981"/>
                  </a:cubicBezTo>
                  <a:cubicBezTo>
                    <a:pt x="727869" y="231775"/>
                    <a:pt x="731855" y="232485"/>
                    <a:pt x="735806" y="233363"/>
                  </a:cubicBezTo>
                  <a:cubicBezTo>
                    <a:pt x="739001" y="234073"/>
                    <a:pt x="742184" y="234845"/>
                    <a:pt x="745331" y="235744"/>
                  </a:cubicBezTo>
                  <a:cubicBezTo>
                    <a:pt x="747745" y="236434"/>
                    <a:pt x="750040" y="237516"/>
                    <a:pt x="752475" y="238125"/>
                  </a:cubicBezTo>
                  <a:cubicBezTo>
                    <a:pt x="756401" y="239107"/>
                    <a:pt x="760430" y="239628"/>
                    <a:pt x="764381" y="240506"/>
                  </a:cubicBezTo>
                  <a:cubicBezTo>
                    <a:pt x="767576" y="241216"/>
                    <a:pt x="770686" y="242302"/>
                    <a:pt x="773906" y="242888"/>
                  </a:cubicBezTo>
                  <a:cubicBezTo>
                    <a:pt x="790844" y="245968"/>
                    <a:pt x="800637" y="245914"/>
                    <a:pt x="819150" y="247650"/>
                  </a:cubicBezTo>
                  <a:cubicBezTo>
                    <a:pt x="835035" y="249139"/>
                    <a:pt x="851131" y="249284"/>
                    <a:pt x="866775" y="252413"/>
                  </a:cubicBezTo>
                  <a:cubicBezTo>
                    <a:pt x="892259" y="257509"/>
                    <a:pt x="863118" y="251983"/>
                    <a:pt x="897731" y="257175"/>
                  </a:cubicBezTo>
                  <a:cubicBezTo>
                    <a:pt x="907281" y="258607"/>
                    <a:pt x="917145" y="258885"/>
                    <a:pt x="926306" y="261938"/>
                  </a:cubicBezTo>
                  <a:cubicBezTo>
                    <a:pt x="936573" y="265360"/>
                    <a:pt x="939064" y="266393"/>
                    <a:pt x="952500" y="269081"/>
                  </a:cubicBezTo>
                  <a:cubicBezTo>
                    <a:pt x="956469" y="269875"/>
                    <a:pt x="960480" y="270481"/>
                    <a:pt x="964406" y="271463"/>
                  </a:cubicBezTo>
                  <a:cubicBezTo>
                    <a:pt x="966841" y="272072"/>
                    <a:pt x="969136" y="273154"/>
                    <a:pt x="971550" y="273844"/>
                  </a:cubicBezTo>
                  <a:cubicBezTo>
                    <a:pt x="974697" y="274743"/>
                    <a:pt x="977928" y="275326"/>
                    <a:pt x="981075" y="276225"/>
                  </a:cubicBezTo>
                  <a:cubicBezTo>
                    <a:pt x="983489" y="276915"/>
                    <a:pt x="985784" y="277997"/>
                    <a:pt x="988219" y="278606"/>
                  </a:cubicBezTo>
                  <a:cubicBezTo>
                    <a:pt x="992145" y="279588"/>
                    <a:pt x="996220" y="279923"/>
                    <a:pt x="1000125" y="280988"/>
                  </a:cubicBezTo>
                  <a:cubicBezTo>
                    <a:pt x="1004968" y="282309"/>
                    <a:pt x="1009650" y="284163"/>
                    <a:pt x="1014412" y="285750"/>
                  </a:cubicBezTo>
                  <a:lnTo>
                    <a:pt x="1042987" y="295275"/>
                  </a:lnTo>
                  <a:lnTo>
                    <a:pt x="1057275" y="300038"/>
                  </a:lnTo>
                  <a:lnTo>
                    <a:pt x="1064419" y="302419"/>
                  </a:lnTo>
                  <a:cubicBezTo>
                    <a:pt x="1066800" y="304006"/>
                    <a:pt x="1068932" y="306054"/>
                    <a:pt x="1071562" y="307181"/>
                  </a:cubicBezTo>
                  <a:cubicBezTo>
                    <a:pt x="1077536" y="309741"/>
                    <a:pt x="1093275" y="311129"/>
                    <a:pt x="1097756" y="311944"/>
                  </a:cubicBezTo>
                  <a:cubicBezTo>
                    <a:pt x="1100976" y="312529"/>
                    <a:pt x="1104037" y="313893"/>
                    <a:pt x="1107281" y="314325"/>
                  </a:cubicBezTo>
                  <a:cubicBezTo>
                    <a:pt x="1122860" y="316402"/>
                    <a:pt x="1158524" y="318272"/>
                    <a:pt x="1171575" y="319088"/>
                  </a:cubicBezTo>
                  <a:cubicBezTo>
                    <a:pt x="1186739" y="322879"/>
                    <a:pt x="1188451" y="323850"/>
                    <a:pt x="1209675" y="323850"/>
                  </a:cubicBezTo>
                  <a:cubicBezTo>
                    <a:pt x="1242228" y="323850"/>
                    <a:pt x="1274762" y="322263"/>
                    <a:pt x="1307306" y="321469"/>
                  </a:cubicBezTo>
                  <a:cubicBezTo>
                    <a:pt x="1319212" y="320675"/>
                    <a:pt x="1331158" y="320337"/>
                    <a:pt x="1343025" y="319088"/>
                  </a:cubicBezTo>
                  <a:cubicBezTo>
                    <a:pt x="1346280" y="318745"/>
                    <a:pt x="1349355" y="317416"/>
                    <a:pt x="1352550" y="316706"/>
                  </a:cubicBezTo>
                  <a:cubicBezTo>
                    <a:pt x="1363607" y="314249"/>
                    <a:pt x="1363811" y="314849"/>
                    <a:pt x="1373981" y="311944"/>
                  </a:cubicBezTo>
                  <a:cubicBezTo>
                    <a:pt x="1376395" y="311254"/>
                    <a:pt x="1378637" y="309895"/>
                    <a:pt x="1381125" y="309563"/>
                  </a:cubicBezTo>
                  <a:cubicBezTo>
                    <a:pt x="1390599" y="308300"/>
                    <a:pt x="1400185" y="308087"/>
                    <a:pt x="1409700" y="307181"/>
                  </a:cubicBezTo>
                  <a:cubicBezTo>
                    <a:pt x="1416855" y="306499"/>
                    <a:pt x="1424016" y="305816"/>
                    <a:pt x="1431131" y="304800"/>
                  </a:cubicBezTo>
                  <a:cubicBezTo>
                    <a:pt x="1452791" y="301706"/>
                    <a:pt x="1433137" y="302454"/>
                    <a:pt x="1459706" y="300038"/>
                  </a:cubicBezTo>
                  <a:cubicBezTo>
                    <a:pt x="1471590" y="298958"/>
                    <a:pt x="1483519" y="298450"/>
                    <a:pt x="1495425" y="297656"/>
                  </a:cubicBezTo>
                  <a:cubicBezTo>
                    <a:pt x="1499394" y="296862"/>
                    <a:pt x="1503405" y="296257"/>
                    <a:pt x="1507331" y="295275"/>
                  </a:cubicBezTo>
                  <a:cubicBezTo>
                    <a:pt x="1509766" y="294666"/>
                    <a:pt x="1512040" y="293503"/>
                    <a:pt x="1514475" y="292894"/>
                  </a:cubicBezTo>
                  <a:cubicBezTo>
                    <a:pt x="1531803" y="288562"/>
                    <a:pt x="1521568" y="292376"/>
                    <a:pt x="1540669" y="288131"/>
                  </a:cubicBezTo>
                  <a:cubicBezTo>
                    <a:pt x="1543119" y="287586"/>
                    <a:pt x="1545343" y="286199"/>
                    <a:pt x="1547812" y="285750"/>
                  </a:cubicBezTo>
                  <a:cubicBezTo>
                    <a:pt x="1554108" y="284605"/>
                    <a:pt x="1560527" y="284274"/>
                    <a:pt x="1566862" y="283369"/>
                  </a:cubicBezTo>
                  <a:cubicBezTo>
                    <a:pt x="1571642" y="282686"/>
                    <a:pt x="1576387" y="281782"/>
                    <a:pt x="1581150" y="280988"/>
                  </a:cubicBezTo>
                  <a:lnTo>
                    <a:pt x="1609725" y="271463"/>
                  </a:lnTo>
                  <a:cubicBezTo>
                    <a:pt x="1609727" y="271462"/>
                    <a:pt x="1624009" y="266700"/>
                    <a:pt x="1624012" y="266700"/>
                  </a:cubicBezTo>
                  <a:lnTo>
                    <a:pt x="1654969" y="264319"/>
                  </a:lnTo>
                  <a:cubicBezTo>
                    <a:pt x="1666207" y="262446"/>
                    <a:pt x="1668827" y="262400"/>
                    <a:pt x="1678781" y="259556"/>
                  </a:cubicBezTo>
                  <a:cubicBezTo>
                    <a:pt x="1681195" y="258866"/>
                    <a:pt x="1683475" y="257719"/>
                    <a:pt x="1685925" y="257175"/>
                  </a:cubicBezTo>
                  <a:cubicBezTo>
                    <a:pt x="1698011" y="254489"/>
                    <a:pt x="1712046" y="253611"/>
                    <a:pt x="1724025" y="252413"/>
                  </a:cubicBezTo>
                  <a:cubicBezTo>
                    <a:pt x="1726406" y="251619"/>
                    <a:pt x="1728734" y="250640"/>
                    <a:pt x="1731169" y="250031"/>
                  </a:cubicBezTo>
                  <a:cubicBezTo>
                    <a:pt x="1744462" y="246707"/>
                    <a:pt x="1758357" y="246212"/>
                    <a:pt x="1771650" y="242888"/>
                  </a:cubicBezTo>
                  <a:cubicBezTo>
                    <a:pt x="1827377" y="228952"/>
                    <a:pt x="1777902" y="240506"/>
                    <a:pt x="1924050" y="240506"/>
                  </a:cubicBezTo>
                </a:path>
              </a:pathLst>
            </a:custGeom>
            <a:noFill/>
            <a:ln w="38100">
              <a:solidFill>
                <a:schemeClr val="bg1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9666"/>
            </a:p>
          </p:txBody>
        </p:sp>
        <p:sp>
          <p:nvSpPr>
            <p:cNvPr id="236" name="Freeform 235"/>
            <p:cNvSpPr/>
            <p:nvPr/>
          </p:nvSpPr>
          <p:spPr>
            <a:xfrm>
              <a:off x="4953204" y="3315635"/>
              <a:ext cx="1785617" cy="296014"/>
            </a:xfrm>
            <a:custGeom>
              <a:avLst/>
              <a:gdLst>
                <a:gd name="connsiteX0" fmla="*/ 0 w 1931193"/>
                <a:gd name="connsiteY0" fmla="*/ 0 h 319088"/>
                <a:gd name="connsiteX1" fmla="*/ 11906 w 1931193"/>
                <a:gd name="connsiteY1" fmla="*/ 2381 h 319088"/>
                <a:gd name="connsiteX2" fmla="*/ 21431 w 1931193"/>
                <a:gd name="connsiteY2" fmla="*/ 4763 h 319088"/>
                <a:gd name="connsiteX3" fmla="*/ 47625 w 1931193"/>
                <a:gd name="connsiteY3" fmla="*/ 7144 h 319088"/>
                <a:gd name="connsiteX4" fmla="*/ 173831 w 1931193"/>
                <a:gd name="connsiteY4" fmla="*/ 11906 h 319088"/>
                <a:gd name="connsiteX5" fmla="*/ 183356 w 1931193"/>
                <a:gd name="connsiteY5" fmla="*/ 14288 h 319088"/>
                <a:gd name="connsiteX6" fmla="*/ 204787 w 1931193"/>
                <a:gd name="connsiteY6" fmla="*/ 19050 h 319088"/>
                <a:gd name="connsiteX7" fmla="*/ 211931 w 1931193"/>
                <a:gd name="connsiteY7" fmla="*/ 26194 h 319088"/>
                <a:gd name="connsiteX8" fmla="*/ 216693 w 1931193"/>
                <a:gd name="connsiteY8" fmla="*/ 40481 h 319088"/>
                <a:gd name="connsiteX9" fmla="*/ 214312 w 1931193"/>
                <a:gd name="connsiteY9" fmla="*/ 47625 h 319088"/>
                <a:gd name="connsiteX10" fmla="*/ 216693 w 1931193"/>
                <a:gd name="connsiteY10" fmla="*/ 66675 h 319088"/>
                <a:gd name="connsiteX11" fmla="*/ 230981 w 1931193"/>
                <a:gd name="connsiteY11" fmla="*/ 73819 h 319088"/>
                <a:gd name="connsiteX12" fmla="*/ 273843 w 1931193"/>
                <a:gd name="connsiteY12" fmla="*/ 78581 h 319088"/>
                <a:gd name="connsiteX13" fmla="*/ 307181 w 1931193"/>
                <a:gd name="connsiteY13" fmla="*/ 83344 h 319088"/>
                <a:gd name="connsiteX14" fmla="*/ 330993 w 1931193"/>
                <a:gd name="connsiteY14" fmla="*/ 88106 h 319088"/>
                <a:gd name="connsiteX15" fmla="*/ 345281 w 1931193"/>
                <a:gd name="connsiteY15" fmla="*/ 92869 h 319088"/>
                <a:gd name="connsiteX16" fmla="*/ 352425 w 1931193"/>
                <a:gd name="connsiteY16" fmla="*/ 97631 h 319088"/>
                <a:gd name="connsiteX17" fmla="*/ 366712 w 1931193"/>
                <a:gd name="connsiteY17" fmla="*/ 104775 h 319088"/>
                <a:gd name="connsiteX18" fmla="*/ 371475 w 1931193"/>
                <a:gd name="connsiteY18" fmla="*/ 111919 h 319088"/>
                <a:gd name="connsiteX19" fmla="*/ 378618 w 1931193"/>
                <a:gd name="connsiteY19" fmla="*/ 114300 h 319088"/>
                <a:gd name="connsiteX20" fmla="*/ 385762 w 1931193"/>
                <a:gd name="connsiteY20" fmla="*/ 119063 h 319088"/>
                <a:gd name="connsiteX21" fmla="*/ 400050 w 1931193"/>
                <a:gd name="connsiteY21" fmla="*/ 130969 h 319088"/>
                <a:gd name="connsiteX22" fmla="*/ 414337 w 1931193"/>
                <a:gd name="connsiteY22" fmla="*/ 135731 h 319088"/>
                <a:gd name="connsiteX23" fmla="*/ 421481 w 1931193"/>
                <a:gd name="connsiteY23" fmla="*/ 140494 h 319088"/>
                <a:gd name="connsiteX24" fmla="*/ 442912 w 1931193"/>
                <a:gd name="connsiteY24" fmla="*/ 145256 h 319088"/>
                <a:gd name="connsiteX25" fmla="*/ 461962 w 1931193"/>
                <a:gd name="connsiteY25" fmla="*/ 150019 h 319088"/>
                <a:gd name="connsiteX26" fmla="*/ 490537 w 1931193"/>
                <a:gd name="connsiteY26" fmla="*/ 152400 h 319088"/>
                <a:gd name="connsiteX27" fmla="*/ 545306 w 1931193"/>
                <a:gd name="connsiteY27" fmla="*/ 150019 h 319088"/>
                <a:gd name="connsiteX28" fmla="*/ 559593 w 1931193"/>
                <a:gd name="connsiteY28" fmla="*/ 142875 h 319088"/>
                <a:gd name="connsiteX29" fmla="*/ 573881 w 1931193"/>
                <a:gd name="connsiteY29" fmla="*/ 138113 h 319088"/>
                <a:gd name="connsiteX30" fmla="*/ 588168 w 1931193"/>
                <a:gd name="connsiteY30" fmla="*/ 128588 h 319088"/>
                <a:gd name="connsiteX31" fmla="*/ 595312 w 1931193"/>
                <a:gd name="connsiteY31" fmla="*/ 121444 h 319088"/>
                <a:gd name="connsiteX32" fmla="*/ 600075 w 1931193"/>
                <a:gd name="connsiteY32" fmla="*/ 114300 h 319088"/>
                <a:gd name="connsiteX33" fmla="*/ 607218 w 1931193"/>
                <a:gd name="connsiteY33" fmla="*/ 109538 h 319088"/>
                <a:gd name="connsiteX34" fmla="*/ 623887 w 1931193"/>
                <a:gd name="connsiteY34" fmla="*/ 88106 h 319088"/>
                <a:gd name="connsiteX35" fmla="*/ 638175 w 1931193"/>
                <a:gd name="connsiteY35" fmla="*/ 78581 h 319088"/>
                <a:gd name="connsiteX36" fmla="*/ 666750 w 1931193"/>
                <a:gd name="connsiteY36" fmla="*/ 69056 h 319088"/>
                <a:gd name="connsiteX37" fmla="*/ 681037 w 1931193"/>
                <a:gd name="connsiteY37" fmla="*/ 64294 h 319088"/>
                <a:gd name="connsiteX38" fmla="*/ 688181 w 1931193"/>
                <a:gd name="connsiteY38" fmla="*/ 61913 h 319088"/>
                <a:gd name="connsiteX39" fmla="*/ 707231 w 1931193"/>
                <a:gd name="connsiteY39" fmla="*/ 57150 h 319088"/>
                <a:gd name="connsiteX40" fmla="*/ 721518 w 1931193"/>
                <a:gd name="connsiteY40" fmla="*/ 52388 h 319088"/>
                <a:gd name="connsiteX41" fmla="*/ 731043 w 1931193"/>
                <a:gd name="connsiteY41" fmla="*/ 50006 h 319088"/>
                <a:gd name="connsiteX42" fmla="*/ 745331 w 1931193"/>
                <a:gd name="connsiteY42" fmla="*/ 45244 h 319088"/>
                <a:gd name="connsiteX43" fmla="*/ 759618 w 1931193"/>
                <a:gd name="connsiteY43" fmla="*/ 40481 h 319088"/>
                <a:gd name="connsiteX44" fmla="*/ 773906 w 1931193"/>
                <a:gd name="connsiteY44" fmla="*/ 33338 h 319088"/>
                <a:gd name="connsiteX45" fmla="*/ 788193 w 1931193"/>
                <a:gd name="connsiteY45" fmla="*/ 28575 h 319088"/>
                <a:gd name="connsiteX46" fmla="*/ 809625 w 1931193"/>
                <a:gd name="connsiteY46" fmla="*/ 19050 h 319088"/>
                <a:gd name="connsiteX47" fmla="*/ 823912 w 1931193"/>
                <a:gd name="connsiteY47" fmla="*/ 14288 h 319088"/>
                <a:gd name="connsiteX48" fmla="*/ 831056 w 1931193"/>
                <a:gd name="connsiteY48" fmla="*/ 11906 h 319088"/>
                <a:gd name="connsiteX49" fmla="*/ 869156 w 1931193"/>
                <a:gd name="connsiteY49" fmla="*/ 14288 h 319088"/>
                <a:gd name="connsiteX50" fmla="*/ 888206 w 1931193"/>
                <a:gd name="connsiteY50" fmla="*/ 19050 h 319088"/>
                <a:gd name="connsiteX51" fmla="*/ 909637 w 1931193"/>
                <a:gd name="connsiteY51" fmla="*/ 26194 h 319088"/>
                <a:gd name="connsiteX52" fmla="*/ 923925 w 1931193"/>
                <a:gd name="connsiteY52" fmla="*/ 30956 h 319088"/>
                <a:gd name="connsiteX53" fmla="*/ 931068 w 1931193"/>
                <a:gd name="connsiteY53" fmla="*/ 33338 h 319088"/>
                <a:gd name="connsiteX54" fmla="*/ 947737 w 1931193"/>
                <a:gd name="connsiteY54" fmla="*/ 45244 h 319088"/>
                <a:gd name="connsiteX55" fmla="*/ 954881 w 1931193"/>
                <a:gd name="connsiteY55" fmla="*/ 50006 h 319088"/>
                <a:gd name="connsiteX56" fmla="*/ 969168 w 1931193"/>
                <a:gd name="connsiteY56" fmla="*/ 54769 h 319088"/>
                <a:gd name="connsiteX57" fmla="*/ 976312 w 1931193"/>
                <a:gd name="connsiteY57" fmla="*/ 59531 h 319088"/>
                <a:gd name="connsiteX58" fmla="*/ 985837 w 1931193"/>
                <a:gd name="connsiteY58" fmla="*/ 61913 h 319088"/>
                <a:gd name="connsiteX59" fmla="*/ 992981 w 1931193"/>
                <a:gd name="connsiteY59" fmla="*/ 64294 h 319088"/>
                <a:gd name="connsiteX60" fmla="*/ 1004887 w 1931193"/>
                <a:gd name="connsiteY60" fmla="*/ 66675 h 319088"/>
                <a:gd name="connsiteX61" fmla="*/ 1019175 w 1931193"/>
                <a:gd name="connsiteY61" fmla="*/ 71438 h 319088"/>
                <a:gd name="connsiteX62" fmla="*/ 1045368 w 1931193"/>
                <a:gd name="connsiteY62" fmla="*/ 78581 h 319088"/>
                <a:gd name="connsiteX63" fmla="*/ 1073943 w 1931193"/>
                <a:gd name="connsiteY63" fmla="*/ 83344 h 319088"/>
                <a:gd name="connsiteX64" fmla="*/ 1092993 w 1931193"/>
                <a:gd name="connsiteY64" fmla="*/ 88106 h 319088"/>
                <a:gd name="connsiteX65" fmla="*/ 1107281 w 1931193"/>
                <a:gd name="connsiteY65" fmla="*/ 92869 h 319088"/>
                <a:gd name="connsiteX66" fmla="*/ 1126331 w 1931193"/>
                <a:gd name="connsiteY66" fmla="*/ 97631 h 319088"/>
                <a:gd name="connsiteX67" fmla="*/ 1135856 w 1931193"/>
                <a:gd name="connsiteY67" fmla="*/ 100013 h 319088"/>
                <a:gd name="connsiteX68" fmla="*/ 1143000 w 1931193"/>
                <a:gd name="connsiteY68" fmla="*/ 102394 h 319088"/>
                <a:gd name="connsiteX69" fmla="*/ 1173956 w 1931193"/>
                <a:gd name="connsiteY69" fmla="*/ 107156 h 319088"/>
                <a:gd name="connsiteX70" fmla="*/ 1202531 w 1931193"/>
                <a:gd name="connsiteY70" fmla="*/ 111919 h 319088"/>
                <a:gd name="connsiteX71" fmla="*/ 1231106 w 1931193"/>
                <a:gd name="connsiteY71" fmla="*/ 114300 h 319088"/>
                <a:gd name="connsiteX72" fmla="*/ 1240631 w 1931193"/>
                <a:gd name="connsiteY72" fmla="*/ 116681 h 319088"/>
                <a:gd name="connsiteX73" fmla="*/ 1252537 w 1931193"/>
                <a:gd name="connsiteY73" fmla="*/ 119063 h 319088"/>
                <a:gd name="connsiteX74" fmla="*/ 1266825 w 1931193"/>
                <a:gd name="connsiteY74" fmla="*/ 123825 h 319088"/>
                <a:gd name="connsiteX75" fmla="*/ 1276350 w 1931193"/>
                <a:gd name="connsiteY75" fmla="*/ 126206 h 319088"/>
                <a:gd name="connsiteX76" fmla="*/ 1283493 w 1931193"/>
                <a:gd name="connsiteY76" fmla="*/ 128588 h 319088"/>
                <a:gd name="connsiteX77" fmla="*/ 1309687 w 1931193"/>
                <a:gd name="connsiteY77" fmla="*/ 133350 h 319088"/>
                <a:gd name="connsiteX78" fmla="*/ 1316831 w 1931193"/>
                <a:gd name="connsiteY78" fmla="*/ 135731 h 319088"/>
                <a:gd name="connsiteX79" fmla="*/ 1326356 w 1931193"/>
                <a:gd name="connsiteY79" fmla="*/ 138113 h 319088"/>
                <a:gd name="connsiteX80" fmla="*/ 1350168 w 1931193"/>
                <a:gd name="connsiteY80" fmla="*/ 142875 h 319088"/>
                <a:gd name="connsiteX81" fmla="*/ 1459706 w 1931193"/>
                <a:gd name="connsiteY81" fmla="*/ 145256 h 319088"/>
                <a:gd name="connsiteX82" fmla="*/ 1476375 w 1931193"/>
                <a:gd name="connsiteY82" fmla="*/ 147638 h 319088"/>
                <a:gd name="connsiteX83" fmla="*/ 1483518 w 1931193"/>
                <a:gd name="connsiteY83" fmla="*/ 150019 h 319088"/>
                <a:gd name="connsiteX84" fmla="*/ 1500187 w 1931193"/>
                <a:gd name="connsiteY84" fmla="*/ 152400 h 319088"/>
                <a:gd name="connsiteX85" fmla="*/ 1519237 w 1931193"/>
                <a:gd name="connsiteY85" fmla="*/ 157163 h 319088"/>
                <a:gd name="connsiteX86" fmla="*/ 1535906 w 1931193"/>
                <a:gd name="connsiteY86" fmla="*/ 161925 h 319088"/>
                <a:gd name="connsiteX87" fmla="*/ 1550193 w 1931193"/>
                <a:gd name="connsiteY87" fmla="*/ 171450 h 319088"/>
                <a:gd name="connsiteX88" fmla="*/ 1562100 w 1931193"/>
                <a:gd name="connsiteY88" fmla="*/ 183356 h 319088"/>
                <a:gd name="connsiteX89" fmla="*/ 1569243 w 1931193"/>
                <a:gd name="connsiteY89" fmla="*/ 190500 h 319088"/>
                <a:gd name="connsiteX90" fmla="*/ 1576387 w 1931193"/>
                <a:gd name="connsiteY90" fmla="*/ 195263 h 319088"/>
                <a:gd name="connsiteX91" fmla="*/ 1593056 w 1931193"/>
                <a:gd name="connsiteY91" fmla="*/ 207169 h 319088"/>
                <a:gd name="connsiteX92" fmla="*/ 1600200 w 1931193"/>
                <a:gd name="connsiteY92" fmla="*/ 209550 h 319088"/>
                <a:gd name="connsiteX93" fmla="*/ 1607343 w 1931193"/>
                <a:gd name="connsiteY93" fmla="*/ 214313 h 319088"/>
                <a:gd name="connsiteX94" fmla="*/ 1616868 w 1931193"/>
                <a:gd name="connsiteY94" fmla="*/ 219075 h 319088"/>
                <a:gd name="connsiteX95" fmla="*/ 1626393 w 1931193"/>
                <a:gd name="connsiteY95" fmla="*/ 226219 h 319088"/>
                <a:gd name="connsiteX96" fmla="*/ 1640681 w 1931193"/>
                <a:gd name="connsiteY96" fmla="*/ 230981 h 319088"/>
                <a:gd name="connsiteX97" fmla="*/ 1659731 w 1931193"/>
                <a:gd name="connsiteY97" fmla="*/ 240506 h 319088"/>
                <a:gd name="connsiteX98" fmla="*/ 1707356 w 1931193"/>
                <a:gd name="connsiteY98" fmla="*/ 242888 h 319088"/>
                <a:gd name="connsiteX99" fmla="*/ 1721643 w 1931193"/>
                <a:gd name="connsiteY99" fmla="*/ 250031 h 319088"/>
                <a:gd name="connsiteX100" fmla="*/ 1726406 w 1931193"/>
                <a:gd name="connsiteY100" fmla="*/ 257175 h 319088"/>
                <a:gd name="connsiteX101" fmla="*/ 1735931 w 1931193"/>
                <a:gd name="connsiteY101" fmla="*/ 261938 h 319088"/>
                <a:gd name="connsiteX102" fmla="*/ 1743075 w 1931193"/>
                <a:gd name="connsiteY102" fmla="*/ 266700 h 319088"/>
                <a:gd name="connsiteX103" fmla="*/ 1752600 w 1931193"/>
                <a:gd name="connsiteY103" fmla="*/ 273844 h 319088"/>
                <a:gd name="connsiteX104" fmla="*/ 1759743 w 1931193"/>
                <a:gd name="connsiteY104" fmla="*/ 276225 h 319088"/>
                <a:gd name="connsiteX105" fmla="*/ 1774031 w 1931193"/>
                <a:gd name="connsiteY105" fmla="*/ 285750 h 319088"/>
                <a:gd name="connsiteX106" fmla="*/ 1781175 w 1931193"/>
                <a:gd name="connsiteY106" fmla="*/ 292894 h 319088"/>
                <a:gd name="connsiteX107" fmla="*/ 1795462 w 1931193"/>
                <a:gd name="connsiteY107" fmla="*/ 300038 h 319088"/>
                <a:gd name="connsiteX108" fmla="*/ 1812131 w 1931193"/>
                <a:gd name="connsiteY108" fmla="*/ 311944 h 319088"/>
                <a:gd name="connsiteX109" fmla="*/ 1828800 w 1931193"/>
                <a:gd name="connsiteY109" fmla="*/ 319088 h 319088"/>
                <a:gd name="connsiteX110" fmla="*/ 1852612 w 1931193"/>
                <a:gd name="connsiteY110" fmla="*/ 314325 h 319088"/>
                <a:gd name="connsiteX111" fmla="*/ 1859756 w 1931193"/>
                <a:gd name="connsiteY111" fmla="*/ 309563 h 319088"/>
                <a:gd name="connsiteX112" fmla="*/ 1866900 w 1931193"/>
                <a:gd name="connsiteY112" fmla="*/ 307181 h 319088"/>
                <a:gd name="connsiteX113" fmla="*/ 1874043 w 1931193"/>
                <a:gd name="connsiteY113" fmla="*/ 302419 h 319088"/>
                <a:gd name="connsiteX114" fmla="*/ 1883568 w 1931193"/>
                <a:gd name="connsiteY114" fmla="*/ 300038 h 319088"/>
                <a:gd name="connsiteX115" fmla="*/ 1890712 w 1931193"/>
                <a:gd name="connsiteY115" fmla="*/ 297656 h 319088"/>
                <a:gd name="connsiteX116" fmla="*/ 1909762 w 1931193"/>
                <a:gd name="connsiteY116" fmla="*/ 300038 h 319088"/>
                <a:gd name="connsiteX117" fmla="*/ 1919287 w 1931193"/>
                <a:gd name="connsiteY117" fmla="*/ 302419 h 319088"/>
                <a:gd name="connsiteX118" fmla="*/ 1926431 w 1931193"/>
                <a:gd name="connsiteY118" fmla="*/ 304800 h 319088"/>
                <a:gd name="connsiteX119" fmla="*/ 1931193 w 1931193"/>
                <a:gd name="connsiteY119" fmla="*/ 304800 h 31908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  <a:cxn ang="0">
                  <a:pos x="connsiteX29" y="connsiteY29"/>
                </a:cxn>
                <a:cxn ang="0">
                  <a:pos x="connsiteX30" y="connsiteY30"/>
                </a:cxn>
                <a:cxn ang="0">
                  <a:pos x="connsiteX31" y="connsiteY31"/>
                </a:cxn>
                <a:cxn ang="0">
                  <a:pos x="connsiteX32" y="connsiteY32"/>
                </a:cxn>
                <a:cxn ang="0">
                  <a:pos x="connsiteX33" y="connsiteY33"/>
                </a:cxn>
                <a:cxn ang="0">
                  <a:pos x="connsiteX34" y="connsiteY34"/>
                </a:cxn>
                <a:cxn ang="0">
                  <a:pos x="connsiteX35" y="connsiteY35"/>
                </a:cxn>
                <a:cxn ang="0">
                  <a:pos x="connsiteX36" y="connsiteY36"/>
                </a:cxn>
                <a:cxn ang="0">
                  <a:pos x="connsiteX37" y="connsiteY37"/>
                </a:cxn>
                <a:cxn ang="0">
                  <a:pos x="connsiteX38" y="connsiteY38"/>
                </a:cxn>
                <a:cxn ang="0">
                  <a:pos x="connsiteX39" y="connsiteY39"/>
                </a:cxn>
                <a:cxn ang="0">
                  <a:pos x="connsiteX40" y="connsiteY40"/>
                </a:cxn>
                <a:cxn ang="0">
                  <a:pos x="connsiteX41" y="connsiteY41"/>
                </a:cxn>
                <a:cxn ang="0">
                  <a:pos x="connsiteX42" y="connsiteY42"/>
                </a:cxn>
                <a:cxn ang="0">
                  <a:pos x="connsiteX43" y="connsiteY43"/>
                </a:cxn>
                <a:cxn ang="0">
                  <a:pos x="connsiteX44" y="connsiteY44"/>
                </a:cxn>
                <a:cxn ang="0">
                  <a:pos x="connsiteX45" y="connsiteY45"/>
                </a:cxn>
                <a:cxn ang="0">
                  <a:pos x="connsiteX46" y="connsiteY46"/>
                </a:cxn>
                <a:cxn ang="0">
                  <a:pos x="connsiteX47" y="connsiteY47"/>
                </a:cxn>
                <a:cxn ang="0">
                  <a:pos x="connsiteX48" y="connsiteY48"/>
                </a:cxn>
                <a:cxn ang="0">
                  <a:pos x="connsiteX49" y="connsiteY49"/>
                </a:cxn>
                <a:cxn ang="0">
                  <a:pos x="connsiteX50" y="connsiteY50"/>
                </a:cxn>
                <a:cxn ang="0">
                  <a:pos x="connsiteX51" y="connsiteY51"/>
                </a:cxn>
                <a:cxn ang="0">
                  <a:pos x="connsiteX52" y="connsiteY52"/>
                </a:cxn>
                <a:cxn ang="0">
                  <a:pos x="connsiteX53" y="connsiteY53"/>
                </a:cxn>
                <a:cxn ang="0">
                  <a:pos x="connsiteX54" y="connsiteY54"/>
                </a:cxn>
                <a:cxn ang="0">
                  <a:pos x="connsiteX55" y="connsiteY55"/>
                </a:cxn>
                <a:cxn ang="0">
                  <a:pos x="connsiteX56" y="connsiteY56"/>
                </a:cxn>
                <a:cxn ang="0">
                  <a:pos x="connsiteX57" y="connsiteY57"/>
                </a:cxn>
                <a:cxn ang="0">
                  <a:pos x="connsiteX58" y="connsiteY58"/>
                </a:cxn>
                <a:cxn ang="0">
                  <a:pos x="connsiteX59" y="connsiteY59"/>
                </a:cxn>
                <a:cxn ang="0">
                  <a:pos x="connsiteX60" y="connsiteY60"/>
                </a:cxn>
                <a:cxn ang="0">
                  <a:pos x="connsiteX61" y="connsiteY61"/>
                </a:cxn>
                <a:cxn ang="0">
                  <a:pos x="connsiteX62" y="connsiteY62"/>
                </a:cxn>
                <a:cxn ang="0">
                  <a:pos x="connsiteX63" y="connsiteY63"/>
                </a:cxn>
                <a:cxn ang="0">
                  <a:pos x="connsiteX64" y="connsiteY64"/>
                </a:cxn>
                <a:cxn ang="0">
                  <a:pos x="connsiteX65" y="connsiteY65"/>
                </a:cxn>
                <a:cxn ang="0">
                  <a:pos x="connsiteX66" y="connsiteY66"/>
                </a:cxn>
                <a:cxn ang="0">
                  <a:pos x="connsiteX67" y="connsiteY67"/>
                </a:cxn>
                <a:cxn ang="0">
                  <a:pos x="connsiteX68" y="connsiteY68"/>
                </a:cxn>
                <a:cxn ang="0">
                  <a:pos x="connsiteX69" y="connsiteY69"/>
                </a:cxn>
                <a:cxn ang="0">
                  <a:pos x="connsiteX70" y="connsiteY70"/>
                </a:cxn>
                <a:cxn ang="0">
                  <a:pos x="connsiteX71" y="connsiteY71"/>
                </a:cxn>
                <a:cxn ang="0">
                  <a:pos x="connsiteX72" y="connsiteY72"/>
                </a:cxn>
                <a:cxn ang="0">
                  <a:pos x="connsiteX73" y="connsiteY73"/>
                </a:cxn>
                <a:cxn ang="0">
                  <a:pos x="connsiteX74" y="connsiteY74"/>
                </a:cxn>
                <a:cxn ang="0">
                  <a:pos x="connsiteX75" y="connsiteY75"/>
                </a:cxn>
                <a:cxn ang="0">
                  <a:pos x="connsiteX76" y="connsiteY76"/>
                </a:cxn>
                <a:cxn ang="0">
                  <a:pos x="connsiteX77" y="connsiteY77"/>
                </a:cxn>
                <a:cxn ang="0">
                  <a:pos x="connsiteX78" y="connsiteY78"/>
                </a:cxn>
                <a:cxn ang="0">
                  <a:pos x="connsiteX79" y="connsiteY79"/>
                </a:cxn>
                <a:cxn ang="0">
                  <a:pos x="connsiteX80" y="connsiteY80"/>
                </a:cxn>
                <a:cxn ang="0">
                  <a:pos x="connsiteX81" y="connsiteY81"/>
                </a:cxn>
                <a:cxn ang="0">
                  <a:pos x="connsiteX82" y="connsiteY82"/>
                </a:cxn>
                <a:cxn ang="0">
                  <a:pos x="connsiteX83" y="connsiteY83"/>
                </a:cxn>
                <a:cxn ang="0">
                  <a:pos x="connsiteX84" y="connsiteY84"/>
                </a:cxn>
                <a:cxn ang="0">
                  <a:pos x="connsiteX85" y="connsiteY85"/>
                </a:cxn>
                <a:cxn ang="0">
                  <a:pos x="connsiteX86" y="connsiteY86"/>
                </a:cxn>
                <a:cxn ang="0">
                  <a:pos x="connsiteX87" y="connsiteY87"/>
                </a:cxn>
                <a:cxn ang="0">
                  <a:pos x="connsiteX88" y="connsiteY88"/>
                </a:cxn>
                <a:cxn ang="0">
                  <a:pos x="connsiteX89" y="connsiteY89"/>
                </a:cxn>
                <a:cxn ang="0">
                  <a:pos x="connsiteX90" y="connsiteY90"/>
                </a:cxn>
                <a:cxn ang="0">
                  <a:pos x="connsiteX91" y="connsiteY91"/>
                </a:cxn>
                <a:cxn ang="0">
                  <a:pos x="connsiteX92" y="connsiteY92"/>
                </a:cxn>
                <a:cxn ang="0">
                  <a:pos x="connsiteX93" y="connsiteY93"/>
                </a:cxn>
                <a:cxn ang="0">
                  <a:pos x="connsiteX94" y="connsiteY94"/>
                </a:cxn>
                <a:cxn ang="0">
                  <a:pos x="connsiteX95" y="connsiteY95"/>
                </a:cxn>
                <a:cxn ang="0">
                  <a:pos x="connsiteX96" y="connsiteY96"/>
                </a:cxn>
                <a:cxn ang="0">
                  <a:pos x="connsiteX97" y="connsiteY97"/>
                </a:cxn>
                <a:cxn ang="0">
                  <a:pos x="connsiteX98" y="connsiteY98"/>
                </a:cxn>
                <a:cxn ang="0">
                  <a:pos x="connsiteX99" y="connsiteY99"/>
                </a:cxn>
                <a:cxn ang="0">
                  <a:pos x="connsiteX100" y="connsiteY100"/>
                </a:cxn>
                <a:cxn ang="0">
                  <a:pos x="connsiteX101" y="connsiteY101"/>
                </a:cxn>
                <a:cxn ang="0">
                  <a:pos x="connsiteX102" y="connsiteY102"/>
                </a:cxn>
                <a:cxn ang="0">
                  <a:pos x="connsiteX103" y="connsiteY103"/>
                </a:cxn>
                <a:cxn ang="0">
                  <a:pos x="connsiteX104" y="connsiteY104"/>
                </a:cxn>
                <a:cxn ang="0">
                  <a:pos x="connsiteX105" y="connsiteY105"/>
                </a:cxn>
                <a:cxn ang="0">
                  <a:pos x="connsiteX106" y="connsiteY106"/>
                </a:cxn>
                <a:cxn ang="0">
                  <a:pos x="connsiteX107" y="connsiteY107"/>
                </a:cxn>
                <a:cxn ang="0">
                  <a:pos x="connsiteX108" y="connsiteY108"/>
                </a:cxn>
                <a:cxn ang="0">
                  <a:pos x="connsiteX109" y="connsiteY109"/>
                </a:cxn>
                <a:cxn ang="0">
                  <a:pos x="connsiteX110" y="connsiteY110"/>
                </a:cxn>
                <a:cxn ang="0">
                  <a:pos x="connsiteX111" y="connsiteY111"/>
                </a:cxn>
                <a:cxn ang="0">
                  <a:pos x="connsiteX112" y="connsiteY112"/>
                </a:cxn>
                <a:cxn ang="0">
                  <a:pos x="connsiteX113" y="connsiteY113"/>
                </a:cxn>
                <a:cxn ang="0">
                  <a:pos x="connsiteX114" y="connsiteY114"/>
                </a:cxn>
                <a:cxn ang="0">
                  <a:pos x="connsiteX115" y="connsiteY115"/>
                </a:cxn>
                <a:cxn ang="0">
                  <a:pos x="connsiteX116" y="connsiteY116"/>
                </a:cxn>
                <a:cxn ang="0">
                  <a:pos x="connsiteX117" y="connsiteY117"/>
                </a:cxn>
                <a:cxn ang="0">
                  <a:pos x="connsiteX118" y="connsiteY118"/>
                </a:cxn>
                <a:cxn ang="0">
                  <a:pos x="connsiteX119" y="connsiteY119"/>
                </a:cxn>
              </a:cxnLst>
              <a:rect l="l" t="t" r="r" b="b"/>
              <a:pathLst>
                <a:path w="1931193" h="319088">
                  <a:moveTo>
                    <a:pt x="0" y="0"/>
                  </a:moveTo>
                  <a:cubicBezTo>
                    <a:pt x="3969" y="794"/>
                    <a:pt x="7955" y="1503"/>
                    <a:pt x="11906" y="2381"/>
                  </a:cubicBezTo>
                  <a:cubicBezTo>
                    <a:pt x="15101" y="3091"/>
                    <a:pt x="18187" y="4330"/>
                    <a:pt x="21431" y="4763"/>
                  </a:cubicBezTo>
                  <a:cubicBezTo>
                    <a:pt x="30121" y="5922"/>
                    <a:pt x="38894" y="6350"/>
                    <a:pt x="47625" y="7144"/>
                  </a:cubicBezTo>
                  <a:cubicBezTo>
                    <a:pt x="98272" y="17272"/>
                    <a:pt x="42564" y="6857"/>
                    <a:pt x="173831" y="11906"/>
                  </a:cubicBezTo>
                  <a:cubicBezTo>
                    <a:pt x="177101" y="12032"/>
                    <a:pt x="180147" y="13646"/>
                    <a:pt x="183356" y="14288"/>
                  </a:cubicBezTo>
                  <a:cubicBezTo>
                    <a:pt x="204317" y="18481"/>
                    <a:pt x="190880" y="14415"/>
                    <a:pt x="204787" y="19050"/>
                  </a:cubicBezTo>
                  <a:cubicBezTo>
                    <a:pt x="207168" y="21431"/>
                    <a:pt x="210296" y="23250"/>
                    <a:pt x="211931" y="26194"/>
                  </a:cubicBezTo>
                  <a:cubicBezTo>
                    <a:pt x="214369" y="30582"/>
                    <a:pt x="216693" y="40481"/>
                    <a:pt x="216693" y="40481"/>
                  </a:cubicBezTo>
                  <a:cubicBezTo>
                    <a:pt x="215899" y="42862"/>
                    <a:pt x="214312" y="45115"/>
                    <a:pt x="214312" y="47625"/>
                  </a:cubicBezTo>
                  <a:cubicBezTo>
                    <a:pt x="214312" y="54024"/>
                    <a:pt x="214316" y="60733"/>
                    <a:pt x="216693" y="66675"/>
                  </a:cubicBezTo>
                  <a:cubicBezTo>
                    <a:pt x="217946" y="69809"/>
                    <a:pt x="228120" y="73183"/>
                    <a:pt x="230981" y="73819"/>
                  </a:cubicBezTo>
                  <a:cubicBezTo>
                    <a:pt x="245211" y="76981"/>
                    <a:pt x="259235" y="77364"/>
                    <a:pt x="273843" y="78581"/>
                  </a:cubicBezTo>
                  <a:cubicBezTo>
                    <a:pt x="290322" y="84076"/>
                    <a:pt x="274932" y="79550"/>
                    <a:pt x="307181" y="83344"/>
                  </a:cubicBezTo>
                  <a:cubicBezTo>
                    <a:pt x="314238" y="84174"/>
                    <a:pt x="323873" y="85970"/>
                    <a:pt x="330993" y="88106"/>
                  </a:cubicBezTo>
                  <a:cubicBezTo>
                    <a:pt x="335802" y="89549"/>
                    <a:pt x="341104" y="90084"/>
                    <a:pt x="345281" y="92869"/>
                  </a:cubicBezTo>
                  <a:cubicBezTo>
                    <a:pt x="347662" y="94456"/>
                    <a:pt x="349865" y="96351"/>
                    <a:pt x="352425" y="97631"/>
                  </a:cubicBezTo>
                  <a:cubicBezTo>
                    <a:pt x="372142" y="107490"/>
                    <a:pt x="346238" y="91127"/>
                    <a:pt x="366712" y="104775"/>
                  </a:cubicBezTo>
                  <a:cubicBezTo>
                    <a:pt x="368300" y="107156"/>
                    <a:pt x="369240" y="110131"/>
                    <a:pt x="371475" y="111919"/>
                  </a:cubicBezTo>
                  <a:cubicBezTo>
                    <a:pt x="373435" y="113487"/>
                    <a:pt x="376373" y="113178"/>
                    <a:pt x="378618" y="114300"/>
                  </a:cubicBezTo>
                  <a:cubicBezTo>
                    <a:pt x="381178" y="115580"/>
                    <a:pt x="383563" y="117231"/>
                    <a:pt x="385762" y="119063"/>
                  </a:cubicBezTo>
                  <a:cubicBezTo>
                    <a:pt x="392168" y="124401"/>
                    <a:pt x="392451" y="127592"/>
                    <a:pt x="400050" y="130969"/>
                  </a:cubicBezTo>
                  <a:cubicBezTo>
                    <a:pt x="404637" y="133008"/>
                    <a:pt x="414337" y="135731"/>
                    <a:pt x="414337" y="135731"/>
                  </a:cubicBezTo>
                  <a:cubicBezTo>
                    <a:pt x="416718" y="137319"/>
                    <a:pt x="418850" y="139367"/>
                    <a:pt x="421481" y="140494"/>
                  </a:cubicBezTo>
                  <a:cubicBezTo>
                    <a:pt x="424903" y="141960"/>
                    <a:pt x="440200" y="144578"/>
                    <a:pt x="442912" y="145256"/>
                  </a:cubicBezTo>
                  <a:cubicBezTo>
                    <a:pt x="455272" y="148346"/>
                    <a:pt x="445375" y="148068"/>
                    <a:pt x="461962" y="150019"/>
                  </a:cubicBezTo>
                  <a:cubicBezTo>
                    <a:pt x="471455" y="151136"/>
                    <a:pt x="481012" y="151606"/>
                    <a:pt x="490537" y="152400"/>
                  </a:cubicBezTo>
                  <a:cubicBezTo>
                    <a:pt x="508793" y="151606"/>
                    <a:pt x="527086" y="151420"/>
                    <a:pt x="545306" y="150019"/>
                  </a:cubicBezTo>
                  <a:cubicBezTo>
                    <a:pt x="553187" y="149413"/>
                    <a:pt x="552617" y="145975"/>
                    <a:pt x="559593" y="142875"/>
                  </a:cubicBezTo>
                  <a:cubicBezTo>
                    <a:pt x="564181" y="140836"/>
                    <a:pt x="573881" y="138113"/>
                    <a:pt x="573881" y="138113"/>
                  </a:cubicBezTo>
                  <a:cubicBezTo>
                    <a:pt x="578643" y="134938"/>
                    <a:pt x="584121" y="132635"/>
                    <a:pt x="588168" y="128588"/>
                  </a:cubicBezTo>
                  <a:cubicBezTo>
                    <a:pt x="590549" y="126207"/>
                    <a:pt x="593156" y="124031"/>
                    <a:pt x="595312" y="121444"/>
                  </a:cubicBezTo>
                  <a:cubicBezTo>
                    <a:pt x="597144" y="119245"/>
                    <a:pt x="598051" y="116324"/>
                    <a:pt x="600075" y="114300"/>
                  </a:cubicBezTo>
                  <a:cubicBezTo>
                    <a:pt x="602098" y="112277"/>
                    <a:pt x="604837" y="111125"/>
                    <a:pt x="607218" y="109538"/>
                  </a:cubicBezTo>
                  <a:cubicBezTo>
                    <a:pt x="612758" y="101227"/>
                    <a:pt x="616139" y="94132"/>
                    <a:pt x="623887" y="88106"/>
                  </a:cubicBezTo>
                  <a:cubicBezTo>
                    <a:pt x="628405" y="84592"/>
                    <a:pt x="632745" y="80391"/>
                    <a:pt x="638175" y="78581"/>
                  </a:cubicBezTo>
                  <a:lnTo>
                    <a:pt x="666750" y="69056"/>
                  </a:lnTo>
                  <a:lnTo>
                    <a:pt x="681037" y="64294"/>
                  </a:lnTo>
                  <a:cubicBezTo>
                    <a:pt x="683418" y="63500"/>
                    <a:pt x="685746" y="62522"/>
                    <a:pt x="688181" y="61913"/>
                  </a:cubicBezTo>
                  <a:cubicBezTo>
                    <a:pt x="694531" y="60325"/>
                    <a:pt x="701021" y="59220"/>
                    <a:pt x="707231" y="57150"/>
                  </a:cubicBezTo>
                  <a:cubicBezTo>
                    <a:pt x="711993" y="55563"/>
                    <a:pt x="716648" y="53606"/>
                    <a:pt x="721518" y="52388"/>
                  </a:cubicBezTo>
                  <a:cubicBezTo>
                    <a:pt x="724693" y="51594"/>
                    <a:pt x="727908" y="50946"/>
                    <a:pt x="731043" y="50006"/>
                  </a:cubicBezTo>
                  <a:cubicBezTo>
                    <a:pt x="735851" y="48563"/>
                    <a:pt x="740568" y="46831"/>
                    <a:pt x="745331" y="45244"/>
                  </a:cubicBezTo>
                  <a:lnTo>
                    <a:pt x="759618" y="40481"/>
                  </a:lnTo>
                  <a:cubicBezTo>
                    <a:pt x="785680" y="31793"/>
                    <a:pt x="746200" y="45652"/>
                    <a:pt x="773906" y="33338"/>
                  </a:cubicBezTo>
                  <a:cubicBezTo>
                    <a:pt x="778493" y="31299"/>
                    <a:pt x="784016" y="31359"/>
                    <a:pt x="788193" y="28575"/>
                  </a:cubicBezTo>
                  <a:cubicBezTo>
                    <a:pt x="799514" y="21029"/>
                    <a:pt x="792622" y="24718"/>
                    <a:pt x="809625" y="19050"/>
                  </a:cubicBezTo>
                  <a:lnTo>
                    <a:pt x="823912" y="14288"/>
                  </a:lnTo>
                  <a:lnTo>
                    <a:pt x="831056" y="11906"/>
                  </a:lnTo>
                  <a:cubicBezTo>
                    <a:pt x="843756" y="12700"/>
                    <a:pt x="856529" y="12710"/>
                    <a:pt x="869156" y="14288"/>
                  </a:cubicBezTo>
                  <a:cubicBezTo>
                    <a:pt x="875651" y="15100"/>
                    <a:pt x="881997" y="16980"/>
                    <a:pt x="888206" y="19050"/>
                  </a:cubicBezTo>
                  <a:lnTo>
                    <a:pt x="909637" y="26194"/>
                  </a:lnTo>
                  <a:lnTo>
                    <a:pt x="923925" y="30956"/>
                  </a:lnTo>
                  <a:cubicBezTo>
                    <a:pt x="926306" y="31750"/>
                    <a:pt x="928980" y="31946"/>
                    <a:pt x="931068" y="33338"/>
                  </a:cubicBezTo>
                  <a:cubicBezTo>
                    <a:pt x="947904" y="44561"/>
                    <a:pt x="927061" y="30476"/>
                    <a:pt x="947737" y="45244"/>
                  </a:cubicBezTo>
                  <a:cubicBezTo>
                    <a:pt x="950066" y="46907"/>
                    <a:pt x="952266" y="48844"/>
                    <a:pt x="954881" y="50006"/>
                  </a:cubicBezTo>
                  <a:cubicBezTo>
                    <a:pt x="959468" y="52045"/>
                    <a:pt x="964991" y="51985"/>
                    <a:pt x="969168" y="54769"/>
                  </a:cubicBezTo>
                  <a:cubicBezTo>
                    <a:pt x="971549" y="56356"/>
                    <a:pt x="973682" y="58404"/>
                    <a:pt x="976312" y="59531"/>
                  </a:cubicBezTo>
                  <a:cubicBezTo>
                    <a:pt x="979320" y="60820"/>
                    <a:pt x="982690" y="61014"/>
                    <a:pt x="985837" y="61913"/>
                  </a:cubicBezTo>
                  <a:cubicBezTo>
                    <a:pt x="988251" y="62603"/>
                    <a:pt x="990546" y="63685"/>
                    <a:pt x="992981" y="64294"/>
                  </a:cubicBezTo>
                  <a:cubicBezTo>
                    <a:pt x="996907" y="65276"/>
                    <a:pt x="1000982" y="65610"/>
                    <a:pt x="1004887" y="66675"/>
                  </a:cubicBezTo>
                  <a:cubicBezTo>
                    <a:pt x="1009730" y="67996"/>
                    <a:pt x="1014412" y="69850"/>
                    <a:pt x="1019175" y="71438"/>
                  </a:cubicBezTo>
                  <a:cubicBezTo>
                    <a:pt x="1027895" y="74345"/>
                    <a:pt x="1035965" y="77237"/>
                    <a:pt x="1045368" y="78581"/>
                  </a:cubicBezTo>
                  <a:cubicBezTo>
                    <a:pt x="1057588" y="80327"/>
                    <a:pt x="1062630" y="80734"/>
                    <a:pt x="1073943" y="83344"/>
                  </a:cubicBezTo>
                  <a:cubicBezTo>
                    <a:pt x="1080321" y="84816"/>
                    <a:pt x="1086784" y="86036"/>
                    <a:pt x="1092993" y="88106"/>
                  </a:cubicBezTo>
                  <a:cubicBezTo>
                    <a:pt x="1097756" y="89694"/>
                    <a:pt x="1102411" y="91652"/>
                    <a:pt x="1107281" y="92869"/>
                  </a:cubicBezTo>
                  <a:lnTo>
                    <a:pt x="1126331" y="97631"/>
                  </a:lnTo>
                  <a:cubicBezTo>
                    <a:pt x="1129506" y="98425"/>
                    <a:pt x="1132751" y="98978"/>
                    <a:pt x="1135856" y="100013"/>
                  </a:cubicBezTo>
                  <a:cubicBezTo>
                    <a:pt x="1138237" y="100807"/>
                    <a:pt x="1140550" y="101850"/>
                    <a:pt x="1143000" y="102394"/>
                  </a:cubicBezTo>
                  <a:cubicBezTo>
                    <a:pt x="1148949" y="103716"/>
                    <a:pt x="1168637" y="106396"/>
                    <a:pt x="1173956" y="107156"/>
                  </a:cubicBezTo>
                  <a:cubicBezTo>
                    <a:pt x="1187362" y="111626"/>
                    <a:pt x="1180199" y="109792"/>
                    <a:pt x="1202531" y="111919"/>
                  </a:cubicBezTo>
                  <a:cubicBezTo>
                    <a:pt x="1212046" y="112825"/>
                    <a:pt x="1221581" y="113506"/>
                    <a:pt x="1231106" y="114300"/>
                  </a:cubicBezTo>
                  <a:cubicBezTo>
                    <a:pt x="1234281" y="115094"/>
                    <a:pt x="1237436" y="115971"/>
                    <a:pt x="1240631" y="116681"/>
                  </a:cubicBezTo>
                  <a:cubicBezTo>
                    <a:pt x="1244582" y="117559"/>
                    <a:pt x="1248632" y="117998"/>
                    <a:pt x="1252537" y="119063"/>
                  </a:cubicBezTo>
                  <a:cubicBezTo>
                    <a:pt x="1257380" y="120384"/>
                    <a:pt x="1261955" y="122608"/>
                    <a:pt x="1266825" y="123825"/>
                  </a:cubicBezTo>
                  <a:cubicBezTo>
                    <a:pt x="1270000" y="124619"/>
                    <a:pt x="1273203" y="125307"/>
                    <a:pt x="1276350" y="126206"/>
                  </a:cubicBezTo>
                  <a:cubicBezTo>
                    <a:pt x="1278763" y="126896"/>
                    <a:pt x="1281058" y="127979"/>
                    <a:pt x="1283493" y="128588"/>
                  </a:cubicBezTo>
                  <a:cubicBezTo>
                    <a:pt x="1300787" y="132912"/>
                    <a:pt x="1290629" y="129115"/>
                    <a:pt x="1309687" y="133350"/>
                  </a:cubicBezTo>
                  <a:cubicBezTo>
                    <a:pt x="1312137" y="133894"/>
                    <a:pt x="1314417" y="135041"/>
                    <a:pt x="1316831" y="135731"/>
                  </a:cubicBezTo>
                  <a:cubicBezTo>
                    <a:pt x="1319978" y="136630"/>
                    <a:pt x="1323209" y="137214"/>
                    <a:pt x="1326356" y="138113"/>
                  </a:cubicBezTo>
                  <a:cubicBezTo>
                    <a:pt x="1337584" y="141321"/>
                    <a:pt x="1333788" y="142257"/>
                    <a:pt x="1350168" y="142875"/>
                  </a:cubicBezTo>
                  <a:cubicBezTo>
                    <a:pt x="1386663" y="144252"/>
                    <a:pt x="1423193" y="144462"/>
                    <a:pt x="1459706" y="145256"/>
                  </a:cubicBezTo>
                  <a:cubicBezTo>
                    <a:pt x="1465262" y="146050"/>
                    <a:pt x="1470871" y="146537"/>
                    <a:pt x="1476375" y="147638"/>
                  </a:cubicBezTo>
                  <a:cubicBezTo>
                    <a:pt x="1478836" y="148130"/>
                    <a:pt x="1481057" y="149527"/>
                    <a:pt x="1483518" y="150019"/>
                  </a:cubicBezTo>
                  <a:cubicBezTo>
                    <a:pt x="1489022" y="151120"/>
                    <a:pt x="1494683" y="151299"/>
                    <a:pt x="1500187" y="152400"/>
                  </a:cubicBezTo>
                  <a:cubicBezTo>
                    <a:pt x="1506605" y="153684"/>
                    <a:pt x="1512887" y="155575"/>
                    <a:pt x="1519237" y="157163"/>
                  </a:cubicBezTo>
                  <a:cubicBezTo>
                    <a:pt x="1531202" y="160154"/>
                    <a:pt x="1525653" y="158508"/>
                    <a:pt x="1535906" y="161925"/>
                  </a:cubicBezTo>
                  <a:cubicBezTo>
                    <a:pt x="1540668" y="165100"/>
                    <a:pt x="1547018" y="166688"/>
                    <a:pt x="1550193" y="171450"/>
                  </a:cubicBezTo>
                  <a:cubicBezTo>
                    <a:pt x="1558927" y="184550"/>
                    <a:pt x="1550191" y="173432"/>
                    <a:pt x="1562100" y="183356"/>
                  </a:cubicBezTo>
                  <a:cubicBezTo>
                    <a:pt x="1564687" y="185512"/>
                    <a:pt x="1566656" y="188344"/>
                    <a:pt x="1569243" y="190500"/>
                  </a:cubicBezTo>
                  <a:cubicBezTo>
                    <a:pt x="1571442" y="192332"/>
                    <a:pt x="1574058" y="193599"/>
                    <a:pt x="1576387" y="195263"/>
                  </a:cubicBezTo>
                  <a:cubicBezTo>
                    <a:pt x="1578898" y="197056"/>
                    <a:pt x="1589320" y="205301"/>
                    <a:pt x="1593056" y="207169"/>
                  </a:cubicBezTo>
                  <a:cubicBezTo>
                    <a:pt x="1595301" y="208292"/>
                    <a:pt x="1597819" y="208756"/>
                    <a:pt x="1600200" y="209550"/>
                  </a:cubicBezTo>
                  <a:cubicBezTo>
                    <a:pt x="1602581" y="211138"/>
                    <a:pt x="1604858" y="212893"/>
                    <a:pt x="1607343" y="214313"/>
                  </a:cubicBezTo>
                  <a:cubicBezTo>
                    <a:pt x="1610425" y="216074"/>
                    <a:pt x="1613858" y="217194"/>
                    <a:pt x="1616868" y="219075"/>
                  </a:cubicBezTo>
                  <a:cubicBezTo>
                    <a:pt x="1620234" y="221178"/>
                    <a:pt x="1622843" y="224444"/>
                    <a:pt x="1626393" y="226219"/>
                  </a:cubicBezTo>
                  <a:cubicBezTo>
                    <a:pt x="1630883" y="228464"/>
                    <a:pt x="1636191" y="228736"/>
                    <a:pt x="1640681" y="230981"/>
                  </a:cubicBezTo>
                  <a:cubicBezTo>
                    <a:pt x="1647031" y="234156"/>
                    <a:pt x="1652640" y="240151"/>
                    <a:pt x="1659731" y="240506"/>
                  </a:cubicBezTo>
                  <a:lnTo>
                    <a:pt x="1707356" y="242888"/>
                  </a:lnTo>
                  <a:cubicBezTo>
                    <a:pt x="1713166" y="244824"/>
                    <a:pt x="1717027" y="245415"/>
                    <a:pt x="1721643" y="250031"/>
                  </a:cubicBezTo>
                  <a:cubicBezTo>
                    <a:pt x="1723667" y="252055"/>
                    <a:pt x="1724207" y="255343"/>
                    <a:pt x="1726406" y="257175"/>
                  </a:cubicBezTo>
                  <a:cubicBezTo>
                    <a:pt x="1729133" y="259448"/>
                    <a:pt x="1732849" y="260177"/>
                    <a:pt x="1735931" y="261938"/>
                  </a:cubicBezTo>
                  <a:cubicBezTo>
                    <a:pt x="1738416" y="263358"/>
                    <a:pt x="1740746" y="265037"/>
                    <a:pt x="1743075" y="266700"/>
                  </a:cubicBezTo>
                  <a:cubicBezTo>
                    <a:pt x="1746305" y="269007"/>
                    <a:pt x="1749154" y="271875"/>
                    <a:pt x="1752600" y="273844"/>
                  </a:cubicBezTo>
                  <a:cubicBezTo>
                    <a:pt x="1754779" y="275089"/>
                    <a:pt x="1757362" y="275431"/>
                    <a:pt x="1759743" y="276225"/>
                  </a:cubicBezTo>
                  <a:cubicBezTo>
                    <a:pt x="1782533" y="299015"/>
                    <a:pt x="1753353" y="271965"/>
                    <a:pt x="1774031" y="285750"/>
                  </a:cubicBezTo>
                  <a:cubicBezTo>
                    <a:pt x="1776833" y="287618"/>
                    <a:pt x="1778588" y="290738"/>
                    <a:pt x="1781175" y="292894"/>
                  </a:cubicBezTo>
                  <a:cubicBezTo>
                    <a:pt x="1787329" y="298022"/>
                    <a:pt x="1788303" y="297651"/>
                    <a:pt x="1795462" y="300038"/>
                  </a:cubicBezTo>
                  <a:cubicBezTo>
                    <a:pt x="1799544" y="303099"/>
                    <a:pt x="1807262" y="309162"/>
                    <a:pt x="1812131" y="311944"/>
                  </a:cubicBezTo>
                  <a:cubicBezTo>
                    <a:pt x="1820366" y="316650"/>
                    <a:pt x="1820788" y="316417"/>
                    <a:pt x="1828800" y="319088"/>
                  </a:cubicBezTo>
                  <a:cubicBezTo>
                    <a:pt x="1834940" y="318211"/>
                    <a:pt x="1845963" y="317649"/>
                    <a:pt x="1852612" y="314325"/>
                  </a:cubicBezTo>
                  <a:cubicBezTo>
                    <a:pt x="1855172" y="313045"/>
                    <a:pt x="1857196" y="310843"/>
                    <a:pt x="1859756" y="309563"/>
                  </a:cubicBezTo>
                  <a:cubicBezTo>
                    <a:pt x="1862001" y="308440"/>
                    <a:pt x="1864655" y="308304"/>
                    <a:pt x="1866900" y="307181"/>
                  </a:cubicBezTo>
                  <a:cubicBezTo>
                    <a:pt x="1869459" y="305901"/>
                    <a:pt x="1871413" y="303546"/>
                    <a:pt x="1874043" y="302419"/>
                  </a:cubicBezTo>
                  <a:cubicBezTo>
                    <a:pt x="1877051" y="301130"/>
                    <a:pt x="1880421" y="300937"/>
                    <a:pt x="1883568" y="300038"/>
                  </a:cubicBezTo>
                  <a:cubicBezTo>
                    <a:pt x="1885982" y="299348"/>
                    <a:pt x="1888331" y="298450"/>
                    <a:pt x="1890712" y="297656"/>
                  </a:cubicBezTo>
                  <a:cubicBezTo>
                    <a:pt x="1897062" y="298450"/>
                    <a:pt x="1903450" y="298986"/>
                    <a:pt x="1909762" y="300038"/>
                  </a:cubicBezTo>
                  <a:cubicBezTo>
                    <a:pt x="1912990" y="300576"/>
                    <a:pt x="1916140" y="301520"/>
                    <a:pt x="1919287" y="302419"/>
                  </a:cubicBezTo>
                  <a:cubicBezTo>
                    <a:pt x="1921701" y="303109"/>
                    <a:pt x="1923970" y="304308"/>
                    <a:pt x="1926431" y="304800"/>
                  </a:cubicBezTo>
                  <a:cubicBezTo>
                    <a:pt x="1927988" y="305111"/>
                    <a:pt x="1929606" y="304800"/>
                    <a:pt x="1931193" y="304800"/>
                  </a:cubicBezTo>
                </a:path>
              </a:pathLst>
            </a:custGeom>
            <a:noFill/>
            <a:ln w="38100">
              <a:solidFill>
                <a:schemeClr val="bg1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9666"/>
            </a:p>
          </p:txBody>
        </p:sp>
        <p:sp>
          <p:nvSpPr>
            <p:cNvPr id="237" name="Freeform 236"/>
            <p:cNvSpPr/>
            <p:nvPr/>
          </p:nvSpPr>
          <p:spPr>
            <a:xfrm>
              <a:off x="4957607" y="3362025"/>
              <a:ext cx="1781214" cy="278477"/>
            </a:xfrm>
            <a:custGeom>
              <a:avLst/>
              <a:gdLst>
                <a:gd name="connsiteX0" fmla="*/ 0 w 1926431"/>
                <a:gd name="connsiteY0" fmla="*/ 0 h 300184"/>
                <a:gd name="connsiteX1" fmla="*/ 30956 w 1926431"/>
                <a:gd name="connsiteY1" fmla="*/ 4763 h 300184"/>
                <a:gd name="connsiteX2" fmla="*/ 45244 w 1926431"/>
                <a:gd name="connsiteY2" fmla="*/ 7144 h 300184"/>
                <a:gd name="connsiteX3" fmla="*/ 52388 w 1926431"/>
                <a:gd name="connsiteY3" fmla="*/ 9525 h 300184"/>
                <a:gd name="connsiteX4" fmla="*/ 71438 w 1926431"/>
                <a:gd name="connsiteY4" fmla="*/ 11907 h 300184"/>
                <a:gd name="connsiteX5" fmla="*/ 83344 w 1926431"/>
                <a:gd name="connsiteY5" fmla="*/ 14288 h 300184"/>
                <a:gd name="connsiteX6" fmla="*/ 90488 w 1926431"/>
                <a:gd name="connsiteY6" fmla="*/ 16669 h 300184"/>
                <a:gd name="connsiteX7" fmla="*/ 126206 w 1926431"/>
                <a:gd name="connsiteY7" fmla="*/ 21432 h 300184"/>
                <a:gd name="connsiteX8" fmla="*/ 147638 w 1926431"/>
                <a:gd name="connsiteY8" fmla="*/ 26194 h 300184"/>
                <a:gd name="connsiteX9" fmla="*/ 157163 w 1926431"/>
                <a:gd name="connsiteY9" fmla="*/ 28575 h 300184"/>
                <a:gd name="connsiteX10" fmla="*/ 169069 w 1926431"/>
                <a:gd name="connsiteY10" fmla="*/ 30957 h 300184"/>
                <a:gd name="connsiteX11" fmla="*/ 183356 w 1926431"/>
                <a:gd name="connsiteY11" fmla="*/ 35719 h 300184"/>
                <a:gd name="connsiteX12" fmla="*/ 190500 w 1926431"/>
                <a:gd name="connsiteY12" fmla="*/ 38100 h 300184"/>
                <a:gd name="connsiteX13" fmla="*/ 211931 w 1926431"/>
                <a:gd name="connsiteY13" fmla="*/ 45244 h 300184"/>
                <a:gd name="connsiteX14" fmla="*/ 219075 w 1926431"/>
                <a:gd name="connsiteY14" fmla="*/ 47625 h 300184"/>
                <a:gd name="connsiteX15" fmla="*/ 226219 w 1926431"/>
                <a:gd name="connsiteY15" fmla="*/ 52388 h 300184"/>
                <a:gd name="connsiteX16" fmla="*/ 240506 w 1926431"/>
                <a:gd name="connsiteY16" fmla="*/ 57150 h 300184"/>
                <a:gd name="connsiteX17" fmla="*/ 247650 w 1926431"/>
                <a:gd name="connsiteY17" fmla="*/ 61913 h 300184"/>
                <a:gd name="connsiteX18" fmla="*/ 261938 w 1926431"/>
                <a:gd name="connsiteY18" fmla="*/ 66675 h 300184"/>
                <a:gd name="connsiteX19" fmla="*/ 269081 w 1926431"/>
                <a:gd name="connsiteY19" fmla="*/ 71438 h 300184"/>
                <a:gd name="connsiteX20" fmla="*/ 292894 w 1926431"/>
                <a:gd name="connsiteY20" fmla="*/ 78582 h 300184"/>
                <a:gd name="connsiteX21" fmla="*/ 309563 w 1926431"/>
                <a:gd name="connsiteY21" fmla="*/ 83344 h 300184"/>
                <a:gd name="connsiteX22" fmla="*/ 335756 w 1926431"/>
                <a:gd name="connsiteY22" fmla="*/ 92869 h 300184"/>
                <a:gd name="connsiteX23" fmla="*/ 357188 w 1926431"/>
                <a:gd name="connsiteY23" fmla="*/ 100013 h 300184"/>
                <a:gd name="connsiteX24" fmla="*/ 364331 w 1926431"/>
                <a:gd name="connsiteY24" fmla="*/ 102394 h 300184"/>
                <a:gd name="connsiteX25" fmla="*/ 378619 w 1926431"/>
                <a:gd name="connsiteY25" fmla="*/ 104775 h 300184"/>
                <a:gd name="connsiteX26" fmla="*/ 402431 w 1926431"/>
                <a:gd name="connsiteY26" fmla="*/ 111919 h 300184"/>
                <a:gd name="connsiteX27" fmla="*/ 426244 w 1926431"/>
                <a:gd name="connsiteY27" fmla="*/ 119063 h 300184"/>
                <a:gd name="connsiteX28" fmla="*/ 514350 w 1926431"/>
                <a:gd name="connsiteY28" fmla="*/ 126207 h 300184"/>
                <a:gd name="connsiteX29" fmla="*/ 597694 w 1926431"/>
                <a:gd name="connsiteY29" fmla="*/ 121444 h 300184"/>
                <a:gd name="connsiteX30" fmla="*/ 604838 w 1926431"/>
                <a:gd name="connsiteY30" fmla="*/ 119063 h 300184"/>
                <a:gd name="connsiteX31" fmla="*/ 626269 w 1926431"/>
                <a:gd name="connsiteY31" fmla="*/ 104775 h 300184"/>
                <a:gd name="connsiteX32" fmla="*/ 640556 w 1926431"/>
                <a:gd name="connsiteY32" fmla="*/ 95250 h 300184"/>
                <a:gd name="connsiteX33" fmla="*/ 654844 w 1926431"/>
                <a:gd name="connsiteY33" fmla="*/ 85725 h 300184"/>
                <a:gd name="connsiteX34" fmla="*/ 661988 w 1926431"/>
                <a:gd name="connsiteY34" fmla="*/ 78582 h 300184"/>
                <a:gd name="connsiteX35" fmla="*/ 669131 w 1926431"/>
                <a:gd name="connsiteY35" fmla="*/ 73819 h 300184"/>
                <a:gd name="connsiteX36" fmla="*/ 673894 w 1926431"/>
                <a:gd name="connsiteY36" fmla="*/ 66675 h 300184"/>
                <a:gd name="connsiteX37" fmla="*/ 688181 w 1926431"/>
                <a:gd name="connsiteY37" fmla="*/ 59532 h 300184"/>
                <a:gd name="connsiteX38" fmla="*/ 711994 w 1926431"/>
                <a:gd name="connsiteY38" fmla="*/ 42863 h 300184"/>
                <a:gd name="connsiteX39" fmla="*/ 719138 w 1926431"/>
                <a:gd name="connsiteY39" fmla="*/ 38100 h 300184"/>
                <a:gd name="connsiteX40" fmla="*/ 740569 w 1926431"/>
                <a:gd name="connsiteY40" fmla="*/ 30957 h 300184"/>
                <a:gd name="connsiteX41" fmla="*/ 747713 w 1926431"/>
                <a:gd name="connsiteY41" fmla="*/ 28575 h 300184"/>
                <a:gd name="connsiteX42" fmla="*/ 766763 w 1926431"/>
                <a:gd name="connsiteY42" fmla="*/ 23813 h 300184"/>
                <a:gd name="connsiteX43" fmla="*/ 788194 w 1926431"/>
                <a:gd name="connsiteY43" fmla="*/ 16669 h 300184"/>
                <a:gd name="connsiteX44" fmla="*/ 795338 w 1926431"/>
                <a:gd name="connsiteY44" fmla="*/ 14288 h 300184"/>
                <a:gd name="connsiteX45" fmla="*/ 809625 w 1926431"/>
                <a:gd name="connsiteY45" fmla="*/ 11907 h 300184"/>
                <a:gd name="connsiteX46" fmla="*/ 819150 w 1926431"/>
                <a:gd name="connsiteY46" fmla="*/ 9525 h 300184"/>
                <a:gd name="connsiteX47" fmla="*/ 842963 w 1926431"/>
                <a:gd name="connsiteY47" fmla="*/ 4763 h 300184"/>
                <a:gd name="connsiteX48" fmla="*/ 890588 w 1926431"/>
                <a:gd name="connsiteY48" fmla="*/ 7144 h 300184"/>
                <a:gd name="connsiteX49" fmla="*/ 916781 w 1926431"/>
                <a:gd name="connsiteY49" fmla="*/ 14288 h 300184"/>
                <a:gd name="connsiteX50" fmla="*/ 942975 w 1926431"/>
                <a:gd name="connsiteY50" fmla="*/ 21432 h 300184"/>
                <a:gd name="connsiteX51" fmla="*/ 964406 w 1926431"/>
                <a:gd name="connsiteY51" fmla="*/ 35719 h 300184"/>
                <a:gd name="connsiteX52" fmla="*/ 971550 w 1926431"/>
                <a:gd name="connsiteY52" fmla="*/ 40482 h 300184"/>
                <a:gd name="connsiteX53" fmla="*/ 985838 w 1926431"/>
                <a:gd name="connsiteY53" fmla="*/ 45244 h 300184"/>
                <a:gd name="connsiteX54" fmla="*/ 1007269 w 1926431"/>
                <a:gd name="connsiteY54" fmla="*/ 54769 h 300184"/>
                <a:gd name="connsiteX55" fmla="*/ 1014413 w 1926431"/>
                <a:gd name="connsiteY55" fmla="*/ 57150 h 300184"/>
                <a:gd name="connsiteX56" fmla="*/ 1033463 w 1926431"/>
                <a:gd name="connsiteY56" fmla="*/ 61913 h 300184"/>
                <a:gd name="connsiteX57" fmla="*/ 1052513 w 1926431"/>
                <a:gd name="connsiteY57" fmla="*/ 66675 h 300184"/>
                <a:gd name="connsiteX58" fmla="*/ 1062038 w 1926431"/>
                <a:gd name="connsiteY58" fmla="*/ 69057 h 300184"/>
                <a:gd name="connsiteX59" fmla="*/ 1076325 w 1926431"/>
                <a:gd name="connsiteY59" fmla="*/ 71438 h 300184"/>
                <a:gd name="connsiteX60" fmla="*/ 1090613 w 1926431"/>
                <a:gd name="connsiteY60" fmla="*/ 76200 h 300184"/>
                <a:gd name="connsiteX61" fmla="*/ 1104900 w 1926431"/>
                <a:gd name="connsiteY61" fmla="*/ 78582 h 300184"/>
                <a:gd name="connsiteX62" fmla="*/ 1126331 w 1926431"/>
                <a:gd name="connsiteY62" fmla="*/ 85725 h 300184"/>
                <a:gd name="connsiteX63" fmla="*/ 1133475 w 1926431"/>
                <a:gd name="connsiteY63" fmla="*/ 88107 h 300184"/>
                <a:gd name="connsiteX64" fmla="*/ 1147763 w 1926431"/>
                <a:gd name="connsiteY64" fmla="*/ 90488 h 300184"/>
                <a:gd name="connsiteX65" fmla="*/ 1164431 w 1926431"/>
                <a:gd name="connsiteY65" fmla="*/ 92869 h 300184"/>
                <a:gd name="connsiteX66" fmla="*/ 1173956 w 1926431"/>
                <a:gd name="connsiteY66" fmla="*/ 95250 h 300184"/>
                <a:gd name="connsiteX67" fmla="*/ 1185863 w 1926431"/>
                <a:gd name="connsiteY67" fmla="*/ 97632 h 300184"/>
                <a:gd name="connsiteX68" fmla="*/ 1195388 w 1926431"/>
                <a:gd name="connsiteY68" fmla="*/ 100013 h 300184"/>
                <a:gd name="connsiteX69" fmla="*/ 1231106 w 1926431"/>
                <a:gd name="connsiteY69" fmla="*/ 102394 h 300184"/>
                <a:gd name="connsiteX70" fmla="*/ 1252538 w 1926431"/>
                <a:gd name="connsiteY70" fmla="*/ 107157 h 300184"/>
                <a:gd name="connsiteX71" fmla="*/ 1293019 w 1926431"/>
                <a:gd name="connsiteY71" fmla="*/ 111919 h 300184"/>
                <a:gd name="connsiteX72" fmla="*/ 1316831 w 1926431"/>
                <a:gd name="connsiteY72" fmla="*/ 116682 h 300184"/>
                <a:gd name="connsiteX73" fmla="*/ 1328738 w 1926431"/>
                <a:gd name="connsiteY73" fmla="*/ 119063 h 300184"/>
                <a:gd name="connsiteX74" fmla="*/ 1347788 w 1926431"/>
                <a:gd name="connsiteY74" fmla="*/ 123825 h 300184"/>
                <a:gd name="connsiteX75" fmla="*/ 1362075 w 1926431"/>
                <a:gd name="connsiteY75" fmla="*/ 126207 h 300184"/>
                <a:gd name="connsiteX76" fmla="*/ 1378744 w 1926431"/>
                <a:gd name="connsiteY76" fmla="*/ 128588 h 300184"/>
                <a:gd name="connsiteX77" fmla="*/ 1388269 w 1926431"/>
                <a:gd name="connsiteY77" fmla="*/ 130969 h 300184"/>
                <a:gd name="connsiteX78" fmla="*/ 1454944 w 1926431"/>
                <a:gd name="connsiteY78" fmla="*/ 135732 h 300184"/>
                <a:gd name="connsiteX79" fmla="*/ 1481138 w 1926431"/>
                <a:gd name="connsiteY79" fmla="*/ 140494 h 300184"/>
                <a:gd name="connsiteX80" fmla="*/ 1504950 w 1926431"/>
                <a:gd name="connsiteY80" fmla="*/ 145257 h 300184"/>
                <a:gd name="connsiteX81" fmla="*/ 1516856 w 1926431"/>
                <a:gd name="connsiteY81" fmla="*/ 147638 h 300184"/>
                <a:gd name="connsiteX82" fmla="*/ 1524000 w 1926431"/>
                <a:gd name="connsiteY82" fmla="*/ 150019 h 300184"/>
                <a:gd name="connsiteX83" fmla="*/ 1535906 w 1926431"/>
                <a:gd name="connsiteY83" fmla="*/ 152400 h 300184"/>
                <a:gd name="connsiteX84" fmla="*/ 1550194 w 1926431"/>
                <a:gd name="connsiteY84" fmla="*/ 159544 h 300184"/>
                <a:gd name="connsiteX85" fmla="*/ 1557338 w 1926431"/>
                <a:gd name="connsiteY85" fmla="*/ 161925 h 300184"/>
                <a:gd name="connsiteX86" fmla="*/ 1576388 w 1926431"/>
                <a:gd name="connsiteY86" fmla="*/ 173832 h 300184"/>
                <a:gd name="connsiteX87" fmla="*/ 1593056 w 1926431"/>
                <a:gd name="connsiteY87" fmla="*/ 185738 h 300184"/>
                <a:gd name="connsiteX88" fmla="*/ 1619250 w 1926431"/>
                <a:gd name="connsiteY88" fmla="*/ 197644 h 300184"/>
                <a:gd name="connsiteX89" fmla="*/ 1626394 w 1926431"/>
                <a:gd name="connsiteY89" fmla="*/ 202407 h 300184"/>
                <a:gd name="connsiteX90" fmla="*/ 1640681 w 1926431"/>
                <a:gd name="connsiteY90" fmla="*/ 207169 h 300184"/>
                <a:gd name="connsiteX91" fmla="*/ 1647825 w 1926431"/>
                <a:gd name="connsiteY91" fmla="*/ 211932 h 300184"/>
                <a:gd name="connsiteX92" fmla="*/ 1664494 w 1926431"/>
                <a:gd name="connsiteY92" fmla="*/ 216694 h 300184"/>
                <a:gd name="connsiteX93" fmla="*/ 1674019 w 1926431"/>
                <a:gd name="connsiteY93" fmla="*/ 221457 h 300184"/>
                <a:gd name="connsiteX94" fmla="*/ 1685925 w 1926431"/>
                <a:gd name="connsiteY94" fmla="*/ 223838 h 300184"/>
                <a:gd name="connsiteX95" fmla="*/ 1693069 w 1926431"/>
                <a:gd name="connsiteY95" fmla="*/ 226219 h 300184"/>
                <a:gd name="connsiteX96" fmla="*/ 1702594 w 1926431"/>
                <a:gd name="connsiteY96" fmla="*/ 228600 h 300184"/>
                <a:gd name="connsiteX97" fmla="*/ 1709738 w 1926431"/>
                <a:gd name="connsiteY97" fmla="*/ 233363 h 300184"/>
                <a:gd name="connsiteX98" fmla="*/ 1716881 w 1926431"/>
                <a:gd name="connsiteY98" fmla="*/ 235744 h 300184"/>
                <a:gd name="connsiteX99" fmla="*/ 1733550 w 1926431"/>
                <a:gd name="connsiteY99" fmla="*/ 250032 h 300184"/>
                <a:gd name="connsiteX100" fmla="*/ 1743075 w 1926431"/>
                <a:gd name="connsiteY100" fmla="*/ 252413 h 300184"/>
                <a:gd name="connsiteX101" fmla="*/ 1757363 w 1926431"/>
                <a:gd name="connsiteY101" fmla="*/ 261938 h 300184"/>
                <a:gd name="connsiteX102" fmla="*/ 1778794 w 1926431"/>
                <a:gd name="connsiteY102" fmla="*/ 273844 h 300184"/>
                <a:gd name="connsiteX103" fmla="*/ 1785938 w 1926431"/>
                <a:gd name="connsiteY103" fmla="*/ 278607 h 300184"/>
                <a:gd name="connsiteX104" fmla="*/ 1800225 w 1926431"/>
                <a:gd name="connsiteY104" fmla="*/ 283369 h 300184"/>
                <a:gd name="connsiteX105" fmla="*/ 1814513 w 1926431"/>
                <a:gd name="connsiteY105" fmla="*/ 288132 h 300184"/>
                <a:gd name="connsiteX106" fmla="*/ 1828800 w 1926431"/>
                <a:gd name="connsiteY106" fmla="*/ 292894 h 300184"/>
                <a:gd name="connsiteX107" fmla="*/ 1883569 w 1926431"/>
                <a:gd name="connsiteY107" fmla="*/ 295275 h 300184"/>
                <a:gd name="connsiteX108" fmla="*/ 1914525 w 1926431"/>
                <a:gd name="connsiteY108" fmla="*/ 300038 h 300184"/>
                <a:gd name="connsiteX109" fmla="*/ 1926431 w 1926431"/>
                <a:gd name="connsiteY109" fmla="*/ 300038 h 300184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  <a:cxn ang="0">
                  <a:pos x="connsiteX29" y="connsiteY29"/>
                </a:cxn>
                <a:cxn ang="0">
                  <a:pos x="connsiteX30" y="connsiteY30"/>
                </a:cxn>
                <a:cxn ang="0">
                  <a:pos x="connsiteX31" y="connsiteY31"/>
                </a:cxn>
                <a:cxn ang="0">
                  <a:pos x="connsiteX32" y="connsiteY32"/>
                </a:cxn>
                <a:cxn ang="0">
                  <a:pos x="connsiteX33" y="connsiteY33"/>
                </a:cxn>
                <a:cxn ang="0">
                  <a:pos x="connsiteX34" y="connsiteY34"/>
                </a:cxn>
                <a:cxn ang="0">
                  <a:pos x="connsiteX35" y="connsiteY35"/>
                </a:cxn>
                <a:cxn ang="0">
                  <a:pos x="connsiteX36" y="connsiteY36"/>
                </a:cxn>
                <a:cxn ang="0">
                  <a:pos x="connsiteX37" y="connsiteY37"/>
                </a:cxn>
                <a:cxn ang="0">
                  <a:pos x="connsiteX38" y="connsiteY38"/>
                </a:cxn>
                <a:cxn ang="0">
                  <a:pos x="connsiteX39" y="connsiteY39"/>
                </a:cxn>
                <a:cxn ang="0">
                  <a:pos x="connsiteX40" y="connsiteY40"/>
                </a:cxn>
                <a:cxn ang="0">
                  <a:pos x="connsiteX41" y="connsiteY41"/>
                </a:cxn>
                <a:cxn ang="0">
                  <a:pos x="connsiteX42" y="connsiteY42"/>
                </a:cxn>
                <a:cxn ang="0">
                  <a:pos x="connsiteX43" y="connsiteY43"/>
                </a:cxn>
                <a:cxn ang="0">
                  <a:pos x="connsiteX44" y="connsiteY44"/>
                </a:cxn>
                <a:cxn ang="0">
                  <a:pos x="connsiteX45" y="connsiteY45"/>
                </a:cxn>
                <a:cxn ang="0">
                  <a:pos x="connsiteX46" y="connsiteY46"/>
                </a:cxn>
                <a:cxn ang="0">
                  <a:pos x="connsiteX47" y="connsiteY47"/>
                </a:cxn>
                <a:cxn ang="0">
                  <a:pos x="connsiteX48" y="connsiteY48"/>
                </a:cxn>
                <a:cxn ang="0">
                  <a:pos x="connsiteX49" y="connsiteY49"/>
                </a:cxn>
                <a:cxn ang="0">
                  <a:pos x="connsiteX50" y="connsiteY50"/>
                </a:cxn>
                <a:cxn ang="0">
                  <a:pos x="connsiteX51" y="connsiteY51"/>
                </a:cxn>
                <a:cxn ang="0">
                  <a:pos x="connsiteX52" y="connsiteY52"/>
                </a:cxn>
                <a:cxn ang="0">
                  <a:pos x="connsiteX53" y="connsiteY53"/>
                </a:cxn>
                <a:cxn ang="0">
                  <a:pos x="connsiteX54" y="connsiteY54"/>
                </a:cxn>
                <a:cxn ang="0">
                  <a:pos x="connsiteX55" y="connsiteY55"/>
                </a:cxn>
                <a:cxn ang="0">
                  <a:pos x="connsiteX56" y="connsiteY56"/>
                </a:cxn>
                <a:cxn ang="0">
                  <a:pos x="connsiteX57" y="connsiteY57"/>
                </a:cxn>
                <a:cxn ang="0">
                  <a:pos x="connsiteX58" y="connsiteY58"/>
                </a:cxn>
                <a:cxn ang="0">
                  <a:pos x="connsiteX59" y="connsiteY59"/>
                </a:cxn>
                <a:cxn ang="0">
                  <a:pos x="connsiteX60" y="connsiteY60"/>
                </a:cxn>
                <a:cxn ang="0">
                  <a:pos x="connsiteX61" y="connsiteY61"/>
                </a:cxn>
                <a:cxn ang="0">
                  <a:pos x="connsiteX62" y="connsiteY62"/>
                </a:cxn>
                <a:cxn ang="0">
                  <a:pos x="connsiteX63" y="connsiteY63"/>
                </a:cxn>
                <a:cxn ang="0">
                  <a:pos x="connsiteX64" y="connsiteY64"/>
                </a:cxn>
                <a:cxn ang="0">
                  <a:pos x="connsiteX65" y="connsiteY65"/>
                </a:cxn>
                <a:cxn ang="0">
                  <a:pos x="connsiteX66" y="connsiteY66"/>
                </a:cxn>
                <a:cxn ang="0">
                  <a:pos x="connsiteX67" y="connsiteY67"/>
                </a:cxn>
                <a:cxn ang="0">
                  <a:pos x="connsiteX68" y="connsiteY68"/>
                </a:cxn>
                <a:cxn ang="0">
                  <a:pos x="connsiteX69" y="connsiteY69"/>
                </a:cxn>
                <a:cxn ang="0">
                  <a:pos x="connsiteX70" y="connsiteY70"/>
                </a:cxn>
                <a:cxn ang="0">
                  <a:pos x="connsiteX71" y="connsiteY71"/>
                </a:cxn>
                <a:cxn ang="0">
                  <a:pos x="connsiteX72" y="connsiteY72"/>
                </a:cxn>
                <a:cxn ang="0">
                  <a:pos x="connsiteX73" y="connsiteY73"/>
                </a:cxn>
                <a:cxn ang="0">
                  <a:pos x="connsiteX74" y="connsiteY74"/>
                </a:cxn>
                <a:cxn ang="0">
                  <a:pos x="connsiteX75" y="connsiteY75"/>
                </a:cxn>
                <a:cxn ang="0">
                  <a:pos x="connsiteX76" y="connsiteY76"/>
                </a:cxn>
                <a:cxn ang="0">
                  <a:pos x="connsiteX77" y="connsiteY77"/>
                </a:cxn>
                <a:cxn ang="0">
                  <a:pos x="connsiteX78" y="connsiteY78"/>
                </a:cxn>
                <a:cxn ang="0">
                  <a:pos x="connsiteX79" y="connsiteY79"/>
                </a:cxn>
                <a:cxn ang="0">
                  <a:pos x="connsiteX80" y="connsiteY80"/>
                </a:cxn>
                <a:cxn ang="0">
                  <a:pos x="connsiteX81" y="connsiteY81"/>
                </a:cxn>
                <a:cxn ang="0">
                  <a:pos x="connsiteX82" y="connsiteY82"/>
                </a:cxn>
                <a:cxn ang="0">
                  <a:pos x="connsiteX83" y="connsiteY83"/>
                </a:cxn>
                <a:cxn ang="0">
                  <a:pos x="connsiteX84" y="connsiteY84"/>
                </a:cxn>
                <a:cxn ang="0">
                  <a:pos x="connsiteX85" y="connsiteY85"/>
                </a:cxn>
                <a:cxn ang="0">
                  <a:pos x="connsiteX86" y="connsiteY86"/>
                </a:cxn>
                <a:cxn ang="0">
                  <a:pos x="connsiteX87" y="connsiteY87"/>
                </a:cxn>
                <a:cxn ang="0">
                  <a:pos x="connsiteX88" y="connsiteY88"/>
                </a:cxn>
                <a:cxn ang="0">
                  <a:pos x="connsiteX89" y="connsiteY89"/>
                </a:cxn>
                <a:cxn ang="0">
                  <a:pos x="connsiteX90" y="connsiteY90"/>
                </a:cxn>
                <a:cxn ang="0">
                  <a:pos x="connsiteX91" y="connsiteY91"/>
                </a:cxn>
                <a:cxn ang="0">
                  <a:pos x="connsiteX92" y="connsiteY92"/>
                </a:cxn>
                <a:cxn ang="0">
                  <a:pos x="connsiteX93" y="connsiteY93"/>
                </a:cxn>
                <a:cxn ang="0">
                  <a:pos x="connsiteX94" y="connsiteY94"/>
                </a:cxn>
                <a:cxn ang="0">
                  <a:pos x="connsiteX95" y="connsiteY95"/>
                </a:cxn>
                <a:cxn ang="0">
                  <a:pos x="connsiteX96" y="connsiteY96"/>
                </a:cxn>
                <a:cxn ang="0">
                  <a:pos x="connsiteX97" y="connsiteY97"/>
                </a:cxn>
                <a:cxn ang="0">
                  <a:pos x="connsiteX98" y="connsiteY98"/>
                </a:cxn>
                <a:cxn ang="0">
                  <a:pos x="connsiteX99" y="connsiteY99"/>
                </a:cxn>
                <a:cxn ang="0">
                  <a:pos x="connsiteX100" y="connsiteY100"/>
                </a:cxn>
                <a:cxn ang="0">
                  <a:pos x="connsiteX101" y="connsiteY101"/>
                </a:cxn>
                <a:cxn ang="0">
                  <a:pos x="connsiteX102" y="connsiteY102"/>
                </a:cxn>
                <a:cxn ang="0">
                  <a:pos x="connsiteX103" y="connsiteY103"/>
                </a:cxn>
                <a:cxn ang="0">
                  <a:pos x="connsiteX104" y="connsiteY104"/>
                </a:cxn>
                <a:cxn ang="0">
                  <a:pos x="connsiteX105" y="connsiteY105"/>
                </a:cxn>
                <a:cxn ang="0">
                  <a:pos x="connsiteX106" y="connsiteY106"/>
                </a:cxn>
                <a:cxn ang="0">
                  <a:pos x="connsiteX107" y="connsiteY107"/>
                </a:cxn>
                <a:cxn ang="0">
                  <a:pos x="connsiteX108" y="connsiteY108"/>
                </a:cxn>
                <a:cxn ang="0">
                  <a:pos x="connsiteX109" y="connsiteY109"/>
                </a:cxn>
              </a:cxnLst>
              <a:rect l="l" t="t" r="r" b="b"/>
              <a:pathLst>
                <a:path w="1926431" h="300184">
                  <a:moveTo>
                    <a:pt x="0" y="0"/>
                  </a:moveTo>
                  <a:cubicBezTo>
                    <a:pt x="35555" y="5928"/>
                    <a:pt x="-8777" y="-1349"/>
                    <a:pt x="30956" y="4763"/>
                  </a:cubicBezTo>
                  <a:cubicBezTo>
                    <a:pt x="35728" y="5497"/>
                    <a:pt x="40531" y="6097"/>
                    <a:pt x="45244" y="7144"/>
                  </a:cubicBezTo>
                  <a:cubicBezTo>
                    <a:pt x="47694" y="7688"/>
                    <a:pt x="49918" y="9076"/>
                    <a:pt x="52388" y="9525"/>
                  </a:cubicBezTo>
                  <a:cubicBezTo>
                    <a:pt x="58684" y="10670"/>
                    <a:pt x="65113" y="10934"/>
                    <a:pt x="71438" y="11907"/>
                  </a:cubicBezTo>
                  <a:cubicBezTo>
                    <a:pt x="75438" y="12522"/>
                    <a:pt x="79418" y="13306"/>
                    <a:pt x="83344" y="14288"/>
                  </a:cubicBezTo>
                  <a:cubicBezTo>
                    <a:pt x="85779" y="14897"/>
                    <a:pt x="88027" y="16177"/>
                    <a:pt x="90488" y="16669"/>
                  </a:cubicBezTo>
                  <a:cubicBezTo>
                    <a:pt x="95954" y="17762"/>
                    <a:pt x="121583" y="20854"/>
                    <a:pt x="126206" y="21432"/>
                  </a:cubicBezTo>
                  <a:cubicBezTo>
                    <a:pt x="140110" y="26066"/>
                    <a:pt x="126683" y="22003"/>
                    <a:pt x="147638" y="26194"/>
                  </a:cubicBezTo>
                  <a:cubicBezTo>
                    <a:pt x="150847" y="26836"/>
                    <a:pt x="153968" y="27865"/>
                    <a:pt x="157163" y="28575"/>
                  </a:cubicBezTo>
                  <a:cubicBezTo>
                    <a:pt x="161114" y="29453"/>
                    <a:pt x="165164" y="29892"/>
                    <a:pt x="169069" y="30957"/>
                  </a:cubicBezTo>
                  <a:cubicBezTo>
                    <a:pt x="173912" y="32278"/>
                    <a:pt x="178594" y="34132"/>
                    <a:pt x="183356" y="35719"/>
                  </a:cubicBezTo>
                  <a:lnTo>
                    <a:pt x="190500" y="38100"/>
                  </a:lnTo>
                  <a:lnTo>
                    <a:pt x="211931" y="45244"/>
                  </a:lnTo>
                  <a:lnTo>
                    <a:pt x="219075" y="47625"/>
                  </a:lnTo>
                  <a:cubicBezTo>
                    <a:pt x="221456" y="49213"/>
                    <a:pt x="223604" y="51226"/>
                    <a:pt x="226219" y="52388"/>
                  </a:cubicBezTo>
                  <a:cubicBezTo>
                    <a:pt x="230806" y="54427"/>
                    <a:pt x="240506" y="57150"/>
                    <a:pt x="240506" y="57150"/>
                  </a:cubicBezTo>
                  <a:cubicBezTo>
                    <a:pt x="242887" y="58738"/>
                    <a:pt x="245035" y="60751"/>
                    <a:pt x="247650" y="61913"/>
                  </a:cubicBezTo>
                  <a:cubicBezTo>
                    <a:pt x="252238" y="63952"/>
                    <a:pt x="261938" y="66675"/>
                    <a:pt x="261938" y="66675"/>
                  </a:cubicBezTo>
                  <a:cubicBezTo>
                    <a:pt x="264319" y="68263"/>
                    <a:pt x="266466" y="70276"/>
                    <a:pt x="269081" y="71438"/>
                  </a:cubicBezTo>
                  <a:cubicBezTo>
                    <a:pt x="279253" y="75959"/>
                    <a:pt x="283206" y="75814"/>
                    <a:pt x="292894" y="78582"/>
                  </a:cubicBezTo>
                  <a:cubicBezTo>
                    <a:pt x="316767" y="85404"/>
                    <a:pt x="279839" y="75914"/>
                    <a:pt x="309563" y="83344"/>
                  </a:cubicBezTo>
                  <a:cubicBezTo>
                    <a:pt x="324538" y="93329"/>
                    <a:pt x="308472" y="83774"/>
                    <a:pt x="335756" y="92869"/>
                  </a:cubicBezTo>
                  <a:lnTo>
                    <a:pt x="357188" y="100013"/>
                  </a:lnTo>
                  <a:cubicBezTo>
                    <a:pt x="359569" y="100807"/>
                    <a:pt x="361855" y="101981"/>
                    <a:pt x="364331" y="102394"/>
                  </a:cubicBezTo>
                  <a:lnTo>
                    <a:pt x="378619" y="104775"/>
                  </a:lnTo>
                  <a:cubicBezTo>
                    <a:pt x="429110" y="121608"/>
                    <a:pt x="366457" y="101127"/>
                    <a:pt x="402431" y="111919"/>
                  </a:cubicBezTo>
                  <a:cubicBezTo>
                    <a:pt x="408037" y="113601"/>
                    <a:pt x="419532" y="118148"/>
                    <a:pt x="426244" y="119063"/>
                  </a:cubicBezTo>
                  <a:cubicBezTo>
                    <a:pt x="466658" y="124573"/>
                    <a:pt x="473091" y="124035"/>
                    <a:pt x="514350" y="126207"/>
                  </a:cubicBezTo>
                  <a:cubicBezTo>
                    <a:pt x="556028" y="124862"/>
                    <a:pt x="568992" y="129644"/>
                    <a:pt x="597694" y="121444"/>
                  </a:cubicBezTo>
                  <a:cubicBezTo>
                    <a:pt x="600108" y="120754"/>
                    <a:pt x="602457" y="119857"/>
                    <a:pt x="604838" y="119063"/>
                  </a:cubicBezTo>
                  <a:lnTo>
                    <a:pt x="626269" y="104775"/>
                  </a:lnTo>
                  <a:cubicBezTo>
                    <a:pt x="626277" y="104770"/>
                    <a:pt x="640549" y="95257"/>
                    <a:pt x="640556" y="95250"/>
                  </a:cubicBezTo>
                  <a:cubicBezTo>
                    <a:pt x="649475" y="86332"/>
                    <a:pt x="644505" y="89172"/>
                    <a:pt x="654844" y="85725"/>
                  </a:cubicBezTo>
                  <a:cubicBezTo>
                    <a:pt x="657225" y="83344"/>
                    <a:pt x="659401" y="80738"/>
                    <a:pt x="661988" y="78582"/>
                  </a:cubicBezTo>
                  <a:cubicBezTo>
                    <a:pt x="664186" y="76750"/>
                    <a:pt x="667107" y="75843"/>
                    <a:pt x="669131" y="73819"/>
                  </a:cubicBezTo>
                  <a:cubicBezTo>
                    <a:pt x="671155" y="71795"/>
                    <a:pt x="671870" y="68699"/>
                    <a:pt x="673894" y="66675"/>
                  </a:cubicBezTo>
                  <a:cubicBezTo>
                    <a:pt x="678509" y="62060"/>
                    <a:pt x="682372" y="61468"/>
                    <a:pt x="688181" y="59532"/>
                  </a:cubicBezTo>
                  <a:cubicBezTo>
                    <a:pt x="702289" y="48951"/>
                    <a:pt x="694399" y="54593"/>
                    <a:pt x="711994" y="42863"/>
                  </a:cubicBezTo>
                  <a:cubicBezTo>
                    <a:pt x="714375" y="41275"/>
                    <a:pt x="716423" y="39005"/>
                    <a:pt x="719138" y="38100"/>
                  </a:cubicBezTo>
                  <a:lnTo>
                    <a:pt x="740569" y="30957"/>
                  </a:lnTo>
                  <a:cubicBezTo>
                    <a:pt x="742950" y="30163"/>
                    <a:pt x="745278" y="29184"/>
                    <a:pt x="747713" y="28575"/>
                  </a:cubicBezTo>
                  <a:cubicBezTo>
                    <a:pt x="754063" y="26988"/>
                    <a:pt x="760554" y="25883"/>
                    <a:pt x="766763" y="23813"/>
                  </a:cubicBezTo>
                  <a:lnTo>
                    <a:pt x="788194" y="16669"/>
                  </a:lnTo>
                  <a:cubicBezTo>
                    <a:pt x="790575" y="15875"/>
                    <a:pt x="792862" y="14701"/>
                    <a:pt x="795338" y="14288"/>
                  </a:cubicBezTo>
                  <a:cubicBezTo>
                    <a:pt x="800100" y="13494"/>
                    <a:pt x="804891" y="12854"/>
                    <a:pt x="809625" y="11907"/>
                  </a:cubicBezTo>
                  <a:cubicBezTo>
                    <a:pt x="812834" y="11265"/>
                    <a:pt x="815941" y="10167"/>
                    <a:pt x="819150" y="9525"/>
                  </a:cubicBezTo>
                  <a:cubicBezTo>
                    <a:pt x="848368" y="3681"/>
                    <a:pt x="820822" y="10298"/>
                    <a:pt x="842963" y="4763"/>
                  </a:cubicBezTo>
                  <a:cubicBezTo>
                    <a:pt x="858838" y="5557"/>
                    <a:pt x="874744" y="5877"/>
                    <a:pt x="890588" y="7144"/>
                  </a:cubicBezTo>
                  <a:cubicBezTo>
                    <a:pt x="906837" y="8444"/>
                    <a:pt x="899374" y="10807"/>
                    <a:pt x="916781" y="14288"/>
                  </a:cubicBezTo>
                  <a:cubicBezTo>
                    <a:pt x="923173" y="15566"/>
                    <a:pt x="937793" y="17977"/>
                    <a:pt x="942975" y="21432"/>
                  </a:cubicBezTo>
                  <a:lnTo>
                    <a:pt x="964406" y="35719"/>
                  </a:lnTo>
                  <a:cubicBezTo>
                    <a:pt x="966787" y="37307"/>
                    <a:pt x="968835" y="39577"/>
                    <a:pt x="971550" y="40482"/>
                  </a:cubicBezTo>
                  <a:lnTo>
                    <a:pt x="985838" y="45244"/>
                  </a:lnTo>
                  <a:cubicBezTo>
                    <a:pt x="997158" y="52792"/>
                    <a:pt x="990266" y="49102"/>
                    <a:pt x="1007269" y="54769"/>
                  </a:cubicBezTo>
                  <a:cubicBezTo>
                    <a:pt x="1009650" y="55563"/>
                    <a:pt x="1011978" y="56541"/>
                    <a:pt x="1014413" y="57150"/>
                  </a:cubicBezTo>
                  <a:cubicBezTo>
                    <a:pt x="1020763" y="58738"/>
                    <a:pt x="1027253" y="59843"/>
                    <a:pt x="1033463" y="61913"/>
                  </a:cubicBezTo>
                  <a:cubicBezTo>
                    <a:pt x="1046232" y="66169"/>
                    <a:pt x="1035265" y="62842"/>
                    <a:pt x="1052513" y="66675"/>
                  </a:cubicBezTo>
                  <a:cubicBezTo>
                    <a:pt x="1055708" y="67385"/>
                    <a:pt x="1058829" y="68415"/>
                    <a:pt x="1062038" y="69057"/>
                  </a:cubicBezTo>
                  <a:cubicBezTo>
                    <a:pt x="1066772" y="70004"/>
                    <a:pt x="1071641" y="70267"/>
                    <a:pt x="1076325" y="71438"/>
                  </a:cubicBezTo>
                  <a:cubicBezTo>
                    <a:pt x="1081195" y="72655"/>
                    <a:pt x="1085661" y="75374"/>
                    <a:pt x="1090613" y="76200"/>
                  </a:cubicBezTo>
                  <a:cubicBezTo>
                    <a:pt x="1095375" y="76994"/>
                    <a:pt x="1100216" y="77411"/>
                    <a:pt x="1104900" y="78582"/>
                  </a:cubicBezTo>
                  <a:cubicBezTo>
                    <a:pt x="1104905" y="78583"/>
                    <a:pt x="1122756" y="84533"/>
                    <a:pt x="1126331" y="85725"/>
                  </a:cubicBezTo>
                  <a:cubicBezTo>
                    <a:pt x="1128712" y="86519"/>
                    <a:pt x="1130999" y="87694"/>
                    <a:pt x="1133475" y="88107"/>
                  </a:cubicBezTo>
                  <a:lnTo>
                    <a:pt x="1147763" y="90488"/>
                  </a:lnTo>
                  <a:cubicBezTo>
                    <a:pt x="1153310" y="91341"/>
                    <a:pt x="1158909" y="91865"/>
                    <a:pt x="1164431" y="92869"/>
                  </a:cubicBezTo>
                  <a:cubicBezTo>
                    <a:pt x="1167651" y="93454"/>
                    <a:pt x="1170761" y="94540"/>
                    <a:pt x="1173956" y="95250"/>
                  </a:cubicBezTo>
                  <a:cubicBezTo>
                    <a:pt x="1177907" y="96128"/>
                    <a:pt x="1181912" y="96754"/>
                    <a:pt x="1185863" y="97632"/>
                  </a:cubicBezTo>
                  <a:cubicBezTo>
                    <a:pt x="1189058" y="98342"/>
                    <a:pt x="1192133" y="99670"/>
                    <a:pt x="1195388" y="100013"/>
                  </a:cubicBezTo>
                  <a:cubicBezTo>
                    <a:pt x="1207255" y="101262"/>
                    <a:pt x="1219200" y="101600"/>
                    <a:pt x="1231106" y="102394"/>
                  </a:cubicBezTo>
                  <a:cubicBezTo>
                    <a:pt x="1242207" y="106094"/>
                    <a:pt x="1236975" y="104762"/>
                    <a:pt x="1252538" y="107157"/>
                  </a:cubicBezTo>
                  <a:cubicBezTo>
                    <a:pt x="1272081" y="110164"/>
                    <a:pt x="1270760" y="109693"/>
                    <a:pt x="1293019" y="111919"/>
                  </a:cubicBezTo>
                  <a:lnTo>
                    <a:pt x="1316831" y="116682"/>
                  </a:lnTo>
                  <a:cubicBezTo>
                    <a:pt x="1320800" y="117476"/>
                    <a:pt x="1324898" y="117783"/>
                    <a:pt x="1328738" y="119063"/>
                  </a:cubicBezTo>
                  <a:cubicBezTo>
                    <a:pt x="1338655" y="122369"/>
                    <a:pt x="1335139" y="121525"/>
                    <a:pt x="1347788" y="123825"/>
                  </a:cubicBezTo>
                  <a:cubicBezTo>
                    <a:pt x="1352538" y="124689"/>
                    <a:pt x="1357303" y="125473"/>
                    <a:pt x="1362075" y="126207"/>
                  </a:cubicBezTo>
                  <a:cubicBezTo>
                    <a:pt x="1367622" y="127061"/>
                    <a:pt x="1373222" y="127584"/>
                    <a:pt x="1378744" y="128588"/>
                  </a:cubicBezTo>
                  <a:cubicBezTo>
                    <a:pt x="1381964" y="129173"/>
                    <a:pt x="1385029" y="130506"/>
                    <a:pt x="1388269" y="130969"/>
                  </a:cubicBezTo>
                  <a:cubicBezTo>
                    <a:pt x="1407636" y="133735"/>
                    <a:pt x="1437633" y="134770"/>
                    <a:pt x="1454944" y="135732"/>
                  </a:cubicBezTo>
                  <a:cubicBezTo>
                    <a:pt x="1475227" y="140802"/>
                    <a:pt x="1452117" y="135372"/>
                    <a:pt x="1481138" y="140494"/>
                  </a:cubicBezTo>
                  <a:cubicBezTo>
                    <a:pt x="1489109" y="141901"/>
                    <a:pt x="1497013" y="143669"/>
                    <a:pt x="1504950" y="145257"/>
                  </a:cubicBezTo>
                  <a:cubicBezTo>
                    <a:pt x="1508919" y="146051"/>
                    <a:pt x="1513016" y="146358"/>
                    <a:pt x="1516856" y="147638"/>
                  </a:cubicBezTo>
                  <a:cubicBezTo>
                    <a:pt x="1519237" y="148432"/>
                    <a:pt x="1521565" y="149410"/>
                    <a:pt x="1524000" y="150019"/>
                  </a:cubicBezTo>
                  <a:cubicBezTo>
                    <a:pt x="1527926" y="151001"/>
                    <a:pt x="1531980" y="151418"/>
                    <a:pt x="1535906" y="152400"/>
                  </a:cubicBezTo>
                  <a:cubicBezTo>
                    <a:pt x="1547875" y="155393"/>
                    <a:pt x="1538556" y="153726"/>
                    <a:pt x="1550194" y="159544"/>
                  </a:cubicBezTo>
                  <a:cubicBezTo>
                    <a:pt x="1552439" y="160666"/>
                    <a:pt x="1554957" y="161131"/>
                    <a:pt x="1557338" y="161925"/>
                  </a:cubicBezTo>
                  <a:cubicBezTo>
                    <a:pt x="1584308" y="182154"/>
                    <a:pt x="1550250" y="157496"/>
                    <a:pt x="1576388" y="173832"/>
                  </a:cubicBezTo>
                  <a:cubicBezTo>
                    <a:pt x="1584666" y="179005"/>
                    <a:pt x="1585162" y="181432"/>
                    <a:pt x="1593056" y="185738"/>
                  </a:cubicBezTo>
                  <a:cubicBezTo>
                    <a:pt x="1609786" y="194864"/>
                    <a:pt x="1606985" y="193556"/>
                    <a:pt x="1619250" y="197644"/>
                  </a:cubicBezTo>
                  <a:cubicBezTo>
                    <a:pt x="1621631" y="199232"/>
                    <a:pt x="1623779" y="201245"/>
                    <a:pt x="1626394" y="202407"/>
                  </a:cubicBezTo>
                  <a:cubicBezTo>
                    <a:pt x="1630981" y="204446"/>
                    <a:pt x="1640681" y="207169"/>
                    <a:pt x="1640681" y="207169"/>
                  </a:cubicBezTo>
                  <a:cubicBezTo>
                    <a:pt x="1643062" y="208757"/>
                    <a:pt x="1645265" y="210652"/>
                    <a:pt x="1647825" y="211932"/>
                  </a:cubicBezTo>
                  <a:cubicBezTo>
                    <a:pt x="1651240" y="213640"/>
                    <a:pt x="1661444" y="215931"/>
                    <a:pt x="1664494" y="216694"/>
                  </a:cubicBezTo>
                  <a:cubicBezTo>
                    <a:pt x="1667669" y="218282"/>
                    <a:pt x="1670651" y="220334"/>
                    <a:pt x="1674019" y="221457"/>
                  </a:cubicBezTo>
                  <a:cubicBezTo>
                    <a:pt x="1677859" y="222737"/>
                    <a:pt x="1681999" y="222856"/>
                    <a:pt x="1685925" y="223838"/>
                  </a:cubicBezTo>
                  <a:cubicBezTo>
                    <a:pt x="1688360" y="224447"/>
                    <a:pt x="1690655" y="225529"/>
                    <a:pt x="1693069" y="226219"/>
                  </a:cubicBezTo>
                  <a:cubicBezTo>
                    <a:pt x="1696216" y="227118"/>
                    <a:pt x="1699419" y="227806"/>
                    <a:pt x="1702594" y="228600"/>
                  </a:cubicBezTo>
                  <a:cubicBezTo>
                    <a:pt x="1704975" y="230188"/>
                    <a:pt x="1707178" y="232083"/>
                    <a:pt x="1709738" y="233363"/>
                  </a:cubicBezTo>
                  <a:cubicBezTo>
                    <a:pt x="1711983" y="234485"/>
                    <a:pt x="1714793" y="234352"/>
                    <a:pt x="1716881" y="235744"/>
                  </a:cubicBezTo>
                  <a:cubicBezTo>
                    <a:pt x="1731176" y="245274"/>
                    <a:pt x="1716211" y="241363"/>
                    <a:pt x="1733550" y="250032"/>
                  </a:cubicBezTo>
                  <a:cubicBezTo>
                    <a:pt x="1736477" y="251496"/>
                    <a:pt x="1739900" y="251619"/>
                    <a:pt x="1743075" y="252413"/>
                  </a:cubicBezTo>
                  <a:cubicBezTo>
                    <a:pt x="1758931" y="268269"/>
                    <a:pt x="1741854" y="253322"/>
                    <a:pt x="1757363" y="261938"/>
                  </a:cubicBezTo>
                  <a:cubicBezTo>
                    <a:pt x="1781927" y="275584"/>
                    <a:pt x="1762629" y="268456"/>
                    <a:pt x="1778794" y="273844"/>
                  </a:cubicBezTo>
                  <a:cubicBezTo>
                    <a:pt x="1781175" y="275432"/>
                    <a:pt x="1783323" y="277445"/>
                    <a:pt x="1785938" y="278607"/>
                  </a:cubicBezTo>
                  <a:cubicBezTo>
                    <a:pt x="1790525" y="280646"/>
                    <a:pt x="1795463" y="281782"/>
                    <a:pt x="1800225" y="283369"/>
                  </a:cubicBezTo>
                  <a:lnTo>
                    <a:pt x="1814513" y="288132"/>
                  </a:lnTo>
                  <a:cubicBezTo>
                    <a:pt x="1814515" y="288133"/>
                    <a:pt x="1828798" y="292894"/>
                    <a:pt x="1828800" y="292894"/>
                  </a:cubicBezTo>
                  <a:lnTo>
                    <a:pt x="1883569" y="295275"/>
                  </a:lnTo>
                  <a:cubicBezTo>
                    <a:pt x="1890226" y="296385"/>
                    <a:pt x="1908382" y="299526"/>
                    <a:pt x="1914525" y="300038"/>
                  </a:cubicBezTo>
                  <a:cubicBezTo>
                    <a:pt x="1918480" y="300368"/>
                    <a:pt x="1922462" y="300038"/>
                    <a:pt x="1926431" y="300038"/>
                  </a:cubicBezTo>
                </a:path>
              </a:pathLst>
            </a:custGeom>
            <a:noFill/>
            <a:ln w="38100"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9666"/>
            </a:p>
          </p:txBody>
        </p:sp>
      </p:grpSp>
      <p:grpSp>
        <p:nvGrpSpPr>
          <p:cNvPr id="238" name="Group 237"/>
          <p:cNvGrpSpPr/>
          <p:nvPr/>
        </p:nvGrpSpPr>
        <p:grpSpPr>
          <a:xfrm>
            <a:off x="18031467" y="7015701"/>
            <a:ext cx="4740043" cy="5059295"/>
            <a:chOff x="6831563" y="2279865"/>
            <a:chExt cx="1822848" cy="1825410"/>
          </a:xfrm>
        </p:grpSpPr>
        <p:pic>
          <p:nvPicPr>
            <p:cNvPr id="239" name="Picture 238"/>
            <p:cNvPicPr>
              <a:picLocks noChangeAspect="1"/>
            </p:cNvPicPr>
            <p:nvPr/>
          </p:nvPicPr>
          <p:blipFill>
            <a:blip r:embed="rId2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 rot="16200000">
              <a:off x="6810759" y="2300669"/>
              <a:ext cx="1825410" cy="1783801"/>
            </a:xfrm>
            <a:prstGeom prst="rect">
              <a:avLst/>
            </a:prstGeom>
          </p:spPr>
        </p:pic>
        <p:sp>
          <p:nvSpPr>
            <p:cNvPr id="240" name="Freeform 239"/>
            <p:cNvSpPr/>
            <p:nvPr/>
          </p:nvSpPr>
          <p:spPr>
            <a:xfrm>
              <a:off x="6866417" y="2749456"/>
              <a:ext cx="1787994" cy="294791"/>
            </a:xfrm>
            <a:custGeom>
              <a:avLst/>
              <a:gdLst>
                <a:gd name="connsiteX0" fmla="*/ 0 w 1933764"/>
                <a:gd name="connsiteY0" fmla="*/ 0 h 317770"/>
                <a:gd name="connsiteX1" fmla="*/ 30956 w 1933764"/>
                <a:gd name="connsiteY1" fmla="*/ 9525 h 317770"/>
                <a:gd name="connsiteX2" fmla="*/ 52388 w 1933764"/>
                <a:gd name="connsiteY2" fmla="*/ 11906 h 317770"/>
                <a:gd name="connsiteX3" fmla="*/ 66675 w 1933764"/>
                <a:gd name="connsiteY3" fmla="*/ 14287 h 317770"/>
                <a:gd name="connsiteX4" fmla="*/ 85725 w 1933764"/>
                <a:gd name="connsiteY4" fmla="*/ 16668 h 317770"/>
                <a:gd name="connsiteX5" fmla="*/ 102394 w 1933764"/>
                <a:gd name="connsiteY5" fmla="*/ 21431 h 317770"/>
                <a:gd name="connsiteX6" fmla="*/ 123825 w 1933764"/>
                <a:gd name="connsiteY6" fmla="*/ 26193 h 317770"/>
                <a:gd name="connsiteX7" fmla="*/ 145256 w 1933764"/>
                <a:gd name="connsiteY7" fmla="*/ 33337 h 317770"/>
                <a:gd name="connsiteX8" fmla="*/ 152400 w 1933764"/>
                <a:gd name="connsiteY8" fmla="*/ 35718 h 317770"/>
                <a:gd name="connsiteX9" fmla="*/ 166688 w 1933764"/>
                <a:gd name="connsiteY9" fmla="*/ 42862 h 317770"/>
                <a:gd name="connsiteX10" fmla="*/ 185738 w 1933764"/>
                <a:gd name="connsiteY10" fmla="*/ 52387 h 317770"/>
                <a:gd name="connsiteX11" fmla="*/ 195263 w 1933764"/>
                <a:gd name="connsiteY11" fmla="*/ 57150 h 317770"/>
                <a:gd name="connsiteX12" fmla="*/ 211931 w 1933764"/>
                <a:gd name="connsiteY12" fmla="*/ 66675 h 317770"/>
                <a:gd name="connsiteX13" fmla="*/ 226219 w 1933764"/>
                <a:gd name="connsiteY13" fmla="*/ 71437 h 317770"/>
                <a:gd name="connsiteX14" fmla="*/ 240506 w 1933764"/>
                <a:gd name="connsiteY14" fmla="*/ 76200 h 317770"/>
                <a:gd name="connsiteX15" fmla="*/ 247650 w 1933764"/>
                <a:gd name="connsiteY15" fmla="*/ 78581 h 317770"/>
                <a:gd name="connsiteX16" fmla="*/ 254794 w 1933764"/>
                <a:gd name="connsiteY16" fmla="*/ 83343 h 317770"/>
                <a:gd name="connsiteX17" fmla="*/ 269081 w 1933764"/>
                <a:gd name="connsiteY17" fmla="*/ 88106 h 317770"/>
                <a:gd name="connsiteX18" fmla="*/ 283369 w 1933764"/>
                <a:gd name="connsiteY18" fmla="*/ 92868 h 317770"/>
                <a:gd name="connsiteX19" fmla="*/ 290513 w 1933764"/>
                <a:gd name="connsiteY19" fmla="*/ 95250 h 317770"/>
                <a:gd name="connsiteX20" fmla="*/ 297656 w 1933764"/>
                <a:gd name="connsiteY20" fmla="*/ 97631 h 317770"/>
                <a:gd name="connsiteX21" fmla="*/ 307181 w 1933764"/>
                <a:gd name="connsiteY21" fmla="*/ 102393 h 317770"/>
                <a:gd name="connsiteX22" fmla="*/ 328613 w 1933764"/>
                <a:gd name="connsiteY22" fmla="*/ 109537 h 317770"/>
                <a:gd name="connsiteX23" fmla="*/ 350044 w 1933764"/>
                <a:gd name="connsiteY23" fmla="*/ 116681 h 317770"/>
                <a:gd name="connsiteX24" fmla="*/ 357188 w 1933764"/>
                <a:gd name="connsiteY24" fmla="*/ 119062 h 317770"/>
                <a:gd name="connsiteX25" fmla="*/ 364331 w 1933764"/>
                <a:gd name="connsiteY25" fmla="*/ 121443 h 317770"/>
                <a:gd name="connsiteX26" fmla="*/ 388144 w 1933764"/>
                <a:gd name="connsiteY26" fmla="*/ 128587 h 317770"/>
                <a:gd name="connsiteX27" fmla="*/ 416719 w 1933764"/>
                <a:gd name="connsiteY27" fmla="*/ 138112 h 317770"/>
                <a:gd name="connsiteX28" fmla="*/ 431006 w 1933764"/>
                <a:gd name="connsiteY28" fmla="*/ 142875 h 317770"/>
                <a:gd name="connsiteX29" fmla="*/ 438150 w 1933764"/>
                <a:gd name="connsiteY29" fmla="*/ 147637 h 317770"/>
                <a:gd name="connsiteX30" fmla="*/ 452438 w 1933764"/>
                <a:gd name="connsiteY30" fmla="*/ 152400 h 317770"/>
                <a:gd name="connsiteX31" fmla="*/ 466725 w 1933764"/>
                <a:gd name="connsiteY31" fmla="*/ 157162 h 317770"/>
                <a:gd name="connsiteX32" fmla="*/ 488156 w 1933764"/>
                <a:gd name="connsiteY32" fmla="*/ 164306 h 317770"/>
                <a:gd name="connsiteX33" fmla="*/ 495300 w 1933764"/>
                <a:gd name="connsiteY33" fmla="*/ 166687 h 317770"/>
                <a:gd name="connsiteX34" fmla="*/ 502444 w 1933764"/>
                <a:gd name="connsiteY34" fmla="*/ 169068 h 317770"/>
                <a:gd name="connsiteX35" fmla="*/ 509588 w 1933764"/>
                <a:gd name="connsiteY35" fmla="*/ 173831 h 317770"/>
                <a:gd name="connsiteX36" fmla="*/ 526256 w 1933764"/>
                <a:gd name="connsiteY36" fmla="*/ 178593 h 317770"/>
                <a:gd name="connsiteX37" fmla="*/ 559594 w 1933764"/>
                <a:gd name="connsiteY37" fmla="*/ 188118 h 317770"/>
                <a:gd name="connsiteX38" fmla="*/ 576263 w 1933764"/>
                <a:gd name="connsiteY38" fmla="*/ 190500 h 317770"/>
                <a:gd name="connsiteX39" fmla="*/ 592931 w 1933764"/>
                <a:gd name="connsiteY39" fmla="*/ 195262 h 317770"/>
                <a:gd name="connsiteX40" fmla="*/ 607219 w 1933764"/>
                <a:gd name="connsiteY40" fmla="*/ 197643 h 317770"/>
                <a:gd name="connsiteX41" fmla="*/ 635794 w 1933764"/>
                <a:gd name="connsiteY41" fmla="*/ 202406 h 317770"/>
                <a:gd name="connsiteX42" fmla="*/ 654844 w 1933764"/>
                <a:gd name="connsiteY42" fmla="*/ 204787 h 317770"/>
                <a:gd name="connsiteX43" fmla="*/ 676275 w 1933764"/>
                <a:gd name="connsiteY43" fmla="*/ 209550 h 317770"/>
                <a:gd name="connsiteX44" fmla="*/ 688181 w 1933764"/>
                <a:gd name="connsiteY44" fmla="*/ 211931 h 317770"/>
                <a:gd name="connsiteX45" fmla="*/ 702469 w 1933764"/>
                <a:gd name="connsiteY45" fmla="*/ 214312 h 317770"/>
                <a:gd name="connsiteX46" fmla="*/ 711994 w 1933764"/>
                <a:gd name="connsiteY46" fmla="*/ 216693 h 317770"/>
                <a:gd name="connsiteX47" fmla="*/ 757238 w 1933764"/>
                <a:gd name="connsiteY47" fmla="*/ 223837 h 317770"/>
                <a:gd name="connsiteX48" fmla="*/ 764381 w 1933764"/>
                <a:gd name="connsiteY48" fmla="*/ 226218 h 317770"/>
                <a:gd name="connsiteX49" fmla="*/ 828675 w 1933764"/>
                <a:gd name="connsiteY49" fmla="*/ 233362 h 317770"/>
                <a:gd name="connsiteX50" fmla="*/ 835819 w 1933764"/>
                <a:gd name="connsiteY50" fmla="*/ 235743 h 317770"/>
                <a:gd name="connsiteX51" fmla="*/ 854869 w 1933764"/>
                <a:gd name="connsiteY51" fmla="*/ 240506 h 317770"/>
                <a:gd name="connsiteX52" fmla="*/ 869156 w 1933764"/>
                <a:gd name="connsiteY52" fmla="*/ 245268 h 317770"/>
                <a:gd name="connsiteX53" fmla="*/ 890588 w 1933764"/>
                <a:gd name="connsiteY53" fmla="*/ 252412 h 317770"/>
                <a:gd name="connsiteX54" fmla="*/ 897731 w 1933764"/>
                <a:gd name="connsiteY54" fmla="*/ 254793 h 317770"/>
                <a:gd name="connsiteX55" fmla="*/ 904875 w 1933764"/>
                <a:gd name="connsiteY55" fmla="*/ 257175 h 317770"/>
                <a:gd name="connsiteX56" fmla="*/ 916781 w 1933764"/>
                <a:gd name="connsiteY56" fmla="*/ 259556 h 317770"/>
                <a:gd name="connsiteX57" fmla="*/ 935831 w 1933764"/>
                <a:gd name="connsiteY57" fmla="*/ 261937 h 317770"/>
                <a:gd name="connsiteX58" fmla="*/ 945356 w 1933764"/>
                <a:gd name="connsiteY58" fmla="*/ 264318 h 317770"/>
                <a:gd name="connsiteX59" fmla="*/ 971550 w 1933764"/>
                <a:gd name="connsiteY59" fmla="*/ 269081 h 317770"/>
                <a:gd name="connsiteX60" fmla="*/ 978694 w 1933764"/>
                <a:gd name="connsiteY60" fmla="*/ 273843 h 317770"/>
                <a:gd name="connsiteX61" fmla="*/ 988219 w 1933764"/>
                <a:gd name="connsiteY61" fmla="*/ 276225 h 317770"/>
                <a:gd name="connsiteX62" fmla="*/ 995363 w 1933764"/>
                <a:gd name="connsiteY62" fmla="*/ 278606 h 317770"/>
                <a:gd name="connsiteX63" fmla="*/ 1002506 w 1933764"/>
                <a:gd name="connsiteY63" fmla="*/ 283368 h 317770"/>
                <a:gd name="connsiteX64" fmla="*/ 1016794 w 1933764"/>
                <a:gd name="connsiteY64" fmla="*/ 288131 h 317770"/>
                <a:gd name="connsiteX65" fmla="*/ 1038225 w 1933764"/>
                <a:gd name="connsiteY65" fmla="*/ 297656 h 317770"/>
                <a:gd name="connsiteX66" fmla="*/ 1045369 w 1933764"/>
                <a:gd name="connsiteY66" fmla="*/ 300037 h 317770"/>
                <a:gd name="connsiteX67" fmla="*/ 1078706 w 1933764"/>
                <a:gd name="connsiteY67" fmla="*/ 304800 h 317770"/>
                <a:gd name="connsiteX68" fmla="*/ 1169194 w 1933764"/>
                <a:gd name="connsiteY68" fmla="*/ 307181 h 317770"/>
                <a:gd name="connsiteX69" fmla="*/ 1226344 w 1933764"/>
                <a:gd name="connsiteY69" fmla="*/ 311943 h 317770"/>
                <a:gd name="connsiteX70" fmla="*/ 1307306 w 1933764"/>
                <a:gd name="connsiteY70" fmla="*/ 314325 h 317770"/>
                <a:gd name="connsiteX71" fmla="*/ 1423988 w 1933764"/>
                <a:gd name="connsiteY71" fmla="*/ 314325 h 317770"/>
                <a:gd name="connsiteX72" fmla="*/ 1431131 w 1933764"/>
                <a:gd name="connsiteY72" fmla="*/ 311943 h 317770"/>
                <a:gd name="connsiteX73" fmla="*/ 1440656 w 1933764"/>
                <a:gd name="connsiteY73" fmla="*/ 309562 h 317770"/>
                <a:gd name="connsiteX74" fmla="*/ 1454944 w 1933764"/>
                <a:gd name="connsiteY74" fmla="*/ 304800 h 317770"/>
                <a:gd name="connsiteX75" fmla="*/ 1464469 w 1933764"/>
                <a:gd name="connsiteY75" fmla="*/ 302418 h 317770"/>
                <a:gd name="connsiteX76" fmla="*/ 1485900 w 1933764"/>
                <a:gd name="connsiteY76" fmla="*/ 295275 h 317770"/>
                <a:gd name="connsiteX77" fmla="*/ 1502569 w 1933764"/>
                <a:gd name="connsiteY77" fmla="*/ 290512 h 317770"/>
                <a:gd name="connsiteX78" fmla="*/ 1516856 w 1933764"/>
                <a:gd name="connsiteY78" fmla="*/ 285750 h 317770"/>
                <a:gd name="connsiteX79" fmla="*/ 1564481 w 1933764"/>
                <a:gd name="connsiteY79" fmla="*/ 278606 h 317770"/>
                <a:gd name="connsiteX80" fmla="*/ 1571625 w 1933764"/>
                <a:gd name="connsiteY80" fmla="*/ 276225 h 317770"/>
                <a:gd name="connsiteX81" fmla="*/ 1590675 w 1933764"/>
                <a:gd name="connsiteY81" fmla="*/ 273843 h 317770"/>
                <a:gd name="connsiteX82" fmla="*/ 1607344 w 1933764"/>
                <a:gd name="connsiteY82" fmla="*/ 271462 h 317770"/>
                <a:gd name="connsiteX83" fmla="*/ 1633538 w 1933764"/>
                <a:gd name="connsiteY83" fmla="*/ 266700 h 317770"/>
                <a:gd name="connsiteX84" fmla="*/ 1678781 w 1933764"/>
                <a:gd name="connsiteY84" fmla="*/ 261937 h 317770"/>
                <a:gd name="connsiteX85" fmla="*/ 1707356 w 1933764"/>
                <a:gd name="connsiteY85" fmla="*/ 257175 h 317770"/>
                <a:gd name="connsiteX86" fmla="*/ 1724025 w 1933764"/>
                <a:gd name="connsiteY86" fmla="*/ 254793 h 317770"/>
                <a:gd name="connsiteX87" fmla="*/ 1769269 w 1933764"/>
                <a:gd name="connsiteY87" fmla="*/ 247650 h 317770"/>
                <a:gd name="connsiteX88" fmla="*/ 1816894 w 1933764"/>
                <a:gd name="connsiteY88" fmla="*/ 242887 h 317770"/>
                <a:gd name="connsiteX89" fmla="*/ 1909763 w 1933764"/>
                <a:gd name="connsiteY89" fmla="*/ 245268 h 317770"/>
                <a:gd name="connsiteX90" fmla="*/ 1921669 w 1933764"/>
                <a:gd name="connsiteY90" fmla="*/ 247650 h 31777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  <a:cxn ang="0">
                  <a:pos x="connsiteX29" y="connsiteY29"/>
                </a:cxn>
                <a:cxn ang="0">
                  <a:pos x="connsiteX30" y="connsiteY30"/>
                </a:cxn>
                <a:cxn ang="0">
                  <a:pos x="connsiteX31" y="connsiteY31"/>
                </a:cxn>
                <a:cxn ang="0">
                  <a:pos x="connsiteX32" y="connsiteY32"/>
                </a:cxn>
                <a:cxn ang="0">
                  <a:pos x="connsiteX33" y="connsiteY33"/>
                </a:cxn>
                <a:cxn ang="0">
                  <a:pos x="connsiteX34" y="connsiteY34"/>
                </a:cxn>
                <a:cxn ang="0">
                  <a:pos x="connsiteX35" y="connsiteY35"/>
                </a:cxn>
                <a:cxn ang="0">
                  <a:pos x="connsiteX36" y="connsiteY36"/>
                </a:cxn>
                <a:cxn ang="0">
                  <a:pos x="connsiteX37" y="connsiteY37"/>
                </a:cxn>
                <a:cxn ang="0">
                  <a:pos x="connsiteX38" y="connsiteY38"/>
                </a:cxn>
                <a:cxn ang="0">
                  <a:pos x="connsiteX39" y="connsiteY39"/>
                </a:cxn>
                <a:cxn ang="0">
                  <a:pos x="connsiteX40" y="connsiteY40"/>
                </a:cxn>
                <a:cxn ang="0">
                  <a:pos x="connsiteX41" y="connsiteY41"/>
                </a:cxn>
                <a:cxn ang="0">
                  <a:pos x="connsiteX42" y="connsiteY42"/>
                </a:cxn>
                <a:cxn ang="0">
                  <a:pos x="connsiteX43" y="connsiteY43"/>
                </a:cxn>
                <a:cxn ang="0">
                  <a:pos x="connsiteX44" y="connsiteY44"/>
                </a:cxn>
                <a:cxn ang="0">
                  <a:pos x="connsiteX45" y="connsiteY45"/>
                </a:cxn>
                <a:cxn ang="0">
                  <a:pos x="connsiteX46" y="connsiteY46"/>
                </a:cxn>
                <a:cxn ang="0">
                  <a:pos x="connsiteX47" y="connsiteY47"/>
                </a:cxn>
                <a:cxn ang="0">
                  <a:pos x="connsiteX48" y="connsiteY48"/>
                </a:cxn>
                <a:cxn ang="0">
                  <a:pos x="connsiteX49" y="connsiteY49"/>
                </a:cxn>
                <a:cxn ang="0">
                  <a:pos x="connsiteX50" y="connsiteY50"/>
                </a:cxn>
                <a:cxn ang="0">
                  <a:pos x="connsiteX51" y="connsiteY51"/>
                </a:cxn>
                <a:cxn ang="0">
                  <a:pos x="connsiteX52" y="connsiteY52"/>
                </a:cxn>
                <a:cxn ang="0">
                  <a:pos x="connsiteX53" y="connsiteY53"/>
                </a:cxn>
                <a:cxn ang="0">
                  <a:pos x="connsiteX54" y="connsiteY54"/>
                </a:cxn>
                <a:cxn ang="0">
                  <a:pos x="connsiteX55" y="connsiteY55"/>
                </a:cxn>
                <a:cxn ang="0">
                  <a:pos x="connsiteX56" y="connsiteY56"/>
                </a:cxn>
                <a:cxn ang="0">
                  <a:pos x="connsiteX57" y="connsiteY57"/>
                </a:cxn>
                <a:cxn ang="0">
                  <a:pos x="connsiteX58" y="connsiteY58"/>
                </a:cxn>
                <a:cxn ang="0">
                  <a:pos x="connsiteX59" y="connsiteY59"/>
                </a:cxn>
                <a:cxn ang="0">
                  <a:pos x="connsiteX60" y="connsiteY60"/>
                </a:cxn>
                <a:cxn ang="0">
                  <a:pos x="connsiteX61" y="connsiteY61"/>
                </a:cxn>
                <a:cxn ang="0">
                  <a:pos x="connsiteX62" y="connsiteY62"/>
                </a:cxn>
                <a:cxn ang="0">
                  <a:pos x="connsiteX63" y="connsiteY63"/>
                </a:cxn>
                <a:cxn ang="0">
                  <a:pos x="connsiteX64" y="connsiteY64"/>
                </a:cxn>
                <a:cxn ang="0">
                  <a:pos x="connsiteX65" y="connsiteY65"/>
                </a:cxn>
                <a:cxn ang="0">
                  <a:pos x="connsiteX66" y="connsiteY66"/>
                </a:cxn>
                <a:cxn ang="0">
                  <a:pos x="connsiteX67" y="connsiteY67"/>
                </a:cxn>
                <a:cxn ang="0">
                  <a:pos x="connsiteX68" y="connsiteY68"/>
                </a:cxn>
                <a:cxn ang="0">
                  <a:pos x="connsiteX69" y="connsiteY69"/>
                </a:cxn>
                <a:cxn ang="0">
                  <a:pos x="connsiteX70" y="connsiteY70"/>
                </a:cxn>
                <a:cxn ang="0">
                  <a:pos x="connsiteX71" y="connsiteY71"/>
                </a:cxn>
                <a:cxn ang="0">
                  <a:pos x="connsiteX72" y="connsiteY72"/>
                </a:cxn>
                <a:cxn ang="0">
                  <a:pos x="connsiteX73" y="connsiteY73"/>
                </a:cxn>
                <a:cxn ang="0">
                  <a:pos x="connsiteX74" y="connsiteY74"/>
                </a:cxn>
                <a:cxn ang="0">
                  <a:pos x="connsiteX75" y="connsiteY75"/>
                </a:cxn>
                <a:cxn ang="0">
                  <a:pos x="connsiteX76" y="connsiteY76"/>
                </a:cxn>
                <a:cxn ang="0">
                  <a:pos x="connsiteX77" y="connsiteY77"/>
                </a:cxn>
                <a:cxn ang="0">
                  <a:pos x="connsiteX78" y="connsiteY78"/>
                </a:cxn>
                <a:cxn ang="0">
                  <a:pos x="connsiteX79" y="connsiteY79"/>
                </a:cxn>
                <a:cxn ang="0">
                  <a:pos x="connsiteX80" y="connsiteY80"/>
                </a:cxn>
                <a:cxn ang="0">
                  <a:pos x="connsiteX81" y="connsiteY81"/>
                </a:cxn>
                <a:cxn ang="0">
                  <a:pos x="connsiteX82" y="connsiteY82"/>
                </a:cxn>
                <a:cxn ang="0">
                  <a:pos x="connsiteX83" y="connsiteY83"/>
                </a:cxn>
                <a:cxn ang="0">
                  <a:pos x="connsiteX84" y="connsiteY84"/>
                </a:cxn>
                <a:cxn ang="0">
                  <a:pos x="connsiteX85" y="connsiteY85"/>
                </a:cxn>
                <a:cxn ang="0">
                  <a:pos x="connsiteX86" y="connsiteY86"/>
                </a:cxn>
                <a:cxn ang="0">
                  <a:pos x="connsiteX87" y="connsiteY87"/>
                </a:cxn>
                <a:cxn ang="0">
                  <a:pos x="connsiteX88" y="connsiteY88"/>
                </a:cxn>
                <a:cxn ang="0">
                  <a:pos x="connsiteX89" y="connsiteY89"/>
                </a:cxn>
                <a:cxn ang="0">
                  <a:pos x="connsiteX90" y="connsiteY90"/>
                </a:cxn>
              </a:cxnLst>
              <a:rect l="l" t="t" r="r" b="b"/>
              <a:pathLst>
                <a:path w="1933764" h="317770">
                  <a:moveTo>
                    <a:pt x="0" y="0"/>
                  </a:moveTo>
                  <a:cubicBezTo>
                    <a:pt x="10698" y="4279"/>
                    <a:pt x="18916" y="8187"/>
                    <a:pt x="30956" y="9525"/>
                  </a:cubicBezTo>
                  <a:cubicBezTo>
                    <a:pt x="38100" y="10319"/>
                    <a:pt x="45263" y="10956"/>
                    <a:pt x="52388" y="11906"/>
                  </a:cubicBezTo>
                  <a:cubicBezTo>
                    <a:pt x="57174" y="12544"/>
                    <a:pt x="61896" y="13604"/>
                    <a:pt x="66675" y="14287"/>
                  </a:cubicBezTo>
                  <a:cubicBezTo>
                    <a:pt x="73010" y="15192"/>
                    <a:pt x="79375" y="15874"/>
                    <a:pt x="85725" y="16668"/>
                  </a:cubicBezTo>
                  <a:cubicBezTo>
                    <a:pt x="93683" y="19321"/>
                    <a:pt x="93420" y="19437"/>
                    <a:pt x="102394" y="21431"/>
                  </a:cubicBezTo>
                  <a:cubicBezTo>
                    <a:pt x="111129" y="23372"/>
                    <a:pt x="115533" y="23705"/>
                    <a:pt x="123825" y="26193"/>
                  </a:cubicBezTo>
                  <a:cubicBezTo>
                    <a:pt x="131038" y="28357"/>
                    <a:pt x="138112" y="30956"/>
                    <a:pt x="145256" y="33337"/>
                  </a:cubicBezTo>
                  <a:lnTo>
                    <a:pt x="152400" y="35718"/>
                  </a:lnTo>
                  <a:cubicBezTo>
                    <a:pt x="168056" y="46156"/>
                    <a:pt x="151195" y="35820"/>
                    <a:pt x="166688" y="42862"/>
                  </a:cubicBezTo>
                  <a:cubicBezTo>
                    <a:pt x="173151" y="45800"/>
                    <a:pt x="179388" y="49212"/>
                    <a:pt x="185738" y="52387"/>
                  </a:cubicBezTo>
                  <a:cubicBezTo>
                    <a:pt x="188913" y="53975"/>
                    <a:pt x="192309" y="55181"/>
                    <a:pt x="195263" y="57150"/>
                  </a:cubicBezTo>
                  <a:cubicBezTo>
                    <a:pt x="201704" y="61444"/>
                    <a:pt x="204381" y="63655"/>
                    <a:pt x="211931" y="66675"/>
                  </a:cubicBezTo>
                  <a:cubicBezTo>
                    <a:pt x="216592" y="68539"/>
                    <a:pt x="221456" y="69850"/>
                    <a:pt x="226219" y="71437"/>
                  </a:cubicBezTo>
                  <a:lnTo>
                    <a:pt x="240506" y="76200"/>
                  </a:lnTo>
                  <a:cubicBezTo>
                    <a:pt x="242887" y="76994"/>
                    <a:pt x="245561" y="77189"/>
                    <a:pt x="247650" y="78581"/>
                  </a:cubicBezTo>
                  <a:cubicBezTo>
                    <a:pt x="250031" y="80168"/>
                    <a:pt x="252179" y="82181"/>
                    <a:pt x="254794" y="83343"/>
                  </a:cubicBezTo>
                  <a:cubicBezTo>
                    <a:pt x="259381" y="85382"/>
                    <a:pt x="264319" y="86518"/>
                    <a:pt x="269081" y="88106"/>
                  </a:cubicBezTo>
                  <a:lnTo>
                    <a:pt x="283369" y="92868"/>
                  </a:lnTo>
                  <a:lnTo>
                    <a:pt x="290513" y="95250"/>
                  </a:lnTo>
                  <a:cubicBezTo>
                    <a:pt x="292894" y="96044"/>
                    <a:pt x="295411" y="96509"/>
                    <a:pt x="297656" y="97631"/>
                  </a:cubicBezTo>
                  <a:cubicBezTo>
                    <a:pt x="300831" y="99218"/>
                    <a:pt x="303885" y="101075"/>
                    <a:pt x="307181" y="102393"/>
                  </a:cubicBezTo>
                  <a:cubicBezTo>
                    <a:pt x="307201" y="102401"/>
                    <a:pt x="325031" y="108343"/>
                    <a:pt x="328613" y="109537"/>
                  </a:cubicBezTo>
                  <a:lnTo>
                    <a:pt x="350044" y="116681"/>
                  </a:lnTo>
                  <a:lnTo>
                    <a:pt x="357188" y="119062"/>
                  </a:lnTo>
                  <a:cubicBezTo>
                    <a:pt x="359569" y="119856"/>
                    <a:pt x="361896" y="120834"/>
                    <a:pt x="364331" y="121443"/>
                  </a:cubicBezTo>
                  <a:cubicBezTo>
                    <a:pt x="378726" y="125043"/>
                    <a:pt x="370751" y="122790"/>
                    <a:pt x="388144" y="128587"/>
                  </a:cubicBezTo>
                  <a:lnTo>
                    <a:pt x="416719" y="138112"/>
                  </a:lnTo>
                  <a:cubicBezTo>
                    <a:pt x="416724" y="138114"/>
                    <a:pt x="431001" y="142871"/>
                    <a:pt x="431006" y="142875"/>
                  </a:cubicBezTo>
                  <a:cubicBezTo>
                    <a:pt x="433387" y="144462"/>
                    <a:pt x="435535" y="146475"/>
                    <a:pt x="438150" y="147637"/>
                  </a:cubicBezTo>
                  <a:cubicBezTo>
                    <a:pt x="442738" y="149676"/>
                    <a:pt x="447675" y="150812"/>
                    <a:pt x="452438" y="152400"/>
                  </a:cubicBezTo>
                  <a:lnTo>
                    <a:pt x="466725" y="157162"/>
                  </a:lnTo>
                  <a:lnTo>
                    <a:pt x="488156" y="164306"/>
                  </a:lnTo>
                  <a:lnTo>
                    <a:pt x="495300" y="166687"/>
                  </a:lnTo>
                  <a:lnTo>
                    <a:pt x="502444" y="169068"/>
                  </a:lnTo>
                  <a:cubicBezTo>
                    <a:pt x="504825" y="170656"/>
                    <a:pt x="507028" y="172551"/>
                    <a:pt x="509588" y="173831"/>
                  </a:cubicBezTo>
                  <a:cubicBezTo>
                    <a:pt x="513589" y="175832"/>
                    <a:pt x="522441" y="177448"/>
                    <a:pt x="526256" y="178593"/>
                  </a:cubicBezTo>
                  <a:cubicBezTo>
                    <a:pt x="538601" y="182296"/>
                    <a:pt x="546303" y="186219"/>
                    <a:pt x="559594" y="188118"/>
                  </a:cubicBezTo>
                  <a:lnTo>
                    <a:pt x="576263" y="190500"/>
                  </a:lnTo>
                  <a:cubicBezTo>
                    <a:pt x="583072" y="192770"/>
                    <a:pt x="585455" y="193767"/>
                    <a:pt x="592931" y="195262"/>
                  </a:cubicBezTo>
                  <a:cubicBezTo>
                    <a:pt x="597666" y="196209"/>
                    <a:pt x="602456" y="196849"/>
                    <a:pt x="607219" y="197643"/>
                  </a:cubicBezTo>
                  <a:cubicBezTo>
                    <a:pt x="621435" y="202383"/>
                    <a:pt x="611144" y="199506"/>
                    <a:pt x="635794" y="202406"/>
                  </a:cubicBezTo>
                  <a:lnTo>
                    <a:pt x="654844" y="204787"/>
                  </a:lnTo>
                  <a:cubicBezTo>
                    <a:pt x="667438" y="208985"/>
                    <a:pt x="657839" y="206198"/>
                    <a:pt x="676275" y="209550"/>
                  </a:cubicBezTo>
                  <a:cubicBezTo>
                    <a:pt x="680257" y="210274"/>
                    <a:pt x="684199" y="211207"/>
                    <a:pt x="688181" y="211931"/>
                  </a:cubicBezTo>
                  <a:cubicBezTo>
                    <a:pt x="692931" y="212795"/>
                    <a:pt x="697734" y="213365"/>
                    <a:pt x="702469" y="214312"/>
                  </a:cubicBezTo>
                  <a:cubicBezTo>
                    <a:pt x="705678" y="214954"/>
                    <a:pt x="708777" y="216090"/>
                    <a:pt x="711994" y="216693"/>
                  </a:cubicBezTo>
                  <a:cubicBezTo>
                    <a:pt x="730204" y="220107"/>
                    <a:pt x="740252" y="221411"/>
                    <a:pt x="757238" y="223837"/>
                  </a:cubicBezTo>
                  <a:cubicBezTo>
                    <a:pt x="759619" y="224631"/>
                    <a:pt x="761920" y="225726"/>
                    <a:pt x="764381" y="226218"/>
                  </a:cubicBezTo>
                  <a:cubicBezTo>
                    <a:pt x="794643" y="232271"/>
                    <a:pt x="795781" y="231169"/>
                    <a:pt x="828675" y="233362"/>
                  </a:cubicBezTo>
                  <a:cubicBezTo>
                    <a:pt x="831056" y="234156"/>
                    <a:pt x="833397" y="235083"/>
                    <a:pt x="835819" y="235743"/>
                  </a:cubicBezTo>
                  <a:cubicBezTo>
                    <a:pt x="842134" y="237465"/>
                    <a:pt x="848659" y="238436"/>
                    <a:pt x="854869" y="240506"/>
                  </a:cubicBezTo>
                  <a:lnTo>
                    <a:pt x="869156" y="245268"/>
                  </a:lnTo>
                  <a:lnTo>
                    <a:pt x="890588" y="252412"/>
                  </a:lnTo>
                  <a:lnTo>
                    <a:pt x="897731" y="254793"/>
                  </a:lnTo>
                  <a:cubicBezTo>
                    <a:pt x="900112" y="255587"/>
                    <a:pt x="902414" y="256683"/>
                    <a:pt x="904875" y="257175"/>
                  </a:cubicBezTo>
                  <a:cubicBezTo>
                    <a:pt x="908844" y="257969"/>
                    <a:pt x="912781" y="258941"/>
                    <a:pt x="916781" y="259556"/>
                  </a:cubicBezTo>
                  <a:cubicBezTo>
                    <a:pt x="923106" y="260529"/>
                    <a:pt x="929519" y="260885"/>
                    <a:pt x="935831" y="261937"/>
                  </a:cubicBezTo>
                  <a:cubicBezTo>
                    <a:pt x="939059" y="262475"/>
                    <a:pt x="942136" y="263733"/>
                    <a:pt x="945356" y="264318"/>
                  </a:cubicBezTo>
                  <a:cubicBezTo>
                    <a:pt x="976641" y="270007"/>
                    <a:pt x="949946" y="263681"/>
                    <a:pt x="971550" y="269081"/>
                  </a:cubicBezTo>
                  <a:cubicBezTo>
                    <a:pt x="973931" y="270668"/>
                    <a:pt x="976064" y="272716"/>
                    <a:pt x="978694" y="273843"/>
                  </a:cubicBezTo>
                  <a:cubicBezTo>
                    <a:pt x="981702" y="275132"/>
                    <a:pt x="985072" y="275326"/>
                    <a:pt x="988219" y="276225"/>
                  </a:cubicBezTo>
                  <a:cubicBezTo>
                    <a:pt x="990633" y="276915"/>
                    <a:pt x="992982" y="277812"/>
                    <a:pt x="995363" y="278606"/>
                  </a:cubicBezTo>
                  <a:cubicBezTo>
                    <a:pt x="997744" y="280193"/>
                    <a:pt x="999891" y="282206"/>
                    <a:pt x="1002506" y="283368"/>
                  </a:cubicBezTo>
                  <a:cubicBezTo>
                    <a:pt x="1007094" y="285407"/>
                    <a:pt x="1012617" y="285346"/>
                    <a:pt x="1016794" y="288131"/>
                  </a:cubicBezTo>
                  <a:cubicBezTo>
                    <a:pt x="1028114" y="295677"/>
                    <a:pt x="1021225" y="291989"/>
                    <a:pt x="1038225" y="297656"/>
                  </a:cubicBezTo>
                  <a:lnTo>
                    <a:pt x="1045369" y="300037"/>
                  </a:lnTo>
                  <a:cubicBezTo>
                    <a:pt x="1059422" y="304721"/>
                    <a:pt x="1054930" y="303829"/>
                    <a:pt x="1078706" y="304800"/>
                  </a:cubicBezTo>
                  <a:cubicBezTo>
                    <a:pt x="1108854" y="306031"/>
                    <a:pt x="1139031" y="306387"/>
                    <a:pt x="1169194" y="307181"/>
                  </a:cubicBezTo>
                  <a:cubicBezTo>
                    <a:pt x="1192987" y="309824"/>
                    <a:pt x="1199222" y="310836"/>
                    <a:pt x="1226344" y="311943"/>
                  </a:cubicBezTo>
                  <a:cubicBezTo>
                    <a:pt x="1253321" y="313044"/>
                    <a:pt x="1280319" y="313531"/>
                    <a:pt x="1307306" y="314325"/>
                  </a:cubicBezTo>
                  <a:cubicBezTo>
                    <a:pt x="1358063" y="319400"/>
                    <a:pt x="1338165" y="318412"/>
                    <a:pt x="1423988" y="314325"/>
                  </a:cubicBezTo>
                  <a:cubicBezTo>
                    <a:pt x="1426495" y="314206"/>
                    <a:pt x="1428718" y="312633"/>
                    <a:pt x="1431131" y="311943"/>
                  </a:cubicBezTo>
                  <a:cubicBezTo>
                    <a:pt x="1434278" y="311044"/>
                    <a:pt x="1437521" y="310502"/>
                    <a:pt x="1440656" y="309562"/>
                  </a:cubicBezTo>
                  <a:cubicBezTo>
                    <a:pt x="1445465" y="308120"/>
                    <a:pt x="1450074" y="306018"/>
                    <a:pt x="1454944" y="304800"/>
                  </a:cubicBezTo>
                  <a:cubicBezTo>
                    <a:pt x="1458119" y="304006"/>
                    <a:pt x="1461334" y="303358"/>
                    <a:pt x="1464469" y="302418"/>
                  </a:cubicBezTo>
                  <a:cubicBezTo>
                    <a:pt x="1471681" y="300254"/>
                    <a:pt x="1478756" y="297656"/>
                    <a:pt x="1485900" y="295275"/>
                  </a:cubicBezTo>
                  <a:cubicBezTo>
                    <a:pt x="1509911" y="287271"/>
                    <a:pt x="1472666" y="299482"/>
                    <a:pt x="1502569" y="290512"/>
                  </a:cubicBezTo>
                  <a:cubicBezTo>
                    <a:pt x="1507377" y="289070"/>
                    <a:pt x="1511887" y="286460"/>
                    <a:pt x="1516856" y="285750"/>
                  </a:cubicBezTo>
                  <a:lnTo>
                    <a:pt x="1564481" y="278606"/>
                  </a:lnTo>
                  <a:cubicBezTo>
                    <a:pt x="1566862" y="277812"/>
                    <a:pt x="1569155" y="276674"/>
                    <a:pt x="1571625" y="276225"/>
                  </a:cubicBezTo>
                  <a:cubicBezTo>
                    <a:pt x="1577921" y="275080"/>
                    <a:pt x="1584332" y="274689"/>
                    <a:pt x="1590675" y="273843"/>
                  </a:cubicBezTo>
                  <a:cubicBezTo>
                    <a:pt x="1596238" y="273101"/>
                    <a:pt x="1601822" y="272466"/>
                    <a:pt x="1607344" y="271462"/>
                  </a:cubicBezTo>
                  <a:lnTo>
                    <a:pt x="1633538" y="266700"/>
                  </a:lnTo>
                  <a:cubicBezTo>
                    <a:pt x="1687633" y="261005"/>
                    <a:pt x="1640950" y="267341"/>
                    <a:pt x="1678781" y="261937"/>
                  </a:cubicBezTo>
                  <a:cubicBezTo>
                    <a:pt x="1693302" y="257097"/>
                    <a:pt x="1681832" y="260366"/>
                    <a:pt x="1707356" y="257175"/>
                  </a:cubicBezTo>
                  <a:cubicBezTo>
                    <a:pt x="1712925" y="256479"/>
                    <a:pt x="1718469" y="255587"/>
                    <a:pt x="1724025" y="254793"/>
                  </a:cubicBezTo>
                  <a:cubicBezTo>
                    <a:pt x="1741819" y="248862"/>
                    <a:pt x="1736285" y="250188"/>
                    <a:pt x="1769269" y="247650"/>
                  </a:cubicBezTo>
                  <a:cubicBezTo>
                    <a:pt x="1805821" y="244837"/>
                    <a:pt x="1789980" y="246731"/>
                    <a:pt x="1816894" y="242887"/>
                  </a:cubicBezTo>
                  <a:cubicBezTo>
                    <a:pt x="1847850" y="243681"/>
                    <a:pt x="1878830" y="243829"/>
                    <a:pt x="1909763" y="245268"/>
                  </a:cubicBezTo>
                  <a:cubicBezTo>
                    <a:pt x="1965110" y="247843"/>
                    <a:pt x="1905090" y="247650"/>
                    <a:pt x="1921669" y="247650"/>
                  </a:cubicBezTo>
                </a:path>
              </a:pathLst>
            </a:custGeom>
            <a:noFill/>
            <a:ln w="38100">
              <a:solidFill>
                <a:schemeClr val="bg1"/>
              </a:solidFill>
              <a:prstDash val="sysDot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9666"/>
            </a:p>
          </p:txBody>
        </p:sp>
        <p:sp>
          <p:nvSpPr>
            <p:cNvPr id="241" name="Freeform 240"/>
            <p:cNvSpPr/>
            <p:nvPr/>
          </p:nvSpPr>
          <p:spPr>
            <a:xfrm>
              <a:off x="6864216" y="2771546"/>
              <a:ext cx="1779012" cy="300431"/>
            </a:xfrm>
            <a:custGeom>
              <a:avLst/>
              <a:gdLst>
                <a:gd name="connsiteX0" fmla="*/ 0 w 1924050"/>
                <a:gd name="connsiteY0" fmla="*/ 0 h 323850"/>
                <a:gd name="connsiteX1" fmla="*/ 26194 w 1924050"/>
                <a:gd name="connsiteY1" fmla="*/ 2381 h 323850"/>
                <a:gd name="connsiteX2" fmla="*/ 33337 w 1924050"/>
                <a:gd name="connsiteY2" fmla="*/ 4763 h 323850"/>
                <a:gd name="connsiteX3" fmla="*/ 59531 w 1924050"/>
                <a:gd name="connsiteY3" fmla="*/ 9525 h 323850"/>
                <a:gd name="connsiteX4" fmla="*/ 83344 w 1924050"/>
                <a:gd name="connsiteY4" fmla="*/ 16669 h 323850"/>
                <a:gd name="connsiteX5" fmla="*/ 90487 w 1924050"/>
                <a:gd name="connsiteY5" fmla="*/ 19050 h 323850"/>
                <a:gd name="connsiteX6" fmla="*/ 97631 w 1924050"/>
                <a:gd name="connsiteY6" fmla="*/ 23813 h 323850"/>
                <a:gd name="connsiteX7" fmla="*/ 114300 w 1924050"/>
                <a:gd name="connsiteY7" fmla="*/ 28575 h 323850"/>
                <a:gd name="connsiteX8" fmla="*/ 128587 w 1924050"/>
                <a:gd name="connsiteY8" fmla="*/ 33338 h 323850"/>
                <a:gd name="connsiteX9" fmla="*/ 142875 w 1924050"/>
                <a:gd name="connsiteY9" fmla="*/ 38100 h 323850"/>
                <a:gd name="connsiteX10" fmla="*/ 150019 w 1924050"/>
                <a:gd name="connsiteY10" fmla="*/ 40481 h 323850"/>
                <a:gd name="connsiteX11" fmla="*/ 171450 w 1924050"/>
                <a:gd name="connsiteY11" fmla="*/ 50006 h 323850"/>
                <a:gd name="connsiteX12" fmla="*/ 178594 w 1924050"/>
                <a:gd name="connsiteY12" fmla="*/ 52388 h 323850"/>
                <a:gd name="connsiteX13" fmla="*/ 200025 w 1924050"/>
                <a:gd name="connsiteY13" fmla="*/ 61913 h 323850"/>
                <a:gd name="connsiteX14" fmla="*/ 214312 w 1924050"/>
                <a:gd name="connsiteY14" fmla="*/ 66675 h 323850"/>
                <a:gd name="connsiteX15" fmla="*/ 221456 w 1924050"/>
                <a:gd name="connsiteY15" fmla="*/ 69056 h 323850"/>
                <a:gd name="connsiteX16" fmla="*/ 235744 w 1924050"/>
                <a:gd name="connsiteY16" fmla="*/ 76200 h 323850"/>
                <a:gd name="connsiteX17" fmla="*/ 254794 w 1924050"/>
                <a:gd name="connsiteY17" fmla="*/ 80963 h 323850"/>
                <a:gd name="connsiteX18" fmla="*/ 269081 w 1924050"/>
                <a:gd name="connsiteY18" fmla="*/ 88106 h 323850"/>
                <a:gd name="connsiteX19" fmla="*/ 283369 w 1924050"/>
                <a:gd name="connsiteY19" fmla="*/ 95250 h 323850"/>
                <a:gd name="connsiteX20" fmla="*/ 290512 w 1924050"/>
                <a:gd name="connsiteY20" fmla="*/ 100013 h 323850"/>
                <a:gd name="connsiteX21" fmla="*/ 304800 w 1924050"/>
                <a:gd name="connsiteY21" fmla="*/ 104775 h 323850"/>
                <a:gd name="connsiteX22" fmla="*/ 311944 w 1924050"/>
                <a:gd name="connsiteY22" fmla="*/ 107156 h 323850"/>
                <a:gd name="connsiteX23" fmla="*/ 330994 w 1924050"/>
                <a:gd name="connsiteY23" fmla="*/ 116681 h 323850"/>
                <a:gd name="connsiteX24" fmla="*/ 352425 w 1924050"/>
                <a:gd name="connsiteY24" fmla="*/ 123825 h 323850"/>
                <a:gd name="connsiteX25" fmla="*/ 359569 w 1924050"/>
                <a:gd name="connsiteY25" fmla="*/ 126206 h 323850"/>
                <a:gd name="connsiteX26" fmla="*/ 366712 w 1924050"/>
                <a:gd name="connsiteY26" fmla="*/ 130969 h 323850"/>
                <a:gd name="connsiteX27" fmla="*/ 381000 w 1924050"/>
                <a:gd name="connsiteY27" fmla="*/ 135731 h 323850"/>
                <a:gd name="connsiteX28" fmla="*/ 388144 w 1924050"/>
                <a:gd name="connsiteY28" fmla="*/ 138113 h 323850"/>
                <a:gd name="connsiteX29" fmla="*/ 395287 w 1924050"/>
                <a:gd name="connsiteY29" fmla="*/ 140494 h 323850"/>
                <a:gd name="connsiteX30" fmla="*/ 402431 w 1924050"/>
                <a:gd name="connsiteY30" fmla="*/ 142875 h 323850"/>
                <a:gd name="connsiteX31" fmla="*/ 419100 w 1924050"/>
                <a:gd name="connsiteY31" fmla="*/ 150019 h 323850"/>
                <a:gd name="connsiteX32" fmla="*/ 433387 w 1924050"/>
                <a:gd name="connsiteY32" fmla="*/ 154781 h 323850"/>
                <a:gd name="connsiteX33" fmla="*/ 447675 w 1924050"/>
                <a:gd name="connsiteY33" fmla="*/ 159544 h 323850"/>
                <a:gd name="connsiteX34" fmla="*/ 454819 w 1924050"/>
                <a:gd name="connsiteY34" fmla="*/ 161925 h 323850"/>
                <a:gd name="connsiteX35" fmla="*/ 466725 w 1924050"/>
                <a:gd name="connsiteY35" fmla="*/ 164306 h 323850"/>
                <a:gd name="connsiteX36" fmla="*/ 481012 w 1924050"/>
                <a:gd name="connsiteY36" fmla="*/ 169069 h 323850"/>
                <a:gd name="connsiteX37" fmla="*/ 490537 w 1924050"/>
                <a:gd name="connsiteY37" fmla="*/ 171450 h 323850"/>
                <a:gd name="connsiteX38" fmla="*/ 497681 w 1924050"/>
                <a:gd name="connsiteY38" fmla="*/ 173831 h 323850"/>
                <a:gd name="connsiteX39" fmla="*/ 521494 w 1924050"/>
                <a:gd name="connsiteY39" fmla="*/ 178594 h 323850"/>
                <a:gd name="connsiteX40" fmla="*/ 528637 w 1924050"/>
                <a:gd name="connsiteY40" fmla="*/ 180975 h 323850"/>
                <a:gd name="connsiteX41" fmla="*/ 552450 w 1924050"/>
                <a:gd name="connsiteY41" fmla="*/ 185738 h 323850"/>
                <a:gd name="connsiteX42" fmla="*/ 576262 w 1924050"/>
                <a:gd name="connsiteY42" fmla="*/ 192881 h 323850"/>
                <a:gd name="connsiteX43" fmla="*/ 590550 w 1924050"/>
                <a:gd name="connsiteY43" fmla="*/ 197644 h 323850"/>
                <a:gd name="connsiteX44" fmla="*/ 609600 w 1924050"/>
                <a:gd name="connsiteY44" fmla="*/ 202406 h 323850"/>
                <a:gd name="connsiteX45" fmla="*/ 626269 w 1924050"/>
                <a:gd name="connsiteY45" fmla="*/ 207169 h 323850"/>
                <a:gd name="connsiteX46" fmla="*/ 652462 w 1924050"/>
                <a:gd name="connsiteY46" fmla="*/ 211931 h 323850"/>
                <a:gd name="connsiteX47" fmla="*/ 666750 w 1924050"/>
                <a:gd name="connsiteY47" fmla="*/ 216694 h 323850"/>
                <a:gd name="connsiteX48" fmla="*/ 676275 w 1924050"/>
                <a:gd name="connsiteY48" fmla="*/ 219075 h 323850"/>
                <a:gd name="connsiteX49" fmla="*/ 683419 w 1924050"/>
                <a:gd name="connsiteY49" fmla="*/ 221456 h 323850"/>
                <a:gd name="connsiteX50" fmla="*/ 695325 w 1924050"/>
                <a:gd name="connsiteY50" fmla="*/ 223838 h 323850"/>
                <a:gd name="connsiteX51" fmla="*/ 714375 w 1924050"/>
                <a:gd name="connsiteY51" fmla="*/ 228600 h 323850"/>
                <a:gd name="connsiteX52" fmla="*/ 723900 w 1924050"/>
                <a:gd name="connsiteY52" fmla="*/ 230981 h 323850"/>
                <a:gd name="connsiteX53" fmla="*/ 735806 w 1924050"/>
                <a:gd name="connsiteY53" fmla="*/ 233363 h 323850"/>
                <a:gd name="connsiteX54" fmla="*/ 745331 w 1924050"/>
                <a:gd name="connsiteY54" fmla="*/ 235744 h 323850"/>
                <a:gd name="connsiteX55" fmla="*/ 752475 w 1924050"/>
                <a:gd name="connsiteY55" fmla="*/ 238125 h 323850"/>
                <a:gd name="connsiteX56" fmla="*/ 764381 w 1924050"/>
                <a:gd name="connsiteY56" fmla="*/ 240506 h 323850"/>
                <a:gd name="connsiteX57" fmla="*/ 773906 w 1924050"/>
                <a:gd name="connsiteY57" fmla="*/ 242888 h 323850"/>
                <a:gd name="connsiteX58" fmla="*/ 819150 w 1924050"/>
                <a:gd name="connsiteY58" fmla="*/ 247650 h 323850"/>
                <a:gd name="connsiteX59" fmla="*/ 866775 w 1924050"/>
                <a:gd name="connsiteY59" fmla="*/ 252413 h 323850"/>
                <a:gd name="connsiteX60" fmla="*/ 897731 w 1924050"/>
                <a:gd name="connsiteY60" fmla="*/ 257175 h 323850"/>
                <a:gd name="connsiteX61" fmla="*/ 926306 w 1924050"/>
                <a:gd name="connsiteY61" fmla="*/ 261938 h 323850"/>
                <a:gd name="connsiteX62" fmla="*/ 952500 w 1924050"/>
                <a:gd name="connsiteY62" fmla="*/ 269081 h 323850"/>
                <a:gd name="connsiteX63" fmla="*/ 964406 w 1924050"/>
                <a:gd name="connsiteY63" fmla="*/ 271463 h 323850"/>
                <a:gd name="connsiteX64" fmla="*/ 971550 w 1924050"/>
                <a:gd name="connsiteY64" fmla="*/ 273844 h 323850"/>
                <a:gd name="connsiteX65" fmla="*/ 981075 w 1924050"/>
                <a:gd name="connsiteY65" fmla="*/ 276225 h 323850"/>
                <a:gd name="connsiteX66" fmla="*/ 988219 w 1924050"/>
                <a:gd name="connsiteY66" fmla="*/ 278606 h 323850"/>
                <a:gd name="connsiteX67" fmla="*/ 1000125 w 1924050"/>
                <a:gd name="connsiteY67" fmla="*/ 280988 h 323850"/>
                <a:gd name="connsiteX68" fmla="*/ 1014412 w 1924050"/>
                <a:gd name="connsiteY68" fmla="*/ 285750 h 323850"/>
                <a:gd name="connsiteX69" fmla="*/ 1042987 w 1924050"/>
                <a:gd name="connsiteY69" fmla="*/ 295275 h 323850"/>
                <a:gd name="connsiteX70" fmla="*/ 1057275 w 1924050"/>
                <a:gd name="connsiteY70" fmla="*/ 300038 h 323850"/>
                <a:gd name="connsiteX71" fmla="*/ 1064419 w 1924050"/>
                <a:gd name="connsiteY71" fmla="*/ 302419 h 323850"/>
                <a:gd name="connsiteX72" fmla="*/ 1071562 w 1924050"/>
                <a:gd name="connsiteY72" fmla="*/ 307181 h 323850"/>
                <a:gd name="connsiteX73" fmla="*/ 1097756 w 1924050"/>
                <a:gd name="connsiteY73" fmla="*/ 311944 h 323850"/>
                <a:gd name="connsiteX74" fmla="*/ 1107281 w 1924050"/>
                <a:gd name="connsiteY74" fmla="*/ 314325 h 323850"/>
                <a:gd name="connsiteX75" fmla="*/ 1171575 w 1924050"/>
                <a:gd name="connsiteY75" fmla="*/ 319088 h 323850"/>
                <a:gd name="connsiteX76" fmla="*/ 1209675 w 1924050"/>
                <a:gd name="connsiteY76" fmla="*/ 323850 h 323850"/>
                <a:gd name="connsiteX77" fmla="*/ 1307306 w 1924050"/>
                <a:gd name="connsiteY77" fmla="*/ 321469 h 323850"/>
                <a:gd name="connsiteX78" fmla="*/ 1343025 w 1924050"/>
                <a:gd name="connsiteY78" fmla="*/ 319088 h 323850"/>
                <a:gd name="connsiteX79" fmla="*/ 1352550 w 1924050"/>
                <a:gd name="connsiteY79" fmla="*/ 316706 h 323850"/>
                <a:gd name="connsiteX80" fmla="*/ 1373981 w 1924050"/>
                <a:gd name="connsiteY80" fmla="*/ 311944 h 323850"/>
                <a:gd name="connsiteX81" fmla="*/ 1381125 w 1924050"/>
                <a:gd name="connsiteY81" fmla="*/ 309563 h 323850"/>
                <a:gd name="connsiteX82" fmla="*/ 1409700 w 1924050"/>
                <a:gd name="connsiteY82" fmla="*/ 307181 h 323850"/>
                <a:gd name="connsiteX83" fmla="*/ 1431131 w 1924050"/>
                <a:gd name="connsiteY83" fmla="*/ 304800 h 323850"/>
                <a:gd name="connsiteX84" fmla="*/ 1459706 w 1924050"/>
                <a:gd name="connsiteY84" fmla="*/ 300038 h 323850"/>
                <a:gd name="connsiteX85" fmla="*/ 1495425 w 1924050"/>
                <a:gd name="connsiteY85" fmla="*/ 297656 h 323850"/>
                <a:gd name="connsiteX86" fmla="*/ 1507331 w 1924050"/>
                <a:gd name="connsiteY86" fmla="*/ 295275 h 323850"/>
                <a:gd name="connsiteX87" fmla="*/ 1514475 w 1924050"/>
                <a:gd name="connsiteY87" fmla="*/ 292894 h 323850"/>
                <a:gd name="connsiteX88" fmla="*/ 1540669 w 1924050"/>
                <a:gd name="connsiteY88" fmla="*/ 288131 h 323850"/>
                <a:gd name="connsiteX89" fmla="*/ 1547812 w 1924050"/>
                <a:gd name="connsiteY89" fmla="*/ 285750 h 323850"/>
                <a:gd name="connsiteX90" fmla="*/ 1566862 w 1924050"/>
                <a:gd name="connsiteY90" fmla="*/ 283369 h 323850"/>
                <a:gd name="connsiteX91" fmla="*/ 1581150 w 1924050"/>
                <a:gd name="connsiteY91" fmla="*/ 280988 h 323850"/>
                <a:gd name="connsiteX92" fmla="*/ 1609725 w 1924050"/>
                <a:gd name="connsiteY92" fmla="*/ 271463 h 323850"/>
                <a:gd name="connsiteX93" fmla="*/ 1624012 w 1924050"/>
                <a:gd name="connsiteY93" fmla="*/ 266700 h 323850"/>
                <a:gd name="connsiteX94" fmla="*/ 1654969 w 1924050"/>
                <a:gd name="connsiteY94" fmla="*/ 264319 h 323850"/>
                <a:gd name="connsiteX95" fmla="*/ 1678781 w 1924050"/>
                <a:gd name="connsiteY95" fmla="*/ 259556 h 323850"/>
                <a:gd name="connsiteX96" fmla="*/ 1685925 w 1924050"/>
                <a:gd name="connsiteY96" fmla="*/ 257175 h 323850"/>
                <a:gd name="connsiteX97" fmla="*/ 1724025 w 1924050"/>
                <a:gd name="connsiteY97" fmla="*/ 252413 h 323850"/>
                <a:gd name="connsiteX98" fmla="*/ 1731169 w 1924050"/>
                <a:gd name="connsiteY98" fmla="*/ 250031 h 323850"/>
                <a:gd name="connsiteX99" fmla="*/ 1771650 w 1924050"/>
                <a:gd name="connsiteY99" fmla="*/ 242888 h 323850"/>
                <a:gd name="connsiteX100" fmla="*/ 1924050 w 1924050"/>
                <a:gd name="connsiteY100" fmla="*/ 240506 h 32385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  <a:cxn ang="0">
                  <a:pos x="connsiteX29" y="connsiteY29"/>
                </a:cxn>
                <a:cxn ang="0">
                  <a:pos x="connsiteX30" y="connsiteY30"/>
                </a:cxn>
                <a:cxn ang="0">
                  <a:pos x="connsiteX31" y="connsiteY31"/>
                </a:cxn>
                <a:cxn ang="0">
                  <a:pos x="connsiteX32" y="connsiteY32"/>
                </a:cxn>
                <a:cxn ang="0">
                  <a:pos x="connsiteX33" y="connsiteY33"/>
                </a:cxn>
                <a:cxn ang="0">
                  <a:pos x="connsiteX34" y="connsiteY34"/>
                </a:cxn>
                <a:cxn ang="0">
                  <a:pos x="connsiteX35" y="connsiteY35"/>
                </a:cxn>
                <a:cxn ang="0">
                  <a:pos x="connsiteX36" y="connsiteY36"/>
                </a:cxn>
                <a:cxn ang="0">
                  <a:pos x="connsiteX37" y="connsiteY37"/>
                </a:cxn>
                <a:cxn ang="0">
                  <a:pos x="connsiteX38" y="connsiteY38"/>
                </a:cxn>
                <a:cxn ang="0">
                  <a:pos x="connsiteX39" y="connsiteY39"/>
                </a:cxn>
                <a:cxn ang="0">
                  <a:pos x="connsiteX40" y="connsiteY40"/>
                </a:cxn>
                <a:cxn ang="0">
                  <a:pos x="connsiteX41" y="connsiteY41"/>
                </a:cxn>
                <a:cxn ang="0">
                  <a:pos x="connsiteX42" y="connsiteY42"/>
                </a:cxn>
                <a:cxn ang="0">
                  <a:pos x="connsiteX43" y="connsiteY43"/>
                </a:cxn>
                <a:cxn ang="0">
                  <a:pos x="connsiteX44" y="connsiteY44"/>
                </a:cxn>
                <a:cxn ang="0">
                  <a:pos x="connsiteX45" y="connsiteY45"/>
                </a:cxn>
                <a:cxn ang="0">
                  <a:pos x="connsiteX46" y="connsiteY46"/>
                </a:cxn>
                <a:cxn ang="0">
                  <a:pos x="connsiteX47" y="connsiteY47"/>
                </a:cxn>
                <a:cxn ang="0">
                  <a:pos x="connsiteX48" y="connsiteY48"/>
                </a:cxn>
                <a:cxn ang="0">
                  <a:pos x="connsiteX49" y="connsiteY49"/>
                </a:cxn>
                <a:cxn ang="0">
                  <a:pos x="connsiteX50" y="connsiteY50"/>
                </a:cxn>
                <a:cxn ang="0">
                  <a:pos x="connsiteX51" y="connsiteY51"/>
                </a:cxn>
                <a:cxn ang="0">
                  <a:pos x="connsiteX52" y="connsiteY52"/>
                </a:cxn>
                <a:cxn ang="0">
                  <a:pos x="connsiteX53" y="connsiteY53"/>
                </a:cxn>
                <a:cxn ang="0">
                  <a:pos x="connsiteX54" y="connsiteY54"/>
                </a:cxn>
                <a:cxn ang="0">
                  <a:pos x="connsiteX55" y="connsiteY55"/>
                </a:cxn>
                <a:cxn ang="0">
                  <a:pos x="connsiteX56" y="connsiteY56"/>
                </a:cxn>
                <a:cxn ang="0">
                  <a:pos x="connsiteX57" y="connsiteY57"/>
                </a:cxn>
                <a:cxn ang="0">
                  <a:pos x="connsiteX58" y="connsiteY58"/>
                </a:cxn>
                <a:cxn ang="0">
                  <a:pos x="connsiteX59" y="connsiteY59"/>
                </a:cxn>
                <a:cxn ang="0">
                  <a:pos x="connsiteX60" y="connsiteY60"/>
                </a:cxn>
                <a:cxn ang="0">
                  <a:pos x="connsiteX61" y="connsiteY61"/>
                </a:cxn>
                <a:cxn ang="0">
                  <a:pos x="connsiteX62" y="connsiteY62"/>
                </a:cxn>
                <a:cxn ang="0">
                  <a:pos x="connsiteX63" y="connsiteY63"/>
                </a:cxn>
                <a:cxn ang="0">
                  <a:pos x="connsiteX64" y="connsiteY64"/>
                </a:cxn>
                <a:cxn ang="0">
                  <a:pos x="connsiteX65" y="connsiteY65"/>
                </a:cxn>
                <a:cxn ang="0">
                  <a:pos x="connsiteX66" y="connsiteY66"/>
                </a:cxn>
                <a:cxn ang="0">
                  <a:pos x="connsiteX67" y="connsiteY67"/>
                </a:cxn>
                <a:cxn ang="0">
                  <a:pos x="connsiteX68" y="connsiteY68"/>
                </a:cxn>
                <a:cxn ang="0">
                  <a:pos x="connsiteX69" y="connsiteY69"/>
                </a:cxn>
                <a:cxn ang="0">
                  <a:pos x="connsiteX70" y="connsiteY70"/>
                </a:cxn>
                <a:cxn ang="0">
                  <a:pos x="connsiteX71" y="connsiteY71"/>
                </a:cxn>
                <a:cxn ang="0">
                  <a:pos x="connsiteX72" y="connsiteY72"/>
                </a:cxn>
                <a:cxn ang="0">
                  <a:pos x="connsiteX73" y="connsiteY73"/>
                </a:cxn>
                <a:cxn ang="0">
                  <a:pos x="connsiteX74" y="connsiteY74"/>
                </a:cxn>
                <a:cxn ang="0">
                  <a:pos x="connsiteX75" y="connsiteY75"/>
                </a:cxn>
                <a:cxn ang="0">
                  <a:pos x="connsiteX76" y="connsiteY76"/>
                </a:cxn>
                <a:cxn ang="0">
                  <a:pos x="connsiteX77" y="connsiteY77"/>
                </a:cxn>
                <a:cxn ang="0">
                  <a:pos x="connsiteX78" y="connsiteY78"/>
                </a:cxn>
                <a:cxn ang="0">
                  <a:pos x="connsiteX79" y="connsiteY79"/>
                </a:cxn>
                <a:cxn ang="0">
                  <a:pos x="connsiteX80" y="connsiteY80"/>
                </a:cxn>
                <a:cxn ang="0">
                  <a:pos x="connsiteX81" y="connsiteY81"/>
                </a:cxn>
                <a:cxn ang="0">
                  <a:pos x="connsiteX82" y="connsiteY82"/>
                </a:cxn>
                <a:cxn ang="0">
                  <a:pos x="connsiteX83" y="connsiteY83"/>
                </a:cxn>
                <a:cxn ang="0">
                  <a:pos x="connsiteX84" y="connsiteY84"/>
                </a:cxn>
                <a:cxn ang="0">
                  <a:pos x="connsiteX85" y="connsiteY85"/>
                </a:cxn>
                <a:cxn ang="0">
                  <a:pos x="connsiteX86" y="connsiteY86"/>
                </a:cxn>
                <a:cxn ang="0">
                  <a:pos x="connsiteX87" y="connsiteY87"/>
                </a:cxn>
                <a:cxn ang="0">
                  <a:pos x="connsiteX88" y="connsiteY88"/>
                </a:cxn>
                <a:cxn ang="0">
                  <a:pos x="connsiteX89" y="connsiteY89"/>
                </a:cxn>
                <a:cxn ang="0">
                  <a:pos x="connsiteX90" y="connsiteY90"/>
                </a:cxn>
                <a:cxn ang="0">
                  <a:pos x="connsiteX91" y="connsiteY91"/>
                </a:cxn>
                <a:cxn ang="0">
                  <a:pos x="connsiteX92" y="connsiteY92"/>
                </a:cxn>
                <a:cxn ang="0">
                  <a:pos x="connsiteX93" y="connsiteY93"/>
                </a:cxn>
                <a:cxn ang="0">
                  <a:pos x="connsiteX94" y="connsiteY94"/>
                </a:cxn>
                <a:cxn ang="0">
                  <a:pos x="connsiteX95" y="connsiteY95"/>
                </a:cxn>
                <a:cxn ang="0">
                  <a:pos x="connsiteX96" y="connsiteY96"/>
                </a:cxn>
                <a:cxn ang="0">
                  <a:pos x="connsiteX97" y="connsiteY97"/>
                </a:cxn>
                <a:cxn ang="0">
                  <a:pos x="connsiteX98" y="connsiteY98"/>
                </a:cxn>
                <a:cxn ang="0">
                  <a:pos x="connsiteX99" y="connsiteY99"/>
                </a:cxn>
                <a:cxn ang="0">
                  <a:pos x="connsiteX100" y="connsiteY100"/>
                </a:cxn>
              </a:cxnLst>
              <a:rect l="l" t="t" r="r" b="b"/>
              <a:pathLst>
                <a:path w="1924050" h="323850">
                  <a:moveTo>
                    <a:pt x="0" y="0"/>
                  </a:moveTo>
                  <a:cubicBezTo>
                    <a:pt x="8731" y="794"/>
                    <a:pt x="17515" y="1141"/>
                    <a:pt x="26194" y="2381"/>
                  </a:cubicBezTo>
                  <a:cubicBezTo>
                    <a:pt x="28679" y="2736"/>
                    <a:pt x="30902" y="4154"/>
                    <a:pt x="33337" y="4763"/>
                  </a:cubicBezTo>
                  <a:cubicBezTo>
                    <a:pt x="43537" y="7313"/>
                    <a:pt x="48934" y="7406"/>
                    <a:pt x="59531" y="9525"/>
                  </a:cubicBezTo>
                  <a:cubicBezTo>
                    <a:pt x="68531" y="11325"/>
                    <a:pt x="74228" y="13630"/>
                    <a:pt x="83344" y="16669"/>
                  </a:cubicBezTo>
                  <a:lnTo>
                    <a:pt x="90487" y="19050"/>
                  </a:lnTo>
                  <a:cubicBezTo>
                    <a:pt x="92868" y="20638"/>
                    <a:pt x="95071" y="22533"/>
                    <a:pt x="97631" y="23813"/>
                  </a:cubicBezTo>
                  <a:cubicBezTo>
                    <a:pt x="101632" y="25813"/>
                    <a:pt x="110486" y="27431"/>
                    <a:pt x="114300" y="28575"/>
                  </a:cubicBezTo>
                  <a:cubicBezTo>
                    <a:pt x="119108" y="30018"/>
                    <a:pt x="123825" y="31750"/>
                    <a:pt x="128587" y="33338"/>
                  </a:cubicBezTo>
                  <a:lnTo>
                    <a:pt x="142875" y="38100"/>
                  </a:lnTo>
                  <a:lnTo>
                    <a:pt x="150019" y="40481"/>
                  </a:lnTo>
                  <a:cubicBezTo>
                    <a:pt x="161340" y="48030"/>
                    <a:pt x="154445" y="44338"/>
                    <a:pt x="171450" y="50006"/>
                  </a:cubicBezTo>
                  <a:cubicBezTo>
                    <a:pt x="173831" y="50800"/>
                    <a:pt x="176505" y="50996"/>
                    <a:pt x="178594" y="52388"/>
                  </a:cubicBezTo>
                  <a:cubicBezTo>
                    <a:pt x="189913" y="59934"/>
                    <a:pt x="183023" y="56246"/>
                    <a:pt x="200025" y="61913"/>
                  </a:cubicBezTo>
                  <a:lnTo>
                    <a:pt x="214312" y="66675"/>
                  </a:lnTo>
                  <a:lnTo>
                    <a:pt x="221456" y="69056"/>
                  </a:lnTo>
                  <a:cubicBezTo>
                    <a:pt x="228961" y="74059"/>
                    <a:pt x="227400" y="73924"/>
                    <a:pt x="235744" y="76200"/>
                  </a:cubicBezTo>
                  <a:cubicBezTo>
                    <a:pt x="242059" y="77922"/>
                    <a:pt x="254794" y="80963"/>
                    <a:pt x="254794" y="80963"/>
                  </a:cubicBezTo>
                  <a:cubicBezTo>
                    <a:pt x="275268" y="94612"/>
                    <a:pt x="249361" y="78246"/>
                    <a:pt x="269081" y="88106"/>
                  </a:cubicBezTo>
                  <a:cubicBezTo>
                    <a:pt x="287546" y="97338"/>
                    <a:pt x="265413" y="89265"/>
                    <a:pt x="283369" y="95250"/>
                  </a:cubicBezTo>
                  <a:cubicBezTo>
                    <a:pt x="285750" y="96838"/>
                    <a:pt x="287897" y="98851"/>
                    <a:pt x="290512" y="100013"/>
                  </a:cubicBezTo>
                  <a:cubicBezTo>
                    <a:pt x="295100" y="102052"/>
                    <a:pt x="300037" y="103188"/>
                    <a:pt x="304800" y="104775"/>
                  </a:cubicBezTo>
                  <a:cubicBezTo>
                    <a:pt x="307181" y="105569"/>
                    <a:pt x="309699" y="106033"/>
                    <a:pt x="311944" y="107156"/>
                  </a:cubicBezTo>
                  <a:cubicBezTo>
                    <a:pt x="318294" y="110331"/>
                    <a:pt x="324259" y="114436"/>
                    <a:pt x="330994" y="116681"/>
                  </a:cubicBezTo>
                  <a:lnTo>
                    <a:pt x="352425" y="123825"/>
                  </a:lnTo>
                  <a:lnTo>
                    <a:pt x="359569" y="126206"/>
                  </a:lnTo>
                  <a:cubicBezTo>
                    <a:pt x="361950" y="127794"/>
                    <a:pt x="364097" y="129807"/>
                    <a:pt x="366712" y="130969"/>
                  </a:cubicBezTo>
                  <a:cubicBezTo>
                    <a:pt x="371300" y="133008"/>
                    <a:pt x="376237" y="134143"/>
                    <a:pt x="381000" y="135731"/>
                  </a:cubicBezTo>
                  <a:lnTo>
                    <a:pt x="388144" y="138113"/>
                  </a:lnTo>
                  <a:lnTo>
                    <a:pt x="395287" y="140494"/>
                  </a:lnTo>
                  <a:lnTo>
                    <a:pt x="402431" y="142875"/>
                  </a:lnTo>
                  <a:cubicBezTo>
                    <a:pt x="413765" y="150431"/>
                    <a:pt x="405121" y="145826"/>
                    <a:pt x="419100" y="150019"/>
                  </a:cubicBezTo>
                  <a:cubicBezTo>
                    <a:pt x="423908" y="151461"/>
                    <a:pt x="428625" y="153194"/>
                    <a:pt x="433387" y="154781"/>
                  </a:cubicBezTo>
                  <a:lnTo>
                    <a:pt x="447675" y="159544"/>
                  </a:lnTo>
                  <a:cubicBezTo>
                    <a:pt x="450056" y="160338"/>
                    <a:pt x="452358" y="161433"/>
                    <a:pt x="454819" y="161925"/>
                  </a:cubicBezTo>
                  <a:cubicBezTo>
                    <a:pt x="458788" y="162719"/>
                    <a:pt x="462820" y="163241"/>
                    <a:pt x="466725" y="164306"/>
                  </a:cubicBezTo>
                  <a:cubicBezTo>
                    <a:pt x="471568" y="165627"/>
                    <a:pt x="476142" y="167852"/>
                    <a:pt x="481012" y="169069"/>
                  </a:cubicBezTo>
                  <a:cubicBezTo>
                    <a:pt x="484187" y="169863"/>
                    <a:pt x="487390" y="170551"/>
                    <a:pt x="490537" y="171450"/>
                  </a:cubicBezTo>
                  <a:cubicBezTo>
                    <a:pt x="492951" y="172140"/>
                    <a:pt x="495235" y="173267"/>
                    <a:pt x="497681" y="173831"/>
                  </a:cubicBezTo>
                  <a:cubicBezTo>
                    <a:pt x="505569" y="175651"/>
                    <a:pt x="513815" y="176034"/>
                    <a:pt x="521494" y="178594"/>
                  </a:cubicBezTo>
                  <a:cubicBezTo>
                    <a:pt x="523875" y="179388"/>
                    <a:pt x="526191" y="180411"/>
                    <a:pt x="528637" y="180975"/>
                  </a:cubicBezTo>
                  <a:cubicBezTo>
                    <a:pt x="536525" y="182795"/>
                    <a:pt x="544597" y="183775"/>
                    <a:pt x="552450" y="185738"/>
                  </a:cubicBezTo>
                  <a:cubicBezTo>
                    <a:pt x="566840" y="189335"/>
                    <a:pt x="558878" y="187086"/>
                    <a:pt x="576262" y="192881"/>
                  </a:cubicBezTo>
                  <a:lnTo>
                    <a:pt x="590550" y="197644"/>
                  </a:lnTo>
                  <a:cubicBezTo>
                    <a:pt x="596900" y="199231"/>
                    <a:pt x="603391" y="200336"/>
                    <a:pt x="609600" y="202406"/>
                  </a:cubicBezTo>
                  <a:cubicBezTo>
                    <a:pt x="615724" y="204448"/>
                    <a:pt x="619686" y="205972"/>
                    <a:pt x="626269" y="207169"/>
                  </a:cubicBezTo>
                  <a:cubicBezTo>
                    <a:pt x="641872" y="210006"/>
                    <a:pt x="640003" y="208193"/>
                    <a:pt x="652462" y="211931"/>
                  </a:cubicBezTo>
                  <a:cubicBezTo>
                    <a:pt x="657271" y="213374"/>
                    <a:pt x="661880" y="215477"/>
                    <a:pt x="666750" y="216694"/>
                  </a:cubicBezTo>
                  <a:cubicBezTo>
                    <a:pt x="669925" y="217488"/>
                    <a:pt x="673128" y="218176"/>
                    <a:pt x="676275" y="219075"/>
                  </a:cubicBezTo>
                  <a:cubicBezTo>
                    <a:pt x="678689" y="219765"/>
                    <a:pt x="680984" y="220847"/>
                    <a:pt x="683419" y="221456"/>
                  </a:cubicBezTo>
                  <a:cubicBezTo>
                    <a:pt x="687345" y="222438"/>
                    <a:pt x="691381" y="222928"/>
                    <a:pt x="695325" y="223838"/>
                  </a:cubicBezTo>
                  <a:cubicBezTo>
                    <a:pt x="701703" y="225310"/>
                    <a:pt x="708025" y="227013"/>
                    <a:pt x="714375" y="228600"/>
                  </a:cubicBezTo>
                  <a:cubicBezTo>
                    <a:pt x="717550" y="229394"/>
                    <a:pt x="720691" y="230339"/>
                    <a:pt x="723900" y="230981"/>
                  </a:cubicBezTo>
                  <a:cubicBezTo>
                    <a:pt x="727869" y="231775"/>
                    <a:pt x="731855" y="232485"/>
                    <a:pt x="735806" y="233363"/>
                  </a:cubicBezTo>
                  <a:cubicBezTo>
                    <a:pt x="739001" y="234073"/>
                    <a:pt x="742184" y="234845"/>
                    <a:pt x="745331" y="235744"/>
                  </a:cubicBezTo>
                  <a:cubicBezTo>
                    <a:pt x="747745" y="236434"/>
                    <a:pt x="750040" y="237516"/>
                    <a:pt x="752475" y="238125"/>
                  </a:cubicBezTo>
                  <a:cubicBezTo>
                    <a:pt x="756401" y="239107"/>
                    <a:pt x="760430" y="239628"/>
                    <a:pt x="764381" y="240506"/>
                  </a:cubicBezTo>
                  <a:cubicBezTo>
                    <a:pt x="767576" y="241216"/>
                    <a:pt x="770686" y="242302"/>
                    <a:pt x="773906" y="242888"/>
                  </a:cubicBezTo>
                  <a:cubicBezTo>
                    <a:pt x="790844" y="245968"/>
                    <a:pt x="800637" y="245914"/>
                    <a:pt x="819150" y="247650"/>
                  </a:cubicBezTo>
                  <a:cubicBezTo>
                    <a:pt x="835035" y="249139"/>
                    <a:pt x="851131" y="249284"/>
                    <a:pt x="866775" y="252413"/>
                  </a:cubicBezTo>
                  <a:cubicBezTo>
                    <a:pt x="892259" y="257509"/>
                    <a:pt x="863118" y="251983"/>
                    <a:pt x="897731" y="257175"/>
                  </a:cubicBezTo>
                  <a:cubicBezTo>
                    <a:pt x="907281" y="258607"/>
                    <a:pt x="917145" y="258885"/>
                    <a:pt x="926306" y="261938"/>
                  </a:cubicBezTo>
                  <a:cubicBezTo>
                    <a:pt x="936573" y="265360"/>
                    <a:pt x="939064" y="266393"/>
                    <a:pt x="952500" y="269081"/>
                  </a:cubicBezTo>
                  <a:cubicBezTo>
                    <a:pt x="956469" y="269875"/>
                    <a:pt x="960480" y="270481"/>
                    <a:pt x="964406" y="271463"/>
                  </a:cubicBezTo>
                  <a:cubicBezTo>
                    <a:pt x="966841" y="272072"/>
                    <a:pt x="969136" y="273154"/>
                    <a:pt x="971550" y="273844"/>
                  </a:cubicBezTo>
                  <a:cubicBezTo>
                    <a:pt x="974697" y="274743"/>
                    <a:pt x="977928" y="275326"/>
                    <a:pt x="981075" y="276225"/>
                  </a:cubicBezTo>
                  <a:cubicBezTo>
                    <a:pt x="983489" y="276915"/>
                    <a:pt x="985784" y="277997"/>
                    <a:pt x="988219" y="278606"/>
                  </a:cubicBezTo>
                  <a:cubicBezTo>
                    <a:pt x="992145" y="279588"/>
                    <a:pt x="996220" y="279923"/>
                    <a:pt x="1000125" y="280988"/>
                  </a:cubicBezTo>
                  <a:cubicBezTo>
                    <a:pt x="1004968" y="282309"/>
                    <a:pt x="1009650" y="284163"/>
                    <a:pt x="1014412" y="285750"/>
                  </a:cubicBezTo>
                  <a:lnTo>
                    <a:pt x="1042987" y="295275"/>
                  </a:lnTo>
                  <a:lnTo>
                    <a:pt x="1057275" y="300038"/>
                  </a:lnTo>
                  <a:lnTo>
                    <a:pt x="1064419" y="302419"/>
                  </a:lnTo>
                  <a:cubicBezTo>
                    <a:pt x="1066800" y="304006"/>
                    <a:pt x="1068932" y="306054"/>
                    <a:pt x="1071562" y="307181"/>
                  </a:cubicBezTo>
                  <a:cubicBezTo>
                    <a:pt x="1077536" y="309741"/>
                    <a:pt x="1093275" y="311129"/>
                    <a:pt x="1097756" y="311944"/>
                  </a:cubicBezTo>
                  <a:cubicBezTo>
                    <a:pt x="1100976" y="312529"/>
                    <a:pt x="1104037" y="313893"/>
                    <a:pt x="1107281" y="314325"/>
                  </a:cubicBezTo>
                  <a:cubicBezTo>
                    <a:pt x="1122860" y="316402"/>
                    <a:pt x="1158524" y="318272"/>
                    <a:pt x="1171575" y="319088"/>
                  </a:cubicBezTo>
                  <a:cubicBezTo>
                    <a:pt x="1186739" y="322879"/>
                    <a:pt x="1188451" y="323850"/>
                    <a:pt x="1209675" y="323850"/>
                  </a:cubicBezTo>
                  <a:cubicBezTo>
                    <a:pt x="1242228" y="323850"/>
                    <a:pt x="1274762" y="322263"/>
                    <a:pt x="1307306" y="321469"/>
                  </a:cubicBezTo>
                  <a:cubicBezTo>
                    <a:pt x="1319212" y="320675"/>
                    <a:pt x="1331158" y="320337"/>
                    <a:pt x="1343025" y="319088"/>
                  </a:cubicBezTo>
                  <a:cubicBezTo>
                    <a:pt x="1346280" y="318745"/>
                    <a:pt x="1349355" y="317416"/>
                    <a:pt x="1352550" y="316706"/>
                  </a:cubicBezTo>
                  <a:cubicBezTo>
                    <a:pt x="1363607" y="314249"/>
                    <a:pt x="1363811" y="314849"/>
                    <a:pt x="1373981" y="311944"/>
                  </a:cubicBezTo>
                  <a:cubicBezTo>
                    <a:pt x="1376395" y="311254"/>
                    <a:pt x="1378637" y="309895"/>
                    <a:pt x="1381125" y="309563"/>
                  </a:cubicBezTo>
                  <a:cubicBezTo>
                    <a:pt x="1390599" y="308300"/>
                    <a:pt x="1400185" y="308087"/>
                    <a:pt x="1409700" y="307181"/>
                  </a:cubicBezTo>
                  <a:cubicBezTo>
                    <a:pt x="1416855" y="306499"/>
                    <a:pt x="1424016" y="305816"/>
                    <a:pt x="1431131" y="304800"/>
                  </a:cubicBezTo>
                  <a:cubicBezTo>
                    <a:pt x="1452791" y="301706"/>
                    <a:pt x="1433137" y="302454"/>
                    <a:pt x="1459706" y="300038"/>
                  </a:cubicBezTo>
                  <a:cubicBezTo>
                    <a:pt x="1471590" y="298958"/>
                    <a:pt x="1483519" y="298450"/>
                    <a:pt x="1495425" y="297656"/>
                  </a:cubicBezTo>
                  <a:cubicBezTo>
                    <a:pt x="1499394" y="296862"/>
                    <a:pt x="1503405" y="296257"/>
                    <a:pt x="1507331" y="295275"/>
                  </a:cubicBezTo>
                  <a:cubicBezTo>
                    <a:pt x="1509766" y="294666"/>
                    <a:pt x="1512040" y="293503"/>
                    <a:pt x="1514475" y="292894"/>
                  </a:cubicBezTo>
                  <a:cubicBezTo>
                    <a:pt x="1531803" y="288562"/>
                    <a:pt x="1521568" y="292376"/>
                    <a:pt x="1540669" y="288131"/>
                  </a:cubicBezTo>
                  <a:cubicBezTo>
                    <a:pt x="1543119" y="287586"/>
                    <a:pt x="1545343" y="286199"/>
                    <a:pt x="1547812" y="285750"/>
                  </a:cubicBezTo>
                  <a:cubicBezTo>
                    <a:pt x="1554108" y="284605"/>
                    <a:pt x="1560527" y="284274"/>
                    <a:pt x="1566862" y="283369"/>
                  </a:cubicBezTo>
                  <a:cubicBezTo>
                    <a:pt x="1571642" y="282686"/>
                    <a:pt x="1576387" y="281782"/>
                    <a:pt x="1581150" y="280988"/>
                  </a:cubicBezTo>
                  <a:lnTo>
                    <a:pt x="1609725" y="271463"/>
                  </a:lnTo>
                  <a:cubicBezTo>
                    <a:pt x="1609727" y="271462"/>
                    <a:pt x="1624009" y="266700"/>
                    <a:pt x="1624012" y="266700"/>
                  </a:cubicBezTo>
                  <a:lnTo>
                    <a:pt x="1654969" y="264319"/>
                  </a:lnTo>
                  <a:cubicBezTo>
                    <a:pt x="1666207" y="262446"/>
                    <a:pt x="1668827" y="262400"/>
                    <a:pt x="1678781" y="259556"/>
                  </a:cubicBezTo>
                  <a:cubicBezTo>
                    <a:pt x="1681195" y="258866"/>
                    <a:pt x="1683475" y="257719"/>
                    <a:pt x="1685925" y="257175"/>
                  </a:cubicBezTo>
                  <a:cubicBezTo>
                    <a:pt x="1698011" y="254489"/>
                    <a:pt x="1712046" y="253611"/>
                    <a:pt x="1724025" y="252413"/>
                  </a:cubicBezTo>
                  <a:cubicBezTo>
                    <a:pt x="1726406" y="251619"/>
                    <a:pt x="1728734" y="250640"/>
                    <a:pt x="1731169" y="250031"/>
                  </a:cubicBezTo>
                  <a:cubicBezTo>
                    <a:pt x="1744462" y="246707"/>
                    <a:pt x="1758357" y="246212"/>
                    <a:pt x="1771650" y="242888"/>
                  </a:cubicBezTo>
                  <a:cubicBezTo>
                    <a:pt x="1827377" y="228952"/>
                    <a:pt x="1777902" y="240506"/>
                    <a:pt x="1924050" y="240506"/>
                  </a:cubicBezTo>
                </a:path>
              </a:pathLst>
            </a:custGeom>
            <a:noFill/>
            <a:ln w="38100">
              <a:solidFill>
                <a:schemeClr val="bg1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9666"/>
            </a:p>
          </p:txBody>
        </p:sp>
        <p:sp>
          <p:nvSpPr>
            <p:cNvPr id="242" name="Freeform 241"/>
            <p:cNvSpPr/>
            <p:nvPr/>
          </p:nvSpPr>
          <p:spPr>
            <a:xfrm>
              <a:off x="6862014" y="3310555"/>
              <a:ext cx="1785617" cy="296014"/>
            </a:xfrm>
            <a:custGeom>
              <a:avLst/>
              <a:gdLst>
                <a:gd name="connsiteX0" fmla="*/ 0 w 1931193"/>
                <a:gd name="connsiteY0" fmla="*/ 0 h 319088"/>
                <a:gd name="connsiteX1" fmla="*/ 11906 w 1931193"/>
                <a:gd name="connsiteY1" fmla="*/ 2381 h 319088"/>
                <a:gd name="connsiteX2" fmla="*/ 21431 w 1931193"/>
                <a:gd name="connsiteY2" fmla="*/ 4763 h 319088"/>
                <a:gd name="connsiteX3" fmla="*/ 47625 w 1931193"/>
                <a:gd name="connsiteY3" fmla="*/ 7144 h 319088"/>
                <a:gd name="connsiteX4" fmla="*/ 173831 w 1931193"/>
                <a:gd name="connsiteY4" fmla="*/ 11906 h 319088"/>
                <a:gd name="connsiteX5" fmla="*/ 183356 w 1931193"/>
                <a:gd name="connsiteY5" fmla="*/ 14288 h 319088"/>
                <a:gd name="connsiteX6" fmla="*/ 204787 w 1931193"/>
                <a:gd name="connsiteY6" fmla="*/ 19050 h 319088"/>
                <a:gd name="connsiteX7" fmla="*/ 211931 w 1931193"/>
                <a:gd name="connsiteY7" fmla="*/ 26194 h 319088"/>
                <a:gd name="connsiteX8" fmla="*/ 216693 w 1931193"/>
                <a:gd name="connsiteY8" fmla="*/ 40481 h 319088"/>
                <a:gd name="connsiteX9" fmla="*/ 214312 w 1931193"/>
                <a:gd name="connsiteY9" fmla="*/ 47625 h 319088"/>
                <a:gd name="connsiteX10" fmla="*/ 216693 w 1931193"/>
                <a:gd name="connsiteY10" fmla="*/ 66675 h 319088"/>
                <a:gd name="connsiteX11" fmla="*/ 230981 w 1931193"/>
                <a:gd name="connsiteY11" fmla="*/ 73819 h 319088"/>
                <a:gd name="connsiteX12" fmla="*/ 273843 w 1931193"/>
                <a:gd name="connsiteY12" fmla="*/ 78581 h 319088"/>
                <a:gd name="connsiteX13" fmla="*/ 307181 w 1931193"/>
                <a:gd name="connsiteY13" fmla="*/ 83344 h 319088"/>
                <a:gd name="connsiteX14" fmla="*/ 330993 w 1931193"/>
                <a:gd name="connsiteY14" fmla="*/ 88106 h 319088"/>
                <a:gd name="connsiteX15" fmla="*/ 345281 w 1931193"/>
                <a:gd name="connsiteY15" fmla="*/ 92869 h 319088"/>
                <a:gd name="connsiteX16" fmla="*/ 352425 w 1931193"/>
                <a:gd name="connsiteY16" fmla="*/ 97631 h 319088"/>
                <a:gd name="connsiteX17" fmla="*/ 366712 w 1931193"/>
                <a:gd name="connsiteY17" fmla="*/ 104775 h 319088"/>
                <a:gd name="connsiteX18" fmla="*/ 371475 w 1931193"/>
                <a:gd name="connsiteY18" fmla="*/ 111919 h 319088"/>
                <a:gd name="connsiteX19" fmla="*/ 378618 w 1931193"/>
                <a:gd name="connsiteY19" fmla="*/ 114300 h 319088"/>
                <a:gd name="connsiteX20" fmla="*/ 385762 w 1931193"/>
                <a:gd name="connsiteY20" fmla="*/ 119063 h 319088"/>
                <a:gd name="connsiteX21" fmla="*/ 400050 w 1931193"/>
                <a:gd name="connsiteY21" fmla="*/ 130969 h 319088"/>
                <a:gd name="connsiteX22" fmla="*/ 414337 w 1931193"/>
                <a:gd name="connsiteY22" fmla="*/ 135731 h 319088"/>
                <a:gd name="connsiteX23" fmla="*/ 421481 w 1931193"/>
                <a:gd name="connsiteY23" fmla="*/ 140494 h 319088"/>
                <a:gd name="connsiteX24" fmla="*/ 442912 w 1931193"/>
                <a:gd name="connsiteY24" fmla="*/ 145256 h 319088"/>
                <a:gd name="connsiteX25" fmla="*/ 461962 w 1931193"/>
                <a:gd name="connsiteY25" fmla="*/ 150019 h 319088"/>
                <a:gd name="connsiteX26" fmla="*/ 490537 w 1931193"/>
                <a:gd name="connsiteY26" fmla="*/ 152400 h 319088"/>
                <a:gd name="connsiteX27" fmla="*/ 545306 w 1931193"/>
                <a:gd name="connsiteY27" fmla="*/ 150019 h 319088"/>
                <a:gd name="connsiteX28" fmla="*/ 559593 w 1931193"/>
                <a:gd name="connsiteY28" fmla="*/ 142875 h 319088"/>
                <a:gd name="connsiteX29" fmla="*/ 573881 w 1931193"/>
                <a:gd name="connsiteY29" fmla="*/ 138113 h 319088"/>
                <a:gd name="connsiteX30" fmla="*/ 588168 w 1931193"/>
                <a:gd name="connsiteY30" fmla="*/ 128588 h 319088"/>
                <a:gd name="connsiteX31" fmla="*/ 595312 w 1931193"/>
                <a:gd name="connsiteY31" fmla="*/ 121444 h 319088"/>
                <a:gd name="connsiteX32" fmla="*/ 600075 w 1931193"/>
                <a:gd name="connsiteY32" fmla="*/ 114300 h 319088"/>
                <a:gd name="connsiteX33" fmla="*/ 607218 w 1931193"/>
                <a:gd name="connsiteY33" fmla="*/ 109538 h 319088"/>
                <a:gd name="connsiteX34" fmla="*/ 623887 w 1931193"/>
                <a:gd name="connsiteY34" fmla="*/ 88106 h 319088"/>
                <a:gd name="connsiteX35" fmla="*/ 638175 w 1931193"/>
                <a:gd name="connsiteY35" fmla="*/ 78581 h 319088"/>
                <a:gd name="connsiteX36" fmla="*/ 666750 w 1931193"/>
                <a:gd name="connsiteY36" fmla="*/ 69056 h 319088"/>
                <a:gd name="connsiteX37" fmla="*/ 681037 w 1931193"/>
                <a:gd name="connsiteY37" fmla="*/ 64294 h 319088"/>
                <a:gd name="connsiteX38" fmla="*/ 688181 w 1931193"/>
                <a:gd name="connsiteY38" fmla="*/ 61913 h 319088"/>
                <a:gd name="connsiteX39" fmla="*/ 707231 w 1931193"/>
                <a:gd name="connsiteY39" fmla="*/ 57150 h 319088"/>
                <a:gd name="connsiteX40" fmla="*/ 721518 w 1931193"/>
                <a:gd name="connsiteY40" fmla="*/ 52388 h 319088"/>
                <a:gd name="connsiteX41" fmla="*/ 731043 w 1931193"/>
                <a:gd name="connsiteY41" fmla="*/ 50006 h 319088"/>
                <a:gd name="connsiteX42" fmla="*/ 745331 w 1931193"/>
                <a:gd name="connsiteY42" fmla="*/ 45244 h 319088"/>
                <a:gd name="connsiteX43" fmla="*/ 759618 w 1931193"/>
                <a:gd name="connsiteY43" fmla="*/ 40481 h 319088"/>
                <a:gd name="connsiteX44" fmla="*/ 773906 w 1931193"/>
                <a:gd name="connsiteY44" fmla="*/ 33338 h 319088"/>
                <a:gd name="connsiteX45" fmla="*/ 788193 w 1931193"/>
                <a:gd name="connsiteY45" fmla="*/ 28575 h 319088"/>
                <a:gd name="connsiteX46" fmla="*/ 809625 w 1931193"/>
                <a:gd name="connsiteY46" fmla="*/ 19050 h 319088"/>
                <a:gd name="connsiteX47" fmla="*/ 823912 w 1931193"/>
                <a:gd name="connsiteY47" fmla="*/ 14288 h 319088"/>
                <a:gd name="connsiteX48" fmla="*/ 831056 w 1931193"/>
                <a:gd name="connsiteY48" fmla="*/ 11906 h 319088"/>
                <a:gd name="connsiteX49" fmla="*/ 869156 w 1931193"/>
                <a:gd name="connsiteY49" fmla="*/ 14288 h 319088"/>
                <a:gd name="connsiteX50" fmla="*/ 888206 w 1931193"/>
                <a:gd name="connsiteY50" fmla="*/ 19050 h 319088"/>
                <a:gd name="connsiteX51" fmla="*/ 909637 w 1931193"/>
                <a:gd name="connsiteY51" fmla="*/ 26194 h 319088"/>
                <a:gd name="connsiteX52" fmla="*/ 923925 w 1931193"/>
                <a:gd name="connsiteY52" fmla="*/ 30956 h 319088"/>
                <a:gd name="connsiteX53" fmla="*/ 931068 w 1931193"/>
                <a:gd name="connsiteY53" fmla="*/ 33338 h 319088"/>
                <a:gd name="connsiteX54" fmla="*/ 947737 w 1931193"/>
                <a:gd name="connsiteY54" fmla="*/ 45244 h 319088"/>
                <a:gd name="connsiteX55" fmla="*/ 954881 w 1931193"/>
                <a:gd name="connsiteY55" fmla="*/ 50006 h 319088"/>
                <a:gd name="connsiteX56" fmla="*/ 969168 w 1931193"/>
                <a:gd name="connsiteY56" fmla="*/ 54769 h 319088"/>
                <a:gd name="connsiteX57" fmla="*/ 976312 w 1931193"/>
                <a:gd name="connsiteY57" fmla="*/ 59531 h 319088"/>
                <a:gd name="connsiteX58" fmla="*/ 985837 w 1931193"/>
                <a:gd name="connsiteY58" fmla="*/ 61913 h 319088"/>
                <a:gd name="connsiteX59" fmla="*/ 992981 w 1931193"/>
                <a:gd name="connsiteY59" fmla="*/ 64294 h 319088"/>
                <a:gd name="connsiteX60" fmla="*/ 1004887 w 1931193"/>
                <a:gd name="connsiteY60" fmla="*/ 66675 h 319088"/>
                <a:gd name="connsiteX61" fmla="*/ 1019175 w 1931193"/>
                <a:gd name="connsiteY61" fmla="*/ 71438 h 319088"/>
                <a:gd name="connsiteX62" fmla="*/ 1045368 w 1931193"/>
                <a:gd name="connsiteY62" fmla="*/ 78581 h 319088"/>
                <a:gd name="connsiteX63" fmla="*/ 1073943 w 1931193"/>
                <a:gd name="connsiteY63" fmla="*/ 83344 h 319088"/>
                <a:gd name="connsiteX64" fmla="*/ 1092993 w 1931193"/>
                <a:gd name="connsiteY64" fmla="*/ 88106 h 319088"/>
                <a:gd name="connsiteX65" fmla="*/ 1107281 w 1931193"/>
                <a:gd name="connsiteY65" fmla="*/ 92869 h 319088"/>
                <a:gd name="connsiteX66" fmla="*/ 1126331 w 1931193"/>
                <a:gd name="connsiteY66" fmla="*/ 97631 h 319088"/>
                <a:gd name="connsiteX67" fmla="*/ 1135856 w 1931193"/>
                <a:gd name="connsiteY67" fmla="*/ 100013 h 319088"/>
                <a:gd name="connsiteX68" fmla="*/ 1143000 w 1931193"/>
                <a:gd name="connsiteY68" fmla="*/ 102394 h 319088"/>
                <a:gd name="connsiteX69" fmla="*/ 1173956 w 1931193"/>
                <a:gd name="connsiteY69" fmla="*/ 107156 h 319088"/>
                <a:gd name="connsiteX70" fmla="*/ 1202531 w 1931193"/>
                <a:gd name="connsiteY70" fmla="*/ 111919 h 319088"/>
                <a:gd name="connsiteX71" fmla="*/ 1231106 w 1931193"/>
                <a:gd name="connsiteY71" fmla="*/ 114300 h 319088"/>
                <a:gd name="connsiteX72" fmla="*/ 1240631 w 1931193"/>
                <a:gd name="connsiteY72" fmla="*/ 116681 h 319088"/>
                <a:gd name="connsiteX73" fmla="*/ 1252537 w 1931193"/>
                <a:gd name="connsiteY73" fmla="*/ 119063 h 319088"/>
                <a:gd name="connsiteX74" fmla="*/ 1266825 w 1931193"/>
                <a:gd name="connsiteY74" fmla="*/ 123825 h 319088"/>
                <a:gd name="connsiteX75" fmla="*/ 1276350 w 1931193"/>
                <a:gd name="connsiteY75" fmla="*/ 126206 h 319088"/>
                <a:gd name="connsiteX76" fmla="*/ 1283493 w 1931193"/>
                <a:gd name="connsiteY76" fmla="*/ 128588 h 319088"/>
                <a:gd name="connsiteX77" fmla="*/ 1309687 w 1931193"/>
                <a:gd name="connsiteY77" fmla="*/ 133350 h 319088"/>
                <a:gd name="connsiteX78" fmla="*/ 1316831 w 1931193"/>
                <a:gd name="connsiteY78" fmla="*/ 135731 h 319088"/>
                <a:gd name="connsiteX79" fmla="*/ 1326356 w 1931193"/>
                <a:gd name="connsiteY79" fmla="*/ 138113 h 319088"/>
                <a:gd name="connsiteX80" fmla="*/ 1350168 w 1931193"/>
                <a:gd name="connsiteY80" fmla="*/ 142875 h 319088"/>
                <a:gd name="connsiteX81" fmla="*/ 1459706 w 1931193"/>
                <a:gd name="connsiteY81" fmla="*/ 145256 h 319088"/>
                <a:gd name="connsiteX82" fmla="*/ 1476375 w 1931193"/>
                <a:gd name="connsiteY82" fmla="*/ 147638 h 319088"/>
                <a:gd name="connsiteX83" fmla="*/ 1483518 w 1931193"/>
                <a:gd name="connsiteY83" fmla="*/ 150019 h 319088"/>
                <a:gd name="connsiteX84" fmla="*/ 1500187 w 1931193"/>
                <a:gd name="connsiteY84" fmla="*/ 152400 h 319088"/>
                <a:gd name="connsiteX85" fmla="*/ 1519237 w 1931193"/>
                <a:gd name="connsiteY85" fmla="*/ 157163 h 319088"/>
                <a:gd name="connsiteX86" fmla="*/ 1535906 w 1931193"/>
                <a:gd name="connsiteY86" fmla="*/ 161925 h 319088"/>
                <a:gd name="connsiteX87" fmla="*/ 1550193 w 1931193"/>
                <a:gd name="connsiteY87" fmla="*/ 171450 h 319088"/>
                <a:gd name="connsiteX88" fmla="*/ 1562100 w 1931193"/>
                <a:gd name="connsiteY88" fmla="*/ 183356 h 319088"/>
                <a:gd name="connsiteX89" fmla="*/ 1569243 w 1931193"/>
                <a:gd name="connsiteY89" fmla="*/ 190500 h 319088"/>
                <a:gd name="connsiteX90" fmla="*/ 1576387 w 1931193"/>
                <a:gd name="connsiteY90" fmla="*/ 195263 h 319088"/>
                <a:gd name="connsiteX91" fmla="*/ 1593056 w 1931193"/>
                <a:gd name="connsiteY91" fmla="*/ 207169 h 319088"/>
                <a:gd name="connsiteX92" fmla="*/ 1600200 w 1931193"/>
                <a:gd name="connsiteY92" fmla="*/ 209550 h 319088"/>
                <a:gd name="connsiteX93" fmla="*/ 1607343 w 1931193"/>
                <a:gd name="connsiteY93" fmla="*/ 214313 h 319088"/>
                <a:gd name="connsiteX94" fmla="*/ 1616868 w 1931193"/>
                <a:gd name="connsiteY94" fmla="*/ 219075 h 319088"/>
                <a:gd name="connsiteX95" fmla="*/ 1626393 w 1931193"/>
                <a:gd name="connsiteY95" fmla="*/ 226219 h 319088"/>
                <a:gd name="connsiteX96" fmla="*/ 1640681 w 1931193"/>
                <a:gd name="connsiteY96" fmla="*/ 230981 h 319088"/>
                <a:gd name="connsiteX97" fmla="*/ 1659731 w 1931193"/>
                <a:gd name="connsiteY97" fmla="*/ 240506 h 319088"/>
                <a:gd name="connsiteX98" fmla="*/ 1707356 w 1931193"/>
                <a:gd name="connsiteY98" fmla="*/ 242888 h 319088"/>
                <a:gd name="connsiteX99" fmla="*/ 1721643 w 1931193"/>
                <a:gd name="connsiteY99" fmla="*/ 250031 h 319088"/>
                <a:gd name="connsiteX100" fmla="*/ 1726406 w 1931193"/>
                <a:gd name="connsiteY100" fmla="*/ 257175 h 319088"/>
                <a:gd name="connsiteX101" fmla="*/ 1735931 w 1931193"/>
                <a:gd name="connsiteY101" fmla="*/ 261938 h 319088"/>
                <a:gd name="connsiteX102" fmla="*/ 1743075 w 1931193"/>
                <a:gd name="connsiteY102" fmla="*/ 266700 h 319088"/>
                <a:gd name="connsiteX103" fmla="*/ 1752600 w 1931193"/>
                <a:gd name="connsiteY103" fmla="*/ 273844 h 319088"/>
                <a:gd name="connsiteX104" fmla="*/ 1759743 w 1931193"/>
                <a:gd name="connsiteY104" fmla="*/ 276225 h 319088"/>
                <a:gd name="connsiteX105" fmla="*/ 1774031 w 1931193"/>
                <a:gd name="connsiteY105" fmla="*/ 285750 h 319088"/>
                <a:gd name="connsiteX106" fmla="*/ 1781175 w 1931193"/>
                <a:gd name="connsiteY106" fmla="*/ 292894 h 319088"/>
                <a:gd name="connsiteX107" fmla="*/ 1795462 w 1931193"/>
                <a:gd name="connsiteY107" fmla="*/ 300038 h 319088"/>
                <a:gd name="connsiteX108" fmla="*/ 1812131 w 1931193"/>
                <a:gd name="connsiteY108" fmla="*/ 311944 h 319088"/>
                <a:gd name="connsiteX109" fmla="*/ 1828800 w 1931193"/>
                <a:gd name="connsiteY109" fmla="*/ 319088 h 319088"/>
                <a:gd name="connsiteX110" fmla="*/ 1852612 w 1931193"/>
                <a:gd name="connsiteY110" fmla="*/ 314325 h 319088"/>
                <a:gd name="connsiteX111" fmla="*/ 1859756 w 1931193"/>
                <a:gd name="connsiteY111" fmla="*/ 309563 h 319088"/>
                <a:gd name="connsiteX112" fmla="*/ 1866900 w 1931193"/>
                <a:gd name="connsiteY112" fmla="*/ 307181 h 319088"/>
                <a:gd name="connsiteX113" fmla="*/ 1874043 w 1931193"/>
                <a:gd name="connsiteY113" fmla="*/ 302419 h 319088"/>
                <a:gd name="connsiteX114" fmla="*/ 1883568 w 1931193"/>
                <a:gd name="connsiteY114" fmla="*/ 300038 h 319088"/>
                <a:gd name="connsiteX115" fmla="*/ 1890712 w 1931193"/>
                <a:gd name="connsiteY115" fmla="*/ 297656 h 319088"/>
                <a:gd name="connsiteX116" fmla="*/ 1909762 w 1931193"/>
                <a:gd name="connsiteY116" fmla="*/ 300038 h 319088"/>
                <a:gd name="connsiteX117" fmla="*/ 1919287 w 1931193"/>
                <a:gd name="connsiteY117" fmla="*/ 302419 h 319088"/>
                <a:gd name="connsiteX118" fmla="*/ 1926431 w 1931193"/>
                <a:gd name="connsiteY118" fmla="*/ 304800 h 319088"/>
                <a:gd name="connsiteX119" fmla="*/ 1931193 w 1931193"/>
                <a:gd name="connsiteY119" fmla="*/ 304800 h 31908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  <a:cxn ang="0">
                  <a:pos x="connsiteX29" y="connsiteY29"/>
                </a:cxn>
                <a:cxn ang="0">
                  <a:pos x="connsiteX30" y="connsiteY30"/>
                </a:cxn>
                <a:cxn ang="0">
                  <a:pos x="connsiteX31" y="connsiteY31"/>
                </a:cxn>
                <a:cxn ang="0">
                  <a:pos x="connsiteX32" y="connsiteY32"/>
                </a:cxn>
                <a:cxn ang="0">
                  <a:pos x="connsiteX33" y="connsiteY33"/>
                </a:cxn>
                <a:cxn ang="0">
                  <a:pos x="connsiteX34" y="connsiteY34"/>
                </a:cxn>
                <a:cxn ang="0">
                  <a:pos x="connsiteX35" y="connsiteY35"/>
                </a:cxn>
                <a:cxn ang="0">
                  <a:pos x="connsiteX36" y="connsiteY36"/>
                </a:cxn>
                <a:cxn ang="0">
                  <a:pos x="connsiteX37" y="connsiteY37"/>
                </a:cxn>
                <a:cxn ang="0">
                  <a:pos x="connsiteX38" y="connsiteY38"/>
                </a:cxn>
                <a:cxn ang="0">
                  <a:pos x="connsiteX39" y="connsiteY39"/>
                </a:cxn>
                <a:cxn ang="0">
                  <a:pos x="connsiteX40" y="connsiteY40"/>
                </a:cxn>
                <a:cxn ang="0">
                  <a:pos x="connsiteX41" y="connsiteY41"/>
                </a:cxn>
                <a:cxn ang="0">
                  <a:pos x="connsiteX42" y="connsiteY42"/>
                </a:cxn>
                <a:cxn ang="0">
                  <a:pos x="connsiteX43" y="connsiteY43"/>
                </a:cxn>
                <a:cxn ang="0">
                  <a:pos x="connsiteX44" y="connsiteY44"/>
                </a:cxn>
                <a:cxn ang="0">
                  <a:pos x="connsiteX45" y="connsiteY45"/>
                </a:cxn>
                <a:cxn ang="0">
                  <a:pos x="connsiteX46" y="connsiteY46"/>
                </a:cxn>
                <a:cxn ang="0">
                  <a:pos x="connsiteX47" y="connsiteY47"/>
                </a:cxn>
                <a:cxn ang="0">
                  <a:pos x="connsiteX48" y="connsiteY48"/>
                </a:cxn>
                <a:cxn ang="0">
                  <a:pos x="connsiteX49" y="connsiteY49"/>
                </a:cxn>
                <a:cxn ang="0">
                  <a:pos x="connsiteX50" y="connsiteY50"/>
                </a:cxn>
                <a:cxn ang="0">
                  <a:pos x="connsiteX51" y="connsiteY51"/>
                </a:cxn>
                <a:cxn ang="0">
                  <a:pos x="connsiteX52" y="connsiteY52"/>
                </a:cxn>
                <a:cxn ang="0">
                  <a:pos x="connsiteX53" y="connsiteY53"/>
                </a:cxn>
                <a:cxn ang="0">
                  <a:pos x="connsiteX54" y="connsiteY54"/>
                </a:cxn>
                <a:cxn ang="0">
                  <a:pos x="connsiteX55" y="connsiteY55"/>
                </a:cxn>
                <a:cxn ang="0">
                  <a:pos x="connsiteX56" y="connsiteY56"/>
                </a:cxn>
                <a:cxn ang="0">
                  <a:pos x="connsiteX57" y="connsiteY57"/>
                </a:cxn>
                <a:cxn ang="0">
                  <a:pos x="connsiteX58" y="connsiteY58"/>
                </a:cxn>
                <a:cxn ang="0">
                  <a:pos x="connsiteX59" y="connsiteY59"/>
                </a:cxn>
                <a:cxn ang="0">
                  <a:pos x="connsiteX60" y="connsiteY60"/>
                </a:cxn>
                <a:cxn ang="0">
                  <a:pos x="connsiteX61" y="connsiteY61"/>
                </a:cxn>
                <a:cxn ang="0">
                  <a:pos x="connsiteX62" y="connsiteY62"/>
                </a:cxn>
                <a:cxn ang="0">
                  <a:pos x="connsiteX63" y="connsiteY63"/>
                </a:cxn>
                <a:cxn ang="0">
                  <a:pos x="connsiteX64" y="connsiteY64"/>
                </a:cxn>
                <a:cxn ang="0">
                  <a:pos x="connsiteX65" y="connsiteY65"/>
                </a:cxn>
                <a:cxn ang="0">
                  <a:pos x="connsiteX66" y="connsiteY66"/>
                </a:cxn>
                <a:cxn ang="0">
                  <a:pos x="connsiteX67" y="connsiteY67"/>
                </a:cxn>
                <a:cxn ang="0">
                  <a:pos x="connsiteX68" y="connsiteY68"/>
                </a:cxn>
                <a:cxn ang="0">
                  <a:pos x="connsiteX69" y="connsiteY69"/>
                </a:cxn>
                <a:cxn ang="0">
                  <a:pos x="connsiteX70" y="connsiteY70"/>
                </a:cxn>
                <a:cxn ang="0">
                  <a:pos x="connsiteX71" y="connsiteY71"/>
                </a:cxn>
                <a:cxn ang="0">
                  <a:pos x="connsiteX72" y="connsiteY72"/>
                </a:cxn>
                <a:cxn ang="0">
                  <a:pos x="connsiteX73" y="connsiteY73"/>
                </a:cxn>
                <a:cxn ang="0">
                  <a:pos x="connsiteX74" y="connsiteY74"/>
                </a:cxn>
                <a:cxn ang="0">
                  <a:pos x="connsiteX75" y="connsiteY75"/>
                </a:cxn>
                <a:cxn ang="0">
                  <a:pos x="connsiteX76" y="connsiteY76"/>
                </a:cxn>
                <a:cxn ang="0">
                  <a:pos x="connsiteX77" y="connsiteY77"/>
                </a:cxn>
                <a:cxn ang="0">
                  <a:pos x="connsiteX78" y="connsiteY78"/>
                </a:cxn>
                <a:cxn ang="0">
                  <a:pos x="connsiteX79" y="connsiteY79"/>
                </a:cxn>
                <a:cxn ang="0">
                  <a:pos x="connsiteX80" y="connsiteY80"/>
                </a:cxn>
                <a:cxn ang="0">
                  <a:pos x="connsiteX81" y="connsiteY81"/>
                </a:cxn>
                <a:cxn ang="0">
                  <a:pos x="connsiteX82" y="connsiteY82"/>
                </a:cxn>
                <a:cxn ang="0">
                  <a:pos x="connsiteX83" y="connsiteY83"/>
                </a:cxn>
                <a:cxn ang="0">
                  <a:pos x="connsiteX84" y="connsiteY84"/>
                </a:cxn>
                <a:cxn ang="0">
                  <a:pos x="connsiteX85" y="connsiteY85"/>
                </a:cxn>
                <a:cxn ang="0">
                  <a:pos x="connsiteX86" y="connsiteY86"/>
                </a:cxn>
                <a:cxn ang="0">
                  <a:pos x="connsiteX87" y="connsiteY87"/>
                </a:cxn>
                <a:cxn ang="0">
                  <a:pos x="connsiteX88" y="connsiteY88"/>
                </a:cxn>
                <a:cxn ang="0">
                  <a:pos x="connsiteX89" y="connsiteY89"/>
                </a:cxn>
                <a:cxn ang="0">
                  <a:pos x="connsiteX90" y="connsiteY90"/>
                </a:cxn>
                <a:cxn ang="0">
                  <a:pos x="connsiteX91" y="connsiteY91"/>
                </a:cxn>
                <a:cxn ang="0">
                  <a:pos x="connsiteX92" y="connsiteY92"/>
                </a:cxn>
                <a:cxn ang="0">
                  <a:pos x="connsiteX93" y="connsiteY93"/>
                </a:cxn>
                <a:cxn ang="0">
                  <a:pos x="connsiteX94" y="connsiteY94"/>
                </a:cxn>
                <a:cxn ang="0">
                  <a:pos x="connsiteX95" y="connsiteY95"/>
                </a:cxn>
                <a:cxn ang="0">
                  <a:pos x="connsiteX96" y="connsiteY96"/>
                </a:cxn>
                <a:cxn ang="0">
                  <a:pos x="connsiteX97" y="connsiteY97"/>
                </a:cxn>
                <a:cxn ang="0">
                  <a:pos x="connsiteX98" y="connsiteY98"/>
                </a:cxn>
                <a:cxn ang="0">
                  <a:pos x="connsiteX99" y="connsiteY99"/>
                </a:cxn>
                <a:cxn ang="0">
                  <a:pos x="connsiteX100" y="connsiteY100"/>
                </a:cxn>
                <a:cxn ang="0">
                  <a:pos x="connsiteX101" y="connsiteY101"/>
                </a:cxn>
                <a:cxn ang="0">
                  <a:pos x="connsiteX102" y="connsiteY102"/>
                </a:cxn>
                <a:cxn ang="0">
                  <a:pos x="connsiteX103" y="connsiteY103"/>
                </a:cxn>
                <a:cxn ang="0">
                  <a:pos x="connsiteX104" y="connsiteY104"/>
                </a:cxn>
                <a:cxn ang="0">
                  <a:pos x="connsiteX105" y="connsiteY105"/>
                </a:cxn>
                <a:cxn ang="0">
                  <a:pos x="connsiteX106" y="connsiteY106"/>
                </a:cxn>
                <a:cxn ang="0">
                  <a:pos x="connsiteX107" y="connsiteY107"/>
                </a:cxn>
                <a:cxn ang="0">
                  <a:pos x="connsiteX108" y="connsiteY108"/>
                </a:cxn>
                <a:cxn ang="0">
                  <a:pos x="connsiteX109" y="connsiteY109"/>
                </a:cxn>
                <a:cxn ang="0">
                  <a:pos x="connsiteX110" y="connsiteY110"/>
                </a:cxn>
                <a:cxn ang="0">
                  <a:pos x="connsiteX111" y="connsiteY111"/>
                </a:cxn>
                <a:cxn ang="0">
                  <a:pos x="connsiteX112" y="connsiteY112"/>
                </a:cxn>
                <a:cxn ang="0">
                  <a:pos x="connsiteX113" y="connsiteY113"/>
                </a:cxn>
                <a:cxn ang="0">
                  <a:pos x="connsiteX114" y="connsiteY114"/>
                </a:cxn>
                <a:cxn ang="0">
                  <a:pos x="connsiteX115" y="connsiteY115"/>
                </a:cxn>
                <a:cxn ang="0">
                  <a:pos x="connsiteX116" y="connsiteY116"/>
                </a:cxn>
                <a:cxn ang="0">
                  <a:pos x="connsiteX117" y="connsiteY117"/>
                </a:cxn>
                <a:cxn ang="0">
                  <a:pos x="connsiteX118" y="connsiteY118"/>
                </a:cxn>
                <a:cxn ang="0">
                  <a:pos x="connsiteX119" y="connsiteY119"/>
                </a:cxn>
              </a:cxnLst>
              <a:rect l="l" t="t" r="r" b="b"/>
              <a:pathLst>
                <a:path w="1931193" h="319088">
                  <a:moveTo>
                    <a:pt x="0" y="0"/>
                  </a:moveTo>
                  <a:cubicBezTo>
                    <a:pt x="3969" y="794"/>
                    <a:pt x="7955" y="1503"/>
                    <a:pt x="11906" y="2381"/>
                  </a:cubicBezTo>
                  <a:cubicBezTo>
                    <a:pt x="15101" y="3091"/>
                    <a:pt x="18187" y="4330"/>
                    <a:pt x="21431" y="4763"/>
                  </a:cubicBezTo>
                  <a:cubicBezTo>
                    <a:pt x="30121" y="5922"/>
                    <a:pt x="38894" y="6350"/>
                    <a:pt x="47625" y="7144"/>
                  </a:cubicBezTo>
                  <a:cubicBezTo>
                    <a:pt x="98272" y="17272"/>
                    <a:pt x="42564" y="6857"/>
                    <a:pt x="173831" y="11906"/>
                  </a:cubicBezTo>
                  <a:cubicBezTo>
                    <a:pt x="177101" y="12032"/>
                    <a:pt x="180147" y="13646"/>
                    <a:pt x="183356" y="14288"/>
                  </a:cubicBezTo>
                  <a:cubicBezTo>
                    <a:pt x="204317" y="18481"/>
                    <a:pt x="190880" y="14415"/>
                    <a:pt x="204787" y="19050"/>
                  </a:cubicBezTo>
                  <a:cubicBezTo>
                    <a:pt x="207168" y="21431"/>
                    <a:pt x="210296" y="23250"/>
                    <a:pt x="211931" y="26194"/>
                  </a:cubicBezTo>
                  <a:cubicBezTo>
                    <a:pt x="214369" y="30582"/>
                    <a:pt x="216693" y="40481"/>
                    <a:pt x="216693" y="40481"/>
                  </a:cubicBezTo>
                  <a:cubicBezTo>
                    <a:pt x="215899" y="42862"/>
                    <a:pt x="214312" y="45115"/>
                    <a:pt x="214312" y="47625"/>
                  </a:cubicBezTo>
                  <a:cubicBezTo>
                    <a:pt x="214312" y="54024"/>
                    <a:pt x="214316" y="60733"/>
                    <a:pt x="216693" y="66675"/>
                  </a:cubicBezTo>
                  <a:cubicBezTo>
                    <a:pt x="217946" y="69809"/>
                    <a:pt x="228120" y="73183"/>
                    <a:pt x="230981" y="73819"/>
                  </a:cubicBezTo>
                  <a:cubicBezTo>
                    <a:pt x="245211" y="76981"/>
                    <a:pt x="259235" y="77364"/>
                    <a:pt x="273843" y="78581"/>
                  </a:cubicBezTo>
                  <a:cubicBezTo>
                    <a:pt x="290322" y="84076"/>
                    <a:pt x="274932" y="79550"/>
                    <a:pt x="307181" y="83344"/>
                  </a:cubicBezTo>
                  <a:cubicBezTo>
                    <a:pt x="314238" y="84174"/>
                    <a:pt x="323873" y="85970"/>
                    <a:pt x="330993" y="88106"/>
                  </a:cubicBezTo>
                  <a:cubicBezTo>
                    <a:pt x="335802" y="89549"/>
                    <a:pt x="341104" y="90084"/>
                    <a:pt x="345281" y="92869"/>
                  </a:cubicBezTo>
                  <a:cubicBezTo>
                    <a:pt x="347662" y="94456"/>
                    <a:pt x="349865" y="96351"/>
                    <a:pt x="352425" y="97631"/>
                  </a:cubicBezTo>
                  <a:cubicBezTo>
                    <a:pt x="372142" y="107490"/>
                    <a:pt x="346238" y="91127"/>
                    <a:pt x="366712" y="104775"/>
                  </a:cubicBezTo>
                  <a:cubicBezTo>
                    <a:pt x="368300" y="107156"/>
                    <a:pt x="369240" y="110131"/>
                    <a:pt x="371475" y="111919"/>
                  </a:cubicBezTo>
                  <a:cubicBezTo>
                    <a:pt x="373435" y="113487"/>
                    <a:pt x="376373" y="113178"/>
                    <a:pt x="378618" y="114300"/>
                  </a:cubicBezTo>
                  <a:cubicBezTo>
                    <a:pt x="381178" y="115580"/>
                    <a:pt x="383563" y="117231"/>
                    <a:pt x="385762" y="119063"/>
                  </a:cubicBezTo>
                  <a:cubicBezTo>
                    <a:pt x="392168" y="124401"/>
                    <a:pt x="392451" y="127592"/>
                    <a:pt x="400050" y="130969"/>
                  </a:cubicBezTo>
                  <a:cubicBezTo>
                    <a:pt x="404637" y="133008"/>
                    <a:pt x="414337" y="135731"/>
                    <a:pt x="414337" y="135731"/>
                  </a:cubicBezTo>
                  <a:cubicBezTo>
                    <a:pt x="416718" y="137319"/>
                    <a:pt x="418850" y="139367"/>
                    <a:pt x="421481" y="140494"/>
                  </a:cubicBezTo>
                  <a:cubicBezTo>
                    <a:pt x="424903" y="141960"/>
                    <a:pt x="440200" y="144578"/>
                    <a:pt x="442912" y="145256"/>
                  </a:cubicBezTo>
                  <a:cubicBezTo>
                    <a:pt x="455272" y="148346"/>
                    <a:pt x="445375" y="148068"/>
                    <a:pt x="461962" y="150019"/>
                  </a:cubicBezTo>
                  <a:cubicBezTo>
                    <a:pt x="471455" y="151136"/>
                    <a:pt x="481012" y="151606"/>
                    <a:pt x="490537" y="152400"/>
                  </a:cubicBezTo>
                  <a:cubicBezTo>
                    <a:pt x="508793" y="151606"/>
                    <a:pt x="527086" y="151420"/>
                    <a:pt x="545306" y="150019"/>
                  </a:cubicBezTo>
                  <a:cubicBezTo>
                    <a:pt x="553187" y="149413"/>
                    <a:pt x="552617" y="145975"/>
                    <a:pt x="559593" y="142875"/>
                  </a:cubicBezTo>
                  <a:cubicBezTo>
                    <a:pt x="564181" y="140836"/>
                    <a:pt x="573881" y="138113"/>
                    <a:pt x="573881" y="138113"/>
                  </a:cubicBezTo>
                  <a:cubicBezTo>
                    <a:pt x="578643" y="134938"/>
                    <a:pt x="584121" y="132635"/>
                    <a:pt x="588168" y="128588"/>
                  </a:cubicBezTo>
                  <a:cubicBezTo>
                    <a:pt x="590549" y="126207"/>
                    <a:pt x="593156" y="124031"/>
                    <a:pt x="595312" y="121444"/>
                  </a:cubicBezTo>
                  <a:cubicBezTo>
                    <a:pt x="597144" y="119245"/>
                    <a:pt x="598051" y="116324"/>
                    <a:pt x="600075" y="114300"/>
                  </a:cubicBezTo>
                  <a:cubicBezTo>
                    <a:pt x="602098" y="112277"/>
                    <a:pt x="604837" y="111125"/>
                    <a:pt x="607218" y="109538"/>
                  </a:cubicBezTo>
                  <a:cubicBezTo>
                    <a:pt x="612758" y="101227"/>
                    <a:pt x="616139" y="94132"/>
                    <a:pt x="623887" y="88106"/>
                  </a:cubicBezTo>
                  <a:cubicBezTo>
                    <a:pt x="628405" y="84592"/>
                    <a:pt x="632745" y="80391"/>
                    <a:pt x="638175" y="78581"/>
                  </a:cubicBezTo>
                  <a:lnTo>
                    <a:pt x="666750" y="69056"/>
                  </a:lnTo>
                  <a:lnTo>
                    <a:pt x="681037" y="64294"/>
                  </a:lnTo>
                  <a:cubicBezTo>
                    <a:pt x="683418" y="63500"/>
                    <a:pt x="685746" y="62522"/>
                    <a:pt x="688181" y="61913"/>
                  </a:cubicBezTo>
                  <a:cubicBezTo>
                    <a:pt x="694531" y="60325"/>
                    <a:pt x="701021" y="59220"/>
                    <a:pt x="707231" y="57150"/>
                  </a:cubicBezTo>
                  <a:cubicBezTo>
                    <a:pt x="711993" y="55563"/>
                    <a:pt x="716648" y="53606"/>
                    <a:pt x="721518" y="52388"/>
                  </a:cubicBezTo>
                  <a:cubicBezTo>
                    <a:pt x="724693" y="51594"/>
                    <a:pt x="727908" y="50946"/>
                    <a:pt x="731043" y="50006"/>
                  </a:cubicBezTo>
                  <a:cubicBezTo>
                    <a:pt x="735851" y="48563"/>
                    <a:pt x="740568" y="46831"/>
                    <a:pt x="745331" y="45244"/>
                  </a:cubicBezTo>
                  <a:lnTo>
                    <a:pt x="759618" y="40481"/>
                  </a:lnTo>
                  <a:cubicBezTo>
                    <a:pt x="785680" y="31793"/>
                    <a:pt x="746200" y="45652"/>
                    <a:pt x="773906" y="33338"/>
                  </a:cubicBezTo>
                  <a:cubicBezTo>
                    <a:pt x="778493" y="31299"/>
                    <a:pt x="784016" y="31359"/>
                    <a:pt x="788193" y="28575"/>
                  </a:cubicBezTo>
                  <a:cubicBezTo>
                    <a:pt x="799514" y="21029"/>
                    <a:pt x="792622" y="24718"/>
                    <a:pt x="809625" y="19050"/>
                  </a:cubicBezTo>
                  <a:lnTo>
                    <a:pt x="823912" y="14288"/>
                  </a:lnTo>
                  <a:lnTo>
                    <a:pt x="831056" y="11906"/>
                  </a:lnTo>
                  <a:cubicBezTo>
                    <a:pt x="843756" y="12700"/>
                    <a:pt x="856529" y="12710"/>
                    <a:pt x="869156" y="14288"/>
                  </a:cubicBezTo>
                  <a:cubicBezTo>
                    <a:pt x="875651" y="15100"/>
                    <a:pt x="881997" y="16980"/>
                    <a:pt x="888206" y="19050"/>
                  </a:cubicBezTo>
                  <a:lnTo>
                    <a:pt x="909637" y="26194"/>
                  </a:lnTo>
                  <a:lnTo>
                    <a:pt x="923925" y="30956"/>
                  </a:lnTo>
                  <a:cubicBezTo>
                    <a:pt x="926306" y="31750"/>
                    <a:pt x="928980" y="31946"/>
                    <a:pt x="931068" y="33338"/>
                  </a:cubicBezTo>
                  <a:cubicBezTo>
                    <a:pt x="947904" y="44561"/>
                    <a:pt x="927061" y="30476"/>
                    <a:pt x="947737" y="45244"/>
                  </a:cubicBezTo>
                  <a:cubicBezTo>
                    <a:pt x="950066" y="46907"/>
                    <a:pt x="952266" y="48844"/>
                    <a:pt x="954881" y="50006"/>
                  </a:cubicBezTo>
                  <a:cubicBezTo>
                    <a:pt x="959468" y="52045"/>
                    <a:pt x="964991" y="51985"/>
                    <a:pt x="969168" y="54769"/>
                  </a:cubicBezTo>
                  <a:cubicBezTo>
                    <a:pt x="971549" y="56356"/>
                    <a:pt x="973682" y="58404"/>
                    <a:pt x="976312" y="59531"/>
                  </a:cubicBezTo>
                  <a:cubicBezTo>
                    <a:pt x="979320" y="60820"/>
                    <a:pt x="982690" y="61014"/>
                    <a:pt x="985837" y="61913"/>
                  </a:cubicBezTo>
                  <a:cubicBezTo>
                    <a:pt x="988251" y="62603"/>
                    <a:pt x="990546" y="63685"/>
                    <a:pt x="992981" y="64294"/>
                  </a:cubicBezTo>
                  <a:cubicBezTo>
                    <a:pt x="996907" y="65276"/>
                    <a:pt x="1000982" y="65610"/>
                    <a:pt x="1004887" y="66675"/>
                  </a:cubicBezTo>
                  <a:cubicBezTo>
                    <a:pt x="1009730" y="67996"/>
                    <a:pt x="1014412" y="69850"/>
                    <a:pt x="1019175" y="71438"/>
                  </a:cubicBezTo>
                  <a:cubicBezTo>
                    <a:pt x="1027895" y="74345"/>
                    <a:pt x="1035965" y="77237"/>
                    <a:pt x="1045368" y="78581"/>
                  </a:cubicBezTo>
                  <a:cubicBezTo>
                    <a:pt x="1057588" y="80327"/>
                    <a:pt x="1062630" y="80734"/>
                    <a:pt x="1073943" y="83344"/>
                  </a:cubicBezTo>
                  <a:cubicBezTo>
                    <a:pt x="1080321" y="84816"/>
                    <a:pt x="1086784" y="86036"/>
                    <a:pt x="1092993" y="88106"/>
                  </a:cubicBezTo>
                  <a:cubicBezTo>
                    <a:pt x="1097756" y="89694"/>
                    <a:pt x="1102411" y="91652"/>
                    <a:pt x="1107281" y="92869"/>
                  </a:cubicBezTo>
                  <a:lnTo>
                    <a:pt x="1126331" y="97631"/>
                  </a:lnTo>
                  <a:cubicBezTo>
                    <a:pt x="1129506" y="98425"/>
                    <a:pt x="1132751" y="98978"/>
                    <a:pt x="1135856" y="100013"/>
                  </a:cubicBezTo>
                  <a:cubicBezTo>
                    <a:pt x="1138237" y="100807"/>
                    <a:pt x="1140550" y="101850"/>
                    <a:pt x="1143000" y="102394"/>
                  </a:cubicBezTo>
                  <a:cubicBezTo>
                    <a:pt x="1148949" y="103716"/>
                    <a:pt x="1168637" y="106396"/>
                    <a:pt x="1173956" y="107156"/>
                  </a:cubicBezTo>
                  <a:cubicBezTo>
                    <a:pt x="1187362" y="111626"/>
                    <a:pt x="1180199" y="109792"/>
                    <a:pt x="1202531" y="111919"/>
                  </a:cubicBezTo>
                  <a:cubicBezTo>
                    <a:pt x="1212046" y="112825"/>
                    <a:pt x="1221581" y="113506"/>
                    <a:pt x="1231106" y="114300"/>
                  </a:cubicBezTo>
                  <a:cubicBezTo>
                    <a:pt x="1234281" y="115094"/>
                    <a:pt x="1237436" y="115971"/>
                    <a:pt x="1240631" y="116681"/>
                  </a:cubicBezTo>
                  <a:cubicBezTo>
                    <a:pt x="1244582" y="117559"/>
                    <a:pt x="1248632" y="117998"/>
                    <a:pt x="1252537" y="119063"/>
                  </a:cubicBezTo>
                  <a:cubicBezTo>
                    <a:pt x="1257380" y="120384"/>
                    <a:pt x="1261955" y="122608"/>
                    <a:pt x="1266825" y="123825"/>
                  </a:cubicBezTo>
                  <a:cubicBezTo>
                    <a:pt x="1270000" y="124619"/>
                    <a:pt x="1273203" y="125307"/>
                    <a:pt x="1276350" y="126206"/>
                  </a:cubicBezTo>
                  <a:cubicBezTo>
                    <a:pt x="1278763" y="126896"/>
                    <a:pt x="1281058" y="127979"/>
                    <a:pt x="1283493" y="128588"/>
                  </a:cubicBezTo>
                  <a:cubicBezTo>
                    <a:pt x="1300787" y="132912"/>
                    <a:pt x="1290629" y="129115"/>
                    <a:pt x="1309687" y="133350"/>
                  </a:cubicBezTo>
                  <a:cubicBezTo>
                    <a:pt x="1312137" y="133894"/>
                    <a:pt x="1314417" y="135041"/>
                    <a:pt x="1316831" y="135731"/>
                  </a:cubicBezTo>
                  <a:cubicBezTo>
                    <a:pt x="1319978" y="136630"/>
                    <a:pt x="1323209" y="137214"/>
                    <a:pt x="1326356" y="138113"/>
                  </a:cubicBezTo>
                  <a:cubicBezTo>
                    <a:pt x="1337584" y="141321"/>
                    <a:pt x="1333788" y="142257"/>
                    <a:pt x="1350168" y="142875"/>
                  </a:cubicBezTo>
                  <a:cubicBezTo>
                    <a:pt x="1386663" y="144252"/>
                    <a:pt x="1423193" y="144462"/>
                    <a:pt x="1459706" y="145256"/>
                  </a:cubicBezTo>
                  <a:cubicBezTo>
                    <a:pt x="1465262" y="146050"/>
                    <a:pt x="1470871" y="146537"/>
                    <a:pt x="1476375" y="147638"/>
                  </a:cubicBezTo>
                  <a:cubicBezTo>
                    <a:pt x="1478836" y="148130"/>
                    <a:pt x="1481057" y="149527"/>
                    <a:pt x="1483518" y="150019"/>
                  </a:cubicBezTo>
                  <a:cubicBezTo>
                    <a:pt x="1489022" y="151120"/>
                    <a:pt x="1494683" y="151299"/>
                    <a:pt x="1500187" y="152400"/>
                  </a:cubicBezTo>
                  <a:cubicBezTo>
                    <a:pt x="1506605" y="153684"/>
                    <a:pt x="1512887" y="155575"/>
                    <a:pt x="1519237" y="157163"/>
                  </a:cubicBezTo>
                  <a:cubicBezTo>
                    <a:pt x="1531202" y="160154"/>
                    <a:pt x="1525653" y="158508"/>
                    <a:pt x="1535906" y="161925"/>
                  </a:cubicBezTo>
                  <a:cubicBezTo>
                    <a:pt x="1540668" y="165100"/>
                    <a:pt x="1547018" y="166688"/>
                    <a:pt x="1550193" y="171450"/>
                  </a:cubicBezTo>
                  <a:cubicBezTo>
                    <a:pt x="1558927" y="184550"/>
                    <a:pt x="1550191" y="173432"/>
                    <a:pt x="1562100" y="183356"/>
                  </a:cubicBezTo>
                  <a:cubicBezTo>
                    <a:pt x="1564687" y="185512"/>
                    <a:pt x="1566656" y="188344"/>
                    <a:pt x="1569243" y="190500"/>
                  </a:cubicBezTo>
                  <a:cubicBezTo>
                    <a:pt x="1571442" y="192332"/>
                    <a:pt x="1574058" y="193599"/>
                    <a:pt x="1576387" y="195263"/>
                  </a:cubicBezTo>
                  <a:cubicBezTo>
                    <a:pt x="1578898" y="197056"/>
                    <a:pt x="1589320" y="205301"/>
                    <a:pt x="1593056" y="207169"/>
                  </a:cubicBezTo>
                  <a:cubicBezTo>
                    <a:pt x="1595301" y="208292"/>
                    <a:pt x="1597819" y="208756"/>
                    <a:pt x="1600200" y="209550"/>
                  </a:cubicBezTo>
                  <a:cubicBezTo>
                    <a:pt x="1602581" y="211138"/>
                    <a:pt x="1604858" y="212893"/>
                    <a:pt x="1607343" y="214313"/>
                  </a:cubicBezTo>
                  <a:cubicBezTo>
                    <a:pt x="1610425" y="216074"/>
                    <a:pt x="1613858" y="217194"/>
                    <a:pt x="1616868" y="219075"/>
                  </a:cubicBezTo>
                  <a:cubicBezTo>
                    <a:pt x="1620234" y="221178"/>
                    <a:pt x="1622843" y="224444"/>
                    <a:pt x="1626393" y="226219"/>
                  </a:cubicBezTo>
                  <a:cubicBezTo>
                    <a:pt x="1630883" y="228464"/>
                    <a:pt x="1636191" y="228736"/>
                    <a:pt x="1640681" y="230981"/>
                  </a:cubicBezTo>
                  <a:cubicBezTo>
                    <a:pt x="1647031" y="234156"/>
                    <a:pt x="1652640" y="240151"/>
                    <a:pt x="1659731" y="240506"/>
                  </a:cubicBezTo>
                  <a:lnTo>
                    <a:pt x="1707356" y="242888"/>
                  </a:lnTo>
                  <a:cubicBezTo>
                    <a:pt x="1713166" y="244824"/>
                    <a:pt x="1717027" y="245415"/>
                    <a:pt x="1721643" y="250031"/>
                  </a:cubicBezTo>
                  <a:cubicBezTo>
                    <a:pt x="1723667" y="252055"/>
                    <a:pt x="1724207" y="255343"/>
                    <a:pt x="1726406" y="257175"/>
                  </a:cubicBezTo>
                  <a:cubicBezTo>
                    <a:pt x="1729133" y="259448"/>
                    <a:pt x="1732849" y="260177"/>
                    <a:pt x="1735931" y="261938"/>
                  </a:cubicBezTo>
                  <a:cubicBezTo>
                    <a:pt x="1738416" y="263358"/>
                    <a:pt x="1740746" y="265037"/>
                    <a:pt x="1743075" y="266700"/>
                  </a:cubicBezTo>
                  <a:cubicBezTo>
                    <a:pt x="1746305" y="269007"/>
                    <a:pt x="1749154" y="271875"/>
                    <a:pt x="1752600" y="273844"/>
                  </a:cubicBezTo>
                  <a:cubicBezTo>
                    <a:pt x="1754779" y="275089"/>
                    <a:pt x="1757362" y="275431"/>
                    <a:pt x="1759743" y="276225"/>
                  </a:cubicBezTo>
                  <a:cubicBezTo>
                    <a:pt x="1782533" y="299015"/>
                    <a:pt x="1753353" y="271965"/>
                    <a:pt x="1774031" y="285750"/>
                  </a:cubicBezTo>
                  <a:cubicBezTo>
                    <a:pt x="1776833" y="287618"/>
                    <a:pt x="1778588" y="290738"/>
                    <a:pt x="1781175" y="292894"/>
                  </a:cubicBezTo>
                  <a:cubicBezTo>
                    <a:pt x="1787329" y="298022"/>
                    <a:pt x="1788303" y="297651"/>
                    <a:pt x="1795462" y="300038"/>
                  </a:cubicBezTo>
                  <a:cubicBezTo>
                    <a:pt x="1799544" y="303099"/>
                    <a:pt x="1807262" y="309162"/>
                    <a:pt x="1812131" y="311944"/>
                  </a:cubicBezTo>
                  <a:cubicBezTo>
                    <a:pt x="1820366" y="316650"/>
                    <a:pt x="1820788" y="316417"/>
                    <a:pt x="1828800" y="319088"/>
                  </a:cubicBezTo>
                  <a:cubicBezTo>
                    <a:pt x="1834940" y="318211"/>
                    <a:pt x="1845963" y="317649"/>
                    <a:pt x="1852612" y="314325"/>
                  </a:cubicBezTo>
                  <a:cubicBezTo>
                    <a:pt x="1855172" y="313045"/>
                    <a:pt x="1857196" y="310843"/>
                    <a:pt x="1859756" y="309563"/>
                  </a:cubicBezTo>
                  <a:cubicBezTo>
                    <a:pt x="1862001" y="308440"/>
                    <a:pt x="1864655" y="308304"/>
                    <a:pt x="1866900" y="307181"/>
                  </a:cubicBezTo>
                  <a:cubicBezTo>
                    <a:pt x="1869459" y="305901"/>
                    <a:pt x="1871413" y="303546"/>
                    <a:pt x="1874043" y="302419"/>
                  </a:cubicBezTo>
                  <a:cubicBezTo>
                    <a:pt x="1877051" y="301130"/>
                    <a:pt x="1880421" y="300937"/>
                    <a:pt x="1883568" y="300038"/>
                  </a:cubicBezTo>
                  <a:cubicBezTo>
                    <a:pt x="1885982" y="299348"/>
                    <a:pt x="1888331" y="298450"/>
                    <a:pt x="1890712" y="297656"/>
                  </a:cubicBezTo>
                  <a:cubicBezTo>
                    <a:pt x="1897062" y="298450"/>
                    <a:pt x="1903450" y="298986"/>
                    <a:pt x="1909762" y="300038"/>
                  </a:cubicBezTo>
                  <a:cubicBezTo>
                    <a:pt x="1912990" y="300576"/>
                    <a:pt x="1916140" y="301520"/>
                    <a:pt x="1919287" y="302419"/>
                  </a:cubicBezTo>
                  <a:cubicBezTo>
                    <a:pt x="1921701" y="303109"/>
                    <a:pt x="1923970" y="304308"/>
                    <a:pt x="1926431" y="304800"/>
                  </a:cubicBezTo>
                  <a:cubicBezTo>
                    <a:pt x="1927988" y="305111"/>
                    <a:pt x="1929606" y="304800"/>
                    <a:pt x="1931193" y="304800"/>
                  </a:cubicBezTo>
                </a:path>
              </a:pathLst>
            </a:custGeom>
            <a:noFill/>
            <a:ln w="38100">
              <a:solidFill>
                <a:schemeClr val="bg1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9666"/>
            </a:p>
          </p:txBody>
        </p:sp>
        <p:sp>
          <p:nvSpPr>
            <p:cNvPr id="243" name="Freeform 242"/>
            <p:cNvSpPr/>
            <p:nvPr/>
          </p:nvSpPr>
          <p:spPr>
            <a:xfrm>
              <a:off x="6866417" y="3356945"/>
              <a:ext cx="1781214" cy="278477"/>
            </a:xfrm>
            <a:custGeom>
              <a:avLst/>
              <a:gdLst>
                <a:gd name="connsiteX0" fmla="*/ 0 w 1926431"/>
                <a:gd name="connsiteY0" fmla="*/ 0 h 300184"/>
                <a:gd name="connsiteX1" fmla="*/ 30956 w 1926431"/>
                <a:gd name="connsiteY1" fmla="*/ 4763 h 300184"/>
                <a:gd name="connsiteX2" fmla="*/ 45244 w 1926431"/>
                <a:gd name="connsiteY2" fmla="*/ 7144 h 300184"/>
                <a:gd name="connsiteX3" fmla="*/ 52388 w 1926431"/>
                <a:gd name="connsiteY3" fmla="*/ 9525 h 300184"/>
                <a:gd name="connsiteX4" fmla="*/ 71438 w 1926431"/>
                <a:gd name="connsiteY4" fmla="*/ 11907 h 300184"/>
                <a:gd name="connsiteX5" fmla="*/ 83344 w 1926431"/>
                <a:gd name="connsiteY5" fmla="*/ 14288 h 300184"/>
                <a:gd name="connsiteX6" fmla="*/ 90488 w 1926431"/>
                <a:gd name="connsiteY6" fmla="*/ 16669 h 300184"/>
                <a:gd name="connsiteX7" fmla="*/ 126206 w 1926431"/>
                <a:gd name="connsiteY7" fmla="*/ 21432 h 300184"/>
                <a:gd name="connsiteX8" fmla="*/ 147638 w 1926431"/>
                <a:gd name="connsiteY8" fmla="*/ 26194 h 300184"/>
                <a:gd name="connsiteX9" fmla="*/ 157163 w 1926431"/>
                <a:gd name="connsiteY9" fmla="*/ 28575 h 300184"/>
                <a:gd name="connsiteX10" fmla="*/ 169069 w 1926431"/>
                <a:gd name="connsiteY10" fmla="*/ 30957 h 300184"/>
                <a:gd name="connsiteX11" fmla="*/ 183356 w 1926431"/>
                <a:gd name="connsiteY11" fmla="*/ 35719 h 300184"/>
                <a:gd name="connsiteX12" fmla="*/ 190500 w 1926431"/>
                <a:gd name="connsiteY12" fmla="*/ 38100 h 300184"/>
                <a:gd name="connsiteX13" fmla="*/ 211931 w 1926431"/>
                <a:gd name="connsiteY13" fmla="*/ 45244 h 300184"/>
                <a:gd name="connsiteX14" fmla="*/ 219075 w 1926431"/>
                <a:gd name="connsiteY14" fmla="*/ 47625 h 300184"/>
                <a:gd name="connsiteX15" fmla="*/ 226219 w 1926431"/>
                <a:gd name="connsiteY15" fmla="*/ 52388 h 300184"/>
                <a:gd name="connsiteX16" fmla="*/ 240506 w 1926431"/>
                <a:gd name="connsiteY16" fmla="*/ 57150 h 300184"/>
                <a:gd name="connsiteX17" fmla="*/ 247650 w 1926431"/>
                <a:gd name="connsiteY17" fmla="*/ 61913 h 300184"/>
                <a:gd name="connsiteX18" fmla="*/ 261938 w 1926431"/>
                <a:gd name="connsiteY18" fmla="*/ 66675 h 300184"/>
                <a:gd name="connsiteX19" fmla="*/ 269081 w 1926431"/>
                <a:gd name="connsiteY19" fmla="*/ 71438 h 300184"/>
                <a:gd name="connsiteX20" fmla="*/ 292894 w 1926431"/>
                <a:gd name="connsiteY20" fmla="*/ 78582 h 300184"/>
                <a:gd name="connsiteX21" fmla="*/ 309563 w 1926431"/>
                <a:gd name="connsiteY21" fmla="*/ 83344 h 300184"/>
                <a:gd name="connsiteX22" fmla="*/ 335756 w 1926431"/>
                <a:gd name="connsiteY22" fmla="*/ 92869 h 300184"/>
                <a:gd name="connsiteX23" fmla="*/ 357188 w 1926431"/>
                <a:gd name="connsiteY23" fmla="*/ 100013 h 300184"/>
                <a:gd name="connsiteX24" fmla="*/ 364331 w 1926431"/>
                <a:gd name="connsiteY24" fmla="*/ 102394 h 300184"/>
                <a:gd name="connsiteX25" fmla="*/ 378619 w 1926431"/>
                <a:gd name="connsiteY25" fmla="*/ 104775 h 300184"/>
                <a:gd name="connsiteX26" fmla="*/ 402431 w 1926431"/>
                <a:gd name="connsiteY26" fmla="*/ 111919 h 300184"/>
                <a:gd name="connsiteX27" fmla="*/ 426244 w 1926431"/>
                <a:gd name="connsiteY27" fmla="*/ 119063 h 300184"/>
                <a:gd name="connsiteX28" fmla="*/ 514350 w 1926431"/>
                <a:gd name="connsiteY28" fmla="*/ 126207 h 300184"/>
                <a:gd name="connsiteX29" fmla="*/ 597694 w 1926431"/>
                <a:gd name="connsiteY29" fmla="*/ 121444 h 300184"/>
                <a:gd name="connsiteX30" fmla="*/ 604838 w 1926431"/>
                <a:gd name="connsiteY30" fmla="*/ 119063 h 300184"/>
                <a:gd name="connsiteX31" fmla="*/ 626269 w 1926431"/>
                <a:gd name="connsiteY31" fmla="*/ 104775 h 300184"/>
                <a:gd name="connsiteX32" fmla="*/ 640556 w 1926431"/>
                <a:gd name="connsiteY32" fmla="*/ 95250 h 300184"/>
                <a:gd name="connsiteX33" fmla="*/ 654844 w 1926431"/>
                <a:gd name="connsiteY33" fmla="*/ 85725 h 300184"/>
                <a:gd name="connsiteX34" fmla="*/ 661988 w 1926431"/>
                <a:gd name="connsiteY34" fmla="*/ 78582 h 300184"/>
                <a:gd name="connsiteX35" fmla="*/ 669131 w 1926431"/>
                <a:gd name="connsiteY35" fmla="*/ 73819 h 300184"/>
                <a:gd name="connsiteX36" fmla="*/ 673894 w 1926431"/>
                <a:gd name="connsiteY36" fmla="*/ 66675 h 300184"/>
                <a:gd name="connsiteX37" fmla="*/ 688181 w 1926431"/>
                <a:gd name="connsiteY37" fmla="*/ 59532 h 300184"/>
                <a:gd name="connsiteX38" fmla="*/ 711994 w 1926431"/>
                <a:gd name="connsiteY38" fmla="*/ 42863 h 300184"/>
                <a:gd name="connsiteX39" fmla="*/ 719138 w 1926431"/>
                <a:gd name="connsiteY39" fmla="*/ 38100 h 300184"/>
                <a:gd name="connsiteX40" fmla="*/ 740569 w 1926431"/>
                <a:gd name="connsiteY40" fmla="*/ 30957 h 300184"/>
                <a:gd name="connsiteX41" fmla="*/ 747713 w 1926431"/>
                <a:gd name="connsiteY41" fmla="*/ 28575 h 300184"/>
                <a:gd name="connsiteX42" fmla="*/ 766763 w 1926431"/>
                <a:gd name="connsiteY42" fmla="*/ 23813 h 300184"/>
                <a:gd name="connsiteX43" fmla="*/ 788194 w 1926431"/>
                <a:gd name="connsiteY43" fmla="*/ 16669 h 300184"/>
                <a:gd name="connsiteX44" fmla="*/ 795338 w 1926431"/>
                <a:gd name="connsiteY44" fmla="*/ 14288 h 300184"/>
                <a:gd name="connsiteX45" fmla="*/ 809625 w 1926431"/>
                <a:gd name="connsiteY45" fmla="*/ 11907 h 300184"/>
                <a:gd name="connsiteX46" fmla="*/ 819150 w 1926431"/>
                <a:gd name="connsiteY46" fmla="*/ 9525 h 300184"/>
                <a:gd name="connsiteX47" fmla="*/ 842963 w 1926431"/>
                <a:gd name="connsiteY47" fmla="*/ 4763 h 300184"/>
                <a:gd name="connsiteX48" fmla="*/ 890588 w 1926431"/>
                <a:gd name="connsiteY48" fmla="*/ 7144 h 300184"/>
                <a:gd name="connsiteX49" fmla="*/ 916781 w 1926431"/>
                <a:gd name="connsiteY49" fmla="*/ 14288 h 300184"/>
                <a:gd name="connsiteX50" fmla="*/ 942975 w 1926431"/>
                <a:gd name="connsiteY50" fmla="*/ 21432 h 300184"/>
                <a:gd name="connsiteX51" fmla="*/ 964406 w 1926431"/>
                <a:gd name="connsiteY51" fmla="*/ 35719 h 300184"/>
                <a:gd name="connsiteX52" fmla="*/ 971550 w 1926431"/>
                <a:gd name="connsiteY52" fmla="*/ 40482 h 300184"/>
                <a:gd name="connsiteX53" fmla="*/ 985838 w 1926431"/>
                <a:gd name="connsiteY53" fmla="*/ 45244 h 300184"/>
                <a:gd name="connsiteX54" fmla="*/ 1007269 w 1926431"/>
                <a:gd name="connsiteY54" fmla="*/ 54769 h 300184"/>
                <a:gd name="connsiteX55" fmla="*/ 1014413 w 1926431"/>
                <a:gd name="connsiteY55" fmla="*/ 57150 h 300184"/>
                <a:gd name="connsiteX56" fmla="*/ 1033463 w 1926431"/>
                <a:gd name="connsiteY56" fmla="*/ 61913 h 300184"/>
                <a:gd name="connsiteX57" fmla="*/ 1052513 w 1926431"/>
                <a:gd name="connsiteY57" fmla="*/ 66675 h 300184"/>
                <a:gd name="connsiteX58" fmla="*/ 1062038 w 1926431"/>
                <a:gd name="connsiteY58" fmla="*/ 69057 h 300184"/>
                <a:gd name="connsiteX59" fmla="*/ 1076325 w 1926431"/>
                <a:gd name="connsiteY59" fmla="*/ 71438 h 300184"/>
                <a:gd name="connsiteX60" fmla="*/ 1090613 w 1926431"/>
                <a:gd name="connsiteY60" fmla="*/ 76200 h 300184"/>
                <a:gd name="connsiteX61" fmla="*/ 1104900 w 1926431"/>
                <a:gd name="connsiteY61" fmla="*/ 78582 h 300184"/>
                <a:gd name="connsiteX62" fmla="*/ 1126331 w 1926431"/>
                <a:gd name="connsiteY62" fmla="*/ 85725 h 300184"/>
                <a:gd name="connsiteX63" fmla="*/ 1133475 w 1926431"/>
                <a:gd name="connsiteY63" fmla="*/ 88107 h 300184"/>
                <a:gd name="connsiteX64" fmla="*/ 1147763 w 1926431"/>
                <a:gd name="connsiteY64" fmla="*/ 90488 h 300184"/>
                <a:gd name="connsiteX65" fmla="*/ 1164431 w 1926431"/>
                <a:gd name="connsiteY65" fmla="*/ 92869 h 300184"/>
                <a:gd name="connsiteX66" fmla="*/ 1173956 w 1926431"/>
                <a:gd name="connsiteY66" fmla="*/ 95250 h 300184"/>
                <a:gd name="connsiteX67" fmla="*/ 1185863 w 1926431"/>
                <a:gd name="connsiteY67" fmla="*/ 97632 h 300184"/>
                <a:gd name="connsiteX68" fmla="*/ 1195388 w 1926431"/>
                <a:gd name="connsiteY68" fmla="*/ 100013 h 300184"/>
                <a:gd name="connsiteX69" fmla="*/ 1231106 w 1926431"/>
                <a:gd name="connsiteY69" fmla="*/ 102394 h 300184"/>
                <a:gd name="connsiteX70" fmla="*/ 1252538 w 1926431"/>
                <a:gd name="connsiteY70" fmla="*/ 107157 h 300184"/>
                <a:gd name="connsiteX71" fmla="*/ 1293019 w 1926431"/>
                <a:gd name="connsiteY71" fmla="*/ 111919 h 300184"/>
                <a:gd name="connsiteX72" fmla="*/ 1316831 w 1926431"/>
                <a:gd name="connsiteY72" fmla="*/ 116682 h 300184"/>
                <a:gd name="connsiteX73" fmla="*/ 1328738 w 1926431"/>
                <a:gd name="connsiteY73" fmla="*/ 119063 h 300184"/>
                <a:gd name="connsiteX74" fmla="*/ 1347788 w 1926431"/>
                <a:gd name="connsiteY74" fmla="*/ 123825 h 300184"/>
                <a:gd name="connsiteX75" fmla="*/ 1362075 w 1926431"/>
                <a:gd name="connsiteY75" fmla="*/ 126207 h 300184"/>
                <a:gd name="connsiteX76" fmla="*/ 1378744 w 1926431"/>
                <a:gd name="connsiteY76" fmla="*/ 128588 h 300184"/>
                <a:gd name="connsiteX77" fmla="*/ 1388269 w 1926431"/>
                <a:gd name="connsiteY77" fmla="*/ 130969 h 300184"/>
                <a:gd name="connsiteX78" fmla="*/ 1454944 w 1926431"/>
                <a:gd name="connsiteY78" fmla="*/ 135732 h 300184"/>
                <a:gd name="connsiteX79" fmla="*/ 1481138 w 1926431"/>
                <a:gd name="connsiteY79" fmla="*/ 140494 h 300184"/>
                <a:gd name="connsiteX80" fmla="*/ 1504950 w 1926431"/>
                <a:gd name="connsiteY80" fmla="*/ 145257 h 300184"/>
                <a:gd name="connsiteX81" fmla="*/ 1516856 w 1926431"/>
                <a:gd name="connsiteY81" fmla="*/ 147638 h 300184"/>
                <a:gd name="connsiteX82" fmla="*/ 1524000 w 1926431"/>
                <a:gd name="connsiteY82" fmla="*/ 150019 h 300184"/>
                <a:gd name="connsiteX83" fmla="*/ 1535906 w 1926431"/>
                <a:gd name="connsiteY83" fmla="*/ 152400 h 300184"/>
                <a:gd name="connsiteX84" fmla="*/ 1550194 w 1926431"/>
                <a:gd name="connsiteY84" fmla="*/ 159544 h 300184"/>
                <a:gd name="connsiteX85" fmla="*/ 1557338 w 1926431"/>
                <a:gd name="connsiteY85" fmla="*/ 161925 h 300184"/>
                <a:gd name="connsiteX86" fmla="*/ 1576388 w 1926431"/>
                <a:gd name="connsiteY86" fmla="*/ 173832 h 300184"/>
                <a:gd name="connsiteX87" fmla="*/ 1593056 w 1926431"/>
                <a:gd name="connsiteY87" fmla="*/ 185738 h 300184"/>
                <a:gd name="connsiteX88" fmla="*/ 1619250 w 1926431"/>
                <a:gd name="connsiteY88" fmla="*/ 197644 h 300184"/>
                <a:gd name="connsiteX89" fmla="*/ 1626394 w 1926431"/>
                <a:gd name="connsiteY89" fmla="*/ 202407 h 300184"/>
                <a:gd name="connsiteX90" fmla="*/ 1640681 w 1926431"/>
                <a:gd name="connsiteY90" fmla="*/ 207169 h 300184"/>
                <a:gd name="connsiteX91" fmla="*/ 1647825 w 1926431"/>
                <a:gd name="connsiteY91" fmla="*/ 211932 h 300184"/>
                <a:gd name="connsiteX92" fmla="*/ 1664494 w 1926431"/>
                <a:gd name="connsiteY92" fmla="*/ 216694 h 300184"/>
                <a:gd name="connsiteX93" fmla="*/ 1674019 w 1926431"/>
                <a:gd name="connsiteY93" fmla="*/ 221457 h 300184"/>
                <a:gd name="connsiteX94" fmla="*/ 1685925 w 1926431"/>
                <a:gd name="connsiteY94" fmla="*/ 223838 h 300184"/>
                <a:gd name="connsiteX95" fmla="*/ 1693069 w 1926431"/>
                <a:gd name="connsiteY95" fmla="*/ 226219 h 300184"/>
                <a:gd name="connsiteX96" fmla="*/ 1702594 w 1926431"/>
                <a:gd name="connsiteY96" fmla="*/ 228600 h 300184"/>
                <a:gd name="connsiteX97" fmla="*/ 1709738 w 1926431"/>
                <a:gd name="connsiteY97" fmla="*/ 233363 h 300184"/>
                <a:gd name="connsiteX98" fmla="*/ 1716881 w 1926431"/>
                <a:gd name="connsiteY98" fmla="*/ 235744 h 300184"/>
                <a:gd name="connsiteX99" fmla="*/ 1733550 w 1926431"/>
                <a:gd name="connsiteY99" fmla="*/ 250032 h 300184"/>
                <a:gd name="connsiteX100" fmla="*/ 1743075 w 1926431"/>
                <a:gd name="connsiteY100" fmla="*/ 252413 h 300184"/>
                <a:gd name="connsiteX101" fmla="*/ 1757363 w 1926431"/>
                <a:gd name="connsiteY101" fmla="*/ 261938 h 300184"/>
                <a:gd name="connsiteX102" fmla="*/ 1778794 w 1926431"/>
                <a:gd name="connsiteY102" fmla="*/ 273844 h 300184"/>
                <a:gd name="connsiteX103" fmla="*/ 1785938 w 1926431"/>
                <a:gd name="connsiteY103" fmla="*/ 278607 h 300184"/>
                <a:gd name="connsiteX104" fmla="*/ 1800225 w 1926431"/>
                <a:gd name="connsiteY104" fmla="*/ 283369 h 300184"/>
                <a:gd name="connsiteX105" fmla="*/ 1814513 w 1926431"/>
                <a:gd name="connsiteY105" fmla="*/ 288132 h 300184"/>
                <a:gd name="connsiteX106" fmla="*/ 1828800 w 1926431"/>
                <a:gd name="connsiteY106" fmla="*/ 292894 h 300184"/>
                <a:gd name="connsiteX107" fmla="*/ 1883569 w 1926431"/>
                <a:gd name="connsiteY107" fmla="*/ 295275 h 300184"/>
                <a:gd name="connsiteX108" fmla="*/ 1914525 w 1926431"/>
                <a:gd name="connsiteY108" fmla="*/ 300038 h 300184"/>
                <a:gd name="connsiteX109" fmla="*/ 1926431 w 1926431"/>
                <a:gd name="connsiteY109" fmla="*/ 300038 h 300184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  <a:cxn ang="0">
                  <a:pos x="connsiteX29" y="connsiteY29"/>
                </a:cxn>
                <a:cxn ang="0">
                  <a:pos x="connsiteX30" y="connsiteY30"/>
                </a:cxn>
                <a:cxn ang="0">
                  <a:pos x="connsiteX31" y="connsiteY31"/>
                </a:cxn>
                <a:cxn ang="0">
                  <a:pos x="connsiteX32" y="connsiteY32"/>
                </a:cxn>
                <a:cxn ang="0">
                  <a:pos x="connsiteX33" y="connsiteY33"/>
                </a:cxn>
                <a:cxn ang="0">
                  <a:pos x="connsiteX34" y="connsiteY34"/>
                </a:cxn>
                <a:cxn ang="0">
                  <a:pos x="connsiteX35" y="connsiteY35"/>
                </a:cxn>
                <a:cxn ang="0">
                  <a:pos x="connsiteX36" y="connsiteY36"/>
                </a:cxn>
                <a:cxn ang="0">
                  <a:pos x="connsiteX37" y="connsiteY37"/>
                </a:cxn>
                <a:cxn ang="0">
                  <a:pos x="connsiteX38" y="connsiteY38"/>
                </a:cxn>
                <a:cxn ang="0">
                  <a:pos x="connsiteX39" y="connsiteY39"/>
                </a:cxn>
                <a:cxn ang="0">
                  <a:pos x="connsiteX40" y="connsiteY40"/>
                </a:cxn>
                <a:cxn ang="0">
                  <a:pos x="connsiteX41" y="connsiteY41"/>
                </a:cxn>
                <a:cxn ang="0">
                  <a:pos x="connsiteX42" y="connsiteY42"/>
                </a:cxn>
                <a:cxn ang="0">
                  <a:pos x="connsiteX43" y="connsiteY43"/>
                </a:cxn>
                <a:cxn ang="0">
                  <a:pos x="connsiteX44" y="connsiteY44"/>
                </a:cxn>
                <a:cxn ang="0">
                  <a:pos x="connsiteX45" y="connsiteY45"/>
                </a:cxn>
                <a:cxn ang="0">
                  <a:pos x="connsiteX46" y="connsiteY46"/>
                </a:cxn>
                <a:cxn ang="0">
                  <a:pos x="connsiteX47" y="connsiteY47"/>
                </a:cxn>
                <a:cxn ang="0">
                  <a:pos x="connsiteX48" y="connsiteY48"/>
                </a:cxn>
                <a:cxn ang="0">
                  <a:pos x="connsiteX49" y="connsiteY49"/>
                </a:cxn>
                <a:cxn ang="0">
                  <a:pos x="connsiteX50" y="connsiteY50"/>
                </a:cxn>
                <a:cxn ang="0">
                  <a:pos x="connsiteX51" y="connsiteY51"/>
                </a:cxn>
                <a:cxn ang="0">
                  <a:pos x="connsiteX52" y="connsiteY52"/>
                </a:cxn>
                <a:cxn ang="0">
                  <a:pos x="connsiteX53" y="connsiteY53"/>
                </a:cxn>
                <a:cxn ang="0">
                  <a:pos x="connsiteX54" y="connsiteY54"/>
                </a:cxn>
                <a:cxn ang="0">
                  <a:pos x="connsiteX55" y="connsiteY55"/>
                </a:cxn>
                <a:cxn ang="0">
                  <a:pos x="connsiteX56" y="connsiteY56"/>
                </a:cxn>
                <a:cxn ang="0">
                  <a:pos x="connsiteX57" y="connsiteY57"/>
                </a:cxn>
                <a:cxn ang="0">
                  <a:pos x="connsiteX58" y="connsiteY58"/>
                </a:cxn>
                <a:cxn ang="0">
                  <a:pos x="connsiteX59" y="connsiteY59"/>
                </a:cxn>
                <a:cxn ang="0">
                  <a:pos x="connsiteX60" y="connsiteY60"/>
                </a:cxn>
                <a:cxn ang="0">
                  <a:pos x="connsiteX61" y="connsiteY61"/>
                </a:cxn>
                <a:cxn ang="0">
                  <a:pos x="connsiteX62" y="connsiteY62"/>
                </a:cxn>
                <a:cxn ang="0">
                  <a:pos x="connsiteX63" y="connsiteY63"/>
                </a:cxn>
                <a:cxn ang="0">
                  <a:pos x="connsiteX64" y="connsiteY64"/>
                </a:cxn>
                <a:cxn ang="0">
                  <a:pos x="connsiteX65" y="connsiteY65"/>
                </a:cxn>
                <a:cxn ang="0">
                  <a:pos x="connsiteX66" y="connsiteY66"/>
                </a:cxn>
                <a:cxn ang="0">
                  <a:pos x="connsiteX67" y="connsiteY67"/>
                </a:cxn>
                <a:cxn ang="0">
                  <a:pos x="connsiteX68" y="connsiteY68"/>
                </a:cxn>
                <a:cxn ang="0">
                  <a:pos x="connsiteX69" y="connsiteY69"/>
                </a:cxn>
                <a:cxn ang="0">
                  <a:pos x="connsiteX70" y="connsiteY70"/>
                </a:cxn>
                <a:cxn ang="0">
                  <a:pos x="connsiteX71" y="connsiteY71"/>
                </a:cxn>
                <a:cxn ang="0">
                  <a:pos x="connsiteX72" y="connsiteY72"/>
                </a:cxn>
                <a:cxn ang="0">
                  <a:pos x="connsiteX73" y="connsiteY73"/>
                </a:cxn>
                <a:cxn ang="0">
                  <a:pos x="connsiteX74" y="connsiteY74"/>
                </a:cxn>
                <a:cxn ang="0">
                  <a:pos x="connsiteX75" y="connsiteY75"/>
                </a:cxn>
                <a:cxn ang="0">
                  <a:pos x="connsiteX76" y="connsiteY76"/>
                </a:cxn>
                <a:cxn ang="0">
                  <a:pos x="connsiteX77" y="connsiteY77"/>
                </a:cxn>
                <a:cxn ang="0">
                  <a:pos x="connsiteX78" y="connsiteY78"/>
                </a:cxn>
                <a:cxn ang="0">
                  <a:pos x="connsiteX79" y="connsiteY79"/>
                </a:cxn>
                <a:cxn ang="0">
                  <a:pos x="connsiteX80" y="connsiteY80"/>
                </a:cxn>
                <a:cxn ang="0">
                  <a:pos x="connsiteX81" y="connsiteY81"/>
                </a:cxn>
                <a:cxn ang="0">
                  <a:pos x="connsiteX82" y="connsiteY82"/>
                </a:cxn>
                <a:cxn ang="0">
                  <a:pos x="connsiteX83" y="connsiteY83"/>
                </a:cxn>
                <a:cxn ang="0">
                  <a:pos x="connsiteX84" y="connsiteY84"/>
                </a:cxn>
                <a:cxn ang="0">
                  <a:pos x="connsiteX85" y="connsiteY85"/>
                </a:cxn>
                <a:cxn ang="0">
                  <a:pos x="connsiteX86" y="connsiteY86"/>
                </a:cxn>
                <a:cxn ang="0">
                  <a:pos x="connsiteX87" y="connsiteY87"/>
                </a:cxn>
                <a:cxn ang="0">
                  <a:pos x="connsiteX88" y="connsiteY88"/>
                </a:cxn>
                <a:cxn ang="0">
                  <a:pos x="connsiteX89" y="connsiteY89"/>
                </a:cxn>
                <a:cxn ang="0">
                  <a:pos x="connsiteX90" y="connsiteY90"/>
                </a:cxn>
                <a:cxn ang="0">
                  <a:pos x="connsiteX91" y="connsiteY91"/>
                </a:cxn>
                <a:cxn ang="0">
                  <a:pos x="connsiteX92" y="connsiteY92"/>
                </a:cxn>
                <a:cxn ang="0">
                  <a:pos x="connsiteX93" y="connsiteY93"/>
                </a:cxn>
                <a:cxn ang="0">
                  <a:pos x="connsiteX94" y="connsiteY94"/>
                </a:cxn>
                <a:cxn ang="0">
                  <a:pos x="connsiteX95" y="connsiteY95"/>
                </a:cxn>
                <a:cxn ang="0">
                  <a:pos x="connsiteX96" y="connsiteY96"/>
                </a:cxn>
                <a:cxn ang="0">
                  <a:pos x="connsiteX97" y="connsiteY97"/>
                </a:cxn>
                <a:cxn ang="0">
                  <a:pos x="connsiteX98" y="connsiteY98"/>
                </a:cxn>
                <a:cxn ang="0">
                  <a:pos x="connsiteX99" y="connsiteY99"/>
                </a:cxn>
                <a:cxn ang="0">
                  <a:pos x="connsiteX100" y="connsiteY100"/>
                </a:cxn>
                <a:cxn ang="0">
                  <a:pos x="connsiteX101" y="connsiteY101"/>
                </a:cxn>
                <a:cxn ang="0">
                  <a:pos x="connsiteX102" y="connsiteY102"/>
                </a:cxn>
                <a:cxn ang="0">
                  <a:pos x="connsiteX103" y="connsiteY103"/>
                </a:cxn>
                <a:cxn ang="0">
                  <a:pos x="connsiteX104" y="connsiteY104"/>
                </a:cxn>
                <a:cxn ang="0">
                  <a:pos x="connsiteX105" y="connsiteY105"/>
                </a:cxn>
                <a:cxn ang="0">
                  <a:pos x="connsiteX106" y="connsiteY106"/>
                </a:cxn>
                <a:cxn ang="0">
                  <a:pos x="connsiteX107" y="connsiteY107"/>
                </a:cxn>
                <a:cxn ang="0">
                  <a:pos x="connsiteX108" y="connsiteY108"/>
                </a:cxn>
                <a:cxn ang="0">
                  <a:pos x="connsiteX109" y="connsiteY109"/>
                </a:cxn>
              </a:cxnLst>
              <a:rect l="l" t="t" r="r" b="b"/>
              <a:pathLst>
                <a:path w="1926431" h="300184">
                  <a:moveTo>
                    <a:pt x="0" y="0"/>
                  </a:moveTo>
                  <a:cubicBezTo>
                    <a:pt x="35555" y="5928"/>
                    <a:pt x="-8777" y="-1349"/>
                    <a:pt x="30956" y="4763"/>
                  </a:cubicBezTo>
                  <a:cubicBezTo>
                    <a:pt x="35728" y="5497"/>
                    <a:pt x="40531" y="6097"/>
                    <a:pt x="45244" y="7144"/>
                  </a:cubicBezTo>
                  <a:cubicBezTo>
                    <a:pt x="47694" y="7688"/>
                    <a:pt x="49918" y="9076"/>
                    <a:pt x="52388" y="9525"/>
                  </a:cubicBezTo>
                  <a:cubicBezTo>
                    <a:pt x="58684" y="10670"/>
                    <a:pt x="65113" y="10934"/>
                    <a:pt x="71438" y="11907"/>
                  </a:cubicBezTo>
                  <a:cubicBezTo>
                    <a:pt x="75438" y="12522"/>
                    <a:pt x="79418" y="13306"/>
                    <a:pt x="83344" y="14288"/>
                  </a:cubicBezTo>
                  <a:cubicBezTo>
                    <a:pt x="85779" y="14897"/>
                    <a:pt x="88027" y="16177"/>
                    <a:pt x="90488" y="16669"/>
                  </a:cubicBezTo>
                  <a:cubicBezTo>
                    <a:pt x="95954" y="17762"/>
                    <a:pt x="121583" y="20854"/>
                    <a:pt x="126206" y="21432"/>
                  </a:cubicBezTo>
                  <a:cubicBezTo>
                    <a:pt x="140110" y="26066"/>
                    <a:pt x="126683" y="22003"/>
                    <a:pt x="147638" y="26194"/>
                  </a:cubicBezTo>
                  <a:cubicBezTo>
                    <a:pt x="150847" y="26836"/>
                    <a:pt x="153968" y="27865"/>
                    <a:pt x="157163" y="28575"/>
                  </a:cubicBezTo>
                  <a:cubicBezTo>
                    <a:pt x="161114" y="29453"/>
                    <a:pt x="165164" y="29892"/>
                    <a:pt x="169069" y="30957"/>
                  </a:cubicBezTo>
                  <a:cubicBezTo>
                    <a:pt x="173912" y="32278"/>
                    <a:pt x="178594" y="34132"/>
                    <a:pt x="183356" y="35719"/>
                  </a:cubicBezTo>
                  <a:lnTo>
                    <a:pt x="190500" y="38100"/>
                  </a:lnTo>
                  <a:lnTo>
                    <a:pt x="211931" y="45244"/>
                  </a:lnTo>
                  <a:lnTo>
                    <a:pt x="219075" y="47625"/>
                  </a:lnTo>
                  <a:cubicBezTo>
                    <a:pt x="221456" y="49213"/>
                    <a:pt x="223604" y="51226"/>
                    <a:pt x="226219" y="52388"/>
                  </a:cubicBezTo>
                  <a:cubicBezTo>
                    <a:pt x="230806" y="54427"/>
                    <a:pt x="240506" y="57150"/>
                    <a:pt x="240506" y="57150"/>
                  </a:cubicBezTo>
                  <a:cubicBezTo>
                    <a:pt x="242887" y="58738"/>
                    <a:pt x="245035" y="60751"/>
                    <a:pt x="247650" y="61913"/>
                  </a:cubicBezTo>
                  <a:cubicBezTo>
                    <a:pt x="252238" y="63952"/>
                    <a:pt x="261938" y="66675"/>
                    <a:pt x="261938" y="66675"/>
                  </a:cubicBezTo>
                  <a:cubicBezTo>
                    <a:pt x="264319" y="68263"/>
                    <a:pt x="266466" y="70276"/>
                    <a:pt x="269081" y="71438"/>
                  </a:cubicBezTo>
                  <a:cubicBezTo>
                    <a:pt x="279253" y="75959"/>
                    <a:pt x="283206" y="75814"/>
                    <a:pt x="292894" y="78582"/>
                  </a:cubicBezTo>
                  <a:cubicBezTo>
                    <a:pt x="316767" y="85404"/>
                    <a:pt x="279839" y="75914"/>
                    <a:pt x="309563" y="83344"/>
                  </a:cubicBezTo>
                  <a:cubicBezTo>
                    <a:pt x="324538" y="93329"/>
                    <a:pt x="308472" y="83774"/>
                    <a:pt x="335756" y="92869"/>
                  </a:cubicBezTo>
                  <a:lnTo>
                    <a:pt x="357188" y="100013"/>
                  </a:lnTo>
                  <a:cubicBezTo>
                    <a:pt x="359569" y="100807"/>
                    <a:pt x="361855" y="101981"/>
                    <a:pt x="364331" y="102394"/>
                  </a:cubicBezTo>
                  <a:lnTo>
                    <a:pt x="378619" y="104775"/>
                  </a:lnTo>
                  <a:cubicBezTo>
                    <a:pt x="429110" y="121608"/>
                    <a:pt x="366457" y="101127"/>
                    <a:pt x="402431" y="111919"/>
                  </a:cubicBezTo>
                  <a:cubicBezTo>
                    <a:pt x="408037" y="113601"/>
                    <a:pt x="419532" y="118148"/>
                    <a:pt x="426244" y="119063"/>
                  </a:cubicBezTo>
                  <a:cubicBezTo>
                    <a:pt x="466658" y="124573"/>
                    <a:pt x="473091" y="124035"/>
                    <a:pt x="514350" y="126207"/>
                  </a:cubicBezTo>
                  <a:cubicBezTo>
                    <a:pt x="556028" y="124862"/>
                    <a:pt x="568992" y="129644"/>
                    <a:pt x="597694" y="121444"/>
                  </a:cubicBezTo>
                  <a:cubicBezTo>
                    <a:pt x="600108" y="120754"/>
                    <a:pt x="602457" y="119857"/>
                    <a:pt x="604838" y="119063"/>
                  </a:cubicBezTo>
                  <a:lnTo>
                    <a:pt x="626269" y="104775"/>
                  </a:lnTo>
                  <a:cubicBezTo>
                    <a:pt x="626277" y="104770"/>
                    <a:pt x="640549" y="95257"/>
                    <a:pt x="640556" y="95250"/>
                  </a:cubicBezTo>
                  <a:cubicBezTo>
                    <a:pt x="649475" y="86332"/>
                    <a:pt x="644505" y="89172"/>
                    <a:pt x="654844" y="85725"/>
                  </a:cubicBezTo>
                  <a:cubicBezTo>
                    <a:pt x="657225" y="83344"/>
                    <a:pt x="659401" y="80738"/>
                    <a:pt x="661988" y="78582"/>
                  </a:cubicBezTo>
                  <a:cubicBezTo>
                    <a:pt x="664186" y="76750"/>
                    <a:pt x="667107" y="75843"/>
                    <a:pt x="669131" y="73819"/>
                  </a:cubicBezTo>
                  <a:cubicBezTo>
                    <a:pt x="671155" y="71795"/>
                    <a:pt x="671870" y="68699"/>
                    <a:pt x="673894" y="66675"/>
                  </a:cubicBezTo>
                  <a:cubicBezTo>
                    <a:pt x="678509" y="62060"/>
                    <a:pt x="682372" y="61468"/>
                    <a:pt x="688181" y="59532"/>
                  </a:cubicBezTo>
                  <a:cubicBezTo>
                    <a:pt x="702289" y="48951"/>
                    <a:pt x="694399" y="54593"/>
                    <a:pt x="711994" y="42863"/>
                  </a:cubicBezTo>
                  <a:cubicBezTo>
                    <a:pt x="714375" y="41275"/>
                    <a:pt x="716423" y="39005"/>
                    <a:pt x="719138" y="38100"/>
                  </a:cubicBezTo>
                  <a:lnTo>
                    <a:pt x="740569" y="30957"/>
                  </a:lnTo>
                  <a:cubicBezTo>
                    <a:pt x="742950" y="30163"/>
                    <a:pt x="745278" y="29184"/>
                    <a:pt x="747713" y="28575"/>
                  </a:cubicBezTo>
                  <a:cubicBezTo>
                    <a:pt x="754063" y="26988"/>
                    <a:pt x="760554" y="25883"/>
                    <a:pt x="766763" y="23813"/>
                  </a:cubicBezTo>
                  <a:lnTo>
                    <a:pt x="788194" y="16669"/>
                  </a:lnTo>
                  <a:cubicBezTo>
                    <a:pt x="790575" y="15875"/>
                    <a:pt x="792862" y="14701"/>
                    <a:pt x="795338" y="14288"/>
                  </a:cubicBezTo>
                  <a:cubicBezTo>
                    <a:pt x="800100" y="13494"/>
                    <a:pt x="804891" y="12854"/>
                    <a:pt x="809625" y="11907"/>
                  </a:cubicBezTo>
                  <a:cubicBezTo>
                    <a:pt x="812834" y="11265"/>
                    <a:pt x="815941" y="10167"/>
                    <a:pt x="819150" y="9525"/>
                  </a:cubicBezTo>
                  <a:cubicBezTo>
                    <a:pt x="848368" y="3681"/>
                    <a:pt x="820822" y="10298"/>
                    <a:pt x="842963" y="4763"/>
                  </a:cubicBezTo>
                  <a:cubicBezTo>
                    <a:pt x="858838" y="5557"/>
                    <a:pt x="874744" y="5877"/>
                    <a:pt x="890588" y="7144"/>
                  </a:cubicBezTo>
                  <a:cubicBezTo>
                    <a:pt x="906837" y="8444"/>
                    <a:pt x="899374" y="10807"/>
                    <a:pt x="916781" y="14288"/>
                  </a:cubicBezTo>
                  <a:cubicBezTo>
                    <a:pt x="923173" y="15566"/>
                    <a:pt x="937793" y="17977"/>
                    <a:pt x="942975" y="21432"/>
                  </a:cubicBezTo>
                  <a:lnTo>
                    <a:pt x="964406" y="35719"/>
                  </a:lnTo>
                  <a:cubicBezTo>
                    <a:pt x="966787" y="37307"/>
                    <a:pt x="968835" y="39577"/>
                    <a:pt x="971550" y="40482"/>
                  </a:cubicBezTo>
                  <a:lnTo>
                    <a:pt x="985838" y="45244"/>
                  </a:lnTo>
                  <a:cubicBezTo>
                    <a:pt x="997158" y="52792"/>
                    <a:pt x="990266" y="49102"/>
                    <a:pt x="1007269" y="54769"/>
                  </a:cubicBezTo>
                  <a:cubicBezTo>
                    <a:pt x="1009650" y="55563"/>
                    <a:pt x="1011978" y="56541"/>
                    <a:pt x="1014413" y="57150"/>
                  </a:cubicBezTo>
                  <a:cubicBezTo>
                    <a:pt x="1020763" y="58738"/>
                    <a:pt x="1027253" y="59843"/>
                    <a:pt x="1033463" y="61913"/>
                  </a:cubicBezTo>
                  <a:cubicBezTo>
                    <a:pt x="1046232" y="66169"/>
                    <a:pt x="1035265" y="62842"/>
                    <a:pt x="1052513" y="66675"/>
                  </a:cubicBezTo>
                  <a:cubicBezTo>
                    <a:pt x="1055708" y="67385"/>
                    <a:pt x="1058829" y="68415"/>
                    <a:pt x="1062038" y="69057"/>
                  </a:cubicBezTo>
                  <a:cubicBezTo>
                    <a:pt x="1066772" y="70004"/>
                    <a:pt x="1071641" y="70267"/>
                    <a:pt x="1076325" y="71438"/>
                  </a:cubicBezTo>
                  <a:cubicBezTo>
                    <a:pt x="1081195" y="72655"/>
                    <a:pt x="1085661" y="75374"/>
                    <a:pt x="1090613" y="76200"/>
                  </a:cubicBezTo>
                  <a:cubicBezTo>
                    <a:pt x="1095375" y="76994"/>
                    <a:pt x="1100216" y="77411"/>
                    <a:pt x="1104900" y="78582"/>
                  </a:cubicBezTo>
                  <a:cubicBezTo>
                    <a:pt x="1104905" y="78583"/>
                    <a:pt x="1122756" y="84533"/>
                    <a:pt x="1126331" y="85725"/>
                  </a:cubicBezTo>
                  <a:cubicBezTo>
                    <a:pt x="1128712" y="86519"/>
                    <a:pt x="1130999" y="87694"/>
                    <a:pt x="1133475" y="88107"/>
                  </a:cubicBezTo>
                  <a:lnTo>
                    <a:pt x="1147763" y="90488"/>
                  </a:lnTo>
                  <a:cubicBezTo>
                    <a:pt x="1153310" y="91341"/>
                    <a:pt x="1158909" y="91865"/>
                    <a:pt x="1164431" y="92869"/>
                  </a:cubicBezTo>
                  <a:cubicBezTo>
                    <a:pt x="1167651" y="93454"/>
                    <a:pt x="1170761" y="94540"/>
                    <a:pt x="1173956" y="95250"/>
                  </a:cubicBezTo>
                  <a:cubicBezTo>
                    <a:pt x="1177907" y="96128"/>
                    <a:pt x="1181912" y="96754"/>
                    <a:pt x="1185863" y="97632"/>
                  </a:cubicBezTo>
                  <a:cubicBezTo>
                    <a:pt x="1189058" y="98342"/>
                    <a:pt x="1192133" y="99670"/>
                    <a:pt x="1195388" y="100013"/>
                  </a:cubicBezTo>
                  <a:cubicBezTo>
                    <a:pt x="1207255" y="101262"/>
                    <a:pt x="1219200" y="101600"/>
                    <a:pt x="1231106" y="102394"/>
                  </a:cubicBezTo>
                  <a:cubicBezTo>
                    <a:pt x="1242207" y="106094"/>
                    <a:pt x="1236975" y="104762"/>
                    <a:pt x="1252538" y="107157"/>
                  </a:cubicBezTo>
                  <a:cubicBezTo>
                    <a:pt x="1272081" y="110164"/>
                    <a:pt x="1270760" y="109693"/>
                    <a:pt x="1293019" y="111919"/>
                  </a:cubicBezTo>
                  <a:lnTo>
                    <a:pt x="1316831" y="116682"/>
                  </a:lnTo>
                  <a:cubicBezTo>
                    <a:pt x="1320800" y="117476"/>
                    <a:pt x="1324898" y="117783"/>
                    <a:pt x="1328738" y="119063"/>
                  </a:cubicBezTo>
                  <a:cubicBezTo>
                    <a:pt x="1338655" y="122369"/>
                    <a:pt x="1335139" y="121525"/>
                    <a:pt x="1347788" y="123825"/>
                  </a:cubicBezTo>
                  <a:cubicBezTo>
                    <a:pt x="1352538" y="124689"/>
                    <a:pt x="1357303" y="125473"/>
                    <a:pt x="1362075" y="126207"/>
                  </a:cubicBezTo>
                  <a:cubicBezTo>
                    <a:pt x="1367622" y="127061"/>
                    <a:pt x="1373222" y="127584"/>
                    <a:pt x="1378744" y="128588"/>
                  </a:cubicBezTo>
                  <a:cubicBezTo>
                    <a:pt x="1381964" y="129173"/>
                    <a:pt x="1385029" y="130506"/>
                    <a:pt x="1388269" y="130969"/>
                  </a:cubicBezTo>
                  <a:cubicBezTo>
                    <a:pt x="1407636" y="133735"/>
                    <a:pt x="1437633" y="134770"/>
                    <a:pt x="1454944" y="135732"/>
                  </a:cubicBezTo>
                  <a:cubicBezTo>
                    <a:pt x="1475227" y="140802"/>
                    <a:pt x="1452117" y="135372"/>
                    <a:pt x="1481138" y="140494"/>
                  </a:cubicBezTo>
                  <a:cubicBezTo>
                    <a:pt x="1489109" y="141901"/>
                    <a:pt x="1497013" y="143669"/>
                    <a:pt x="1504950" y="145257"/>
                  </a:cubicBezTo>
                  <a:cubicBezTo>
                    <a:pt x="1508919" y="146051"/>
                    <a:pt x="1513016" y="146358"/>
                    <a:pt x="1516856" y="147638"/>
                  </a:cubicBezTo>
                  <a:cubicBezTo>
                    <a:pt x="1519237" y="148432"/>
                    <a:pt x="1521565" y="149410"/>
                    <a:pt x="1524000" y="150019"/>
                  </a:cubicBezTo>
                  <a:cubicBezTo>
                    <a:pt x="1527926" y="151001"/>
                    <a:pt x="1531980" y="151418"/>
                    <a:pt x="1535906" y="152400"/>
                  </a:cubicBezTo>
                  <a:cubicBezTo>
                    <a:pt x="1547875" y="155393"/>
                    <a:pt x="1538556" y="153726"/>
                    <a:pt x="1550194" y="159544"/>
                  </a:cubicBezTo>
                  <a:cubicBezTo>
                    <a:pt x="1552439" y="160666"/>
                    <a:pt x="1554957" y="161131"/>
                    <a:pt x="1557338" y="161925"/>
                  </a:cubicBezTo>
                  <a:cubicBezTo>
                    <a:pt x="1584308" y="182154"/>
                    <a:pt x="1550250" y="157496"/>
                    <a:pt x="1576388" y="173832"/>
                  </a:cubicBezTo>
                  <a:cubicBezTo>
                    <a:pt x="1584666" y="179005"/>
                    <a:pt x="1585162" y="181432"/>
                    <a:pt x="1593056" y="185738"/>
                  </a:cubicBezTo>
                  <a:cubicBezTo>
                    <a:pt x="1609786" y="194864"/>
                    <a:pt x="1606985" y="193556"/>
                    <a:pt x="1619250" y="197644"/>
                  </a:cubicBezTo>
                  <a:cubicBezTo>
                    <a:pt x="1621631" y="199232"/>
                    <a:pt x="1623779" y="201245"/>
                    <a:pt x="1626394" y="202407"/>
                  </a:cubicBezTo>
                  <a:cubicBezTo>
                    <a:pt x="1630981" y="204446"/>
                    <a:pt x="1640681" y="207169"/>
                    <a:pt x="1640681" y="207169"/>
                  </a:cubicBezTo>
                  <a:cubicBezTo>
                    <a:pt x="1643062" y="208757"/>
                    <a:pt x="1645265" y="210652"/>
                    <a:pt x="1647825" y="211932"/>
                  </a:cubicBezTo>
                  <a:cubicBezTo>
                    <a:pt x="1651240" y="213640"/>
                    <a:pt x="1661444" y="215931"/>
                    <a:pt x="1664494" y="216694"/>
                  </a:cubicBezTo>
                  <a:cubicBezTo>
                    <a:pt x="1667669" y="218282"/>
                    <a:pt x="1670651" y="220334"/>
                    <a:pt x="1674019" y="221457"/>
                  </a:cubicBezTo>
                  <a:cubicBezTo>
                    <a:pt x="1677859" y="222737"/>
                    <a:pt x="1681999" y="222856"/>
                    <a:pt x="1685925" y="223838"/>
                  </a:cubicBezTo>
                  <a:cubicBezTo>
                    <a:pt x="1688360" y="224447"/>
                    <a:pt x="1690655" y="225529"/>
                    <a:pt x="1693069" y="226219"/>
                  </a:cubicBezTo>
                  <a:cubicBezTo>
                    <a:pt x="1696216" y="227118"/>
                    <a:pt x="1699419" y="227806"/>
                    <a:pt x="1702594" y="228600"/>
                  </a:cubicBezTo>
                  <a:cubicBezTo>
                    <a:pt x="1704975" y="230188"/>
                    <a:pt x="1707178" y="232083"/>
                    <a:pt x="1709738" y="233363"/>
                  </a:cubicBezTo>
                  <a:cubicBezTo>
                    <a:pt x="1711983" y="234485"/>
                    <a:pt x="1714793" y="234352"/>
                    <a:pt x="1716881" y="235744"/>
                  </a:cubicBezTo>
                  <a:cubicBezTo>
                    <a:pt x="1731176" y="245274"/>
                    <a:pt x="1716211" y="241363"/>
                    <a:pt x="1733550" y="250032"/>
                  </a:cubicBezTo>
                  <a:cubicBezTo>
                    <a:pt x="1736477" y="251496"/>
                    <a:pt x="1739900" y="251619"/>
                    <a:pt x="1743075" y="252413"/>
                  </a:cubicBezTo>
                  <a:cubicBezTo>
                    <a:pt x="1758931" y="268269"/>
                    <a:pt x="1741854" y="253322"/>
                    <a:pt x="1757363" y="261938"/>
                  </a:cubicBezTo>
                  <a:cubicBezTo>
                    <a:pt x="1781927" y="275584"/>
                    <a:pt x="1762629" y="268456"/>
                    <a:pt x="1778794" y="273844"/>
                  </a:cubicBezTo>
                  <a:cubicBezTo>
                    <a:pt x="1781175" y="275432"/>
                    <a:pt x="1783323" y="277445"/>
                    <a:pt x="1785938" y="278607"/>
                  </a:cubicBezTo>
                  <a:cubicBezTo>
                    <a:pt x="1790525" y="280646"/>
                    <a:pt x="1795463" y="281782"/>
                    <a:pt x="1800225" y="283369"/>
                  </a:cubicBezTo>
                  <a:lnTo>
                    <a:pt x="1814513" y="288132"/>
                  </a:lnTo>
                  <a:cubicBezTo>
                    <a:pt x="1814515" y="288133"/>
                    <a:pt x="1828798" y="292894"/>
                    <a:pt x="1828800" y="292894"/>
                  </a:cubicBezTo>
                  <a:lnTo>
                    <a:pt x="1883569" y="295275"/>
                  </a:lnTo>
                  <a:cubicBezTo>
                    <a:pt x="1890226" y="296385"/>
                    <a:pt x="1908382" y="299526"/>
                    <a:pt x="1914525" y="300038"/>
                  </a:cubicBezTo>
                  <a:cubicBezTo>
                    <a:pt x="1918480" y="300368"/>
                    <a:pt x="1922462" y="300038"/>
                    <a:pt x="1926431" y="300038"/>
                  </a:cubicBezTo>
                </a:path>
              </a:pathLst>
            </a:custGeom>
            <a:noFill/>
            <a:ln w="38100"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9666"/>
            </a:p>
          </p:txBody>
        </p:sp>
      </p:grpSp>
      <p:graphicFrame>
        <p:nvGraphicFramePr>
          <p:cNvPr id="248" name="Object 247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322870397"/>
              </p:ext>
            </p:extLst>
          </p:nvPr>
        </p:nvGraphicFramePr>
        <p:xfrm>
          <a:off x="1158239" y="12812524"/>
          <a:ext cx="3051806" cy="42941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23" imgW="2704619" imgH="3820874" progId="Prism10.Document">
                  <p:embed/>
                </p:oleObj>
              </mc:Choice>
              <mc:Fallback>
                <p:oleObj name="Prism 10" r:id="rId23" imgW="2704619" imgH="3820874" progId="Prism10.Document">
                  <p:embed/>
                  <p:pic>
                    <p:nvPicPr>
                      <p:cNvPr id="248" name="Object 247"/>
                      <p:cNvPicPr/>
                      <p:nvPr/>
                    </p:nvPicPr>
                    <p:blipFill>
                      <a:blip r:embed="rId24"/>
                      <a:stretch>
                        <a:fillRect/>
                      </a:stretch>
                    </p:blipFill>
                    <p:spPr>
                      <a:xfrm>
                        <a:off x="1158239" y="12812524"/>
                        <a:ext cx="3051806" cy="42941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pSp>
        <p:nvGrpSpPr>
          <p:cNvPr id="6" name="Group 5"/>
          <p:cNvGrpSpPr/>
          <p:nvPr/>
        </p:nvGrpSpPr>
        <p:grpSpPr>
          <a:xfrm>
            <a:off x="20833079" y="12326748"/>
            <a:ext cx="1821181" cy="2170687"/>
            <a:chOff x="20452079" y="11746528"/>
            <a:chExt cx="1821181" cy="2170687"/>
          </a:xfrm>
        </p:grpSpPr>
        <p:sp>
          <p:nvSpPr>
            <p:cNvPr id="98" name="TextBox 97">
              <a:extLst>
                <a:ext uri="{FF2B5EF4-FFF2-40B4-BE49-F238E27FC236}">
                  <a16:creationId xmlns:a16="http://schemas.microsoft.com/office/drawing/2014/main" id="{3B9872B2-9D1A-EB02-54AB-9FF97973659E}"/>
                </a:ext>
              </a:extLst>
            </p:cNvPr>
            <p:cNvSpPr txBox="1"/>
            <p:nvPr/>
          </p:nvSpPr>
          <p:spPr>
            <a:xfrm>
              <a:off x="21071510" y="12365388"/>
              <a:ext cx="753731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2800" dirty="0">
                  <a:cs typeface="Arial" panose="020B0604020202020204" pitchFamily="34" charset="0"/>
                </a:rPr>
                <a:t>Con</a:t>
              </a:r>
            </a:p>
          </p:txBody>
        </p:sp>
        <p:sp>
          <p:nvSpPr>
            <p:cNvPr id="99" name="Rectangle 98">
              <a:extLst>
                <a:ext uri="{FF2B5EF4-FFF2-40B4-BE49-F238E27FC236}">
                  <a16:creationId xmlns:a16="http://schemas.microsoft.com/office/drawing/2014/main" id="{7A2596D0-46BE-4279-A5B3-59C91930BE65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20452079" y="11760089"/>
              <a:ext cx="1821181" cy="2157126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800">
                <a:cs typeface="Arial" panose="020B0604020202020204" pitchFamily="34" charset="0"/>
              </a:endParaRPr>
            </a:p>
          </p:txBody>
        </p:sp>
        <p:sp>
          <p:nvSpPr>
            <p:cNvPr id="107" name="Rectangle 106">
              <a:extLst>
                <a:ext uri="{FF2B5EF4-FFF2-40B4-BE49-F238E27FC236}">
                  <a16:creationId xmlns:a16="http://schemas.microsoft.com/office/drawing/2014/main" id="{D8BFDBB0-710E-C27A-78EE-DF914C34E7F7}"/>
                </a:ext>
              </a:extLst>
            </p:cNvPr>
            <p:cNvSpPr/>
            <p:nvPr/>
          </p:nvSpPr>
          <p:spPr>
            <a:xfrm>
              <a:off x="20587548" y="12525232"/>
              <a:ext cx="424590" cy="236352"/>
            </a:xfrm>
            <a:prstGeom prst="rect">
              <a:avLst/>
            </a:prstGeom>
            <a:solidFill>
              <a:schemeClr val="bg2">
                <a:lumMod val="90000"/>
              </a:schemeClr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800" dirty="0">
                <a:cs typeface="Arial" panose="020B0604020202020204" pitchFamily="34" charset="0"/>
              </a:endParaRPr>
            </a:p>
          </p:txBody>
        </p:sp>
        <p:sp>
          <p:nvSpPr>
            <p:cNvPr id="108" name="TextBox 107">
              <a:extLst>
                <a:ext uri="{FF2B5EF4-FFF2-40B4-BE49-F238E27FC236}">
                  <a16:creationId xmlns:a16="http://schemas.microsoft.com/office/drawing/2014/main" id="{9AB4959C-3B6C-CA70-04B7-A0075AB99D90}"/>
                </a:ext>
              </a:extLst>
            </p:cNvPr>
            <p:cNvSpPr txBox="1"/>
            <p:nvPr/>
          </p:nvSpPr>
          <p:spPr>
            <a:xfrm>
              <a:off x="21073112" y="13246717"/>
              <a:ext cx="915635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2800" dirty="0">
                  <a:cs typeface="Arial" panose="020B0604020202020204" pitchFamily="34" charset="0"/>
                </a:rPr>
                <a:t>X31</a:t>
              </a:r>
              <a:r>
                <a:rPr lang="en-US" sz="2800" baseline="-25000" dirty="0">
                  <a:cs typeface="Arial" panose="020B0604020202020204" pitchFamily="34" charset="0"/>
                </a:rPr>
                <a:t>hi</a:t>
              </a:r>
            </a:p>
          </p:txBody>
        </p:sp>
        <p:sp>
          <p:nvSpPr>
            <p:cNvPr id="109" name="Rectangle 108">
              <a:extLst>
                <a:ext uri="{FF2B5EF4-FFF2-40B4-BE49-F238E27FC236}">
                  <a16:creationId xmlns:a16="http://schemas.microsoft.com/office/drawing/2014/main" id="{3259DBA0-AD77-8F85-227B-E980D6C79335}"/>
                </a:ext>
              </a:extLst>
            </p:cNvPr>
            <p:cNvSpPr/>
            <p:nvPr/>
          </p:nvSpPr>
          <p:spPr>
            <a:xfrm>
              <a:off x="20587548" y="13421245"/>
              <a:ext cx="424590" cy="236352"/>
            </a:xfrm>
            <a:prstGeom prst="rect">
              <a:avLst/>
            </a:prstGeom>
            <a:solidFill>
              <a:srgbClr val="C00000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800">
                <a:cs typeface="Arial" panose="020B0604020202020204" pitchFamily="34" charset="0"/>
              </a:endParaRPr>
            </a:p>
          </p:txBody>
        </p:sp>
        <p:sp>
          <p:nvSpPr>
            <p:cNvPr id="110" name="TextBox 109">
              <a:extLst>
                <a:ext uri="{FF2B5EF4-FFF2-40B4-BE49-F238E27FC236}">
                  <a16:creationId xmlns:a16="http://schemas.microsoft.com/office/drawing/2014/main" id="{AF1BBFB5-F136-74A5-EC62-385A26239619}"/>
                </a:ext>
              </a:extLst>
            </p:cNvPr>
            <p:cNvSpPr txBox="1"/>
            <p:nvPr/>
          </p:nvSpPr>
          <p:spPr>
            <a:xfrm>
              <a:off x="20455606" y="11746528"/>
              <a:ext cx="1331069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2800" dirty="0">
                  <a:cs typeface="Arial" panose="020B0604020202020204" pitchFamily="34" charset="0"/>
                </a:rPr>
                <a:t>Legend:</a:t>
              </a:r>
            </a:p>
          </p:txBody>
        </p:sp>
        <p:sp>
          <p:nvSpPr>
            <p:cNvPr id="111" name="TextBox 110">
              <a:extLst>
                <a:ext uri="{FF2B5EF4-FFF2-40B4-BE49-F238E27FC236}">
                  <a16:creationId xmlns:a16="http://schemas.microsoft.com/office/drawing/2014/main" id="{9AB4959C-3B6C-CA70-04B7-A0075AB99D90}"/>
                </a:ext>
              </a:extLst>
            </p:cNvPr>
            <p:cNvSpPr txBox="1"/>
            <p:nvPr/>
          </p:nvSpPr>
          <p:spPr>
            <a:xfrm>
              <a:off x="21081128" y="12789568"/>
              <a:ext cx="1178528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2800" dirty="0">
                  <a:cs typeface="Arial" panose="020B0604020202020204" pitchFamily="34" charset="0"/>
                </a:rPr>
                <a:t>X31</a:t>
              </a:r>
              <a:r>
                <a:rPr lang="en-US" sz="2800" baseline="-25000" dirty="0">
                  <a:cs typeface="Arial" panose="020B0604020202020204" pitchFamily="34" charset="0"/>
                </a:rPr>
                <a:t>mod</a:t>
              </a:r>
            </a:p>
          </p:txBody>
        </p:sp>
        <p:sp>
          <p:nvSpPr>
            <p:cNvPr id="112" name="Rectangle 111">
              <a:extLst>
                <a:ext uri="{FF2B5EF4-FFF2-40B4-BE49-F238E27FC236}">
                  <a16:creationId xmlns:a16="http://schemas.microsoft.com/office/drawing/2014/main" id="{3259DBA0-AD77-8F85-227B-E980D6C79335}"/>
                </a:ext>
              </a:extLst>
            </p:cNvPr>
            <p:cNvSpPr/>
            <p:nvPr/>
          </p:nvSpPr>
          <p:spPr>
            <a:xfrm>
              <a:off x="20587548" y="12964096"/>
              <a:ext cx="424590" cy="236352"/>
            </a:xfrm>
            <a:prstGeom prst="rect">
              <a:avLst/>
            </a:prstGeom>
            <a:solidFill>
              <a:srgbClr val="FF0000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800">
                <a:cs typeface="Arial" panose="020B0604020202020204" pitchFamily="34" charset="0"/>
              </a:endParaRPr>
            </a:p>
          </p:txBody>
        </p:sp>
      </p:grpSp>
      <p:graphicFrame>
        <p:nvGraphicFramePr>
          <p:cNvPr id="244" name="Object 24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10258257"/>
              </p:ext>
            </p:extLst>
          </p:nvPr>
        </p:nvGraphicFramePr>
        <p:xfrm>
          <a:off x="7003623" y="12796483"/>
          <a:ext cx="3386818" cy="42894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25" imgW="3198725" imgH="3808629" progId="Prism10.Document">
                  <p:embed/>
                </p:oleObj>
              </mc:Choice>
              <mc:Fallback>
                <p:oleObj name="Prism 10" r:id="rId25" imgW="3198725" imgH="3808629" progId="Prism10.Document">
                  <p:embed/>
                  <p:pic>
                    <p:nvPicPr>
                      <p:cNvPr id="244" name="Object 243"/>
                      <p:cNvPicPr/>
                      <p:nvPr/>
                    </p:nvPicPr>
                    <p:blipFill>
                      <a:blip r:embed="rId26"/>
                      <a:stretch>
                        <a:fillRect/>
                      </a:stretch>
                    </p:blipFill>
                    <p:spPr>
                      <a:xfrm>
                        <a:off x="7003623" y="12796483"/>
                        <a:ext cx="3386818" cy="42894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" name="Rectangle 3"/>
          <p:cNvSpPr/>
          <p:nvPr/>
        </p:nvSpPr>
        <p:spPr>
          <a:xfrm rot="16200000">
            <a:off x="-504618" y="14571998"/>
            <a:ext cx="2920992" cy="52322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2800" dirty="0"/>
              <a:t>CLDN1 (MFI/mm</a:t>
            </a:r>
            <a:r>
              <a:rPr lang="en-US" sz="2800" baseline="30000" dirty="0"/>
              <a:t>2</a:t>
            </a:r>
            <a:r>
              <a:rPr lang="en-US" sz="2800" dirty="0"/>
              <a:t>)</a:t>
            </a:r>
          </a:p>
        </p:txBody>
      </p:sp>
      <p:sp>
        <p:nvSpPr>
          <p:cNvPr id="5" name="Rectangle 4"/>
          <p:cNvSpPr/>
          <p:nvPr/>
        </p:nvSpPr>
        <p:spPr>
          <a:xfrm rot="16200000">
            <a:off x="-1229689" y="19456619"/>
            <a:ext cx="4371133" cy="52322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2800" dirty="0"/>
              <a:t>Relative Expression to </a:t>
            </a:r>
            <a:r>
              <a:rPr lang="en-US" sz="2800" i="1" dirty="0"/>
              <a:t>Rplp0</a:t>
            </a:r>
            <a:r>
              <a:rPr lang="en-US" sz="2800" dirty="0"/>
              <a:t> </a:t>
            </a:r>
          </a:p>
        </p:txBody>
      </p:sp>
      <p:graphicFrame>
        <p:nvGraphicFramePr>
          <p:cNvPr id="113" name="Object 11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860274620"/>
              </p:ext>
            </p:extLst>
          </p:nvPr>
        </p:nvGraphicFramePr>
        <p:xfrm>
          <a:off x="4180276" y="12812525"/>
          <a:ext cx="2911337" cy="42941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27" imgW="2562726" imgH="3820874" progId="Prism10.Document">
                  <p:embed/>
                </p:oleObj>
              </mc:Choice>
              <mc:Fallback>
                <p:oleObj name="Prism 10" r:id="rId27" imgW="2562726" imgH="3820874" progId="Prism10.Document">
                  <p:embed/>
                  <p:pic>
                    <p:nvPicPr>
                      <p:cNvPr id="113" name="Object 112"/>
                      <p:cNvPicPr/>
                      <p:nvPr/>
                    </p:nvPicPr>
                    <p:blipFill>
                      <a:blip r:embed="rId28"/>
                      <a:stretch>
                        <a:fillRect/>
                      </a:stretch>
                    </p:blipFill>
                    <p:spPr>
                      <a:xfrm>
                        <a:off x="4180276" y="12812525"/>
                        <a:ext cx="2911337" cy="42941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49" name="Object 248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143457128"/>
              </p:ext>
            </p:extLst>
          </p:nvPr>
        </p:nvGraphicFramePr>
        <p:xfrm>
          <a:off x="11210925" y="12855387"/>
          <a:ext cx="3032125" cy="42481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29" imgW="2704619" imgH="3820874" progId="Prism10.Document">
                  <p:embed/>
                </p:oleObj>
              </mc:Choice>
              <mc:Fallback>
                <p:oleObj name="Prism 10" r:id="rId29" imgW="2704619" imgH="3820874" progId="Prism10.Document">
                  <p:embed/>
                  <p:pic>
                    <p:nvPicPr>
                      <p:cNvPr id="249" name="Object 248"/>
                      <p:cNvPicPr/>
                      <p:nvPr/>
                    </p:nvPicPr>
                    <p:blipFill>
                      <a:blip r:embed="rId30"/>
                      <a:stretch>
                        <a:fillRect/>
                      </a:stretch>
                    </p:blipFill>
                    <p:spPr>
                      <a:xfrm>
                        <a:off x="11210925" y="12855387"/>
                        <a:ext cx="3032125" cy="42481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16" name="Rectangle 115"/>
          <p:cNvSpPr/>
          <p:nvPr/>
        </p:nvSpPr>
        <p:spPr>
          <a:xfrm rot="16200000">
            <a:off x="9713338" y="14488643"/>
            <a:ext cx="2754280" cy="52322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2800" dirty="0"/>
              <a:t>OCLN (MFI/mm</a:t>
            </a:r>
            <a:r>
              <a:rPr lang="en-US" sz="2800" baseline="30000" dirty="0"/>
              <a:t>2</a:t>
            </a:r>
            <a:r>
              <a:rPr lang="en-US" sz="2800" dirty="0"/>
              <a:t>)</a:t>
            </a:r>
          </a:p>
        </p:txBody>
      </p:sp>
      <p:graphicFrame>
        <p:nvGraphicFramePr>
          <p:cNvPr id="118" name="Object 117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341412491"/>
              </p:ext>
            </p:extLst>
          </p:nvPr>
        </p:nvGraphicFramePr>
        <p:xfrm>
          <a:off x="14100759" y="12849038"/>
          <a:ext cx="3006406" cy="42545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31" imgW="2704619" imgH="3820874" progId="Prism10.Document">
                  <p:embed/>
                </p:oleObj>
              </mc:Choice>
              <mc:Fallback>
                <p:oleObj name="Prism 10" r:id="rId31" imgW="2704619" imgH="3820874" progId="Prism10.Document">
                  <p:embed/>
                  <p:pic>
                    <p:nvPicPr>
                      <p:cNvPr id="118" name="Object 117"/>
                      <p:cNvPicPr/>
                      <p:nvPr/>
                    </p:nvPicPr>
                    <p:blipFill>
                      <a:blip r:embed="rId32"/>
                      <a:stretch>
                        <a:fillRect/>
                      </a:stretch>
                    </p:blipFill>
                    <p:spPr>
                      <a:xfrm>
                        <a:off x="14100759" y="12849038"/>
                        <a:ext cx="3006406" cy="42545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19" name="Object 118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078904683"/>
              </p:ext>
            </p:extLst>
          </p:nvPr>
        </p:nvGraphicFramePr>
        <p:xfrm>
          <a:off x="17057834" y="12858730"/>
          <a:ext cx="2993798" cy="424565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33" imgW="2704619" imgH="3820874" progId="Prism10.Document">
                  <p:embed/>
                </p:oleObj>
              </mc:Choice>
              <mc:Fallback>
                <p:oleObj name="Prism 10" r:id="rId33" imgW="2704619" imgH="3820874" progId="Prism10.Document">
                  <p:embed/>
                  <p:pic>
                    <p:nvPicPr>
                      <p:cNvPr id="119" name="Object 118"/>
                      <p:cNvPicPr/>
                      <p:nvPr/>
                    </p:nvPicPr>
                    <p:blipFill>
                      <a:blip r:embed="rId34"/>
                      <a:stretch>
                        <a:fillRect/>
                      </a:stretch>
                    </p:blipFill>
                    <p:spPr>
                      <a:xfrm>
                        <a:off x="17057834" y="12858730"/>
                        <a:ext cx="2993798" cy="424565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20" name="TextBox 119"/>
          <p:cNvSpPr txBox="1"/>
          <p:nvPr/>
        </p:nvSpPr>
        <p:spPr>
          <a:xfrm>
            <a:off x="701569" y="12234739"/>
            <a:ext cx="442750" cy="646331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sz="3600" b="1" dirty="0"/>
              <a:t>B</a:t>
            </a:r>
          </a:p>
        </p:txBody>
      </p:sp>
      <p:sp>
        <p:nvSpPr>
          <p:cNvPr id="121" name="TextBox 120"/>
          <p:cNvSpPr txBox="1"/>
          <p:nvPr/>
        </p:nvSpPr>
        <p:spPr>
          <a:xfrm>
            <a:off x="4025009" y="12234739"/>
            <a:ext cx="428322" cy="646331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sz="3600" b="1" dirty="0"/>
              <a:t>C</a:t>
            </a:r>
          </a:p>
        </p:txBody>
      </p:sp>
      <p:sp>
        <p:nvSpPr>
          <p:cNvPr id="122" name="TextBox 121"/>
          <p:cNvSpPr txBox="1"/>
          <p:nvPr/>
        </p:nvSpPr>
        <p:spPr>
          <a:xfrm>
            <a:off x="6935327" y="12234743"/>
            <a:ext cx="476412" cy="646331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sz="3600" b="1" dirty="0"/>
              <a:t>D</a:t>
            </a:r>
          </a:p>
        </p:txBody>
      </p:sp>
      <p:sp>
        <p:nvSpPr>
          <p:cNvPr id="123" name="TextBox 122"/>
          <p:cNvSpPr txBox="1"/>
          <p:nvPr/>
        </p:nvSpPr>
        <p:spPr>
          <a:xfrm>
            <a:off x="10826599" y="12234743"/>
            <a:ext cx="409086" cy="646331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sz="3600" b="1" dirty="0"/>
              <a:t>E</a:t>
            </a:r>
          </a:p>
        </p:txBody>
      </p:sp>
      <p:sp>
        <p:nvSpPr>
          <p:cNvPr id="124" name="TextBox 123"/>
          <p:cNvSpPr txBox="1"/>
          <p:nvPr/>
        </p:nvSpPr>
        <p:spPr>
          <a:xfrm>
            <a:off x="14023261" y="12234743"/>
            <a:ext cx="396262" cy="646331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sz="3600" b="1" dirty="0"/>
              <a:t>F</a:t>
            </a:r>
          </a:p>
        </p:txBody>
      </p:sp>
      <p:sp>
        <p:nvSpPr>
          <p:cNvPr id="125" name="TextBox 124"/>
          <p:cNvSpPr txBox="1"/>
          <p:nvPr/>
        </p:nvSpPr>
        <p:spPr>
          <a:xfrm>
            <a:off x="16998107" y="12234739"/>
            <a:ext cx="479618" cy="646331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sz="3600" b="1" dirty="0"/>
              <a:t>G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883E07AB-E42B-C807-B4E7-F064E352B42D}"/>
              </a:ext>
            </a:extLst>
          </p:cNvPr>
          <p:cNvSpPr txBox="1"/>
          <p:nvPr/>
        </p:nvSpPr>
        <p:spPr>
          <a:xfrm>
            <a:off x="197715" y="210681"/>
            <a:ext cx="4532587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200" b="1" dirty="0"/>
              <a:t>Supplementary Figure S3.</a:t>
            </a:r>
          </a:p>
        </p:txBody>
      </p:sp>
      <p:sp>
        <p:nvSpPr>
          <p:cNvPr id="3" name="Rectangle 2">
            <a:extLst>
              <a:ext uri="{FF2B5EF4-FFF2-40B4-BE49-F238E27FC236}">
                <a16:creationId xmlns:a16="http://schemas.microsoft.com/office/drawing/2014/main" id="{619DEF77-0772-99F4-673F-6B7AA92AB67D}"/>
              </a:ext>
            </a:extLst>
          </p:cNvPr>
          <p:cNvSpPr/>
          <p:nvPr/>
        </p:nvSpPr>
        <p:spPr>
          <a:xfrm>
            <a:off x="928023" y="22748068"/>
            <a:ext cx="21902480" cy="674030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36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3. Maternal IAV infection had no effect on levels of tight junction proteins, CD31, </a:t>
            </a:r>
            <a:r>
              <a:rPr lang="en-US" sz="3600" b="1" i="1" dirty="0">
                <a:latin typeface="Arial" panose="020B0604020202020204" pitchFamily="34" charset="0"/>
                <a:cs typeface="Arial" panose="020B0604020202020204" pitchFamily="34" charset="0"/>
              </a:rPr>
              <a:t>Nos-2</a:t>
            </a:r>
            <a:r>
              <a:rPr lang="en-US" sz="3600" b="1" dirty="0">
                <a:latin typeface="Arial" panose="020B0604020202020204" pitchFamily="34" charset="0"/>
                <a:cs typeface="Arial" panose="020B0604020202020204" pitchFamily="34" charset="0"/>
              </a:rPr>
              <a:t>, or </a:t>
            </a:r>
            <a:r>
              <a:rPr lang="en-US" sz="3600" b="1" i="1" dirty="0">
                <a:latin typeface="Arial" panose="020B0604020202020204" pitchFamily="34" charset="0"/>
                <a:cs typeface="Arial" panose="020B0604020202020204" pitchFamily="34" charset="0"/>
              </a:rPr>
              <a:t>Cox-2</a:t>
            </a:r>
            <a:r>
              <a:rPr lang="en-US" sz="3600" b="1" dirty="0">
                <a:latin typeface="Arial" panose="020B0604020202020204" pitchFamily="34" charset="0"/>
                <a:cs typeface="Arial" panose="020B0604020202020204" pitchFamily="34" charset="0"/>
              </a:rPr>
              <a:t> in the placenta.</a:t>
            </a:r>
            <a:r>
              <a:rPr lang="en-US" sz="3600" dirty="0">
                <a:solidFill>
                  <a:srgbClr val="0D0D0D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en-US" sz="3600" b="1" dirty="0">
                <a:solidFill>
                  <a:srgbClr val="0D0D0D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US" sz="3600" dirty="0">
                <a:solidFill>
                  <a:srgbClr val="0D0D0D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) Representative cross-sectional images of CLDN1 and OCLN staining in placental specimens. </a:t>
            </a:r>
            <a:r>
              <a:rPr lang="en-US" sz="36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sz="3600" b="1" dirty="0">
                <a:latin typeface="Arial" panose="020B0604020202020204" pitchFamily="34" charset="0"/>
                <a:cs typeface="Arial" panose="020B0604020202020204" pitchFamily="34" charset="0"/>
              </a:rPr>
              <a:t>B-G</a:t>
            </a:r>
            <a:r>
              <a:rPr lang="en-US" sz="36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r>
              <a:rPr lang="en-US" sz="3600" dirty="0">
                <a:solidFill>
                  <a:srgbClr val="0D0D0D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3600" dirty="0">
                <a:latin typeface="Arial" panose="020B0604020202020204" pitchFamily="34" charset="0"/>
                <a:cs typeface="Arial" panose="020B0604020202020204" pitchFamily="34" charset="0"/>
              </a:rPr>
              <a:t>MFI/mm² quantification for CLDN1 and OCLN did not reach significance across treatment groups. (</a:t>
            </a:r>
            <a:r>
              <a:rPr lang="en-US" sz="3600" b="1" dirty="0">
                <a:latin typeface="Arial" panose="020B0604020202020204" pitchFamily="34" charset="0"/>
                <a:cs typeface="Arial" panose="020B0604020202020204" pitchFamily="34" charset="0"/>
              </a:rPr>
              <a:t>H-N</a:t>
            </a:r>
            <a:r>
              <a:rPr lang="en-US" sz="3600" dirty="0">
                <a:latin typeface="Arial" panose="020B0604020202020204" pitchFamily="34" charset="0"/>
                <a:cs typeface="Arial" panose="020B0604020202020204" pitchFamily="34" charset="0"/>
              </a:rPr>
              <a:t>) No changes were observed in expression of </a:t>
            </a:r>
            <a:r>
              <a:rPr lang="en-US" sz="3600" i="1" dirty="0">
                <a:latin typeface="Arial" panose="020B0604020202020204" pitchFamily="34" charset="0"/>
                <a:cs typeface="Arial" panose="020B0604020202020204" pitchFamily="34" charset="0"/>
              </a:rPr>
              <a:t>Cldn1</a:t>
            </a:r>
            <a:r>
              <a:rPr lang="en-US" sz="3600" dirty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US" sz="3600" i="1" dirty="0">
                <a:latin typeface="Arial" panose="020B0604020202020204" pitchFamily="34" charset="0"/>
                <a:cs typeface="Arial" panose="020B0604020202020204" pitchFamily="34" charset="0"/>
              </a:rPr>
              <a:t>Cldn2</a:t>
            </a:r>
            <a:r>
              <a:rPr lang="en-US" sz="3600" dirty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US" sz="3600" i="1" dirty="0">
                <a:latin typeface="Arial" panose="020B0604020202020204" pitchFamily="34" charset="0"/>
                <a:cs typeface="Arial" panose="020B0604020202020204" pitchFamily="34" charset="0"/>
              </a:rPr>
              <a:t>Cldn4, </a:t>
            </a:r>
            <a:r>
              <a:rPr lang="en-US" sz="3600" i="1" dirty="0" err="1">
                <a:latin typeface="Arial" panose="020B0604020202020204" pitchFamily="34" charset="0"/>
                <a:cs typeface="Arial" panose="020B0604020202020204" pitchFamily="34" charset="0"/>
              </a:rPr>
              <a:t>Ocln</a:t>
            </a:r>
            <a:r>
              <a:rPr lang="en-US" sz="3600" i="1" dirty="0">
                <a:latin typeface="Arial" panose="020B0604020202020204" pitchFamily="34" charset="0"/>
                <a:cs typeface="Arial" panose="020B0604020202020204" pitchFamily="34" charset="0"/>
              </a:rPr>
              <a:t>, Zo-1, Nos-2</a:t>
            </a:r>
            <a:r>
              <a:rPr lang="en-US" sz="3600" dirty="0">
                <a:latin typeface="Arial" panose="020B0604020202020204" pitchFamily="34" charset="0"/>
                <a:cs typeface="Arial" panose="020B0604020202020204" pitchFamily="34" charset="0"/>
              </a:rPr>
              <a:t>, or </a:t>
            </a:r>
            <a:r>
              <a:rPr lang="en-US" sz="3600" i="1" dirty="0">
                <a:latin typeface="Arial" panose="020B0604020202020204" pitchFamily="34" charset="0"/>
                <a:cs typeface="Arial" panose="020B0604020202020204" pitchFamily="34" charset="0"/>
              </a:rPr>
              <a:t>Cox-2</a:t>
            </a:r>
            <a:r>
              <a:rPr lang="en-US" sz="3600" dirty="0">
                <a:latin typeface="Arial" panose="020B0604020202020204" pitchFamily="34" charset="0"/>
                <a:cs typeface="Arial" panose="020B0604020202020204" pitchFamily="34" charset="0"/>
              </a:rPr>
              <a:t> between treatment groups. </a:t>
            </a:r>
            <a:r>
              <a:rPr lang="en-US" sz="3600" dirty="0">
                <a:solidFill>
                  <a:srgbClr val="131F33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ne representative placenta per litter was used. Data are expressed as means ± SEM; </a:t>
            </a:r>
            <a:r>
              <a:rPr lang="en-US" sz="3600" dirty="0">
                <a:latin typeface="Arial" panose="020B0604020202020204" pitchFamily="34" charset="0"/>
                <a:cs typeface="Arial" panose="020B0604020202020204" pitchFamily="34" charset="0"/>
              </a:rPr>
              <a:t>circles represent individual placentas; </a:t>
            </a:r>
            <a:r>
              <a:rPr lang="en-US" sz="3600" dirty="0">
                <a:solidFill>
                  <a:srgbClr val="131F33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 per group: Con = 8-10, X31</a:t>
            </a:r>
            <a:r>
              <a:rPr lang="en-US" sz="3600" baseline="-25000" dirty="0">
                <a:solidFill>
                  <a:srgbClr val="131F33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od</a:t>
            </a:r>
            <a:r>
              <a:rPr lang="en-US" sz="3600" dirty="0">
                <a:solidFill>
                  <a:srgbClr val="131F33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= 7-9, X31</a:t>
            </a:r>
            <a:r>
              <a:rPr lang="en-US" sz="3600" baseline="-25000" dirty="0">
                <a:solidFill>
                  <a:srgbClr val="131F33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i</a:t>
            </a:r>
            <a:r>
              <a:rPr lang="en-US" sz="3600" dirty="0">
                <a:solidFill>
                  <a:srgbClr val="131F33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= 5-8</a:t>
            </a:r>
            <a:r>
              <a:rPr lang="en-US" sz="3600" dirty="0">
                <a:solidFill>
                  <a:srgbClr val="0D0D0D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sz="3600" dirty="0">
                <a:latin typeface="Arial" panose="020B0604020202020204" pitchFamily="34" charset="0"/>
                <a:cs typeface="Arial" panose="020B0604020202020204" pitchFamily="34" charset="0"/>
              </a:rPr>
              <a:t>Statistical analysis was conducted using a one-way ANOVA with Tukey's post hoc test.</a:t>
            </a:r>
            <a:r>
              <a:rPr lang="en-US" dirty="0"/>
              <a:t> </a:t>
            </a:r>
            <a:r>
              <a:rPr lang="en-US" sz="3600" dirty="0">
                <a:latin typeface="Arial" panose="020B0604020202020204" pitchFamily="34" charset="0"/>
                <a:cs typeface="Arial" panose="020B0604020202020204" pitchFamily="34" charset="0"/>
              </a:rPr>
              <a:t>For data containing residuals with unequal variance, Brown-Forsythe was used.</a:t>
            </a:r>
            <a:r>
              <a:rPr lang="en-US" sz="3600" dirty="0">
                <a:solidFill>
                  <a:srgbClr val="131F33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3600" dirty="0">
                <a:solidFill>
                  <a:srgbClr val="0D0D0D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lacental regions are delineated as: Decidua (small dotted lines), Junctional Zone (JZ; large dotted lines), Labyrinth (solid lines). Scale bars for the whole placenta (</a:t>
            </a:r>
            <a:r>
              <a:rPr lang="en-US" sz="3600" b="1" dirty="0">
                <a:solidFill>
                  <a:srgbClr val="0D0D0D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US" sz="3600" dirty="0">
                <a:solidFill>
                  <a:srgbClr val="0D0D0D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left rows) and magnification (</a:t>
            </a:r>
            <a:r>
              <a:rPr lang="en-US" sz="3600" b="1" dirty="0">
                <a:solidFill>
                  <a:srgbClr val="0D0D0D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-</a:t>
            </a:r>
            <a:r>
              <a:rPr lang="en-US" sz="3600" dirty="0">
                <a:solidFill>
                  <a:srgbClr val="0D0D0D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ight rows) are 200 </a:t>
            </a:r>
            <a:r>
              <a:rPr lang="el-GR" sz="3600" dirty="0">
                <a:solidFill>
                  <a:srgbClr val="0D0D0D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sz="3600" dirty="0">
                <a:solidFill>
                  <a:srgbClr val="0D0D0D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 and 50 </a:t>
            </a:r>
            <a:r>
              <a:rPr lang="el-GR" sz="3600" dirty="0">
                <a:solidFill>
                  <a:srgbClr val="0D0D0D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sz="3600" dirty="0">
                <a:solidFill>
                  <a:srgbClr val="0D0D0D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, respectively. </a:t>
            </a:r>
            <a:r>
              <a:rPr lang="en-US" sz="3600" dirty="0">
                <a:latin typeface="Arial" panose="020B0604020202020204" pitchFamily="34" charset="0"/>
                <a:cs typeface="Arial" panose="020B0604020202020204" pitchFamily="34" charset="0"/>
              </a:rPr>
              <a:t>JZ = junctional zone.</a:t>
            </a:r>
          </a:p>
          <a:p>
            <a:pPr algn="just"/>
            <a:endParaRPr lang="en-US" sz="3600" dirty="0">
              <a:solidFill>
                <a:srgbClr val="0D0D0D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06015504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4" name="Object 43"/>
          <p:cNvGraphicFramePr>
            <a:graphicFrameLocks noChangeAspect="1"/>
          </p:cNvGraphicFramePr>
          <p:nvPr/>
        </p:nvGraphicFramePr>
        <p:xfrm>
          <a:off x="20126325" y="5480833"/>
          <a:ext cx="2435225" cy="371633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3" imgW="2424073" imgH="3730836" progId="Prism10.Document">
                  <p:embed/>
                </p:oleObj>
              </mc:Choice>
              <mc:Fallback>
                <p:oleObj name="Prism 10" r:id="rId3" imgW="2424073" imgH="3730836" progId="Prism10.Document">
                  <p:embed/>
                  <p:pic>
                    <p:nvPicPr>
                      <p:cNvPr id="44" name="Object 43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20126325" y="5480833"/>
                        <a:ext cx="2435225" cy="371633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5" name="Object 44"/>
          <p:cNvGraphicFramePr>
            <a:graphicFrameLocks noChangeAspect="1"/>
          </p:cNvGraphicFramePr>
          <p:nvPr/>
        </p:nvGraphicFramePr>
        <p:xfrm>
          <a:off x="20137438" y="1561751"/>
          <a:ext cx="2424112" cy="37496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5" imgW="2424073" imgH="3730836" progId="Prism10.Document">
                  <p:embed/>
                </p:oleObj>
              </mc:Choice>
              <mc:Fallback>
                <p:oleObj name="Prism 10" r:id="rId5" imgW="2424073" imgH="3730836" progId="Prism10.Document">
                  <p:embed/>
                  <p:pic>
                    <p:nvPicPr>
                      <p:cNvPr id="45" name="Object 44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20137438" y="1561751"/>
                        <a:ext cx="2424112" cy="37496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6" name="Object 5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194921265"/>
              </p:ext>
            </p:extLst>
          </p:nvPr>
        </p:nvGraphicFramePr>
        <p:xfrm>
          <a:off x="7431241" y="9849862"/>
          <a:ext cx="3136900" cy="414496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7" imgW="2820583" imgH="3735518" progId="Prism10.Document">
                  <p:embed/>
                </p:oleObj>
              </mc:Choice>
              <mc:Fallback>
                <p:oleObj name="Prism 10" r:id="rId7" imgW="2820583" imgH="3735518" progId="Prism10.Document">
                  <p:embed/>
                  <p:pic>
                    <p:nvPicPr>
                      <p:cNvPr id="56" name="Object 55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7431241" y="9849862"/>
                        <a:ext cx="3136900" cy="414496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7" name="Object 5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760592796"/>
              </p:ext>
            </p:extLst>
          </p:nvPr>
        </p:nvGraphicFramePr>
        <p:xfrm>
          <a:off x="587269" y="9812668"/>
          <a:ext cx="3521075" cy="413861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9" imgW="3117695" imgH="3735518" progId="Prism10.Document">
                  <p:embed/>
                </p:oleObj>
              </mc:Choice>
              <mc:Fallback>
                <p:oleObj name="Prism 10" r:id="rId9" imgW="3117695" imgH="3735518" progId="Prism10.Document">
                  <p:embed/>
                  <p:pic>
                    <p:nvPicPr>
                      <p:cNvPr id="57" name="Object 56"/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587269" y="9812668"/>
                        <a:ext cx="3521075" cy="413861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8" name="Object 57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211548568"/>
              </p:ext>
            </p:extLst>
          </p:nvPr>
        </p:nvGraphicFramePr>
        <p:xfrm>
          <a:off x="4291013" y="9826049"/>
          <a:ext cx="2836862" cy="41687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11" imgW="2820583" imgH="3735518" progId="Prism10.Document">
                  <p:embed/>
                </p:oleObj>
              </mc:Choice>
              <mc:Fallback>
                <p:oleObj name="Prism 10" r:id="rId11" imgW="2820583" imgH="3735518" progId="Prism10.Document">
                  <p:embed/>
                  <p:pic>
                    <p:nvPicPr>
                      <p:cNvPr id="58" name="Object 57"/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4291013" y="9826049"/>
                        <a:ext cx="2836862" cy="41687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9" name="Object 58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02689146"/>
              </p:ext>
            </p:extLst>
          </p:nvPr>
        </p:nvGraphicFramePr>
        <p:xfrm>
          <a:off x="10871316" y="9862562"/>
          <a:ext cx="2770188" cy="413226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13" imgW="2820583" imgH="3735518" progId="Prism10.Document">
                  <p:embed/>
                </p:oleObj>
              </mc:Choice>
              <mc:Fallback>
                <p:oleObj name="Prism 10" r:id="rId13" imgW="2820583" imgH="3735518" progId="Prism10.Document">
                  <p:embed/>
                  <p:pic>
                    <p:nvPicPr>
                      <p:cNvPr id="59" name="Object 58"/>
                      <p:cNvPicPr/>
                      <p:nvPr/>
                    </p:nvPicPr>
                    <p:blipFill>
                      <a:blip r:embed="rId14"/>
                      <a:stretch>
                        <a:fillRect/>
                      </a:stretch>
                    </p:blipFill>
                    <p:spPr>
                      <a:xfrm>
                        <a:off x="10871316" y="9862562"/>
                        <a:ext cx="2770188" cy="413226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1" name="Object 60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891274414"/>
              </p:ext>
            </p:extLst>
          </p:nvPr>
        </p:nvGraphicFramePr>
        <p:xfrm>
          <a:off x="17006929" y="9937174"/>
          <a:ext cx="2760662" cy="40560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15" imgW="2820583" imgH="3735518" progId="Prism10.Document">
                  <p:embed/>
                </p:oleObj>
              </mc:Choice>
              <mc:Fallback>
                <p:oleObj name="Prism 10" r:id="rId15" imgW="2820583" imgH="3735518" progId="Prism10.Document">
                  <p:embed/>
                  <p:pic>
                    <p:nvPicPr>
                      <p:cNvPr id="61" name="Object 60"/>
                      <p:cNvPicPr/>
                      <p:nvPr/>
                    </p:nvPicPr>
                    <p:blipFill>
                      <a:blip r:embed="rId16"/>
                      <a:stretch>
                        <a:fillRect/>
                      </a:stretch>
                    </p:blipFill>
                    <p:spPr>
                      <a:xfrm>
                        <a:off x="17006929" y="9937174"/>
                        <a:ext cx="2760662" cy="40560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2" name="Object 6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115297681"/>
              </p:ext>
            </p:extLst>
          </p:nvPr>
        </p:nvGraphicFramePr>
        <p:xfrm>
          <a:off x="20070765" y="9949874"/>
          <a:ext cx="2770187" cy="40433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17" imgW="2820583" imgH="3735518" progId="Prism10.Document">
                  <p:embed/>
                </p:oleObj>
              </mc:Choice>
              <mc:Fallback>
                <p:oleObj name="Prism 10" r:id="rId17" imgW="2820583" imgH="3735518" progId="Prism10.Document">
                  <p:embed/>
                  <p:pic>
                    <p:nvPicPr>
                      <p:cNvPr id="62" name="Object 61"/>
                      <p:cNvPicPr/>
                      <p:nvPr/>
                    </p:nvPicPr>
                    <p:blipFill>
                      <a:blip r:embed="rId18"/>
                      <a:stretch>
                        <a:fillRect/>
                      </a:stretch>
                    </p:blipFill>
                    <p:spPr>
                      <a:xfrm>
                        <a:off x="20070765" y="9949874"/>
                        <a:ext cx="2770187" cy="40433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3" name="Object 6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834367970"/>
              </p:ext>
            </p:extLst>
          </p:nvPr>
        </p:nvGraphicFramePr>
        <p:xfrm>
          <a:off x="13944679" y="9872087"/>
          <a:ext cx="2759075" cy="41211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19" imgW="2820583" imgH="3735518" progId="Prism10.Document">
                  <p:embed/>
                </p:oleObj>
              </mc:Choice>
              <mc:Fallback>
                <p:oleObj name="Prism 10" r:id="rId19" imgW="2820583" imgH="3735518" progId="Prism10.Document">
                  <p:embed/>
                  <p:pic>
                    <p:nvPicPr>
                      <p:cNvPr id="63" name="Object 62"/>
                      <p:cNvPicPr/>
                      <p:nvPr/>
                    </p:nvPicPr>
                    <p:blipFill>
                      <a:blip r:embed="rId20"/>
                      <a:stretch>
                        <a:fillRect/>
                      </a:stretch>
                    </p:blipFill>
                    <p:spPr>
                      <a:xfrm>
                        <a:off x="13944679" y="9872087"/>
                        <a:ext cx="2759075" cy="41211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73" name="TextBox 72"/>
          <p:cNvSpPr txBox="1"/>
          <p:nvPr/>
        </p:nvSpPr>
        <p:spPr>
          <a:xfrm>
            <a:off x="654634" y="9014673"/>
            <a:ext cx="476412" cy="646331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sz="3600" b="1" dirty="0"/>
              <a:t>D</a:t>
            </a:r>
          </a:p>
        </p:txBody>
      </p:sp>
      <p:sp>
        <p:nvSpPr>
          <p:cNvPr id="74" name="TextBox 73"/>
          <p:cNvSpPr txBox="1"/>
          <p:nvPr/>
        </p:nvSpPr>
        <p:spPr>
          <a:xfrm>
            <a:off x="4013200" y="9014673"/>
            <a:ext cx="409086" cy="646331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sz="3600" b="1" dirty="0"/>
              <a:t>E</a:t>
            </a:r>
          </a:p>
        </p:txBody>
      </p:sp>
      <p:sp>
        <p:nvSpPr>
          <p:cNvPr id="75" name="TextBox 74"/>
          <p:cNvSpPr txBox="1"/>
          <p:nvPr/>
        </p:nvSpPr>
        <p:spPr>
          <a:xfrm>
            <a:off x="7191440" y="9014677"/>
            <a:ext cx="396262" cy="646331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sz="3600" b="1" dirty="0"/>
              <a:t>F</a:t>
            </a:r>
          </a:p>
        </p:txBody>
      </p:sp>
      <p:sp>
        <p:nvSpPr>
          <p:cNvPr id="76" name="TextBox 75"/>
          <p:cNvSpPr txBox="1"/>
          <p:nvPr/>
        </p:nvSpPr>
        <p:spPr>
          <a:xfrm>
            <a:off x="10465251" y="9014677"/>
            <a:ext cx="479618" cy="646331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sz="3600" b="1" dirty="0"/>
              <a:t>G</a:t>
            </a:r>
          </a:p>
        </p:txBody>
      </p:sp>
      <p:sp>
        <p:nvSpPr>
          <p:cNvPr id="77" name="TextBox 76"/>
          <p:cNvSpPr txBox="1"/>
          <p:nvPr/>
        </p:nvSpPr>
        <p:spPr>
          <a:xfrm>
            <a:off x="13623916" y="9014677"/>
            <a:ext cx="476412" cy="646331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sz="3600" b="1" dirty="0"/>
              <a:t>H</a:t>
            </a:r>
          </a:p>
        </p:txBody>
      </p:sp>
      <p:sp>
        <p:nvSpPr>
          <p:cNvPr id="78" name="TextBox 77"/>
          <p:cNvSpPr txBox="1"/>
          <p:nvPr/>
        </p:nvSpPr>
        <p:spPr>
          <a:xfrm>
            <a:off x="16734453" y="9014673"/>
            <a:ext cx="308098" cy="646331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sz="3600" b="1" dirty="0"/>
              <a:t>I</a:t>
            </a:r>
          </a:p>
        </p:txBody>
      </p:sp>
      <p:sp>
        <p:nvSpPr>
          <p:cNvPr id="79" name="TextBox 78"/>
          <p:cNvSpPr txBox="1"/>
          <p:nvPr/>
        </p:nvSpPr>
        <p:spPr>
          <a:xfrm>
            <a:off x="19702981" y="9014673"/>
            <a:ext cx="336952" cy="646331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sz="3600" b="1" dirty="0"/>
              <a:t>J</a:t>
            </a:r>
          </a:p>
        </p:txBody>
      </p:sp>
      <p:sp>
        <p:nvSpPr>
          <p:cNvPr id="81" name="TextBox 80"/>
          <p:cNvSpPr txBox="1"/>
          <p:nvPr/>
        </p:nvSpPr>
        <p:spPr>
          <a:xfrm>
            <a:off x="19702981" y="1130613"/>
            <a:ext cx="442750" cy="646331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sz="3600" b="1" dirty="0"/>
              <a:t>B</a:t>
            </a:r>
          </a:p>
        </p:txBody>
      </p:sp>
      <p:sp>
        <p:nvSpPr>
          <p:cNvPr id="82" name="TextBox 81"/>
          <p:cNvSpPr txBox="1"/>
          <p:nvPr/>
        </p:nvSpPr>
        <p:spPr>
          <a:xfrm>
            <a:off x="19702981" y="5263531"/>
            <a:ext cx="428322" cy="646331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sz="3600" b="1" dirty="0"/>
              <a:t>C</a:t>
            </a:r>
          </a:p>
        </p:txBody>
      </p:sp>
      <p:sp>
        <p:nvSpPr>
          <p:cNvPr id="14" name="TextBox 13"/>
          <p:cNvSpPr txBox="1"/>
          <p:nvPr/>
        </p:nvSpPr>
        <p:spPr>
          <a:xfrm rot="16200000">
            <a:off x="300996" y="4995558"/>
            <a:ext cx="1172126" cy="536397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sz="2800" b="1" dirty="0">
                <a:solidFill>
                  <a:srgbClr val="FF0000"/>
                </a:solidFill>
              </a:rPr>
              <a:t>CLDN5</a:t>
            </a:r>
          </a:p>
        </p:txBody>
      </p:sp>
      <p:sp>
        <p:nvSpPr>
          <p:cNvPr id="15" name="TextBox 14"/>
          <p:cNvSpPr txBox="1"/>
          <p:nvPr/>
        </p:nvSpPr>
        <p:spPr>
          <a:xfrm rot="16200000">
            <a:off x="404252" y="3944002"/>
            <a:ext cx="965618" cy="536397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sz="2800" b="1" dirty="0">
                <a:solidFill>
                  <a:srgbClr val="00B050"/>
                </a:solidFill>
              </a:rPr>
              <a:t>CD31</a:t>
            </a:r>
          </a:p>
        </p:txBody>
      </p:sp>
      <p:pic>
        <p:nvPicPr>
          <p:cNvPr id="12" name="Picture 11"/>
          <p:cNvPicPr>
            <a:picLocks noChangeAspect="1"/>
          </p:cNvPicPr>
          <p:nvPr/>
        </p:nvPicPr>
        <p:blipFill>
          <a:blip r:embed="rId21" cstate="print">
            <a:extLst>
              <a:ext uri="{BEBA8EAE-BF5A-486C-A8C5-ECC9F3942E4B}">
                <a14:imgProps xmlns:a14="http://schemas.microsoft.com/office/drawing/2010/main">
                  <a14:imgLayer r:embed="rId22">
                    <a14:imgEffect>
                      <a14:brightnessContrast brigh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376587" y="1724899"/>
            <a:ext cx="9181413" cy="6980375"/>
          </a:xfrm>
          <a:prstGeom prst="rect">
            <a:avLst/>
          </a:prstGeom>
        </p:spPr>
      </p:pic>
      <p:sp>
        <p:nvSpPr>
          <p:cNvPr id="21" name="Freeform 20"/>
          <p:cNvSpPr/>
          <p:nvPr/>
        </p:nvSpPr>
        <p:spPr>
          <a:xfrm>
            <a:off x="12018848" y="2262637"/>
            <a:ext cx="2198725" cy="2503327"/>
          </a:xfrm>
          <a:custGeom>
            <a:avLst/>
            <a:gdLst>
              <a:gd name="connsiteX0" fmla="*/ 166688 w 1121569"/>
              <a:gd name="connsiteY0" fmla="*/ 88107 h 1185863"/>
              <a:gd name="connsiteX1" fmla="*/ 185738 w 1121569"/>
              <a:gd name="connsiteY1" fmla="*/ 85725 h 1185863"/>
              <a:gd name="connsiteX2" fmla="*/ 192882 w 1121569"/>
              <a:gd name="connsiteY2" fmla="*/ 80963 h 1185863"/>
              <a:gd name="connsiteX3" fmla="*/ 200025 w 1121569"/>
              <a:gd name="connsiteY3" fmla="*/ 78582 h 1185863"/>
              <a:gd name="connsiteX4" fmla="*/ 214313 w 1121569"/>
              <a:gd name="connsiteY4" fmla="*/ 69057 h 1185863"/>
              <a:gd name="connsiteX5" fmla="*/ 221457 w 1121569"/>
              <a:gd name="connsiteY5" fmla="*/ 66675 h 1185863"/>
              <a:gd name="connsiteX6" fmla="*/ 228600 w 1121569"/>
              <a:gd name="connsiteY6" fmla="*/ 61913 h 1185863"/>
              <a:gd name="connsiteX7" fmla="*/ 242888 w 1121569"/>
              <a:gd name="connsiteY7" fmla="*/ 57150 h 1185863"/>
              <a:gd name="connsiteX8" fmla="*/ 250032 w 1121569"/>
              <a:gd name="connsiteY8" fmla="*/ 54769 h 1185863"/>
              <a:gd name="connsiteX9" fmla="*/ 257175 w 1121569"/>
              <a:gd name="connsiteY9" fmla="*/ 52388 h 1185863"/>
              <a:gd name="connsiteX10" fmla="*/ 288132 w 1121569"/>
              <a:gd name="connsiteY10" fmla="*/ 47625 h 1185863"/>
              <a:gd name="connsiteX11" fmla="*/ 323850 w 1121569"/>
              <a:gd name="connsiteY11" fmla="*/ 35719 h 1185863"/>
              <a:gd name="connsiteX12" fmla="*/ 330994 w 1121569"/>
              <a:gd name="connsiteY12" fmla="*/ 33338 h 1185863"/>
              <a:gd name="connsiteX13" fmla="*/ 338138 w 1121569"/>
              <a:gd name="connsiteY13" fmla="*/ 30957 h 1185863"/>
              <a:gd name="connsiteX14" fmla="*/ 345282 w 1121569"/>
              <a:gd name="connsiteY14" fmla="*/ 26194 h 1185863"/>
              <a:gd name="connsiteX15" fmla="*/ 352425 w 1121569"/>
              <a:gd name="connsiteY15" fmla="*/ 23813 h 1185863"/>
              <a:gd name="connsiteX16" fmla="*/ 378619 w 1121569"/>
              <a:gd name="connsiteY16" fmla="*/ 19050 h 1185863"/>
              <a:gd name="connsiteX17" fmla="*/ 390525 w 1121569"/>
              <a:gd name="connsiteY17" fmla="*/ 16669 h 1185863"/>
              <a:gd name="connsiteX18" fmla="*/ 416719 w 1121569"/>
              <a:gd name="connsiteY18" fmla="*/ 9525 h 1185863"/>
              <a:gd name="connsiteX19" fmla="*/ 500063 w 1121569"/>
              <a:gd name="connsiteY19" fmla="*/ 4763 h 1185863"/>
              <a:gd name="connsiteX20" fmla="*/ 523875 w 1121569"/>
              <a:gd name="connsiteY20" fmla="*/ 2382 h 1185863"/>
              <a:gd name="connsiteX21" fmla="*/ 542925 w 1121569"/>
              <a:gd name="connsiteY21" fmla="*/ 0 h 1185863"/>
              <a:gd name="connsiteX22" fmla="*/ 611982 w 1121569"/>
              <a:gd name="connsiteY22" fmla="*/ 2382 h 1185863"/>
              <a:gd name="connsiteX23" fmla="*/ 626269 w 1121569"/>
              <a:gd name="connsiteY23" fmla="*/ 4763 h 1185863"/>
              <a:gd name="connsiteX24" fmla="*/ 640557 w 1121569"/>
              <a:gd name="connsiteY24" fmla="*/ 9525 h 1185863"/>
              <a:gd name="connsiteX25" fmla="*/ 664369 w 1121569"/>
              <a:gd name="connsiteY25" fmla="*/ 14288 h 1185863"/>
              <a:gd name="connsiteX26" fmla="*/ 671513 w 1121569"/>
              <a:gd name="connsiteY26" fmla="*/ 16669 h 1185863"/>
              <a:gd name="connsiteX27" fmla="*/ 721519 w 1121569"/>
              <a:gd name="connsiteY27" fmla="*/ 23813 h 1185863"/>
              <a:gd name="connsiteX28" fmla="*/ 735807 w 1121569"/>
              <a:gd name="connsiteY28" fmla="*/ 28575 h 1185863"/>
              <a:gd name="connsiteX29" fmla="*/ 742950 w 1121569"/>
              <a:gd name="connsiteY29" fmla="*/ 30957 h 1185863"/>
              <a:gd name="connsiteX30" fmla="*/ 752475 w 1121569"/>
              <a:gd name="connsiteY30" fmla="*/ 33338 h 1185863"/>
              <a:gd name="connsiteX31" fmla="*/ 766763 w 1121569"/>
              <a:gd name="connsiteY31" fmla="*/ 38100 h 1185863"/>
              <a:gd name="connsiteX32" fmla="*/ 788194 w 1121569"/>
              <a:gd name="connsiteY32" fmla="*/ 45244 h 1185863"/>
              <a:gd name="connsiteX33" fmla="*/ 809625 w 1121569"/>
              <a:gd name="connsiteY33" fmla="*/ 52388 h 1185863"/>
              <a:gd name="connsiteX34" fmla="*/ 816769 w 1121569"/>
              <a:gd name="connsiteY34" fmla="*/ 54769 h 1185863"/>
              <a:gd name="connsiteX35" fmla="*/ 823913 w 1121569"/>
              <a:gd name="connsiteY35" fmla="*/ 57150 h 1185863"/>
              <a:gd name="connsiteX36" fmla="*/ 857250 w 1121569"/>
              <a:gd name="connsiteY36" fmla="*/ 59532 h 1185863"/>
              <a:gd name="connsiteX37" fmla="*/ 885825 w 1121569"/>
              <a:gd name="connsiteY37" fmla="*/ 64294 h 1185863"/>
              <a:gd name="connsiteX38" fmla="*/ 900113 w 1121569"/>
              <a:gd name="connsiteY38" fmla="*/ 69057 h 1185863"/>
              <a:gd name="connsiteX39" fmla="*/ 909638 w 1121569"/>
              <a:gd name="connsiteY39" fmla="*/ 71438 h 1185863"/>
              <a:gd name="connsiteX40" fmla="*/ 921544 w 1121569"/>
              <a:gd name="connsiteY40" fmla="*/ 73819 h 1185863"/>
              <a:gd name="connsiteX41" fmla="*/ 935832 w 1121569"/>
              <a:gd name="connsiteY41" fmla="*/ 78582 h 1185863"/>
              <a:gd name="connsiteX42" fmla="*/ 950119 w 1121569"/>
              <a:gd name="connsiteY42" fmla="*/ 85725 h 1185863"/>
              <a:gd name="connsiteX43" fmla="*/ 964407 w 1121569"/>
              <a:gd name="connsiteY43" fmla="*/ 90488 h 1185863"/>
              <a:gd name="connsiteX44" fmla="*/ 969169 w 1121569"/>
              <a:gd name="connsiteY44" fmla="*/ 97632 h 1185863"/>
              <a:gd name="connsiteX45" fmla="*/ 976313 w 1121569"/>
              <a:gd name="connsiteY45" fmla="*/ 100013 h 1185863"/>
              <a:gd name="connsiteX46" fmla="*/ 983457 w 1121569"/>
              <a:gd name="connsiteY46" fmla="*/ 104775 h 1185863"/>
              <a:gd name="connsiteX47" fmla="*/ 997744 w 1121569"/>
              <a:gd name="connsiteY47" fmla="*/ 111919 h 1185863"/>
              <a:gd name="connsiteX48" fmla="*/ 1014413 w 1121569"/>
              <a:gd name="connsiteY48" fmla="*/ 128588 h 1185863"/>
              <a:gd name="connsiteX49" fmla="*/ 1019175 w 1121569"/>
              <a:gd name="connsiteY49" fmla="*/ 135732 h 1185863"/>
              <a:gd name="connsiteX50" fmla="*/ 1033463 w 1121569"/>
              <a:gd name="connsiteY50" fmla="*/ 145257 h 1185863"/>
              <a:gd name="connsiteX51" fmla="*/ 1042988 w 1121569"/>
              <a:gd name="connsiteY51" fmla="*/ 159544 h 1185863"/>
              <a:gd name="connsiteX52" fmla="*/ 1052513 w 1121569"/>
              <a:gd name="connsiteY52" fmla="*/ 173832 h 1185863"/>
              <a:gd name="connsiteX53" fmla="*/ 1057275 w 1121569"/>
              <a:gd name="connsiteY53" fmla="*/ 180975 h 1185863"/>
              <a:gd name="connsiteX54" fmla="*/ 1064419 w 1121569"/>
              <a:gd name="connsiteY54" fmla="*/ 188119 h 1185863"/>
              <a:gd name="connsiteX55" fmla="*/ 1071563 w 1121569"/>
              <a:gd name="connsiteY55" fmla="*/ 202407 h 1185863"/>
              <a:gd name="connsiteX56" fmla="*/ 1078707 w 1121569"/>
              <a:gd name="connsiteY56" fmla="*/ 226219 h 1185863"/>
              <a:gd name="connsiteX57" fmla="*/ 1081088 w 1121569"/>
              <a:gd name="connsiteY57" fmla="*/ 233363 h 1185863"/>
              <a:gd name="connsiteX58" fmla="*/ 1090613 w 1121569"/>
              <a:gd name="connsiteY58" fmla="*/ 247650 h 1185863"/>
              <a:gd name="connsiteX59" fmla="*/ 1095375 w 1121569"/>
              <a:gd name="connsiteY59" fmla="*/ 254794 h 1185863"/>
              <a:gd name="connsiteX60" fmla="*/ 1097757 w 1121569"/>
              <a:gd name="connsiteY60" fmla="*/ 261938 h 1185863"/>
              <a:gd name="connsiteX61" fmla="*/ 1102519 w 1121569"/>
              <a:gd name="connsiteY61" fmla="*/ 269082 h 1185863"/>
              <a:gd name="connsiteX62" fmla="*/ 1107282 w 1121569"/>
              <a:gd name="connsiteY62" fmla="*/ 283369 h 1185863"/>
              <a:gd name="connsiteX63" fmla="*/ 1112044 w 1121569"/>
              <a:gd name="connsiteY63" fmla="*/ 297657 h 1185863"/>
              <a:gd name="connsiteX64" fmla="*/ 1116807 w 1121569"/>
              <a:gd name="connsiteY64" fmla="*/ 314325 h 1185863"/>
              <a:gd name="connsiteX65" fmla="*/ 1121569 w 1121569"/>
              <a:gd name="connsiteY65" fmla="*/ 335757 h 1185863"/>
              <a:gd name="connsiteX66" fmla="*/ 1119188 w 1121569"/>
              <a:gd name="connsiteY66" fmla="*/ 381000 h 1185863"/>
              <a:gd name="connsiteX67" fmla="*/ 1116807 w 1121569"/>
              <a:gd name="connsiteY67" fmla="*/ 392907 h 1185863"/>
              <a:gd name="connsiteX68" fmla="*/ 1107282 w 1121569"/>
              <a:gd name="connsiteY68" fmla="*/ 426244 h 1185863"/>
              <a:gd name="connsiteX69" fmla="*/ 1104900 w 1121569"/>
              <a:gd name="connsiteY69" fmla="*/ 433388 h 1185863"/>
              <a:gd name="connsiteX70" fmla="*/ 1100138 w 1121569"/>
              <a:gd name="connsiteY70" fmla="*/ 440532 h 1185863"/>
              <a:gd name="connsiteX71" fmla="*/ 1090613 w 1121569"/>
              <a:gd name="connsiteY71" fmla="*/ 454819 h 1185863"/>
              <a:gd name="connsiteX72" fmla="*/ 1083469 w 1121569"/>
              <a:gd name="connsiteY72" fmla="*/ 469107 h 1185863"/>
              <a:gd name="connsiteX73" fmla="*/ 1076325 w 1121569"/>
              <a:gd name="connsiteY73" fmla="*/ 476250 h 1185863"/>
              <a:gd name="connsiteX74" fmla="*/ 1059657 w 1121569"/>
              <a:gd name="connsiteY74" fmla="*/ 495300 h 1185863"/>
              <a:gd name="connsiteX75" fmla="*/ 1050132 w 1121569"/>
              <a:gd name="connsiteY75" fmla="*/ 509588 h 1185863"/>
              <a:gd name="connsiteX76" fmla="*/ 1038225 w 1121569"/>
              <a:gd name="connsiteY76" fmla="*/ 523875 h 1185863"/>
              <a:gd name="connsiteX77" fmla="*/ 1035844 w 1121569"/>
              <a:gd name="connsiteY77" fmla="*/ 531019 h 1185863"/>
              <a:gd name="connsiteX78" fmla="*/ 1021557 w 1121569"/>
              <a:gd name="connsiteY78" fmla="*/ 540544 h 1185863"/>
              <a:gd name="connsiteX79" fmla="*/ 1012032 w 1121569"/>
              <a:gd name="connsiteY79" fmla="*/ 552450 h 1185863"/>
              <a:gd name="connsiteX80" fmla="*/ 1002507 w 1121569"/>
              <a:gd name="connsiteY80" fmla="*/ 566738 h 1185863"/>
              <a:gd name="connsiteX81" fmla="*/ 997744 w 1121569"/>
              <a:gd name="connsiteY81" fmla="*/ 573882 h 1185863"/>
              <a:gd name="connsiteX82" fmla="*/ 995363 w 1121569"/>
              <a:gd name="connsiteY82" fmla="*/ 581025 h 1185863"/>
              <a:gd name="connsiteX83" fmla="*/ 990600 w 1121569"/>
              <a:gd name="connsiteY83" fmla="*/ 600075 h 1185863"/>
              <a:gd name="connsiteX84" fmla="*/ 981075 w 1121569"/>
              <a:gd name="connsiteY84" fmla="*/ 614363 h 1185863"/>
              <a:gd name="connsiteX85" fmla="*/ 973932 w 1121569"/>
              <a:gd name="connsiteY85" fmla="*/ 619125 h 1185863"/>
              <a:gd name="connsiteX86" fmla="*/ 964407 w 1121569"/>
              <a:gd name="connsiteY86" fmla="*/ 633413 h 1185863"/>
              <a:gd name="connsiteX87" fmla="*/ 950119 w 1121569"/>
              <a:gd name="connsiteY87" fmla="*/ 645319 h 1185863"/>
              <a:gd name="connsiteX88" fmla="*/ 938213 w 1121569"/>
              <a:gd name="connsiteY88" fmla="*/ 657225 h 1185863"/>
              <a:gd name="connsiteX89" fmla="*/ 935832 w 1121569"/>
              <a:gd name="connsiteY89" fmla="*/ 664369 h 1185863"/>
              <a:gd name="connsiteX90" fmla="*/ 928688 w 1121569"/>
              <a:gd name="connsiteY90" fmla="*/ 669132 h 1185863"/>
              <a:gd name="connsiteX91" fmla="*/ 921544 w 1121569"/>
              <a:gd name="connsiteY91" fmla="*/ 676275 h 1185863"/>
              <a:gd name="connsiteX92" fmla="*/ 909638 w 1121569"/>
              <a:gd name="connsiteY92" fmla="*/ 685800 h 1185863"/>
              <a:gd name="connsiteX93" fmla="*/ 902494 w 1121569"/>
              <a:gd name="connsiteY93" fmla="*/ 707232 h 1185863"/>
              <a:gd name="connsiteX94" fmla="*/ 900113 w 1121569"/>
              <a:gd name="connsiteY94" fmla="*/ 714375 h 1185863"/>
              <a:gd name="connsiteX95" fmla="*/ 890588 w 1121569"/>
              <a:gd name="connsiteY95" fmla="*/ 728663 h 1185863"/>
              <a:gd name="connsiteX96" fmla="*/ 883444 w 1121569"/>
              <a:gd name="connsiteY96" fmla="*/ 735807 h 1185863"/>
              <a:gd name="connsiteX97" fmla="*/ 866775 w 1121569"/>
              <a:gd name="connsiteY97" fmla="*/ 754857 h 1185863"/>
              <a:gd name="connsiteX98" fmla="*/ 847725 w 1121569"/>
              <a:gd name="connsiteY98" fmla="*/ 783432 h 1185863"/>
              <a:gd name="connsiteX99" fmla="*/ 842963 w 1121569"/>
              <a:gd name="connsiteY99" fmla="*/ 790575 h 1185863"/>
              <a:gd name="connsiteX100" fmla="*/ 838200 w 1121569"/>
              <a:gd name="connsiteY100" fmla="*/ 797719 h 1185863"/>
              <a:gd name="connsiteX101" fmla="*/ 831057 w 1121569"/>
              <a:gd name="connsiteY101" fmla="*/ 812007 h 1185863"/>
              <a:gd name="connsiteX102" fmla="*/ 828675 w 1121569"/>
              <a:gd name="connsiteY102" fmla="*/ 819150 h 1185863"/>
              <a:gd name="connsiteX103" fmla="*/ 821532 w 1121569"/>
              <a:gd name="connsiteY103" fmla="*/ 826294 h 1185863"/>
              <a:gd name="connsiteX104" fmla="*/ 804863 w 1121569"/>
              <a:gd name="connsiteY104" fmla="*/ 845344 h 1185863"/>
              <a:gd name="connsiteX105" fmla="*/ 795338 w 1121569"/>
              <a:gd name="connsiteY105" fmla="*/ 859632 h 1185863"/>
              <a:gd name="connsiteX106" fmla="*/ 788194 w 1121569"/>
              <a:gd name="connsiteY106" fmla="*/ 866775 h 1185863"/>
              <a:gd name="connsiteX107" fmla="*/ 778669 w 1121569"/>
              <a:gd name="connsiteY107" fmla="*/ 881063 h 1185863"/>
              <a:gd name="connsiteX108" fmla="*/ 773907 w 1121569"/>
              <a:gd name="connsiteY108" fmla="*/ 888207 h 1185863"/>
              <a:gd name="connsiteX109" fmla="*/ 766763 w 1121569"/>
              <a:gd name="connsiteY109" fmla="*/ 895350 h 1185863"/>
              <a:gd name="connsiteX110" fmla="*/ 762000 w 1121569"/>
              <a:gd name="connsiteY110" fmla="*/ 909638 h 1185863"/>
              <a:gd name="connsiteX111" fmla="*/ 752475 w 1121569"/>
              <a:gd name="connsiteY111" fmla="*/ 923925 h 1185863"/>
              <a:gd name="connsiteX112" fmla="*/ 747713 w 1121569"/>
              <a:gd name="connsiteY112" fmla="*/ 931069 h 1185863"/>
              <a:gd name="connsiteX113" fmla="*/ 738188 w 1121569"/>
              <a:gd name="connsiteY113" fmla="*/ 945357 h 1185863"/>
              <a:gd name="connsiteX114" fmla="*/ 726282 w 1121569"/>
              <a:gd name="connsiteY114" fmla="*/ 966788 h 1185863"/>
              <a:gd name="connsiteX115" fmla="*/ 711994 w 1121569"/>
              <a:gd name="connsiteY115" fmla="*/ 988219 h 1185863"/>
              <a:gd name="connsiteX116" fmla="*/ 707232 w 1121569"/>
              <a:gd name="connsiteY116" fmla="*/ 995363 h 1185863"/>
              <a:gd name="connsiteX117" fmla="*/ 704850 w 1121569"/>
              <a:gd name="connsiteY117" fmla="*/ 1002507 h 1185863"/>
              <a:gd name="connsiteX118" fmla="*/ 697707 w 1121569"/>
              <a:gd name="connsiteY118" fmla="*/ 1007269 h 1185863"/>
              <a:gd name="connsiteX119" fmla="*/ 685800 w 1121569"/>
              <a:gd name="connsiteY119" fmla="*/ 1028700 h 1185863"/>
              <a:gd name="connsiteX120" fmla="*/ 678657 w 1121569"/>
              <a:gd name="connsiteY120" fmla="*/ 1033463 h 1185863"/>
              <a:gd name="connsiteX121" fmla="*/ 673894 w 1121569"/>
              <a:gd name="connsiteY121" fmla="*/ 1040607 h 1185863"/>
              <a:gd name="connsiteX122" fmla="*/ 659607 w 1121569"/>
              <a:gd name="connsiteY122" fmla="*/ 1047750 h 1185863"/>
              <a:gd name="connsiteX123" fmla="*/ 652463 w 1121569"/>
              <a:gd name="connsiteY123" fmla="*/ 1052513 h 1185863"/>
              <a:gd name="connsiteX124" fmla="*/ 638175 w 1121569"/>
              <a:gd name="connsiteY124" fmla="*/ 1057275 h 1185863"/>
              <a:gd name="connsiteX125" fmla="*/ 592932 w 1121569"/>
              <a:gd name="connsiteY125" fmla="*/ 1054894 h 1185863"/>
              <a:gd name="connsiteX126" fmla="*/ 585788 w 1121569"/>
              <a:gd name="connsiteY126" fmla="*/ 1052513 h 1185863"/>
              <a:gd name="connsiteX127" fmla="*/ 581025 w 1121569"/>
              <a:gd name="connsiteY127" fmla="*/ 1045369 h 1185863"/>
              <a:gd name="connsiteX128" fmla="*/ 573882 w 1121569"/>
              <a:gd name="connsiteY128" fmla="*/ 1038225 h 1185863"/>
              <a:gd name="connsiteX129" fmla="*/ 566738 w 1121569"/>
              <a:gd name="connsiteY129" fmla="*/ 1033463 h 1185863"/>
              <a:gd name="connsiteX130" fmla="*/ 552450 w 1121569"/>
              <a:gd name="connsiteY130" fmla="*/ 1019175 h 1185863"/>
              <a:gd name="connsiteX131" fmla="*/ 545307 w 1121569"/>
              <a:gd name="connsiteY131" fmla="*/ 1014413 h 1185863"/>
              <a:gd name="connsiteX132" fmla="*/ 533400 w 1121569"/>
              <a:gd name="connsiteY132" fmla="*/ 1000125 h 1185863"/>
              <a:gd name="connsiteX133" fmla="*/ 526257 w 1121569"/>
              <a:gd name="connsiteY133" fmla="*/ 995363 h 1185863"/>
              <a:gd name="connsiteX134" fmla="*/ 523875 w 1121569"/>
              <a:gd name="connsiteY134" fmla="*/ 988219 h 1185863"/>
              <a:gd name="connsiteX135" fmla="*/ 514350 w 1121569"/>
              <a:gd name="connsiteY135" fmla="*/ 973932 h 1185863"/>
              <a:gd name="connsiteX136" fmla="*/ 504825 w 1121569"/>
              <a:gd name="connsiteY136" fmla="*/ 952500 h 1185863"/>
              <a:gd name="connsiteX137" fmla="*/ 500063 w 1121569"/>
              <a:gd name="connsiteY137" fmla="*/ 938213 h 1185863"/>
              <a:gd name="connsiteX138" fmla="*/ 497682 w 1121569"/>
              <a:gd name="connsiteY138" fmla="*/ 931069 h 1185863"/>
              <a:gd name="connsiteX139" fmla="*/ 495300 w 1121569"/>
              <a:gd name="connsiteY139" fmla="*/ 921544 h 1185863"/>
              <a:gd name="connsiteX140" fmla="*/ 495300 w 1121569"/>
              <a:gd name="connsiteY140" fmla="*/ 812007 h 1185863"/>
              <a:gd name="connsiteX141" fmla="*/ 497682 w 1121569"/>
              <a:gd name="connsiteY141" fmla="*/ 804863 h 1185863"/>
              <a:gd name="connsiteX142" fmla="*/ 504825 w 1121569"/>
              <a:gd name="connsiteY142" fmla="*/ 778669 h 1185863"/>
              <a:gd name="connsiteX143" fmla="*/ 507207 w 1121569"/>
              <a:gd name="connsiteY143" fmla="*/ 771525 h 1185863"/>
              <a:gd name="connsiteX144" fmla="*/ 516732 w 1121569"/>
              <a:gd name="connsiteY144" fmla="*/ 757238 h 1185863"/>
              <a:gd name="connsiteX145" fmla="*/ 531019 w 1121569"/>
              <a:gd name="connsiteY145" fmla="*/ 714375 h 1185863"/>
              <a:gd name="connsiteX146" fmla="*/ 535782 w 1121569"/>
              <a:gd name="connsiteY146" fmla="*/ 700088 h 1185863"/>
              <a:gd name="connsiteX147" fmla="*/ 538163 w 1121569"/>
              <a:gd name="connsiteY147" fmla="*/ 692944 h 1185863"/>
              <a:gd name="connsiteX148" fmla="*/ 542925 w 1121569"/>
              <a:gd name="connsiteY148" fmla="*/ 685800 h 1185863"/>
              <a:gd name="connsiteX149" fmla="*/ 547688 w 1121569"/>
              <a:gd name="connsiteY149" fmla="*/ 671513 h 1185863"/>
              <a:gd name="connsiteX150" fmla="*/ 550069 w 1121569"/>
              <a:gd name="connsiteY150" fmla="*/ 664369 h 1185863"/>
              <a:gd name="connsiteX151" fmla="*/ 554832 w 1121569"/>
              <a:gd name="connsiteY151" fmla="*/ 657225 h 1185863"/>
              <a:gd name="connsiteX152" fmla="*/ 557213 w 1121569"/>
              <a:gd name="connsiteY152" fmla="*/ 650082 h 1185863"/>
              <a:gd name="connsiteX153" fmla="*/ 566738 w 1121569"/>
              <a:gd name="connsiteY153" fmla="*/ 635794 h 1185863"/>
              <a:gd name="connsiteX154" fmla="*/ 576263 w 1121569"/>
              <a:gd name="connsiteY154" fmla="*/ 621507 h 1185863"/>
              <a:gd name="connsiteX155" fmla="*/ 581025 w 1121569"/>
              <a:gd name="connsiteY155" fmla="*/ 614363 h 1185863"/>
              <a:gd name="connsiteX156" fmla="*/ 583407 w 1121569"/>
              <a:gd name="connsiteY156" fmla="*/ 607219 h 1185863"/>
              <a:gd name="connsiteX157" fmla="*/ 590550 w 1121569"/>
              <a:gd name="connsiteY157" fmla="*/ 602457 h 1185863"/>
              <a:gd name="connsiteX158" fmla="*/ 592932 w 1121569"/>
              <a:gd name="connsiteY158" fmla="*/ 595313 h 1185863"/>
              <a:gd name="connsiteX159" fmla="*/ 597694 w 1121569"/>
              <a:gd name="connsiteY159" fmla="*/ 578644 h 1185863"/>
              <a:gd name="connsiteX160" fmla="*/ 602457 w 1121569"/>
              <a:gd name="connsiteY160" fmla="*/ 571500 h 1185863"/>
              <a:gd name="connsiteX161" fmla="*/ 609600 w 1121569"/>
              <a:gd name="connsiteY161" fmla="*/ 557213 h 1185863"/>
              <a:gd name="connsiteX162" fmla="*/ 611982 w 1121569"/>
              <a:gd name="connsiteY162" fmla="*/ 550069 h 1185863"/>
              <a:gd name="connsiteX163" fmla="*/ 616744 w 1121569"/>
              <a:gd name="connsiteY163" fmla="*/ 542925 h 1185863"/>
              <a:gd name="connsiteX164" fmla="*/ 621507 w 1121569"/>
              <a:gd name="connsiteY164" fmla="*/ 521494 h 1185863"/>
              <a:gd name="connsiteX165" fmla="*/ 619125 w 1121569"/>
              <a:gd name="connsiteY165" fmla="*/ 485775 h 1185863"/>
              <a:gd name="connsiteX166" fmla="*/ 616744 w 1121569"/>
              <a:gd name="connsiteY166" fmla="*/ 476250 h 1185863"/>
              <a:gd name="connsiteX167" fmla="*/ 614363 w 1121569"/>
              <a:gd name="connsiteY167" fmla="*/ 464344 h 1185863"/>
              <a:gd name="connsiteX168" fmla="*/ 609600 w 1121569"/>
              <a:gd name="connsiteY168" fmla="*/ 447675 h 1185863"/>
              <a:gd name="connsiteX169" fmla="*/ 604838 w 1121569"/>
              <a:gd name="connsiteY169" fmla="*/ 440532 h 1185863"/>
              <a:gd name="connsiteX170" fmla="*/ 597694 w 1121569"/>
              <a:gd name="connsiteY170" fmla="*/ 438150 h 1185863"/>
              <a:gd name="connsiteX171" fmla="*/ 578644 w 1121569"/>
              <a:gd name="connsiteY171" fmla="*/ 426244 h 1185863"/>
              <a:gd name="connsiteX172" fmla="*/ 571500 w 1121569"/>
              <a:gd name="connsiteY172" fmla="*/ 423863 h 1185863"/>
              <a:gd name="connsiteX173" fmla="*/ 564357 w 1121569"/>
              <a:gd name="connsiteY173" fmla="*/ 421482 h 1185863"/>
              <a:gd name="connsiteX174" fmla="*/ 516732 w 1121569"/>
              <a:gd name="connsiteY174" fmla="*/ 416719 h 1185863"/>
              <a:gd name="connsiteX175" fmla="*/ 504825 w 1121569"/>
              <a:gd name="connsiteY175" fmla="*/ 414338 h 1185863"/>
              <a:gd name="connsiteX176" fmla="*/ 440532 w 1121569"/>
              <a:gd name="connsiteY176" fmla="*/ 419100 h 1185863"/>
              <a:gd name="connsiteX177" fmla="*/ 416719 w 1121569"/>
              <a:gd name="connsiteY177" fmla="*/ 426244 h 1185863"/>
              <a:gd name="connsiteX178" fmla="*/ 402432 w 1121569"/>
              <a:gd name="connsiteY178" fmla="*/ 431007 h 1185863"/>
              <a:gd name="connsiteX179" fmla="*/ 388144 w 1121569"/>
              <a:gd name="connsiteY179" fmla="*/ 438150 h 1185863"/>
              <a:gd name="connsiteX180" fmla="*/ 366713 w 1121569"/>
              <a:gd name="connsiteY180" fmla="*/ 452438 h 1185863"/>
              <a:gd name="connsiteX181" fmla="*/ 359569 w 1121569"/>
              <a:gd name="connsiteY181" fmla="*/ 457200 h 1185863"/>
              <a:gd name="connsiteX182" fmla="*/ 330994 w 1121569"/>
              <a:gd name="connsiteY182" fmla="*/ 466725 h 1185863"/>
              <a:gd name="connsiteX183" fmla="*/ 323850 w 1121569"/>
              <a:gd name="connsiteY183" fmla="*/ 469107 h 1185863"/>
              <a:gd name="connsiteX184" fmla="*/ 316707 w 1121569"/>
              <a:gd name="connsiteY184" fmla="*/ 471488 h 1185863"/>
              <a:gd name="connsiteX185" fmla="*/ 309563 w 1121569"/>
              <a:gd name="connsiteY185" fmla="*/ 476250 h 1185863"/>
              <a:gd name="connsiteX186" fmla="*/ 302419 w 1121569"/>
              <a:gd name="connsiteY186" fmla="*/ 478632 h 1185863"/>
              <a:gd name="connsiteX187" fmla="*/ 288132 w 1121569"/>
              <a:gd name="connsiteY187" fmla="*/ 488157 h 1185863"/>
              <a:gd name="connsiteX188" fmla="*/ 273844 w 1121569"/>
              <a:gd name="connsiteY188" fmla="*/ 500063 h 1185863"/>
              <a:gd name="connsiteX189" fmla="*/ 269082 w 1121569"/>
              <a:gd name="connsiteY189" fmla="*/ 507207 h 1185863"/>
              <a:gd name="connsiteX190" fmla="*/ 261938 w 1121569"/>
              <a:gd name="connsiteY190" fmla="*/ 511969 h 1185863"/>
              <a:gd name="connsiteX191" fmla="*/ 252413 w 1121569"/>
              <a:gd name="connsiteY191" fmla="*/ 526257 h 1185863"/>
              <a:gd name="connsiteX192" fmla="*/ 247650 w 1121569"/>
              <a:gd name="connsiteY192" fmla="*/ 533400 h 1185863"/>
              <a:gd name="connsiteX193" fmla="*/ 242888 w 1121569"/>
              <a:gd name="connsiteY193" fmla="*/ 540544 h 1185863"/>
              <a:gd name="connsiteX194" fmla="*/ 235744 w 1121569"/>
              <a:gd name="connsiteY194" fmla="*/ 545307 h 1185863"/>
              <a:gd name="connsiteX195" fmla="*/ 223838 w 1121569"/>
              <a:gd name="connsiteY195" fmla="*/ 557213 h 1185863"/>
              <a:gd name="connsiteX196" fmla="*/ 211932 w 1121569"/>
              <a:gd name="connsiteY196" fmla="*/ 569119 h 1185863"/>
              <a:gd name="connsiteX197" fmla="*/ 195263 w 1121569"/>
              <a:gd name="connsiteY197" fmla="*/ 585788 h 1185863"/>
              <a:gd name="connsiteX198" fmla="*/ 185738 w 1121569"/>
              <a:gd name="connsiteY198" fmla="*/ 597694 h 1185863"/>
              <a:gd name="connsiteX199" fmla="*/ 176213 w 1121569"/>
              <a:gd name="connsiteY199" fmla="*/ 607219 h 1185863"/>
              <a:gd name="connsiteX200" fmla="*/ 164307 w 1121569"/>
              <a:gd name="connsiteY200" fmla="*/ 616744 h 1185863"/>
              <a:gd name="connsiteX201" fmla="*/ 152400 w 1121569"/>
              <a:gd name="connsiteY201" fmla="*/ 626269 h 1185863"/>
              <a:gd name="connsiteX202" fmla="*/ 138113 w 1121569"/>
              <a:gd name="connsiteY202" fmla="*/ 638175 h 1185863"/>
              <a:gd name="connsiteX203" fmla="*/ 123825 w 1121569"/>
              <a:gd name="connsiteY203" fmla="*/ 647700 h 1185863"/>
              <a:gd name="connsiteX204" fmla="*/ 116682 w 1121569"/>
              <a:gd name="connsiteY204" fmla="*/ 654844 h 1185863"/>
              <a:gd name="connsiteX205" fmla="*/ 111919 w 1121569"/>
              <a:gd name="connsiteY205" fmla="*/ 661988 h 1185863"/>
              <a:gd name="connsiteX206" fmla="*/ 104775 w 1121569"/>
              <a:gd name="connsiteY206" fmla="*/ 664369 h 1185863"/>
              <a:gd name="connsiteX207" fmla="*/ 102394 w 1121569"/>
              <a:gd name="connsiteY207" fmla="*/ 671513 h 1185863"/>
              <a:gd name="connsiteX208" fmla="*/ 95250 w 1121569"/>
              <a:gd name="connsiteY208" fmla="*/ 673894 h 1185863"/>
              <a:gd name="connsiteX209" fmla="*/ 88107 w 1121569"/>
              <a:gd name="connsiteY209" fmla="*/ 678657 h 1185863"/>
              <a:gd name="connsiteX210" fmla="*/ 78582 w 1121569"/>
              <a:gd name="connsiteY210" fmla="*/ 690563 h 1185863"/>
              <a:gd name="connsiteX211" fmla="*/ 66675 w 1121569"/>
              <a:gd name="connsiteY211" fmla="*/ 702469 h 1185863"/>
              <a:gd name="connsiteX212" fmla="*/ 57150 w 1121569"/>
              <a:gd name="connsiteY212" fmla="*/ 714375 h 1185863"/>
              <a:gd name="connsiteX213" fmla="*/ 47625 w 1121569"/>
              <a:gd name="connsiteY213" fmla="*/ 726282 h 1185863"/>
              <a:gd name="connsiteX214" fmla="*/ 38100 w 1121569"/>
              <a:gd name="connsiteY214" fmla="*/ 738188 h 1185863"/>
              <a:gd name="connsiteX215" fmla="*/ 26194 w 1121569"/>
              <a:gd name="connsiteY215" fmla="*/ 750094 h 1185863"/>
              <a:gd name="connsiteX216" fmla="*/ 23813 w 1121569"/>
              <a:gd name="connsiteY216" fmla="*/ 757238 h 1185863"/>
              <a:gd name="connsiteX217" fmla="*/ 9525 w 1121569"/>
              <a:gd name="connsiteY217" fmla="*/ 766763 h 1185863"/>
              <a:gd name="connsiteX218" fmla="*/ 2382 w 1121569"/>
              <a:gd name="connsiteY218" fmla="*/ 788194 h 1185863"/>
              <a:gd name="connsiteX219" fmla="*/ 0 w 1121569"/>
              <a:gd name="connsiteY219" fmla="*/ 795338 h 1185863"/>
              <a:gd name="connsiteX220" fmla="*/ 2382 w 1121569"/>
              <a:gd name="connsiteY220" fmla="*/ 807244 h 1185863"/>
              <a:gd name="connsiteX221" fmla="*/ 45244 w 1121569"/>
              <a:gd name="connsiteY221" fmla="*/ 812007 h 1185863"/>
              <a:gd name="connsiteX222" fmla="*/ 52388 w 1121569"/>
              <a:gd name="connsiteY222" fmla="*/ 807244 h 1185863"/>
              <a:gd name="connsiteX223" fmla="*/ 59532 w 1121569"/>
              <a:gd name="connsiteY223" fmla="*/ 804863 h 1185863"/>
              <a:gd name="connsiteX224" fmla="*/ 73819 w 1121569"/>
              <a:gd name="connsiteY224" fmla="*/ 795338 h 1185863"/>
              <a:gd name="connsiteX225" fmla="*/ 88107 w 1121569"/>
              <a:gd name="connsiteY225" fmla="*/ 790575 h 1185863"/>
              <a:gd name="connsiteX226" fmla="*/ 130969 w 1121569"/>
              <a:gd name="connsiteY226" fmla="*/ 797719 h 1185863"/>
              <a:gd name="connsiteX227" fmla="*/ 145257 w 1121569"/>
              <a:gd name="connsiteY227" fmla="*/ 802482 h 1185863"/>
              <a:gd name="connsiteX228" fmla="*/ 152400 w 1121569"/>
              <a:gd name="connsiteY228" fmla="*/ 804863 h 1185863"/>
              <a:gd name="connsiteX229" fmla="*/ 166688 w 1121569"/>
              <a:gd name="connsiteY229" fmla="*/ 812007 h 1185863"/>
              <a:gd name="connsiteX230" fmla="*/ 180975 w 1121569"/>
              <a:gd name="connsiteY230" fmla="*/ 819150 h 1185863"/>
              <a:gd name="connsiteX231" fmla="*/ 202407 w 1121569"/>
              <a:gd name="connsiteY231" fmla="*/ 833438 h 1185863"/>
              <a:gd name="connsiteX232" fmla="*/ 209550 w 1121569"/>
              <a:gd name="connsiteY232" fmla="*/ 838200 h 1185863"/>
              <a:gd name="connsiteX233" fmla="*/ 216694 w 1121569"/>
              <a:gd name="connsiteY233" fmla="*/ 842963 h 1185863"/>
              <a:gd name="connsiteX234" fmla="*/ 223838 w 1121569"/>
              <a:gd name="connsiteY234" fmla="*/ 845344 h 1185863"/>
              <a:gd name="connsiteX235" fmla="*/ 228600 w 1121569"/>
              <a:gd name="connsiteY235" fmla="*/ 852488 h 1185863"/>
              <a:gd name="connsiteX236" fmla="*/ 242888 w 1121569"/>
              <a:gd name="connsiteY236" fmla="*/ 857250 h 1185863"/>
              <a:gd name="connsiteX237" fmla="*/ 257175 w 1121569"/>
              <a:gd name="connsiteY237" fmla="*/ 864394 h 1185863"/>
              <a:gd name="connsiteX238" fmla="*/ 271463 w 1121569"/>
              <a:gd name="connsiteY238" fmla="*/ 871538 h 1185863"/>
              <a:gd name="connsiteX239" fmla="*/ 276225 w 1121569"/>
              <a:gd name="connsiteY239" fmla="*/ 878682 h 1185863"/>
              <a:gd name="connsiteX240" fmla="*/ 290513 w 1121569"/>
              <a:gd name="connsiteY240" fmla="*/ 883444 h 1185863"/>
              <a:gd name="connsiteX241" fmla="*/ 319088 w 1121569"/>
              <a:gd name="connsiteY241" fmla="*/ 902494 h 1185863"/>
              <a:gd name="connsiteX242" fmla="*/ 326232 w 1121569"/>
              <a:gd name="connsiteY242" fmla="*/ 907257 h 1185863"/>
              <a:gd name="connsiteX243" fmla="*/ 333375 w 1121569"/>
              <a:gd name="connsiteY243" fmla="*/ 909638 h 1185863"/>
              <a:gd name="connsiteX244" fmla="*/ 347663 w 1121569"/>
              <a:gd name="connsiteY244" fmla="*/ 919163 h 1185863"/>
              <a:gd name="connsiteX245" fmla="*/ 354807 w 1121569"/>
              <a:gd name="connsiteY245" fmla="*/ 923925 h 1185863"/>
              <a:gd name="connsiteX246" fmla="*/ 361950 w 1121569"/>
              <a:gd name="connsiteY246" fmla="*/ 928688 h 1185863"/>
              <a:gd name="connsiteX247" fmla="*/ 376238 w 1121569"/>
              <a:gd name="connsiteY247" fmla="*/ 940594 h 1185863"/>
              <a:gd name="connsiteX248" fmla="*/ 381000 w 1121569"/>
              <a:gd name="connsiteY248" fmla="*/ 947738 h 1185863"/>
              <a:gd name="connsiteX249" fmla="*/ 388144 w 1121569"/>
              <a:gd name="connsiteY249" fmla="*/ 950119 h 1185863"/>
              <a:gd name="connsiteX250" fmla="*/ 390525 w 1121569"/>
              <a:gd name="connsiteY250" fmla="*/ 957263 h 1185863"/>
              <a:gd name="connsiteX251" fmla="*/ 397669 w 1121569"/>
              <a:gd name="connsiteY251" fmla="*/ 962025 h 1185863"/>
              <a:gd name="connsiteX252" fmla="*/ 407194 w 1121569"/>
              <a:gd name="connsiteY252" fmla="*/ 973932 h 1185863"/>
              <a:gd name="connsiteX253" fmla="*/ 409575 w 1121569"/>
              <a:gd name="connsiteY253" fmla="*/ 981075 h 1185863"/>
              <a:gd name="connsiteX254" fmla="*/ 426244 w 1121569"/>
              <a:gd name="connsiteY254" fmla="*/ 1000125 h 1185863"/>
              <a:gd name="connsiteX255" fmla="*/ 435769 w 1121569"/>
              <a:gd name="connsiteY255" fmla="*/ 1012032 h 1185863"/>
              <a:gd name="connsiteX256" fmla="*/ 438150 w 1121569"/>
              <a:gd name="connsiteY256" fmla="*/ 1019175 h 1185863"/>
              <a:gd name="connsiteX257" fmla="*/ 454819 w 1121569"/>
              <a:gd name="connsiteY257" fmla="*/ 1040607 h 1185863"/>
              <a:gd name="connsiteX258" fmla="*/ 457200 w 1121569"/>
              <a:gd name="connsiteY258" fmla="*/ 1047750 h 1185863"/>
              <a:gd name="connsiteX259" fmla="*/ 466725 w 1121569"/>
              <a:gd name="connsiteY259" fmla="*/ 1062038 h 1185863"/>
              <a:gd name="connsiteX260" fmla="*/ 471488 w 1121569"/>
              <a:gd name="connsiteY260" fmla="*/ 1076325 h 1185863"/>
              <a:gd name="connsiteX261" fmla="*/ 473869 w 1121569"/>
              <a:gd name="connsiteY261" fmla="*/ 1083469 h 1185863"/>
              <a:gd name="connsiteX262" fmla="*/ 478632 w 1121569"/>
              <a:gd name="connsiteY262" fmla="*/ 1090613 h 1185863"/>
              <a:gd name="connsiteX263" fmla="*/ 485775 w 1121569"/>
              <a:gd name="connsiteY263" fmla="*/ 1104900 h 1185863"/>
              <a:gd name="connsiteX264" fmla="*/ 488157 w 1121569"/>
              <a:gd name="connsiteY264" fmla="*/ 1112044 h 1185863"/>
              <a:gd name="connsiteX265" fmla="*/ 497682 w 1121569"/>
              <a:gd name="connsiteY265" fmla="*/ 1126332 h 1185863"/>
              <a:gd name="connsiteX266" fmla="*/ 502444 w 1121569"/>
              <a:gd name="connsiteY266" fmla="*/ 1133475 h 1185863"/>
              <a:gd name="connsiteX267" fmla="*/ 507207 w 1121569"/>
              <a:gd name="connsiteY267" fmla="*/ 1140619 h 1185863"/>
              <a:gd name="connsiteX268" fmla="*/ 509588 w 1121569"/>
              <a:gd name="connsiteY268" fmla="*/ 1147763 h 1185863"/>
              <a:gd name="connsiteX269" fmla="*/ 514350 w 1121569"/>
              <a:gd name="connsiteY269" fmla="*/ 1154907 h 1185863"/>
              <a:gd name="connsiteX270" fmla="*/ 519113 w 1121569"/>
              <a:gd name="connsiteY270" fmla="*/ 1169194 h 1185863"/>
              <a:gd name="connsiteX271" fmla="*/ 526257 w 1121569"/>
              <a:gd name="connsiteY271" fmla="*/ 1183482 h 1185863"/>
              <a:gd name="connsiteX272" fmla="*/ 526257 w 1121569"/>
              <a:gd name="connsiteY272" fmla="*/ 1185863 h 1185863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  <a:cxn ang="0">
                <a:pos x="connsiteX31" y="connsiteY31"/>
              </a:cxn>
              <a:cxn ang="0">
                <a:pos x="connsiteX32" y="connsiteY32"/>
              </a:cxn>
              <a:cxn ang="0">
                <a:pos x="connsiteX33" y="connsiteY33"/>
              </a:cxn>
              <a:cxn ang="0">
                <a:pos x="connsiteX34" y="connsiteY34"/>
              </a:cxn>
              <a:cxn ang="0">
                <a:pos x="connsiteX35" y="connsiteY35"/>
              </a:cxn>
              <a:cxn ang="0">
                <a:pos x="connsiteX36" y="connsiteY36"/>
              </a:cxn>
              <a:cxn ang="0">
                <a:pos x="connsiteX37" y="connsiteY37"/>
              </a:cxn>
              <a:cxn ang="0">
                <a:pos x="connsiteX38" y="connsiteY38"/>
              </a:cxn>
              <a:cxn ang="0">
                <a:pos x="connsiteX39" y="connsiteY39"/>
              </a:cxn>
              <a:cxn ang="0">
                <a:pos x="connsiteX40" y="connsiteY40"/>
              </a:cxn>
              <a:cxn ang="0">
                <a:pos x="connsiteX41" y="connsiteY41"/>
              </a:cxn>
              <a:cxn ang="0">
                <a:pos x="connsiteX42" y="connsiteY42"/>
              </a:cxn>
              <a:cxn ang="0">
                <a:pos x="connsiteX43" y="connsiteY43"/>
              </a:cxn>
              <a:cxn ang="0">
                <a:pos x="connsiteX44" y="connsiteY44"/>
              </a:cxn>
              <a:cxn ang="0">
                <a:pos x="connsiteX45" y="connsiteY45"/>
              </a:cxn>
              <a:cxn ang="0">
                <a:pos x="connsiteX46" y="connsiteY46"/>
              </a:cxn>
              <a:cxn ang="0">
                <a:pos x="connsiteX47" y="connsiteY47"/>
              </a:cxn>
              <a:cxn ang="0">
                <a:pos x="connsiteX48" y="connsiteY48"/>
              </a:cxn>
              <a:cxn ang="0">
                <a:pos x="connsiteX49" y="connsiteY49"/>
              </a:cxn>
              <a:cxn ang="0">
                <a:pos x="connsiteX50" y="connsiteY50"/>
              </a:cxn>
              <a:cxn ang="0">
                <a:pos x="connsiteX51" y="connsiteY51"/>
              </a:cxn>
              <a:cxn ang="0">
                <a:pos x="connsiteX52" y="connsiteY52"/>
              </a:cxn>
              <a:cxn ang="0">
                <a:pos x="connsiteX53" y="connsiteY53"/>
              </a:cxn>
              <a:cxn ang="0">
                <a:pos x="connsiteX54" y="connsiteY54"/>
              </a:cxn>
              <a:cxn ang="0">
                <a:pos x="connsiteX55" y="connsiteY55"/>
              </a:cxn>
              <a:cxn ang="0">
                <a:pos x="connsiteX56" y="connsiteY56"/>
              </a:cxn>
              <a:cxn ang="0">
                <a:pos x="connsiteX57" y="connsiteY57"/>
              </a:cxn>
              <a:cxn ang="0">
                <a:pos x="connsiteX58" y="connsiteY58"/>
              </a:cxn>
              <a:cxn ang="0">
                <a:pos x="connsiteX59" y="connsiteY59"/>
              </a:cxn>
              <a:cxn ang="0">
                <a:pos x="connsiteX60" y="connsiteY60"/>
              </a:cxn>
              <a:cxn ang="0">
                <a:pos x="connsiteX61" y="connsiteY61"/>
              </a:cxn>
              <a:cxn ang="0">
                <a:pos x="connsiteX62" y="connsiteY62"/>
              </a:cxn>
              <a:cxn ang="0">
                <a:pos x="connsiteX63" y="connsiteY63"/>
              </a:cxn>
              <a:cxn ang="0">
                <a:pos x="connsiteX64" y="connsiteY64"/>
              </a:cxn>
              <a:cxn ang="0">
                <a:pos x="connsiteX65" y="connsiteY65"/>
              </a:cxn>
              <a:cxn ang="0">
                <a:pos x="connsiteX66" y="connsiteY66"/>
              </a:cxn>
              <a:cxn ang="0">
                <a:pos x="connsiteX67" y="connsiteY67"/>
              </a:cxn>
              <a:cxn ang="0">
                <a:pos x="connsiteX68" y="connsiteY68"/>
              </a:cxn>
              <a:cxn ang="0">
                <a:pos x="connsiteX69" y="connsiteY69"/>
              </a:cxn>
              <a:cxn ang="0">
                <a:pos x="connsiteX70" y="connsiteY70"/>
              </a:cxn>
              <a:cxn ang="0">
                <a:pos x="connsiteX71" y="connsiteY71"/>
              </a:cxn>
              <a:cxn ang="0">
                <a:pos x="connsiteX72" y="connsiteY72"/>
              </a:cxn>
              <a:cxn ang="0">
                <a:pos x="connsiteX73" y="connsiteY73"/>
              </a:cxn>
              <a:cxn ang="0">
                <a:pos x="connsiteX74" y="connsiteY74"/>
              </a:cxn>
              <a:cxn ang="0">
                <a:pos x="connsiteX75" y="connsiteY75"/>
              </a:cxn>
              <a:cxn ang="0">
                <a:pos x="connsiteX76" y="connsiteY76"/>
              </a:cxn>
              <a:cxn ang="0">
                <a:pos x="connsiteX77" y="connsiteY77"/>
              </a:cxn>
              <a:cxn ang="0">
                <a:pos x="connsiteX78" y="connsiteY78"/>
              </a:cxn>
              <a:cxn ang="0">
                <a:pos x="connsiteX79" y="connsiteY79"/>
              </a:cxn>
              <a:cxn ang="0">
                <a:pos x="connsiteX80" y="connsiteY80"/>
              </a:cxn>
              <a:cxn ang="0">
                <a:pos x="connsiteX81" y="connsiteY81"/>
              </a:cxn>
              <a:cxn ang="0">
                <a:pos x="connsiteX82" y="connsiteY82"/>
              </a:cxn>
              <a:cxn ang="0">
                <a:pos x="connsiteX83" y="connsiteY83"/>
              </a:cxn>
              <a:cxn ang="0">
                <a:pos x="connsiteX84" y="connsiteY84"/>
              </a:cxn>
              <a:cxn ang="0">
                <a:pos x="connsiteX85" y="connsiteY85"/>
              </a:cxn>
              <a:cxn ang="0">
                <a:pos x="connsiteX86" y="connsiteY86"/>
              </a:cxn>
              <a:cxn ang="0">
                <a:pos x="connsiteX87" y="connsiteY87"/>
              </a:cxn>
              <a:cxn ang="0">
                <a:pos x="connsiteX88" y="connsiteY88"/>
              </a:cxn>
              <a:cxn ang="0">
                <a:pos x="connsiteX89" y="connsiteY89"/>
              </a:cxn>
              <a:cxn ang="0">
                <a:pos x="connsiteX90" y="connsiteY90"/>
              </a:cxn>
              <a:cxn ang="0">
                <a:pos x="connsiteX91" y="connsiteY91"/>
              </a:cxn>
              <a:cxn ang="0">
                <a:pos x="connsiteX92" y="connsiteY92"/>
              </a:cxn>
              <a:cxn ang="0">
                <a:pos x="connsiteX93" y="connsiteY93"/>
              </a:cxn>
              <a:cxn ang="0">
                <a:pos x="connsiteX94" y="connsiteY94"/>
              </a:cxn>
              <a:cxn ang="0">
                <a:pos x="connsiteX95" y="connsiteY95"/>
              </a:cxn>
              <a:cxn ang="0">
                <a:pos x="connsiteX96" y="connsiteY96"/>
              </a:cxn>
              <a:cxn ang="0">
                <a:pos x="connsiteX97" y="connsiteY97"/>
              </a:cxn>
              <a:cxn ang="0">
                <a:pos x="connsiteX98" y="connsiteY98"/>
              </a:cxn>
              <a:cxn ang="0">
                <a:pos x="connsiteX99" y="connsiteY99"/>
              </a:cxn>
              <a:cxn ang="0">
                <a:pos x="connsiteX100" y="connsiteY100"/>
              </a:cxn>
              <a:cxn ang="0">
                <a:pos x="connsiteX101" y="connsiteY101"/>
              </a:cxn>
              <a:cxn ang="0">
                <a:pos x="connsiteX102" y="connsiteY102"/>
              </a:cxn>
              <a:cxn ang="0">
                <a:pos x="connsiteX103" y="connsiteY103"/>
              </a:cxn>
              <a:cxn ang="0">
                <a:pos x="connsiteX104" y="connsiteY104"/>
              </a:cxn>
              <a:cxn ang="0">
                <a:pos x="connsiteX105" y="connsiteY105"/>
              </a:cxn>
              <a:cxn ang="0">
                <a:pos x="connsiteX106" y="connsiteY106"/>
              </a:cxn>
              <a:cxn ang="0">
                <a:pos x="connsiteX107" y="connsiteY107"/>
              </a:cxn>
              <a:cxn ang="0">
                <a:pos x="connsiteX108" y="connsiteY108"/>
              </a:cxn>
              <a:cxn ang="0">
                <a:pos x="connsiteX109" y="connsiteY109"/>
              </a:cxn>
              <a:cxn ang="0">
                <a:pos x="connsiteX110" y="connsiteY110"/>
              </a:cxn>
              <a:cxn ang="0">
                <a:pos x="connsiteX111" y="connsiteY111"/>
              </a:cxn>
              <a:cxn ang="0">
                <a:pos x="connsiteX112" y="connsiteY112"/>
              </a:cxn>
              <a:cxn ang="0">
                <a:pos x="connsiteX113" y="connsiteY113"/>
              </a:cxn>
              <a:cxn ang="0">
                <a:pos x="connsiteX114" y="connsiteY114"/>
              </a:cxn>
              <a:cxn ang="0">
                <a:pos x="connsiteX115" y="connsiteY115"/>
              </a:cxn>
              <a:cxn ang="0">
                <a:pos x="connsiteX116" y="connsiteY116"/>
              </a:cxn>
              <a:cxn ang="0">
                <a:pos x="connsiteX117" y="connsiteY117"/>
              </a:cxn>
              <a:cxn ang="0">
                <a:pos x="connsiteX118" y="connsiteY118"/>
              </a:cxn>
              <a:cxn ang="0">
                <a:pos x="connsiteX119" y="connsiteY119"/>
              </a:cxn>
              <a:cxn ang="0">
                <a:pos x="connsiteX120" y="connsiteY120"/>
              </a:cxn>
              <a:cxn ang="0">
                <a:pos x="connsiteX121" y="connsiteY121"/>
              </a:cxn>
              <a:cxn ang="0">
                <a:pos x="connsiteX122" y="connsiteY122"/>
              </a:cxn>
              <a:cxn ang="0">
                <a:pos x="connsiteX123" y="connsiteY123"/>
              </a:cxn>
              <a:cxn ang="0">
                <a:pos x="connsiteX124" y="connsiteY124"/>
              </a:cxn>
              <a:cxn ang="0">
                <a:pos x="connsiteX125" y="connsiteY125"/>
              </a:cxn>
              <a:cxn ang="0">
                <a:pos x="connsiteX126" y="connsiteY126"/>
              </a:cxn>
              <a:cxn ang="0">
                <a:pos x="connsiteX127" y="connsiteY127"/>
              </a:cxn>
              <a:cxn ang="0">
                <a:pos x="connsiteX128" y="connsiteY128"/>
              </a:cxn>
              <a:cxn ang="0">
                <a:pos x="connsiteX129" y="connsiteY129"/>
              </a:cxn>
              <a:cxn ang="0">
                <a:pos x="connsiteX130" y="connsiteY130"/>
              </a:cxn>
              <a:cxn ang="0">
                <a:pos x="connsiteX131" y="connsiteY131"/>
              </a:cxn>
              <a:cxn ang="0">
                <a:pos x="connsiteX132" y="connsiteY132"/>
              </a:cxn>
              <a:cxn ang="0">
                <a:pos x="connsiteX133" y="connsiteY133"/>
              </a:cxn>
              <a:cxn ang="0">
                <a:pos x="connsiteX134" y="connsiteY134"/>
              </a:cxn>
              <a:cxn ang="0">
                <a:pos x="connsiteX135" y="connsiteY135"/>
              </a:cxn>
              <a:cxn ang="0">
                <a:pos x="connsiteX136" y="connsiteY136"/>
              </a:cxn>
              <a:cxn ang="0">
                <a:pos x="connsiteX137" y="connsiteY137"/>
              </a:cxn>
              <a:cxn ang="0">
                <a:pos x="connsiteX138" y="connsiteY138"/>
              </a:cxn>
              <a:cxn ang="0">
                <a:pos x="connsiteX139" y="connsiteY139"/>
              </a:cxn>
              <a:cxn ang="0">
                <a:pos x="connsiteX140" y="connsiteY140"/>
              </a:cxn>
              <a:cxn ang="0">
                <a:pos x="connsiteX141" y="connsiteY141"/>
              </a:cxn>
              <a:cxn ang="0">
                <a:pos x="connsiteX142" y="connsiteY142"/>
              </a:cxn>
              <a:cxn ang="0">
                <a:pos x="connsiteX143" y="connsiteY143"/>
              </a:cxn>
              <a:cxn ang="0">
                <a:pos x="connsiteX144" y="connsiteY144"/>
              </a:cxn>
              <a:cxn ang="0">
                <a:pos x="connsiteX145" y="connsiteY145"/>
              </a:cxn>
              <a:cxn ang="0">
                <a:pos x="connsiteX146" y="connsiteY146"/>
              </a:cxn>
              <a:cxn ang="0">
                <a:pos x="connsiteX147" y="connsiteY147"/>
              </a:cxn>
              <a:cxn ang="0">
                <a:pos x="connsiteX148" y="connsiteY148"/>
              </a:cxn>
              <a:cxn ang="0">
                <a:pos x="connsiteX149" y="connsiteY149"/>
              </a:cxn>
              <a:cxn ang="0">
                <a:pos x="connsiteX150" y="connsiteY150"/>
              </a:cxn>
              <a:cxn ang="0">
                <a:pos x="connsiteX151" y="connsiteY151"/>
              </a:cxn>
              <a:cxn ang="0">
                <a:pos x="connsiteX152" y="connsiteY152"/>
              </a:cxn>
              <a:cxn ang="0">
                <a:pos x="connsiteX153" y="connsiteY153"/>
              </a:cxn>
              <a:cxn ang="0">
                <a:pos x="connsiteX154" y="connsiteY154"/>
              </a:cxn>
              <a:cxn ang="0">
                <a:pos x="connsiteX155" y="connsiteY155"/>
              </a:cxn>
              <a:cxn ang="0">
                <a:pos x="connsiteX156" y="connsiteY156"/>
              </a:cxn>
              <a:cxn ang="0">
                <a:pos x="connsiteX157" y="connsiteY157"/>
              </a:cxn>
              <a:cxn ang="0">
                <a:pos x="connsiteX158" y="connsiteY158"/>
              </a:cxn>
              <a:cxn ang="0">
                <a:pos x="connsiteX159" y="connsiteY159"/>
              </a:cxn>
              <a:cxn ang="0">
                <a:pos x="connsiteX160" y="connsiteY160"/>
              </a:cxn>
              <a:cxn ang="0">
                <a:pos x="connsiteX161" y="connsiteY161"/>
              </a:cxn>
              <a:cxn ang="0">
                <a:pos x="connsiteX162" y="connsiteY162"/>
              </a:cxn>
              <a:cxn ang="0">
                <a:pos x="connsiteX163" y="connsiteY163"/>
              </a:cxn>
              <a:cxn ang="0">
                <a:pos x="connsiteX164" y="connsiteY164"/>
              </a:cxn>
              <a:cxn ang="0">
                <a:pos x="connsiteX165" y="connsiteY165"/>
              </a:cxn>
              <a:cxn ang="0">
                <a:pos x="connsiteX166" y="connsiteY166"/>
              </a:cxn>
              <a:cxn ang="0">
                <a:pos x="connsiteX167" y="connsiteY167"/>
              </a:cxn>
              <a:cxn ang="0">
                <a:pos x="connsiteX168" y="connsiteY168"/>
              </a:cxn>
              <a:cxn ang="0">
                <a:pos x="connsiteX169" y="connsiteY169"/>
              </a:cxn>
              <a:cxn ang="0">
                <a:pos x="connsiteX170" y="connsiteY170"/>
              </a:cxn>
              <a:cxn ang="0">
                <a:pos x="connsiteX171" y="connsiteY171"/>
              </a:cxn>
              <a:cxn ang="0">
                <a:pos x="connsiteX172" y="connsiteY172"/>
              </a:cxn>
              <a:cxn ang="0">
                <a:pos x="connsiteX173" y="connsiteY173"/>
              </a:cxn>
              <a:cxn ang="0">
                <a:pos x="connsiteX174" y="connsiteY174"/>
              </a:cxn>
              <a:cxn ang="0">
                <a:pos x="connsiteX175" y="connsiteY175"/>
              </a:cxn>
              <a:cxn ang="0">
                <a:pos x="connsiteX176" y="connsiteY176"/>
              </a:cxn>
              <a:cxn ang="0">
                <a:pos x="connsiteX177" y="connsiteY177"/>
              </a:cxn>
              <a:cxn ang="0">
                <a:pos x="connsiteX178" y="connsiteY178"/>
              </a:cxn>
              <a:cxn ang="0">
                <a:pos x="connsiteX179" y="connsiteY179"/>
              </a:cxn>
              <a:cxn ang="0">
                <a:pos x="connsiteX180" y="connsiteY180"/>
              </a:cxn>
              <a:cxn ang="0">
                <a:pos x="connsiteX181" y="connsiteY181"/>
              </a:cxn>
              <a:cxn ang="0">
                <a:pos x="connsiteX182" y="connsiteY182"/>
              </a:cxn>
              <a:cxn ang="0">
                <a:pos x="connsiteX183" y="connsiteY183"/>
              </a:cxn>
              <a:cxn ang="0">
                <a:pos x="connsiteX184" y="connsiteY184"/>
              </a:cxn>
              <a:cxn ang="0">
                <a:pos x="connsiteX185" y="connsiteY185"/>
              </a:cxn>
              <a:cxn ang="0">
                <a:pos x="connsiteX186" y="connsiteY186"/>
              </a:cxn>
              <a:cxn ang="0">
                <a:pos x="connsiteX187" y="connsiteY187"/>
              </a:cxn>
              <a:cxn ang="0">
                <a:pos x="connsiteX188" y="connsiteY188"/>
              </a:cxn>
              <a:cxn ang="0">
                <a:pos x="connsiteX189" y="connsiteY189"/>
              </a:cxn>
              <a:cxn ang="0">
                <a:pos x="connsiteX190" y="connsiteY190"/>
              </a:cxn>
              <a:cxn ang="0">
                <a:pos x="connsiteX191" y="connsiteY191"/>
              </a:cxn>
              <a:cxn ang="0">
                <a:pos x="connsiteX192" y="connsiteY192"/>
              </a:cxn>
              <a:cxn ang="0">
                <a:pos x="connsiteX193" y="connsiteY193"/>
              </a:cxn>
              <a:cxn ang="0">
                <a:pos x="connsiteX194" y="connsiteY194"/>
              </a:cxn>
              <a:cxn ang="0">
                <a:pos x="connsiteX195" y="connsiteY195"/>
              </a:cxn>
              <a:cxn ang="0">
                <a:pos x="connsiteX196" y="connsiteY196"/>
              </a:cxn>
              <a:cxn ang="0">
                <a:pos x="connsiteX197" y="connsiteY197"/>
              </a:cxn>
              <a:cxn ang="0">
                <a:pos x="connsiteX198" y="connsiteY198"/>
              </a:cxn>
              <a:cxn ang="0">
                <a:pos x="connsiteX199" y="connsiteY199"/>
              </a:cxn>
              <a:cxn ang="0">
                <a:pos x="connsiteX200" y="connsiteY200"/>
              </a:cxn>
              <a:cxn ang="0">
                <a:pos x="connsiteX201" y="connsiteY201"/>
              </a:cxn>
              <a:cxn ang="0">
                <a:pos x="connsiteX202" y="connsiteY202"/>
              </a:cxn>
              <a:cxn ang="0">
                <a:pos x="connsiteX203" y="connsiteY203"/>
              </a:cxn>
              <a:cxn ang="0">
                <a:pos x="connsiteX204" y="connsiteY204"/>
              </a:cxn>
              <a:cxn ang="0">
                <a:pos x="connsiteX205" y="connsiteY205"/>
              </a:cxn>
              <a:cxn ang="0">
                <a:pos x="connsiteX206" y="connsiteY206"/>
              </a:cxn>
              <a:cxn ang="0">
                <a:pos x="connsiteX207" y="connsiteY207"/>
              </a:cxn>
              <a:cxn ang="0">
                <a:pos x="connsiteX208" y="connsiteY208"/>
              </a:cxn>
              <a:cxn ang="0">
                <a:pos x="connsiteX209" y="connsiteY209"/>
              </a:cxn>
              <a:cxn ang="0">
                <a:pos x="connsiteX210" y="connsiteY210"/>
              </a:cxn>
              <a:cxn ang="0">
                <a:pos x="connsiteX211" y="connsiteY211"/>
              </a:cxn>
              <a:cxn ang="0">
                <a:pos x="connsiteX212" y="connsiteY212"/>
              </a:cxn>
              <a:cxn ang="0">
                <a:pos x="connsiteX213" y="connsiteY213"/>
              </a:cxn>
              <a:cxn ang="0">
                <a:pos x="connsiteX214" y="connsiteY214"/>
              </a:cxn>
              <a:cxn ang="0">
                <a:pos x="connsiteX215" y="connsiteY215"/>
              </a:cxn>
              <a:cxn ang="0">
                <a:pos x="connsiteX216" y="connsiteY216"/>
              </a:cxn>
              <a:cxn ang="0">
                <a:pos x="connsiteX217" y="connsiteY217"/>
              </a:cxn>
              <a:cxn ang="0">
                <a:pos x="connsiteX218" y="connsiteY218"/>
              </a:cxn>
              <a:cxn ang="0">
                <a:pos x="connsiteX219" y="connsiteY219"/>
              </a:cxn>
              <a:cxn ang="0">
                <a:pos x="connsiteX220" y="connsiteY220"/>
              </a:cxn>
              <a:cxn ang="0">
                <a:pos x="connsiteX221" y="connsiteY221"/>
              </a:cxn>
              <a:cxn ang="0">
                <a:pos x="connsiteX222" y="connsiteY222"/>
              </a:cxn>
              <a:cxn ang="0">
                <a:pos x="connsiteX223" y="connsiteY223"/>
              </a:cxn>
              <a:cxn ang="0">
                <a:pos x="connsiteX224" y="connsiteY224"/>
              </a:cxn>
              <a:cxn ang="0">
                <a:pos x="connsiteX225" y="connsiteY225"/>
              </a:cxn>
              <a:cxn ang="0">
                <a:pos x="connsiteX226" y="connsiteY226"/>
              </a:cxn>
              <a:cxn ang="0">
                <a:pos x="connsiteX227" y="connsiteY227"/>
              </a:cxn>
              <a:cxn ang="0">
                <a:pos x="connsiteX228" y="connsiteY228"/>
              </a:cxn>
              <a:cxn ang="0">
                <a:pos x="connsiteX229" y="connsiteY229"/>
              </a:cxn>
              <a:cxn ang="0">
                <a:pos x="connsiteX230" y="connsiteY230"/>
              </a:cxn>
              <a:cxn ang="0">
                <a:pos x="connsiteX231" y="connsiteY231"/>
              </a:cxn>
              <a:cxn ang="0">
                <a:pos x="connsiteX232" y="connsiteY232"/>
              </a:cxn>
              <a:cxn ang="0">
                <a:pos x="connsiteX233" y="connsiteY233"/>
              </a:cxn>
              <a:cxn ang="0">
                <a:pos x="connsiteX234" y="connsiteY234"/>
              </a:cxn>
              <a:cxn ang="0">
                <a:pos x="connsiteX235" y="connsiteY235"/>
              </a:cxn>
              <a:cxn ang="0">
                <a:pos x="connsiteX236" y="connsiteY236"/>
              </a:cxn>
              <a:cxn ang="0">
                <a:pos x="connsiteX237" y="connsiteY237"/>
              </a:cxn>
              <a:cxn ang="0">
                <a:pos x="connsiteX238" y="connsiteY238"/>
              </a:cxn>
              <a:cxn ang="0">
                <a:pos x="connsiteX239" y="connsiteY239"/>
              </a:cxn>
              <a:cxn ang="0">
                <a:pos x="connsiteX240" y="connsiteY240"/>
              </a:cxn>
              <a:cxn ang="0">
                <a:pos x="connsiteX241" y="connsiteY241"/>
              </a:cxn>
              <a:cxn ang="0">
                <a:pos x="connsiteX242" y="connsiteY242"/>
              </a:cxn>
              <a:cxn ang="0">
                <a:pos x="connsiteX243" y="connsiteY243"/>
              </a:cxn>
              <a:cxn ang="0">
                <a:pos x="connsiteX244" y="connsiteY244"/>
              </a:cxn>
              <a:cxn ang="0">
                <a:pos x="connsiteX245" y="connsiteY245"/>
              </a:cxn>
              <a:cxn ang="0">
                <a:pos x="connsiteX246" y="connsiteY246"/>
              </a:cxn>
              <a:cxn ang="0">
                <a:pos x="connsiteX247" y="connsiteY247"/>
              </a:cxn>
              <a:cxn ang="0">
                <a:pos x="connsiteX248" y="connsiteY248"/>
              </a:cxn>
              <a:cxn ang="0">
                <a:pos x="connsiteX249" y="connsiteY249"/>
              </a:cxn>
              <a:cxn ang="0">
                <a:pos x="connsiteX250" y="connsiteY250"/>
              </a:cxn>
              <a:cxn ang="0">
                <a:pos x="connsiteX251" y="connsiteY251"/>
              </a:cxn>
              <a:cxn ang="0">
                <a:pos x="connsiteX252" y="connsiteY252"/>
              </a:cxn>
              <a:cxn ang="0">
                <a:pos x="connsiteX253" y="connsiteY253"/>
              </a:cxn>
              <a:cxn ang="0">
                <a:pos x="connsiteX254" y="connsiteY254"/>
              </a:cxn>
              <a:cxn ang="0">
                <a:pos x="connsiteX255" y="connsiteY255"/>
              </a:cxn>
              <a:cxn ang="0">
                <a:pos x="connsiteX256" y="connsiteY256"/>
              </a:cxn>
              <a:cxn ang="0">
                <a:pos x="connsiteX257" y="connsiteY257"/>
              </a:cxn>
              <a:cxn ang="0">
                <a:pos x="connsiteX258" y="connsiteY258"/>
              </a:cxn>
              <a:cxn ang="0">
                <a:pos x="connsiteX259" y="connsiteY259"/>
              </a:cxn>
              <a:cxn ang="0">
                <a:pos x="connsiteX260" y="connsiteY260"/>
              </a:cxn>
              <a:cxn ang="0">
                <a:pos x="connsiteX261" y="connsiteY261"/>
              </a:cxn>
              <a:cxn ang="0">
                <a:pos x="connsiteX262" y="connsiteY262"/>
              </a:cxn>
              <a:cxn ang="0">
                <a:pos x="connsiteX263" y="connsiteY263"/>
              </a:cxn>
              <a:cxn ang="0">
                <a:pos x="connsiteX264" y="connsiteY264"/>
              </a:cxn>
              <a:cxn ang="0">
                <a:pos x="connsiteX265" y="connsiteY265"/>
              </a:cxn>
              <a:cxn ang="0">
                <a:pos x="connsiteX266" y="connsiteY266"/>
              </a:cxn>
              <a:cxn ang="0">
                <a:pos x="connsiteX267" y="connsiteY267"/>
              </a:cxn>
              <a:cxn ang="0">
                <a:pos x="connsiteX268" y="connsiteY268"/>
              </a:cxn>
              <a:cxn ang="0">
                <a:pos x="connsiteX269" y="connsiteY269"/>
              </a:cxn>
              <a:cxn ang="0">
                <a:pos x="connsiteX270" y="connsiteY270"/>
              </a:cxn>
              <a:cxn ang="0">
                <a:pos x="connsiteX271" y="connsiteY271"/>
              </a:cxn>
              <a:cxn ang="0">
                <a:pos x="connsiteX272" y="connsiteY272"/>
              </a:cxn>
            </a:cxnLst>
            <a:rect l="l" t="t" r="r" b="b"/>
            <a:pathLst>
              <a:path w="1121569" h="1185863">
                <a:moveTo>
                  <a:pt x="166688" y="88107"/>
                </a:moveTo>
                <a:cubicBezTo>
                  <a:pt x="173038" y="87313"/>
                  <a:pt x="179564" y="87409"/>
                  <a:pt x="185738" y="85725"/>
                </a:cubicBezTo>
                <a:cubicBezTo>
                  <a:pt x="188499" y="84972"/>
                  <a:pt x="190322" y="82243"/>
                  <a:pt x="192882" y="80963"/>
                </a:cubicBezTo>
                <a:cubicBezTo>
                  <a:pt x="195127" y="79841"/>
                  <a:pt x="197644" y="79376"/>
                  <a:pt x="200025" y="78582"/>
                </a:cubicBezTo>
                <a:cubicBezTo>
                  <a:pt x="204788" y="75407"/>
                  <a:pt x="208883" y="70868"/>
                  <a:pt x="214313" y="69057"/>
                </a:cubicBezTo>
                <a:cubicBezTo>
                  <a:pt x="216694" y="68263"/>
                  <a:pt x="219212" y="67798"/>
                  <a:pt x="221457" y="66675"/>
                </a:cubicBezTo>
                <a:cubicBezTo>
                  <a:pt x="224016" y="65395"/>
                  <a:pt x="225985" y="63075"/>
                  <a:pt x="228600" y="61913"/>
                </a:cubicBezTo>
                <a:cubicBezTo>
                  <a:pt x="233188" y="59874"/>
                  <a:pt x="238125" y="58738"/>
                  <a:pt x="242888" y="57150"/>
                </a:cubicBezTo>
                <a:lnTo>
                  <a:pt x="250032" y="54769"/>
                </a:lnTo>
                <a:cubicBezTo>
                  <a:pt x="252413" y="53975"/>
                  <a:pt x="254714" y="52880"/>
                  <a:pt x="257175" y="52388"/>
                </a:cubicBezTo>
                <a:cubicBezTo>
                  <a:pt x="275357" y="48752"/>
                  <a:pt x="265066" y="50509"/>
                  <a:pt x="288132" y="47625"/>
                </a:cubicBezTo>
                <a:lnTo>
                  <a:pt x="323850" y="35719"/>
                </a:lnTo>
                <a:lnTo>
                  <a:pt x="330994" y="33338"/>
                </a:lnTo>
                <a:lnTo>
                  <a:pt x="338138" y="30957"/>
                </a:lnTo>
                <a:cubicBezTo>
                  <a:pt x="340519" y="29369"/>
                  <a:pt x="342722" y="27474"/>
                  <a:pt x="345282" y="26194"/>
                </a:cubicBezTo>
                <a:cubicBezTo>
                  <a:pt x="347527" y="25072"/>
                  <a:pt x="349990" y="24422"/>
                  <a:pt x="352425" y="23813"/>
                </a:cubicBezTo>
                <a:cubicBezTo>
                  <a:pt x="360252" y="21856"/>
                  <a:pt x="370853" y="20462"/>
                  <a:pt x="378619" y="19050"/>
                </a:cubicBezTo>
                <a:cubicBezTo>
                  <a:pt x="382601" y="18326"/>
                  <a:pt x="386599" y="17651"/>
                  <a:pt x="390525" y="16669"/>
                </a:cubicBezTo>
                <a:cubicBezTo>
                  <a:pt x="403647" y="13389"/>
                  <a:pt x="395837" y="11845"/>
                  <a:pt x="416719" y="9525"/>
                </a:cubicBezTo>
                <a:cubicBezTo>
                  <a:pt x="458677" y="4863"/>
                  <a:pt x="430968" y="7420"/>
                  <a:pt x="500063" y="4763"/>
                </a:cubicBezTo>
                <a:lnTo>
                  <a:pt x="523875" y="2382"/>
                </a:lnTo>
                <a:cubicBezTo>
                  <a:pt x="530235" y="1675"/>
                  <a:pt x="536526" y="0"/>
                  <a:pt x="542925" y="0"/>
                </a:cubicBezTo>
                <a:cubicBezTo>
                  <a:pt x="565958" y="0"/>
                  <a:pt x="588963" y="1588"/>
                  <a:pt x="611982" y="2382"/>
                </a:cubicBezTo>
                <a:cubicBezTo>
                  <a:pt x="616744" y="3176"/>
                  <a:pt x="621585" y="3592"/>
                  <a:pt x="626269" y="4763"/>
                </a:cubicBezTo>
                <a:cubicBezTo>
                  <a:pt x="631139" y="5980"/>
                  <a:pt x="635634" y="8540"/>
                  <a:pt x="640557" y="9525"/>
                </a:cubicBezTo>
                <a:cubicBezTo>
                  <a:pt x="648494" y="11113"/>
                  <a:pt x="656690" y="11729"/>
                  <a:pt x="664369" y="14288"/>
                </a:cubicBezTo>
                <a:cubicBezTo>
                  <a:pt x="666750" y="15082"/>
                  <a:pt x="669037" y="16256"/>
                  <a:pt x="671513" y="16669"/>
                </a:cubicBezTo>
                <a:cubicBezTo>
                  <a:pt x="686344" y="19141"/>
                  <a:pt x="707616" y="19179"/>
                  <a:pt x="721519" y="23813"/>
                </a:cubicBezTo>
                <a:lnTo>
                  <a:pt x="735807" y="28575"/>
                </a:lnTo>
                <a:cubicBezTo>
                  <a:pt x="738188" y="29369"/>
                  <a:pt x="740515" y="30348"/>
                  <a:pt x="742950" y="30957"/>
                </a:cubicBezTo>
                <a:cubicBezTo>
                  <a:pt x="746125" y="31751"/>
                  <a:pt x="749340" y="32398"/>
                  <a:pt x="752475" y="33338"/>
                </a:cubicBezTo>
                <a:cubicBezTo>
                  <a:pt x="757284" y="34780"/>
                  <a:pt x="762000" y="36512"/>
                  <a:pt x="766763" y="38100"/>
                </a:cubicBezTo>
                <a:lnTo>
                  <a:pt x="788194" y="45244"/>
                </a:lnTo>
                <a:lnTo>
                  <a:pt x="809625" y="52388"/>
                </a:lnTo>
                <a:lnTo>
                  <a:pt x="816769" y="54769"/>
                </a:lnTo>
                <a:cubicBezTo>
                  <a:pt x="819150" y="55563"/>
                  <a:pt x="821409" y="56971"/>
                  <a:pt x="823913" y="57150"/>
                </a:cubicBezTo>
                <a:lnTo>
                  <a:pt x="857250" y="59532"/>
                </a:lnTo>
                <a:cubicBezTo>
                  <a:pt x="866775" y="61119"/>
                  <a:pt x="876664" y="61240"/>
                  <a:pt x="885825" y="64294"/>
                </a:cubicBezTo>
                <a:cubicBezTo>
                  <a:pt x="890588" y="65882"/>
                  <a:pt x="895243" y="67840"/>
                  <a:pt x="900113" y="69057"/>
                </a:cubicBezTo>
                <a:cubicBezTo>
                  <a:pt x="903288" y="69851"/>
                  <a:pt x="906443" y="70728"/>
                  <a:pt x="909638" y="71438"/>
                </a:cubicBezTo>
                <a:cubicBezTo>
                  <a:pt x="913589" y="72316"/>
                  <a:pt x="917639" y="72754"/>
                  <a:pt x="921544" y="73819"/>
                </a:cubicBezTo>
                <a:cubicBezTo>
                  <a:pt x="926387" y="75140"/>
                  <a:pt x="931069" y="76994"/>
                  <a:pt x="935832" y="78582"/>
                </a:cubicBezTo>
                <a:cubicBezTo>
                  <a:pt x="961883" y="87266"/>
                  <a:pt x="922422" y="73415"/>
                  <a:pt x="950119" y="85725"/>
                </a:cubicBezTo>
                <a:cubicBezTo>
                  <a:pt x="954707" y="87764"/>
                  <a:pt x="964407" y="90488"/>
                  <a:pt x="964407" y="90488"/>
                </a:cubicBezTo>
                <a:cubicBezTo>
                  <a:pt x="965994" y="92869"/>
                  <a:pt x="966934" y="95844"/>
                  <a:pt x="969169" y="97632"/>
                </a:cubicBezTo>
                <a:cubicBezTo>
                  <a:pt x="971129" y="99200"/>
                  <a:pt x="974068" y="98891"/>
                  <a:pt x="976313" y="100013"/>
                </a:cubicBezTo>
                <a:cubicBezTo>
                  <a:pt x="978873" y="101293"/>
                  <a:pt x="980897" y="103495"/>
                  <a:pt x="983457" y="104775"/>
                </a:cubicBezTo>
                <a:cubicBezTo>
                  <a:pt x="1003174" y="114634"/>
                  <a:pt x="977270" y="98271"/>
                  <a:pt x="997744" y="111919"/>
                </a:cubicBezTo>
                <a:cubicBezTo>
                  <a:pt x="1008661" y="128296"/>
                  <a:pt x="1001839" y="124397"/>
                  <a:pt x="1014413" y="128588"/>
                </a:cubicBezTo>
                <a:cubicBezTo>
                  <a:pt x="1016000" y="130969"/>
                  <a:pt x="1016940" y="133944"/>
                  <a:pt x="1019175" y="135732"/>
                </a:cubicBezTo>
                <a:cubicBezTo>
                  <a:pt x="1035539" y="148824"/>
                  <a:pt x="1016460" y="123396"/>
                  <a:pt x="1033463" y="145257"/>
                </a:cubicBezTo>
                <a:cubicBezTo>
                  <a:pt x="1036977" y="149775"/>
                  <a:pt x="1039813" y="154782"/>
                  <a:pt x="1042988" y="159544"/>
                </a:cubicBezTo>
                <a:lnTo>
                  <a:pt x="1052513" y="173832"/>
                </a:lnTo>
                <a:cubicBezTo>
                  <a:pt x="1054100" y="176213"/>
                  <a:pt x="1055252" y="178952"/>
                  <a:pt x="1057275" y="180975"/>
                </a:cubicBezTo>
                <a:lnTo>
                  <a:pt x="1064419" y="188119"/>
                </a:lnTo>
                <a:cubicBezTo>
                  <a:pt x="1073101" y="214168"/>
                  <a:pt x="1059255" y="174715"/>
                  <a:pt x="1071563" y="202407"/>
                </a:cubicBezTo>
                <a:cubicBezTo>
                  <a:pt x="1076085" y="212581"/>
                  <a:pt x="1075938" y="216530"/>
                  <a:pt x="1078707" y="226219"/>
                </a:cubicBezTo>
                <a:cubicBezTo>
                  <a:pt x="1079397" y="228633"/>
                  <a:pt x="1079869" y="231169"/>
                  <a:pt x="1081088" y="233363"/>
                </a:cubicBezTo>
                <a:cubicBezTo>
                  <a:pt x="1083868" y="238366"/>
                  <a:pt x="1087438" y="242888"/>
                  <a:pt x="1090613" y="247650"/>
                </a:cubicBezTo>
                <a:cubicBezTo>
                  <a:pt x="1092200" y="250031"/>
                  <a:pt x="1094470" y="252079"/>
                  <a:pt x="1095375" y="254794"/>
                </a:cubicBezTo>
                <a:cubicBezTo>
                  <a:pt x="1096169" y="257175"/>
                  <a:pt x="1096634" y="259693"/>
                  <a:pt x="1097757" y="261938"/>
                </a:cubicBezTo>
                <a:cubicBezTo>
                  <a:pt x="1099037" y="264498"/>
                  <a:pt x="1101357" y="266467"/>
                  <a:pt x="1102519" y="269082"/>
                </a:cubicBezTo>
                <a:cubicBezTo>
                  <a:pt x="1104558" y="273669"/>
                  <a:pt x="1105694" y="278607"/>
                  <a:pt x="1107282" y="283369"/>
                </a:cubicBezTo>
                <a:lnTo>
                  <a:pt x="1112044" y="297657"/>
                </a:lnTo>
                <a:cubicBezTo>
                  <a:pt x="1114312" y="304462"/>
                  <a:pt x="1115313" y="306855"/>
                  <a:pt x="1116807" y="314325"/>
                </a:cubicBezTo>
                <a:cubicBezTo>
                  <a:pt x="1121000" y="335287"/>
                  <a:pt x="1116934" y="321850"/>
                  <a:pt x="1121569" y="335757"/>
                </a:cubicBezTo>
                <a:cubicBezTo>
                  <a:pt x="1120775" y="350838"/>
                  <a:pt x="1120442" y="365950"/>
                  <a:pt x="1119188" y="381000"/>
                </a:cubicBezTo>
                <a:cubicBezTo>
                  <a:pt x="1118852" y="385034"/>
                  <a:pt x="1117717" y="388963"/>
                  <a:pt x="1116807" y="392907"/>
                </a:cubicBezTo>
                <a:cubicBezTo>
                  <a:pt x="1112325" y="412327"/>
                  <a:pt x="1112964" y="409199"/>
                  <a:pt x="1107282" y="426244"/>
                </a:cubicBezTo>
                <a:cubicBezTo>
                  <a:pt x="1106488" y="428625"/>
                  <a:pt x="1106292" y="431299"/>
                  <a:pt x="1104900" y="433388"/>
                </a:cubicBezTo>
                <a:cubicBezTo>
                  <a:pt x="1103313" y="435769"/>
                  <a:pt x="1101418" y="437972"/>
                  <a:pt x="1100138" y="440532"/>
                </a:cubicBezTo>
                <a:cubicBezTo>
                  <a:pt x="1093247" y="454315"/>
                  <a:pt x="1104154" y="441278"/>
                  <a:pt x="1090613" y="454819"/>
                </a:cubicBezTo>
                <a:cubicBezTo>
                  <a:pt x="1088227" y="461979"/>
                  <a:pt x="1088599" y="462952"/>
                  <a:pt x="1083469" y="469107"/>
                </a:cubicBezTo>
                <a:cubicBezTo>
                  <a:pt x="1081313" y="471694"/>
                  <a:pt x="1078392" y="473592"/>
                  <a:pt x="1076325" y="476250"/>
                </a:cubicBezTo>
                <a:cubicBezTo>
                  <a:pt x="1061364" y="495485"/>
                  <a:pt x="1073487" y="486080"/>
                  <a:pt x="1059657" y="495300"/>
                </a:cubicBezTo>
                <a:cubicBezTo>
                  <a:pt x="1055471" y="507854"/>
                  <a:pt x="1060041" y="497697"/>
                  <a:pt x="1050132" y="509588"/>
                </a:cubicBezTo>
                <a:cubicBezTo>
                  <a:pt x="1033570" y="529463"/>
                  <a:pt x="1059077" y="503026"/>
                  <a:pt x="1038225" y="523875"/>
                </a:cubicBezTo>
                <a:cubicBezTo>
                  <a:pt x="1037431" y="526256"/>
                  <a:pt x="1037236" y="528930"/>
                  <a:pt x="1035844" y="531019"/>
                </a:cubicBezTo>
                <a:cubicBezTo>
                  <a:pt x="1030748" y="538664"/>
                  <a:pt x="1029046" y="538048"/>
                  <a:pt x="1021557" y="540544"/>
                </a:cubicBezTo>
                <a:cubicBezTo>
                  <a:pt x="1016192" y="556634"/>
                  <a:pt x="1023632" y="539192"/>
                  <a:pt x="1012032" y="552450"/>
                </a:cubicBezTo>
                <a:cubicBezTo>
                  <a:pt x="1008263" y="556758"/>
                  <a:pt x="1005682" y="561975"/>
                  <a:pt x="1002507" y="566738"/>
                </a:cubicBezTo>
                <a:lnTo>
                  <a:pt x="997744" y="573882"/>
                </a:lnTo>
                <a:cubicBezTo>
                  <a:pt x="996950" y="576263"/>
                  <a:pt x="995972" y="578590"/>
                  <a:pt x="995363" y="581025"/>
                </a:cubicBezTo>
                <a:cubicBezTo>
                  <a:pt x="994401" y="584872"/>
                  <a:pt x="993077" y="595617"/>
                  <a:pt x="990600" y="600075"/>
                </a:cubicBezTo>
                <a:cubicBezTo>
                  <a:pt x="987820" y="605079"/>
                  <a:pt x="985838" y="611188"/>
                  <a:pt x="981075" y="614363"/>
                </a:cubicBezTo>
                <a:lnTo>
                  <a:pt x="973932" y="619125"/>
                </a:lnTo>
                <a:cubicBezTo>
                  <a:pt x="970757" y="623888"/>
                  <a:pt x="969170" y="630238"/>
                  <a:pt x="964407" y="633413"/>
                </a:cubicBezTo>
                <a:cubicBezTo>
                  <a:pt x="957382" y="638095"/>
                  <a:pt x="955849" y="638443"/>
                  <a:pt x="950119" y="645319"/>
                </a:cubicBezTo>
                <a:cubicBezTo>
                  <a:pt x="940198" y="657225"/>
                  <a:pt x="951310" y="648495"/>
                  <a:pt x="938213" y="657225"/>
                </a:cubicBezTo>
                <a:cubicBezTo>
                  <a:pt x="937419" y="659606"/>
                  <a:pt x="937400" y="662409"/>
                  <a:pt x="935832" y="664369"/>
                </a:cubicBezTo>
                <a:cubicBezTo>
                  <a:pt x="934044" y="666604"/>
                  <a:pt x="930887" y="667300"/>
                  <a:pt x="928688" y="669132"/>
                </a:cubicBezTo>
                <a:cubicBezTo>
                  <a:pt x="926101" y="671288"/>
                  <a:pt x="923700" y="673688"/>
                  <a:pt x="921544" y="676275"/>
                </a:cubicBezTo>
                <a:cubicBezTo>
                  <a:pt x="913258" y="686218"/>
                  <a:pt x="921367" y="681891"/>
                  <a:pt x="909638" y="685800"/>
                </a:cubicBezTo>
                <a:lnTo>
                  <a:pt x="902494" y="707232"/>
                </a:lnTo>
                <a:cubicBezTo>
                  <a:pt x="901700" y="709613"/>
                  <a:pt x="901505" y="712287"/>
                  <a:pt x="900113" y="714375"/>
                </a:cubicBezTo>
                <a:cubicBezTo>
                  <a:pt x="896938" y="719138"/>
                  <a:pt x="894635" y="724616"/>
                  <a:pt x="890588" y="728663"/>
                </a:cubicBezTo>
                <a:cubicBezTo>
                  <a:pt x="888207" y="731044"/>
                  <a:pt x="885512" y="733149"/>
                  <a:pt x="883444" y="735807"/>
                </a:cubicBezTo>
                <a:cubicBezTo>
                  <a:pt x="868485" y="755040"/>
                  <a:pt x="880605" y="745636"/>
                  <a:pt x="866775" y="754857"/>
                </a:cubicBezTo>
                <a:lnTo>
                  <a:pt x="847725" y="783432"/>
                </a:lnTo>
                <a:lnTo>
                  <a:pt x="842963" y="790575"/>
                </a:lnTo>
                <a:lnTo>
                  <a:pt x="838200" y="797719"/>
                </a:lnTo>
                <a:cubicBezTo>
                  <a:pt x="832219" y="815666"/>
                  <a:pt x="840284" y="793553"/>
                  <a:pt x="831057" y="812007"/>
                </a:cubicBezTo>
                <a:cubicBezTo>
                  <a:pt x="829934" y="814252"/>
                  <a:pt x="830067" y="817062"/>
                  <a:pt x="828675" y="819150"/>
                </a:cubicBezTo>
                <a:cubicBezTo>
                  <a:pt x="826807" y="821952"/>
                  <a:pt x="823599" y="823636"/>
                  <a:pt x="821532" y="826294"/>
                </a:cubicBezTo>
                <a:cubicBezTo>
                  <a:pt x="806575" y="845526"/>
                  <a:pt x="818692" y="836126"/>
                  <a:pt x="804863" y="845344"/>
                </a:cubicBezTo>
                <a:cubicBezTo>
                  <a:pt x="801688" y="850107"/>
                  <a:pt x="799386" y="855585"/>
                  <a:pt x="795338" y="859632"/>
                </a:cubicBezTo>
                <a:cubicBezTo>
                  <a:pt x="792957" y="862013"/>
                  <a:pt x="790261" y="864117"/>
                  <a:pt x="788194" y="866775"/>
                </a:cubicBezTo>
                <a:cubicBezTo>
                  <a:pt x="784680" y="871293"/>
                  <a:pt x="781844" y="876300"/>
                  <a:pt x="778669" y="881063"/>
                </a:cubicBezTo>
                <a:cubicBezTo>
                  <a:pt x="777082" y="883444"/>
                  <a:pt x="775931" y="886183"/>
                  <a:pt x="773907" y="888207"/>
                </a:cubicBezTo>
                <a:lnTo>
                  <a:pt x="766763" y="895350"/>
                </a:lnTo>
                <a:cubicBezTo>
                  <a:pt x="765175" y="900113"/>
                  <a:pt x="764785" y="905461"/>
                  <a:pt x="762000" y="909638"/>
                </a:cubicBezTo>
                <a:lnTo>
                  <a:pt x="752475" y="923925"/>
                </a:lnTo>
                <a:cubicBezTo>
                  <a:pt x="750888" y="926306"/>
                  <a:pt x="748618" y="928354"/>
                  <a:pt x="747713" y="931069"/>
                </a:cubicBezTo>
                <a:cubicBezTo>
                  <a:pt x="744267" y="941408"/>
                  <a:pt x="747107" y="936438"/>
                  <a:pt x="738188" y="945357"/>
                </a:cubicBezTo>
                <a:cubicBezTo>
                  <a:pt x="733997" y="957930"/>
                  <a:pt x="737199" y="950413"/>
                  <a:pt x="726282" y="966788"/>
                </a:cubicBezTo>
                <a:lnTo>
                  <a:pt x="711994" y="988219"/>
                </a:lnTo>
                <a:cubicBezTo>
                  <a:pt x="710407" y="990600"/>
                  <a:pt x="708137" y="992648"/>
                  <a:pt x="707232" y="995363"/>
                </a:cubicBezTo>
                <a:cubicBezTo>
                  <a:pt x="706438" y="997744"/>
                  <a:pt x="706418" y="1000547"/>
                  <a:pt x="704850" y="1002507"/>
                </a:cubicBezTo>
                <a:cubicBezTo>
                  <a:pt x="703062" y="1004742"/>
                  <a:pt x="700088" y="1005682"/>
                  <a:pt x="697707" y="1007269"/>
                </a:cubicBezTo>
                <a:cubicBezTo>
                  <a:pt x="695225" y="1014713"/>
                  <a:pt x="692818" y="1024021"/>
                  <a:pt x="685800" y="1028700"/>
                </a:cubicBezTo>
                <a:lnTo>
                  <a:pt x="678657" y="1033463"/>
                </a:lnTo>
                <a:cubicBezTo>
                  <a:pt x="677069" y="1035844"/>
                  <a:pt x="675918" y="1038583"/>
                  <a:pt x="673894" y="1040607"/>
                </a:cubicBezTo>
                <a:cubicBezTo>
                  <a:pt x="669279" y="1045222"/>
                  <a:pt x="665416" y="1045814"/>
                  <a:pt x="659607" y="1047750"/>
                </a:cubicBezTo>
                <a:cubicBezTo>
                  <a:pt x="657226" y="1049338"/>
                  <a:pt x="655078" y="1051351"/>
                  <a:pt x="652463" y="1052513"/>
                </a:cubicBezTo>
                <a:cubicBezTo>
                  <a:pt x="647875" y="1054552"/>
                  <a:pt x="638175" y="1057275"/>
                  <a:pt x="638175" y="1057275"/>
                </a:cubicBezTo>
                <a:cubicBezTo>
                  <a:pt x="623094" y="1056481"/>
                  <a:pt x="607972" y="1056261"/>
                  <a:pt x="592932" y="1054894"/>
                </a:cubicBezTo>
                <a:cubicBezTo>
                  <a:pt x="590432" y="1054667"/>
                  <a:pt x="587748" y="1054081"/>
                  <a:pt x="585788" y="1052513"/>
                </a:cubicBezTo>
                <a:cubicBezTo>
                  <a:pt x="583553" y="1050725"/>
                  <a:pt x="582857" y="1047568"/>
                  <a:pt x="581025" y="1045369"/>
                </a:cubicBezTo>
                <a:cubicBezTo>
                  <a:pt x="578869" y="1042782"/>
                  <a:pt x="576469" y="1040381"/>
                  <a:pt x="573882" y="1038225"/>
                </a:cubicBezTo>
                <a:cubicBezTo>
                  <a:pt x="571683" y="1036393"/>
                  <a:pt x="568877" y="1035364"/>
                  <a:pt x="566738" y="1033463"/>
                </a:cubicBezTo>
                <a:cubicBezTo>
                  <a:pt x="561704" y="1028988"/>
                  <a:pt x="558054" y="1022911"/>
                  <a:pt x="552450" y="1019175"/>
                </a:cubicBezTo>
                <a:cubicBezTo>
                  <a:pt x="550069" y="1017588"/>
                  <a:pt x="547505" y="1016245"/>
                  <a:pt x="545307" y="1014413"/>
                </a:cubicBezTo>
                <a:cubicBezTo>
                  <a:pt x="521902" y="994909"/>
                  <a:pt x="552131" y="1018856"/>
                  <a:pt x="533400" y="1000125"/>
                </a:cubicBezTo>
                <a:cubicBezTo>
                  <a:pt x="531377" y="998102"/>
                  <a:pt x="528638" y="996950"/>
                  <a:pt x="526257" y="995363"/>
                </a:cubicBezTo>
                <a:cubicBezTo>
                  <a:pt x="525463" y="992982"/>
                  <a:pt x="525094" y="990413"/>
                  <a:pt x="523875" y="988219"/>
                </a:cubicBezTo>
                <a:cubicBezTo>
                  <a:pt x="521095" y="983216"/>
                  <a:pt x="514350" y="973932"/>
                  <a:pt x="514350" y="973932"/>
                </a:cubicBezTo>
                <a:cubicBezTo>
                  <a:pt x="508683" y="956929"/>
                  <a:pt x="512373" y="963821"/>
                  <a:pt x="504825" y="952500"/>
                </a:cubicBezTo>
                <a:lnTo>
                  <a:pt x="500063" y="938213"/>
                </a:lnTo>
                <a:cubicBezTo>
                  <a:pt x="499269" y="935832"/>
                  <a:pt x="498291" y="933504"/>
                  <a:pt x="497682" y="931069"/>
                </a:cubicBezTo>
                <a:lnTo>
                  <a:pt x="495300" y="921544"/>
                </a:lnTo>
                <a:cubicBezTo>
                  <a:pt x="489509" y="875212"/>
                  <a:pt x="491185" y="896362"/>
                  <a:pt x="495300" y="812007"/>
                </a:cubicBezTo>
                <a:cubicBezTo>
                  <a:pt x="495422" y="809500"/>
                  <a:pt x="497073" y="807298"/>
                  <a:pt x="497682" y="804863"/>
                </a:cubicBezTo>
                <a:cubicBezTo>
                  <a:pt x="504415" y="777933"/>
                  <a:pt x="494606" y="809326"/>
                  <a:pt x="504825" y="778669"/>
                </a:cubicBezTo>
                <a:cubicBezTo>
                  <a:pt x="505619" y="776288"/>
                  <a:pt x="505815" y="773614"/>
                  <a:pt x="507207" y="771525"/>
                </a:cubicBezTo>
                <a:lnTo>
                  <a:pt x="516732" y="757238"/>
                </a:lnTo>
                <a:lnTo>
                  <a:pt x="531019" y="714375"/>
                </a:lnTo>
                <a:lnTo>
                  <a:pt x="535782" y="700088"/>
                </a:lnTo>
                <a:cubicBezTo>
                  <a:pt x="536576" y="697707"/>
                  <a:pt x="536771" y="695033"/>
                  <a:pt x="538163" y="692944"/>
                </a:cubicBezTo>
                <a:cubicBezTo>
                  <a:pt x="539750" y="690563"/>
                  <a:pt x="541763" y="688415"/>
                  <a:pt x="542925" y="685800"/>
                </a:cubicBezTo>
                <a:cubicBezTo>
                  <a:pt x="544964" y="681213"/>
                  <a:pt x="546100" y="676275"/>
                  <a:pt x="547688" y="671513"/>
                </a:cubicBezTo>
                <a:cubicBezTo>
                  <a:pt x="548482" y="669132"/>
                  <a:pt x="548677" y="666457"/>
                  <a:pt x="550069" y="664369"/>
                </a:cubicBezTo>
                <a:lnTo>
                  <a:pt x="554832" y="657225"/>
                </a:lnTo>
                <a:cubicBezTo>
                  <a:pt x="555626" y="654844"/>
                  <a:pt x="555994" y="652276"/>
                  <a:pt x="557213" y="650082"/>
                </a:cubicBezTo>
                <a:cubicBezTo>
                  <a:pt x="559993" y="645078"/>
                  <a:pt x="563563" y="640557"/>
                  <a:pt x="566738" y="635794"/>
                </a:cubicBezTo>
                <a:lnTo>
                  <a:pt x="576263" y="621507"/>
                </a:lnTo>
                <a:cubicBezTo>
                  <a:pt x="577851" y="619126"/>
                  <a:pt x="580120" y="617078"/>
                  <a:pt x="581025" y="614363"/>
                </a:cubicBezTo>
                <a:cubicBezTo>
                  <a:pt x="581819" y="611982"/>
                  <a:pt x="581839" y="609179"/>
                  <a:pt x="583407" y="607219"/>
                </a:cubicBezTo>
                <a:cubicBezTo>
                  <a:pt x="585195" y="604984"/>
                  <a:pt x="588169" y="604044"/>
                  <a:pt x="590550" y="602457"/>
                </a:cubicBezTo>
                <a:cubicBezTo>
                  <a:pt x="591344" y="600076"/>
                  <a:pt x="592242" y="597727"/>
                  <a:pt x="592932" y="595313"/>
                </a:cubicBezTo>
                <a:cubicBezTo>
                  <a:pt x="593949" y="591753"/>
                  <a:pt x="595791" y="582450"/>
                  <a:pt x="597694" y="578644"/>
                </a:cubicBezTo>
                <a:cubicBezTo>
                  <a:pt x="598974" y="576084"/>
                  <a:pt x="600869" y="573881"/>
                  <a:pt x="602457" y="571500"/>
                </a:cubicBezTo>
                <a:cubicBezTo>
                  <a:pt x="608440" y="553550"/>
                  <a:pt x="600370" y="575673"/>
                  <a:pt x="609600" y="557213"/>
                </a:cubicBezTo>
                <a:cubicBezTo>
                  <a:pt x="610723" y="554968"/>
                  <a:pt x="610859" y="552314"/>
                  <a:pt x="611982" y="550069"/>
                </a:cubicBezTo>
                <a:cubicBezTo>
                  <a:pt x="613262" y="547509"/>
                  <a:pt x="615464" y="545485"/>
                  <a:pt x="616744" y="542925"/>
                </a:cubicBezTo>
                <a:cubicBezTo>
                  <a:pt x="619675" y="537063"/>
                  <a:pt x="620592" y="526980"/>
                  <a:pt x="621507" y="521494"/>
                </a:cubicBezTo>
                <a:cubicBezTo>
                  <a:pt x="620713" y="509588"/>
                  <a:pt x="620374" y="497642"/>
                  <a:pt x="619125" y="485775"/>
                </a:cubicBezTo>
                <a:cubicBezTo>
                  <a:pt x="618782" y="482520"/>
                  <a:pt x="617454" y="479445"/>
                  <a:pt x="616744" y="476250"/>
                </a:cubicBezTo>
                <a:cubicBezTo>
                  <a:pt x="615866" y="472299"/>
                  <a:pt x="615241" y="468295"/>
                  <a:pt x="614363" y="464344"/>
                </a:cubicBezTo>
                <a:cubicBezTo>
                  <a:pt x="613751" y="461592"/>
                  <a:pt x="611193" y="450861"/>
                  <a:pt x="609600" y="447675"/>
                </a:cubicBezTo>
                <a:cubicBezTo>
                  <a:pt x="608320" y="445116"/>
                  <a:pt x="607073" y="442320"/>
                  <a:pt x="604838" y="440532"/>
                </a:cubicBezTo>
                <a:cubicBezTo>
                  <a:pt x="602878" y="438964"/>
                  <a:pt x="600075" y="438944"/>
                  <a:pt x="597694" y="438150"/>
                </a:cubicBezTo>
                <a:cubicBezTo>
                  <a:pt x="590147" y="426830"/>
                  <a:pt x="595646" y="431911"/>
                  <a:pt x="578644" y="426244"/>
                </a:cubicBezTo>
                <a:lnTo>
                  <a:pt x="571500" y="423863"/>
                </a:lnTo>
                <a:cubicBezTo>
                  <a:pt x="569119" y="423069"/>
                  <a:pt x="566833" y="421895"/>
                  <a:pt x="564357" y="421482"/>
                </a:cubicBezTo>
                <a:cubicBezTo>
                  <a:pt x="539080" y="417268"/>
                  <a:pt x="554885" y="419444"/>
                  <a:pt x="516732" y="416719"/>
                </a:cubicBezTo>
                <a:cubicBezTo>
                  <a:pt x="512763" y="415925"/>
                  <a:pt x="508873" y="414338"/>
                  <a:pt x="504825" y="414338"/>
                </a:cubicBezTo>
                <a:cubicBezTo>
                  <a:pt x="480778" y="414338"/>
                  <a:pt x="462374" y="414731"/>
                  <a:pt x="440532" y="419100"/>
                </a:cubicBezTo>
                <a:cubicBezTo>
                  <a:pt x="431544" y="420898"/>
                  <a:pt x="425818" y="423211"/>
                  <a:pt x="416719" y="426244"/>
                </a:cubicBezTo>
                <a:cubicBezTo>
                  <a:pt x="416714" y="426246"/>
                  <a:pt x="402437" y="431003"/>
                  <a:pt x="402432" y="431007"/>
                </a:cubicBezTo>
                <a:cubicBezTo>
                  <a:pt x="393199" y="437161"/>
                  <a:pt x="398003" y="434864"/>
                  <a:pt x="388144" y="438150"/>
                </a:cubicBezTo>
                <a:lnTo>
                  <a:pt x="366713" y="452438"/>
                </a:lnTo>
                <a:cubicBezTo>
                  <a:pt x="364332" y="454025"/>
                  <a:pt x="362284" y="456295"/>
                  <a:pt x="359569" y="457200"/>
                </a:cubicBezTo>
                <a:lnTo>
                  <a:pt x="330994" y="466725"/>
                </a:lnTo>
                <a:lnTo>
                  <a:pt x="323850" y="469107"/>
                </a:lnTo>
                <a:cubicBezTo>
                  <a:pt x="321469" y="469901"/>
                  <a:pt x="318795" y="470096"/>
                  <a:pt x="316707" y="471488"/>
                </a:cubicBezTo>
                <a:cubicBezTo>
                  <a:pt x="314326" y="473075"/>
                  <a:pt x="312123" y="474970"/>
                  <a:pt x="309563" y="476250"/>
                </a:cubicBezTo>
                <a:cubicBezTo>
                  <a:pt x="307318" y="477373"/>
                  <a:pt x="304613" y="477413"/>
                  <a:pt x="302419" y="478632"/>
                </a:cubicBezTo>
                <a:cubicBezTo>
                  <a:pt x="297416" y="481412"/>
                  <a:pt x="292180" y="484110"/>
                  <a:pt x="288132" y="488157"/>
                </a:cubicBezTo>
                <a:cubicBezTo>
                  <a:pt x="278964" y="497324"/>
                  <a:pt x="283790" y="493432"/>
                  <a:pt x="273844" y="500063"/>
                </a:cubicBezTo>
                <a:cubicBezTo>
                  <a:pt x="272257" y="502444"/>
                  <a:pt x="271106" y="505183"/>
                  <a:pt x="269082" y="507207"/>
                </a:cubicBezTo>
                <a:cubicBezTo>
                  <a:pt x="267058" y="509231"/>
                  <a:pt x="263823" y="509815"/>
                  <a:pt x="261938" y="511969"/>
                </a:cubicBezTo>
                <a:cubicBezTo>
                  <a:pt x="258169" y="516277"/>
                  <a:pt x="255588" y="521494"/>
                  <a:pt x="252413" y="526257"/>
                </a:cubicBezTo>
                <a:lnTo>
                  <a:pt x="247650" y="533400"/>
                </a:lnTo>
                <a:cubicBezTo>
                  <a:pt x="246062" y="535781"/>
                  <a:pt x="245269" y="538956"/>
                  <a:pt x="242888" y="540544"/>
                </a:cubicBezTo>
                <a:lnTo>
                  <a:pt x="235744" y="545307"/>
                </a:lnTo>
                <a:cubicBezTo>
                  <a:pt x="223046" y="564353"/>
                  <a:pt x="239712" y="541339"/>
                  <a:pt x="223838" y="557213"/>
                </a:cubicBezTo>
                <a:cubicBezTo>
                  <a:pt x="207964" y="573087"/>
                  <a:pt x="230978" y="556421"/>
                  <a:pt x="211932" y="569119"/>
                </a:cubicBezTo>
                <a:cubicBezTo>
                  <a:pt x="201015" y="585496"/>
                  <a:pt x="207837" y="581597"/>
                  <a:pt x="195263" y="585788"/>
                </a:cubicBezTo>
                <a:cubicBezTo>
                  <a:pt x="189278" y="603745"/>
                  <a:pt x="198048" y="582307"/>
                  <a:pt x="185738" y="597694"/>
                </a:cubicBezTo>
                <a:cubicBezTo>
                  <a:pt x="176501" y="609240"/>
                  <a:pt x="191800" y="602024"/>
                  <a:pt x="176213" y="607219"/>
                </a:cubicBezTo>
                <a:cubicBezTo>
                  <a:pt x="162562" y="627695"/>
                  <a:pt x="180739" y="603598"/>
                  <a:pt x="164307" y="616744"/>
                </a:cubicBezTo>
                <a:cubicBezTo>
                  <a:pt x="148921" y="629053"/>
                  <a:pt x="170354" y="620285"/>
                  <a:pt x="152400" y="626269"/>
                </a:cubicBezTo>
                <a:cubicBezTo>
                  <a:pt x="126850" y="643306"/>
                  <a:pt x="165643" y="616764"/>
                  <a:pt x="138113" y="638175"/>
                </a:cubicBezTo>
                <a:cubicBezTo>
                  <a:pt x="133595" y="641689"/>
                  <a:pt x="127872" y="643652"/>
                  <a:pt x="123825" y="647700"/>
                </a:cubicBezTo>
                <a:cubicBezTo>
                  <a:pt x="121444" y="650081"/>
                  <a:pt x="118838" y="652257"/>
                  <a:pt x="116682" y="654844"/>
                </a:cubicBezTo>
                <a:cubicBezTo>
                  <a:pt x="114850" y="657043"/>
                  <a:pt x="114154" y="660200"/>
                  <a:pt x="111919" y="661988"/>
                </a:cubicBezTo>
                <a:cubicBezTo>
                  <a:pt x="109959" y="663556"/>
                  <a:pt x="107156" y="663575"/>
                  <a:pt x="104775" y="664369"/>
                </a:cubicBezTo>
                <a:cubicBezTo>
                  <a:pt x="103981" y="666750"/>
                  <a:pt x="104169" y="669738"/>
                  <a:pt x="102394" y="671513"/>
                </a:cubicBezTo>
                <a:cubicBezTo>
                  <a:pt x="100619" y="673288"/>
                  <a:pt x="97495" y="672771"/>
                  <a:pt x="95250" y="673894"/>
                </a:cubicBezTo>
                <a:cubicBezTo>
                  <a:pt x="92690" y="675174"/>
                  <a:pt x="90488" y="677069"/>
                  <a:pt x="88107" y="678657"/>
                </a:cubicBezTo>
                <a:cubicBezTo>
                  <a:pt x="83470" y="692563"/>
                  <a:pt x="89353" y="679792"/>
                  <a:pt x="78582" y="690563"/>
                </a:cubicBezTo>
                <a:cubicBezTo>
                  <a:pt x="62714" y="706432"/>
                  <a:pt x="85717" y="689776"/>
                  <a:pt x="66675" y="702469"/>
                </a:cubicBezTo>
                <a:cubicBezTo>
                  <a:pt x="60690" y="720426"/>
                  <a:pt x="69460" y="698988"/>
                  <a:pt x="57150" y="714375"/>
                </a:cubicBezTo>
                <a:cubicBezTo>
                  <a:pt x="44002" y="730809"/>
                  <a:pt x="68102" y="712630"/>
                  <a:pt x="47625" y="726282"/>
                </a:cubicBezTo>
                <a:cubicBezTo>
                  <a:pt x="42989" y="740189"/>
                  <a:pt x="48871" y="727416"/>
                  <a:pt x="38100" y="738188"/>
                </a:cubicBezTo>
                <a:cubicBezTo>
                  <a:pt x="22229" y="754060"/>
                  <a:pt x="45241" y="737398"/>
                  <a:pt x="26194" y="750094"/>
                </a:cubicBezTo>
                <a:cubicBezTo>
                  <a:pt x="25400" y="752475"/>
                  <a:pt x="25588" y="755463"/>
                  <a:pt x="23813" y="757238"/>
                </a:cubicBezTo>
                <a:cubicBezTo>
                  <a:pt x="19766" y="761285"/>
                  <a:pt x="9525" y="766763"/>
                  <a:pt x="9525" y="766763"/>
                </a:cubicBezTo>
                <a:lnTo>
                  <a:pt x="2382" y="788194"/>
                </a:lnTo>
                <a:lnTo>
                  <a:pt x="0" y="795338"/>
                </a:lnTo>
                <a:cubicBezTo>
                  <a:pt x="794" y="799307"/>
                  <a:pt x="961" y="803454"/>
                  <a:pt x="2382" y="807244"/>
                </a:cubicBezTo>
                <a:cubicBezTo>
                  <a:pt x="9150" y="825292"/>
                  <a:pt x="26749" y="813163"/>
                  <a:pt x="45244" y="812007"/>
                </a:cubicBezTo>
                <a:cubicBezTo>
                  <a:pt x="47625" y="810419"/>
                  <a:pt x="49828" y="808524"/>
                  <a:pt x="52388" y="807244"/>
                </a:cubicBezTo>
                <a:cubicBezTo>
                  <a:pt x="54633" y="806121"/>
                  <a:pt x="57338" y="806082"/>
                  <a:pt x="59532" y="804863"/>
                </a:cubicBezTo>
                <a:cubicBezTo>
                  <a:pt x="64535" y="802083"/>
                  <a:pt x="68389" y="797148"/>
                  <a:pt x="73819" y="795338"/>
                </a:cubicBezTo>
                <a:lnTo>
                  <a:pt x="88107" y="790575"/>
                </a:lnTo>
                <a:cubicBezTo>
                  <a:pt x="106764" y="792441"/>
                  <a:pt x="113754" y="791980"/>
                  <a:pt x="130969" y="797719"/>
                </a:cubicBezTo>
                <a:lnTo>
                  <a:pt x="145257" y="802482"/>
                </a:lnTo>
                <a:cubicBezTo>
                  <a:pt x="147638" y="803276"/>
                  <a:pt x="150312" y="803471"/>
                  <a:pt x="152400" y="804863"/>
                </a:cubicBezTo>
                <a:cubicBezTo>
                  <a:pt x="172873" y="818510"/>
                  <a:pt x="146970" y="802148"/>
                  <a:pt x="166688" y="812007"/>
                </a:cubicBezTo>
                <a:cubicBezTo>
                  <a:pt x="185148" y="821237"/>
                  <a:pt x="163025" y="813167"/>
                  <a:pt x="180975" y="819150"/>
                </a:cubicBezTo>
                <a:lnTo>
                  <a:pt x="202407" y="833438"/>
                </a:lnTo>
                <a:lnTo>
                  <a:pt x="209550" y="838200"/>
                </a:lnTo>
                <a:cubicBezTo>
                  <a:pt x="211931" y="839788"/>
                  <a:pt x="213979" y="842058"/>
                  <a:pt x="216694" y="842963"/>
                </a:cubicBezTo>
                <a:lnTo>
                  <a:pt x="223838" y="845344"/>
                </a:lnTo>
                <a:cubicBezTo>
                  <a:pt x="225425" y="847725"/>
                  <a:pt x="226173" y="850971"/>
                  <a:pt x="228600" y="852488"/>
                </a:cubicBezTo>
                <a:cubicBezTo>
                  <a:pt x="232857" y="855149"/>
                  <a:pt x="242888" y="857250"/>
                  <a:pt x="242888" y="857250"/>
                </a:cubicBezTo>
                <a:cubicBezTo>
                  <a:pt x="263364" y="870901"/>
                  <a:pt x="237457" y="854534"/>
                  <a:pt x="257175" y="864394"/>
                </a:cubicBezTo>
                <a:cubicBezTo>
                  <a:pt x="275636" y="873625"/>
                  <a:pt x="253510" y="865555"/>
                  <a:pt x="271463" y="871538"/>
                </a:cubicBezTo>
                <a:cubicBezTo>
                  <a:pt x="273050" y="873919"/>
                  <a:pt x="273798" y="877165"/>
                  <a:pt x="276225" y="878682"/>
                </a:cubicBezTo>
                <a:cubicBezTo>
                  <a:pt x="280482" y="881343"/>
                  <a:pt x="290513" y="883444"/>
                  <a:pt x="290513" y="883444"/>
                </a:cubicBezTo>
                <a:lnTo>
                  <a:pt x="319088" y="902494"/>
                </a:lnTo>
                <a:cubicBezTo>
                  <a:pt x="321469" y="904082"/>
                  <a:pt x="323517" y="906352"/>
                  <a:pt x="326232" y="907257"/>
                </a:cubicBezTo>
                <a:cubicBezTo>
                  <a:pt x="328613" y="908051"/>
                  <a:pt x="331181" y="908419"/>
                  <a:pt x="333375" y="909638"/>
                </a:cubicBezTo>
                <a:cubicBezTo>
                  <a:pt x="338379" y="912418"/>
                  <a:pt x="342900" y="915988"/>
                  <a:pt x="347663" y="919163"/>
                </a:cubicBezTo>
                <a:lnTo>
                  <a:pt x="354807" y="923925"/>
                </a:lnTo>
                <a:cubicBezTo>
                  <a:pt x="357188" y="925512"/>
                  <a:pt x="359926" y="926664"/>
                  <a:pt x="361950" y="928688"/>
                </a:cubicBezTo>
                <a:cubicBezTo>
                  <a:pt x="371118" y="937856"/>
                  <a:pt x="366292" y="933964"/>
                  <a:pt x="376238" y="940594"/>
                </a:cubicBezTo>
                <a:cubicBezTo>
                  <a:pt x="377825" y="942975"/>
                  <a:pt x="378765" y="945950"/>
                  <a:pt x="381000" y="947738"/>
                </a:cubicBezTo>
                <a:cubicBezTo>
                  <a:pt x="382960" y="949306"/>
                  <a:pt x="386369" y="948344"/>
                  <a:pt x="388144" y="950119"/>
                </a:cubicBezTo>
                <a:cubicBezTo>
                  <a:pt x="389919" y="951894"/>
                  <a:pt x="388957" y="955303"/>
                  <a:pt x="390525" y="957263"/>
                </a:cubicBezTo>
                <a:cubicBezTo>
                  <a:pt x="392313" y="959498"/>
                  <a:pt x="395288" y="960438"/>
                  <a:pt x="397669" y="962025"/>
                </a:cubicBezTo>
                <a:cubicBezTo>
                  <a:pt x="403653" y="979979"/>
                  <a:pt x="394885" y="958546"/>
                  <a:pt x="407194" y="973932"/>
                </a:cubicBezTo>
                <a:cubicBezTo>
                  <a:pt x="408762" y="975892"/>
                  <a:pt x="408356" y="978881"/>
                  <a:pt x="409575" y="981075"/>
                </a:cubicBezTo>
                <a:cubicBezTo>
                  <a:pt x="417747" y="995784"/>
                  <a:pt x="415808" y="993168"/>
                  <a:pt x="426244" y="1000125"/>
                </a:cubicBezTo>
                <a:cubicBezTo>
                  <a:pt x="432228" y="1018079"/>
                  <a:pt x="423460" y="996646"/>
                  <a:pt x="435769" y="1012032"/>
                </a:cubicBezTo>
                <a:cubicBezTo>
                  <a:pt x="437337" y="1013992"/>
                  <a:pt x="436758" y="1017087"/>
                  <a:pt x="438150" y="1019175"/>
                </a:cubicBezTo>
                <a:cubicBezTo>
                  <a:pt x="446369" y="1031503"/>
                  <a:pt x="448479" y="1021586"/>
                  <a:pt x="454819" y="1040607"/>
                </a:cubicBezTo>
                <a:cubicBezTo>
                  <a:pt x="455613" y="1042988"/>
                  <a:pt x="455981" y="1045556"/>
                  <a:pt x="457200" y="1047750"/>
                </a:cubicBezTo>
                <a:cubicBezTo>
                  <a:pt x="459980" y="1052754"/>
                  <a:pt x="464915" y="1056608"/>
                  <a:pt x="466725" y="1062038"/>
                </a:cubicBezTo>
                <a:lnTo>
                  <a:pt x="471488" y="1076325"/>
                </a:lnTo>
                <a:cubicBezTo>
                  <a:pt x="472282" y="1078706"/>
                  <a:pt x="472477" y="1081381"/>
                  <a:pt x="473869" y="1083469"/>
                </a:cubicBezTo>
                <a:lnTo>
                  <a:pt x="478632" y="1090613"/>
                </a:lnTo>
                <a:cubicBezTo>
                  <a:pt x="484615" y="1108564"/>
                  <a:pt x="476546" y="1086443"/>
                  <a:pt x="485775" y="1104900"/>
                </a:cubicBezTo>
                <a:cubicBezTo>
                  <a:pt x="486898" y="1107145"/>
                  <a:pt x="486938" y="1109850"/>
                  <a:pt x="488157" y="1112044"/>
                </a:cubicBezTo>
                <a:cubicBezTo>
                  <a:pt x="490937" y="1117048"/>
                  <a:pt x="494507" y="1121569"/>
                  <a:pt x="497682" y="1126332"/>
                </a:cubicBezTo>
                <a:lnTo>
                  <a:pt x="502444" y="1133475"/>
                </a:lnTo>
                <a:lnTo>
                  <a:pt x="507207" y="1140619"/>
                </a:lnTo>
                <a:cubicBezTo>
                  <a:pt x="508001" y="1143000"/>
                  <a:pt x="508466" y="1145518"/>
                  <a:pt x="509588" y="1147763"/>
                </a:cubicBezTo>
                <a:cubicBezTo>
                  <a:pt x="510868" y="1150323"/>
                  <a:pt x="513188" y="1152292"/>
                  <a:pt x="514350" y="1154907"/>
                </a:cubicBezTo>
                <a:cubicBezTo>
                  <a:pt x="516389" y="1159494"/>
                  <a:pt x="516329" y="1165017"/>
                  <a:pt x="519113" y="1169194"/>
                </a:cubicBezTo>
                <a:cubicBezTo>
                  <a:pt x="523768" y="1176177"/>
                  <a:pt x="524285" y="1175596"/>
                  <a:pt x="526257" y="1183482"/>
                </a:cubicBezTo>
                <a:cubicBezTo>
                  <a:pt x="526450" y="1184252"/>
                  <a:pt x="526257" y="1185069"/>
                  <a:pt x="526257" y="1185863"/>
                </a:cubicBezTo>
              </a:path>
            </a:pathLst>
          </a:custGeom>
          <a:noFill/>
          <a:ln w="38100">
            <a:solidFill>
              <a:schemeClr val="bg1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9666">
              <a:ln w="38100">
                <a:solidFill>
                  <a:schemeClr val="tx1"/>
                </a:solidFill>
              </a:ln>
            </a:endParaRPr>
          </a:p>
        </p:txBody>
      </p:sp>
      <p:sp>
        <p:nvSpPr>
          <p:cNvPr id="22" name="Freeform 21"/>
          <p:cNvSpPr/>
          <p:nvPr/>
        </p:nvSpPr>
        <p:spPr>
          <a:xfrm>
            <a:off x="10626168" y="2478789"/>
            <a:ext cx="1693003" cy="3793528"/>
          </a:xfrm>
          <a:custGeom>
            <a:avLst/>
            <a:gdLst>
              <a:gd name="connsiteX0" fmla="*/ 863600 w 863600"/>
              <a:gd name="connsiteY0" fmla="*/ 0 h 1797050"/>
              <a:gd name="connsiteX1" fmla="*/ 815975 w 863600"/>
              <a:gd name="connsiteY1" fmla="*/ 6350 h 1797050"/>
              <a:gd name="connsiteX2" fmla="*/ 806450 w 863600"/>
              <a:gd name="connsiteY2" fmla="*/ 9525 h 1797050"/>
              <a:gd name="connsiteX3" fmla="*/ 787400 w 863600"/>
              <a:gd name="connsiteY3" fmla="*/ 22225 h 1797050"/>
              <a:gd name="connsiteX4" fmla="*/ 758825 w 863600"/>
              <a:gd name="connsiteY4" fmla="*/ 34925 h 1797050"/>
              <a:gd name="connsiteX5" fmla="*/ 749300 w 863600"/>
              <a:gd name="connsiteY5" fmla="*/ 38100 h 1797050"/>
              <a:gd name="connsiteX6" fmla="*/ 739775 w 863600"/>
              <a:gd name="connsiteY6" fmla="*/ 44450 h 1797050"/>
              <a:gd name="connsiteX7" fmla="*/ 720725 w 863600"/>
              <a:gd name="connsiteY7" fmla="*/ 50800 h 1797050"/>
              <a:gd name="connsiteX8" fmla="*/ 711200 w 863600"/>
              <a:gd name="connsiteY8" fmla="*/ 53975 h 1797050"/>
              <a:gd name="connsiteX9" fmla="*/ 692150 w 863600"/>
              <a:gd name="connsiteY9" fmla="*/ 66675 h 1797050"/>
              <a:gd name="connsiteX10" fmla="*/ 682625 w 863600"/>
              <a:gd name="connsiteY10" fmla="*/ 73025 h 1797050"/>
              <a:gd name="connsiteX11" fmla="*/ 673100 w 863600"/>
              <a:gd name="connsiteY11" fmla="*/ 76200 h 1797050"/>
              <a:gd name="connsiteX12" fmla="*/ 663575 w 863600"/>
              <a:gd name="connsiteY12" fmla="*/ 85725 h 1797050"/>
              <a:gd name="connsiteX13" fmla="*/ 644525 w 863600"/>
              <a:gd name="connsiteY13" fmla="*/ 92075 h 1797050"/>
              <a:gd name="connsiteX14" fmla="*/ 635000 w 863600"/>
              <a:gd name="connsiteY14" fmla="*/ 95250 h 1797050"/>
              <a:gd name="connsiteX15" fmla="*/ 615950 w 863600"/>
              <a:gd name="connsiteY15" fmla="*/ 107950 h 1797050"/>
              <a:gd name="connsiteX16" fmla="*/ 587375 w 863600"/>
              <a:gd name="connsiteY16" fmla="*/ 130175 h 1797050"/>
              <a:gd name="connsiteX17" fmla="*/ 577850 w 863600"/>
              <a:gd name="connsiteY17" fmla="*/ 133350 h 1797050"/>
              <a:gd name="connsiteX18" fmla="*/ 571500 w 863600"/>
              <a:gd name="connsiteY18" fmla="*/ 142875 h 1797050"/>
              <a:gd name="connsiteX19" fmla="*/ 561975 w 863600"/>
              <a:gd name="connsiteY19" fmla="*/ 146050 h 1797050"/>
              <a:gd name="connsiteX20" fmla="*/ 542925 w 863600"/>
              <a:gd name="connsiteY20" fmla="*/ 158750 h 1797050"/>
              <a:gd name="connsiteX21" fmla="*/ 533400 w 863600"/>
              <a:gd name="connsiteY21" fmla="*/ 168275 h 1797050"/>
              <a:gd name="connsiteX22" fmla="*/ 523875 w 863600"/>
              <a:gd name="connsiteY22" fmla="*/ 171450 h 1797050"/>
              <a:gd name="connsiteX23" fmla="*/ 504825 w 863600"/>
              <a:gd name="connsiteY23" fmla="*/ 184150 h 1797050"/>
              <a:gd name="connsiteX24" fmla="*/ 476250 w 863600"/>
              <a:gd name="connsiteY24" fmla="*/ 203200 h 1797050"/>
              <a:gd name="connsiteX25" fmla="*/ 466725 w 863600"/>
              <a:gd name="connsiteY25" fmla="*/ 209550 h 1797050"/>
              <a:gd name="connsiteX26" fmla="*/ 447675 w 863600"/>
              <a:gd name="connsiteY26" fmla="*/ 225425 h 1797050"/>
              <a:gd name="connsiteX27" fmla="*/ 428625 w 863600"/>
              <a:gd name="connsiteY27" fmla="*/ 254000 h 1797050"/>
              <a:gd name="connsiteX28" fmla="*/ 422275 w 863600"/>
              <a:gd name="connsiteY28" fmla="*/ 263525 h 1797050"/>
              <a:gd name="connsiteX29" fmla="*/ 419100 w 863600"/>
              <a:gd name="connsiteY29" fmla="*/ 273050 h 1797050"/>
              <a:gd name="connsiteX30" fmla="*/ 400050 w 863600"/>
              <a:gd name="connsiteY30" fmla="*/ 285750 h 1797050"/>
              <a:gd name="connsiteX31" fmla="*/ 396875 w 863600"/>
              <a:gd name="connsiteY31" fmla="*/ 295275 h 1797050"/>
              <a:gd name="connsiteX32" fmla="*/ 377825 w 863600"/>
              <a:gd name="connsiteY32" fmla="*/ 307975 h 1797050"/>
              <a:gd name="connsiteX33" fmla="*/ 361950 w 863600"/>
              <a:gd name="connsiteY33" fmla="*/ 323850 h 1797050"/>
              <a:gd name="connsiteX34" fmla="*/ 355600 w 863600"/>
              <a:gd name="connsiteY34" fmla="*/ 333375 h 1797050"/>
              <a:gd name="connsiteX35" fmla="*/ 346075 w 863600"/>
              <a:gd name="connsiteY35" fmla="*/ 339725 h 1797050"/>
              <a:gd name="connsiteX36" fmla="*/ 336550 w 863600"/>
              <a:gd name="connsiteY36" fmla="*/ 349250 h 1797050"/>
              <a:gd name="connsiteX37" fmla="*/ 317500 w 863600"/>
              <a:gd name="connsiteY37" fmla="*/ 361950 h 1797050"/>
              <a:gd name="connsiteX38" fmla="*/ 295275 w 863600"/>
              <a:gd name="connsiteY38" fmla="*/ 390525 h 1797050"/>
              <a:gd name="connsiteX39" fmla="*/ 288925 w 863600"/>
              <a:gd name="connsiteY39" fmla="*/ 400050 h 1797050"/>
              <a:gd name="connsiteX40" fmla="*/ 279400 w 863600"/>
              <a:gd name="connsiteY40" fmla="*/ 406400 h 1797050"/>
              <a:gd name="connsiteX41" fmla="*/ 263525 w 863600"/>
              <a:gd name="connsiteY41" fmla="*/ 434975 h 1797050"/>
              <a:gd name="connsiteX42" fmla="*/ 254000 w 863600"/>
              <a:gd name="connsiteY42" fmla="*/ 441325 h 1797050"/>
              <a:gd name="connsiteX43" fmla="*/ 247650 w 863600"/>
              <a:gd name="connsiteY43" fmla="*/ 450850 h 1797050"/>
              <a:gd name="connsiteX44" fmla="*/ 238125 w 863600"/>
              <a:gd name="connsiteY44" fmla="*/ 457200 h 1797050"/>
              <a:gd name="connsiteX45" fmla="*/ 234950 w 863600"/>
              <a:gd name="connsiteY45" fmla="*/ 466725 h 1797050"/>
              <a:gd name="connsiteX46" fmla="*/ 228600 w 863600"/>
              <a:gd name="connsiteY46" fmla="*/ 476250 h 1797050"/>
              <a:gd name="connsiteX47" fmla="*/ 225425 w 863600"/>
              <a:gd name="connsiteY47" fmla="*/ 485775 h 1797050"/>
              <a:gd name="connsiteX48" fmla="*/ 219075 w 863600"/>
              <a:gd name="connsiteY48" fmla="*/ 495300 h 1797050"/>
              <a:gd name="connsiteX49" fmla="*/ 215900 w 863600"/>
              <a:gd name="connsiteY49" fmla="*/ 504825 h 1797050"/>
              <a:gd name="connsiteX50" fmla="*/ 206375 w 863600"/>
              <a:gd name="connsiteY50" fmla="*/ 511175 h 1797050"/>
              <a:gd name="connsiteX51" fmla="*/ 196850 w 863600"/>
              <a:gd name="connsiteY51" fmla="*/ 530225 h 1797050"/>
              <a:gd name="connsiteX52" fmla="*/ 187325 w 863600"/>
              <a:gd name="connsiteY52" fmla="*/ 536575 h 1797050"/>
              <a:gd name="connsiteX53" fmla="*/ 180975 w 863600"/>
              <a:gd name="connsiteY53" fmla="*/ 555625 h 1797050"/>
              <a:gd name="connsiteX54" fmla="*/ 174625 w 863600"/>
              <a:gd name="connsiteY54" fmla="*/ 565150 h 1797050"/>
              <a:gd name="connsiteX55" fmla="*/ 168275 w 863600"/>
              <a:gd name="connsiteY55" fmla="*/ 584200 h 1797050"/>
              <a:gd name="connsiteX56" fmla="*/ 161925 w 863600"/>
              <a:gd name="connsiteY56" fmla="*/ 603250 h 1797050"/>
              <a:gd name="connsiteX57" fmla="*/ 158750 w 863600"/>
              <a:gd name="connsiteY57" fmla="*/ 612775 h 1797050"/>
              <a:gd name="connsiteX58" fmla="*/ 139700 w 863600"/>
              <a:gd name="connsiteY58" fmla="*/ 641350 h 1797050"/>
              <a:gd name="connsiteX59" fmla="*/ 133350 w 863600"/>
              <a:gd name="connsiteY59" fmla="*/ 650875 h 1797050"/>
              <a:gd name="connsiteX60" fmla="*/ 127000 w 863600"/>
              <a:gd name="connsiteY60" fmla="*/ 669925 h 1797050"/>
              <a:gd name="connsiteX61" fmla="*/ 117475 w 863600"/>
              <a:gd name="connsiteY61" fmla="*/ 688975 h 1797050"/>
              <a:gd name="connsiteX62" fmla="*/ 111125 w 863600"/>
              <a:gd name="connsiteY62" fmla="*/ 698500 h 1797050"/>
              <a:gd name="connsiteX63" fmla="*/ 104775 w 863600"/>
              <a:gd name="connsiteY63" fmla="*/ 717550 h 1797050"/>
              <a:gd name="connsiteX64" fmla="*/ 92075 w 863600"/>
              <a:gd name="connsiteY64" fmla="*/ 746125 h 1797050"/>
              <a:gd name="connsiteX65" fmla="*/ 85725 w 863600"/>
              <a:gd name="connsiteY65" fmla="*/ 765175 h 1797050"/>
              <a:gd name="connsiteX66" fmla="*/ 82550 w 863600"/>
              <a:gd name="connsiteY66" fmla="*/ 774700 h 1797050"/>
              <a:gd name="connsiteX67" fmla="*/ 79375 w 863600"/>
              <a:gd name="connsiteY67" fmla="*/ 796925 h 1797050"/>
              <a:gd name="connsiteX68" fmla="*/ 73025 w 863600"/>
              <a:gd name="connsiteY68" fmla="*/ 815975 h 1797050"/>
              <a:gd name="connsiteX69" fmla="*/ 69850 w 863600"/>
              <a:gd name="connsiteY69" fmla="*/ 825500 h 1797050"/>
              <a:gd name="connsiteX70" fmla="*/ 66675 w 863600"/>
              <a:gd name="connsiteY70" fmla="*/ 835025 h 1797050"/>
              <a:gd name="connsiteX71" fmla="*/ 63500 w 863600"/>
              <a:gd name="connsiteY71" fmla="*/ 850900 h 1797050"/>
              <a:gd name="connsiteX72" fmla="*/ 60325 w 863600"/>
              <a:gd name="connsiteY72" fmla="*/ 860425 h 1797050"/>
              <a:gd name="connsiteX73" fmla="*/ 53975 w 863600"/>
              <a:gd name="connsiteY73" fmla="*/ 895350 h 1797050"/>
              <a:gd name="connsiteX74" fmla="*/ 50800 w 863600"/>
              <a:gd name="connsiteY74" fmla="*/ 923925 h 1797050"/>
              <a:gd name="connsiteX75" fmla="*/ 47625 w 863600"/>
              <a:gd name="connsiteY75" fmla="*/ 936625 h 1797050"/>
              <a:gd name="connsiteX76" fmla="*/ 38100 w 863600"/>
              <a:gd name="connsiteY76" fmla="*/ 981075 h 1797050"/>
              <a:gd name="connsiteX77" fmla="*/ 28575 w 863600"/>
              <a:gd name="connsiteY77" fmla="*/ 1012825 h 1797050"/>
              <a:gd name="connsiteX78" fmla="*/ 25400 w 863600"/>
              <a:gd name="connsiteY78" fmla="*/ 1079500 h 1797050"/>
              <a:gd name="connsiteX79" fmla="*/ 22225 w 863600"/>
              <a:gd name="connsiteY79" fmla="*/ 1089025 h 1797050"/>
              <a:gd name="connsiteX80" fmla="*/ 15875 w 863600"/>
              <a:gd name="connsiteY80" fmla="*/ 1117600 h 1797050"/>
              <a:gd name="connsiteX81" fmla="*/ 9525 w 863600"/>
              <a:gd name="connsiteY81" fmla="*/ 1139825 h 1797050"/>
              <a:gd name="connsiteX82" fmla="*/ 3175 w 863600"/>
              <a:gd name="connsiteY82" fmla="*/ 1174750 h 1797050"/>
              <a:gd name="connsiteX83" fmla="*/ 0 w 863600"/>
              <a:gd name="connsiteY83" fmla="*/ 1209675 h 1797050"/>
              <a:gd name="connsiteX84" fmla="*/ 3175 w 863600"/>
              <a:gd name="connsiteY84" fmla="*/ 1416050 h 1797050"/>
              <a:gd name="connsiteX85" fmla="*/ 9525 w 863600"/>
              <a:gd name="connsiteY85" fmla="*/ 1450975 h 1797050"/>
              <a:gd name="connsiteX86" fmla="*/ 15875 w 863600"/>
              <a:gd name="connsiteY86" fmla="*/ 1470025 h 1797050"/>
              <a:gd name="connsiteX87" fmla="*/ 19050 w 863600"/>
              <a:gd name="connsiteY87" fmla="*/ 1479550 h 1797050"/>
              <a:gd name="connsiteX88" fmla="*/ 22225 w 863600"/>
              <a:gd name="connsiteY88" fmla="*/ 1492250 h 1797050"/>
              <a:gd name="connsiteX89" fmla="*/ 31750 w 863600"/>
              <a:gd name="connsiteY89" fmla="*/ 1520825 h 1797050"/>
              <a:gd name="connsiteX90" fmla="*/ 34925 w 863600"/>
              <a:gd name="connsiteY90" fmla="*/ 1530350 h 1797050"/>
              <a:gd name="connsiteX91" fmla="*/ 38100 w 863600"/>
              <a:gd name="connsiteY91" fmla="*/ 1543050 h 1797050"/>
              <a:gd name="connsiteX92" fmla="*/ 44450 w 863600"/>
              <a:gd name="connsiteY92" fmla="*/ 1562100 h 1797050"/>
              <a:gd name="connsiteX93" fmla="*/ 50800 w 863600"/>
              <a:gd name="connsiteY93" fmla="*/ 1587500 h 1797050"/>
              <a:gd name="connsiteX94" fmla="*/ 57150 w 863600"/>
              <a:gd name="connsiteY94" fmla="*/ 1606550 h 1797050"/>
              <a:gd name="connsiteX95" fmla="*/ 63500 w 863600"/>
              <a:gd name="connsiteY95" fmla="*/ 1638300 h 1797050"/>
              <a:gd name="connsiteX96" fmla="*/ 66675 w 863600"/>
              <a:gd name="connsiteY96" fmla="*/ 1663700 h 1797050"/>
              <a:gd name="connsiteX97" fmla="*/ 73025 w 863600"/>
              <a:gd name="connsiteY97" fmla="*/ 1682750 h 1797050"/>
              <a:gd name="connsiteX98" fmla="*/ 76200 w 863600"/>
              <a:gd name="connsiteY98" fmla="*/ 1695450 h 1797050"/>
              <a:gd name="connsiteX99" fmla="*/ 79375 w 863600"/>
              <a:gd name="connsiteY99" fmla="*/ 1704975 h 1797050"/>
              <a:gd name="connsiteX100" fmla="*/ 85725 w 863600"/>
              <a:gd name="connsiteY100" fmla="*/ 1730375 h 1797050"/>
              <a:gd name="connsiteX101" fmla="*/ 88900 w 863600"/>
              <a:gd name="connsiteY101" fmla="*/ 1743075 h 1797050"/>
              <a:gd name="connsiteX102" fmla="*/ 92075 w 863600"/>
              <a:gd name="connsiteY102" fmla="*/ 1752600 h 1797050"/>
              <a:gd name="connsiteX103" fmla="*/ 98425 w 863600"/>
              <a:gd name="connsiteY103" fmla="*/ 1774825 h 1797050"/>
              <a:gd name="connsiteX104" fmla="*/ 111125 w 863600"/>
              <a:gd name="connsiteY104" fmla="*/ 1797050 h 179705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  <a:cxn ang="0">
                <a:pos x="connsiteX31" y="connsiteY31"/>
              </a:cxn>
              <a:cxn ang="0">
                <a:pos x="connsiteX32" y="connsiteY32"/>
              </a:cxn>
              <a:cxn ang="0">
                <a:pos x="connsiteX33" y="connsiteY33"/>
              </a:cxn>
              <a:cxn ang="0">
                <a:pos x="connsiteX34" y="connsiteY34"/>
              </a:cxn>
              <a:cxn ang="0">
                <a:pos x="connsiteX35" y="connsiteY35"/>
              </a:cxn>
              <a:cxn ang="0">
                <a:pos x="connsiteX36" y="connsiteY36"/>
              </a:cxn>
              <a:cxn ang="0">
                <a:pos x="connsiteX37" y="connsiteY37"/>
              </a:cxn>
              <a:cxn ang="0">
                <a:pos x="connsiteX38" y="connsiteY38"/>
              </a:cxn>
              <a:cxn ang="0">
                <a:pos x="connsiteX39" y="connsiteY39"/>
              </a:cxn>
              <a:cxn ang="0">
                <a:pos x="connsiteX40" y="connsiteY40"/>
              </a:cxn>
              <a:cxn ang="0">
                <a:pos x="connsiteX41" y="connsiteY41"/>
              </a:cxn>
              <a:cxn ang="0">
                <a:pos x="connsiteX42" y="connsiteY42"/>
              </a:cxn>
              <a:cxn ang="0">
                <a:pos x="connsiteX43" y="connsiteY43"/>
              </a:cxn>
              <a:cxn ang="0">
                <a:pos x="connsiteX44" y="connsiteY44"/>
              </a:cxn>
              <a:cxn ang="0">
                <a:pos x="connsiteX45" y="connsiteY45"/>
              </a:cxn>
              <a:cxn ang="0">
                <a:pos x="connsiteX46" y="connsiteY46"/>
              </a:cxn>
              <a:cxn ang="0">
                <a:pos x="connsiteX47" y="connsiteY47"/>
              </a:cxn>
              <a:cxn ang="0">
                <a:pos x="connsiteX48" y="connsiteY48"/>
              </a:cxn>
              <a:cxn ang="0">
                <a:pos x="connsiteX49" y="connsiteY49"/>
              </a:cxn>
              <a:cxn ang="0">
                <a:pos x="connsiteX50" y="connsiteY50"/>
              </a:cxn>
              <a:cxn ang="0">
                <a:pos x="connsiteX51" y="connsiteY51"/>
              </a:cxn>
              <a:cxn ang="0">
                <a:pos x="connsiteX52" y="connsiteY52"/>
              </a:cxn>
              <a:cxn ang="0">
                <a:pos x="connsiteX53" y="connsiteY53"/>
              </a:cxn>
              <a:cxn ang="0">
                <a:pos x="connsiteX54" y="connsiteY54"/>
              </a:cxn>
              <a:cxn ang="0">
                <a:pos x="connsiteX55" y="connsiteY55"/>
              </a:cxn>
              <a:cxn ang="0">
                <a:pos x="connsiteX56" y="connsiteY56"/>
              </a:cxn>
              <a:cxn ang="0">
                <a:pos x="connsiteX57" y="connsiteY57"/>
              </a:cxn>
              <a:cxn ang="0">
                <a:pos x="connsiteX58" y="connsiteY58"/>
              </a:cxn>
              <a:cxn ang="0">
                <a:pos x="connsiteX59" y="connsiteY59"/>
              </a:cxn>
              <a:cxn ang="0">
                <a:pos x="connsiteX60" y="connsiteY60"/>
              </a:cxn>
              <a:cxn ang="0">
                <a:pos x="connsiteX61" y="connsiteY61"/>
              </a:cxn>
              <a:cxn ang="0">
                <a:pos x="connsiteX62" y="connsiteY62"/>
              </a:cxn>
              <a:cxn ang="0">
                <a:pos x="connsiteX63" y="connsiteY63"/>
              </a:cxn>
              <a:cxn ang="0">
                <a:pos x="connsiteX64" y="connsiteY64"/>
              </a:cxn>
              <a:cxn ang="0">
                <a:pos x="connsiteX65" y="connsiteY65"/>
              </a:cxn>
              <a:cxn ang="0">
                <a:pos x="connsiteX66" y="connsiteY66"/>
              </a:cxn>
              <a:cxn ang="0">
                <a:pos x="connsiteX67" y="connsiteY67"/>
              </a:cxn>
              <a:cxn ang="0">
                <a:pos x="connsiteX68" y="connsiteY68"/>
              </a:cxn>
              <a:cxn ang="0">
                <a:pos x="connsiteX69" y="connsiteY69"/>
              </a:cxn>
              <a:cxn ang="0">
                <a:pos x="connsiteX70" y="connsiteY70"/>
              </a:cxn>
              <a:cxn ang="0">
                <a:pos x="connsiteX71" y="connsiteY71"/>
              </a:cxn>
              <a:cxn ang="0">
                <a:pos x="connsiteX72" y="connsiteY72"/>
              </a:cxn>
              <a:cxn ang="0">
                <a:pos x="connsiteX73" y="connsiteY73"/>
              </a:cxn>
              <a:cxn ang="0">
                <a:pos x="connsiteX74" y="connsiteY74"/>
              </a:cxn>
              <a:cxn ang="0">
                <a:pos x="connsiteX75" y="connsiteY75"/>
              </a:cxn>
              <a:cxn ang="0">
                <a:pos x="connsiteX76" y="connsiteY76"/>
              </a:cxn>
              <a:cxn ang="0">
                <a:pos x="connsiteX77" y="connsiteY77"/>
              </a:cxn>
              <a:cxn ang="0">
                <a:pos x="connsiteX78" y="connsiteY78"/>
              </a:cxn>
              <a:cxn ang="0">
                <a:pos x="connsiteX79" y="connsiteY79"/>
              </a:cxn>
              <a:cxn ang="0">
                <a:pos x="connsiteX80" y="connsiteY80"/>
              </a:cxn>
              <a:cxn ang="0">
                <a:pos x="connsiteX81" y="connsiteY81"/>
              </a:cxn>
              <a:cxn ang="0">
                <a:pos x="connsiteX82" y="connsiteY82"/>
              </a:cxn>
              <a:cxn ang="0">
                <a:pos x="connsiteX83" y="connsiteY83"/>
              </a:cxn>
              <a:cxn ang="0">
                <a:pos x="connsiteX84" y="connsiteY84"/>
              </a:cxn>
              <a:cxn ang="0">
                <a:pos x="connsiteX85" y="connsiteY85"/>
              </a:cxn>
              <a:cxn ang="0">
                <a:pos x="connsiteX86" y="connsiteY86"/>
              </a:cxn>
              <a:cxn ang="0">
                <a:pos x="connsiteX87" y="connsiteY87"/>
              </a:cxn>
              <a:cxn ang="0">
                <a:pos x="connsiteX88" y="connsiteY88"/>
              </a:cxn>
              <a:cxn ang="0">
                <a:pos x="connsiteX89" y="connsiteY89"/>
              </a:cxn>
              <a:cxn ang="0">
                <a:pos x="connsiteX90" y="connsiteY90"/>
              </a:cxn>
              <a:cxn ang="0">
                <a:pos x="connsiteX91" y="connsiteY91"/>
              </a:cxn>
              <a:cxn ang="0">
                <a:pos x="connsiteX92" y="connsiteY92"/>
              </a:cxn>
              <a:cxn ang="0">
                <a:pos x="connsiteX93" y="connsiteY93"/>
              </a:cxn>
              <a:cxn ang="0">
                <a:pos x="connsiteX94" y="connsiteY94"/>
              </a:cxn>
              <a:cxn ang="0">
                <a:pos x="connsiteX95" y="connsiteY95"/>
              </a:cxn>
              <a:cxn ang="0">
                <a:pos x="connsiteX96" y="connsiteY96"/>
              </a:cxn>
              <a:cxn ang="0">
                <a:pos x="connsiteX97" y="connsiteY97"/>
              </a:cxn>
              <a:cxn ang="0">
                <a:pos x="connsiteX98" y="connsiteY98"/>
              </a:cxn>
              <a:cxn ang="0">
                <a:pos x="connsiteX99" y="connsiteY99"/>
              </a:cxn>
              <a:cxn ang="0">
                <a:pos x="connsiteX100" y="connsiteY100"/>
              </a:cxn>
              <a:cxn ang="0">
                <a:pos x="connsiteX101" y="connsiteY101"/>
              </a:cxn>
              <a:cxn ang="0">
                <a:pos x="connsiteX102" y="connsiteY102"/>
              </a:cxn>
              <a:cxn ang="0">
                <a:pos x="connsiteX103" y="connsiteY103"/>
              </a:cxn>
              <a:cxn ang="0">
                <a:pos x="connsiteX104" y="connsiteY104"/>
              </a:cxn>
            </a:cxnLst>
            <a:rect l="l" t="t" r="r" b="b"/>
            <a:pathLst>
              <a:path w="863600" h="1797050">
                <a:moveTo>
                  <a:pt x="863600" y="0"/>
                </a:moveTo>
                <a:cubicBezTo>
                  <a:pt x="836136" y="2497"/>
                  <a:pt x="835608" y="741"/>
                  <a:pt x="815975" y="6350"/>
                </a:cubicBezTo>
                <a:cubicBezTo>
                  <a:pt x="812757" y="7269"/>
                  <a:pt x="809376" y="7900"/>
                  <a:pt x="806450" y="9525"/>
                </a:cubicBezTo>
                <a:cubicBezTo>
                  <a:pt x="799779" y="13231"/>
                  <a:pt x="794640" y="19812"/>
                  <a:pt x="787400" y="22225"/>
                </a:cubicBezTo>
                <a:cubicBezTo>
                  <a:pt x="738253" y="38607"/>
                  <a:pt x="789014" y="19831"/>
                  <a:pt x="758825" y="34925"/>
                </a:cubicBezTo>
                <a:cubicBezTo>
                  <a:pt x="755832" y="36422"/>
                  <a:pt x="752293" y="36603"/>
                  <a:pt x="749300" y="38100"/>
                </a:cubicBezTo>
                <a:cubicBezTo>
                  <a:pt x="745887" y="39807"/>
                  <a:pt x="743262" y="42900"/>
                  <a:pt x="739775" y="44450"/>
                </a:cubicBezTo>
                <a:cubicBezTo>
                  <a:pt x="733658" y="47168"/>
                  <a:pt x="727075" y="48683"/>
                  <a:pt x="720725" y="50800"/>
                </a:cubicBezTo>
                <a:cubicBezTo>
                  <a:pt x="717550" y="51858"/>
                  <a:pt x="713985" y="52119"/>
                  <a:pt x="711200" y="53975"/>
                </a:cubicBezTo>
                <a:lnTo>
                  <a:pt x="692150" y="66675"/>
                </a:lnTo>
                <a:cubicBezTo>
                  <a:pt x="688975" y="68792"/>
                  <a:pt x="686245" y="71818"/>
                  <a:pt x="682625" y="73025"/>
                </a:cubicBezTo>
                <a:lnTo>
                  <a:pt x="673100" y="76200"/>
                </a:lnTo>
                <a:cubicBezTo>
                  <a:pt x="669925" y="79375"/>
                  <a:pt x="667500" y="83544"/>
                  <a:pt x="663575" y="85725"/>
                </a:cubicBezTo>
                <a:cubicBezTo>
                  <a:pt x="657724" y="88976"/>
                  <a:pt x="650875" y="89958"/>
                  <a:pt x="644525" y="92075"/>
                </a:cubicBezTo>
                <a:cubicBezTo>
                  <a:pt x="641350" y="93133"/>
                  <a:pt x="637785" y="93394"/>
                  <a:pt x="635000" y="95250"/>
                </a:cubicBezTo>
                <a:cubicBezTo>
                  <a:pt x="628650" y="99483"/>
                  <a:pt x="621346" y="102554"/>
                  <a:pt x="615950" y="107950"/>
                </a:cubicBezTo>
                <a:cubicBezTo>
                  <a:pt x="607732" y="116168"/>
                  <a:pt x="598768" y="126377"/>
                  <a:pt x="587375" y="130175"/>
                </a:cubicBezTo>
                <a:lnTo>
                  <a:pt x="577850" y="133350"/>
                </a:lnTo>
                <a:cubicBezTo>
                  <a:pt x="575733" y="136525"/>
                  <a:pt x="574480" y="140491"/>
                  <a:pt x="571500" y="142875"/>
                </a:cubicBezTo>
                <a:cubicBezTo>
                  <a:pt x="568887" y="144966"/>
                  <a:pt x="564901" y="144425"/>
                  <a:pt x="561975" y="146050"/>
                </a:cubicBezTo>
                <a:cubicBezTo>
                  <a:pt x="555304" y="149756"/>
                  <a:pt x="548321" y="153354"/>
                  <a:pt x="542925" y="158750"/>
                </a:cubicBezTo>
                <a:cubicBezTo>
                  <a:pt x="539750" y="161925"/>
                  <a:pt x="537136" y="165784"/>
                  <a:pt x="533400" y="168275"/>
                </a:cubicBezTo>
                <a:cubicBezTo>
                  <a:pt x="530615" y="170131"/>
                  <a:pt x="526801" y="169825"/>
                  <a:pt x="523875" y="171450"/>
                </a:cubicBezTo>
                <a:cubicBezTo>
                  <a:pt x="517204" y="175156"/>
                  <a:pt x="511175" y="179917"/>
                  <a:pt x="504825" y="184150"/>
                </a:cubicBezTo>
                <a:lnTo>
                  <a:pt x="476250" y="203200"/>
                </a:lnTo>
                <a:cubicBezTo>
                  <a:pt x="473075" y="205317"/>
                  <a:pt x="469423" y="206852"/>
                  <a:pt x="466725" y="209550"/>
                </a:cubicBezTo>
                <a:cubicBezTo>
                  <a:pt x="454502" y="221773"/>
                  <a:pt x="460936" y="216584"/>
                  <a:pt x="447675" y="225425"/>
                </a:cubicBezTo>
                <a:lnTo>
                  <a:pt x="428625" y="254000"/>
                </a:lnTo>
                <a:cubicBezTo>
                  <a:pt x="426508" y="257175"/>
                  <a:pt x="423482" y="259905"/>
                  <a:pt x="422275" y="263525"/>
                </a:cubicBezTo>
                <a:cubicBezTo>
                  <a:pt x="421217" y="266700"/>
                  <a:pt x="421467" y="270683"/>
                  <a:pt x="419100" y="273050"/>
                </a:cubicBezTo>
                <a:cubicBezTo>
                  <a:pt x="413704" y="278446"/>
                  <a:pt x="400050" y="285750"/>
                  <a:pt x="400050" y="285750"/>
                </a:cubicBezTo>
                <a:cubicBezTo>
                  <a:pt x="398992" y="288925"/>
                  <a:pt x="399242" y="292908"/>
                  <a:pt x="396875" y="295275"/>
                </a:cubicBezTo>
                <a:cubicBezTo>
                  <a:pt x="391479" y="300671"/>
                  <a:pt x="377825" y="307975"/>
                  <a:pt x="377825" y="307975"/>
                </a:cubicBezTo>
                <a:cubicBezTo>
                  <a:pt x="360892" y="333375"/>
                  <a:pt x="383117" y="302683"/>
                  <a:pt x="361950" y="323850"/>
                </a:cubicBezTo>
                <a:cubicBezTo>
                  <a:pt x="359252" y="326548"/>
                  <a:pt x="358298" y="330677"/>
                  <a:pt x="355600" y="333375"/>
                </a:cubicBezTo>
                <a:cubicBezTo>
                  <a:pt x="352902" y="336073"/>
                  <a:pt x="349006" y="337282"/>
                  <a:pt x="346075" y="339725"/>
                </a:cubicBezTo>
                <a:cubicBezTo>
                  <a:pt x="342626" y="342600"/>
                  <a:pt x="340094" y="346493"/>
                  <a:pt x="336550" y="349250"/>
                </a:cubicBezTo>
                <a:cubicBezTo>
                  <a:pt x="330526" y="353935"/>
                  <a:pt x="322896" y="356554"/>
                  <a:pt x="317500" y="361950"/>
                </a:cubicBezTo>
                <a:cubicBezTo>
                  <a:pt x="302579" y="376871"/>
                  <a:pt x="310466" y="367739"/>
                  <a:pt x="295275" y="390525"/>
                </a:cubicBezTo>
                <a:cubicBezTo>
                  <a:pt x="293158" y="393700"/>
                  <a:pt x="292100" y="397933"/>
                  <a:pt x="288925" y="400050"/>
                </a:cubicBezTo>
                <a:lnTo>
                  <a:pt x="279400" y="406400"/>
                </a:lnTo>
                <a:cubicBezTo>
                  <a:pt x="276091" y="416326"/>
                  <a:pt x="272883" y="428737"/>
                  <a:pt x="263525" y="434975"/>
                </a:cubicBezTo>
                <a:lnTo>
                  <a:pt x="254000" y="441325"/>
                </a:lnTo>
                <a:cubicBezTo>
                  <a:pt x="251883" y="444500"/>
                  <a:pt x="250348" y="448152"/>
                  <a:pt x="247650" y="450850"/>
                </a:cubicBezTo>
                <a:cubicBezTo>
                  <a:pt x="244952" y="453548"/>
                  <a:pt x="240509" y="454220"/>
                  <a:pt x="238125" y="457200"/>
                </a:cubicBezTo>
                <a:cubicBezTo>
                  <a:pt x="236034" y="459813"/>
                  <a:pt x="236447" y="463732"/>
                  <a:pt x="234950" y="466725"/>
                </a:cubicBezTo>
                <a:cubicBezTo>
                  <a:pt x="233243" y="470138"/>
                  <a:pt x="230307" y="472837"/>
                  <a:pt x="228600" y="476250"/>
                </a:cubicBezTo>
                <a:cubicBezTo>
                  <a:pt x="227103" y="479243"/>
                  <a:pt x="226922" y="482782"/>
                  <a:pt x="225425" y="485775"/>
                </a:cubicBezTo>
                <a:cubicBezTo>
                  <a:pt x="223718" y="489188"/>
                  <a:pt x="220782" y="491887"/>
                  <a:pt x="219075" y="495300"/>
                </a:cubicBezTo>
                <a:cubicBezTo>
                  <a:pt x="217578" y="498293"/>
                  <a:pt x="217991" y="502212"/>
                  <a:pt x="215900" y="504825"/>
                </a:cubicBezTo>
                <a:cubicBezTo>
                  <a:pt x="213516" y="507805"/>
                  <a:pt x="209550" y="509058"/>
                  <a:pt x="206375" y="511175"/>
                </a:cubicBezTo>
                <a:cubicBezTo>
                  <a:pt x="203793" y="518922"/>
                  <a:pt x="203005" y="524070"/>
                  <a:pt x="196850" y="530225"/>
                </a:cubicBezTo>
                <a:cubicBezTo>
                  <a:pt x="194152" y="532923"/>
                  <a:pt x="190500" y="534458"/>
                  <a:pt x="187325" y="536575"/>
                </a:cubicBezTo>
                <a:cubicBezTo>
                  <a:pt x="185208" y="542925"/>
                  <a:pt x="184688" y="550056"/>
                  <a:pt x="180975" y="555625"/>
                </a:cubicBezTo>
                <a:cubicBezTo>
                  <a:pt x="178858" y="558800"/>
                  <a:pt x="176175" y="561663"/>
                  <a:pt x="174625" y="565150"/>
                </a:cubicBezTo>
                <a:cubicBezTo>
                  <a:pt x="171907" y="571267"/>
                  <a:pt x="170392" y="577850"/>
                  <a:pt x="168275" y="584200"/>
                </a:cubicBezTo>
                <a:lnTo>
                  <a:pt x="161925" y="603250"/>
                </a:lnTo>
                <a:cubicBezTo>
                  <a:pt x="160867" y="606425"/>
                  <a:pt x="160606" y="609990"/>
                  <a:pt x="158750" y="612775"/>
                </a:cubicBezTo>
                <a:lnTo>
                  <a:pt x="139700" y="641350"/>
                </a:lnTo>
                <a:cubicBezTo>
                  <a:pt x="137583" y="644525"/>
                  <a:pt x="134557" y="647255"/>
                  <a:pt x="133350" y="650875"/>
                </a:cubicBezTo>
                <a:cubicBezTo>
                  <a:pt x="131233" y="657225"/>
                  <a:pt x="130713" y="664356"/>
                  <a:pt x="127000" y="669925"/>
                </a:cubicBezTo>
                <a:cubicBezTo>
                  <a:pt x="108802" y="697222"/>
                  <a:pt x="130620" y="662685"/>
                  <a:pt x="117475" y="688975"/>
                </a:cubicBezTo>
                <a:cubicBezTo>
                  <a:pt x="115768" y="692388"/>
                  <a:pt x="112675" y="695013"/>
                  <a:pt x="111125" y="698500"/>
                </a:cubicBezTo>
                <a:cubicBezTo>
                  <a:pt x="108407" y="704617"/>
                  <a:pt x="108488" y="711981"/>
                  <a:pt x="104775" y="717550"/>
                </a:cubicBezTo>
                <a:cubicBezTo>
                  <a:pt x="94712" y="732644"/>
                  <a:pt x="99632" y="723455"/>
                  <a:pt x="92075" y="746125"/>
                </a:cubicBezTo>
                <a:lnTo>
                  <a:pt x="85725" y="765175"/>
                </a:lnTo>
                <a:lnTo>
                  <a:pt x="82550" y="774700"/>
                </a:lnTo>
                <a:cubicBezTo>
                  <a:pt x="81492" y="782108"/>
                  <a:pt x="81058" y="789633"/>
                  <a:pt x="79375" y="796925"/>
                </a:cubicBezTo>
                <a:cubicBezTo>
                  <a:pt x="77870" y="803447"/>
                  <a:pt x="75142" y="809625"/>
                  <a:pt x="73025" y="815975"/>
                </a:cubicBezTo>
                <a:lnTo>
                  <a:pt x="69850" y="825500"/>
                </a:lnTo>
                <a:cubicBezTo>
                  <a:pt x="68792" y="828675"/>
                  <a:pt x="67331" y="831743"/>
                  <a:pt x="66675" y="835025"/>
                </a:cubicBezTo>
                <a:cubicBezTo>
                  <a:pt x="65617" y="840317"/>
                  <a:pt x="64809" y="845665"/>
                  <a:pt x="63500" y="850900"/>
                </a:cubicBezTo>
                <a:cubicBezTo>
                  <a:pt x="62688" y="854147"/>
                  <a:pt x="61137" y="857178"/>
                  <a:pt x="60325" y="860425"/>
                </a:cubicBezTo>
                <a:cubicBezTo>
                  <a:pt x="58615" y="867266"/>
                  <a:pt x="54784" y="889284"/>
                  <a:pt x="53975" y="895350"/>
                </a:cubicBezTo>
                <a:cubicBezTo>
                  <a:pt x="52708" y="904850"/>
                  <a:pt x="52257" y="914453"/>
                  <a:pt x="50800" y="923925"/>
                </a:cubicBezTo>
                <a:cubicBezTo>
                  <a:pt x="50136" y="928238"/>
                  <a:pt x="48481" y="932346"/>
                  <a:pt x="47625" y="936625"/>
                </a:cubicBezTo>
                <a:cubicBezTo>
                  <a:pt x="43628" y="956609"/>
                  <a:pt x="45180" y="959834"/>
                  <a:pt x="38100" y="981075"/>
                </a:cubicBezTo>
                <a:cubicBezTo>
                  <a:pt x="30370" y="1004265"/>
                  <a:pt x="33373" y="993631"/>
                  <a:pt x="28575" y="1012825"/>
                </a:cubicBezTo>
                <a:cubicBezTo>
                  <a:pt x="27517" y="1035050"/>
                  <a:pt x="27248" y="1057327"/>
                  <a:pt x="25400" y="1079500"/>
                </a:cubicBezTo>
                <a:cubicBezTo>
                  <a:pt x="25122" y="1082835"/>
                  <a:pt x="23037" y="1085778"/>
                  <a:pt x="22225" y="1089025"/>
                </a:cubicBezTo>
                <a:cubicBezTo>
                  <a:pt x="15678" y="1115214"/>
                  <a:pt x="22394" y="1094785"/>
                  <a:pt x="15875" y="1117600"/>
                </a:cubicBezTo>
                <a:cubicBezTo>
                  <a:pt x="10571" y="1136162"/>
                  <a:pt x="14488" y="1117492"/>
                  <a:pt x="9525" y="1139825"/>
                </a:cubicBezTo>
                <a:cubicBezTo>
                  <a:pt x="7770" y="1147721"/>
                  <a:pt x="4037" y="1167426"/>
                  <a:pt x="3175" y="1174750"/>
                </a:cubicBezTo>
                <a:cubicBezTo>
                  <a:pt x="1809" y="1186360"/>
                  <a:pt x="1058" y="1198033"/>
                  <a:pt x="0" y="1209675"/>
                </a:cubicBezTo>
                <a:cubicBezTo>
                  <a:pt x="1058" y="1278467"/>
                  <a:pt x="1265" y="1347277"/>
                  <a:pt x="3175" y="1416050"/>
                </a:cubicBezTo>
                <a:cubicBezTo>
                  <a:pt x="3426" y="1425086"/>
                  <a:pt x="6600" y="1441224"/>
                  <a:pt x="9525" y="1450975"/>
                </a:cubicBezTo>
                <a:cubicBezTo>
                  <a:pt x="11448" y="1457386"/>
                  <a:pt x="13758" y="1463675"/>
                  <a:pt x="15875" y="1470025"/>
                </a:cubicBezTo>
                <a:cubicBezTo>
                  <a:pt x="16933" y="1473200"/>
                  <a:pt x="18238" y="1476303"/>
                  <a:pt x="19050" y="1479550"/>
                </a:cubicBezTo>
                <a:cubicBezTo>
                  <a:pt x="20108" y="1483783"/>
                  <a:pt x="20971" y="1488070"/>
                  <a:pt x="22225" y="1492250"/>
                </a:cubicBezTo>
                <a:cubicBezTo>
                  <a:pt x="25110" y="1501867"/>
                  <a:pt x="28575" y="1511300"/>
                  <a:pt x="31750" y="1520825"/>
                </a:cubicBezTo>
                <a:cubicBezTo>
                  <a:pt x="32808" y="1524000"/>
                  <a:pt x="34113" y="1527103"/>
                  <a:pt x="34925" y="1530350"/>
                </a:cubicBezTo>
                <a:cubicBezTo>
                  <a:pt x="35983" y="1534583"/>
                  <a:pt x="36846" y="1538870"/>
                  <a:pt x="38100" y="1543050"/>
                </a:cubicBezTo>
                <a:cubicBezTo>
                  <a:pt x="40023" y="1549461"/>
                  <a:pt x="42827" y="1555606"/>
                  <a:pt x="44450" y="1562100"/>
                </a:cubicBezTo>
                <a:cubicBezTo>
                  <a:pt x="46567" y="1570567"/>
                  <a:pt x="48040" y="1579221"/>
                  <a:pt x="50800" y="1587500"/>
                </a:cubicBezTo>
                <a:cubicBezTo>
                  <a:pt x="52917" y="1593850"/>
                  <a:pt x="55837" y="1599986"/>
                  <a:pt x="57150" y="1606550"/>
                </a:cubicBezTo>
                <a:cubicBezTo>
                  <a:pt x="59267" y="1617133"/>
                  <a:pt x="62161" y="1627590"/>
                  <a:pt x="63500" y="1638300"/>
                </a:cubicBezTo>
                <a:cubicBezTo>
                  <a:pt x="64558" y="1646767"/>
                  <a:pt x="64887" y="1655357"/>
                  <a:pt x="66675" y="1663700"/>
                </a:cubicBezTo>
                <a:cubicBezTo>
                  <a:pt x="68077" y="1670245"/>
                  <a:pt x="71402" y="1676256"/>
                  <a:pt x="73025" y="1682750"/>
                </a:cubicBezTo>
                <a:cubicBezTo>
                  <a:pt x="74083" y="1686983"/>
                  <a:pt x="75001" y="1691254"/>
                  <a:pt x="76200" y="1695450"/>
                </a:cubicBezTo>
                <a:cubicBezTo>
                  <a:pt x="77119" y="1698668"/>
                  <a:pt x="78494" y="1701746"/>
                  <a:pt x="79375" y="1704975"/>
                </a:cubicBezTo>
                <a:cubicBezTo>
                  <a:pt x="81671" y="1713395"/>
                  <a:pt x="83608" y="1721908"/>
                  <a:pt x="85725" y="1730375"/>
                </a:cubicBezTo>
                <a:cubicBezTo>
                  <a:pt x="86783" y="1734608"/>
                  <a:pt x="87520" y="1738935"/>
                  <a:pt x="88900" y="1743075"/>
                </a:cubicBezTo>
                <a:cubicBezTo>
                  <a:pt x="89958" y="1746250"/>
                  <a:pt x="91156" y="1749382"/>
                  <a:pt x="92075" y="1752600"/>
                </a:cubicBezTo>
                <a:cubicBezTo>
                  <a:pt x="93042" y="1755985"/>
                  <a:pt x="96186" y="1770795"/>
                  <a:pt x="98425" y="1774825"/>
                </a:cubicBezTo>
                <a:cubicBezTo>
                  <a:pt x="111712" y="1798742"/>
                  <a:pt x="111125" y="1785690"/>
                  <a:pt x="111125" y="1797050"/>
                </a:cubicBezTo>
              </a:path>
            </a:pathLst>
          </a:custGeom>
          <a:noFill/>
          <a:ln w="38100">
            <a:solidFill>
              <a:schemeClr val="bg1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9666"/>
          </a:p>
        </p:txBody>
      </p:sp>
      <p:sp>
        <p:nvSpPr>
          <p:cNvPr id="23" name="Freeform 22"/>
          <p:cNvSpPr/>
          <p:nvPr/>
        </p:nvSpPr>
        <p:spPr>
          <a:xfrm>
            <a:off x="10831570" y="5105868"/>
            <a:ext cx="5688986" cy="2212014"/>
          </a:xfrm>
          <a:custGeom>
            <a:avLst/>
            <a:gdLst>
              <a:gd name="connsiteX0" fmla="*/ 0 w 2901950"/>
              <a:gd name="connsiteY0" fmla="*/ 543038 h 1047863"/>
              <a:gd name="connsiteX1" fmla="*/ 12700 w 2901950"/>
              <a:gd name="connsiteY1" fmla="*/ 568438 h 1047863"/>
              <a:gd name="connsiteX2" fmla="*/ 41275 w 2901950"/>
              <a:gd name="connsiteY2" fmla="*/ 584313 h 1047863"/>
              <a:gd name="connsiteX3" fmla="*/ 57150 w 2901950"/>
              <a:gd name="connsiteY3" fmla="*/ 603363 h 1047863"/>
              <a:gd name="connsiteX4" fmla="*/ 76200 w 2901950"/>
              <a:gd name="connsiteY4" fmla="*/ 616063 h 1047863"/>
              <a:gd name="connsiteX5" fmla="*/ 92075 w 2901950"/>
              <a:gd name="connsiteY5" fmla="*/ 631938 h 1047863"/>
              <a:gd name="connsiteX6" fmla="*/ 107950 w 2901950"/>
              <a:gd name="connsiteY6" fmla="*/ 647813 h 1047863"/>
              <a:gd name="connsiteX7" fmla="*/ 123825 w 2901950"/>
              <a:gd name="connsiteY7" fmla="*/ 660513 h 1047863"/>
              <a:gd name="connsiteX8" fmla="*/ 142875 w 2901950"/>
              <a:gd name="connsiteY8" fmla="*/ 673213 h 1047863"/>
              <a:gd name="connsiteX9" fmla="*/ 158750 w 2901950"/>
              <a:gd name="connsiteY9" fmla="*/ 685913 h 1047863"/>
              <a:gd name="connsiteX10" fmla="*/ 177800 w 2901950"/>
              <a:gd name="connsiteY10" fmla="*/ 698613 h 1047863"/>
              <a:gd name="connsiteX11" fmla="*/ 187325 w 2901950"/>
              <a:gd name="connsiteY11" fmla="*/ 701788 h 1047863"/>
              <a:gd name="connsiteX12" fmla="*/ 200025 w 2901950"/>
              <a:gd name="connsiteY12" fmla="*/ 708138 h 1047863"/>
              <a:gd name="connsiteX13" fmla="*/ 209550 w 2901950"/>
              <a:gd name="connsiteY13" fmla="*/ 714488 h 1047863"/>
              <a:gd name="connsiteX14" fmla="*/ 228600 w 2901950"/>
              <a:gd name="connsiteY14" fmla="*/ 720838 h 1047863"/>
              <a:gd name="connsiteX15" fmla="*/ 238125 w 2901950"/>
              <a:gd name="connsiteY15" fmla="*/ 727188 h 1047863"/>
              <a:gd name="connsiteX16" fmla="*/ 247650 w 2901950"/>
              <a:gd name="connsiteY16" fmla="*/ 730363 h 1047863"/>
              <a:gd name="connsiteX17" fmla="*/ 266700 w 2901950"/>
              <a:gd name="connsiteY17" fmla="*/ 743063 h 1047863"/>
              <a:gd name="connsiteX18" fmla="*/ 276225 w 2901950"/>
              <a:gd name="connsiteY18" fmla="*/ 746238 h 1047863"/>
              <a:gd name="connsiteX19" fmla="*/ 295275 w 2901950"/>
              <a:gd name="connsiteY19" fmla="*/ 758938 h 1047863"/>
              <a:gd name="connsiteX20" fmla="*/ 323850 w 2901950"/>
              <a:gd name="connsiteY20" fmla="*/ 774813 h 1047863"/>
              <a:gd name="connsiteX21" fmla="*/ 333375 w 2901950"/>
              <a:gd name="connsiteY21" fmla="*/ 781163 h 1047863"/>
              <a:gd name="connsiteX22" fmla="*/ 342900 w 2901950"/>
              <a:gd name="connsiteY22" fmla="*/ 787513 h 1047863"/>
              <a:gd name="connsiteX23" fmla="*/ 361950 w 2901950"/>
              <a:gd name="connsiteY23" fmla="*/ 793863 h 1047863"/>
              <a:gd name="connsiteX24" fmla="*/ 371475 w 2901950"/>
              <a:gd name="connsiteY24" fmla="*/ 800213 h 1047863"/>
              <a:gd name="connsiteX25" fmla="*/ 390525 w 2901950"/>
              <a:gd name="connsiteY25" fmla="*/ 806563 h 1047863"/>
              <a:gd name="connsiteX26" fmla="*/ 400050 w 2901950"/>
              <a:gd name="connsiteY26" fmla="*/ 812913 h 1047863"/>
              <a:gd name="connsiteX27" fmla="*/ 419100 w 2901950"/>
              <a:gd name="connsiteY27" fmla="*/ 819263 h 1047863"/>
              <a:gd name="connsiteX28" fmla="*/ 428625 w 2901950"/>
              <a:gd name="connsiteY28" fmla="*/ 822438 h 1047863"/>
              <a:gd name="connsiteX29" fmla="*/ 466725 w 2901950"/>
              <a:gd name="connsiteY29" fmla="*/ 835138 h 1047863"/>
              <a:gd name="connsiteX30" fmla="*/ 476250 w 2901950"/>
              <a:gd name="connsiteY30" fmla="*/ 838313 h 1047863"/>
              <a:gd name="connsiteX31" fmla="*/ 485775 w 2901950"/>
              <a:gd name="connsiteY31" fmla="*/ 841488 h 1047863"/>
              <a:gd name="connsiteX32" fmla="*/ 514350 w 2901950"/>
              <a:gd name="connsiteY32" fmla="*/ 847838 h 1047863"/>
              <a:gd name="connsiteX33" fmla="*/ 523875 w 2901950"/>
              <a:gd name="connsiteY33" fmla="*/ 851013 h 1047863"/>
              <a:gd name="connsiteX34" fmla="*/ 536575 w 2901950"/>
              <a:gd name="connsiteY34" fmla="*/ 854188 h 1047863"/>
              <a:gd name="connsiteX35" fmla="*/ 555625 w 2901950"/>
              <a:gd name="connsiteY35" fmla="*/ 860538 h 1047863"/>
              <a:gd name="connsiteX36" fmla="*/ 565150 w 2901950"/>
              <a:gd name="connsiteY36" fmla="*/ 863713 h 1047863"/>
              <a:gd name="connsiteX37" fmla="*/ 590550 w 2901950"/>
              <a:gd name="connsiteY37" fmla="*/ 870063 h 1047863"/>
              <a:gd name="connsiteX38" fmla="*/ 603250 w 2901950"/>
              <a:gd name="connsiteY38" fmla="*/ 873238 h 1047863"/>
              <a:gd name="connsiteX39" fmla="*/ 641350 w 2901950"/>
              <a:gd name="connsiteY39" fmla="*/ 885938 h 1047863"/>
              <a:gd name="connsiteX40" fmla="*/ 650875 w 2901950"/>
              <a:gd name="connsiteY40" fmla="*/ 889113 h 1047863"/>
              <a:gd name="connsiteX41" fmla="*/ 660400 w 2901950"/>
              <a:gd name="connsiteY41" fmla="*/ 892288 h 1047863"/>
              <a:gd name="connsiteX42" fmla="*/ 685800 w 2901950"/>
              <a:gd name="connsiteY42" fmla="*/ 898638 h 1047863"/>
              <a:gd name="connsiteX43" fmla="*/ 714375 w 2901950"/>
              <a:gd name="connsiteY43" fmla="*/ 914513 h 1047863"/>
              <a:gd name="connsiteX44" fmla="*/ 723900 w 2901950"/>
              <a:gd name="connsiteY44" fmla="*/ 920863 h 1047863"/>
              <a:gd name="connsiteX45" fmla="*/ 742950 w 2901950"/>
              <a:gd name="connsiteY45" fmla="*/ 930388 h 1047863"/>
              <a:gd name="connsiteX46" fmla="*/ 762000 w 2901950"/>
              <a:gd name="connsiteY46" fmla="*/ 936738 h 1047863"/>
              <a:gd name="connsiteX47" fmla="*/ 771525 w 2901950"/>
              <a:gd name="connsiteY47" fmla="*/ 939913 h 1047863"/>
              <a:gd name="connsiteX48" fmla="*/ 793750 w 2901950"/>
              <a:gd name="connsiteY48" fmla="*/ 949438 h 1047863"/>
              <a:gd name="connsiteX49" fmla="*/ 866775 w 2901950"/>
              <a:gd name="connsiteY49" fmla="*/ 946263 h 1047863"/>
              <a:gd name="connsiteX50" fmla="*/ 904875 w 2901950"/>
              <a:gd name="connsiteY50" fmla="*/ 943088 h 1047863"/>
              <a:gd name="connsiteX51" fmla="*/ 917575 w 2901950"/>
              <a:gd name="connsiteY51" fmla="*/ 939913 h 1047863"/>
              <a:gd name="connsiteX52" fmla="*/ 1035050 w 2901950"/>
              <a:gd name="connsiteY52" fmla="*/ 936738 h 1047863"/>
              <a:gd name="connsiteX53" fmla="*/ 1057275 w 2901950"/>
              <a:gd name="connsiteY53" fmla="*/ 930388 h 1047863"/>
              <a:gd name="connsiteX54" fmla="*/ 1066800 w 2901950"/>
              <a:gd name="connsiteY54" fmla="*/ 924038 h 1047863"/>
              <a:gd name="connsiteX55" fmla="*/ 1095375 w 2901950"/>
              <a:gd name="connsiteY55" fmla="*/ 914513 h 1047863"/>
              <a:gd name="connsiteX56" fmla="*/ 1123950 w 2901950"/>
              <a:gd name="connsiteY56" fmla="*/ 904988 h 1047863"/>
              <a:gd name="connsiteX57" fmla="*/ 1133475 w 2901950"/>
              <a:gd name="connsiteY57" fmla="*/ 901813 h 1047863"/>
              <a:gd name="connsiteX58" fmla="*/ 1143000 w 2901950"/>
              <a:gd name="connsiteY58" fmla="*/ 898638 h 1047863"/>
              <a:gd name="connsiteX59" fmla="*/ 1162050 w 2901950"/>
              <a:gd name="connsiteY59" fmla="*/ 895463 h 1047863"/>
              <a:gd name="connsiteX60" fmla="*/ 1181100 w 2901950"/>
              <a:gd name="connsiteY60" fmla="*/ 889113 h 1047863"/>
              <a:gd name="connsiteX61" fmla="*/ 1200150 w 2901950"/>
              <a:gd name="connsiteY61" fmla="*/ 882763 h 1047863"/>
              <a:gd name="connsiteX62" fmla="*/ 1219200 w 2901950"/>
              <a:gd name="connsiteY62" fmla="*/ 873238 h 1047863"/>
              <a:gd name="connsiteX63" fmla="*/ 1250950 w 2901950"/>
              <a:gd name="connsiteY63" fmla="*/ 863713 h 1047863"/>
              <a:gd name="connsiteX64" fmla="*/ 1279525 w 2901950"/>
              <a:gd name="connsiteY64" fmla="*/ 860538 h 1047863"/>
              <a:gd name="connsiteX65" fmla="*/ 1336675 w 2901950"/>
              <a:gd name="connsiteY65" fmla="*/ 866888 h 1047863"/>
              <a:gd name="connsiteX66" fmla="*/ 1368425 w 2901950"/>
              <a:gd name="connsiteY66" fmla="*/ 873238 h 1047863"/>
              <a:gd name="connsiteX67" fmla="*/ 1387475 w 2901950"/>
              <a:gd name="connsiteY67" fmla="*/ 879588 h 1047863"/>
              <a:gd name="connsiteX68" fmla="*/ 1397000 w 2901950"/>
              <a:gd name="connsiteY68" fmla="*/ 882763 h 1047863"/>
              <a:gd name="connsiteX69" fmla="*/ 1425575 w 2901950"/>
              <a:gd name="connsiteY69" fmla="*/ 895463 h 1047863"/>
              <a:gd name="connsiteX70" fmla="*/ 1454150 w 2901950"/>
              <a:gd name="connsiteY70" fmla="*/ 904988 h 1047863"/>
              <a:gd name="connsiteX71" fmla="*/ 1463675 w 2901950"/>
              <a:gd name="connsiteY71" fmla="*/ 908163 h 1047863"/>
              <a:gd name="connsiteX72" fmla="*/ 1473200 w 2901950"/>
              <a:gd name="connsiteY72" fmla="*/ 911338 h 1047863"/>
              <a:gd name="connsiteX73" fmla="*/ 1482725 w 2901950"/>
              <a:gd name="connsiteY73" fmla="*/ 917688 h 1047863"/>
              <a:gd name="connsiteX74" fmla="*/ 1501775 w 2901950"/>
              <a:gd name="connsiteY74" fmla="*/ 924038 h 1047863"/>
              <a:gd name="connsiteX75" fmla="*/ 1511300 w 2901950"/>
              <a:gd name="connsiteY75" fmla="*/ 930388 h 1047863"/>
              <a:gd name="connsiteX76" fmla="*/ 1530350 w 2901950"/>
              <a:gd name="connsiteY76" fmla="*/ 936738 h 1047863"/>
              <a:gd name="connsiteX77" fmla="*/ 1549400 w 2901950"/>
              <a:gd name="connsiteY77" fmla="*/ 943088 h 1047863"/>
              <a:gd name="connsiteX78" fmla="*/ 1577975 w 2901950"/>
              <a:gd name="connsiteY78" fmla="*/ 952613 h 1047863"/>
              <a:gd name="connsiteX79" fmla="*/ 1587500 w 2901950"/>
              <a:gd name="connsiteY79" fmla="*/ 955788 h 1047863"/>
              <a:gd name="connsiteX80" fmla="*/ 1651000 w 2901950"/>
              <a:gd name="connsiteY80" fmla="*/ 958963 h 1047863"/>
              <a:gd name="connsiteX81" fmla="*/ 1682750 w 2901950"/>
              <a:gd name="connsiteY81" fmla="*/ 965313 h 1047863"/>
              <a:gd name="connsiteX82" fmla="*/ 1701800 w 2901950"/>
              <a:gd name="connsiteY82" fmla="*/ 971663 h 1047863"/>
              <a:gd name="connsiteX83" fmla="*/ 1720850 w 2901950"/>
              <a:gd name="connsiteY83" fmla="*/ 978013 h 1047863"/>
              <a:gd name="connsiteX84" fmla="*/ 1739900 w 2901950"/>
              <a:gd name="connsiteY84" fmla="*/ 984363 h 1047863"/>
              <a:gd name="connsiteX85" fmla="*/ 1749425 w 2901950"/>
              <a:gd name="connsiteY85" fmla="*/ 987538 h 1047863"/>
              <a:gd name="connsiteX86" fmla="*/ 1771650 w 2901950"/>
              <a:gd name="connsiteY86" fmla="*/ 990713 h 1047863"/>
              <a:gd name="connsiteX87" fmla="*/ 1876425 w 2901950"/>
              <a:gd name="connsiteY87" fmla="*/ 990713 h 1047863"/>
              <a:gd name="connsiteX88" fmla="*/ 1914525 w 2901950"/>
              <a:gd name="connsiteY88" fmla="*/ 984363 h 1047863"/>
              <a:gd name="connsiteX89" fmla="*/ 1933575 w 2901950"/>
              <a:gd name="connsiteY89" fmla="*/ 978013 h 1047863"/>
              <a:gd name="connsiteX90" fmla="*/ 1943100 w 2901950"/>
              <a:gd name="connsiteY90" fmla="*/ 974838 h 1047863"/>
              <a:gd name="connsiteX91" fmla="*/ 1952625 w 2901950"/>
              <a:gd name="connsiteY91" fmla="*/ 971663 h 1047863"/>
              <a:gd name="connsiteX92" fmla="*/ 1965325 w 2901950"/>
              <a:gd name="connsiteY92" fmla="*/ 965313 h 1047863"/>
              <a:gd name="connsiteX93" fmla="*/ 1984375 w 2901950"/>
              <a:gd name="connsiteY93" fmla="*/ 958963 h 1047863"/>
              <a:gd name="connsiteX94" fmla="*/ 2006600 w 2901950"/>
              <a:gd name="connsiteY94" fmla="*/ 952613 h 1047863"/>
              <a:gd name="connsiteX95" fmla="*/ 2035175 w 2901950"/>
              <a:gd name="connsiteY95" fmla="*/ 939913 h 1047863"/>
              <a:gd name="connsiteX96" fmla="*/ 2044700 w 2901950"/>
              <a:gd name="connsiteY96" fmla="*/ 936738 h 1047863"/>
              <a:gd name="connsiteX97" fmla="*/ 2054225 w 2901950"/>
              <a:gd name="connsiteY97" fmla="*/ 930388 h 1047863"/>
              <a:gd name="connsiteX98" fmla="*/ 2073275 w 2901950"/>
              <a:gd name="connsiteY98" fmla="*/ 924038 h 1047863"/>
              <a:gd name="connsiteX99" fmla="*/ 2082800 w 2901950"/>
              <a:gd name="connsiteY99" fmla="*/ 917688 h 1047863"/>
              <a:gd name="connsiteX100" fmla="*/ 2092325 w 2901950"/>
              <a:gd name="connsiteY100" fmla="*/ 914513 h 1047863"/>
              <a:gd name="connsiteX101" fmla="*/ 2111375 w 2901950"/>
              <a:gd name="connsiteY101" fmla="*/ 901813 h 1047863"/>
              <a:gd name="connsiteX102" fmla="*/ 2130425 w 2901950"/>
              <a:gd name="connsiteY102" fmla="*/ 889113 h 1047863"/>
              <a:gd name="connsiteX103" fmla="*/ 2139950 w 2901950"/>
              <a:gd name="connsiteY103" fmla="*/ 882763 h 1047863"/>
              <a:gd name="connsiteX104" fmla="*/ 2152650 w 2901950"/>
              <a:gd name="connsiteY104" fmla="*/ 876413 h 1047863"/>
              <a:gd name="connsiteX105" fmla="*/ 2181225 w 2901950"/>
              <a:gd name="connsiteY105" fmla="*/ 860538 h 1047863"/>
              <a:gd name="connsiteX106" fmla="*/ 2193925 w 2901950"/>
              <a:gd name="connsiteY106" fmla="*/ 851013 h 1047863"/>
              <a:gd name="connsiteX107" fmla="*/ 2203450 w 2901950"/>
              <a:gd name="connsiteY107" fmla="*/ 841488 h 1047863"/>
              <a:gd name="connsiteX108" fmla="*/ 2212975 w 2901950"/>
              <a:gd name="connsiteY108" fmla="*/ 838313 h 1047863"/>
              <a:gd name="connsiteX109" fmla="*/ 2222500 w 2901950"/>
              <a:gd name="connsiteY109" fmla="*/ 831963 h 1047863"/>
              <a:gd name="connsiteX110" fmla="*/ 2232025 w 2901950"/>
              <a:gd name="connsiteY110" fmla="*/ 828788 h 1047863"/>
              <a:gd name="connsiteX111" fmla="*/ 2251075 w 2901950"/>
              <a:gd name="connsiteY111" fmla="*/ 816088 h 1047863"/>
              <a:gd name="connsiteX112" fmla="*/ 2260600 w 2901950"/>
              <a:gd name="connsiteY112" fmla="*/ 809738 h 1047863"/>
              <a:gd name="connsiteX113" fmla="*/ 2289175 w 2901950"/>
              <a:gd name="connsiteY113" fmla="*/ 787513 h 1047863"/>
              <a:gd name="connsiteX114" fmla="*/ 2298700 w 2901950"/>
              <a:gd name="connsiteY114" fmla="*/ 781163 h 1047863"/>
              <a:gd name="connsiteX115" fmla="*/ 2305050 w 2901950"/>
              <a:gd name="connsiteY115" fmla="*/ 771638 h 1047863"/>
              <a:gd name="connsiteX116" fmla="*/ 2324100 w 2901950"/>
              <a:gd name="connsiteY116" fmla="*/ 758938 h 1047863"/>
              <a:gd name="connsiteX117" fmla="*/ 2339975 w 2901950"/>
              <a:gd name="connsiteY117" fmla="*/ 746238 h 1047863"/>
              <a:gd name="connsiteX118" fmla="*/ 2346325 w 2901950"/>
              <a:gd name="connsiteY118" fmla="*/ 736713 h 1047863"/>
              <a:gd name="connsiteX119" fmla="*/ 2355850 w 2901950"/>
              <a:gd name="connsiteY119" fmla="*/ 730363 h 1047863"/>
              <a:gd name="connsiteX120" fmla="*/ 2378075 w 2901950"/>
              <a:gd name="connsiteY120" fmla="*/ 708138 h 1047863"/>
              <a:gd name="connsiteX121" fmla="*/ 2390775 w 2901950"/>
              <a:gd name="connsiteY121" fmla="*/ 692263 h 1047863"/>
              <a:gd name="connsiteX122" fmla="*/ 2406650 w 2901950"/>
              <a:gd name="connsiteY122" fmla="*/ 676388 h 1047863"/>
              <a:gd name="connsiteX123" fmla="*/ 2428875 w 2901950"/>
              <a:gd name="connsiteY123" fmla="*/ 650988 h 1047863"/>
              <a:gd name="connsiteX124" fmla="*/ 2435225 w 2901950"/>
              <a:gd name="connsiteY124" fmla="*/ 641463 h 1047863"/>
              <a:gd name="connsiteX125" fmla="*/ 2444750 w 2901950"/>
              <a:gd name="connsiteY125" fmla="*/ 638288 h 1047863"/>
              <a:gd name="connsiteX126" fmla="*/ 2463800 w 2901950"/>
              <a:gd name="connsiteY126" fmla="*/ 625588 h 1047863"/>
              <a:gd name="connsiteX127" fmla="*/ 2482850 w 2901950"/>
              <a:gd name="connsiteY127" fmla="*/ 612888 h 1047863"/>
              <a:gd name="connsiteX128" fmla="*/ 2489200 w 2901950"/>
              <a:gd name="connsiteY128" fmla="*/ 603363 h 1047863"/>
              <a:gd name="connsiteX129" fmla="*/ 2505075 w 2901950"/>
              <a:gd name="connsiteY129" fmla="*/ 584313 h 1047863"/>
              <a:gd name="connsiteX130" fmla="*/ 2511425 w 2901950"/>
              <a:gd name="connsiteY130" fmla="*/ 565263 h 1047863"/>
              <a:gd name="connsiteX131" fmla="*/ 2514600 w 2901950"/>
              <a:gd name="connsiteY131" fmla="*/ 555738 h 1047863"/>
              <a:gd name="connsiteX132" fmla="*/ 2517775 w 2901950"/>
              <a:gd name="connsiteY132" fmla="*/ 546213 h 1047863"/>
              <a:gd name="connsiteX133" fmla="*/ 2520950 w 2901950"/>
              <a:gd name="connsiteY133" fmla="*/ 533513 h 1047863"/>
              <a:gd name="connsiteX134" fmla="*/ 2524125 w 2901950"/>
              <a:gd name="connsiteY134" fmla="*/ 523988 h 1047863"/>
              <a:gd name="connsiteX135" fmla="*/ 2533650 w 2901950"/>
              <a:gd name="connsiteY135" fmla="*/ 489063 h 1047863"/>
              <a:gd name="connsiteX136" fmla="*/ 2536825 w 2901950"/>
              <a:gd name="connsiteY136" fmla="*/ 460488 h 1047863"/>
              <a:gd name="connsiteX137" fmla="*/ 2540000 w 2901950"/>
              <a:gd name="connsiteY137" fmla="*/ 406513 h 1047863"/>
              <a:gd name="connsiteX138" fmla="*/ 2546350 w 2901950"/>
              <a:gd name="connsiteY138" fmla="*/ 387463 h 1047863"/>
              <a:gd name="connsiteX139" fmla="*/ 2549525 w 2901950"/>
              <a:gd name="connsiteY139" fmla="*/ 374763 h 1047863"/>
              <a:gd name="connsiteX140" fmla="*/ 2555875 w 2901950"/>
              <a:gd name="connsiteY140" fmla="*/ 336663 h 1047863"/>
              <a:gd name="connsiteX141" fmla="*/ 2559050 w 2901950"/>
              <a:gd name="connsiteY141" fmla="*/ 327138 h 1047863"/>
              <a:gd name="connsiteX142" fmla="*/ 2562225 w 2901950"/>
              <a:gd name="connsiteY142" fmla="*/ 311263 h 1047863"/>
              <a:gd name="connsiteX143" fmla="*/ 2565400 w 2901950"/>
              <a:gd name="connsiteY143" fmla="*/ 301738 h 1047863"/>
              <a:gd name="connsiteX144" fmla="*/ 2568575 w 2901950"/>
              <a:gd name="connsiteY144" fmla="*/ 289038 h 1047863"/>
              <a:gd name="connsiteX145" fmla="*/ 2571750 w 2901950"/>
              <a:gd name="connsiteY145" fmla="*/ 279513 h 1047863"/>
              <a:gd name="connsiteX146" fmla="*/ 2578100 w 2901950"/>
              <a:gd name="connsiteY146" fmla="*/ 257288 h 1047863"/>
              <a:gd name="connsiteX147" fmla="*/ 2584450 w 2901950"/>
              <a:gd name="connsiteY147" fmla="*/ 247763 h 1047863"/>
              <a:gd name="connsiteX148" fmla="*/ 2590800 w 2901950"/>
              <a:gd name="connsiteY148" fmla="*/ 225538 h 1047863"/>
              <a:gd name="connsiteX149" fmla="*/ 2597150 w 2901950"/>
              <a:gd name="connsiteY149" fmla="*/ 216013 h 1047863"/>
              <a:gd name="connsiteX150" fmla="*/ 2603500 w 2901950"/>
              <a:gd name="connsiteY150" fmla="*/ 193788 h 1047863"/>
              <a:gd name="connsiteX151" fmla="*/ 2613025 w 2901950"/>
              <a:gd name="connsiteY151" fmla="*/ 174738 h 1047863"/>
              <a:gd name="connsiteX152" fmla="*/ 2616200 w 2901950"/>
              <a:gd name="connsiteY152" fmla="*/ 165213 h 1047863"/>
              <a:gd name="connsiteX153" fmla="*/ 2628900 w 2901950"/>
              <a:gd name="connsiteY153" fmla="*/ 146163 h 1047863"/>
              <a:gd name="connsiteX154" fmla="*/ 2635250 w 2901950"/>
              <a:gd name="connsiteY154" fmla="*/ 133463 h 1047863"/>
              <a:gd name="connsiteX155" fmla="*/ 2638425 w 2901950"/>
              <a:gd name="connsiteY155" fmla="*/ 123938 h 1047863"/>
              <a:gd name="connsiteX156" fmla="*/ 2660650 w 2901950"/>
              <a:gd name="connsiteY156" fmla="*/ 95363 h 1047863"/>
              <a:gd name="connsiteX157" fmla="*/ 2682875 w 2901950"/>
              <a:gd name="connsiteY157" fmla="*/ 69963 h 1047863"/>
              <a:gd name="connsiteX158" fmla="*/ 2698750 w 2901950"/>
              <a:gd name="connsiteY158" fmla="*/ 54088 h 1047863"/>
              <a:gd name="connsiteX159" fmla="*/ 2705100 w 2901950"/>
              <a:gd name="connsiteY159" fmla="*/ 44563 h 1047863"/>
              <a:gd name="connsiteX160" fmla="*/ 2714625 w 2901950"/>
              <a:gd name="connsiteY160" fmla="*/ 38213 h 1047863"/>
              <a:gd name="connsiteX161" fmla="*/ 2743200 w 2901950"/>
              <a:gd name="connsiteY161" fmla="*/ 15988 h 1047863"/>
              <a:gd name="connsiteX162" fmla="*/ 2771775 w 2901950"/>
              <a:gd name="connsiteY162" fmla="*/ 3288 h 1047863"/>
              <a:gd name="connsiteX163" fmla="*/ 2781300 w 2901950"/>
              <a:gd name="connsiteY163" fmla="*/ 113 h 1047863"/>
              <a:gd name="connsiteX164" fmla="*/ 2844800 w 2901950"/>
              <a:gd name="connsiteY164" fmla="*/ 6463 h 1047863"/>
              <a:gd name="connsiteX165" fmla="*/ 2854325 w 2901950"/>
              <a:gd name="connsiteY165" fmla="*/ 12813 h 1047863"/>
              <a:gd name="connsiteX166" fmla="*/ 2870200 w 2901950"/>
              <a:gd name="connsiteY166" fmla="*/ 31863 h 1047863"/>
              <a:gd name="connsiteX167" fmla="*/ 2882900 w 2901950"/>
              <a:gd name="connsiteY167" fmla="*/ 50913 h 1047863"/>
              <a:gd name="connsiteX168" fmla="*/ 2889250 w 2901950"/>
              <a:gd name="connsiteY168" fmla="*/ 60438 h 1047863"/>
              <a:gd name="connsiteX169" fmla="*/ 2898775 w 2901950"/>
              <a:gd name="connsiteY169" fmla="*/ 89013 h 1047863"/>
              <a:gd name="connsiteX170" fmla="*/ 2901950 w 2901950"/>
              <a:gd name="connsiteY170" fmla="*/ 98538 h 1047863"/>
              <a:gd name="connsiteX171" fmla="*/ 2898775 w 2901950"/>
              <a:gd name="connsiteY171" fmla="*/ 158863 h 1047863"/>
              <a:gd name="connsiteX172" fmla="*/ 2889250 w 2901950"/>
              <a:gd name="connsiteY172" fmla="*/ 190613 h 1047863"/>
              <a:gd name="connsiteX173" fmla="*/ 2882900 w 2901950"/>
              <a:gd name="connsiteY173" fmla="*/ 212838 h 1047863"/>
              <a:gd name="connsiteX174" fmla="*/ 2873375 w 2901950"/>
              <a:gd name="connsiteY174" fmla="*/ 244588 h 1047863"/>
              <a:gd name="connsiteX175" fmla="*/ 2870200 w 2901950"/>
              <a:gd name="connsiteY175" fmla="*/ 254113 h 1047863"/>
              <a:gd name="connsiteX176" fmla="*/ 2847975 w 2901950"/>
              <a:gd name="connsiteY176" fmla="*/ 282688 h 1047863"/>
              <a:gd name="connsiteX177" fmla="*/ 2844800 w 2901950"/>
              <a:gd name="connsiteY177" fmla="*/ 292213 h 1047863"/>
              <a:gd name="connsiteX178" fmla="*/ 2822575 w 2901950"/>
              <a:gd name="connsiteY178" fmla="*/ 320788 h 1047863"/>
              <a:gd name="connsiteX179" fmla="*/ 2809875 w 2901950"/>
              <a:gd name="connsiteY179" fmla="*/ 336663 h 1047863"/>
              <a:gd name="connsiteX180" fmla="*/ 2797175 w 2901950"/>
              <a:gd name="connsiteY180" fmla="*/ 352538 h 1047863"/>
              <a:gd name="connsiteX181" fmla="*/ 2784475 w 2901950"/>
              <a:gd name="connsiteY181" fmla="*/ 365238 h 1047863"/>
              <a:gd name="connsiteX182" fmla="*/ 2778125 w 2901950"/>
              <a:gd name="connsiteY182" fmla="*/ 374763 h 1047863"/>
              <a:gd name="connsiteX183" fmla="*/ 2768600 w 2901950"/>
              <a:gd name="connsiteY183" fmla="*/ 381113 h 1047863"/>
              <a:gd name="connsiteX184" fmla="*/ 2755900 w 2901950"/>
              <a:gd name="connsiteY184" fmla="*/ 393813 h 1047863"/>
              <a:gd name="connsiteX185" fmla="*/ 2752725 w 2901950"/>
              <a:gd name="connsiteY185" fmla="*/ 403338 h 1047863"/>
              <a:gd name="connsiteX186" fmla="*/ 2743200 w 2901950"/>
              <a:gd name="connsiteY186" fmla="*/ 409688 h 1047863"/>
              <a:gd name="connsiteX187" fmla="*/ 2736850 w 2901950"/>
              <a:gd name="connsiteY187" fmla="*/ 419213 h 1047863"/>
              <a:gd name="connsiteX188" fmla="*/ 2727325 w 2901950"/>
              <a:gd name="connsiteY188" fmla="*/ 425563 h 1047863"/>
              <a:gd name="connsiteX189" fmla="*/ 2705100 w 2901950"/>
              <a:gd name="connsiteY189" fmla="*/ 447788 h 1047863"/>
              <a:gd name="connsiteX190" fmla="*/ 2701925 w 2901950"/>
              <a:gd name="connsiteY190" fmla="*/ 457313 h 1047863"/>
              <a:gd name="connsiteX191" fmla="*/ 2682875 w 2901950"/>
              <a:gd name="connsiteY191" fmla="*/ 470013 h 1047863"/>
              <a:gd name="connsiteX192" fmla="*/ 2679700 w 2901950"/>
              <a:gd name="connsiteY192" fmla="*/ 479538 h 1047863"/>
              <a:gd name="connsiteX193" fmla="*/ 2663825 w 2901950"/>
              <a:gd name="connsiteY193" fmla="*/ 498588 h 1047863"/>
              <a:gd name="connsiteX194" fmla="*/ 2651125 w 2901950"/>
              <a:gd name="connsiteY194" fmla="*/ 514463 h 1047863"/>
              <a:gd name="connsiteX195" fmla="*/ 2647950 w 2901950"/>
              <a:gd name="connsiteY195" fmla="*/ 523988 h 1047863"/>
              <a:gd name="connsiteX196" fmla="*/ 2638425 w 2901950"/>
              <a:gd name="connsiteY196" fmla="*/ 533513 h 1047863"/>
              <a:gd name="connsiteX197" fmla="*/ 2616200 w 2901950"/>
              <a:gd name="connsiteY197" fmla="*/ 558913 h 1047863"/>
              <a:gd name="connsiteX198" fmla="*/ 2603500 w 2901950"/>
              <a:gd name="connsiteY198" fmla="*/ 577963 h 1047863"/>
              <a:gd name="connsiteX199" fmla="*/ 2600325 w 2901950"/>
              <a:gd name="connsiteY199" fmla="*/ 587488 h 1047863"/>
              <a:gd name="connsiteX200" fmla="*/ 2587625 w 2901950"/>
              <a:gd name="connsiteY200" fmla="*/ 606538 h 1047863"/>
              <a:gd name="connsiteX201" fmla="*/ 2584450 w 2901950"/>
              <a:gd name="connsiteY201" fmla="*/ 616063 h 1047863"/>
              <a:gd name="connsiteX202" fmla="*/ 2571750 w 2901950"/>
              <a:gd name="connsiteY202" fmla="*/ 635113 h 1047863"/>
              <a:gd name="connsiteX203" fmla="*/ 2568575 w 2901950"/>
              <a:gd name="connsiteY203" fmla="*/ 644638 h 1047863"/>
              <a:gd name="connsiteX204" fmla="*/ 2559050 w 2901950"/>
              <a:gd name="connsiteY204" fmla="*/ 650988 h 1047863"/>
              <a:gd name="connsiteX205" fmla="*/ 2543175 w 2901950"/>
              <a:gd name="connsiteY205" fmla="*/ 679563 h 1047863"/>
              <a:gd name="connsiteX206" fmla="*/ 2533650 w 2901950"/>
              <a:gd name="connsiteY206" fmla="*/ 685913 h 1047863"/>
              <a:gd name="connsiteX207" fmla="*/ 2517775 w 2901950"/>
              <a:gd name="connsiteY207" fmla="*/ 714488 h 1047863"/>
              <a:gd name="connsiteX208" fmla="*/ 2508250 w 2901950"/>
              <a:gd name="connsiteY208" fmla="*/ 720838 h 1047863"/>
              <a:gd name="connsiteX209" fmla="*/ 2495550 w 2901950"/>
              <a:gd name="connsiteY209" fmla="*/ 736713 h 1047863"/>
              <a:gd name="connsiteX210" fmla="*/ 2489200 w 2901950"/>
              <a:gd name="connsiteY210" fmla="*/ 746238 h 1047863"/>
              <a:gd name="connsiteX211" fmla="*/ 2470150 w 2901950"/>
              <a:gd name="connsiteY211" fmla="*/ 762113 h 1047863"/>
              <a:gd name="connsiteX212" fmla="*/ 2463800 w 2901950"/>
              <a:gd name="connsiteY212" fmla="*/ 771638 h 1047863"/>
              <a:gd name="connsiteX213" fmla="*/ 2444750 w 2901950"/>
              <a:gd name="connsiteY213" fmla="*/ 784338 h 1047863"/>
              <a:gd name="connsiteX214" fmla="*/ 2428875 w 2901950"/>
              <a:gd name="connsiteY214" fmla="*/ 800213 h 1047863"/>
              <a:gd name="connsiteX215" fmla="*/ 2409825 w 2901950"/>
              <a:gd name="connsiteY215" fmla="*/ 819263 h 1047863"/>
              <a:gd name="connsiteX216" fmla="*/ 2403475 w 2901950"/>
              <a:gd name="connsiteY216" fmla="*/ 828788 h 1047863"/>
              <a:gd name="connsiteX217" fmla="*/ 2393950 w 2901950"/>
              <a:gd name="connsiteY217" fmla="*/ 835138 h 1047863"/>
              <a:gd name="connsiteX218" fmla="*/ 2378075 w 2901950"/>
              <a:gd name="connsiteY218" fmla="*/ 851013 h 1047863"/>
              <a:gd name="connsiteX219" fmla="*/ 2371725 w 2901950"/>
              <a:gd name="connsiteY219" fmla="*/ 860538 h 1047863"/>
              <a:gd name="connsiteX220" fmla="*/ 2362200 w 2901950"/>
              <a:gd name="connsiteY220" fmla="*/ 870063 h 1047863"/>
              <a:gd name="connsiteX221" fmla="*/ 2339975 w 2901950"/>
              <a:gd name="connsiteY221" fmla="*/ 892288 h 1047863"/>
              <a:gd name="connsiteX222" fmla="*/ 2327275 w 2901950"/>
              <a:gd name="connsiteY222" fmla="*/ 908163 h 1047863"/>
              <a:gd name="connsiteX223" fmla="*/ 2320925 w 2901950"/>
              <a:gd name="connsiteY223" fmla="*/ 917688 h 1047863"/>
              <a:gd name="connsiteX224" fmla="*/ 2298700 w 2901950"/>
              <a:gd name="connsiteY224" fmla="*/ 946263 h 1047863"/>
              <a:gd name="connsiteX225" fmla="*/ 2286000 w 2901950"/>
              <a:gd name="connsiteY225" fmla="*/ 984363 h 1047863"/>
              <a:gd name="connsiteX226" fmla="*/ 2282825 w 2901950"/>
              <a:gd name="connsiteY226" fmla="*/ 993888 h 1047863"/>
              <a:gd name="connsiteX227" fmla="*/ 2276475 w 2901950"/>
              <a:gd name="connsiteY227" fmla="*/ 1003413 h 1047863"/>
              <a:gd name="connsiteX228" fmla="*/ 2279650 w 2901950"/>
              <a:gd name="connsiteY228" fmla="*/ 1047863 h 1047863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  <a:cxn ang="0">
                <a:pos x="connsiteX31" y="connsiteY31"/>
              </a:cxn>
              <a:cxn ang="0">
                <a:pos x="connsiteX32" y="connsiteY32"/>
              </a:cxn>
              <a:cxn ang="0">
                <a:pos x="connsiteX33" y="connsiteY33"/>
              </a:cxn>
              <a:cxn ang="0">
                <a:pos x="connsiteX34" y="connsiteY34"/>
              </a:cxn>
              <a:cxn ang="0">
                <a:pos x="connsiteX35" y="connsiteY35"/>
              </a:cxn>
              <a:cxn ang="0">
                <a:pos x="connsiteX36" y="connsiteY36"/>
              </a:cxn>
              <a:cxn ang="0">
                <a:pos x="connsiteX37" y="connsiteY37"/>
              </a:cxn>
              <a:cxn ang="0">
                <a:pos x="connsiteX38" y="connsiteY38"/>
              </a:cxn>
              <a:cxn ang="0">
                <a:pos x="connsiteX39" y="connsiteY39"/>
              </a:cxn>
              <a:cxn ang="0">
                <a:pos x="connsiteX40" y="connsiteY40"/>
              </a:cxn>
              <a:cxn ang="0">
                <a:pos x="connsiteX41" y="connsiteY41"/>
              </a:cxn>
              <a:cxn ang="0">
                <a:pos x="connsiteX42" y="connsiteY42"/>
              </a:cxn>
              <a:cxn ang="0">
                <a:pos x="connsiteX43" y="connsiteY43"/>
              </a:cxn>
              <a:cxn ang="0">
                <a:pos x="connsiteX44" y="connsiteY44"/>
              </a:cxn>
              <a:cxn ang="0">
                <a:pos x="connsiteX45" y="connsiteY45"/>
              </a:cxn>
              <a:cxn ang="0">
                <a:pos x="connsiteX46" y="connsiteY46"/>
              </a:cxn>
              <a:cxn ang="0">
                <a:pos x="connsiteX47" y="connsiteY47"/>
              </a:cxn>
              <a:cxn ang="0">
                <a:pos x="connsiteX48" y="connsiteY48"/>
              </a:cxn>
              <a:cxn ang="0">
                <a:pos x="connsiteX49" y="connsiteY49"/>
              </a:cxn>
              <a:cxn ang="0">
                <a:pos x="connsiteX50" y="connsiteY50"/>
              </a:cxn>
              <a:cxn ang="0">
                <a:pos x="connsiteX51" y="connsiteY51"/>
              </a:cxn>
              <a:cxn ang="0">
                <a:pos x="connsiteX52" y="connsiteY52"/>
              </a:cxn>
              <a:cxn ang="0">
                <a:pos x="connsiteX53" y="connsiteY53"/>
              </a:cxn>
              <a:cxn ang="0">
                <a:pos x="connsiteX54" y="connsiteY54"/>
              </a:cxn>
              <a:cxn ang="0">
                <a:pos x="connsiteX55" y="connsiteY55"/>
              </a:cxn>
              <a:cxn ang="0">
                <a:pos x="connsiteX56" y="connsiteY56"/>
              </a:cxn>
              <a:cxn ang="0">
                <a:pos x="connsiteX57" y="connsiteY57"/>
              </a:cxn>
              <a:cxn ang="0">
                <a:pos x="connsiteX58" y="connsiteY58"/>
              </a:cxn>
              <a:cxn ang="0">
                <a:pos x="connsiteX59" y="connsiteY59"/>
              </a:cxn>
              <a:cxn ang="0">
                <a:pos x="connsiteX60" y="connsiteY60"/>
              </a:cxn>
              <a:cxn ang="0">
                <a:pos x="connsiteX61" y="connsiteY61"/>
              </a:cxn>
              <a:cxn ang="0">
                <a:pos x="connsiteX62" y="connsiteY62"/>
              </a:cxn>
              <a:cxn ang="0">
                <a:pos x="connsiteX63" y="connsiteY63"/>
              </a:cxn>
              <a:cxn ang="0">
                <a:pos x="connsiteX64" y="connsiteY64"/>
              </a:cxn>
              <a:cxn ang="0">
                <a:pos x="connsiteX65" y="connsiteY65"/>
              </a:cxn>
              <a:cxn ang="0">
                <a:pos x="connsiteX66" y="connsiteY66"/>
              </a:cxn>
              <a:cxn ang="0">
                <a:pos x="connsiteX67" y="connsiteY67"/>
              </a:cxn>
              <a:cxn ang="0">
                <a:pos x="connsiteX68" y="connsiteY68"/>
              </a:cxn>
              <a:cxn ang="0">
                <a:pos x="connsiteX69" y="connsiteY69"/>
              </a:cxn>
              <a:cxn ang="0">
                <a:pos x="connsiteX70" y="connsiteY70"/>
              </a:cxn>
              <a:cxn ang="0">
                <a:pos x="connsiteX71" y="connsiteY71"/>
              </a:cxn>
              <a:cxn ang="0">
                <a:pos x="connsiteX72" y="connsiteY72"/>
              </a:cxn>
              <a:cxn ang="0">
                <a:pos x="connsiteX73" y="connsiteY73"/>
              </a:cxn>
              <a:cxn ang="0">
                <a:pos x="connsiteX74" y="connsiteY74"/>
              </a:cxn>
              <a:cxn ang="0">
                <a:pos x="connsiteX75" y="connsiteY75"/>
              </a:cxn>
              <a:cxn ang="0">
                <a:pos x="connsiteX76" y="connsiteY76"/>
              </a:cxn>
              <a:cxn ang="0">
                <a:pos x="connsiteX77" y="connsiteY77"/>
              </a:cxn>
              <a:cxn ang="0">
                <a:pos x="connsiteX78" y="connsiteY78"/>
              </a:cxn>
              <a:cxn ang="0">
                <a:pos x="connsiteX79" y="connsiteY79"/>
              </a:cxn>
              <a:cxn ang="0">
                <a:pos x="connsiteX80" y="connsiteY80"/>
              </a:cxn>
              <a:cxn ang="0">
                <a:pos x="connsiteX81" y="connsiteY81"/>
              </a:cxn>
              <a:cxn ang="0">
                <a:pos x="connsiteX82" y="connsiteY82"/>
              </a:cxn>
              <a:cxn ang="0">
                <a:pos x="connsiteX83" y="connsiteY83"/>
              </a:cxn>
              <a:cxn ang="0">
                <a:pos x="connsiteX84" y="connsiteY84"/>
              </a:cxn>
              <a:cxn ang="0">
                <a:pos x="connsiteX85" y="connsiteY85"/>
              </a:cxn>
              <a:cxn ang="0">
                <a:pos x="connsiteX86" y="connsiteY86"/>
              </a:cxn>
              <a:cxn ang="0">
                <a:pos x="connsiteX87" y="connsiteY87"/>
              </a:cxn>
              <a:cxn ang="0">
                <a:pos x="connsiteX88" y="connsiteY88"/>
              </a:cxn>
              <a:cxn ang="0">
                <a:pos x="connsiteX89" y="connsiteY89"/>
              </a:cxn>
              <a:cxn ang="0">
                <a:pos x="connsiteX90" y="connsiteY90"/>
              </a:cxn>
              <a:cxn ang="0">
                <a:pos x="connsiteX91" y="connsiteY91"/>
              </a:cxn>
              <a:cxn ang="0">
                <a:pos x="connsiteX92" y="connsiteY92"/>
              </a:cxn>
              <a:cxn ang="0">
                <a:pos x="connsiteX93" y="connsiteY93"/>
              </a:cxn>
              <a:cxn ang="0">
                <a:pos x="connsiteX94" y="connsiteY94"/>
              </a:cxn>
              <a:cxn ang="0">
                <a:pos x="connsiteX95" y="connsiteY95"/>
              </a:cxn>
              <a:cxn ang="0">
                <a:pos x="connsiteX96" y="connsiteY96"/>
              </a:cxn>
              <a:cxn ang="0">
                <a:pos x="connsiteX97" y="connsiteY97"/>
              </a:cxn>
              <a:cxn ang="0">
                <a:pos x="connsiteX98" y="connsiteY98"/>
              </a:cxn>
              <a:cxn ang="0">
                <a:pos x="connsiteX99" y="connsiteY99"/>
              </a:cxn>
              <a:cxn ang="0">
                <a:pos x="connsiteX100" y="connsiteY100"/>
              </a:cxn>
              <a:cxn ang="0">
                <a:pos x="connsiteX101" y="connsiteY101"/>
              </a:cxn>
              <a:cxn ang="0">
                <a:pos x="connsiteX102" y="connsiteY102"/>
              </a:cxn>
              <a:cxn ang="0">
                <a:pos x="connsiteX103" y="connsiteY103"/>
              </a:cxn>
              <a:cxn ang="0">
                <a:pos x="connsiteX104" y="connsiteY104"/>
              </a:cxn>
              <a:cxn ang="0">
                <a:pos x="connsiteX105" y="connsiteY105"/>
              </a:cxn>
              <a:cxn ang="0">
                <a:pos x="connsiteX106" y="connsiteY106"/>
              </a:cxn>
              <a:cxn ang="0">
                <a:pos x="connsiteX107" y="connsiteY107"/>
              </a:cxn>
              <a:cxn ang="0">
                <a:pos x="connsiteX108" y="connsiteY108"/>
              </a:cxn>
              <a:cxn ang="0">
                <a:pos x="connsiteX109" y="connsiteY109"/>
              </a:cxn>
              <a:cxn ang="0">
                <a:pos x="connsiteX110" y="connsiteY110"/>
              </a:cxn>
              <a:cxn ang="0">
                <a:pos x="connsiteX111" y="connsiteY111"/>
              </a:cxn>
              <a:cxn ang="0">
                <a:pos x="connsiteX112" y="connsiteY112"/>
              </a:cxn>
              <a:cxn ang="0">
                <a:pos x="connsiteX113" y="connsiteY113"/>
              </a:cxn>
              <a:cxn ang="0">
                <a:pos x="connsiteX114" y="connsiteY114"/>
              </a:cxn>
              <a:cxn ang="0">
                <a:pos x="connsiteX115" y="connsiteY115"/>
              </a:cxn>
              <a:cxn ang="0">
                <a:pos x="connsiteX116" y="connsiteY116"/>
              </a:cxn>
              <a:cxn ang="0">
                <a:pos x="connsiteX117" y="connsiteY117"/>
              </a:cxn>
              <a:cxn ang="0">
                <a:pos x="connsiteX118" y="connsiteY118"/>
              </a:cxn>
              <a:cxn ang="0">
                <a:pos x="connsiteX119" y="connsiteY119"/>
              </a:cxn>
              <a:cxn ang="0">
                <a:pos x="connsiteX120" y="connsiteY120"/>
              </a:cxn>
              <a:cxn ang="0">
                <a:pos x="connsiteX121" y="connsiteY121"/>
              </a:cxn>
              <a:cxn ang="0">
                <a:pos x="connsiteX122" y="connsiteY122"/>
              </a:cxn>
              <a:cxn ang="0">
                <a:pos x="connsiteX123" y="connsiteY123"/>
              </a:cxn>
              <a:cxn ang="0">
                <a:pos x="connsiteX124" y="connsiteY124"/>
              </a:cxn>
              <a:cxn ang="0">
                <a:pos x="connsiteX125" y="connsiteY125"/>
              </a:cxn>
              <a:cxn ang="0">
                <a:pos x="connsiteX126" y="connsiteY126"/>
              </a:cxn>
              <a:cxn ang="0">
                <a:pos x="connsiteX127" y="connsiteY127"/>
              </a:cxn>
              <a:cxn ang="0">
                <a:pos x="connsiteX128" y="connsiteY128"/>
              </a:cxn>
              <a:cxn ang="0">
                <a:pos x="connsiteX129" y="connsiteY129"/>
              </a:cxn>
              <a:cxn ang="0">
                <a:pos x="connsiteX130" y="connsiteY130"/>
              </a:cxn>
              <a:cxn ang="0">
                <a:pos x="connsiteX131" y="connsiteY131"/>
              </a:cxn>
              <a:cxn ang="0">
                <a:pos x="connsiteX132" y="connsiteY132"/>
              </a:cxn>
              <a:cxn ang="0">
                <a:pos x="connsiteX133" y="connsiteY133"/>
              </a:cxn>
              <a:cxn ang="0">
                <a:pos x="connsiteX134" y="connsiteY134"/>
              </a:cxn>
              <a:cxn ang="0">
                <a:pos x="connsiteX135" y="connsiteY135"/>
              </a:cxn>
              <a:cxn ang="0">
                <a:pos x="connsiteX136" y="connsiteY136"/>
              </a:cxn>
              <a:cxn ang="0">
                <a:pos x="connsiteX137" y="connsiteY137"/>
              </a:cxn>
              <a:cxn ang="0">
                <a:pos x="connsiteX138" y="connsiteY138"/>
              </a:cxn>
              <a:cxn ang="0">
                <a:pos x="connsiteX139" y="connsiteY139"/>
              </a:cxn>
              <a:cxn ang="0">
                <a:pos x="connsiteX140" y="connsiteY140"/>
              </a:cxn>
              <a:cxn ang="0">
                <a:pos x="connsiteX141" y="connsiteY141"/>
              </a:cxn>
              <a:cxn ang="0">
                <a:pos x="connsiteX142" y="connsiteY142"/>
              </a:cxn>
              <a:cxn ang="0">
                <a:pos x="connsiteX143" y="connsiteY143"/>
              </a:cxn>
              <a:cxn ang="0">
                <a:pos x="connsiteX144" y="connsiteY144"/>
              </a:cxn>
              <a:cxn ang="0">
                <a:pos x="connsiteX145" y="connsiteY145"/>
              </a:cxn>
              <a:cxn ang="0">
                <a:pos x="connsiteX146" y="connsiteY146"/>
              </a:cxn>
              <a:cxn ang="0">
                <a:pos x="connsiteX147" y="connsiteY147"/>
              </a:cxn>
              <a:cxn ang="0">
                <a:pos x="connsiteX148" y="connsiteY148"/>
              </a:cxn>
              <a:cxn ang="0">
                <a:pos x="connsiteX149" y="connsiteY149"/>
              </a:cxn>
              <a:cxn ang="0">
                <a:pos x="connsiteX150" y="connsiteY150"/>
              </a:cxn>
              <a:cxn ang="0">
                <a:pos x="connsiteX151" y="connsiteY151"/>
              </a:cxn>
              <a:cxn ang="0">
                <a:pos x="connsiteX152" y="connsiteY152"/>
              </a:cxn>
              <a:cxn ang="0">
                <a:pos x="connsiteX153" y="connsiteY153"/>
              </a:cxn>
              <a:cxn ang="0">
                <a:pos x="connsiteX154" y="connsiteY154"/>
              </a:cxn>
              <a:cxn ang="0">
                <a:pos x="connsiteX155" y="connsiteY155"/>
              </a:cxn>
              <a:cxn ang="0">
                <a:pos x="connsiteX156" y="connsiteY156"/>
              </a:cxn>
              <a:cxn ang="0">
                <a:pos x="connsiteX157" y="connsiteY157"/>
              </a:cxn>
              <a:cxn ang="0">
                <a:pos x="connsiteX158" y="connsiteY158"/>
              </a:cxn>
              <a:cxn ang="0">
                <a:pos x="connsiteX159" y="connsiteY159"/>
              </a:cxn>
              <a:cxn ang="0">
                <a:pos x="connsiteX160" y="connsiteY160"/>
              </a:cxn>
              <a:cxn ang="0">
                <a:pos x="connsiteX161" y="connsiteY161"/>
              </a:cxn>
              <a:cxn ang="0">
                <a:pos x="connsiteX162" y="connsiteY162"/>
              </a:cxn>
              <a:cxn ang="0">
                <a:pos x="connsiteX163" y="connsiteY163"/>
              </a:cxn>
              <a:cxn ang="0">
                <a:pos x="connsiteX164" y="connsiteY164"/>
              </a:cxn>
              <a:cxn ang="0">
                <a:pos x="connsiteX165" y="connsiteY165"/>
              </a:cxn>
              <a:cxn ang="0">
                <a:pos x="connsiteX166" y="connsiteY166"/>
              </a:cxn>
              <a:cxn ang="0">
                <a:pos x="connsiteX167" y="connsiteY167"/>
              </a:cxn>
              <a:cxn ang="0">
                <a:pos x="connsiteX168" y="connsiteY168"/>
              </a:cxn>
              <a:cxn ang="0">
                <a:pos x="connsiteX169" y="connsiteY169"/>
              </a:cxn>
              <a:cxn ang="0">
                <a:pos x="connsiteX170" y="connsiteY170"/>
              </a:cxn>
              <a:cxn ang="0">
                <a:pos x="connsiteX171" y="connsiteY171"/>
              </a:cxn>
              <a:cxn ang="0">
                <a:pos x="connsiteX172" y="connsiteY172"/>
              </a:cxn>
              <a:cxn ang="0">
                <a:pos x="connsiteX173" y="connsiteY173"/>
              </a:cxn>
              <a:cxn ang="0">
                <a:pos x="connsiteX174" y="connsiteY174"/>
              </a:cxn>
              <a:cxn ang="0">
                <a:pos x="connsiteX175" y="connsiteY175"/>
              </a:cxn>
              <a:cxn ang="0">
                <a:pos x="connsiteX176" y="connsiteY176"/>
              </a:cxn>
              <a:cxn ang="0">
                <a:pos x="connsiteX177" y="connsiteY177"/>
              </a:cxn>
              <a:cxn ang="0">
                <a:pos x="connsiteX178" y="connsiteY178"/>
              </a:cxn>
              <a:cxn ang="0">
                <a:pos x="connsiteX179" y="connsiteY179"/>
              </a:cxn>
              <a:cxn ang="0">
                <a:pos x="connsiteX180" y="connsiteY180"/>
              </a:cxn>
              <a:cxn ang="0">
                <a:pos x="connsiteX181" y="connsiteY181"/>
              </a:cxn>
              <a:cxn ang="0">
                <a:pos x="connsiteX182" y="connsiteY182"/>
              </a:cxn>
              <a:cxn ang="0">
                <a:pos x="connsiteX183" y="connsiteY183"/>
              </a:cxn>
              <a:cxn ang="0">
                <a:pos x="connsiteX184" y="connsiteY184"/>
              </a:cxn>
              <a:cxn ang="0">
                <a:pos x="connsiteX185" y="connsiteY185"/>
              </a:cxn>
              <a:cxn ang="0">
                <a:pos x="connsiteX186" y="connsiteY186"/>
              </a:cxn>
              <a:cxn ang="0">
                <a:pos x="connsiteX187" y="connsiteY187"/>
              </a:cxn>
              <a:cxn ang="0">
                <a:pos x="connsiteX188" y="connsiteY188"/>
              </a:cxn>
              <a:cxn ang="0">
                <a:pos x="connsiteX189" y="connsiteY189"/>
              </a:cxn>
              <a:cxn ang="0">
                <a:pos x="connsiteX190" y="connsiteY190"/>
              </a:cxn>
              <a:cxn ang="0">
                <a:pos x="connsiteX191" y="connsiteY191"/>
              </a:cxn>
              <a:cxn ang="0">
                <a:pos x="connsiteX192" y="connsiteY192"/>
              </a:cxn>
              <a:cxn ang="0">
                <a:pos x="connsiteX193" y="connsiteY193"/>
              </a:cxn>
              <a:cxn ang="0">
                <a:pos x="connsiteX194" y="connsiteY194"/>
              </a:cxn>
              <a:cxn ang="0">
                <a:pos x="connsiteX195" y="connsiteY195"/>
              </a:cxn>
              <a:cxn ang="0">
                <a:pos x="connsiteX196" y="connsiteY196"/>
              </a:cxn>
              <a:cxn ang="0">
                <a:pos x="connsiteX197" y="connsiteY197"/>
              </a:cxn>
              <a:cxn ang="0">
                <a:pos x="connsiteX198" y="connsiteY198"/>
              </a:cxn>
              <a:cxn ang="0">
                <a:pos x="connsiteX199" y="connsiteY199"/>
              </a:cxn>
              <a:cxn ang="0">
                <a:pos x="connsiteX200" y="connsiteY200"/>
              </a:cxn>
              <a:cxn ang="0">
                <a:pos x="connsiteX201" y="connsiteY201"/>
              </a:cxn>
              <a:cxn ang="0">
                <a:pos x="connsiteX202" y="connsiteY202"/>
              </a:cxn>
              <a:cxn ang="0">
                <a:pos x="connsiteX203" y="connsiteY203"/>
              </a:cxn>
              <a:cxn ang="0">
                <a:pos x="connsiteX204" y="connsiteY204"/>
              </a:cxn>
              <a:cxn ang="0">
                <a:pos x="connsiteX205" y="connsiteY205"/>
              </a:cxn>
              <a:cxn ang="0">
                <a:pos x="connsiteX206" y="connsiteY206"/>
              </a:cxn>
              <a:cxn ang="0">
                <a:pos x="connsiteX207" y="connsiteY207"/>
              </a:cxn>
              <a:cxn ang="0">
                <a:pos x="connsiteX208" y="connsiteY208"/>
              </a:cxn>
              <a:cxn ang="0">
                <a:pos x="connsiteX209" y="connsiteY209"/>
              </a:cxn>
              <a:cxn ang="0">
                <a:pos x="connsiteX210" y="connsiteY210"/>
              </a:cxn>
              <a:cxn ang="0">
                <a:pos x="connsiteX211" y="connsiteY211"/>
              </a:cxn>
              <a:cxn ang="0">
                <a:pos x="connsiteX212" y="connsiteY212"/>
              </a:cxn>
              <a:cxn ang="0">
                <a:pos x="connsiteX213" y="connsiteY213"/>
              </a:cxn>
              <a:cxn ang="0">
                <a:pos x="connsiteX214" y="connsiteY214"/>
              </a:cxn>
              <a:cxn ang="0">
                <a:pos x="connsiteX215" y="connsiteY215"/>
              </a:cxn>
              <a:cxn ang="0">
                <a:pos x="connsiteX216" y="connsiteY216"/>
              </a:cxn>
              <a:cxn ang="0">
                <a:pos x="connsiteX217" y="connsiteY217"/>
              </a:cxn>
              <a:cxn ang="0">
                <a:pos x="connsiteX218" y="connsiteY218"/>
              </a:cxn>
              <a:cxn ang="0">
                <a:pos x="connsiteX219" y="connsiteY219"/>
              </a:cxn>
              <a:cxn ang="0">
                <a:pos x="connsiteX220" y="connsiteY220"/>
              </a:cxn>
              <a:cxn ang="0">
                <a:pos x="connsiteX221" y="connsiteY221"/>
              </a:cxn>
              <a:cxn ang="0">
                <a:pos x="connsiteX222" y="connsiteY222"/>
              </a:cxn>
              <a:cxn ang="0">
                <a:pos x="connsiteX223" y="connsiteY223"/>
              </a:cxn>
              <a:cxn ang="0">
                <a:pos x="connsiteX224" y="connsiteY224"/>
              </a:cxn>
              <a:cxn ang="0">
                <a:pos x="connsiteX225" y="connsiteY225"/>
              </a:cxn>
              <a:cxn ang="0">
                <a:pos x="connsiteX226" y="connsiteY226"/>
              </a:cxn>
              <a:cxn ang="0">
                <a:pos x="connsiteX227" y="connsiteY227"/>
              </a:cxn>
              <a:cxn ang="0">
                <a:pos x="connsiteX228" y="connsiteY228"/>
              </a:cxn>
            </a:cxnLst>
            <a:rect l="l" t="t" r="r" b="b"/>
            <a:pathLst>
              <a:path w="2901950" h="1047863">
                <a:moveTo>
                  <a:pt x="0" y="543038"/>
                </a:moveTo>
                <a:cubicBezTo>
                  <a:pt x="2303" y="548796"/>
                  <a:pt x="6847" y="563316"/>
                  <a:pt x="12700" y="568438"/>
                </a:cubicBezTo>
                <a:cubicBezTo>
                  <a:pt x="26137" y="580195"/>
                  <a:pt x="28193" y="579952"/>
                  <a:pt x="41275" y="584313"/>
                </a:cubicBezTo>
                <a:cubicBezTo>
                  <a:pt x="46919" y="592780"/>
                  <a:pt x="48688" y="596781"/>
                  <a:pt x="57150" y="603363"/>
                </a:cubicBezTo>
                <a:cubicBezTo>
                  <a:pt x="63174" y="608048"/>
                  <a:pt x="76200" y="616063"/>
                  <a:pt x="76200" y="616063"/>
                </a:cubicBezTo>
                <a:cubicBezTo>
                  <a:pt x="93133" y="641463"/>
                  <a:pt x="70908" y="610771"/>
                  <a:pt x="92075" y="631938"/>
                </a:cubicBezTo>
                <a:cubicBezTo>
                  <a:pt x="113242" y="653105"/>
                  <a:pt x="82550" y="630880"/>
                  <a:pt x="107950" y="647813"/>
                </a:cubicBezTo>
                <a:cubicBezTo>
                  <a:pt x="119683" y="665412"/>
                  <a:pt x="107587" y="651492"/>
                  <a:pt x="123825" y="660513"/>
                </a:cubicBezTo>
                <a:cubicBezTo>
                  <a:pt x="130496" y="664219"/>
                  <a:pt x="142875" y="673213"/>
                  <a:pt x="142875" y="673213"/>
                </a:cubicBezTo>
                <a:cubicBezTo>
                  <a:pt x="154608" y="690812"/>
                  <a:pt x="142512" y="676892"/>
                  <a:pt x="158750" y="685913"/>
                </a:cubicBezTo>
                <a:cubicBezTo>
                  <a:pt x="165421" y="689619"/>
                  <a:pt x="170560" y="696200"/>
                  <a:pt x="177800" y="698613"/>
                </a:cubicBezTo>
                <a:cubicBezTo>
                  <a:pt x="180975" y="699671"/>
                  <a:pt x="184249" y="700470"/>
                  <a:pt x="187325" y="701788"/>
                </a:cubicBezTo>
                <a:cubicBezTo>
                  <a:pt x="191675" y="703652"/>
                  <a:pt x="195916" y="705790"/>
                  <a:pt x="200025" y="708138"/>
                </a:cubicBezTo>
                <a:cubicBezTo>
                  <a:pt x="203338" y="710031"/>
                  <a:pt x="206063" y="712938"/>
                  <a:pt x="209550" y="714488"/>
                </a:cubicBezTo>
                <a:cubicBezTo>
                  <a:pt x="215667" y="717206"/>
                  <a:pt x="223031" y="717125"/>
                  <a:pt x="228600" y="720838"/>
                </a:cubicBezTo>
                <a:cubicBezTo>
                  <a:pt x="231775" y="722955"/>
                  <a:pt x="234712" y="725481"/>
                  <a:pt x="238125" y="727188"/>
                </a:cubicBezTo>
                <a:cubicBezTo>
                  <a:pt x="241118" y="728685"/>
                  <a:pt x="244724" y="728738"/>
                  <a:pt x="247650" y="730363"/>
                </a:cubicBezTo>
                <a:cubicBezTo>
                  <a:pt x="254321" y="734069"/>
                  <a:pt x="259460" y="740650"/>
                  <a:pt x="266700" y="743063"/>
                </a:cubicBezTo>
                <a:cubicBezTo>
                  <a:pt x="269875" y="744121"/>
                  <a:pt x="273299" y="744613"/>
                  <a:pt x="276225" y="746238"/>
                </a:cubicBezTo>
                <a:cubicBezTo>
                  <a:pt x="282896" y="749944"/>
                  <a:pt x="288035" y="756525"/>
                  <a:pt x="295275" y="758938"/>
                </a:cubicBezTo>
                <a:cubicBezTo>
                  <a:pt x="312040" y="764526"/>
                  <a:pt x="302015" y="760257"/>
                  <a:pt x="323850" y="774813"/>
                </a:cubicBezTo>
                <a:lnTo>
                  <a:pt x="333375" y="781163"/>
                </a:lnTo>
                <a:cubicBezTo>
                  <a:pt x="336550" y="783280"/>
                  <a:pt x="339280" y="786306"/>
                  <a:pt x="342900" y="787513"/>
                </a:cubicBezTo>
                <a:cubicBezTo>
                  <a:pt x="349250" y="789630"/>
                  <a:pt x="356381" y="790150"/>
                  <a:pt x="361950" y="793863"/>
                </a:cubicBezTo>
                <a:cubicBezTo>
                  <a:pt x="365125" y="795980"/>
                  <a:pt x="367988" y="798663"/>
                  <a:pt x="371475" y="800213"/>
                </a:cubicBezTo>
                <a:cubicBezTo>
                  <a:pt x="377592" y="802931"/>
                  <a:pt x="384956" y="802850"/>
                  <a:pt x="390525" y="806563"/>
                </a:cubicBezTo>
                <a:cubicBezTo>
                  <a:pt x="393700" y="808680"/>
                  <a:pt x="396563" y="811363"/>
                  <a:pt x="400050" y="812913"/>
                </a:cubicBezTo>
                <a:cubicBezTo>
                  <a:pt x="406167" y="815631"/>
                  <a:pt x="412750" y="817146"/>
                  <a:pt x="419100" y="819263"/>
                </a:cubicBezTo>
                <a:lnTo>
                  <a:pt x="428625" y="822438"/>
                </a:lnTo>
                <a:lnTo>
                  <a:pt x="466725" y="835138"/>
                </a:lnTo>
                <a:lnTo>
                  <a:pt x="476250" y="838313"/>
                </a:lnTo>
                <a:cubicBezTo>
                  <a:pt x="479425" y="839371"/>
                  <a:pt x="482493" y="840832"/>
                  <a:pt x="485775" y="841488"/>
                </a:cubicBezTo>
                <a:cubicBezTo>
                  <a:pt x="496687" y="843670"/>
                  <a:pt x="503888" y="844849"/>
                  <a:pt x="514350" y="847838"/>
                </a:cubicBezTo>
                <a:cubicBezTo>
                  <a:pt x="517568" y="848757"/>
                  <a:pt x="520657" y="850094"/>
                  <a:pt x="523875" y="851013"/>
                </a:cubicBezTo>
                <a:cubicBezTo>
                  <a:pt x="528071" y="852212"/>
                  <a:pt x="532395" y="852934"/>
                  <a:pt x="536575" y="854188"/>
                </a:cubicBezTo>
                <a:cubicBezTo>
                  <a:pt x="542986" y="856111"/>
                  <a:pt x="549275" y="858421"/>
                  <a:pt x="555625" y="860538"/>
                </a:cubicBezTo>
                <a:cubicBezTo>
                  <a:pt x="558800" y="861596"/>
                  <a:pt x="561903" y="862901"/>
                  <a:pt x="565150" y="863713"/>
                </a:cubicBezTo>
                <a:lnTo>
                  <a:pt x="590550" y="870063"/>
                </a:lnTo>
                <a:cubicBezTo>
                  <a:pt x="594783" y="871121"/>
                  <a:pt x="599110" y="871858"/>
                  <a:pt x="603250" y="873238"/>
                </a:cubicBezTo>
                <a:lnTo>
                  <a:pt x="641350" y="885938"/>
                </a:lnTo>
                <a:lnTo>
                  <a:pt x="650875" y="889113"/>
                </a:lnTo>
                <a:cubicBezTo>
                  <a:pt x="654050" y="890171"/>
                  <a:pt x="657153" y="891476"/>
                  <a:pt x="660400" y="892288"/>
                </a:cubicBezTo>
                <a:cubicBezTo>
                  <a:pt x="668867" y="894405"/>
                  <a:pt x="677521" y="895878"/>
                  <a:pt x="685800" y="898638"/>
                </a:cubicBezTo>
                <a:cubicBezTo>
                  <a:pt x="702565" y="904226"/>
                  <a:pt x="692540" y="899957"/>
                  <a:pt x="714375" y="914513"/>
                </a:cubicBezTo>
                <a:cubicBezTo>
                  <a:pt x="717550" y="916630"/>
                  <a:pt x="720280" y="919656"/>
                  <a:pt x="723900" y="920863"/>
                </a:cubicBezTo>
                <a:cubicBezTo>
                  <a:pt x="758638" y="932442"/>
                  <a:pt x="706021" y="913975"/>
                  <a:pt x="742950" y="930388"/>
                </a:cubicBezTo>
                <a:cubicBezTo>
                  <a:pt x="749067" y="933106"/>
                  <a:pt x="755650" y="934621"/>
                  <a:pt x="762000" y="936738"/>
                </a:cubicBezTo>
                <a:cubicBezTo>
                  <a:pt x="765175" y="937796"/>
                  <a:pt x="768740" y="938057"/>
                  <a:pt x="771525" y="939913"/>
                </a:cubicBezTo>
                <a:cubicBezTo>
                  <a:pt x="784681" y="948684"/>
                  <a:pt x="777348" y="945338"/>
                  <a:pt x="793750" y="949438"/>
                </a:cubicBezTo>
                <a:lnTo>
                  <a:pt x="866775" y="946263"/>
                </a:lnTo>
                <a:cubicBezTo>
                  <a:pt x="879498" y="945536"/>
                  <a:pt x="892229" y="944669"/>
                  <a:pt x="904875" y="943088"/>
                </a:cubicBezTo>
                <a:cubicBezTo>
                  <a:pt x="909205" y="942547"/>
                  <a:pt x="913217" y="940126"/>
                  <a:pt x="917575" y="939913"/>
                </a:cubicBezTo>
                <a:cubicBezTo>
                  <a:pt x="956701" y="938004"/>
                  <a:pt x="995892" y="937796"/>
                  <a:pt x="1035050" y="936738"/>
                </a:cubicBezTo>
                <a:cubicBezTo>
                  <a:pt x="1039119" y="935721"/>
                  <a:pt x="1052720" y="932665"/>
                  <a:pt x="1057275" y="930388"/>
                </a:cubicBezTo>
                <a:cubicBezTo>
                  <a:pt x="1060688" y="928681"/>
                  <a:pt x="1063313" y="925588"/>
                  <a:pt x="1066800" y="924038"/>
                </a:cubicBezTo>
                <a:lnTo>
                  <a:pt x="1095375" y="914513"/>
                </a:lnTo>
                <a:lnTo>
                  <a:pt x="1123950" y="904988"/>
                </a:lnTo>
                <a:lnTo>
                  <a:pt x="1133475" y="901813"/>
                </a:lnTo>
                <a:cubicBezTo>
                  <a:pt x="1136650" y="900755"/>
                  <a:pt x="1139699" y="899188"/>
                  <a:pt x="1143000" y="898638"/>
                </a:cubicBezTo>
                <a:cubicBezTo>
                  <a:pt x="1149350" y="897580"/>
                  <a:pt x="1155805" y="897024"/>
                  <a:pt x="1162050" y="895463"/>
                </a:cubicBezTo>
                <a:cubicBezTo>
                  <a:pt x="1168544" y="893840"/>
                  <a:pt x="1174750" y="891230"/>
                  <a:pt x="1181100" y="889113"/>
                </a:cubicBezTo>
                <a:lnTo>
                  <a:pt x="1200150" y="882763"/>
                </a:lnTo>
                <a:cubicBezTo>
                  <a:pt x="1234888" y="871184"/>
                  <a:pt x="1182271" y="889651"/>
                  <a:pt x="1219200" y="873238"/>
                </a:cubicBezTo>
                <a:cubicBezTo>
                  <a:pt x="1223781" y="871202"/>
                  <a:pt x="1243888" y="864800"/>
                  <a:pt x="1250950" y="863713"/>
                </a:cubicBezTo>
                <a:cubicBezTo>
                  <a:pt x="1260422" y="862256"/>
                  <a:pt x="1270000" y="861596"/>
                  <a:pt x="1279525" y="860538"/>
                </a:cubicBezTo>
                <a:cubicBezTo>
                  <a:pt x="1311521" y="863204"/>
                  <a:pt x="1311379" y="862145"/>
                  <a:pt x="1336675" y="866888"/>
                </a:cubicBezTo>
                <a:cubicBezTo>
                  <a:pt x="1347283" y="868877"/>
                  <a:pt x="1358186" y="869825"/>
                  <a:pt x="1368425" y="873238"/>
                </a:cubicBezTo>
                <a:lnTo>
                  <a:pt x="1387475" y="879588"/>
                </a:lnTo>
                <a:cubicBezTo>
                  <a:pt x="1390650" y="880646"/>
                  <a:pt x="1394215" y="880907"/>
                  <a:pt x="1397000" y="882763"/>
                </a:cubicBezTo>
                <a:cubicBezTo>
                  <a:pt x="1412094" y="892826"/>
                  <a:pt x="1402905" y="887906"/>
                  <a:pt x="1425575" y="895463"/>
                </a:cubicBezTo>
                <a:lnTo>
                  <a:pt x="1454150" y="904988"/>
                </a:lnTo>
                <a:lnTo>
                  <a:pt x="1463675" y="908163"/>
                </a:lnTo>
                <a:cubicBezTo>
                  <a:pt x="1466850" y="909221"/>
                  <a:pt x="1470415" y="909482"/>
                  <a:pt x="1473200" y="911338"/>
                </a:cubicBezTo>
                <a:cubicBezTo>
                  <a:pt x="1476375" y="913455"/>
                  <a:pt x="1479238" y="916138"/>
                  <a:pt x="1482725" y="917688"/>
                </a:cubicBezTo>
                <a:cubicBezTo>
                  <a:pt x="1488842" y="920406"/>
                  <a:pt x="1496206" y="920325"/>
                  <a:pt x="1501775" y="924038"/>
                </a:cubicBezTo>
                <a:cubicBezTo>
                  <a:pt x="1504950" y="926155"/>
                  <a:pt x="1507813" y="928838"/>
                  <a:pt x="1511300" y="930388"/>
                </a:cubicBezTo>
                <a:cubicBezTo>
                  <a:pt x="1517417" y="933106"/>
                  <a:pt x="1524000" y="934621"/>
                  <a:pt x="1530350" y="936738"/>
                </a:cubicBezTo>
                <a:lnTo>
                  <a:pt x="1549400" y="943088"/>
                </a:lnTo>
                <a:lnTo>
                  <a:pt x="1577975" y="952613"/>
                </a:lnTo>
                <a:cubicBezTo>
                  <a:pt x="1581150" y="953671"/>
                  <a:pt x="1584157" y="955621"/>
                  <a:pt x="1587500" y="955788"/>
                </a:cubicBezTo>
                <a:lnTo>
                  <a:pt x="1651000" y="958963"/>
                </a:lnTo>
                <a:cubicBezTo>
                  <a:pt x="1663873" y="961109"/>
                  <a:pt x="1670909" y="961761"/>
                  <a:pt x="1682750" y="965313"/>
                </a:cubicBezTo>
                <a:cubicBezTo>
                  <a:pt x="1689161" y="967236"/>
                  <a:pt x="1695450" y="969546"/>
                  <a:pt x="1701800" y="971663"/>
                </a:cubicBezTo>
                <a:lnTo>
                  <a:pt x="1720850" y="978013"/>
                </a:lnTo>
                <a:lnTo>
                  <a:pt x="1739900" y="984363"/>
                </a:lnTo>
                <a:cubicBezTo>
                  <a:pt x="1743075" y="985421"/>
                  <a:pt x="1746112" y="987065"/>
                  <a:pt x="1749425" y="987538"/>
                </a:cubicBezTo>
                <a:lnTo>
                  <a:pt x="1771650" y="990713"/>
                </a:lnTo>
                <a:cubicBezTo>
                  <a:pt x="1810793" y="1003761"/>
                  <a:pt x="1782760" y="995643"/>
                  <a:pt x="1876425" y="990713"/>
                </a:cubicBezTo>
                <a:cubicBezTo>
                  <a:pt x="1889166" y="990042"/>
                  <a:pt x="1902235" y="988050"/>
                  <a:pt x="1914525" y="984363"/>
                </a:cubicBezTo>
                <a:cubicBezTo>
                  <a:pt x="1920936" y="982440"/>
                  <a:pt x="1927225" y="980130"/>
                  <a:pt x="1933575" y="978013"/>
                </a:cubicBezTo>
                <a:lnTo>
                  <a:pt x="1943100" y="974838"/>
                </a:lnTo>
                <a:cubicBezTo>
                  <a:pt x="1946275" y="973780"/>
                  <a:pt x="1949632" y="973160"/>
                  <a:pt x="1952625" y="971663"/>
                </a:cubicBezTo>
                <a:cubicBezTo>
                  <a:pt x="1956858" y="969546"/>
                  <a:pt x="1960931" y="967071"/>
                  <a:pt x="1965325" y="965313"/>
                </a:cubicBezTo>
                <a:cubicBezTo>
                  <a:pt x="1971540" y="962827"/>
                  <a:pt x="1978025" y="961080"/>
                  <a:pt x="1984375" y="958963"/>
                </a:cubicBezTo>
                <a:cubicBezTo>
                  <a:pt x="1998040" y="954408"/>
                  <a:pt x="1990653" y="956600"/>
                  <a:pt x="2006600" y="952613"/>
                </a:cubicBezTo>
                <a:cubicBezTo>
                  <a:pt x="2021694" y="942550"/>
                  <a:pt x="2012505" y="947470"/>
                  <a:pt x="2035175" y="939913"/>
                </a:cubicBezTo>
                <a:cubicBezTo>
                  <a:pt x="2038350" y="938855"/>
                  <a:pt x="2041915" y="938594"/>
                  <a:pt x="2044700" y="936738"/>
                </a:cubicBezTo>
                <a:cubicBezTo>
                  <a:pt x="2047875" y="934621"/>
                  <a:pt x="2050738" y="931938"/>
                  <a:pt x="2054225" y="930388"/>
                </a:cubicBezTo>
                <a:cubicBezTo>
                  <a:pt x="2060342" y="927670"/>
                  <a:pt x="2067706" y="927751"/>
                  <a:pt x="2073275" y="924038"/>
                </a:cubicBezTo>
                <a:cubicBezTo>
                  <a:pt x="2076450" y="921921"/>
                  <a:pt x="2079387" y="919395"/>
                  <a:pt x="2082800" y="917688"/>
                </a:cubicBezTo>
                <a:cubicBezTo>
                  <a:pt x="2085793" y="916191"/>
                  <a:pt x="2089399" y="916138"/>
                  <a:pt x="2092325" y="914513"/>
                </a:cubicBezTo>
                <a:cubicBezTo>
                  <a:pt x="2098996" y="910807"/>
                  <a:pt x="2105025" y="906046"/>
                  <a:pt x="2111375" y="901813"/>
                </a:cubicBezTo>
                <a:lnTo>
                  <a:pt x="2130425" y="889113"/>
                </a:lnTo>
                <a:cubicBezTo>
                  <a:pt x="2133600" y="886996"/>
                  <a:pt x="2136537" y="884470"/>
                  <a:pt x="2139950" y="882763"/>
                </a:cubicBezTo>
                <a:cubicBezTo>
                  <a:pt x="2144183" y="880646"/>
                  <a:pt x="2148591" y="878848"/>
                  <a:pt x="2152650" y="876413"/>
                </a:cubicBezTo>
                <a:cubicBezTo>
                  <a:pt x="2179943" y="860037"/>
                  <a:pt x="2162066" y="866924"/>
                  <a:pt x="2181225" y="860538"/>
                </a:cubicBezTo>
                <a:cubicBezTo>
                  <a:pt x="2185458" y="857363"/>
                  <a:pt x="2189907" y="854457"/>
                  <a:pt x="2193925" y="851013"/>
                </a:cubicBezTo>
                <a:cubicBezTo>
                  <a:pt x="2197334" y="848091"/>
                  <a:pt x="2199714" y="843979"/>
                  <a:pt x="2203450" y="841488"/>
                </a:cubicBezTo>
                <a:cubicBezTo>
                  <a:pt x="2206235" y="839632"/>
                  <a:pt x="2209982" y="839810"/>
                  <a:pt x="2212975" y="838313"/>
                </a:cubicBezTo>
                <a:cubicBezTo>
                  <a:pt x="2216388" y="836606"/>
                  <a:pt x="2219087" y="833670"/>
                  <a:pt x="2222500" y="831963"/>
                </a:cubicBezTo>
                <a:cubicBezTo>
                  <a:pt x="2225493" y="830466"/>
                  <a:pt x="2229099" y="830413"/>
                  <a:pt x="2232025" y="828788"/>
                </a:cubicBezTo>
                <a:cubicBezTo>
                  <a:pt x="2238696" y="825082"/>
                  <a:pt x="2244725" y="820321"/>
                  <a:pt x="2251075" y="816088"/>
                </a:cubicBezTo>
                <a:cubicBezTo>
                  <a:pt x="2254250" y="813971"/>
                  <a:pt x="2257902" y="812436"/>
                  <a:pt x="2260600" y="809738"/>
                </a:cubicBezTo>
                <a:cubicBezTo>
                  <a:pt x="2275521" y="794817"/>
                  <a:pt x="2266389" y="802704"/>
                  <a:pt x="2289175" y="787513"/>
                </a:cubicBezTo>
                <a:lnTo>
                  <a:pt x="2298700" y="781163"/>
                </a:lnTo>
                <a:cubicBezTo>
                  <a:pt x="2300817" y="777988"/>
                  <a:pt x="2302178" y="774151"/>
                  <a:pt x="2305050" y="771638"/>
                </a:cubicBezTo>
                <a:cubicBezTo>
                  <a:pt x="2310793" y="766612"/>
                  <a:pt x="2324100" y="758938"/>
                  <a:pt x="2324100" y="758938"/>
                </a:cubicBezTo>
                <a:cubicBezTo>
                  <a:pt x="2342298" y="731641"/>
                  <a:pt x="2318067" y="763765"/>
                  <a:pt x="2339975" y="746238"/>
                </a:cubicBezTo>
                <a:cubicBezTo>
                  <a:pt x="2342955" y="743854"/>
                  <a:pt x="2343627" y="739411"/>
                  <a:pt x="2346325" y="736713"/>
                </a:cubicBezTo>
                <a:cubicBezTo>
                  <a:pt x="2349023" y="734015"/>
                  <a:pt x="2352675" y="732480"/>
                  <a:pt x="2355850" y="730363"/>
                </a:cubicBezTo>
                <a:cubicBezTo>
                  <a:pt x="2370406" y="708528"/>
                  <a:pt x="2361310" y="713726"/>
                  <a:pt x="2378075" y="708138"/>
                </a:cubicBezTo>
                <a:cubicBezTo>
                  <a:pt x="2384256" y="689595"/>
                  <a:pt x="2376414" y="706624"/>
                  <a:pt x="2390775" y="692263"/>
                </a:cubicBezTo>
                <a:cubicBezTo>
                  <a:pt x="2411942" y="671096"/>
                  <a:pt x="2381250" y="693321"/>
                  <a:pt x="2406650" y="676388"/>
                </a:cubicBezTo>
                <a:cubicBezTo>
                  <a:pt x="2421467" y="654163"/>
                  <a:pt x="2413000" y="661571"/>
                  <a:pt x="2428875" y="650988"/>
                </a:cubicBezTo>
                <a:cubicBezTo>
                  <a:pt x="2430992" y="647813"/>
                  <a:pt x="2432245" y="643847"/>
                  <a:pt x="2435225" y="641463"/>
                </a:cubicBezTo>
                <a:cubicBezTo>
                  <a:pt x="2437838" y="639372"/>
                  <a:pt x="2441824" y="639913"/>
                  <a:pt x="2444750" y="638288"/>
                </a:cubicBezTo>
                <a:cubicBezTo>
                  <a:pt x="2451421" y="634582"/>
                  <a:pt x="2458404" y="630984"/>
                  <a:pt x="2463800" y="625588"/>
                </a:cubicBezTo>
                <a:cubicBezTo>
                  <a:pt x="2475692" y="613696"/>
                  <a:pt x="2469065" y="617483"/>
                  <a:pt x="2482850" y="612888"/>
                </a:cubicBezTo>
                <a:cubicBezTo>
                  <a:pt x="2484967" y="609713"/>
                  <a:pt x="2486757" y="606294"/>
                  <a:pt x="2489200" y="603363"/>
                </a:cubicBezTo>
                <a:cubicBezTo>
                  <a:pt x="2496321" y="594818"/>
                  <a:pt x="2500570" y="594448"/>
                  <a:pt x="2505075" y="584313"/>
                </a:cubicBezTo>
                <a:cubicBezTo>
                  <a:pt x="2507793" y="578196"/>
                  <a:pt x="2509308" y="571613"/>
                  <a:pt x="2511425" y="565263"/>
                </a:cubicBezTo>
                <a:lnTo>
                  <a:pt x="2514600" y="555738"/>
                </a:lnTo>
                <a:cubicBezTo>
                  <a:pt x="2515658" y="552563"/>
                  <a:pt x="2516963" y="549460"/>
                  <a:pt x="2517775" y="546213"/>
                </a:cubicBezTo>
                <a:cubicBezTo>
                  <a:pt x="2518833" y="541980"/>
                  <a:pt x="2519751" y="537709"/>
                  <a:pt x="2520950" y="533513"/>
                </a:cubicBezTo>
                <a:cubicBezTo>
                  <a:pt x="2521869" y="530295"/>
                  <a:pt x="2523244" y="527217"/>
                  <a:pt x="2524125" y="523988"/>
                </a:cubicBezTo>
                <a:cubicBezTo>
                  <a:pt x="2534868" y="484599"/>
                  <a:pt x="2526342" y="510987"/>
                  <a:pt x="2533650" y="489063"/>
                </a:cubicBezTo>
                <a:cubicBezTo>
                  <a:pt x="2534708" y="479538"/>
                  <a:pt x="2536090" y="470043"/>
                  <a:pt x="2536825" y="460488"/>
                </a:cubicBezTo>
                <a:cubicBezTo>
                  <a:pt x="2538207" y="442518"/>
                  <a:pt x="2537669" y="424384"/>
                  <a:pt x="2540000" y="406513"/>
                </a:cubicBezTo>
                <a:cubicBezTo>
                  <a:pt x="2540866" y="399876"/>
                  <a:pt x="2544727" y="393957"/>
                  <a:pt x="2546350" y="387463"/>
                </a:cubicBezTo>
                <a:cubicBezTo>
                  <a:pt x="2547408" y="383230"/>
                  <a:pt x="2548578" y="379023"/>
                  <a:pt x="2549525" y="374763"/>
                </a:cubicBezTo>
                <a:cubicBezTo>
                  <a:pt x="2560884" y="323646"/>
                  <a:pt x="2542622" y="402926"/>
                  <a:pt x="2555875" y="336663"/>
                </a:cubicBezTo>
                <a:cubicBezTo>
                  <a:pt x="2556531" y="333381"/>
                  <a:pt x="2558238" y="330385"/>
                  <a:pt x="2559050" y="327138"/>
                </a:cubicBezTo>
                <a:cubicBezTo>
                  <a:pt x="2560359" y="321903"/>
                  <a:pt x="2560916" y="316498"/>
                  <a:pt x="2562225" y="311263"/>
                </a:cubicBezTo>
                <a:cubicBezTo>
                  <a:pt x="2563037" y="308016"/>
                  <a:pt x="2564481" y="304956"/>
                  <a:pt x="2565400" y="301738"/>
                </a:cubicBezTo>
                <a:cubicBezTo>
                  <a:pt x="2566599" y="297542"/>
                  <a:pt x="2567376" y="293234"/>
                  <a:pt x="2568575" y="289038"/>
                </a:cubicBezTo>
                <a:cubicBezTo>
                  <a:pt x="2569494" y="285820"/>
                  <a:pt x="2570831" y="282731"/>
                  <a:pt x="2571750" y="279513"/>
                </a:cubicBezTo>
                <a:cubicBezTo>
                  <a:pt x="2573106" y="274766"/>
                  <a:pt x="2575562" y="262363"/>
                  <a:pt x="2578100" y="257288"/>
                </a:cubicBezTo>
                <a:cubicBezTo>
                  <a:pt x="2579807" y="253875"/>
                  <a:pt x="2582333" y="250938"/>
                  <a:pt x="2584450" y="247763"/>
                </a:cubicBezTo>
                <a:cubicBezTo>
                  <a:pt x="2585467" y="243694"/>
                  <a:pt x="2588523" y="230093"/>
                  <a:pt x="2590800" y="225538"/>
                </a:cubicBezTo>
                <a:cubicBezTo>
                  <a:pt x="2592507" y="222125"/>
                  <a:pt x="2595443" y="219426"/>
                  <a:pt x="2597150" y="216013"/>
                </a:cubicBezTo>
                <a:cubicBezTo>
                  <a:pt x="2599688" y="210938"/>
                  <a:pt x="2602144" y="198535"/>
                  <a:pt x="2603500" y="193788"/>
                </a:cubicBezTo>
                <a:cubicBezTo>
                  <a:pt x="2608820" y="175167"/>
                  <a:pt x="2603748" y="193291"/>
                  <a:pt x="2613025" y="174738"/>
                </a:cubicBezTo>
                <a:cubicBezTo>
                  <a:pt x="2614522" y="171745"/>
                  <a:pt x="2614575" y="168139"/>
                  <a:pt x="2616200" y="165213"/>
                </a:cubicBezTo>
                <a:cubicBezTo>
                  <a:pt x="2619906" y="158542"/>
                  <a:pt x="2625487" y="152989"/>
                  <a:pt x="2628900" y="146163"/>
                </a:cubicBezTo>
                <a:cubicBezTo>
                  <a:pt x="2631017" y="141930"/>
                  <a:pt x="2633386" y="137813"/>
                  <a:pt x="2635250" y="133463"/>
                </a:cubicBezTo>
                <a:cubicBezTo>
                  <a:pt x="2636568" y="130387"/>
                  <a:pt x="2636800" y="126864"/>
                  <a:pt x="2638425" y="123938"/>
                </a:cubicBezTo>
                <a:cubicBezTo>
                  <a:pt x="2658844" y="87183"/>
                  <a:pt x="2642652" y="118503"/>
                  <a:pt x="2660650" y="95363"/>
                </a:cubicBezTo>
                <a:cubicBezTo>
                  <a:pt x="2680596" y="69719"/>
                  <a:pt x="2664436" y="82256"/>
                  <a:pt x="2682875" y="69963"/>
                </a:cubicBezTo>
                <a:cubicBezTo>
                  <a:pt x="2699808" y="44563"/>
                  <a:pt x="2677583" y="75255"/>
                  <a:pt x="2698750" y="54088"/>
                </a:cubicBezTo>
                <a:cubicBezTo>
                  <a:pt x="2701448" y="51390"/>
                  <a:pt x="2702402" y="47261"/>
                  <a:pt x="2705100" y="44563"/>
                </a:cubicBezTo>
                <a:cubicBezTo>
                  <a:pt x="2707798" y="41865"/>
                  <a:pt x="2711773" y="40748"/>
                  <a:pt x="2714625" y="38213"/>
                </a:cubicBezTo>
                <a:cubicBezTo>
                  <a:pt x="2762911" y="-4708"/>
                  <a:pt x="2715142" y="30017"/>
                  <a:pt x="2743200" y="15988"/>
                </a:cubicBezTo>
                <a:cubicBezTo>
                  <a:pt x="2773389" y="894"/>
                  <a:pt x="2722628" y="19670"/>
                  <a:pt x="2771775" y="3288"/>
                </a:cubicBezTo>
                <a:lnTo>
                  <a:pt x="2781300" y="113"/>
                </a:lnTo>
                <a:cubicBezTo>
                  <a:pt x="2784454" y="299"/>
                  <a:pt x="2828235" y="-1820"/>
                  <a:pt x="2844800" y="6463"/>
                </a:cubicBezTo>
                <a:cubicBezTo>
                  <a:pt x="2848213" y="8170"/>
                  <a:pt x="2851150" y="10696"/>
                  <a:pt x="2854325" y="12813"/>
                </a:cubicBezTo>
                <a:cubicBezTo>
                  <a:pt x="2877016" y="46850"/>
                  <a:pt x="2841679" y="-4807"/>
                  <a:pt x="2870200" y="31863"/>
                </a:cubicBezTo>
                <a:cubicBezTo>
                  <a:pt x="2874885" y="37887"/>
                  <a:pt x="2878667" y="44563"/>
                  <a:pt x="2882900" y="50913"/>
                </a:cubicBezTo>
                <a:cubicBezTo>
                  <a:pt x="2885017" y="54088"/>
                  <a:pt x="2888043" y="56818"/>
                  <a:pt x="2889250" y="60438"/>
                </a:cubicBezTo>
                <a:lnTo>
                  <a:pt x="2898775" y="89013"/>
                </a:lnTo>
                <a:lnTo>
                  <a:pt x="2901950" y="98538"/>
                </a:lnTo>
                <a:cubicBezTo>
                  <a:pt x="2900892" y="118646"/>
                  <a:pt x="2900519" y="138803"/>
                  <a:pt x="2898775" y="158863"/>
                </a:cubicBezTo>
                <a:cubicBezTo>
                  <a:pt x="2898103" y="166590"/>
                  <a:pt x="2890650" y="185012"/>
                  <a:pt x="2889250" y="190613"/>
                </a:cubicBezTo>
                <a:cubicBezTo>
                  <a:pt x="2879324" y="230315"/>
                  <a:pt x="2892010" y="180954"/>
                  <a:pt x="2882900" y="212838"/>
                </a:cubicBezTo>
                <a:cubicBezTo>
                  <a:pt x="2873303" y="246427"/>
                  <a:pt x="2888465" y="199317"/>
                  <a:pt x="2873375" y="244588"/>
                </a:cubicBezTo>
                <a:cubicBezTo>
                  <a:pt x="2872317" y="247763"/>
                  <a:pt x="2872056" y="251328"/>
                  <a:pt x="2870200" y="254113"/>
                </a:cubicBezTo>
                <a:cubicBezTo>
                  <a:pt x="2855009" y="276899"/>
                  <a:pt x="2862896" y="267767"/>
                  <a:pt x="2847975" y="282688"/>
                </a:cubicBezTo>
                <a:cubicBezTo>
                  <a:pt x="2846917" y="285863"/>
                  <a:pt x="2846425" y="289287"/>
                  <a:pt x="2844800" y="292213"/>
                </a:cubicBezTo>
                <a:cubicBezTo>
                  <a:pt x="2835306" y="309303"/>
                  <a:pt x="2834145" y="309218"/>
                  <a:pt x="2822575" y="320788"/>
                </a:cubicBezTo>
                <a:cubicBezTo>
                  <a:pt x="2814595" y="344729"/>
                  <a:pt x="2826288" y="316147"/>
                  <a:pt x="2809875" y="336663"/>
                </a:cubicBezTo>
                <a:cubicBezTo>
                  <a:pt x="2792348" y="358571"/>
                  <a:pt x="2824472" y="334340"/>
                  <a:pt x="2797175" y="352538"/>
                </a:cubicBezTo>
                <a:cubicBezTo>
                  <a:pt x="2790248" y="373320"/>
                  <a:pt x="2799869" y="352923"/>
                  <a:pt x="2784475" y="365238"/>
                </a:cubicBezTo>
                <a:cubicBezTo>
                  <a:pt x="2781495" y="367622"/>
                  <a:pt x="2780823" y="372065"/>
                  <a:pt x="2778125" y="374763"/>
                </a:cubicBezTo>
                <a:cubicBezTo>
                  <a:pt x="2775427" y="377461"/>
                  <a:pt x="2771775" y="378996"/>
                  <a:pt x="2768600" y="381113"/>
                </a:cubicBezTo>
                <a:cubicBezTo>
                  <a:pt x="2760133" y="406513"/>
                  <a:pt x="2772833" y="376880"/>
                  <a:pt x="2755900" y="393813"/>
                </a:cubicBezTo>
                <a:cubicBezTo>
                  <a:pt x="2753533" y="396180"/>
                  <a:pt x="2754816" y="400725"/>
                  <a:pt x="2752725" y="403338"/>
                </a:cubicBezTo>
                <a:cubicBezTo>
                  <a:pt x="2750341" y="406318"/>
                  <a:pt x="2746375" y="407571"/>
                  <a:pt x="2743200" y="409688"/>
                </a:cubicBezTo>
                <a:cubicBezTo>
                  <a:pt x="2741083" y="412863"/>
                  <a:pt x="2739548" y="416515"/>
                  <a:pt x="2736850" y="419213"/>
                </a:cubicBezTo>
                <a:cubicBezTo>
                  <a:pt x="2734152" y="421911"/>
                  <a:pt x="2729838" y="422691"/>
                  <a:pt x="2727325" y="425563"/>
                </a:cubicBezTo>
                <a:cubicBezTo>
                  <a:pt x="2706347" y="449538"/>
                  <a:pt x="2724681" y="441261"/>
                  <a:pt x="2705100" y="447788"/>
                </a:cubicBezTo>
                <a:cubicBezTo>
                  <a:pt x="2704042" y="450963"/>
                  <a:pt x="2704292" y="454946"/>
                  <a:pt x="2701925" y="457313"/>
                </a:cubicBezTo>
                <a:cubicBezTo>
                  <a:pt x="2696529" y="462709"/>
                  <a:pt x="2682875" y="470013"/>
                  <a:pt x="2682875" y="470013"/>
                </a:cubicBezTo>
                <a:cubicBezTo>
                  <a:pt x="2681817" y="473188"/>
                  <a:pt x="2681197" y="476545"/>
                  <a:pt x="2679700" y="479538"/>
                </a:cubicBezTo>
                <a:cubicBezTo>
                  <a:pt x="2675280" y="488379"/>
                  <a:pt x="2670847" y="491566"/>
                  <a:pt x="2663825" y="498588"/>
                </a:cubicBezTo>
                <a:cubicBezTo>
                  <a:pt x="2655845" y="522529"/>
                  <a:pt x="2667538" y="493947"/>
                  <a:pt x="2651125" y="514463"/>
                </a:cubicBezTo>
                <a:cubicBezTo>
                  <a:pt x="2649034" y="517076"/>
                  <a:pt x="2649806" y="521203"/>
                  <a:pt x="2647950" y="523988"/>
                </a:cubicBezTo>
                <a:cubicBezTo>
                  <a:pt x="2645459" y="527724"/>
                  <a:pt x="2641182" y="529969"/>
                  <a:pt x="2638425" y="533513"/>
                </a:cubicBezTo>
                <a:cubicBezTo>
                  <a:pt x="2618479" y="559157"/>
                  <a:pt x="2634639" y="546620"/>
                  <a:pt x="2616200" y="558913"/>
                </a:cubicBezTo>
                <a:cubicBezTo>
                  <a:pt x="2611967" y="565263"/>
                  <a:pt x="2605913" y="570723"/>
                  <a:pt x="2603500" y="577963"/>
                </a:cubicBezTo>
                <a:cubicBezTo>
                  <a:pt x="2602442" y="581138"/>
                  <a:pt x="2601950" y="584562"/>
                  <a:pt x="2600325" y="587488"/>
                </a:cubicBezTo>
                <a:cubicBezTo>
                  <a:pt x="2596619" y="594159"/>
                  <a:pt x="2590038" y="599298"/>
                  <a:pt x="2587625" y="606538"/>
                </a:cubicBezTo>
                <a:cubicBezTo>
                  <a:pt x="2586567" y="609713"/>
                  <a:pt x="2586075" y="613137"/>
                  <a:pt x="2584450" y="616063"/>
                </a:cubicBezTo>
                <a:cubicBezTo>
                  <a:pt x="2580744" y="622734"/>
                  <a:pt x="2574163" y="627873"/>
                  <a:pt x="2571750" y="635113"/>
                </a:cubicBezTo>
                <a:cubicBezTo>
                  <a:pt x="2570692" y="638288"/>
                  <a:pt x="2570666" y="642025"/>
                  <a:pt x="2568575" y="644638"/>
                </a:cubicBezTo>
                <a:cubicBezTo>
                  <a:pt x="2566191" y="647618"/>
                  <a:pt x="2562225" y="648871"/>
                  <a:pt x="2559050" y="650988"/>
                </a:cubicBezTo>
                <a:cubicBezTo>
                  <a:pt x="2555741" y="660914"/>
                  <a:pt x="2552533" y="673325"/>
                  <a:pt x="2543175" y="679563"/>
                </a:cubicBezTo>
                <a:lnTo>
                  <a:pt x="2533650" y="685913"/>
                </a:lnTo>
                <a:cubicBezTo>
                  <a:pt x="2530341" y="695839"/>
                  <a:pt x="2527133" y="708250"/>
                  <a:pt x="2517775" y="714488"/>
                </a:cubicBezTo>
                <a:lnTo>
                  <a:pt x="2508250" y="720838"/>
                </a:lnTo>
                <a:cubicBezTo>
                  <a:pt x="2502069" y="739381"/>
                  <a:pt x="2509911" y="722352"/>
                  <a:pt x="2495550" y="736713"/>
                </a:cubicBezTo>
                <a:cubicBezTo>
                  <a:pt x="2492852" y="739411"/>
                  <a:pt x="2491643" y="743307"/>
                  <a:pt x="2489200" y="746238"/>
                </a:cubicBezTo>
                <a:cubicBezTo>
                  <a:pt x="2481560" y="755405"/>
                  <a:pt x="2479516" y="755869"/>
                  <a:pt x="2470150" y="762113"/>
                </a:cubicBezTo>
                <a:cubicBezTo>
                  <a:pt x="2468033" y="765288"/>
                  <a:pt x="2466672" y="769125"/>
                  <a:pt x="2463800" y="771638"/>
                </a:cubicBezTo>
                <a:cubicBezTo>
                  <a:pt x="2458057" y="776664"/>
                  <a:pt x="2444750" y="784338"/>
                  <a:pt x="2444750" y="784338"/>
                </a:cubicBezTo>
                <a:cubicBezTo>
                  <a:pt x="2431665" y="803965"/>
                  <a:pt x="2446193" y="784819"/>
                  <a:pt x="2428875" y="800213"/>
                </a:cubicBezTo>
                <a:cubicBezTo>
                  <a:pt x="2422163" y="806179"/>
                  <a:pt x="2414806" y="811791"/>
                  <a:pt x="2409825" y="819263"/>
                </a:cubicBezTo>
                <a:cubicBezTo>
                  <a:pt x="2407708" y="822438"/>
                  <a:pt x="2406173" y="826090"/>
                  <a:pt x="2403475" y="828788"/>
                </a:cubicBezTo>
                <a:cubicBezTo>
                  <a:pt x="2400777" y="831486"/>
                  <a:pt x="2397125" y="833021"/>
                  <a:pt x="2393950" y="835138"/>
                </a:cubicBezTo>
                <a:cubicBezTo>
                  <a:pt x="2377017" y="860538"/>
                  <a:pt x="2399242" y="829846"/>
                  <a:pt x="2378075" y="851013"/>
                </a:cubicBezTo>
                <a:cubicBezTo>
                  <a:pt x="2375377" y="853711"/>
                  <a:pt x="2374168" y="857607"/>
                  <a:pt x="2371725" y="860538"/>
                </a:cubicBezTo>
                <a:cubicBezTo>
                  <a:pt x="2368850" y="863987"/>
                  <a:pt x="2364957" y="866519"/>
                  <a:pt x="2362200" y="870063"/>
                </a:cubicBezTo>
                <a:cubicBezTo>
                  <a:pt x="2344368" y="892989"/>
                  <a:pt x="2358176" y="886221"/>
                  <a:pt x="2339975" y="892288"/>
                </a:cubicBezTo>
                <a:cubicBezTo>
                  <a:pt x="2333794" y="910831"/>
                  <a:pt x="2341636" y="893802"/>
                  <a:pt x="2327275" y="908163"/>
                </a:cubicBezTo>
                <a:cubicBezTo>
                  <a:pt x="2324577" y="910861"/>
                  <a:pt x="2323368" y="914757"/>
                  <a:pt x="2320925" y="917688"/>
                </a:cubicBezTo>
                <a:cubicBezTo>
                  <a:pt x="2311793" y="928646"/>
                  <a:pt x="2304050" y="930214"/>
                  <a:pt x="2298700" y="946263"/>
                </a:cubicBezTo>
                <a:lnTo>
                  <a:pt x="2286000" y="984363"/>
                </a:lnTo>
                <a:cubicBezTo>
                  <a:pt x="2284942" y="987538"/>
                  <a:pt x="2284681" y="991103"/>
                  <a:pt x="2282825" y="993888"/>
                </a:cubicBezTo>
                <a:lnTo>
                  <a:pt x="2276475" y="1003413"/>
                </a:lnTo>
                <a:cubicBezTo>
                  <a:pt x="2279731" y="1045743"/>
                  <a:pt x="2279650" y="1030889"/>
                  <a:pt x="2279650" y="1047863"/>
                </a:cubicBezTo>
              </a:path>
            </a:pathLst>
          </a:custGeom>
          <a:noFill/>
          <a:ln w="38100">
            <a:solidFill>
              <a:schemeClr val="bg1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9666"/>
          </a:p>
        </p:txBody>
      </p:sp>
      <p:sp>
        <p:nvSpPr>
          <p:cNvPr id="25" name="Freeform 24"/>
          <p:cNvSpPr/>
          <p:nvPr/>
        </p:nvSpPr>
        <p:spPr>
          <a:xfrm>
            <a:off x="15306822" y="5199940"/>
            <a:ext cx="3835733" cy="3458410"/>
          </a:xfrm>
          <a:custGeom>
            <a:avLst/>
            <a:gdLst>
              <a:gd name="connsiteX0" fmla="*/ 0 w 1956606"/>
              <a:gd name="connsiteY0" fmla="*/ 1022350 h 1638300"/>
              <a:gd name="connsiteX1" fmla="*/ 34925 w 1956606"/>
              <a:gd name="connsiteY1" fmla="*/ 1044575 h 1638300"/>
              <a:gd name="connsiteX2" fmla="*/ 44450 w 1956606"/>
              <a:gd name="connsiteY2" fmla="*/ 1050925 h 1638300"/>
              <a:gd name="connsiteX3" fmla="*/ 76200 w 1956606"/>
              <a:gd name="connsiteY3" fmla="*/ 1060450 h 1638300"/>
              <a:gd name="connsiteX4" fmla="*/ 117475 w 1956606"/>
              <a:gd name="connsiteY4" fmla="*/ 1063625 h 1638300"/>
              <a:gd name="connsiteX5" fmla="*/ 133350 w 1956606"/>
              <a:gd name="connsiteY5" fmla="*/ 1066800 h 1638300"/>
              <a:gd name="connsiteX6" fmla="*/ 161925 w 1956606"/>
              <a:gd name="connsiteY6" fmla="*/ 1076325 h 1638300"/>
              <a:gd name="connsiteX7" fmla="*/ 171450 w 1956606"/>
              <a:gd name="connsiteY7" fmla="*/ 1079500 h 1638300"/>
              <a:gd name="connsiteX8" fmla="*/ 180975 w 1956606"/>
              <a:gd name="connsiteY8" fmla="*/ 1082675 h 1638300"/>
              <a:gd name="connsiteX9" fmla="*/ 190500 w 1956606"/>
              <a:gd name="connsiteY9" fmla="*/ 1111250 h 1638300"/>
              <a:gd name="connsiteX10" fmla="*/ 193675 w 1956606"/>
              <a:gd name="connsiteY10" fmla="*/ 1120775 h 1638300"/>
              <a:gd name="connsiteX11" fmla="*/ 206375 w 1956606"/>
              <a:gd name="connsiteY11" fmla="*/ 1171575 h 1638300"/>
              <a:gd name="connsiteX12" fmla="*/ 219075 w 1956606"/>
              <a:gd name="connsiteY12" fmla="*/ 1190625 h 1638300"/>
              <a:gd name="connsiteX13" fmla="*/ 222250 w 1956606"/>
              <a:gd name="connsiteY13" fmla="*/ 1200150 h 1638300"/>
              <a:gd name="connsiteX14" fmla="*/ 241300 w 1956606"/>
              <a:gd name="connsiteY14" fmla="*/ 1219200 h 1638300"/>
              <a:gd name="connsiteX15" fmla="*/ 250825 w 1956606"/>
              <a:gd name="connsiteY15" fmla="*/ 1231900 h 1638300"/>
              <a:gd name="connsiteX16" fmla="*/ 260350 w 1956606"/>
              <a:gd name="connsiteY16" fmla="*/ 1235075 h 1638300"/>
              <a:gd name="connsiteX17" fmla="*/ 276225 w 1956606"/>
              <a:gd name="connsiteY17" fmla="*/ 1247775 h 1638300"/>
              <a:gd name="connsiteX18" fmla="*/ 285750 w 1956606"/>
              <a:gd name="connsiteY18" fmla="*/ 1257300 h 1638300"/>
              <a:gd name="connsiteX19" fmla="*/ 304800 w 1956606"/>
              <a:gd name="connsiteY19" fmla="*/ 1270000 h 1638300"/>
              <a:gd name="connsiteX20" fmla="*/ 320675 w 1956606"/>
              <a:gd name="connsiteY20" fmla="*/ 1285875 h 1638300"/>
              <a:gd name="connsiteX21" fmla="*/ 330200 w 1956606"/>
              <a:gd name="connsiteY21" fmla="*/ 1295400 h 1638300"/>
              <a:gd name="connsiteX22" fmla="*/ 339725 w 1956606"/>
              <a:gd name="connsiteY22" fmla="*/ 1298575 h 1638300"/>
              <a:gd name="connsiteX23" fmla="*/ 358775 w 1956606"/>
              <a:gd name="connsiteY23" fmla="*/ 1311275 h 1638300"/>
              <a:gd name="connsiteX24" fmla="*/ 396875 w 1956606"/>
              <a:gd name="connsiteY24" fmla="*/ 1336675 h 1638300"/>
              <a:gd name="connsiteX25" fmla="*/ 406400 w 1956606"/>
              <a:gd name="connsiteY25" fmla="*/ 1343025 h 1638300"/>
              <a:gd name="connsiteX26" fmla="*/ 415925 w 1956606"/>
              <a:gd name="connsiteY26" fmla="*/ 1349375 h 1638300"/>
              <a:gd name="connsiteX27" fmla="*/ 425450 w 1956606"/>
              <a:gd name="connsiteY27" fmla="*/ 1352550 h 1638300"/>
              <a:gd name="connsiteX28" fmla="*/ 441325 w 1956606"/>
              <a:gd name="connsiteY28" fmla="*/ 1365250 h 1638300"/>
              <a:gd name="connsiteX29" fmla="*/ 460375 w 1956606"/>
              <a:gd name="connsiteY29" fmla="*/ 1377950 h 1638300"/>
              <a:gd name="connsiteX30" fmla="*/ 469900 w 1956606"/>
              <a:gd name="connsiteY30" fmla="*/ 1384300 h 1638300"/>
              <a:gd name="connsiteX31" fmla="*/ 488950 w 1956606"/>
              <a:gd name="connsiteY31" fmla="*/ 1390650 h 1638300"/>
              <a:gd name="connsiteX32" fmla="*/ 498475 w 1956606"/>
              <a:gd name="connsiteY32" fmla="*/ 1393825 h 1638300"/>
              <a:gd name="connsiteX33" fmla="*/ 511175 w 1956606"/>
              <a:gd name="connsiteY33" fmla="*/ 1400175 h 1638300"/>
              <a:gd name="connsiteX34" fmla="*/ 520700 w 1956606"/>
              <a:gd name="connsiteY34" fmla="*/ 1403350 h 1638300"/>
              <a:gd name="connsiteX35" fmla="*/ 530225 w 1956606"/>
              <a:gd name="connsiteY35" fmla="*/ 1409700 h 1638300"/>
              <a:gd name="connsiteX36" fmla="*/ 539750 w 1956606"/>
              <a:gd name="connsiteY36" fmla="*/ 1412875 h 1638300"/>
              <a:gd name="connsiteX37" fmla="*/ 558800 w 1956606"/>
              <a:gd name="connsiteY37" fmla="*/ 1425575 h 1638300"/>
              <a:gd name="connsiteX38" fmla="*/ 577850 w 1956606"/>
              <a:gd name="connsiteY38" fmla="*/ 1435100 h 1638300"/>
              <a:gd name="connsiteX39" fmla="*/ 587375 w 1956606"/>
              <a:gd name="connsiteY39" fmla="*/ 1438275 h 1638300"/>
              <a:gd name="connsiteX40" fmla="*/ 606425 w 1956606"/>
              <a:gd name="connsiteY40" fmla="*/ 1450975 h 1638300"/>
              <a:gd name="connsiteX41" fmla="*/ 625475 w 1956606"/>
              <a:gd name="connsiteY41" fmla="*/ 1460500 h 1638300"/>
              <a:gd name="connsiteX42" fmla="*/ 647700 w 1956606"/>
              <a:gd name="connsiteY42" fmla="*/ 1466850 h 1638300"/>
              <a:gd name="connsiteX43" fmla="*/ 666750 w 1956606"/>
              <a:gd name="connsiteY43" fmla="*/ 1473200 h 1638300"/>
              <a:gd name="connsiteX44" fmla="*/ 682625 w 1956606"/>
              <a:gd name="connsiteY44" fmla="*/ 1476375 h 1638300"/>
              <a:gd name="connsiteX45" fmla="*/ 701675 w 1956606"/>
              <a:gd name="connsiteY45" fmla="*/ 1482725 h 1638300"/>
              <a:gd name="connsiteX46" fmla="*/ 758825 w 1956606"/>
              <a:gd name="connsiteY46" fmla="*/ 1489075 h 1638300"/>
              <a:gd name="connsiteX47" fmla="*/ 768350 w 1956606"/>
              <a:gd name="connsiteY47" fmla="*/ 1492250 h 1638300"/>
              <a:gd name="connsiteX48" fmla="*/ 774700 w 1956606"/>
              <a:gd name="connsiteY48" fmla="*/ 1501775 h 1638300"/>
              <a:gd name="connsiteX49" fmla="*/ 784225 w 1956606"/>
              <a:gd name="connsiteY49" fmla="*/ 1511300 h 1638300"/>
              <a:gd name="connsiteX50" fmla="*/ 806450 w 1956606"/>
              <a:gd name="connsiteY50" fmla="*/ 1536700 h 1638300"/>
              <a:gd name="connsiteX51" fmla="*/ 831850 w 1956606"/>
              <a:gd name="connsiteY51" fmla="*/ 1552575 h 1638300"/>
              <a:gd name="connsiteX52" fmla="*/ 850900 w 1956606"/>
              <a:gd name="connsiteY52" fmla="*/ 1565275 h 1638300"/>
              <a:gd name="connsiteX53" fmla="*/ 860425 w 1956606"/>
              <a:gd name="connsiteY53" fmla="*/ 1568450 h 1638300"/>
              <a:gd name="connsiteX54" fmla="*/ 869950 w 1956606"/>
              <a:gd name="connsiteY54" fmla="*/ 1574800 h 1638300"/>
              <a:gd name="connsiteX55" fmla="*/ 889000 w 1956606"/>
              <a:gd name="connsiteY55" fmla="*/ 1581150 h 1638300"/>
              <a:gd name="connsiteX56" fmla="*/ 898525 w 1956606"/>
              <a:gd name="connsiteY56" fmla="*/ 1584325 h 1638300"/>
              <a:gd name="connsiteX57" fmla="*/ 908050 w 1956606"/>
              <a:gd name="connsiteY57" fmla="*/ 1590675 h 1638300"/>
              <a:gd name="connsiteX58" fmla="*/ 933450 w 1956606"/>
              <a:gd name="connsiteY58" fmla="*/ 1597025 h 1638300"/>
              <a:gd name="connsiteX59" fmla="*/ 952500 w 1956606"/>
              <a:gd name="connsiteY59" fmla="*/ 1603375 h 1638300"/>
              <a:gd name="connsiteX60" fmla="*/ 981075 w 1956606"/>
              <a:gd name="connsiteY60" fmla="*/ 1612900 h 1638300"/>
              <a:gd name="connsiteX61" fmla="*/ 990600 w 1956606"/>
              <a:gd name="connsiteY61" fmla="*/ 1616075 h 1638300"/>
              <a:gd name="connsiteX62" fmla="*/ 1009650 w 1956606"/>
              <a:gd name="connsiteY62" fmla="*/ 1619250 h 1638300"/>
              <a:gd name="connsiteX63" fmla="*/ 1031875 w 1956606"/>
              <a:gd name="connsiteY63" fmla="*/ 1622425 h 1638300"/>
              <a:gd name="connsiteX64" fmla="*/ 1044575 w 1956606"/>
              <a:gd name="connsiteY64" fmla="*/ 1625600 h 1638300"/>
              <a:gd name="connsiteX65" fmla="*/ 1069975 w 1956606"/>
              <a:gd name="connsiteY65" fmla="*/ 1628775 h 1638300"/>
              <a:gd name="connsiteX66" fmla="*/ 1146175 w 1956606"/>
              <a:gd name="connsiteY66" fmla="*/ 1638300 h 1638300"/>
              <a:gd name="connsiteX67" fmla="*/ 1390650 w 1956606"/>
              <a:gd name="connsiteY67" fmla="*/ 1638300 h 1638300"/>
              <a:gd name="connsiteX68" fmla="*/ 1628775 w 1956606"/>
              <a:gd name="connsiteY68" fmla="*/ 1635125 h 1638300"/>
              <a:gd name="connsiteX69" fmla="*/ 1689100 w 1956606"/>
              <a:gd name="connsiteY69" fmla="*/ 1628775 h 1638300"/>
              <a:gd name="connsiteX70" fmla="*/ 1704975 w 1956606"/>
              <a:gd name="connsiteY70" fmla="*/ 1625600 h 1638300"/>
              <a:gd name="connsiteX71" fmla="*/ 1724025 w 1956606"/>
              <a:gd name="connsiteY71" fmla="*/ 1619250 h 1638300"/>
              <a:gd name="connsiteX72" fmla="*/ 1733550 w 1956606"/>
              <a:gd name="connsiteY72" fmla="*/ 1612900 h 1638300"/>
              <a:gd name="connsiteX73" fmla="*/ 1739900 w 1956606"/>
              <a:gd name="connsiteY73" fmla="*/ 1603375 h 1638300"/>
              <a:gd name="connsiteX74" fmla="*/ 1746250 w 1956606"/>
              <a:gd name="connsiteY74" fmla="*/ 1562100 h 1638300"/>
              <a:gd name="connsiteX75" fmla="*/ 1752600 w 1956606"/>
              <a:gd name="connsiteY75" fmla="*/ 1533525 h 1638300"/>
              <a:gd name="connsiteX76" fmla="*/ 1762125 w 1956606"/>
              <a:gd name="connsiteY76" fmla="*/ 1514475 h 1638300"/>
              <a:gd name="connsiteX77" fmla="*/ 1765300 w 1956606"/>
              <a:gd name="connsiteY77" fmla="*/ 1504950 h 1638300"/>
              <a:gd name="connsiteX78" fmla="*/ 1784350 w 1956606"/>
              <a:gd name="connsiteY78" fmla="*/ 1498600 h 1638300"/>
              <a:gd name="connsiteX79" fmla="*/ 1812925 w 1956606"/>
              <a:gd name="connsiteY79" fmla="*/ 1485900 h 1638300"/>
              <a:gd name="connsiteX80" fmla="*/ 1822450 w 1956606"/>
              <a:gd name="connsiteY80" fmla="*/ 1482725 h 1638300"/>
              <a:gd name="connsiteX81" fmla="*/ 1841500 w 1956606"/>
              <a:gd name="connsiteY81" fmla="*/ 1470025 h 1638300"/>
              <a:gd name="connsiteX82" fmla="*/ 1847850 w 1956606"/>
              <a:gd name="connsiteY82" fmla="*/ 1460500 h 1638300"/>
              <a:gd name="connsiteX83" fmla="*/ 1857375 w 1956606"/>
              <a:gd name="connsiteY83" fmla="*/ 1454150 h 1638300"/>
              <a:gd name="connsiteX84" fmla="*/ 1873250 w 1956606"/>
              <a:gd name="connsiteY84" fmla="*/ 1435100 h 1638300"/>
              <a:gd name="connsiteX85" fmla="*/ 1879600 w 1956606"/>
              <a:gd name="connsiteY85" fmla="*/ 1416050 h 1638300"/>
              <a:gd name="connsiteX86" fmla="*/ 1882775 w 1956606"/>
              <a:gd name="connsiteY86" fmla="*/ 1406525 h 1638300"/>
              <a:gd name="connsiteX87" fmla="*/ 1889125 w 1956606"/>
              <a:gd name="connsiteY87" fmla="*/ 1330325 h 1638300"/>
              <a:gd name="connsiteX88" fmla="*/ 1885950 w 1956606"/>
              <a:gd name="connsiteY88" fmla="*/ 1219200 h 1638300"/>
              <a:gd name="connsiteX89" fmla="*/ 1873250 w 1956606"/>
              <a:gd name="connsiteY89" fmla="*/ 1168400 h 1638300"/>
              <a:gd name="connsiteX90" fmla="*/ 1866900 w 1956606"/>
              <a:gd name="connsiteY90" fmla="*/ 1146175 h 1638300"/>
              <a:gd name="connsiteX91" fmla="*/ 1860550 w 1956606"/>
              <a:gd name="connsiteY91" fmla="*/ 1136650 h 1638300"/>
              <a:gd name="connsiteX92" fmla="*/ 1857375 w 1956606"/>
              <a:gd name="connsiteY92" fmla="*/ 1127125 h 1638300"/>
              <a:gd name="connsiteX93" fmla="*/ 1844675 w 1956606"/>
              <a:gd name="connsiteY93" fmla="*/ 1108075 h 1638300"/>
              <a:gd name="connsiteX94" fmla="*/ 1841500 w 1956606"/>
              <a:gd name="connsiteY94" fmla="*/ 1098550 h 1638300"/>
              <a:gd name="connsiteX95" fmla="*/ 1835150 w 1956606"/>
              <a:gd name="connsiteY95" fmla="*/ 1089025 h 1638300"/>
              <a:gd name="connsiteX96" fmla="*/ 1831975 w 1956606"/>
              <a:gd name="connsiteY96" fmla="*/ 1079500 h 1638300"/>
              <a:gd name="connsiteX97" fmla="*/ 1819275 w 1956606"/>
              <a:gd name="connsiteY97" fmla="*/ 1060450 h 1638300"/>
              <a:gd name="connsiteX98" fmla="*/ 1806575 w 1956606"/>
              <a:gd name="connsiteY98" fmla="*/ 1041400 h 1638300"/>
              <a:gd name="connsiteX99" fmla="*/ 1800225 w 1956606"/>
              <a:gd name="connsiteY99" fmla="*/ 1031875 h 1638300"/>
              <a:gd name="connsiteX100" fmla="*/ 1793875 w 1956606"/>
              <a:gd name="connsiteY100" fmla="*/ 1022350 h 1638300"/>
              <a:gd name="connsiteX101" fmla="*/ 1784350 w 1956606"/>
              <a:gd name="connsiteY101" fmla="*/ 1009650 h 1638300"/>
              <a:gd name="connsiteX102" fmla="*/ 1774825 w 1956606"/>
              <a:gd name="connsiteY102" fmla="*/ 1003300 h 1638300"/>
              <a:gd name="connsiteX103" fmla="*/ 1762125 w 1956606"/>
              <a:gd name="connsiteY103" fmla="*/ 987425 h 1638300"/>
              <a:gd name="connsiteX104" fmla="*/ 1743075 w 1956606"/>
              <a:gd name="connsiteY104" fmla="*/ 971550 h 1638300"/>
              <a:gd name="connsiteX105" fmla="*/ 1724025 w 1956606"/>
              <a:gd name="connsiteY105" fmla="*/ 965200 h 1638300"/>
              <a:gd name="connsiteX106" fmla="*/ 1714500 w 1956606"/>
              <a:gd name="connsiteY106" fmla="*/ 958850 h 1638300"/>
              <a:gd name="connsiteX107" fmla="*/ 1704975 w 1956606"/>
              <a:gd name="connsiteY107" fmla="*/ 955675 h 1638300"/>
              <a:gd name="connsiteX108" fmla="*/ 1660525 w 1956606"/>
              <a:gd name="connsiteY108" fmla="*/ 949325 h 1638300"/>
              <a:gd name="connsiteX109" fmla="*/ 1616075 w 1956606"/>
              <a:gd name="connsiteY109" fmla="*/ 942975 h 1638300"/>
              <a:gd name="connsiteX110" fmla="*/ 1597025 w 1956606"/>
              <a:gd name="connsiteY110" fmla="*/ 933450 h 1638300"/>
              <a:gd name="connsiteX111" fmla="*/ 1587500 w 1956606"/>
              <a:gd name="connsiteY111" fmla="*/ 923925 h 1638300"/>
              <a:gd name="connsiteX112" fmla="*/ 1577975 w 1956606"/>
              <a:gd name="connsiteY112" fmla="*/ 917575 h 1638300"/>
              <a:gd name="connsiteX113" fmla="*/ 1571625 w 1956606"/>
              <a:gd name="connsiteY113" fmla="*/ 908050 h 1638300"/>
              <a:gd name="connsiteX114" fmla="*/ 1558925 w 1956606"/>
              <a:gd name="connsiteY114" fmla="*/ 879475 h 1638300"/>
              <a:gd name="connsiteX115" fmla="*/ 1546225 w 1956606"/>
              <a:gd name="connsiteY115" fmla="*/ 841375 h 1638300"/>
              <a:gd name="connsiteX116" fmla="*/ 1543050 w 1956606"/>
              <a:gd name="connsiteY116" fmla="*/ 831850 h 1638300"/>
              <a:gd name="connsiteX117" fmla="*/ 1530350 w 1956606"/>
              <a:gd name="connsiteY117" fmla="*/ 812800 h 1638300"/>
              <a:gd name="connsiteX118" fmla="*/ 1524000 w 1956606"/>
              <a:gd name="connsiteY118" fmla="*/ 803275 h 1638300"/>
              <a:gd name="connsiteX119" fmla="*/ 1511300 w 1956606"/>
              <a:gd name="connsiteY119" fmla="*/ 784225 h 1638300"/>
              <a:gd name="connsiteX120" fmla="*/ 1504950 w 1956606"/>
              <a:gd name="connsiteY120" fmla="*/ 774700 h 1638300"/>
              <a:gd name="connsiteX121" fmla="*/ 1476375 w 1956606"/>
              <a:gd name="connsiteY121" fmla="*/ 755650 h 1638300"/>
              <a:gd name="connsiteX122" fmla="*/ 1466850 w 1956606"/>
              <a:gd name="connsiteY122" fmla="*/ 749300 h 1638300"/>
              <a:gd name="connsiteX123" fmla="*/ 1457325 w 1956606"/>
              <a:gd name="connsiteY123" fmla="*/ 746125 h 1638300"/>
              <a:gd name="connsiteX124" fmla="*/ 1438275 w 1956606"/>
              <a:gd name="connsiteY124" fmla="*/ 733425 h 1638300"/>
              <a:gd name="connsiteX125" fmla="*/ 1428750 w 1956606"/>
              <a:gd name="connsiteY125" fmla="*/ 723900 h 1638300"/>
              <a:gd name="connsiteX126" fmla="*/ 1419225 w 1956606"/>
              <a:gd name="connsiteY126" fmla="*/ 720725 h 1638300"/>
              <a:gd name="connsiteX127" fmla="*/ 1400175 w 1956606"/>
              <a:gd name="connsiteY127" fmla="*/ 708025 h 1638300"/>
              <a:gd name="connsiteX128" fmla="*/ 1381125 w 1956606"/>
              <a:gd name="connsiteY128" fmla="*/ 695325 h 1638300"/>
              <a:gd name="connsiteX129" fmla="*/ 1371600 w 1956606"/>
              <a:gd name="connsiteY129" fmla="*/ 688975 h 1638300"/>
              <a:gd name="connsiteX130" fmla="*/ 1362075 w 1956606"/>
              <a:gd name="connsiteY130" fmla="*/ 682625 h 1638300"/>
              <a:gd name="connsiteX131" fmla="*/ 1343025 w 1956606"/>
              <a:gd name="connsiteY131" fmla="*/ 676275 h 1638300"/>
              <a:gd name="connsiteX132" fmla="*/ 1314450 w 1956606"/>
              <a:gd name="connsiteY132" fmla="*/ 682625 h 1638300"/>
              <a:gd name="connsiteX133" fmla="*/ 1292225 w 1956606"/>
              <a:gd name="connsiteY133" fmla="*/ 676275 h 1638300"/>
              <a:gd name="connsiteX134" fmla="*/ 1276350 w 1956606"/>
              <a:gd name="connsiteY134" fmla="*/ 660400 h 1638300"/>
              <a:gd name="connsiteX135" fmla="*/ 1270000 w 1956606"/>
              <a:gd name="connsiteY135" fmla="*/ 650875 h 1638300"/>
              <a:gd name="connsiteX136" fmla="*/ 1241425 w 1956606"/>
              <a:gd name="connsiteY136" fmla="*/ 628650 h 1638300"/>
              <a:gd name="connsiteX137" fmla="*/ 1225550 w 1956606"/>
              <a:gd name="connsiteY137" fmla="*/ 625475 h 1638300"/>
              <a:gd name="connsiteX138" fmla="*/ 1181100 w 1956606"/>
              <a:gd name="connsiteY138" fmla="*/ 628650 h 1638300"/>
              <a:gd name="connsiteX139" fmla="*/ 1162050 w 1956606"/>
              <a:gd name="connsiteY139" fmla="*/ 644525 h 1638300"/>
              <a:gd name="connsiteX140" fmla="*/ 1152525 w 1956606"/>
              <a:gd name="connsiteY140" fmla="*/ 650875 h 1638300"/>
              <a:gd name="connsiteX141" fmla="*/ 1133475 w 1956606"/>
              <a:gd name="connsiteY141" fmla="*/ 663575 h 1638300"/>
              <a:gd name="connsiteX142" fmla="*/ 1120775 w 1956606"/>
              <a:gd name="connsiteY142" fmla="*/ 660400 h 1638300"/>
              <a:gd name="connsiteX143" fmla="*/ 1117600 w 1956606"/>
              <a:gd name="connsiteY143" fmla="*/ 650875 h 1638300"/>
              <a:gd name="connsiteX144" fmla="*/ 1120775 w 1956606"/>
              <a:gd name="connsiteY144" fmla="*/ 568325 h 1638300"/>
              <a:gd name="connsiteX145" fmla="*/ 1136650 w 1956606"/>
              <a:gd name="connsiteY145" fmla="*/ 539750 h 1638300"/>
              <a:gd name="connsiteX146" fmla="*/ 1146175 w 1956606"/>
              <a:gd name="connsiteY146" fmla="*/ 520700 h 1638300"/>
              <a:gd name="connsiteX147" fmla="*/ 1149350 w 1956606"/>
              <a:gd name="connsiteY147" fmla="*/ 511175 h 1638300"/>
              <a:gd name="connsiteX148" fmla="*/ 1155700 w 1956606"/>
              <a:gd name="connsiteY148" fmla="*/ 501650 h 1638300"/>
              <a:gd name="connsiteX149" fmla="*/ 1158875 w 1956606"/>
              <a:gd name="connsiteY149" fmla="*/ 492125 h 1638300"/>
              <a:gd name="connsiteX150" fmla="*/ 1165225 w 1956606"/>
              <a:gd name="connsiteY150" fmla="*/ 482600 h 1638300"/>
              <a:gd name="connsiteX151" fmla="*/ 1168400 w 1956606"/>
              <a:gd name="connsiteY151" fmla="*/ 473075 h 1638300"/>
              <a:gd name="connsiteX152" fmla="*/ 1181100 w 1956606"/>
              <a:gd name="connsiteY152" fmla="*/ 454025 h 1638300"/>
              <a:gd name="connsiteX153" fmla="*/ 1187450 w 1956606"/>
              <a:gd name="connsiteY153" fmla="*/ 444500 h 1638300"/>
              <a:gd name="connsiteX154" fmla="*/ 1193800 w 1956606"/>
              <a:gd name="connsiteY154" fmla="*/ 434975 h 1638300"/>
              <a:gd name="connsiteX155" fmla="*/ 1203325 w 1956606"/>
              <a:gd name="connsiteY155" fmla="*/ 428625 h 1638300"/>
              <a:gd name="connsiteX156" fmla="*/ 1206500 w 1956606"/>
              <a:gd name="connsiteY156" fmla="*/ 419100 h 1638300"/>
              <a:gd name="connsiteX157" fmla="*/ 1225550 w 1956606"/>
              <a:gd name="connsiteY157" fmla="*/ 406400 h 1638300"/>
              <a:gd name="connsiteX158" fmla="*/ 1231900 w 1956606"/>
              <a:gd name="connsiteY158" fmla="*/ 396875 h 1638300"/>
              <a:gd name="connsiteX159" fmla="*/ 1250950 w 1956606"/>
              <a:gd name="connsiteY159" fmla="*/ 390525 h 1638300"/>
              <a:gd name="connsiteX160" fmla="*/ 1260475 w 1956606"/>
              <a:gd name="connsiteY160" fmla="*/ 387350 h 1638300"/>
              <a:gd name="connsiteX161" fmla="*/ 1270000 w 1956606"/>
              <a:gd name="connsiteY161" fmla="*/ 384175 h 1638300"/>
              <a:gd name="connsiteX162" fmla="*/ 1282700 w 1956606"/>
              <a:gd name="connsiteY162" fmla="*/ 381000 h 1638300"/>
              <a:gd name="connsiteX163" fmla="*/ 1330325 w 1956606"/>
              <a:gd name="connsiteY163" fmla="*/ 387350 h 1638300"/>
              <a:gd name="connsiteX164" fmla="*/ 1339850 w 1956606"/>
              <a:gd name="connsiteY164" fmla="*/ 393700 h 1638300"/>
              <a:gd name="connsiteX165" fmla="*/ 1355725 w 1956606"/>
              <a:gd name="connsiteY165" fmla="*/ 409575 h 1638300"/>
              <a:gd name="connsiteX166" fmla="*/ 1362075 w 1956606"/>
              <a:gd name="connsiteY166" fmla="*/ 419100 h 1638300"/>
              <a:gd name="connsiteX167" fmla="*/ 1371600 w 1956606"/>
              <a:gd name="connsiteY167" fmla="*/ 428625 h 1638300"/>
              <a:gd name="connsiteX168" fmla="*/ 1377950 w 1956606"/>
              <a:gd name="connsiteY168" fmla="*/ 438150 h 1638300"/>
              <a:gd name="connsiteX169" fmla="*/ 1387475 w 1956606"/>
              <a:gd name="connsiteY169" fmla="*/ 444500 h 1638300"/>
              <a:gd name="connsiteX170" fmla="*/ 1397000 w 1956606"/>
              <a:gd name="connsiteY170" fmla="*/ 454025 h 1638300"/>
              <a:gd name="connsiteX171" fmla="*/ 1416050 w 1956606"/>
              <a:gd name="connsiteY171" fmla="*/ 460375 h 1638300"/>
              <a:gd name="connsiteX172" fmla="*/ 1425575 w 1956606"/>
              <a:gd name="connsiteY172" fmla="*/ 463550 h 1638300"/>
              <a:gd name="connsiteX173" fmla="*/ 1498600 w 1956606"/>
              <a:gd name="connsiteY173" fmla="*/ 466725 h 1638300"/>
              <a:gd name="connsiteX174" fmla="*/ 1533525 w 1956606"/>
              <a:gd name="connsiteY174" fmla="*/ 473075 h 1638300"/>
              <a:gd name="connsiteX175" fmla="*/ 1577975 w 1956606"/>
              <a:gd name="connsiteY175" fmla="*/ 479425 h 1638300"/>
              <a:gd name="connsiteX176" fmla="*/ 1673225 w 1956606"/>
              <a:gd name="connsiteY176" fmla="*/ 476250 h 1638300"/>
              <a:gd name="connsiteX177" fmla="*/ 1685925 w 1956606"/>
              <a:gd name="connsiteY177" fmla="*/ 473075 h 1638300"/>
              <a:gd name="connsiteX178" fmla="*/ 1714500 w 1956606"/>
              <a:gd name="connsiteY178" fmla="*/ 463550 h 1638300"/>
              <a:gd name="connsiteX179" fmla="*/ 1724025 w 1956606"/>
              <a:gd name="connsiteY179" fmla="*/ 460375 h 1638300"/>
              <a:gd name="connsiteX180" fmla="*/ 1733550 w 1956606"/>
              <a:gd name="connsiteY180" fmla="*/ 457200 h 1638300"/>
              <a:gd name="connsiteX181" fmla="*/ 1743075 w 1956606"/>
              <a:gd name="connsiteY181" fmla="*/ 450850 h 1638300"/>
              <a:gd name="connsiteX182" fmla="*/ 1762125 w 1956606"/>
              <a:gd name="connsiteY182" fmla="*/ 444500 h 1638300"/>
              <a:gd name="connsiteX183" fmla="*/ 1771650 w 1956606"/>
              <a:gd name="connsiteY183" fmla="*/ 441325 h 1638300"/>
              <a:gd name="connsiteX184" fmla="*/ 1800225 w 1956606"/>
              <a:gd name="connsiteY184" fmla="*/ 428625 h 1638300"/>
              <a:gd name="connsiteX185" fmla="*/ 1809750 w 1956606"/>
              <a:gd name="connsiteY185" fmla="*/ 425450 h 1638300"/>
              <a:gd name="connsiteX186" fmla="*/ 1819275 w 1956606"/>
              <a:gd name="connsiteY186" fmla="*/ 419100 h 1638300"/>
              <a:gd name="connsiteX187" fmla="*/ 1838325 w 1956606"/>
              <a:gd name="connsiteY187" fmla="*/ 412750 h 1638300"/>
              <a:gd name="connsiteX188" fmla="*/ 1847850 w 1956606"/>
              <a:gd name="connsiteY188" fmla="*/ 409575 h 1638300"/>
              <a:gd name="connsiteX189" fmla="*/ 1866900 w 1956606"/>
              <a:gd name="connsiteY189" fmla="*/ 400050 h 1638300"/>
              <a:gd name="connsiteX190" fmla="*/ 1885950 w 1956606"/>
              <a:gd name="connsiteY190" fmla="*/ 390525 h 1638300"/>
              <a:gd name="connsiteX191" fmla="*/ 1895475 w 1956606"/>
              <a:gd name="connsiteY191" fmla="*/ 381000 h 1638300"/>
              <a:gd name="connsiteX192" fmla="*/ 1901825 w 1956606"/>
              <a:gd name="connsiteY192" fmla="*/ 371475 h 1638300"/>
              <a:gd name="connsiteX193" fmla="*/ 1911350 w 1956606"/>
              <a:gd name="connsiteY193" fmla="*/ 365125 h 1638300"/>
              <a:gd name="connsiteX194" fmla="*/ 1920875 w 1956606"/>
              <a:gd name="connsiteY194" fmla="*/ 355600 h 1638300"/>
              <a:gd name="connsiteX195" fmla="*/ 1930400 w 1956606"/>
              <a:gd name="connsiteY195" fmla="*/ 349250 h 1638300"/>
              <a:gd name="connsiteX196" fmla="*/ 1939925 w 1956606"/>
              <a:gd name="connsiteY196" fmla="*/ 339725 h 1638300"/>
              <a:gd name="connsiteX197" fmla="*/ 1952625 w 1956606"/>
              <a:gd name="connsiteY197" fmla="*/ 320675 h 1638300"/>
              <a:gd name="connsiteX198" fmla="*/ 1952625 w 1956606"/>
              <a:gd name="connsiteY198" fmla="*/ 200025 h 1638300"/>
              <a:gd name="connsiteX199" fmla="*/ 1946275 w 1956606"/>
              <a:gd name="connsiteY199" fmla="*/ 171450 h 1638300"/>
              <a:gd name="connsiteX200" fmla="*/ 1933575 w 1956606"/>
              <a:gd name="connsiteY200" fmla="*/ 152400 h 1638300"/>
              <a:gd name="connsiteX201" fmla="*/ 1927225 w 1956606"/>
              <a:gd name="connsiteY201" fmla="*/ 142875 h 1638300"/>
              <a:gd name="connsiteX202" fmla="*/ 1920875 w 1956606"/>
              <a:gd name="connsiteY202" fmla="*/ 133350 h 1638300"/>
              <a:gd name="connsiteX203" fmla="*/ 1914525 w 1956606"/>
              <a:gd name="connsiteY203" fmla="*/ 123825 h 1638300"/>
              <a:gd name="connsiteX204" fmla="*/ 1905000 w 1956606"/>
              <a:gd name="connsiteY204" fmla="*/ 117475 h 1638300"/>
              <a:gd name="connsiteX205" fmla="*/ 1889125 w 1956606"/>
              <a:gd name="connsiteY205" fmla="*/ 98425 h 1638300"/>
              <a:gd name="connsiteX206" fmla="*/ 1879600 w 1956606"/>
              <a:gd name="connsiteY206" fmla="*/ 95250 h 1638300"/>
              <a:gd name="connsiteX207" fmla="*/ 1873250 w 1956606"/>
              <a:gd name="connsiteY207" fmla="*/ 85725 h 1638300"/>
              <a:gd name="connsiteX208" fmla="*/ 1863725 w 1956606"/>
              <a:gd name="connsiteY208" fmla="*/ 82550 h 1638300"/>
              <a:gd name="connsiteX209" fmla="*/ 1844675 w 1956606"/>
              <a:gd name="connsiteY209" fmla="*/ 73025 h 1638300"/>
              <a:gd name="connsiteX210" fmla="*/ 1838325 w 1956606"/>
              <a:gd name="connsiteY210" fmla="*/ 63500 h 1638300"/>
              <a:gd name="connsiteX211" fmla="*/ 1819275 w 1956606"/>
              <a:gd name="connsiteY211" fmla="*/ 57150 h 1638300"/>
              <a:gd name="connsiteX212" fmla="*/ 1800225 w 1956606"/>
              <a:gd name="connsiteY212" fmla="*/ 41275 h 1638300"/>
              <a:gd name="connsiteX213" fmla="*/ 1781175 w 1956606"/>
              <a:gd name="connsiteY213" fmla="*/ 31750 h 1638300"/>
              <a:gd name="connsiteX214" fmla="*/ 1774825 w 1956606"/>
              <a:gd name="connsiteY214" fmla="*/ 22225 h 1638300"/>
              <a:gd name="connsiteX215" fmla="*/ 1765300 w 1956606"/>
              <a:gd name="connsiteY215" fmla="*/ 19050 h 1638300"/>
              <a:gd name="connsiteX216" fmla="*/ 1755775 w 1956606"/>
              <a:gd name="connsiteY216" fmla="*/ 12700 h 1638300"/>
              <a:gd name="connsiteX217" fmla="*/ 1739900 w 1956606"/>
              <a:gd name="connsiteY217" fmla="*/ 0 h 16383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  <a:cxn ang="0">
                <a:pos x="connsiteX31" y="connsiteY31"/>
              </a:cxn>
              <a:cxn ang="0">
                <a:pos x="connsiteX32" y="connsiteY32"/>
              </a:cxn>
              <a:cxn ang="0">
                <a:pos x="connsiteX33" y="connsiteY33"/>
              </a:cxn>
              <a:cxn ang="0">
                <a:pos x="connsiteX34" y="connsiteY34"/>
              </a:cxn>
              <a:cxn ang="0">
                <a:pos x="connsiteX35" y="connsiteY35"/>
              </a:cxn>
              <a:cxn ang="0">
                <a:pos x="connsiteX36" y="connsiteY36"/>
              </a:cxn>
              <a:cxn ang="0">
                <a:pos x="connsiteX37" y="connsiteY37"/>
              </a:cxn>
              <a:cxn ang="0">
                <a:pos x="connsiteX38" y="connsiteY38"/>
              </a:cxn>
              <a:cxn ang="0">
                <a:pos x="connsiteX39" y="connsiteY39"/>
              </a:cxn>
              <a:cxn ang="0">
                <a:pos x="connsiteX40" y="connsiteY40"/>
              </a:cxn>
              <a:cxn ang="0">
                <a:pos x="connsiteX41" y="connsiteY41"/>
              </a:cxn>
              <a:cxn ang="0">
                <a:pos x="connsiteX42" y="connsiteY42"/>
              </a:cxn>
              <a:cxn ang="0">
                <a:pos x="connsiteX43" y="connsiteY43"/>
              </a:cxn>
              <a:cxn ang="0">
                <a:pos x="connsiteX44" y="connsiteY44"/>
              </a:cxn>
              <a:cxn ang="0">
                <a:pos x="connsiteX45" y="connsiteY45"/>
              </a:cxn>
              <a:cxn ang="0">
                <a:pos x="connsiteX46" y="connsiteY46"/>
              </a:cxn>
              <a:cxn ang="0">
                <a:pos x="connsiteX47" y="connsiteY47"/>
              </a:cxn>
              <a:cxn ang="0">
                <a:pos x="connsiteX48" y="connsiteY48"/>
              </a:cxn>
              <a:cxn ang="0">
                <a:pos x="connsiteX49" y="connsiteY49"/>
              </a:cxn>
              <a:cxn ang="0">
                <a:pos x="connsiteX50" y="connsiteY50"/>
              </a:cxn>
              <a:cxn ang="0">
                <a:pos x="connsiteX51" y="connsiteY51"/>
              </a:cxn>
              <a:cxn ang="0">
                <a:pos x="connsiteX52" y="connsiteY52"/>
              </a:cxn>
              <a:cxn ang="0">
                <a:pos x="connsiteX53" y="connsiteY53"/>
              </a:cxn>
              <a:cxn ang="0">
                <a:pos x="connsiteX54" y="connsiteY54"/>
              </a:cxn>
              <a:cxn ang="0">
                <a:pos x="connsiteX55" y="connsiteY55"/>
              </a:cxn>
              <a:cxn ang="0">
                <a:pos x="connsiteX56" y="connsiteY56"/>
              </a:cxn>
              <a:cxn ang="0">
                <a:pos x="connsiteX57" y="connsiteY57"/>
              </a:cxn>
              <a:cxn ang="0">
                <a:pos x="connsiteX58" y="connsiteY58"/>
              </a:cxn>
              <a:cxn ang="0">
                <a:pos x="connsiteX59" y="connsiteY59"/>
              </a:cxn>
              <a:cxn ang="0">
                <a:pos x="connsiteX60" y="connsiteY60"/>
              </a:cxn>
              <a:cxn ang="0">
                <a:pos x="connsiteX61" y="connsiteY61"/>
              </a:cxn>
              <a:cxn ang="0">
                <a:pos x="connsiteX62" y="connsiteY62"/>
              </a:cxn>
              <a:cxn ang="0">
                <a:pos x="connsiteX63" y="connsiteY63"/>
              </a:cxn>
              <a:cxn ang="0">
                <a:pos x="connsiteX64" y="connsiteY64"/>
              </a:cxn>
              <a:cxn ang="0">
                <a:pos x="connsiteX65" y="connsiteY65"/>
              </a:cxn>
              <a:cxn ang="0">
                <a:pos x="connsiteX66" y="connsiteY66"/>
              </a:cxn>
              <a:cxn ang="0">
                <a:pos x="connsiteX67" y="connsiteY67"/>
              </a:cxn>
              <a:cxn ang="0">
                <a:pos x="connsiteX68" y="connsiteY68"/>
              </a:cxn>
              <a:cxn ang="0">
                <a:pos x="connsiteX69" y="connsiteY69"/>
              </a:cxn>
              <a:cxn ang="0">
                <a:pos x="connsiteX70" y="connsiteY70"/>
              </a:cxn>
              <a:cxn ang="0">
                <a:pos x="connsiteX71" y="connsiteY71"/>
              </a:cxn>
              <a:cxn ang="0">
                <a:pos x="connsiteX72" y="connsiteY72"/>
              </a:cxn>
              <a:cxn ang="0">
                <a:pos x="connsiteX73" y="connsiteY73"/>
              </a:cxn>
              <a:cxn ang="0">
                <a:pos x="connsiteX74" y="connsiteY74"/>
              </a:cxn>
              <a:cxn ang="0">
                <a:pos x="connsiteX75" y="connsiteY75"/>
              </a:cxn>
              <a:cxn ang="0">
                <a:pos x="connsiteX76" y="connsiteY76"/>
              </a:cxn>
              <a:cxn ang="0">
                <a:pos x="connsiteX77" y="connsiteY77"/>
              </a:cxn>
              <a:cxn ang="0">
                <a:pos x="connsiteX78" y="connsiteY78"/>
              </a:cxn>
              <a:cxn ang="0">
                <a:pos x="connsiteX79" y="connsiteY79"/>
              </a:cxn>
              <a:cxn ang="0">
                <a:pos x="connsiteX80" y="connsiteY80"/>
              </a:cxn>
              <a:cxn ang="0">
                <a:pos x="connsiteX81" y="connsiteY81"/>
              </a:cxn>
              <a:cxn ang="0">
                <a:pos x="connsiteX82" y="connsiteY82"/>
              </a:cxn>
              <a:cxn ang="0">
                <a:pos x="connsiteX83" y="connsiteY83"/>
              </a:cxn>
              <a:cxn ang="0">
                <a:pos x="connsiteX84" y="connsiteY84"/>
              </a:cxn>
              <a:cxn ang="0">
                <a:pos x="connsiteX85" y="connsiteY85"/>
              </a:cxn>
              <a:cxn ang="0">
                <a:pos x="connsiteX86" y="connsiteY86"/>
              </a:cxn>
              <a:cxn ang="0">
                <a:pos x="connsiteX87" y="connsiteY87"/>
              </a:cxn>
              <a:cxn ang="0">
                <a:pos x="connsiteX88" y="connsiteY88"/>
              </a:cxn>
              <a:cxn ang="0">
                <a:pos x="connsiteX89" y="connsiteY89"/>
              </a:cxn>
              <a:cxn ang="0">
                <a:pos x="connsiteX90" y="connsiteY90"/>
              </a:cxn>
              <a:cxn ang="0">
                <a:pos x="connsiteX91" y="connsiteY91"/>
              </a:cxn>
              <a:cxn ang="0">
                <a:pos x="connsiteX92" y="connsiteY92"/>
              </a:cxn>
              <a:cxn ang="0">
                <a:pos x="connsiteX93" y="connsiteY93"/>
              </a:cxn>
              <a:cxn ang="0">
                <a:pos x="connsiteX94" y="connsiteY94"/>
              </a:cxn>
              <a:cxn ang="0">
                <a:pos x="connsiteX95" y="connsiteY95"/>
              </a:cxn>
              <a:cxn ang="0">
                <a:pos x="connsiteX96" y="connsiteY96"/>
              </a:cxn>
              <a:cxn ang="0">
                <a:pos x="connsiteX97" y="connsiteY97"/>
              </a:cxn>
              <a:cxn ang="0">
                <a:pos x="connsiteX98" y="connsiteY98"/>
              </a:cxn>
              <a:cxn ang="0">
                <a:pos x="connsiteX99" y="connsiteY99"/>
              </a:cxn>
              <a:cxn ang="0">
                <a:pos x="connsiteX100" y="connsiteY100"/>
              </a:cxn>
              <a:cxn ang="0">
                <a:pos x="connsiteX101" y="connsiteY101"/>
              </a:cxn>
              <a:cxn ang="0">
                <a:pos x="connsiteX102" y="connsiteY102"/>
              </a:cxn>
              <a:cxn ang="0">
                <a:pos x="connsiteX103" y="connsiteY103"/>
              </a:cxn>
              <a:cxn ang="0">
                <a:pos x="connsiteX104" y="connsiteY104"/>
              </a:cxn>
              <a:cxn ang="0">
                <a:pos x="connsiteX105" y="connsiteY105"/>
              </a:cxn>
              <a:cxn ang="0">
                <a:pos x="connsiteX106" y="connsiteY106"/>
              </a:cxn>
              <a:cxn ang="0">
                <a:pos x="connsiteX107" y="connsiteY107"/>
              </a:cxn>
              <a:cxn ang="0">
                <a:pos x="connsiteX108" y="connsiteY108"/>
              </a:cxn>
              <a:cxn ang="0">
                <a:pos x="connsiteX109" y="connsiteY109"/>
              </a:cxn>
              <a:cxn ang="0">
                <a:pos x="connsiteX110" y="connsiteY110"/>
              </a:cxn>
              <a:cxn ang="0">
                <a:pos x="connsiteX111" y="connsiteY111"/>
              </a:cxn>
              <a:cxn ang="0">
                <a:pos x="connsiteX112" y="connsiteY112"/>
              </a:cxn>
              <a:cxn ang="0">
                <a:pos x="connsiteX113" y="connsiteY113"/>
              </a:cxn>
              <a:cxn ang="0">
                <a:pos x="connsiteX114" y="connsiteY114"/>
              </a:cxn>
              <a:cxn ang="0">
                <a:pos x="connsiteX115" y="connsiteY115"/>
              </a:cxn>
              <a:cxn ang="0">
                <a:pos x="connsiteX116" y="connsiteY116"/>
              </a:cxn>
              <a:cxn ang="0">
                <a:pos x="connsiteX117" y="connsiteY117"/>
              </a:cxn>
              <a:cxn ang="0">
                <a:pos x="connsiteX118" y="connsiteY118"/>
              </a:cxn>
              <a:cxn ang="0">
                <a:pos x="connsiteX119" y="connsiteY119"/>
              </a:cxn>
              <a:cxn ang="0">
                <a:pos x="connsiteX120" y="connsiteY120"/>
              </a:cxn>
              <a:cxn ang="0">
                <a:pos x="connsiteX121" y="connsiteY121"/>
              </a:cxn>
              <a:cxn ang="0">
                <a:pos x="connsiteX122" y="connsiteY122"/>
              </a:cxn>
              <a:cxn ang="0">
                <a:pos x="connsiteX123" y="connsiteY123"/>
              </a:cxn>
              <a:cxn ang="0">
                <a:pos x="connsiteX124" y="connsiteY124"/>
              </a:cxn>
              <a:cxn ang="0">
                <a:pos x="connsiteX125" y="connsiteY125"/>
              </a:cxn>
              <a:cxn ang="0">
                <a:pos x="connsiteX126" y="connsiteY126"/>
              </a:cxn>
              <a:cxn ang="0">
                <a:pos x="connsiteX127" y="connsiteY127"/>
              </a:cxn>
              <a:cxn ang="0">
                <a:pos x="connsiteX128" y="connsiteY128"/>
              </a:cxn>
              <a:cxn ang="0">
                <a:pos x="connsiteX129" y="connsiteY129"/>
              </a:cxn>
              <a:cxn ang="0">
                <a:pos x="connsiteX130" y="connsiteY130"/>
              </a:cxn>
              <a:cxn ang="0">
                <a:pos x="connsiteX131" y="connsiteY131"/>
              </a:cxn>
              <a:cxn ang="0">
                <a:pos x="connsiteX132" y="connsiteY132"/>
              </a:cxn>
              <a:cxn ang="0">
                <a:pos x="connsiteX133" y="connsiteY133"/>
              </a:cxn>
              <a:cxn ang="0">
                <a:pos x="connsiteX134" y="connsiteY134"/>
              </a:cxn>
              <a:cxn ang="0">
                <a:pos x="connsiteX135" y="connsiteY135"/>
              </a:cxn>
              <a:cxn ang="0">
                <a:pos x="connsiteX136" y="connsiteY136"/>
              </a:cxn>
              <a:cxn ang="0">
                <a:pos x="connsiteX137" y="connsiteY137"/>
              </a:cxn>
              <a:cxn ang="0">
                <a:pos x="connsiteX138" y="connsiteY138"/>
              </a:cxn>
              <a:cxn ang="0">
                <a:pos x="connsiteX139" y="connsiteY139"/>
              </a:cxn>
              <a:cxn ang="0">
                <a:pos x="connsiteX140" y="connsiteY140"/>
              </a:cxn>
              <a:cxn ang="0">
                <a:pos x="connsiteX141" y="connsiteY141"/>
              </a:cxn>
              <a:cxn ang="0">
                <a:pos x="connsiteX142" y="connsiteY142"/>
              </a:cxn>
              <a:cxn ang="0">
                <a:pos x="connsiteX143" y="connsiteY143"/>
              </a:cxn>
              <a:cxn ang="0">
                <a:pos x="connsiteX144" y="connsiteY144"/>
              </a:cxn>
              <a:cxn ang="0">
                <a:pos x="connsiteX145" y="connsiteY145"/>
              </a:cxn>
              <a:cxn ang="0">
                <a:pos x="connsiteX146" y="connsiteY146"/>
              </a:cxn>
              <a:cxn ang="0">
                <a:pos x="connsiteX147" y="connsiteY147"/>
              </a:cxn>
              <a:cxn ang="0">
                <a:pos x="connsiteX148" y="connsiteY148"/>
              </a:cxn>
              <a:cxn ang="0">
                <a:pos x="connsiteX149" y="connsiteY149"/>
              </a:cxn>
              <a:cxn ang="0">
                <a:pos x="connsiteX150" y="connsiteY150"/>
              </a:cxn>
              <a:cxn ang="0">
                <a:pos x="connsiteX151" y="connsiteY151"/>
              </a:cxn>
              <a:cxn ang="0">
                <a:pos x="connsiteX152" y="connsiteY152"/>
              </a:cxn>
              <a:cxn ang="0">
                <a:pos x="connsiteX153" y="connsiteY153"/>
              </a:cxn>
              <a:cxn ang="0">
                <a:pos x="connsiteX154" y="connsiteY154"/>
              </a:cxn>
              <a:cxn ang="0">
                <a:pos x="connsiteX155" y="connsiteY155"/>
              </a:cxn>
              <a:cxn ang="0">
                <a:pos x="connsiteX156" y="connsiteY156"/>
              </a:cxn>
              <a:cxn ang="0">
                <a:pos x="connsiteX157" y="connsiteY157"/>
              </a:cxn>
              <a:cxn ang="0">
                <a:pos x="connsiteX158" y="connsiteY158"/>
              </a:cxn>
              <a:cxn ang="0">
                <a:pos x="connsiteX159" y="connsiteY159"/>
              </a:cxn>
              <a:cxn ang="0">
                <a:pos x="connsiteX160" y="connsiteY160"/>
              </a:cxn>
              <a:cxn ang="0">
                <a:pos x="connsiteX161" y="connsiteY161"/>
              </a:cxn>
              <a:cxn ang="0">
                <a:pos x="connsiteX162" y="connsiteY162"/>
              </a:cxn>
              <a:cxn ang="0">
                <a:pos x="connsiteX163" y="connsiteY163"/>
              </a:cxn>
              <a:cxn ang="0">
                <a:pos x="connsiteX164" y="connsiteY164"/>
              </a:cxn>
              <a:cxn ang="0">
                <a:pos x="connsiteX165" y="connsiteY165"/>
              </a:cxn>
              <a:cxn ang="0">
                <a:pos x="connsiteX166" y="connsiteY166"/>
              </a:cxn>
              <a:cxn ang="0">
                <a:pos x="connsiteX167" y="connsiteY167"/>
              </a:cxn>
              <a:cxn ang="0">
                <a:pos x="connsiteX168" y="connsiteY168"/>
              </a:cxn>
              <a:cxn ang="0">
                <a:pos x="connsiteX169" y="connsiteY169"/>
              </a:cxn>
              <a:cxn ang="0">
                <a:pos x="connsiteX170" y="connsiteY170"/>
              </a:cxn>
              <a:cxn ang="0">
                <a:pos x="connsiteX171" y="connsiteY171"/>
              </a:cxn>
              <a:cxn ang="0">
                <a:pos x="connsiteX172" y="connsiteY172"/>
              </a:cxn>
              <a:cxn ang="0">
                <a:pos x="connsiteX173" y="connsiteY173"/>
              </a:cxn>
              <a:cxn ang="0">
                <a:pos x="connsiteX174" y="connsiteY174"/>
              </a:cxn>
              <a:cxn ang="0">
                <a:pos x="connsiteX175" y="connsiteY175"/>
              </a:cxn>
              <a:cxn ang="0">
                <a:pos x="connsiteX176" y="connsiteY176"/>
              </a:cxn>
              <a:cxn ang="0">
                <a:pos x="connsiteX177" y="connsiteY177"/>
              </a:cxn>
              <a:cxn ang="0">
                <a:pos x="connsiteX178" y="connsiteY178"/>
              </a:cxn>
              <a:cxn ang="0">
                <a:pos x="connsiteX179" y="connsiteY179"/>
              </a:cxn>
              <a:cxn ang="0">
                <a:pos x="connsiteX180" y="connsiteY180"/>
              </a:cxn>
              <a:cxn ang="0">
                <a:pos x="connsiteX181" y="connsiteY181"/>
              </a:cxn>
              <a:cxn ang="0">
                <a:pos x="connsiteX182" y="connsiteY182"/>
              </a:cxn>
              <a:cxn ang="0">
                <a:pos x="connsiteX183" y="connsiteY183"/>
              </a:cxn>
              <a:cxn ang="0">
                <a:pos x="connsiteX184" y="connsiteY184"/>
              </a:cxn>
              <a:cxn ang="0">
                <a:pos x="connsiteX185" y="connsiteY185"/>
              </a:cxn>
              <a:cxn ang="0">
                <a:pos x="connsiteX186" y="connsiteY186"/>
              </a:cxn>
              <a:cxn ang="0">
                <a:pos x="connsiteX187" y="connsiteY187"/>
              </a:cxn>
              <a:cxn ang="0">
                <a:pos x="connsiteX188" y="connsiteY188"/>
              </a:cxn>
              <a:cxn ang="0">
                <a:pos x="connsiteX189" y="connsiteY189"/>
              </a:cxn>
              <a:cxn ang="0">
                <a:pos x="connsiteX190" y="connsiteY190"/>
              </a:cxn>
              <a:cxn ang="0">
                <a:pos x="connsiteX191" y="connsiteY191"/>
              </a:cxn>
              <a:cxn ang="0">
                <a:pos x="connsiteX192" y="connsiteY192"/>
              </a:cxn>
              <a:cxn ang="0">
                <a:pos x="connsiteX193" y="connsiteY193"/>
              </a:cxn>
              <a:cxn ang="0">
                <a:pos x="connsiteX194" y="connsiteY194"/>
              </a:cxn>
              <a:cxn ang="0">
                <a:pos x="connsiteX195" y="connsiteY195"/>
              </a:cxn>
              <a:cxn ang="0">
                <a:pos x="connsiteX196" y="connsiteY196"/>
              </a:cxn>
              <a:cxn ang="0">
                <a:pos x="connsiteX197" y="connsiteY197"/>
              </a:cxn>
              <a:cxn ang="0">
                <a:pos x="connsiteX198" y="connsiteY198"/>
              </a:cxn>
              <a:cxn ang="0">
                <a:pos x="connsiteX199" y="connsiteY199"/>
              </a:cxn>
              <a:cxn ang="0">
                <a:pos x="connsiteX200" y="connsiteY200"/>
              </a:cxn>
              <a:cxn ang="0">
                <a:pos x="connsiteX201" y="connsiteY201"/>
              </a:cxn>
              <a:cxn ang="0">
                <a:pos x="connsiteX202" y="connsiteY202"/>
              </a:cxn>
              <a:cxn ang="0">
                <a:pos x="connsiteX203" y="connsiteY203"/>
              </a:cxn>
              <a:cxn ang="0">
                <a:pos x="connsiteX204" y="connsiteY204"/>
              </a:cxn>
              <a:cxn ang="0">
                <a:pos x="connsiteX205" y="connsiteY205"/>
              </a:cxn>
              <a:cxn ang="0">
                <a:pos x="connsiteX206" y="connsiteY206"/>
              </a:cxn>
              <a:cxn ang="0">
                <a:pos x="connsiteX207" y="connsiteY207"/>
              </a:cxn>
              <a:cxn ang="0">
                <a:pos x="connsiteX208" y="connsiteY208"/>
              </a:cxn>
              <a:cxn ang="0">
                <a:pos x="connsiteX209" y="connsiteY209"/>
              </a:cxn>
              <a:cxn ang="0">
                <a:pos x="connsiteX210" y="connsiteY210"/>
              </a:cxn>
              <a:cxn ang="0">
                <a:pos x="connsiteX211" y="connsiteY211"/>
              </a:cxn>
              <a:cxn ang="0">
                <a:pos x="connsiteX212" y="connsiteY212"/>
              </a:cxn>
              <a:cxn ang="0">
                <a:pos x="connsiteX213" y="connsiteY213"/>
              </a:cxn>
              <a:cxn ang="0">
                <a:pos x="connsiteX214" y="connsiteY214"/>
              </a:cxn>
              <a:cxn ang="0">
                <a:pos x="connsiteX215" y="connsiteY215"/>
              </a:cxn>
              <a:cxn ang="0">
                <a:pos x="connsiteX216" y="connsiteY216"/>
              </a:cxn>
              <a:cxn ang="0">
                <a:pos x="connsiteX217" y="connsiteY217"/>
              </a:cxn>
            </a:cxnLst>
            <a:rect l="l" t="t" r="r" b="b"/>
            <a:pathLst>
              <a:path w="1956606" h="1638300">
                <a:moveTo>
                  <a:pt x="0" y="1022350"/>
                </a:moveTo>
                <a:cubicBezTo>
                  <a:pt x="22419" y="1035802"/>
                  <a:pt x="10740" y="1028452"/>
                  <a:pt x="34925" y="1044575"/>
                </a:cubicBezTo>
                <a:cubicBezTo>
                  <a:pt x="38100" y="1046692"/>
                  <a:pt x="40830" y="1049718"/>
                  <a:pt x="44450" y="1050925"/>
                </a:cubicBezTo>
                <a:cubicBezTo>
                  <a:pt x="49573" y="1052633"/>
                  <a:pt x="68784" y="1059578"/>
                  <a:pt x="76200" y="1060450"/>
                </a:cubicBezTo>
                <a:cubicBezTo>
                  <a:pt x="89904" y="1062062"/>
                  <a:pt x="103717" y="1062567"/>
                  <a:pt x="117475" y="1063625"/>
                </a:cubicBezTo>
                <a:cubicBezTo>
                  <a:pt x="122767" y="1064683"/>
                  <a:pt x="128144" y="1065380"/>
                  <a:pt x="133350" y="1066800"/>
                </a:cubicBezTo>
                <a:lnTo>
                  <a:pt x="161925" y="1076325"/>
                </a:lnTo>
                <a:lnTo>
                  <a:pt x="171450" y="1079500"/>
                </a:lnTo>
                <a:lnTo>
                  <a:pt x="180975" y="1082675"/>
                </a:lnTo>
                <a:lnTo>
                  <a:pt x="190500" y="1111250"/>
                </a:lnTo>
                <a:cubicBezTo>
                  <a:pt x="191558" y="1114425"/>
                  <a:pt x="193019" y="1117493"/>
                  <a:pt x="193675" y="1120775"/>
                </a:cubicBezTo>
                <a:cubicBezTo>
                  <a:pt x="194591" y="1125355"/>
                  <a:pt x="200796" y="1163207"/>
                  <a:pt x="206375" y="1171575"/>
                </a:cubicBezTo>
                <a:cubicBezTo>
                  <a:pt x="210608" y="1177925"/>
                  <a:pt x="216662" y="1183385"/>
                  <a:pt x="219075" y="1190625"/>
                </a:cubicBezTo>
                <a:cubicBezTo>
                  <a:pt x="220133" y="1193800"/>
                  <a:pt x="220195" y="1197508"/>
                  <a:pt x="222250" y="1200150"/>
                </a:cubicBezTo>
                <a:cubicBezTo>
                  <a:pt x="227763" y="1207239"/>
                  <a:pt x="235912" y="1212016"/>
                  <a:pt x="241300" y="1219200"/>
                </a:cubicBezTo>
                <a:cubicBezTo>
                  <a:pt x="244475" y="1223433"/>
                  <a:pt x="246760" y="1228512"/>
                  <a:pt x="250825" y="1231900"/>
                </a:cubicBezTo>
                <a:cubicBezTo>
                  <a:pt x="253396" y="1234043"/>
                  <a:pt x="257175" y="1234017"/>
                  <a:pt x="260350" y="1235075"/>
                </a:cubicBezTo>
                <a:cubicBezTo>
                  <a:pt x="274552" y="1256377"/>
                  <a:pt x="257822" y="1235506"/>
                  <a:pt x="276225" y="1247775"/>
                </a:cubicBezTo>
                <a:cubicBezTo>
                  <a:pt x="279961" y="1250266"/>
                  <a:pt x="282206" y="1254543"/>
                  <a:pt x="285750" y="1257300"/>
                </a:cubicBezTo>
                <a:cubicBezTo>
                  <a:pt x="291774" y="1261985"/>
                  <a:pt x="304800" y="1270000"/>
                  <a:pt x="304800" y="1270000"/>
                </a:cubicBezTo>
                <a:cubicBezTo>
                  <a:pt x="316442" y="1287462"/>
                  <a:pt x="304800" y="1272646"/>
                  <a:pt x="320675" y="1285875"/>
                </a:cubicBezTo>
                <a:cubicBezTo>
                  <a:pt x="324124" y="1288750"/>
                  <a:pt x="326464" y="1292909"/>
                  <a:pt x="330200" y="1295400"/>
                </a:cubicBezTo>
                <a:cubicBezTo>
                  <a:pt x="332985" y="1297256"/>
                  <a:pt x="336799" y="1296950"/>
                  <a:pt x="339725" y="1298575"/>
                </a:cubicBezTo>
                <a:cubicBezTo>
                  <a:pt x="346396" y="1302281"/>
                  <a:pt x="352425" y="1307042"/>
                  <a:pt x="358775" y="1311275"/>
                </a:cubicBezTo>
                <a:lnTo>
                  <a:pt x="396875" y="1336675"/>
                </a:lnTo>
                <a:lnTo>
                  <a:pt x="406400" y="1343025"/>
                </a:lnTo>
                <a:cubicBezTo>
                  <a:pt x="409575" y="1345142"/>
                  <a:pt x="412305" y="1348168"/>
                  <a:pt x="415925" y="1349375"/>
                </a:cubicBezTo>
                <a:lnTo>
                  <a:pt x="425450" y="1352550"/>
                </a:lnTo>
                <a:cubicBezTo>
                  <a:pt x="437183" y="1370149"/>
                  <a:pt x="425087" y="1356229"/>
                  <a:pt x="441325" y="1365250"/>
                </a:cubicBezTo>
                <a:cubicBezTo>
                  <a:pt x="447996" y="1368956"/>
                  <a:pt x="454025" y="1373717"/>
                  <a:pt x="460375" y="1377950"/>
                </a:cubicBezTo>
                <a:cubicBezTo>
                  <a:pt x="463550" y="1380067"/>
                  <a:pt x="466280" y="1383093"/>
                  <a:pt x="469900" y="1384300"/>
                </a:cubicBezTo>
                <a:lnTo>
                  <a:pt x="488950" y="1390650"/>
                </a:lnTo>
                <a:cubicBezTo>
                  <a:pt x="492125" y="1391708"/>
                  <a:pt x="495482" y="1392328"/>
                  <a:pt x="498475" y="1393825"/>
                </a:cubicBezTo>
                <a:cubicBezTo>
                  <a:pt x="502708" y="1395942"/>
                  <a:pt x="506825" y="1398311"/>
                  <a:pt x="511175" y="1400175"/>
                </a:cubicBezTo>
                <a:cubicBezTo>
                  <a:pt x="514251" y="1401493"/>
                  <a:pt x="517707" y="1401853"/>
                  <a:pt x="520700" y="1403350"/>
                </a:cubicBezTo>
                <a:cubicBezTo>
                  <a:pt x="524113" y="1405057"/>
                  <a:pt x="526812" y="1407993"/>
                  <a:pt x="530225" y="1409700"/>
                </a:cubicBezTo>
                <a:cubicBezTo>
                  <a:pt x="533218" y="1411197"/>
                  <a:pt x="536824" y="1411250"/>
                  <a:pt x="539750" y="1412875"/>
                </a:cubicBezTo>
                <a:cubicBezTo>
                  <a:pt x="546421" y="1416581"/>
                  <a:pt x="551560" y="1423162"/>
                  <a:pt x="558800" y="1425575"/>
                </a:cubicBezTo>
                <a:cubicBezTo>
                  <a:pt x="582741" y="1433555"/>
                  <a:pt x="553231" y="1422790"/>
                  <a:pt x="577850" y="1435100"/>
                </a:cubicBezTo>
                <a:cubicBezTo>
                  <a:pt x="580843" y="1436597"/>
                  <a:pt x="584449" y="1436650"/>
                  <a:pt x="587375" y="1438275"/>
                </a:cubicBezTo>
                <a:cubicBezTo>
                  <a:pt x="594046" y="1441981"/>
                  <a:pt x="599185" y="1448562"/>
                  <a:pt x="606425" y="1450975"/>
                </a:cubicBezTo>
                <a:cubicBezTo>
                  <a:pt x="630366" y="1458955"/>
                  <a:pt x="600856" y="1448190"/>
                  <a:pt x="625475" y="1460500"/>
                </a:cubicBezTo>
                <a:cubicBezTo>
                  <a:pt x="630810" y="1463168"/>
                  <a:pt x="642614" y="1465324"/>
                  <a:pt x="647700" y="1466850"/>
                </a:cubicBezTo>
                <a:cubicBezTo>
                  <a:pt x="654111" y="1468773"/>
                  <a:pt x="660186" y="1471887"/>
                  <a:pt x="666750" y="1473200"/>
                </a:cubicBezTo>
                <a:cubicBezTo>
                  <a:pt x="672042" y="1474258"/>
                  <a:pt x="677419" y="1474955"/>
                  <a:pt x="682625" y="1476375"/>
                </a:cubicBezTo>
                <a:cubicBezTo>
                  <a:pt x="689083" y="1478136"/>
                  <a:pt x="695009" y="1482119"/>
                  <a:pt x="701675" y="1482725"/>
                </a:cubicBezTo>
                <a:cubicBezTo>
                  <a:pt x="744053" y="1486578"/>
                  <a:pt x="725028" y="1484247"/>
                  <a:pt x="758825" y="1489075"/>
                </a:cubicBezTo>
                <a:cubicBezTo>
                  <a:pt x="762000" y="1490133"/>
                  <a:pt x="765737" y="1490159"/>
                  <a:pt x="768350" y="1492250"/>
                </a:cubicBezTo>
                <a:cubicBezTo>
                  <a:pt x="771330" y="1494634"/>
                  <a:pt x="772257" y="1498844"/>
                  <a:pt x="774700" y="1501775"/>
                </a:cubicBezTo>
                <a:cubicBezTo>
                  <a:pt x="777575" y="1505224"/>
                  <a:pt x="781468" y="1507756"/>
                  <a:pt x="784225" y="1511300"/>
                </a:cubicBezTo>
                <a:cubicBezTo>
                  <a:pt x="804171" y="1536944"/>
                  <a:pt x="788011" y="1524407"/>
                  <a:pt x="806450" y="1536700"/>
                </a:cubicBezTo>
                <a:cubicBezTo>
                  <a:pt x="821682" y="1559549"/>
                  <a:pt x="800112" y="1531416"/>
                  <a:pt x="831850" y="1552575"/>
                </a:cubicBezTo>
                <a:cubicBezTo>
                  <a:pt x="838200" y="1556808"/>
                  <a:pt x="843660" y="1562862"/>
                  <a:pt x="850900" y="1565275"/>
                </a:cubicBezTo>
                <a:cubicBezTo>
                  <a:pt x="854075" y="1566333"/>
                  <a:pt x="857432" y="1566953"/>
                  <a:pt x="860425" y="1568450"/>
                </a:cubicBezTo>
                <a:cubicBezTo>
                  <a:pt x="863838" y="1570157"/>
                  <a:pt x="866463" y="1573250"/>
                  <a:pt x="869950" y="1574800"/>
                </a:cubicBezTo>
                <a:cubicBezTo>
                  <a:pt x="876067" y="1577518"/>
                  <a:pt x="882650" y="1579033"/>
                  <a:pt x="889000" y="1581150"/>
                </a:cubicBezTo>
                <a:cubicBezTo>
                  <a:pt x="892175" y="1582208"/>
                  <a:pt x="895740" y="1582469"/>
                  <a:pt x="898525" y="1584325"/>
                </a:cubicBezTo>
                <a:cubicBezTo>
                  <a:pt x="901700" y="1586442"/>
                  <a:pt x="904464" y="1589371"/>
                  <a:pt x="908050" y="1590675"/>
                </a:cubicBezTo>
                <a:cubicBezTo>
                  <a:pt x="916252" y="1593657"/>
                  <a:pt x="925171" y="1594265"/>
                  <a:pt x="933450" y="1597025"/>
                </a:cubicBezTo>
                <a:lnTo>
                  <a:pt x="952500" y="1603375"/>
                </a:lnTo>
                <a:lnTo>
                  <a:pt x="981075" y="1612900"/>
                </a:lnTo>
                <a:cubicBezTo>
                  <a:pt x="984250" y="1613958"/>
                  <a:pt x="987299" y="1615525"/>
                  <a:pt x="990600" y="1616075"/>
                </a:cubicBezTo>
                <a:lnTo>
                  <a:pt x="1009650" y="1619250"/>
                </a:lnTo>
                <a:cubicBezTo>
                  <a:pt x="1017047" y="1620388"/>
                  <a:pt x="1024512" y="1621086"/>
                  <a:pt x="1031875" y="1622425"/>
                </a:cubicBezTo>
                <a:cubicBezTo>
                  <a:pt x="1036168" y="1623206"/>
                  <a:pt x="1040271" y="1624883"/>
                  <a:pt x="1044575" y="1625600"/>
                </a:cubicBezTo>
                <a:cubicBezTo>
                  <a:pt x="1052991" y="1627003"/>
                  <a:pt x="1061521" y="1627622"/>
                  <a:pt x="1069975" y="1628775"/>
                </a:cubicBezTo>
                <a:cubicBezTo>
                  <a:pt x="1134772" y="1637611"/>
                  <a:pt x="1092555" y="1632938"/>
                  <a:pt x="1146175" y="1638300"/>
                </a:cubicBezTo>
                <a:cubicBezTo>
                  <a:pt x="1589788" y="1628218"/>
                  <a:pt x="1037541" y="1638300"/>
                  <a:pt x="1390650" y="1638300"/>
                </a:cubicBezTo>
                <a:cubicBezTo>
                  <a:pt x="1470032" y="1638300"/>
                  <a:pt x="1549400" y="1636183"/>
                  <a:pt x="1628775" y="1635125"/>
                </a:cubicBezTo>
                <a:cubicBezTo>
                  <a:pt x="1657381" y="1632741"/>
                  <a:pt x="1664214" y="1632923"/>
                  <a:pt x="1689100" y="1628775"/>
                </a:cubicBezTo>
                <a:cubicBezTo>
                  <a:pt x="1694423" y="1627888"/>
                  <a:pt x="1699769" y="1627020"/>
                  <a:pt x="1704975" y="1625600"/>
                </a:cubicBezTo>
                <a:cubicBezTo>
                  <a:pt x="1711433" y="1623839"/>
                  <a:pt x="1718456" y="1622963"/>
                  <a:pt x="1724025" y="1619250"/>
                </a:cubicBezTo>
                <a:lnTo>
                  <a:pt x="1733550" y="1612900"/>
                </a:lnTo>
                <a:cubicBezTo>
                  <a:pt x="1735667" y="1609725"/>
                  <a:pt x="1738193" y="1606788"/>
                  <a:pt x="1739900" y="1603375"/>
                </a:cubicBezTo>
                <a:cubicBezTo>
                  <a:pt x="1745751" y="1591672"/>
                  <a:pt x="1744926" y="1572034"/>
                  <a:pt x="1746250" y="1562100"/>
                </a:cubicBezTo>
                <a:cubicBezTo>
                  <a:pt x="1747068" y="1555962"/>
                  <a:pt x="1750714" y="1540127"/>
                  <a:pt x="1752600" y="1533525"/>
                </a:cubicBezTo>
                <a:cubicBezTo>
                  <a:pt x="1757920" y="1514904"/>
                  <a:pt x="1752848" y="1533028"/>
                  <a:pt x="1762125" y="1514475"/>
                </a:cubicBezTo>
                <a:cubicBezTo>
                  <a:pt x="1763622" y="1511482"/>
                  <a:pt x="1762577" y="1506895"/>
                  <a:pt x="1765300" y="1504950"/>
                </a:cubicBezTo>
                <a:cubicBezTo>
                  <a:pt x="1770747" y="1501059"/>
                  <a:pt x="1778781" y="1502313"/>
                  <a:pt x="1784350" y="1498600"/>
                </a:cubicBezTo>
                <a:cubicBezTo>
                  <a:pt x="1799444" y="1488537"/>
                  <a:pt x="1790255" y="1493457"/>
                  <a:pt x="1812925" y="1485900"/>
                </a:cubicBezTo>
                <a:cubicBezTo>
                  <a:pt x="1816100" y="1484842"/>
                  <a:pt x="1819665" y="1484581"/>
                  <a:pt x="1822450" y="1482725"/>
                </a:cubicBezTo>
                <a:lnTo>
                  <a:pt x="1841500" y="1470025"/>
                </a:lnTo>
                <a:cubicBezTo>
                  <a:pt x="1843617" y="1466850"/>
                  <a:pt x="1845152" y="1463198"/>
                  <a:pt x="1847850" y="1460500"/>
                </a:cubicBezTo>
                <a:cubicBezTo>
                  <a:pt x="1850548" y="1457802"/>
                  <a:pt x="1854444" y="1456593"/>
                  <a:pt x="1857375" y="1454150"/>
                </a:cubicBezTo>
                <a:cubicBezTo>
                  <a:pt x="1862653" y="1449752"/>
                  <a:pt x="1870312" y="1441711"/>
                  <a:pt x="1873250" y="1435100"/>
                </a:cubicBezTo>
                <a:cubicBezTo>
                  <a:pt x="1875968" y="1428983"/>
                  <a:pt x="1877483" y="1422400"/>
                  <a:pt x="1879600" y="1416050"/>
                </a:cubicBezTo>
                <a:lnTo>
                  <a:pt x="1882775" y="1406525"/>
                </a:lnTo>
                <a:cubicBezTo>
                  <a:pt x="1886190" y="1379205"/>
                  <a:pt x="1889125" y="1359983"/>
                  <a:pt x="1889125" y="1330325"/>
                </a:cubicBezTo>
                <a:cubicBezTo>
                  <a:pt x="1889125" y="1293268"/>
                  <a:pt x="1888415" y="1256175"/>
                  <a:pt x="1885950" y="1219200"/>
                </a:cubicBezTo>
                <a:cubicBezTo>
                  <a:pt x="1883822" y="1187284"/>
                  <a:pt x="1879580" y="1193722"/>
                  <a:pt x="1873250" y="1168400"/>
                </a:cubicBezTo>
                <a:cubicBezTo>
                  <a:pt x="1872233" y="1164331"/>
                  <a:pt x="1869177" y="1150730"/>
                  <a:pt x="1866900" y="1146175"/>
                </a:cubicBezTo>
                <a:cubicBezTo>
                  <a:pt x="1865193" y="1142762"/>
                  <a:pt x="1862257" y="1140063"/>
                  <a:pt x="1860550" y="1136650"/>
                </a:cubicBezTo>
                <a:cubicBezTo>
                  <a:pt x="1859053" y="1133657"/>
                  <a:pt x="1859000" y="1130051"/>
                  <a:pt x="1857375" y="1127125"/>
                </a:cubicBezTo>
                <a:cubicBezTo>
                  <a:pt x="1853669" y="1120454"/>
                  <a:pt x="1847088" y="1115315"/>
                  <a:pt x="1844675" y="1108075"/>
                </a:cubicBezTo>
                <a:cubicBezTo>
                  <a:pt x="1843617" y="1104900"/>
                  <a:pt x="1842997" y="1101543"/>
                  <a:pt x="1841500" y="1098550"/>
                </a:cubicBezTo>
                <a:cubicBezTo>
                  <a:pt x="1839793" y="1095137"/>
                  <a:pt x="1836857" y="1092438"/>
                  <a:pt x="1835150" y="1089025"/>
                </a:cubicBezTo>
                <a:cubicBezTo>
                  <a:pt x="1833653" y="1086032"/>
                  <a:pt x="1833600" y="1082426"/>
                  <a:pt x="1831975" y="1079500"/>
                </a:cubicBezTo>
                <a:cubicBezTo>
                  <a:pt x="1828269" y="1072829"/>
                  <a:pt x="1823508" y="1066800"/>
                  <a:pt x="1819275" y="1060450"/>
                </a:cubicBezTo>
                <a:lnTo>
                  <a:pt x="1806575" y="1041400"/>
                </a:lnTo>
                <a:lnTo>
                  <a:pt x="1800225" y="1031875"/>
                </a:lnTo>
                <a:cubicBezTo>
                  <a:pt x="1798108" y="1028700"/>
                  <a:pt x="1796165" y="1025403"/>
                  <a:pt x="1793875" y="1022350"/>
                </a:cubicBezTo>
                <a:cubicBezTo>
                  <a:pt x="1790700" y="1018117"/>
                  <a:pt x="1788092" y="1013392"/>
                  <a:pt x="1784350" y="1009650"/>
                </a:cubicBezTo>
                <a:cubicBezTo>
                  <a:pt x="1781652" y="1006952"/>
                  <a:pt x="1778000" y="1005417"/>
                  <a:pt x="1774825" y="1003300"/>
                </a:cubicBezTo>
                <a:cubicBezTo>
                  <a:pt x="1769613" y="987663"/>
                  <a:pt x="1775382" y="998472"/>
                  <a:pt x="1762125" y="987425"/>
                </a:cubicBezTo>
                <a:cubicBezTo>
                  <a:pt x="1753580" y="980304"/>
                  <a:pt x="1753210" y="976055"/>
                  <a:pt x="1743075" y="971550"/>
                </a:cubicBezTo>
                <a:cubicBezTo>
                  <a:pt x="1736958" y="968832"/>
                  <a:pt x="1729594" y="968913"/>
                  <a:pt x="1724025" y="965200"/>
                </a:cubicBezTo>
                <a:cubicBezTo>
                  <a:pt x="1720850" y="963083"/>
                  <a:pt x="1717913" y="960557"/>
                  <a:pt x="1714500" y="958850"/>
                </a:cubicBezTo>
                <a:cubicBezTo>
                  <a:pt x="1711507" y="957353"/>
                  <a:pt x="1708222" y="956487"/>
                  <a:pt x="1704975" y="955675"/>
                </a:cubicBezTo>
                <a:cubicBezTo>
                  <a:pt x="1688306" y="951508"/>
                  <a:pt x="1679184" y="951520"/>
                  <a:pt x="1660525" y="949325"/>
                </a:cubicBezTo>
                <a:cubicBezTo>
                  <a:pt x="1650312" y="948124"/>
                  <a:pt x="1627264" y="945461"/>
                  <a:pt x="1616075" y="942975"/>
                </a:cubicBezTo>
                <a:cubicBezTo>
                  <a:pt x="1608264" y="941239"/>
                  <a:pt x="1603252" y="938640"/>
                  <a:pt x="1597025" y="933450"/>
                </a:cubicBezTo>
                <a:cubicBezTo>
                  <a:pt x="1593576" y="930575"/>
                  <a:pt x="1590949" y="926800"/>
                  <a:pt x="1587500" y="923925"/>
                </a:cubicBezTo>
                <a:cubicBezTo>
                  <a:pt x="1584569" y="921482"/>
                  <a:pt x="1581150" y="919692"/>
                  <a:pt x="1577975" y="917575"/>
                </a:cubicBezTo>
                <a:cubicBezTo>
                  <a:pt x="1575858" y="914400"/>
                  <a:pt x="1573175" y="911537"/>
                  <a:pt x="1571625" y="908050"/>
                </a:cubicBezTo>
                <a:cubicBezTo>
                  <a:pt x="1556512" y="874045"/>
                  <a:pt x="1573296" y="901031"/>
                  <a:pt x="1558925" y="879475"/>
                </a:cubicBezTo>
                <a:cubicBezTo>
                  <a:pt x="1547646" y="834359"/>
                  <a:pt x="1558529" y="870083"/>
                  <a:pt x="1546225" y="841375"/>
                </a:cubicBezTo>
                <a:cubicBezTo>
                  <a:pt x="1544907" y="838299"/>
                  <a:pt x="1544675" y="834776"/>
                  <a:pt x="1543050" y="831850"/>
                </a:cubicBezTo>
                <a:cubicBezTo>
                  <a:pt x="1539344" y="825179"/>
                  <a:pt x="1534583" y="819150"/>
                  <a:pt x="1530350" y="812800"/>
                </a:cubicBezTo>
                <a:lnTo>
                  <a:pt x="1524000" y="803275"/>
                </a:lnTo>
                <a:lnTo>
                  <a:pt x="1511300" y="784225"/>
                </a:lnTo>
                <a:cubicBezTo>
                  <a:pt x="1509183" y="781050"/>
                  <a:pt x="1508125" y="776817"/>
                  <a:pt x="1504950" y="774700"/>
                </a:cubicBezTo>
                <a:lnTo>
                  <a:pt x="1476375" y="755650"/>
                </a:lnTo>
                <a:cubicBezTo>
                  <a:pt x="1473200" y="753533"/>
                  <a:pt x="1470470" y="750507"/>
                  <a:pt x="1466850" y="749300"/>
                </a:cubicBezTo>
                <a:lnTo>
                  <a:pt x="1457325" y="746125"/>
                </a:lnTo>
                <a:cubicBezTo>
                  <a:pt x="1426939" y="715739"/>
                  <a:pt x="1465844" y="751805"/>
                  <a:pt x="1438275" y="733425"/>
                </a:cubicBezTo>
                <a:cubicBezTo>
                  <a:pt x="1434539" y="730934"/>
                  <a:pt x="1432486" y="726391"/>
                  <a:pt x="1428750" y="723900"/>
                </a:cubicBezTo>
                <a:cubicBezTo>
                  <a:pt x="1425965" y="722044"/>
                  <a:pt x="1422151" y="722350"/>
                  <a:pt x="1419225" y="720725"/>
                </a:cubicBezTo>
                <a:cubicBezTo>
                  <a:pt x="1412554" y="717019"/>
                  <a:pt x="1406525" y="712258"/>
                  <a:pt x="1400175" y="708025"/>
                </a:cubicBezTo>
                <a:lnTo>
                  <a:pt x="1381125" y="695325"/>
                </a:lnTo>
                <a:lnTo>
                  <a:pt x="1371600" y="688975"/>
                </a:lnTo>
                <a:cubicBezTo>
                  <a:pt x="1368425" y="686858"/>
                  <a:pt x="1365695" y="683832"/>
                  <a:pt x="1362075" y="682625"/>
                </a:cubicBezTo>
                <a:lnTo>
                  <a:pt x="1343025" y="676275"/>
                </a:lnTo>
                <a:cubicBezTo>
                  <a:pt x="1333203" y="679549"/>
                  <a:pt x="1325626" y="682625"/>
                  <a:pt x="1314450" y="682625"/>
                </a:cubicBezTo>
                <a:cubicBezTo>
                  <a:pt x="1310463" y="682625"/>
                  <a:pt x="1296717" y="677772"/>
                  <a:pt x="1292225" y="676275"/>
                </a:cubicBezTo>
                <a:cubicBezTo>
                  <a:pt x="1275292" y="650875"/>
                  <a:pt x="1297517" y="681567"/>
                  <a:pt x="1276350" y="660400"/>
                </a:cubicBezTo>
                <a:cubicBezTo>
                  <a:pt x="1273652" y="657702"/>
                  <a:pt x="1272443" y="653806"/>
                  <a:pt x="1270000" y="650875"/>
                </a:cubicBezTo>
                <a:cubicBezTo>
                  <a:pt x="1264319" y="644058"/>
                  <a:pt x="1248505" y="630066"/>
                  <a:pt x="1241425" y="628650"/>
                </a:cubicBezTo>
                <a:lnTo>
                  <a:pt x="1225550" y="625475"/>
                </a:lnTo>
                <a:cubicBezTo>
                  <a:pt x="1210733" y="626533"/>
                  <a:pt x="1195728" y="626069"/>
                  <a:pt x="1181100" y="628650"/>
                </a:cubicBezTo>
                <a:cubicBezTo>
                  <a:pt x="1175100" y="629709"/>
                  <a:pt x="1165730" y="641459"/>
                  <a:pt x="1162050" y="644525"/>
                </a:cubicBezTo>
                <a:cubicBezTo>
                  <a:pt x="1159119" y="646968"/>
                  <a:pt x="1155456" y="648432"/>
                  <a:pt x="1152525" y="650875"/>
                </a:cubicBezTo>
                <a:cubicBezTo>
                  <a:pt x="1136670" y="664088"/>
                  <a:pt x="1150214" y="657995"/>
                  <a:pt x="1133475" y="663575"/>
                </a:cubicBezTo>
                <a:cubicBezTo>
                  <a:pt x="1129242" y="662517"/>
                  <a:pt x="1124182" y="663126"/>
                  <a:pt x="1120775" y="660400"/>
                </a:cubicBezTo>
                <a:cubicBezTo>
                  <a:pt x="1118162" y="658309"/>
                  <a:pt x="1117600" y="654222"/>
                  <a:pt x="1117600" y="650875"/>
                </a:cubicBezTo>
                <a:cubicBezTo>
                  <a:pt x="1117600" y="623338"/>
                  <a:pt x="1118880" y="595797"/>
                  <a:pt x="1120775" y="568325"/>
                </a:cubicBezTo>
                <a:cubicBezTo>
                  <a:pt x="1121608" y="556252"/>
                  <a:pt x="1132938" y="550885"/>
                  <a:pt x="1136650" y="539750"/>
                </a:cubicBezTo>
                <a:cubicBezTo>
                  <a:pt x="1144630" y="515809"/>
                  <a:pt x="1133865" y="545319"/>
                  <a:pt x="1146175" y="520700"/>
                </a:cubicBezTo>
                <a:cubicBezTo>
                  <a:pt x="1147672" y="517707"/>
                  <a:pt x="1147853" y="514168"/>
                  <a:pt x="1149350" y="511175"/>
                </a:cubicBezTo>
                <a:cubicBezTo>
                  <a:pt x="1151057" y="507762"/>
                  <a:pt x="1153993" y="505063"/>
                  <a:pt x="1155700" y="501650"/>
                </a:cubicBezTo>
                <a:cubicBezTo>
                  <a:pt x="1157197" y="498657"/>
                  <a:pt x="1157378" y="495118"/>
                  <a:pt x="1158875" y="492125"/>
                </a:cubicBezTo>
                <a:cubicBezTo>
                  <a:pt x="1160582" y="488712"/>
                  <a:pt x="1163518" y="486013"/>
                  <a:pt x="1165225" y="482600"/>
                </a:cubicBezTo>
                <a:cubicBezTo>
                  <a:pt x="1166722" y="479607"/>
                  <a:pt x="1166775" y="476001"/>
                  <a:pt x="1168400" y="473075"/>
                </a:cubicBezTo>
                <a:cubicBezTo>
                  <a:pt x="1172106" y="466404"/>
                  <a:pt x="1176867" y="460375"/>
                  <a:pt x="1181100" y="454025"/>
                </a:cubicBezTo>
                <a:lnTo>
                  <a:pt x="1187450" y="444500"/>
                </a:lnTo>
                <a:cubicBezTo>
                  <a:pt x="1189567" y="441325"/>
                  <a:pt x="1190625" y="437092"/>
                  <a:pt x="1193800" y="434975"/>
                </a:cubicBezTo>
                <a:lnTo>
                  <a:pt x="1203325" y="428625"/>
                </a:lnTo>
                <a:cubicBezTo>
                  <a:pt x="1204383" y="425450"/>
                  <a:pt x="1204133" y="421467"/>
                  <a:pt x="1206500" y="419100"/>
                </a:cubicBezTo>
                <a:cubicBezTo>
                  <a:pt x="1211896" y="413704"/>
                  <a:pt x="1225550" y="406400"/>
                  <a:pt x="1225550" y="406400"/>
                </a:cubicBezTo>
                <a:cubicBezTo>
                  <a:pt x="1227667" y="403225"/>
                  <a:pt x="1228664" y="398897"/>
                  <a:pt x="1231900" y="396875"/>
                </a:cubicBezTo>
                <a:cubicBezTo>
                  <a:pt x="1237576" y="393327"/>
                  <a:pt x="1244600" y="392642"/>
                  <a:pt x="1250950" y="390525"/>
                </a:cubicBezTo>
                <a:lnTo>
                  <a:pt x="1260475" y="387350"/>
                </a:lnTo>
                <a:cubicBezTo>
                  <a:pt x="1263650" y="386292"/>
                  <a:pt x="1266753" y="384987"/>
                  <a:pt x="1270000" y="384175"/>
                </a:cubicBezTo>
                <a:lnTo>
                  <a:pt x="1282700" y="381000"/>
                </a:lnTo>
                <a:cubicBezTo>
                  <a:pt x="1291212" y="381709"/>
                  <a:pt x="1317356" y="380865"/>
                  <a:pt x="1330325" y="387350"/>
                </a:cubicBezTo>
                <a:cubicBezTo>
                  <a:pt x="1333738" y="389057"/>
                  <a:pt x="1336675" y="391583"/>
                  <a:pt x="1339850" y="393700"/>
                </a:cubicBezTo>
                <a:cubicBezTo>
                  <a:pt x="1356783" y="419100"/>
                  <a:pt x="1334558" y="388408"/>
                  <a:pt x="1355725" y="409575"/>
                </a:cubicBezTo>
                <a:cubicBezTo>
                  <a:pt x="1358423" y="412273"/>
                  <a:pt x="1359632" y="416169"/>
                  <a:pt x="1362075" y="419100"/>
                </a:cubicBezTo>
                <a:cubicBezTo>
                  <a:pt x="1364950" y="422549"/>
                  <a:pt x="1368725" y="425176"/>
                  <a:pt x="1371600" y="428625"/>
                </a:cubicBezTo>
                <a:cubicBezTo>
                  <a:pt x="1374043" y="431556"/>
                  <a:pt x="1375252" y="435452"/>
                  <a:pt x="1377950" y="438150"/>
                </a:cubicBezTo>
                <a:cubicBezTo>
                  <a:pt x="1380648" y="440848"/>
                  <a:pt x="1384544" y="442057"/>
                  <a:pt x="1387475" y="444500"/>
                </a:cubicBezTo>
                <a:cubicBezTo>
                  <a:pt x="1390924" y="447375"/>
                  <a:pt x="1393075" y="451844"/>
                  <a:pt x="1397000" y="454025"/>
                </a:cubicBezTo>
                <a:cubicBezTo>
                  <a:pt x="1402851" y="457276"/>
                  <a:pt x="1409700" y="458258"/>
                  <a:pt x="1416050" y="460375"/>
                </a:cubicBezTo>
                <a:cubicBezTo>
                  <a:pt x="1419225" y="461433"/>
                  <a:pt x="1422231" y="463405"/>
                  <a:pt x="1425575" y="463550"/>
                </a:cubicBezTo>
                <a:lnTo>
                  <a:pt x="1498600" y="466725"/>
                </a:lnTo>
                <a:cubicBezTo>
                  <a:pt x="1555097" y="474796"/>
                  <a:pt x="1496100" y="465590"/>
                  <a:pt x="1533525" y="473075"/>
                </a:cubicBezTo>
                <a:cubicBezTo>
                  <a:pt x="1548784" y="476127"/>
                  <a:pt x="1562367" y="477474"/>
                  <a:pt x="1577975" y="479425"/>
                </a:cubicBezTo>
                <a:cubicBezTo>
                  <a:pt x="1609725" y="478367"/>
                  <a:pt x="1641512" y="478115"/>
                  <a:pt x="1673225" y="476250"/>
                </a:cubicBezTo>
                <a:cubicBezTo>
                  <a:pt x="1677581" y="475994"/>
                  <a:pt x="1681745" y="474329"/>
                  <a:pt x="1685925" y="473075"/>
                </a:cubicBezTo>
                <a:lnTo>
                  <a:pt x="1714500" y="463550"/>
                </a:lnTo>
                <a:lnTo>
                  <a:pt x="1724025" y="460375"/>
                </a:lnTo>
                <a:cubicBezTo>
                  <a:pt x="1727200" y="459317"/>
                  <a:pt x="1730765" y="459056"/>
                  <a:pt x="1733550" y="457200"/>
                </a:cubicBezTo>
                <a:cubicBezTo>
                  <a:pt x="1736725" y="455083"/>
                  <a:pt x="1739588" y="452400"/>
                  <a:pt x="1743075" y="450850"/>
                </a:cubicBezTo>
                <a:cubicBezTo>
                  <a:pt x="1749192" y="448132"/>
                  <a:pt x="1755775" y="446617"/>
                  <a:pt x="1762125" y="444500"/>
                </a:cubicBezTo>
                <a:cubicBezTo>
                  <a:pt x="1765300" y="443442"/>
                  <a:pt x="1768865" y="443181"/>
                  <a:pt x="1771650" y="441325"/>
                </a:cubicBezTo>
                <a:cubicBezTo>
                  <a:pt x="1786744" y="431262"/>
                  <a:pt x="1777555" y="436182"/>
                  <a:pt x="1800225" y="428625"/>
                </a:cubicBezTo>
                <a:cubicBezTo>
                  <a:pt x="1803400" y="427567"/>
                  <a:pt x="1806965" y="427306"/>
                  <a:pt x="1809750" y="425450"/>
                </a:cubicBezTo>
                <a:cubicBezTo>
                  <a:pt x="1812925" y="423333"/>
                  <a:pt x="1815788" y="420650"/>
                  <a:pt x="1819275" y="419100"/>
                </a:cubicBezTo>
                <a:cubicBezTo>
                  <a:pt x="1825392" y="416382"/>
                  <a:pt x="1831975" y="414867"/>
                  <a:pt x="1838325" y="412750"/>
                </a:cubicBezTo>
                <a:cubicBezTo>
                  <a:pt x="1841500" y="411692"/>
                  <a:pt x="1845065" y="411431"/>
                  <a:pt x="1847850" y="409575"/>
                </a:cubicBezTo>
                <a:cubicBezTo>
                  <a:pt x="1875147" y="391377"/>
                  <a:pt x="1840610" y="413195"/>
                  <a:pt x="1866900" y="400050"/>
                </a:cubicBezTo>
                <a:cubicBezTo>
                  <a:pt x="1891519" y="387740"/>
                  <a:pt x="1862009" y="398505"/>
                  <a:pt x="1885950" y="390525"/>
                </a:cubicBezTo>
                <a:cubicBezTo>
                  <a:pt x="1889125" y="387350"/>
                  <a:pt x="1892600" y="384449"/>
                  <a:pt x="1895475" y="381000"/>
                </a:cubicBezTo>
                <a:cubicBezTo>
                  <a:pt x="1897918" y="378069"/>
                  <a:pt x="1899127" y="374173"/>
                  <a:pt x="1901825" y="371475"/>
                </a:cubicBezTo>
                <a:cubicBezTo>
                  <a:pt x="1904523" y="368777"/>
                  <a:pt x="1908419" y="367568"/>
                  <a:pt x="1911350" y="365125"/>
                </a:cubicBezTo>
                <a:cubicBezTo>
                  <a:pt x="1914799" y="362250"/>
                  <a:pt x="1917426" y="358475"/>
                  <a:pt x="1920875" y="355600"/>
                </a:cubicBezTo>
                <a:cubicBezTo>
                  <a:pt x="1923806" y="353157"/>
                  <a:pt x="1927469" y="351693"/>
                  <a:pt x="1930400" y="349250"/>
                </a:cubicBezTo>
                <a:cubicBezTo>
                  <a:pt x="1933849" y="346375"/>
                  <a:pt x="1937168" y="343269"/>
                  <a:pt x="1939925" y="339725"/>
                </a:cubicBezTo>
                <a:cubicBezTo>
                  <a:pt x="1944610" y="333701"/>
                  <a:pt x="1952625" y="320675"/>
                  <a:pt x="1952625" y="320675"/>
                </a:cubicBezTo>
                <a:cubicBezTo>
                  <a:pt x="1958231" y="264614"/>
                  <a:pt x="1957628" y="285073"/>
                  <a:pt x="1952625" y="200025"/>
                </a:cubicBezTo>
                <a:cubicBezTo>
                  <a:pt x="1952387" y="195978"/>
                  <a:pt x="1949673" y="177566"/>
                  <a:pt x="1946275" y="171450"/>
                </a:cubicBezTo>
                <a:cubicBezTo>
                  <a:pt x="1942569" y="164779"/>
                  <a:pt x="1937808" y="158750"/>
                  <a:pt x="1933575" y="152400"/>
                </a:cubicBezTo>
                <a:lnTo>
                  <a:pt x="1927225" y="142875"/>
                </a:lnTo>
                <a:lnTo>
                  <a:pt x="1920875" y="133350"/>
                </a:lnTo>
                <a:cubicBezTo>
                  <a:pt x="1918758" y="130175"/>
                  <a:pt x="1917700" y="125942"/>
                  <a:pt x="1914525" y="123825"/>
                </a:cubicBezTo>
                <a:lnTo>
                  <a:pt x="1905000" y="117475"/>
                </a:lnTo>
                <a:cubicBezTo>
                  <a:pt x="1900314" y="110447"/>
                  <a:pt x="1896459" y="103314"/>
                  <a:pt x="1889125" y="98425"/>
                </a:cubicBezTo>
                <a:cubicBezTo>
                  <a:pt x="1886340" y="96569"/>
                  <a:pt x="1882775" y="96308"/>
                  <a:pt x="1879600" y="95250"/>
                </a:cubicBezTo>
                <a:cubicBezTo>
                  <a:pt x="1877483" y="92075"/>
                  <a:pt x="1876230" y="88109"/>
                  <a:pt x="1873250" y="85725"/>
                </a:cubicBezTo>
                <a:cubicBezTo>
                  <a:pt x="1870637" y="83634"/>
                  <a:pt x="1866718" y="84047"/>
                  <a:pt x="1863725" y="82550"/>
                </a:cubicBezTo>
                <a:cubicBezTo>
                  <a:pt x="1839106" y="70240"/>
                  <a:pt x="1868616" y="81005"/>
                  <a:pt x="1844675" y="73025"/>
                </a:cubicBezTo>
                <a:cubicBezTo>
                  <a:pt x="1842558" y="69850"/>
                  <a:pt x="1841561" y="65522"/>
                  <a:pt x="1838325" y="63500"/>
                </a:cubicBezTo>
                <a:cubicBezTo>
                  <a:pt x="1832649" y="59952"/>
                  <a:pt x="1819275" y="57150"/>
                  <a:pt x="1819275" y="57150"/>
                </a:cubicBezTo>
                <a:cubicBezTo>
                  <a:pt x="1812253" y="50128"/>
                  <a:pt x="1809066" y="45695"/>
                  <a:pt x="1800225" y="41275"/>
                </a:cubicBezTo>
                <a:cubicBezTo>
                  <a:pt x="1773935" y="28130"/>
                  <a:pt x="1808472" y="49948"/>
                  <a:pt x="1781175" y="31750"/>
                </a:cubicBezTo>
                <a:cubicBezTo>
                  <a:pt x="1779058" y="28575"/>
                  <a:pt x="1777805" y="24609"/>
                  <a:pt x="1774825" y="22225"/>
                </a:cubicBezTo>
                <a:cubicBezTo>
                  <a:pt x="1772212" y="20134"/>
                  <a:pt x="1768293" y="20547"/>
                  <a:pt x="1765300" y="19050"/>
                </a:cubicBezTo>
                <a:cubicBezTo>
                  <a:pt x="1761887" y="17343"/>
                  <a:pt x="1758706" y="15143"/>
                  <a:pt x="1755775" y="12700"/>
                </a:cubicBezTo>
                <a:cubicBezTo>
                  <a:pt x="1738977" y="-1298"/>
                  <a:pt x="1753217" y="6659"/>
                  <a:pt x="1739900" y="0"/>
                </a:cubicBezTo>
              </a:path>
            </a:pathLst>
          </a:custGeom>
          <a:noFill/>
          <a:ln w="38100">
            <a:solidFill>
              <a:schemeClr val="bg1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9666"/>
          </a:p>
        </p:txBody>
      </p:sp>
      <p:sp>
        <p:nvSpPr>
          <p:cNvPr id="30" name="Freeform 29"/>
          <p:cNvSpPr/>
          <p:nvPr/>
        </p:nvSpPr>
        <p:spPr>
          <a:xfrm>
            <a:off x="13053634" y="4140971"/>
            <a:ext cx="946126" cy="1280148"/>
          </a:xfrm>
          <a:custGeom>
            <a:avLst/>
            <a:gdLst>
              <a:gd name="connsiteX0" fmla="*/ 0 w 482618"/>
              <a:gd name="connsiteY0" fmla="*/ 314325 h 606425"/>
              <a:gd name="connsiteX1" fmla="*/ 12700 w 482618"/>
              <a:gd name="connsiteY1" fmla="*/ 349250 h 606425"/>
              <a:gd name="connsiteX2" fmla="*/ 15875 w 482618"/>
              <a:gd name="connsiteY2" fmla="*/ 358775 h 606425"/>
              <a:gd name="connsiteX3" fmla="*/ 19050 w 482618"/>
              <a:gd name="connsiteY3" fmla="*/ 368300 h 606425"/>
              <a:gd name="connsiteX4" fmla="*/ 22225 w 482618"/>
              <a:gd name="connsiteY4" fmla="*/ 387350 h 606425"/>
              <a:gd name="connsiteX5" fmla="*/ 28575 w 482618"/>
              <a:gd name="connsiteY5" fmla="*/ 425450 h 606425"/>
              <a:gd name="connsiteX6" fmla="*/ 34925 w 482618"/>
              <a:gd name="connsiteY6" fmla="*/ 444500 h 606425"/>
              <a:gd name="connsiteX7" fmla="*/ 41275 w 482618"/>
              <a:gd name="connsiteY7" fmla="*/ 469900 h 606425"/>
              <a:gd name="connsiteX8" fmla="*/ 47625 w 482618"/>
              <a:gd name="connsiteY8" fmla="*/ 488950 h 606425"/>
              <a:gd name="connsiteX9" fmla="*/ 50800 w 482618"/>
              <a:gd name="connsiteY9" fmla="*/ 498475 h 606425"/>
              <a:gd name="connsiteX10" fmla="*/ 53975 w 482618"/>
              <a:gd name="connsiteY10" fmla="*/ 511175 h 606425"/>
              <a:gd name="connsiteX11" fmla="*/ 63500 w 482618"/>
              <a:gd name="connsiteY11" fmla="*/ 539750 h 606425"/>
              <a:gd name="connsiteX12" fmla="*/ 66675 w 482618"/>
              <a:gd name="connsiteY12" fmla="*/ 549275 h 606425"/>
              <a:gd name="connsiteX13" fmla="*/ 73025 w 482618"/>
              <a:gd name="connsiteY13" fmla="*/ 558800 h 606425"/>
              <a:gd name="connsiteX14" fmla="*/ 76200 w 482618"/>
              <a:gd name="connsiteY14" fmla="*/ 568325 h 606425"/>
              <a:gd name="connsiteX15" fmla="*/ 95250 w 482618"/>
              <a:gd name="connsiteY15" fmla="*/ 596900 h 606425"/>
              <a:gd name="connsiteX16" fmla="*/ 101600 w 482618"/>
              <a:gd name="connsiteY16" fmla="*/ 606425 h 606425"/>
              <a:gd name="connsiteX17" fmla="*/ 136525 w 482618"/>
              <a:gd name="connsiteY17" fmla="*/ 603250 h 606425"/>
              <a:gd name="connsiteX18" fmla="*/ 146050 w 482618"/>
              <a:gd name="connsiteY18" fmla="*/ 600075 h 606425"/>
              <a:gd name="connsiteX19" fmla="*/ 152400 w 482618"/>
              <a:gd name="connsiteY19" fmla="*/ 581025 h 606425"/>
              <a:gd name="connsiteX20" fmla="*/ 155575 w 482618"/>
              <a:gd name="connsiteY20" fmla="*/ 568325 h 606425"/>
              <a:gd name="connsiteX21" fmla="*/ 161925 w 482618"/>
              <a:gd name="connsiteY21" fmla="*/ 539750 h 606425"/>
              <a:gd name="connsiteX22" fmla="*/ 168275 w 482618"/>
              <a:gd name="connsiteY22" fmla="*/ 479425 h 606425"/>
              <a:gd name="connsiteX23" fmla="*/ 171450 w 482618"/>
              <a:gd name="connsiteY23" fmla="*/ 454025 h 606425"/>
              <a:gd name="connsiteX24" fmla="*/ 174625 w 482618"/>
              <a:gd name="connsiteY24" fmla="*/ 441325 h 606425"/>
              <a:gd name="connsiteX25" fmla="*/ 177800 w 482618"/>
              <a:gd name="connsiteY25" fmla="*/ 425450 h 606425"/>
              <a:gd name="connsiteX26" fmla="*/ 184150 w 482618"/>
              <a:gd name="connsiteY26" fmla="*/ 406400 h 606425"/>
              <a:gd name="connsiteX27" fmla="*/ 190500 w 482618"/>
              <a:gd name="connsiteY27" fmla="*/ 387350 h 606425"/>
              <a:gd name="connsiteX28" fmla="*/ 196850 w 482618"/>
              <a:gd name="connsiteY28" fmla="*/ 368300 h 606425"/>
              <a:gd name="connsiteX29" fmla="*/ 200025 w 482618"/>
              <a:gd name="connsiteY29" fmla="*/ 358775 h 606425"/>
              <a:gd name="connsiteX30" fmla="*/ 206375 w 482618"/>
              <a:gd name="connsiteY30" fmla="*/ 349250 h 606425"/>
              <a:gd name="connsiteX31" fmla="*/ 212725 w 482618"/>
              <a:gd name="connsiteY31" fmla="*/ 330200 h 606425"/>
              <a:gd name="connsiteX32" fmla="*/ 250825 w 482618"/>
              <a:gd name="connsiteY32" fmla="*/ 273050 h 606425"/>
              <a:gd name="connsiteX33" fmla="*/ 257175 w 482618"/>
              <a:gd name="connsiteY33" fmla="*/ 263525 h 606425"/>
              <a:gd name="connsiteX34" fmla="*/ 276225 w 482618"/>
              <a:gd name="connsiteY34" fmla="*/ 244475 h 606425"/>
              <a:gd name="connsiteX35" fmla="*/ 288925 w 482618"/>
              <a:gd name="connsiteY35" fmla="*/ 228600 h 606425"/>
              <a:gd name="connsiteX36" fmla="*/ 301625 w 482618"/>
              <a:gd name="connsiteY36" fmla="*/ 209550 h 606425"/>
              <a:gd name="connsiteX37" fmla="*/ 320675 w 482618"/>
              <a:gd name="connsiteY37" fmla="*/ 196850 h 606425"/>
              <a:gd name="connsiteX38" fmla="*/ 327025 w 482618"/>
              <a:gd name="connsiteY38" fmla="*/ 187325 h 606425"/>
              <a:gd name="connsiteX39" fmla="*/ 346075 w 482618"/>
              <a:gd name="connsiteY39" fmla="*/ 174625 h 606425"/>
              <a:gd name="connsiteX40" fmla="*/ 368300 w 482618"/>
              <a:gd name="connsiteY40" fmla="*/ 146050 h 606425"/>
              <a:gd name="connsiteX41" fmla="*/ 377825 w 482618"/>
              <a:gd name="connsiteY41" fmla="*/ 139700 h 606425"/>
              <a:gd name="connsiteX42" fmla="*/ 384175 w 482618"/>
              <a:gd name="connsiteY42" fmla="*/ 130175 h 606425"/>
              <a:gd name="connsiteX43" fmla="*/ 393700 w 482618"/>
              <a:gd name="connsiteY43" fmla="*/ 123825 h 606425"/>
              <a:gd name="connsiteX44" fmla="*/ 396875 w 482618"/>
              <a:gd name="connsiteY44" fmla="*/ 114300 h 606425"/>
              <a:gd name="connsiteX45" fmla="*/ 406400 w 482618"/>
              <a:gd name="connsiteY45" fmla="*/ 104775 h 606425"/>
              <a:gd name="connsiteX46" fmla="*/ 419100 w 482618"/>
              <a:gd name="connsiteY46" fmla="*/ 85725 h 606425"/>
              <a:gd name="connsiteX47" fmla="*/ 425450 w 482618"/>
              <a:gd name="connsiteY47" fmla="*/ 76200 h 606425"/>
              <a:gd name="connsiteX48" fmla="*/ 441325 w 482618"/>
              <a:gd name="connsiteY48" fmla="*/ 57150 h 606425"/>
              <a:gd name="connsiteX49" fmla="*/ 450850 w 482618"/>
              <a:gd name="connsiteY49" fmla="*/ 47625 h 606425"/>
              <a:gd name="connsiteX50" fmla="*/ 460375 w 482618"/>
              <a:gd name="connsiteY50" fmla="*/ 28575 h 606425"/>
              <a:gd name="connsiteX51" fmla="*/ 469900 w 482618"/>
              <a:gd name="connsiteY51" fmla="*/ 19050 h 606425"/>
              <a:gd name="connsiteX52" fmla="*/ 473075 w 482618"/>
              <a:gd name="connsiteY52" fmla="*/ 9525 h 606425"/>
              <a:gd name="connsiteX53" fmla="*/ 482600 w 482618"/>
              <a:gd name="connsiteY53" fmla="*/ 0 h 60642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  <a:cxn ang="0">
                <a:pos x="connsiteX31" y="connsiteY31"/>
              </a:cxn>
              <a:cxn ang="0">
                <a:pos x="connsiteX32" y="connsiteY32"/>
              </a:cxn>
              <a:cxn ang="0">
                <a:pos x="connsiteX33" y="connsiteY33"/>
              </a:cxn>
              <a:cxn ang="0">
                <a:pos x="connsiteX34" y="connsiteY34"/>
              </a:cxn>
              <a:cxn ang="0">
                <a:pos x="connsiteX35" y="connsiteY35"/>
              </a:cxn>
              <a:cxn ang="0">
                <a:pos x="connsiteX36" y="connsiteY36"/>
              </a:cxn>
              <a:cxn ang="0">
                <a:pos x="connsiteX37" y="connsiteY37"/>
              </a:cxn>
              <a:cxn ang="0">
                <a:pos x="connsiteX38" y="connsiteY38"/>
              </a:cxn>
              <a:cxn ang="0">
                <a:pos x="connsiteX39" y="connsiteY39"/>
              </a:cxn>
              <a:cxn ang="0">
                <a:pos x="connsiteX40" y="connsiteY40"/>
              </a:cxn>
              <a:cxn ang="0">
                <a:pos x="connsiteX41" y="connsiteY41"/>
              </a:cxn>
              <a:cxn ang="0">
                <a:pos x="connsiteX42" y="connsiteY42"/>
              </a:cxn>
              <a:cxn ang="0">
                <a:pos x="connsiteX43" y="connsiteY43"/>
              </a:cxn>
              <a:cxn ang="0">
                <a:pos x="connsiteX44" y="connsiteY44"/>
              </a:cxn>
              <a:cxn ang="0">
                <a:pos x="connsiteX45" y="connsiteY45"/>
              </a:cxn>
              <a:cxn ang="0">
                <a:pos x="connsiteX46" y="connsiteY46"/>
              </a:cxn>
              <a:cxn ang="0">
                <a:pos x="connsiteX47" y="connsiteY47"/>
              </a:cxn>
              <a:cxn ang="0">
                <a:pos x="connsiteX48" y="connsiteY48"/>
              </a:cxn>
              <a:cxn ang="0">
                <a:pos x="connsiteX49" y="connsiteY49"/>
              </a:cxn>
              <a:cxn ang="0">
                <a:pos x="connsiteX50" y="connsiteY50"/>
              </a:cxn>
              <a:cxn ang="0">
                <a:pos x="connsiteX51" y="connsiteY51"/>
              </a:cxn>
              <a:cxn ang="0">
                <a:pos x="connsiteX52" y="connsiteY52"/>
              </a:cxn>
              <a:cxn ang="0">
                <a:pos x="connsiteX53" y="connsiteY53"/>
              </a:cxn>
            </a:cxnLst>
            <a:rect l="l" t="t" r="r" b="b"/>
            <a:pathLst>
              <a:path w="482618" h="606425">
                <a:moveTo>
                  <a:pt x="0" y="314325"/>
                </a:moveTo>
                <a:cubicBezTo>
                  <a:pt x="8836" y="336415"/>
                  <a:pt x="4548" y="324793"/>
                  <a:pt x="12700" y="349250"/>
                </a:cubicBezTo>
                <a:lnTo>
                  <a:pt x="15875" y="358775"/>
                </a:lnTo>
                <a:cubicBezTo>
                  <a:pt x="16933" y="361950"/>
                  <a:pt x="18500" y="364999"/>
                  <a:pt x="19050" y="368300"/>
                </a:cubicBezTo>
                <a:cubicBezTo>
                  <a:pt x="20108" y="374650"/>
                  <a:pt x="21246" y="380987"/>
                  <a:pt x="22225" y="387350"/>
                </a:cubicBezTo>
                <a:cubicBezTo>
                  <a:pt x="23828" y="397772"/>
                  <a:pt x="25616" y="414600"/>
                  <a:pt x="28575" y="425450"/>
                </a:cubicBezTo>
                <a:cubicBezTo>
                  <a:pt x="30336" y="431908"/>
                  <a:pt x="33302" y="438006"/>
                  <a:pt x="34925" y="444500"/>
                </a:cubicBezTo>
                <a:cubicBezTo>
                  <a:pt x="37042" y="452967"/>
                  <a:pt x="38515" y="461621"/>
                  <a:pt x="41275" y="469900"/>
                </a:cubicBezTo>
                <a:lnTo>
                  <a:pt x="47625" y="488950"/>
                </a:lnTo>
                <a:cubicBezTo>
                  <a:pt x="48683" y="492125"/>
                  <a:pt x="49988" y="495228"/>
                  <a:pt x="50800" y="498475"/>
                </a:cubicBezTo>
                <a:cubicBezTo>
                  <a:pt x="51858" y="502708"/>
                  <a:pt x="52721" y="506995"/>
                  <a:pt x="53975" y="511175"/>
                </a:cubicBezTo>
                <a:lnTo>
                  <a:pt x="63500" y="539750"/>
                </a:lnTo>
                <a:cubicBezTo>
                  <a:pt x="64558" y="542925"/>
                  <a:pt x="64819" y="546490"/>
                  <a:pt x="66675" y="549275"/>
                </a:cubicBezTo>
                <a:cubicBezTo>
                  <a:pt x="68792" y="552450"/>
                  <a:pt x="71318" y="555387"/>
                  <a:pt x="73025" y="558800"/>
                </a:cubicBezTo>
                <a:cubicBezTo>
                  <a:pt x="74522" y="561793"/>
                  <a:pt x="74575" y="565399"/>
                  <a:pt x="76200" y="568325"/>
                </a:cubicBezTo>
                <a:lnTo>
                  <a:pt x="95250" y="596900"/>
                </a:lnTo>
                <a:lnTo>
                  <a:pt x="101600" y="606425"/>
                </a:lnTo>
                <a:cubicBezTo>
                  <a:pt x="113242" y="605367"/>
                  <a:pt x="124953" y="604903"/>
                  <a:pt x="136525" y="603250"/>
                </a:cubicBezTo>
                <a:cubicBezTo>
                  <a:pt x="139838" y="602777"/>
                  <a:pt x="144105" y="602798"/>
                  <a:pt x="146050" y="600075"/>
                </a:cubicBezTo>
                <a:cubicBezTo>
                  <a:pt x="149941" y="594628"/>
                  <a:pt x="150777" y="587519"/>
                  <a:pt x="152400" y="581025"/>
                </a:cubicBezTo>
                <a:cubicBezTo>
                  <a:pt x="153458" y="576792"/>
                  <a:pt x="154628" y="572585"/>
                  <a:pt x="155575" y="568325"/>
                </a:cubicBezTo>
                <a:cubicBezTo>
                  <a:pt x="163637" y="532048"/>
                  <a:pt x="154182" y="570723"/>
                  <a:pt x="161925" y="539750"/>
                </a:cubicBezTo>
                <a:cubicBezTo>
                  <a:pt x="164042" y="519642"/>
                  <a:pt x="165767" y="499488"/>
                  <a:pt x="168275" y="479425"/>
                </a:cubicBezTo>
                <a:cubicBezTo>
                  <a:pt x="169333" y="470958"/>
                  <a:pt x="170047" y="462441"/>
                  <a:pt x="171450" y="454025"/>
                </a:cubicBezTo>
                <a:cubicBezTo>
                  <a:pt x="172167" y="449721"/>
                  <a:pt x="173678" y="445585"/>
                  <a:pt x="174625" y="441325"/>
                </a:cubicBezTo>
                <a:cubicBezTo>
                  <a:pt x="175796" y="436057"/>
                  <a:pt x="176380" y="430656"/>
                  <a:pt x="177800" y="425450"/>
                </a:cubicBezTo>
                <a:cubicBezTo>
                  <a:pt x="179561" y="418992"/>
                  <a:pt x="182033" y="412750"/>
                  <a:pt x="184150" y="406400"/>
                </a:cubicBezTo>
                <a:lnTo>
                  <a:pt x="190500" y="387350"/>
                </a:lnTo>
                <a:lnTo>
                  <a:pt x="196850" y="368300"/>
                </a:lnTo>
                <a:cubicBezTo>
                  <a:pt x="197908" y="365125"/>
                  <a:pt x="198169" y="361560"/>
                  <a:pt x="200025" y="358775"/>
                </a:cubicBezTo>
                <a:cubicBezTo>
                  <a:pt x="202142" y="355600"/>
                  <a:pt x="204825" y="352737"/>
                  <a:pt x="206375" y="349250"/>
                </a:cubicBezTo>
                <a:cubicBezTo>
                  <a:pt x="209093" y="343133"/>
                  <a:pt x="209012" y="335769"/>
                  <a:pt x="212725" y="330200"/>
                </a:cubicBezTo>
                <a:lnTo>
                  <a:pt x="250825" y="273050"/>
                </a:lnTo>
                <a:cubicBezTo>
                  <a:pt x="252942" y="269875"/>
                  <a:pt x="254477" y="266223"/>
                  <a:pt x="257175" y="263525"/>
                </a:cubicBezTo>
                <a:lnTo>
                  <a:pt x="276225" y="244475"/>
                </a:lnTo>
                <a:cubicBezTo>
                  <a:pt x="283375" y="223025"/>
                  <a:pt x="273459" y="246275"/>
                  <a:pt x="288925" y="228600"/>
                </a:cubicBezTo>
                <a:cubicBezTo>
                  <a:pt x="293951" y="222857"/>
                  <a:pt x="295275" y="213783"/>
                  <a:pt x="301625" y="209550"/>
                </a:cubicBezTo>
                <a:lnTo>
                  <a:pt x="320675" y="196850"/>
                </a:lnTo>
                <a:cubicBezTo>
                  <a:pt x="322792" y="193675"/>
                  <a:pt x="324153" y="189838"/>
                  <a:pt x="327025" y="187325"/>
                </a:cubicBezTo>
                <a:cubicBezTo>
                  <a:pt x="332768" y="182299"/>
                  <a:pt x="346075" y="174625"/>
                  <a:pt x="346075" y="174625"/>
                </a:cubicBezTo>
                <a:cubicBezTo>
                  <a:pt x="354925" y="161350"/>
                  <a:pt x="357109" y="155376"/>
                  <a:pt x="368300" y="146050"/>
                </a:cubicBezTo>
                <a:cubicBezTo>
                  <a:pt x="371231" y="143607"/>
                  <a:pt x="374650" y="141817"/>
                  <a:pt x="377825" y="139700"/>
                </a:cubicBezTo>
                <a:cubicBezTo>
                  <a:pt x="379942" y="136525"/>
                  <a:pt x="381477" y="132873"/>
                  <a:pt x="384175" y="130175"/>
                </a:cubicBezTo>
                <a:cubicBezTo>
                  <a:pt x="386873" y="127477"/>
                  <a:pt x="391316" y="126805"/>
                  <a:pt x="393700" y="123825"/>
                </a:cubicBezTo>
                <a:cubicBezTo>
                  <a:pt x="395791" y="121212"/>
                  <a:pt x="395019" y="117085"/>
                  <a:pt x="396875" y="114300"/>
                </a:cubicBezTo>
                <a:cubicBezTo>
                  <a:pt x="399366" y="110564"/>
                  <a:pt x="403643" y="108319"/>
                  <a:pt x="406400" y="104775"/>
                </a:cubicBezTo>
                <a:cubicBezTo>
                  <a:pt x="411085" y="98751"/>
                  <a:pt x="414867" y="92075"/>
                  <a:pt x="419100" y="85725"/>
                </a:cubicBezTo>
                <a:cubicBezTo>
                  <a:pt x="421217" y="82550"/>
                  <a:pt x="422752" y="78898"/>
                  <a:pt x="425450" y="76200"/>
                </a:cubicBezTo>
                <a:cubicBezTo>
                  <a:pt x="453277" y="48373"/>
                  <a:pt x="419223" y="83672"/>
                  <a:pt x="441325" y="57150"/>
                </a:cubicBezTo>
                <a:cubicBezTo>
                  <a:pt x="444200" y="53701"/>
                  <a:pt x="447975" y="51074"/>
                  <a:pt x="450850" y="47625"/>
                </a:cubicBezTo>
                <a:cubicBezTo>
                  <a:pt x="475829" y="17650"/>
                  <a:pt x="441282" y="57214"/>
                  <a:pt x="460375" y="28575"/>
                </a:cubicBezTo>
                <a:cubicBezTo>
                  <a:pt x="462866" y="24839"/>
                  <a:pt x="466725" y="22225"/>
                  <a:pt x="469900" y="19050"/>
                </a:cubicBezTo>
                <a:cubicBezTo>
                  <a:pt x="470958" y="15875"/>
                  <a:pt x="470984" y="12138"/>
                  <a:pt x="473075" y="9525"/>
                </a:cubicBezTo>
                <a:cubicBezTo>
                  <a:pt x="483481" y="-3482"/>
                  <a:pt x="482600" y="8674"/>
                  <a:pt x="482600" y="0"/>
                </a:cubicBezTo>
              </a:path>
            </a:pathLst>
          </a:custGeom>
          <a:noFill/>
          <a:ln w="38100">
            <a:solidFill>
              <a:schemeClr val="bg1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9666"/>
          </a:p>
        </p:txBody>
      </p:sp>
      <p:sp>
        <p:nvSpPr>
          <p:cNvPr id="31" name="Freeform 30"/>
          <p:cNvSpPr/>
          <p:nvPr/>
        </p:nvSpPr>
        <p:spPr>
          <a:xfrm>
            <a:off x="14018398" y="3095405"/>
            <a:ext cx="896296" cy="1005352"/>
          </a:xfrm>
          <a:custGeom>
            <a:avLst/>
            <a:gdLst>
              <a:gd name="connsiteX0" fmla="*/ 0 w 457200"/>
              <a:gd name="connsiteY0" fmla="*/ 476250 h 476250"/>
              <a:gd name="connsiteX1" fmla="*/ 15875 w 457200"/>
              <a:gd name="connsiteY1" fmla="*/ 450850 h 476250"/>
              <a:gd name="connsiteX2" fmla="*/ 22225 w 457200"/>
              <a:gd name="connsiteY2" fmla="*/ 441325 h 476250"/>
              <a:gd name="connsiteX3" fmla="*/ 28575 w 457200"/>
              <a:gd name="connsiteY3" fmla="*/ 422275 h 476250"/>
              <a:gd name="connsiteX4" fmla="*/ 53975 w 457200"/>
              <a:gd name="connsiteY4" fmla="*/ 384175 h 476250"/>
              <a:gd name="connsiteX5" fmla="*/ 60325 w 457200"/>
              <a:gd name="connsiteY5" fmla="*/ 374650 h 476250"/>
              <a:gd name="connsiteX6" fmla="*/ 73025 w 457200"/>
              <a:gd name="connsiteY6" fmla="*/ 355600 h 476250"/>
              <a:gd name="connsiteX7" fmla="*/ 85725 w 457200"/>
              <a:gd name="connsiteY7" fmla="*/ 336550 h 476250"/>
              <a:gd name="connsiteX8" fmla="*/ 88900 w 457200"/>
              <a:gd name="connsiteY8" fmla="*/ 327025 h 476250"/>
              <a:gd name="connsiteX9" fmla="*/ 101600 w 457200"/>
              <a:gd name="connsiteY9" fmla="*/ 307975 h 476250"/>
              <a:gd name="connsiteX10" fmla="*/ 104775 w 457200"/>
              <a:gd name="connsiteY10" fmla="*/ 298450 h 476250"/>
              <a:gd name="connsiteX11" fmla="*/ 117475 w 457200"/>
              <a:gd name="connsiteY11" fmla="*/ 279400 h 476250"/>
              <a:gd name="connsiteX12" fmla="*/ 123825 w 457200"/>
              <a:gd name="connsiteY12" fmla="*/ 269875 h 476250"/>
              <a:gd name="connsiteX13" fmla="*/ 130175 w 457200"/>
              <a:gd name="connsiteY13" fmla="*/ 260350 h 476250"/>
              <a:gd name="connsiteX14" fmla="*/ 142875 w 457200"/>
              <a:gd name="connsiteY14" fmla="*/ 241300 h 476250"/>
              <a:gd name="connsiteX15" fmla="*/ 155575 w 457200"/>
              <a:gd name="connsiteY15" fmla="*/ 219075 h 476250"/>
              <a:gd name="connsiteX16" fmla="*/ 168275 w 457200"/>
              <a:gd name="connsiteY16" fmla="*/ 203200 h 476250"/>
              <a:gd name="connsiteX17" fmla="*/ 180975 w 457200"/>
              <a:gd name="connsiteY17" fmla="*/ 184150 h 476250"/>
              <a:gd name="connsiteX18" fmla="*/ 193675 w 457200"/>
              <a:gd name="connsiteY18" fmla="*/ 168275 h 476250"/>
              <a:gd name="connsiteX19" fmla="*/ 206375 w 457200"/>
              <a:gd name="connsiteY19" fmla="*/ 149225 h 476250"/>
              <a:gd name="connsiteX20" fmla="*/ 212725 w 457200"/>
              <a:gd name="connsiteY20" fmla="*/ 139700 h 476250"/>
              <a:gd name="connsiteX21" fmla="*/ 222250 w 457200"/>
              <a:gd name="connsiteY21" fmla="*/ 130175 h 476250"/>
              <a:gd name="connsiteX22" fmla="*/ 244475 w 457200"/>
              <a:gd name="connsiteY22" fmla="*/ 101600 h 476250"/>
              <a:gd name="connsiteX23" fmla="*/ 263525 w 457200"/>
              <a:gd name="connsiteY23" fmla="*/ 88900 h 476250"/>
              <a:gd name="connsiteX24" fmla="*/ 285750 w 457200"/>
              <a:gd name="connsiteY24" fmla="*/ 79375 h 476250"/>
              <a:gd name="connsiteX25" fmla="*/ 307975 w 457200"/>
              <a:gd name="connsiteY25" fmla="*/ 69850 h 476250"/>
              <a:gd name="connsiteX26" fmla="*/ 317500 w 457200"/>
              <a:gd name="connsiteY26" fmla="*/ 63500 h 476250"/>
              <a:gd name="connsiteX27" fmla="*/ 330200 w 457200"/>
              <a:gd name="connsiteY27" fmla="*/ 53975 h 476250"/>
              <a:gd name="connsiteX28" fmla="*/ 339725 w 457200"/>
              <a:gd name="connsiteY28" fmla="*/ 50800 h 476250"/>
              <a:gd name="connsiteX29" fmla="*/ 368300 w 457200"/>
              <a:gd name="connsiteY29" fmla="*/ 34925 h 476250"/>
              <a:gd name="connsiteX30" fmla="*/ 377825 w 457200"/>
              <a:gd name="connsiteY30" fmla="*/ 28575 h 476250"/>
              <a:gd name="connsiteX31" fmla="*/ 396875 w 457200"/>
              <a:gd name="connsiteY31" fmla="*/ 22225 h 476250"/>
              <a:gd name="connsiteX32" fmla="*/ 425450 w 457200"/>
              <a:gd name="connsiteY32" fmla="*/ 9525 h 476250"/>
              <a:gd name="connsiteX33" fmla="*/ 438150 w 457200"/>
              <a:gd name="connsiteY33" fmla="*/ 6350 h 476250"/>
              <a:gd name="connsiteX34" fmla="*/ 457200 w 457200"/>
              <a:gd name="connsiteY34" fmla="*/ 0 h 47625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  <a:cxn ang="0">
                <a:pos x="connsiteX31" y="connsiteY31"/>
              </a:cxn>
              <a:cxn ang="0">
                <a:pos x="connsiteX32" y="connsiteY32"/>
              </a:cxn>
              <a:cxn ang="0">
                <a:pos x="connsiteX33" y="connsiteY33"/>
              </a:cxn>
              <a:cxn ang="0">
                <a:pos x="connsiteX34" y="connsiteY34"/>
              </a:cxn>
            </a:cxnLst>
            <a:rect l="l" t="t" r="r" b="b"/>
            <a:pathLst>
              <a:path w="457200" h="476250">
                <a:moveTo>
                  <a:pt x="0" y="476250"/>
                </a:moveTo>
                <a:cubicBezTo>
                  <a:pt x="29148" y="439815"/>
                  <a:pt x="3466" y="475667"/>
                  <a:pt x="15875" y="450850"/>
                </a:cubicBezTo>
                <a:cubicBezTo>
                  <a:pt x="17582" y="447437"/>
                  <a:pt x="20675" y="444812"/>
                  <a:pt x="22225" y="441325"/>
                </a:cubicBezTo>
                <a:cubicBezTo>
                  <a:pt x="24943" y="435208"/>
                  <a:pt x="24862" y="427844"/>
                  <a:pt x="28575" y="422275"/>
                </a:cubicBezTo>
                <a:lnTo>
                  <a:pt x="53975" y="384175"/>
                </a:lnTo>
                <a:cubicBezTo>
                  <a:pt x="56092" y="381000"/>
                  <a:pt x="59118" y="378270"/>
                  <a:pt x="60325" y="374650"/>
                </a:cubicBezTo>
                <a:cubicBezTo>
                  <a:pt x="64920" y="360865"/>
                  <a:pt x="61133" y="367492"/>
                  <a:pt x="73025" y="355600"/>
                </a:cubicBezTo>
                <a:cubicBezTo>
                  <a:pt x="80574" y="332952"/>
                  <a:pt x="69870" y="360333"/>
                  <a:pt x="85725" y="336550"/>
                </a:cubicBezTo>
                <a:cubicBezTo>
                  <a:pt x="87581" y="333765"/>
                  <a:pt x="87275" y="329951"/>
                  <a:pt x="88900" y="327025"/>
                </a:cubicBezTo>
                <a:cubicBezTo>
                  <a:pt x="92606" y="320354"/>
                  <a:pt x="99187" y="315215"/>
                  <a:pt x="101600" y="307975"/>
                </a:cubicBezTo>
                <a:cubicBezTo>
                  <a:pt x="102658" y="304800"/>
                  <a:pt x="103150" y="301376"/>
                  <a:pt x="104775" y="298450"/>
                </a:cubicBezTo>
                <a:cubicBezTo>
                  <a:pt x="108481" y="291779"/>
                  <a:pt x="113242" y="285750"/>
                  <a:pt x="117475" y="279400"/>
                </a:cubicBezTo>
                <a:lnTo>
                  <a:pt x="123825" y="269875"/>
                </a:lnTo>
                <a:cubicBezTo>
                  <a:pt x="125942" y="266700"/>
                  <a:pt x="128968" y="263970"/>
                  <a:pt x="130175" y="260350"/>
                </a:cubicBezTo>
                <a:cubicBezTo>
                  <a:pt x="134770" y="246565"/>
                  <a:pt x="130983" y="253192"/>
                  <a:pt x="142875" y="241300"/>
                </a:cubicBezTo>
                <a:cubicBezTo>
                  <a:pt x="150155" y="219461"/>
                  <a:pt x="140198" y="245985"/>
                  <a:pt x="155575" y="219075"/>
                </a:cubicBezTo>
                <a:cubicBezTo>
                  <a:pt x="165012" y="202559"/>
                  <a:pt x="150201" y="215249"/>
                  <a:pt x="168275" y="203200"/>
                </a:cubicBezTo>
                <a:cubicBezTo>
                  <a:pt x="175824" y="180552"/>
                  <a:pt x="165120" y="207933"/>
                  <a:pt x="180975" y="184150"/>
                </a:cubicBezTo>
                <a:cubicBezTo>
                  <a:pt x="193244" y="165747"/>
                  <a:pt x="172373" y="182477"/>
                  <a:pt x="193675" y="168275"/>
                </a:cubicBezTo>
                <a:lnTo>
                  <a:pt x="206375" y="149225"/>
                </a:lnTo>
                <a:cubicBezTo>
                  <a:pt x="208492" y="146050"/>
                  <a:pt x="210027" y="142398"/>
                  <a:pt x="212725" y="139700"/>
                </a:cubicBezTo>
                <a:cubicBezTo>
                  <a:pt x="215900" y="136525"/>
                  <a:pt x="219493" y="133719"/>
                  <a:pt x="222250" y="130175"/>
                </a:cubicBezTo>
                <a:cubicBezTo>
                  <a:pt x="232754" y="116670"/>
                  <a:pt x="232311" y="111061"/>
                  <a:pt x="244475" y="101600"/>
                </a:cubicBezTo>
                <a:cubicBezTo>
                  <a:pt x="250499" y="96915"/>
                  <a:pt x="256285" y="91313"/>
                  <a:pt x="263525" y="88900"/>
                </a:cubicBezTo>
                <a:cubicBezTo>
                  <a:pt x="285863" y="81454"/>
                  <a:pt x="258287" y="91145"/>
                  <a:pt x="285750" y="79375"/>
                </a:cubicBezTo>
                <a:cubicBezTo>
                  <a:pt x="303560" y="71742"/>
                  <a:pt x="286915" y="81884"/>
                  <a:pt x="307975" y="69850"/>
                </a:cubicBezTo>
                <a:cubicBezTo>
                  <a:pt x="311288" y="67957"/>
                  <a:pt x="314395" y="65718"/>
                  <a:pt x="317500" y="63500"/>
                </a:cubicBezTo>
                <a:cubicBezTo>
                  <a:pt x="321806" y="60424"/>
                  <a:pt x="325606" y="56600"/>
                  <a:pt x="330200" y="53975"/>
                </a:cubicBezTo>
                <a:cubicBezTo>
                  <a:pt x="333106" y="52315"/>
                  <a:pt x="336550" y="51858"/>
                  <a:pt x="339725" y="50800"/>
                </a:cubicBezTo>
                <a:cubicBezTo>
                  <a:pt x="369620" y="20905"/>
                  <a:pt x="321681" y="66005"/>
                  <a:pt x="368300" y="34925"/>
                </a:cubicBezTo>
                <a:cubicBezTo>
                  <a:pt x="371475" y="32808"/>
                  <a:pt x="374338" y="30125"/>
                  <a:pt x="377825" y="28575"/>
                </a:cubicBezTo>
                <a:cubicBezTo>
                  <a:pt x="383942" y="25857"/>
                  <a:pt x="391306" y="25938"/>
                  <a:pt x="396875" y="22225"/>
                </a:cubicBezTo>
                <a:cubicBezTo>
                  <a:pt x="409385" y="13885"/>
                  <a:pt x="407314" y="14059"/>
                  <a:pt x="425450" y="9525"/>
                </a:cubicBezTo>
                <a:cubicBezTo>
                  <a:pt x="429683" y="8467"/>
                  <a:pt x="433970" y="7604"/>
                  <a:pt x="438150" y="6350"/>
                </a:cubicBezTo>
                <a:cubicBezTo>
                  <a:pt x="444561" y="4427"/>
                  <a:pt x="457200" y="0"/>
                  <a:pt x="457200" y="0"/>
                </a:cubicBezTo>
              </a:path>
            </a:pathLst>
          </a:custGeom>
          <a:noFill/>
          <a:ln w="38100">
            <a:solidFill>
              <a:schemeClr val="bg1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9666"/>
          </a:p>
        </p:txBody>
      </p:sp>
      <p:sp>
        <p:nvSpPr>
          <p:cNvPr id="33" name="Freeform 32"/>
          <p:cNvSpPr/>
          <p:nvPr/>
        </p:nvSpPr>
        <p:spPr>
          <a:xfrm>
            <a:off x="14927142" y="2264314"/>
            <a:ext cx="4400563" cy="2942330"/>
          </a:xfrm>
          <a:custGeom>
            <a:avLst/>
            <a:gdLst>
              <a:gd name="connsiteX0" fmla="*/ 0 w 2244725"/>
              <a:gd name="connsiteY0" fmla="*/ 390525 h 1393825"/>
              <a:gd name="connsiteX1" fmla="*/ 25400 w 2244725"/>
              <a:gd name="connsiteY1" fmla="*/ 384175 h 1393825"/>
              <a:gd name="connsiteX2" fmla="*/ 53975 w 2244725"/>
              <a:gd name="connsiteY2" fmla="*/ 371475 h 1393825"/>
              <a:gd name="connsiteX3" fmla="*/ 161925 w 2244725"/>
              <a:gd name="connsiteY3" fmla="*/ 365125 h 1393825"/>
              <a:gd name="connsiteX4" fmla="*/ 184150 w 2244725"/>
              <a:gd name="connsiteY4" fmla="*/ 358775 h 1393825"/>
              <a:gd name="connsiteX5" fmla="*/ 203200 w 2244725"/>
              <a:gd name="connsiteY5" fmla="*/ 352425 h 1393825"/>
              <a:gd name="connsiteX6" fmla="*/ 244475 w 2244725"/>
              <a:gd name="connsiteY6" fmla="*/ 342900 h 1393825"/>
              <a:gd name="connsiteX7" fmla="*/ 263525 w 2244725"/>
              <a:gd name="connsiteY7" fmla="*/ 336550 h 1393825"/>
              <a:gd name="connsiteX8" fmla="*/ 292100 w 2244725"/>
              <a:gd name="connsiteY8" fmla="*/ 320675 h 1393825"/>
              <a:gd name="connsiteX9" fmla="*/ 301625 w 2244725"/>
              <a:gd name="connsiteY9" fmla="*/ 311150 h 1393825"/>
              <a:gd name="connsiteX10" fmla="*/ 314325 w 2244725"/>
              <a:gd name="connsiteY10" fmla="*/ 292100 h 1393825"/>
              <a:gd name="connsiteX11" fmla="*/ 320675 w 2244725"/>
              <a:gd name="connsiteY11" fmla="*/ 282575 h 1393825"/>
              <a:gd name="connsiteX12" fmla="*/ 327025 w 2244725"/>
              <a:gd name="connsiteY12" fmla="*/ 273050 h 1393825"/>
              <a:gd name="connsiteX13" fmla="*/ 333375 w 2244725"/>
              <a:gd name="connsiteY13" fmla="*/ 263525 h 1393825"/>
              <a:gd name="connsiteX14" fmla="*/ 336550 w 2244725"/>
              <a:gd name="connsiteY14" fmla="*/ 254000 h 1393825"/>
              <a:gd name="connsiteX15" fmla="*/ 352425 w 2244725"/>
              <a:gd name="connsiteY15" fmla="*/ 234950 h 1393825"/>
              <a:gd name="connsiteX16" fmla="*/ 365125 w 2244725"/>
              <a:gd name="connsiteY16" fmla="*/ 215900 h 1393825"/>
              <a:gd name="connsiteX17" fmla="*/ 371475 w 2244725"/>
              <a:gd name="connsiteY17" fmla="*/ 206375 h 1393825"/>
              <a:gd name="connsiteX18" fmla="*/ 381000 w 2244725"/>
              <a:gd name="connsiteY18" fmla="*/ 200025 h 1393825"/>
              <a:gd name="connsiteX19" fmla="*/ 387350 w 2244725"/>
              <a:gd name="connsiteY19" fmla="*/ 190500 h 1393825"/>
              <a:gd name="connsiteX20" fmla="*/ 396875 w 2244725"/>
              <a:gd name="connsiteY20" fmla="*/ 184150 h 1393825"/>
              <a:gd name="connsiteX21" fmla="*/ 406400 w 2244725"/>
              <a:gd name="connsiteY21" fmla="*/ 174625 h 1393825"/>
              <a:gd name="connsiteX22" fmla="*/ 415925 w 2244725"/>
              <a:gd name="connsiteY22" fmla="*/ 168275 h 1393825"/>
              <a:gd name="connsiteX23" fmla="*/ 425450 w 2244725"/>
              <a:gd name="connsiteY23" fmla="*/ 158750 h 1393825"/>
              <a:gd name="connsiteX24" fmla="*/ 434975 w 2244725"/>
              <a:gd name="connsiteY24" fmla="*/ 152400 h 1393825"/>
              <a:gd name="connsiteX25" fmla="*/ 444500 w 2244725"/>
              <a:gd name="connsiteY25" fmla="*/ 142875 h 1393825"/>
              <a:gd name="connsiteX26" fmla="*/ 463550 w 2244725"/>
              <a:gd name="connsiteY26" fmla="*/ 136525 h 1393825"/>
              <a:gd name="connsiteX27" fmla="*/ 492125 w 2244725"/>
              <a:gd name="connsiteY27" fmla="*/ 123825 h 1393825"/>
              <a:gd name="connsiteX28" fmla="*/ 501650 w 2244725"/>
              <a:gd name="connsiteY28" fmla="*/ 120650 h 1393825"/>
              <a:gd name="connsiteX29" fmla="*/ 511175 w 2244725"/>
              <a:gd name="connsiteY29" fmla="*/ 114300 h 1393825"/>
              <a:gd name="connsiteX30" fmla="*/ 530225 w 2244725"/>
              <a:gd name="connsiteY30" fmla="*/ 107950 h 1393825"/>
              <a:gd name="connsiteX31" fmla="*/ 539750 w 2244725"/>
              <a:gd name="connsiteY31" fmla="*/ 104775 h 1393825"/>
              <a:gd name="connsiteX32" fmla="*/ 549275 w 2244725"/>
              <a:gd name="connsiteY32" fmla="*/ 101600 h 1393825"/>
              <a:gd name="connsiteX33" fmla="*/ 561975 w 2244725"/>
              <a:gd name="connsiteY33" fmla="*/ 98425 h 1393825"/>
              <a:gd name="connsiteX34" fmla="*/ 581025 w 2244725"/>
              <a:gd name="connsiteY34" fmla="*/ 92075 h 1393825"/>
              <a:gd name="connsiteX35" fmla="*/ 609600 w 2244725"/>
              <a:gd name="connsiteY35" fmla="*/ 82550 h 1393825"/>
              <a:gd name="connsiteX36" fmla="*/ 619125 w 2244725"/>
              <a:gd name="connsiteY36" fmla="*/ 79375 h 1393825"/>
              <a:gd name="connsiteX37" fmla="*/ 628650 w 2244725"/>
              <a:gd name="connsiteY37" fmla="*/ 76200 h 1393825"/>
              <a:gd name="connsiteX38" fmla="*/ 638175 w 2244725"/>
              <a:gd name="connsiteY38" fmla="*/ 69850 h 1393825"/>
              <a:gd name="connsiteX39" fmla="*/ 657225 w 2244725"/>
              <a:gd name="connsiteY39" fmla="*/ 63500 h 1393825"/>
              <a:gd name="connsiteX40" fmla="*/ 666750 w 2244725"/>
              <a:gd name="connsiteY40" fmla="*/ 57150 h 1393825"/>
              <a:gd name="connsiteX41" fmla="*/ 685800 w 2244725"/>
              <a:gd name="connsiteY41" fmla="*/ 50800 h 1393825"/>
              <a:gd name="connsiteX42" fmla="*/ 695325 w 2244725"/>
              <a:gd name="connsiteY42" fmla="*/ 47625 h 1393825"/>
              <a:gd name="connsiteX43" fmla="*/ 723900 w 2244725"/>
              <a:gd name="connsiteY43" fmla="*/ 38100 h 1393825"/>
              <a:gd name="connsiteX44" fmla="*/ 733425 w 2244725"/>
              <a:gd name="connsiteY44" fmla="*/ 34925 h 1393825"/>
              <a:gd name="connsiteX45" fmla="*/ 746125 w 2244725"/>
              <a:gd name="connsiteY45" fmla="*/ 31750 h 1393825"/>
              <a:gd name="connsiteX46" fmla="*/ 777875 w 2244725"/>
              <a:gd name="connsiteY46" fmla="*/ 25400 h 1393825"/>
              <a:gd name="connsiteX47" fmla="*/ 812800 w 2244725"/>
              <a:gd name="connsiteY47" fmla="*/ 15875 h 1393825"/>
              <a:gd name="connsiteX48" fmla="*/ 831850 w 2244725"/>
              <a:gd name="connsiteY48" fmla="*/ 12700 h 1393825"/>
              <a:gd name="connsiteX49" fmla="*/ 844550 w 2244725"/>
              <a:gd name="connsiteY49" fmla="*/ 9525 h 1393825"/>
              <a:gd name="connsiteX50" fmla="*/ 889000 w 2244725"/>
              <a:gd name="connsiteY50" fmla="*/ 6350 h 1393825"/>
              <a:gd name="connsiteX51" fmla="*/ 920750 w 2244725"/>
              <a:gd name="connsiteY51" fmla="*/ 3175 h 1393825"/>
              <a:gd name="connsiteX52" fmla="*/ 1019175 w 2244725"/>
              <a:gd name="connsiteY52" fmla="*/ 0 h 1393825"/>
              <a:gd name="connsiteX53" fmla="*/ 1079500 w 2244725"/>
              <a:gd name="connsiteY53" fmla="*/ 3175 h 1393825"/>
              <a:gd name="connsiteX54" fmla="*/ 1089025 w 2244725"/>
              <a:gd name="connsiteY54" fmla="*/ 6350 h 1393825"/>
              <a:gd name="connsiteX55" fmla="*/ 1120775 w 2244725"/>
              <a:gd name="connsiteY55" fmla="*/ 15875 h 1393825"/>
              <a:gd name="connsiteX56" fmla="*/ 1168400 w 2244725"/>
              <a:gd name="connsiteY56" fmla="*/ 31750 h 1393825"/>
              <a:gd name="connsiteX57" fmla="*/ 1200150 w 2244725"/>
              <a:gd name="connsiteY57" fmla="*/ 41275 h 1393825"/>
              <a:gd name="connsiteX58" fmla="*/ 1235075 w 2244725"/>
              <a:gd name="connsiteY58" fmla="*/ 47625 h 1393825"/>
              <a:gd name="connsiteX59" fmla="*/ 1254125 w 2244725"/>
              <a:gd name="connsiteY59" fmla="*/ 53975 h 1393825"/>
              <a:gd name="connsiteX60" fmla="*/ 1273175 w 2244725"/>
              <a:gd name="connsiteY60" fmla="*/ 60325 h 1393825"/>
              <a:gd name="connsiteX61" fmla="*/ 1292225 w 2244725"/>
              <a:gd name="connsiteY61" fmla="*/ 66675 h 1393825"/>
              <a:gd name="connsiteX62" fmla="*/ 1301750 w 2244725"/>
              <a:gd name="connsiteY62" fmla="*/ 69850 h 1393825"/>
              <a:gd name="connsiteX63" fmla="*/ 1320800 w 2244725"/>
              <a:gd name="connsiteY63" fmla="*/ 79375 h 1393825"/>
              <a:gd name="connsiteX64" fmla="*/ 1330325 w 2244725"/>
              <a:gd name="connsiteY64" fmla="*/ 85725 h 1393825"/>
              <a:gd name="connsiteX65" fmla="*/ 1339850 w 2244725"/>
              <a:gd name="connsiteY65" fmla="*/ 88900 h 1393825"/>
              <a:gd name="connsiteX66" fmla="*/ 1358900 w 2244725"/>
              <a:gd name="connsiteY66" fmla="*/ 101600 h 1393825"/>
              <a:gd name="connsiteX67" fmla="*/ 1377950 w 2244725"/>
              <a:gd name="connsiteY67" fmla="*/ 107950 h 1393825"/>
              <a:gd name="connsiteX68" fmla="*/ 1387475 w 2244725"/>
              <a:gd name="connsiteY68" fmla="*/ 114300 h 1393825"/>
              <a:gd name="connsiteX69" fmla="*/ 1406525 w 2244725"/>
              <a:gd name="connsiteY69" fmla="*/ 120650 h 1393825"/>
              <a:gd name="connsiteX70" fmla="*/ 1435100 w 2244725"/>
              <a:gd name="connsiteY70" fmla="*/ 139700 h 1393825"/>
              <a:gd name="connsiteX71" fmla="*/ 1444625 w 2244725"/>
              <a:gd name="connsiteY71" fmla="*/ 146050 h 1393825"/>
              <a:gd name="connsiteX72" fmla="*/ 1454150 w 2244725"/>
              <a:gd name="connsiteY72" fmla="*/ 152400 h 1393825"/>
              <a:gd name="connsiteX73" fmla="*/ 1473200 w 2244725"/>
              <a:gd name="connsiteY73" fmla="*/ 168275 h 1393825"/>
              <a:gd name="connsiteX74" fmla="*/ 1482725 w 2244725"/>
              <a:gd name="connsiteY74" fmla="*/ 171450 h 1393825"/>
              <a:gd name="connsiteX75" fmla="*/ 1501775 w 2244725"/>
              <a:gd name="connsiteY75" fmla="*/ 184150 h 1393825"/>
              <a:gd name="connsiteX76" fmla="*/ 1517650 w 2244725"/>
              <a:gd name="connsiteY76" fmla="*/ 196850 h 1393825"/>
              <a:gd name="connsiteX77" fmla="*/ 1533525 w 2244725"/>
              <a:gd name="connsiteY77" fmla="*/ 209550 h 1393825"/>
              <a:gd name="connsiteX78" fmla="*/ 1543050 w 2244725"/>
              <a:gd name="connsiteY78" fmla="*/ 219075 h 1393825"/>
              <a:gd name="connsiteX79" fmla="*/ 1552575 w 2244725"/>
              <a:gd name="connsiteY79" fmla="*/ 225425 h 1393825"/>
              <a:gd name="connsiteX80" fmla="*/ 1558925 w 2244725"/>
              <a:gd name="connsiteY80" fmla="*/ 234950 h 1393825"/>
              <a:gd name="connsiteX81" fmla="*/ 1568450 w 2244725"/>
              <a:gd name="connsiteY81" fmla="*/ 238125 h 1393825"/>
              <a:gd name="connsiteX82" fmla="*/ 1587500 w 2244725"/>
              <a:gd name="connsiteY82" fmla="*/ 247650 h 1393825"/>
              <a:gd name="connsiteX83" fmla="*/ 1597025 w 2244725"/>
              <a:gd name="connsiteY83" fmla="*/ 257175 h 1393825"/>
              <a:gd name="connsiteX84" fmla="*/ 1616075 w 2244725"/>
              <a:gd name="connsiteY84" fmla="*/ 269875 h 1393825"/>
              <a:gd name="connsiteX85" fmla="*/ 1625600 w 2244725"/>
              <a:gd name="connsiteY85" fmla="*/ 279400 h 1393825"/>
              <a:gd name="connsiteX86" fmla="*/ 1644650 w 2244725"/>
              <a:gd name="connsiteY86" fmla="*/ 292100 h 1393825"/>
              <a:gd name="connsiteX87" fmla="*/ 1651000 w 2244725"/>
              <a:gd name="connsiteY87" fmla="*/ 301625 h 1393825"/>
              <a:gd name="connsiteX88" fmla="*/ 1670050 w 2244725"/>
              <a:gd name="connsiteY88" fmla="*/ 314325 h 1393825"/>
              <a:gd name="connsiteX89" fmla="*/ 1685925 w 2244725"/>
              <a:gd name="connsiteY89" fmla="*/ 330200 h 1393825"/>
              <a:gd name="connsiteX90" fmla="*/ 1701800 w 2244725"/>
              <a:gd name="connsiteY90" fmla="*/ 349250 h 1393825"/>
              <a:gd name="connsiteX91" fmla="*/ 1711325 w 2244725"/>
              <a:gd name="connsiteY91" fmla="*/ 355600 h 1393825"/>
              <a:gd name="connsiteX92" fmla="*/ 1724025 w 2244725"/>
              <a:gd name="connsiteY92" fmla="*/ 374650 h 1393825"/>
              <a:gd name="connsiteX93" fmla="*/ 1736725 w 2244725"/>
              <a:gd name="connsiteY93" fmla="*/ 393700 h 1393825"/>
              <a:gd name="connsiteX94" fmla="*/ 1746250 w 2244725"/>
              <a:gd name="connsiteY94" fmla="*/ 403225 h 1393825"/>
              <a:gd name="connsiteX95" fmla="*/ 1752600 w 2244725"/>
              <a:gd name="connsiteY95" fmla="*/ 412750 h 1393825"/>
              <a:gd name="connsiteX96" fmla="*/ 1762125 w 2244725"/>
              <a:gd name="connsiteY96" fmla="*/ 419100 h 1393825"/>
              <a:gd name="connsiteX97" fmla="*/ 1784350 w 2244725"/>
              <a:gd name="connsiteY97" fmla="*/ 444500 h 1393825"/>
              <a:gd name="connsiteX98" fmla="*/ 1790700 w 2244725"/>
              <a:gd name="connsiteY98" fmla="*/ 454025 h 1393825"/>
              <a:gd name="connsiteX99" fmla="*/ 1809750 w 2244725"/>
              <a:gd name="connsiteY99" fmla="*/ 469900 h 1393825"/>
              <a:gd name="connsiteX100" fmla="*/ 1816100 w 2244725"/>
              <a:gd name="connsiteY100" fmla="*/ 479425 h 1393825"/>
              <a:gd name="connsiteX101" fmla="*/ 1835150 w 2244725"/>
              <a:gd name="connsiteY101" fmla="*/ 492125 h 1393825"/>
              <a:gd name="connsiteX102" fmla="*/ 1851025 w 2244725"/>
              <a:gd name="connsiteY102" fmla="*/ 511175 h 1393825"/>
              <a:gd name="connsiteX103" fmla="*/ 1863725 w 2244725"/>
              <a:gd name="connsiteY103" fmla="*/ 530225 h 1393825"/>
              <a:gd name="connsiteX104" fmla="*/ 1882775 w 2244725"/>
              <a:gd name="connsiteY104" fmla="*/ 558800 h 1393825"/>
              <a:gd name="connsiteX105" fmla="*/ 1889125 w 2244725"/>
              <a:gd name="connsiteY105" fmla="*/ 568325 h 1393825"/>
              <a:gd name="connsiteX106" fmla="*/ 1895475 w 2244725"/>
              <a:gd name="connsiteY106" fmla="*/ 577850 h 1393825"/>
              <a:gd name="connsiteX107" fmla="*/ 1905000 w 2244725"/>
              <a:gd name="connsiteY107" fmla="*/ 587375 h 1393825"/>
              <a:gd name="connsiteX108" fmla="*/ 1917700 w 2244725"/>
              <a:gd name="connsiteY108" fmla="*/ 615950 h 1393825"/>
              <a:gd name="connsiteX109" fmla="*/ 1920875 w 2244725"/>
              <a:gd name="connsiteY109" fmla="*/ 625475 h 1393825"/>
              <a:gd name="connsiteX110" fmla="*/ 1927225 w 2244725"/>
              <a:gd name="connsiteY110" fmla="*/ 635000 h 1393825"/>
              <a:gd name="connsiteX111" fmla="*/ 1930400 w 2244725"/>
              <a:gd name="connsiteY111" fmla="*/ 644525 h 1393825"/>
              <a:gd name="connsiteX112" fmla="*/ 1936750 w 2244725"/>
              <a:gd name="connsiteY112" fmla="*/ 654050 h 1393825"/>
              <a:gd name="connsiteX113" fmla="*/ 1943100 w 2244725"/>
              <a:gd name="connsiteY113" fmla="*/ 673100 h 1393825"/>
              <a:gd name="connsiteX114" fmla="*/ 1946275 w 2244725"/>
              <a:gd name="connsiteY114" fmla="*/ 682625 h 1393825"/>
              <a:gd name="connsiteX115" fmla="*/ 1949450 w 2244725"/>
              <a:gd name="connsiteY115" fmla="*/ 692150 h 1393825"/>
              <a:gd name="connsiteX116" fmla="*/ 1987550 w 2244725"/>
              <a:gd name="connsiteY116" fmla="*/ 749300 h 1393825"/>
              <a:gd name="connsiteX117" fmla="*/ 1993900 w 2244725"/>
              <a:gd name="connsiteY117" fmla="*/ 758825 h 1393825"/>
              <a:gd name="connsiteX118" fmla="*/ 2000250 w 2244725"/>
              <a:gd name="connsiteY118" fmla="*/ 768350 h 1393825"/>
              <a:gd name="connsiteX119" fmla="*/ 2028825 w 2244725"/>
              <a:gd name="connsiteY119" fmla="*/ 784225 h 1393825"/>
              <a:gd name="connsiteX120" fmla="*/ 2038350 w 2244725"/>
              <a:gd name="connsiteY120" fmla="*/ 790575 h 1393825"/>
              <a:gd name="connsiteX121" fmla="*/ 2047875 w 2244725"/>
              <a:gd name="connsiteY121" fmla="*/ 796925 h 1393825"/>
              <a:gd name="connsiteX122" fmla="*/ 2054225 w 2244725"/>
              <a:gd name="connsiteY122" fmla="*/ 806450 h 1393825"/>
              <a:gd name="connsiteX123" fmla="*/ 2063750 w 2244725"/>
              <a:gd name="connsiteY123" fmla="*/ 809625 h 1393825"/>
              <a:gd name="connsiteX124" fmla="*/ 2073275 w 2244725"/>
              <a:gd name="connsiteY124" fmla="*/ 815975 h 1393825"/>
              <a:gd name="connsiteX125" fmla="*/ 2101850 w 2244725"/>
              <a:gd name="connsiteY125" fmla="*/ 838200 h 1393825"/>
              <a:gd name="connsiteX126" fmla="*/ 2111375 w 2244725"/>
              <a:gd name="connsiteY126" fmla="*/ 844550 h 1393825"/>
              <a:gd name="connsiteX127" fmla="*/ 2120900 w 2244725"/>
              <a:gd name="connsiteY127" fmla="*/ 850900 h 1393825"/>
              <a:gd name="connsiteX128" fmla="*/ 2127250 w 2244725"/>
              <a:gd name="connsiteY128" fmla="*/ 860425 h 1393825"/>
              <a:gd name="connsiteX129" fmla="*/ 2136775 w 2244725"/>
              <a:gd name="connsiteY129" fmla="*/ 863600 h 1393825"/>
              <a:gd name="connsiteX130" fmla="*/ 2155825 w 2244725"/>
              <a:gd name="connsiteY130" fmla="*/ 876300 h 1393825"/>
              <a:gd name="connsiteX131" fmla="*/ 2165350 w 2244725"/>
              <a:gd name="connsiteY131" fmla="*/ 882650 h 1393825"/>
              <a:gd name="connsiteX132" fmla="*/ 2174875 w 2244725"/>
              <a:gd name="connsiteY132" fmla="*/ 889000 h 1393825"/>
              <a:gd name="connsiteX133" fmla="*/ 2181225 w 2244725"/>
              <a:gd name="connsiteY133" fmla="*/ 898525 h 1393825"/>
              <a:gd name="connsiteX134" fmla="*/ 2190750 w 2244725"/>
              <a:gd name="connsiteY134" fmla="*/ 908050 h 1393825"/>
              <a:gd name="connsiteX135" fmla="*/ 2197100 w 2244725"/>
              <a:gd name="connsiteY135" fmla="*/ 927100 h 1393825"/>
              <a:gd name="connsiteX136" fmla="*/ 2200275 w 2244725"/>
              <a:gd name="connsiteY136" fmla="*/ 936625 h 1393825"/>
              <a:gd name="connsiteX137" fmla="*/ 2209800 w 2244725"/>
              <a:gd name="connsiteY137" fmla="*/ 965200 h 1393825"/>
              <a:gd name="connsiteX138" fmla="*/ 2212975 w 2244725"/>
              <a:gd name="connsiteY138" fmla="*/ 974725 h 1393825"/>
              <a:gd name="connsiteX139" fmla="*/ 2216150 w 2244725"/>
              <a:gd name="connsiteY139" fmla="*/ 984250 h 1393825"/>
              <a:gd name="connsiteX140" fmla="*/ 2222500 w 2244725"/>
              <a:gd name="connsiteY140" fmla="*/ 993775 h 1393825"/>
              <a:gd name="connsiteX141" fmla="*/ 2225675 w 2244725"/>
              <a:gd name="connsiteY141" fmla="*/ 1003300 h 1393825"/>
              <a:gd name="connsiteX142" fmla="*/ 2232025 w 2244725"/>
              <a:gd name="connsiteY142" fmla="*/ 1012825 h 1393825"/>
              <a:gd name="connsiteX143" fmla="*/ 2238375 w 2244725"/>
              <a:gd name="connsiteY143" fmla="*/ 1031875 h 1393825"/>
              <a:gd name="connsiteX144" fmla="*/ 2241550 w 2244725"/>
              <a:gd name="connsiteY144" fmla="*/ 1041400 h 1393825"/>
              <a:gd name="connsiteX145" fmla="*/ 2244725 w 2244725"/>
              <a:gd name="connsiteY145" fmla="*/ 1050925 h 1393825"/>
              <a:gd name="connsiteX146" fmla="*/ 2241550 w 2244725"/>
              <a:gd name="connsiteY146" fmla="*/ 1149350 h 1393825"/>
              <a:gd name="connsiteX147" fmla="*/ 2235200 w 2244725"/>
              <a:gd name="connsiteY147" fmla="*/ 1168400 h 1393825"/>
              <a:gd name="connsiteX148" fmla="*/ 2228850 w 2244725"/>
              <a:gd name="connsiteY148" fmla="*/ 1177925 h 1393825"/>
              <a:gd name="connsiteX149" fmla="*/ 2219325 w 2244725"/>
              <a:gd name="connsiteY149" fmla="*/ 1209675 h 1393825"/>
              <a:gd name="connsiteX150" fmla="*/ 2216150 w 2244725"/>
              <a:gd name="connsiteY150" fmla="*/ 1219200 h 1393825"/>
              <a:gd name="connsiteX151" fmla="*/ 2200275 w 2244725"/>
              <a:gd name="connsiteY151" fmla="*/ 1238250 h 1393825"/>
              <a:gd name="connsiteX152" fmla="*/ 2184400 w 2244725"/>
              <a:gd name="connsiteY152" fmla="*/ 1250950 h 1393825"/>
              <a:gd name="connsiteX153" fmla="*/ 2168525 w 2244725"/>
              <a:gd name="connsiteY153" fmla="*/ 1266825 h 1393825"/>
              <a:gd name="connsiteX154" fmla="*/ 2162175 w 2244725"/>
              <a:gd name="connsiteY154" fmla="*/ 1276350 h 1393825"/>
              <a:gd name="connsiteX155" fmla="*/ 2143125 w 2244725"/>
              <a:gd name="connsiteY155" fmla="*/ 1289050 h 1393825"/>
              <a:gd name="connsiteX156" fmla="*/ 2133600 w 2244725"/>
              <a:gd name="connsiteY156" fmla="*/ 1295400 h 1393825"/>
              <a:gd name="connsiteX157" fmla="*/ 2117725 w 2244725"/>
              <a:gd name="connsiteY157" fmla="*/ 1311275 h 1393825"/>
              <a:gd name="connsiteX158" fmla="*/ 2101850 w 2244725"/>
              <a:gd name="connsiteY158" fmla="*/ 1327150 h 1393825"/>
              <a:gd name="connsiteX159" fmla="*/ 2092325 w 2244725"/>
              <a:gd name="connsiteY159" fmla="*/ 1330325 h 1393825"/>
              <a:gd name="connsiteX160" fmla="*/ 2073275 w 2244725"/>
              <a:gd name="connsiteY160" fmla="*/ 1343025 h 1393825"/>
              <a:gd name="connsiteX161" fmla="*/ 2054225 w 2244725"/>
              <a:gd name="connsiteY161" fmla="*/ 1352550 h 1393825"/>
              <a:gd name="connsiteX162" fmla="*/ 2035175 w 2244725"/>
              <a:gd name="connsiteY162" fmla="*/ 1358900 h 1393825"/>
              <a:gd name="connsiteX163" fmla="*/ 2025650 w 2244725"/>
              <a:gd name="connsiteY163" fmla="*/ 1362075 h 1393825"/>
              <a:gd name="connsiteX164" fmla="*/ 2016125 w 2244725"/>
              <a:gd name="connsiteY164" fmla="*/ 1368425 h 1393825"/>
              <a:gd name="connsiteX165" fmla="*/ 1997075 w 2244725"/>
              <a:gd name="connsiteY165" fmla="*/ 1374775 h 1393825"/>
              <a:gd name="connsiteX166" fmla="*/ 1987550 w 2244725"/>
              <a:gd name="connsiteY166" fmla="*/ 1377950 h 1393825"/>
              <a:gd name="connsiteX167" fmla="*/ 1958975 w 2244725"/>
              <a:gd name="connsiteY167" fmla="*/ 1387475 h 1393825"/>
              <a:gd name="connsiteX168" fmla="*/ 1949450 w 2244725"/>
              <a:gd name="connsiteY168" fmla="*/ 1390650 h 1393825"/>
              <a:gd name="connsiteX169" fmla="*/ 1939925 w 2244725"/>
              <a:gd name="connsiteY169" fmla="*/ 1393825 h 1393825"/>
              <a:gd name="connsiteX170" fmla="*/ 1930400 w 2244725"/>
              <a:gd name="connsiteY170" fmla="*/ 1393825 h 139382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  <a:cxn ang="0">
                <a:pos x="connsiteX31" y="connsiteY31"/>
              </a:cxn>
              <a:cxn ang="0">
                <a:pos x="connsiteX32" y="connsiteY32"/>
              </a:cxn>
              <a:cxn ang="0">
                <a:pos x="connsiteX33" y="connsiteY33"/>
              </a:cxn>
              <a:cxn ang="0">
                <a:pos x="connsiteX34" y="connsiteY34"/>
              </a:cxn>
              <a:cxn ang="0">
                <a:pos x="connsiteX35" y="connsiteY35"/>
              </a:cxn>
              <a:cxn ang="0">
                <a:pos x="connsiteX36" y="connsiteY36"/>
              </a:cxn>
              <a:cxn ang="0">
                <a:pos x="connsiteX37" y="connsiteY37"/>
              </a:cxn>
              <a:cxn ang="0">
                <a:pos x="connsiteX38" y="connsiteY38"/>
              </a:cxn>
              <a:cxn ang="0">
                <a:pos x="connsiteX39" y="connsiteY39"/>
              </a:cxn>
              <a:cxn ang="0">
                <a:pos x="connsiteX40" y="connsiteY40"/>
              </a:cxn>
              <a:cxn ang="0">
                <a:pos x="connsiteX41" y="connsiteY41"/>
              </a:cxn>
              <a:cxn ang="0">
                <a:pos x="connsiteX42" y="connsiteY42"/>
              </a:cxn>
              <a:cxn ang="0">
                <a:pos x="connsiteX43" y="connsiteY43"/>
              </a:cxn>
              <a:cxn ang="0">
                <a:pos x="connsiteX44" y="connsiteY44"/>
              </a:cxn>
              <a:cxn ang="0">
                <a:pos x="connsiteX45" y="connsiteY45"/>
              </a:cxn>
              <a:cxn ang="0">
                <a:pos x="connsiteX46" y="connsiteY46"/>
              </a:cxn>
              <a:cxn ang="0">
                <a:pos x="connsiteX47" y="connsiteY47"/>
              </a:cxn>
              <a:cxn ang="0">
                <a:pos x="connsiteX48" y="connsiteY48"/>
              </a:cxn>
              <a:cxn ang="0">
                <a:pos x="connsiteX49" y="connsiteY49"/>
              </a:cxn>
              <a:cxn ang="0">
                <a:pos x="connsiteX50" y="connsiteY50"/>
              </a:cxn>
              <a:cxn ang="0">
                <a:pos x="connsiteX51" y="connsiteY51"/>
              </a:cxn>
              <a:cxn ang="0">
                <a:pos x="connsiteX52" y="connsiteY52"/>
              </a:cxn>
              <a:cxn ang="0">
                <a:pos x="connsiteX53" y="connsiteY53"/>
              </a:cxn>
              <a:cxn ang="0">
                <a:pos x="connsiteX54" y="connsiteY54"/>
              </a:cxn>
              <a:cxn ang="0">
                <a:pos x="connsiteX55" y="connsiteY55"/>
              </a:cxn>
              <a:cxn ang="0">
                <a:pos x="connsiteX56" y="connsiteY56"/>
              </a:cxn>
              <a:cxn ang="0">
                <a:pos x="connsiteX57" y="connsiteY57"/>
              </a:cxn>
              <a:cxn ang="0">
                <a:pos x="connsiteX58" y="connsiteY58"/>
              </a:cxn>
              <a:cxn ang="0">
                <a:pos x="connsiteX59" y="connsiteY59"/>
              </a:cxn>
              <a:cxn ang="0">
                <a:pos x="connsiteX60" y="connsiteY60"/>
              </a:cxn>
              <a:cxn ang="0">
                <a:pos x="connsiteX61" y="connsiteY61"/>
              </a:cxn>
              <a:cxn ang="0">
                <a:pos x="connsiteX62" y="connsiteY62"/>
              </a:cxn>
              <a:cxn ang="0">
                <a:pos x="connsiteX63" y="connsiteY63"/>
              </a:cxn>
              <a:cxn ang="0">
                <a:pos x="connsiteX64" y="connsiteY64"/>
              </a:cxn>
              <a:cxn ang="0">
                <a:pos x="connsiteX65" y="connsiteY65"/>
              </a:cxn>
              <a:cxn ang="0">
                <a:pos x="connsiteX66" y="connsiteY66"/>
              </a:cxn>
              <a:cxn ang="0">
                <a:pos x="connsiteX67" y="connsiteY67"/>
              </a:cxn>
              <a:cxn ang="0">
                <a:pos x="connsiteX68" y="connsiteY68"/>
              </a:cxn>
              <a:cxn ang="0">
                <a:pos x="connsiteX69" y="connsiteY69"/>
              </a:cxn>
              <a:cxn ang="0">
                <a:pos x="connsiteX70" y="connsiteY70"/>
              </a:cxn>
              <a:cxn ang="0">
                <a:pos x="connsiteX71" y="connsiteY71"/>
              </a:cxn>
              <a:cxn ang="0">
                <a:pos x="connsiteX72" y="connsiteY72"/>
              </a:cxn>
              <a:cxn ang="0">
                <a:pos x="connsiteX73" y="connsiteY73"/>
              </a:cxn>
              <a:cxn ang="0">
                <a:pos x="connsiteX74" y="connsiteY74"/>
              </a:cxn>
              <a:cxn ang="0">
                <a:pos x="connsiteX75" y="connsiteY75"/>
              </a:cxn>
              <a:cxn ang="0">
                <a:pos x="connsiteX76" y="connsiteY76"/>
              </a:cxn>
              <a:cxn ang="0">
                <a:pos x="connsiteX77" y="connsiteY77"/>
              </a:cxn>
              <a:cxn ang="0">
                <a:pos x="connsiteX78" y="connsiteY78"/>
              </a:cxn>
              <a:cxn ang="0">
                <a:pos x="connsiteX79" y="connsiteY79"/>
              </a:cxn>
              <a:cxn ang="0">
                <a:pos x="connsiteX80" y="connsiteY80"/>
              </a:cxn>
              <a:cxn ang="0">
                <a:pos x="connsiteX81" y="connsiteY81"/>
              </a:cxn>
              <a:cxn ang="0">
                <a:pos x="connsiteX82" y="connsiteY82"/>
              </a:cxn>
              <a:cxn ang="0">
                <a:pos x="connsiteX83" y="connsiteY83"/>
              </a:cxn>
              <a:cxn ang="0">
                <a:pos x="connsiteX84" y="connsiteY84"/>
              </a:cxn>
              <a:cxn ang="0">
                <a:pos x="connsiteX85" y="connsiteY85"/>
              </a:cxn>
              <a:cxn ang="0">
                <a:pos x="connsiteX86" y="connsiteY86"/>
              </a:cxn>
              <a:cxn ang="0">
                <a:pos x="connsiteX87" y="connsiteY87"/>
              </a:cxn>
              <a:cxn ang="0">
                <a:pos x="connsiteX88" y="connsiteY88"/>
              </a:cxn>
              <a:cxn ang="0">
                <a:pos x="connsiteX89" y="connsiteY89"/>
              </a:cxn>
              <a:cxn ang="0">
                <a:pos x="connsiteX90" y="connsiteY90"/>
              </a:cxn>
              <a:cxn ang="0">
                <a:pos x="connsiteX91" y="connsiteY91"/>
              </a:cxn>
              <a:cxn ang="0">
                <a:pos x="connsiteX92" y="connsiteY92"/>
              </a:cxn>
              <a:cxn ang="0">
                <a:pos x="connsiteX93" y="connsiteY93"/>
              </a:cxn>
              <a:cxn ang="0">
                <a:pos x="connsiteX94" y="connsiteY94"/>
              </a:cxn>
              <a:cxn ang="0">
                <a:pos x="connsiteX95" y="connsiteY95"/>
              </a:cxn>
              <a:cxn ang="0">
                <a:pos x="connsiteX96" y="connsiteY96"/>
              </a:cxn>
              <a:cxn ang="0">
                <a:pos x="connsiteX97" y="connsiteY97"/>
              </a:cxn>
              <a:cxn ang="0">
                <a:pos x="connsiteX98" y="connsiteY98"/>
              </a:cxn>
              <a:cxn ang="0">
                <a:pos x="connsiteX99" y="connsiteY99"/>
              </a:cxn>
              <a:cxn ang="0">
                <a:pos x="connsiteX100" y="connsiteY100"/>
              </a:cxn>
              <a:cxn ang="0">
                <a:pos x="connsiteX101" y="connsiteY101"/>
              </a:cxn>
              <a:cxn ang="0">
                <a:pos x="connsiteX102" y="connsiteY102"/>
              </a:cxn>
              <a:cxn ang="0">
                <a:pos x="connsiteX103" y="connsiteY103"/>
              </a:cxn>
              <a:cxn ang="0">
                <a:pos x="connsiteX104" y="connsiteY104"/>
              </a:cxn>
              <a:cxn ang="0">
                <a:pos x="connsiteX105" y="connsiteY105"/>
              </a:cxn>
              <a:cxn ang="0">
                <a:pos x="connsiteX106" y="connsiteY106"/>
              </a:cxn>
              <a:cxn ang="0">
                <a:pos x="connsiteX107" y="connsiteY107"/>
              </a:cxn>
              <a:cxn ang="0">
                <a:pos x="connsiteX108" y="connsiteY108"/>
              </a:cxn>
              <a:cxn ang="0">
                <a:pos x="connsiteX109" y="connsiteY109"/>
              </a:cxn>
              <a:cxn ang="0">
                <a:pos x="connsiteX110" y="connsiteY110"/>
              </a:cxn>
              <a:cxn ang="0">
                <a:pos x="connsiteX111" y="connsiteY111"/>
              </a:cxn>
              <a:cxn ang="0">
                <a:pos x="connsiteX112" y="connsiteY112"/>
              </a:cxn>
              <a:cxn ang="0">
                <a:pos x="connsiteX113" y="connsiteY113"/>
              </a:cxn>
              <a:cxn ang="0">
                <a:pos x="connsiteX114" y="connsiteY114"/>
              </a:cxn>
              <a:cxn ang="0">
                <a:pos x="connsiteX115" y="connsiteY115"/>
              </a:cxn>
              <a:cxn ang="0">
                <a:pos x="connsiteX116" y="connsiteY116"/>
              </a:cxn>
              <a:cxn ang="0">
                <a:pos x="connsiteX117" y="connsiteY117"/>
              </a:cxn>
              <a:cxn ang="0">
                <a:pos x="connsiteX118" y="connsiteY118"/>
              </a:cxn>
              <a:cxn ang="0">
                <a:pos x="connsiteX119" y="connsiteY119"/>
              </a:cxn>
              <a:cxn ang="0">
                <a:pos x="connsiteX120" y="connsiteY120"/>
              </a:cxn>
              <a:cxn ang="0">
                <a:pos x="connsiteX121" y="connsiteY121"/>
              </a:cxn>
              <a:cxn ang="0">
                <a:pos x="connsiteX122" y="connsiteY122"/>
              </a:cxn>
              <a:cxn ang="0">
                <a:pos x="connsiteX123" y="connsiteY123"/>
              </a:cxn>
              <a:cxn ang="0">
                <a:pos x="connsiteX124" y="connsiteY124"/>
              </a:cxn>
              <a:cxn ang="0">
                <a:pos x="connsiteX125" y="connsiteY125"/>
              </a:cxn>
              <a:cxn ang="0">
                <a:pos x="connsiteX126" y="connsiteY126"/>
              </a:cxn>
              <a:cxn ang="0">
                <a:pos x="connsiteX127" y="connsiteY127"/>
              </a:cxn>
              <a:cxn ang="0">
                <a:pos x="connsiteX128" y="connsiteY128"/>
              </a:cxn>
              <a:cxn ang="0">
                <a:pos x="connsiteX129" y="connsiteY129"/>
              </a:cxn>
              <a:cxn ang="0">
                <a:pos x="connsiteX130" y="connsiteY130"/>
              </a:cxn>
              <a:cxn ang="0">
                <a:pos x="connsiteX131" y="connsiteY131"/>
              </a:cxn>
              <a:cxn ang="0">
                <a:pos x="connsiteX132" y="connsiteY132"/>
              </a:cxn>
              <a:cxn ang="0">
                <a:pos x="connsiteX133" y="connsiteY133"/>
              </a:cxn>
              <a:cxn ang="0">
                <a:pos x="connsiteX134" y="connsiteY134"/>
              </a:cxn>
              <a:cxn ang="0">
                <a:pos x="connsiteX135" y="connsiteY135"/>
              </a:cxn>
              <a:cxn ang="0">
                <a:pos x="connsiteX136" y="connsiteY136"/>
              </a:cxn>
              <a:cxn ang="0">
                <a:pos x="connsiteX137" y="connsiteY137"/>
              </a:cxn>
              <a:cxn ang="0">
                <a:pos x="connsiteX138" y="connsiteY138"/>
              </a:cxn>
              <a:cxn ang="0">
                <a:pos x="connsiteX139" y="connsiteY139"/>
              </a:cxn>
              <a:cxn ang="0">
                <a:pos x="connsiteX140" y="connsiteY140"/>
              </a:cxn>
              <a:cxn ang="0">
                <a:pos x="connsiteX141" y="connsiteY141"/>
              </a:cxn>
              <a:cxn ang="0">
                <a:pos x="connsiteX142" y="connsiteY142"/>
              </a:cxn>
              <a:cxn ang="0">
                <a:pos x="connsiteX143" y="connsiteY143"/>
              </a:cxn>
              <a:cxn ang="0">
                <a:pos x="connsiteX144" y="connsiteY144"/>
              </a:cxn>
              <a:cxn ang="0">
                <a:pos x="connsiteX145" y="connsiteY145"/>
              </a:cxn>
              <a:cxn ang="0">
                <a:pos x="connsiteX146" y="connsiteY146"/>
              </a:cxn>
              <a:cxn ang="0">
                <a:pos x="connsiteX147" y="connsiteY147"/>
              </a:cxn>
              <a:cxn ang="0">
                <a:pos x="connsiteX148" y="connsiteY148"/>
              </a:cxn>
              <a:cxn ang="0">
                <a:pos x="connsiteX149" y="connsiteY149"/>
              </a:cxn>
              <a:cxn ang="0">
                <a:pos x="connsiteX150" y="connsiteY150"/>
              </a:cxn>
              <a:cxn ang="0">
                <a:pos x="connsiteX151" y="connsiteY151"/>
              </a:cxn>
              <a:cxn ang="0">
                <a:pos x="connsiteX152" y="connsiteY152"/>
              </a:cxn>
              <a:cxn ang="0">
                <a:pos x="connsiteX153" y="connsiteY153"/>
              </a:cxn>
              <a:cxn ang="0">
                <a:pos x="connsiteX154" y="connsiteY154"/>
              </a:cxn>
              <a:cxn ang="0">
                <a:pos x="connsiteX155" y="connsiteY155"/>
              </a:cxn>
              <a:cxn ang="0">
                <a:pos x="connsiteX156" y="connsiteY156"/>
              </a:cxn>
              <a:cxn ang="0">
                <a:pos x="connsiteX157" y="connsiteY157"/>
              </a:cxn>
              <a:cxn ang="0">
                <a:pos x="connsiteX158" y="connsiteY158"/>
              </a:cxn>
              <a:cxn ang="0">
                <a:pos x="connsiteX159" y="connsiteY159"/>
              </a:cxn>
              <a:cxn ang="0">
                <a:pos x="connsiteX160" y="connsiteY160"/>
              </a:cxn>
              <a:cxn ang="0">
                <a:pos x="connsiteX161" y="connsiteY161"/>
              </a:cxn>
              <a:cxn ang="0">
                <a:pos x="connsiteX162" y="connsiteY162"/>
              </a:cxn>
              <a:cxn ang="0">
                <a:pos x="connsiteX163" y="connsiteY163"/>
              </a:cxn>
              <a:cxn ang="0">
                <a:pos x="connsiteX164" y="connsiteY164"/>
              </a:cxn>
              <a:cxn ang="0">
                <a:pos x="connsiteX165" y="connsiteY165"/>
              </a:cxn>
              <a:cxn ang="0">
                <a:pos x="connsiteX166" y="connsiteY166"/>
              </a:cxn>
              <a:cxn ang="0">
                <a:pos x="connsiteX167" y="connsiteY167"/>
              </a:cxn>
              <a:cxn ang="0">
                <a:pos x="connsiteX168" y="connsiteY168"/>
              </a:cxn>
              <a:cxn ang="0">
                <a:pos x="connsiteX169" y="connsiteY169"/>
              </a:cxn>
              <a:cxn ang="0">
                <a:pos x="connsiteX170" y="connsiteY170"/>
              </a:cxn>
            </a:cxnLst>
            <a:rect l="l" t="t" r="r" b="b"/>
            <a:pathLst>
              <a:path w="2244725" h="1393825">
                <a:moveTo>
                  <a:pt x="0" y="390525"/>
                </a:moveTo>
                <a:cubicBezTo>
                  <a:pt x="6038" y="389317"/>
                  <a:pt x="18891" y="387429"/>
                  <a:pt x="25400" y="384175"/>
                </a:cubicBezTo>
                <a:cubicBezTo>
                  <a:pt x="38608" y="377571"/>
                  <a:pt x="34614" y="372964"/>
                  <a:pt x="53975" y="371475"/>
                </a:cubicBezTo>
                <a:cubicBezTo>
                  <a:pt x="117435" y="366593"/>
                  <a:pt x="81467" y="368956"/>
                  <a:pt x="161925" y="365125"/>
                </a:cubicBezTo>
                <a:cubicBezTo>
                  <a:pt x="193936" y="354455"/>
                  <a:pt x="144283" y="370735"/>
                  <a:pt x="184150" y="358775"/>
                </a:cubicBezTo>
                <a:cubicBezTo>
                  <a:pt x="190561" y="356852"/>
                  <a:pt x="196636" y="353738"/>
                  <a:pt x="203200" y="352425"/>
                </a:cubicBezTo>
                <a:cubicBezTo>
                  <a:pt x="215793" y="349906"/>
                  <a:pt x="232987" y="346729"/>
                  <a:pt x="244475" y="342900"/>
                </a:cubicBezTo>
                <a:lnTo>
                  <a:pt x="263525" y="336550"/>
                </a:lnTo>
                <a:cubicBezTo>
                  <a:pt x="275503" y="332557"/>
                  <a:pt x="281183" y="331592"/>
                  <a:pt x="292100" y="320675"/>
                </a:cubicBezTo>
                <a:cubicBezTo>
                  <a:pt x="295275" y="317500"/>
                  <a:pt x="298868" y="314694"/>
                  <a:pt x="301625" y="311150"/>
                </a:cubicBezTo>
                <a:cubicBezTo>
                  <a:pt x="306310" y="305126"/>
                  <a:pt x="310092" y="298450"/>
                  <a:pt x="314325" y="292100"/>
                </a:cubicBezTo>
                <a:lnTo>
                  <a:pt x="320675" y="282575"/>
                </a:lnTo>
                <a:lnTo>
                  <a:pt x="327025" y="273050"/>
                </a:lnTo>
                <a:cubicBezTo>
                  <a:pt x="329142" y="269875"/>
                  <a:pt x="332168" y="267145"/>
                  <a:pt x="333375" y="263525"/>
                </a:cubicBezTo>
                <a:cubicBezTo>
                  <a:pt x="334433" y="260350"/>
                  <a:pt x="335053" y="256993"/>
                  <a:pt x="336550" y="254000"/>
                </a:cubicBezTo>
                <a:cubicBezTo>
                  <a:pt x="343357" y="240385"/>
                  <a:pt x="342594" y="247589"/>
                  <a:pt x="352425" y="234950"/>
                </a:cubicBezTo>
                <a:cubicBezTo>
                  <a:pt x="357110" y="228926"/>
                  <a:pt x="360892" y="222250"/>
                  <a:pt x="365125" y="215900"/>
                </a:cubicBezTo>
                <a:cubicBezTo>
                  <a:pt x="367242" y="212725"/>
                  <a:pt x="368300" y="208492"/>
                  <a:pt x="371475" y="206375"/>
                </a:cubicBezTo>
                <a:lnTo>
                  <a:pt x="381000" y="200025"/>
                </a:lnTo>
                <a:cubicBezTo>
                  <a:pt x="383117" y="196850"/>
                  <a:pt x="384652" y="193198"/>
                  <a:pt x="387350" y="190500"/>
                </a:cubicBezTo>
                <a:cubicBezTo>
                  <a:pt x="390048" y="187802"/>
                  <a:pt x="393944" y="186593"/>
                  <a:pt x="396875" y="184150"/>
                </a:cubicBezTo>
                <a:cubicBezTo>
                  <a:pt x="400324" y="181275"/>
                  <a:pt x="402951" y="177500"/>
                  <a:pt x="406400" y="174625"/>
                </a:cubicBezTo>
                <a:cubicBezTo>
                  <a:pt x="409331" y="172182"/>
                  <a:pt x="412994" y="170718"/>
                  <a:pt x="415925" y="168275"/>
                </a:cubicBezTo>
                <a:cubicBezTo>
                  <a:pt x="419374" y="165400"/>
                  <a:pt x="422001" y="161625"/>
                  <a:pt x="425450" y="158750"/>
                </a:cubicBezTo>
                <a:cubicBezTo>
                  <a:pt x="428381" y="156307"/>
                  <a:pt x="432044" y="154843"/>
                  <a:pt x="434975" y="152400"/>
                </a:cubicBezTo>
                <a:cubicBezTo>
                  <a:pt x="438424" y="149525"/>
                  <a:pt x="440575" y="145056"/>
                  <a:pt x="444500" y="142875"/>
                </a:cubicBezTo>
                <a:cubicBezTo>
                  <a:pt x="450351" y="139624"/>
                  <a:pt x="457981" y="140238"/>
                  <a:pt x="463550" y="136525"/>
                </a:cubicBezTo>
                <a:cubicBezTo>
                  <a:pt x="478644" y="126462"/>
                  <a:pt x="469455" y="131382"/>
                  <a:pt x="492125" y="123825"/>
                </a:cubicBezTo>
                <a:cubicBezTo>
                  <a:pt x="495300" y="122767"/>
                  <a:pt x="498865" y="122506"/>
                  <a:pt x="501650" y="120650"/>
                </a:cubicBezTo>
                <a:cubicBezTo>
                  <a:pt x="504825" y="118533"/>
                  <a:pt x="507688" y="115850"/>
                  <a:pt x="511175" y="114300"/>
                </a:cubicBezTo>
                <a:cubicBezTo>
                  <a:pt x="517292" y="111582"/>
                  <a:pt x="523875" y="110067"/>
                  <a:pt x="530225" y="107950"/>
                </a:cubicBezTo>
                <a:lnTo>
                  <a:pt x="539750" y="104775"/>
                </a:lnTo>
                <a:cubicBezTo>
                  <a:pt x="542925" y="103717"/>
                  <a:pt x="546028" y="102412"/>
                  <a:pt x="549275" y="101600"/>
                </a:cubicBezTo>
                <a:cubicBezTo>
                  <a:pt x="553508" y="100542"/>
                  <a:pt x="557795" y="99679"/>
                  <a:pt x="561975" y="98425"/>
                </a:cubicBezTo>
                <a:cubicBezTo>
                  <a:pt x="568386" y="96502"/>
                  <a:pt x="574675" y="94192"/>
                  <a:pt x="581025" y="92075"/>
                </a:cubicBezTo>
                <a:lnTo>
                  <a:pt x="609600" y="82550"/>
                </a:lnTo>
                <a:lnTo>
                  <a:pt x="619125" y="79375"/>
                </a:lnTo>
                <a:cubicBezTo>
                  <a:pt x="622300" y="78317"/>
                  <a:pt x="625865" y="78056"/>
                  <a:pt x="628650" y="76200"/>
                </a:cubicBezTo>
                <a:cubicBezTo>
                  <a:pt x="631825" y="74083"/>
                  <a:pt x="634688" y="71400"/>
                  <a:pt x="638175" y="69850"/>
                </a:cubicBezTo>
                <a:cubicBezTo>
                  <a:pt x="644292" y="67132"/>
                  <a:pt x="651656" y="67213"/>
                  <a:pt x="657225" y="63500"/>
                </a:cubicBezTo>
                <a:cubicBezTo>
                  <a:pt x="660400" y="61383"/>
                  <a:pt x="663263" y="58700"/>
                  <a:pt x="666750" y="57150"/>
                </a:cubicBezTo>
                <a:cubicBezTo>
                  <a:pt x="672867" y="54432"/>
                  <a:pt x="679450" y="52917"/>
                  <a:pt x="685800" y="50800"/>
                </a:cubicBezTo>
                <a:lnTo>
                  <a:pt x="695325" y="47625"/>
                </a:lnTo>
                <a:lnTo>
                  <a:pt x="723900" y="38100"/>
                </a:lnTo>
                <a:cubicBezTo>
                  <a:pt x="727075" y="37042"/>
                  <a:pt x="730178" y="35737"/>
                  <a:pt x="733425" y="34925"/>
                </a:cubicBezTo>
                <a:cubicBezTo>
                  <a:pt x="737658" y="33867"/>
                  <a:pt x="741858" y="32664"/>
                  <a:pt x="746125" y="31750"/>
                </a:cubicBezTo>
                <a:cubicBezTo>
                  <a:pt x="756678" y="29489"/>
                  <a:pt x="767636" y="28813"/>
                  <a:pt x="777875" y="25400"/>
                </a:cubicBezTo>
                <a:cubicBezTo>
                  <a:pt x="790187" y="21296"/>
                  <a:pt x="798477" y="18262"/>
                  <a:pt x="812800" y="15875"/>
                </a:cubicBezTo>
                <a:cubicBezTo>
                  <a:pt x="819150" y="14817"/>
                  <a:pt x="825537" y="13963"/>
                  <a:pt x="831850" y="12700"/>
                </a:cubicBezTo>
                <a:cubicBezTo>
                  <a:pt x="836129" y="11844"/>
                  <a:pt x="840213" y="10007"/>
                  <a:pt x="844550" y="9525"/>
                </a:cubicBezTo>
                <a:cubicBezTo>
                  <a:pt x="859314" y="7885"/>
                  <a:pt x="874197" y="7584"/>
                  <a:pt x="889000" y="6350"/>
                </a:cubicBezTo>
                <a:cubicBezTo>
                  <a:pt x="899599" y="5467"/>
                  <a:pt x="910127" y="3693"/>
                  <a:pt x="920750" y="3175"/>
                </a:cubicBezTo>
                <a:cubicBezTo>
                  <a:pt x="953536" y="1576"/>
                  <a:pt x="986367" y="1058"/>
                  <a:pt x="1019175" y="0"/>
                </a:cubicBezTo>
                <a:cubicBezTo>
                  <a:pt x="1039283" y="1058"/>
                  <a:pt x="1059447" y="1352"/>
                  <a:pt x="1079500" y="3175"/>
                </a:cubicBezTo>
                <a:cubicBezTo>
                  <a:pt x="1082833" y="3478"/>
                  <a:pt x="1085807" y="5431"/>
                  <a:pt x="1089025" y="6350"/>
                </a:cubicBezTo>
                <a:cubicBezTo>
                  <a:pt x="1122614" y="15947"/>
                  <a:pt x="1075504" y="785"/>
                  <a:pt x="1120775" y="15875"/>
                </a:cubicBezTo>
                <a:lnTo>
                  <a:pt x="1168400" y="31750"/>
                </a:lnTo>
                <a:cubicBezTo>
                  <a:pt x="1178926" y="35259"/>
                  <a:pt x="1189236" y="39092"/>
                  <a:pt x="1200150" y="41275"/>
                </a:cubicBezTo>
                <a:cubicBezTo>
                  <a:pt x="1209226" y="43090"/>
                  <a:pt x="1225711" y="45071"/>
                  <a:pt x="1235075" y="47625"/>
                </a:cubicBezTo>
                <a:cubicBezTo>
                  <a:pt x="1241533" y="49386"/>
                  <a:pt x="1247775" y="51858"/>
                  <a:pt x="1254125" y="53975"/>
                </a:cubicBezTo>
                <a:lnTo>
                  <a:pt x="1273175" y="60325"/>
                </a:lnTo>
                <a:lnTo>
                  <a:pt x="1292225" y="66675"/>
                </a:lnTo>
                <a:cubicBezTo>
                  <a:pt x="1295400" y="67733"/>
                  <a:pt x="1298965" y="67994"/>
                  <a:pt x="1301750" y="69850"/>
                </a:cubicBezTo>
                <a:cubicBezTo>
                  <a:pt x="1329047" y="88048"/>
                  <a:pt x="1294510" y="66230"/>
                  <a:pt x="1320800" y="79375"/>
                </a:cubicBezTo>
                <a:cubicBezTo>
                  <a:pt x="1324213" y="81082"/>
                  <a:pt x="1326912" y="84018"/>
                  <a:pt x="1330325" y="85725"/>
                </a:cubicBezTo>
                <a:cubicBezTo>
                  <a:pt x="1333318" y="87222"/>
                  <a:pt x="1336924" y="87275"/>
                  <a:pt x="1339850" y="88900"/>
                </a:cubicBezTo>
                <a:cubicBezTo>
                  <a:pt x="1346521" y="92606"/>
                  <a:pt x="1351660" y="99187"/>
                  <a:pt x="1358900" y="101600"/>
                </a:cubicBezTo>
                <a:cubicBezTo>
                  <a:pt x="1365250" y="103717"/>
                  <a:pt x="1372381" y="104237"/>
                  <a:pt x="1377950" y="107950"/>
                </a:cubicBezTo>
                <a:cubicBezTo>
                  <a:pt x="1381125" y="110067"/>
                  <a:pt x="1383988" y="112750"/>
                  <a:pt x="1387475" y="114300"/>
                </a:cubicBezTo>
                <a:cubicBezTo>
                  <a:pt x="1393592" y="117018"/>
                  <a:pt x="1400956" y="116937"/>
                  <a:pt x="1406525" y="120650"/>
                </a:cubicBezTo>
                <a:lnTo>
                  <a:pt x="1435100" y="139700"/>
                </a:lnTo>
                <a:lnTo>
                  <a:pt x="1444625" y="146050"/>
                </a:lnTo>
                <a:cubicBezTo>
                  <a:pt x="1447800" y="148167"/>
                  <a:pt x="1451452" y="149702"/>
                  <a:pt x="1454150" y="152400"/>
                </a:cubicBezTo>
                <a:cubicBezTo>
                  <a:pt x="1461172" y="159422"/>
                  <a:pt x="1464359" y="163855"/>
                  <a:pt x="1473200" y="168275"/>
                </a:cubicBezTo>
                <a:cubicBezTo>
                  <a:pt x="1476193" y="169772"/>
                  <a:pt x="1479799" y="169825"/>
                  <a:pt x="1482725" y="171450"/>
                </a:cubicBezTo>
                <a:cubicBezTo>
                  <a:pt x="1489396" y="175156"/>
                  <a:pt x="1501775" y="184150"/>
                  <a:pt x="1501775" y="184150"/>
                </a:cubicBezTo>
                <a:cubicBezTo>
                  <a:pt x="1519973" y="211447"/>
                  <a:pt x="1495742" y="179323"/>
                  <a:pt x="1517650" y="196850"/>
                </a:cubicBezTo>
                <a:cubicBezTo>
                  <a:pt x="1538166" y="213263"/>
                  <a:pt x="1509584" y="201570"/>
                  <a:pt x="1533525" y="209550"/>
                </a:cubicBezTo>
                <a:cubicBezTo>
                  <a:pt x="1536700" y="212725"/>
                  <a:pt x="1539601" y="216200"/>
                  <a:pt x="1543050" y="219075"/>
                </a:cubicBezTo>
                <a:cubicBezTo>
                  <a:pt x="1545981" y="221518"/>
                  <a:pt x="1549877" y="222727"/>
                  <a:pt x="1552575" y="225425"/>
                </a:cubicBezTo>
                <a:cubicBezTo>
                  <a:pt x="1555273" y="228123"/>
                  <a:pt x="1555945" y="232566"/>
                  <a:pt x="1558925" y="234950"/>
                </a:cubicBezTo>
                <a:cubicBezTo>
                  <a:pt x="1561538" y="237041"/>
                  <a:pt x="1565457" y="236628"/>
                  <a:pt x="1568450" y="238125"/>
                </a:cubicBezTo>
                <a:cubicBezTo>
                  <a:pt x="1593069" y="250435"/>
                  <a:pt x="1563559" y="239670"/>
                  <a:pt x="1587500" y="247650"/>
                </a:cubicBezTo>
                <a:cubicBezTo>
                  <a:pt x="1590675" y="250825"/>
                  <a:pt x="1593481" y="254418"/>
                  <a:pt x="1597025" y="257175"/>
                </a:cubicBezTo>
                <a:cubicBezTo>
                  <a:pt x="1603049" y="261860"/>
                  <a:pt x="1610679" y="264479"/>
                  <a:pt x="1616075" y="269875"/>
                </a:cubicBezTo>
                <a:cubicBezTo>
                  <a:pt x="1619250" y="273050"/>
                  <a:pt x="1622056" y="276643"/>
                  <a:pt x="1625600" y="279400"/>
                </a:cubicBezTo>
                <a:cubicBezTo>
                  <a:pt x="1631624" y="284085"/>
                  <a:pt x="1644650" y="292100"/>
                  <a:pt x="1644650" y="292100"/>
                </a:cubicBezTo>
                <a:cubicBezTo>
                  <a:pt x="1646767" y="295275"/>
                  <a:pt x="1648128" y="299112"/>
                  <a:pt x="1651000" y="301625"/>
                </a:cubicBezTo>
                <a:cubicBezTo>
                  <a:pt x="1656743" y="306651"/>
                  <a:pt x="1670050" y="314325"/>
                  <a:pt x="1670050" y="314325"/>
                </a:cubicBezTo>
                <a:cubicBezTo>
                  <a:pt x="1681692" y="331787"/>
                  <a:pt x="1670050" y="316971"/>
                  <a:pt x="1685925" y="330200"/>
                </a:cubicBezTo>
                <a:cubicBezTo>
                  <a:pt x="1717133" y="356207"/>
                  <a:pt x="1676825" y="324275"/>
                  <a:pt x="1701800" y="349250"/>
                </a:cubicBezTo>
                <a:cubicBezTo>
                  <a:pt x="1704498" y="351948"/>
                  <a:pt x="1708150" y="353483"/>
                  <a:pt x="1711325" y="355600"/>
                </a:cubicBezTo>
                <a:cubicBezTo>
                  <a:pt x="1717397" y="373816"/>
                  <a:pt x="1710152" y="356813"/>
                  <a:pt x="1724025" y="374650"/>
                </a:cubicBezTo>
                <a:cubicBezTo>
                  <a:pt x="1728710" y="380674"/>
                  <a:pt x="1732492" y="387350"/>
                  <a:pt x="1736725" y="393700"/>
                </a:cubicBezTo>
                <a:cubicBezTo>
                  <a:pt x="1739216" y="397436"/>
                  <a:pt x="1743375" y="399776"/>
                  <a:pt x="1746250" y="403225"/>
                </a:cubicBezTo>
                <a:cubicBezTo>
                  <a:pt x="1748693" y="406156"/>
                  <a:pt x="1749902" y="410052"/>
                  <a:pt x="1752600" y="412750"/>
                </a:cubicBezTo>
                <a:cubicBezTo>
                  <a:pt x="1755298" y="415448"/>
                  <a:pt x="1758950" y="416983"/>
                  <a:pt x="1762125" y="419100"/>
                </a:cubicBezTo>
                <a:cubicBezTo>
                  <a:pt x="1776942" y="441325"/>
                  <a:pt x="1768475" y="433917"/>
                  <a:pt x="1784350" y="444500"/>
                </a:cubicBezTo>
                <a:cubicBezTo>
                  <a:pt x="1786467" y="447675"/>
                  <a:pt x="1788257" y="451094"/>
                  <a:pt x="1790700" y="454025"/>
                </a:cubicBezTo>
                <a:cubicBezTo>
                  <a:pt x="1798340" y="463192"/>
                  <a:pt x="1800384" y="463656"/>
                  <a:pt x="1809750" y="469900"/>
                </a:cubicBezTo>
                <a:cubicBezTo>
                  <a:pt x="1811867" y="473075"/>
                  <a:pt x="1813228" y="476912"/>
                  <a:pt x="1816100" y="479425"/>
                </a:cubicBezTo>
                <a:cubicBezTo>
                  <a:pt x="1821843" y="484451"/>
                  <a:pt x="1835150" y="492125"/>
                  <a:pt x="1835150" y="492125"/>
                </a:cubicBezTo>
                <a:cubicBezTo>
                  <a:pt x="1857841" y="526162"/>
                  <a:pt x="1822504" y="474505"/>
                  <a:pt x="1851025" y="511175"/>
                </a:cubicBezTo>
                <a:cubicBezTo>
                  <a:pt x="1855710" y="517199"/>
                  <a:pt x="1859492" y="523875"/>
                  <a:pt x="1863725" y="530225"/>
                </a:cubicBezTo>
                <a:lnTo>
                  <a:pt x="1882775" y="558800"/>
                </a:lnTo>
                <a:lnTo>
                  <a:pt x="1889125" y="568325"/>
                </a:lnTo>
                <a:cubicBezTo>
                  <a:pt x="1891242" y="571500"/>
                  <a:pt x="1892777" y="575152"/>
                  <a:pt x="1895475" y="577850"/>
                </a:cubicBezTo>
                <a:lnTo>
                  <a:pt x="1905000" y="587375"/>
                </a:lnTo>
                <a:cubicBezTo>
                  <a:pt x="1921382" y="636522"/>
                  <a:pt x="1902606" y="585761"/>
                  <a:pt x="1917700" y="615950"/>
                </a:cubicBezTo>
                <a:cubicBezTo>
                  <a:pt x="1919197" y="618943"/>
                  <a:pt x="1919378" y="622482"/>
                  <a:pt x="1920875" y="625475"/>
                </a:cubicBezTo>
                <a:cubicBezTo>
                  <a:pt x="1922582" y="628888"/>
                  <a:pt x="1925518" y="631587"/>
                  <a:pt x="1927225" y="635000"/>
                </a:cubicBezTo>
                <a:cubicBezTo>
                  <a:pt x="1928722" y="637993"/>
                  <a:pt x="1928903" y="641532"/>
                  <a:pt x="1930400" y="644525"/>
                </a:cubicBezTo>
                <a:cubicBezTo>
                  <a:pt x="1932107" y="647938"/>
                  <a:pt x="1935200" y="650563"/>
                  <a:pt x="1936750" y="654050"/>
                </a:cubicBezTo>
                <a:cubicBezTo>
                  <a:pt x="1939468" y="660167"/>
                  <a:pt x="1940983" y="666750"/>
                  <a:pt x="1943100" y="673100"/>
                </a:cubicBezTo>
                <a:lnTo>
                  <a:pt x="1946275" y="682625"/>
                </a:lnTo>
                <a:cubicBezTo>
                  <a:pt x="1947333" y="685800"/>
                  <a:pt x="1947594" y="689365"/>
                  <a:pt x="1949450" y="692150"/>
                </a:cubicBezTo>
                <a:lnTo>
                  <a:pt x="1987550" y="749300"/>
                </a:lnTo>
                <a:lnTo>
                  <a:pt x="1993900" y="758825"/>
                </a:lnTo>
                <a:cubicBezTo>
                  <a:pt x="1996017" y="762000"/>
                  <a:pt x="1996630" y="767143"/>
                  <a:pt x="2000250" y="768350"/>
                </a:cubicBezTo>
                <a:cubicBezTo>
                  <a:pt x="2017015" y="773938"/>
                  <a:pt x="2006990" y="769669"/>
                  <a:pt x="2028825" y="784225"/>
                </a:cubicBezTo>
                <a:lnTo>
                  <a:pt x="2038350" y="790575"/>
                </a:lnTo>
                <a:lnTo>
                  <a:pt x="2047875" y="796925"/>
                </a:lnTo>
                <a:cubicBezTo>
                  <a:pt x="2049992" y="800100"/>
                  <a:pt x="2051245" y="804066"/>
                  <a:pt x="2054225" y="806450"/>
                </a:cubicBezTo>
                <a:cubicBezTo>
                  <a:pt x="2056838" y="808541"/>
                  <a:pt x="2060757" y="808128"/>
                  <a:pt x="2063750" y="809625"/>
                </a:cubicBezTo>
                <a:cubicBezTo>
                  <a:pt x="2067163" y="811332"/>
                  <a:pt x="2070344" y="813532"/>
                  <a:pt x="2073275" y="815975"/>
                </a:cubicBezTo>
                <a:cubicBezTo>
                  <a:pt x="2103118" y="840844"/>
                  <a:pt x="2053702" y="806102"/>
                  <a:pt x="2101850" y="838200"/>
                </a:cubicBezTo>
                <a:lnTo>
                  <a:pt x="2111375" y="844550"/>
                </a:lnTo>
                <a:lnTo>
                  <a:pt x="2120900" y="850900"/>
                </a:lnTo>
                <a:cubicBezTo>
                  <a:pt x="2123017" y="854075"/>
                  <a:pt x="2124270" y="858041"/>
                  <a:pt x="2127250" y="860425"/>
                </a:cubicBezTo>
                <a:cubicBezTo>
                  <a:pt x="2129863" y="862516"/>
                  <a:pt x="2133849" y="861975"/>
                  <a:pt x="2136775" y="863600"/>
                </a:cubicBezTo>
                <a:cubicBezTo>
                  <a:pt x="2143446" y="867306"/>
                  <a:pt x="2149475" y="872067"/>
                  <a:pt x="2155825" y="876300"/>
                </a:cubicBezTo>
                <a:lnTo>
                  <a:pt x="2165350" y="882650"/>
                </a:lnTo>
                <a:lnTo>
                  <a:pt x="2174875" y="889000"/>
                </a:lnTo>
                <a:cubicBezTo>
                  <a:pt x="2176992" y="892175"/>
                  <a:pt x="2178782" y="895594"/>
                  <a:pt x="2181225" y="898525"/>
                </a:cubicBezTo>
                <a:cubicBezTo>
                  <a:pt x="2184100" y="901974"/>
                  <a:pt x="2188569" y="904125"/>
                  <a:pt x="2190750" y="908050"/>
                </a:cubicBezTo>
                <a:cubicBezTo>
                  <a:pt x="2194001" y="913901"/>
                  <a:pt x="2194983" y="920750"/>
                  <a:pt x="2197100" y="927100"/>
                </a:cubicBezTo>
                <a:lnTo>
                  <a:pt x="2200275" y="936625"/>
                </a:lnTo>
                <a:lnTo>
                  <a:pt x="2209800" y="965200"/>
                </a:lnTo>
                <a:lnTo>
                  <a:pt x="2212975" y="974725"/>
                </a:lnTo>
                <a:cubicBezTo>
                  <a:pt x="2214033" y="977900"/>
                  <a:pt x="2214294" y="981465"/>
                  <a:pt x="2216150" y="984250"/>
                </a:cubicBezTo>
                <a:cubicBezTo>
                  <a:pt x="2218267" y="987425"/>
                  <a:pt x="2220793" y="990362"/>
                  <a:pt x="2222500" y="993775"/>
                </a:cubicBezTo>
                <a:cubicBezTo>
                  <a:pt x="2223997" y="996768"/>
                  <a:pt x="2224178" y="1000307"/>
                  <a:pt x="2225675" y="1003300"/>
                </a:cubicBezTo>
                <a:cubicBezTo>
                  <a:pt x="2227382" y="1006713"/>
                  <a:pt x="2230475" y="1009338"/>
                  <a:pt x="2232025" y="1012825"/>
                </a:cubicBezTo>
                <a:cubicBezTo>
                  <a:pt x="2234743" y="1018942"/>
                  <a:pt x="2236258" y="1025525"/>
                  <a:pt x="2238375" y="1031875"/>
                </a:cubicBezTo>
                <a:lnTo>
                  <a:pt x="2241550" y="1041400"/>
                </a:lnTo>
                <a:lnTo>
                  <a:pt x="2244725" y="1050925"/>
                </a:lnTo>
                <a:cubicBezTo>
                  <a:pt x="2243667" y="1083733"/>
                  <a:pt x="2244203" y="1116632"/>
                  <a:pt x="2241550" y="1149350"/>
                </a:cubicBezTo>
                <a:cubicBezTo>
                  <a:pt x="2241009" y="1156022"/>
                  <a:pt x="2238913" y="1162831"/>
                  <a:pt x="2235200" y="1168400"/>
                </a:cubicBezTo>
                <a:lnTo>
                  <a:pt x="2228850" y="1177925"/>
                </a:lnTo>
                <a:cubicBezTo>
                  <a:pt x="2224052" y="1197119"/>
                  <a:pt x="2227055" y="1186485"/>
                  <a:pt x="2219325" y="1209675"/>
                </a:cubicBezTo>
                <a:cubicBezTo>
                  <a:pt x="2218267" y="1212850"/>
                  <a:pt x="2218006" y="1216415"/>
                  <a:pt x="2216150" y="1219200"/>
                </a:cubicBezTo>
                <a:cubicBezTo>
                  <a:pt x="2200384" y="1242849"/>
                  <a:pt x="2220647" y="1213804"/>
                  <a:pt x="2200275" y="1238250"/>
                </a:cubicBezTo>
                <a:cubicBezTo>
                  <a:pt x="2189228" y="1251507"/>
                  <a:pt x="2200037" y="1245738"/>
                  <a:pt x="2184400" y="1250950"/>
                </a:cubicBezTo>
                <a:cubicBezTo>
                  <a:pt x="2167467" y="1276350"/>
                  <a:pt x="2189692" y="1245658"/>
                  <a:pt x="2168525" y="1266825"/>
                </a:cubicBezTo>
                <a:cubicBezTo>
                  <a:pt x="2165827" y="1269523"/>
                  <a:pt x="2165047" y="1273837"/>
                  <a:pt x="2162175" y="1276350"/>
                </a:cubicBezTo>
                <a:cubicBezTo>
                  <a:pt x="2156432" y="1281376"/>
                  <a:pt x="2149475" y="1284817"/>
                  <a:pt x="2143125" y="1289050"/>
                </a:cubicBezTo>
                <a:lnTo>
                  <a:pt x="2133600" y="1295400"/>
                </a:lnTo>
                <a:cubicBezTo>
                  <a:pt x="2116667" y="1320800"/>
                  <a:pt x="2138892" y="1290108"/>
                  <a:pt x="2117725" y="1311275"/>
                </a:cubicBezTo>
                <a:cubicBezTo>
                  <a:pt x="2105025" y="1323975"/>
                  <a:pt x="2118783" y="1318683"/>
                  <a:pt x="2101850" y="1327150"/>
                </a:cubicBezTo>
                <a:cubicBezTo>
                  <a:pt x="2098857" y="1328647"/>
                  <a:pt x="2095251" y="1328700"/>
                  <a:pt x="2092325" y="1330325"/>
                </a:cubicBezTo>
                <a:cubicBezTo>
                  <a:pt x="2085654" y="1334031"/>
                  <a:pt x="2080515" y="1340612"/>
                  <a:pt x="2073275" y="1343025"/>
                </a:cubicBezTo>
                <a:cubicBezTo>
                  <a:pt x="2038537" y="1354604"/>
                  <a:pt x="2091154" y="1336137"/>
                  <a:pt x="2054225" y="1352550"/>
                </a:cubicBezTo>
                <a:cubicBezTo>
                  <a:pt x="2048108" y="1355268"/>
                  <a:pt x="2041525" y="1356783"/>
                  <a:pt x="2035175" y="1358900"/>
                </a:cubicBezTo>
                <a:cubicBezTo>
                  <a:pt x="2032000" y="1359958"/>
                  <a:pt x="2028435" y="1360219"/>
                  <a:pt x="2025650" y="1362075"/>
                </a:cubicBezTo>
                <a:cubicBezTo>
                  <a:pt x="2022475" y="1364192"/>
                  <a:pt x="2019612" y="1366875"/>
                  <a:pt x="2016125" y="1368425"/>
                </a:cubicBezTo>
                <a:cubicBezTo>
                  <a:pt x="2010008" y="1371143"/>
                  <a:pt x="2003425" y="1372658"/>
                  <a:pt x="1997075" y="1374775"/>
                </a:cubicBezTo>
                <a:lnTo>
                  <a:pt x="1987550" y="1377950"/>
                </a:lnTo>
                <a:lnTo>
                  <a:pt x="1958975" y="1387475"/>
                </a:lnTo>
                <a:lnTo>
                  <a:pt x="1949450" y="1390650"/>
                </a:lnTo>
                <a:cubicBezTo>
                  <a:pt x="1946275" y="1391708"/>
                  <a:pt x="1943272" y="1393825"/>
                  <a:pt x="1939925" y="1393825"/>
                </a:cubicBezTo>
                <a:lnTo>
                  <a:pt x="1930400" y="1393825"/>
                </a:lnTo>
              </a:path>
            </a:pathLst>
          </a:custGeom>
          <a:noFill/>
          <a:ln w="38100">
            <a:solidFill>
              <a:schemeClr val="bg1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9666"/>
          </a:p>
        </p:txBody>
      </p:sp>
      <p:grpSp>
        <p:nvGrpSpPr>
          <p:cNvPr id="2" name="Group 1">
            <a:extLst>
              <a:ext uri="{FF2B5EF4-FFF2-40B4-BE49-F238E27FC236}">
                <a16:creationId xmlns:a16="http://schemas.microsoft.com/office/drawing/2014/main" id="{4883EB30-D792-2677-4E18-33BE0C9B3250}"/>
              </a:ext>
            </a:extLst>
          </p:cNvPr>
          <p:cNvGrpSpPr/>
          <p:nvPr/>
        </p:nvGrpSpPr>
        <p:grpSpPr>
          <a:xfrm>
            <a:off x="1162701" y="1724895"/>
            <a:ext cx="9187031" cy="6980375"/>
            <a:chOff x="4853457" y="275457"/>
            <a:chExt cx="4493074" cy="3417862"/>
          </a:xfrm>
        </p:grpSpPr>
        <p:pic>
          <p:nvPicPr>
            <p:cNvPr id="5" name="Picture 4"/>
            <p:cNvPicPr>
              <a:picLocks noChangeAspect="1"/>
            </p:cNvPicPr>
            <p:nvPr/>
          </p:nvPicPr>
          <p:blipFill>
            <a:blip r:embed="rId2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853457" y="275457"/>
              <a:ext cx="4493074" cy="3417862"/>
            </a:xfrm>
            <a:prstGeom prst="rect">
              <a:avLst/>
            </a:prstGeom>
          </p:spPr>
        </p:pic>
        <p:sp>
          <p:nvSpPr>
            <p:cNvPr id="35" name="Freeform 34"/>
            <p:cNvSpPr/>
            <p:nvPr/>
          </p:nvSpPr>
          <p:spPr>
            <a:xfrm>
              <a:off x="5659031" y="541674"/>
              <a:ext cx="1075324" cy="1224533"/>
            </a:xfrm>
            <a:custGeom>
              <a:avLst/>
              <a:gdLst>
                <a:gd name="connsiteX0" fmla="*/ 166688 w 1121569"/>
                <a:gd name="connsiteY0" fmla="*/ 88107 h 1185863"/>
                <a:gd name="connsiteX1" fmla="*/ 185738 w 1121569"/>
                <a:gd name="connsiteY1" fmla="*/ 85725 h 1185863"/>
                <a:gd name="connsiteX2" fmla="*/ 192882 w 1121569"/>
                <a:gd name="connsiteY2" fmla="*/ 80963 h 1185863"/>
                <a:gd name="connsiteX3" fmla="*/ 200025 w 1121569"/>
                <a:gd name="connsiteY3" fmla="*/ 78582 h 1185863"/>
                <a:gd name="connsiteX4" fmla="*/ 214313 w 1121569"/>
                <a:gd name="connsiteY4" fmla="*/ 69057 h 1185863"/>
                <a:gd name="connsiteX5" fmla="*/ 221457 w 1121569"/>
                <a:gd name="connsiteY5" fmla="*/ 66675 h 1185863"/>
                <a:gd name="connsiteX6" fmla="*/ 228600 w 1121569"/>
                <a:gd name="connsiteY6" fmla="*/ 61913 h 1185863"/>
                <a:gd name="connsiteX7" fmla="*/ 242888 w 1121569"/>
                <a:gd name="connsiteY7" fmla="*/ 57150 h 1185863"/>
                <a:gd name="connsiteX8" fmla="*/ 250032 w 1121569"/>
                <a:gd name="connsiteY8" fmla="*/ 54769 h 1185863"/>
                <a:gd name="connsiteX9" fmla="*/ 257175 w 1121569"/>
                <a:gd name="connsiteY9" fmla="*/ 52388 h 1185863"/>
                <a:gd name="connsiteX10" fmla="*/ 288132 w 1121569"/>
                <a:gd name="connsiteY10" fmla="*/ 47625 h 1185863"/>
                <a:gd name="connsiteX11" fmla="*/ 323850 w 1121569"/>
                <a:gd name="connsiteY11" fmla="*/ 35719 h 1185863"/>
                <a:gd name="connsiteX12" fmla="*/ 330994 w 1121569"/>
                <a:gd name="connsiteY12" fmla="*/ 33338 h 1185863"/>
                <a:gd name="connsiteX13" fmla="*/ 338138 w 1121569"/>
                <a:gd name="connsiteY13" fmla="*/ 30957 h 1185863"/>
                <a:gd name="connsiteX14" fmla="*/ 345282 w 1121569"/>
                <a:gd name="connsiteY14" fmla="*/ 26194 h 1185863"/>
                <a:gd name="connsiteX15" fmla="*/ 352425 w 1121569"/>
                <a:gd name="connsiteY15" fmla="*/ 23813 h 1185863"/>
                <a:gd name="connsiteX16" fmla="*/ 378619 w 1121569"/>
                <a:gd name="connsiteY16" fmla="*/ 19050 h 1185863"/>
                <a:gd name="connsiteX17" fmla="*/ 390525 w 1121569"/>
                <a:gd name="connsiteY17" fmla="*/ 16669 h 1185863"/>
                <a:gd name="connsiteX18" fmla="*/ 416719 w 1121569"/>
                <a:gd name="connsiteY18" fmla="*/ 9525 h 1185863"/>
                <a:gd name="connsiteX19" fmla="*/ 500063 w 1121569"/>
                <a:gd name="connsiteY19" fmla="*/ 4763 h 1185863"/>
                <a:gd name="connsiteX20" fmla="*/ 523875 w 1121569"/>
                <a:gd name="connsiteY20" fmla="*/ 2382 h 1185863"/>
                <a:gd name="connsiteX21" fmla="*/ 542925 w 1121569"/>
                <a:gd name="connsiteY21" fmla="*/ 0 h 1185863"/>
                <a:gd name="connsiteX22" fmla="*/ 611982 w 1121569"/>
                <a:gd name="connsiteY22" fmla="*/ 2382 h 1185863"/>
                <a:gd name="connsiteX23" fmla="*/ 626269 w 1121569"/>
                <a:gd name="connsiteY23" fmla="*/ 4763 h 1185863"/>
                <a:gd name="connsiteX24" fmla="*/ 640557 w 1121569"/>
                <a:gd name="connsiteY24" fmla="*/ 9525 h 1185863"/>
                <a:gd name="connsiteX25" fmla="*/ 664369 w 1121569"/>
                <a:gd name="connsiteY25" fmla="*/ 14288 h 1185863"/>
                <a:gd name="connsiteX26" fmla="*/ 671513 w 1121569"/>
                <a:gd name="connsiteY26" fmla="*/ 16669 h 1185863"/>
                <a:gd name="connsiteX27" fmla="*/ 721519 w 1121569"/>
                <a:gd name="connsiteY27" fmla="*/ 23813 h 1185863"/>
                <a:gd name="connsiteX28" fmla="*/ 735807 w 1121569"/>
                <a:gd name="connsiteY28" fmla="*/ 28575 h 1185863"/>
                <a:gd name="connsiteX29" fmla="*/ 742950 w 1121569"/>
                <a:gd name="connsiteY29" fmla="*/ 30957 h 1185863"/>
                <a:gd name="connsiteX30" fmla="*/ 752475 w 1121569"/>
                <a:gd name="connsiteY30" fmla="*/ 33338 h 1185863"/>
                <a:gd name="connsiteX31" fmla="*/ 766763 w 1121569"/>
                <a:gd name="connsiteY31" fmla="*/ 38100 h 1185863"/>
                <a:gd name="connsiteX32" fmla="*/ 788194 w 1121569"/>
                <a:gd name="connsiteY32" fmla="*/ 45244 h 1185863"/>
                <a:gd name="connsiteX33" fmla="*/ 809625 w 1121569"/>
                <a:gd name="connsiteY33" fmla="*/ 52388 h 1185863"/>
                <a:gd name="connsiteX34" fmla="*/ 816769 w 1121569"/>
                <a:gd name="connsiteY34" fmla="*/ 54769 h 1185863"/>
                <a:gd name="connsiteX35" fmla="*/ 823913 w 1121569"/>
                <a:gd name="connsiteY35" fmla="*/ 57150 h 1185863"/>
                <a:gd name="connsiteX36" fmla="*/ 857250 w 1121569"/>
                <a:gd name="connsiteY36" fmla="*/ 59532 h 1185863"/>
                <a:gd name="connsiteX37" fmla="*/ 885825 w 1121569"/>
                <a:gd name="connsiteY37" fmla="*/ 64294 h 1185863"/>
                <a:gd name="connsiteX38" fmla="*/ 900113 w 1121569"/>
                <a:gd name="connsiteY38" fmla="*/ 69057 h 1185863"/>
                <a:gd name="connsiteX39" fmla="*/ 909638 w 1121569"/>
                <a:gd name="connsiteY39" fmla="*/ 71438 h 1185863"/>
                <a:gd name="connsiteX40" fmla="*/ 921544 w 1121569"/>
                <a:gd name="connsiteY40" fmla="*/ 73819 h 1185863"/>
                <a:gd name="connsiteX41" fmla="*/ 935832 w 1121569"/>
                <a:gd name="connsiteY41" fmla="*/ 78582 h 1185863"/>
                <a:gd name="connsiteX42" fmla="*/ 950119 w 1121569"/>
                <a:gd name="connsiteY42" fmla="*/ 85725 h 1185863"/>
                <a:gd name="connsiteX43" fmla="*/ 964407 w 1121569"/>
                <a:gd name="connsiteY43" fmla="*/ 90488 h 1185863"/>
                <a:gd name="connsiteX44" fmla="*/ 969169 w 1121569"/>
                <a:gd name="connsiteY44" fmla="*/ 97632 h 1185863"/>
                <a:gd name="connsiteX45" fmla="*/ 976313 w 1121569"/>
                <a:gd name="connsiteY45" fmla="*/ 100013 h 1185863"/>
                <a:gd name="connsiteX46" fmla="*/ 983457 w 1121569"/>
                <a:gd name="connsiteY46" fmla="*/ 104775 h 1185863"/>
                <a:gd name="connsiteX47" fmla="*/ 997744 w 1121569"/>
                <a:gd name="connsiteY47" fmla="*/ 111919 h 1185863"/>
                <a:gd name="connsiteX48" fmla="*/ 1014413 w 1121569"/>
                <a:gd name="connsiteY48" fmla="*/ 128588 h 1185863"/>
                <a:gd name="connsiteX49" fmla="*/ 1019175 w 1121569"/>
                <a:gd name="connsiteY49" fmla="*/ 135732 h 1185863"/>
                <a:gd name="connsiteX50" fmla="*/ 1033463 w 1121569"/>
                <a:gd name="connsiteY50" fmla="*/ 145257 h 1185863"/>
                <a:gd name="connsiteX51" fmla="*/ 1042988 w 1121569"/>
                <a:gd name="connsiteY51" fmla="*/ 159544 h 1185863"/>
                <a:gd name="connsiteX52" fmla="*/ 1052513 w 1121569"/>
                <a:gd name="connsiteY52" fmla="*/ 173832 h 1185863"/>
                <a:gd name="connsiteX53" fmla="*/ 1057275 w 1121569"/>
                <a:gd name="connsiteY53" fmla="*/ 180975 h 1185863"/>
                <a:gd name="connsiteX54" fmla="*/ 1064419 w 1121569"/>
                <a:gd name="connsiteY54" fmla="*/ 188119 h 1185863"/>
                <a:gd name="connsiteX55" fmla="*/ 1071563 w 1121569"/>
                <a:gd name="connsiteY55" fmla="*/ 202407 h 1185863"/>
                <a:gd name="connsiteX56" fmla="*/ 1078707 w 1121569"/>
                <a:gd name="connsiteY56" fmla="*/ 226219 h 1185863"/>
                <a:gd name="connsiteX57" fmla="*/ 1081088 w 1121569"/>
                <a:gd name="connsiteY57" fmla="*/ 233363 h 1185863"/>
                <a:gd name="connsiteX58" fmla="*/ 1090613 w 1121569"/>
                <a:gd name="connsiteY58" fmla="*/ 247650 h 1185863"/>
                <a:gd name="connsiteX59" fmla="*/ 1095375 w 1121569"/>
                <a:gd name="connsiteY59" fmla="*/ 254794 h 1185863"/>
                <a:gd name="connsiteX60" fmla="*/ 1097757 w 1121569"/>
                <a:gd name="connsiteY60" fmla="*/ 261938 h 1185863"/>
                <a:gd name="connsiteX61" fmla="*/ 1102519 w 1121569"/>
                <a:gd name="connsiteY61" fmla="*/ 269082 h 1185863"/>
                <a:gd name="connsiteX62" fmla="*/ 1107282 w 1121569"/>
                <a:gd name="connsiteY62" fmla="*/ 283369 h 1185863"/>
                <a:gd name="connsiteX63" fmla="*/ 1112044 w 1121569"/>
                <a:gd name="connsiteY63" fmla="*/ 297657 h 1185863"/>
                <a:gd name="connsiteX64" fmla="*/ 1116807 w 1121569"/>
                <a:gd name="connsiteY64" fmla="*/ 314325 h 1185863"/>
                <a:gd name="connsiteX65" fmla="*/ 1121569 w 1121569"/>
                <a:gd name="connsiteY65" fmla="*/ 335757 h 1185863"/>
                <a:gd name="connsiteX66" fmla="*/ 1119188 w 1121569"/>
                <a:gd name="connsiteY66" fmla="*/ 381000 h 1185863"/>
                <a:gd name="connsiteX67" fmla="*/ 1116807 w 1121569"/>
                <a:gd name="connsiteY67" fmla="*/ 392907 h 1185863"/>
                <a:gd name="connsiteX68" fmla="*/ 1107282 w 1121569"/>
                <a:gd name="connsiteY68" fmla="*/ 426244 h 1185863"/>
                <a:gd name="connsiteX69" fmla="*/ 1104900 w 1121569"/>
                <a:gd name="connsiteY69" fmla="*/ 433388 h 1185863"/>
                <a:gd name="connsiteX70" fmla="*/ 1100138 w 1121569"/>
                <a:gd name="connsiteY70" fmla="*/ 440532 h 1185863"/>
                <a:gd name="connsiteX71" fmla="*/ 1090613 w 1121569"/>
                <a:gd name="connsiteY71" fmla="*/ 454819 h 1185863"/>
                <a:gd name="connsiteX72" fmla="*/ 1083469 w 1121569"/>
                <a:gd name="connsiteY72" fmla="*/ 469107 h 1185863"/>
                <a:gd name="connsiteX73" fmla="*/ 1076325 w 1121569"/>
                <a:gd name="connsiteY73" fmla="*/ 476250 h 1185863"/>
                <a:gd name="connsiteX74" fmla="*/ 1059657 w 1121569"/>
                <a:gd name="connsiteY74" fmla="*/ 495300 h 1185863"/>
                <a:gd name="connsiteX75" fmla="*/ 1050132 w 1121569"/>
                <a:gd name="connsiteY75" fmla="*/ 509588 h 1185863"/>
                <a:gd name="connsiteX76" fmla="*/ 1038225 w 1121569"/>
                <a:gd name="connsiteY76" fmla="*/ 523875 h 1185863"/>
                <a:gd name="connsiteX77" fmla="*/ 1035844 w 1121569"/>
                <a:gd name="connsiteY77" fmla="*/ 531019 h 1185863"/>
                <a:gd name="connsiteX78" fmla="*/ 1021557 w 1121569"/>
                <a:gd name="connsiteY78" fmla="*/ 540544 h 1185863"/>
                <a:gd name="connsiteX79" fmla="*/ 1012032 w 1121569"/>
                <a:gd name="connsiteY79" fmla="*/ 552450 h 1185863"/>
                <a:gd name="connsiteX80" fmla="*/ 1002507 w 1121569"/>
                <a:gd name="connsiteY80" fmla="*/ 566738 h 1185863"/>
                <a:gd name="connsiteX81" fmla="*/ 997744 w 1121569"/>
                <a:gd name="connsiteY81" fmla="*/ 573882 h 1185863"/>
                <a:gd name="connsiteX82" fmla="*/ 995363 w 1121569"/>
                <a:gd name="connsiteY82" fmla="*/ 581025 h 1185863"/>
                <a:gd name="connsiteX83" fmla="*/ 990600 w 1121569"/>
                <a:gd name="connsiteY83" fmla="*/ 600075 h 1185863"/>
                <a:gd name="connsiteX84" fmla="*/ 981075 w 1121569"/>
                <a:gd name="connsiteY84" fmla="*/ 614363 h 1185863"/>
                <a:gd name="connsiteX85" fmla="*/ 973932 w 1121569"/>
                <a:gd name="connsiteY85" fmla="*/ 619125 h 1185863"/>
                <a:gd name="connsiteX86" fmla="*/ 964407 w 1121569"/>
                <a:gd name="connsiteY86" fmla="*/ 633413 h 1185863"/>
                <a:gd name="connsiteX87" fmla="*/ 950119 w 1121569"/>
                <a:gd name="connsiteY87" fmla="*/ 645319 h 1185863"/>
                <a:gd name="connsiteX88" fmla="*/ 938213 w 1121569"/>
                <a:gd name="connsiteY88" fmla="*/ 657225 h 1185863"/>
                <a:gd name="connsiteX89" fmla="*/ 935832 w 1121569"/>
                <a:gd name="connsiteY89" fmla="*/ 664369 h 1185863"/>
                <a:gd name="connsiteX90" fmla="*/ 928688 w 1121569"/>
                <a:gd name="connsiteY90" fmla="*/ 669132 h 1185863"/>
                <a:gd name="connsiteX91" fmla="*/ 921544 w 1121569"/>
                <a:gd name="connsiteY91" fmla="*/ 676275 h 1185863"/>
                <a:gd name="connsiteX92" fmla="*/ 909638 w 1121569"/>
                <a:gd name="connsiteY92" fmla="*/ 685800 h 1185863"/>
                <a:gd name="connsiteX93" fmla="*/ 902494 w 1121569"/>
                <a:gd name="connsiteY93" fmla="*/ 707232 h 1185863"/>
                <a:gd name="connsiteX94" fmla="*/ 900113 w 1121569"/>
                <a:gd name="connsiteY94" fmla="*/ 714375 h 1185863"/>
                <a:gd name="connsiteX95" fmla="*/ 890588 w 1121569"/>
                <a:gd name="connsiteY95" fmla="*/ 728663 h 1185863"/>
                <a:gd name="connsiteX96" fmla="*/ 883444 w 1121569"/>
                <a:gd name="connsiteY96" fmla="*/ 735807 h 1185863"/>
                <a:gd name="connsiteX97" fmla="*/ 866775 w 1121569"/>
                <a:gd name="connsiteY97" fmla="*/ 754857 h 1185863"/>
                <a:gd name="connsiteX98" fmla="*/ 847725 w 1121569"/>
                <a:gd name="connsiteY98" fmla="*/ 783432 h 1185863"/>
                <a:gd name="connsiteX99" fmla="*/ 842963 w 1121569"/>
                <a:gd name="connsiteY99" fmla="*/ 790575 h 1185863"/>
                <a:gd name="connsiteX100" fmla="*/ 838200 w 1121569"/>
                <a:gd name="connsiteY100" fmla="*/ 797719 h 1185863"/>
                <a:gd name="connsiteX101" fmla="*/ 831057 w 1121569"/>
                <a:gd name="connsiteY101" fmla="*/ 812007 h 1185863"/>
                <a:gd name="connsiteX102" fmla="*/ 828675 w 1121569"/>
                <a:gd name="connsiteY102" fmla="*/ 819150 h 1185863"/>
                <a:gd name="connsiteX103" fmla="*/ 821532 w 1121569"/>
                <a:gd name="connsiteY103" fmla="*/ 826294 h 1185863"/>
                <a:gd name="connsiteX104" fmla="*/ 804863 w 1121569"/>
                <a:gd name="connsiteY104" fmla="*/ 845344 h 1185863"/>
                <a:gd name="connsiteX105" fmla="*/ 795338 w 1121569"/>
                <a:gd name="connsiteY105" fmla="*/ 859632 h 1185863"/>
                <a:gd name="connsiteX106" fmla="*/ 788194 w 1121569"/>
                <a:gd name="connsiteY106" fmla="*/ 866775 h 1185863"/>
                <a:gd name="connsiteX107" fmla="*/ 778669 w 1121569"/>
                <a:gd name="connsiteY107" fmla="*/ 881063 h 1185863"/>
                <a:gd name="connsiteX108" fmla="*/ 773907 w 1121569"/>
                <a:gd name="connsiteY108" fmla="*/ 888207 h 1185863"/>
                <a:gd name="connsiteX109" fmla="*/ 766763 w 1121569"/>
                <a:gd name="connsiteY109" fmla="*/ 895350 h 1185863"/>
                <a:gd name="connsiteX110" fmla="*/ 762000 w 1121569"/>
                <a:gd name="connsiteY110" fmla="*/ 909638 h 1185863"/>
                <a:gd name="connsiteX111" fmla="*/ 752475 w 1121569"/>
                <a:gd name="connsiteY111" fmla="*/ 923925 h 1185863"/>
                <a:gd name="connsiteX112" fmla="*/ 747713 w 1121569"/>
                <a:gd name="connsiteY112" fmla="*/ 931069 h 1185863"/>
                <a:gd name="connsiteX113" fmla="*/ 738188 w 1121569"/>
                <a:gd name="connsiteY113" fmla="*/ 945357 h 1185863"/>
                <a:gd name="connsiteX114" fmla="*/ 726282 w 1121569"/>
                <a:gd name="connsiteY114" fmla="*/ 966788 h 1185863"/>
                <a:gd name="connsiteX115" fmla="*/ 711994 w 1121569"/>
                <a:gd name="connsiteY115" fmla="*/ 988219 h 1185863"/>
                <a:gd name="connsiteX116" fmla="*/ 707232 w 1121569"/>
                <a:gd name="connsiteY116" fmla="*/ 995363 h 1185863"/>
                <a:gd name="connsiteX117" fmla="*/ 704850 w 1121569"/>
                <a:gd name="connsiteY117" fmla="*/ 1002507 h 1185863"/>
                <a:gd name="connsiteX118" fmla="*/ 697707 w 1121569"/>
                <a:gd name="connsiteY118" fmla="*/ 1007269 h 1185863"/>
                <a:gd name="connsiteX119" fmla="*/ 685800 w 1121569"/>
                <a:gd name="connsiteY119" fmla="*/ 1028700 h 1185863"/>
                <a:gd name="connsiteX120" fmla="*/ 678657 w 1121569"/>
                <a:gd name="connsiteY120" fmla="*/ 1033463 h 1185863"/>
                <a:gd name="connsiteX121" fmla="*/ 673894 w 1121569"/>
                <a:gd name="connsiteY121" fmla="*/ 1040607 h 1185863"/>
                <a:gd name="connsiteX122" fmla="*/ 659607 w 1121569"/>
                <a:gd name="connsiteY122" fmla="*/ 1047750 h 1185863"/>
                <a:gd name="connsiteX123" fmla="*/ 652463 w 1121569"/>
                <a:gd name="connsiteY123" fmla="*/ 1052513 h 1185863"/>
                <a:gd name="connsiteX124" fmla="*/ 638175 w 1121569"/>
                <a:gd name="connsiteY124" fmla="*/ 1057275 h 1185863"/>
                <a:gd name="connsiteX125" fmla="*/ 592932 w 1121569"/>
                <a:gd name="connsiteY125" fmla="*/ 1054894 h 1185863"/>
                <a:gd name="connsiteX126" fmla="*/ 585788 w 1121569"/>
                <a:gd name="connsiteY126" fmla="*/ 1052513 h 1185863"/>
                <a:gd name="connsiteX127" fmla="*/ 581025 w 1121569"/>
                <a:gd name="connsiteY127" fmla="*/ 1045369 h 1185863"/>
                <a:gd name="connsiteX128" fmla="*/ 573882 w 1121569"/>
                <a:gd name="connsiteY128" fmla="*/ 1038225 h 1185863"/>
                <a:gd name="connsiteX129" fmla="*/ 566738 w 1121569"/>
                <a:gd name="connsiteY129" fmla="*/ 1033463 h 1185863"/>
                <a:gd name="connsiteX130" fmla="*/ 552450 w 1121569"/>
                <a:gd name="connsiteY130" fmla="*/ 1019175 h 1185863"/>
                <a:gd name="connsiteX131" fmla="*/ 545307 w 1121569"/>
                <a:gd name="connsiteY131" fmla="*/ 1014413 h 1185863"/>
                <a:gd name="connsiteX132" fmla="*/ 533400 w 1121569"/>
                <a:gd name="connsiteY132" fmla="*/ 1000125 h 1185863"/>
                <a:gd name="connsiteX133" fmla="*/ 526257 w 1121569"/>
                <a:gd name="connsiteY133" fmla="*/ 995363 h 1185863"/>
                <a:gd name="connsiteX134" fmla="*/ 523875 w 1121569"/>
                <a:gd name="connsiteY134" fmla="*/ 988219 h 1185863"/>
                <a:gd name="connsiteX135" fmla="*/ 514350 w 1121569"/>
                <a:gd name="connsiteY135" fmla="*/ 973932 h 1185863"/>
                <a:gd name="connsiteX136" fmla="*/ 504825 w 1121569"/>
                <a:gd name="connsiteY136" fmla="*/ 952500 h 1185863"/>
                <a:gd name="connsiteX137" fmla="*/ 500063 w 1121569"/>
                <a:gd name="connsiteY137" fmla="*/ 938213 h 1185863"/>
                <a:gd name="connsiteX138" fmla="*/ 497682 w 1121569"/>
                <a:gd name="connsiteY138" fmla="*/ 931069 h 1185863"/>
                <a:gd name="connsiteX139" fmla="*/ 495300 w 1121569"/>
                <a:gd name="connsiteY139" fmla="*/ 921544 h 1185863"/>
                <a:gd name="connsiteX140" fmla="*/ 495300 w 1121569"/>
                <a:gd name="connsiteY140" fmla="*/ 812007 h 1185863"/>
                <a:gd name="connsiteX141" fmla="*/ 497682 w 1121569"/>
                <a:gd name="connsiteY141" fmla="*/ 804863 h 1185863"/>
                <a:gd name="connsiteX142" fmla="*/ 504825 w 1121569"/>
                <a:gd name="connsiteY142" fmla="*/ 778669 h 1185863"/>
                <a:gd name="connsiteX143" fmla="*/ 507207 w 1121569"/>
                <a:gd name="connsiteY143" fmla="*/ 771525 h 1185863"/>
                <a:gd name="connsiteX144" fmla="*/ 516732 w 1121569"/>
                <a:gd name="connsiteY144" fmla="*/ 757238 h 1185863"/>
                <a:gd name="connsiteX145" fmla="*/ 531019 w 1121569"/>
                <a:gd name="connsiteY145" fmla="*/ 714375 h 1185863"/>
                <a:gd name="connsiteX146" fmla="*/ 535782 w 1121569"/>
                <a:gd name="connsiteY146" fmla="*/ 700088 h 1185863"/>
                <a:gd name="connsiteX147" fmla="*/ 538163 w 1121569"/>
                <a:gd name="connsiteY147" fmla="*/ 692944 h 1185863"/>
                <a:gd name="connsiteX148" fmla="*/ 542925 w 1121569"/>
                <a:gd name="connsiteY148" fmla="*/ 685800 h 1185863"/>
                <a:gd name="connsiteX149" fmla="*/ 547688 w 1121569"/>
                <a:gd name="connsiteY149" fmla="*/ 671513 h 1185863"/>
                <a:gd name="connsiteX150" fmla="*/ 550069 w 1121569"/>
                <a:gd name="connsiteY150" fmla="*/ 664369 h 1185863"/>
                <a:gd name="connsiteX151" fmla="*/ 554832 w 1121569"/>
                <a:gd name="connsiteY151" fmla="*/ 657225 h 1185863"/>
                <a:gd name="connsiteX152" fmla="*/ 557213 w 1121569"/>
                <a:gd name="connsiteY152" fmla="*/ 650082 h 1185863"/>
                <a:gd name="connsiteX153" fmla="*/ 566738 w 1121569"/>
                <a:gd name="connsiteY153" fmla="*/ 635794 h 1185863"/>
                <a:gd name="connsiteX154" fmla="*/ 576263 w 1121569"/>
                <a:gd name="connsiteY154" fmla="*/ 621507 h 1185863"/>
                <a:gd name="connsiteX155" fmla="*/ 581025 w 1121569"/>
                <a:gd name="connsiteY155" fmla="*/ 614363 h 1185863"/>
                <a:gd name="connsiteX156" fmla="*/ 583407 w 1121569"/>
                <a:gd name="connsiteY156" fmla="*/ 607219 h 1185863"/>
                <a:gd name="connsiteX157" fmla="*/ 590550 w 1121569"/>
                <a:gd name="connsiteY157" fmla="*/ 602457 h 1185863"/>
                <a:gd name="connsiteX158" fmla="*/ 592932 w 1121569"/>
                <a:gd name="connsiteY158" fmla="*/ 595313 h 1185863"/>
                <a:gd name="connsiteX159" fmla="*/ 597694 w 1121569"/>
                <a:gd name="connsiteY159" fmla="*/ 578644 h 1185863"/>
                <a:gd name="connsiteX160" fmla="*/ 602457 w 1121569"/>
                <a:gd name="connsiteY160" fmla="*/ 571500 h 1185863"/>
                <a:gd name="connsiteX161" fmla="*/ 609600 w 1121569"/>
                <a:gd name="connsiteY161" fmla="*/ 557213 h 1185863"/>
                <a:gd name="connsiteX162" fmla="*/ 611982 w 1121569"/>
                <a:gd name="connsiteY162" fmla="*/ 550069 h 1185863"/>
                <a:gd name="connsiteX163" fmla="*/ 616744 w 1121569"/>
                <a:gd name="connsiteY163" fmla="*/ 542925 h 1185863"/>
                <a:gd name="connsiteX164" fmla="*/ 621507 w 1121569"/>
                <a:gd name="connsiteY164" fmla="*/ 521494 h 1185863"/>
                <a:gd name="connsiteX165" fmla="*/ 619125 w 1121569"/>
                <a:gd name="connsiteY165" fmla="*/ 485775 h 1185863"/>
                <a:gd name="connsiteX166" fmla="*/ 616744 w 1121569"/>
                <a:gd name="connsiteY166" fmla="*/ 476250 h 1185863"/>
                <a:gd name="connsiteX167" fmla="*/ 614363 w 1121569"/>
                <a:gd name="connsiteY167" fmla="*/ 464344 h 1185863"/>
                <a:gd name="connsiteX168" fmla="*/ 609600 w 1121569"/>
                <a:gd name="connsiteY168" fmla="*/ 447675 h 1185863"/>
                <a:gd name="connsiteX169" fmla="*/ 604838 w 1121569"/>
                <a:gd name="connsiteY169" fmla="*/ 440532 h 1185863"/>
                <a:gd name="connsiteX170" fmla="*/ 597694 w 1121569"/>
                <a:gd name="connsiteY170" fmla="*/ 438150 h 1185863"/>
                <a:gd name="connsiteX171" fmla="*/ 578644 w 1121569"/>
                <a:gd name="connsiteY171" fmla="*/ 426244 h 1185863"/>
                <a:gd name="connsiteX172" fmla="*/ 571500 w 1121569"/>
                <a:gd name="connsiteY172" fmla="*/ 423863 h 1185863"/>
                <a:gd name="connsiteX173" fmla="*/ 564357 w 1121569"/>
                <a:gd name="connsiteY173" fmla="*/ 421482 h 1185863"/>
                <a:gd name="connsiteX174" fmla="*/ 516732 w 1121569"/>
                <a:gd name="connsiteY174" fmla="*/ 416719 h 1185863"/>
                <a:gd name="connsiteX175" fmla="*/ 504825 w 1121569"/>
                <a:gd name="connsiteY175" fmla="*/ 414338 h 1185863"/>
                <a:gd name="connsiteX176" fmla="*/ 440532 w 1121569"/>
                <a:gd name="connsiteY176" fmla="*/ 419100 h 1185863"/>
                <a:gd name="connsiteX177" fmla="*/ 416719 w 1121569"/>
                <a:gd name="connsiteY177" fmla="*/ 426244 h 1185863"/>
                <a:gd name="connsiteX178" fmla="*/ 402432 w 1121569"/>
                <a:gd name="connsiteY178" fmla="*/ 431007 h 1185863"/>
                <a:gd name="connsiteX179" fmla="*/ 388144 w 1121569"/>
                <a:gd name="connsiteY179" fmla="*/ 438150 h 1185863"/>
                <a:gd name="connsiteX180" fmla="*/ 366713 w 1121569"/>
                <a:gd name="connsiteY180" fmla="*/ 452438 h 1185863"/>
                <a:gd name="connsiteX181" fmla="*/ 359569 w 1121569"/>
                <a:gd name="connsiteY181" fmla="*/ 457200 h 1185863"/>
                <a:gd name="connsiteX182" fmla="*/ 330994 w 1121569"/>
                <a:gd name="connsiteY182" fmla="*/ 466725 h 1185863"/>
                <a:gd name="connsiteX183" fmla="*/ 323850 w 1121569"/>
                <a:gd name="connsiteY183" fmla="*/ 469107 h 1185863"/>
                <a:gd name="connsiteX184" fmla="*/ 316707 w 1121569"/>
                <a:gd name="connsiteY184" fmla="*/ 471488 h 1185863"/>
                <a:gd name="connsiteX185" fmla="*/ 309563 w 1121569"/>
                <a:gd name="connsiteY185" fmla="*/ 476250 h 1185863"/>
                <a:gd name="connsiteX186" fmla="*/ 302419 w 1121569"/>
                <a:gd name="connsiteY186" fmla="*/ 478632 h 1185863"/>
                <a:gd name="connsiteX187" fmla="*/ 288132 w 1121569"/>
                <a:gd name="connsiteY187" fmla="*/ 488157 h 1185863"/>
                <a:gd name="connsiteX188" fmla="*/ 273844 w 1121569"/>
                <a:gd name="connsiteY188" fmla="*/ 500063 h 1185863"/>
                <a:gd name="connsiteX189" fmla="*/ 269082 w 1121569"/>
                <a:gd name="connsiteY189" fmla="*/ 507207 h 1185863"/>
                <a:gd name="connsiteX190" fmla="*/ 261938 w 1121569"/>
                <a:gd name="connsiteY190" fmla="*/ 511969 h 1185863"/>
                <a:gd name="connsiteX191" fmla="*/ 252413 w 1121569"/>
                <a:gd name="connsiteY191" fmla="*/ 526257 h 1185863"/>
                <a:gd name="connsiteX192" fmla="*/ 247650 w 1121569"/>
                <a:gd name="connsiteY192" fmla="*/ 533400 h 1185863"/>
                <a:gd name="connsiteX193" fmla="*/ 242888 w 1121569"/>
                <a:gd name="connsiteY193" fmla="*/ 540544 h 1185863"/>
                <a:gd name="connsiteX194" fmla="*/ 235744 w 1121569"/>
                <a:gd name="connsiteY194" fmla="*/ 545307 h 1185863"/>
                <a:gd name="connsiteX195" fmla="*/ 223838 w 1121569"/>
                <a:gd name="connsiteY195" fmla="*/ 557213 h 1185863"/>
                <a:gd name="connsiteX196" fmla="*/ 211932 w 1121569"/>
                <a:gd name="connsiteY196" fmla="*/ 569119 h 1185863"/>
                <a:gd name="connsiteX197" fmla="*/ 195263 w 1121569"/>
                <a:gd name="connsiteY197" fmla="*/ 585788 h 1185863"/>
                <a:gd name="connsiteX198" fmla="*/ 185738 w 1121569"/>
                <a:gd name="connsiteY198" fmla="*/ 597694 h 1185863"/>
                <a:gd name="connsiteX199" fmla="*/ 176213 w 1121569"/>
                <a:gd name="connsiteY199" fmla="*/ 607219 h 1185863"/>
                <a:gd name="connsiteX200" fmla="*/ 164307 w 1121569"/>
                <a:gd name="connsiteY200" fmla="*/ 616744 h 1185863"/>
                <a:gd name="connsiteX201" fmla="*/ 152400 w 1121569"/>
                <a:gd name="connsiteY201" fmla="*/ 626269 h 1185863"/>
                <a:gd name="connsiteX202" fmla="*/ 138113 w 1121569"/>
                <a:gd name="connsiteY202" fmla="*/ 638175 h 1185863"/>
                <a:gd name="connsiteX203" fmla="*/ 123825 w 1121569"/>
                <a:gd name="connsiteY203" fmla="*/ 647700 h 1185863"/>
                <a:gd name="connsiteX204" fmla="*/ 116682 w 1121569"/>
                <a:gd name="connsiteY204" fmla="*/ 654844 h 1185863"/>
                <a:gd name="connsiteX205" fmla="*/ 111919 w 1121569"/>
                <a:gd name="connsiteY205" fmla="*/ 661988 h 1185863"/>
                <a:gd name="connsiteX206" fmla="*/ 104775 w 1121569"/>
                <a:gd name="connsiteY206" fmla="*/ 664369 h 1185863"/>
                <a:gd name="connsiteX207" fmla="*/ 102394 w 1121569"/>
                <a:gd name="connsiteY207" fmla="*/ 671513 h 1185863"/>
                <a:gd name="connsiteX208" fmla="*/ 95250 w 1121569"/>
                <a:gd name="connsiteY208" fmla="*/ 673894 h 1185863"/>
                <a:gd name="connsiteX209" fmla="*/ 88107 w 1121569"/>
                <a:gd name="connsiteY209" fmla="*/ 678657 h 1185863"/>
                <a:gd name="connsiteX210" fmla="*/ 78582 w 1121569"/>
                <a:gd name="connsiteY210" fmla="*/ 690563 h 1185863"/>
                <a:gd name="connsiteX211" fmla="*/ 66675 w 1121569"/>
                <a:gd name="connsiteY211" fmla="*/ 702469 h 1185863"/>
                <a:gd name="connsiteX212" fmla="*/ 57150 w 1121569"/>
                <a:gd name="connsiteY212" fmla="*/ 714375 h 1185863"/>
                <a:gd name="connsiteX213" fmla="*/ 47625 w 1121569"/>
                <a:gd name="connsiteY213" fmla="*/ 726282 h 1185863"/>
                <a:gd name="connsiteX214" fmla="*/ 38100 w 1121569"/>
                <a:gd name="connsiteY214" fmla="*/ 738188 h 1185863"/>
                <a:gd name="connsiteX215" fmla="*/ 26194 w 1121569"/>
                <a:gd name="connsiteY215" fmla="*/ 750094 h 1185863"/>
                <a:gd name="connsiteX216" fmla="*/ 23813 w 1121569"/>
                <a:gd name="connsiteY216" fmla="*/ 757238 h 1185863"/>
                <a:gd name="connsiteX217" fmla="*/ 9525 w 1121569"/>
                <a:gd name="connsiteY217" fmla="*/ 766763 h 1185863"/>
                <a:gd name="connsiteX218" fmla="*/ 2382 w 1121569"/>
                <a:gd name="connsiteY218" fmla="*/ 788194 h 1185863"/>
                <a:gd name="connsiteX219" fmla="*/ 0 w 1121569"/>
                <a:gd name="connsiteY219" fmla="*/ 795338 h 1185863"/>
                <a:gd name="connsiteX220" fmla="*/ 2382 w 1121569"/>
                <a:gd name="connsiteY220" fmla="*/ 807244 h 1185863"/>
                <a:gd name="connsiteX221" fmla="*/ 45244 w 1121569"/>
                <a:gd name="connsiteY221" fmla="*/ 812007 h 1185863"/>
                <a:gd name="connsiteX222" fmla="*/ 52388 w 1121569"/>
                <a:gd name="connsiteY222" fmla="*/ 807244 h 1185863"/>
                <a:gd name="connsiteX223" fmla="*/ 59532 w 1121569"/>
                <a:gd name="connsiteY223" fmla="*/ 804863 h 1185863"/>
                <a:gd name="connsiteX224" fmla="*/ 73819 w 1121569"/>
                <a:gd name="connsiteY224" fmla="*/ 795338 h 1185863"/>
                <a:gd name="connsiteX225" fmla="*/ 88107 w 1121569"/>
                <a:gd name="connsiteY225" fmla="*/ 790575 h 1185863"/>
                <a:gd name="connsiteX226" fmla="*/ 130969 w 1121569"/>
                <a:gd name="connsiteY226" fmla="*/ 797719 h 1185863"/>
                <a:gd name="connsiteX227" fmla="*/ 145257 w 1121569"/>
                <a:gd name="connsiteY227" fmla="*/ 802482 h 1185863"/>
                <a:gd name="connsiteX228" fmla="*/ 152400 w 1121569"/>
                <a:gd name="connsiteY228" fmla="*/ 804863 h 1185863"/>
                <a:gd name="connsiteX229" fmla="*/ 166688 w 1121569"/>
                <a:gd name="connsiteY229" fmla="*/ 812007 h 1185863"/>
                <a:gd name="connsiteX230" fmla="*/ 180975 w 1121569"/>
                <a:gd name="connsiteY230" fmla="*/ 819150 h 1185863"/>
                <a:gd name="connsiteX231" fmla="*/ 202407 w 1121569"/>
                <a:gd name="connsiteY231" fmla="*/ 833438 h 1185863"/>
                <a:gd name="connsiteX232" fmla="*/ 209550 w 1121569"/>
                <a:gd name="connsiteY232" fmla="*/ 838200 h 1185863"/>
                <a:gd name="connsiteX233" fmla="*/ 216694 w 1121569"/>
                <a:gd name="connsiteY233" fmla="*/ 842963 h 1185863"/>
                <a:gd name="connsiteX234" fmla="*/ 223838 w 1121569"/>
                <a:gd name="connsiteY234" fmla="*/ 845344 h 1185863"/>
                <a:gd name="connsiteX235" fmla="*/ 228600 w 1121569"/>
                <a:gd name="connsiteY235" fmla="*/ 852488 h 1185863"/>
                <a:gd name="connsiteX236" fmla="*/ 242888 w 1121569"/>
                <a:gd name="connsiteY236" fmla="*/ 857250 h 1185863"/>
                <a:gd name="connsiteX237" fmla="*/ 257175 w 1121569"/>
                <a:gd name="connsiteY237" fmla="*/ 864394 h 1185863"/>
                <a:gd name="connsiteX238" fmla="*/ 271463 w 1121569"/>
                <a:gd name="connsiteY238" fmla="*/ 871538 h 1185863"/>
                <a:gd name="connsiteX239" fmla="*/ 276225 w 1121569"/>
                <a:gd name="connsiteY239" fmla="*/ 878682 h 1185863"/>
                <a:gd name="connsiteX240" fmla="*/ 290513 w 1121569"/>
                <a:gd name="connsiteY240" fmla="*/ 883444 h 1185863"/>
                <a:gd name="connsiteX241" fmla="*/ 319088 w 1121569"/>
                <a:gd name="connsiteY241" fmla="*/ 902494 h 1185863"/>
                <a:gd name="connsiteX242" fmla="*/ 326232 w 1121569"/>
                <a:gd name="connsiteY242" fmla="*/ 907257 h 1185863"/>
                <a:gd name="connsiteX243" fmla="*/ 333375 w 1121569"/>
                <a:gd name="connsiteY243" fmla="*/ 909638 h 1185863"/>
                <a:gd name="connsiteX244" fmla="*/ 347663 w 1121569"/>
                <a:gd name="connsiteY244" fmla="*/ 919163 h 1185863"/>
                <a:gd name="connsiteX245" fmla="*/ 354807 w 1121569"/>
                <a:gd name="connsiteY245" fmla="*/ 923925 h 1185863"/>
                <a:gd name="connsiteX246" fmla="*/ 361950 w 1121569"/>
                <a:gd name="connsiteY246" fmla="*/ 928688 h 1185863"/>
                <a:gd name="connsiteX247" fmla="*/ 376238 w 1121569"/>
                <a:gd name="connsiteY247" fmla="*/ 940594 h 1185863"/>
                <a:gd name="connsiteX248" fmla="*/ 381000 w 1121569"/>
                <a:gd name="connsiteY248" fmla="*/ 947738 h 1185863"/>
                <a:gd name="connsiteX249" fmla="*/ 388144 w 1121569"/>
                <a:gd name="connsiteY249" fmla="*/ 950119 h 1185863"/>
                <a:gd name="connsiteX250" fmla="*/ 390525 w 1121569"/>
                <a:gd name="connsiteY250" fmla="*/ 957263 h 1185863"/>
                <a:gd name="connsiteX251" fmla="*/ 397669 w 1121569"/>
                <a:gd name="connsiteY251" fmla="*/ 962025 h 1185863"/>
                <a:gd name="connsiteX252" fmla="*/ 407194 w 1121569"/>
                <a:gd name="connsiteY252" fmla="*/ 973932 h 1185863"/>
                <a:gd name="connsiteX253" fmla="*/ 409575 w 1121569"/>
                <a:gd name="connsiteY253" fmla="*/ 981075 h 1185863"/>
                <a:gd name="connsiteX254" fmla="*/ 426244 w 1121569"/>
                <a:gd name="connsiteY254" fmla="*/ 1000125 h 1185863"/>
                <a:gd name="connsiteX255" fmla="*/ 435769 w 1121569"/>
                <a:gd name="connsiteY255" fmla="*/ 1012032 h 1185863"/>
                <a:gd name="connsiteX256" fmla="*/ 438150 w 1121569"/>
                <a:gd name="connsiteY256" fmla="*/ 1019175 h 1185863"/>
                <a:gd name="connsiteX257" fmla="*/ 454819 w 1121569"/>
                <a:gd name="connsiteY257" fmla="*/ 1040607 h 1185863"/>
                <a:gd name="connsiteX258" fmla="*/ 457200 w 1121569"/>
                <a:gd name="connsiteY258" fmla="*/ 1047750 h 1185863"/>
                <a:gd name="connsiteX259" fmla="*/ 466725 w 1121569"/>
                <a:gd name="connsiteY259" fmla="*/ 1062038 h 1185863"/>
                <a:gd name="connsiteX260" fmla="*/ 471488 w 1121569"/>
                <a:gd name="connsiteY260" fmla="*/ 1076325 h 1185863"/>
                <a:gd name="connsiteX261" fmla="*/ 473869 w 1121569"/>
                <a:gd name="connsiteY261" fmla="*/ 1083469 h 1185863"/>
                <a:gd name="connsiteX262" fmla="*/ 478632 w 1121569"/>
                <a:gd name="connsiteY262" fmla="*/ 1090613 h 1185863"/>
                <a:gd name="connsiteX263" fmla="*/ 485775 w 1121569"/>
                <a:gd name="connsiteY263" fmla="*/ 1104900 h 1185863"/>
                <a:gd name="connsiteX264" fmla="*/ 488157 w 1121569"/>
                <a:gd name="connsiteY264" fmla="*/ 1112044 h 1185863"/>
                <a:gd name="connsiteX265" fmla="*/ 497682 w 1121569"/>
                <a:gd name="connsiteY265" fmla="*/ 1126332 h 1185863"/>
                <a:gd name="connsiteX266" fmla="*/ 502444 w 1121569"/>
                <a:gd name="connsiteY266" fmla="*/ 1133475 h 1185863"/>
                <a:gd name="connsiteX267" fmla="*/ 507207 w 1121569"/>
                <a:gd name="connsiteY267" fmla="*/ 1140619 h 1185863"/>
                <a:gd name="connsiteX268" fmla="*/ 509588 w 1121569"/>
                <a:gd name="connsiteY268" fmla="*/ 1147763 h 1185863"/>
                <a:gd name="connsiteX269" fmla="*/ 514350 w 1121569"/>
                <a:gd name="connsiteY269" fmla="*/ 1154907 h 1185863"/>
                <a:gd name="connsiteX270" fmla="*/ 519113 w 1121569"/>
                <a:gd name="connsiteY270" fmla="*/ 1169194 h 1185863"/>
                <a:gd name="connsiteX271" fmla="*/ 526257 w 1121569"/>
                <a:gd name="connsiteY271" fmla="*/ 1183482 h 1185863"/>
                <a:gd name="connsiteX272" fmla="*/ 526257 w 1121569"/>
                <a:gd name="connsiteY272" fmla="*/ 1185863 h 1185863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  <a:cxn ang="0">
                  <a:pos x="connsiteX29" y="connsiteY29"/>
                </a:cxn>
                <a:cxn ang="0">
                  <a:pos x="connsiteX30" y="connsiteY30"/>
                </a:cxn>
                <a:cxn ang="0">
                  <a:pos x="connsiteX31" y="connsiteY31"/>
                </a:cxn>
                <a:cxn ang="0">
                  <a:pos x="connsiteX32" y="connsiteY32"/>
                </a:cxn>
                <a:cxn ang="0">
                  <a:pos x="connsiteX33" y="connsiteY33"/>
                </a:cxn>
                <a:cxn ang="0">
                  <a:pos x="connsiteX34" y="connsiteY34"/>
                </a:cxn>
                <a:cxn ang="0">
                  <a:pos x="connsiteX35" y="connsiteY35"/>
                </a:cxn>
                <a:cxn ang="0">
                  <a:pos x="connsiteX36" y="connsiteY36"/>
                </a:cxn>
                <a:cxn ang="0">
                  <a:pos x="connsiteX37" y="connsiteY37"/>
                </a:cxn>
                <a:cxn ang="0">
                  <a:pos x="connsiteX38" y="connsiteY38"/>
                </a:cxn>
                <a:cxn ang="0">
                  <a:pos x="connsiteX39" y="connsiteY39"/>
                </a:cxn>
                <a:cxn ang="0">
                  <a:pos x="connsiteX40" y="connsiteY40"/>
                </a:cxn>
                <a:cxn ang="0">
                  <a:pos x="connsiteX41" y="connsiteY41"/>
                </a:cxn>
                <a:cxn ang="0">
                  <a:pos x="connsiteX42" y="connsiteY42"/>
                </a:cxn>
                <a:cxn ang="0">
                  <a:pos x="connsiteX43" y="connsiteY43"/>
                </a:cxn>
                <a:cxn ang="0">
                  <a:pos x="connsiteX44" y="connsiteY44"/>
                </a:cxn>
                <a:cxn ang="0">
                  <a:pos x="connsiteX45" y="connsiteY45"/>
                </a:cxn>
                <a:cxn ang="0">
                  <a:pos x="connsiteX46" y="connsiteY46"/>
                </a:cxn>
                <a:cxn ang="0">
                  <a:pos x="connsiteX47" y="connsiteY47"/>
                </a:cxn>
                <a:cxn ang="0">
                  <a:pos x="connsiteX48" y="connsiteY48"/>
                </a:cxn>
                <a:cxn ang="0">
                  <a:pos x="connsiteX49" y="connsiteY49"/>
                </a:cxn>
                <a:cxn ang="0">
                  <a:pos x="connsiteX50" y="connsiteY50"/>
                </a:cxn>
                <a:cxn ang="0">
                  <a:pos x="connsiteX51" y="connsiteY51"/>
                </a:cxn>
                <a:cxn ang="0">
                  <a:pos x="connsiteX52" y="connsiteY52"/>
                </a:cxn>
                <a:cxn ang="0">
                  <a:pos x="connsiteX53" y="connsiteY53"/>
                </a:cxn>
                <a:cxn ang="0">
                  <a:pos x="connsiteX54" y="connsiteY54"/>
                </a:cxn>
                <a:cxn ang="0">
                  <a:pos x="connsiteX55" y="connsiteY55"/>
                </a:cxn>
                <a:cxn ang="0">
                  <a:pos x="connsiteX56" y="connsiteY56"/>
                </a:cxn>
                <a:cxn ang="0">
                  <a:pos x="connsiteX57" y="connsiteY57"/>
                </a:cxn>
                <a:cxn ang="0">
                  <a:pos x="connsiteX58" y="connsiteY58"/>
                </a:cxn>
                <a:cxn ang="0">
                  <a:pos x="connsiteX59" y="connsiteY59"/>
                </a:cxn>
                <a:cxn ang="0">
                  <a:pos x="connsiteX60" y="connsiteY60"/>
                </a:cxn>
                <a:cxn ang="0">
                  <a:pos x="connsiteX61" y="connsiteY61"/>
                </a:cxn>
                <a:cxn ang="0">
                  <a:pos x="connsiteX62" y="connsiteY62"/>
                </a:cxn>
                <a:cxn ang="0">
                  <a:pos x="connsiteX63" y="connsiteY63"/>
                </a:cxn>
                <a:cxn ang="0">
                  <a:pos x="connsiteX64" y="connsiteY64"/>
                </a:cxn>
                <a:cxn ang="0">
                  <a:pos x="connsiteX65" y="connsiteY65"/>
                </a:cxn>
                <a:cxn ang="0">
                  <a:pos x="connsiteX66" y="connsiteY66"/>
                </a:cxn>
                <a:cxn ang="0">
                  <a:pos x="connsiteX67" y="connsiteY67"/>
                </a:cxn>
                <a:cxn ang="0">
                  <a:pos x="connsiteX68" y="connsiteY68"/>
                </a:cxn>
                <a:cxn ang="0">
                  <a:pos x="connsiteX69" y="connsiteY69"/>
                </a:cxn>
                <a:cxn ang="0">
                  <a:pos x="connsiteX70" y="connsiteY70"/>
                </a:cxn>
                <a:cxn ang="0">
                  <a:pos x="connsiteX71" y="connsiteY71"/>
                </a:cxn>
                <a:cxn ang="0">
                  <a:pos x="connsiteX72" y="connsiteY72"/>
                </a:cxn>
                <a:cxn ang="0">
                  <a:pos x="connsiteX73" y="connsiteY73"/>
                </a:cxn>
                <a:cxn ang="0">
                  <a:pos x="connsiteX74" y="connsiteY74"/>
                </a:cxn>
                <a:cxn ang="0">
                  <a:pos x="connsiteX75" y="connsiteY75"/>
                </a:cxn>
                <a:cxn ang="0">
                  <a:pos x="connsiteX76" y="connsiteY76"/>
                </a:cxn>
                <a:cxn ang="0">
                  <a:pos x="connsiteX77" y="connsiteY77"/>
                </a:cxn>
                <a:cxn ang="0">
                  <a:pos x="connsiteX78" y="connsiteY78"/>
                </a:cxn>
                <a:cxn ang="0">
                  <a:pos x="connsiteX79" y="connsiteY79"/>
                </a:cxn>
                <a:cxn ang="0">
                  <a:pos x="connsiteX80" y="connsiteY80"/>
                </a:cxn>
                <a:cxn ang="0">
                  <a:pos x="connsiteX81" y="connsiteY81"/>
                </a:cxn>
                <a:cxn ang="0">
                  <a:pos x="connsiteX82" y="connsiteY82"/>
                </a:cxn>
                <a:cxn ang="0">
                  <a:pos x="connsiteX83" y="connsiteY83"/>
                </a:cxn>
                <a:cxn ang="0">
                  <a:pos x="connsiteX84" y="connsiteY84"/>
                </a:cxn>
                <a:cxn ang="0">
                  <a:pos x="connsiteX85" y="connsiteY85"/>
                </a:cxn>
                <a:cxn ang="0">
                  <a:pos x="connsiteX86" y="connsiteY86"/>
                </a:cxn>
                <a:cxn ang="0">
                  <a:pos x="connsiteX87" y="connsiteY87"/>
                </a:cxn>
                <a:cxn ang="0">
                  <a:pos x="connsiteX88" y="connsiteY88"/>
                </a:cxn>
                <a:cxn ang="0">
                  <a:pos x="connsiteX89" y="connsiteY89"/>
                </a:cxn>
                <a:cxn ang="0">
                  <a:pos x="connsiteX90" y="connsiteY90"/>
                </a:cxn>
                <a:cxn ang="0">
                  <a:pos x="connsiteX91" y="connsiteY91"/>
                </a:cxn>
                <a:cxn ang="0">
                  <a:pos x="connsiteX92" y="connsiteY92"/>
                </a:cxn>
                <a:cxn ang="0">
                  <a:pos x="connsiteX93" y="connsiteY93"/>
                </a:cxn>
                <a:cxn ang="0">
                  <a:pos x="connsiteX94" y="connsiteY94"/>
                </a:cxn>
                <a:cxn ang="0">
                  <a:pos x="connsiteX95" y="connsiteY95"/>
                </a:cxn>
                <a:cxn ang="0">
                  <a:pos x="connsiteX96" y="connsiteY96"/>
                </a:cxn>
                <a:cxn ang="0">
                  <a:pos x="connsiteX97" y="connsiteY97"/>
                </a:cxn>
                <a:cxn ang="0">
                  <a:pos x="connsiteX98" y="connsiteY98"/>
                </a:cxn>
                <a:cxn ang="0">
                  <a:pos x="connsiteX99" y="connsiteY99"/>
                </a:cxn>
                <a:cxn ang="0">
                  <a:pos x="connsiteX100" y="connsiteY100"/>
                </a:cxn>
                <a:cxn ang="0">
                  <a:pos x="connsiteX101" y="connsiteY101"/>
                </a:cxn>
                <a:cxn ang="0">
                  <a:pos x="connsiteX102" y="connsiteY102"/>
                </a:cxn>
                <a:cxn ang="0">
                  <a:pos x="connsiteX103" y="connsiteY103"/>
                </a:cxn>
                <a:cxn ang="0">
                  <a:pos x="connsiteX104" y="connsiteY104"/>
                </a:cxn>
                <a:cxn ang="0">
                  <a:pos x="connsiteX105" y="connsiteY105"/>
                </a:cxn>
                <a:cxn ang="0">
                  <a:pos x="connsiteX106" y="connsiteY106"/>
                </a:cxn>
                <a:cxn ang="0">
                  <a:pos x="connsiteX107" y="connsiteY107"/>
                </a:cxn>
                <a:cxn ang="0">
                  <a:pos x="connsiteX108" y="connsiteY108"/>
                </a:cxn>
                <a:cxn ang="0">
                  <a:pos x="connsiteX109" y="connsiteY109"/>
                </a:cxn>
                <a:cxn ang="0">
                  <a:pos x="connsiteX110" y="connsiteY110"/>
                </a:cxn>
                <a:cxn ang="0">
                  <a:pos x="connsiteX111" y="connsiteY111"/>
                </a:cxn>
                <a:cxn ang="0">
                  <a:pos x="connsiteX112" y="connsiteY112"/>
                </a:cxn>
                <a:cxn ang="0">
                  <a:pos x="connsiteX113" y="connsiteY113"/>
                </a:cxn>
                <a:cxn ang="0">
                  <a:pos x="connsiteX114" y="connsiteY114"/>
                </a:cxn>
                <a:cxn ang="0">
                  <a:pos x="connsiteX115" y="connsiteY115"/>
                </a:cxn>
                <a:cxn ang="0">
                  <a:pos x="connsiteX116" y="connsiteY116"/>
                </a:cxn>
                <a:cxn ang="0">
                  <a:pos x="connsiteX117" y="connsiteY117"/>
                </a:cxn>
                <a:cxn ang="0">
                  <a:pos x="connsiteX118" y="connsiteY118"/>
                </a:cxn>
                <a:cxn ang="0">
                  <a:pos x="connsiteX119" y="connsiteY119"/>
                </a:cxn>
                <a:cxn ang="0">
                  <a:pos x="connsiteX120" y="connsiteY120"/>
                </a:cxn>
                <a:cxn ang="0">
                  <a:pos x="connsiteX121" y="connsiteY121"/>
                </a:cxn>
                <a:cxn ang="0">
                  <a:pos x="connsiteX122" y="connsiteY122"/>
                </a:cxn>
                <a:cxn ang="0">
                  <a:pos x="connsiteX123" y="connsiteY123"/>
                </a:cxn>
                <a:cxn ang="0">
                  <a:pos x="connsiteX124" y="connsiteY124"/>
                </a:cxn>
                <a:cxn ang="0">
                  <a:pos x="connsiteX125" y="connsiteY125"/>
                </a:cxn>
                <a:cxn ang="0">
                  <a:pos x="connsiteX126" y="connsiteY126"/>
                </a:cxn>
                <a:cxn ang="0">
                  <a:pos x="connsiteX127" y="connsiteY127"/>
                </a:cxn>
                <a:cxn ang="0">
                  <a:pos x="connsiteX128" y="connsiteY128"/>
                </a:cxn>
                <a:cxn ang="0">
                  <a:pos x="connsiteX129" y="connsiteY129"/>
                </a:cxn>
                <a:cxn ang="0">
                  <a:pos x="connsiteX130" y="connsiteY130"/>
                </a:cxn>
                <a:cxn ang="0">
                  <a:pos x="connsiteX131" y="connsiteY131"/>
                </a:cxn>
                <a:cxn ang="0">
                  <a:pos x="connsiteX132" y="connsiteY132"/>
                </a:cxn>
                <a:cxn ang="0">
                  <a:pos x="connsiteX133" y="connsiteY133"/>
                </a:cxn>
                <a:cxn ang="0">
                  <a:pos x="connsiteX134" y="connsiteY134"/>
                </a:cxn>
                <a:cxn ang="0">
                  <a:pos x="connsiteX135" y="connsiteY135"/>
                </a:cxn>
                <a:cxn ang="0">
                  <a:pos x="connsiteX136" y="connsiteY136"/>
                </a:cxn>
                <a:cxn ang="0">
                  <a:pos x="connsiteX137" y="connsiteY137"/>
                </a:cxn>
                <a:cxn ang="0">
                  <a:pos x="connsiteX138" y="connsiteY138"/>
                </a:cxn>
                <a:cxn ang="0">
                  <a:pos x="connsiteX139" y="connsiteY139"/>
                </a:cxn>
                <a:cxn ang="0">
                  <a:pos x="connsiteX140" y="connsiteY140"/>
                </a:cxn>
                <a:cxn ang="0">
                  <a:pos x="connsiteX141" y="connsiteY141"/>
                </a:cxn>
                <a:cxn ang="0">
                  <a:pos x="connsiteX142" y="connsiteY142"/>
                </a:cxn>
                <a:cxn ang="0">
                  <a:pos x="connsiteX143" y="connsiteY143"/>
                </a:cxn>
                <a:cxn ang="0">
                  <a:pos x="connsiteX144" y="connsiteY144"/>
                </a:cxn>
                <a:cxn ang="0">
                  <a:pos x="connsiteX145" y="connsiteY145"/>
                </a:cxn>
                <a:cxn ang="0">
                  <a:pos x="connsiteX146" y="connsiteY146"/>
                </a:cxn>
                <a:cxn ang="0">
                  <a:pos x="connsiteX147" y="connsiteY147"/>
                </a:cxn>
                <a:cxn ang="0">
                  <a:pos x="connsiteX148" y="connsiteY148"/>
                </a:cxn>
                <a:cxn ang="0">
                  <a:pos x="connsiteX149" y="connsiteY149"/>
                </a:cxn>
                <a:cxn ang="0">
                  <a:pos x="connsiteX150" y="connsiteY150"/>
                </a:cxn>
                <a:cxn ang="0">
                  <a:pos x="connsiteX151" y="connsiteY151"/>
                </a:cxn>
                <a:cxn ang="0">
                  <a:pos x="connsiteX152" y="connsiteY152"/>
                </a:cxn>
                <a:cxn ang="0">
                  <a:pos x="connsiteX153" y="connsiteY153"/>
                </a:cxn>
                <a:cxn ang="0">
                  <a:pos x="connsiteX154" y="connsiteY154"/>
                </a:cxn>
                <a:cxn ang="0">
                  <a:pos x="connsiteX155" y="connsiteY155"/>
                </a:cxn>
                <a:cxn ang="0">
                  <a:pos x="connsiteX156" y="connsiteY156"/>
                </a:cxn>
                <a:cxn ang="0">
                  <a:pos x="connsiteX157" y="connsiteY157"/>
                </a:cxn>
                <a:cxn ang="0">
                  <a:pos x="connsiteX158" y="connsiteY158"/>
                </a:cxn>
                <a:cxn ang="0">
                  <a:pos x="connsiteX159" y="connsiteY159"/>
                </a:cxn>
                <a:cxn ang="0">
                  <a:pos x="connsiteX160" y="connsiteY160"/>
                </a:cxn>
                <a:cxn ang="0">
                  <a:pos x="connsiteX161" y="connsiteY161"/>
                </a:cxn>
                <a:cxn ang="0">
                  <a:pos x="connsiteX162" y="connsiteY162"/>
                </a:cxn>
                <a:cxn ang="0">
                  <a:pos x="connsiteX163" y="connsiteY163"/>
                </a:cxn>
                <a:cxn ang="0">
                  <a:pos x="connsiteX164" y="connsiteY164"/>
                </a:cxn>
                <a:cxn ang="0">
                  <a:pos x="connsiteX165" y="connsiteY165"/>
                </a:cxn>
                <a:cxn ang="0">
                  <a:pos x="connsiteX166" y="connsiteY166"/>
                </a:cxn>
                <a:cxn ang="0">
                  <a:pos x="connsiteX167" y="connsiteY167"/>
                </a:cxn>
                <a:cxn ang="0">
                  <a:pos x="connsiteX168" y="connsiteY168"/>
                </a:cxn>
                <a:cxn ang="0">
                  <a:pos x="connsiteX169" y="connsiteY169"/>
                </a:cxn>
                <a:cxn ang="0">
                  <a:pos x="connsiteX170" y="connsiteY170"/>
                </a:cxn>
                <a:cxn ang="0">
                  <a:pos x="connsiteX171" y="connsiteY171"/>
                </a:cxn>
                <a:cxn ang="0">
                  <a:pos x="connsiteX172" y="connsiteY172"/>
                </a:cxn>
                <a:cxn ang="0">
                  <a:pos x="connsiteX173" y="connsiteY173"/>
                </a:cxn>
                <a:cxn ang="0">
                  <a:pos x="connsiteX174" y="connsiteY174"/>
                </a:cxn>
                <a:cxn ang="0">
                  <a:pos x="connsiteX175" y="connsiteY175"/>
                </a:cxn>
                <a:cxn ang="0">
                  <a:pos x="connsiteX176" y="connsiteY176"/>
                </a:cxn>
                <a:cxn ang="0">
                  <a:pos x="connsiteX177" y="connsiteY177"/>
                </a:cxn>
                <a:cxn ang="0">
                  <a:pos x="connsiteX178" y="connsiteY178"/>
                </a:cxn>
                <a:cxn ang="0">
                  <a:pos x="connsiteX179" y="connsiteY179"/>
                </a:cxn>
                <a:cxn ang="0">
                  <a:pos x="connsiteX180" y="connsiteY180"/>
                </a:cxn>
                <a:cxn ang="0">
                  <a:pos x="connsiteX181" y="connsiteY181"/>
                </a:cxn>
                <a:cxn ang="0">
                  <a:pos x="connsiteX182" y="connsiteY182"/>
                </a:cxn>
                <a:cxn ang="0">
                  <a:pos x="connsiteX183" y="connsiteY183"/>
                </a:cxn>
                <a:cxn ang="0">
                  <a:pos x="connsiteX184" y="connsiteY184"/>
                </a:cxn>
                <a:cxn ang="0">
                  <a:pos x="connsiteX185" y="connsiteY185"/>
                </a:cxn>
                <a:cxn ang="0">
                  <a:pos x="connsiteX186" y="connsiteY186"/>
                </a:cxn>
                <a:cxn ang="0">
                  <a:pos x="connsiteX187" y="connsiteY187"/>
                </a:cxn>
                <a:cxn ang="0">
                  <a:pos x="connsiteX188" y="connsiteY188"/>
                </a:cxn>
                <a:cxn ang="0">
                  <a:pos x="connsiteX189" y="connsiteY189"/>
                </a:cxn>
                <a:cxn ang="0">
                  <a:pos x="connsiteX190" y="connsiteY190"/>
                </a:cxn>
                <a:cxn ang="0">
                  <a:pos x="connsiteX191" y="connsiteY191"/>
                </a:cxn>
                <a:cxn ang="0">
                  <a:pos x="connsiteX192" y="connsiteY192"/>
                </a:cxn>
                <a:cxn ang="0">
                  <a:pos x="connsiteX193" y="connsiteY193"/>
                </a:cxn>
                <a:cxn ang="0">
                  <a:pos x="connsiteX194" y="connsiteY194"/>
                </a:cxn>
                <a:cxn ang="0">
                  <a:pos x="connsiteX195" y="connsiteY195"/>
                </a:cxn>
                <a:cxn ang="0">
                  <a:pos x="connsiteX196" y="connsiteY196"/>
                </a:cxn>
                <a:cxn ang="0">
                  <a:pos x="connsiteX197" y="connsiteY197"/>
                </a:cxn>
                <a:cxn ang="0">
                  <a:pos x="connsiteX198" y="connsiteY198"/>
                </a:cxn>
                <a:cxn ang="0">
                  <a:pos x="connsiteX199" y="connsiteY199"/>
                </a:cxn>
                <a:cxn ang="0">
                  <a:pos x="connsiteX200" y="connsiteY200"/>
                </a:cxn>
                <a:cxn ang="0">
                  <a:pos x="connsiteX201" y="connsiteY201"/>
                </a:cxn>
                <a:cxn ang="0">
                  <a:pos x="connsiteX202" y="connsiteY202"/>
                </a:cxn>
                <a:cxn ang="0">
                  <a:pos x="connsiteX203" y="connsiteY203"/>
                </a:cxn>
                <a:cxn ang="0">
                  <a:pos x="connsiteX204" y="connsiteY204"/>
                </a:cxn>
                <a:cxn ang="0">
                  <a:pos x="connsiteX205" y="connsiteY205"/>
                </a:cxn>
                <a:cxn ang="0">
                  <a:pos x="connsiteX206" y="connsiteY206"/>
                </a:cxn>
                <a:cxn ang="0">
                  <a:pos x="connsiteX207" y="connsiteY207"/>
                </a:cxn>
                <a:cxn ang="0">
                  <a:pos x="connsiteX208" y="connsiteY208"/>
                </a:cxn>
                <a:cxn ang="0">
                  <a:pos x="connsiteX209" y="connsiteY209"/>
                </a:cxn>
                <a:cxn ang="0">
                  <a:pos x="connsiteX210" y="connsiteY210"/>
                </a:cxn>
                <a:cxn ang="0">
                  <a:pos x="connsiteX211" y="connsiteY211"/>
                </a:cxn>
                <a:cxn ang="0">
                  <a:pos x="connsiteX212" y="connsiteY212"/>
                </a:cxn>
                <a:cxn ang="0">
                  <a:pos x="connsiteX213" y="connsiteY213"/>
                </a:cxn>
                <a:cxn ang="0">
                  <a:pos x="connsiteX214" y="connsiteY214"/>
                </a:cxn>
                <a:cxn ang="0">
                  <a:pos x="connsiteX215" y="connsiteY215"/>
                </a:cxn>
                <a:cxn ang="0">
                  <a:pos x="connsiteX216" y="connsiteY216"/>
                </a:cxn>
                <a:cxn ang="0">
                  <a:pos x="connsiteX217" y="connsiteY217"/>
                </a:cxn>
                <a:cxn ang="0">
                  <a:pos x="connsiteX218" y="connsiteY218"/>
                </a:cxn>
                <a:cxn ang="0">
                  <a:pos x="connsiteX219" y="connsiteY219"/>
                </a:cxn>
                <a:cxn ang="0">
                  <a:pos x="connsiteX220" y="connsiteY220"/>
                </a:cxn>
                <a:cxn ang="0">
                  <a:pos x="connsiteX221" y="connsiteY221"/>
                </a:cxn>
                <a:cxn ang="0">
                  <a:pos x="connsiteX222" y="connsiteY222"/>
                </a:cxn>
                <a:cxn ang="0">
                  <a:pos x="connsiteX223" y="connsiteY223"/>
                </a:cxn>
                <a:cxn ang="0">
                  <a:pos x="connsiteX224" y="connsiteY224"/>
                </a:cxn>
                <a:cxn ang="0">
                  <a:pos x="connsiteX225" y="connsiteY225"/>
                </a:cxn>
                <a:cxn ang="0">
                  <a:pos x="connsiteX226" y="connsiteY226"/>
                </a:cxn>
                <a:cxn ang="0">
                  <a:pos x="connsiteX227" y="connsiteY227"/>
                </a:cxn>
                <a:cxn ang="0">
                  <a:pos x="connsiteX228" y="connsiteY228"/>
                </a:cxn>
                <a:cxn ang="0">
                  <a:pos x="connsiteX229" y="connsiteY229"/>
                </a:cxn>
                <a:cxn ang="0">
                  <a:pos x="connsiteX230" y="connsiteY230"/>
                </a:cxn>
                <a:cxn ang="0">
                  <a:pos x="connsiteX231" y="connsiteY231"/>
                </a:cxn>
                <a:cxn ang="0">
                  <a:pos x="connsiteX232" y="connsiteY232"/>
                </a:cxn>
                <a:cxn ang="0">
                  <a:pos x="connsiteX233" y="connsiteY233"/>
                </a:cxn>
                <a:cxn ang="0">
                  <a:pos x="connsiteX234" y="connsiteY234"/>
                </a:cxn>
                <a:cxn ang="0">
                  <a:pos x="connsiteX235" y="connsiteY235"/>
                </a:cxn>
                <a:cxn ang="0">
                  <a:pos x="connsiteX236" y="connsiteY236"/>
                </a:cxn>
                <a:cxn ang="0">
                  <a:pos x="connsiteX237" y="connsiteY237"/>
                </a:cxn>
                <a:cxn ang="0">
                  <a:pos x="connsiteX238" y="connsiteY238"/>
                </a:cxn>
                <a:cxn ang="0">
                  <a:pos x="connsiteX239" y="connsiteY239"/>
                </a:cxn>
                <a:cxn ang="0">
                  <a:pos x="connsiteX240" y="connsiteY240"/>
                </a:cxn>
                <a:cxn ang="0">
                  <a:pos x="connsiteX241" y="connsiteY241"/>
                </a:cxn>
                <a:cxn ang="0">
                  <a:pos x="connsiteX242" y="connsiteY242"/>
                </a:cxn>
                <a:cxn ang="0">
                  <a:pos x="connsiteX243" y="connsiteY243"/>
                </a:cxn>
                <a:cxn ang="0">
                  <a:pos x="connsiteX244" y="connsiteY244"/>
                </a:cxn>
                <a:cxn ang="0">
                  <a:pos x="connsiteX245" y="connsiteY245"/>
                </a:cxn>
                <a:cxn ang="0">
                  <a:pos x="connsiteX246" y="connsiteY246"/>
                </a:cxn>
                <a:cxn ang="0">
                  <a:pos x="connsiteX247" y="connsiteY247"/>
                </a:cxn>
                <a:cxn ang="0">
                  <a:pos x="connsiteX248" y="connsiteY248"/>
                </a:cxn>
                <a:cxn ang="0">
                  <a:pos x="connsiteX249" y="connsiteY249"/>
                </a:cxn>
                <a:cxn ang="0">
                  <a:pos x="connsiteX250" y="connsiteY250"/>
                </a:cxn>
                <a:cxn ang="0">
                  <a:pos x="connsiteX251" y="connsiteY251"/>
                </a:cxn>
                <a:cxn ang="0">
                  <a:pos x="connsiteX252" y="connsiteY252"/>
                </a:cxn>
                <a:cxn ang="0">
                  <a:pos x="connsiteX253" y="connsiteY253"/>
                </a:cxn>
                <a:cxn ang="0">
                  <a:pos x="connsiteX254" y="connsiteY254"/>
                </a:cxn>
                <a:cxn ang="0">
                  <a:pos x="connsiteX255" y="connsiteY255"/>
                </a:cxn>
                <a:cxn ang="0">
                  <a:pos x="connsiteX256" y="connsiteY256"/>
                </a:cxn>
                <a:cxn ang="0">
                  <a:pos x="connsiteX257" y="connsiteY257"/>
                </a:cxn>
                <a:cxn ang="0">
                  <a:pos x="connsiteX258" y="connsiteY258"/>
                </a:cxn>
                <a:cxn ang="0">
                  <a:pos x="connsiteX259" y="connsiteY259"/>
                </a:cxn>
                <a:cxn ang="0">
                  <a:pos x="connsiteX260" y="connsiteY260"/>
                </a:cxn>
                <a:cxn ang="0">
                  <a:pos x="connsiteX261" y="connsiteY261"/>
                </a:cxn>
                <a:cxn ang="0">
                  <a:pos x="connsiteX262" y="connsiteY262"/>
                </a:cxn>
                <a:cxn ang="0">
                  <a:pos x="connsiteX263" y="connsiteY263"/>
                </a:cxn>
                <a:cxn ang="0">
                  <a:pos x="connsiteX264" y="connsiteY264"/>
                </a:cxn>
                <a:cxn ang="0">
                  <a:pos x="connsiteX265" y="connsiteY265"/>
                </a:cxn>
                <a:cxn ang="0">
                  <a:pos x="connsiteX266" y="connsiteY266"/>
                </a:cxn>
                <a:cxn ang="0">
                  <a:pos x="connsiteX267" y="connsiteY267"/>
                </a:cxn>
                <a:cxn ang="0">
                  <a:pos x="connsiteX268" y="connsiteY268"/>
                </a:cxn>
                <a:cxn ang="0">
                  <a:pos x="connsiteX269" y="connsiteY269"/>
                </a:cxn>
                <a:cxn ang="0">
                  <a:pos x="connsiteX270" y="connsiteY270"/>
                </a:cxn>
                <a:cxn ang="0">
                  <a:pos x="connsiteX271" y="connsiteY271"/>
                </a:cxn>
                <a:cxn ang="0">
                  <a:pos x="connsiteX272" y="connsiteY272"/>
                </a:cxn>
              </a:cxnLst>
              <a:rect l="l" t="t" r="r" b="b"/>
              <a:pathLst>
                <a:path w="1121569" h="1185863">
                  <a:moveTo>
                    <a:pt x="166688" y="88107"/>
                  </a:moveTo>
                  <a:cubicBezTo>
                    <a:pt x="173038" y="87313"/>
                    <a:pt x="179564" y="87409"/>
                    <a:pt x="185738" y="85725"/>
                  </a:cubicBezTo>
                  <a:cubicBezTo>
                    <a:pt x="188499" y="84972"/>
                    <a:pt x="190322" y="82243"/>
                    <a:pt x="192882" y="80963"/>
                  </a:cubicBezTo>
                  <a:cubicBezTo>
                    <a:pt x="195127" y="79841"/>
                    <a:pt x="197644" y="79376"/>
                    <a:pt x="200025" y="78582"/>
                  </a:cubicBezTo>
                  <a:cubicBezTo>
                    <a:pt x="204788" y="75407"/>
                    <a:pt x="208883" y="70868"/>
                    <a:pt x="214313" y="69057"/>
                  </a:cubicBezTo>
                  <a:cubicBezTo>
                    <a:pt x="216694" y="68263"/>
                    <a:pt x="219212" y="67798"/>
                    <a:pt x="221457" y="66675"/>
                  </a:cubicBezTo>
                  <a:cubicBezTo>
                    <a:pt x="224016" y="65395"/>
                    <a:pt x="225985" y="63075"/>
                    <a:pt x="228600" y="61913"/>
                  </a:cubicBezTo>
                  <a:cubicBezTo>
                    <a:pt x="233188" y="59874"/>
                    <a:pt x="238125" y="58738"/>
                    <a:pt x="242888" y="57150"/>
                  </a:cubicBezTo>
                  <a:lnTo>
                    <a:pt x="250032" y="54769"/>
                  </a:lnTo>
                  <a:cubicBezTo>
                    <a:pt x="252413" y="53975"/>
                    <a:pt x="254714" y="52880"/>
                    <a:pt x="257175" y="52388"/>
                  </a:cubicBezTo>
                  <a:cubicBezTo>
                    <a:pt x="275357" y="48752"/>
                    <a:pt x="265066" y="50509"/>
                    <a:pt x="288132" y="47625"/>
                  </a:cubicBezTo>
                  <a:lnTo>
                    <a:pt x="323850" y="35719"/>
                  </a:lnTo>
                  <a:lnTo>
                    <a:pt x="330994" y="33338"/>
                  </a:lnTo>
                  <a:lnTo>
                    <a:pt x="338138" y="30957"/>
                  </a:lnTo>
                  <a:cubicBezTo>
                    <a:pt x="340519" y="29369"/>
                    <a:pt x="342722" y="27474"/>
                    <a:pt x="345282" y="26194"/>
                  </a:cubicBezTo>
                  <a:cubicBezTo>
                    <a:pt x="347527" y="25072"/>
                    <a:pt x="349990" y="24422"/>
                    <a:pt x="352425" y="23813"/>
                  </a:cubicBezTo>
                  <a:cubicBezTo>
                    <a:pt x="360252" y="21856"/>
                    <a:pt x="370853" y="20462"/>
                    <a:pt x="378619" y="19050"/>
                  </a:cubicBezTo>
                  <a:cubicBezTo>
                    <a:pt x="382601" y="18326"/>
                    <a:pt x="386599" y="17651"/>
                    <a:pt x="390525" y="16669"/>
                  </a:cubicBezTo>
                  <a:cubicBezTo>
                    <a:pt x="403647" y="13389"/>
                    <a:pt x="395837" y="11845"/>
                    <a:pt x="416719" y="9525"/>
                  </a:cubicBezTo>
                  <a:cubicBezTo>
                    <a:pt x="458677" y="4863"/>
                    <a:pt x="430968" y="7420"/>
                    <a:pt x="500063" y="4763"/>
                  </a:cubicBezTo>
                  <a:lnTo>
                    <a:pt x="523875" y="2382"/>
                  </a:lnTo>
                  <a:cubicBezTo>
                    <a:pt x="530235" y="1675"/>
                    <a:pt x="536526" y="0"/>
                    <a:pt x="542925" y="0"/>
                  </a:cubicBezTo>
                  <a:cubicBezTo>
                    <a:pt x="565958" y="0"/>
                    <a:pt x="588963" y="1588"/>
                    <a:pt x="611982" y="2382"/>
                  </a:cubicBezTo>
                  <a:cubicBezTo>
                    <a:pt x="616744" y="3176"/>
                    <a:pt x="621585" y="3592"/>
                    <a:pt x="626269" y="4763"/>
                  </a:cubicBezTo>
                  <a:cubicBezTo>
                    <a:pt x="631139" y="5980"/>
                    <a:pt x="635634" y="8540"/>
                    <a:pt x="640557" y="9525"/>
                  </a:cubicBezTo>
                  <a:cubicBezTo>
                    <a:pt x="648494" y="11113"/>
                    <a:pt x="656690" y="11729"/>
                    <a:pt x="664369" y="14288"/>
                  </a:cubicBezTo>
                  <a:cubicBezTo>
                    <a:pt x="666750" y="15082"/>
                    <a:pt x="669037" y="16256"/>
                    <a:pt x="671513" y="16669"/>
                  </a:cubicBezTo>
                  <a:cubicBezTo>
                    <a:pt x="686344" y="19141"/>
                    <a:pt x="707616" y="19179"/>
                    <a:pt x="721519" y="23813"/>
                  </a:cubicBezTo>
                  <a:lnTo>
                    <a:pt x="735807" y="28575"/>
                  </a:lnTo>
                  <a:cubicBezTo>
                    <a:pt x="738188" y="29369"/>
                    <a:pt x="740515" y="30348"/>
                    <a:pt x="742950" y="30957"/>
                  </a:cubicBezTo>
                  <a:cubicBezTo>
                    <a:pt x="746125" y="31751"/>
                    <a:pt x="749340" y="32398"/>
                    <a:pt x="752475" y="33338"/>
                  </a:cubicBezTo>
                  <a:cubicBezTo>
                    <a:pt x="757284" y="34780"/>
                    <a:pt x="762000" y="36512"/>
                    <a:pt x="766763" y="38100"/>
                  </a:cubicBezTo>
                  <a:lnTo>
                    <a:pt x="788194" y="45244"/>
                  </a:lnTo>
                  <a:lnTo>
                    <a:pt x="809625" y="52388"/>
                  </a:lnTo>
                  <a:lnTo>
                    <a:pt x="816769" y="54769"/>
                  </a:lnTo>
                  <a:cubicBezTo>
                    <a:pt x="819150" y="55563"/>
                    <a:pt x="821409" y="56971"/>
                    <a:pt x="823913" y="57150"/>
                  </a:cubicBezTo>
                  <a:lnTo>
                    <a:pt x="857250" y="59532"/>
                  </a:lnTo>
                  <a:cubicBezTo>
                    <a:pt x="866775" y="61119"/>
                    <a:pt x="876664" y="61240"/>
                    <a:pt x="885825" y="64294"/>
                  </a:cubicBezTo>
                  <a:cubicBezTo>
                    <a:pt x="890588" y="65882"/>
                    <a:pt x="895243" y="67840"/>
                    <a:pt x="900113" y="69057"/>
                  </a:cubicBezTo>
                  <a:cubicBezTo>
                    <a:pt x="903288" y="69851"/>
                    <a:pt x="906443" y="70728"/>
                    <a:pt x="909638" y="71438"/>
                  </a:cubicBezTo>
                  <a:cubicBezTo>
                    <a:pt x="913589" y="72316"/>
                    <a:pt x="917639" y="72754"/>
                    <a:pt x="921544" y="73819"/>
                  </a:cubicBezTo>
                  <a:cubicBezTo>
                    <a:pt x="926387" y="75140"/>
                    <a:pt x="931069" y="76994"/>
                    <a:pt x="935832" y="78582"/>
                  </a:cubicBezTo>
                  <a:cubicBezTo>
                    <a:pt x="961883" y="87266"/>
                    <a:pt x="922422" y="73415"/>
                    <a:pt x="950119" y="85725"/>
                  </a:cubicBezTo>
                  <a:cubicBezTo>
                    <a:pt x="954707" y="87764"/>
                    <a:pt x="964407" y="90488"/>
                    <a:pt x="964407" y="90488"/>
                  </a:cubicBezTo>
                  <a:cubicBezTo>
                    <a:pt x="965994" y="92869"/>
                    <a:pt x="966934" y="95844"/>
                    <a:pt x="969169" y="97632"/>
                  </a:cubicBezTo>
                  <a:cubicBezTo>
                    <a:pt x="971129" y="99200"/>
                    <a:pt x="974068" y="98891"/>
                    <a:pt x="976313" y="100013"/>
                  </a:cubicBezTo>
                  <a:cubicBezTo>
                    <a:pt x="978873" y="101293"/>
                    <a:pt x="980897" y="103495"/>
                    <a:pt x="983457" y="104775"/>
                  </a:cubicBezTo>
                  <a:cubicBezTo>
                    <a:pt x="1003174" y="114634"/>
                    <a:pt x="977270" y="98271"/>
                    <a:pt x="997744" y="111919"/>
                  </a:cubicBezTo>
                  <a:cubicBezTo>
                    <a:pt x="1008661" y="128296"/>
                    <a:pt x="1001839" y="124397"/>
                    <a:pt x="1014413" y="128588"/>
                  </a:cubicBezTo>
                  <a:cubicBezTo>
                    <a:pt x="1016000" y="130969"/>
                    <a:pt x="1016940" y="133944"/>
                    <a:pt x="1019175" y="135732"/>
                  </a:cubicBezTo>
                  <a:cubicBezTo>
                    <a:pt x="1035539" y="148824"/>
                    <a:pt x="1016460" y="123396"/>
                    <a:pt x="1033463" y="145257"/>
                  </a:cubicBezTo>
                  <a:cubicBezTo>
                    <a:pt x="1036977" y="149775"/>
                    <a:pt x="1039813" y="154782"/>
                    <a:pt x="1042988" y="159544"/>
                  </a:cubicBezTo>
                  <a:lnTo>
                    <a:pt x="1052513" y="173832"/>
                  </a:lnTo>
                  <a:cubicBezTo>
                    <a:pt x="1054100" y="176213"/>
                    <a:pt x="1055252" y="178952"/>
                    <a:pt x="1057275" y="180975"/>
                  </a:cubicBezTo>
                  <a:lnTo>
                    <a:pt x="1064419" y="188119"/>
                  </a:lnTo>
                  <a:cubicBezTo>
                    <a:pt x="1073101" y="214168"/>
                    <a:pt x="1059255" y="174715"/>
                    <a:pt x="1071563" y="202407"/>
                  </a:cubicBezTo>
                  <a:cubicBezTo>
                    <a:pt x="1076085" y="212581"/>
                    <a:pt x="1075938" y="216530"/>
                    <a:pt x="1078707" y="226219"/>
                  </a:cubicBezTo>
                  <a:cubicBezTo>
                    <a:pt x="1079397" y="228633"/>
                    <a:pt x="1079869" y="231169"/>
                    <a:pt x="1081088" y="233363"/>
                  </a:cubicBezTo>
                  <a:cubicBezTo>
                    <a:pt x="1083868" y="238366"/>
                    <a:pt x="1087438" y="242888"/>
                    <a:pt x="1090613" y="247650"/>
                  </a:cubicBezTo>
                  <a:cubicBezTo>
                    <a:pt x="1092200" y="250031"/>
                    <a:pt x="1094470" y="252079"/>
                    <a:pt x="1095375" y="254794"/>
                  </a:cubicBezTo>
                  <a:cubicBezTo>
                    <a:pt x="1096169" y="257175"/>
                    <a:pt x="1096634" y="259693"/>
                    <a:pt x="1097757" y="261938"/>
                  </a:cubicBezTo>
                  <a:cubicBezTo>
                    <a:pt x="1099037" y="264498"/>
                    <a:pt x="1101357" y="266467"/>
                    <a:pt x="1102519" y="269082"/>
                  </a:cubicBezTo>
                  <a:cubicBezTo>
                    <a:pt x="1104558" y="273669"/>
                    <a:pt x="1105694" y="278607"/>
                    <a:pt x="1107282" y="283369"/>
                  </a:cubicBezTo>
                  <a:lnTo>
                    <a:pt x="1112044" y="297657"/>
                  </a:lnTo>
                  <a:cubicBezTo>
                    <a:pt x="1114312" y="304462"/>
                    <a:pt x="1115313" y="306855"/>
                    <a:pt x="1116807" y="314325"/>
                  </a:cubicBezTo>
                  <a:cubicBezTo>
                    <a:pt x="1121000" y="335287"/>
                    <a:pt x="1116934" y="321850"/>
                    <a:pt x="1121569" y="335757"/>
                  </a:cubicBezTo>
                  <a:cubicBezTo>
                    <a:pt x="1120775" y="350838"/>
                    <a:pt x="1120442" y="365950"/>
                    <a:pt x="1119188" y="381000"/>
                  </a:cubicBezTo>
                  <a:cubicBezTo>
                    <a:pt x="1118852" y="385034"/>
                    <a:pt x="1117717" y="388963"/>
                    <a:pt x="1116807" y="392907"/>
                  </a:cubicBezTo>
                  <a:cubicBezTo>
                    <a:pt x="1112325" y="412327"/>
                    <a:pt x="1112964" y="409199"/>
                    <a:pt x="1107282" y="426244"/>
                  </a:cubicBezTo>
                  <a:cubicBezTo>
                    <a:pt x="1106488" y="428625"/>
                    <a:pt x="1106292" y="431299"/>
                    <a:pt x="1104900" y="433388"/>
                  </a:cubicBezTo>
                  <a:cubicBezTo>
                    <a:pt x="1103313" y="435769"/>
                    <a:pt x="1101418" y="437972"/>
                    <a:pt x="1100138" y="440532"/>
                  </a:cubicBezTo>
                  <a:cubicBezTo>
                    <a:pt x="1093247" y="454315"/>
                    <a:pt x="1104154" y="441278"/>
                    <a:pt x="1090613" y="454819"/>
                  </a:cubicBezTo>
                  <a:cubicBezTo>
                    <a:pt x="1088227" y="461979"/>
                    <a:pt x="1088599" y="462952"/>
                    <a:pt x="1083469" y="469107"/>
                  </a:cubicBezTo>
                  <a:cubicBezTo>
                    <a:pt x="1081313" y="471694"/>
                    <a:pt x="1078392" y="473592"/>
                    <a:pt x="1076325" y="476250"/>
                  </a:cubicBezTo>
                  <a:cubicBezTo>
                    <a:pt x="1061364" y="495485"/>
                    <a:pt x="1073487" y="486080"/>
                    <a:pt x="1059657" y="495300"/>
                  </a:cubicBezTo>
                  <a:cubicBezTo>
                    <a:pt x="1055471" y="507854"/>
                    <a:pt x="1060041" y="497697"/>
                    <a:pt x="1050132" y="509588"/>
                  </a:cubicBezTo>
                  <a:cubicBezTo>
                    <a:pt x="1033570" y="529463"/>
                    <a:pt x="1059077" y="503026"/>
                    <a:pt x="1038225" y="523875"/>
                  </a:cubicBezTo>
                  <a:cubicBezTo>
                    <a:pt x="1037431" y="526256"/>
                    <a:pt x="1037236" y="528930"/>
                    <a:pt x="1035844" y="531019"/>
                  </a:cubicBezTo>
                  <a:cubicBezTo>
                    <a:pt x="1030748" y="538664"/>
                    <a:pt x="1029046" y="538048"/>
                    <a:pt x="1021557" y="540544"/>
                  </a:cubicBezTo>
                  <a:cubicBezTo>
                    <a:pt x="1016192" y="556634"/>
                    <a:pt x="1023632" y="539192"/>
                    <a:pt x="1012032" y="552450"/>
                  </a:cubicBezTo>
                  <a:cubicBezTo>
                    <a:pt x="1008263" y="556758"/>
                    <a:pt x="1005682" y="561975"/>
                    <a:pt x="1002507" y="566738"/>
                  </a:cubicBezTo>
                  <a:lnTo>
                    <a:pt x="997744" y="573882"/>
                  </a:lnTo>
                  <a:cubicBezTo>
                    <a:pt x="996950" y="576263"/>
                    <a:pt x="995972" y="578590"/>
                    <a:pt x="995363" y="581025"/>
                  </a:cubicBezTo>
                  <a:cubicBezTo>
                    <a:pt x="994401" y="584872"/>
                    <a:pt x="993077" y="595617"/>
                    <a:pt x="990600" y="600075"/>
                  </a:cubicBezTo>
                  <a:cubicBezTo>
                    <a:pt x="987820" y="605079"/>
                    <a:pt x="985838" y="611188"/>
                    <a:pt x="981075" y="614363"/>
                  </a:cubicBezTo>
                  <a:lnTo>
                    <a:pt x="973932" y="619125"/>
                  </a:lnTo>
                  <a:cubicBezTo>
                    <a:pt x="970757" y="623888"/>
                    <a:pt x="969170" y="630238"/>
                    <a:pt x="964407" y="633413"/>
                  </a:cubicBezTo>
                  <a:cubicBezTo>
                    <a:pt x="957382" y="638095"/>
                    <a:pt x="955849" y="638443"/>
                    <a:pt x="950119" y="645319"/>
                  </a:cubicBezTo>
                  <a:cubicBezTo>
                    <a:pt x="940198" y="657225"/>
                    <a:pt x="951310" y="648495"/>
                    <a:pt x="938213" y="657225"/>
                  </a:cubicBezTo>
                  <a:cubicBezTo>
                    <a:pt x="937419" y="659606"/>
                    <a:pt x="937400" y="662409"/>
                    <a:pt x="935832" y="664369"/>
                  </a:cubicBezTo>
                  <a:cubicBezTo>
                    <a:pt x="934044" y="666604"/>
                    <a:pt x="930887" y="667300"/>
                    <a:pt x="928688" y="669132"/>
                  </a:cubicBezTo>
                  <a:cubicBezTo>
                    <a:pt x="926101" y="671288"/>
                    <a:pt x="923700" y="673688"/>
                    <a:pt x="921544" y="676275"/>
                  </a:cubicBezTo>
                  <a:cubicBezTo>
                    <a:pt x="913258" y="686218"/>
                    <a:pt x="921367" y="681891"/>
                    <a:pt x="909638" y="685800"/>
                  </a:cubicBezTo>
                  <a:lnTo>
                    <a:pt x="902494" y="707232"/>
                  </a:lnTo>
                  <a:cubicBezTo>
                    <a:pt x="901700" y="709613"/>
                    <a:pt x="901505" y="712287"/>
                    <a:pt x="900113" y="714375"/>
                  </a:cubicBezTo>
                  <a:cubicBezTo>
                    <a:pt x="896938" y="719138"/>
                    <a:pt x="894635" y="724616"/>
                    <a:pt x="890588" y="728663"/>
                  </a:cubicBezTo>
                  <a:cubicBezTo>
                    <a:pt x="888207" y="731044"/>
                    <a:pt x="885512" y="733149"/>
                    <a:pt x="883444" y="735807"/>
                  </a:cubicBezTo>
                  <a:cubicBezTo>
                    <a:pt x="868485" y="755040"/>
                    <a:pt x="880605" y="745636"/>
                    <a:pt x="866775" y="754857"/>
                  </a:cubicBezTo>
                  <a:lnTo>
                    <a:pt x="847725" y="783432"/>
                  </a:lnTo>
                  <a:lnTo>
                    <a:pt x="842963" y="790575"/>
                  </a:lnTo>
                  <a:lnTo>
                    <a:pt x="838200" y="797719"/>
                  </a:lnTo>
                  <a:cubicBezTo>
                    <a:pt x="832219" y="815666"/>
                    <a:pt x="840284" y="793553"/>
                    <a:pt x="831057" y="812007"/>
                  </a:cubicBezTo>
                  <a:cubicBezTo>
                    <a:pt x="829934" y="814252"/>
                    <a:pt x="830067" y="817062"/>
                    <a:pt x="828675" y="819150"/>
                  </a:cubicBezTo>
                  <a:cubicBezTo>
                    <a:pt x="826807" y="821952"/>
                    <a:pt x="823599" y="823636"/>
                    <a:pt x="821532" y="826294"/>
                  </a:cubicBezTo>
                  <a:cubicBezTo>
                    <a:pt x="806575" y="845526"/>
                    <a:pt x="818692" y="836126"/>
                    <a:pt x="804863" y="845344"/>
                  </a:cubicBezTo>
                  <a:cubicBezTo>
                    <a:pt x="801688" y="850107"/>
                    <a:pt x="799386" y="855585"/>
                    <a:pt x="795338" y="859632"/>
                  </a:cubicBezTo>
                  <a:cubicBezTo>
                    <a:pt x="792957" y="862013"/>
                    <a:pt x="790261" y="864117"/>
                    <a:pt x="788194" y="866775"/>
                  </a:cubicBezTo>
                  <a:cubicBezTo>
                    <a:pt x="784680" y="871293"/>
                    <a:pt x="781844" y="876300"/>
                    <a:pt x="778669" y="881063"/>
                  </a:cubicBezTo>
                  <a:cubicBezTo>
                    <a:pt x="777082" y="883444"/>
                    <a:pt x="775931" y="886183"/>
                    <a:pt x="773907" y="888207"/>
                  </a:cubicBezTo>
                  <a:lnTo>
                    <a:pt x="766763" y="895350"/>
                  </a:lnTo>
                  <a:cubicBezTo>
                    <a:pt x="765175" y="900113"/>
                    <a:pt x="764785" y="905461"/>
                    <a:pt x="762000" y="909638"/>
                  </a:cubicBezTo>
                  <a:lnTo>
                    <a:pt x="752475" y="923925"/>
                  </a:lnTo>
                  <a:cubicBezTo>
                    <a:pt x="750888" y="926306"/>
                    <a:pt x="748618" y="928354"/>
                    <a:pt x="747713" y="931069"/>
                  </a:cubicBezTo>
                  <a:cubicBezTo>
                    <a:pt x="744267" y="941408"/>
                    <a:pt x="747107" y="936438"/>
                    <a:pt x="738188" y="945357"/>
                  </a:cubicBezTo>
                  <a:cubicBezTo>
                    <a:pt x="733997" y="957930"/>
                    <a:pt x="737199" y="950413"/>
                    <a:pt x="726282" y="966788"/>
                  </a:cubicBezTo>
                  <a:lnTo>
                    <a:pt x="711994" y="988219"/>
                  </a:lnTo>
                  <a:cubicBezTo>
                    <a:pt x="710407" y="990600"/>
                    <a:pt x="708137" y="992648"/>
                    <a:pt x="707232" y="995363"/>
                  </a:cubicBezTo>
                  <a:cubicBezTo>
                    <a:pt x="706438" y="997744"/>
                    <a:pt x="706418" y="1000547"/>
                    <a:pt x="704850" y="1002507"/>
                  </a:cubicBezTo>
                  <a:cubicBezTo>
                    <a:pt x="703062" y="1004742"/>
                    <a:pt x="700088" y="1005682"/>
                    <a:pt x="697707" y="1007269"/>
                  </a:cubicBezTo>
                  <a:cubicBezTo>
                    <a:pt x="695225" y="1014713"/>
                    <a:pt x="692818" y="1024021"/>
                    <a:pt x="685800" y="1028700"/>
                  </a:cubicBezTo>
                  <a:lnTo>
                    <a:pt x="678657" y="1033463"/>
                  </a:lnTo>
                  <a:cubicBezTo>
                    <a:pt x="677069" y="1035844"/>
                    <a:pt x="675918" y="1038583"/>
                    <a:pt x="673894" y="1040607"/>
                  </a:cubicBezTo>
                  <a:cubicBezTo>
                    <a:pt x="669279" y="1045222"/>
                    <a:pt x="665416" y="1045814"/>
                    <a:pt x="659607" y="1047750"/>
                  </a:cubicBezTo>
                  <a:cubicBezTo>
                    <a:pt x="657226" y="1049338"/>
                    <a:pt x="655078" y="1051351"/>
                    <a:pt x="652463" y="1052513"/>
                  </a:cubicBezTo>
                  <a:cubicBezTo>
                    <a:pt x="647875" y="1054552"/>
                    <a:pt x="638175" y="1057275"/>
                    <a:pt x="638175" y="1057275"/>
                  </a:cubicBezTo>
                  <a:cubicBezTo>
                    <a:pt x="623094" y="1056481"/>
                    <a:pt x="607972" y="1056261"/>
                    <a:pt x="592932" y="1054894"/>
                  </a:cubicBezTo>
                  <a:cubicBezTo>
                    <a:pt x="590432" y="1054667"/>
                    <a:pt x="587748" y="1054081"/>
                    <a:pt x="585788" y="1052513"/>
                  </a:cubicBezTo>
                  <a:cubicBezTo>
                    <a:pt x="583553" y="1050725"/>
                    <a:pt x="582857" y="1047568"/>
                    <a:pt x="581025" y="1045369"/>
                  </a:cubicBezTo>
                  <a:cubicBezTo>
                    <a:pt x="578869" y="1042782"/>
                    <a:pt x="576469" y="1040381"/>
                    <a:pt x="573882" y="1038225"/>
                  </a:cubicBezTo>
                  <a:cubicBezTo>
                    <a:pt x="571683" y="1036393"/>
                    <a:pt x="568877" y="1035364"/>
                    <a:pt x="566738" y="1033463"/>
                  </a:cubicBezTo>
                  <a:cubicBezTo>
                    <a:pt x="561704" y="1028988"/>
                    <a:pt x="558054" y="1022911"/>
                    <a:pt x="552450" y="1019175"/>
                  </a:cubicBezTo>
                  <a:cubicBezTo>
                    <a:pt x="550069" y="1017588"/>
                    <a:pt x="547505" y="1016245"/>
                    <a:pt x="545307" y="1014413"/>
                  </a:cubicBezTo>
                  <a:cubicBezTo>
                    <a:pt x="521902" y="994909"/>
                    <a:pt x="552131" y="1018856"/>
                    <a:pt x="533400" y="1000125"/>
                  </a:cubicBezTo>
                  <a:cubicBezTo>
                    <a:pt x="531377" y="998102"/>
                    <a:pt x="528638" y="996950"/>
                    <a:pt x="526257" y="995363"/>
                  </a:cubicBezTo>
                  <a:cubicBezTo>
                    <a:pt x="525463" y="992982"/>
                    <a:pt x="525094" y="990413"/>
                    <a:pt x="523875" y="988219"/>
                  </a:cubicBezTo>
                  <a:cubicBezTo>
                    <a:pt x="521095" y="983216"/>
                    <a:pt x="514350" y="973932"/>
                    <a:pt x="514350" y="973932"/>
                  </a:cubicBezTo>
                  <a:cubicBezTo>
                    <a:pt x="508683" y="956929"/>
                    <a:pt x="512373" y="963821"/>
                    <a:pt x="504825" y="952500"/>
                  </a:cubicBezTo>
                  <a:lnTo>
                    <a:pt x="500063" y="938213"/>
                  </a:lnTo>
                  <a:cubicBezTo>
                    <a:pt x="499269" y="935832"/>
                    <a:pt x="498291" y="933504"/>
                    <a:pt x="497682" y="931069"/>
                  </a:cubicBezTo>
                  <a:lnTo>
                    <a:pt x="495300" y="921544"/>
                  </a:lnTo>
                  <a:cubicBezTo>
                    <a:pt x="489509" y="875212"/>
                    <a:pt x="491185" y="896362"/>
                    <a:pt x="495300" y="812007"/>
                  </a:cubicBezTo>
                  <a:cubicBezTo>
                    <a:pt x="495422" y="809500"/>
                    <a:pt x="497073" y="807298"/>
                    <a:pt x="497682" y="804863"/>
                  </a:cubicBezTo>
                  <a:cubicBezTo>
                    <a:pt x="504415" y="777933"/>
                    <a:pt x="494606" y="809326"/>
                    <a:pt x="504825" y="778669"/>
                  </a:cubicBezTo>
                  <a:cubicBezTo>
                    <a:pt x="505619" y="776288"/>
                    <a:pt x="505815" y="773614"/>
                    <a:pt x="507207" y="771525"/>
                  </a:cubicBezTo>
                  <a:lnTo>
                    <a:pt x="516732" y="757238"/>
                  </a:lnTo>
                  <a:lnTo>
                    <a:pt x="531019" y="714375"/>
                  </a:lnTo>
                  <a:lnTo>
                    <a:pt x="535782" y="700088"/>
                  </a:lnTo>
                  <a:cubicBezTo>
                    <a:pt x="536576" y="697707"/>
                    <a:pt x="536771" y="695033"/>
                    <a:pt x="538163" y="692944"/>
                  </a:cubicBezTo>
                  <a:cubicBezTo>
                    <a:pt x="539750" y="690563"/>
                    <a:pt x="541763" y="688415"/>
                    <a:pt x="542925" y="685800"/>
                  </a:cubicBezTo>
                  <a:cubicBezTo>
                    <a:pt x="544964" y="681213"/>
                    <a:pt x="546100" y="676275"/>
                    <a:pt x="547688" y="671513"/>
                  </a:cubicBezTo>
                  <a:cubicBezTo>
                    <a:pt x="548482" y="669132"/>
                    <a:pt x="548677" y="666457"/>
                    <a:pt x="550069" y="664369"/>
                  </a:cubicBezTo>
                  <a:lnTo>
                    <a:pt x="554832" y="657225"/>
                  </a:lnTo>
                  <a:cubicBezTo>
                    <a:pt x="555626" y="654844"/>
                    <a:pt x="555994" y="652276"/>
                    <a:pt x="557213" y="650082"/>
                  </a:cubicBezTo>
                  <a:cubicBezTo>
                    <a:pt x="559993" y="645078"/>
                    <a:pt x="563563" y="640557"/>
                    <a:pt x="566738" y="635794"/>
                  </a:cubicBezTo>
                  <a:lnTo>
                    <a:pt x="576263" y="621507"/>
                  </a:lnTo>
                  <a:cubicBezTo>
                    <a:pt x="577851" y="619126"/>
                    <a:pt x="580120" y="617078"/>
                    <a:pt x="581025" y="614363"/>
                  </a:cubicBezTo>
                  <a:cubicBezTo>
                    <a:pt x="581819" y="611982"/>
                    <a:pt x="581839" y="609179"/>
                    <a:pt x="583407" y="607219"/>
                  </a:cubicBezTo>
                  <a:cubicBezTo>
                    <a:pt x="585195" y="604984"/>
                    <a:pt x="588169" y="604044"/>
                    <a:pt x="590550" y="602457"/>
                  </a:cubicBezTo>
                  <a:cubicBezTo>
                    <a:pt x="591344" y="600076"/>
                    <a:pt x="592242" y="597727"/>
                    <a:pt x="592932" y="595313"/>
                  </a:cubicBezTo>
                  <a:cubicBezTo>
                    <a:pt x="593949" y="591753"/>
                    <a:pt x="595791" y="582450"/>
                    <a:pt x="597694" y="578644"/>
                  </a:cubicBezTo>
                  <a:cubicBezTo>
                    <a:pt x="598974" y="576084"/>
                    <a:pt x="600869" y="573881"/>
                    <a:pt x="602457" y="571500"/>
                  </a:cubicBezTo>
                  <a:cubicBezTo>
                    <a:pt x="608440" y="553550"/>
                    <a:pt x="600370" y="575673"/>
                    <a:pt x="609600" y="557213"/>
                  </a:cubicBezTo>
                  <a:cubicBezTo>
                    <a:pt x="610723" y="554968"/>
                    <a:pt x="610859" y="552314"/>
                    <a:pt x="611982" y="550069"/>
                  </a:cubicBezTo>
                  <a:cubicBezTo>
                    <a:pt x="613262" y="547509"/>
                    <a:pt x="615464" y="545485"/>
                    <a:pt x="616744" y="542925"/>
                  </a:cubicBezTo>
                  <a:cubicBezTo>
                    <a:pt x="619675" y="537063"/>
                    <a:pt x="620592" y="526980"/>
                    <a:pt x="621507" y="521494"/>
                  </a:cubicBezTo>
                  <a:cubicBezTo>
                    <a:pt x="620713" y="509588"/>
                    <a:pt x="620374" y="497642"/>
                    <a:pt x="619125" y="485775"/>
                  </a:cubicBezTo>
                  <a:cubicBezTo>
                    <a:pt x="618782" y="482520"/>
                    <a:pt x="617454" y="479445"/>
                    <a:pt x="616744" y="476250"/>
                  </a:cubicBezTo>
                  <a:cubicBezTo>
                    <a:pt x="615866" y="472299"/>
                    <a:pt x="615241" y="468295"/>
                    <a:pt x="614363" y="464344"/>
                  </a:cubicBezTo>
                  <a:cubicBezTo>
                    <a:pt x="613751" y="461592"/>
                    <a:pt x="611193" y="450861"/>
                    <a:pt x="609600" y="447675"/>
                  </a:cubicBezTo>
                  <a:cubicBezTo>
                    <a:pt x="608320" y="445116"/>
                    <a:pt x="607073" y="442320"/>
                    <a:pt x="604838" y="440532"/>
                  </a:cubicBezTo>
                  <a:cubicBezTo>
                    <a:pt x="602878" y="438964"/>
                    <a:pt x="600075" y="438944"/>
                    <a:pt x="597694" y="438150"/>
                  </a:cubicBezTo>
                  <a:cubicBezTo>
                    <a:pt x="590147" y="426830"/>
                    <a:pt x="595646" y="431911"/>
                    <a:pt x="578644" y="426244"/>
                  </a:cubicBezTo>
                  <a:lnTo>
                    <a:pt x="571500" y="423863"/>
                  </a:lnTo>
                  <a:cubicBezTo>
                    <a:pt x="569119" y="423069"/>
                    <a:pt x="566833" y="421895"/>
                    <a:pt x="564357" y="421482"/>
                  </a:cubicBezTo>
                  <a:cubicBezTo>
                    <a:pt x="539080" y="417268"/>
                    <a:pt x="554885" y="419444"/>
                    <a:pt x="516732" y="416719"/>
                  </a:cubicBezTo>
                  <a:cubicBezTo>
                    <a:pt x="512763" y="415925"/>
                    <a:pt x="508873" y="414338"/>
                    <a:pt x="504825" y="414338"/>
                  </a:cubicBezTo>
                  <a:cubicBezTo>
                    <a:pt x="480778" y="414338"/>
                    <a:pt x="462374" y="414731"/>
                    <a:pt x="440532" y="419100"/>
                  </a:cubicBezTo>
                  <a:cubicBezTo>
                    <a:pt x="431544" y="420898"/>
                    <a:pt x="425818" y="423211"/>
                    <a:pt x="416719" y="426244"/>
                  </a:cubicBezTo>
                  <a:cubicBezTo>
                    <a:pt x="416714" y="426246"/>
                    <a:pt x="402437" y="431003"/>
                    <a:pt x="402432" y="431007"/>
                  </a:cubicBezTo>
                  <a:cubicBezTo>
                    <a:pt x="393199" y="437161"/>
                    <a:pt x="398003" y="434864"/>
                    <a:pt x="388144" y="438150"/>
                  </a:cubicBezTo>
                  <a:lnTo>
                    <a:pt x="366713" y="452438"/>
                  </a:lnTo>
                  <a:cubicBezTo>
                    <a:pt x="364332" y="454025"/>
                    <a:pt x="362284" y="456295"/>
                    <a:pt x="359569" y="457200"/>
                  </a:cubicBezTo>
                  <a:lnTo>
                    <a:pt x="330994" y="466725"/>
                  </a:lnTo>
                  <a:lnTo>
                    <a:pt x="323850" y="469107"/>
                  </a:lnTo>
                  <a:cubicBezTo>
                    <a:pt x="321469" y="469901"/>
                    <a:pt x="318795" y="470096"/>
                    <a:pt x="316707" y="471488"/>
                  </a:cubicBezTo>
                  <a:cubicBezTo>
                    <a:pt x="314326" y="473075"/>
                    <a:pt x="312123" y="474970"/>
                    <a:pt x="309563" y="476250"/>
                  </a:cubicBezTo>
                  <a:cubicBezTo>
                    <a:pt x="307318" y="477373"/>
                    <a:pt x="304613" y="477413"/>
                    <a:pt x="302419" y="478632"/>
                  </a:cubicBezTo>
                  <a:cubicBezTo>
                    <a:pt x="297416" y="481412"/>
                    <a:pt x="292180" y="484110"/>
                    <a:pt x="288132" y="488157"/>
                  </a:cubicBezTo>
                  <a:cubicBezTo>
                    <a:pt x="278964" y="497324"/>
                    <a:pt x="283790" y="493432"/>
                    <a:pt x="273844" y="500063"/>
                  </a:cubicBezTo>
                  <a:cubicBezTo>
                    <a:pt x="272257" y="502444"/>
                    <a:pt x="271106" y="505183"/>
                    <a:pt x="269082" y="507207"/>
                  </a:cubicBezTo>
                  <a:cubicBezTo>
                    <a:pt x="267058" y="509231"/>
                    <a:pt x="263823" y="509815"/>
                    <a:pt x="261938" y="511969"/>
                  </a:cubicBezTo>
                  <a:cubicBezTo>
                    <a:pt x="258169" y="516277"/>
                    <a:pt x="255588" y="521494"/>
                    <a:pt x="252413" y="526257"/>
                  </a:cubicBezTo>
                  <a:lnTo>
                    <a:pt x="247650" y="533400"/>
                  </a:lnTo>
                  <a:cubicBezTo>
                    <a:pt x="246062" y="535781"/>
                    <a:pt x="245269" y="538956"/>
                    <a:pt x="242888" y="540544"/>
                  </a:cubicBezTo>
                  <a:lnTo>
                    <a:pt x="235744" y="545307"/>
                  </a:lnTo>
                  <a:cubicBezTo>
                    <a:pt x="223046" y="564353"/>
                    <a:pt x="239712" y="541339"/>
                    <a:pt x="223838" y="557213"/>
                  </a:cubicBezTo>
                  <a:cubicBezTo>
                    <a:pt x="207964" y="573087"/>
                    <a:pt x="230978" y="556421"/>
                    <a:pt x="211932" y="569119"/>
                  </a:cubicBezTo>
                  <a:cubicBezTo>
                    <a:pt x="201015" y="585496"/>
                    <a:pt x="207837" y="581597"/>
                    <a:pt x="195263" y="585788"/>
                  </a:cubicBezTo>
                  <a:cubicBezTo>
                    <a:pt x="189278" y="603745"/>
                    <a:pt x="198048" y="582307"/>
                    <a:pt x="185738" y="597694"/>
                  </a:cubicBezTo>
                  <a:cubicBezTo>
                    <a:pt x="176501" y="609240"/>
                    <a:pt x="191800" y="602024"/>
                    <a:pt x="176213" y="607219"/>
                  </a:cubicBezTo>
                  <a:cubicBezTo>
                    <a:pt x="162562" y="627695"/>
                    <a:pt x="180739" y="603598"/>
                    <a:pt x="164307" y="616744"/>
                  </a:cubicBezTo>
                  <a:cubicBezTo>
                    <a:pt x="148921" y="629053"/>
                    <a:pt x="170354" y="620285"/>
                    <a:pt x="152400" y="626269"/>
                  </a:cubicBezTo>
                  <a:cubicBezTo>
                    <a:pt x="126850" y="643306"/>
                    <a:pt x="165643" y="616764"/>
                    <a:pt x="138113" y="638175"/>
                  </a:cubicBezTo>
                  <a:cubicBezTo>
                    <a:pt x="133595" y="641689"/>
                    <a:pt x="127872" y="643652"/>
                    <a:pt x="123825" y="647700"/>
                  </a:cubicBezTo>
                  <a:cubicBezTo>
                    <a:pt x="121444" y="650081"/>
                    <a:pt x="118838" y="652257"/>
                    <a:pt x="116682" y="654844"/>
                  </a:cubicBezTo>
                  <a:cubicBezTo>
                    <a:pt x="114850" y="657043"/>
                    <a:pt x="114154" y="660200"/>
                    <a:pt x="111919" y="661988"/>
                  </a:cubicBezTo>
                  <a:cubicBezTo>
                    <a:pt x="109959" y="663556"/>
                    <a:pt x="107156" y="663575"/>
                    <a:pt x="104775" y="664369"/>
                  </a:cubicBezTo>
                  <a:cubicBezTo>
                    <a:pt x="103981" y="666750"/>
                    <a:pt x="104169" y="669738"/>
                    <a:pt x="102394" y="671513"/>
                  </a:cubicBezTo>
                  <a:cubicBezTo>
                    <a:pt x="100619" y="673288"/>
                    <a:pt x="97495" y="672771"/>
                    <a:pt x="95250" y="673894"/>
                  </a:cubicBezTo>
                  <a:cubicBezTo>
                    <a:pt x="92690" y="675174"/>
                    <a:pt x="90488" y="677069"/>
                    <a:pt x="88107" y="678657"/>
                  </a:cubicBezTo>
                  <a:cubicBezTo>
                    <a:pt x="83470" y="692563"/>
                    <a:pt x="89353" y="679792"/>
                    <a:pt x="78582" y="690563"/>
                  </a:cubicBezTo>
                  <a:cubicBezTo>
                    <a:pt x="62714" y="706432"/>
                    <a:pt x="85717" y="689776"/>
                    <a:pt x="66675" y="702469"/>
                  </a:cubicBezTo>
                  <a:cubicBezTo>
                    <a:pt x="60690" y="720426"/>
                    <a:pt x="69460" y="698988"/>
                    <a:pt x="57150" y="714375"/>
                  </a:cubicBezTo>
                  <a:cubicBezTo>
                    <a:pt x="44002" y="730809"/>
                    <a:pt x="68102" y="712630"/>
                    <a:pt x="47625" y="726282"/>
                  </a:cubicBezTo>
                  <a:cubicBezTo>
                    <a:pt x="42989" y="740189"/>
                    <a:pt x="48871" y="727416"/>
                    <a:pt x="38100" y="738188"/>
                  </a:cubicBezTo>
                  <a:cubicBezTo>
                    <a:pt x="22229" y="754060"/>
                    <a:pt x="45241" y="737398"/>
                    <a:pt x="26194" y="750094"/>
                  </a:cubicBezTo>
                  <a:cubicBezTo>
                    <a:pt x="25400" y="752475"/>
                    <a:pt x="25588" y="755463"/>
                    <a:pt x="23813" y="757238"/>
                  </a:cubicBezTo>
                  <a:cubicBezTo>
                    <a:pt x="19766" y="761285"/>
                    <a:pt x="9525" y="766763"/>
                    <a:pt x="9525" y="766763"/>
                  </a:cubicBezTo>
                  <a:lnTo>
                    <a:pt x="2382" y="788194"/>
                  </a:lnTo>
                  <a:lnTo>
                    <a:pt x="0" y="795338"/>
                  </a:lnTo>
                  <a:cubicBezTo>
                    <a:pt x="794" y="799307"/>
                    <a:pt x="961" y="803454"/>
                    <a:pt x="2382" y="807244"/>
                  </a:cubicBezTo>
                  <a:cubicBezTo>
                    <a:pt x="9150" y="825292"/>
                    <a:pt x="26749" y="813163"/>
                    <a:pt x="45244" y="812007"/>
                  </a:cubicBezTo>
                  <a:cubicBezTo>
                    <a:pt x="47625" y="810419"/>
                    <a:pt x="49828" y="808524"/>
                    <a:pt x="52388" y="807244"/>
                  </a:cubicBezTo>
                  <a:cubicBezTo>
                    <a:pt x="54633" y="806121"/>
                    <a:pt x="57338" y="806082"/>
                    <a:pt x="59532" y="804863"/>
                  </a:cubicBezTo>
                  <a:cubicBezTo>
                    <a:pt x="64535" y="802083"/>
                    <a:pt x="68389" y="797148"/>
                    <a:pt x="73819" y="795338"/>
                  </a:cubicBezTo>
                  <a:lnTo>
                    <a:pt x="88107" y="790575"/>
                  </a:lnTo>
                  <a:cubicBezTo>
                    <a:pt x="106764" y="792441"/>
                    <a:pt x="113754" y="791980"/>
                    <a:pt x="130969" y="797719"/>
                  </a:cubicBezTo>
                  <a:lnTo>
                    <a:pt x="145257" y="802482"/>
                  </a:lnTo>
                  <a:cubicBezTo>
                    <a:pt x="147638" y="803276"/>
                    <a:pt x="150312" y="803471"/>
                    <a:pt x="152400" y="804863"/>
                  </a:cubicBezTo>
                  <a:cubicBezTo>
                    <a:pt x="172873" y="818510"/>
                    <a:pt x="146970" y="802148"/>
                    <a:pt x="166688" y="812007"/>
                  </a:cubicBezTo>
                  <a:cubicBezTo>
                    <a:pt x="185148" y="821237"/>
                    <a:pt x="163025" y="813167"/>
                    <a:pt x="180975" y="819150"/>
                  </a:cubicBezTo>
                  <a:lnTo>
                    <a:pt x="202407" y="833438"/>
                  </a:lnTo>
                  <a:lnTo>
                    <a:pt x="209550" y="838200"/>
                  </a:lnTo>
                  <a:cubicBezTo>
                    <a:pt x="211931" y="839788"/>
                    <a:pt x="213979" y="842058"/>
                    <a:pt x="216694" y="842963"/>
                  </a:cubicBezTo>
                  <a:lnTo>
                    <a:pt x="223838" y="845344"/>
                  </a:lnTo>
                  <a:cubicBezTo>
                    <a:pt x="225425" y="847725"/>
                    <a:pt x="226173" y="850971"/>
                    <a:pt x="228600" y="852488"/>
                  </a:cubicBezTo>
                  <a:cubicBezTo>
                    <a:pt x="232857" y="855149"/>
                    <a:pt x="242888" y="857250"/>
                    <a:pt x="242888" y="857250"/>
                  </a:cubicBezTo>
                  <a:cubicBezTo>
                    <a:pt x="263364" y="870901"/>
                    <a:pt x="237457" y="854534"/>
                    <a:pt x="257175" y="864394"/>
                  </a:cubicBezTo>
                  <a:cubicBezTo>
                    <a:pt x="275636" y="873625"/>
                    <a:pt x="253510" y="865555"/>
                    <a:pt x="271463" y="871538"/>
                  </a:cubicBezTo>
                  <a:cubicBezTo>
                    <a:pt x="273050" y="873919"/>
                    <a:pt x="273798" y="877165"/>
                    <a:pt x="276225" y="878682"/>
                  </a:cubicBezTo>
                  <a:cubicBezTo>
                    <a:pt x="280482" y="881343"/>
                    <a:pt x="290513" y="883444"/>
                    <a:pt x="290513" y="883444"/>
                  </a:cubicBezTo>
                  <a:lnTo>
                    <a:pt x="319088" y="902494"/>
                  </a:lnTo>
                  <a:cubicBezTo>
                    <a:pt x="321469" y="904082"/>
                    <a:pt x="323517" y="906352"/>
                    <a:pt x="326232" y="907257"/>
                  </a:cubicBezTo>
                  <a:cubicBezTo>
                    <a:pt x="328613" y="908051"/>
                    <a:pt x="331181" y="908419"/>
                    <a:pt x="333375" y="909638"/>
                  </a:cubicBezTo>
                  <a:cubicBezTo>
                    <a:pt x="338379" y="912418"/>
                    <a:pt x="342900" y="915988"/>
                    <a:pt x="347663" y="919163"/>
                  </a:cubicBezTo>
                  <a:lnTo>
                    <a:pt x="354807" y="923925"/>
                  </a:lnTo>
                  <a:cubicBezTo>
                    <a:pt x="357188" y="925512"/>
                    <a:pt x="359926" y="926664"/>
                    <a:pt x="361950" y="928688"/>
                  </a:cubicBezTo>
                  <a:cubicBezTo>
                    <a:pt x="371118" y="937856"/>
                    <a:pt x="366292" y="933964"/>
                    <a:pt x="376238" y="940594"/>
                  </a:cubicBezTo>
                  <a:cubicBezTo>
                    <a:pt x="377825" y="942975"/>
                    <a:pt x="378765" y="945950"/>
                    <a:pt x="381000" y="947738"/>
                  </a:cubicBezTo>
                  <a:cubicBezTo>
                    <a:pt x="382960" y="949306"/>
                    <a:pt x="386369" y="948344"/>
                    <a:pt x="388144" y="950119"/>
                  </a:cubicBezTo>
                  <a:cubicBezTo>
                    <a:pt x="389919" y="951894"/>
                    <a:pt x="388957" y="955303"/>
                    <a:pt x="390525" y="957263"/>
                  </a:cubicBezTo>
                  <a:cubicBezTo>
                    <a:pt x="392313" y="959498"/>
                    <a:pt x="395288" y="960438"/>
                    <a:pt x="397669" y="962025"/>
                  </a:cubicBezTo>
                  <a:cubicBezTo>
                    <a:pt x="403653" y="979979"/>
                    <a:pt x="394885" y="958546"/>
                    <a:pt x="407194" y="973932"/>
                  </a:cubicBezTo>
                  <a:cubicBezTo>
                    <a:pt x="408762" y="975892"/>
                    <a:pt x="408356" y="978881"/>
                    <a:pt x="409575" y="981075"/>
                  </a:cubicBezTo>
                  <a:cubicBezTo>
                    <a:pt x="417747" y="995784"/>
                    <a:pt x="415808" y="993168"/>
                    <a:pt x="426244" y="1000125"/>
                  </a:cubicBezTo>
                  <a:cubicBezTo>
                    <a:pt x="432228" y="1018079"/>
                    <a:pt x="423460" y="996646"/>
                    <a:pt x="435769" y="1012032"/>
                  </a:cubicBezTo>
                  <a:cubicBezTo>
                    <a:pt x="437337" y="1013992"/>
                    <a:pt x="436758" y="1017087"/>
                    <a:pt x="438150" y="1019175"/>
                  </a:cubicBezTo>
                  <a:cubicBezTo>
                    <a:pt x="446369" y="1031503"/>
                    <a:pt x="448479" y="1021586"/>
                    <a:pt x="454819" y="1040607"/>
                  </a:cubicBezTo>
                  <a:cubicBezTo>
                    <a:pt x="455613" y="1042988"/>
                    <a:pt x="455981" y="1045556"/>
                    <a:pt x="457200" y="1047750"/>
                  </a:cubicBezTo>
                  <a:cubicBezTo>
                    <a:pt x="459980" y="1052754"/>
                    <a:pt x="464915" y="1056608"/>
                    <a:pt x="466725" y="1062038"/>
                  </a:cubicBezTo>
                  <a:lnTo>
                    <a:pt x="471488" y="1076325"/>
                  </a:lnTo>
                  <a:cubicBezTo>
                    <a:pt x="472282" y="1078706"/>
                    <a:pt x="472477" y="1081381"/>
                    <a:pt x="473869" y="1083469"/>
                  </a:cubicBezTo>
                  <a:lnTo>
                    <a:pt x="478632" y="1090613"/>
                  </a:lnTo>
                  <a:cubicBezTo>
                    <a:pt x="484615" y="1108564"/>
                    <a:pt x="476546" y="1086443"/>
                    <a:pt x="485775" y="1104900"/>
                  </a:cubicBezTo>
                  <a:cubicBezTo>
                    <a:pt x="486898" y="1107145"/>
                    <a:pt x="486938" y="1109850"/>
                    <a:pt x="488157" y="1112044"/>
                  </a:cubicBezTo>
                  <a:cubicBezTo>
                    <a:pt x="490937" y="1117048"/>
                    <a:pt x="494507" y="1121569"/>
                    <a:pt x="497682" y="1126332"/>
                  </a:cubicBezTo>
                  <a:lnTo>
                    <a:pt x="502444" y="1133475"/>
                  </a:lnTo>
                  <a:lnTo>
                    <a:pt x="507207" y="1140619"/>
                  </a:lnTo>
                  <a:cubicBezTo>
                    <a:pt x="508001" y="1143000"/>
                    <a:pt x="508466" y="1145518"/>
                    <a:pt x="509588" y="1147763"/>
                  </a:cubicBezTo>
                  <a:cubicBezTo>
                    <a:pt x="510868" y="1150323"/>
                    <a:pt x="513188" y="1152292"/>
                    <a:pt x="514350" y="1154907"/>
                  </a:cubicBezTo>
                  <a:cubicBezTo>
                    <a:pt x="516389" y="1159494"/>
                    <a:pt x="516329" y="1165017"/>
                    <a:pt x="519113" y="1169194"/>
                  </a:cubicBezTo>
                  <a:cubicBezTo>
                    <a:pt x="523768" y="1176177"/>
                    <a:pt x="524285" y="1175596"/>
                    <a:pt x="526257" y="1183482"/>
                  </a:cubicBezTo>
                  <a:cubicBezTo>
                    <a:pt x="526450" y="1184252"/>
                    <a:pt x="526257" y="1185069"/>
                    <a:pt x="526257" y="1185863"/>
                  </a:cubicBezTo>
                </a:path>
              </a:pathLst>
            </a:custGeom>
            <a:noFill/>
            <a:ln w="38100">
              <a:solidFill>
                <a:schemeClr val="bg1"/>
              </a:solidFill>
              <a:prstDash val="sysDot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9666"/>
            </a:p>
          </p:txBody>
        </p:sp>
        <p:sp>
          <p:nvSpPr>
            <p:cNvPr id="36" name="Freeform 35"/>
            <p:cNvSpPr/>
            <p:nvPr/>
          </p:nvSpPr>
          <p:spPr>
            <a:xfrm>
              <a:off x="4977917" y="647670"/>
              <a:ext cx="827992" cy="1860268"/>
            </a:xfrm>
            <a:custGeom>
              <a:avLst/>
              <a:gdLst>
                <a:gd name="connsiteX0" fmla="*/ 863600 w 863600"/>
                <a:gd name="connsiteY0" fmla="*/ 0 h 1797050"/>
                <a:gd name="connsiteX1" fmla="*/ 815975 w 863600"/>
                <a:gd name="connsiteY1" fmla="*/ 6350 h 1797050"/>
                <a:gd name="connsiteX2" fmla="*/ 806450 w 863600"/>
                <a:gd name="connsiteY2" fmla="*/ 9525 h 1797050"/>
                <a:gd name="connsiteX3" fmla="*/ 787400 w 863600"/>
                <a:gd name="connsiteY3" fmla="*/ 22225 h 1797050"/>
                <a:gd name="connsiteX4" fmla="*/ 758825 w 863600"/>
                <a:gd name="connsiteY4" fmla="*/ 34925 h 1797050"/>
                <a:gd name="connsiteX5" fmla="*/ 749300 w 863600"/>
                <a:gd name="connsiteY5" fmla="*/ 38100 h 1797050"/>
                <a:gd name="connsiteX6" fmla="*/ 739775 w 863600"/>
                <a:gd name="connsiteY6" fmla="*/ 44450 h 1797050"/>
                <a:gd name="connsiteX7" fmla="*/ 720725 w 863600"/>
                <a:gd name="connsiteY7" fmla="*/ 50800 h 1797050"/>
                <a:gd name="connsiteX8" fmla="*/ 711200 w 863600"/>
                <a:gd name="connsiteY8" fmla="*/ 53975 h 1797050"/>
                <a:gd name="connsiteX9" fmla="*/ 692150 w 863600"/>
                <a:gd name="connsiteY9" fmla="*/ 66675 h 1797050"/>
                <a:gd name="connsiteX10" fmla="*/ 682625 w 863600"/>
                <a:gd name="connsiteY10" fmla="*/ 73025 h 1797050"/>
                <a:gd name="connsiteX11" fmla="*/ 673100 w 863600"/>
                <a:gd name="connsiteY11" fmla="*/ 76200 h 1797050"/>
                <a:gd name="connsiteX12" fmla="*/ 663575 w 863600"/>
                <a:gd name="connsiteY12" fmla="*/ 85725 h 1797050"/>
                <a:gd name="connsiteX13" fmla="*/ 644525 w 863600"/>
                <a:gd name="connsiteY13" fmla="*/ 92075 h 1797050"/>
                <a:gd name="connsiteX14" fmla="*/ 635000 w 863600"/>
                <a:gd name="connsiteY14" fmla="*/ 95250 h 1797050"/>
                <a:gd name="connsiteX15" fmla="*/ 615950 w 863600"/>
                <a:gd name="connsiteY15" fmla="*/ 107950 h 1797050"/>
                <a:gd name="connsiteX16" fmla="*/ 587375 w 863600"/>
                <a:gd name="connsiteY16" fmla="*/ 130175 h 1797050"/>
                <a:gd name="connsiteX17" fmla="*/ 577850 w 863600"/>
                <a:gd name="connsiteY17" fmla="*/ 133350 h 1797050"/>
                <a:gd name="connsiteX18" fmla="*/ 571500 w 863600"/>
                <a:gd name="connsiteY18" fmla="*/ 142875 h 1797050"/>
                <a:gd name="connsiteX19" fmla="*/ 561975 w 863600"/>
                <a:gd name="connsiteY19" fmla="*/ 146050 h 1797050"/>
                <a:gd name="connsiteX20" fmla="*/ 542925 w 863600"/>
                <a:gd name="connsiteY20" fmla="*/ 158750 h 1797050"/>
                <a:gd name="connsiteX21" fmla="*/ 533400 w 863600"/>
                <a:gd name="connsiteY21" fmla="*/ 168275 h 1797050"/>
                <a:gd name="connsiteX22" fmla="*/ 523875 w 863600"/>
                <a:gd name="connsiteY22" fmla="*/ 171450 h 1797050"/>
                <a:gd name="connsiteX23" fmla="*/ 504825 w 863600"/>
                <a:gd name="connsiteY23" fmla="*/ 184150 h 1797050"/>
                <a:gd name="connsiteX24" fmla="*/ 476250 w 863600"/>
                <a:gd name="connsiteY24" fmla="*/ 203200 h 1797050"/>
                <a:gd name="connsiteX25" fmla="*/ 466725 w 863600"/>
                <a:gd name="connsiteY25" fmla="*/ 209550 h 1797050"/>
                <a:gd name="connsiteX26" fmla="*/ 447675 w 863600"/>
                <a:gd name="connsiteY26" fmla="*/ 225425 h 1797050"/>
                <a:gd name="connsiteX27" fmla="*/ 428625 w 863600"/>
                <a:gd name="connsiteY27" fmla="*/ 254000 h 1797050"/>
                <a:gd name="connsiteX28" fmla="*/ 422275 w 863600"/>
                <a:gd name="connsiteY28" fmla="*/ 263525 h 1797050"/>
                <a:gd name="connsiteX29" fmla="*/ 419100 w 863600"/>
                <a:gd name="connsiteY29" fmla="*/ 273050 h 1797050"/>
                <a:gd name="connsiteX30" fmla="*/ 400050 w 863600"/>
                <a:gd name="connsiteY30" fmla="*/ 285750 h 1797050"/>
                <a:gd name="connsiteX31" fmla="*/ 396875 w 863600"/>
                <a:gd name="connsiteY31" fmla="*/ 295275 h 1797050"/>
                <a:gd name="connsiteX32" fmla="*/ 377825 w 863600"/>
                <a:gd name="connsiteY32" fmla="*/ 307975 h 1797050"/>
                <a:gd name="connsiteX33" fmla="*/ 361950 w 863600"/>
                <a:gd name="connsiteY33" fmla="*/ 323850 h 1797050"/>
                <a:gd name="connsiteX34" fmla="*/ 355600 w 863600"/>
                <a:gd name="connsiteY34" fmla="*/ 333375 h 1797050"/>
                <a:gd name="connsiteX35" fmla="*/ 346075 w 863600"/>
                <a:gd name="connsiteY35" fmla="*/ 339725 h 1797050"/>
                <a:gd name="connsiteX36" fmla="*/ 336550 w 863600"/>
                <a:gd name="connsiteY36" fmla="*/ 349250 h 1797050"/>
                <a:gd name="connsiteX37" fmla="*/ 317500 w 863600"/>
                <a:gd name="connsiteY37" fmla="*/ 361950 h 1797050"/>
                <a:gd name="connsiteX38" fmla="*/ 295275 w 863600"/>
                <a:gd name="connsiteY38" fmla="*/ 390525 h 1797050"/>
                <a:gd name="connsiteX39" fmla="*/ 288925 w 863600"/>
                <a:gd name="connsiteY39" fmla="*/ 400050 h 1797050"/>
                <a:gd name="connsiteX40" fmla="*/ 279400 w 863600"/>
                <a:gd name="connsiteY40" fmla="*/ 406400 h 1797050"/>
                <a:gd name="connsiteX41" fmla="*/ 263525 w 863600"/>
                <a:gd name="connsiteY41" fmla="*/ 434975 h 1797050"/>
                <a:gd name="connsiteX42" fmla="*/ 254000 w 863600"/>
                <a:gd name="connsiteY42" fmla="*/ 441325 h 1797050"/>
                <a:gd name="connsiteX43" fmla="*/ 247650 w 863600"/>
                <a:gd name="connsiteY43" fmla="*/ 450850 h 1797050"/>
                <a:gd name="connsiteX44" fmla="*/ 238125 w 863600"/>
                <a:gd name="connsiteY44" fmla="*/ 457200 h 1797050"/>
                <a:gd name="connsiteX45" fmla="*/ 234950 w 863600"/>
                <a:gd name="connsiteY45" fmla="*/ 466725 h 1797050"/>
                <a:gd name="connsiteX46" fmla="*/ 228600 w 863600"/>
                <a:gd name="connsiteY46" fmla="*/ 476250 h 1797050"/>
                <a:gd name="connsiteX47" fmla="*/ 225425 w 863600"/>
                <a:gd name="connsiteY47" fmla="*/ 485775 h 1797050"/>
                <a:gd name="connsiteX48" fmla="*/ 219075 w 863600"/>
                <a:gd name="connsiteY48" fmla="*/ 495300 h 1797050"/>
                <a:gd name="connsiteX49" fmla="*/ 215900 w 863600"/>
                <a:gd name="connsiteY49" fmla="*/ 504825 h 1797050"/>
                <a:gd name="connsiteX50" fmla="*/ 206375 w 863600"/>
                <a:gd name="connsiteY50" fmla="*/ 511175 h 1797050"/>
                <a:gd name="connsiteX51" fmla="*/ 196850 w 863600"/>
                <a:gd name="connsiteY51" fmla="*/ 530225 h 1797050"/>
                <a:gd name="connsiteX52" fmla="*/ 187325 w 863600"/>
                <a:gd name="connsiteY52" fmla="*/ 536575 h 1797050"/>
                <a:gd name="connsiteX53" fmla="*/ 180975 w 863600"/>
                <a:gd name="connsiteY53" fmla="*/ 555625 h 1797050"/>
                <a:gd name="connsiteX54" fmla="*/ 174625 w 863600"/>
                <a:gd name="connsiteY54" fmla="*/ 565150 h 1797050"/>
                <a:gd name="connsiteX55" fmla="*/ 168275 w 863600"/>
                <a:gd name="connsiteY55" fmla="*/ 584200 h 1797050"/>
                <a:gd name="connsiteX56" fmla="*/ 161925 w 863600"/>
                <a:gd name="connsiteY56" fmla="*/ 603250 h 1797050"/>
                <a:gd name="connsiteX57" fmla="*/ 158750 w 863600"/>
                <a:gd name="connsiteY57" fmla="*/ 612775 h 1797050"/>
                <a:gd name="connsiteX58" fmla="*/ 139700 w 863600"/>
                <a:gd name="connsiteY58" fmla="*/ 641350 h 1797050"/>
                <a:gd name="connsiteX59" fmla="*/ 133350 w 863600"/>
                <a:gd name="connsiteY59" fmla="*/ 650875 h 1797050"/>
                <a:gd name="connsiteX60" fmla="*/ 127000 w 863600"/>
                <a:gd name="connsiteY60" fmla="*/ 669925 h 1797050"/>
                <a:gd name="connsiteX61" fmla="*/ 117475 w 863600"/>
                <a:gd name="connsiteY61" fmla="*/ 688975 h 1797050"/>
                <a:gd name="connsiteX62" fmla="*/ 111125 w 863600"/>
                <a:gd name="connsiteY62" fmla="*/ 698500 h 1797050"/>
                <a:gd name="connsiteX63" fmla="*/ 104775 w 863600"/>
                <a:gd name="connsiteY63" fmla="*/ 717550 h 1797050"/>
                <a:gd name="connsiteX64" fmla="*/ 92075 w 863600"/>
                <a:gd name="connsiteY64" fmla="*/ 746125 h 1797050"/>
                <a:gd name="connsiteX65" fmla="*/ 85725 w 863600"/>
                <a:gd name="connsiteY65" fmla="*/ 765175 h 1797050"/>
                <a:gd name="connsiteX66" fmla="*/ 82550 w 863600"/>
                <a:gd name="connsiteY66" fmla="*/ 774700 h 1797050"/>
                <a:gd name="connsiteX67" fmla="*/ 79375 w 863600"/>
                <a:gd name="connsiteY67" fmla="*/ 796925 h 1797050"/>
                <a:gd name="connsiteX68" fmla="*/ 73025 w 863600"/>
                <a:gd name="connsiteY68" fmla="*/ 815975 h 1797050"/>
                <a:gd name="connsiteX69" fmla="*/ 69850 w 863600"/>
                <a:gd name="connsiteY69" fmla="*/ 825500 h 1797050"/>
                <a:gd name="connsiteX70" fmla="*/ 66675 w 863600"/>
                <a:gd name="connsiteY70" fmla="*/ 835025 h 1797050"/>
                <a:gd name="connsiteX71" fmla="*/ 63500 w 863600"/>
                <a:gd name="connsiteY71" fmla="*/ 850900 h 1797050"/>
                <a:gd name="connsiteX72" fmla="*/ 60325 w 863600"/>
                <a:gd name="connsiteY72" fmla="*/ 860425 h 1797050"/>
                <a:gd name="connsiteX73" fmla="*/ 53975 w 863600"/>
                <a:gd name="connsiteY73" fmla="*/ 895350 h 1797050"/>
                <a:gd name="connsiteX74" fmla="*/ 50800 w 863600"/>
                <a:gd name="connsiteY74" fmla="*/ 923925 h 1797050"/>
                <a:gd name="connsiteX75" fmla="*/ 47625 w 863600"/>
                <a:gd name="connsiteY75" fmla="*/ 936625 h 1797050"/>
                <a:gd name="connsiteX76" fmla="*/ 38100 w 863600"/>
                <a:gd name="connsiteY76" fmla="*/ 981075 h 1797050"/>
                <a:gd name="connsiteX77" fmla="*/ 28575 w 863600"/>
                <a:gd name="connsiteY77" fmla="*/ 1012825 h 1797050"/>
                <a:gd name="connsiteX78" fmla="*/ 25400 w 863600"/>
                <a:gd name="connsiteY78" fmla="*/ 1079500 h 1797050"/>
                <a:gd name="connsiteX79" fmla="*/ 22225 w 863600"/>
                <a:gd name="connsiteY79" fmla="*/ 1089025 h 1797050"/>
                <a:gd name="connsiteX80" fmla="*/ 15875 w 863600"/>
                <a:gd name="connsiteY80" fmla="*/ 1117600 h 1797050"/>
                <a:gd name="connsiteX81" fmla="*/ 9525 w 863600"/>
                <a:gd name="connsiteY81" fmla="*/ 1139825 h 1797050"/>
                <a:gd name="connsiteX82" fmla="*/ 3175 w 863600"/>
                <a:gd name="connsiteY82" fmla="*/ 1174750 h 1797050"/>
                <a:gd name="connsiteX83" fmla="*/ 0 w 863600"/>
                <a:gd name="connsiteY83" fmla="*/ 1209675 h 1797050"/>
                <a:gd name="connsiteX84" fmla="*/ 3175 w 863600"/>
                <a:gd name="connsiteY84" fmla="*/ 1416050 h 1797050"/>
                <a:gd name="connsiteX85" fmla="*/ 9525 w 863600"/>
                <a:gd name="connsiteY85" fmla="*/ 1450975 h 1797050"/>
                <a:gd name="connsiteX86" fmla="*/ 15875 w 863600"/>
                <a:gd name="connsiteY86" fmla="*/ 1470025 h 1797050"/>
                <a:gd name="connsiteX87" fmla="*/ 19050 w 863600"/>
                <a:gd name="connsiteY87" fmla="*/ 1479550 h 1797050"/>
                <a:gd name="connsiteX88" fmla="*/ 22225 w 863600"/>
                <a:gd name="connsiteY88" fmla="*/ 1492250 h 1797050"/>
                <a:gd name="connsiteX89" fmla="*/ 31750 w 863600"/>
                <a:gd name="connsiteY89" fmla="*/ 1520825 h 1797050"/>
                <a:gd name="connsiteX90" fmla="*/ 34925 w 863600"/>
                <a:gd name="connsiteY90" fmla="*/ 1530350 h 1797050"/>
                <a:gd name="connsiteX91" fmla="*/ 38100 w 863600"/>
                <a:gd name="connsiteY91" fmla="*/ 1543050 h 1797050"/>
                <a:gd name="connsiteX92" fmla="*/ 44450 w 863600"/>
                <a:gd name="connsiteY92" fmla="*/ 1562100 h 1797050"/>
                <a:gd name="connsiteX93" fmla="*/ 50800 w 863600"/>
                <a:gd name="connsiteY93" fmla="*/ 1587500 h 1797050"/>
                <a:gd name="connsiteX94" fmla="*/ 57150 w 863600"/>
                <a:gd name="connsiteY94" fmla="*/ 1606550 h 1797050"/>
                <a:gd name="connsiteX95" fmla="*/ 63500 w 863600"/>
                <a:gd name="connsiteY95" fmla="*/ 1638300 h 1797050"/>
                <a:gd name="connsiteX96" fmla="*/ 66675 w 863600"/>
                <a:gd name="connsiteY96" fmla="*/ 1663700 h 1797050"/>
                <a:gd name="connsiteX97" fmla="*/ 73025 w 863600"/>
                <a:gd name="connsiteY97" fmla="*/ 1682750 h 1797050"/>
                <a:gd name="connsiteX98" fmla="*/ 76200 w 863600"/>
                <a:gd name="connsiteY98" fmla="*/ 1695450 h 1797050"/>
                <a:gd name="connsiteX99" fmla="*/ 79375 w 863600"/>
                <a:gd name="connsiteY99" fmla="*/ 1704975 h 1797050"/>
                <a:gd name="connsiteX100" fmla="*/ 85725 w 863600"/>
                <a:gd name="connsiteY100" fmla="*/ 1730375 h 1797050"/>
                <a:gd name="connsiteX101" fmla="*/ 88900 w 863600"/>
                <a:gd name="connsiteY101" fmla="*/ 1743075 h 1797050"/>
                <a:gd name="connsiteX102" fmla="*/ 92075 w 863600"/>
                <a:gd name="connsiteY102" fmla="*/ 1752600 h 1797050"/>
                <a:gd name="connsiteX103" fmla="*/ 98425 w 863600"/>
                <a:gd name="connsiteY103" fmla="*/ 1774825 h 1797050"/>
                <a:gd name="connsiteX104" fmla="*/ 111125 w 863600"/>
                <a:gd name="connsiteY104" fmla="*/ 1797050 h 179705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  <a:cxn ang="0">
                  <a:pos x="connsiteX29" y="connsiteY29"/>
                </a:cxn>
                <a:cxn ang="0">
                  <a:pos x="connsiteX30" y="connsiteY30"/>
                </a:cxn>
                <a:cxn ang="0">
                  <a:pos x="connsiteX31" y="connsiteY31"/>
                </a:cxn>
                <a:cxn ang="0">
                  <a:pos x="connsiteX32" y="connsiteY32"/>
                </a:cxn>
                <a:cxn ang="0">
                  <a:pos x="connsiteX33" y="connsiteY33"/>
                </a:cxn>
                <a:cxn ang="0">
                  <a:pos x="connsiteX34" y="connsiteY34"/>
                </a:cxn>
                <a:cxn ang="0">
                  <a:pos x="connsiteX35" y="connsiteY35"/>
                </a:cxn>
                <a:cxn ang="0">
                  <a:pos x="connsiteX36" y="connsiteY36"/>
                </a:cxn>
                <a:cxn ang="0">
                  <a:pos x="connsiteX37" y="connsiteY37"/>
                </a:cxn>
                <a:cxn ang="0">
                  <a:pos x="connsiteX38" y="connsiteY38"/>
                </a:cxn>
                <a:cxn ang="0">
                  <a:pos x="connsiteX39" y="connsiteY39"/>
                </a:cxn>
                <a:cxn ang="0">
                  <a:pos x="connsiteX40" y="connsiteY40"/>
                </a:cxn>
                <a:cxn ang="0">
                  <a:pos x="connsiteX41" y="connsiteY41"/>
                </a:cxn>
                <a:cxn ang="0">
                  <a:pos x="connsiteX42" y="connsiteY42"/>
                </a:cxn>
                <a:cxn ang="0">
                  <a:pos x="connsiteX43" y="connsiteY43"/>
                </a:cxn>
                <a:cxn ang="0">
                  <a:pos x="connsiteX44" y="connsiteY44"/>
                </a:cxn>
                <a:cxn ang="0">
                  <a:pos x="connsiteX45" y="connsiteY45"/>
                </a:cxn>
                <a:cxn ang="0">
                  <a:pos x="connsiteX46" y="connsiteY46"/>
                </a:cxn>
                <a:cxn ang="0">
                  <a:pos x="connsiteX47" y="connsiteY47"/>
                </a:cxn>
                <a:cxn ang="0">
                  <a:pos x="connsiteX48" y="connsiteY48"/>
                </a:cxn>
                <a:cxn ang="0">
                  <a:pos x="connsiteX49" y="connsiteY49"/>
                </a:cxn>
                <a:cxn ang="0">
                  <a:pos x="connsiteX50" y="connsiteY50"/>
                </a:cxn>
                <a:cxn ang="0">
                  <a:pos x="connsiteX51" y="connsiteY51"/>
                </a:cxn>
                <a:cxn ang="0">
                  <a:pos x="connsiteX52" y="connsiteY52"/>
                </a:cxn>
                <a:cxn ang="0">
                  <a:pos x="connsiteX53" y="connsiteY53"/>
                </a:cxn>
                <a:cxn ang="0">
                  <a:pos x="connsiteX54" y="connsiteY54"/>
                </a:cxn>
                <a:cxn ang="0">
                  <a:pos x="connsiteX55" y="connsiteY55"/>
                </a:cxn>
                <a:cxn ang="0">
                  <a:pos x="connsiteX56" y="connsiteY56"/>
                </a:cxn>
                <a:cxn ang="0">
                  <a:pos x="connsiteX57" y="connsiteY57"/>
                </a:cxn>
                <a:cxn ang="0">
                  <a:pos x="connsiteX58" y="connsiteY58"/>
                </a:cxn>
                <a:cxn ang="0">
                  <a:pos x="connsiteX59" y="connsiteY59"/>
                </a:cxn>
                <a:cxn ang="0">
                  <a:pos x="connsiteX60" y="connsiteY60"/>
                </a:cxn>
                <a:cxn ang="0">
                  <a:pos x="connsiteX61" y="connsiteY61"/>
                </a:cxn>
                <a:cxn ang="0">
                  <a:pos x="connsiteX62" y="connsiteY62"/>
                </a:cxn>
                <a:cxn ang="0">
                  <a:pos x="connsiteX63" y="connsiteY63"/>
                </a:cxn>
                <a:cxn ang="0">
                  <a:pos x="connsiteX64" y="connsiteY64"/>
                </a:cxn>
                <a:cxn ang="0">
                  <a:pos x="connsiteX65" y="connsiteY65"/>
                </a:cxn>
                <a:cxn ang="0">
                  <a:pos x="connsiteX66" y="connsiteY66"/>
                </a:cxn>
                <a:cxn ang="0">
                  <a:pos x="connsiteX67" y="connsiteY67"/>
                </a:cxn>
                <a:cxn ang="0">
                  <a:pos x="connsiteX68" y="connsiteY68"/>
                </a:cxn>
                <a:cxn ang="0">
                  <a:pos x="connsiteX69" y="connsiteY69"/>
                </a:cxn>
                <a:cxn ang="0">
                  <a:pos x="connsiteX70" y="connsiteY70"/>
                </a:cxn>
                <a:cxn ang="0">
                  <a:pos x="connsiteX71" y="connsiteY71"/>
                </a:cxn>
                <a:cxn ang="0">
                  <a:pos x="connsiteX72" y="connsiteY72"/>
                </a:cxn>
                <a:cxn ang="0">
                  <a:pos x="connsiteX73" y="connsiteY73"/>
                </a:cxn>
                <a:cxn ang="0">
                  <a:pos x="connsiteX74" y="connsiteY74"/>
                </a:cxn>
                <a:cxn ang="0">
                  <a:pos x="connsiteX75" y="connsiteY75"/>
                </a:cxn>
                <a:cxn ang="0">
                  <a:pos x="connsiteX76" y="connsiteY76"/>
                </a:cxn>
                <a:cxn ang="0">
                  <a:pos x="connsiteX77" y="connsiteY77"/>
                </a:cxn>
                <a:cxn ang="0">
                  <a:pos x="connsiteX78" y="connsiteY78"/>
                </a:cxn>
                <a:cxn ang="0">
                  <a:pos x="connsiteX79" y="connsiteY79"/>
                </a:cxn>
                <a:cxn ang="0">
                  <a:pos x="connsiteX80" y="connsiteY80"/>
                </a:cxn>
                <a:cxn ang="0">
                  <a:pos x="connsiteX81" y="connsiteY81"/>
                </a:cxn>
                <a:cxn ang="0">
                  <a:pos x="connsiteX82" y="connsiteY82"/>
                </a:cxn>
                <a:cxn ang="0">
                  <a:pos x="connsiteX83" y="connsiteY83"/>
                </a:cxn>
                <a:cxn ang="0">
                  <a:pos x="connsiteX84" y="connsiteY84"/>
                </a:cxn>
                <a:cxn ang="0">
                  <a:pos x="connsiteX85" y="connsiteY85"/>
                </a:cxn>
                <a:cxn ang="0">
                  <a:pos x="connsiteX86" y="connsiteY86"/>
                </a:cxn>
                <a:cxn ang="0">
                  <a:pos x="connsiteX87" y="connsiteY87"/>
                </a:cxn>
                <a:cxn ang="0">
                  <a:pos x="connsiteX88" y="connsiteY88"/>
                </a:cxn>
                <a:cxn ang="0">
                  <a:pos x="connsiteX89" y="connsiteY89"/>
                </a:cxn>
                <a:cxn ang="0">
                  <a:pos x="connsiteX90" y="connsiteY90"/>
                </a:cxn>
                <a:cxn ang="0">
                  <a:pos x="connsiteX91" y="connsiteY91"/>
                </a:cxn>
                <a:cxn ang="0">
                  <a:pos x="connsiteX92" y="connsiteY92"/>
                </a:cxn>
                <a:cxn ang="0">
                  <a:pos x="connsiteX93" y="connsiteY93"/>
                </a:cxn>
                <a:cxn ang="0">
                  <a:pos x="connsiteX94" y="connsiteY94"/>
                </a:cxn>
                <a:cxn ang="0">
                  <a:pos x="connsiteX95" y="connsiteY95"/>
                </a:cxn>
                <a:cxn ang="0">
                  <a:pos x="connsiteX96" y="connsiteY96"/>
                </a:cxn>
                <a:cxn ang="0">
                  <a:pos x="connsiteX97" y="connsiteY97"/>
                </a:cxn>
                <a:cxn ang="0">
                  <a:pos x="connsiteX98" y="connsiteY98"/>
                </a:cxn>
                <a:cxn ang="0">
                  <a:pos x="connsiteX99" y="connsiteY99"/>
                </a:cxn>
                <a:cxn ang="0">
                  <a:pos x="connsiteX100" y="connsiteY100"/>
                </a:cxn>
                <a:cxn ang="0">
                  <a:pos x="connsiteX101" y="connsiteY101"/>
                </a:cxn>
                <a:cxn ang="0">
                  <a:pos x="connsiteX102" y="connsiteY102"/>
                </a:cxn>
                <a:cxn ang="0">
                  <a:pos x="connsiteX103" y="connsiteY103"/>
                </a:cxn>
                <a:cxn ang="0">
                  <a:pos x="connsiteX104" y="connsiteY104"/>
                </a:cxn>
              </a:cxnLst>
              <a:rect l="l" t="t" r="r" b="b"/>
              <a:pathLst>
                <a:path w="863600" h="1797050">
                  <a:moveTo>
                    <a:pt x="863600" y="0"/>
                  </a:moveTo>
                  <a:cubicBezTo>
                    <a:pt x="836136" y="2497"/>
                    <a:pt x="835608" y="741"/>
                    <a:pt x="815975" y="6350"/>
                  </a:cubicBezTo>
                  <a:cubicBezTo>
                    <a:pt x="812757" y="7269"/>
                    <a:pt x="809376" y="7900"/>
                    <a:pt x="806450" y="9525"/>
                  </a:cubicBezTo>
                  <a:cubicBezTo>
                    <a:pt x="799779" y="13231"/>
                    <a:pt x="794640" y="19812"/>
                    <a:pt x="787400" y="22225"/>
                  </a:cubicBezTo>
                  <a:cubicBezTo>
                    <a:pt x="738253" y="38607"/>
                    <a:pt x="789014" y="19831"/>
                    <a:pt x="758825" y="34925"/>
                  </a:cubicBezTo>
                  <a:cubicBezTo>
                    <a:pt x="755832" y="36422"/>
                    <a:pt x="752293" y="36603"/>
                    <a:pt x="749300" y="38100"/>
                  </a:cubicBezTo>
                  <a:cubicBezTo>
                    <a:pt x="745887" y="39807"/>
                    <a:pt x="743262" y="42900"/>
                    <a:pt x="739775" y="44450"/>
                  </a:cubicBezTo>
                  <a:cubicBezTo>
                    <a:pt x="733658" y="47168"/>
                    <a:pt x="727075" y="48683"/>
                    <a:pt x="720725" y="50800"/>
                  </a:cubicBezTo>
                  <a:cubicBezTo>
                    <a:pt x="717550" y="51858"/>
                    <a:pt x="713985" y="52119"/>
                    <a:pt x="711200" y="53975"/>
                  </a:cubicBezTo>
                  <a:lnTo>
                    <a:pt x="692150" y="66675"/>
                  </a:lnTo>
                  <a:cubicBezTo>
                    <a:pt x="688975" y="68792"/>
                    <a:pt x="686245" y="71818"/>
                    <a:pt x="682625" y="73025"/>
                  </a:cubicBezTo>
                  <a:lnTo>
                    <a:pt x="673100" y="76200"/>
                  </a:lnTo>
                  <a:cubicBezTo>
                    <a:pt x="669925" y="79375"/>
                    <a:pt x="667500" y="83544"/>
                    <a:pt x="663575" y="85725"/>
                  </a:cubicBezTo>
                  <a:cubicBezTo>
                    <a:pt x="657724" y="88976"/>
                    <a:pt x="650875" y="89958"/>
                    <a:pt x="644525" y="92075"/>
                  </a:cubicBezTo>
                  <a:cubicBezTo>
                    <a:pt x="641350" y="93133"/>
                    <a:pt x="637785" y="93394"/>
                    <a:pt x="635000" y="95250"/>
                  </a:cubicBezTo>
                  <a:cubicBezTo>
                    <a:pt x="628650" y="99483"/>
                    <a:pt x="621346" y="102554"/>
                    <a:pt x="615950" y="107950"/>
                  </a:cubicBezTo>
                  <a:cubicBezTo>
                    <a:pt x="607732" y="116168"/>
                    <a:pt x="598768" y="126377"/>
                    <a:pt x="587375" y="130175"/>
                  </a:cubicBezTo>
                  <a:lnTo>
                    <a:pt x="577850" y="133350"/>
                  </a:lnTo>
                  <a:cubicBezTo>
                    <a:pt x="575733" y="136525"/>
                    <a:pt x="574480" y="140491"/>
                    <a:pt x="571500" y="142875"/>
                  </a:cubicBezTo>
                  <a:cubicBezTo>
                    <a:pt x="568887" y="144966"/>
                    <a:pt x="564901" y="144425"/>
                    <a:pt x="561975" y="146050"/>
                  </a:cubicBezTo>
                  <a:cubicBezTo>
                    <a:pt x="555304" y="149756"/>
                    <a:pt x="548321" y="153354"/>
                    <a:pt x="542925" y="158750"/>
                  </a:cubicBezTo>
                  <a:cubicBezTo>
                    <a:pt x="539750" y="161925"/>
                    <a:pt x="537136" y="165784"/>
                    <a:pt x="533400" y="168275"/>
                  </a:cubicBezTo>
                  <a:cubicBezTo>
                    <a:pt x="530615" y="170131"/>
                    <a:pt x="526801" y="169825"/>
                    <a:pt x="523875" y="171450"/>
                  </a:cubicBezTo>
                  <a:cubicBezTo>
                    <a:pt x="517204" y="175156"/>
                    <a:pt x="511175" y="179917"/>
                    <a:pt x="504825" y="184150"/>
                  </a:cubicBezTo>
                  <a:lnTo>
                    <a:pt x="476250" y="203200"/>
                  </a:lnTo>
                  <a:cubicBezTo>
                    <a:pt x="473075" y="205317"/>
                    <a:pt x="469423" y="206852"/>
                    <a:pt x="466725" y="209550"/>
                  </a:cubicBezTo>
                  <a:cubicBezTo>
                    <a:pt x="454502" y="221773"/>
                    <a:pt x="460936" y="216584"/>
                    <a:pt x="447675" y="225425"/>
                  </a:cubicBezTo>
                  <a:lnTo>
                    <a:pt x="428625" y="254000"/>
                  </a:lnTo>
                  <a:cubicBezTo>
                    <a:pt x="426508" y="257175"/>
                    <a:pt x="423482" y="259905"/>
                    <a:pt x="422275" y="263525"/>
                  </a:cubicBezTo>
                  <a:cubicBezTo>
                    <a:pt x="421217" y="266700"/>
                    <a:pt x="421467" y="270683"/>
                    <a:pt x="419100" y="273050"/>
                  </a:cubicBezTo>
                  <a:cubicBezTo>
                    <a:pt x="413704" y="278446"/>
                    <a:pt x="400050" y="285750"/>
                    <a:pt x="400050" y="285750"/>
                  </a:cubicBezTo>
                  <a:cubicBezTo>
                    <a:pt x="398992" y="288925"/>
                    <a:pt x="399242" y="292908"/>
                    <a:pt x="396875" y="295275"/>
                  </a:cubicBezTo>
                  <a:cubicBezTo>
                    <a:pt x="391479" y="300671"/>
                    <a:pt x="377825" y="307975"/>
                    <a:pt x="377825" y="307975"/>
                  </a:cubicBezTo>
                  <a:cubicBezTo>
                    <a:pt x="360892" y="333375"/>
                    <a:pt x="383117" y="302683"/>
                    <a:pt x="361950" y="323850"/>
                  </a:cubicBezTo>
                  <a:cubicBezTo>
                    <a:pt x="359252" y="326548"/>
                    <a:pt x="358298" y="330677"/>
                    <a:pt x="355600" y="333375"/>
                  </a:cubicBezTo>
                  <a:cubicBezTo>
                    <a:pt x="352902" y="336073"/>
                    <a:pt x="349006" y="337282"/>
                    <a:pt x="346075" y="339725"/>
                  </a:cubicBezTo>
                  <a:cubicBezTo>
                    <a:pt x="342626" y="342600"/>
                    <a:pt x="340094" y="346493"/>
                    <a:pt x="336550" y="349250"/>
                  </a:cubicBezTo>
                  <a:cubicBezTo>
                    <a:pt x="330526" y="353935"/>
                    <a:pt x="322896" y="356554"/>
                    <a:pt x="317500" y="361950"/>
                  </a:cubicBezTo>
                  <a:cubicBezTo>
                    <a:pt x="302579" y="376871"/>
                    <a:pt x="310466" y="367739"/>
                    <a:pt x="295275" y="390525"/>
                  </a:cubicBezTo>
                  <a:cubicBezTo>
                    <a:pt x="293158" y="393700"/>
                    <a:pt x="292100" y="397933"/>
                    <a:pt x="288925" y="400050"/>
                  </a:cubicBezTo>
                  <a:lnTo>
                    <a:pt x="279400" y="406400"/>
                  </a:lnTo>
                  <a:cubicBezTo>
                    <a:pt x="276091" y="416326"/>
                    <a:pt x="272883" y="428737"/>
                    <a:pt x="263525" y="434975"/>
                  </a:cubicBezTo>
                  <a:lnTo>
                    <a:pt x="254000" y="441325"/>
                  </a:lnTo>
                  <a:cubicBezTo>
                    <a:pt x="251883" y="444500"/>
                    <a:pt x="250348" y="448152"/>
                    <a:pt x="247650" y="450850"/>
                  </a:cubicBezTo>
                  <a:cubicBezTo>
                    <a:pt x="244952" y="453548"/>
                    <a:pt x="240509" y="454220"/>
                    <a:pt x="238125" y="457200"/>
                  </a:cubicBezTo>
                  <a:cubicBezTo>
                    <a:pt x="236034" y="459813"/>
                    <a:pt x="236447" y="463732"/>
                    <a:pt x="234950" y="466725"/>
                  </a:cubicBezTo>
                  <a:cubicBezTo>
                    <a:pt x="233243" y="470138"/>
                    <a:pt x="230307" y="472837"/>
                    <a:pt x="228600" y="476250"/>
                  </a:cubicBezTo>
                  <a:cubicBezTo>
                    <a:pt x="227103" y="479243"/>
                    <a:pt x="226922" y="482782"/>
                    <a:pt x="225425" y="485775"/>
                  </a:cubicBezTo>
                  <a:cubicBezTo>
                    <a:pt x="223718" y="489188"/>
                    <a:pt x="220782" y="491887"/>
                    <a:pt x="219075" y="495300"/>
                  </a:cubicBezTo>
                  <a:cubicBezTo>
                    <a:pt x="217578" y="498293"/>
                    <a:pt x="217991" y="502212"/>
                    <a:pt x="215900" y="504825"/>
                  </a:cubicBezTo>
                  <a:cubicBezTo>
                    <a:pt x="213516" y="507805"/>
                    <a:pt x="209550" y="509058"/>
                    <a:pt x="206375" y="511175"/>
                  </a:cubicBezTo>
                  <a:cubicBezTo>
                    <a:pt x="203793" y="518922"/>
                    <a:pt x="203005" y="524070"/>
                    <a:pt x="196850" y="530225"/>
                  </a:cubicBezTo>
                  <a:cubicBezTo>
                    <a:pt x="194152" y="532923"/>
                    <a:pt x="190500" y="534458"/>
                    <a:pt x="187325" y="536575"/>
                  </a:cubicBezTo>
                  <a:cubicBezTo>
                    <a:pt x="185208" y="542925"/>
                    <a:pt x="184688" y="550056"/>
                    <a:pt x="180975" y="555625"/>
                  </a:cubicBezTo>
                  <a:cubicBezTo>
                    <a:pt x="178858" y="558800"/>
                    <a:pt x="176175" y="561663"/>
                    <a:pt x="174625" y="565150"/>
                  </a:cubicBezTo>
                  <a:cubicBezTo>
                    <a:pt x="171907" y="571267"/>
                    <a:pt x="170392" y="577850"/>
                    <a:pt x="168275" y="584200"/>
                  </a:cubicBezTo>
                  <a:lnTo>
                    <a:pt x="161925" y="603250"/>
                  </a:lnTo>
                  <a:cubicBezTo>
                    <a:pt x="160867" y="606425"/>
                    <a:pt x="160606" y="609990"/>
                    <a:pt x="158750" y="612775"/>
                  </a:cubicBezTo>
                  <a:lnTo>
                    <a:pt x="139700" y="641350"/>
                  </a:lnTo>
                  <a:cubicBezTo>
                    <a:pt x="137583" y="644525"/>
                    <a:pt x="134557" y="647255"/>
                    <a:pt x="133350" y="650875"/>
                  </a:cubicBezTo>
                  <a:cubicBezTo>
                    <a:pt x="131233" y="657225"/>
                    <a:pt x="130713" y="664356"/>
                    <a:pt x="127000" y="669925"/>
                  </a:cubicBezTo>
                  <a:cubicBezTo>
                    <a:pt x="108802" y="697222"/>
                    <a:pt x="130620" y="662685"/>
                    <a:pt x="117475" y="688975"/>
                  </a:cubicBezTo>
                  <a:cubicBezTo>
                    <a:pt x="115768" y="692388"/>
                    <a:pt x="112675" y="695013"/>
                    <a:pt x="111125" y="698500"/>
                  </a:cubicBezTo>
                  <a:cubicBezTo>
                    <a:pt x="108407" y="704617"/>
                    <a:pt x="108488" y="711981"/>
                    <a:pt x="104775" y="717550"/>
                  </a:cubicBezTo>
                  <a:cubicBezTo>
                    <a:pt x="94712" y="732644"/>
                    <a:pt x="99632" y="723455"/>
                    <a:pt x="92075" y="746125"/>
                  </a:cubicBezTo>
                  <a:lnTo>
                    <a:pt x="85725" y="765175"/>
                  </a:lnTo>
                  <a:lnTo>
                    <a:pt x="82550" y="774700"/>
                  </a:lnTo>
                  <a:cubicBezTo>
                    <a:pt x="81492" y="782108"/>
                    <a:pt x="81058" y="789633"/>
                    <a:pt x="79375" y="796925"/>
                  </a:cubicBezTo>
                  <a:cubicBezTo>
                    <a:pt x="77870" y="803447"/>
                    <a:pt x="75142" y="809625"/>
                    <a:pt x="73025" y="815975"/>
                  </a:cubicBezTo>
                  <a:lnTo>
                    <a:pt x="69850" y="825500"/>
                  </a:lnTo>
                  <a:cubicBezTo>
                    <a:pt x="68792" y="828675"/>
                    <a:pt x="67331" y="831743"/>
                    <a:pt x="66675" y="835025"/>
                  </a:cubicBezTo>
                  <a:cubicBezTo>
                    <a:pt x="65617" y="840317"/>
                    <a:pt x="64809" y="845665"/>
                    <a:pt x="63500" y="850900"/>
                  </a:cubicBezTo>
                  <a:cubicBezTo>
                    <a:pt x="62688" y="854147"/>
                    <a:pt x="61137" y="857178"/>
                    <a:pt x="60325" y="860425"/>
                  </a:cubicBezTo>
                  <a:cubicBezTo>
                    <a:pt x="58615" y="867266"/>
                    <a:pt x="54784" y="889284"/>
                    <a:pt x="53975" y="895350"/>
                  </a:cubicBezTo>
                  <a:cubicBezTo>
                    <a:pt x="52708" y="904850"/>
                    <a:pt x="52257" y="914453"/>
                    <a:pt x="50800" y="923925"/>
                  </a:cubicBezTo>
                  <a:cubicBezTo>
                    <a:pt x="50136" y="928238"/>
                    <a:pt x="48481" y="932346"/>
                    <a:pt x="47625" y="936625"/>
                  </a:cubicBezTo>
                  <a:cubicBezTo>
                    <a:pt x="43628" y="956609"/>
                    <a:pt x="45180" y="959834"/>
                    <a:pt x="38100" y="981075"/>
                  </a:cubicBezTo>
                  <a:cubicBezTo>
                    <a:pt x="30370" y="1004265"/>
                    <a:pt x="33373" y="993631"/>
                    <a:pt x="28575" y="1012825"/>
                  </a:cubicBezTo>
                  <a:cubicBezTo>
                    <a:pt x="27517" y="1035050"/>
                    <a:pt x="27248" y="1057327"/>
                    <a:pt x="25400" y="1079500"/>
                  </a:cubicBezTo>
                  <a:cubicBezTo>
                    <a:pt x="25122" y="1082835"/>
                    <a:pt x="23037" y="1085778"/>
                    <a:pt x="22225" y="1089025"/>
                  </a:cubicBezTo>
                  <a:cubicBezTo>
                    <a:pt x="15678" y="1115214"/>
                    <a:pt x="22394" y="1094785"/>
                    <a:pt x="15875" y="1117600"/>
                  </a:cubicBezTo>
                  <a:cubicBezTo>
                    <a:pt x="10571" y="1136162"/>
                    <a:pt x="14488" y="1117492"/>
                    <a:pt x="9525" y="1139825"/>
                  </a:cubicBezTo>
                  <a:cubicBezTo>
                    <a:pt x="7770" y="1147721"/>
                    <a:pt x="4037" y="1167426"/>
                    <a:pt x="3175" y="1174750"/>
                  </a:cubicBezTo>
                  <a:cubicBezTo>
                    <a:pt x="1809" y="1186360"/>
                    <a:pt x="1058" y="1198033"/>
                    <a:pt x="0" y="1209675"/>
                  </a:cubicBezTo>
                  <a:cubicBezTo>
                    <a:pt x="1058" y="1278467"/>
                    <a:pt x="1265" y="1347277"/>
                    <a:pt x="3175" y="1416050"/>
                  </a:cubicBezTo>
                  <a:cubicBezTo>
                    <a:pt x="3426" y="1425086"/>
                    <a:pt x="6600" y="1441224"/>
                    <a:pt x="9525" y="1450975"/>
                  </a:cubicBezTo>
                  <a:cubicBezTo>
                    <a:pt x="11448" y="1457386"/>
                    <a:pt x="13758" y="1463675"/>
                    <a:pt x="15875" y="1470025"/>
                  </a:cubicBezTo>
                  <a:cubicBezTo>
                    <a:pt x="16933" y="1473200"/>
                    <a:pt x="18238" y="1476303"/>
                    <a:pt x="19050" y="1479550"/>
                  </a:cubicBezTo>
                  <a:cubicBezTo>
                    <a:pt x="20108" y="1483783"/>
                    <a:pt x="20971" y="1488070"/>
                    <a:pt x="22225" y="1492250"/>
                  </a:cubicBezTo>
                  <a:cubicBezTo>
                    <a:pt x="25110" y="1501867"/>
                    <a:pt x="28575" y="1511300"/>
                    <a:pt x="31750" y="1520825"/>
                  </a:cubicBezTo>
                  <a:cubicBezTo>
                    <a:pt x="32808" y="1524000"/>
                    <a:pt x="34113" y="1527103"/>
                    <a:pt x="34925" y="1530350"/>
                  </a:cubicBezTo>
                  <a:cubicBezTo>
                    <a:pt x="35983" y="1534583"/>
                    <a:pt x="36846" y="1538870"/>
                    <a:pt x="38100" y="1543050"/>
                  </a:cubicBezTo>
                  <a:cubicBezTo>
                    <a:pt x="40023" y="1549461"/>
                    <a:pt x="42827" y="1555606"/>
                    <a:pt x="44450" y="1562100"/>
                  </a:cubicBezTo>
                  <a:cubicBezTo>
                    <a:pt x="46567" y="1570567"/>
                    <a:pt x="48040" y="1579221"/>
                    <a:pt x="50800" y="1587500"/>
                  </a:cubicBezTo>
                  <a:cubicBezTo>
                    <a:pt x="52917" y="1593850"/>
                    <a:pt x="55837" y="1599986"/>
                    <a:pt x="57150" y="1606550"/>
                  </a:cubicBezTo>
                  <a:cubicBezTo>
                    <a:pt x="59267" y="1617133"/>
                    <a:pt x="62161" y="1627590"/>
                    <a:pt x="63500" y="1638300"/>
                  </a:cubicBezTo>
                  <a:cubicBezTo>
                    <a:pt x="64558" y="1646767"/>
                    <a:pt x="64887" y="1655357"/>
                    <a:pt x="66675" y="1663700"/>
                  </a:cubicBezTo>
                  <a:cubicBezTo>
                    <a:pt x="68077" y="1670245"/>
                    <a:pt x="71402" y="1676256"/>
                    <a:pt x="73025" y="1682750"/>
                  </a:cubicBezTo>
                  <a:cubicBezTo>
                    <a:pt x="74083" y="1686983"/>
                    <a:pt x="75001" y="1691254"/>
                    <a:pt x="76200" y="1695450"/>
                  </a:cubicBezTo>
                  <a:cubicBezTo>
                    <a:pt x="77119" y="1698668"/>
                    <a:pt x="78494" y="1701746"/>
                    <a:pt x="79375" y="1704975"/>
                  </a:cubicBezTo>
                  <a:cubicBezTo>
                    <a:pt x="81671" y="1713395"/>
                    <a:pt x="83608" y="1721908"/>
                    <a:pt x="85725" y="1730375"/>
                  </a:cubicBezTo>
                  <a:cubicBezTo>
                    <a:pt x="86783" y="1734608"/>
                    <a:pt x="87520" y="1738935"/>
                    <a:pt x="88900" y="1743075"/>
                  </a:cubicBezTo>
                  <a:cubicBezTo>
                    <a:pt x="89958" y="1746250"/>
                    <a:pt x="91156" y="1749382"/>
                    <a:pt x="92075" y="1752600"/>
                  </a:cubicBezTo>
                  <a:cubicBezTo>
                    <a:pt x="93042" y="1755985"/>
                    <a:pt x="96186" y="1770795"/>
                    <a:pt x="98425" y="1774825"/>
                  </a:cubicBezTo>
                  <a:cubicBezTo>
                    <a:pt x="111712" y="1798742"/>
                    <a:pt x="111125" y="1785690"/>
                    <a:pt x="111125" y="1797050"/>
                  </a:cubicBezTo>
                </a:path>
              </a:pathLst>
            </a:custGeom>
            <a:noFill/>
            <a:ln w="38100">
              <a:solidFill>
                <a:schemeClr val="bg1"/>
              </a:solidFill>
              <a:prstDash val="sysDot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9666"/>
            </a:p>
          </p:txBody>
        </p:sp>
        <p:sp>
          <p:nvSpPr>
            <p:cNvPr id="37" name="Freeform 36"/>
            <p:cNvSpPr/>
            <p:nvPr/>
          </p:nvSpPr>
          <p:spPr>
            <a:xfrm>
              <a:off x="5078372" y="1935937"/>
              <a:ext cx="2782296" cy="1082033"/>
            </a:xfrm>
            <a:custGeom>
              <a:avLst/>
              <a:gdLst>
                <a:gd name="connsiteX0" fmla="*/ 0 w 2901950"/>
                <a:gd name="connsiteY0" fmla="*/ 543038 h 1047863"/>
                <a:gd name="connsiteX1" fmla="*/ 12700 w 2901950"/>
                <a:gd name="connsiteY1" fmla="*/ 568438 h 1047863"/>
                <a:gd name="connsiteX2" fmla="*/ 41275 w 2901950"/>
                <a:gd name="connsiteY2" fmla="*/ 584313 h 1047863"/>
                <a:gd name="connsiteX3" fmla="*/ 57150 w 2901950"/>
                <a:gd name="connsiteY3" fmla="*/ 603363 h 1047863"/>
                <a:gd name="connsiteX4" fmla="*/ 76200 w 2901950"/>
                <a:gd name="connsiteY4" fmla="*/ 616063 h 1047863"/>
                <a:gd name="connsiteX5" fmla="*/ 92075 w 2901950"/>
                <a:gd name="connsiteY5" fmla="*/ 631938 h 1047863"/>
                <a:gd name="connsiteX6" fmla="*/ 107950 w 2901950"/>
                <a:gd name="connsiteY6" fmla="*/ 647813 h 1047863"/>
                <a:gd name="connsiteX7" fmla="*/ 123825 w 2901950"/>
                <a:gd name="connsiteY7" fmla="*/ 660513 h 1047863"/>
                <a:gd name="connsiteX8" fmla="*/ 142875 w 2901950"/>
                <a:gd name="connsiteY8" fmla="*/ 673213 h 1047863"/>
                <a:gd name="connsiteX9" fmla="*/ 158750 w 2901950"/>
                <a:gd name="connsiteY9" fmla="*/ 685913 h 1047863"/>
                <a:gd name="connsiteX10" fmla="*/ 177800 w 2901950"/>
                <a:gd name="connsiteY10" fmla="*/ 698613 h 1047863"/>
                <a:gd name="connsiteX11" fmla="*/ 187325 w 2901950"/>
                <a:gd name="connsiteY11" fmla="*/ 701788 h 1047863"/>
                <a:gd name="connsiteX12" fmla="*/ 200025 w 2901950"/>
                <a:gd name="connsiteY12" fmla="*/ 708138 h 1047863"/>
                <a:gd name="connsiteX13" fmla="*/ 209550 w 2901950"/>
                <a:gd name="connsiteY13" fmla="*/ 714488 h 1047863"/>
                <a:gd name="connsiteX14" fmla="*/ 228600 w 2901950"/>
                <a:gd name="connsiteY14" fmla="*/ 720838 h 1047863"/>
                <a:gd name="connsiteX15" fmla="*/ 238125 w 2901950"/>
                <a:gd name="connsiteY15" fmla="*/ 727188 h 1047863"/>
                <a:gd name="connsiteX16" fmla="*/ 247650 w 2901950"/>
                <a:gd name="connsiteY16" fmla="*/ 730363 h 1047863"/>
                <a:gd name="connsiteX17" fmla="*/ 266700 w 2901950"/>
                <a:gd name="connsiteY17" fmla="*/ 743063 h 1047863"/>
                <a:gd name="connsiteX18" fmla="*/ 276225 w 2901950"/>
                <a:gd name="connsiteY18" fmla="*/ 746238 h 1047863"/>
                <a:gd name="connsiteX19" fmla="*/ 295275 w 2901950"/>
                <a:gd name="connsiteY19" fmla="*/ 758938 h 1047863"/>
                <a:gd name="connsiteX20" fmla="*/ 323850 w 2901950"/>
                <a:gd name="connsiteY20" fmla="*/ 774813 h 1047863"/>
                <a:gd name="connsiteX21" fmla="*/ 333375 w 2901950"/>
                <a:gd name="connsiteY21" fmla="*/ 781163 h 1047863"/>
                <a:gd name="connsiteX22" fmla="*/ 342900 w 2901950"/>
                <a:gd name="connsiteY22" fmla="*/ 787513 h 1047863"/>
                <a:gd name="connsiteX23" fmla="*/ 361950 w 2901950"/>
                <a:gd name="connsiteY23" fmla="*/ 793863 h 1047863"/>
                <a:gd name="connsiteX24" fmla="*/ 371475 w 2901950"/>
                <a:gd name="connsiteY24" fmla="*/ 800213 h 1047863"/>
                <a:gd name="connsiteX25" fmla="*/ 390525 w 2901950"/>
                <a:gd name="connsiteY25" fmla="*/ 806563 h 1047863"/>
                <a:gd name="connsiteX26" fmla="*/ 400050 w 2901950"/>
                <a:gd name="connsiteY26" fmla="*/ 812913 h 1047863"/>
                <a:gd name="connsiteX27" fmla="*/ 419100 w 2901950"/>
                <a:gd name="connsiteY27" fmla="*/ 819263 h 1047863"/>
                <a:gd name="connsiteX28" fmla="*/ 428625 w 2901950"/>
                <a:gd name="connsiteY28" fmla="*/ 822438 h 1047863"/>
                <a:gd name="connsiteX29" fmla="*/ 466725 w 2901950"/>
                <a:gd name="connsiteY29" fmla="*/ 835138 h 1047863"/>
                <a:gd name="connsiteX30" fmla="*/ 476250 w 2901950"/>
                <a:gd name="connsiteY30" fmla="*/ 838313 h 1047863"/>
                <a:gd name="connsiteX31" fmla="*/ 485775 w 2901950"/>
                <a:gd name="connsiteY31" fmla="*/ 841488 h 1047863"/>
                <a:gd name="connsiteX32" fmla="*/ 514350 w 2901950"/>
                <a:gd name="connsiteY32" fmla="*/ 847838 h 1047863"/>
                <a:gd name="connsiteX33" fmla="*/ 523875 w 2901950"/>
                <a:gd name="connsiteY33" fmla="*/ 851013 h 1047863"/>
                <a:gd name="connsiteX34" fmla="*/ 536575 w 2901950"/>
                <a:gd name="connsiteY34" fmla="*/ 854188 h 1047863"/>
                <a:gd name="connsiteX35" fmla="*/ 555625 w 2901950"/>
                <a:gd name="connsiteY35" fmla="*/ 860538 h 1047863"/>
                <a:gd name="connsiteX36" fmla="*/ 565150 w 2901950"/>
                <a:gd name="connsiteY36" fmla="*/ 863713 h 1047863"/>
                <a:gd name="connsiteX37" fmla="*/ 590550 w 2901950"/>
                <a:gd name="connsiteY37" fmla="*/ 870063 h 1047863"/>
                <a:gd name="connsiteX38" fmla="*/ 603250 w 2901950"/>
                <a:gd name="connsiteY38" fmla="*/ 873238 h 1047863"/>
                <a:gd name="connsiteX39" fmla="*/ 641350 w 2901950"/>
                <a:gd name="connsiteY39" fmla="*/ 885938 h 1047863"/>
                <a:gd name="connsiteX40" fmla="*/ 650875 w 2901950"/>
                <a:gd name="connsiteY40" fmla="*/ 889113 h 1047863"/>
                <a:gd name="connsiteX41" fmla="*/ 660400 w 2901950"/>
                <a:gd name="connsiteY41" fmla="*/ 892288 h 1047863"/>
                <a:gd name="connsiteX42" fmla="*/ 685800 w 2901950"/>
                <a:gd name="connsiteY42" fmla="*/ 898638 h 1047863"/>
                <a:gd name="connsiteX43" fmla="*/ 714375 w 2901950"/>
                <a:gd name="connsiteY43" fmla="*/ 914513 h 1047863"/>
                <a:gd name="connsiteX44" fmla="*/ 723900 w 2901950"/>
                <a:gd name="connsiteY44" fmla="*/ 920863 h 1047863"/>
                <a:gd name="connsiteX45" fmla="*/ 742950 w 2901950"/>
                <a:gd name="connsiteY45" fmla="*/ 930388 h 1047863"/>
                <a:gd name="connsiteX46" fmla="*/ 762000 w 2901950"/>
                <a:gd name="connsiteY46" fmla="*/ 936738 h 1047863"/>
                <a:gd name="connsiteX47" fmla="*/ 771525 w 2901950"/>
                <a:gd name="connsiteY47" fmla="*/ 939913 h 1047863"/>
                <a:gd name="connsiteX48" fmla="*/ 793750 w 2901950"/>
                <a:gd name="connsiteY48" fmla="*/ 949438 h 1047863"/>
                <a:gd name="connsiteX49" fmla="*/ 866775 w 2901950"/>
                <a:gd name="connsiteY49" fmla="*/ 946263 h 1047863"/>
                <a:gd name="connsiteX50" fmla="*/ 904875 w 2901950"/>
                <a:gd name="connsiteY50" fmla="*/ 943088 h 1047863"/>
                <a:gd name="connsiteX51" fmla="*/ 917575 w 2901950"/>
                <a:gd name="connsiteY51" fmla="*/ 939913 h 1047863"/>
                <a:gd name="connsiteX52" fmla="*/ 1035050 w 2901950"/>
                <a:gd name="connsiteY52" fmla="*/ 936738 h 1047863"/>
                <a:gd name="connsiteX53" fmla="*/ 1057275 w 2901950"/>
                <a:gd name="connsiteY53" fmla="*/ 930388 h 1047863"/>
                <a:gd name="connsiteX54" fmla="*/ 1066800 w 2901950"/>
                <a:gd name="connsiteY54" fmla="*/ 924038 h 1047863"/>
                <a:gd name="connsiteX55" fmla="*/ 1095375 w 2901950"/>
                <a:gd name="connsiteY55" fmla="*/ 914513 h 1047863"/>
                <a:gd name="connsiteX56" fmla="*/ 1123950 w 2901950"/>
                <a:gd name="connsiteY56" fmla="*/ 904988 h 1047863"/>
                <a:gd name="connsiteX57" fmla="*/ 1133475 w 2901950"/>
                <a:gd name="connsiteY57" fmla="*/ 901813 h 1047863"/>
                <a:gd name="connsiteX58" fmla="*/ 1143000 w 2901950"/>
                <a:gd name="connsiteY58" fmla="*/ 898638 h 1047863"/>
                <a:gd name="connsiteX59" fmla="*/ 1162050 w 2901950"/>
                <a:gd name="connsiteY59" fmla="*/ 895463 h 1047863"/>
                <a:gd name="connsiteX60" fmla="*/ 1181100 w 2901950"/>
                <a:gd name="connsiteY60" fmla="*/ 889113 h 1047863"/>
                <a:gd name="connsiteX61" fmla="*/ 1200150 w 2901950"/>
                <a:gd name="connsiteY61" fmla="*/ 882763 h 1047863"/>
                <a:gd name="connsiteX62" fmla="*/ 1219200 w 2901950"/>
                <a:gd name="connsiteY62" fmla="*/ 873238 h 1047863"/>
                <a:gd name="connsiteX63" fmla="*/ 1250950 w 2901950"/>
                <a:gd name="connsiteY63" fmla="*/ 863713 h 1047863"/>
                <a:gd name="connsiteX64" fmla="*/ 1279525 w 2901950"/>
                <a:gd name="connsiteY64" fmla="*/ 860538 h 1047863"/>
                <a:gd name="connsiteX65" fmla="*/ 1336675 w 2901950"/>
                <a:gd name="connsiteY65" fmla="*/ 866888 h 1047863"/>
                <a:gd name="connsiteX66" fmla="*/ 1368425 w 2901950"/>
                <a:gd name="connsiteY66" fmla="*/ 873238 h 1047863"/>
                <a:gd name="connsiteX67" fmla="*/ 1387475 w 2901950"/>
                <a:gd name="connsiteY67" fmla="*/ 879588 h 1047863"/>
                <a:gd name="connsiteX68" fmla="*/ 1397000 w 2901950"/>
                <a:gd name="connsiteY68" fmla="*/ 882763 h 1047863"/>
                <a:gd name="connsiteX69" fmla="*/ 1425575 w 2901950"/>
                <a:gd name="connsiteY69" fmla="*/ 895463 h 1047863"/>
                <a:gd name="connsiteX70" fmla="*/ 1454150 w 2901950"/>
                <a:gd name="connsiteY70" fmla="*/ 904988 h 1047863"/>
                <a:gd name="connsiteX71" fmla="*/ 1463675 w 2901950"/>
                <a:gd name="connsiteY71" fmla="*/ 908163 h 1047863"/>
                <a:gd name="connsiteX72" fmla="*/ 1473200 w 2901950"/>
                <a:gd name="connsiteY72" fmla="*/ 911338 h 1047863"/>
                <a:gd name="connsiteX73" fmla="*/ 1482725 w 2901950"/>
                <a:gd name="connsiteY73" fmla="*/ 917688 h 1047863"/>
                <a:gd name="connsiteX74" fmla="*/ 1501775 w 2901950"/>
                <a:gd name="connsiteY74" fmla="*/ 924038 h 1047863"/>
                <a:gd name="connsiteX75" fmla="*/ 1511300 w 2901950"/>
                <a:gd name="connsiteY75" fmla="*/ 930388 h 1047863"/>
                <a:gd name="connsiteX76" fmla="*/ 1530350 w 2901950"/>
                <a:gd name="connsiteY76" fmla="*/ 936738 h 1047863"/>
                <a:gd name="connsiteX77" fmla="*/ 1549400 w 2901950"/>
                <a:gd name="connsiteY77" fmla="*/ 943088 h 1047863"/>
                <a:gd name="connsiteX78" fmla="*/ 1577975 w 2901950"/>
                <a:gd name="connsiteY78" fmla="*/ 952613 h 1047863"/>
                <a:gd name="connsiteX79" fmla="*/ 1587500 w 2901950"/>
                <a:gd name="connsiteY79" fmla="*/ 955788 h 1047863"/>
                <a:gd name="connsiteX80" fmla="*/ 1651000 w 2901950"/>
                <a:gd name="connsiteY80" fmla="*/ 958963 h 1047863"/>
                <a:gd name="connsiteX81" fmla="*/ 1682750 w 2901950"/>
                <a:gd name="connsiteY81" fmla="*/ 965313 h 1047863"/>
                <a:gd name="connsiteX82" fmla="*/ 1701800 w 2901950"/>
                <a:gd name="connsiteY82" fmla="*/ 971663 h 1047863"/>
                <a:gd name="connsiteX83" fmla="*/ 1720850 w 2901950"/>
                <a:gd name="connsiteY83" fmla="*/ 978013 h 1047863"/>
                <a:gd name="connsiteX84" fmla="*/ 1739900 w 2901950"/>
                <a:gd name="connsiteY84" fmla="*/ 984363 h 1047863"/>
                <a:gd name="connsiteX85" fmla="*/ 1749425 w 2901950"/>
                <a:gd name="connsiteY85" fmla="*/ 987538 h 1047863"/>
                <a:gd name="connsiteX86" fmla="*/ 1771650 w 2901950"/>
                <a:gd name="connsiteY86" fmla="*/ 990713 h 1047863"/>
                <a:gd name="connsiteX87" fmla="*/ 1876425 w 2901950"/>
                <a:gd name="connsiteY87" fmla="*/ 990713 h 1047863"/>
                <a:gd name="connsiteX88" fmla="*/ 1914525 w 2901950"/>
                <a:gd name="connsiteY88" fmla="*/ 984363 h 1047863"/>
                <a:gd name="connsiteX89" fmla="*/ 1933575 w 2901950"/>
                <a:gd name="connsiteY89" fmla="*/ 978013 h 1047863"/>
                <a:gd name="connsiteX90" fmla="*/ 1943100 w 2901950"/>
                <a:gd name="connsiteY90" fmla="*/ 974838 h 1047863"/>
                <a:gd name="connsiteX91" fmla="*/ 1952625 w 2901950"/>
                <a:gd name="connsiteY91" fmla="*/ 971663 h 1047863"/>
                <a:gd name="connsiteX92" fmla="*/ 1965325 w 2901950"/>
                <a:gd name="connsiteY92" fmla="*/ 965313 h 1047863"/>
                <a:gd name="connsiteX93" fmla="*/ 1984375 w 2901950"/>
                <a:gd name="connsiteY93" fmla="*/ 958963 h 1047863"/>
                <a:gd name="connsiteX94" fmla="*/ 2006600 w 2901950"/>
                <a:gd name="connsiteY94" fmla="*/ 952613 h 1047863"/>
                <a:gd name="connsiteX95" fmla="*/ 2035175 w 2901950"/>
                <a:gd name="connsiteY95" fmla="*/ 939913 h 1047863"/>
                <a:gd name="connsiteX96" fmla="*/ 2044700 w 2901950"/>
                <a:gd name="connsiteY96" fmla="*/ 936738 h 1047863"/>
                <a:gd name="connsiteX97" fmla="*/ 2054225 w 2901950"/>
                <a:gd name="connsiteY97" fmla="*/ 930388 h 1047863"/>
                <a:gd name="connsiteX98" fmla="*/ 2073275 w 2901950"/>
                <a:gd name="connsiteY98" fmla="*/ 924038 h 1047863"/>
                <a:gd name="connsiteX99" fmla="*/ 2082800 w 2901950"/>
                <a:gd name="connsiteY99" fmla="*/ 917688 h 1047863"/>
                <a:gd name="connsiteX100" fmla="*/ 2092325 w 2901950"/>
                <a:gd name="connsiteY100" fmla="*/ 914513 h 1047863"/>
                <a:gd name="connsiteX101" fmla="*/ 2111375 w 2901950"/>
                <a:gd name="connsiteY101" fmla="*/ 901813 h 1047863"/>
                <a:gd name="connsiteX102" fmla="*/ 2130425 w 2901950"/>
                <a:gd name="connsiteY102" fmla="*/ 889113 h 1047863"/>
                <a:gd name="connsiteX103" fmla="*/ 2139950 w 2901950"/>
                <a:gd name="connsiteY103" fmla="*/ 882763 h 1047863"/>
                <a:gd name="connsiteX104" fmla="*/ 2152650 w 2901950"/>
                <a:gd name="connsiteY104" fmla="*/ 876413 h 1047863"/>
                <a:gd name="connsiteX105" fmla="*/ 2181225 w 2901950"/>
                <a:gd name="connsiteY105" fmla="*/ 860538 h 1047863"/>
                <a:gd name="connsiteX106" fmla="*/ 2193925 w 2901950"/>
                <a:gd name="connsiteY106" fmla="*/ 851013 h 1047863"/>
                <a:gd name="connsiteX107" fmla="*/ 2203450 w 2901950"/>
                <a:gd name="connsiteY107" fmla="*/ 841488 h 1047863"/>
                <a:gd name="connsiteX108" fmla="*/ 2212975 w 2901950"/>
                <a:gd name="connsiteY108" fmla="*/ 838313 h 1047863"/>
                <a:gd name="connsiteX109" fmla="*/ 2222500 w 2901950"/>
                <a:gd name="connsiteY109" fmla="*/ 831963 h 1047863"/>
                <a:gd name="connsiteX110" fmla="*/ 2232025 w 2901950"/>
                <a:gd name="connsiteY110" fmla="*/ 828788 h 1047863"/>
                <a:gd name="connsiteX111" fmla="*/ 2251075 w 2901950"/>
                <a:gd name="connsiteY111" fmla="*/ 816088 h 1047863"/>
                <a:gd name="connsiteX112" fmla="*/ 2260600 w 2901950"/>
                <a:gd name="connsiteY112" fmla="*/ 809738 h 1047863"/>
                <a:gd name="connsiteX113" fmla="*/ 2289175 w 2901950"/>
                <a:gd name="connsiteY113" fmla="*/ 787513 h 1047863"/>
                <a:gd name="connsiteX114" fmla="*/ 2298700 w 2901950"/>
                <a:gd name="connsiteY114" fmla="*/ 781163 h 1047863"/>
                <a:gd name="connsiteX115" fmla="*/ 2305050 w 2901950"/>
                <a:gd name="connsiteY115" fmla="*/ 771638 h 1047863"/>
                <a:gd name="connsiteX116" fmla="*/ 2324100 w 2901950"/>
                <a:gd name="connsiteY116" fmla="*/ 758938 h 1047863"/>
                <a:gd name="connsiteX117" fmla="*/ 2339975 w 2901950"/>
                <a:gd name="connsiteY117" fmla="*/ 746238 h 1047863"/>
                <a:gd name="connsiteX118" fmla="*/ 2346325 w 2901950"/>
                <a:gd name="connsiteY118" fmla="*/ 736713 h 1047863"/>
                <a:gd name="connsiteX119" fmla="*/ 2355850 w 2901950"/>
                <a:gd name="connsiteY119" fmla="*/ 730363 h 1047863"/>
                <a:gd name="connsiteX120" fmla="*/ 2378075 w 2901950"/>
                <a:gd name="connsiteY120" fmla="*/ 708138 h 1047863"/>
                <a:gd name="connsiteX121" fmla="*/ 2390775 w 2901950"/>
                <a:gd name="connsiteY121" fmla="*/ 692263 h 1047863"/>
                <a:gd name="connsiteX122" fmla="*/ 2406650 w 2901950"/>
                <a:gd name="connsiteY122" fmla="*/ 676388 h 1047863"/>
                <a:gd name="connsiteX123" fmla="*/ 2428875 w 2901950"/>
                <a:gd name="connsiteY123" fmla="*/ 650988 h 1047863"/>
                <a:gd name="connsiteX124" fmla="*/ 2435225 w 2901950"/>
                <a:gd name="connsiteY124" fmla="*/ 641463 h 1047863"/>
                <a:gd name="connsiteX125" fmla="*/ 2444750 w 2901950"/>
                <a:gd name="connsiteY125" fmla="*/ 638288 h 1047863"/>
                <a:gd name="connsiteX126" fmla="*/ 2463800 w 2901950"/>
                <a:gd name="connsiteY126" fmla="*/ 625588 h 1047863"/>
                <a:gd name="connsiteX127" fmla="*/ 2482850 w 2901950"/>
                <a:gd name="connsiteY127" fmla="*/ 612888 h 1047863"/>
                <a:gd name="connsiteX128" fmla="*/ 2489200 w 2901950"/>
                <a:gd name="connsiteY128" fmla="*/ 603363 h 1047863"/>
                <a:gd name="connsiteX129" fmla="*/ 2505075 w 2901950"/>
                <a:gd name="connsiteY129" fmla="*/ 584313 h 1047863"/>
                <a:gd name="connsiteX130" fmla="*/ 2511425 w 2901950"/>
                <a:gd name="connsiteY130" fmla="*/ 565263 h 1047863"/>
                <a:gd name="connsiteX131" fmla="*/ 2514600 w 2901950"/>
                <a:gd name="connsiteY131" fmla="*/ 555738 h 1047863"/>
                <a:gd name="connsiteX132" fmla="*/ 2517775 w 2901950"/>
                <a:gd name="connsiteY132" fmla="*/ 546213 h 1047863"/>
                <a:gd name="connsiteX133" fmla="*/ 2520950 w 2901950"/>
                <a:gd name="connsiteY133" fmla="*/ 533513 h 1047863"/>
                <a:gd name="connsiteX134" fmla="*/ 2524125 w 2901950"/>
                <a:gd name="connsiteY134" fmla="*/ 523988 h 1047863"/>
                <a:gd name="connsiteX135" fmla="*/ 2533650 w 2901950"/>
                <a:gd name="connsiteY135" fmla="*/ 489063 h 1047863"/>
                <a:gd name="connsiteX136" fmla="*/ 2536825 w 2901950"/>
                <a:gd name="connsiteY136" fmla="*/ 460488 h 1047863"/>
                <a:gd name="connsiteX137" fmla="*/ 2540000 w 2901950"/>
                <a:gd name="connsiteY137" fmla="*/ 406513 h 1047863"/>
                <a:gd name="connsiteX138" fmla="*/ 2546350 w 2901950"/>
                <a:gd name="connsiteY138" fmla="*/ 387463 h 1047863"/>
                <a:gd name="connsiteX139" fmla="*/ 2549525 w 2901950"/>
                <a:gd name="connsiteY139" fmla="*/ 374763 h 1047863"/>
                <a:gd name="connsiteX140" fmla="*/ 2555875 w 2901950"/>
                <a:gd name="connsiteY140" fmla="*/ 336663 h 1047863"/>
                <a:gd name="connsiteX141" fmla="*/ 2559050 w 2901950"/>
                <a:gd name="connsiteY141" fmla="*/ 327138 h 1047863"/>
                <a:gd name="connsiteX142" fmla="*/ 2562225 w 2901950"/>
                <a:gd name="connsiteY142" fmla="*/ 311263 h 1047863"/>
                <a:gd name="connsiteX143" fmla="*/ 2565400 w 2901950"/>
                <a:gd name="connsiteY143" fmla="*/ 301738 h 1047863"/>
                <a:gd name="connsiteX144" fmla="*/ 2568575 w 2901950"/>
                <a:gd name="connsiteY144" fmla="*/ 289038 h 1047863"/>
                <a:gd name="connsiteX145" fmla="*/ 2571750 w 2901950"/>
                <a:gd name="connsiteY145" fmla="*/ 279513 h 1047863"/>
                <a:gd name="connsiteX146" fmla="*/ 2578100 w 2901950"/>
                <a:gd name="connsiteY146" fmla="*/ 257288 h 1047863"/>
                <a:gd name="connsiteX147" fmla="*/ 2584450 w 2901950"/>
                <a:gd name="connsiteY147" fmla="*/ 247763 h 1047863"/>
                <a:gd name="connsiteX148" fmla="*/ 2590800 w 2901950"/>
                <a:gd name="connsiteY148" fmla="*/ 225538 h 1047863"/>
                <a:gd name="connsiteX149" fmla="*/ 2597150 w 2901950"/>
                <a:gd name="connsiteY149" fmla="*/ 216013 h 1047863"/>
                <a:gd name="connsiteX150" fmla="*/ 2603500 w 2901950"/>
                <a:gd name="connsiteY150" fmla="*/ 193788 h 1047863"/>
                <a:gd name="connsiteX151" fmla="*/ 2613025 w 2901950"/>
                <a:gd name="connsiteY151" fmla="*/ 174738 h 1047863"/>
                <a:gd name="connsiteX152" fmla="*/ 2616200 w 2901950"/>
                <a:gd name="connsiteY152" fmla="*/ 165213 h 1047863"/>
                <a:gd name="connsiteX153" fmla="*/ 2628900 w 2901950"/>
                <a:gd name="connsiteY153" fmla="*/ 146163 h 1047863"/>
                <a:gd name="connsiteX154" fmla="*/ 2635250 w 2901950"/>
                <a:gd name="connsiteY154" fmla="*/ 133463 h 1047863"/>
                <a:gd name="connsiteX155" fmla="*/ 2638425 w 2901950"/>
                <a:gd name="connsiteY155" fmla="*/ 123938 h 1047863"/>
                <a:gd name="connsiteX156" fmla="*/ 2660650 w 2901950"/>
                <a:gd name="connsiteY156" fmla="*/ 95363 h 1047863"/>
                <a:gd name="connsiteX157" fmla="*/ 2682875 w 2901950"/>
                <a:gd name="connsiteY157" fmla="*/ 69963 h 1047863"/>
                <a:gd name="connsiteX158" fmla="*/ 2698750 w 2901950"/>
                <a:gd name="connsiteY158" fmla="*/ 54088 h 1047863"/>
                <a:gd name="connsiteX159" fmla="*/ 2705100 w 2901950"/>
                <a:gd name="connsiteY159" fmla="*/ 44563 h 1047863"/>
                <a:gd name="connsiteX160" fmla="*/ 2714625 w 2901950"/>
                <a:gd name="connsiteY160" fmla="*/ 38213 h 1047863"/>
                <a:gd name="connsiteX161" fmla="*/ 2743200 w 2901950"/>
                <a:gd name="connsiteY161" fmla="*/ 15988 h 1047863"/>
                <a:gd name="connsiteX162" fmla="*/ 2771775 w 2901950"/>
                <a:gd name="connsiteY162" fmla="*/ 3288 h 1047863"/>
                <a:gd name="connsiteX163" fmla="*/ 2781300 w 2901950"/>
                <a:gd name="connsiteY163" fmla="*/ 113 h 1047863"/>
                <a:gd name="connsiteX164" fmla="*/ 2844800 w 2901950"/>
                <a:gd name="connsiteY164" fmla="*/ 6463 h 1047863"/>
                <a:gd name="connsiteX165" fmla="*/ 2854325 w 2901950"/>
                <a:gd name="connsiteY165" fmla="*/ 12813 h 1047863"/>
                <a:gd name="connsiteX166" fmla="*/ 2870200 w 2901950"/>
                <a:gd name="connsiteY166" fmla="*/ 31863 h 1047863"/>
                <a:gd name="connsiteX167" fmla="*/ 2882900 w 2901950"/>
                <a:gd name="connsiteY167" fmla="*/ 50913 h 1047863"/>
                <a:gd name="connsiteX168" fmla="*/ 2889250 w 2901950"/>
                <a:gd name="connsiteY168" fmla="*/ 60438 h 1047863"/>
                <a:gd name="connsiteX169" fmla="*/ 2898775 w 2901950"/>
                <a:gd name="connsiteY169" fmla="*/ 89013 h 1047863"/>
                <a:gd name="connsiteX170" fmla="*/ 2901950 w 2901950"/>
                <a:gd name="connsiteY170" fmla="*/ 98538 h 1047863"/>
                <a:gd name="connsiteX171" fmla="*/ 2898775 w 2901950"/>
                <a:gd name="connsiteY171" fmla="*/ 158863 h 1047863"/>
                <a:gd name="connsiteX172" fmla="*/ 2889250 w 2901950"/>
                <a:gd name="connsiteY172" fmla="*/ 190613 h 1047863"/>
                <a:gd name="connsiteX173" fmla="*/ 2882900 w 2901950"/>
                <a:gd name="connsiteY173" fmla="*/ 212838 h 1047863"/>
                <a:gd name="connsiteX174" fmla="*/ 2873375 w 2901950"/>
                <a:gd name="connsiteY174" fmla="*/ 244588 h 1047863"/>
                <a:gd name="connsiteX175" fmla="*/ 2870200 w 2901950"/>
                <a:gd name="connsiteY175" fmla="*/ 254113 h 1047863"/>
                <a:gd name="connsiteX176" fmla="*/ 2847975 w 2901950"/>
                <a:gd name="connsiteY176" fmla="*/ 282688 h 1047863"/>
                <a:gd name="connsiteX177" fmla="*/ 2844800 w 2901950"/>
                <a:gd name="connsiteY177" fmla="*/ 292213 h 1047863"/>
                <a:gd name="connsiteX178" fmla="*/ 2822575 w 2901950"/>
                <a:gd name="connsiteY178" fmla="*/ 320788 h 1047863"/>
                <a:gd name="connsiteX179" fmla="*/ 2809875 w 2901950"/>
                <a:gd name="connsiteY179" fmla="*/ 336663 h 1047863"/>
                <a:gd name="connsiteX180" fmla="*/ 2797175 w 2901950"/>
                <a:gd name="connsiteY180" fmla="*/ 352538 h 1047863"/>
                <a:gd name="connsiteX181" fmla="*/ 2784475 w 2901950"/>
                <a:gd name="connsiteY181" fmla="*/ 365238 h 1047863"/>
                <a:gd name="connsiteX182" fmla="*/ 2778125 w 2901950"/>
                <a:gd name="connsiteY182" fmla="*/ 374763 h 1047863"/>
                <a:gd name="connsiteX183" fmla="*/ 2768600 w 2901950"/>
                <a:gd name="connsiteY183" fmla="*/ 381113 h 1047863"/>
                <a:gd name="connsiteX184" fmla="*/ 2755900 w 2901950"/>
                <a:gd name="connsiteY184" fmla="*/ 393813 h 1047863"/>
                <a:gd name="connsiteX185" fmla="*/ 2752725 w 2901950"/>
                <a:gd name="connsiteY185" fmla="*/ 403338 h 1047863"/>
                <a:gd name="connsiteX186" fmla="*/ 2743200 w 2901950"/>
                <a:gd name="connsiteY186" fmla="*/ 409688 h 1047863"/>
                <a:gd name="connsiteX187" fmla="*/ 2736850 w 2901950"/>
                <a:gd name="connsiteY187" fmla="*/ 419213 h 1047863"/>
                <a:gd name="connsiteX188" fmla="*/ 2727325 w 2901950"/>
                <a:gd name="connsiteY188" fmla="*/ 425563 h 1047863"/>
                <a:gd name="connsiteX189" fmla="*/ 2705100 w 2901950"/>
                <a:gd name="connsiteY189" fmla="*/ 447788 h 1047863"/>
                <a:gd name="connsiteX190" fmla="*/ 2701925 w 2901950"/>
                <a:gd name="connsiteY190" fmla="*/ 457313 h 1047863"/>
                <a:gd name="connsiteX191" fmla="*/ 2682875 w 2901950"/>
                <a:gd name="connsiteY191" fmla="*/ 470013 h 1047863"/>
                <a:gd name="connsiteX192" fmla="*/ 2679700 w 2901950"/>
                <a:gd name="connsiteY192" fmla="*/ 479538 h 1047863"/>
                <a:gd name="connsiteX193" fmla="*/ 2663825 w 2901950"/>
                <a:gd name="connsiteY193" fmla="*/ 498588 h 1047863"/>
                <a:gd name="connsiteX194" fmla="*/ 2651125 w 2901950"/>
                <a:gd name="connsiteY194" fmla="*/ 514463 h 1047863"/>
                <a:gd name="connsiteX195" fmla="*/ 2647950 w 2901950"/>
                <a:gd name="connsiteY195" fmla="*/ 523988 h 1047863"/>
                <a:gd name="connsiteX196" fmla="*/ 2638425 w 2901950"/>
                <a:gd name="connsiteY196" fmla="*/ 533513 h 1047863"/>
                <a:gd name="connsiteX197" fmla="*/ 2616200 w 2901950"/>
                <a:gd name="connsiteY197" fmla="*/ 558913 h 1047863"/>
                <a:gd name="connsiteX198" fmla="*/ 2603500 w 2901950"/>
                <a:gd name="connsiteY198" fmla="*/ 577963 h 1047863"/>
                <a:gd name="connsiteX199" fmla="*/ 2600325 w 2901950"/>
                <a:gd name="connsiteY199" fmla="*/ 587488 h 1047863"/>
                <a:gd name="connsiteX200" fmla="*/ 2587625 w 2901950"/>
                <a:gd name="connsiteY200" fmla="*/ 606538 h 1047863"/>
                <a:gd name="connsiteX201" fmla="*/ 2584450 w 2901950"/>
                <a:gd name="connsiteY201" fmla="*/ 616063 h 1047863"/>
                <a:gd name="connsiteX202" fmla="*/ 2571750 w 2901950"/>
                <a:gd name="connsiteY202" fmla="*/ 635113 h 1047863"/>
                <a:gd name="connsiteX203" fmla="*/ 2568575 w 2901950"/>
                <a:gd name="connsiteY203" fmla="*/ 644638 h 1047863"/>
                <a:gd name="connsiteX204" fmla="*/ 2559050 w 2901950"/>
                <a:gd name="connsiteY204" fmla="*/ 650988 h 1047863"/>
                <a:gd name="connsiteX205" fmla="*/ 2543175 w 2901950"/>
                <a:gd name="connsiteY205" fmla="*/ 679563 h 1047863"/>
                <a:gd name="connsiteX206" fmla="*/ 2533650 w 2901950"/>
                <a:gd name="connsiteY206" fmla="*/ 685913 h 1047863"/>
                <a:gd name="connsiteX207" fmla="*/ 2517775 w 2901950"/>
                <a:gd name="connsiteY207" fmla="*/ 714488 h 1047863"/>
                <a:gd name="connsiteX208" fmla="*/ 2508250 w 2901950"/>
                <a:gd name="connsiteY208" fmla="*/ 720838 h 1047863"/>
                <a:gd name="connsiteX209" fmla="*/ 2495550 w 2901950"/>
                <a:gd name="connsiteY209" fmla="*/ 736713 h 1047863"/>
                <a:gd name="connsiteX210" fmla="*/ 2489200 w 2901950"/>
                <a:gd name="connsiteY210" fmla="*/ 746238 h 1047863"/>
                <a:gd name="connsiteX211" fmla="*/ 2470150 w 2901950"/>
                <a:gd name="connsiteY211" fmla="*/ 762113 h 1047863"/>
                <a:gd name="connsiteX212" fmla="*/ 2463800 w 2901950"/>
                <a:gd name="connsiteY212" fmla="*/ 771638 h 1047863"/>
                <a:gd name="connsiteX213" fmla="*/ 2444750 w 2901950"/>
                <a:gd name="connsiteY213" fmla="*/ 784338 h 1047863"/>
                <a:gd name="connsiteX214" fmla="*/ 2428875 w 2901950"/>
                <a:gd name="connsiteY214" fmla="*/ 800213 h 1047863"/>
                <a:gd name="connsiteX215" fmla="*/ 2409825 w 2901950"/>
                <a:gd name="connsiteY215" fmla="*/ 819263 h 1047863"/>
                <a:gd name="connsiteX216" fmla="*/ 2403475 w 2901950"/>
                <a:gd name="connsiteY216" fmla="*/ 828788 h 1047863"/>
                <a:gd name="connsiteX217" fmla="*/ 2393950 w 2901950"/>
                <a:gd name="connsiteY217" fmla="*/ 835138 h 1047863"/>
                <a:gd name="connsiteX218" fmla="*/ 2378075 w 2901950"/>
                <a:gd name="connsiteY218" fmla="*/ 851013 h 1047863"/>
                <a:gd name="connsiteX219" fmla="*/ 2371725 w 2901950"/>
                <a:gd name="connsiteY219" fmla="*/ 860538 h 1047863"/>
                <a:gd name="connsiteX220" fmla="*/ 2362200 w 2901950"/>
                <a:gd name="connsiteY220" fmla="*/ 870063 h 1047863"/>
                <a:gd name="connsiteX221" fmla="*/ 2339975 w 2901950"/>
                <a:gd name="connsiteY221" fmla="*/ 892288 h 1047863"/>
                <a:gd name="connsiteX222" fmla="*/ 2327275 w 2901950"/>
                <a:gd name="connsiteY222" fmla="*/ 908163 h 1047863"/>
                <a:gd name="connsiteX223" fmla="*/ 2320925 w 2901950"/>
                <a:gd name="connsiteY223" fmla="*/ 917688 h 1047863"/>
                <a:gd name="connsiteX224" fmla="*/ 2298700 w 2901950"/>
                <a:gd name="connsiteY224" fmla="*/ 946263 h 1047863"/>
                <a:gd name="connsiteX225" fmla="*/ 2286000 w 2901950"/>
                <a:gd name="connsiteY225" fmla="*/ 984363 h 1047863"/>
                <a:gd name="connsiteX226" fmla="*/ 2282825 w 2901950"/>
                <a:gd name="connsiteY226" fmla="*/ 993888 h 1047863"/>
                <a:gd name="connsiteX227" fmla="*/ 2276475 w 2901950"/>
                <a:gd name="connsiteY227" fmla="*/ 1003413 h 1047863"/>
                <a:gd name="connsiteX228" fmla="*/ 2279650 w 2901950"/>
                <a:gd name="connsiteY228" fmla="*/ 1047863 h 1047863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  <a:cxn ang="0">
                  <a:pos x="connsiteX29" y="connsiteY29"/>
                </a:cxn>
                <a:cxn ang="0">
                  <a:pos x="connsiteX30" y="connsiteY30"/>
                </a:cxn>
                <a:cxn ang="0">
                  <a:pos x="connsiteX31" y="connsiteY31"/>
                </a:cxn>
                <a:cxn ang="0">
                  <a:pos x="connsiteX32" y="connsiteY32"/>
                </a:cxn>
                <a:cxn ang="0">
                  <a:pos x="connsiteX33" y="connsiteY33"/>
                </a:cxn>
                <a:cxn ang="0">
                  <a:pos x="connsiteX34" y="connsiteY34"/>
                </a:cxn>
                <a:cxn ang="0">
                  <a:pos x="connsiteX35" y="connsiteY35"/>
                </a:cxn>
                <a:cxn ang="0">
                  <a:pos x="connsiteX36" y="connsiteY36"/>
                </a:cxn>
                <a:cxn ang="0">
                  <a:pos x="connsiteX37" y="connsiteY37"/>
                </a:cxn>
                <a:cxn ang="0">
                  <a:pos x="connsiteX38" y="connsiteY38"/>
                </a:cxn>
                <a:cxn ang="0">
                  <a:pos x="connsiteX39" y="connsiteY39"/>
                </a:cxn>
                <a:cxn ang="0">
                  <a:pos x="connsiteX40" y="connsiteY40"/>
                </a:cxn>
                <a:cxn ang="0">
                  <a:pos x="connsiteX41" y="connsiteY41"/>
                </a:cxn>
                <a:cxn ang="0">
                  <a:pos x="connsiteX42" y="connsiteY42"/>
                </a:cxn>
                <a:cxn ang="0">
                  <a:pos x="connsiteX43" y="connsiteY43"/>
                </a:cxn>
                <a:cxn ang="0">
                  <a:pos x="connsiteX44" y="connsiteY44"/>
                </a:cxn>
                <a:cxn ang="0">
                  <a:pos x="connsiteX45" y="connsiteY45"/>
                </a:cxn>
                <a:cxn ang="0">
                  <a:pos x="connsiteX46" y="connsiteY46"/>
                </a:cxn>
                <a:cxn ang="0">
                  <a:pos x="connsiteX47" y="connsiteY47"/>
                </a:cxn>
                <a:cxn ang="0">
                  <a:pos x="connsiteX48" y="connsiteY48"/>
                </a:cxn>
                <a:cxn ang="0">
                  <a:pos x="connsiteX49" y="connsiteY49"/>
                </a:cxn>
                <a:cxn ang="0">
                  <a:pos x="connsiteX50" y="connsiteY50"/>
                </a:cxn>
                <a:cxn ang="0">
                  <a:pos x="connsiteX51" y="connsiteY51"/>
                </a:cxn>
                <a:cxn ang="0">
                  <a:pos x="connsiteX52" y="connsiteY52"/>
                </a:cxn>
                <a:cxn ang="0">
                  <a:pos x="connsiteX53" y="connsiteY53"/>
                </a:cxn>
                <a:cxn ang="0">
                  <a:pos x="connsiteX54" y="connsiteY54"/>
                </a:cxn>
                <a:cxn ang="0">
                  <a:pos x="connsiteX55" y="connsiteY55"/>
                </a:cxn>
                <a:cxn ang="0">
                  <a:pos x="connsiteX56" y="connsiteY56"/>
                </a:cxn>
                <a:cxn ang="0">
                  <a:pos x="connsiteX57" y="connsiteY57"/>
                </a:cxn>
                <a:cxn ang="0">
                  <a:pos x="connsiteX58" y="connsiteY58"/>
                </a:cxn>
                <a:cxn ang="0">
                  <a:pos x="connsiteX59" y="connsiteY59"/>
                </a:cxn>
                <a:cxn ang="0">
                  <a:pos x="connsiteX60" y="connsiteY60"/>
                </a:cxn>
                <a:cxn ang="0">
                  <a:pos x="connsiteX61" y="connsiteY61"/>
                </a:cxn>
                <a:cxn ang="0">
                  <a:pos x="connsiteX62" y="connsiteY62"/>
                </a:cxn>
                <a:cxn ang="0">
                  <a:pos x="connsiteX63" y="connsiteY63"/>
                </a:cxn>
                <a:cxn ang="0">
                  <a:pos x="connsiteX64" y="connsiteY64"/>
                </a:cxn>
                <a:cxn ang="0">
                  <a:pos x="connsiteX65" y="connsiteY65"/>
                </a:cxn>
                <a:cxn ang="0">
                  <a:pos x="connsiteX66" y="connsiteY66"/>
                </a:cxn>
                <a:cxn ang="0">
                  <a:pos x="connsiteX67" y="connsiteY67"/>
                </a:cxn>
                <a:cxn ang="0">
                  <a:pos x="connsiteX68" y="connsiteY68"/>
                </a:cxn>
                <a:cxn ang="0">
                  <a:pos x="connsiteX69" y="connsiteY69"/>
                </a:cxn>
                <a:cxn ang="0">
                  <a:pos x="connsiteX70" y="connsiteY70"/>
                </a:cxn>
                <a:cxn ang="0">
                  <a:pos x="connsiteX71" y="connsiteY71"/>
                </a:cxn>
                <a:cxn ang="0">
                  <a:pos x="connsiteX72" y="connsiteY72"/>
                </a:cxn>
                <a:cxn ang="0">
                  <a:pos x="connsiteX73" y="connsiteY73"/>
                </a:cxn>
                <a:cxn ang="0">
                  <a:pos x="connsiteX74" y="connsiteY74"/>
                </a:cxn>
                <a:cxn ang="0">
                  <a:pos x="connsiteX75" y="connsiteY75"/>
                </a:cxn>
                <a:cxn ang="0">
                  <a:pos x="connsiteX76" y="connsiteY76"/>
                </a:cxn>
                <a:cxn ang="0">
                  <a:pos x="connsiteX77" y="connsiteY77"/>
                </a:cxn>
                <a:cxn ang="0">
                  <a:pos x="connsiteX78" y="connsiteY78"/>
                </a:cxn>
                <a:cxn ang="0">
                  <a:pos x="connsiteX79" y="connsiteY79"/>
                </a:cxn>
                <a:cxn ang="0">
                  <a:pos x="connsiteX80" y="connsiteY80"/>
                </a:cxn>
                <a:cxn ang="0">
                  <a:pos x="connsiteX81" y="connsiteY81"/>
                </a:cxn>
                <a:cxn ang="0">
                  <a:pos x="connsiteX82" y="connsiteY82"/>
                </a:cxn>
                <a:cxn ang="0">
                  <a:pos x="connsiteX83" y="connsiteY83"/>
                </a:cxn>
                <a:cxn ang="0">
                  <a:pos x="connsiteX84" y="connsiteY84"/>
                </a:cxn>
                <a:cxn ang="0">
                  <a:pos x="connsiteX85" y="connsiteY85"/>
                </a:cxn>
                <a:cxn ang="0">
                  <a:pos x="connsiteX86" y="connsiteY86"/>
                </a:cxn>
                <a:cxn ang="0">
                  <a:pos x="connsiteX87" y="connsiteY87"/>
                </a:cxn>
                <a:cxn ang="0">
                  <a:pos x="connsiteX88" y="connsiteY88"/>
                </a:cxn>
                <a:cxn ang="0">
                  <a:pos x="connsiteX89" y="connsiteY89"/>
                </a:cxn>
                <a:cxn ang="0">
                  <a:pos x="connsiteX90" y="connsiteY90"/>
                </a:cxn>
                <a:cxn ang="0">
                  <a:pos x="connsiteX91" y="connsiteY91"/>
                </a:cxn>
                <a:cxn ang="0">
                  <a:pos x="connsiteX92" y="connsiteY92"/>
                </a:cxn>
                <a:cxn ang="0">
                  <a:pos x="connsiteX93" y="connsiteY93"/>
                </a:cxn>
                <a:cxn ang="0">
                  <a:pos x="connsiteX94" y="connsiteY94"/>
                </a:cxn>
                <a:cxn ang="0">
                  <a:pos x="connsiteX95" y="connsiteY95"/>
                </a:cxn>
                <a:cxn ang="0">
                  <a:pos x="connsiteX96" y="connsiteY96"/>
                </a:cxn>
                <a:cxn ang="0">
                  <a:pos x="connsiteX97" y="connsiteY97"/>
                </a:cxn>
                <a:cxn ang="0">
                  <a:pos x="connsiteX98" y="connsiteY98"/>
                </a:cxn>
                <a:cxn ang="0">
                  <a:pos x="connsiteX99" y="connsiteY99"/>
                </a:cxn>
                <a:cxn ang="0">
                  <a:pos x="connsiteX100" y="connsiteY100"/>
                </a:cxn>
                <a:cxn ang="0">
                  <a:pos x="connsiteX101" y="connsiteY101"/>
                </a:cxn>
                <a:cxn ang="0">
                  <a:pos x="connsiteX102" y="connsiteY102"/>
                </a:cxn>
                <a:cxn ang="0">
                  <a:pos x="connsiteX103" y="connsiteY103"/>
                </a:cxn>
                <a:cxn ang="0">
                  <a:pos x="connsiteX104" y="connsiteY104"/>
                </a:cxn>
                <a:cxn ang="0">
                  <a:pos x="connsiteX105" y="connsiteY105"/>
                </a:cxn>
                <a:cxn ang="0">
                  <a:pos x="connsiteX106" y="connsiteY106"/>
                </a:cxn>
                <a:cxn ang="0">
                  <a:pos x="connsiteX107" y="connsiteY107"/>
                </a:cxn>
                <a:cxn ang="0">
                  <a:pos x="connsiteX108" y="connsiteY108"/>
                </a:cxn>
                <a:cxn ang="0">
                  <a:pos x="connsiteX109" y="connsiteY109"/>
                </a:cxn>
                <a:cxn ang="0">
                  <a:pos x="connsiteX110" y="connsiteY110"/>
                </a:cxn>
                <a:cxn ang="0">
                  <a:pos x="connsiteX111" y="connsiteY111"/>
                </a:cxn>
                <a:cxn ang="0">
                  <a:pos x="connsiteX112" y="connsiteY112"/>
                </a:cxn>
                <a:cxn ang="0">
                  <a:pos x="connsiteX113" y="connsiteY113"/>
                </a:cxn>
                <a:cxn ang="0">
                  <a:pos x="connsiteX114" y="connsiteY114"/>
                </a:cxn>
                <a:cxn ang="0">
                  <a:pos x="connsiteX115" y="connsiteY115"/>
                </a:cxn>
                <a:cxn ang="0">
                  <a:pos x="connsiteX116" y="connsiteY116"/>
                </a:cxn>
                <a:cxn ang="0">
                  <a:pos x="connsiteX117" y="connsiteY117"/>
                </a:cxn>
                <a:cxn ang="0">
                  <a:pos x="connsiteX118" y="connsiteY118"/>
                </a:cxn>
                <a:cxn ang="0">
                  <a:pos x="connsiteX119" y="connsiteY119"/>
                </a:cxn>
                <a:cxn ang="0">
                  <a:pos x="connsiteX120" y="connsiteY120"/>
                </a:cxn>
                <a:cxn ang="0">
                  <a:pos x="connsiteX121" y="connsiteY121"/>
                </a:cxn>
                <a:cxn ang="0">
                  <a:pos x="connsiteX122" y="connsiteY122"/>
                </a:cxn>
                <a:cxn ang="0">
                  <a:pos x="connsiteX123" y="connsiteY123"/>
                </a:cxn>
                <a:cxn ang="0">
                  <a:pos x="connsiteX124" y="connsiteY124"/>
                </a:cxn>
                <a:cxn ang="0">
                  <a:pos x="connsiteX125" y="connsiteY125"/>
                </a:cxn>
                <a:cxn ang="0">
                  <a:pos x="connsiteX126" y="connsiteY126"/>
                </a:cxn>
                <a:cxn ang="0">
                  <a:pos x="connsiteX127" y="connsiteY127"/>
                </a:cxn>
                <a:cxn ang="0">
                  <a:pos x="connsiteX128" y="connsiteY128"/>
                </a:cxn>
                <a:cxn ang="0">
                  <a:pos x="connsiteX129" y="connsiteY129"/>
                </a:cxn>
                <a:cxn ang="0">
                  <a:pos x="connsiteX130" y="connsiteY130"/>
                </a:cxn>
                <a:cxn ang="0">
                  <a:pos x="connsiteX131" y="connsiteY131"/>
                </a:cxn>
                <a:cxn ang="0">
                  <a:pos x="connsiteX132" y="connsiteY132"/>
                </a:cxn>
                <a:cxn ang="0">
                  <a:pos x="connsiteX133" y="connsiteY133"/>
                </a:cxn>
                <a:cxn ang="0">
                  <a:pos x="connsiteX134" y="connsiteY134"/>
                </a:cxn>
                <a:cxn ang="0">
                  <a:pos x="connsiteX135" y="connsiteY135"/>
                </a:cxn>
                <a:cxn ang="0">
                  <a:pos x="connsiteX136" y="connsiteY136"/>
                </a:cxn>
                <a:cxn ang="0">
                  <a:pos x="connsiteX137" y="connsiteY137"/>
                </a:cxn>
                <a:cxn ang="0">
                  <a:pos x="connsiteX138" y="connsiteY138"/>
                </a:cxn>
                <a:cxn ang="0">
                  <a:pos x="connsiteX139" y="connsiteY139"/>
                </a:cxn>
                <a:cxn ang="0">
                  <a:pos x="connsiteX140" y="connsiteY140"/>
                </a:cxn>
                <a:cxn ang="0">
                  <a:pos x="connsiteX141" y="connsiteY141"/>
                </a:cxn>
                <a:cxn ang="0">
                  <a:pos x="connsiteX142" y="connsiteY142"/>
                </a:cxn>
                <a:cxn ang="0">
                  <a:pos x="connsiteX143" y="connsiteY143"/>
                </a:cxn>
                <a:cxn ang="0">
                  <a:pos x="connsiteX144" y="connsiteY144"/>
                </a:cxn>
                <a:cxn ang="0">
                  <a:pos x="connsiteX145" y="connsiteY145"/>
                </a:cxn>
                <a:cxn ang="0">
                  <a:pos x="connsiteX146" y="connsiteY146"/>
                </a:cxn>
                <a:cxn ang="0">
                  <a:pos x="connsiteX147" y="connsiteY147"/>
                </a:cxn>
                <a:cxn ang="0">
                  <a:pos x="connsiteX148" y="connsiteY148"/>
                </a:cxn>
                <a:cxn ang="0">
                  <a:pos x="connsiteX149" y="connsiteY149"/>
                </a:cxn>
                <a:cxn ang="0">
                  <a:pos x="connsiteX150" y="connsiteY150"/>
                </a:cxn>
                <a:cxn ang="0">
                  <a:pos x="connsiteX151" y="connsiteY151"/>
                </a:cxn>
                <a:cxn ang="0">
                  <a:pos x="connsiteX152" y="connsiteY152"/>
                </a:cxn>
                <a:cxn ang="0">
                  <a:pos x="connsiteX153" y="connsiteY153"/>
                </a:cxn>
                <a:cxn ang="0">
                  <a:pos x="connsiteX154" y="connsiteY154"/>
                </a:cxn>
                <a:cxn ang="0">
                  <a:pos x="connsiteX155" y="connsiteY155"/>
                </a:cxn>
                <a:cxn ang="0">
                  <a:pos x="connsiteX156" y="connsiteY156"/>
                </a:cxn>
                <a:cxn ang="0">
                  <a:pos x="connsiteX157" y="connsiteY157"/>
                </a:cxn>
                <a:cxn ang="0">
                  <a:pos x="connsiteX158" y="connsiteY158"/>
                </a:cxn>
                <a:cxn ang="0">
                  <a:pos x="connsiteX159" y="connsiteY159"/>
                </a:cxn>
                <a:cxn ang="0">
                  <a:pos x="connsiteX160" y="connsiteY160"/>
                </a:cxn>
                <a:cxn ang="0">
                  <a:pos x="connsiteX161" y="connsiteY161"/>
                </a:cxn>
                <a:cxn ang="0">
                  <a:pos x="connsiteX162" y="connsiteY162"/>
                </a:cxn>
                <a:cxn ang="0">
                  <a:pos x="connsiteX163" y="connsiteY163"/>
                </a:cxn>
                <a:cxn ang="0">
                  <a:pos x="connsiteX164" y="connsiteY164"/>
                </a:cxn>
                <a:cxn ang="0">
                  <a:pos x="connsiteX165" y="connsiteY165"/>
                </a:cxn>
                <a:cxn ang="0">
                  <a:pos x="connsiteX166" y="connsiteY166"/>
                </a:cxn>
                <a:cxn ang="0">
                  <a:pos x="connsiteX167" y="connsiteY167"/>
                </a:cxn>
                <a:cxn ang="0">
                  <a:pos x="connsiteX168" y="connsiteY168"/>
                </a:cxn>
                <a:cxn ang="0">
                  <a:pos x="connsiteX169" y="connsiteY169"/>
                </a:cxn>
                <a:cxn ang="0">
                  <a:pos x="connsiteX170" y="connsiteY170"/>
                </a:cxn>
                <a:cxn ang="0">
                  <a:pos x="connsiteX171" y="connsiteY171"/>
                </a:cxn>
                <a:cxn ang="0">
                  <a:pos x="connsiteX172" y="connsiteY172"/>
                </a:cxn>
                <a:cxn ang="0">
                  <a:pos x="connsiteX173" y="connsiteY173"/>
                </a:cxn>
                <a:cxn ang="0">
                  <a:pos x="connsiteX174" y="connsiteY174"/>
                </a:cxn>
                <a:cxn ang="0">
                  <a:pos x="connsiteX175" y="connsiteY175"/>
                </a:cxn>
                <a:cxn ang="0">
                  <a:pos x="connsiteX176" y="connsiteY176"/>
                </a:cxn>
                <a:cxn ang="0">
                  <a:pos x="connsiteX177" y="connsiteY177"/>
                </a:cxn>
                <a:cxn ang="0">
                  <a:pos x="connsiteX178" y="connsiteY178"/>
                </a:cxn>
                <a:cxn ang="0">
                  <a:pos x="connsiteX179" y="connsiteY179"/>
                </a:cxn>
                <a:cxn ang="0">
                  <a:pos x="connsiteX180" y="connsiteY180"/>
                </a:cxn>
                <a:cxn ang="0">
                  <a:pos x="connsiteX181" y="connsiteY181"/>
                </a:cxn>
                <a:cxn ang="0">
                  <a:pos x="connsiteX182" y="connsiteY182"/>
                </a:cxn>
                <a:cxn ang="0">
                  <a:pos x="connsiteX183" y="connsiteY183"/>
                </a:cxn>
                <a:cxn ang="0">
                  <a:pos x="connsiteX184" y="connsiteY184"/>
                </a:cxn>
                <a:cxn ang="0">
                  <a:pos x="connsiteX185" y="connsiteY185"/>
                </a:cxn>
                <a:cxn ang="0">
                  <a:pos x="connsiteX186" y="connsiteY186"/>
                </a:cxn>
                <a:cxn ang="0">
                  <a:pos x="connsiteX187" y="connsiteY187"/>
                </a:cxn>
                <a:cxn ang="0">
                  <a:pos x="connsiteX188" y="connsiteY188"/>
                </a:cxn>
                <a:cxn ang="0">
                  <a:pos x="connsiteX189" y="connsiteY189"/>
                </a:cxn>
                <a:cxn ang="0">
                  <a:pos x="connsiteX190" y="connsiteY190"/>
                </a:cxn>
                <a:cxn ang="0">
                  <a:pos x="connsiteX191" y="connsiteY191"/>
                </a:cxn>
                <a:cxn ang="0">
                  <a:pos x="connsiteX192" y="connsiteY192"/>
                </a:cxn>
                <a:cxn ang="0">
                  <a:pos x="connsiteX193" y="connsiteY193"/>
                </a:cxn>
                <a:cxn ang="0">
                  <a:pos x="connsiteX194" y="connsiteY194"/>
                </a:cxn>
                <a:cxn ang="0">
                  <a:pos x="connsiteX195" y="connsiteY195"/>
                </a:cxn>
                <a:cxn ang="0">
                  <a:pos x="connsiteX196" y="connsiteY196"/>
                </a:cxn>
                <a:cxn ang="0">
                  <a:pos x="connsiteX197" y="connsiteY197"/>
                </a:cxn>
                <a:cxn ang="0">
                  <a:pos x="connsiteX198" y="connsiteY198"/>
                </a:cxn>
                <a:cxn ang="0">
                  <a:pos x="connsiteX199" y="connsiteY199"/>
                </a:cxn>
                <a:cxn ang="0">
                  <a:pos x="connsiteX200" y="connsiteY200"/>
                </a:cxn>
                <a:cxn ang="0">
                  <a:pos x="connsiteX201" y="connsiteY201"/>
                </a:cxn>
                <a:cxn ang="0">
                  <a:pos x="connsiteX202" y="connsiteY202"/>
                </a:cxn>
                <a:cxn ang="0">
                  <a:pos x="connsiteX203" y="connsiteY203"/>
                </a:cxn>
                <a:cxn ang="0">
                  <a:pos x="connsiteX204" y="connsiteY204"/>
                </a:cxn>
                <a:cxn ang="0">
                  <a:pos x="connsiteX205" y="connsiteY205"/>
                </a:cxn>
                <a:cxn ang="0">
                  <a:pos x="connsiteX206" y="connsiteY206"/>
                </a:cxn>
                <a:cxn ang="0">
                  <a:pos x="connsiteX207" y="connsiteY207"/>
                </a:cxn>
                <a:cxn ang="0">
                  <a:pos x="connsiteX208" y="connsiteY208"/>
                </a:cxn>
                <a:cxn ang="0">
                  <a:pos x="connsiteX209" y="connsiteY209"/>
                </a:cxn>
                <a:cxn ang="0">
                  <a:pos x="connsiteX210" y="connsiteY210"/>
                </a:cxn>
                <a:cxn ang="0">
                  <a:pos x="connsiteX211" y="connsiteY211"/>
                </a:cxn>
                <a:cxn ang="0">
                  <a:pos x="connsiteX212" y="connsiteY212"/>
                </a:cxn>
                <a:cxn ang="0">
                  <a:pos x="connsiteX213" y="connsiteY213"/>
                </a:cxn>
                <a:cxn ang="0">
                  <a:pos x="connsiteX214" y="connsiteY214"/>
                </a:cxn>
                <a:cxn ang="0">
                  <a:pos x="connsiteX215" y="connsiteY215"/>
                </a:cxn>
                <a:cxn ang="0">
                  <a:pos x="connsiteX216" y="connsiteY216"/>
                </a:cxn>
                <a:cxn ang="0">
                  <a:pos x="connsiteX217" y="connsiteY217"/>
                </a:cxn>
                <a:cxn ang="0">
                  <a:pos x="connsiteX218" y="connsiteY218"/>
                </a:cxn>
                <a:cxn ang="0">
                  <a:pos x="connsiteX219" y="connsiteY219"/>
                </a:cxn>
                <a:cxn ang="0">
                  <a:pos x="connsiteX220" y="connsiteY220"/>
                </a:cxn>
                <a:cxn ang="0">
                  <a:pos x="connsiteX221" y="connsiteY221"/>
                </a:cxn>
                <a:cxn ang="0">
                  <a:pos x="connsiteX222" y="connsiteY222"/>
                </a:cxn>
                <a:cxn ang="0">
                  <a:pos x="connsiteX223" y="connsiteY223"/>
                </a:cxn>
                <a:cxn ang="0">
                  <a:pos x="connsiteX224" y="connsiteY224"/>
                </a:cxn>
                <a:cxn ang="0">
                  <a:pos x="connsiteX225" y="connsiteY225"/>
                </a:cxn>
                <a:cxn ang="0">
                  <a:pos x="connsiteX226" y="connsiteY226"/>
                </a:cxn>
                <a:cxn ang="0">
                  <a:pos x="connsiteX227" y="connsiteY227"/>
                </a:cxn>
                <a:cxn ang="0">
                  <a:pos x="connsiteX228" y="connsiteY228"/>
                </a:cxn>
              </a:cxnLst>
              <a:rect l="l" t="t" r="r" b="b"/>
              <a:pathLst>
                <a:path w="2901950" h="1047863">
                  <a:moveTo>
                    <a:pt x="0" y="543038"/>
                  </a:moveTo>
                  <a:cubicBezTo>
                    <a:pt x="2303" y="548796"/>
                    <a:pt x="6847" y="563316"/>
                    <a:pt x="12700" y="568438"/>
                  </a:cubicBezTo>
                  <a:cubicBezTo>
                    <a:pt x="26137" y="580195"/>
                    <a:pt x="28193" y="579952"/>
                    <a:pt x="41275" y="584313"/>
                  </a:cubicBezTo>
                  <a:cubicBezTo>
                    <a:pt x="46919" y="592780"/>
                    <a:pt x="48688" y="596781"/>
                    <a:pt x="57150" y="603363"/>
                  </a:cubicBezTo>
                  <a:cubicBezTo>
                    <a:pt x="63174" y="608048"/>
                    <a:pt x="76200" y="616063"/>
                    <a:pt x="76200" y="616063"/>
                  </a:cubicBezTo>
                  <a:cubicBezTo>
                    <a:pt x="93133" y="641463"/>
                    <a:pt x="70908" y="610771"/>
                    <a:pt x="92075" y="631938"/>
                  </a:cubicBezTo>
                  <a:cubicBezTo>
                    <a:pt x="113242" y="653105"/>
                    <a:pt x="82550" y="630880"/>
                    <a:pt x="107950" y="647813"/>
                  </a:cubicBezTo>
                  <a:cubicBezTo>
                    <a:pt x="119683" y="665412"/>
                    <a:pt x="107587" y="651492"/>
                    <a:pt x="123825" y="660513"/>
                  </a:cubicBezTo>
                  <a:cubicBezTo>
                    <a:pt x="130496" y="664219"/>
                    <a:pt x="142875" y="673213"/>
                    <a:pt x="142875" y="673213"/>
                  </a:cubicBezTo>
                  <a:cubicBezTo>
                    <a:pt x="154608" y="690812"/>
                    <a:pt x="142512" y="676892"/>
                    <a:pt x="158750" y="685913"/>
                  </a:cubicBezTo>
                  <a:cubicBezTo>
                    <a:pt x="165421" y="689619"/>
                    <a:pt x="170560" y="696200"/>
                    <a:pt x="177800" y="698613"/>
                  </a:cubicBezTo>
                  <a:cubicBezTo>
                    <a:pt x="180975" y="699671"/>
                    <a:pt x="184249" y="700470"/>
                    <a:pt x="187325" y="701788"/>
                  </a:cubicBezTo>
                  <a:cubicBezTo>
                    <a:pt x="191675" y="703652"/>
                    <a:pt x="195916" y="705790"/>
                    <a:pt x="200025" y="708138"/>
                  </a:cubicBezTo>
                  <a:cubicBezTo>
                    <a:pt x="203338" y="710031"/>
                    <a:pt x="206063" y="712938"/>
                    <a:pt x="209550" y="714488"/>
                  </a:cubicBezTo>
                  <a:cubicBezTo>
                    <a:pt x="215667" y="717206"/>
                    <a:pt x="223031" y="717125"/>
                    <a:pt x="228600" y="720838"/>
                  </a:cubicBezTo>
                  <a:cubicBezTo>
                    <a:pt x="231775" y="722955"/>
                    <a:pt x="234712" y="725481"/>
                    <a:pt x="238125" y="727188"/>
                  </a:cubicBezTo>
                  <a:cubicBezTo>
                    <a:pt x="241118" y="728685"/>
                    <a:pt x="244724" y="728738"/>
                    <a:pt x="247650" y="730363"/>
                  </a:cubicBezTo>
                  <a:cubicBezTo>
                    <a:pt x="254321" y="734069"/>
                    <a:pt x="259460" y="740650"/>
                    <a:pt x="266700" y="743063"/>
                  </a:cubicBezTo>
                  <a:cubicBezTo>
                    <a:pt x="269875" y="744121"/>
                    <a:pt x="273299" y="744613"/>
                    <a:pt x="276225" y="746238"/>
                  </a:cubicBezTo>
                  <a:cubicBezTo>
                    <a:pt x="282896" y="749944"/>
                    <a:pt x="288035" y="756525"/>
                    <a:pt x="295275" y="758938"/>
                  </a:cubicBezTo>
                  <a:cubicBezTo>
                    <a:pt x="312040" y="764526"/>
                    <a:pt x="302015" y="760257"/>
                    <a:pt x="323850" y="774813"/>
                  </a:cubicBezTo>
                  <a:lnTo>
                    <a:pt x="333375" y="781163"/>
                  </a:lnTo>
                  <a:cubicBezTo>
                    <a:pt x="336550" y="783280"/>
                    <a:pt x="339280" y="786306"/>
                    <a:pt x="342900" y="787513"/>
                  </a:cubicBezTo>
                  <a:cubicBezTo>
                    <a:pt x="349250" y="789630"/>
                    <a:pt x="356381" y="790150"/>
                    <a:pt x="361950" y="793863"/>
                  </a:cubicBezTo>
                  <a:cubicBezTo>
                    <a:pt x="365125" y="795980"/>
                    <a:pt x="367988" y="798663"/>
                    <a:pt x="371475" y="800213"/>
                  </a:cubicBezTo>
                  <a:cubicBezTo>
                    <a:pt x="377592" y="802931"/>
                    <a:pt x="384956" y="802850"/>
                    <a:pt x="390525" y="806563"/>
                  </a:cubicBezTo>
                  <a:cubicBezTo>
                    <a:pt x="393700" y="808680"/>
                    <a:pt x="396563" y="811363"/>
                    <a:pt x="400050" y="812913"/>
                  </a:cubicBezTo>
                  <a:cubicBezTo>
                    <a:pt x="406167" y="815631"/>
                    <a:pt x="412750" y="817146"/>
                    <a:pt x="419100" y="819263"/>
                  </a:cubicBezTo>
                  <a:lnTo>
                    <a:pt x="428625" y="822438"/>
                  </a:lnTo>
                  <a:lnTo>
                    <a:pt x="466725" y="835138"/>
                  </a:lnTo>
                  <a:lnTo>
                    <a:pt x="476250" y="838313"/>
                  </a:lnTo>
                  <a:cubicBezTo>
                    <a:pt x="479425" y="839371"/>
                    <a:pt x="482493" y="840832"/>
                    <a:pt x="485775" y="841488"/>
                  </a:cubicBezTo>
                  <a:cubicBezTo>
                    <a:pt x="496687" y="843670"/>
                    <a:pt x="503888" y="844849"/>
                    <a:pt x="514350" y="847838"/>
                  </a:cubicBezTo>
                  <a:cubicBezTo>
                    <a:pt x="517568" y="848757"/>
                    <a:pt x="520657" y="850094"/>
                    <a:pt x="523875" y="851013"/>
                  </a:cubicBezTo>
                  <a:cubicBezTo>
                    <a:pt x="528071" y="852212"/>
                    <a:pt x="532395" y="852934"/>
                    <a:pt x="536575" y="854188"/>
                  </a:cubicBezTo>
                  <a:cubicBezTo>
                    <a:pt x="542986" y="856111"/>
                    <a:pt x="549275" y="858421"/>
                    <a:pt x="555625" y="860538"/>
                  </a:cubicBezTo>
                  <a:cubicBezTo>
                    <a:pt x="558800" y="861596"/>
                    <a:pt x="561903" y="862901"/>
                    <a:pt x="565150" y="863713"/>
                  </a:cubicBezTo>
                  <a:lnTo>
                    <a:pt x="590550" y="870063"/>
                  </a:lnTo>
                  <a:cubicBezTo>
                    <a:pt x="594783" y="871121"/>
                    <a:pt x="599110" y="871858"/>
                    <a:pt x="603250" y="873238"/>
                  </a:cubicBezTo>
                  <a:lnTo>
                    <a:pt x="641350" y="885938"/>
                  </a:lnTo>
                  <a:lnTo>
                    <a:pt x="650875" y="889113"/>
                  </a:lnTo>
                  <a:cubicBezTo>
                    <a:pt x="654050" y="890171"/>
                    <a:pt x="657153" y="891476"/>
                    <a:pt x="660400" y="892288"/>
                  </a:cubicBezTo>
                  <a:cubicBezTo>
                    <a:pt x="668867" y="894405"/>
                    <a:pt x="677521" y="895878"/>
                    <a:pt x="685800" y="898638"/>
                  </a:cubicBezTo>
                  <a:cubicBezTo>
                    <a:pt x="702565" y="904226"/>
                    <a:pt x="692540" y="899957"/>
                    <a:pt x="714375" y="914513"/>
                  </a:cubicBezTo>
                  <a:cubicBezTo>
                    <a:pt x="717550" y="916630"/>
                    <a:pt x="720280" y="919656"/>
                    <a:pt x="723900" y="920863"/>
                  </a:cubicBezTo>
                  <a:cubicBezTo>
                    <a:pt x="758638" y="932442"/>
                    <a:pt x="706021" y="913975"/>
                    <a:pt x="742950" y="930388"/>
                  </a:cubicBezTo>
                  <a:cubicBezTo>
                    <a:pt x="749067" y="933106"/>
                    <a:pt x="755650" y="934621"/>
                    <a:pt x="762000" y="936738"/>
                  </a:cubicBezTo>
                  <a:cubicBezTo>
                    <a:pt x="765175" y="937796"/>
                    <a:pt x="768740" y="938057"/>
                    <a:pt x="771525" y="939913"/>
                  </a:cubicBezTo>
                  <a:cubicBezTo>
                    <a:pt x="784681" y="948684"/>
                    <a:pt x="777348" y="945338"/>
                    <a:pt x="793750" y="949438"/>
                  </a:cubicBezTo>
                  <a:lnTo>
                    <a:pt x="866775" y="946263"/>
                  </a:lnTo>
                  <a:cubicBezTo>
                    <a:pt x="879498" y="945536"/>
                    <a:pt x="892229" y="944669"/>
                    <a:pt x="904875" y="943088"/>
                  </a:cubicBezTo>
                  <a:cubicBezTo>
                    <a:pt x="909205" y="942547"/>
                    <a:pt x="913217" y="940126"/>
                    <a:pt x="917575" y="939913"/>
                  </a:cubicBezTo>
                  <a:cubicBezTo>
                    <a:pt x="956701" y="938004"/>
                    <a:pt x="995892" y="937796"/>
                    <a:pt x="1035050" y="936738"/>
                  </a:cubicBezTo>
                  <a:cubicBezTo>
                    <a:pt x="1039119" y="935721"/>
                    <a:pt x="1052720" y="932665"/>
                    <a:pt x="1057275" y="930388"/>
                  </a:cubicBezTo>
                  <a:cubicBezTo>
                    <a:pt x="1060688" y="928681"/>
                    <a:pt x="1063313" y="925588"/>
                    <a:pt x="1066800" y="924038"/>
                  </a:cubicBezTo>
                  <a:lnTo>
                    <a:pt x="1095375" y="914513"/>
                  </a:lnTo>
                  <a:lnTo>
                    <a:pt x="1123950" y="904988"/>
                  </a:lnTo>
                  <a:lnTo>
                    <a:pt x="1133475" y="901813"/>
                  </a:lnTo>
                  <a:cubicBezTo>
                    <a:pt x="1136650" y="900755"/>
                    <a:pt x="1139699" y="899188"/>
                    <a:pt x="1143000" y="898638"/>
                  </a:cubicBezTo>
                  <a:cubicBezTo>
                    <a:pt x="1149350" y="897580"/>
                    <a:pt x="1155805" y="897024"/>
                    <a:pt x="1162050" y="895463"/>
                  </a:cubicBezTo>
                  <a:cubicBezTo>
                    <a:pt x="1168544" y="893840"/>
                    <a:pt x="1174750" y="891230"/>
                    <a:pt x="1181100" y="889113"/>
                  </a:cubicBezTo>
                  <a:lnTo>
                    <a:pt x="1200150" y="882763"/>
                  </a:lnTo>
                  <a:cubicBezTo>
                    <a:pt x="1234888" y="871184"/>
                    <a:pt x="1182271" y="889651"/>
                    <a:pt x="1219200" y="873238"/>
                  </a:cubicBezTo>
                  <a:cubicBezTo>
                    <a:pt x="1223781" y="871202"/>
                    <a:pt x="1243888" y="864800"/>
                    <a:pt x="1250950" y="863713"/>
                  </a:cubicBezTo>
                  <a:cubicBezTo>
                    <a:pt x="1260422" y="862256"/>
                    <a:pt x="1270000" y="861596"/>
                    <a:pt x="1279525" y="860538"/>
                  </a:cubicBezTo>
                  <a:cubicBezTo>
                    <a:pt x="1311521" y="863204"/>
                    <a:pt x="1311379" y="862145"/>
                    <a:pt x="1336675" y="866888"/>
                  </a:cubicBezTo>
                  <a:cubicBezTo>
                    <a:pt x="1347283" y="868877"/>
                    <a:pt x="1358186" y="869825"/>
                    <a:pt x="1368425" y="873238"/>
                  </a:cubicBezTo>
                  <a:lnTo>
                    <a:pt x="1387475" y="879588"/>
                  </a:lnTo>
                  <a:cubicBezTo>
                    <a:pt x="1390650" y="880646"/>
                    <a:pt x="1394215" y="880907"/>
                    <a:pt x="1397000" y="882763"/>
                  </a:cubicBezTo>
                  <a:cubicBezTo>
                    <a:pt x="1412094" y="892826"/>
                    <a:pt x="1402905" y="887906"/>
                    <a:pt x="1425575" y="895463"/>
                  </a:cubicBezTo>
                  <a:lnTo>
                    <a:pt x="1454150" y="904988"/>
                  </a:lnTo>
                  <a:lnTo>
                    <a:pt x="1463675" y="908163"/>
                  </a:lnTo>
                  <a:cubicBezTo>
                    <a:pt x="1466850" y="909221"/>
                    <a:pt x="1470415" y="909482"/>
                    <a:pt x="1473200" y="911338"/>
                  </a:cubicBezTo>
                  <a:cubicBezTo>
                    <a:pt x="1476375" y="913455"/>
                    <a:pt x="1479238" y="916138"/>
                    <a:pt x="1482725" y="917688"/>
                  </a:cubicBezTo>
                  <a:cubicBezTo>
                    <a:pt x="1488842" y="920406"/>
                    <a:pt x="1496206" y="920325"/>
                    <a:pt x="1501775" y="924038"/>
                  </a:cubicBezTo>
                  <a:cubicBezTo>
                    <a:pt x="1504950" y="926155"/>
                    <a:pt x="1507813" y="928838"/>
                    <a:pt x="1511300" y="930388"/>
                  </a:cubicBezTo>
                  <a:cubicBezTo>
                    <a:pt x="1517417" y="933106"/>
                    <a:pt x="1524000" y="934621"/>
                    <a:pt x="1530350" y="936738"/>
                  </a:cubicBezTo>
                  <a:lnTo>
                    <a:pt x="1549400" y="943088"/>
                  </a:lnTo>
                  <a:lnTo>
                    <a:pt x="1577975" y="952613"/>
                  </a:lnTo>
                  <a:cubicBezTo>
                    <a:pt x="1581150" y="953671"/>
                    <a:pt x="1584157" y="955621"/>
                    <a:pt x="1587500" y="955788"/>
                  </a:cubicBezTo>
                  <a:lnTo>
                    <a:pt x="1651000" y="958963"/>
                  </a:lnTo>
                  <a:cubicBezTo>
                    <a:pt x="1663873" y="961109"/>
                    <a:pt x="1670909" y="961761"/>
                    <a:pt x="1682750" y="965313"/>
                  </a:cubicBezTo>
                  <a:cubicBezTo>
                    <a:pt x="1689161" y="967236"/>
                    <a:pt x="1695450" y="969546"/>
                    <a:pt x="1701800" y="971663"/>
                  </a:cubicBezTo>
                  <a:lnTo>
                    <a:pt x="1720850" y="978013"/>
                  </a:lnTo>
                  <a:lnTo>
                    <a:pt x="1739900" y="984363"/>
                  </a:lnTo>
                  <a:cubicBezTo>
                    <a:pt x="1743075" y="985421"/>
                    <a:pt x="1746112" y="987065"/>
                    <a:pt x="1749425" y="987538"/>
                  </a:cubicBezTo>
                  <a:lnTo>
                    <a:pt x="1771650" y="990713"/>
                  </a:lnTo>
                  <a:cubicBezTo>
                    <a:pt x="1810793" y="1003761"/>
                    <a:pt x="1782760" y="995643"/>
                    <a:pt x="1876425" y="990713"/>
                  </a:cubicBezTo>
                  <a:cubicBezTo>
                    <a:pt x="1889166" y="990042"/>
                    <a:pt x="1902235" y="988050"/>
                    <a:pt x="1914525" y="984363"/>
                  </a:cubicBezTo>
                  <a:cubicBezTo>
                    <a:pt x="1920936" y="982440"/>
                    <a:pt x="1927225" y="980130"/>
                    <a:pt x="1933575" y="978013"/>
                  </a:cubicBezTo>
                  <a:lnTo>
                    <a:pt x="1943100" y="974838"/>
                  </a:lnTo>
                  <a:cubicBezTo>
                    <a:pt x="1946275" y="973780"/>
                    <a:pt x="1949632" y="973160"/>
                    <a:pt x="1952625" y="971663"/>
                  </a:cubicBezTo>
                  <a:cubicBezTo>
                    <a:pt x="1956858" y="969546"/>
                    <a:pt x="1960931" y="967071"/>
                    <a:pt x="1965325" y="965313"/>
                  </a:cubicBezTo>
                  <a:cubicBezTo>
                    <a:pt x="1971540" y="962827"/>
                    <a:pt x="1978025" y="961080"/>
                    <a:pt x="1984375" y="958963"/>
                  </a:cubicBezTo>
                  <a:cubicBezTo>
                    <a:pt x="1998040" y="954408"/>
                    <a:pt x="1990653" y="956600"/>
                    <a:pt x="2006600" y="952613"/>
                  </a:cubicBezTo>
                  <a:cubicBezTo>
                    <a:pt x="2021694" y="942550"/>
                    <a:pt x="2012505" y="947470"/>
                    <a:pt x="2035175" y="939913"/>
                  </a:cubicBezTo>
                  <a:cubicBezTo>
                    <a:pt x="2038350" y="938855"/>
                    <a:pt x="2041915" y="938594"/>
                    <a:pt x="2044700" y="936738"/>
                  </a:cubicBezTo>
                  <a:cubicBezTo>
                    <a:pt x="2047875" y="934621"/>
                    <a:pt x="2050738" y="931938"/>
                    <a:pt x="2054225" y="930388"/>
                  </a:cubicBezTo>
                  <a:cubicBezTo>
                    <a:pt x="2060342" y="927670"/>
                    <a:pt x="2067706" y="927751"/>
                    <a:pt x="2073275" y="924038"/>
                  </a:cubicBezTo>
                  <a:cubicBezTo>
                    <a:pt x="2076450" y="921921"/>
                    <a:pt x="2079387" y="919395"/>
                    <a:pt x="2082800" y="917688"/>
                  </a:cubicBezTo>
                  <a:cubicBezTo>
                    <a:pt x="2085793" y="916191"/>
                    <a:pt x="2089399" y="916138"/>
                    <a:pt x="2092325" y="914513"/>
                  </a:cubicBezTo>
                  <a:cubicBezTo>
                    <a:pt x="2098996" y="910807"/>
                    <a:pt x="2105025" y="906046"/>
                    <a:pt x="2111375" y="901813"/>
                  </a:cubicBezTo>
                  <a:lnTo>
                    <a:pt x="2130425" y="889113"/>
                  </a:lnTo>
                  <a:cubicBezTo>
                    <a:pt x="2133600" y="886996"/>
                    <a:pt x="2136537" y="884470"/>
                    <a:pt x="2139950" y="882763"/>
                  </a:cubicBezTo>
                  <a:cubicBezTo>
                    <a:pt x="2144183" y="880646"/>
                    <a:pt x="2148591" y="878848"/>
                    <a:pt x="2152650" y="876413"/>
                  </a:cubicBezTo>
                  <a:cubicBezTo>
                    <a:pt x="2179943" y="860037"/>
                    <a:pt x="2162066" y="866924"/>
                    <a:pt x="2181225" y="860538"/>
                  </a:cubicBezTo>
                  <a:cubicBezTo>
                    <a:pt x="2185458" y="857363"/>
                    <a:pt x="2189907" y="854457"/>
                    <a:pt x="2193925" y="851013"/>
                  </a:cubicBezTo>
                  <a:cubicBezTo>
                    <a:pt x="2197334" y="848091"/>
                    <a:pt x="2199714" y="843979"/>
                    <a:pt x="2203450" y="841488"/>
                  </a:cubicBezTo>
                  <a:cubicBezTo>
                    <a:pt x="2206235" y="839632"/>
                    <a:pt x="2209982" y="839810"/>
                    <a:pt x="2212975" y="838313"/>
                  </a:cubicBezTo>
                  <a:cubicBezTo>
                    <a:pt x="2216388" y="836606"/>
                    <a:pt x="2219087" y="833670"/>
                    <a:pt x="2222500" y="831963"/>
                  </a:cubicBezTo>
                  <a:cubicBezTo>
                    <a:pt x="2225493" y="830466"/>
                    <a:pt x="2229099" y="830413"/>
                    <a:pt x="2232025" y="828788"/>
                  </a:cubicBezTo>
                  <a:cubicBezTo>
                    <a:pt x="2238696" y="825082"/>
                    <a:pt x="2244725" y="820321"/>
                    <a:pt x="2251075" y="816088"/>
                  </a:cubicBezTo>
                  <a:cubicBezTo>
                    <a:pt x="2254250" y="813971"/>
                    <a:pt x="2257902" y="812436"/>
                    <a:pt x="2260600" y="809738"/>
                  </a:cubicBezTo>
                  <a:cubicBezTo>
                    <a:pt x="2275521" y="794817"/>
                    <a:pt x="2266389" y="802704"/>
                    <a:pt x="2289175" y="787513"/>
                  </a:cubicBezTo>
                  <a:lnTo>
                    <a:pt x="2298700" y="781163"/>
                  </a:lnTo>
                  <a:cubicBezTo>
                    <a:pt x="2300817" y="777988"/>
                    <a:pt x="2302178" y="774151"/>
                    <a:pt x="2305050" y="771638"/>
                  </a:cubicBezTo>
                  <a:cubicBezTo>
                    <a:pt x="2310793" y="766612"/>
                    <a:pt x="2324100" y="758938"/>
                    <a:pt x="2324100" y="758938"/>
                  </a:cubicBezTo>
                  <a:cubicBezTo>
                    <a:pt x="2342298" y="731641"/>
                    <a:pt x="2318067" y="763765"/>
                    <a:pt x="2339975" y="746238"/>
                  </a:cubicBezTo>
                  <a:cubicBezTo>
                    <a:pt x="2342955" y="743854"/>
                    <a:pt x="2343627" y="739411"/>
                    <a:pt x="2346325" y="736713"/>
                  </a:cubicBezTo>
                  <a:cubicBezTo>
                    <a:pt x="2349023" y="734015"/>
                    <a:pt x="2352675" y="732480"/>
                    <a:pt x="2355850" y="730363"/>
                  </a:cubicBezTo>
                  <a:cubicBezTo>
                    <a:pt x="2370406" y="708528"/>
                    <a:pt x="2361310" y="713726"/>
                    <a:pt x="2378075" y="708138"/>
                  </a:cubicBezTo>
                  <a:cubicBezTo>
                    <a:pt x="2384256" y="689595"/>
                    <a:pt x="2376414" y="706624"/>
                    <a:pt x="2390775" y="692263"/>
                  </a:cubicBezTo>
                  <a:cubicBezTo>
                    <a:pt x="2411942" y="671096"/>
                    <a:pt x="2381250" y="693321"/>
                    <a:pt x="2406650" y="676388"/>
                  </a:cubicBezTo>
                  <a:cubicBezTo>
                    <a:pt x="2421467" y="654163"/>
                    <a:pt x="2413000" y="661571"/>
                    <a:pt x="2428875" y="650988"/>
                  </a:cubicBezTo>
                  <a:cubicBezTo>
                    <a:pt x="2430992" y="647813"/>
                    <a:pt x="2432245" y="643847"/>
                    <a:pt x="2435225" y="641463"/>
                  </a:cubicBezTo>
                  <a:cubicBezTo>
                    <a:pt x="2437838" y="639372"/>
                    <a:pt x="2441824" y="639913"/>
                    <a:pt x="2444750" y="638288"/>
                  </a:cubicBezTo>
                  <a:cubicBezTo>
                    <a:pt x="2451421" y="634582"/>
                    <a:pt x="2458404" y="630984"/>
                    <a:pt x="2463800" y="625588"/>
                  </a:cubicBezTo>
                  <a:cubicBezTo>
                    <a:pt x="2475692" y="613696"/>
                    <a:pt x="2469065" y="617483"/>
                    <a:pt x="2482850" y="612888"/>
                  </a:cubicBezTo>
                  <a:cubicBezTo>
                    <a:pt x="2484967" y="609713"/>
                    <a:pt x="2486757" y="606294"/>
                    <a:pt x="2489200" y="603363"/>
                  </a:cubicBezTo>
                  <a:cubicBezTo>
                    <a:pt x="2496321" y="594818"/>
                    <a:pt x="2500570" y="594448"/>
                    <a:pt x="2505075" y="584313"/>
                  </a:cubicBezTo>
                  <a:cubicBezTo>
                    <a:pt x="2507793" y="578196"/>
                    <a:pt x="2509308" y="571613"/>
                    <a:pt x="2511425" y="565263"/>
                  </a:cubicBezTo>
                  <a:lnTo>
                    <a:pt x="2514600" y="555738"/>
                  </a:lnTo>
                  <a:cubicBezTo>
                    <a:pt x="2515658" y="552563"/>
                    <a:pt x="2516963" y="549460"/>
                    <a:pt x="2517775" y="546213"/>
                  </a:cubicBezTo>
                  <a:cubicBezTo>
                    <a:pt x="2518833" y="541980"/>
                    <a:pt x="2519751" y="537709"/>
                    <a:pt x="2520950" y="533513"/>
                  </a:cubicBezTo>
                  <a:cubicBezTo>
                    <a:pt x="2521869" y="530295"/>
                    <a:pt x="2523244" y="527217"/>
                    <a:pt x="2524125" y="523988"/>
                  </a:cubicBezTo>
                  <a:cubicBezTo>
                    <a:pt x="2534868" y="484599"/>
                    <a:pt x="2526342" y="510987"/>
                    <a:pt x="2533650" y="489063"/>
                  </a:cubicBezTo>
                  <a:cubicBezTo>
                    <a:pt x="2534708" y="479538"/>
                    <a:pt x="2536090" y="470043"/>
                    <a:pt x="2536825" y="460488"/>
                  </a:cubicBezTo>
                  <a:cubicBezTo>
                    <a:pt x="2538207" y="442518"/>
                    <a:pt x="2537669" y="424384"/>
                    <a:pt x="2540000" y="406513"/>
                  </a:cubicBezTo>
                  <a:cubicBezTo>
                    <a:pt x="2540866" y="399876"/>
                    <a:pt x="2544727" y="393957"/>
                    <a:pt x="2546350" y="387463"/>
                  </a:cubicBezTo>
                  <a:cubicBezTo>
                    <a:pt x="2547408" y="383230"/>
                    <a:pt x="2548578" y="379023"/>
                    <a:pt x="2549525" y="374763"/>
                  </a:cubicBezTo>
                  <a:cubicBezTo>
                    <a:pt x="2560884" y="323646"/>
                    <a:pt x="2542622" y="402926"/>
                    <a:pt x="2555875" y="336663"/>
                  </a:cubicBezTo>
                  <a:cubicBezTo>
                    <a:pt x="2556531" y="333381"/>
                    <a:pt x="2558238" y="330385"/>
                    <a:pt x="2559050" y="327138"/>
                  </a:cubicBezTo>
                  <a:cubicBezTo>
                    <a:pt x="2560359" y="321903"/>
                    <a:pt x="2560916" y="316498"/>
                    <a:pt x="2562225" y="311263"/>
                  </a:cubicBezTo>
                  <a:cubicBezTo>
                    <a:pt x="2563037" y="308016"/>
                    <a:pt x="2564481" y="304956"/>
                    <a:pt x="2565400" y="301738"/>
                  </a:cubicBezTo>
                  <a:cubicBezTo>
                    <a:pt x="2566599" y="297542"/>
                    <a:pt x="2567376" y="293234"/>
                    <a:pt x="2568575" y="289038"/>
                  </a:cubicBezTo>
                  <a:cubicBezTo>
                    <a:pt x="2569494" y="285820"/>
                    <a:pt x="2570831" y="282731"/>
                    <a:pt x="2571750" y="279513"/>
                  </a:cubicBezTo>
                  <a:cubicBezTo>
                    <a:pt x="2573106" y="274766"/>
                    <a:pt x="2575562" y="262363"/>
                    <a:pt x="2578100" y="257288"/>
                  </a:cubicBezTo>
                  <a:cubicBezTo>
                    <a:pt x="2579807" y="253875"/>
                    <a:pt x="2582333" y="250938"/>
                    <a:pt x="2584450" y="247763"/>
                  </a:cubicBezTo>
                  <a:cubicBezTo>
                    <a:pt x="2585467" y="243694"/>
                    <a:pt x="2588523" y="230093"/>
                    <a:pt x="2590800" y="225538"/>
                  </a:cubicBezTo>
                  <a:cubicBezTo>
                    <a:pt x="2592507" y="222125"/>
                    <a:pt x="2595443" y="219426"/>
                    <a:pt x="2597150" y="216013"/>
                  </a:cubicBezTo>
                  <a:cubicBezTo>
                    <a:pt x="2599688" y="210938"/>
                    <a:pt x="2602144" y="198535"/>
                    <a:pt x="2603500" y="193788"/>
                  </a:cubicBezTo>
                  <a:cubicBezTo>
                    <a:pt x="2608820" y="175167"/>
                    <a:pt x="2603748" y="193291"/>
                    <a:pt x="2613025" y="174738"/>
                  </a:cubicBezTo>
                  <a:cubicBezTo>
                    <a:pt x="2614522" y="171745"/>
                    <a:pt x="2614575" y="168139"/>
                    <a:pt x="2616200" y="165213"/>
                  </a:cubicBezTo>
                  <a:cubicBezTo>
                    <a:pt x="2619906" y="158542"/>
                    <a:pt x="2625487" y="152989"/>
                    <a:pt x="2628900" y="146163"/>
                  </a:cubicBezTo>
                  <a:cubicBezTo>
                    <a:pt x="2631017" y="141930"/>
                    <a:pt x="2633386" y="137813"/>
                    <a:pt x="2635250" y="133463"/>
                  </a:cubicBezTo>
                  <a:cubicBezTo>
                    <a:pt x="2636568" y="130387"/>
                    <a:pt x="2636800" y="126864"/>
                    <a:pt x="2638425" y="123938"/>
                  </a:cubicBezTo>
                  <a:cubicBezTo>
                    <a:pt x="2658844" y="87183"/>
                    <a:pt x="2642652" y="118503"/>
                    <a:pt x="2660650" y="95363"/>
                  </a:cubicBezTo>
                  <a:cubicBezTo>
                    <a:pt x="2680596" y="69719"/>
                    <a:pt x="2664436" y="82256"/>
                    <a:pt x="2682875" y="69963"/>
                  </a:cubicBezTo>
                  <a:cubicBezTo>
                    <a:pt x="2699808" y="44563"/>
                    <a:pt x="2677583" y="75255"/>
                    <a:pt x="2698750" y="54088"/>
                  </a:cubicBezTo>
                  <a:cubicBezTo>
                    <a:pt x="2701448" y="51390"/>
                    <a:pt x="2702402" y="47261"/>
                    <a:pt x="2705100" y="44563"/>
                  </a:cubicBezTo>
                  <a:cubicBezTo>
                    <a:pt x="2707798" y="41865"/>
                    <a:pt x="2711773" y="40748"/>
                    <a:pt x="2714625" y="38213"/>
                  </a:cubicBezTo>
                  <a:cubicBezTo>
                    <a:pt x="2762911" y="-4708"/>
                    <a:pt x="2715142" y="30017"/>
                    <a:pt x="2743200" y="15988"/>
                  </a:cubicBezTo>
                  <a:cubicBezTo>
                    <a:pt x="2773389" y="894"/>
                    <a:pt x="2722628" y="19670"/>
                    <a:pt x="2771775" y="3288"/>
                  </a:cubicBezTo>
                  <a:lnTo>
                    <a:pt x="2781300" y="113"/>
                  </a:lnTo>
                  <a:cubicBezTo>
                    <a:pt x="2784454" y="299"/>
                    <a:pt x="2828235" y="-1820"/>
                    <a:pt x="2844800" y="6463"/>
                  </a:cubicBezTo>
                  <a:cubicBezTo>
                    <a:pt x="2848213" y="8170"/>
                    <a:pt x="2851150" y="10696"/>
                    <a:pt x="2854325" y="12813"/>
                  </a:cubicBezTo>
                  <a:cubicBezTo>
                    <a:pt x="2877016" y="46850"/>
                    <a:pt x="2841679" y="-4807"/>
                    <a:pt x="2870200" y="31863"/>
                  </a:cubicBezTo>
                  <a:cubicBezTo>
                    <a:pt x="2874885" y="37887"/>
                    <a:pt x="2878667" y="44563"/>
                    <a:pt x="2882900" y="50913"/>
                  </a:cubicBezTo>
                  <a:cubicBezTo>
                    <a:pt x="2885017" y="54088"/>
                    <a:pt x="2888043" y="56818"/>
                    <a:pt x="2889250" y="60438"/>
                  </a:cubicBezTo>
                  <a:lnTo>
                    <a:pt x="2898775" y="89013"/>
                  </a:lnTo>
                  <a:lnTo>
                    <a:pt x="2901950" y="98538"/>
                  </a:lnTo>
                  <a:cubicBezTo>
                    <a:pt x="2900892" y="118646"/>
                    <a:pt x="2900519" y="138803"/>
                    <a:pt x="2898775" y="158863"/>
                  </a:cubicBezTo>
                  <a:cubicBezTo>
                    <a:pt x="2898103" y="166590"/>
                    <a:pt x="2890650" y="185012"/>
                    <a:pt x="2889250" y="190613"/>
                  </a:cubicBezTo>
                  <a:cubicBezTo>
                    <a:pt x="2879324" y="230315"/>
                    <a:pt x="2892010" y="180954"/>
                    <a:pt x="2882900" y="212838"/>
                  </a:cubicBezTo>
                  <a:cubicBezTo>
                    <a:pt x="2873303" y="246427"/>
                    <a:pt x="2888465" y="199317"/>
                    <a:pt x="2873375" y="244588"/>
                  </a:cubicBezTo>
                  <a:cubicBezTo>
                    <a:pt x="2872317" y="247763"/>
                    <a:pt x="2872056" y="251328"/>
                    <a:pt x="2870200" y="254113"/>
                  </a:cubicBezTo>
                  <a:cubicBezTo>
                    <a:pt x="2855009" y="276899"/>
                    <a:pt x="2862896" y="267767"/>
                    <a:pt x="2847975" y="282688"/>
                  </a:cubicBezTo>
                  <a:cubicBezTo>
                    <a:pt x="2846917" y="285863"/>
                    <a:pt x="2846425" y="289287"/>
                    <a:pt x="2844800" y="292213"/>
                  </a:cubicBezTo>
                  <a:cubicBezTo>
                    <a:pt x="2835306" y="309303"/>
                    <a:pt x="2834145" y="309218"/>
                    <a:pt x="2822575" y="320788"/>
                  </a:cubicBezTo>
                  <a:cubicBezTo>
                    <a:pt x="2814595" y="344729"/>
                    <a:pt x="2826288" y="316147"/>
                    <a:pt x="2809875" y="336663"/>
                  </a:cubicBezTo>
                  <a:cubicBezTo>
                    <a:pt x="2792348" y="358571"/>
                    <a:pt x="2824472" y="334340"/>
                    <a:pt x="2797175" y="352538"/>
                  </a:cubicBezTo>
                  <a:cubicBezTo>
                    <a:pt x="2790248" y="373320"/>
                    <a:pt x="2799869" y="352923"/>
                    <a:pt x="2784475" y="365238"/>
                  </a:cubicBezTo>
                  <a:cubicBezTo>
                    <a:pt x="2781495" y="367622"/>
                    <a:pt x="2780823" y="372065"/>
                    <a:pt x="2778125" y="374763"/>
                  </a:cubicBezTo>
                  <a:cubicBezTo>
                    <a:pt x="2775427" y="377461"/>
                    <a:pt x="2771775" y="378996"/>
                    <a:pt x="2768600" y="381113"/>
                  </a:cubicBezTo>
                  <a:cubicBezTo>
                    <a:pt x="2760133" y="406513"/>
                    <a:pt x="2772833" y="376880"/>
                    <a:pt x="2755900" y="393813"/>
                  </a:cubicBezTo>
                  <a:cubicBezTo>
                    <a:pt x="2753533" y="396180"/>
                    <a:pt x="2754816" y="400725"/>
                    <a:pt x="2752725" y="403338"/>
                  </a:cubicBezTo>
                  <a:cubicBezTo>
                    <a:pt x="2750341" y="406318"/>
                    <a:pt x="2746375" y="407571"/>
                    <a:pt x="2743200" y="409688"/>
                  </a:cubicBezTo>
                  <a:cubicBezTo>
                    <a:pt x="2741083" y="412863"/>
                    <a:pt x="2739548" y="416515"/>
                    <a:pt x="2736850" y="419213"/>
                  </a:cubicBezTo>
                  <a:cubicBezTo>
                    <a:pt x="2734152" y="421911"/>
                    <a:pt x="2729838" y="422691"/>
                    <a:pt x="2727325" y="425563"/>
                  </a:cubicBezTo>
                  <a:cubicBezTo>
                    <a:pt x="2706347" y="449538"/>
                    <a:pt x="2724681" y="441261"/>
                    <a:pt x="2705100" y="447788"/>
                  </a:cubicBezTo>
                  <a:cubicBezTo>
                    <a:pt x="2704042" y="450963"/>
                    <a:pt x="2704292" y="454946"/>
                    <a:pt x="2701925" y="457313"/>
                  </a:cubicBezTo>
                  <a:cubicBezTo>
                    <a:pt x="2696529" y="462709"/>
                    <a:pt x="2682875" y="470013"/>
                    <a:pt x="2682875" y="470013"/>
                  </a:cubicBezTo>
                  <a:cubicBezTo>
                    <a:pt x="2681817" y="473188"/>
                    <a:pt x="2681197" y="476545"/>
                    <a:pt x="2679700" y="479538"/>
                  </a:cubicBezTo>
                  <a:cubicBezTo>
                    <a:pt x="2675280" y="488379"/>
                    <a:pt x="2670847" y="491566"/>
                    <a:pt x="2663825" y="498588"/>
                  </a:cubicBezTo>
                  <a:cubicBezTo>
                    <a:pt x="2655845" y="522529"/>
                    <a:pt x="2667538" y="493947"/>
                    <a:pt x="2651125" y="514463"/>
                  </a:cubicBezTo>
                  <a:cubicBezTo>
                    <a:pt x="2649034" y="517076"/>
                    <a:pt x="2649806" y="521203"/>
                    <a:pt x="2647950" y="523988"/>
                  </a:cubicBezTo>
                  <a:cubicBezTo>
                    <a:pt x="2645459" y="527724"/>
                    <a:pt x="2641182" y="529969"/>
                    <a:pt x="2638425" y="533513"/>
                  </a:cubicBezTo>
                  <a:cubicBezTo>
                    <a:pt x="2618479" y="559157"/>
                    <a:pt x="2634639" y="546620"/>
                    <a:pt x="2616200" y="558913"/>
                  </a:cubicBezTo>
                  <a:cubicBezTo>
                    <a:pt x="2611967" y="565263"/>
                    <a:pt x="2605913" y="570723"/>
                    <a:pt x="2603500" y="577963"/>
                  </a:cubicBezTo>
                  <a:cubicBezTo>
                    <a:pt x="2602442" y="581138"/>
                    <a:pt x="2601950" y="584562"/>
                    <a:pt x="2600325" y="587488"/>
                  </a:cubicBezTo>
                  <a:cubicBezTo>
                    <a:pt x="2596619" y="594159"/>
                    <a:pt x="2590038" y="599298"/>
                    <a:pt x="2587625" y="606538"/>
                  </a:cubicBezTo>
                  <a:cubicBezTo>
                    <a:pt x="2586567" y="609713"/>
                    <a:pt x="2586075" y="613137"/>
                    <a:pt x="2584450" y="616063"/>
                  </a:cubicBezTo>
                  <a:cubicBezTo>
                    <a:pt x="2580744" y="622734"/>
                    <a:pt x="2574163" y="627873"/>
                    <a:pt x="2571750" y="635113"/>
                  </a:cubicBezTo>
                  <a:cubicBezTo>
                    <a:pt x="2570692" y="638288"/>
                    <a:pt x="2570666" y="642025"/>
                    <a:pt x="2568575" y="644638"/>
                  </a:cubicBezTo>
                  <a:cubicBezTo>
                    <a:pt x="2566191" y="647618"/>
                    <a:pt x="2562225" y="648871"/>
                    <a:pt x="2559050" y="650988"/>
                  </a:cubicBezTo>
                  <a:cubicBezTo>
                    <a:pt x="2555741" y="660914"/>
                    <a:pt x="2552533" y="673325"/>
                    <a:pt x="2543175" y="679563"/>
                  </a:cubicBezTo>
                  <a:lnTo>
                    <a:pt x="2533650" y="685913"/>
                  </a:lnTo>
                  <a:cubicBezTo>
                    <a:pt x="2530341" y="695839"/>
                    <a:pt x="2527133" y="708250"/>
                    <a:pt x="2517775" y="714488"/>
                  </a:cubicBezTo>
                  <a:lnTo>
                    <a:pt x="2508250" y="720838"/>
                  </a:lnTo>
                  <a:cubicBezTo>
                    <a:pt x="2502069" y="739381"/>
                    <a:pt x="2509911" y="722352"/>
                    <a:pt x="2495550" y="736713"/>
                  </a:cubicBezTo>
                  <a:cubicBezTo>
                    <a:pt x="2492852" y="739411"/>
                    <a:pt x="2491643" y="743307"/>
                    <a:pt x="2489200" y="746238"/>
                  </a:cubicBezTo>
                  <a:cubicBezTo>
                    <a:pt x="2481560" y="755405"/>
                    <a:pt x="2479516" y="755869"/>
                    <a:pt x="2470150" y="762113"/>
                  </a:cubicBezTo>
                  <a:cubicBezTo>
                    <a:pt x="2468033" y="765288"/>
                    <a:pt x="2466672" y="769125"/>
                    <a:pt x="2463800" y="771638"/>
                  </a:cubicBezTo>
                  <a:cubicBezTo>
                    <a:pt x="2458057" y="776664"/>
                    <a:pt x="2444750" y="784338"/>
                    <a:pt x="2444750" y="784338"/>
                  </a:cubicBezTo>
                  <a:cubicBezTo>
                    <a:pt x="2431665" y="803965"/>
                    <a:pt x="2446193" y="784819"/>
                    <a:pt x="2428875" y="800213"/>
                  </a:cubicBezTo>
                  <a:cubicBezTo>
                    <a:pt x="2422163" y="806179"/>
                    <a:pt x="2414806" y="811791"/>
                    <a:pt x="2409825" y="819263"/>
                  </a:cubicBezTo>
                  <a:cubicBezTo>
                    <a:pt x="2407708" y="822438"/>
                    <a:pt x="2406173" y="826090"/>
                    <a:pt x="2403475" y="828788"/>
                  </a:cubicBezTo>
                  <a:cubicBezTo>
                    <a:pt x="2400777" y="831486"/>
                    <a:pt x="2397125" y="833021"/>
                    <a:pt x="2393950" y="835138"/>
                  </a:cubicBezTo>
                  <a:cubicBezTo>
                    <a:pt x="2377017" y="860538"/>
                    <a:pt x="2399242" y="829846"/>
                    <a:pt x="2378075" y="851013"/>
                  </a:cubicBezTo>
                  <a:cubicBezTo>
                    <a:pt x="2375377" y="853711"/>
                    <a:pt x="2374168" y="857607"/>
                    <a:pt x="2371725" y="860538"/>
                  </a:cubicBezTo>
                  <a:cubicBezTo>
                    <a:pt x="2368850" y="863987"/>
                    <a:pt x="2364957" y="866519"/>
                    <a:pt x="2362200" y="870063"/>
                  </a:cubicBezTo>
                  <a:cubicBezTo>
                    <a:pt x="2344368" y="892989"/>
                    <a:pt x="2358176" y="886221"/>
                    <a:pt x="2339975" y="892288"/>
                  </a:cubicBezTo>
                  <a:cubicBezTo>
                    <a:pt x="2333794" y="910831"/>
                    <a:pt x="2341636" y="893802"/>
                    <a:pt x="2327275" y="908163"/>
                  </a:cubicBezTo>
                  <a:cubicBezTo>
                    <a:pt x="2324577" y="910861"/>
                    <a:pt x="2323368" y="914757"/>
                    <a:pt x="2320925" y="917688"/>
                  </a:cubicBezTo>
                  <a:cubicBezTo>
                    <a:pt x="2311793" y="928646"/>
                    <a:pt x="2304050" y="930214"/>
                    <a:pt x="2298700" y="946263"/>
                  </a:cubicBezTo>
                  <a:lnTo>
                    <a:pt x="2286000" y="984363"/>
                  </a:lnTo>
                  <a:cubicBezTo>
                    <a:pt x="2284942" y="987538"/>
                    <a:pt x="2284681" y="991103"/>
                    <a:pt x="2282825" y="993888"/>
                  </a:cubicBezTo>
                  <a:lnTo>
                    <a:pt x="2276475" y="1003413"/>
                  </a:lnTo>
                  <a:cubicBezTo>
                    <a:pt x="2279731" y="1045743"/>
                    <a:pt x="2279650" y="1030889"/>
                    <a:pt x="2279650" y="1047863"/>
                  </a:cubicBezTo>
                </a:path>
              </a:pathLst>
            </a:custGeom>
            <a:noFill/>
            <a:ln w="38100">
              <a:solidFill>
                <a:schemeClr val="bg1"/>
              </a:solidFill>
              <a:prstDash val="sysDot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9666"/>
            </a:p>
          </p:txBody>
        </p:sp>
        <p:sp>
          <p:nvSpPr>
            <p:cNvPr id="38" name="Freeform 37"/>
            <p:cNvSpPr/>
            <p:nvPr/>
          </p:nvSpPr>
          <p:spPr>
            <a:xfrm>
              <a:off x="7267071" y="1982067"/>
              <a:ext cx="1875931" cy="1691723"/>
            </a:xfrm>
            <a:custGeom>
              <a:avLst/>
              <a:gdLst>
                <a:gd name="connsiteX0" fmla="*/ 0 w 1956606"/>
                <a:gd name="connsiteY0" fmla="*/ 1022350 h 1638300"/>
                <a:gd name="connsiteX1" fmla="*/ 34925 w 1956606"/>
                <a:gd name="connsiteY1" fmla="*/ 1044575 h 1638300"/>
                <a:gd name="connsiteX2" fmla="*/ 44450 w 1956606"/>
                <a:gd name="connsiteY2" fmla="*/ 1050925 h 1638300"/>
                <a:gd name="connsiteX3" fmla="*/ 76200 w 1956606"/>
                <a:gd name="connsiteY3" fmla="*/ 1060450 h 1638300"/>
                <a:gd name="connsiteX4" fmla="*/ 117475 w 1956606"/>
                <a:gd name="connsiteY4" fmla="*/ 1063625 h 1638300"/>
                <a:gd name="connsiteX5" fmla="*/ 133350 w 1956606"/>
                <a:gd name="connsiteY5" fmla="*/ 1066800 h 1638300"/>
                <a:gd name="connsiteX6" fmla="*/ 161925 w 1956606"/>
                <a:gd name="connsiteY6" fmla="*/ 1076325 h 1638300"/>
                <a:gd name="connsiteX7" fmla="*/ 171450 w 1956606"/>
                <a:gd name="connsiteY7" fmla="*/ 1079500 h 1638300"/>
                <a:gd name="connsiteX8" fmla="*/ 180975 w 1956606"/>
                <a:gd name="connsiteY8" fmla="*/ 1082675 h 1638300"/>
                <a:gd name="connsiteX9" fmla="*/ 190500 w 1956606"/>
                <a:gd name="connsiteY9" fmla="*/ 1111250 h 1638300"/>
                <a:gd name="connsiteX10" fmla="*/ 193675 w 1956606"/>
                <a:gd name="connsiteY10" fmla="*/ 1120775 h 1638300"/>
                <a:gd name="connsiteX11" fmla="*/ 206375 w 1956606"/>
                <a:gd name="connsiteY11" fmla="*/ 1171575 h 1638300"/>
                <a:gd name="connsiteX12" fmla="*/ 219075 w 1956606"/>
                <a:gd name="connsiteY12" fmla="*/ 1190625 h 1638300"/>
                <a:gd name="connsiteX13" fmla="*/ 222250 w 1956606"/>
                <a:gd name="connsiteY13" fmla="*/ 1200150 h 1638300"/>
                <a:gd name="connsiteX14" fmla="*/ 241300 w 1956606"/>
                <a:gd name="connsiteY14" fmla="*/ 1219200 h 1638300"/>
                <a:gd name="connsiteX15" fmla="*/ 250825 w 1956606"/>
                <a:gd name="connsiteY15" fmla="*/ 1231900 h 1638300"/>
                <a:gd name="connsiteX16" fmla="*/ 260350 w 1956606"/>
                <a:gd name="connsiteY16" fmla="*/ 1235075 h 1638300"/>
                <a:gd name="connsiteX17" fmla="*/ 276225 w 1956606"/>
                <a:gd name="connsiteY17" fmla="*/ 1247775 h 1638300"/>
                <a:gd name="connsiteX18" fmla="*/ 285750 w 1956606"/>
                <a:gd name="connsiteY18" fmla="*/ 1257300 h 1638300"/>
                <a:gd name="connsiteX19" fmla="*/ 304800 w 1956606"/>
                <a:gd name="connsiteY19" fmla="*/ 1270000 h 1638300"/>
                <a:gd name="connsiteX20" fmla="*/ 320675 w 1956606"/>
                <a:gd name="connsiteY20" fmla="*/ 1285875 h 1638300"/>
                <a:gd name="connsiteX21" fmla="*/ 330200 w 1956606"/>
                <a:gd name="connsiteY21" fmla="*/ 1295400 h 1638300"/>
                <a:gd name="connsiteX22" fmla="*/ 339725 w 1956606"/>
                <a:gd name="connsiteY22" fmla="*/ 1298575 h 1638300"/>
                <a:gd name="connsiteX23" fmla="*/ 358775 w 1956606"/>
                <a:gd name="connsiteY23" fmla="*/ 1311275 h 1638300"/>
                <a:gd name="connsiteX24" fmla="*/ 396875 w 1956606"/>
                <a:gd name="connsiteY24" fmla="*/ 1336675 h 1638300"/>
                <a:gd name="connsiteX25" fmla="*/ 406400 w 1956606"/>
                <a:gd name="connsiteY25" fmla="*/ 1343025 h 1638300"/>
                <a:gd name="connsiteX26" fmla="*/ 415925 w 1956606"/>
                <a:gd name="connsiteY26" fmla="*/ 1349375 h 1638300"/>
                <a:gd name="connsiteX27" fmla="*/ 425450 w 1956606"/>
                <a:gd name="connsiteY27" fmla="*/ 1352550 h 1638300"/>
                <a:gd name="connsiteX28" fmla="*/ 441325 w 1956606"/>
                <a:gd name="connsiteY28" fmla="*/ 1365250 h 1638300"/>
                <a:gd name="connsiteX29" fmla="*/ 460375 w 1956606"/>
                <a:gd name="connsiteY29" fmla="*/ 1377950 h 1638300"/>
                <a:gd name="connsiteX30" fmla="*/ 469900 w 1956606"/>
                <a:gd name="connsiteY30" fmla="*/ 1384300 h 1638300"/>
                <a:gd name="connsiteX31" fmla="*/ 488950 w 1956606"/>
                <a:gd name="connsiteY31" fmla="*/ 1390650 h 1638300"/>
                <a:gd name="connsiteX32" fmla="*/ 498475 w 1956606"/>
                <a:gd name="connsiteY32" fmla="*/ 1393825 h 1638300"/>
                <a:gd name="connsiteX33" fmla="*/ 511175 w 1956606"/>
                <a:gd name="connsiteY33" fmla="*/ 1400175 h 1638300"/>
                <a:gd name="connsiteX34" fmla="*/ 520700 w 1956606"/>
                <a:gd name="connsiteY34" fmla="*/ 1403350 h 1638300"/>
                <a:gd name="connsiteX35" fmla="*/ 530225 w 1956606"/>
                <a:gd name="connsiteY35" fmla="*/ 1409700 h 1638300"/>
                <a:gd name="connsiteX36" fmla="*/ 539750 w 1956606"/>
                <a:gd name="connsiteY36" fmla="*/ 1412875 h 1638300"/>
                <a:gd name="connsiteX37" fmla="*/ 558800 w 1956606"/>
                <a:gd name="connsiteY37" fmla="*/ 1425575 h 1638300"/>
                <a:gd name="connsiteX38" fmla="*/ 577850 w 1956606"/>
                <a:gd name="connsiteY38" fmla="*/ 1435100 h 1638300"/>
                <a:gd name="connsiteX39" fmla="*/ 587375 w 1956606"/>
                <a:gd name="connsiteY39" fmla="*/ 1438275 h 1638300"/>
                <a:gd name="connsiteX40" fmla="*/ 606425 w 1956606"/>
                <a:gd name="connsiteY40" fmla="*/ 1450975 h 1638300"/>
                <a:gd name="connsiteX41" fmla="*/ 625475 w 1956606"/>
                <a:gd name="connsiteY41" fmla="*/ 1460500 h 1638300"/>
                <a:gd name="connsiteX42" fmla="*/ 647700 w 1956606"/>
                <a:gd name="connsiteY42" fmla="*/ 1466850 h 1638300"/>
                <a:gd name="connsiteX43" fmla="*/ 666750 w 1956606"/>
                <a:gd name="connsiteY43" fmla="*/ 1473200 h 1638300"/>
                <a:gd name="connsiteX44" fmla="*/ 682625 w 1956606"/>
                <a:gd name="connsiteY44" fmla="*/ 1476375 h 1638300"/>
                <a:gd name="connsiteX45" fmla="*/ 701675 w 1956606"/>
                <a:gd name="connsiteY45" fmla="*/ 1482725 h 1638300"/>
                <a:gd name="connsiteX46" fmla="*/ 758825 w 1956606"/>
                <a:gd name="connsiteY46" fmla="*/ 1489075 h 1638300"/>
                <a:gd name="connsiteX47" fmla="*/ 768350 w 1956606"/>
                <a:gd name="connsiteY47" fmla="*/ 1492250 h 1638300"/>
                <a:gd name="connsiteX48" fmla="*/ 774700 w 1956606"/>
                <a:gd name="connsiteY48" fmla="*/ 1501775 h 1638300"/>
                <a:gd name="connsiteX49" fmla="*/ 784225 w 1956606"/>
                <a:gd name="connsiteY49" fmla="*/ 1511300 h 1638300"/>
                <a:gd name="connsiteX50" fmla="*/ 806450 w 1956606"/>
                <a:gd name="connsiteY50" fmla="*/ 1536700 h 1638300"/>
                <a:gd name="connsiteX51" fmla="*/ 831850 w 1956606"/>
                <a:gd name="connsiteY51" fmla="*/ 1552575 h 1638300"/>
                <a:gd name="connsiteX52" fmla="*/ 850900 w 1956606"/>
                <a:gd name="connsiteY52" fmla="*/ 1565275 h 1638300"/>
                <a:gd name="connsiteX53" fmla="*/ 860425 w 1956606"/>
                <a:gd name="connsiteY53" fmla="*/ 1568450 h 1638300"/>
                <a:gd name="connsiteX54" fmla="*/ 869950 w 1956606"/>
                <a:gd name="connsiteY54" fmla="*/ 1574800 h 1638300"/>
                <a:gd name="connsiteX55" fmla="*/ 889000 w 1956606"/>
                <a:gd name="connsiteY55" fmla="*/ 1581150 h 1638300"/>
                <a:gd name="connsiteX56" fmla="*/ 898525 w 1956606"/>
                <a:gd name="connsiteY56" fmla="*/ 1584325 h 1638300"/>
                <a:gd name="connsiteX57" fmla="*/ 908050 w 1956606"/>
                <a:gd name="connsiteY57" fmla="*/ 1590675 h 1638300"/>
                <a:gd name="connsiteX58" fmla="*/ 933450 w 1956606"/>
                <a:gd name="connsiteY58" fmla="*/ 1597025 h 1638300"/>
                <a:gd name="connsiteX59" fmla="*/ 952500 w 1956606"/>
                <a:gd name="connsiteY59" fmla="*/ 1603375 h 1638300"/>
                <a:gd name="connsiteX60" fmla="*/ 981075 w 1956606"/>
                <a:gd name="connsiteY60" fmla="*/ 1612900 h 1638300"/>
                <a:gd name="connsiteX61" fmla="*/ 990600 w 1956606"/>
                <a:gd name="connsiteY61" fmla="*/ 1616075 h 1638300"/>
                <a:gd name="connsiteX62" fmla="*/ 1009650 w 1956606"/>
                <a:gd name="connsiteY62" fmla="*/ 1619250 h 1638300"/>
                <a:gd name="connsiteX63" fmla="*/ 1031875 w 1956606"/>
                <a:gd name="connsiteY63" fmla="*/ 1622425 h 1638300"/>
                <a:gd name="connsiteX64" fmla="*/ 1044575 w 1956606"/>
                <a:gd name="connsiteY64" fmla="*/ 1625600 h 1638300"/>
                <a:gd name="connsiteX65" fmla="*/ 1069975 w 1956606"/>
                <a:gd name="connsiteY65" fmla="*/ 1628775 h 1638300"/>
                <a:gd name="connsiteX66" fmla="*/ 1146175 w 1956606"/>
                <a:gd name="connsiteY66" fmla="*/ 1638300 h 1638300"/>
                <a:gd name="connsiteX67" fmla="*/ 1390650 w 1956606"/>
                <a:gd name="connsiteY67" fmla="*/ 1638300 h 1638300"/>
                <a:gd name="connsiteX68" fmla="*/ 1628775 w 1956606"/>
                <a:gd name="connsiteY68" fmla="*/ 1635125 h 1638300"/>
                <a:gd name="connsiteX69" fmla="*/ 1689100 w 1956606"/>
                <a:gd name="connsiteY69" fmla="*/ 1628775 h 1638300"/>
                <a:gd name="connsiteX70" fmla="*/ 1704975 w 1956606"/>
                <a:gd name="connsiteY70" fmla="*/ 1625600 h 1638300"/>
                <a:gd name="connsiteX71" fmla="*/ 1724025 w 1956606"/>
                <a:gd name="connsiteY71" fmla="*/ 1619250 h 1638300"/>
                <a:gd name="connsiteX72" fmla="*/ 1733550 w 1956606"/>
                <a:gd name="connsiteY72" fmla="*/ 1612900 h 1638300"/>
                <a:gd name="connsiteX73" fmla="*/ 1739900 w 1956606"/>
                <a:gd name="connsiteY73" fmla="*/ 1603375 h 1638300"/>
                <a:gd name="connsiteX74" fmla="*/ 1746250 w 1956606"/>
                <a:gd name="connsiteY74" fmla="*/ 1562100 h 1638300"/>
                <a:gd name="connsiteX75" fmla="*/ 1752600 w 1956606"/>
                <a:gd name="connsiteY75" fmla="*/ 1533525 h 1638300"/>
                <a:gd name="connsiteX76" fmla="*/ 1762125 w 1956606"/>
                <a:gd name="connsiteY76" fmla="*/ 1514475 h 1638300"/>
                <a:gd name="connsiteX77" fmla="*/ 1765300 w 1956606"/>
                <a:gd name="connsiteY77" fmla="*/ 1504950 h 1638300"/>
                <a:gd name="connsiteX78" fmla="*/ 1784350 w 1956606"/>
                <a:gd name="connsiteY78" fmla="*/ 1498600 h 1638300"/>
                <a:gd name="connsiteX79" fmla="*/ 1812925 w 1956606"/>
                <a:gd name="connsiteY79" fmla="*/ 1485900 h 1638300"/>
                <a:gd name="connsiteX80" fmla="*/ 1822450 w 1956606"/>
                <a:gd name="connsiteY80" fmla="*/ 1482725 h 1638300"/>
                <a:gd name="connsiteX81" fmla="*/ 1841500 w 1956606"/>
                <a:gd name="connsiteY81" fmla="*/ 1470025 h 1638300"/>
                <a:gd name="connsiteX82" fmla="*/ 1847850 w 1956606"/>
                <a:gd name="connsiteY82" fmla="*/ 1460500 h 1638300"/>
                <a:gd name="connsiteX83" fmla="*/ 1857375 w 1956606"/>
                <a:gd name="connsiteY83" fmla="*/ 1454150 h 1638300"/>
                <a:gd name="connsiteX84" fmla="*/ 1873250 w 1956606"/>
                <a:gd name="connsiteY84" fmla="*/ 1435100 h 1638300"/>
                <a:gd name="connsiteX85" fmla="*/ 1879600 w 1956606"/>
                <a:gd name="connsiteY85" fmla="*/ 1416050 h 1638300"/>
                <a:gd name="connsiteX86" fmla="*/ 1882775 w 1956606"/>
                <a:gd name="connsiteY86" fmla="*/ 1406525 h 1638300"/>
                <a:gd name="connsiteX87" fmla="*/ 1889125 w 1956606"/>
                <a:gd name="connsiteY87" fmla="*/ 1330325 h 1638300"/>
                <a:gd name="connsiteX88" fmla="*/ 1885950 w 1956606"/>
                <a:gd name="connsiteY88" fmla="*/ 1219200 h 1638300"/>
                <a:gd name="connsiteX89" fmla="*/ 1873250 w 1956606"/>
                <a:gd name="connsiteY89" fmla="*/ 1168400 h 1638300"/>
                <a:gd name="connsiteX90" fmla="*/ 1866900 w 1956606"/>
                <a:gd name="connsiteY90" fmla="*/ 1146175 h 1638300"/>
                <a:gd name="connsiteX91" fmla="*/ 1860550 w 1956606"/>
                <a:gd name="connsiteY91" fmla="*/ 1136650 h 1638300"/>
                <a:gd name="connsiteX92" fmla="*/ 1857375 w 1956606"/>
                <a:gd name="connsiteY92" fmla="*/ 1127125 h 1638300"/>
                <a:gd name="connsiteX93" fmla="*/ 1844675 w 1956606"/>
                <a:gd name="connsiteY93" fmla="*/ 1108075 h 1638300"/>
                <a:gd name="connsiteX94" fmla="*/ 1841500 w 1956606"/>
                <a:gd name="connsiteY94" fmla="*/ 1098550 h 1638300"/>
                <a:gd name="connsiteX95" fmla="*/ 1835150 w 1956606"/>
                <a:gd name="connsiteY95" fmla="*/ 1089025 h 1638300"/>
                <a:gd name="connsiteX96" fmla="*/ 1831975 w 1956606"/>
                <a:gd name="connsiteY96" fmla="*/ 1079500 h 1638300"/>
                <a:gd name="connsiteX97" fmla="*/ 1819275 w 1956606"/>
                <a:gd name="connsiteY97" fmla="*/ 1060450 h 1638300"/>
                <a:gd name="connsiteX98" fmla="*/ 1806575 w 1956606"/>
                <a:gd name="connsiteY98" fmla="*/ 1041400 h 1638300"/>
                <a:gd name="connsiteX99" fmla="*/ 1800225 w 1956606"/>
                <a:gd name="connsiteY99" fmla="*/ 1031875 h 1638300"/>
                <a:gd name="connsiteX100" fmla="*/ 1793875 w 1956606"/>
                <a:gd name="connsiteY100" fmla="*/ 1022350 h 1638300"/>
                <a:gd name="connsiteX101" fmla="*/ 1784350 w 1956606"/>
                <a:gd name="connsiteY101" fmla="*/ 1009650 h 1638300"/>
                <a:gd name="connsiteX102" fmla="*/ 1774825 w 1956606"/>
                <a:gd name="connsiteY102" fmla="*/ 1003300 h 1638300"/>
                <a:gd name="connsiteX103" fmla="*/ 1762125 w 1956606"/>
                <a:gd name="connsiteY103" fmla="*/ 987425 h 1638300"/>
                <a:gd name="connsiteX104" fmla="*/ 1743075 w 1956606"/>
                <a:gd name="connsiteY104" fmla="*/ 971550 h 1638300"/>
                <a:gd name="connsiteX105" fmla="*/ 1724025 w 1956606"/>
                <a:gd name="connsiteY105" fmla="*/ 965200 h 1638300"/>
                <a:gd name="connsiteX106" fmla="*/ 1714500 w 1956606"/>
                <a:gd name="connsiteY106" fmla="*/ 958850 h 1638300"/>
                <a:gd name="connsiteX107" fmla="*/ 1704975 w 1956606"/>
                <a:gd name="connsiteY107" fmla="*/ 955675 h 1638300"/>
                <a:gd name="connsiteX108" fmla="*/ 1660525 w 1956606"/>
                <a:gd name="connsiteY108" fmla="*/ 949325 h 1638300"/>
                <a:gd name="connsiteX109" fmla="*/ 1616075 w 1956606"/>
                <a:gd name="connsiteY109" fmla="*/ 942975 h 1638300"/>
                <a:gd name="connsiteX110" fmla="*/ 1597025 w 1956606"/>
                <a:gd name="connsiteY110" fmla="*/ 933450 h 1638300"/>
                <a:gd name="connsiteX111" fmla="*/ 1587500 w 1956606"/>
                <a:gd name="connsiteY111" fmla="*/ 923925 h 1638300"/>
                <a:gd name="connsiteX112" fmla="*/ 1577975 w 1956606"/>
                <a:gd name="connsiteY112" fmla="*/ 917575 h 1638300"/>
                <a:gd name="connsiteX113" fmla="*/ 1571625 w 1956606"/>
                <a:gd name="connsiteY113" fmla="*/ 908050 h 1638300"/>
                <a:gd name="connsiteX114" fmla="*/ 1558925 w 1956606"/>
                <a:gd name="connsiteY114" fmla="*/ 879475 h 1638300"/>
                <a:gd name="connsiteX115" fmla="*/ 1546225 w 1956606"/>
                <a:gd name="connsiteY115" fmla="*/ 841375 h 1638300"/>
                <a:gd name="connsiteX116" fmla="*/ 1543050 w 1956606"/>
                <a:gd name="connsiteY116" fmla="*/ 831850 h 1638300"/>
                <a:gd name="connsiteX117" fmla="*/ 1530350 w 1956606"/>
                <a:gd name="connsiteY117" fmla="*/ 812800 h 1638300"/>
                <a:gd name="connsiteX118" fmla="*/ 1524000 w 1956606"/>
                <a:gd name="connsiteY118" fmla="*/ 803275 h 1638300"/>
                <a:gd name="connsiteX119" fmla="*/ 1511300 w 1956606"/>
                <a:gd name="connsiteY119" fmla="*/ 784225 h 1638300"/>
                <a:gd name="connsiteX120" fmla="*/ 1504950 w 1956606"/>
                <a:gd name="connsiteY120" fmla="*/ 774700 h 1638300"/>
                <a:gd name="connsiteX121" fmla="*/ 1476375 w 1956606"/>
                <a:gd name="connsiteY121" fmla="*/ 755650 h 1638300"/>
                <a:gd name="connsiteX122" fmla="*/ 1466850 w 1956606"/>
                <a:gd name="connsiteY122" fmla="*/ 749300 h 1638300"/>
                <a:gd name="connsiteX123" fmla="*/ 1457325 w 1956606"/>
                <a:gd name="connsiteY123" fmla="*/ 746125 h 1638300"/>
                <a:gd name="connsiteX124" fmla="*/ 1438275 w 1956606"/>
                <a:gd name="connsiteY124" fmla="*/ 733425 h 1638300"/>
                <a:gd name="connsiteX125" fmla="*/ 1428750 w 1956606"/>
                <a:gd name="connsiteY125" fmla="*/ 723900 h 1638300"/>
                <a:gd name="connsiteX126" fmla="*/ 1419225 w 1956606"/>
                <a:gd name="connsiteY126" fmla="*/ 720725 h 1638300"/>
                <a:gd name="connsiteX127" fmla="*/ 1400175 w 1956606"/>
                <a:gd name="connsiteY127" fmla="*/ 708025 h 1638300"/>
                <a:gd name="connsiteX128" fmla="*/ 1381125 w 1956606"/>
                <a:gd name="connsiteY128" fmla="*/ 695325 h 1638300"/>
                <a:gd name="connsiteX129" fmla="*/ 1371600 w 1956606"/>
                <a:gd name="connsiteY129" fmla="*/ 688975 h 1638300"/>
                <a:gd name="connsiteX130" fmla="*/ 1362075 w 1956606"/>
                <a:gd name="connsiteY130" fmla="*/ 682625 h 1638300"/>
                <a:gd name="connsiteX131" fmla="*/ 1343025 w 1956606"/>
                <a:gd name="connsiteY131" fmla="*/ 676275 h 1638300"/>
                <a:gd name="connsiteX132" fmla="*/ 1314450 w 1956606"/>
                <a:gd name="connsiteY132" fmla="*/ 682625 h 1638300"/>
                <a:gd name="connsiteX133" fmla="*/ 1292225 w 1956606"/>
                <a:gd name="connsiteY133" fmla="*/ 676275 h 1638300"/>
                <a:gd name="connsiteX134" fmla="*/ 1276350 w 1956606"/>
                <a:gd name="connsiteY134" fmla="*/ 660400 h 1638300"/>
                <a:gd name="connsiteX135" fmla="*/ 1270000 w 1956606"/>
                <a:gd name="connsiteY135" fmla="*/ 650875 h 1638300"/>
                <a:gd name="connsiteX136" fmla="*/ 1241425 w 1956606"/>
                <a:gd name="connsiteY136" fmla="*/ 628650 h 1638300"/>
                <a:gd name="connsiteX137" fmla="*/ 1225550 w 1956606"/>
                <a:gd name="connsiteY137" fmla="*/ 625475 h 1638300"/>
                <a:gd name="connsiteX138" fmla="*/ 1181100 w 1956606"/>
                <a:gd name="connsiteY138" fmla="*/ 628650 h 1638300"/>
                <a:gd name="connsiteX139" fmla="*/ 1162050 w 1956606"/>
                <a:gd name="connsiteY139" fmla="*/ 644525 h 1638300"/>
                <a:gd name="connsiteX140" fmla="*/ 1152525 w 1956606"/>
                <a:gd name="connsiteY140" fmla="*/ 650875 h 1638300"/>
                <a:gd name="connsiteX141" fmla="*/ 1133475 w 1956606"/>
                <a:gd name="connsiteY141" fmla="*/ 663575 h 1638300"/>
                <a:gd name="connsiteX142" fmla="*/ 1120775 w 1956606"/>
                <a:gd name="connsiteY142" fmla="*/ 660400 h 1638300"/>
                <a:gd name="connsiteX143" fmla="*/ 1117600 w 1956606"/>
                <a:gd name="connsiteY143" fmla="*/ 650875 h 1638300"/>
                <a:gd name="connsiteX144" fmla="*/ 1120775 w 1956606"/>
                <a:gd name="connsiteY144" fmla="*/ 568325 h 1638300"/>
                <a:gd name="connsiteX145" fmla="*/ 1136650 w 1956606"/>
                <a:gd name="connsiteY145" fmla="*/ 539750 h 1638300"/>
                <a:gd name="connsiteX146" fmla="*/ 1146175 w 1956606"/>
                <a:gd name="connsiteY146" fmla="*/ 520700 h 1638300"/>
                <a:gd name="connsiteX147" fmla="*/ 1149350 w 1956606"/>
                <a:gd name="connsiteY147" fmla="*/ 511175 h 1638300"/>
                <a:gd name="connsiteX148" fmla="*/ 1155700 w 1956606"/>
                <a:gd name="connsiteY148" fmla="*/ 501650 h 1638300"/>
                <a:gd name="connsiteX149" fmla="*/ 1158875 w 1956606"/>
                <a:gd name="connsiteY149" fmla="*/ 492125 h 1638300"/>
                <a:gd name="connsiteX150" fmla="*/ 1165225 w 1956606"/>
                <a:gd name="connsiteY150" fmla="*/ 482600 h 1638300"/>
                <a:gd name="connsiteX151" fmla="*/ 1168400 w 1956606"/>
                <a:gd name="connsiteY151" fmla="*/ 473075 h 1638300"/>
                <a:gd name="connsiteX152" fmla="*/ 1181100 w 1956606"/>
                <a:gd name="connsiteY152" fmla="*/ 454025 h 1638300"/>
                <a:gd name="connsiteX153" fmla="*/ 1187450 w 1956606"/>
                <a:gd name="connsiteY153" fmla="*/ 444500 h 1638300"/>
                <a:gd name="connsiteX154" fmla="*/ 1193800 w 1956606"/>
                <a:gd name="connsiteY154" fmla="*/ 434975 h 1638300"/>
                <a:gd name="connsiteX155" fmla="*/ 1203325 w 1956606"/>
                <a:gd name="connsiteY155" fmla="*/ 428625 h 1638300"/>
                <a:gd name="connsiteX156" fmla="*/ 1206500 w 1956606"/>
                <a:gd name="connsiteY156" fmla="*/ 419100 h 1638300"/>
                <a:gd name="connsiteX157" fmla="*/ 1225550 w 1956606"/>
                <a:gd name="connsiteY157" fmla="*/ 406400 h 1638300"/>
                <a:gd name="connsiteX158" fmla="*/ 1231900 w 1956606"/>
                <a:gd name="connsiteY158" fmla="*/ 396875 h 1638300"/>
                <a:gd name="connsiteX159" fmla="*/ 1250950 w 1956606"/>
                <a:gd name="connsiteY159" fmla="*/ 390525 h 1638300"/>
                <a:gd name="connsiteX160" fmla="*/ 1260475 w 1956606"/>
                <a:gd name="connsiteY160" fmla="*/ 387350 h 1638300"/>
                <a:gd name="connsiteX161" fmla="*/ 1270000 w 1956606"/>
                <a:gd name="connsiteY161" fmla="*/ 384175 h 1638300"/>
                <a:gd name="connsiteX162" fmla="*/ 1282700 w 1956606"/>
                <a:gd name="connsiteY162" fmla="*/ 381000 h 1638300"/>
                <a:gd name="connsiteX163" fmla="*/ 1330325 w 1956606"/>
                <a:gd name="connsiteY163" fmla="*/ 387350 h 1638300"/>
                <a:gd name="connsiteX164" fmla="*/ 1339850 w 1956606"/>
                <a:gd name="connsiteY164" fmla="*/ 393700 h 1638300"/>
                <a:gd name="connsiteX165" fmla="*/ 1355725 w 1956606"/>
                <a:gd name="connsiteY165" fmla="*/ 409575 h 1638300"/>
                <a:gd name="connsiteX166" fmla="*/ 1362075 w 1956606"/>
                <a:gd name="connsiteY166" fmla="*/ 419100 h 1638300"/>
                <a:gd name="connsiteX167" fmla="*/ 1371600 w 1956606"/>
                <a:gd name="connsiteY167" fmla="*/ 428625 h 1638300"/>
                <a:gd name="connsiteX168" fmla="*/ 1377950 w 1956606"/>
                <a:gd name="connsiteY168" fmla="*/ 438150 h 1638300"/>
                <a:gd name="connsiteX169" fmla="*/ 1387475 w 1956606"/>
                <a:gd name="connsiteY169" fmla="*/ 444500 h 1638300"/>
                <a:gd name="connsiteX170" fmla="*/ 1397000 w 1956606"/>
                <a:gd name="connsiteY170" fmla="*/ 454025 h 1638300"/>
                <a:gd name="connsiteX171" fmla="*/ 1416050 w 1956606"/>
                <a:gd name="connsiteY171" fmla="*/ 460375 h 1638300"/>
                <a:gd name="connsiteX172" fmla="*/ 1425575 w 1956606"/>
                <a:gd name="connsiteY172" fmla="*/ 463550 h 1638300"/>
                <a:gd name="connsiteX173" fmla="*/ 1498600 w 1956606"/>
                <a:gd name="connsiteY173" fmla="*/ 466725 h 1638300"/>
                <a:gd name="connsiteX174" fmla="*/ 1533525 w 1956606"/>
                <a:gd name="connsiteY174" fmla="*/ 473075 h 1638300"/>
                <a:gd name="connsiteX175" fmla="*/ 1577975 w 1956606"/>
                <a:gd name="connsiteY175" fmla="*/ 479425 h 1638300"/>
                <a:gd name="connsiteX176" fmla="*/ 1673225 w 1956606"/>
                <a:gd name="connsiteY176" fmla="*/ 476250 h 1638300"/>
                <a:gd name="connsiteX177" fmla="*/ 1685925 w 1956606"/>
                <a:gd name="connsiteY177" fmla="*/ 473075 h 1638300"/>
                <a:gd name="connsiteX178" fmla="*/ 1714500 w 1956606"/>
                <a:gd name="connsiteY178" fmla="*/ 463550 h 1638300"/>
                <a:gd name="connsiteX179" fmla="*/ 1724025 w 1956606"/>
                <a:gd name="connsiteY179" fmla="*/ 460375 h 1638300"/>
                <a:gd name="connsiteX180" fmla="*/ 1733550 w 1956606"/>
                <a:gd name="connsiteY180" fmla="*/ 457200 h 1638300"/>
                <a:gd name="connsiteX181" fmla="*/ 1743075 w 1956606"/>
                <a:gd name="connsiteY181" fmla="*/ 450850 h 1638300"/>
                <a:gd name="connsiteX182" fmla="*/ 1762125 w 1956606"/>
                <a:gd name="connsiteY182" fmla="*/ 444500 h 1638300"/>
                <a:gd name="connsiteX183" fmla="*/ 1771650 w 1956606"/>
                <a:gd name="connsiteY183" fmla="*/ 441325 h 1638300"/>
                <a:gd name="connsiteX184" fmla="*/ 1800225 w 1956606"/>
                <a:gd name="connsiteY184" fmla="*/ 428625 h 1638300"/>
                <a:gd name="connsiteX185" fmla="*/ 1809750 w 1956606"/>
                <a:gd name="connsiteY185" fmla="*/ 425450 h 1638300"/>
                <a:gd name="connsiteX186" fmla="*/ 1819275 w 1956606"/>
                <a:gd name="connsiteY186" fmla="*/ 419100 h 1638300"/>
                <a:gd name="connsiteX187" fmla="*/ 1838325 w 1956606"/>
                <a:gd name="connsiteY187" fmla="*/ 412750 h 1638300"/>
                <a:gd name="connsiteX188" fmla="*/ 1847850 w 1956606"/>
                <a:gd name="connsiteY188" fmla="*/ 409575 h 1638300"/>
                <a:gd name="connsiteX189" fmla="*/ 1866900 w 1956606"/>
                <a:gd name="connsiteY189" fmla="*/ 400050 h 1638300"/>
                <a:gd name="connsiteX190" fmla="*/ 1885950 w 1956606"/>
                <a:gd name="connsiteY190" fmla="*/ 390525 h 1638300"/>
                <a:gd name="connsiteX191" fmla="*/ 1895475 w 1956606"/>
                <a:gd name="connsiteY191" fmla="*/ 381000 h 1638300"/>
                <a:gd name="connsiteX192" fmla="*/ 1901825 w 1956606"/>
                <a:gd name="connsiteY192" fmla="*/ 371475 h 1638300"/>
                <a:gd name="connsiteX193" fmla="*/ 1911350 w 1956606"/>
                <a:gd name="connsiteY193" fmla="*/ 365125 h 1638300"/>
                <a:gd name="connsiteX194" fmla="*/ 1920875 w 1956606"/>
                <a:gd name="connsiteY194" fmla="*/ 355600 h 1638300"/>
                <a:gd name="connsiteX195" fmla="*/ 1930400 w 1956606"/>
                <a:gd name="connsiteY195" fmla="*/ 349250 h 1638300"/>
                <a:gd name="connsiteX196" fmla="*/ 1939925 w 1956606"/>
                <a:gd name="connsiteY196" fmla="*/ 339725 h 1638300"/>
                <a:gd name="connsiteX197" fmla="*/ 1952625 w 1956606"/>
                <a:gd name="connsiteY197" fmla="*/ 320675 h 1638300"/>
                <a:gd name="connsiteX198" fmla="*/ 1952625 w 1956606"/>
                <a:gd name="connsiteY198" fmla="*/ 200025 h 1638300"/>
                <a:gd name="connsiteX199" fmla="*/ 1946275 w 1956606"/>
                <a:gd name="connsiteY199" fmla="*/ 171450 h 1638300"/>
                <a:gd name="connsiteX200" fmla="*/ 1933575 w 1956606"/>
                <a:gd name="connsiteY200" fmla="*/ 152400 h 1638300"/>
                <a:gd name="connsiteX201" fmla="*/ 1927225 w 1956606"/>
                <a:gd name="connsiteY201" fmla="*/ 142875 h 1638300"/>
                <a:gd name="connsiteX202" fmla="*/ 1920875 w 1956606"/>
                <a:gd name="connsiteY202" fmla="*/ 133350 h 1638300"/>
                <a:gd name="connsiteX203" fmla="*/ 1914525 w 1956606"/>
                <a:gd name="connsiteY203" fmla="*/ 123825 h 1638300"/>
                <a:gd name="connsiteX204" fmla="*/ 1905000 w 1956606"/>
                <a:gd name="connsiteY204" fmla="*/ 117475 h 1638300"/>
                <a:gd name="connsiteX205" fmla="*/ 1889125 w 1956606"/>
                <a:gd name="connsiteY205" fmla="*/ 98425 h 1638300"/>
                <a:gd name="connsiteX206" fmla="*/ 1879600 w 1956606"/>
                <a:gd name="connsiteY206" fmla="*/ 95250 h 1638300"/>
                <a:gd name="connsiteX207" fmla="*/ 1873250 w 1956606"/>
                <a:gd name="connsiteY207" fmla="*/ 85725 h 1638300"/>
                <a:gd name="connsiteX208" fmla="*/ 1863725 w 1956606"/>
                <a:gd name="connsiteY208" fmla="*/ 82550 h 1638300"/>
                <a:gd name="connsiteX209" fmla="*/ 1844675 w 1956606"/>
                <a:gd name="connsiteY209" fmla="*/ 73025 h 1638300"/>
                <a:gd name="connsiteX210" fmla="*/ 1838325 w 1956606"/>
                <a:gd name="connsiteY210" fmla="*/ 63500 h 1638300"/>
                <a:gd name="connsiteX211" fmla="*/ 1819275 w 1956606"/>
                <a:gd name="connsiteY211" fmla="*/ 57150 h 1638300"/>
                <a:gd name="connsiteX212" fmla="*/ 1800225 w 1956606"/>
                <a:gd name="connsiteY212" fmla="*/ 41275 h 1638300"/>
                <a:gd name="connsiteX213" fmla="*/ 1781175 w 1956606"/>
                <a:gd name="connsiteY213" fmla="*/ 31750 h 1638300"/>
                <a:gd name="connsiteX214" fmla="*/ 1774825 w 1956606"/>
                <a:gd name="connsiteY214" fmla="*/ 22225 h 1638300"/>
                <a:gd name="connsiteX215" fmla="*/ 1765300 w 1956606"/>
                <a:gd name="connsiteY215" fmla="*/ 19050 h 1638300"/>
                <a:gd name="connsiteX216" fmla="*/ 1755775 w 1956606"/>
                <a:gd name="connsiteY216" fmla="*/ 12700 h 1638300"/>
                <a:gd name="connsiteX217" fmla="*/ 1739900 w 1956606"/>
                <a:gd name="connsiteY217" fmla="*/ 0 h 1638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  <a:cxn ang="0">
                  <a:pos x="connsiteX29" y="connsiteY29"/>
                </a:cxn>
                <a:cxn ang="0">
                  <a:pos x="connsiteX30" y="connsiteY30"/>
                </a:cxn>
                <a:cxn ang="0">
                  <a:pos x="connsiteX31" y="connsiteY31"/>
                </a:cxn>
                <a:cxn ang="0">
                  <a:pos x="connsiteX32" y="connsiteY32"/>
                </a:cxn>
                <a:cxn ang="0">
                  <a:pos x="connsiteX33" y="connsiteY33"/>
                </a:cxn>
                <a:cxn ang="0">
                  <a:pos x="connsiteX34" y="connsiteY34"/>
                </a:cxn>
                <a:cxn ang="0">
                  <a:pos x="connsiteX35" y="connsiteY35"/>
                </a:cxn>
                <a:cxn ang="0">
                  <a:pos x="connsiteX36" y="connsiteY36"/>
                </a:cxn>
                <a:cxn ang="0">
                  <a:pos x="connsiteX37" y="connsiteY37"/>
                </a:cxn>
                <a:cxn ang="0">
                  <a:pos x="connsiteX38" y="connsiteY38"/>
                </a:cxn>
                <a:cxn ang="0">
                  <a:pos x="connsiteX39" y="connsiteY39"/>
                </a:cxn>
                <a:cxn ang="0">
                  <a:pos x="connsiteX40" y="connsiteY40"/>
                </a:cxn>
                <a:cxn ang="0">
                  <a:pos x="connsiteX41" y="connsiteY41"/>
                </a:cxn>
                <a:cxn ang="0">
                  <a:pos x="connsiteX42" y="connsiteY42"/>
                </a:cxn>
                <a:cxn ang="0">
                  <a:pos x="connsiteX43" y="connsiteY43"/>
                </a:cxn>
                <a:cxn ang="0">
                  <a:pos x="connsiteX44" y="connsiteY44"/>
                </a:cxn>
                <a:cxn ang="0">
                  <a:pos x="connsiteX45" y="connsiteY45"/>
                </a:cxn>
                <a:cxn ang="0">
                  <a:pos x="connsiteX46" y="connsiteY46"/>
                </a:cxn>
                <a:cxn ang="0">
                  <a:pos x="connsiteX47" y="connsiteY47"/>
                </a:cxn>
                <a:cxn ang="0">
                  <a:pos x="connsiteX48" y="connsiteY48"/>
                </a:cxn>
                <a:cxn ang="0">
                  <a:pos x="connsiteX49" y="connsiteY49"/>
                </a:cxn>
                <a:cxn ang="0">
                  <a:pos x="connsiteX50" y="connsiteY50"/>
                </a:cxn>
                <a:cxn ang="0">
                  <a:pos x="connsiteX51" y="connsiteY51"/>
                </a:cxn>
                <a:cxn ang="0">
                  <a:pos x="connsiteX52" y="connsiteY52"/>
                </a:cxn>
                <a:cxn ang="0">
                  <a:pos x="connsiteX53" y="connsiteY53"/>
                </a:cxn>
                <a:cxn ang="0">
                  <a:pos x="connsiteX54" y="connsiteY54"/>
                </a:cxn>
                <a:cxn ang="0">
                  <a:pos x="connsiteX55" y="connsiteY55"/>
                </a:cxn>
                <a:cxn ang="0">
                  <a:pos x="connsiteX56" y="connsiteY56"/>
                </a:cxn>
                <a:cxn ang="0">
                  <a:pos x="connsiteX57" y="connsiteY57"/>
                </a:cxn>
                <a:cxn ang="0">
                  <a:pos x="connsiteX58" y="connsiteY58"/>
                </a:cxn>
                <a:cxn ang="0">
                  <a:pos x="connsiteX59" y="connsiteY59"/>
                </a:cxn>
                <a:cxn ang="0">
                  <a:pos x="connsiteX60" y="connsiteY60"/>
                </a:cxn>
                <a:cxn ang="0">
                  <a:pos x="connsiteX61" y="connsiteY61"/>
                </a:cxn>
                <a:cxn ang="0">
                  <a:pos x="connsiteX62" y="connsiteY62"/>
                </a:cxn>
                <a:cxn ang="0">
                  <a:pos x="connsiteX63" y="connsiteY63"/>
                </a:cxn>
                <a:cxn ang="0">
                  <a:pos x="connsiteX64" y="connsiteY64"/>
                </a:cxn>
                <a:cxn ang="0">
                  <a:pos x="connsiteX65" y="connsiteY65"/>
                </a:cxn>
                <a:cxn ang="0">
                  <a:pos x="connsiteX66" y="connsiteY66"/>
                </a:cxn>
                <a:cxn ang="0">
                  <a:pos x="connsiteX67" y="connsiteY67"/>
                </a:cxn>
                <a:cxn ang="0">
                  <a:pos x="connsiteX68" y="connsiteY68"/>
                </a:cxn>
                <a:cxn ang="0">
                  <a:pos x="connsiteX69" y="connsiteY69"/>
                </a:cxn>
                <a:cxn ang="0">
                  <a:pos x="connsiteX70" y="connsiteY70"/>
                </a:cxn>
                <a:cxn ang="0">
                  <a:pos x="connsiteX71" y="connsiteY71"/>
                </a:cxn>
                <a:cxn ang="0">
                  <a:pos x="connsiteX72" y="connsiteY72"/>
                </a:cxn>
                <a:cxn ang="0">
                  <a:pos x="connsiteX73" y="connsiteY73"/>
                </a:cxn>
                <a:cxn ang="0">
                  <a:pos x="connsiteX74" y="connsiteY74"/>
                </a:cxn>
                <a:cxn ang="0">
                  <a:pos x="connsiteX75" y="connsiteY75"/>
                </a:cxn>
                <a:cxn ang="0">
                  <a:pos x="connsiteX76" y="connsiteY76"/>
                </a:cxn>
                <a:cxn ang="0">
                  <a:pos x="connsiteX77" y="connsiteY77"/>
                </a:cxn>
                <a:cxn ang="0">
                  <a:pos x="connsiteX78" y="connsiteY78"/>
                </a:cxn>
                <a:cxn ang="0">
                  <a:pos x="connsiteX79" y="connsiteY79"/>
                </a:cxn>
                <a:cxn ang="0">
                  <a:pos x="connsiteX80" y="connsiteY80"/>
                </a:cxn>
                <a:cxn ang="0">
                  <a:pos x="connsiteX81" y="connsiteY81"/>
                </a:cxn>
                <a:cxn ang="0">
                  <a:pos x="connsiteX82" y="connsiteY82"/>
                </a:cxn>
                <a:cxn ang="0">
                  <a:pos x="connsiteX83" y="connsiteY83"/>
                </a:cxn>
                <a:cxn ang="0">
                  <a:pos x="connsiteX84" y="connsiteY84"/>
                </a:cxn>
                <a:cxn ang="0">
                  <a:pos x="connsiteX85" y="connsiteY85"/>
                </a:cxn>
                <a:cxn ang="0">
                  <a:pos x="connsiteX86" y="connsiteY86"/>
                </a:cxn>
                <a:cxn ang="0">
                  <a:pos x="connsiteX87" y="connsiteY87"/>
                </a:cxn>
                <a:cxn ang="0">
                  <a:pos x="connsiteX88" y="connsiteY88"/>
                </a:cxn>
                <a:cxn ang="0">
                  <a:pos x="connsiteX89" y="connsiteY89"/>
                </a:cxn>
                <a:cxn ang="0">
                  <a:pos x="connsiteX90" y="connsiteY90"/>
                </a:cxn>
                <a:cxn ang="0">
                  <a:pos x="connsiteX91" y="connsiteY91"/>
                </a:cxn>
                <a:cxn ang="0">
                  <a:pos x="connsiteX92" y="connsiteY92"/>
                </a:cxn>
                <a:cxn ang="0">
                  <a:pos x="connsiteX93" y="connsiteY93"/>
                </a:cxn>
                <a:cxn ang="0">
                  <a:pos x="connsiteX94" y="connsiteY94"/>
                </a:cxn>
                <a:cxn ang="0">
                  <a:pos x="connsiteX95" y="connsiteY95"/>
                </a:cxn>
                <a:cxn ang="0">
                  <a:pos x="connsiteX96" y="connsiteY96"/>
                </a:cxn>
                <a:cxn ang="0">
                  <a:pos x="connsiteX97" y="connsiteY97"/>
                </a:cxn>
                <a:cxn ang="0">
                  <a:pos x="connsiteX98" y="connsiteY98"/>
                </a:cxn>
                <a:cxn ang="0">
                  <a:pos x="connsiteX99" y="connsiteY99"/>
                </a:cxn>
                <a:cxn ang="0">
                  <a:pos x="connsiteX100" y="connsiteY100"/>
                </a:cxn>
                <a:cxn ang="0">
                  <a:pos x="connsiteX101" y="connsiteY101"/>
                </a:cxn>
                <a:cxn ang="0">
                  <a:pos x="connsiteX102" y="connsiteY102"/>
                </a:cxn>
                <a:cxn ang="0">
                  <a:pos x="connsiteX103" y="connsiteY103"/>
                </a:cxn>
                <a:cxn ang="0">
                  <a:pos x="connsiteX104" y="connsiteY104"/>
                </a:cxn>
                <a:cxn ang="0">
                  <a:pos x="connsiteX105" y="connsiteY105"/>
                </a:cxn>
                <a:cxn ang="0">
                  <a:pos x="connsiteX106" y="connsiteY106"/>
                </a:cxn>
                <a:cxn ang="0">
                  <a:pos x="connsiteX107" y="connsiteY107"/>
                </a:cxn>
                <a:cxn ang="0">
                  <a:pos x="connsiteX108" y="connsiteY108"/>
                </a:cxn>
                <a:cxn ang="0">
                  <a:pos x="connsiteX109" y="connsiteY109"/>
                </a:cxn>
                <a:cxn ang="0">
                  <a:pos x="connsiteX110" y="connsiteY110"/>
                </a:cxn>
                <a:cxn ang="0">
                  <a:pos x="connsiteX111" y="connsiteY111"/>
                </a:cxn>
                <a:cxn ang="0">
                  <a:pos x="connsiteX112" y="connsiteY112"/>
                </a:cxn>
                <a:cxn ang="0">
                  <a:pos x="connsiteX113" y="connsiteY113"/>
                </a:cxn>
                <a:cxn ang="0">
                  <a:pos x="connsiteX114" y="connsiteY114"/>
                </a:cxn>
                <a:cxn ang="0">
                  <a:pos x="connsiteX115" y="connsiteY115"/>
                </a:cxn>
                <a:cxn ang="0">
                  <a:pos x="connsiteX116" y="connsiteY116"/>
                </a:cxn>
                <a:cxn ang="0">
                  <a:pos x="connsiteX117" y="connsiteY117"/>
                </a:cxn>
                <a:cxn ang="0">
                  <a:pos x="connsiteX118" y="connsiteY118"/>
                </a:cxn>
                <a:cxn ang="0">
                  <a:pos x="connsiteX119" y="connsiteY119"/>
                </a:cxn>
                <a:cxn ang="0">
                  <a:pos x="connsiteX120" y="connsiteY120"/>
                </a:cxn>
                <a:cxn ang="0">
                  <a:pos x="connsiteX121" y="connsiteY121"/>
                </a:cxn>
                <a:cxn ang="0">
                  <a:pos x="connsiteX122" y="connsiteY122"/>
                </a:cxn>
                <a:cxn ang="0">
                  <a:pos x="connsiteX123" y="connsiteY123"/>
                </a:cxn>
                <a:cxn ang="0">
                  <a:pos x="connsiteX124" y="connsiteY124"/>
                </a:cxn>
                <a:cxn ang="0">
                  <a:pos x="connsiteX125" y="connsiteY125"/>
                </a:cxn>
                <a:cxn ang="0">
                  <a:pos x="connsiteX126" y="connsiteY126"/>
                </a:cxn>
                <a:cxn ang="0">
                  <a:pos x="connsiteX127" y="connsiteY127"/>
                </a:cxn>
                <a:cxn ang="0">
                  <a:pos x="connsiteX128" y="connsiteY128"/>
                </a:cxn>
                <a:cxn ang="0">
                  <a:pos x="connsiteX129" y="connsiteY129"/>
                </a:cxn>
                <a:cxn ang="0">
                  <a:pos x="connsiteX130" y="connsiteY130"/>
                </a:cxn>
                <a:cxn ang="0">
                  <a:pos x="connsiteX131" y="connsiteY131"/>
                </a:cxn>
                <a:cxn ang="0">
                  <a:pos x="connsiteX132" y="connsiteY132"/>
                </a:cxn>
                <a:cxn ang="0">
                  <a:pos x="connsiteX133" y="connsiteY133"/>
                </a:cxn>
                <a:cxn ang="0">
                  <a:pos x="connsiteX134" y="connsiteY134"/>
                </a:cxn>
                <a:cxn ang="0">
                  <a:pos x="connsiteX135" y="connsiteY135"/>
                </a:cxn>
                <a:cxn ang="0">
                  <a:pos x="connsiteX136" y="connsiteY136"/>
                </a:cxn>
                <a:cxn ang="0">
                  <a:pos x="connsiteX137" y="connsiteY137"/>
                </a:cxn>
                <a:cxn ang="0">
                  <a:pos x="connsiteX138" y="connsiteY138"/>
                </a:cxn>
                <a:cxn ang="0">
                  <a:pos x="connsiteX139" y="connsiteY139"/>
                </a:cxn>
                <a:cxn ang="0">
                  <a:pos x="connsiteX140" y="connsiteY140"/>
                </a:cxn>
                <a:cxn ang="0">
                  <a:pos x="connsiteX141" y="connsiteY141"/>
                </a:cxn>
                <a:cxn ang="0">
                  <a:pos x="connsiteX142" y="connsiteY142"/>
                </a:cxn>
                <a:cxn ang="0">
                  <a:pos x="connsiteX143" y="connsiteY143"/>
                </a:cxn>
                <a:cxn ang="0">
                  <a:pos x="connsiteX144" y="connsiteY144"/>
                </a:cxn>
                <a:cxn ang="0">
                  <a:pos x="connsiteX145" y="connsiteY145"/>
                </a:cxn>
                <a:cxn ang="0">
                  <a:pos x="connsiteX146" y="connsiteY146"/>
                </a:cxn>
                <a:cxn ang="0">
                  <a:pos x="connsiteX147" y="connsiteY147"/>
                </a:cxn>
                <a:cxn ang="0">
                  <a:pos x="connsiteX148" y="connsiteY148"/>
                </a:cxn>
                <a:cxn ang="0">
                  <a:pos x="connsiteX149" y="connsiteY149"/>
                </a:cxn>
                <a:cxn ang="0">
                  <a:pos x="connsiteX150" y="connsiteY150"/>
                </a:cxn>
                <a:cxn ang="0">
                  <a:pos x="connsiteX151" y="connsiteY151"/>
                </a:cxn>
                <a:cxn ang="0">
                  <a:pos x="connsiteX152" y="connsiteY152"/>
                </a:cxn>
                <a:cxn ang="0">
                  <a:pos x="connsiteX153" y="connsiteY153"/>
                </a:cxn>
                <a:cxn ang="0">
                  <a:pos x="connsiteX154" y="connsiteY154"/>
                </a:cxn>
                <a:cxn ang="0">
                  <a:pos x="connsiteX155" y="connsiteY155"/>
                </a:cxn>
                <a:cxn ang="0">
                  <a:pos x="connsiteX156" y="connsiteY156"/>
                </a:cxn>
                <a:cxn ang="0">
                  <a:pos x="connsiteX157" y="connsiteY157"/>
                </a:cxn>
                <a:cxn ang="0">
                  <a:pos x="connsiteX158" y="connsiteY158"/>
                </a:cxn>
                <a:cxn ang="0">
                  <a:pos x="connsiteX159" y="connsiteY159"/>
                </a:cxn>
                <a:cxn ang="0">
                  <a:pos x="connsiteX160" y="connsiteY160"/>
                </a:cxn>
                <a:cxn ang="0">
                  <a:pos x="connsiteX161" y="connsiteY161"/>
                </a:cxn>
                <a:cxn ang="0">
                  <a:pos x="connsiteX162" y="connsiteY162"/>
                </a:cxn>
                <a:cxn ang="0">
                  <a:pos x="connsiteX163" y="connsiteY163"/>
                </a:cxn>
                <a:cxn ang="0">
                  <a:pos x="connsiteX164" y="connsiteY164"/>
                </a:cxn>
                <a:cxn ang="0">
                  <a:pos x="connsiteX165" y="connsiteY165"/>
                </a:cxn>
                <a:cxn ang="0">
                  <a:pos x="connsiteX166" y="connsiteY166"/>
                </a:cxn>
                <a:cxn ang="0">
                  <a:pos x="connsiteX167" y="connsiteY167"/>
                </a:cxn>
                <a:cxn ang="0">
                  <a:pos x="connsiteX168" y="connsiteY168"/>
                </a:cxn>
                <a:cxn ang="0">
                  <a:pos x="connsiteX169" y="connsiteY169"/>
                </a:cxn>
                <a:cxn ang="0">
                  <a:pos x="connsiteX170" y="connsiteY170"/>
                </a:cxn>
                <a:cxn ang="0">
                  <a:pos x="connsiteX171" y="connsiteY171"/>
                </a:cxn>
                <a:cxn ang="0">
                  <a:pos x="connsiteX172" y="connsiteY172"/>
                </a:cxn>
                <a:cxn ang="0">
                  <a:pos x="connsiteX173" y="connsiteY173"/>
                </a:cxn>
                <a:cxn ang="0">
                  <a:pos x="connsiteX174" y="connsiteY174"/>
                </a:cxn>
                <a:cxn ang="0">
                  <a:pos x="connsiteX175" y="connsiteY175"/>
                </a:cxn>
                <a:cxn ang="0">
                  <a:pos x="connsiteX176" y="connsiteY176"/>
                </a:cxn>
                <a:cxn ang="0">
                  <a:pos x="connsiteX177" y="connsiteY177"/>
                </a:cxn>
                <a:cxn ang="0">
                  <a:pos x="connsiteX178" y="connsiteY178"/>
                </a:cxn>
                <a:cxn ang="0">
                  <a:pos x="connsiteX179" y="connsiteY179"/>
                </a:cxn>
                <a:cxn ang="0">
                  <a:pos x="connsiteX180" y="connsiteY180"/>
                </a:cxn>
                <a:cxn ang="0">
                  <a:pos x="connsiteX181" y="connsiteY181"/>
                </a:cxn>
                <a:cxn ang="0">
                  <a:pos x="connsiteX182" y="connsiteY182"/>
                </a:cxn>
                <a:cxn ang="0">
                  <a:pos x="connsiteX183" y="connsiteY183"/>
                </a:cxn>
                <a:cxn ang="0">
                  <a:pos x="connsiteX184" y="connsiteY184"/>
                </a:cxn>
                <a:cxn ang="0">
                  <a:pos x="connsiteX185" y="connsiteY185"/>
                </a:cxn>
                <a:cxn ang="0">
                  <a:pos x="connsiteX186" y="connsiteY186"/>
                </a:cxn>
                <a:cxn ang="0">
                  <a:pos x="connsiteX187" y="connsiteY187"/>
                </a:cxn>
                <a:cxn ang="0">
                  <a:pos x="connsiteX188" y="connsiteY188"/>
                </a:cxn>
                <a:cxn ang="0">
                  <a:pos x="connsiteX189" y="connsiteY189"/>
                </a:cxn>
                <a:cxn ang="0">
                  <a:pos x="connsiteX190" y="connsiteY190"/>
                </a:cxn>
                <a:cxn ang="0">
                  <a:pos x="connsiteX191" y="connsiteY191"/>
                </a:cxn>
                <a:cxn ang="0">
                  <a:pos x="connsiteX192" y="connsiteY192"/>
                </a:cxn>
                <a:cxn ang="0">
                  <a:pos x="connsiteX193" y="connsiteY193"/>
                </a:cxn>
                <a:cxn ang="0">
                  <a:pos x="connsiteX194" y="connsiteY194"/>
                </a:cxn>
                <a:cxn ang="0">
                  <a:pos x="connsiteX195" y="connsiteY195"/>
                </a:cxn>
                <a:cxn ang="0">
                  <a:pos x="connsiteX196" y="connsiteY196"/>
                </a:cxn>
                <a:cxn ang="0">
                  <a:pos x="connsiteX197" y="connsiteY197"/>
                </a:cxn>
                <a:cxn ang="0">
                  <a:pos x="connsiteX198" y="connsiteY198"/>
                </a:cxn>
                <a:cxn ang="0">
                  <a:pos x="connsiteX199" y="connsiteY199"/>
                </a:cxn>
                <a:cxn ang="0">
                  <a:pos x="connsiteX200" y="connsiteY200"/>
                </a:cxn>
                <a:cxn ang="0">
                  <a:pos x="connsiteX201" y="connsiteY201"/>
                </a:cxn>
                <a:cxn ang="0">
                  <a:pos x="connsiteX202" y="connsiteY202"/>
                </a:cxn>
                <a:cxn ang="0">
                  <a:pos x="connsiteX203" y="connsiteY203"/>
                </a:cxn>
                <a:cxn ang="0">
                  <a:pos x="connsiteX204" y="connsiteY204"/>
                </a:cxn>
                <a:cxn ang="0">
                  <a:pos x="connsiteX205" y="connsiteY205"/>
                </a:cxn>
                <a:cxn ang="0">
                  <a:pos x="connsiteX206" y="connsiteY206"/>
                </a:cxn>
                <a:cxn ang="0">
                  <a:pos x="connsiteX207" y="connsiteY207"/>
                </a:cxn>
                <a:cxn ang="0">
                  <a:pos x="connsiteX208" y="connsiteY208"/>
                </a:cxn>
                <a:cxn ang="0">
                  <a:pos x="connsiteX209" y="connsiteY209"/>
                </a:cxn>
                <a:cxn ang="0">
                  <a:pos x="connsiteX210" y="connsiteY210"/>
                </a:cxn>
                <a:cxn ang="0">
                  <a:pos x="connsiteX211" y="connsiteY211"/>
                </a:cxn>
                <a:cxn ang="0">
                  <a:pos x="connsiteX212" y="connsiteY212"/>
                </a:cxn>
                <a:cxn ang="0">
                  <a:pos x="connsiteX213" y="connsiteY213"/>
                </a:cxn>
                <a:cxn ang="0">
                  <a:pos x="connsiteX214" y="connsiteY214"/>
                </a:cxn>
                <a:cxn ang="0">
                  <a:pos x="connsiteX215" y="connsiteY215"/>
                </a:cxn>
                <a:cxn ang="0">
                  <a:pos x="connsiteX216" y="connsiteY216"/>
                </a:cxn>
                <a:cxn ang="0">
                  <a:pos x="connsiteX217" y="connsiteY217"/>
                </a:cxn>
              </a:cxnLst>
              <a:rect l="l" t="t" r="r" b="b"/>
              <a:pathLst>
                <a:path w="1956606" h="1638300">
                  <a:moveTo>
                    <a:pt x="0" y="1022350"/>
                  </a:moveTo>
                  <a:cubicBezTo>
                    <a:pt x="22419" y="1035802"/>
                    <a:pt x="10740" y="1028452"/>
                    <a:pt x="34925" y="1044575"/>
                  </a:cubicBezTo>
                  <a:cubicBezTo>
                    <a:pt x="38100" y="1046692"/>
                    <a:pt x="40830" y="1049718"/>
                    <a:pt x="44450" y="1050925"/>
                  </a:cubicBezTo>
                  <a:cubicBezTo>
                    <a:pt x="49573" y="1052633"/>
                    <a:pt x="68784" y="1059578"/>
                    <a:pt x="76200" y="1060450"/>
                  </a:cubicBezTo>
                  <a:cubicBezTo>
                    <a:pt x="89904" y="1062062"/>
                    <a:pt x="103717" y="1062567"/>
                    <a:pt x="117475" y="1063625"/>
                  </a:cubicBezTo>
                  <a:cubicBezTo>
                    <a:pt x="122767" y="1064683"/>
                    <a:pt x="128144" y="1065380"/>
                    <a:pt x="133350" y="1066800"/>
                  </a:cubicBezTo>
                  <a:lnTo>
                    <a:pt x="161925" y="1076325"/>
                  </a:lnTo>
                  <a:lnTo>
                    <a:pt x="171450" y="1079500"/>
                  </a:lnTo>
                  <a:lnTo>
                    <a:pt x="180975" y="1082675"/>
                  </a:lnTo>
                  <a:lnTo>
                    <a:pt x="190500" y="1111250"/>
                  </a:lnTo>
                  <a:cubicBezTo>
                    <a:pt x="191558" y="1114425"/>
                    <a:pt x="193019" y="1117493"/>
                    <a:pt x="193675" y="1120775"/>
                  </a:cubicBezTo>
                  <a:cubicBezTo>
                    <a:pt x="194591" y="1125355"/>
                    <a:pt x="200796" y="1163207"/>
                    <a:pt x="206375" y="1171575"/>
                  </a:cubicBezTo>
                  <a:cubicBezTo>
                    <a:pt x="210608" y="1177925"/>
                    <a:pt x="216662" y="1183385"/>
                    <a:pt x="219075" y="1190625"/>
                  </a:cubicBezTo>
                  <a:cubicBezTo>
                    <a:pt x="220133" y="1193800"/>
                    <a:pt x="220195" y="1197508"/>
                    <a:pt x="222250" y="1200150"/>
                  </a:cubicBezTo>
                  <a:cubicBezTo>
                    <a:pt x="227763" y="1207239"/>
                    <a:pt x="235912" y="1212016"/>
                    <a:pt x="241300" y="1219200"/>
                  </a:cubicBezTo>
                  <a:cubicBezTo>
                    <a:pt x="244475" y="1223433"/>
                    <a:pt x="246760" y="1228512"/>
                    <a:pt x="250825" y="1231900"/>
                  </a:cubicBezTo>
                  <a:cubicBezTo>
                    <a:pt x="253396" y="1234043"/>
                    <a:pt x="257175" y="1234017"/>
                    <a:pt x="260350" y="1235075"/>
                  </a:cubicBezTo>
                  <a:cubicBezTo>
                    <a:pt x="274552" y="1256377"/>
                    <a:pt x="257822" y="1235506"/>
                    <a:pt x="276225" y="1247775"/>
                  </a:cubicBezTo>
                  <a:cubicBezTo>
                    <a:pt x="279961" y="1250266"/>
                    <a:pt x="282206" y="1254543"/>
                    <a:pt x="285750" y="1257300"/>
                  </a:cubicBezTo>
                  <a:cubicBezTo>
                    <a:pt x="291774" y="1261985"/>
                    <a:pt x="304800" y="1270000"/>
                    <a:pt x="304800" y="1270000"/>
                  </a:cubicBezTo>
                  <a:cubicBezTo>
                    <a:pt x="316442" y="1287462"/>
                    <a:pt x="304800" y="1272646"/>
                    <a:pt x="320675" y="1285875"/>
                  </a:cubicBezTo>
                  <a:cubicBezTo>
                    <a:pt x="324124" y="1288750"/>
                    <a:pt x="326464" y="1292909"/>
                    <a:pt x="330200" y="1295400"/>
                  </a:cubicBezTo>
                  <a:cubicBezTo>
                    <a:pt x="332985" y="1297256"/>
                    <a:pt x="336799" y="1296950"/>
                    <a:pt x="339725" y="1298575"/>
                  </a:cubicBezTo>
                  <a:cubicBezTo>
                    <a:pt x="346396" y="1302281"/>
                    <a:pt x="352425" y="1307042"/>
                    <a:pt x="358775" y="1311275"/>
                  </a:cubicBezTo>
                  <a:lnTo>
                    <a:pt x="396875" y="1336675"/>
                  </a:lnTo>
                  <a:lnTo>
                    <a:pt x="406400" y="1343025"/>
                  </a:lnTo>
                  <a:cubicBezTo>
                    <a:pt x="409575" y="1345142"/>
                    <a:pt x="412305" y="1348168"/>
                    <a:pt x="415925" y="1349375"/>
                  </a:cubicBezTo>
                  <a:lnTo>
                    <a:pt x="425450" y="1352550"/>
                  </a:lnTo>
                  <a:cubicBezTo>
                    <a:pt x="437183" y="1370149"/>
                    <a:pt x="425087" y="1356229"/>
                    <a:pt x="441325" y="1365250"/>
                  </a:cubicBezTo>
                  <a:cubicBezTo>
                    <a:pt x="447996" y="1368956"/>
                    <a:pt x="454025" y="1373717"/>
                    <a:pt x="460375" y="1377950"/>
                  </a:cubicBezTo>
                  <a:cubicBezTo>
                    <a:pt x="463550" y="1380067"/>
                    <a:pt x="466280" y="1383093"/>
                    <a:pt x="469900" y="1384300"/>
                  </a:cubicBezTo>
                  <a:lnTo>
                    <a:pt x="488950" y="1390650"/>
                  </a:lnTo>
                  <a:cubicBezTo>
                    <a:pt x="492125" y="1391708"/>
                    <a:pt x="495482" y="1392328"/>
                    <a:pt x="498475" y="1393825"/>
                  </a:cubicBezTo>
                  <a:cubicBezTo>
                    <a:pt x="502708" y="1395942"/>
                    <a:pt x="506825" y="1398311"/>
                    <a:pt x="511175" y="1400175"/>
                  </a:cubicBezTo>
                  <a:cubicBezTo>
                    <a:pt x="514251" y="1401493"/>
                    <a:pt x="517707" y="1401853"/>
                    <a:pt x="520700" y="1403350"/>
                  </a:cubicBezTo>
                  <a:cubicBezTo>
                    <a:pt x="524113" y="1405057"/>
                    <a:pt x="526812" y="1407993"/>
                    <a:pt x="530225" y="1409700"/>
                  </a:cubicBezTo>
                  <a:cubicBezTo>
                    <a:pt x="533218" y="1411197"/>
                    <a:pt x="536824" y="1411250"/>
                    <a:pt x="539750" y="1412875"/>
                  </a:cubicBezTo>
                  <a:cubicBezTo>
                    <a:pt x="546421" y="1416581"/>
                    <a:pt x="551560" y="1423162"/>
                    <a:pt x="558800" y="1425575"/>
                  </a:cubicBezTo>
                  <a:cubicBezTo>
                    <a:pt x="582741" y="1433555"/>
                    <a:pt x="553231" y="1422790"/>
                    <a:pt x="577850" y="1435100"/>
                  </a:cubicBezTo>
                  <a:cubicBezTo>
                    <a:pt x="580843" y="1436597"/>
                    <a:pt x="584449" y="1436650"/>
                    <a:pt x="587375" y="1438275"/>
                  </a:cubicBezTo>
                  <a:cubicBezTo>
                    <a:pt x="594046" y="1441981"/>
                    <a:pt x="599185" y="1448562"/>
                    <a:pt x="606425" y="1450975"/>
                  </a:cubicBezTo>
                  <a:cubicBezTo>
                    <a:pt x="630366" y="1458955"/>
                    <a:pt x="600856" y="1448190"/>
                    <a:pt x="625475" y="1460500"/>
                  </a:cubicBezTo>
                  <a:cubicBezTo>
                    <a:pt x="630810" y="1463168"/>
                    <a:pt x="642614" y="1465324"/>
                    <a:pt x="647700" y="1466850"/>
                  </a:cubicBezTo>
                  <a:cubicBezTo>
                    <a:pt x="654111" y="1468773"/>
                    <a:pt x="660186" y="1471887"/>
                    <a:pt x="666750" y="1473200"/>
                  </a:cubicBezTo>
                  <a:cubicBezTo>
                    <a:pt x="672042" y="1474258"/>
                    <a:pt x="677419" y="1474955"/>
                    <a:pt x="682625" y="1476375"/>
                  </a:cubicBezTo>
                  <a:cubicBezTo>
                    <a:pt x="689083" y="1478136"/>
                    <a:pt x="695009" y="1482119"/>
                    <a:pt x="701675" y="1482725"/>
                  </a:cubicBezTo>
                  <a:cubicBezTo>
                    <a:pt x="744053" y="1486578"/>
                    <a:pt x="725028" y="1484247"/>
                    <a:pt x="758825" y="1489075"/>
                  </a:cubicBezTo>
                  <a:cubicBezTo>
                    <a:pt x="762000" y="1490133"/>
                    <a:pt x="765737" y="1490159"/>
                    <a:pt x="768350" y="1492250"/>
                  </a:cubicBezTo>
                  <a:cubicBezTo>
                    <a:pt x="771330" y="1494634"/>
                    <a:pt x="772257" y="1498844"/>
                    <a:pt x="774700" y="1501775"/>
                  </a:cubicBezTo>
                  <a:cubicBezTo>
                    <a:pt x="777575" y="1505224"/>
                    <a:pt x="781468" y="1507756"/>
                    <a:pt x="784225" y="1511300"/>
                  </a:cubicBezTo>
                  <a:cubicBezTo>
                    <a:pt x="804171" y="1536944"/>
                    <a:pt x="788011" y="1524407"/>
                    <a:pt x="806450" y="1536700"/>
                  </a:cubicBezTo>
                  <a:cubicBezTo>
                    <a:pt x="821682" y="1559549"/>
                    <a:pt x="800112" y="1531416"/>
                    <a:pt x="831850" y="1552575"/>
                  </a:cubicBezTo>
                  <a:cubicBezTo>
                    <a:pt x="838200" y="1556808"/>
                    <a:pt x="843660" y="1562862"/>
                    <a:pt x="850900" y="1565275"/>
                  </a:cubicBezTo>
                  <a:cubicBezTo>
                    <a:pt x="854075" y="1566333"/>
                    <a:pt x="857432" y="1566953"/>
                    <a:pt x="860425" y="1568450"/>
                  </a:cubicBezTo>
                  <a:cubicBezTo>
                    <a:pt x="863838" y="1570157"/>
                    <a:pt x="866463" y="1573250"/>
                    <a:pt x="869950" y="1574800"/>
                  </a:cubicBezTo>
                  <a:cubicBezTo>
                    <a:pt x="876067" y="1577518"/>
                    <a:pt x="882650" y="1579033"/>
                    <a:pt x="889000" y="1581150"/>
                  </a:cubicBezTo>
                  <a:cubicBezTo>
                    <a:pt x="892175" y="1582208"/>
                    <a:pt x="895740" y="1582469"/>
                    <a:pt x="898525" y="1584325"/>
                  </a:cubicBezTo>
                  <a:cubicBezTo>
                    <a:pt x="901700" y="1586442"/>
                    <a:pt x="904464" y="1589371"/>
                    <a:pt x="908050" y="1590675"/>
                  </a:cubicBezTo>
                  <a:cubicBezTo>
                    <a:pt x="916252" y="1593657"/>
                    <a:pt x="925171" y="1594265"/>
                    <a:pt x="933450" y="1597025"/>
                  </a:cubicBezTo>
                  <a:lnTo>
                    <a:pt x="952500" y="1603375"/>
                  </a:lnTo>
                  <a:lnTo>
                    <a:pt x="981075" y="1612900"/>
                  </a:lnTo>
                  <a:cubicBezTo>
                    <a:pt x="984250" y="1613958"/>
                    <a:pt x="987299" y="1615525"/>
                    <a:pt x="990600" y="1616075"/>
                  </a:cubicBezTo>
                  <a:lnTo>
                    <a:pt x="1009650" y="1619250"/>
                  </a:lnTo>
                  <a:cubicBezTo>
                    <a:pt x="1017047" y="1620388"/>
                    <a:pt x="1024512" y="1621086"/>
                    <a:pt x="1031875" y="1622425"/>
                  </a:cubicBezTo>
                  <a:cubicBezTo>
                    <a:pt x="1036168" y="1623206"/>
                    <a:pt x="1040271" y="1624883"/>
                    <a:pt x="1044575" y="1625600"/>
                  </a:cubicBezTo>
                  <a:cubicBezTo>
                    <a:pt x="1052991" y="1627003"/>
                    <a:pt x="1061521" y="1627622"/>
                    <a:pt x="1069975" y="1628775"/>
                  </a:cubicBezTo>
                  <a:cubicBezTo>
                    <a:pt x="1134772" y="1637611"/>
                    <a:pt x="1092555" y="1632938"/>
                    <a:pt x="1146175" y="1638300"/>
                  </a:cubicBezTo>
                  <a:cubicBezTo>
                    <a:pt x="1589788" y="1628218"/>
                    <a:pt x="1037541" y="1638300"/>
                    <a:pt x="1390650" y="1638300"/>
                  </a:cubicBezTo>
                  <a:cubicBezTo>
                    <a:pt x="1470032" y="1638300"/>
                    <a:pt x="1549400" y="1636183"/>
                    <a:pt x="1628775" y="1635125"/>
                  </a:cubicBezTo>
                  <a:cubicBezTo>
                    <a:pt x="1657381" y="1632741"/>
                    <a:pt x="1664214" y="1632923"/>
                    <a:pt x="1689100" y="1628775"/>
                  </a:cubicBezTo>
                  <a:cubicBezTo>
                    <a:pt x="1694423" y="1627888"/>
                    <a:pt x="1699769" y="1627020"/>
                    <a:pt x="1704975" y="1625600"/>
                  </a:cubicBezTo>
                  <a:cubicBezTo>
                    <a:pt x="1711433" y="1623839"/>
                    <a:pt x="1718456" y="1622963"/>
                    <a:pt x="1724025" y="1619250"/>
                  </a:cubicBezTo>
                  <a:lnTo>
                    <a:pt x="1733550" y="1612900"/>
                  </a:lnTo>
                  <a:cubicBezTo>
                    <a:pt x="1735667" y="1609725"/>
                    <a:pt x="1738193" y="1606788"/>
                    <a:pt x="1739900" y="1603375"/>
                  </a:cubicBezTo>
                  <a:cubicBezTo>
                    <a:pt x="1745751" y="1591672"/>
                    <a:pt x="1744926" y="1572034"/>
                    <a:pt x="1746250" y="1562100"/>
                  </a:cubicBezTo>
                  <a:cubicBezTo>
                    <a:pt x="1747068" y="1555962"/>
                    <a:pt x="1750714" y="1540127"/>
                    <a:pt x="1752600" y="1533525"/>
                  </a:cubicBezTo>
                  <a:cubicBezTo>
                    <a:pt x="1757920" y="1514904"/>
                    <a:pt x="1752848" y="1533028"/>
                    <a:pt x="1762125" y="1514475"/>
                  </a:cubicBezTo>
                  <a:cubicBezTo>
                    <a:pt x="1763622" y="1511482"/>
                    <a:pt x="1762577" y="1506895"/>
                    <a:pt x="1765300" y="1504950"/>
                  </a:cubicBezTo>
                  <a:cubicBezTo>
                    <a:pt x="1770747" y="1501059"/>
                    <a:pt x="1778781" y="1502313"/>
                    <a:pt x="1784350" y="1498600"/>
                  </a:cubicBezTo>
                  <a:cubicBezTo>
                    <a:pt x="1799444" y="1488537"/>
                    <a:pt x="1790255" y="1493457"/>
                    <a:pt x="1812925" y="1485900"/>
                  </a:cubicBezTo>
                  <a:cubicBezTo>
                    <a:pt x="1816100" y="1484842"/>
                    <a:pt x="1819665" y="1484581"/>
                    <a:pt x="1822450" y="1482725"/>
                  </a:cubicBezTo>
                  <a:lnTo>
                    <a:pt x="1841500" y="1470025"/>
                  </a:lnTo>
                  <a:cubicBezTo>
                    <a:pt x="1843617" y="1466850"/>
                    <a:pt x="1845152" y="1463198"/>
                    <a:pt x="1847850" y="1460500"/>
                  </a:cubicBezTo>
                  <a:cubicBezTo>
                    <a:pt x="1850548" y="1457802"/>
                    <a:pt x="1854444" y="1456593"/>
                    <a:pt x="1857375" y="1454150"/>
                  </a:cubicBezTo>
                  <a:cubicBezTo>
                    <a:pt x="1862653" y="1449752"/>
                    <a:pt x="1870312" y="1441711"/>
                    <a:pt x="1873250" y="1435100"/>
                  </a:cubicBezTo>
                  <a:cubicBezTo>
                    <a:pt x="1875968" y="1428983"/>
                    <a:pt x="1877483" y="1422400"/>
                    <a:pt x="1879600" y="1416050"/>
                  </a:cubicBezTo>
                  <a:lnTo>
                    <a:pt x="1882775" y="1406525"/>
                  </a:lnTo>
                  <a:cubicBezTo>
                    <a:pt x="1886190" y="1379205"/>
                    <a:pt x="1889125" y="1359983"/>
                    <a:pt x="1889125" y="1330325"/>
                  </a:cubicBezTo>
                  <a:cubicBezTo>
                    <a:pt x="1889125" y="1293268"/>
                    <a:pt x="1888415" y="1256175"/>
                    <a:pt x="1885950" y="1219200"/>
                  </a:cubicBezTo>
                  <a:cubicBezTo>
                    <a:pt x="1883822" y="1187284"/>
                    <a:pt x="1879580" y="1193722"/>
                    <a:pt x="1873250" y="1168400"/>
                  </a:cubicBezTo>
                  <a:cubicBezTo>
                    <a:pt x="1872233" y="1164331"/>
                    <a:pt x="1869177" y="1150730"/>
                    <a:pt x="1866900" y="1146175"/>
                  </a:cubicBezTo>
                  <a:cubicBezTo>
                    <a:pt x="1865193" y="1142762"/>
                    <a:pt x="1862257" y="1140063"/>
                    <a:pt x="1860550" y="1136650"/>
                  </a:cubicBezTo>
                  <a:cubicBezTo>
                    <a:pt x="1859053" y="1133657"/>
                    <a:pt x="1859000" y="1130051"/>
                    <a:pt x="1857375" y="1127125"/>
                  </a:cubicBezTo>
                  <a:cubicBezTo>
                    <a:pt x="1853669" y="1120454"/>
                    <a:pt x="1847088" y="1115315"/>
                    <a:pt x="1844675" y="1108075"/>
                  </a:cubicBezTo>
                  <a:cubicBezTo>
                    <a:pt x="1843617" y="1104900"/>
                    <a:pt x="1842997" y="1101543"/>
                    <a:pt x="1841500" y="1098550"/>
                  </a:cubicBezTo>
                  <a:cubicBezTo>
                    <a:pt x="1839793" y="1095137"/>
                    <a:pt x="1836857" y="1092438"/>
                    <a:pt x="1835150" y="1089025"/>
                  </a:cubicBezTo>
                  <a:cubicBezTo>
                    <a:pt x="1833653" y="1086032"/>
                    <a:pt x="1833600" y="1082426"/>
                    <a:pt x="1831975" y="1079500"/>
                  </a:cubicBezTo>
                  <a:cubicBezTo>
                    <a:pt x="1828269" y="1072829"/>
                    <a:pt x="1823508" y="1066800"/>
                    <a:pt x="1819275" y="1060450"/>
                  </a:cubicBezTo>
                  <a:lnTo>
                    <a:pt x="1806575" y="1041400"/>
                  </a:lnTo>
                  <a:lnTo>
                    <a:pt x="1800225" y="1031875"/>
                  </a:lnTo>
                  <a:cubicBezTo>
                    <a:pt x="1798108" y="1028700"/>
                    <a:pt x="1796165" y="1025403"/>
                    <a:pt x="1793875" y="1022350"/>
                  </a:cubicBezTo>
                  <a:cubicBezTo>
                    <a:pt x="1790700" y="1018117"/>
                    <a:pt x="1788092" y="1013392"/>
                    <a:pt x="1784350" y="1009650"/>
                  </a:cubicBezTo>
                  <a:cubicBezTo>
                    <a:pt x="1781652" y="1006952"/>
                    <a:pt x="1778000" y="1005417"/>
                    <a:pt x="1774825" y="1003300"/>
                  </a:cubicBezTo>
                  <a:cubicBezTo>
                    <a:pt x="1769613" y="987663"/>
                    <a:pt x="1775382" y="998472"/>
                    <a:pt x="1762125" y="987425"/>
                  </a:cubicBezTo>
                  <a:cubicBezTo>
                    <a:pt x="1753580" y="980304"/>
                    <a:pt x="1753210" y="976055"/>
                    <a:pt x="1743075" y="971550"/>
                  </a:cubicBezTo>
                  <a:cubicBezTo>
                    <a:pt x="1736958" y="968832"/>
                    <a:pt x="1729594" y="968913"/>
                    <a:pt x="1724025" y="965200"/>
                  </a:cubicBezTo>
                  <a:cubicBezTo>
                    <a:pt x="1720850" y="963083"/>
                    <a:pt x="1717913" y="960557"/>
                    <a:pt x="1714500" y="958850"/>
                  </a:cubicBezTo>
                  <a:cubicBezTo>
                    <a:pt x="1711507" y="957353"/>
                    <a:pt x="1708222" y="956487"/>
                    <a:pt x="1704975" y="955675"/>
                  </a:cubicBezTo>
                  <a:cubicBezTo>
                    <a:pt x="1688306" y="951508"/>
                    <a:pt x="1679184" y="951520"/>
                    <a:pt x="1660525" y="949325"/>
                  </a:cubicBezTo>
                  <a:cubicBezTo>
                    <a:pt x="1650312" y="948124"/>
                    <a:pt x="1627264" y="945461"/>
                    <a:pt x="1616075" y="942975"/>
                  </a:cubicBezTo>
                  <a:cubicBezTo>
                    <a:pt x="1608264" y="941239"/>
                    <a:pt x="1603252" y="938640"/>
                    <a:pt x="1597025" y="933450"/>
                  </a:cubicBezTo>
                  <a:cubicBezTo>
                    <a:pt x="1593576" y="930575"/>
                    <a:pt x="1590949" y="926800"/>
                    <a:pt x="1587500" y="923925"/>
                  </a:cubicBezTo>
                  <a:cubicBezTo>
                    <a:pt x="1584569" y="921482"/>
                    <a:pt x="1581150" y="919692"/>
                    <a:pt x="1577975" y="917575"/>
                  </a:cubicBezTo>
                  <a:cubicBezTo>
                    <a:pt x="1575858" y="914400"/>
                    <a:pt x="1573175" y="911537"/>
                    <a:pt x="1571625" y="908050"/>
                  </a:cubicBezTo>
                  <a:cubicBezTo>
                    <a:pt x="1556512" y="874045"/>
                    <a:pt x="1573296" y="901031"/>
                    <a:pt x="1558925" y="879475"/>
                  </a:cubicBezTo>
                  <a:cubicBezTo>
                    <a:pt x="1547646" y="834359"/>
                    <a:pt x="1558529" y="870083"/>
                    <a:pt x="1546225" y="841375"/>
                  </a:cubicBezTo>
                  <a:cubicBezTo>
                    <a:pt x="1544907" y="838299"/>
                    <a:pt x="1544675" y="834776"/>
                    <a:pt x="1543050" y="831850"/>
                  </a:cubicBezTo>
                  <a:cubicBezTo>
                    <a:pt x="1539344" y="825179"/>
                    <a:pt x="1534583" y="819150"/>
                    <a:pt x="1530350" y="812800"/>
                  </a:cubicBezTo>
                  <a:lnTo>
                    <a:pt x="1524000" y="803275"/>
                  </a:lnTo>
                  <a:lnTo>
                    <a:pt x="1511300" y="784225"/>
                  </a:lnTo>
                  <a:cubicBezTo>
                    <a:pt x="1509183" y="781050"/>
                    <a:pt x="1508125" y="776817"/>
                    <a:pt x="1504950" y="774700"/>
                  </a:cubicBezTo>
                  <a:lnTo>
                    <a:pt x="1476375" y="755650"/>
                  </a:lnTo>
                  <a:cubicBezTo>
                    <a:pt x="1473200" y="753533"/>
                    <a:pt x="1470470" y="750507"/>
                    <a:pt x="1466850" y="749300"/>
                  </a:cubicBezTo>
                  <a:lnTo>
                    <a:pt x="1457325" y="746125"/>
                  </a:lnTo>
                  <a:cubicBezTo>
                    <a:pt x="1426939" y="715739"/>
                    <a:pt x="1465844" y="751805"/>
                    <a:pt x="1438275" y="733425"/>
                  </a:cubicBezTo>
                  <a:cubicBezTo>
                    <a:pt x="1434539" y="730934"/>
                    <a:pt x="1432486" y="726391"/>
                    <a:pt x="1428750" y="723900"/>
                  </a:cubicBezTo>
                  <a:cubicBezTo>
                    <a:pt x="1425965" y="722044"/>
                    <a:pt x="1422151" y="722350"/>
                    <a:pt x="1419225" y="720725"/>
                  </a:cubicBezTo>
                  <a:cubicBezTo>
                    <a:pt x="1412554" y="717019"/>
                    <a:pt x="1406525" y="712258"/>
                    <a:pt x="1400175" y="708025"/>
                  </a:cubicBezTo>
                  <a:lnTo>
                    <a:pt x="1381125" y="695325"/>
                  </a:lnTo>
                  <a:lnTo>
                    <a:pt x="1371600" y="688975"/>
                  </a:lnTo>
                  <a:cubicBezTo>
                    <a:pt x="1368425" y="686858"/>
                    <a:pt x="1365695" y="683832"/>
                    <a:pt x="1362075" y="682625"/>
                  </a:cubicBezTo>
                  <a:lnTo>
                    <a:pt x="1343025" y="676275"/>
                  </a:lnTo>
                  <a:cubicBezTo>
                    <a:pt x="1333203" y="679549"/>
                    <a:pt x="1325626" y="682625"/>
                    <a:pt x="1314450" y="682625"/>
                  </a:cubicBezTo>
                  <a:cubicBezTo>
                    <a:pt x="1310463" y="682625"/>
                    <a:pt x="1296717" y="677772"/>
                    <a:pt x="1292225" y="676275"/>
                  </a:cubicBezTo>
                  <a:cubicBezTo>
                    <a:pt x="1275292" y="650875"/>
                    <a:pt x="1297517" y="681567"/>
                    <a:pt x="1276350" y="660400"/>
                  </a:cubicBezTo>
                  <a:cubicBezTo>
                    <a:pt x="1273652" y="657702"/>
                    <a:pt x="1272443" y="653806"/>
                    <a:pt x="1270000" y="650875"/>
                  </a:cubicBezTo>
                  <a:cubicBezTo>
                    <a:pt x="1264319" y="644058"/>
                    <a:pt x="1248505" y="630066"/>
                    <a:pt x="1241425" y="628650"/>
                  </a:cubicBezTo>
                  <a:lnTo>
                    <a:pt x="1225550" y="625475"/>
                  </a:lnTo>
                  <a:cubicBezTo>
                    <a:pt x="1210733" y="626533"/>
                    <a:pt x="1195728" y="626069"/>
                    <a:pt x="1181100" y="628650"/>
                  </a:cubicBezTo>
                  <a:cubicBezTo>
                    <a:pt x="1175100" y="629709"/>
                    <a:pt x="1165730" y="641459"/>
                    <a:pt x="1162050" y="644525"/>
                  </a:cubicBezTo>
                  <a:cubicBezTo>
                    <a:pt x="1159119" y="646968"/>
                    <a:pt x="1155456" y="648432"/>
                    <a:pt x="1152525" y="650875"/>
                  </a:cubicBezTo>
                  <a:cubicBezTo>
                    <a:pt x="1136670" y="664088"/>
                    <a:pt x="1150214" y="657995"/>
                    <a:pt x="1133475" y="663575"/>
                  </a:cubicBezTo>
                  <a:cubicBezTo>
                    <a:pt x="1129242" y="662517"/>
                    <a:pt x="1124182" y="663126"/>
                    <a:pt x="1120775" y="660400"/>
                  </a:cubicBezTo>
                  <a:cubicBezTo>
                    <a:pt x="1118162" y="658309"/>
                    <a:pt x="1117600" y="654222"/>
                    <a:pt x="1117600" y="650875"/>
                  </a:cubicBezTo>
                  <a:cubicBezTo>
                    <a:pt x="1117600" y="623338"/>
                    <a:pt x="1118880" y="595797"/>
                    <a:pt x="1120775" y="568325"/>
                  </a:cubicBezTo>
                  <a:cubicBezTo>
                    <a:pt x="1121608" y="556252"/>
                    <a:pt x="1132938" y="550885"/>
                    <a:pt x="1136650" y="539750"/>
                  </a:cubicBezTo>
                  <a:cubicBezTo>
                    <a:pt x="1144630" y="515809"/>
                    <a:pt x="1133865" y="545319"/>
                    <a:pt x="1146175" y="520700"/>
                  </a:cubicBezTo>
                  <a:cubicBezTo>
                    <a:pt x="1147672" y="517707"/>
                    <a:pt x="1147853" y="514168"/>
                    <a:pt x="1149350" y="511175"/>
                  </a:cubicBezTo>
                  <a:cubicBezTo>
                    <a:pt x="1151057" y="507762"/>
                    <a:pt x="1153993" y="505063"/>
                    <a:pt x="1155700" y="501650"/>
                  </a:cubicBezTo>
                  <a:cubicBezTo>
                    <a:pt x="1157197" y="498657"/>
                    <a:pt x="1157378" y="495118"/>
                    <a:pt x="1158875" y="492125"/>
                  </a:cubicBezTo>
                  <a:cubicBezTo>
                    <a:pt x="1160582" y="488712"/>
                    <a:pt x="1163518" y="486013"/>
                    <a:pt x="1165225" y="482600"/>
                  </a:cubicBezTo>
                  <a:cubicBezTo>
                    <a:pt x="1166722" y="479607"/>
                    <a:pt x="1166775" y="476001"/>
                    <a:pt x="1168400" y="473075"/>
                  </a:cubicBezTo>
                  <a:cubicBezTo>
                    <a:pt x="1172106" y="466404"/>
                    <a:pt x="1176867" y="460375"/>
                    <a:pt x="1181100" y="454025"/>
                  </a:cubicBezTo>
                  <a:lnTo>
                    <a:pt x="1187450" y="444500"/>
                  </a:lnTo>
                  <a:cubicBezTo>
                    <a:pt x="1189567" y="441325"/>
                    <a:pt x="1190625" y="437092"/>
                    <a:pt x="1193800" y="434975"/>
                  </a:cubicBezTo>
                  <a:lnTo>
                    <a:pt x="1203325" y="428625"/>
                  </a:lnTo>
                  <a:cubicBezTo>
                    <a:pt x="1204383" y="425450"/>
                    <a:pt x="1204133" y="421467"/>
                    <a:pt x="1206500" y="419100"/>
                  </a:cubicBezTo>
                  <a:cubicBezTo>
                    <a:pt x="1211896" y="413704"/>
                    <a:pt x="1225550" y="406400"/>
                    <a:pt x="1225550" y="406400"/>
                  </a:cubicBezTo>
                  <a:cubicBezTo>
                    <a:pt x="1227667" y="403225"/>
                    <a:pt x="1228664" y="398897"/>
                    <a:pt x="1231900" y="396875"/>
                  </a:cubicBezTo>
                  <a:cubicBezTo>
                    <a:pt x="1237576" y="393327"/>
                    <a:pt x="1244600" y="392642"/>
                    <a:pt x="1250950" y="390525"/>
                  </a:cubicBezTo>
                  <a:lnTo>
                    <a:pt x="1260475" y="387350"/>
                  </a:lnTo>
                  <a:cubicBezTo>
                    <a:pt x="1263650" y="386292"/>
                    <a:pt x="1266753" y="384987"/>
                    <a:pt x="1270000" y="384175"/>
                  </a:cubicBezTo>
                  <a:lnTo>
                    <a:pt x="1282700" y="381000"/>
                  </a:lnTo>
                  <a:cubicBezTo>
                    <a:pt x="1291212" y="381709"/>
                    <a:pt x="1317356" y="380865"/>
                    <a:pt x="1330325" y="387350"/>
                  </a:cubicBezTo>
                  <a:cubicBezTo>
                    <a:pt x="1333738" y="389057"/>
                    <a:pt x="1336675" y="391583"/>
                    <a:pt x="1339850" y="393700"/>
                  </a:cubicBezTo>
                  <a:cubicBezTo>
                    <a:pt x="1356783" y="419100"/>
                    <a:pt x="1334558" y="388408"/>
                    <a:pt x="1355725" y="409575"/>
                  </a:cubicBezTo>
                  <a:cubicBezTo>
                    <a:pt x="1358423" y="412273"/>
                    <a:pt x="1359632" y="416169"/>
                    <a:pt x="1362075" y="419100"/>
                  </a:cubicBezTo>
                  <a:cubicBezTo>
                    <a:pt x="1364950" y="422549"/>
                    <a:pt x="1368725" y="425176"/>
                    <a:pt x="1371600" y="428625"/>
                  </a:cubicBezTo>
                  <a:cubicBezTo>
                    <a:pt x="1374043" y="431556"/>
                    <a:pt x="1375252" y="435452"/>
                    <a:pt x="1377950" y="438150"/>
                  </a:cubicBezTo>
                  <a:cubicBezTo>
                    <a:pt x="1380648" y="440848"/>
                    <a:pt x="1384544" y="442057"/>
                    <a:pt x="1387475" y="444500"/>
                  </a:cubicBezTo>
                  <a:cubicBezTo>
                    <a:pt x="1390924" y="447375"/>
                    <a:pt x="1393075" y="451844"/>
                    <a:pt x="1397000" y="454025"/>
                  </a:cubicBezTo>
                  <a:cubicBezTo>
                    <a:pt x="1402851" y="457276"/>
                    <a:pt x="1409700" y="458258"/>
                    <a:pt x="1416050" y="460375"/>
                  </a:cubicBezTo>
                  <a:cubicBezTo>
                    <a:pt x="1419225" y="461433"/>
                    <a:pt x="1422231" y="463405"/>
                    <a:pt x="1425575" y="463550"/>
                  </a:cubicBezTo>
                  <a:lnTo>
                    <a:pt x="1498600" y="466725"/>
                  </a:lnTo>
                  <a:cubicBezTo>
                    <a:pt x="1555097" y="474796"/>
                    <a:pt x="1496100" y="465590"/>
                    <a:pt x="1533525" y="473075"/>
                  </a:cubicBezTo>
                  <a:cubicBezTo>
                    <a:pt x="1548784" y="476127"/>
                    <a:pt x="1562367" y="477474"/>
                    <a:pt x="1577975" y="479425"/>
                  </a:cubicBezTo>
                  <a:cubicBezTo>
                    <a:pt x="1609725" y="478367"/>
                    <a:pt x="1641512" y="478115"/>
                    <a:pt x="1673225" y="476250"/>
                  </a:cubicBezTo>
                  <a:cubicBezTo>
                    <a:pt x="1677581" y="475994"/>
                    <a:pt x="1681745" y="474329"/>
                    <a:pt x="1685925" y="473075"/>
                  </a:cubicBezTo>
                  <a:lnTo>
                    <a:pt x="1714500" y="463550"/>
                  </a:lnTo>
                  <a:lnTo>
                    <a:pt x="1724025" y="460375"/>
                  </a:lnTo>
                  <a:cubicBezTo>
                    <a:pt x="1727200" y="459317"/>
                    <a:pt x="1730765" y="459056"/>
                    <a:pt x="1733550" y="457200"/>
                  </a:cubicBezTo>
                  <a:cubicBezTo>
                    <a:pt x="1736725" y="455083"/>
                    <a:pt x="1739588" y="452400"/>
                    <a:pt x="1743075" y="450850"/>
                  </a:cubicBezTo>
                  <a:cubicBezTo>
                    <a:pt x="1749192" y="448132"/>
                    <a:pt x="1755775" y="446617"/>
                    <a:pt x="1762125" y="444500"/>
                  </a:cubicBezTo>
                  <a:cubicBezTo>
                    <a:pt x="1765300" y="443442"/>
                    <a:pt x="1768865" y="443181"/>
                    <a:pt x="1771650" y="441325"/>
                  </a:cubicBezTo>
                  <a:cubicBezTo>
                    <a:pt x="1786744" y="431262"/>
                    <a:pt x="1777555" y="436182"/>
                    <a:pt x="1800225" y="428625"/>
                  </a:cubicBezTo>
                  <a:cubicBezTo>
                    <a:pt x="1803400" y="427567"/>
                    <a:pt x="1806965" y="427306"/>
                    <a:pt x="1809750" y="425450"/>
                  </a:cubicBezTo>
                  <a:cubicBezTo>
                    <a:pt x="1812925" y="423333"/>
                    <a:pt x="1815788" y="420650"/>
                    <a:pt x="1819275" y="419100"/>
                  </a:cubicBezTo>
                  <a:cubicBezTo>
                    <a:pt x="1825392" y="416382"/>
                    <a:pt x="1831975" y="414867"/>
                    <a:pt x="1838325" y="412750"/>
                  </a:cubicBezTo>
                  <a:cubicBezTo>
                    <a:pt x="1841500" y="411692"/>
                    <a:pt x="1845065" y="411431"/>
                    <a:pt x="1847850" y="409575"/>
                  </a:cubicBezTo>
                  <a:cubicBezTo>
                    <a:pt x="1875147" y="391377"/>
                    <a:pt x="1840610" y="413195"/>
                    <a:pt x="1866900" y="400050"/>
                  </a:cubicBezTo>
                  <a:cubicBezTo>
                    <a:pt x="1891519" y="387740"/>
                    <a:pt x="1862009" y="398505"/>
                    <a:pt x="1885950" y="390525"/>
                  </a:cubicBezTo>
                  <a:cubicBezTo>
                    <a:pt x="1889125" y="387350"/>
                    <a:pt x="1892600" y="384449"/>
                    <a:pt x="1895475" y="381000"/>
                  </a:cubicBezTo>
                  <a:cubicBezTo>
                    <a:pt x="1897918" y="378069"/>
                    <a:pt x="1899127" y="374173"/>
                    <a:pt x="1901825" y="371475"/>
                  </a:cubicBezTo>
                  <a:cubicBezTo>
                    <a:pt x="1904523" y="368777"/>
                    <a:pt x="1908419" y="367568"/>
                    <a:pt x="1911350" y="365125"/>
                  </a:cubicBezTo>
                  <a:cubicBezTo>
                    <a:pt x="1914799" y="362250"/>
                    <a:pt x="1917426" y="358475"/>
                    <a:pt x="1920875" y="355600"/>
                  </a:cubicBezTo>
                  <a:cubicBezTo>
                    <a:pt x="1923806" y="353157"/>
                    <a:pt x="1927469" y="351693"/>
                    <a:pt x="1930400" y="349250"/>
                  </a:cubicBezTo>
                  <a:cubicBezTo>
                    <a:pt x="1933849" y="346375"/>
                    <a:pt x="1937168" y="343269"/>
                    <a:pt x="1939925" y="339725"/>
                  </a:cubicBezTo>
                  <a:cubicBezTo>
                    <a:pt x="1944610" y="333701"/>
                    <a:pt x="1952625" y="320675"/>
                    <a:pt x="1952625" y="320675"/>
                  </a:cubicBezTo>
                  <a:cubicBezTo>
                    <a:pt x="1958231" y="264614"/>
                    <a:pt x="1957628" y="285073"/>
                    <a:pt x="1952625" y="200025"/>
                  </a:cubicBezTo>
                  <a:cubicBezTo>
                    <a:pt x="1952387" y="195978"/>
                    <a:pt x="1949673" y="177566"/>
                    <a:pt x="1946275" y="171450"/>
                  </a:cubicBezTo>
                  <a:cubicBezTo>
                    <a:pt x="1942569" y="164779"/>
                    <a:pt x="1937808" y="158750"/>
                    <a:pt x="1933575" y="152400"/>
                  </a:cubicBezTo>
                  <a:lnTo>
                    <a:pt x="1927225" y="142875"/>
                  </a:lnTo>
                  <a:lnTo>
                    <a:pt x="1920875" y="133350"/>
                  </a:lnTo>
                  <a:cubicBezTo>
                    <a:pt x="1918758" y="130175"/>
                    <a:pt x="1917700" y="125942"/>
                    <a:pt x="1914525" y="123825"/>
                  </a:cubicBezTo>
                  <a:lnTo>
                    <a:pt x="1905000" y="117475"/>
                  </a:lnTo>
                  <a:cubicBezTo>
                    <a:pt x="1900314" y="110447"/>
                    <a:pt x="1896459" y="103314"/>
                    <a:pt x="1889125" y="98425"/>
                  </a:cubicBezTo>
                  <a:cubicBezTo>
                    <a:pt x="1886340" y="96569"/>
                    <a:pt x="1882775" y="96308"/>
                    <a:pt x="1879600" y="95250"/>
                  </a:cubicBezTo>
                  <a:cubicBezTo>
                    <a:pt x="1877483" y="92075"/>
                    <a:pt x="1876230" y="88109"/>
                    <a:pt x="1873250" y="85725"/>
                  </a:cubicBezTo>
                  <a:cubicBezTo>
                    <a:pt x="1870637" y="83634"/>
                    <a:pt x="1866718" y="84047"/>
                    <a:pt x="1863725" y="82550"/>
                  </a:cubicBezTo>
                  <a:cubicBezTo>
                    <a:pt x="1839106" y="70240"/>
                    <a:pt x="1868616" y="81005"/>
                    <a:pt x="1844675" y="73025"/>
                  </a:cubicBezTo>
                  <a:cubicBezTo>
                    <a:pt x="1842558" y="69850"/>
                    <a:pt x="1841561" y="65522"/>
                    <a:pt x="1838325" y="63500"/>
                  </a:cubicBezTo>
                  <a:cubicBezTo>
                    <a:pt x="1832649" y="59952"/>
                    <a:pt x="1819275" y="57150"/>
                    <a:pt x="1819275" y="57150"/>
                  </a:cubicBezTo>
                  <a:cubicBezTo>
                    <a:pt x="1812253" y="50128"/>
                    <a:pt x="1809066" y="45695"/>
                    <a:pt x="1800225" y="41275"/>
                  </a:cubicBezTo>
                  <a:cubicBezTo>
                    <a:pt x="1773935" y="28130"/>
                    <a:pt x="1808472" y="49948"/>
                    <a:pt x="1781175" y="31750"/>
                  </a:cubicBezTo>
                  <a:cubicBezTo>
                    <a:pt x="1779058" y="28575"/>
                    <a:pt x="1777805" y="24609"/>
                    <a:pt x="1774825" y="22225"/>
                  </a:cubicBezTo>
                  <a:cubicBezTo>
                    <a:pt x="1772212" y="20134"/>
                    <a:pt x="1768293" y="20547"/>
                    <a:pt x="1765300" y="19050"/>
                  </a:cubicBezTo>
                  <a:cubicBezTo>
                    <a:pt x="1761887" y="17343"/>
                    <a:pt x="1758706" y="15143"/>
                    <a:pt x="1755775" y="12700"/>
                  </a:cubicBezTo>
                  <a:cubicBezTo>
                    <a:pt x="1738977" y="-1298"/>
                    <a:pt x="1753217" y="6659"/>
                    <a:pt x="1739900" y="0"/>
                  </a:cubicBezTo>
                </a:path>
              </a:pathLst>
            </a:custGeom>
            <a:noFill/>
            <a:ln w="38100">
              <a:solidFill>
                <a:schemeClr val="bg1"/>
              </a:solidFill>
              <a:prstDash val="sysDot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9666">
                <a:ln w="38100">
                  <a:solidFill>
                    <a:schemeClr val="tx1"/>
                  </a:solidFill>
                </a:ln>
              </a:endParaRPr>
            </a:p>
          </p:txBody>
        </p:sp>
        <p:sp>
          <p:nvSpPr>
            <p:cNvPr id="39" name="Freeform 38"/>
            <p:cNvSpPr/>
            <p:nvPr/>
          </p:nvSpPr>
          <p:spPr>
            <a:xfrm>
              <a:off x="6165111" y="1462771"/>
              <a:ext cx="462719" cy="626200"/>
            </a:xfrm>
            <a:custGeom>
              <a:avLst/>
              <a:gdLst>
                <a:gd name="connsiteX0" fmla="*/ 0 w 482618"/>
                <a:gd name="connsiteY0" fmla="*/ 314325 h 606425"/>
                <a:gd name="connsiteX1" fmla="*/ 12700 w 482618"/>
                <a:gd name="connsiteY1" fmla="*/ 349250 h 606425"/>
                <a:gd name="connsiteX2" fmla="*/ 15875 w 482618"/>
                <a:gd name="connsiteY2" fmla="*/ 358775 h 606425"/>
                <a:gd name="connsiteX3" fmla="*/ 19050 w 482618"/>
                <a:gd name="connsiteY3" fmla="*/ 368300 h 606425"/>
                <a:gd name="connsiteX4" fmla="*/ 22225 w 482618"/>
                <a:gd name="connsiteY4" fmla="*/ 387350 h 606425"/>
                <a:gd name="connsiteX5" fmla="*/ 28575 w 482618"/>
                <a:gd name="connsiteY5" fmla="*/ 425450 h 606425"/>
                <a:gd name="connsiteX6" fmla="*/ 34925 w 482618"/>
                <a:gd name="connsiteY6" fmla="*/ 444500 h 606425"/>
                <a:gd name="connsiteX7" fmla="*/ 41275 w 482618"/>
                <a:gd name="connsiteY7" fmla="*/ 469900 h 606425"/>
                <a:gd name="connsiteX8" fmla="*/ 47625 w 482618"/>
                <a:gd name="connsiteY8" fmla="*/ 488950 h 606425"/>
                <a:gd name="connsiteX9" fmla="*/ 50800 w 482618"/>
                <a:gd name="connsiteY9" fmla="*/ 498475 h 606425"/>
                <a:gd name="connsiteX10" fmla="*/ 53975 w 482618"/>
                <a:gd name="connsiteY10" fmla="*/ 511175 h 606425"/>
                <a:gd name="connsiteX11" fmla="*/ 63500 w 482618"/>
                <a:gd name="connsiteY11" fmla="*/ 539750 h 606425"/>
                <a:gd name="connsiteX12" fmla="*/ 66675 w 482618"/>
                <a:gd name="connsiteY12" fmla="*/ 549275 h 606425"/>
                <a:gd name="connsiteX13" fmla="*/ 73025 w 482618"/>
                <a:gd name="connsiteY13" fmla="*/ 558800 h 606425"/>
                <a:gd name="connsiteX14" fmla="*/ 76200 w 482618"/>
                <a:gd name="connsiteY14" fmla="*/ 568325 h 606425"/>
                <a:gd name="connsiteX15" fmla="*/ 95250 w 482618"/>
                <a:gd name="connsiteY15" fmla="*/ 596900 h 606425"/>
                <a:gd name="connsiteX16" fmla="*/ 101600 w 482618"/>
                <a:gd name="connsiteY16" fmla="*/ 606425 h 606425"/>
                <a:gd name="connsiteX17" fmla="*/ 136525 w 482618"/>
                <a:gd name="connsiteY17" fmla="*/ 603250 h 606425"/>
                <a:gd name="connsiteX18" fmla="*/ 146050 w 482618"/>
                <a:gd name="connsiteY18" fmla="*/ 600075 h 606425"/>
                <a:gd name="connsiteX19" fmla="*/ 152400 w 482618"/>
                <a:gd name="connsiteY19" fmla="*/ 581025 h 606425"/>
                <a:gd name="connsiteX20" fmla="*/ 155575 w 482618"/>
                <a:gd name="connsiteY20" fmla="*/ 568325 h 606425"/>
                <a:gd name="connsiteX21" fmla="*/ 161925 w 482618"/>
                <a:gd name="connsiteY21" fmla="*/ 539750 h 606425"/>
                <a:gd name="connsiteX22" fmla="*/ 168275 w 482618"/>
                <a:gd name="connsiteY22" fmla="*/ 479425 h 606425"/>
                <a:gd name="connsiteX23" fmla="*/ 171450 w 482618"/>
                <a:gd name="connsiteY23" fmla="*/ 454025 h 606425"/>
                <a:gd name="connsiteX24" fmla="*/ 174625 w 482618"/>
                <a:gd name="connsiteY24" fmla="*/ 441325 h 606425"/>
                <a:gd name="connsiteX25" fmla="*/ 177800 w 482618"/>
                <a:gd name="connsiteY25" fmla="*/ 425450 h 606425"/>
                <a:gd name="connsiteX26" fmla="*/ 184150 w 482618"/>
                <a:gd name="connsiteY26" fmla="*/ 406400 h 606425"/>
                <a:gd name="connsiteX27" fmla="*/ 190500 w 482618"/>
                <a:gd name="connsiteY27" fmla="*/ 387350 h 606425"/>
                <a:gd name="connsiteX28" fmla="*/ 196850 w 482618"/>
                <a:gd name="connsiteY28" fmla="*/ 368300 h 606425"/>
                <a:gd name="connsiteX29" fmla="*/ 200025 w 482618"/>
                <a:gd name="connsiteY29" fmla="*/ 358775 h 606425"/>
                <a:gd name="connsiteX30" fmla="*/ 206375 w 482618"/>
                <a:gd name="connsiteY30" fmla="*/ 349250 h 606425"/>
                <a:gd name="connsiteX31" fmla="*/ 212725 w 482618"/>
                <a:gd name="connsiteY31" fmla="*/ 330200 h 606425"/>
                <a:gd name="connsiteX32" fmla="*/ 250825 w 482618"/>
                <a:gd name="connsiteY32" fmla="*/ 273050 h 606425"/>
                <a:gd name="connsiteX33" fmla="*/ 257175 w 482618"/>
                <a:gd name="connsiteY33" fmla="*/ 263525 h 606425"/>
                <a:gd name="connsiteX34" fmla="*/ 276225 w 482618"/>
                <a:gd name="connsiteY34" fmla="*/ 244475 h 606425"/>
                <a:gd name="connsiteX35" fmla="*/ 288925 w 482618"/>
                <a:gd name="connsiteY35" fmla="*/ 228600 h 606425"/>
                <a:gd name="connsiteX36" fmla="*/ 301625 w 482618"/>
                <a:gd name="connsiteY36" fmla="*/ 209550 h 606425"/>
                <a:gd name="connsiteX37" fmla="*/ 320675 w 482618"/>
                <a:gd name="connsiteY37" fmla="*/ 196850 h 606425"/>
                <a:gd name="connsiteX38" fmla="*/ 327025 w 482618"/>
                <a:gd name="connsiteY38" fmla="*/ 187325 h 606425"/>
                <a:gd name="connsiteX39" fmla="*/ 346075 w 482618"/>
                <a:gd name="connsiteY39" fmla="*/ 174625 h 606425"/>
                <a:gd name="connsiteX40" fmla="*/ 368300 w 482618"/>
                <a:gd name="connsiteY40" fmla="*/ 146050 h 606425"/>
                <a:gd name="connsiteX41" fmla="*/ 377825 w 482618"/>
                <a:gd name="connsiteY41" fmla="*/ 139700 h 606425"/>
                <a:gd name="connsiteX42" fmla="*/ 384175 w 482618"/>
                <a:gd name="connsiteY42" fmla="*/ 130175 h 606425"/>
                <a:gd name="connsiteX43" fmla="*/ 393700 w 482618"/>
                <a:gd name="connsiteY43" fmla="*/ 123825 h 606425"/>
                <a:gd name="connsiteX44" fmla="*/ 396875 w 482618"/>
                <a:gd name="connsiteY44" fmla="*/ 114300 h 606425"/>
                <a:gd name="connsiteX45" fmla="*/ 406400 w 482618"/>
                <a:gd name="connsiteY45" fmla="*/ 104775 h 606425"/>
                <a:gd name="connsiteX46" fmla="*/ 419100 w 482618"/>
                <a:gd name="connsiteY46" fmla="*/ 85725 h 606425"/>
                <a:gd name="connsiteX47" fmla="*/ 425450 w 482618"/>
                <a:gd name="connsiteY47" fmla="*/ 76200 h 606425"/>
                <a:gd name="connsiteX48" fmla="*/ 441325 w 482618"/>
                <a:gd name="connsiteY48" fmla="*/ 57150 h 606425"/>
                <a:gd name="connsiteX49" fmla="*/ 450850 w 482618"/>
                <a:gd name="connsiteY49" fmla="*/ 47625 h 606425"/>
                <a:gd name="connsiteX50" fmla="*/ 460375 w 482618"/>
                <a:gd name="connsiteY50" fmla="*/ 28575 h 606425"/>
                <a:gd name="connsiteX51" fmla="*/ 469900 w 482618"/>
                <a:gd name="connsiteY51" fmla="*/ 19050 h 606425"/>
                <a:gd name="connsiteX52" fmla="*/ 473075 w 482618"/>
                <a:gd name="connsiteY52" fmla="*/ 9525 h 606425"/>
                <a:gd name="connsiteX53" fmla="*/ 482600 w 482618"/>
                <a:gd name="connsiteY53" fmla="*/ 0 h 60642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  <a:cxn ang="0">
                  <a:pos x="connsiteX29" y="connsiteY29"/>
                </a:cxn>
                <a:cxn ang="0">
                  <a:pos x="connsiteX30" y="connsiteY30"/>
                </a:cxn>
                <a:cxn ang="0">
                  <a:pos x="connsiteX31" y="connsiteY31"/>
                </a:cxn>
                <a:cxn ang="0">
                  <a:pos x="connsiteX32" y="connsiteY32"/>
                </a:cxn>
                <a:cxn ang="0">
                  <a:pos x="connsiteX33" y="connsiteY33"/>
                </a:cxn>
                <a:cxn ang="0">
                  <a:pos x="connsiteX34" y="connsiteY34"/>
                </a:cxn>
                <a:cxn ang="0">
                  <a:pos x="connsiteX35" y="connsiteY35"/>
                </a:cxn>
                <a:cxn ang="0">
                  <a:pos x="connsiteX36" y="connsiteY36"/>
                </a:cxn>
                <a:cxn ang="0">
                  <a:pos x="connsiteX37" y="connsiteY37"/>
                </a:cxn>
                <a:cxn ang="0">
                  <a:pos x="connsiteX38" y="connsiteY38"/>
                </a:cxn>
                <a:cxn ang="0">
                  <a:pos x="connsiteX39" y="connsiteY39"/>
                </a:cxn>
                <a:cxn ang="0">
                  <a:pos x="connsiteX40" y="connsiteY40"/>
                </a:cxn>
                <a:cxn ang="0">
                  <a:pos x="connsiteX41" y="connsiteY41"/>
                </a:cxn>
                <a:cxn ang="0">
                  <a:pos x="connsiteX42" y="connsiteY42"/>
                </a:cxn>
                <a:cxn ang="0">
                  <a:pos x="connsiteX43" y="connsiteY43"/>
                </a:cxn>
                <a:cxn ang="0">
                  <a:pos x="connsiteX44" y="connsiteY44"/>
                </a:cxn>
                <a:cxn ang="0">
                  <a:pos x="connsiteX45" y="connsiteY45"/>
                </a:cxn>
                <a:cxn ang="0">
                  <a:pos x="connsiteX46" y="connsiteY46"/>
                </a:cxn>
                <a:cxn ang="0">
                  <a:pos x="connsiteX47" y="connsiteY47"/>
                </a:cxn>
                <a:cxn ang="0">
                  <a:pos x="connsiteX48" y="connsiteY48"/>
                </a:cxn>
                <a:cxn ang="0">
                  <a:pos x="connsiteX49" y="connsiteY49"/>
                </a:cxn>
                <a:cxn ang="0">
                  <a:pos x="connsiteX50" y="connsiteY50"/>
                </a:cxn>
                <a:cxn ang="0">
                  <a:pos x="connsiteX51" y="connsiteY51"/>
                </a:cxn>
                <a:cxn ang="0">
                  <a:pos x="connsiteX52" y="connsiteY52"/>
                </a:cxn>
                <a:cxn ang="0">
                  <a:pos x="connsiteX53" y="connsiteY53"/>
                </a:cxn>
              </a:cxnLst>
              <a:rect l="l" t="t" r="r" b="b"/>
              <a:pathLst>
                <a:path w="482618" h="606425">
                  <a:moveTo>
                    <a:pt x="0" y="314325"/>
                  </a:moveTo>
                  <a:cubicBezTo>
                    <a:pt x="8836" y="336415"/>
                    <a:pt x="4548" y="324793"/>
                    <a:pt x="12700" y="349250"/>
                  </a:cubicBezTo>
                  <a:lnTo>
                    <a:pt x="15875" y="358775"/>
                  </a:lnTo>
                  <a:cubicBezTo>
                    <a:pt x="16933" y="361950"/>
                    <a:pt x="18500" y="364999"/>
                    <a:pt x="19050" y="368300"/>
                  </a:cubicBezTo>
                  <a:cubicBezTo>
                    <a:pt x="20108" y="374650"/>
                    <a:pt x="21246" y="380987"/>
                    <a:pt x="22225" y="387350"/>
                  </a:cubicBezTo>
                  <a:cubicBezTo>
                    <a:pt x="23828" y="397772"/>
                    <a:pt x="25616" y="414600"/>
                    <a:pt x="28575" y="425450"/>
                  </a:cubicBezTo>
                  <a:cubicBezTo>
                    <a:pt x="30336" y="431908"/>
                    <a:pt x="33302" y="438006"/>
                    <a:pt x="34925" y="444500"/>
                  </a:cubicBezTo>
                  <a:cubicBezTo>
                    <a:pt x="37042" y="452967"/>
                    <a:pt x="38515" y="461621"/>
                    <a:pt x="41275" y="469900"/>
                  </a:cubicBezTo>
                  <a:lnTo>
                    <a:pt x="47625" y="488950"/>
                  </a:lnTo>
                  <a:cubicBezTo>
                    <a:pt x="48683" y="492125"/>
                    <a:pt x="49988" y="495228"/>
                    <a:pt x="50800" y="498475"/>
                  </a:cubicBezTo>
                  <a:cubicBezTo>
                    <a:pt x="51858" y="502708"/>
                    <a:pt x="52721" y="506995"/>
                    <a:pt x="53975" y="511175"/>
                  </a:cubicBezTo>
                  <a:lnTo>
                    <a:pt x="63500" y="539750"/>
                  </a:lnTo>
                  <a:cubicBezTo>
                    <a:pt x="64558" y="542925"/>
                    <a:pt x="64819" y="546490"/>
                    <a:pt x="66675" y="549275"/>
                  </a:cubicBezTo>
                  <a:cubicBezTo>
                    <a:pt x="68792" y="552450"/>
                    <a:pt x="71318" y="555387"/>
                    <a:pt x="73025" y="558800"/>
                  </a:cubicBezTo>
                  <a:cubicBezTo>
                    <a:pt x="74522" y="561793"/>
                    <a:pt x="74575" y="565399"/>
                    <a:pt x="76200" y="568325"/>
                  </a:cubicBezTo>
                  <a:lnTo>
                    <a:pt x="95250" y="596900"/>
                  </a:lnTo>
                  <a:lnTo>
                    <a:pt x="101600" y="606425"/>
                  </a:lnTo>
                  <a:cubicBezTo>
                    <a:pt x="113242" y="605367"/>
                    <a:pt x="124953" y="604903"/>
                    <a:pt x="136525" y="603250"/>
                  </a:cubicBezTo>
                  <a:cubicBezTo>
                    <a:pt x="139838" y="602777"/>
                    <a:pt x="144105" y="602798"/>
                    <a:pt x="146050" y="600075"/>
                  </a:cubicBezTo>
                  <a:cubicBezTo>
                    <a:pt x="149941" y="594628"/>
                    <a:pt x="150777" y="587519"/>
                    <a:pt x="152400" y="581025"/>
                  </a:cubicBezTo>
                  <a:cubicBezTo>
                    <a:pt x="153458" y="576792"/>
                    <a:pt x="154628" y="572585"/>
                    <a:pt x="155575" y="568325"/>
                  </a:cubicBezTo>
                  <a:cubicBezTo>
                    <a:pt x="163637" y="532048"/>
                    <a:pt x="154182" y="570723"/>
                    <a:pt x="161925" y="539750"/>
                  </a:cubicBezTo>
                  <a:cubicBezTo>
                    <a:pt x="164042" y="519642"/>
                    <a:pt x="165767" y="499488"/>
                    <a:pt x="168275" y="479425"/>
                  </a:cubicBezTo>
                  <a:cubicBezTo>
                    <a:pt x="169333" y="470958"/>
                    <a:pt x="170047" y="462441"/>
                    <a:pt x="171450" y="454025"/>
                  </a:cubicBezTo>
                  <a:cubicBezTo>
                    <a:pt x="172167" y="449721"/>
                    <a:pt x="173678" y="445585"/>
                    <a:pt x="174625" y="441325"/>
                  </a:cubicBezTo>
                  <a:cubicBezTo>
                    <a:pt x="175796" y="436057"/>
                    <a:pt x="176380" y="430656"/>
                    <a:pt x="177800" y="425450"/>
                  </a:cubicBezTo>
                  <a:cubicBezTo>
                    <a:pt x="179561" y="418992"/>
                    <a:pt x="182033" y="412750"/>
                    <a:pt x="184150" y="406400"/>
                  </a:cubicBezTo>
                  <a:lnTo>
                    <a:pt x="190500" y="387350"/>
                  </a:lnTo>
                  <a:lnTo>
                    <a:pt x="196850" y="368300"/>
                  </a:lnTo>
                  <a:cubicBezTo>
                    <a:pt x="197908" y="365125"/>
                    <a:pt x="198169" y="361560"/>
                    <a:pt x="200025" y="358775"/>
                  </a:cubicBezTo>
                  <a:cubicBezTo>
                    <a:pt x="202142" y="355600"/>
                    <a:pt x="204825" y="352737"/>
                    <a:pt x="206375" y="349250"/>
                  </a:cubicBezTo>
                  <a:cubicBezTo>
                    <a:pt x="209093" y="343133"/>
                    <a:pt x="209012" y="335769"/>
                    <a:pt x="212725" y="330200"/>
                  </a:cubicBezTo>
                  <a:lnTo>
                    <a:pt x="250825" y="273050"/>
                  </a:lnTo>
                  <a:cubicBezTo>
                    <a:pt x="252942" y="269875"/>
                    <a:pt x="254477" y="266223"/>
                    <a:pt x="257175" y="263525"/>
                  </a:cubicBezTo>
                  <a:lnTo>
                    <a:pt x="276225" y="244475"/>
                  </a:lnTo>
                  <a:cubicBezTo>
                    <a:pt x="283375" y="223025"/>
                    <a:pt x="273459" y="246275"/>
                    <a:pt x="288925" y="228600"/>
                  </a:cubicBezTo>
                  <a:cubicBezTo>
                    <a:pt x="293951" y="222857"/>
                    <a:pt x="295275" y="213783"/>
                    <a:pt x="301625" y="209550"/>
                  </a:cubicBezTo>
                  <a:lnTo>
                    <a:pt x="320675" y="196850"/>
                  </a:lnTo>
                  <a:cubicBezTo>
                    <a:pt x="322792" y="193675"/>
                    <a:pt x="324153" y="189838"/>
                    <a:pt x="327025" y="187325"/>
                  </a:cubicBezTo>
                  <a:cubicBezTo>
                    <a:pt x="332768" y="182299"/>
                    <a:pt x="346075" y="174625"/>
                    <a:pt x="346075" y="174625"/>
                  </a:cubicBezTo>
                  <a:cubicBezTo>
                    <a:pt x="354925" y="161350"/>
                    <a:pt x="357109" y="155376"/>
                    <a:pt x="368300" y="146050"/>
                  </a:cubicBezTo>
                  <a:cubicBezTo>
                    <a:pt x="371231" y="143607"/>
                    <a:pt x="374650" y="141817"/>
                    <a:pt x="377825" y="139700"/>
                  </a:cubicBezTo>
                  <a:cubicBezTo>
                    <a:pt x="379942" y="136525"/>
                    <a:pt x="381477" y="132873"/>
                    <a:pt x="384175" y="130175"/>
                  </a:cubicBezTo>
                  <a:cubicBezTo>
                    <a:pt x="386873" y="127477"/>
                    <a:pt x="391316" y="126805"/>
                    <a:pt x="393700" y="123825"/>
                  </a:cubicBezTo>
                  <a:cubicBezTo>
                    <a:pt x="395791" y="121212"/>
                    <a:pt x="395019" y="117085"/>
                    <a:pt x="396875" y="114300"/>
                  </a:cubicBezTo>
                  <a:cubicBezTo>
                    <a:pt x="399366" y="110564"/>
                    <a:pt x="403643" y="108319"/>
                    <a:pt x="406400" y="104775"/>
                  </a:cubicBezTo>
                  <a:cubicBezTo>
                    <a:pt x="411085" y="98751"/>
                    <a:pt x="414867" y="92075"/>
                    <a:pt x="419100" y="85725"/>
                  </a:cubicBezTo>
                  <a:cubicBezTo>
                    <a:pt x="421217" y="82550"/>
                    <a:pt x="422752" y="78898"/>
                    <a:pt x="425450" y="76200"/>
                  </a:cubicBezTo>
                  <a:cubicBezTo>
                    <a:pt x="453277" y="48373"/>
                    <a:pt x="419223" y="83672"/>
                    <a:pt x="441325" y="57150"/>
                  </a:cubicBezTo>
                  <a:cubicBezTo>
                    <a:pt x="444200" y="53701"/>
                    <a:pt x="447975" y="51074"/>
                    <a:pt x="450850" y="47625"/>
                  </a:cubicBezTo>
                  <a:cubicBezTo>
                    <a:pt x="475829" y="17650"/>
                    <a:pt x="441282" y="57214"/>
                    <a:pt x="460375" y="28575"/>
                  </a:cubicBezTo>
                  <a:cubicBezTo>
                    <a:pt x="462866" y="24839"/>
                    <a:pt x="466725" y="22225"/>
                    <a:pt x="469900" y="19050"/>
                  </a:cubicBezTo>
                  <a:cubicBezTo>
                    <a:pt x="470958" y="15875"/>
                    <a:pt x="470984" y="12138"/>
                    <a:pt x="473075" y="9525"/>
                  </a:cubicBezTo>
                  <a:cubicBezTo>
                    <a:pt x="483481" y="-3482"/>
                    <a:pt x="482600" y="8674"/>
                    <a:pt x="482600" y="0"/>
                  </a:cubicBezTo>
                </a:path>
              </a:pathLst>
            </a:custGeom>
            <a:noFill/>
            <a:ln w="38100">
              <a:solidFill>
                <a:schemeClr val="bg1"/>
              </a:solidFill>
              <a:prstDash val="sysDot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9666"/>
            </a:p>
          </p:txBody>
        </p:sp>
        <p:sp>
          <p:nvSpPr>
            <p:cNvPr id="40" name="Freeform 39"/>
            <p:cNvSpPr/>
            <p:nvPr/>
          </p:nvSpPr>
          <p:spPr>
            <a:xfrm>
              <a:off x="6636945" y="950046"/>
              <a:ext cx="438349" cy="491780"/>
            </a:xfrm>
            <a:custGeom>
              <a:avLst/>
              <a:gdLst>
                <a:gd name="connsiteX0" fmla="*/ 0 w 457200"/>
                <a:gd name="connsiteY0" fmla="*/ 476250 h 476250"/>
                <a:gd name="connsiteX1" fmla="*/ 15875 w 457200"/>
                <a:gd name="connsiteY1" fmla="*/ 450850 h 476250"/>
                <a:gd name="connsiteX2" fmla="*/ 22225 w 457200"/>
                <a:gd name="connsiteY2" fmla="*/ 441325 h 476250"/>
                <a:gd name="connsiteX3" fmla="*/ 28575 w 457200"/>
                <a:gd name="connsiteY3" fmla="*/ 422275 h 476250"/>
                <a:gd name="connsiteX4" fmla="*/ 53975 w 457200"/>
                <a:gd name="connsiteY4" fmla="*/ 384175 h 476250"/>
                <a:gd name="connsiteX5" fmla="*/ 60325 w 457200"/>
                <a:gd name="connsiteY5" fmla="*/ 374650 h 476250"/>
                <a:gd name="connsiteX6" fmla="*/ 73025 w 457200"/>
                <a:gd name="connsiteY6" fmla="*/ 355600 h 476250"/>
                <a:gd name="connsiteX7" fmla="*/ 85725 w 457200"/>
                <a:gd name="connsiteY7" fmla="*/ 336550 h 476250"/>
                <a:gd name="connsiteX8" fmla="*/ 88900 w 457200"/>
                <a:gd name="connsiteY8" fmla="*/ 327025 h 476250"/>
                <a:gd name="connsiteX9" fmla="*/ 101600 w 457200"/>
                <a:gd name="connsiteY9" fmla="*/ 307975 h 476250"/>
                <a:gd name="connsiteX10" fmla="*/ 104775 w 457200"/>
                <a:gd name="connsiteY10" fmla="*/ 298450 h 476250"/>
                <a:gd name="connsiteX11" fmla="*/ 117475 w 457200"/>
                <a:gd name="connsiteY11" fmla="*/ 279400 h 476250"/>
                <a:gd name="connsiteX12" fmla="*/ 123825 w 457200"/>
                <a:gd name="connsiteY12" fmla="*/ 269875 h 476250"/>
                <a:gd name="connsiteX13" fmla="*/ 130175 w 457200"/>
                <a:gd name="connsiteY13" fmla="*/ 260350 h 476250"/>
                <a:gd name="connsiteX14" fmla="*/ 142875 w 457200"/>
                <a:gd name="connsiteY14" fmla="*/ 241300 h 476250"/>
                <a:gd name="connsiteX15" fmla="*/ 155575 w 457200"/>
                <a:gd name="connsiteY15" fmla="*/ 219075 h 476250"/>
                <a:gd name="connsiteX16" fmla="*/ 168275 w 457200"/>
                <a:gd name="connsiteY16" fmla="*/ 203200 h 476250"/>
                <a:gd name="connsiteX17" fmla="*/ 180975 w 457200"/>
                <a:gd name="connsiteY17" fmla="*/ 184150 h 476250"/>
                <a:gd name="connsiteX18" fmla="*/ 193675 w 457200"/>
                <a:gd name="connsiteY18" fmla="*/ 168275 h 476250"/>
                <a:gd name="connsiteX19" fmla="*/ 206375 w 457200"/>
                <a:gd name="connsiteY19" fmla="*/ 149225 h 476250"/>
                <a:gd name="connsiteX20" fmla="*/ 212725 w 457200"/>
                <a:gd name="connsiteY20" fmla="*/ 139700 h 476250"/>
                <a:gd name="connsiteX21" fmla="*/ 222250 w 457200"/>
                <a:gd name="connsiteY21" fmla="*/ 130175 h 476250"/>
                <a:gd name="connsiteX22" fmla="*/ 244475 w 457200"/>
                <a:gd name="connsiteY22" fmla="*/ 101600 h 476250"/>
                <a:gd name="connsiteX23" fmla="*/ 263525 w 457200"/>
                <a:gd name="connsiteY23" fmla="*/ 88900 h 476250"/>
                <a:gd name="connsiteX24" fmla="*/ 285750 w 457200"/>
                <a:gd name="connsiteY24" fmla="*/ 79375 h 476250"/>
                <a:gd name="connsiteX25" fmla="*/ 307975 w 457200"/>
                <a:gd name="connsiteY25" fmla="*/ 69850 h 476250"/>
                <a:gd name="connsiteX26" fmla="*/ 317500 w 457200"/>
                <a:gd name="connsiteY26" fmla="*/ 63500 h 476250"/>
                <a:gd name="connsiteX27" fmla="*/ 330200 w 457200"/>
                <a:gd name="connsiteY27" fmla="*/ 53975 h 476250"/>
                <a:gd name="connsiteX28" fmla="*/ 339725 w 457200"/>
                <a:gd name="connsiteY28" fmla="*/ 50800 h 476250"/>
                <a:gd name="connsiteX29" fmla="*/ 368300 w 457200"/>
                <a:gd name="connsiteY29" fmla="*/ 34925 h 476250"/>
                <a:gd name="connsiteX30" fmla="*/ 377825 w 457200"/>
                <a:gd name="connsiteY30" fmla="*/ 28575 h 476250"/>
                <a:gd name="connsiteX31" fmla="*/ 396875 w 457200"/>
                <a:gd name="connsiteY31" fmla="*/ 22225 h 476250"/>
                <a:gd name="connsiteX32" fmla="*/ 425450 w 457200"/>
                <a:gd name="connsiteY32" fmla="*/ 9525 h 476250"/>
                <a:gd name="connsiteX33" fmla="*/ 438150 w 457200"/>
                <a:gd name="connsiteY33" fmla="*/ 6350 h 476250"/>
                <a:gd name="connsiteX34" fmla="*/ 457200 w 457200"/>
                <a:gd name="connsiteY34" fmla="*/ 0 h 47625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  <a:cxn ang="0">
                  <a:pos x="connsiteX29" y="connsiteY29"/>
                </a:cxn>
                <a:cxn ang="0">
                  <a:pos x="connsiteX30" y="connsiteY30"/>
                </a:cxn>
                <a:cxn ang="0">
                  <a:pos x="connsiteX31" y="connsiteY31"/>
                </a:cxn>
                <a:cxn ang="0">
                  <a:pos x="connsiteX32" y="connsiteY32"/>
                </a:cxn>
                <a:cxn ang="0">
                  <a:pos x="connsiteX33" y="connsiteY33"/>
                </a:cxn>
                <a:cxn ang="0">
                  <a:pos x="connsiteX34" y="connsiteY34"/>
                </a:cxn>
              </a:cxnLst>
              <a:rect l="l" t="t" r="r" b="b"/>
              <a:pathLst>
                <a:path w="457200" h="476250">
                  <a:moveTo>
                    <a:pt x="0" y="476250"/>
                  </a:moveTo>
                  <a:cubicBezTo>
                    <a:pt x="29148" y="439815"/>
                    <a:pt x="3466" y="475667"/>
                    <a:pt x="15875" y="450850"/>
                  </a:cubicBezTo>
                  <a:cubicBezTo>
                    <a:pt x="17582" y="447437"/>
                    <a:pt x="20675" y="444812"/>
                    <a:pt x="22225" y="441325"/>
                  </a:cubicBezTo>
                  <a:cubicBezTo>
                    <a:pt x="24943" y="435208"/>
                    <a:pt x="24862" y="427844"/>
                    <a:pt x="28575" y="422275"/>
                  </a:cubicBezTo>
                  <a:lnTo>
                    <a:pt x="53975" y="384175"/>
                  </a:lnTo>
                  <a:cubicBezTo>
                    <a:pt x="56092" y="381000"/>
                    <a:pt x="59118" y="378270"/>
                    <a:pt x="60325" y="374650"/>
                  </a:cubicBezTo>
                  <a:cubicBezTo>
                    <a:pt x="64920" y="360865"/>
                    <a:pt x="61133" y="367492"/>
                    <a:pt x="73025" y="355600"/>
                  </a:cubicBezTo>
                  <a:cubicBezTo>
                    <a:pt x="80574" y="332952"/>
                    <a:pt x="69870" y="360333"/>
                    <a:pt x="85725" y="336550"/>
                  </a:cubicBezTo>
                  <a:cubicBezTo>
                    <a:pt x="87581" y="333765"/>
                    <a:pt x="87275" y="329951"/>
                    <a:pt x="88900" y="327025"/>
                  </a:cubicBezTo>
                  <a:cubicBezTo>
                    <a:pt x="92606" y="320354"/>
                    <a:pt x="99187" y="315215"/>
                    <a:pt x="101600" y="307975"/>
                  </a:cubicBezTo>
                  <a:cubicBezTo>
                    <a:pt x="102658" y="304800"/>
                    <a:pt x="103150" y="301376"/>
                    <a:pt x="104775" y="298450"/>
                  </a:cubicBezTo>
                  <a:cubicBezTo>
                    <a:pt x="108481" y="291779"/>
                    <a:pt x="113242" y="285750"/>
                    <a:pt x="117475" y="279400"/>
                  </a:cubicBezTo>
                  <a:lnTo>
                    <a:pt x="123825" y="269875"/>
                  </a:lnTo>
                  <a:cubicBezTo>
                    <a:pt x="125942" y="266700"/>
                    <a:pt x="128968" y="263970"/>
                    <a:pt x="130175" y="260350"/>
                  </a:cubicBezTo>
                  <a:cubicBezTo>
                    <a:pt x="134770" y="246565"/>
                    <a:pt x="130983" y="253192"/>
                    <a:pt x="142875" y="241300"/>
                  </a:cubicBezTo>
                  <a:cubicBezTo>
                    <a:pt x="150155" y="219461"/>
                    <a:pt x="140198" y="245985"/>
                    <a:pt x="155575" y="219075"/>
                  </a:cubicBezTo>
                  <a:cubicBezTo>
                    <a:pt x="165012" y="202559"/>
                    <a:pt x="150201" y="215249"/>
                    <a:pt x="168275" y="203200"/>
                  </a:cubicBezTo>
                  <a:cubicBezTo>
                    <a:pt x="175824" y="180552"/>
                    <a:pt x="165120" y="207933"/>
                    <a:pt x="180975" y="184150"/>
                  </a:cubicBezTo>
                  <a:cubicBezTo>
                    <a:pt x="193244" y="165747"/>
                    <a:pt x="172373" y="182477"/>
                    <a:pt x="193675" y="168275"/>
                  </a:cubicBezTo>
                  <a:lnTo>
                    <a:pt x="206375" y="149225"/>
                  </a:lnTo>
                  <a:cubicBezTo>
                    <a:pt x="208492" y="146050"/>
                    <a:pt x="210027" y="142398"/>
                    <a:pt x="212725" y="139700"/>
                  </a:cubicBezTo>
                  <a:cubicBezTo>
                    <a:pt x="215900" y="136525"/>
                    <a:pt x="219493" y="133719"/>
                    <a:pt x="222250" y="130175"/>
                  </a:cubicBezTo>
                  <a:cubicBezTo>
                    <a:pt x="232754" y="116670"/>
                    <a:pt x="232311" y="111061"/>
                    <a:pt x="244475" y="101600"/>
                  </a:cubicBezTo>
                  <a:cubicBezTo>
                    <a:pt x="250499" y="96915"/>
                    <a:pt x="256285" y="91313"/>
                    <a:pt x="263525" y="88900"/>
                  </a:cubicBezTo>
                  <a:cubicBezTo>
                    <a:pt x="285863" y="81454"/>
                    <a:pt x="258287" y="91145"/>
                    <a:pt x="285750" y="79375"/>
                  </a:cubicBezTo>
                  <a:cubicBezTo>
                    <a:pt x="303560" y="71742"/>
                    <a:pt x="286915" y="81884"/>
                    <a:pt x="307975" y="69850"/>
                  </a:cubicBezTo>
                  <a:cubicBezTo>
                    <a:pt x="311288" y="67957"/>
                    <a:pt x="314395" y="65718"/>
                    <a:pt x="317500" y="63500"/>
                  </a:cubicBezTo>
                  <a:cubicBezTo>
                    <a:pt x="321806" y="60424"/>
                    <a:pt x="325606" y="56600"/>
                    <a:pt x="330200" y="53975"/>
                  </a:cubicBezTo>
                  <a:cubicBezTo>
                    <a:pt x="333106" y="52315"/>
                    <a:pt x="336550" y="51858"/>
                    <a:pt x="339725" y="50800"/>
                  </a:cubicBezTo>
                  <a:cubicBezTo>
                    <a:pt x="369620" y="20905"/>
                    <a:pt x="321681" y="66005"/>
                    <a:pt x="368300" y="34925"/>
                  </a:cubicBezTo>
                  <a:cubicBezTo>
                    <a:pt x="371475" y="32808"/>
                    <a:pt x="374338" y="30125"/>
                    <a:pt x="377825" y="28575"/>
                  </a:cubicBezTo>
                  <a:cubicBezTo>
                    <a:pt x="383942" y="25857"/>
                    <a:pt x="391306" y="25938"/>
                    <a:pt x="396875" y="22225"/>
                  </a:cubicBezTo>
                  <a:cubicBezTo>
                    <a:pt x="409385" y="13885"/>
                    <a:pt x="407314" y="14059"/>
                    <a:pt x="425450" y="9525"/>
                  </a:cubicBezTo>
                  <a:cubicBezTo>
                    <a:pt x="429683" y="8467"/>
                    <a:pt x="433970" y="7604"/>
                    <a:pt x="438150" y="6350"/>
                  </a:cubicBezTo>
                  <a:cubicBezTo>
                    <a:pt x="444561" y="4427"/>
                    <a:pt x="457200" y="0"/>
                    <a:pt x="457200" y="0"/>
                  </a:cubicBezTo>
                </a:path>
              </a:pathLst>
            </a:custGeom>
            <a:noFill/>
            <a:ln w="38100">
              <a:solidFill>
                <a:schemeClr val="bg1"/>
              </a:solidFill>
              <a:prstDash val="sysDot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9666"/>
            </a:p>
          </p:txBody>
        </p:sp>
        <p:sp>
          <p:nvSpPr>
            <p:cNvPr id="41" name="Freeform 40"/>
            <p:cNvSpPr/>
            <p:nvPr/>
          </p:nvSpPr>
          <p:spPr>
            <a:xfrm>
              <a:off x="7081382" y="542496"/>
              <a:ext cx="2152170" cy="1439276"/>
            </a:xfrm>
            <a:custGeom>
              <a:avLst/>
              <a:gdLst>
                <a:gd name="connsiteX0" fmla="*/ 0 w 2244725"/>
                <a:gd name="connsiteY0" fmla="*/ 390525 h 1393825"/>
                <a:gd name="connsiteX1" fmla="*/ 25400 w 2244725"/>
                <a:gd name="connsiteY1" fmla="*/ 384175 h 1393825"/>
                <a:gd name="connsiteX2" fmla="*/ 53975 w 2244725"/>
                <a:gd name="connsiteY2" fmla="*/ 371475 h 1393825"/>
                <a:gd name="connsiteX3" fmla="*/ 161925 w 2244725"/>
                <a:gd name="connsiteY3" fmla="*/ 365125 h 1393825"/>
                <a:gd name="connsiteX4" fmla="*/ 184150 w 2244725"/>
                <a:gd name="connsiteY4" fmla="*/ 358775 h 1393825"/>
                <a:gd name="connsiteX5" fmla="*/ 203200 w 2244725"/>
                <a:gd name="connsiteY5" fmla="*/ 352425 h 1393825"/>
                <a:gd name="connsiteX6" fmla="*/ 244475 w 2244725"/>
                <a:gd name="connsiteY6" fmla="*/ 342900 h 1393825"/>
                <a:gd name="connsiteX7" fmla="*/ 263525 w 2244725"/>
                <a:gd name="connsiteY7" fmla="*/ 336550 h 1393825"/>
                <a:gd name="connsiteX8" fmla="*/ 292100 w 2244725"/>
                <a:gd name="connsiteY8" fmla="*/ 320675 h 1393825"/>
                <a:gd name="connsiteX9" fmla="*/ 301625 w 2244725"/>
                <a:gd name="connsiteY9" fmla="*/ 311150 h 1393825"/>
                <a:gd name="connsiteX10" fmla="*/ 314325 w 2244725"/>
                <a:gd name="connsiteY10" fmla="*/ 292100 h 1393825"/>
                <a:gd name="connsiteX11" fmla="*/ 320675 w 2244725"/>
                <a:gd name="connsiteY11" fmla="*/ 282575 h 1393825"/>
                <a:gd name="connsiteX12" fmla="*/ 327025 w 2244725"/>
                <a:gd name="connsiteY12" fmla="*/ 273050 h 1393825"/>
                <a:gd name="connsiteX13" fmla="*/ 333375 w 2244725"/>
                <a:gd name="connsiteY13" fmla="*/ 263525 h 1393825"/>
                <a:gd name="connsiteX14" fmla="*/ 336550 w 2244725"/>
                <a:gd name="connsiteY14" fmla="*/ 254000 h 1393825"/>
                <a:gd name="connsiteX15" fmla="*/ 352425 w 2244725"/>
                <a:gd name="connsiteY15" fmla="*/ 234950 h 1393825"/>
                <a:gd name="connsiteX16" fmla="*/ 365125 w 2244725"/>
                <a:gd name="connsiteY16" fmla="*/ 215900 h 1393825"/>
                <a:gd name="connsiteX17" fmla="*/ 371475 w 2244725"/>
                <a:gd name="connsiteY17" fmla="*/ 206375 h 1393825"/>
                <a:gd name="connsiteX18" fmla="*/ 381000 w 2244725"/>
                <a:gd name="connsiteY18" fmla="*/ 200025 h 1393825"/>
                <a:gd name="connsiteX19" fmla="*/ 387350 w 2244725"/>
                <a:gd name="connsiteY19" fmla="*/ 190500 h 1393825"/>
                <a:gd name="connsiteX20" fmla="*/ 396875 w 2244725"/>
                <a:gd name="connsiteY20" fmla="*/ 184150 h 1393825"/>
                <a:gd name="connsiteX21" fmla="*/ 406400 w 2244725"/>
                <a:gd name="connsiteY21" fmla="*/ 174625 h 1393825"/>
                <a:gd name="connsiteX22" fmla="*/ 415925 w 2244725"/>
                <a:gd name="connsiteY22" fmla="*/ 168275 h 1393825"/>
                <a:gd name="connsiteX23" fmla="*/ 425450 w 2244725"/>
                <a:gd name="connsiteY23" fmla="*/ 158750 h 1393825"/>
                <a:gd name="connsiteX24" fmla="*/ 434975 w 2244725"/>
                <a:gd name="connsiteY24" fmla="*/ 152400 h 1393825"/>
                <a:gd name="connsiteX25" fmla="*/ 444500 w 2244725"/>
                <a:gd name="connsiteY25" fmla="*/ 142875 h 1393825"/>
                <a:gd name="connsiteX26" fmla="*/ 463550 w 2244725"/>
                <a:gd name="connsiteY26" fmla="*/ 136525 h 1393825"/>
                <a:gd name="connsiteX27" fmla="*/ 492125 w 2244725"/>
                <a:gd name="connsiteY27" fmla="*/ 123825 h 1393825"/>
                <a:gd name="connsiteX28" fmla="*/ 501650 w 2244725"/>
                <a:gd name="connsiteY28" fmla="*/ 120650 h 1393825"/>
                <a:gd name="connsiteX29" fmla="*/ 511175 w 2244725"/>
                <a:gd name="connsiteY29" fmla="*/ 114300 h 1393825"/>
                <a:gd name="connsiteX30" fmla="*/ 530225 w 2244725"/>
                <a:gd name="connsiteY30" fmla="*/ 107950 h 1393825"/>
                <a:gd name="connsiteX31" fmla="*/ 539750 w 2244725"/>
                <a:gd name="connsiteY31" fmla="*/ 104775 h 1393825"/>
                <a:gd name="connsiteX32" fmla="*/ 549275 w 2244725"/>
                <a:gd name="connsiteY32" fmla="*/ 101600 h 1393825"/>
                <a:gd name="connsiteX33" fmla="*/ 561975 w 2244725"/>
                <a:gd name="connsiteY33" fmla="*/ 98425 h 1393825"/>
                <a:gd name="connsiteX34" fmla="*/ 581025 w 2244725"/>
                <a:gd name="connsiteY34" fmla="*/ 92075 h 1393825"/>
                <a:gd name="connsiteX35" fmla="*/ 609600 w 2244725"/>
                <a:gd name="connsiteY35" fmla="*/ 82550 h 1393825"/>
                <a:gd name="connsiteX36" fmla="*/ 619125 w 2244725"/>
                <a:gd name="connsiteY36" fmla="*/ 79375 h 1393825"/>
                <a:gd name="connsiteX37" fmla="*/ 628650 w 2244725"/>
                <a:gd name="connsiteY37" fmla="*/ 76200 h 1393825"/>
                <a:gd name="connsiteX38" fmla="*/ 638175 w 2244725"/>
                <a:gd name="connsiteY38" fmla="*/ 69850 h 1393825"/>
                <a:gd name="connsiteX39" fmla="*/ 657225 w 2244725"/>
                <a:gd name="connsiteY39" fmla="*/ 63500 h 1393825"/>
                <a:gd name="connsiteX40" fmla="*/ 666750 w 2244725"/>
                <a:gd name="connsiteY40" fmla="*/ 57150 h 1393825"/>
                <a:gd name="connsiteX41" fmla="*/ 685800 w 2244725"/>
                <a:gd name="connsiteY41" fmla="*/ 50800 h 1393825"/>
                <a:gd name="connsiteX42" fmla="*/ 695325 w 2244725"/>
                <a:gd name="connsiteY42" fmla="*/ 47625 h 1393825"/>
                <a:gd name="connsiteX43" fmla="*/ 723900 w 2244725"/>
                <a:gd name="connsiteY43" fmla="*/ 38100 h 1393825"/>
                <a:gd name="connsiteX44" fmla="*/ 733425 w 2244725"/>
                <a:gd name="connsiteY44" fmla="*/ 34925 h 1393825"/>
                <a:gd name="connsiteX45" fmla="*/ 746125 w 2244725"/>
                <a:gd name="connsiteY45" fmla="*/ 31750 h 1393825"/>
                <a:gd name="connsiteX46" fmla="*/ 777875 w 2244725"/>
                <a:gd name="connsiteY46" fmla="*/ 25400 h 1393825"/>
                <a:gd name="connsiteX47" fmla="*/ 812800 w 2244725"/>
                <a:gd name="connsiteY47" fmla="*/ 15875 h 1393825"/>
                <a:gd name="connsiteX48" fmla="*/ 831850 w 2244725"/>
                <a:gd name="connsiteY48" fmla="*/ 12700 h 1393825"/>
                <a:gd name="connsiteX49" fmla="*/ 844550 w 2244725"/>
                <a:gd name="connsiteY49" fmla="*/ 9525 h 1393825"/>
                <a:gd name="connsiteX50" fmla="*/ 889000 w 2244725"/>
                <a:gd name="connsiteY50" fmla="*/ 6350 h 1393825"/>
                <a:gd name="connsiteX51" fmla="*/ 920750 w 2244725"/>
                <a:gd name="connsiteY51" fmla="*/ 3175 h 1393825"/>
                <a:gd name="connsiteX52" fmla="*/ 1019175 w 2244725"/>
                <a:gd name="connsiteY52" fmla="*/ 0 h 1393825"/>
                <a:gd name="connsiteX53" fmla="*/ 1079500 w 2244725"/>
                <a:gd name="connsiteY53" fmla="*/ 3175 h 1393825"/>
                <a:gd name="connsiteX54" fmla="*/ 1089025 w 2244725"/>
                <a:gd name="connsiteY54" fmla="*/ 6350 h 1393825"/>
                <a:gd name="connsiteX55" fmla="*/ 1120775 w 2244725"/>
                <a:gd name="connsiteY55" fmla="*/ 15875 h 1393825"/>
                <a:gd name="connsiteX56" fmla="*/ 1168400 w 2244725"/>
                <a:gd name="connsiteY56" fmla="*/ 31750 h 1393825"/>
                <a:gd name="connsiteX57" fmla="*/ 1200150 w 2244725"/>
                <a:gd name="connsiteY57" fmla="*/ 41275 h 1393825"/>
                <a:gd name="connsiteX58" fmla="*/ 1235075 w 2244725"/>
                <a:gd name="connsiteY58" fmla="*/ 47625 h 1393825"/>
                <a:gd name="connsiteX59" fmla="*/ 1254125 w 2244725"/>
                <a:gd name="connsiteY59" fmla="*/ 53975 h 1393825"/>
                <a:gd name="connsiteX60" fmla="*/ 1273175 w 2244725"/>
                <a:gd name="connsiteY60" fmla="*/ 60325 h 1393825"/>
                <a:gd name="connsiteX61" fmla="*/ 1292225 w 2244725"/>
                <a:gd name="connsiteY61" fmla="*/ 66675 h 1393825"/>
                <a:gd name="connsiteX62" fmla="*/ 1301750 w 2244725"/>
                <a:gd name="connsiteY62" fmla="*/ 69850 h 1393825"/>
                <a:gd name="connsiteX63" fmla="*/ 1320800 w 2244725"/>
                <a:gd name="connsiteY63" fmla="*/ 79375 h 1393825"/>
                <a:gd name="connsiteX64" fmla="*/ 1330325 w 2244725"/>
                <a:gd name="connsiteY64" fmla="*/ 85725 h 1393825"/>
                <a:gd name="connsiteX65" fmla="*/ 1339850 w 2244725"/>
                <a:gd name="connsiteY65" fmla="*/ 88900 h 1393825"/>
                <a:gd name="connsiteX66" fmla="*/ 1358900 w 2244725"/>
                <a:gd name="connsiteY66" fmla="*/ 101600 h 1393825"/>
                <a:gd name="connsiteX67" fmla="*/ 1377950 w 2244725"/>
                <a:gd name="connsiteY67" fmla="*/ 107950 h 1393825"/>
                <a:gd name="connsiteX68" fmla="*/ 1387475 w 2244725"/>
                <a:gd name="connsiteY68" fmla="*/ 114300 h 1393825"/>
                <a:gd name="connsiteX69" fmla="*/ 1406525 w 2244725"/>
                <a:gd name="connsiteY69" fmla="*/ 120650 h 1393825"/>
                <a:gd name="connsiteX70" fmla="*/ 1435100 w 2244725"/>
                <a:gd name="connsiteY70" fmla="*/ 139700 h 1393825"/>
                <a:gd name="connsiteX71" fmla="*/ 1444625 w 2244725"/>
                <a:gd name="connsiteY71" fmla="*/ 146050 h 1393825"/>
                <a:gd name="connsiteX72" fmla="*/ 1454150 w 2244725"/>
                <a:gd name="connsiteY72" fmla="*/ 152400 h 1393825"/>
                <a:gd name="connsiteX73" fmla="*/ 1473200 w 2244725"/>
                <a:gd name="connsiteY73" fmla="*/ 168275 h 1393825"/>
                <a:gd name="connsiteX74" fmla="*/ 1482725 w 2244725"/>
                <a:gd name="connsiteY74" fmla="*/ 171450 h 1393825"/>
                <a:gd name="connsiteX75" fmla="*/ 1501775 w 2244725"/>
                <a:gd name="connsiteY75" fmla="*/ 184150 h 1393825"/>
                <a:gd name="connsiteX76" fmla="*/ 1517650 w 2244725"/>
                <a:gd name="connsiteY76" fmla="*/ 196850 h 1393825"/>
                <a:gd name="connsiteX77" fmla="*/ 1533525 w 2244725"/>
                <a:gd name="connsiteY77" fmla="*/ 209550 h 1393825"/>
                <a:gd name="connsiteX78" fmla="*/ 1543050 w 2244725"/>
                <a:gd name="connsiteY78" fmla="*/ 219075 h 1393825"/>
                <a:gd name="connsiteX79" fmla="*/ 1552575 w 2244725"/>
                <a:gd name="connsiteY79" fmla="*/ 225425 h 1393825"/>
                <a:gd name="connsiteX80" fmla="*/ 1558925 w 2244725"/>
                <a:gd name="connsiteY80" fmla="*/ 234950 h 1393825"/>
                <a:gd name="connsiteX81" fmla="*/ 1568450 w 2244725"/>
                <a:gd name="connsiteY81" fmla="*/ 238125 h 1393825"/>
                <a:gd name="connsiteX82" fmla="*/ 1587500 w 2244725"/>
                <a:gd name="connsiteY82" fmla="*/ 247650 h 1393825"/>
                <a:gd name="connsiteX83" fmla="*/ 1597025 w 2244725"/>
                <a:gd name="connsiteY83" fmla="*/ 257175 h 1393825"/>
                <a:gd name="connsiteX84" fmla="*/ 1616075 w 2244725"/>
                <a:gd name="connsiteY84" fmla="*/ 269875 h 1393825"/>
                <a:gd name="connsiteX85" fmla="*/ 1625600 w 2244725"/>
                <a:gd name="connsiteY85" fmla="*/ 279400 h 1393825"/>
                <a:gd name="connsiteX86" fmla="*/ 1644650 w 2244725"/>
                <a:gd name="connsiteY86" fmla="*/ 292100 h 1393825"/>
                <a:gd name="connsiteX87" fmla="*/ 1651000 w 2244725"/>
                <a:gd name="connsiteY87" fmla="*/ 301625 h 1393825"/>
                <a:gd name="connsiteX88" fmla="*/ 1670050 w 2244725"/>
                <a:gd name="connsiteY88" fmla="*/ 314325 h 1393825"/>
                <a:gd name="connsiteX89" fmla="*/ 1685925 w 2244725"/>
                <a:gd name="connsiteY89" fmla="*/ 330200 h 1393825"/>
                <a:gd name="connsiteX90" fmla="*/ 1701800 w 2244725"/>
                <a:gd name="connsiteY90" fmla="*/ 349250 h 1393825"/>
                <a:gd name="connsiteX91" fmla="*/ 1711325 w 2244725"/>
                <a:gd name="connsiteY91" fmla="*/ 355600 h 1393825"/>
                <a:gd name="connsiteX92" fmla="*/ 1724025 w 2244725"/>
                <a:gd name="connsiteY92" fmla="*/ 374650 h 1393825"/>
                <a:gd name="connsiteX93" fmla="*/ 1736725 w 2244725"/>
                <a:gd name="connsiteY93" fmla="*/ 393700 h 1393825"/>
                <a:gd name="connsiteX94" fmla="*/ 1746250 w 2244725"/>
                <a:gd name="connsiteY94" fmla="*/ 403225 h 1393825"/>
                <a:gd name="connsiteX95" fmla="*/ 1752600 w 2244725"/>
                <a:gd name="connsiteY95" fmla="*/ 412750 h 1393825"/>
                <a:gd name="connsiteX96" fmla="*/ 1762125 w 2244725"/>
                <a:gd name="connsiteY96" fmla="*/ 419100 h 1393825"/>
                <a:gd name="connsiteX97" fmla="*/ 1784350 w 2244725"/>
                <a:gd name="connsiteY97" fmla="*/ 444500 h 1393825"/>
                <a:gd name="connsiteX98" fmla="*/ 1790700 w 2244725"/>
                <a:gd name="connsiteY98" fmla="*/ 454025 h 1393825"/>
                <a:gd name="connsiteX99" fmla="*/ 1809750 w 2244725"/>
                <a:gd name="connsiteY99" fmla="*/ 469900 h 1393825"/>
                <a:gd name="connsiteX100" fmla="*/ 1816100 w 2244725"/>
                <a:gd name="connsiteY100" fmla="*/ 479425 h 1393825"/>
                <a:gd name="connsiteX101" fmla="*/ 1835150 w 2244725"/>
                <a:gd name="connsiteY101" fmla="*/ 492125 h 1393825"/>
                <a:gd name="connsiteX102" fmla="*/ 1851025 w 2244725"/>
                <a:gd name="connsiteY102" fmla="*/ 511175 h 1393825"/>
                <a:gd name="connsiteX103" fmla="*/ 1863725 w 2244725"/>
                <a:gd name="connsiteY103" fmla="*/ 530225 h 1393825"/>
                <a:gd name="connsiteX104" fmla="*/ 1882775 w 2244725"/>
                <a:gd name="connsiteY104" fmla="*/ 558800 h 1393825"/>
                <a:gd name="connsiteX105" fmla="*/ 1889125 w 2244725"/>
                <a:gd name="connsiteY105" fmla="*/ 568325 h 1393825"/>
                <a:gd name="connsiteX106" fmla="*/ 1895475 w 2244725"/>
                <a:gd name="connsiteY106" fmla="*/ 577850 h 1393825"/>
                <a:gd name="connsiteX107" fmla="*/ 1905000 w 2244725"/>
                <a:gd name="connsiteY107" fmla="*/ 587375 h 1393825"/>
                <a:gd name="connsiteX108" fmla="*/ 1917700 w 2244725"/>
                <a:gd name="connsiteY108" fmla="*/ 615950 h 1393825"/>
                <a:gd name="connsiteX109" fmla="*/ 1920875 w 2244725"/>
                <a:gd name="connsiteY109" fmla="*/ 625475 h 1393825"/>
                <a:gd name="connsiteX110" fmla="*/ 1927225 w 2244725"/>
                <a:gd name="connsiteY110" fmla="*/ 635000 h 1393825"/>
                <a:gd name="connsiteX111" fmla="*/ 1930400 w 2244725"/>
                <a:gd name="connsiteY111" fmla="*/ 644525 h 1393825"/>
                <a:gd name="connsiteX112" fmla="*/ 1936750 w 2244725"/>
                <a:gd name="connsiteY112" fmla="*/ 654050 h 1393825"/>
                <a:gd name="connsiteX113" fmla="*/ 1943100 w 2244725"/>
                <a:gd name="connsiteY113" fmla="*/ 673100 h 1393825"/>
                <a:gd name="connsiteX114" fmla="*/ 1946275 w 2244725"/>
                <a:gd name="connsiteY114" fmla="*/ 682625 h 1393825"/>
                <a:gd name="connsiteX115" fmla="*/ 1949450 w 2244725"/>
                <a:gd name="connsiteY115" fmla="*/ 692150 h 1393825"/>
                <a:gd name="connsiteX116" fmla="*/ 1987550 w 2244725"/>
                <a:gd name="connsiteY116" fmla="*/ 749300 h 1393825"/>
                <a:gd name="connsiteX117" fmla="*/ 1993900 w 2244725"/>
                <a:gd name="connsiteY117" fmla="*/ 758825 h 1393825"/>
                <a:gd name="connsiteX118" fmla="*/ 2000250 w 2244725"/>
                <a:gd name="connsiteY118" fmla="*/ 768350 h 1393825"/>
                <a:gd name="connsiteX119" fmla="*/ 2028825 w 2244725"/>
                <a:gd name="connsiteY119" fmla="*/ 784225 h 1393825"/>
                <a:gd name="connsiteX120" fmla="*/ 2038350 w 2244725"/>
                <a:gd name="connsiteY120" fmla="*/ 790575 h 1393825"/>
                <a:gd name="connsiteX121" fmla="*/ 2047875 w 2244725"/>
                <a:gd name="connsiteY121" fmla="*/ 796925 h 1393825"/>
                <a:gd name="connsiteX122" fmla="*/ 2054225 w 2244725"/>
                <a:gd name="connsiteY122" fmla="*/ 806450 h 1393825"/>
                <a:gd name="connsiteX123" fmla="*/ 2063750 w 2244725"/>
                <a:gd name="connsiteY123" fmla="*/ 809625 h 1393825"/>
                <a:gd name="connsiteX124" fmla="*/ 2073275 w 2244725"/>
                <a:gd name="connsiteY124" fmla="*/ 815975 h 1393825"/>
                <a:gd name="connsiteX125" fmla="*/ 2101850 w 2244725"/>
                <a:gd name="connsiteY125" fmla="*/ 838200 h 1393825"/>
                <a:gd name="connsiteX126" fmla="*/ 2111375 w 2244725"/>
                <a:gd name="connsiteY126" fmla="*/ 844550 h 1393825"/>
                <a:gd name="connsiteX127" fmla="*/ 2120900 w 2244725"/>
                <a:gd name="connsiteY127" fmla="*/ 850900 h 1393825"/>
                <a:gd name="connsiteX128" fmla="*/ 2127250 w 2244725"/>
                <a:gd name="connsiteY128" fmla="*/ 860425 h 1393825"/>
                <a:gd name="connsiteX129" fmla="*/ 2136775 w 2244725"/>
                <a:gd name="connsiteY129" fmla="*/ 863600 h 1393825"/>
                <a:gd name="connsiteX130" fmla="*/ 2155825 w 2244725"/>
                <a:gd name="connsiteY130" fmla="*/ 876300 h 1393825"/>
                <a:gd name="connsiteX131" fmla="*/ 2165350 w 2244725"/>
                <a:gd name="connsiteY131" fmla="*/ 882650 h 1393825"/>
                <a:gd name="connsiteX132" fmla="*/ 2174875 w 2244725"/>
                <a:gd name="connsiteY132" fmla="*/ 889000 h 1393825"/>
                <a:gd name="connsiteX133" fmla="*/ 2181225 w 2244725"/>
                <a:gd name="connsiteY133" fmla="*/ 898525 h 1393825"/>
                <a:gd name="connsiteX134" fmla="*/ 2190750 w 2244725"/>
                <a:gd name="connsiteY134" fmla="*/ 908050 h 1393825"/>
                <a:gd name="connsiteX135" fmla="*/ 2197100 w 2244725"/>
                <a:gd name="connsiteY135" fmla="*/ 927100 h 1393825"/>
                <a:gd name="connsiteX136" fmla="*/ 2200275 w 2244725"/>
                <a:gd name="connsiteY136" fmla="*/ 936625 h 1393825"/>
                <a:gd name="connsiteX137" fmla="*/ 2209800 w 2244725"/>
                <a:gd name="connsiteY137" fmla="*/ 965200 h 1393825"/>
                <a:gd name="connsiteX138" fmla="*/ 2212975 w 2244725"/>
                <a:gd name="connsiteY138" fmla="*/ 974725 h 1393825"/>
                <a:gd name="connsiteX139" fmla="*/ 2216150 w 2244725"/>
                <a:gd name="connsiteY139" fmla="*/ 984250 h 1393825"/>
                <a:gd name="connsiteX140" fmla="*/ 2222500 w 2244725"/>
                <a:gd name="connsiteY140" fmla="*/ 993775 h 1393825"/>
                <a:gd name="connsiteX141" fmla="*/ 2225675 w 2244725"/>
                <a:gd name="connsiteY141" fmla="*/ 1003300 h 1393825"/>
                <a:gd name="connsiteX142" fmla="*/ 2232025 w 2244725"/>
                <a:gd name="connsiteY142" fmla="*/ 1012825 h 1393825"/>
                <a:gd name="connsiteX143" fmla="*/ 2238375 w 2244725"/>
                <a:gd name="connsiteY143" fmla="*/ 1031875 h 1393825"/>
                <a:gd name="connsiteX144" fmla="*/ 2241550 w 2244725"/>
                <a:gd name="connsiteY144" fmla="*/ 1041400 h 1393825"/>
                <a:gd name="connsiteX145" fmla="*/ 2244725 w 2244725"/>
                <a:gd name="connsiteY145" fmla="*/ 1050925 h 1393825"/>
                <a:gd name="connsiteX146" fmla="*/ 2241550 w 2244725"/>
                <a:gd name="connsiteY146" fmla="*/ 1149350 h 1393825"/>
                <a:gd name="connsiteX147" fmla="*/ 2235200 w 2244725"/>
                <a:gd name="connsiteY147" fmla="*/ 1168400 h 1393825"/>
                <a:gd name="connsiteX148" fmla="*/ 2228850 w 2244725"/>
                <a:gd name="connsiteY148" fmla="*/ 1177925 h 1393825"/>
                <a:gd name="connsiteX149" fmla="*/ 2219325 w 2244725"/>
                <a:gd name="connsiteY149" fmla="*/ 1209675 h 1393825"/>
                <a:gd name="connsiteX150" fmla="*/ 2216150 w 2244725"/>
                <a:gd name="connsiteY150" fmla="*/ 1219200 h 1393825"/>
                <a:gd name="connsiteX151" fmla="*/ 2200275 w 2244725"/>
                <a:gd name="connsiteY151" fmla="*/ 1238250 h 1393825"/>
                <a:gd name="connsiteX152" fmla="*/ 2184400 w 2244725"/>
                <a:gd name="connsiteY152" fmla="*/ 1250950 h 1393825"/>
                <a:gd name="connsiteX153" fmla="*/ 2168525 w 2244725"/>
                <a:gd name="connsiteY153" fmla="*/ 1266825 h 1393825"/>
                <a:gd name="connsiteX154" fmla="*/ 2162175 w 2244725"/>
                <a:gd name="connsiteY154" fmla="*/ 1276350 h 1393825"/>
                <a:gd name="connsiteX155" fmla="*/ 2143125 w 2244725"/>
                <a:gd name="connsiteY155" fmla="*/ 1289050 h 1393825"/>
                <a:gd name="connsiteX156" fmla="*/ 2133600 w 2244725"/>
                <a:gd name="connsiteY156" fmla="*/ 1295400 h 1393825"/>
                <a:gd name="connsiteX157" fmla="*/ 2117725 w 2244725"/>
                <a:gd name="connsiteY157" fmla="*/ 1311275 h 1393825"/>
                <a:gd name="connsiteX158" fmla="*/ 2101850 w 2244725"/>
                <a:gd name="connsiteY158" fmla="*/ 1327150 h 1393825"/>
                <a:gd name="connsiteX159" fmla="*/ 2092325 w 2244725"/>
                <a:gd name="connsiteY159" fmla="*/ 1330325 h 1393825"/>
                <a:gd name="connsiteX160" fmla="*/ 2073275 w 2244725"/>
                <a:gd name="connsiteY160" fmla="*/ 1343025 h 1393825"/>
                <a:gd name="connsiteX161" fmla="*/ 2054225 w 2244725"/>
                <a:gd name="connsiteY161" fmla="*/ 1352550 h 1393825"/>
                <a:gd name="connsiteX162" fmla="*/ 2035175 w 2244725"/>
                <a:gd name="connsiteY162" fmla="*/ 1358900 h 1393825"/>
                <a:gd name="connsiteX163" fmla="*/ 2025650 w 2244725"/>
                <a:gd name="connsiteY163" fmla="*/ 1362075 h 1393825"/>
                <a:gd name="connsiteX164" fmla="*/ 2016125 w 2244725"/>
                <a:gd name="connsiteY164" fmla="*/ 1368425 h 1393825"/>
                <a:gd name="connsiteX165" fmla="*/ 1997075 w 2244725"/>
                <a:gd name="connsiteY165" fmla="*/ 1374775 h 1393825"/>
                <a:gd name="connsiteX166" fmla="*/ 1987550 w 2244725"/>
                <a:gd name="connsiteY166" fmla="*/ 1377950 h 1393825"/>
                <a:gd name="connsiteX167" fmla="*/ 1958975 w 2244725"/>
                <a:gd name="connsiteY167" fmla="*/ 1387475 h 1393825"/>
                <a:gd name="connsiteX168" fmla="*/ 1949450 w 2244725"/>
                <a:gd name="connsiteY168" fmla="*/ 1390650 h 1393825"/>
                <a:gd name="connsiteX169" fmla="*/ 1939925 w 2244725"/>
                <a:gd name="connsiteY169" fmla="*/ 1393825 h 1393825"/>
                <a:gd name="connsiteX170" fmla="*/ 1930400 w 2244725"/>
                <a:gd name="connsiteY170" fmla="*/ 1393825 h 139382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  <a:cxn ang="0">
                  <a:pos x="connsiteX29" y="connsiteY29"/>
                </a:cxn>
                <a:cxn ang="0">
                  <a:pos x="connsiteX30" y="connsiteY30"/>
                </a:cxn>
                <a:cxn ang="0">
                  <a:pos x="connsiteX31" y="connsiteY31"/>
                </a:cxn>
                <a:cxn ang="0">
                  <a:pos x="connsiteX32" y="connsiteY32"/>
                </a:cxn>
                <a:cxn ang="0">
                  <a:pos x="connsiteX33" y="connsiteY33"/>
                </a:cxn>
                <a:cxn ang="0">
                  <a:pos x="connsiteX34" y="connsiteY34"/>
                </a:cxn>
                <a:cxn ang="0">
                  <a:pos x="connsiteX35" y="connsiteY35"/>
                </a:cxn>
                <a:cxn ang="0">
                  <a:pos x="connsiteX36" y="connsiteY36"/>
                </a:cxn>
                <a:cxn ang="0">
                  <a:pos x="connsiteX37" y="connsiteY37"/>
                </a:cxn>
                <a:cxn ang="0">
                  <a:pos x="connsiteX38" y="connsiteY38"/>
                </a:cxn>
                <a:cxn ang="0">
                  <a:pos x="connsiteX39" y="connsiteY39"/>
                </a:cxn>
                <a:cxn ang="0">
                  <a:pos x="connsiteX40" y="connsiteY40"/>
                </a:cxn>
                <a:cxn ang="0">
                  <a:pos x="connsiteX41" y="connsiteY41"/>
                </a:cxn>
                <a:cxn ang="0">
                  <a:pos x="connsiteX42" y="connsiteY42"/>
                </a:cxn>
                <a:cxn ang="0">
                  <a:pos x="connsiteX43" y="connsiteY43"/>
                </a:cxn>
                <a:cxn ang="0">
                  <a:pos x="connsiteX44" y="connsiteY44"/>
                </a:cxn>
                <a:cxn ang="0">
                  <a:pos x="connsiteX45" y="connsiteY45"/>
                </a:cxn>
                <a:cxn ang="0">
                  <a:pos x="connsiteX46" y="connsiteY46"/>
                </a:cxn>
                <a:cxn ang="0">
                  <a:pos x="connsiteX47" y="connsiteY47"/>
                </a:cxn>
                <a:cxn ang="0">
                  <a:pos x="connsiteX48" y="connsiteY48"/>
                </a:cxn>
                <a:cxn ang="0">
                  <a:pos x="connsiteX49" y="connsiteY49"/>
                </a:cxn>
                <a:cxn ang="0">
                  <a:pos x="connsiteX50" y="connsiteY50"/>
                </a:cxn>
                <a:cxn ang="0">
                  <a:pos x="connsiteX51" y="connsiteY51"/>
                </a:cxn>
                <a:cxn ang="0">
                  <a:pos x="connsiteX52" y="connsiteY52"/>
                </a:cxn>
                <a:cxn ang="0">
                  <a:pos x="connsiteX53" y="connsiteY53"/>
                </a:cxn>
                <a:cxn ang="0">
                  <a:pos x="connsiteX54" y="connsiteY54"/>
                </a:cxn>
                <a:cxn ang="0">
                  <a:pos x="connsiteX55" y="connsiteY55"/>
                </a:cxn>
                <a:cxn ang="0">
                  <a:pos x="connsiteX56" y="connsiteY56"/>
                </a:cxn>
                <a:cxn ang="0">
                  <a:pos x="connsiteX57" y="connsiteY57"/>
                </a:cxn>
                <a:cxn ang="0">
                  <a:pos x="connsiteX58" y="connsiteY58"/>
                </a:cxn>
                <a:cxn ang="0">
                  <a:pos x="connsiteX59" y="connsiteY59"/>
                </a:cxn>
                <a:cxn ang="0">
                  <a:pos x="connsiteX60" y="connsiteY60"/>
                </a:cxn>
                <a:cxn ang="0">
                  <a:pos x="connsiteX61" y="connsiteY61"/>
                </a:cxn>
                <a:cxn ang="0">
                  <a:pos x="connsiteX62" y="connsiteY62"/>
                </a:cxn>
                <a:cxn ang="0">
                  <a:pos x="connsiteX63" y="connsiteY63"/>
                </a:cxn>
                <a:cxn ang="0">
                  <a:pos x="connsiteX64" y="connsiteY64"/>
                </a:cxn>
                <a:cxn ang="0">
                  <a:pos x="connsiteX65" y="connsiteY65"/>
                </a:cxn>
                <a:cxn ang="0">
                  <a:pos x="connsiteX66" y="connsiteY66"/>
                </a:cxn>
                <a:cxn ang="0">
                  <a:pos x="connsiteX67" y="connsiteY67"/>
                </a:cxn>
                <a:cxn ang="0">
                  <a:pos x="connsiteX68" y="connsiteY68"/>
                </a:cxn>
                <a:cxn ang="0">
                  <a:pos x="connsiteX69" y="connsiteY69"/>
                </a:cxn>
                <a:cxn ang="0">
                  <a:pos x="connsiteX70" y="connsiteY70"/>
                </a:cxn>
                <a:cxn ang="0">
                  <a:pos x="connsiteX71" y="connsiteY71"/>
                </a:cxn>
                <a:cxn ang="0">
                  <a:pos x="connsiteX72" y="connsiteY72"/>
                </a:cxn>
                <a:cxn ang="0">
                  <a:pos x="connsiteX73" y="connsiteY73"/>
                </a:cxn>
                <a:cxn ang="0">
                  <a:pos x="connsiteX74" y="connsiteY74"/>
                </a:cxn>
                <a:cxn ang="0">
                  <a:pos x="connsiteX75" y="connsiteY75"/>
                </a:cxn>
                <a:cxn ang="0">
                  <a:pos x="connsiteX76" y="connsiteY76"/>
                </a:cxn>
                <a:cxn ang="0">
                  <a:pos x="connsiteX77" y="connsiteY77"/>
                </a:cxn>
                <a:cxn ang="0">
                  <a:pos x="connsiteX78" y="connsiteY78"/>
                </a:cxn>
                <a:cxn ang="0">
                  <a:pos x="connsiteX79" y="connsiteY79"/>
                </a:cxn>
                <a:cxn ang="0">
                  <a:pos x="connsiteX80" y="connsiteY80"/>
                </a:cxn>
                <a:cxn ang="0">
                  <a:pos x="connsiteX81" y="connsiteY81"/>
                </a:cxn>
                <a:cxn ang="0">
                  <a:pos x="connsiteX82" y="connsiteY82"/>
                </a:cxn>
                <a:cxn ang="0">
                  <a:pos x="connsiteX83" y="connsiteY83"/>
                </a:cxn>
                <a:cxn ang="0">
                  <a:pos x="connsiteX84" y="connsiteY84"/>
                </a:cxn>
                <a:cxn ang="0">
                  <a:pos x="connsiteX85" y="connsiteY85"/>
                </a:cxn>
                <a:cxn ang="0">
                  <a:pos x="connsiteX86" y="connsiteY86"/>
                </a:cxn>
                <a:cxn ang="0">
                  <a:pos x="connsiteX87" y="connsiteY87"/>
                </a:cxn>
                <a:cxn ang="0">
                  <a:pos x="connsiteX88" y="connsiteY88"/>
                </a:cxn>
                <a:cxn ang="0">
                  <a:pos x="connsiteX89" y="connsiteY89"/>
                </a:cxn>
                <a:cxn ang="0">
                  <a:pos x="connsiteX90" y="connsiteY90"/>
                </a:cxn>
                <a:cxn ang="0">
                  <a:pos x="connsiteX91" y="connsiteY91"/>
                </a:cxn>
                <a:cxn ang="0">
                  <a:pos x="connsiteX92" y="connsiteY92"/>
                </a:cxn>
                <a:cxn ang="0">
                  <a:pos x="connsiteX93" y="connsiteY93"/>
                </a:cxn>
                <a:cxn ang="0">
                  <a:pos x="connsiteX94" y="connsiteY94"/>
                </a:cxn>
                <a:cxn ang="0">
                  <a:pos x="connsiteX95" y="connsiteY95"/>
                </a:cxn>
                <a:cxn ang="0">
                  <a:pos x="connsiteX96" y="connsiteY96"/>
                </a:cxn>
                <a:cxn ang="0">
                  <a:pos x="connsiteX97" y="connsiteY97"/>
                </a:cxn>
                <a:cxn ang="0">
                  <a:pos x="connsiteX98" y="connsiteY98"/>
                </a:cxn>
                <a:cxn ang="0">
                  <a:pos x="connsiteX99" y="connsiteY99"/>
                </a:cxn>
                <a:cxn ang="0">
                  <a:pos x="connsiteX100" y="connsiteY100"/>
                </a:cxn>
                <a:cxn ang="0">
                  <a:pos x="connsiteX101" y="connsiteY101"/>
                </a:cxn>
                <a:cxn ang="0">
                  <a:pos x="connsiteX102" y="connsiteY102"/>
                </a:cxn>
                <a:cxn ang="0">
                  <a:pos x="connsiteX103" y="connsiteY103"/>
                </a:cxn>
                <a:cxn ang="0">
                  <a:pos x="connsiteX104" y="connsiteY104"/>
                </a:cxn>
                <a:cxn ang="0">
                  <a:pos x="connsiteX105" y="connsiteY105"/>
                </a:cxn>
                <a:cxn ang="0">
                  <a:pos x="connsiteX106" y="connsiteY106"/>
                </a:cxn>
                <a:cxn ang="0">
                  <a:pos x="connsiteX107" y="connsiteY107"/>
                </a:cxn>
                <a:cxn ang="0">
                  <a:pos x="connsiteX108" y="connsiteY108"/>
                </a:cxn>
                <a:cxn ang="0">
                  <a:pos x="connsiteX109" y="connsiteY109"/>
                </a:cxn>
                <a:cxn ang="0">
                  <a:pos x="connsiteX110" y="connsiteY110"/>
                </a:cxn>
                <a:cxn ang="0">
                  <a:pos x="connsiteX111" y="connsiteY111"/>
                </a:cxn>
                <a:cxn ang="0">
                  <a:pos x="connsiteX112" y="connsiteY112"/>
                </a:cxn>
                <a:cxn ang="0">
                  <a:pos x="connsiteX113" y="connsiteY113"/>
                </a:cxn>
                <a:cxn ang="0">
                  <a:pos x="connsiteX114" y="connsiteY114"/>
                </a:cxn>
                <a:cxn ang="0">
                  <a:pos x="connsiteX115" y="connsiteY115"/>
                </a:cxn>
                <a:cxn ang="0">
                  <a:pos x="connsiteX116" y="connsiteY116"/>
                </a:cxn>
                <a:cxn ang="0">
                  <a:pos x="connsiteX117" y="connsiteY117"/>
                </a:cxn>
                <a:cxn ang="0">
                  <a:pos x="connsiteX118" y="connsiteY118"/>
                </a:cxn>
                <a:cxn ang="0">
                  <a:pos x="connsiteX119" y="connsiteY119"/>
                </a:cxn>
                <a:cxn ang="0">
                  <a:pos x="connsiteX120" y="connsiteY120"/>
                </a:cxn>
                <a:cxn ang="0">
                  <a:pos x="connsiteX121" y="connsiteY121"/>
                </a:cxn>
                <a:cxn ang="0">
                  <a:pos x="connsiteX122" y="connsiteY122"/>
                </a:cxn>
                <a:cxn ang="0">
                  <a:pos x="connsiteX123" y="connsiteY123"/>
                </a:cxn>
                <a:cxn ang="0">
                  <a:pos x="connsiteX124" y="connsiteY124"/>
                </a:cxn>
                <a:cxn ang="0">
                  <a:pos x="connsiteX125" y="connsiteY125"/>
                </a:cxn>
                <a:cxn ang="0">
                  <a:pos x="connsiteX126" y="connsiteY126"/>
                </a:cxn>
                <a:cxn ang="0">
                  <a:pos x="connsiteX127" y="connsiteY127"/>
                </a:cxn>
                <a:cxn ang="0">
                  <a:pos x="connsiteX128" y="connsiteY128"/>
                </a:cxn>
                <a:cxn ang="0">
                  <a:pos x="connsiteX129" y="connsiteY129"/>
                </a:cxn>
                <a:cxn ang="0">
                  <a:pos x="connsiteX130" y="connsiteY130"/>
                </a:cxn>
                <a:cxn ang="0">
                  <a:pos x="connsiteX131" y="connsiteY131"/>
                </a:cxn>
                <a:cxn ang="0">
                  <a:pos x="connsiteX132" y="connsiteY132"/>
                </a:cxn>
                <a:cxn ang="0">
                  <a:pos x="connsiteX133" y="connsiteY133"/>
                </a:cxn>
                <a:cxn ang="0">
                  <a:pos x="connsiteX134" y="connsiteY134"/>
                </a:cxn>
                <a:cxn ang="0">
                  <a:pos x="connsiteX135" y="connsiteY135"/>
                </a:cxn>
                <a:cxn ang="0">
                  <a:pos x="connsiteX136" y="connsiteY136"/>
                </a:cxn>
                <a:cxn ang="0">
                  <a:pos x="connsiteX137" y="connsiteY137"/>
                </a:cxn>
                <a:cxn ang="0">
                  <a:pos x="connsiteX138" y="connsiteY138"/>
                </a:cxn>
                <a:cxn ang="0">
                  <a:pos x="connsiteX139" y="connsiteY139"/>
                </a:cxn>
                <a:cxn ang="0">
                  <a:pos x="connsiteX140" y="connsiteY140"/>
                </a:cxn>
                <a:cxn ang="0">
                  <a:pos x="connsiteX141" y="connsiteY141"/>
                </a:cxn>
                <a:cxn ang="0">
                  <a:pos x="connsiteX142" y="connsiteY142"/>
                </a:cxn>
                <a:cxn ang="0">
                  <a:pos x="connsiteX143" y="connsiteY143"/>
                </a:cxn>
                <a:cxn ang="0">
                  <a:pos x="connsiteX144" y="connsiteY144"/>
                </a:cxn>
                <a:cxn ang="0">
                  <a:pos x="connsiteX145" y="connsiteY145"/>
                </a:cxn>
                <a:cxn ang="0">
                  <a:pos x="connsiteX146" y="connsiteY146"/>
                </a:cxn>
                <a:cxn ang="0">
                  <a:pos x="connsiteX147" y="connsiteY147"/>
                </a:cxn>
                <a:cxn ang="0">
                  <a:pos x="connsiteX148" y="connsiteY148"/>
                </a:cxn>
                <a:cxn ang="0">
                  <a:pos x="connsiteX149" y="connsiteY149"/>
                </a:cxn>
                <a:cxn ang="0">
                  <a:pos x="connsiteX150" y="connsiteY150"/>
                </a:cxn>
                <a:cxn ang="0">
                  <a:pos x="connsiteX151" y="connsiteY151"/>
                </a:cxn>
                <a:cxn ang="0">
                  <a:pos x="connsiteX152" y="connsiteY152"/>
                </a:cxn>
                <a:cxn ang="0">
                  <a:pos x="connsiteX153" y="connsiteY153"/>
                </a:cxn>
                <a:cxn ang="0">
                  <a:pos x="connsiteX154" y="connsiteY154"/>
                </a:cxn>
                <a:cxn ang="0">
                  <a:pos x="connsiteX155" y="connsiteY155"/>
                </a:cxn>
                <a:cxn ang="0">
                  <a:pos x="connsiteX156" y="connsiteY156"/>
                </a:cxn>
                <a:cxn ang="0">
                  <a:pos x="connsiteX157" y="connsiteY157"/>
                </a:cxn>
                <a:cxn ang="0">
                  <a:pos x="connsiteX158" y="connsiteY158"/>
                </a:cxn>
                <a:cxn ang="0">
                  <a:pos x="connsiteX159" y="connsiteY159"/>
                </a:cxn>
                <a:cxn ang="0">
                  <a:pos x="connsiteX160" y="connsiteY160"/>
                </a:cxn>
                <a:cxn ang="0">
                  <a:pos x="connsiteX161" y="connsiteY161"/>
                </a:cxn>
                <a:cxn ang="0">
                  <a:pos x="connsiteX162" y="connsiteY162"/>
                </a:cxn>
                <a:cxn ang="0">
                  <a:pos x="connsiteX163" y="connsiteY163"/>
                </a:cxn>
                <a:cxn ang="0">
                  <a:pos x="connsiteX164" y="connsiteY164"/>
                </a:cxn>
                <a:cxn ang="0">
                  <a:pos x="connsiteX165" y="connsiteY165"/>
                </a:cxn>
                <a:cxn ang="0">
                  <a:pos x="connsiteX166" y="connsiteY166"/>
                </a:cxn>
                <a:cxn ang="0">
                  <a:pos x="connsiteX167" y="connsiteY167"/>
                </a:cxn>
                <a:cxn ang="0">
                  <a:pos x="connsiteX168" y="connsiteY168"/>
                </a:cxn>
                <a:cxn ang="0">
                  <a:pos x="connsiteX169" y="connsiteY169"/>
                </a:cxn>
                <a:cxn ang="0">
                  <a:pos x="connsiteX170" y="connsiteY170"/>
                </a:cxn>
              </a:cxnLst>
              <a:rect l="l" t="t" r="r" b="b"/>
              <a:pathLst>
                <a:path w="2244725" h="1393825">
                  <a:moveTo>
                    <a:pt x="0" y="390525"/>
                  </a:moveTo>
                  <a:cubicBezTo>
                    <a:pt x="6038" y="389317"/>
                    <a:pt x="18891" y="387429"/>
                    <a:pt x="25400" y="384175"/>
                  </a:cubicBezTo>
                  <a:cubicBezTo>
                    <a:pt x="38608" y="377571"/>
                    <a:pt x="34614" y="372964"/>
                    <a:pt x="53975" y="371475"/>
                  </a:cubicBezTo>
                  <a:cubicBezTo>
                    <a:pt x="117435" y="366593"/>
                    <a:pt x="81467" y="368956"/>
                    <a:pt x="161925" y="365125"/>
                  </a:cubicBezTo>
                  <a:cubicBezTo>
                    <a:pt x="193936" y="354455"/>
                    <a:pt x="144283" y="370735"/>
                    <a:pt x="184150" y="358775"/>
                  </a:cubicBezTo>
                  <a:cubicBezTo>
                    <a:pt x="190561" y="356852"/>
                    <a:pt x="196636" y="353738"/>
                    <a:pt x="203200" y="352425"/>
                  </a:cubicBezTo>
                  <a:cubicBezTo>
                    <a:pt x="215793" y="349906"/>
                    <a:pt x="232987" y="346729"/>
                    <a:pt x="244475" y="342900"/>
                  </a:cubicBezTo>
                  <a:lnTo>
                    <a:pt x="263525" y="336550"/>
                  </a:lnTo>
                  <a:cubicBezTo>
                    <a:pt x="275503" y="332557"/>
                    <a:pt x="281183" y="331592"/>
                    <a:pt x="292100" y="320675"/>
                  </a:cubicBezTo>
                  <a:cubicBezTo>
                    <a:pt x="295275" y="317500"/>
                    <a:pt x="298868" y="314694"/>
                    <a:pt x="301625" y="311150"/>
                  </a:cubicBezTo>
                  <a:cubicBezTo>
                    <a:pt x="306310" y="305126"/>
                    <a:pt x="310092" y="298450"/>
                    <a:pt x="314325" y="292100"/>
                  </a:cubicBezTo>
                  <a:lnTo>
                    <a:pt x="320675" y="282575"/>
                  </a:lnTo>
                  <a:lnTo>
                    <a:pt x="327025" y="273050"/>
                  </a:lnTo>
                  <a:cubicBezTo>
                    <a:pt x="329142" y="269875"/>
                    <a:pt x="332168" y="267145"/>
                    <a:pt x="333375" y="263525"/>
                  </a:cubicBezTo>
                  <a:cubicBezTo>
                    <a:pt x="334433" y="260350"/>
                    <a:pt x="335053" y="256993"/>
                    <a:pt x="336550" y="254000"/>
                  </a:cubicBezTo>
                  <a:cubicBezTo>
                    <a:pt x="343357" y="240385"/>
                    <a:pt x="342594" y="247589"/>
                    <a:pt x="352425" y="234950"/>
                  </a:cubicBezTo>
                  <a:cubicBezTo>
                    <a:pt x="357110" y="228926"/>
                    <a:pt x="360892" y="222250"/>
                    <a:pt x="365125" y="215900"/>
                  </a:cubicBezTo>
                  <a:cubicBezTo>
                    <a:pt x="367242" y="212725"/>
                    <a:pt x="368300" y="208492"/>
                    <a:pt x="371475" y="206375"/>
                  </a:cubicBezTo>
                  <a:lnTo>
                    <a:pt x="381000" y="200025"/>
                  </a:lnTo>
                  <a:cubicBezTo>
                    <a:pt x="383117" y="196850"/>
                    <a:pt x="384652" y="193198"/>
                    <a:pt x="387350" y="190500"/>
                  </a:cubicBezTo>
                  <a:cubicBezTo>
                    <a:pt x="390048" y="187802"/>
                    <a:pt x="393944" y="186593"/>
                    <a:pt x="396875" y="184150"/>
                  </a:cubicBezTo>
                  <a:cubicBezTo>
                    <a:pt x="400324" y="181275"/>
                    <a:pt x="402951" y="177500"/>
                    <a:pt x="406400" y="174625"/>
                  </a:cubicBezTo>
                  <a:cubicBezTo>
                    <a:pt x="409331" y="172182"/>
                    <a:pt x="412994" y="170718"/>
                    <a:pt x="415925" y="168275"/>
                  </a:cubicBezTo>
                  <a:cubicBezTo>
                    <a:pt x="419374" y="165400"/>
                    <a:pt x="422001" y="161625"/>
                    <a:pt x="425450" y="158750"/>
                  </a:cubicBezTo>
                  <a:cubicBezTo>
                    <a:pt x="428381" y="156307"/>
                    <a:pt x="432044" y="154843"/>
                    <a:pt x="434975" y="152400"/>
                  </a:cubicBezTo>
                  <a:cubicBezTo>
                    <a:pt x="438424" y="149525"/>
                    <a:pt x="440575" y="145056"/>
                    <a:pt x="444500" y="142875"/>
                  </a:cubicBezTo>
                  <a:cubicBezTo>
                    <a:pt x="450351" y="139624"/>
                    <a:pt x="457981" y="140238"/>
                    <a:pt x="463550" y="136525"/>
                  </a:cubicBezTo>
                  <a:cubicBezTo>
                    <a:pt x="478644" y="126462"/>
                    <a:pt x="469455" y="131382"/>
                    <a:pt x="492125" y="123825"/>
                  </a:cubicBezTo>
                  <a:cubicBezTo>
                    <a:pt x="495300" y="122767"/>
                    <a:pt x="498865" y="122506"/>
                    <a:pt x="501650" y="120650"/>
                  </a:cubicBezTo>
                  <a:cubicBezTo>
                    <a:pt x="504825" y="118533"/>
                    <a:pt x="507688" y="115850"/>
                    <a:pt x="511175" y="114300"/>
                  </a:cubicBezTo>
                  <a:cubicBezTo>
                    <a:pt x="517292" y="111582"/>
                    <a:pt x="523875" y="110067"/>
                    <a:pt x="530225" y="107950"/>
                  </a:cubicBezTo>
                  <a:lnTo>
                    <a:pt x="539750" y="104775"/>
                  </a:lnTo>
                  <a:cubicBezTo>
                    <a:pt x="542925" y="103717"/>
                    <a:pt x="546028" y="102412"/>
                    <a:pt x="549275" y="101600"/>
                  </a:cubicBezTo>
                  <a:cubicBezTo>
                    <a:pt x="553508" y="100542"/>
                    <a:pt x="557795" y="99679"/>
                    <a:pt x="561975" y="98425"/>
                  </a:cubicBezTo>
                  <a:cubicBezTo>
                    <a:pt x="568386" y="96502"/>
                    <a:pt x="574675" y="94192"/>
                    <a:pt x="581025" y="92075"/>
                  </a:cubicBezTo>
                  <a:lnTo>
                    <a:pt x="609600" y="82550"/>
                  </a:lnTo>
                  <a:lnTo>
                    <a:pt x="619125" y="79375"/>
                  </a:lnTo>
                  <a:cubicBezTo>
                    <a:pt x="622300" y="78317"/>
                    <a:pt x="625865" y="78056"/>
                    <a:pt x="628650" y="76200"/>
                  </a:cubicBezTo>
                  <a:cubicBezTo>
                    <a:pt x="631825" y="74083"/>
                    <a:pt x="634688" y="71400"/>
                    <a:pt x="638175" y="69850"/>
                  </a:cubicBezTo>
                  <a:cubicBezTo>
                    <a:pt x="644292" y="67132"/>
                    <a:pt x="651656" y="67213"/>
                    <a:pt x="657225" y="63500"/>
                  </a:cubicBezTo>
                  <a:cubicBezTo>
                    <a:pt x="660400" y="61383"/>
                    <a:pt x="663263" y="58700"/>
                    <a:pt x="666750" y="57150"/>
                  </a:cubicBezTo>
                  <a:cubicBezTo>
                    <a:pt x="672867" y="54432"/>
                    <a:pt x="679450" y="52917"/>
                    <a:pt x="685800" y="50800"/>
                  </a:cubicBezTo>
                  <a:lnTo>
                    <a:pt x="695325" y="47625"/>
                  </a:lnTo>
                  <a:lnTo>
                    <a:pt x="723900" y="38100"/>
                  </a:lnTo>
                  <a:cubicBezTo>
                    <a:pt x="727075" y="37042"/>
                    <a:pt x="730178" y="35737"/>
                    <a:pt x="733425" y="34925"/>
                  </a:cubicBezTo>
                  <a:cubicBezTo>
                    <a:pt x="737658" y="33867"/>
                    <a:pt x="741858" y="32664"/>
                    <a:pt x="746125" y="31750"/>
                  </a:cubicBezTo>
                  <a:cubicBezTo>
                    <a:pt x="756678" y="29489"/>
                    <a:pt x="767636" y="28813"/>
                    <a:pt x="777875" y="25400"/>
                  </a:cubicBezTo>
                  <a:cubicBezTo>
                    <a:pt x="790187" y="21296"/>
                    <a:pt x="798477" y="18262"/>
                    <a:pt x="812800" y="15875"/>
                  </a:cubicBezTo>
                  <a:cubicBezTo>
                    <a:pt x="819150" y="14817"/>
                    <a:pt x="825537" y="13963"/>
                    <a:pt x="831850" y="12700"/>
                  </a:cubicBezTo>
                  <a:cubicBezTo>
                    <a:pt x="836129" y="11844"/>
                    <a:pt x="840213" y="10007"/>
                    <a:pt x="844550" y="9525"/>
                  </a:cubicBezTo>
                  <a:cubicBezTo>
                    <a:pt x="859314" y="7885"/>
                    <a:pt x="874197" y="7584"/>
                    <a:pt x="889000" y="6350"/>
                  </a:cubicBezTo>
                  <a:cubicBezTo>
                    <a:pt x="899599" y="5467"/>
                    <a:pt x="910127" y="3693"/>
                    <a:pt x="920750" y="3175"/>
                  </a:cubicBezTo>
                  <a:cubicBezTo>
                    <a:pt x="953536" y="1576"/>
                    <a:pt x="986367" y="1058"/>
                    <a:pt x="1019175" y="0"/>
                  </a:cubicBezTo>
                  <a:cubicBezTo>
                    <a:pt x="1039283" y="1058"/>
                    <a:pt x="1059447" y="1352"/>
                    <a:pt x="1079500" y="3175"/>
                  </a:cubicBezTo>
                  <a:cubicBezTo>
                    <a:pt x="1082833" y="3478"/>
                    <a:pt x="1085807" y="5431"/>
                    <a:pt x="1089025" y="6350"/>
                  </a:cubicBezTo>
                  <a:cubicBezTo>
                    <a:pt x="1122614" y="15947"/>
                    <a:pt x="1075504" y="785"/>
                    <a:pt x="1120775" y="15875"/>
                  </a:cubicBezTo>
                  <a:lnTo>
                    <a:pt x="1168400" y="31750"/>
                  </a:lnTo>
                  <a:cubicBezTo>
                    <a:pt x="1178926" y="35259"/>
                    <a:pt x="1189236" y="39092"/>
                    <a:pt x="1200150" y="41275"/>
                  </a:cubicBezTo>
                  <a:cubicBezTo>
                    <a:pt x="1209226" y="43090"/>
                    <a:pt x="1225711" y="45071"/>
                    <a:pt x="1235075" y="47625"/>
                  </a:cubicBezTo>
                  <a:cubicBezTo>
                    <a:pt x="1241533" y="49386"/>
                    <a:pt x="1247775" y="51858"/>
                    <a:pt x="1254125" y="53975"/>
                  </a:cubicBezTo>
                  <a:lnTo>
                    <a:pt x="1273175" y="60325"/>
                  </a:lnTo>
                  <a:lnTo>
                    <a:pt x="1292225" y="66675"/>
                  </a:lnTo>
                  <a:cubicBezTo>
                    <a:pt x="1295400" y="67733"/>
                    <a:pt x="1298965" y="67994"/>
                    <a:pt x="1301750" y="69850"/>
                  </a:cubicBezTo>
                  <a:cubicBezTo>
                    <a:pt x="1329047" y="88048"/>
                    <a:pt x="1294510" y="66230"/>
                    <a:pt x="1320800" y="79375"/>
                  </a:cubicBezTo>
                  <a:cubicBezTo>
                    <a:pt x="1324213" y="81082"/>
                    <a:pt x="1326912" y="84018"/>
                    <a:pt x="1330325" y="85725"/>
                  </a:cubicBezTo>
                  <a:cubicBezTo>
                    <a:pt x="1333318" y="87222"/>
                    <a:pt x="1336924" y="87275"/>
                    <a:pt x="1339850" y="88900"/>
                  </a:cubicBezTo>
                  <a:cubicBezTo>
                    <a:pt x="1346521" y="92606"/>
                    <a:pt x="1351660" y="99187"/>
                    <a:pt x="1358900" y="101600"/>
                  </a:cubicBezTo>
                  <a:cubicBezTo>
                    <a:pt x="1365250" y="103717"/>
                    <a:pt x="1372381" y="104237"/>
                    <a:pt x="1377950" y="107950"/>
                  </a:cubicBezTo>
                  <a:cubicBezTo>
                    <a:pt x="1381125" y="110067"/>
                    <a:pt x="1383988" y="112750"/>
                    <a:pt x="1387475" y="114300"/>
                  </a:cubicBezTo>
                  <a:cubicBezTo>
                    <a:pt x="1393592" y="117018"/>
                    <a:pt x="1400956" y="116937"/>
                    <a:pt x="1406525" y="120650"/>
                  </a:cubicBezTo>
                  <a:lnTo>
                    <a:pt x="1435100" y="139700"/>
                  </a:lnTo>
                  <a:lnTo>
                    <a:pt x="1444625" y="146050"/>
                  </a:lnTo>
                  <a:cubicBezTo>
                    <a:pt x="1447800" y="148167"/>
                    <a:pt x="1451452" y="149702"/>
                    <a:pt x="1454150" y="152400"/>
                  </a:cubicBezTo>
                  <a:cubicBezTo>
                    <a:pt x="1461172" y="159422"/>
                    <a:pt x="1464359" y="163855"/>
                    <a:pt x="1473200" y="168275"/>
                  </a:cubicBezTo>
                  <a:cubicBezTo>
                    <a:pt x="1476193" y="169772"/>
                    <a:pt x="1479799" y="169825"/>
                    <a:pt x="1482725" y="171450"/>
                  </a:cubicBezTo>
                  <a:cubicBezTo>
                    <a:pt x="1489396" y="175156"/>
                    <a:pt x="1501775" y="184150"/>
                    <a:pt x="1501775" y="184150"/>
                  </a:cubicBezTo>
                  <a:cubicBezTo>
                    <a:pt x="1519973" y="211447"/>
                    <a:pt x="1495742" y="179323"/>
                    <a:pt x="1517650" y="196850"/>
                  </a:cubicBezTo>
                  <a:cubicBezTo>
                    <a:pt x="1538166" y="213263"/>
                    <a:pt x="1509584" y="201570"/>
                    <a:pt x="1533525" y="209550"/>
                  </a:cubicBezTo>
                  <a:cubicBezTo>
                    <a:pt x="1536700" y="212725"/>
                    <a:pt x="1539601" y="216200"/>
                    <a:pt x="1543050" y="219075"/>
                  </a:cubicBezTo>
                  <a:cubicBezTo>
                    <a:pt x="1545981" y="221518"/>
                    <a:pt x="1549877" y="222727"/>
                    <a:pt x="1552575" y="225425"/>
                  </a:cubicBezTo>
                  <a:cubicBezTo>
                    <a:pt x="1555273" y="228123"/>
                    <a:pt x="1555945" y="232566"/>
                    <a:pt x="1558925" y="234950"/>
                  </a:cubicBezTo>
                  <a:cubicBezTo>
                    <a:pt x="1561538" y="237041"/>
                    <a:pt x="1565457" y="236628"/>
                    <a:pt x="1568450" y="238125"/>
                  </a:cubicBezTo>
                  <a:cubicBezTo>
                    <a:pt x="1593069" y="250435"/>
                    <a:pt x="1563559" y="239670"/>
                    <a:pt x="1587500" y="247650"/>
                  </a:cubicBezTo>
                  <a:cubicBezTo>
                    <a:pt x="1590675" y="250825"/>
                    <a:pt x="1593481" y="254418"/>
                    <a:pt x="1597025" y="257175"/>
                  </a:cubicBezTo>
                  <a:cubicBezTo>
                    <a:pt x="1603049" y="261860"/>
                    <a:pt x="1610679" y="264479"/>
                    <a:pt x="1616075" y="269875"/>
                  </a:cubicBezTo>
                  <a:cubicBezTo>
                    <a:pt x="1619250" y="273050"/>
                    <a:pt x="1622056" y="276643"/>
                    <a:pt x="1625600" y="279400"/>
                  </a:cubicBezTo>
                  <a:cubicBezTo>
                    <a:pt x="1631624" y="284085"/>
                    <a:pt x="1644650" y="292100"/>
                    <a:pt x="1644650" y="292100"/>
                  </a:cubicBezTo>
                  <a:cubicBezTo>
                    <a:pt x="1646767" y="295275"/>
                    <a:pt x="1648128" y="299112"/>
                    <a:pt x="1651000" y="301625"/>
                  </a:cubicBezTo>
                  <a:cubicBezTo>
                    <a:pt x="1656743" y="306651"/>
                    <a:pt x="1670050" y="314325"/>
                    <a:pt x="1670050" y="314325"/>
                  </a:cubicBezTo>
                  <a:cubicBezTo>
                    <a:pt x="1681692" y="331787"/>
                    <a:pt x="1670050" y="316971"/>
                    <a:pt x="1685925" y="330200"/>
                  </a:cubicBezTo>
                  <a:cubicBezTo>
                    <a:pt x="1717133" y="356207"/>
                    <a:pt x="1676825" y="324275"/>
                    <a:pt x="1701800" y="349250"/>
                  </a:cubicBezTo>
                  <a:cubicBezTo>
                    <a:pt x="1704498" y="351948"/>
                    <a:pt x="1708150" y="353483"/>
                    <a:pt x="1711325" y="355600"/>
                  </a:cubicBezTo>
                  <a:cubicBezTo>
                    <a:pt x="1717397" y="373816"/>
                    <a:pt x="1710152" y="356813"/>
                    <a:pt x="1724025" y="374650"/>
                  </a:cubicBezTo>
                  <a:cubicBezTo>
                    <a:pt x="1728710" y="380674"/>
                    <a:pt x="1732492" y="387350"/>
                    <a:pt x="1736725" y="393700"/>
                  </a:cubicBezTo>
                  <a:cubicBezTo>
                    <a:pt x="1739216" y="397436"/>
                    <a:pt x="1743375" y="399776"/>
                    <a:pt x="1746250" y="403225"/>
                  </a:cubicBezTo>
                  <a:cubicBezTo>
                    <a:pt x="1748693" y="406156"/>
                    <a:pt x="1749902" y="410052"/>
                    <a:pt x="1752600" y="412750"/>
                  </a:cubicBezTo>
                  <a:cubicBezTo>
                    <a:pt x="1755298" y="415448"/>
                    <a:pt x="1758950" y="416983"/>
                    <a:pt x="1762125" y="419100"/>
                  </a:cubicBezTo>
                  <a:cubicBezTo>
                    <a:pt x="1776942" y="441325"/>
                    <a:pt x="1768475" y="433917"/>
                    <a:pt x="1784350" y="444500"/>
                  </a:cubicBezTo>
                  <a:cubicBezTo>
                    <a:pt x="1786467" y="447675"/>
                    <a:pt x="1788257" y="451094"/>
                    <a:pt x="1790700" y="454025"/>
                  </a:cubicBezTo>
                  <a:cubicBezTo>
                    <a:pt x="1798340" y="463192"/>
                    <a:pt x="1800384" y="463656"/>
                    <a:pt x="1809750" y="469900"/>
                  </a:cubicBezTo>
                  <a:cubicBezTo>
                    <a:pt x="1811867" y="473075"/>
                    <a:pt x="1813228" y="476912"/>
                    <a:pt x="1816100" y="479425"/>
                  </a:cubicBezTo>
                  <a:cubicBezTo>
                    <a:pt x="1821843" y="484451"/>
                    <a:pt x="1835150" y="492125"/>
                    <a:pt x="1835150" y="492125"/>
                  </a:cubicBezTo>
                  <a:cubicBezTo>
                    <a:pt x="1857841" y="526162"/>
                    <a:pt x="1822504" y="474505"/>
                    <a:pt x="1851025" y="511175"/>
                  </a:cubicBezTo>
                  <a:cubicBezTo>
                    <a:pt x="1855710" y="517199"/>
                    <a:pt x="1859492" y="523875"/>
                    <a:pt x="1863725" y="530225"/>
                  </a:cubicBezTo>
                  <a:lnTo>
                    <a:pt x="1882775" y="558800"/>
                  </a:lnTo>
                  <a:lnTo>
                    <a:pt x="1889125" y="568325"/>
                  </a:lnTo>
                  <a:cubicBezTo>
                    <a:pt x="1891242" y="571500"/>
                    <a:pt x="1892777" y="575152"/>
                    <a:pt x="1895475" y="577850"/>
                  </a:cubicBezTo>
                  <a:lnTo>
                    <a:pt x="1905000" y="587375"/>
                  </a:lnTo>
                  <a:cubicBezTo>
                    <a:pt x="1921382" y="636522"/>
                    <a:pt x="1902606" y="585761"/>
                    <a:pt x="1917700" y="615950"/>
                  </a:cubicBezTo>
                  <a:cubicBezTo>
                    <a:pt x="1919197" y="618943"/>
                    <a:pt x="1919378" y="622482"/>
                    <a:pt x="1920875" y="625475"/>
                  </a:cubicBezTo>
                  <a:cubicBezTo>
                    <a:pt x="1922582" y="628888"/>
                    <a:pt x="1925518" y="631587"/>
                    <a:pt x="1927225" y="635000"/>
                  </a:cubicBezTo>
                  <a:cubicBezTo>
                    <a:pt x="1928722" y="637993"/>
                    <a:pt x="1928903" y="641532"/>
                    <a:pt x="1930400" y="644525"/>
                  </a:cubicBezTo>
                  <a:cubicBezTo>
                    <a:pt x="1932107" y="647938"/>
                    <a:pt x="1935200" y="650563"/>
                    <a:pt x="1936750" y="654050"/>
                  </a:cubicBezTo>
                  <a:cubicBezTo>
                    <a:pt x="1939468" y="660167"/>
                    <a:pt x="1940983" y="666750"/>
                    <a:pt x="1943100" y="673100"/>
                  </a:cubicBezTo>
                  <a:lnTo>
                    <a:pt x="1946275" y="682625"/>
                  </a:lnTo>
                  <a:cubicBezTo>
                    <a:pt x="1947333" y="685800"/>
                    <a:pt x="1947594" y="689365"/>
                    <a:pt x="1949450" y="692150"/>
                  </a:cubicBezTo>
                  <a:lnTo>
                    <a:pt x="1987550" y="749300"/>
                  </a:lnTo>
                  <a:lnTo>
                    <a:pt x="1993900" y="758825"/>
                  </a:lnTo>
                  <a:cubicBezTo>
                    <a:pt x="1996017" y="762000"/>
                    <a:pt x="1996630" y="767143"/>
                    <a:pt x="2000250" y="768350"/>
                  </a:cubicBezTo>
                  <a:cubicBezTo>
                    <a:pt x="2017015" y="773938"/>
                    <a:pt x="2006990" y="769669"/>
                    <a:pt x="2028825" y="784225"/>
                  </a:cubicBezTo>
                  <a:lnTo>
                    <a:pt x="2038350" y="790575"/>
                  </a:lnTo>
                  <a:lnTo>
                    <a:pt x="2047875" y="796925"/>
                  </a:lnTo>
                  <a:cubicBezTo>
                    <a:pt x="2049992" y="800100"/>
                    <a:pt x="2051245" y="804066"/>
                    <a:pt x="2054225" y="806450"/>
                  </a:cubicBezTo>
                  <a:cubicBezTo>
                    <a:pt x="2056838" y="808541"/>
                    <a:pt x="2060757" y="808128"/>
                    <a:pt x="2063750" y="809625"/>
                  </a:cubicBezTo>
                  <a:cubicBezTo>
                    <a:pt x="2067163" y="811332"/>
                    <a:pt x="2070344" y="813532"/>
                    <a:pt x="2073275" y="815975"/>
                  </a:cubicBezTo>
                  <a:cubicBezTo>
                    <a:pt x="2103118" y="840844"/>
                    <a:pt x="2053702" y="806102"/>
                    <a:pt x="2101850" y="838200"/>
                  </a:cubicBezTo>
                  <a:lnTo>
                    <a:pt x="2111375" y="844550"/>
                  </a:lnTo>
                  <a:lnTo>
                    <a:pt x="2120900" y="850900"/>
                  </a:lnTo>
                  <a:cubicBezTo>
                    <a:pt x="2123017" y="854075"/>
                    <a:pt x="2124270" y="858041"/>
                    <a:pt x="2127250" y="860425"/>
                  </a:cubicBezTo>
                  <a:cubicBezTo>
                    <a:pt x="2129863" y="862516"/>
                    <a:pt x="2133849" y="861975"/>
                    <a:pt x="2136775" y="863600"/>
                  </a:cubicBezTo>
                  <a:cubicBezTo>
                    <a:pt x="2143446" y="867306"/>
                    <a:pt x="2149475" y="872067"/>
                    <a:pt x="2155825" y="876300"/>
                  </a:cubicBezTo>
                  <a:lnTo>
                    <a:pt x="2165350" y="882650"/>
                  </a:lnTo>
                  <a:lnTo>
                    <a:pt x="2174875" y="889000"/>
                  </a:lnTo>
                  <a:cubicBezTo>
                    <a:pt x="2176992" y="892175"/>
                    <a:pt x="2178782" y="895594"/>
                    <a:pt x="2181225" y="898525"/>
                  </a:cubicBezTo>
                  <a:cubicBezTo>
                    <a:pt x="2184100" y="901974"/>
                    <a:pt x="2188569" y="904125"/>
                    <a:pt x="2190750" y="908050"/>
                  </a:cubicBezTo>
                  <a:cubicBezTo>
                    <a:pt x="2194001" y="913901"/>
                    <a:pt x="2194983" y="920750"/>
                    <a:pt x="2197100" y="927100"/>
                  </a:cubicBezTo>
                  <a:lnTo>
                    <a:pt x="2200275" y="936625"/>
                  </a:lnTo>
                  <a:lnTo>
                    <a:pt x="2209800" y="965200"/>
                  </a:lnTo>
                  <a:lnTo>
                    <a:pt x="2212975" y="974725"/>
                  </a:lnTo>
                  <a:cubicBezTo>
                    <a:pt x="2214033" y="977900"/>
                    <a:pt x="2214294" y="981465"/>
                    <a:pt x="2216150" y="984250"/>
                  </a:cubicBezTo>
                  <a:cubicBezTo>
                    <a:pt x="2218267" y="987425"/>
                    <a:pt x="2220793" y="990362"/>
                    <a:pt x="2222500" y="993775"/>
                  </a:cubicBezTo>
                  <a:cubicBezTo>
                    <a:pt x="2223997" y="996768"/>
                    <a:pt x="2224178" y="1000307"/>
                    <a:pt x="2225675" y="1003300"/>
                  </a:cubicBezTo>
                  <a:cubicBezTo>
                    <a:pt x="2227382" y="1006713"/>
                    <a:pt x="2230475" y="1009338"/>
                    <a:pt x="2232025" y="1012825"/>
                  </a:cubicBezTo>
                  <a:cubicBezTo>
                    <a:pt x="2234743" y="1018942"/>
                    <a:pt x="2236258" y="1025525"/>
                    <a:pt x="2238375" y="1031875"/>
                  </a:cubicBezTo>
                  <a:lnTo>
                    <a:pt x="2241550" y="1041400"/>
                  </a:lnTo>
                  <a:lnTo>
                    <a:pt x="2244725" y="1050925"/>
                  </a:lnTo>
                  <a:cubicBezTo>
                    <a:pt x="2243667" y="1083733"/>
                    <a:pt x="2244203" y="1116632"/>
                    <a:pt x="2241550" y="1149350"/>
                  </a:cubicBezTo>
                  <a:cubicBezTo>
                    <a:pt x="2241009" y="1156022"/>
                    <a:pt x="2238913" y="1162831"/>
                    <a:pt x="2235200" y="1168400"/>
                  </a:cubicBezTo>
                  <a:lnTo>
                    <a:pt x="2228850" y="1177925"/>
                  </a:lnTo>
                  <a:cubicBezTo>
                    <a:pt x="2224052" y="1197119"/>
                    <a:pt x="2227055" y="1186485"/>
                    <a:pt x="2219325" y="1209675"/>
                  </a:cubicBezTo>
                  <a:cubicBezTo>
                    <a:pt x="2218267" y="1212850"/>
                    <a:pt x="2218006" y="1216415"/>
                    <a:pt x="2216150" y="1219200"/>
                  </a:cubicBezTo>
                  <a:cubicBezTo>
                    <a:pt x="2200384" y="1242849"/>
                    <a:pt x="2220647" y="1213804"/>
                    <a:pt x="2200275" y="1238250"/>
                  </a:cubicBezTo>
                  <a:cubicBezTo>
                    <a:pt x="2189228" y="1251507"/>
                    <a:pt x="2200037" y="1245738"/>
                    <a:pt x="2184400" y="1250950"/>
                  </a:cubicBezTo>
                  <a:cubicBezTo>
                    <a:pt x="2167467" y="1276350"/>
                    <a:pt x="2189692" y="1245658"/>
                    <a:pt x="2168525" y="1266825"/>
                  </a:cubicBezTo>
                  <a:cubicBezTo>
                    <a:pt x="2165827" y="1269523"/>
                    <a:pt x="2165047" y="1273837"/>
                    <a:pt x="2162175" y="1276350"/>
                  </a:cubicBezTo>
                  <a:cubicBezTo>
                    <a:pt x="2156432" y="1281376"/>
                    <a:pt x="2149475" y="1284817"/>
                    <a:pt x="2143125" y="1289050"/>
                  </a:cubicBezTo>
                  <a:lnTo>
                    <a:pt x="2133600" y="1295400"/>
                  </a:lnTo>
                  <a:cubicBezTo>
                    <a:pt x="2116667" y="1320800"/>
                    <a:pt x="2138892" y="1290108"/>
                    <a:pt x="2117725" y="1311275"/>
                  </a:cubicBezTo>
                  <a:cubicBezTo>
                    <a:pt x="2105025" y="1323975"/>
                    <a:pt x="2118783" y="1318683"/>
                    <a:pt x="2101850" y="1327150"/>
                  </a:cubicBezTo>
                  <a:cubicBezTo>
                    <a:pt x="2098857" y="1328647"/>
                    <a:pt x="2095251" y="1328700"/>
                    <a:pt x="2092325" y="1330325"/>
                  </a:cubicBezTo>
                  <a:cubicBezTo>
                    <a:pt x="2085654" y="1334031"/>
                    <a:pt x="2080515" y="1340612"/>
                    <a:pt x="2073275" y="1343025"/>
                  </a:cubicBezTo>
                  <a:cubicBezTo>
                    <a:pt x="2038537" y="1354604"/>
                    <a:pt x="2091154" y="1336137"/>
                    <a:pt x="2054225" y="1352550"/>
                  </a:cubicBezTo>
                  <a:cubicBezTo>
                    <a:pt x="2048108" y="1355268"/>
                    <a:pt x="2041525" y="1356783"/>
                    <a:pt x="2035175" y="1358900"/>
                  </a:cubicBezTo>
                  <a:cubicBezTo>
                    <a:pt x="2032000" y="1359958"/>
                    <a:pt x="2028435" y="1360219"/>
                    <a:pt x="2025650" y="1362075"/>
                  </a:cubicBezTo>
                  <a:cubicBezTo>
                    <a:pt x="2022475" y="1364192"/>
                    <a:pt x="2019612" y="1366875"/>
                    <a:pt x="2016125" y="1368425"/>
                  </a:cubicBezTo>
                  <a:cubicBezTo>
                    <a:pt x="2010008" y="1371143"/>
                    <a:pt x="2003425" y="1372658"/>
                    <a:pt x="1997075" y="1374775"/>
                  </a:cubicBezTo>
                  <a:lnTo>
                    <a:pt x="1987550" y="1377950"/>
                  </a:lnTo>
                  <a:lnTo>
                    <a:pt x="1958975" y="1387475"/>
                  </a:lnTo>
                  <a:lnTo>
                    <a:pt x="1949450" y="1390650"/>
                  </a:lnTo>
                  <a:cubicBezTo>
                    <a:pt x="1946275" y="1391708"/>
                    <a:pt x="1943272" y="1393825"/>
                    <a:pt x="1939925" y="1393825"/>
                  </a:cubicBezTo>
                  <a:lnTo>
                    <a:pt x="1930400" y="1393825"/>
                  </a:lnTo>
                </a:path>
              </a:pathLst>
            </a:custGeom>
            <a:noFill/>
            <a:ln w="38100">
              <a:solidFill>
                <a:schemeClr val="bg1"/>
              </a:solidFill>
              <a:prstDash val="sysDot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9666"/>
            </a:p>
          </p:txBody>
        </p:sp>
      </p:grpSp>
      <p:sp>
        <p:nvSpPr>
          <p:cNvPr id="65" name="Rectangle 64"/>
          <p:cNvSpPr/>
          <p:nvPr/>
        </p:nvSpPr>
        <p:spPr>
          <a:xfrm flipH="1">
            <a:off x="642818" y="1734826"/>
            <a:ext cx="428467" cy="6952248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9666"/>
          </a:p>
        </p:txBody>
      </p:sp>
      <p:sp>
        <p:nvSpPr>
          <p:cNvPr id="80" name="TextBox 79"/>
          <p:cNvSpPr txBox="1"/>
          <p:nvPr/>
        </p:nvSpPr>
        <p:spPr>
          <a:xfrm>
            <a:off x="654634" y="1130613"/>
            <a:ext cx="465192" cy="646331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sz="3600" b="1" dirty="0"/>
              <a:t>A</a:t>
            </a:r>
          </a:p>
        </p:txBody>
      </p:sp>
      <p:sp>
        <p:nvSpPr>
          <p:cNvPr id="55" name="Rectangle 54"/>
          <p:cNvSpPr/>
          <p:nvPr/>
        </p:nvSpPr>
        <p:spPr>
          <a:xfrm flipV="1">
            <a:off x="1164769" y="1230383"/>
            <a:ext cx="18369627" cy="420610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9666"/>
          </a:p>
        </p:txBody>
      </p:sp>
      <p:sp>
        <p:nvSpPr>
          <p:cNvPr id="60" name="TextBox 59"/>
          <p:cNvSpPr txBox="1"/>
          <p:nvPr/>
        </p:nvSpPr>
        <p:spPr>
          <a:xfrm>
            <a:off x="8942456" y="1210989"/>
            <a:ext cx="3382893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800" b="1" dirty="0"/>
              <a:t>Fetal brain  E16.5</a:t>
            </a:r>
          </a:p>
        </p:txBody>
      </p:sp>
      <p:cxnSp>
        <p:nvCxnSpPr>
          <p:cNvPr id="4" name="Straight Connector 3">
            <a:extLst>
              <a:ext uri="{FF2B5EF4-FFF2-40B4-BE49-F238E27FC236}">
                <a16:creationId xmlns:a16="http://schemas.microsoft.com/office/drawing/2014/main" id="{AB0573A0-18BE-E37C-5EBB-98F107EF6D9E}"/>
              </a:ext>
            </a:extLst>
          </p:cNvPr>
          <p:cNvCxnSpPr/>
          <p:nvPr/>
        </p:nvCxnSpPr>
        <p:spPr>
          <a:xfrm>
            <a:off x="9521432" y="8475919"/>
            <a:ext cx="678446" cy="0"/>
          </a:xfrm>
          <a:prstGeom prst="line">
            <a:avLst/>
          </a:prstGeom>
          <a:ln w="762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6" name="TextBox 65"/>
          <p:cNvSpPr txBox="1"/>
          <p:nvPr/>
        </p:nvSpPr>
        <p:spPr>
          <a:xfrm>
            <a:off x="1020096" y="9395410"/>
            <a:ext cx="2637810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800" i="1" dirty="0"/>
              <a:t>             Cldn1                             Cldn2                              Cldn4                                </a:t>
            </a:r>
            <a:r>
              <a:rPr lang="en-US" sz="2800" i="1" dirty="0" err="1"/>
              <a:t>Ocln</a:t>
            </a:r>
            <a:r>
              <a:rPr lang="en-US" sz="2800" i="1" dirty="0"/>
              <a:t>                               Zo-1                             Nos-2                           Cox-2                  </a:t>
            </a:r>
          </a:p>
        </p:txBody>
      </p:sp>
      <p:sp>
        <p:nvSpPr>
          <p:cNvPr id="7" name="Rectangle 6"/>
          <p:cNvSpPr/>
          <p:nvPr/>
        </p:nvSpPr>
        <p:spPr>
          <a:xfrm>
            <a:off x="20921587" y="5263531"/>
            <a:ext cx="1162498" cy="52322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2800" dirty="0"/>
              <a:t>CLDN5</a:t>
            </a:r>
          </a:p>
        </p:txBody>
      </p:sp>
      <p:sp>
        <p:nvSpPr>
          <p:cNvPr id="67" name="Rectangle 66"/>
          <p:cNvSpPr/>
          <p:nvPr/>
        </p:nvSpPr>
        <p:spPr>
          <a:xfrm>
            <a:off x="20988612" y="1219104"/>
            <a:ext cx="962123" cy="52322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2800" dirty="0"/>
              <a:t>CD31</a:t>
            </a:r>
          </a:p>
        </p:txBody>
      </p:sp>
      <p:sp>
        <p:nvSpPr>
          <p:cNvPr id="87" name="Rectangle 86"/>
          <p:cNvSpPr/>
          <p:nvPr/>
        </p:nvSpPr>
        <p:spPr>
          <a:xfrm rot="16200000">
            <a:off x="19355628" y="6781342"/>
            <a:ext cx="1643399" cy="95410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2800" dirty="0"/>
              <a:t>MFI/mm</a:t>
            </a:r>
            <a:r>
              <a:rPr lang="en-US" sz="2800" baseline="30000" dirty="0"/>
              <a:t>2</a:t>
            </a:r>
          </a:p>
          <a:p>
            <a:endParaRPr lang="en-US" sz="2800" dirty="0"/>
          </a:p>
        </p:txBody>
      </p:sp>
      <p:sp>
        <p:nvSpPr>
          <p:cNvPr id="88" name="Rectangle 87"/>
          <p:cNvSpPr/>
          <p:nvPr/>
        </p:nvSpPr>
        <p:spPr>
          <a:xfrm rot="16200000">
            <a:off x="19355628" y="2886072"/>
            <a:ext cx="1643399" cy="95410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2800" dirty="0"/>
              <a:t>MFI/mm</a:t>
            </a:r>
            <a:r>
              <a:rPr lang="en-US" sz="2800" baseline="30000" dirty="0"/>
              <a:t>2</a:t>
            </a:r>
          </a:p>
          <a:p>
            <a:endParaRPr lang="en-US" sz="2800" dirty="0"/>
          </a:p>
        </p:txBody>
      </p:sp>
      <p:grpSp>
        <p:nvGrpSpPr>
          <p:cNvPr id="89" name="Group 88"/>
          <p:cNvGrpSpPr/>
          <p:nvPr/>
        </p:nvGrpSpPr>
        <p:grpSpPr>
          <a:xfrm>
            <a:off x="8512155" y="14149678"/>
            <a:ext cx="6292890" cy="590527"/>
            <a:chOff x="15433678" y="7986862"/>
            <a:chExt cx="6292890" cy="590527"/>
          </a:xfrm>
        </p:grpSpPr>
        <p:sp>
          <p:nvSpPr>
            <p:cNvPr id="90" name="TextBox 89">
              <a:extLst>
                <a:ext uri="{FF2B5EF4-FFF2-40B4-BE49-F238E27FC236}">
                  <a16:creationId xmlns:a16="http://schemas.microsoft.com/office/drawing/2014/main" id="{AF1BBFB5-F136-74A5-EC62-385A26239619}"/>
                </a:ext>
              </a:extLst>
            </p:cNvPr>
            <p:cNvSpPr txBox="1"/>
            <p:nvPr/>
          </p:nvSpPr>
          <p:spPr>
            <a:xfrm>
              <a:off x="15641124" y="7988301"/>
              <a:ext cx="1331071" cy="58846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2800" dirty="0">
                  <a:cs typeface="Arial" panose="020B0604020202020204" pitchFamily="34" charset="0"/>
                </a:rPr>
                <a:t>Legend:</a:t>
              </a:r>
            </a:p>
          </p:txBody>
        </p:sp>
        <p:sp>
          <p:nvSpPr>
            <p:cNvPr id="91" name="TextBox 90">
              <a:extLst>
                <a:ext uri="{FF2B5EF4-FFF2-40B4-BE49-F238E27FC236}">
                  <a16:creationId xmlns:a16="http://schemas.microsoft.com/office/drawing/2014/main" id="{3B9872B2-9D1A-EB02-54AB-9FF97973659E}"/>
                </a:ext>
              </a:extLst>
            </p:cNvPr>
            <p:cNvSpPr txBox="1"/>
            <p:nvPr/>
          </p:nvSpPr>
          <p:spPr>
            <a:xfrm>
              <a:off x="17536228" y="7988924"/>
              <a:ext cx="753731" cy="5884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2800" dirty="0">
                  <a:cs typeface="Arial" panose="020B0604020202020204" pitchFamily="34" charset="0"/>
                </a:rPr>
                <a:t>Con</a:t>
              </a:r>
            </a:p>
          </p:txBody>
        </p:sp>
        <p:sp>
          <p:nvSpPr>
            <p:cNvPr id="92" name="TextBox 91">
              <a:extLst>
                <a:ext uri="{FF2B5EF4-FFF2-40B4-BE49-F238E27FC236}">
                  <a16:creationId xmlns:a16="http://schemas.microsoft.com/office/drawing/2014/main" id="{2B696D2C-658E-0F65-BAA3-0FAA9CA6BEDC}"/>
                </a:ext>
              </a:extLst>
            </p:cNvPr>
            <p:cNvSpPr txBox="1"/>
            <p:nvPr/>
          </p:nvSpPr>
          <p:spPr>
            <a:xfrm>
              <a:off x="18877142" y="7988913"/>
              <a:ext cx="1178527" cy="5884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2800" dirty="0">
                  <a:cs typeface="Arial" panose="020B0604020202020204" pitchFamily="34" charset="0"/>
                </a:rPr>
                <a:t>X31</a:t>
              </a:r>
              <a:r>
                <a:rPr lang="en-US" sz="2800" baseline="-25000" dirty="0">
                  <a:cs typeface="Arial" panose="020B0604020202020204" pitchFamily="34" charset="0"/>
                </a:rPr>
                <a:t>mod</a:t>
              </a:r>
            </a:p>
          </p:txBody>
        </p:sp>
        <p:sp>
          <p:nvSpPr>
            <p:cNvPr id="93" name="TextBox 92">
              <a:extLst>
                <a:ext uri="{FF2B5EF4-FFF2-40B4-BE49-F238E27FC236}">
                  <a16:creationId xmlns:a16="http://schemas.microsoft.com/office/drawing/2014/main" id="{9AB4959C-3B6C-CA70-04B7-A0075AB99D90}"/>
                </a:ext>
              </a:extLst>
            </p:cNvPr>
            <p:cNvSpPr txBox="1"/>
            <p:nvPr/>
          </p:nvSpPr>
          <p:spPr>
            <a:xfrm>
              <a:off x="20593250" y="7988906"/>
              <a:ext cx="915635" cy="5884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2800" dirty="0">
                  <a:cs typeface="Arial" panose="020B0604020202020204" pitchFamily="34" charset="0"/>
                </a:rPr>
                <a:t>X31</a:t>
              </a:r>
              <a:r>
                <a:rPr lang="en-US" sz="2800" baseline="-25000" dirty="0">
                  <a:cs typeface="Arial" panose="020B0604020202020204" pitchFamily="34" charset="0"/>
                </a:rPr>
                <a:t>hi</a:t>
              </a:r>
            </a:p>
          </p:txBody>
        </p:sp>
        <p:sp>
          <p:nvSpPr>
            <p:cNvPr id="94" name="Rectangle 93">
              <a:extLst>
                <a:ext uri="{FF2B5EF4-FFF2-40B4-BE49-F238E27FC236}">
                  <a16:creationId xmlns:a16="http://schemas.microsoft.com/office/drawing/2014/main" id="{7A2596D0-46BE-4279-A5B3-59C91930BE65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15433678" y="7986862"/>
              <a:ext cx="6292890" cy="566588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800">
                <a:cs typeface="Arial" panose="020B0604020202020204" pitchFamily="34" charset="0"/>
              </a:endParaRPr>
            </a:p>
          </p:txBody>
        </p:sp>
        <p:sp>
          <p:nvSpPr>
            <p:cNvPr id="95" name="Rectangle 94">
              <a:extLst>
                <a:ext uri="{FF2B5EF4-FFF2-40B4-BE49-F238E27FC236}">
                  <a16:creationId xmlns:a16="http://schemas.microsoft.com/office/drawing/2014/main" id="{0AD6776F-8AD9-CE0E-45CB-9A4DFFD09A92}"/>
                </a:ext>
              </a:extLst>
            </p:cNvPr>
            <p:cNvSpPr/>
            <p:nvPr/>
          </p:nvSpPr>
          <p:spPr>
            <a:xfrm>
              <a:off x="18469774" y="8124545"/>
              <a:ext cx="326017" cy="300659"/>
            </a:xfrm>
            <a:prstGeom prst="rect">
              <a:avLst/>
            </a:prstGeom>
            <a:solidFill>
              <a:srgbClr val="FF0000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800">
                <a:cs typeface="Arial" panose="020B0604020202020204" pitchFamily="34" charset="0"/>
              </a:endParaRPr>
            </a:p>
          </p:txBody>
        </p:sp>
        <p:sp>
          <p:nvSpPr>
            <p:cNvPr id="96" name="Rectangle 95">
              <a:extLst>
                <a:ext uri="{FF2B5EF4-FFF2-40B4-BE49-F238E27FC236}">
                  <a16:creationId xmlns:a16="http://schemas.microsoft.com/office/drawing/2014/main" id="{3259DBA0-AD77-8F85-227B-E980D6C79335}"/>
                </a:ext>
              </a:extLst>
            </p:cNvPr>
            <p:cNvSpPr/>
            <p:nvPr/>
          </p:nvSpPr>
          <p:spPr>
            <a:xfrm>
              <a:off x="20178825" y="8124545"/>
              <a:ext cx="326017" cy="300659"/>
            </a:xfrm>
            <a:prstGeom prst="rect">
              <a:avLst/>
            </a:prstGeom>
            <a:solidFill>
              <a:srgbClr val="C00000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800">
                <a:cs typeface="Arial" panose="020B0604020202020204" pitchFamily="34" charset="0"/>
              </a:endParaRPr>
            </a:p>
          </p:txBody>
        </p:sp>
        <p:sp>
          <p:nvSpPr>
            <p:cNvPr id="97" name="Rectangle 96">
              <a:extLst>
                <a:ext uri="{FF2B5EF4-FFF2-40B4-BE49-F238E27FC236}">
                  <a16:creationId xmlns:a16="http://schemas.microsoft.com/office/drawing/2014/main" id="{D8BFDBB0-710E-C27A-78EE-DF914C34E7F7}"/>
                </a:ext>
              </a:extLst>
            </p:cNvPr>
            <p:cNvSpPr/>
            <p:nvPr/>
          </p:nvSpPr>
          <p:spPr>
            <a:xfrm>
              <a:off x="17158247" y="8124545"/>
              <a:ext cx="326017" cy="300659"/>
            </a:xfrm>
            <a:prstGeom prst="rect">
              <a:avLst/>
            </a:prstGeom>
            <a:solidFill>
              <a:schemeClr val="bg2">
                <a:lumMod val="90000"/>
              </a:schemeClr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800">
                <a:cs typeface="Arial" panose="020B0604020202020204" pitchFamily="34" charset="0"/>
              </a:endParaRPr>
            </a:p>
          </p:txBody>
        </p:sp>
      </p:grpSp>
      <p:sp>
        <p:nvSpPr>
          <p:cNvPr id="3" name="TextBox 2">
            <a:extLst>
              <a:ext uri="{FF2B5EF4-FFF2-40B4-BE49-F238E27FC236}">
                <a16:creationId xmlns:a16="http://schemas.microsoft.com/office/drawing/2014/main" id="{DD6B360D-667A-358B-3CD9-DA21EBB33983}"/>
              </a:ext>
            </a:extLst>
          </p:cNvPr>
          <p:cNvSpPr txBox="1"/>
          <p:nvPr/>
        </p:nvSpPr>
        <p:spPr>
          <a:xfrm>
            <a:off x="642818" y="304103"/>
            <a:ext cx="4532587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200" b="1" dirty="0"/>
              <a:t>Supplementary Figure S4.</a:t>
            </a:r>
          </a:p>
        </p:txBody>
      </p:sp>
      <p:sp>
        <p:nvSpPr>
          <p:cNvPr id="6" name="Rectangle 5"/>
          <p:cNvSpPr/>
          <p:nvPr/>
        </p:nvSpPr>
        <p:spPr>
          <a:xfrm>
            <a:off x="1417186" y="15811930"/>
            <a:ext cx="20391551" cy="507831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buSzPts val="1100"/>
            </a:pPr>
            <a:r>
              <a:rPr lang="en-US" sz="36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4. X31</a:t>
            </a:r>
            <a:r>
              <a:rPr lang="en-US" sz="3600" b="1" baseline="-25000" dirty="0">
                <a:latin typeface="Arial" panose="020B0604020202020204" pitchFamily="34" charset="0"/>
                <a:cs typeface="Arial" panose="020B0604020202020204" pitchFamily="34" charset="0"/>
              </a:rPr>
              <a:t>hi</a:t>
            </a:r>
            <a:r>
              <a:rPr lang="en-US" sz="3600" b="1" dirty="0">
                <a:latin typeface="Arial" panose="020B0604020202020204" pitchFamily="34" charset="0"/>
                <a:cs typeface="Arial" panose="020B0604020202020204" pitchFamily="34" charset="0"/>
              </a:rPr>
              <a:t> exposure did not affect levels of TJPs, CD31, </a:t>
            </a:r>
            <a:r>
              <a:rPr lang="en-US" sz="3600" b="1" i="1" dirty="0">
                <a:latin typeface="Arial" panose="020B0604020202020204" pitchFamily="34" charset="0"/>
                <a:cs typeface="Arial" panose="020B0604020202020204" pitchFamily="34" charset="0"/>
              </a:rPr>
              <a:t>Nos-2</a:t>
            </a:r>
            <a:r>
              <a:rPr lang="en-US" sz="3600" b="1" dirty="0">
                <a:latin typeface="Arial" panose="020B0604020202020204" pitchFamily="34" charset="0"/>
                <a:cs typeface="Arial" panose="020B0604020202020204" pitchFamily="34" charset="0"/>
              </a:rPr>
              <a:t>, or </a:t>
            </a:r>
            <a:r>
              <a:rPr lang="en-US" sz="3600" b="1" i="1" dirty="0">
                <a:latin typeface="Arial" panose="020B0604020202020204" pitchFamily="34" charset="0"/>
                <a:cs typeface="Arial" panose="020B0604020202020204" pitchFamily="34" charset="0"/>
              </a:rPr>
              <a:t>Cox-2</a:t>
            </a:r>
            <a:r>
              <a:rPr lang="en-US" sz="3600" b="1" dirty="0">
                <a:latin typeface="Arial" panose="020B0604020202020204" pitchFamily="34" charset="0"/>
                <a:cs typeface="Arial" panose="020B0604020202020204" pitchFamily="34" charset="0"/>
              </a:rPr>
              <a:t> in the whole fetal brain</a:t>
            </a:r>
            <a:r>
              <a:rPr lang="en-US" sz="36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sz="36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sz="36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US" sz="36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) Representative sagittal cross-sections of CD31 and CLDN5 staining in the whole fetal brain. (</a:t>
            </a:r>
            <a:r>
              <a:rPr lang="en-US" sz="36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US" sz="36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&amp; </a:t>
            </a:r>
            <a:r>
              <a:rPr lang="en-US" sz="36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US" sz="36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) MFI/mm</a:t>
            </a:r>
            <a:r>
              <a:rPr lang="en-US" sz="3600" baseline="30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sz="36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of CD31 and CLDN5 did not differ across treatment groups. (</a:t>
            </a:r>
            <a:r>
              <a:rPr lang="en-US" sz="36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r>
              <a:rPr lang="en-US" sz="36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r>
              <a:rPr lang="en-US" sz="3600" i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ldn1 </a:t>
            </a:r>
            <a:r>
              <a:rPr lang="en-US" sz="36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ene expression was increased in the X31</a:t>
            </a:r>
            <a:r>
              <a:rPr lang="en-US" sz="3600" baseline="-25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od </a:t>
            </a:r>
            <a:r>
              <a:rPr lang="en-US" sz="36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reatment group. (</a:t>
            </a:r>
            <a:r>
              <a:rPr lang="en-US" sz="36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r>
              <a:rPr lang="en-US" sz="36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en-US" sz="36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J</a:t>
            </a:r>
            <a:r>
              <a:rPr lang="en-US" sz="36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) No changes in </a:t>
            </a:r>
            <a:r>
              <a:rPr lang="en-US" sz="3600" i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ldn2</a:t>
            </a:r>
            <a:r>
              <a:rPr lang="en-US" sz="36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US" sz="3600" i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ldn4</a:t>
            </a:r>
            <a:r>
              <a:rPr lang="en-US" sz="36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US" sz="3600" i="1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cln</a:t>
            </a:r>
            <a:r>
              <a:rPr lang="en-US" sz="36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US" sz="3600" i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Zo-1</a:t>
            </a:r>
            <a:r>
              <a:rPr lang="en-US" sz="36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US" sz="3600" i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os-2</a:t>
            </a:r>
            <a:r>
              <a:rPr lang="en-US" sz="36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, and </a:t>
            </a:r>
            <a:r>
              <a:rPr lang="en-US" sz="3600" i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ox2</a:t>
            </a:r>
            <a:r>
              <a:rPr lang="en-US" sz="36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gene expression reached significance</a:t>
            </a:r>
            <a:r>
              <a:rPr lang="en-US" sz="36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sz="3600" dirty="0">
                <a:solidFill>
                  <a:srgbClr val="131F33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ne representative fetus per litter was used.</a:t>
            </a:r>
            <a:r>
              <a:rPr lang="en-US" sz="36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3600" dirty="0">
                <a:solidFill>
                  <a:srgbClr val="131F33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ata are expressed as means ± SEM; </a:t>
            </a:r>
            <a:r>
              <a:rPr lang="en-US" sz="3600" dirty="0">
                <a:latin typeface="Arial" panose="020B0604020202020204" pitchFamily="34" charset="0"/>
                <a:cs typeface="Arial" panose="020B0604020202020204" pitchFamily="34" charset="0"/>
              </a:rPr>
              <a:t>circles represent individual fetuses</a:t>
            </a:r>
            <a:r>
              <a:rPr lang="en-US" sz="3600" dirty="0">
                <a:solidFill>
                  <a:srgbClr val="0D0D0D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;</a:t>
            </a:r>
            <a:r>
              <a:rPr lang="en-US" sz="3600" dirty="0">
                <a:solidFill>
                  <a:srgbClr val="131F33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n per group: Con = 7-10, X31</a:t>
            </a:r>
            <a:r>
              <a:rPr lang="en-US" sz="3600" baseline="-25000" dirty="0">
                <a:solidFill>
                  <a:srgbClr val="131F33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od</a:t>
            </a:r>
            <a:r>
              <a:rPr lang="en-US" sz="3600" dirty="0">
                <a:solidFill>
                  <a:srgbClr val="131F33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= 7-8, X31</a:t>
            </a:r>
            <a:r>
              <a:rPr lang="en-US" sz="3600" baseline="-25000" dirty="0">
                <a:solidFill>
                  <a:srgbClr val="131F33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i</a:t>
            </a:r>
            <a:r>
              <a:rPr lang="en-US" sz="3600" dirty="0">
                <a:solidFill>
                  <a:srgbClr val="131F33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= 8.</a:t>
            </a:r>
            <a:r>
              <a:rPr lang="en-US" sz="36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3600" dirty="0">
                <a:latin typeface="Arial" panose="020B0604020202020204" pitchFamily="34" charset="0"/>
                <a:cs typeface="Arial" panose="020B0604020202020204" pitchFamily="34" charset="0"/>
              </a:rPr>
              <a:t>Statistical analysis was conducted using a one-way ANOVA with Tukey's post hoc test</a:t>
            </a:r>
            <a:r>
              <a:rPr lang="en-US" sz="36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; * p &lt; 0.05.</a:t>
            </a:r>
            <a:r>
              <a:rPr lang="en-US" sz="3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36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otted lines represent regions of interest for MFI/mm</a:t>
            </a:r>
            <a:r>
              <a:rPr lang="en-US" sz="3600" baseline="30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sz="36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quantification. Scale bar = 200 </a:t>
            </a:r>
            <a:r>
              <a:rPr lang="en-US" sz="3600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μm</a:t>
            </a:r>
            <a:r>
              <a:rPr lang="en-US" sz="36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</a:p>
        </p:txBody>
      </p:sp>
    </p:spTree>
    <p:extLst>
      <p:ext uri="{BB962C8B-B14F-4D97-AF65-F5344CB8AC3E}">
        <p14:creationId xmlns:p14="http://schemas.microsoft.com/office/powerpoint/2010/main" val="42272857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7" name="Object 2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421518533"/>
              </p:ext>
            </p:extLst>
          </p:nvPr>
        </p:nvGraphicFramePr>
        <p:xfrm>
          <a:off x="11222038" y="2369706"/>
          <a:ext cx="5988050" cy="50387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2" imgW="5677540" imgH="4776723" progId="Prism10.Document">
                  <p:embed/>
                </p:oleObj>
              </mc:Choice>
              <mc:Fallback>
                <p:oleObj name="Prism 10" r:id="rId2" imgW="5677540" imgH="4776723" progId="Prism10.Document">
                  <p:embed/>
                  <p:pic>
                    <p:nvPicPr>
                      <p:cNvPr id="27" name="Object 26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11222038" y="2369706"/>
                        <a:ext cx="5988050" cy="50387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0" name="TextBox 19"/>
          <p:cNvSpPr txBox="1"/>
          <p:nvPr/>
        </p:nvSpPr>
        <p:spPr>
          <a:xfrm>
            <a:off x="10828259" y="2059391"/>
            <a:ext cx="442750" cy="646331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sz="3600" b="1" dirty="0"/>
              <a:t>B</a:t>
            </a:r>
          </a:p>
        </p:txBody>
      </p:sp>
      <p:sp>
        <p:nvSpPr>
          <p:cNvPr id="21" name="TextBox 20"/>
          <p:cNvSpPr txBox="1"/>
          <p:nvPr/>
        </p:nvSpPr>
        <p:spPr>
          <a:xfrm>
            <a:off x="5771398" y="2059391"/>
            <a:ext cx="465192" cy="646331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sz="3600" b="1" dirty="0"/>
              <a:t>A</a:t>
            </a:r>
          </a:p>
        </p:txBody>
      </p:sp>
      <p:sp>
        <p:nvSpPr>
          <p:cNvPr id="22" name="TextBox 21"/>
          <p:cNvSpPr txBox="1"/>
          <p:nvPr/>
        </p:nvSpPr>
        <p:spPr>
          <a:xfrm>
            <a:off x="5798648" y="9002657"/>
            <a:ext cx="428322" cy="646331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sz="3600" b="1" dirty="0"/>
              <a:t>C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10828259" y="9002661"/>
            <a:ext cx="476412" cy="646331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sz="3600" b="1" dirty="0"/>
              <a:t>D</a:t>
            </a:r>
          </a:p>
        </p:txBody>
      </p:sp>
      <p:graphicFrame>
        <p:nvGraphicFramePr>
          <p:cNvPr id="3" name="Object 2"/>
          <p:cNvGraphicFramePr>
            <a:graphicFrameLocks noChangeAspect="1"/>
          </p:cNvGraphicFramePr>
          <p:nvPr/>
        </p:nvGraphicFramePr>
        <p:xfrm>
          <a:off x="6247120" y="2319213"/>
          <a:ext cx="4308475" cy="60055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4" imgW="2706060" imgH="3730836" progId="Prism10.Document">
                  <p:embed/>
                </p:oleObj>
              </mc:Choice>
              <mc:Fallback>
                <p:oleObj name="Prism 10" r:id="rId4" imgW="2706060" imgH="3730836" progId="Prism10.Document">
                  <p:embed/>
                  <p:pic>
                    <p:nvPicPr>
                      <p:cNvPr id="3" name="Object 2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6247120" y="2319213"/>
                        <a:ext cx="4308475" cy="60055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0" name="Rectangle 9"/>
          <p:cNvSpPr/>
          <p:nvPr/>
        </p:nvSpPr>
        <p:spPr>
          <a:xfrm rot="16200000">
            <a:off x="4514064" y="4732329"/>
            <a:ext cx="3190297" cy="52322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2800" dirty="0"/>
              <a:t># of Iba1+ cells/mm</a:t>
            </a:r>
            <a:r>
              <a:rPr lang="en-US" sz="2800" baseline="30000" dirty="0"/>
              <a:t>2</a:t>
            </a:r>
            <a:endParaRPr lang="en-US" sz="2800" dirty="0"/>
          </a:p>
        </p:txBody>
      </p:sp>
      <p:sp>
        <p:nvSpPr>
          <p:cNvPr id="13" name="TextBox 12"/>
          <p:cNvSpPr txBox="1"/>
          <p:nvPr/>
        </p:nvSpPr>
        <p:spPr>
          <a:xfrm>
            <a:off x="12014705" y="7290163"/>
            <a:ext cx="4365764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800" dirty="0"/>
              <a:t>Fibrinogen (MFI/mm</a:t>
            </a:r>
            <a:r>
              <a:rPr lang="en-US" sz="2800" baseline="30000" dirty="0"/>
              <a:t>2</a:t>
            </a:r>
            <a:r>
              <a:rPr lang="en-US" sz="2800" dirty="0"/>
              <a:t>)</a:t>
            </a:r>
          </a:p>
        </p:txBody>
      </p:sp>
      <p:sp>
        <p:nvSpPr>
          <p:cNvPr id="15" name="TextBox 14"/>
          <p:cNvSpPr txBox="1"/>
          <p:nvPr/>
        </p:nvSpPr>
        <p:spPr>
          <a:xfrm>
            <a:off x="12024623" y="3012654"/>
            <a:ext cx="4365764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3200" dirty="0"/>
              <a:t>R</a:t>
            </a:r>
            <a:r>
              <a:rPr lang="en-US" sz="3200" baseline="30000" dirty="0"/>
              <a:t>2</a:t>
            </a:r>
            <a:r>
              <a:rPr lang="en-US" sz="3200" dirty="0"/>
              <a:t>=0.02</a:t>
            </a:r>
            <a:r>
              <a:rPr lang="en-US" sz="3200"/>
              <a:t>, p=0.54</a:t>
            </a:r>
            <a:endParaRPr lang="en-US" sz="3200" dirty="0"/>
          </a:p>
        </p:txBody>
      </p:sp>
      <p:graphicFrame>
        <p:nvGraphicFramePr>
          <p:cNvPr id="8" name="Object 7"/>
          <p:cNvGraphicFramePr>
            <a:graphicFrameLocks noChangeAspect="1"/>
          </p:cNvGraphicFramePr>
          <p:nvPr/>
        </p:nvGraphicFramePr>
        <p:xfrm>
          <a:off x="11161713" y="9240406"/>
          <a:ext cx="6100762" cy="49815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6" imgW="5700228" imgH="4782846" progId="Prism10.Document">
                  <p:embed/>
                </p:oleObj>
              </mc:Choice>
              <mc:Fallback>
                <p:oleObj name="Prism 10" r:id="rId6" imgW="5700228" imgH="4782846" progId="Prism10.Document">
                  <p:embed/>
                  <p:pic>
                    <p:nvPicPr>
                      <p:cNvPr id="8" name="Object 7"/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11161713" y="9240406"/>
                        <a:ext cx="6100762" cy="49815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3" name="TextBox 22"/>
          <p:cNvSpPr txBox="1"/>
          <p:nvPr/>
        </p:nvSpPr>
        <p:spPr>
          <a:xfrm>
            <a:off x="12521819" y="12800635"/>
            <a:ext cx="4513819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3200" dirty="0"/>
              <a:t>R</a:t>
            </a:r>
            <a:r>
              <a:rPr lang="en-US" sz="3200" baseline="30000" dirty="0"/>
              <a:t>2</a:t>
            </a:r>
            <a:r>
              <a:rPr lang="en-US" sz="3200" dirty="0"/>
              <a:t>=0.13, p=0.12</a:t>
            </a:r>
          </a:p>
        </p:txBody>
      </p:sp>
      <p:graphicFrame>
        <p:nvGraphicFramePr>
          <p:cNvPr id="6" name="Object 5"/>
          <p:cNvGraphicFramePr>
            <a:graphicFrameLocks noChangeAspect="1"/>
          </p:cNvGraphicFramePr>
          <p:nvPr/>
        </p:nvGraphicFramePr>
        <p:xfrm>
          <a:off x="6008072" y="9180290"/>
          <a:ext cx="4529137" cy="59324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8" imgW="2847953" imgH="3730836" progId="Prism10.Document">
                  <p:embed/>
                </p:oleObj>
              </mc:Choice>
              <mc:Fallback>
                <p:oleObj name="Prism 10" r:id="rId8" imgW="2847953" imgH="3730836" progId="Prism10.Document">
                  <p:embed/>
                  <p:pic>
                    <p:nvPicPr>
                      <p:cNvPr id="6" name="Object 5"/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6008072" y="9180290"/>
                        <a:ext cx="4529137" cy="593248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6" name="Rectangle 25"/>
          <p:cNvSpPr/>
          <p:nvPr/>
        </p:nvSpPr>
        <p:spPr>
          <a:xfrm>
            <a:off x="8096250" y="8295929"/>
            <a:ext cx="6438900" cy="95410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2800" b="1" dirty="0"/>
              <a:t>Choroid Plexus (</a:t>
            </a:r>
            <a:r>
              <a:rPr lang="en-US" sz="2800" b="1" dirty="0" err="1"/>
              <a:t>ChP</a:t>
            </a:r>
            <a:r>
              <a:rPr lang="en-US" sz="2800" b="1" dirty="0"/>
              <a:t>)</a:t>
            </a:r>
            <a:endParaRPr lang="en-US" sz="2800" b="1" baseline="30000" dirty="0"/>
          </a:p>
          <a:p>
            <a:pPr algn="ctr"/>
            <a:endParaRPr lang="en-US" sz="2800" b="1" dirty="0"/>
          </a:p>
        </p:txBody>
      </p:sp>
      <p:sp>
        <p:nvSpPr>
          <p:cNvPr id="28" name="Rectangle 27"/>
          <p:cNvSpPr/>
          <p:nvPr/>
        </p:nvSpPr>
        <p:spPr>
          <a:xfrm rot="16200000">
            <a:off x="4514064" y="11678208"/>
            <a:ext cx="3190297" cy="52322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2800" dirty="0"/>
              <a:t># of Iba1+ cells/mm</a:t>
            </a:r>
            <a:r>
              <a:rPr lang="en-US" sz="2800" baseline="30000" dirty="0"/>
              <a:t>2</a:t>
            </a:r>
            <a:endParaRPr lang="en-US" sz="2800" dirty="0"/>
          </a:p>
        </p:txBody>
      </p:sp>
      <p:sp>
        <p:nvSpPr>
          <p:cNvPr id="31" name="Rectangle 30"/>
          <p:cNvSpPr/>
          <p:nvPr/>
        </p:nvSpPr>
        <p:spPr>
          <a:xfrm>
            <a:off x="8096251" y="1342679"/>
            <a:ext cx="6477000" cy="95410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2800" b="1" dirty="0"/>
              <a:t>Subventricular Zone (SVZ)</a:t>
            </a:r>
            <a:endParaRPr lang="en-US" sz="2800" b="1" baseline="30000" dirty="0"/>
          </a:p>
          <a:p>
            <a:pPr algn="ctr"/>
            <a:endParaRPr lang="en-US" sz="2800" b="1" dirty="0"/>
          </a:p>
        </p:txBody>
      </p:sp>
      <p:cxnSp>
        <p:nvCxnSpPr>
          <p:cNvPr id="5" name="Straight Connector 4"/>
          <p:cNvCxnSpPr/>
          <p:nvPr/>
        </p:nvCxnSpPr>
        <p:spPr>
          <a:xfrm flipV="1">
            <a:off x="8096250" y="8834006"/>
            <a:ext cx="6477000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9" name="Straight Connector 28"/>
          <p:cNvCxnSpPr/>
          <p:nvPr/>
        </p:nvCxnSpPr>
        <p:spPr>
          <a:xfrm flipV="1">
            <a:off x="8058150" y="1861706"/>
            <a:ext cx="6477000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" name="Rectangle 6"/>
          <p:cNvSpPr/>
          <p:nvPr/>
        </p:nvSpPr>
        <p:spPr>
          <a:xfrm rot="16200000">
            <a:off x="9570154" y="4732329"/>
            <a:ext cx="3190297" cy="52322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2800" dirty="0"/>
              <a:t># of Iba1+ cells/mm</a:t>
            </a:r>
            <a:r>
              <a:rPr lang="en-US" sz="2800" baseline="30000" dirty="0"/>
              <a:t>2</a:t>
            </a:r>
          </a:p>
        </p:txBody>
      </p:sp>
      <p:sp>
        <p:nvSpPr>
          <p:cNvPr id="30" name="TextBox 29"/>
          <p:cNvSpPr txBox="1"/>
          <p:nvPr/>
        </p:nvSpPr>
        <p:spPr>
          <a:xfrm>
            <a:off x="12014705" y="14071963"/>
            <a:ext cx="4365764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800" dirty="0"/>
              <a:t>Fibrinogen (MFI/mm</a:t>
            </a:r>
            <a:r>
              <a:rPr lang="en-US" sz="2800" baseline="30000" dirty="0"/>
              <a:t>2</a:t>
            </a:r>
            <a:r>
              <a:rPr lang="en-US" sz="2800" dirty="0"/>
              <a:t>)</a:t>
            </a:r>
          </a:p>
        </p:txBody>
      </p:sp>
      <p:sp>
        <p:nvSpPr>
          <p:cNvPr id="32" name="Rectangle 31"/>
          <p:cNvSpPr/>
          <p:nvPr/>
        </p:nvSpPr>
        <p:spPr>
          <a:xfrm rot="16200000">
            <a:off x="9570154" y="11678208"/>
            <a:ext cx="3190297" cy="52322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2800" dirty="0"/>
              <a:t># of Iba1+ cells/mm</a:t>
            </a:r>
            <a:r>
              <a:rPr lang="en-US" sz="2800" baseline="30000" dirty="0"/>
              <a:t>2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AFA9D4EB-903D-C5D2-A01E-42596C678233}"/>
              </a:ext>
            </a:extLst>
          </p:cNvPr>
          <p:cNvSpPr txBox="1"/>
          <p:nvPr/>
        </p:nvSpPr>
        <p:spPr>
          <a:xfrm>
            <a:off x="610974" y="426835"/>
            <a:ext cx="4532587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200" b="1" dirty="0"/>
              <a:t>Supplementary Figure S5.</a:t>
            </a:r>
          </a:p>
        </p:txBody>
      </p:sp>
      <p:grpSp>
        <p:nvGrpSpPr>
          <p:cNvPr id="4" name="Group 3">
            <a:extLst>
              <a:ext uri="{FF2B5EF4-FFF2-40B4-BE49-F238E27FC236}">
                <a16:creationId xmlns:a16="http://schemas.microsoft.com/office/drawing/2014/main" id="{4285CF21-1D49-D26E-9BF5-47E585745194}"/>
              </a:ext>
            </a:extLst>
          </p:cNvPr>
          <p:cNvGrpSpPr/>
          <p:nvPr/>
        </p:nvGrpSpPr>
        <p:grpSpPr>
          <a:xfrm>
            <a:off x="8188506" y="15045466"/>
            <a:ext cx="6292890" cy="590527"/>
            <a:chOff x="15433678" y="7986862"/>
            <a:chExt cx="6292890" cy="590527"/>
          </a:xfrm>
        </p:grpSpPr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635D7557-1EFE-7819-9B14-B68D948D1257}"/>
                </a:ext>
              </a:extLst>
            </p:cNvPr>
            <p:cNvSpPr txBox="1"/>
            <p:nvPr/>
          </p:nvSpPr>
          <p:spPr>
            <a:xfrm>
              <a:off x="15641124" y="7988301"/>
              <a:ext cx="1331071" cy="58846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2800" dirty="0">
                  <a:cs typeface="Arial" panose="020B0604020202020204" pitchFamily="34" charset="0"/>
                </a:rPr>
                <a:t>Legend:</a:t>
              </a: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32901948-9CB8-2B0C-A36D-B42667550184}"/>
                </a:ext>
              </a:extLst>
            </p:cNvPr>
            <p:cNvSpPr txBox="1"/>
            <p:nvPr/>
          </p:nvSpPr>
          <p:spPr>
            <a:xfrm>
              <a:off x="17536228" y="7988924"/>
              <a:ext cx="753731" cy="5884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2800" dirty="0">
                  <a:cs typeface="Arial" panose="020B0604020202020204" pitchFamily="34" charset="0"/>
                </a:rPr>
                <a:t>Con</a:t>
              </a: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004C38ED-9B07-EAF8-F2B5-FFDD4B1F46A6}"/>
                </a:ext>
              </a:extLst>
            </p:cNvPr>
            <p:cNvSpPr txBox="1"/>
            <p:nvPr/>
          </p:nvSpPr>
          <p:spPr>
            <a:xfrm>
              <a:off x="18877142" y="7988913"/>
              <a:ext cx="1178527" cy="5884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2800" dirty="0">
                  <a:cs typeface="Arial" panose="020B0604020202020204" pitchFamily="34" charset="0"/>
                </a:rPr>
                <a:t>X31</a:t>
              </a:r>
              <a:r>
                <a:rPr lang="en-US" sz="2800" baseline="-25000" dirty="0">
                  <a:cs typeface="Arial" panose="020B0604020202020204" pitchFamily="34" charset="0"/>
                </a:rPr>
                <a:t>mod</a:t>
              </a: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A4821426-6865-9943-B216-6E336B83CEDD}"/>
                </a:ext>
              </a:extLst>
            </p:cNvPr>
            <p:cNvSpPr txBox="1"/>
            <p:nvPr/>
          </p:nvSpPr>
          <p:spPr>
            <a:xfrm>
              <a:off x="20593250" y="7988906"/>
              <a:ext cx="915635" cy="5884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2800" dirty="0">
                  <a:cs typeface="Arial" panose="020B0604020202020204" pitchFamily="34" charset="0"/>
                </a:rPr>
                <a:t>X31</a:t>
              </a:r>
              <a:r>
                <a:rPr lang="en-US" sz="2800" baseline="-25000" dirty="0">
                  <a:cs typeface="Arial" panose="020B0604020202020204" pitchFamily="34" charset="0"/>
                </a:rPr>
                <a:t>hi</a:t>
              </a:r>
            </a:p>
          </p:txBody>
        </p:sp>
        <p:sp>
          <p:nvSpPr>
            <p:cNvPr id="16" name="Rectangle 15">
              <a:extLst>
                <a:ext uri="{FF2B5EF4-FFF2-40B4-BE49-F238E27FC236}">
                  <a16:creationId xmlns:a16="http://schemas.microsoft.com/office/drawing/2014/main" id="{9DEF6E78-71D3-A248-47B3-D6F86004C04D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15433678" y="7986862"/>
              <a:ext cx="6292890" cy="566588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800">
                <a:cs typeface="Arial" panose="020B0604020202020204" pitchFamily="34" charset="0"/>
              </a:endParaRPr>
            </a:p>
          </p:txBody>
        </p:sp>
        <p:sp>
          <p:nvSpPr>
            <p:cNvPr id="17" name="Rectangle 16">
              <a:extLst>
                <a:ext uri="{FF2B5EF4-FFF2-40B4-BE49-F238E27FC236}">
                  <a16:creationId xmlns:a16="http://schemas.microsoft.com/office/drawing/2014/main" id="{3500D3E1-52BA-5911-1FF1-22DD9B9FE562}"/>
                </a:ext>
              </a:extLst>
            </p:cNvPr>
            <p:cNvSpPr/>
            <p:nvPr/>
          </p:nvSpPr>
          <p:spPr>
            <a:xfrm>
              <a:off x="18469774" y="8124545"/>
              <a:ext cx="326017" cy="300659"/>
            </a:xfrm>
            <a:prstGeom prst="rect">
              <a:avLst/>
            </a:prstGeom>
            <a:solidFill>
              <a:srgbClr val="FF0000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800">
                <a:cs typeface="Arial" panose="020B0604020202020204" pitchFamily="34" charset="0"/>
              </a:endParaRPr>
            </a:p>
          </p:txBody>
        </p:sp>
        <p:sp>
          <p:nvSpPr>
            <p:cNvPr id="19" name="Rectangle 18">
              <a:extLst>
                <a:ext uri="{FF2B5EF4-FFF2-40B4-BE49-F238E27FC236}">
                  <a16:creationId xmlns:a16="http://schemas.microsoft.com/office/drawing/2014/main" id="{1394654A-AB45-77EE-1354-AD8C13423AEF}"/>
                </a:ext>
              </a:extLst>
            </p:cNvPr>
            <p:cNvSpPr/>
            <p:nvPr/>
          </p:nvSpPr>
          <p:spPr>
            <a:xfrm>
              <a:off x="20178825" y="8124545"/>
              <a:ext cx="326017" cy="300659"/>
            </a:xfrm>
            <a:prstGeom prst="rect">
              <a:avLst/>
            </a:prstGeom>
            <a:solidFill>
              <a:srgbClr val="C00000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800">
                <a:cs typeface="Arial" panose="020B0604020202020204" pitchFamily="34" charset="0"/>
              </a:endParaRPr>
            </a:p>
          </p:txBody>
        </p:sp>
        <p:sp>
          <p:nvSpPr>
            <p:cNvPr id="24" name="Rectangle 23">
              <a:extLst>
                <a:ext uri="{FF2B5EF4-FFF2-40B4-BE49-F238E27FC236}">
                  <a16:creationId xmlns:a16="http://schemas.microsoft.com/office/drawing/2014/main" id="{0FA867B4-EE2A-F277-F41D-D1AAA69D95AB}"/>
                </a:ext>
              </a:extLst>
            </p:cNvPr>
            <p:cNvSpPr/>
            <p:nvPr/>
          </p:nvSpPr>
          <p:spPr>
            <a:xfrm>
              <a:off x="17158247" y="8124545"/>
              <a:ext cx="326017" cy="300659"/>
            </a:xfrm>
            <a:prstGeom prst="rect">
              <a:avLst/>
            </a:prstGeom>
            <a:solidFill>
              <a:schemeClr val="bg2">
                <a:lumMod val="90000"/>
              </a:schemeClr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800">
                <a:cs typeface="Arial" panose="020B0604020202020204" pitchFamily="34" charset="0"/>
              </a:endParaRPr>
            </a:p>
          </p:txBody>
        </p:sp>
      </p:grpSp>
      <p:sp>
        <p:nvSpPr>
          <p:cNvPr id="25" name="Rectangle 24"/>
          <p:cNvSpPr/>
          <p:nvPr/>
        </p:nvSpPr>
        <p:spPr>
          <a:xfrm>
            <a:off x="1672317" y="16539801"/>
            <a:ext cx="19919305" cy="618630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36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upplementary Figure S5. MIA did not alter the number of Iba1</a:t>
            </a:r>
            <a:r>
              <a:rPr lang="en-US" sz="3600" b="1" baseline="30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36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cells at the SVZ and </a:t>
            </a:r>
            <a:r>
              <a:rPr lang="en-US" sz="3600" b="1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hP</a:t>
            </a:r>
            <a:r>
              <a:rPr lang="en-US" sz="36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sz="3600" dirty="0">
                <a:latin typeface="Arial" panose="020B0604020202020204" pitchFamily="34" charset="0"/>
                <a:cs typeface="Arial" panose="020B0604020202020204" pitchFamily="34" charset="0"/>
              </a:rPr>
              <a:t>Quantification of Iba1+ cells/mm² in the (</a:t>
            </a:r>
            <a:r>
              <a:rPr lang="en-US" sz="36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US" sz="3600" dirty="0">
                <a:latin typeface="Arial" panose="020B0604020202020204" pitchFamily="34" charset="0"/>
                <a:cs typeface="Arial" panose="020B0604020202020204" pitchFamily="34" charset="0"/>
              </a:rPr>
              <a:t>) SVZ and (</a:t>
            </a:r>
            <a:r>
              <a:rPr lang="en-US" sz="36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US" sz="3600" dirty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r>
              <a:rPr lang="en-US" sz="3600" dirty="0" err="1">
                <a:latin typeface="Arial" panose="020B0604020202020204" pitchFamily="34" charset="0"/>
                <a:cs typeface="Arial" panose="020B0604020202020204" pitchFamily="34" charset="0"/>
              </a:rPr>
              <a:t>ChP</a:t>
            </a:r>
            <a:r>
              <a:rPr lang="en-US" sz="3600" dirty="0">
                <a:latin typeface="Arial" panose="020B0604020202020204" pitchFamily="34" charset="0"/>
                <a:cs typeface="Arial" panose="020B0604020202020204" pitchFamily="34" charset="0"/>
              </a:rPr>
              <a:t> revealed no differences across treatment groups. Additionally, no correlation was found between the number of Iba1</a:t>
            </a:r>
            <a:r>
              <a:rPr lang="en-US" sz="36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3600" dirty="0">
                <a:latin typeface="Arial" panose="020B0604020202020204" pitchFamily="34" charset="0"/>
                <a:cs typeface="Arial" panose="020B0604020202020204" pitchFamily="34" charset="0"/>
              </a:rPr>
              <a:t> cells and fibrinogen MFI/mm² in either the (</a:t>
            </a:r>
            <a:r>
              <a:rPr lang="en-US" sz="36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US" sz="3600" dirty="0">
                <a:latin typeface="Arial" panose="020B0604020202020204" pitchFamily="34" charset="0"/>
                <a:cs typeface="Arial" panose="020B0604020202020204" pitchFamily="34" charset="0"/>
              </a:rPr>
              <a:t>) SVZ or (</a:t>
            </a:r>
            <a:r>
              <a:rPr lang="en-US" sz="36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r>
              <a:rPr lang="en-US" sz="3600" dirty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r>
              <a:rPr lang="en-US" sz="3600" dirty="0" err="1">
                <a:latin typeface="Arial" panose="020B0604020202020204" pitchFamily="34" charset="0"/>
                <a:cs typeface="Arial" panose="020B0604020202020204" pitchFamily="34" charset="0"/>
              </a:rPr>
              <a:t>ChP</a:t>
            </a:r>
            <a:r>
              <a:rPr lang="en-US" sz="36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. For fibrinogen </a:t>
            </a:r>
            <a:r>
              <a:rPr lang="en-US" sz="3600" dirty="0">
                <a:solidFill>
                  <a:srgbClr val="131F33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FI/ mm</a:t>
            </a:r>
            <a:r>
              <a:rPr lang="en-US" sz="3600" baseline="30000" dirty="0">
                <a:solidFill>
                  <a:srgbClr val="131F33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  </a:t>
            </a:r>
            <a:r>
              <a:rPr lang="en-US" sz="3600" dirty="0">
                <a:solidFill>
                  <a:srgbClr val="131F33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nd number of </a:t>
            </a:r>
            <a:r>
              <a:rPr lang="en-US" sz="3600" dirty="0" err="1">
                <a:solidFill>
                  <a:srgbClr val="131F33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ba</a:t>
            </a:r>
            <a:r>
              <a:rPr lang="en-US" sz="3600" dirty="0">
                <a:solidFill>
                  <a:srgbClr val="131F33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1</a:t>
            </a:r>
            <a:r>
              <a:rPr lang="en-US" sz="3600" baseline="30000" dirty="0">
                <a:solidFill>
                  <a:srgbClr val="131F33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3600" dirty="0">
                <a:solidFill>
                  <a:srgbClr val="131F33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cells/mm</a:t>
            </a:r>
            <a:r>
              <a:rPr lang="en-US" sz="3600" baseline="30000" dirty="0">
                <a:solidFill>
                  <a:srgbClr val="131F33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sz="3600" dirty="0">
                <a:solidFill>
                  <a:srgbClr val="131F33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, values were divided by 1000 at the ChP. One representative fetus per litter was used. Data are expressed as means ± SEM; </a:t>
            </a:r>
            <a:r>
              <a:rPr lang="en-US" sz="3600" dirty="0">
                <a:latin typeface="Arial" panose="020B0604020202020204" pitchFamily="34" charset="0"/>
                <a:cs typeface="Arial" panose="020B0604020202020204" pitchFamily="34" charset="0"/>
              </a:rPr>
              <a:t>circles represent individual fetuses; </a:t>
            </a:r>
            <a:r>
              <a:rPr lang="en-US" sz="3600" dirty="0">
                <a:solidFill>
                  <a:srgbClr val="131F33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 per group: Con = 6, X31</a:t>
            </a:r>
            <a:r>
              <a:rPr lang="en-US" sz="3600" baseline="-25000" dirty="0">
                <a:solidFill>
                  <a:srgbClr val="131F33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od</a:t>
            </a:r>
            <a:r>
              <a:rPr lang="en-US" sz="3600" dirty="0">
                <a:solidFill>
                  <a:srgbClr val="131F33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= 7, X31</a:t>
            </a:r>
            <a:r>
              <a:rPr lang="en-US" sz="3600" baseline="-25000" dirty="0">
                <a:solidFill>
                  <a:srgbClr val="131F33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i</a:t>
            </a:r>
            <a:r>
              <a:rPr lang="en-US" sz="3600" dirty="0">
                <a:solidFill>
                  <a:srgbClr val="131F33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= 7</a:t>
            </a:r>
            <a:r>
              <a:rPr lang="en-US" sz="36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. One-way ANOVA with Tukey post hoc test was used in all the statistical analysis.</a:t>
            </a:r>
            <a:r>
              <a:rPr lang="en-US" sz="3600" dirty="0">
                <a:latin typeface="Arial" panose="020B0604020202020204" pitchFamily="34" charset="0"/>
                <a:cs typeface="Arial" panose="020B0604020202020204" pitchFamily="34" charset="0"/>
              </a:rPr>
              <a:t> In (</a:t>
            </a:r>
            <a:r>
              <a:rPr lang="en-US" sz="36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US" sz="3600" dirty="0">
                <a:latin typeface="Arial" panose="020B0604020202020204" pitchFamily="34" charset="0"/>
                <a:cs typeface="Arial" panose="020B0604020202020204" pitchFamily="34" charset="0"/>
              </a:rPr>
              <a:t> &amp; </a:t>
            </a:r>
            <a:r>
              <a:rPr lang="en-US" sz="36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US" sz="3600" dirty="0">
                <a:latin typeface="Arial" panose="020B0604020202020204" pitchFamily="34" charset="0"/>
                <a:cs typeface="Arial" panose="020B0604020202020204" pitchFamily="34" charset="0"/>
              </a:rPr>
              <a:t>), p-values were obtained from group comparisons using one-way ANOVA</a:t>
            </a:r>
            <a:r>
              <a:rPr lang="en-US" sz="3600" dirty="0">
                <a:solidFill>
                  <a:srgbClr val="131F33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. SVZ = subventricular zone; ChP = choroid plexus.</a:t>
            </a:r>
            <a:r>
              <a:rPr lang="en-US" sz="3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n-US" sz="3600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>
              <a:buSzPts val="1100"/>
            </a:pPr>
            <a:endParaRPr lang="en-US" sz="3600" dirty="0">
              <a:solidFill>
                <a:srgbClr val="000000"/>
              </a:solidFill>
            </a:endParaRPr>
          </a:p>
          <a:p>
            <a:pPr algn="just">
              <a:buSzPts val="1100"/>
            </a:pPr>
            <a:endParaRPr lang="en-US" sz="3600" dirty="0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63351136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4"/>
          <p:cNvSpPr/>
          <p:nvPr/>
        </p:nvSpPr>
        <p:spPr>
          <a:xfrm>
            <a:off x="5125614" y="1169136"/>
            <a:ext cx="12837132" cy="73994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endParaRPr lang="en-US" sz="2104" dirty="0">
              <a:latin typeface="Arial" panose="020B0604020202020204" pitchFamily="34" charset="0"/>
            </a:endParaRPr>
          </a:p>
          <a:p>
            <a:pPr marR="20651" algn="just"/>
            <a:r>
              <a:rPr lang="en-US" altLang="en-US" sz="2104" b="1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Table S1</a:t>
            </a:r>
            <a:r>
              <a:rPr lang="en-US" sz="2104" dirty="0">
                <a:solidFill>
                  <a:srgbClr val="000000"/>
                </a:solidFill>
                <a:latin typeface="Arial" panose="020B0604020202020204" pitchFamily="34" charset="0"/>
              </a:rPr>
              <a:t>. </a:t>
            </a:r>
            <a:r>
              <a:rPr lang="en-US" sz="2104" b="1" dirty="0">
                <a:solidFill>
                  <a:srgbClr val="000000"/>
                </a:solidFill>
                <a:latin typeface="Arial" panose="020B0604020202020204" pitchFamily="34" charset="0"/>
              </a:rPr>
              <a:t>List of gene primers for qPCR.</a:t>
            </a:r>
            <a:r>
              <a:rPr lang="en-US" sz="2104" dirty="0">
                <a:solidFill>
                  <a:srgbClr val="000000"/>
                </a:solidFill>
                <a:latin typeface="Arial" panose="020B0604020202020204" pitchFamily="34" charset="0"/>
              </a:rPr>
              <a:t> </a:t>
            </a:r>
          </a:p>
        </p:txBody>
      </p:sp>
      <p:graphicFrame>
        <p:nvGraphicFramePr>
          <p:cNvPr id="2" name="Table 1"/>
          <p:cNvGraphicFramePr>
            <a:graphicFrameLocks noGrp="1"/>
          </p:cNvGraphicFramePr>
          <p:nvPr/>
        </p:nvGraphicFramePr>
        <p:xfrm>
          <a:off x="5264185" y="1993203"/>
          <a:ext cx="12906829" cy="8584980"/>
        </p:xfrm>
        <a:graphic>
          <a:graphicData uri="http://schemas.openxmlformats.org/drawingml/2006/table">
            <a:tbl>
              <a:tblPr firstRow="1" firstCol="1" bandRow="1">
                <a:tableStyleId>{793D81CF-94F2-401A-BA57-92F5A7B2D0C5}</a:tableStyleId>
              </a:tblPr>
              <a:tblGrid>
                <a:gridCol w="1914829">
                  <a:extLst>
                    <a:ext uri="{9D8B030D-6E8A-4147-A177-3AD203B41FA5}">
                      <a16:colId xmlns:a16="http://schemas.microsoft.com/office/drawing/2014/main" val="2420163188"/>
                    </a:ext>
                  </a:extLst>
                </a:gridCol>
                <a:gridCol w="5382892">
                  <a:extLst>
                    <a:ext uri="{9D8B030D-6E8A-4147-A177-3AD203B41FA5}">
                      <a16:colId xmlns:a16="http://schemas.microsoft.com/office/drawing/2014/main" val="3385089469"/>
                    </a:ext>
                  </a:extLst>
                </a:gridCol>
                <a:gridCol w="5609108">
                  <a:extLst>
                    <a:ext uri="{9D8B030D-6E8A-4147-A177-3AD203B41FA5}">
                      <a16:colId xmlns:a16="http://schemas.microsoft.com/office/drawing/2014/main" val="764628233"/>
                    </a:ext>
                  </a:extLst>
                </a:gridCol>
              </a:tblGrid>
              <a:tr h="715415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300" dirty="0">
                          <a:effectLst/>
                        </a:rPr>
                        <a:t>Gene</a:t>
                      </a:r>
                      <a:endParaRPr lang="en-US" sz="23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131159" marR="131159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300" dirty="0">
                          <a:effectLst/>
                        </a:rPr>
                        <a:t>Forward sequence</a:t>
                      </a:r>
                      <a:endParaRPr lang="en-US" sz="23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131159" marR="131159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300" dirty="0">
                          <a:effectLst/>
                        </a:rPr>
                        <a:t> Reverse sequence</a:t>
                      </a:r>
                      <a:endParaRPr lang="en-US" sz="23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131159" marR="131159" marT="0" marB="0" anchor="ctr"/>
                </a:tc>
                <a:extLst>
                  <a:ext uri="{0D108BD9-81ED-4DB2-BD59-A6C34878D82A}">
                    <a16:rowId xmlns:a16="http://schemas.microsoft.com/office/drawing/2014/main" val="101486312"/>
                  </a:ext>
                </a:extLst>
              </a:tr>
              <a:tr h="715415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300" i="1" dirty="0">
                          <a:effectLst/>
                        </a:rPr>
                        <a:t>Rplp0</a:t>
                      </a:r>
                      <a:endParaRPr lang="en-US" sz="2300" i="1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131159" marR="131159" marT="0" marB="0"/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300" dirty="0">
                          <a:effectLst/>
                        </a:rPr>
                        <a:t>GGACCCGAGAAGACCTCCTT</a:t>
                      </a:r>
                      <a:endParaRPr lang="en-US" sz="23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131159" marR="131159" marT="0" marB="0" anchor="ctr"/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300" dirty="0">
                          <a:effectLst/>
                        </a:rPr>
                        <a:t>GCACATCACTCAGAATTTCAATGG</a:t>
                      </a:r>
                      <a:endParaRPr lang="en-US" sz="23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131159" marR="131159" marT="0" marB="0" anchor="ctr"/>
                </a:tc>
                <a:extLst>
                  <a:ext uri="{0D108BD9-81ED-4DB2-BD59-A6C34878D82A}">
                    <a16:rowId xmlns:a16="http://schemas.microsoft.com/office/drawing/2014/main" val="3674470531"/>
                  </a:ext>
                </a:extLst>
              </a:tr>
              <a:tr h="715415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300" i="1" dirty="0">
                          <a:effectLst/>
                        </a:rPr>
                        <a:t>Hprt1</a:t>
                      </a:r>
                      <a:endParaRPr lang="en-US" sz="2300" i="1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131159" marR="131159" marT="0" marB="0" anchor="ctr"/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300" dirty="0"/>
                        <a:t>CAAACTTTGCTTTCCCTGGT</a:t>
                      </a:r>
                      <a:endParaRPr lang="en-US" sz="23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131159" marR="131159" marT="0" marB="0" anchor="ctr"/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300" dirty="0"/>
                        <a:t>TCTGGCCTGTATCCAACACTTC</a:t>
                      </a:r>
                      <a:endParaRPr lang="en-US" sz="23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131159" marR="131159" marT="0" marB="0" anchor="ctr"/>
                </a:tc>
                <a:extLst>
                  <a:ext uri="{0D108BD9-81ED-4DB2-BD59-A6C34878D82A}">
                    <a16:rowId xmlns:a16="http://schemas.microsoft.com/office/drawing/2014/main" val="3761397178"/>
                  </a:ext>
                </a:extLst>
              </a:tr>
              <a:tr h="715415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300" i="1" dirty="0">
                          <a:effectLst/>
                        </a:rPr>
                        <a:t>Cox2</a:t>
                      </a:r>
                      <a:endParaRPr lang="en-US" sz="2300" i="1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131159" marR="131159" marT="0" marB="0" anchor="ctr"/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300" dirty="0">
                          <a:effectLst/>
                        </a:rPr>
                        <a:t>AACCGAGTCGTTCTGCCAAT</a:t>
                      </a:r>
                      <a:endParaRPr lang="en-US" sz="23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131159" marR="131159" marT="0" marB="0" anchor="ctr"/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300" dirty="0">
                          <a:effectLst/>
                        </a:rPr>
                        <a:t>CTAGGGAGGGGACTGCTCAT</a:t>
                      </a:r>
                      <a:endParaRPr lang="en-US" sz="23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131159" marR="131159" marT="0" marB="0" anchor="ctr"/>
                </a:tc>
                <a:extLst>
                  <a:ext uri="{0D108BD9-81ED-4DB2-BD59-A6C34878D82A}">
                    <a16:rowId xmlns:a16="http://schemas.microsoft.com/office/drawing/2014/main" val="42542177"/>
                  </a:ext>
                </a:extLst>
              </a:tr>
              <a:tr h="715415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300" i="1" dirty="0">
                          <a:effectLst/>
                        </a:rPr>
                        <a:t>Nos2</a:t>
                      </a:r>
                      <a:endParaRPr lang="en-US" sz="2300" i="1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131159" marR="131159" marT="0" marB="0" anchor="ctr"/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300" dirty="0">
                          <a:effectLst/>
                        </a:rPr>
                        <a:t>AGTGAAAAGTCGAGCCGCA</a:t>
                      </a:r>
                      <a:endParaRPr lang="en-US" sz="23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131159" marR="131159" marT="0" marB="0" anchor="ctr"/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300" dirty="0">
                          <a:effectLst/>
                        </a:rPr>
                        <a:t>ACAATCCACAACTCGCTCCA</a:t>
                      </a:r>
                      <a:endParaRPr lang="en-US" sz="23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131159" marR="131159" marT="0" marB="0" anchor="ctr"/>
                </a:tc>
                <a:extLst>
                  <a:ext uri="{0D108BD9-81ED-4DB2-BD59-A6C34878D82A}">
                    <a16:rowId xmlns:a16="http://schemas.microsoft.com/office/drawing/2014/main" val="172786982"/>
                  </a:ext>
                </a:extLst>
              </a:tr>
              <a:tr h="715415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300" i="1" dirty="0">
                          <a:effectLst/>
                        </a:rPr>
                        <a:t>Cldn1</a:t>
                      </a:r>
                      <a:endParaRPr lang="en-US" sz="2300" i="1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131159" marR="131159" marT="0" marB="0" anchor="ctr"/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300" dirty="0">
                          <a:effectLst/>
                        </a:rPr>
                        <a:t>GCCATCTACGAGGGACTGTG</a:t>
                      </a:r>
                      <a:endParaRPr lang="en-US" sz="23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131159" marR="131159" marT="0" marB="0" anchor="ctr"/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300" dirty="0">
                          <a:effectLst/>
                        </a:rPr>
                        <a:t>ACTAATGTCGCCAGACCTGAAA</a:t>
                      </a:r>
                      <a:endParaRPr lang="en-US" sz="23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131159" marR="131159" marT="0" marB="0" anchor="ctr"/>
                </a:tc>
                <a:extLst>
                  <a:ext uri="{0D108BD9-81ED-4DB2-BD59-A6C34878D82A}">
                    <a16:rowId xmlns:a16="http://schemas.microsoft.com/office/drawing/2014/main" val="150162759"/>
                  </a:ext>
                </a:extLst>
              </a:tr>
              <a:tr h="715415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300" i="1" dirty="0">
                          <a:effectLst/>
                        </a:rPr>
                        <a:t>Cldn2</a:t>
                      </a:r>
                      <a:endParaRPr lang="en-US" sz="2300" i="1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131159" marR="131159" marT="0" marB="0" anchor="ctr"/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300" dirty="0">
                          <a:effectLst/>
                        </a:rPr>
                        <a:t>TCTCTGTGGTGGGCATGAGA</a:t>
                      </a:r>
                      <a:endParaRPr lang="en-US" sz="23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131159" marR="131159" marT="0" marB="0" anchor="ctr"/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300" dirty="0">
                          <a:effectLst/>
                        </a:rPr>
                        <a:t>CCAGCGGCGAGTAGAAGTC</a:t>
                      </a:r>
                      <a:endParaRPr lang="en-US" sz="23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131159" marR="131159" marT="0" marB="0" anchor="ctr"/>
                </a:tc>
                <a:extLst>
                  <a:ext uri="{0D108BD9-81ED-4DB2-BD59-A6C34878D82A}">
                    <a16:rowId xmlns:a16="http://schemas.microsoft.com/office/drawing/2014/main" val="2213209500"/>
                  </a:ext>
                </a:extLst>
              </a:tr>
              <a:tr h="715415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300" i="1" dirty="0">
                          <a:effectLst/>
                        </a:rPr>
                        <a:t>Cldn4</a:t>
                      </a:r>
                      <a:endParaRPr lang="en-US" sz="2300" i="1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131159" marR="131159" marT="0" marB="0" anchor="ctr"/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300" dirty="0">
                          <a:effectLst/>
                        </a:rPr>
                        <a:t>CGATGGCGTCTATGGGACTAC</a:t>
                      </a:r>
                      <a:endParaRPr lang="en-US" sz="23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131159" marR="131159" marT="0" marB="0" anchor="ctr"/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300" dirty="0">
                          <a:effectLst/>
                        </a:rPr>
                        <a:t>GATGTTGCTGCCGATGAAGG</a:t>
                      </a:r>
                      <a:endParaRPr lang="en-US" sz="23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131159" marR="131159" marT="0" marB="0" anchor="ctr"/>
                </a:tc>
                <a:extLst>
                  <a:ext uri="{0D108BD9-81ED-4DB2-BD59-A6C34878D82A}">
                    <a16:rowId xmlns:a16="http://schemas.microsoft.com/office/drawing/2014/main" val="949205270"/>
                  </a:ext>
                </a:extLst>
              </a:tr>
              <a:tr h="715415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300" i="1" dirty="0">
                          <a:effectLst/>
                        </a:rPr>
                        <a:t>Cldn5</a:t>
                      </a:r>
                      <a:endParaRPr lang="en-US" sz="2300" i="1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131159" marR="131159" marT="0" marB="0" anchor="ctr"/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300">
                          <a:effectLst/>
                        </a:rPr>
                        <a:t>CAGTTAAGGCACGGGTAGCA</a:t>
                      </a:r>
                      <a:endParaRPr lang="en-US" sz="23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131159" marR="131159" marT="0" marB="0" anchor="ctr"/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300" dirty="0">
                          <a:effectLst/>
                        </a:rPr>
                        <a:t>GCCCAGCTCGTACTTCTGTG</a:t>
                      </a:r>
                      <a:endParaRPr lang="en-US" sz="23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131159" marR="131159" marT="0" marB="0" anchor="ctr"/>
                </a:tc>
                <a:extLst>
                  <a:ext uri="{0D108BD9-81ED-4DB2-BD59-A6C34878D82A}">
                    <a16:rowId xmlns:a16="http://schemas.microsoft.com/office/drawing/2014/main" val="4192788634"/>
                  </a:ext>
                </a:extLst>
              </a:tr>
              <a:tr h="715415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300" i="1" dirty="0" err="1">
                          <a:effectLst/>
                        </a:rPr>
                        <a:t>Ocln</a:t>
                      </a:r>
                      <a:endParaRPr lang="en-US" sz="2300" i="1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131159" marR="131159" marT="0" marB="0" anchor="ctr"/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300" dirty="0">
                          <a:effectLst/>
                        </a:rPr>
                        <a:t>GAGTGAAGAGTACATGGCTGCT</a:t>
                      </a:r>
                      <a:endParaRPr lang="en-US" sz="23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131159" marR="131159" marT="0" marB="0" anchor="ctr"/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300" dirty="0">
                          <a:effectLst/>
                        </a:rPr>
                        <a:t>TTCTCCCGCAACTGGCATC</a:t>
                      </a:r>
                      <a:endParaRPr lang="en-US" sz="23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131159" marR="131159" marT="0" marB="0" anchor="ctr"/>
                </a:tc>
                <a:extLst>
                  <a:ext uri="{0D108BD9-81ED-4DB2-BD59-A6C34878D82A}">
                    <a16:rowId xmlns:a16="http://schemas.microsoft.com/office/drawing/2014/main" val="1999271405"/>
                  </a:ext>
                </a:extLst>
              </a:tr>
              <a:tr h="715415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300" i="1" dirty="0">
                          <a:effectLst/>
                        </a:rPr>
                        <a:t>ZO-1</a:t>
                      </a:r>
                      <a:endParaRPr lang="en-US" sz="2300" i="1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131159" marR="131159" marT="0" marB="0" anchor="ctr"/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300" dirty="0">
                          <a:effectLst/>
                        </a:rPr>
                        <a:t>AAACTCCCCGAATGTGAGGC</a:t>
                      </a:r>
                      <a:endParaRPr lang="en-US" sz="23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131159" marR="131159" marT="0" marB="0" anchor="ctr"/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300" dirty="0">
                          <a:effectLst/>
                        </a:rPr>
                        <a:t>CCATAGAGCCACCGATGATGC</a:t>
                      </a:r>
                      <a:endParaRPr lang="en-US" sz="23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131159" marR="131159" marT="0" marB="0" anchor="ctr"/>
                </a:tc>
                <a:extLst>
                  <a:ext uri="{0D108BD9-81ED-4DB2-BD59-A6C34878D82A}">
                    <a16:rowId xmlns:a16="http://schemas.microsoft.com/office/drawing/2014/main" val="291408585"/>
                  </a:ext>
                </a:extLst>
              </a:tr>
              <a:tr h="715415">
                <a:tc>
                  <a:txBody>
                    <a:bodyPr/>
                    <a:lstStyle/>
                    <a:p>
                      <a:pPr marL="0" marR="0" indent="0" algn="l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300" i="1" dirty="0">
                          <a:effectLst/>
                        </a:rPr>
                        <a:t>      X31-np</a:t>
                      </a:r>
                      <a:endParaRPr lang="en-US" sz="2300" i="1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31159" marR="131159" marT="0" marB="0" anchor="ctr"/>
                </a:tc>
                <a:tc>
                  <a:txBody>
                    <a:bodyPr/>
                    <a:lstStyle/>
                    <a:p>
                      <a:pPr marL="0" marR="0" algn="l" defTabSz="914400" rtl="0" eaLnBrk="1" latinLnBrk="0" hangingPunct="1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3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CAGCCTAATCAGACCAAATG</a:t>
                      </a:r>
                    </a:p>
                  </a:txBody>
                  <a:tcPr marL="131159" marR="131159" marT="0" marB="0" anchor="ctr"/>
                </a:tc>
                <a:tc>
                  <a:txBody>
                    <a:bodyPr/>
                    <a:lstStyle/>
                    <a:p>
                      <a:pPr marL="0" marR="0" algn="l" defTabSz="914400" rtl="0" eaLnBrk="1" latinLnBrk="0" hangingPunct="1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3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TACCTGCTTCTCAGTTCAAG</a:t>
                      </a:r>
                    </a:p>
                  </a:txBody>
                  <a:tcPr marL="131159" marR="131159" marT="0" marB="0" anchor="ctr"/>
                </a:tc>
                <a:extLst>
                  <a:ext uri="{0D108BD9-81ED-4DB2-BD59-A6C34878D82A}">
                    <a16:rowId xmlns:a16="http://schemas.microsoft.com/office/drawing/2014/main" val="2549953589"/>
                  </a:ext>
                </a:extLst>
              </a:tr>
            </a:tbl>
          </a:graphicData>
        </a:graphic>
      </p:graphicFrame>
      <p:sp>
        <p:nvSpPr>
          <p:cNvPr id="4" name="TextBox 3">
            <a:extLst>
              <a:ext uri="{FF2B5EF4-FFF2-40B4-BE49-F238E27FC236}">
                <a16:creationId xmlns:a16="http://schemas.microsoft.com/office/drawing/2014/main" id="{42D49EFB-E37D-22C1-FC05-FEEE9EC88A65}"/>
              </a:ext>
            </a:extLst>
          </p:cNvPr>
          <p:cNvSpPr txBox="1"/>
          <p:nvPr/>
        </p:nvSpPr>
        <p:spPr>
          <a:xfrm>
            <a:off x="5204597" y="10592691"/>
            <a:ext cx="12906828" cy="73994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R="20651" algn="just"/>
            <a:r>
              <a:rPr lang="en-US" sz="2104" dirty="0">
                <a:solidFill>
                  <a:srgbClr val="000000"/>
                </a:solidFill>
                <a:latin typeface="Arial" panose="020B0604020202020204" pitchFamily="34" charset="0"/>
              </a:rPr>
              <a:t>List of primers to evaluate </a:t>
            </a:r>
            <a:r>
              <a:rPr lang="en-US" sz="2104" i="1" dirty="0">
                <a:solidFill>
                  <a:srgbClr val="000000"/>
                </a:solidFill>
                <a:latin typeface="Arial" panose="020B0604020202020204" pitchFamily="34" charset="0"/>
              </a:rPr>
              <a:t>Cox2</a:t>
            </a:r>
            <a:r>
              <a:rPr lang="en-US" sz="2104" dirty="0">
                <a:solidFill>
                  <a:srgbClr val="000000"/>
                </a:solidFill>
                <a:latin typeface="Arial" panose="020B0604020202020204" pitchFamily="34" charset="0"/>
              </a:rPr>
              <a:t>, </a:t>
            </a:r>
            <a:r>
              <a:rPr lang="en-US" sz="2104" i="1" dirty="0">
                <a:solidFill>
                  <a:srgbClr val="000000"/>
                </a:solidFill>
                <a:latin typeface="Arial" panose="020B0604020202020204" pitchFamily="34" charset="0"/>
              </a:rPr>
              <a:t>Nos2, </a:t>
            </a:r>
            <a:r>
              <a:rPr lang="en-US" sz="2104" dirty="0">
                <a:solidFill>
                  <a:srgbClr val="000000"/>
                </a:solidFill>
                <a:latin typeface="Arial" panose="020B0604020202020204" pitchFamily="34" charset="0"/>
              </a:rPr>
              <a:t>TJPs,</a:t>
            </a:r>
            <a:r>
              <a:rPr lang="en-US" sz="2104" i="1" dirty="0">
                <a:solidFill>
                  <a:srgbClr val="000000"/>
                </a:solidFill>
                <a:latin typeface="Arial" panose="020B0604020202020204" pitchFamily="34" charset="0"/>
              </a:rPr>
              <a:t> </a:t>
            </a:r>
            <a:r>
              <a:rPr lang="en-US" sz="2104" dirty="0">
                <a:solidFill>
                  <a:srgbClr val="000000"/>
                </a:solidFill>
                <a:latin typeface="Arial" panose="020B0604020202020204" pitchFamily="34" charset="0"/>
              </a:rPr>
              <a:t>and</a:t>
            </a:r>
            <a:r>
              <a:rPr lang="en-US" sz="2104" i="1" dirty="0">
                <a:solidFill>
                  <a:srgbClr val="000000"/>
                </a:solidFill>
                <a:latin typeface="Arial" panose="020B0604020202020204" pitchFamily="34" charset="0"/>
              </a:rPr>
              <a:t> X31-np </a:t>
            </a:r>
            <a:r>
              <a:rPr lang="en-US" sz="2104" dirty="0">
                <a:solidFill>
                  <a:srgbClr val="000000"/>
                </a:solidFill>
                <a:latin typeface="Arial" panose="020B0604020202020204" pitchFamily="34" charset="0"/>
              </a:rPr>
              <a:t>with </a:t>
            </a:r>
            <a:r>
              <a:rPr lang="en-US" sz="2104" i="1" dirty="0">
                <a:solidFill>
                  <a:srgbClr val="000000"/>
                </a:solidFill>
                <a:latin typeface="Arial" panose="020B0604020202020204" pitchFamily="34" charset="0"/>
              </a:rPr>
              <a:t>Rplp0 and Hprt1 </a:t>
            </a:r>
            <a:r>
              <a:rPr lang="en-US" sz="2104" dirty="0">
                <a:solidFill>
                  <a:srgbClr val="000000"/>
                </a:solidFill>
                <a:latin typeface="Arial" panose="020B0604020202020204" pitchFamily="34" charset="0"/>
              </a:rPr>
              <a:t>used as a housekeeping genes. </a:t>
            </a:r>
            <a:r>
              <a:rPr lang="en-US" sz="2104" i="1" dirty="0">
                <a:solidFill>
                  <a:srgbClr val="000000"/>
                </a:solidFill>
                <a:latin typeface="Arial" panose="020B0604020202020204" pitchFamily="34" charset="0"/>
              </a:rPr>
              <a:t>X31-np</a:t>
            </a:r>
            <a:r>
              <a:rPr lang="en-US" sz="2104" dirty="0">
                <a:solidFill>
                  <a:srgbClr val="000000"/>
                </a:solidFill>
                <a:latin typeface="Arial" panose="020B0604020202020204" pitchFamily="34" charset="0"/>
              </a:rPr>
              <a:t> = X31 viral nucleoprotein.</a:t>
            </a:r>
          </a:p>
        </p:txBody>
      </p:sp>
      <p:graphicFrame>
        <p:nvGraphicFramePr>
          <p:cNvPr id="3" name="Table 2"/>
          <p:cNvGraphicFramePr>
            <a:graphicFrameLocks noGrp="1"/>
          </p:cNvGraphicFramePr>
          <p:nvPr/>
        </p:nvGraphicFramePr>
        <p:xfrm>
          <a:off x="5516153" y="15411469"/>
          <a:ext cx="12458999" cy="2798064"/>
        </p:xfrm>
        <a:graphic>
          <a:graphicData uri="http://schemas.openxmlformats.org/drawingml/2006/table">
            <a:tbl>
              <a:tblPr firstRow="1" firstCol="1" bandRow="1">
                <a:tableStyleId>{793D81CF-94F2-401A-BA57-92F5A7B2D0C5}</a:tableStyleId>
              </a:tblPr>
              <a:tblGrid>
                <a:gridCol w="3312848">
                  <a:extLst>
                    <a:ext uri="{9D8B030D-6E8A-4147-A177-3AD203B41FA5}">
                      <a16:colId xmlns:a16="http://schemas.microsoft.com/office/drawing/2014/main" val="1889908587"/>
                    </a:ext>
                  </a:extLst>
                </a:gridCol>
                <a:gridCol w="2279505">
                  <a:extLst>
                    <a:ext uri="{9D8B030D-6E8A-4147-A177-3AD203B41FA5}">
                      <a16:colId xmlns:a16="http://schemas.microsoft.com/office/drawing/2014/main" val="4091997838"/>
                    </a:ext>
                  </a:extLst>
                </a:gridCol>
                <a:gridCol w="2288882">
                  <a:extLst>
                    <a:ext uri="{9D8B030D-6E8A-4147-A177-3AD203B41FA5}">
                      <a16:colId xmlns:a16="http://schemas.microsoft.com/office/drawing/2014/main" val="953258306"/>
                    </a:ext>
                  </a:extLst>
                </a:gridCol>
                <a:gridCol w="2288882">
                  <a:extLst>
                    <a:ext uri="{9D8B030D-6E8A-4147-A177-3AD203B41FA5}">
                      <a16:colId xmlns:a16="http://schemas.microsoft.com/office/drawing/2014/main" val="3792842251"/>
                    </a:ext>
                  </a:extLst>
                </a:gridCol>
                <a:gridCol w="2288882">
                  <a:extLst>
                    <a:ext uri="{9D8B030D-6E8A-4147-A177-3AD203B41FA5}">
                      <a16:colId xmlns:a16="http://schemas.microsoft.com/office/drawing/2014/main" val="4164580552"/>
                    </a:ext>
                  </a:extLst>
                </a:gridCol>
              </a:tblGrid>
              <a:tr h="699516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300" dirty="0">
                          <a:effectLst/>
                        </a:rPr>
                        <a:t>Outcome</a:t>
                      </a:r>
                      <a:endParaRPr lang="en-US" sz="23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31159" marR="131159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300" dirty="0">
                          <a:effectLst/>
                        </a:rPr>
                        <a:t>Saline</a:t>
                      </a:r>
                      <a:endParaRPr lang="en-US" sz="23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31159" marR="131159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300">
                          <a:effectLst/>
                        </a:rPr>
                        <a:t>X31 </a:t>
                      </a:r>
                      <a:r>
                        <a:rPr lang="en-US" sz="2300" baseline="-25000">
                          <a:effectLst/>
                        </a:rPr>
                        <a:t>mod</a:t>
                      </a:r>
                      <a:endParaRPr lang="en-US" sz="23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31159" marR="131159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300">
                          <a:effectLst/>
                        </a:rPr>
                        <a:t>X31 </a:t>
                      </a:r>
                      <a:r>
                        <a:rPr lang="en-US" sz="2300" baseline="-25000">
                          <a:effectLst/>
                        </a:rPr>
                        <a:t>high</a:t>
                      </a:r>
                      <a:endParaRPr lang="en-US" sz="23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31159" marR="131159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300">
                          <a:effectLst/>
                        </a:rPr>
                        <a:t>p-value</a:t>
                      </a:r>
                      <a:endParaRPr lang="en-US" sz="23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31159" marR="131159" marT="0" marB="0" anchor="ctr"/>
                </a:tc>
                <a:extLst>
                  <a:ext uri="{0D108BD9-81ED-4DB2-BD59-A6C34878D82A}">
                    <a16:rowId xmlns:a16="http://schemas.microsoft.com/office/drawing/2014/main" val="3134434458"/>
                  </a:ext>
                </a:extLst>
              </a:tr>
              <a:tr h="699516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300" dirty="0">
                          <a:effectLst/>
                        </a:rPr>
                        <a:t>Litter size</a:t>
                      </a:r>
                      <a:endParaRPr lang="en-US" sz="23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31159" marR="131159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300" dirty="0">
                          <a:effectLst/>
                        </a:rPr>
                        <a:t>8.7 ± 0.4</a:t>
                      </a:r>
                      <a:endParaRPr lang="en-US" sz="23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31159" marR="131159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300" dirty="0">
                          <a:effectLst/>
                        </a:rPr>
                        <a:t>8.1 ± 0.6</a:t>
                      </a:r>
                      <a:endParaRPr lang="en-US" sz="23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31159" marR="131159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300" dirty="0">
                          <a:effectLst/>
                        </a:rPr>
                        <a:t>8.3 ± 0.4</a:t>
                      </a:r>
                      <a:endParaRPr lang="en-US" sz="23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31159" marR="131159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300" dirty="0">
                          <a:effectLst/>
                        </a:rPr>
                        <a:t>0.67</a:t>
                      </a:r>
                      <a:endParaRPr lang="en-US" sz="23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31159" marR="131159" marT="0" marB="0" anchor="ctr"/>
                </a:tc>
                <a:extLst>
                  <a:ext uri="{0D108BD9-81ED-4DB2-BD59-A6C34878D82A}">
                    <a16:rowId xmlns:a16="http://schemas.microsoft.com/office/drawing/2014/main" val="258354245"/>
                  </a:ext>
                </a:extLst>
              </a:tr>
              <a:tr h="699516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300" dirty="0">
                          <a:effectLst/>
                        </a:rPr>
                        <a:t>Reabsorptions</a:t>
                      </a:r>
                      <a:endParaRPr lang="en-US" sz="23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31159" marR="131159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300" dirty="0">
                          <a:effectLst/>
                        </a:rPr>
                        <a:t>1.1 ± 0.4</a:t>
                      </a:r>
                      <a:endParaRPr lang="en-US" sz="23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31159" marR="131159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300" dirty="0">
                          <a:effectLst/>
                        </a:rPr>
                        <a:t>0.6 ± 0.3</a:t>
                      </a:r>
                      <a:endParaRPr lang="en-US" sz="23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31159" marR="131159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300" dirty="0">
                          <a:effectLst/>
                        </a:rPr>
                        <a:t>1.3 ± 0.5</a:t>
                      </a:r>
                      <a:endParaRPr lang="en-US" sz="23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31159" marR="131159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300" dirty="0">
                          <a:effectLst/>
                        </a:rPr>
                        <a:t>0.43</a:t>
                      </a:r>
                      <a:endParaRPr lang="en-US" sz="23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31159" marR="131159" marT="0" marB="0" anchor="ctr"/>
                </a:tc>
                <a:extLst>
                  <a:ext uri="{0D108BD9-81ED-4DB2-BD59-A6C34878D82A}">
                    <a16:rowId xmlns:a16="http://schemas.microsoft.com/office/drawing/2014/main" val="102282865"/>
                  </a:ext>
                </a:extLst>
              </a:tr>
              <a:tr h="699516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300">
                          <a:effectLst/>
                        </a:rPr>
                        <a:t>Viable </a:t>
                      </a:r>
                      <a:endParaRPr lang="en-US" sz="23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31159" marR="131159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300" dirty="0">
                          <a:effectLst/>
                        </a:rPr>
                        <a:t>7.9 ± 0.4</a:t>
                      </a:r>
                      <a:endParaRPr lang="en-US" sz="23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31159" marR="131159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300" dirty="0">
                          <a:effectLst/>
                        </a:rPr>
                        <a:t>7.7 ± 0.6</a:t>
                      </a:r>
                      <a:endParaRPr lang="en-US" sz="23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31159" marR="131159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300" dirty="0">
                          <a:effectLst/>
                        </a:rPr>
                        <a:t>8.0 ± 0.4</a:t>
                      </a:r>
                      <a:endParaRPr lang="en-US" sz="23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31159" marR="131159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300" dirty="0">
                          <a:effectLst/>
                        </a:rPr>
                        <a:t>0.90</a:t>
                      </a:r>
                      <a:endParaRPr lang="en-US" sz="23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31159" marR="131159" marT="0" marB="0" anchor="ctr"/>
                </a:tc>
                <a:extLst>
                  <a:ext uri="{0D108BD9-81ED-4DB2-BD59-A6C34878D82A}">
                    <a16:rowId xmlns:a16="http://schemas.microsoft.com/office/drawing/2014/main" val="1530274993"/>
                  </a:ext>
                </a:extLst>
              </a:tr>
            </a:tbl>
          </a:graphicData>
        </a:graphic>
      </p:graphicFrame>
      <p:sp>
        <p:nvSpPr>
          <p:cNvPr id="6" name="Rectangle 1"/>
          <p:cNvSpPr>
            <a:spLocks noChangeArrowheads="1"/>
          </p:cNvSpPr>
          <p:nvPr/>
        </p:nvSpPr>
        <p:spPr bwMode="auto">
          <a:xfrm>
            <a:off x="5359892" y="14886294"/>
            <a:ext cx="12469632" cy="50039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174879" tIns="87440" rIns="174879" bIns="87440" numCol="1" anchor="ctr" anchorCtr="0" compatLnSpc="1">
            <a:prstTxWarp prst="textNoShape">
              <a:avLst/>
            </a:prstTxWarp>
            <a:spAutoFit/>
          </a:bodyPr>
          <a:lstStyle/>
          <a:p>
            <a:pPr algn="just" defTabSz="1748608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en-US" sz="2104" b="1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Table S2</a:t>
            </a:r>
            <a:r>
              <a:rPr lang="en-US" altLang="en-US" sz="2104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. </a:t>
            </a:r>
            <a:r>
              <a:rPr lang="en-US" altLang="en-US" sz="2104" b="1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Litter characteristics of gestating dams at GD16.5.</a:t>
            </a:r>
            <a:endParaRPr lang="en-US" altLang="en-US" sz="2104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Rectangle 6"/>
          <p:cNvSpPr/>
          <p:nvPr/>
        </p:nvSpPr>
        <p:spPr>
          <a:xfrm>
            <a:off x="5448300" y="18237560"/>
            <a:ext cx="12661028" cy="287501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 algn="just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en-US" sz="2104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No statistical difference across treatment groups when comparing litter size, reabsorptions and viable fetuses. One-way ANOVA with multiple comparisons was used to compare groups. Data are presented as mean ± SEM. Con: n = 14, X31</a:t>
            </a:r>
            <a:r>
              <a:rPr lang="en-US" altLang="en-US" sz="2104" baseline="-30000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mod:</a:t>
            </a:r>
            <a:r>
              <a:rPr lang="en-US" altLang="en-US" sz="2104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n = 15, X31</a:t>
            </a:r>
            <a:r>
              <a:rPr lang="en-US" altLang="en-US" sz="2104" baseline="-30000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hi</a:t>
            </a:r>
            <a:r>
              <a:rPr lang="en-US" altLang="en-US" sz="2104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: n = 13. Litter size represents the total number of fetuses (viable and resorbed). </a:t>
            </a:r>
            <a:endParaRPr lang="en-US" altLang="en-US" sz="2104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lvl="0" algn="just" eaLnBrk="0" fontAlgn="base" hangingPunct="0">
              <a:spcBef>
                <a:spcPct val="0"/>
              </a:spcBef>
              <a:spcAft>
                <a:spcPct val="0"/>
              </a:spcAft>
            </a:pPr>
            <a:endParaRPr lang="en-US" altLang="en-US" sz="9666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34450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1405</TotalTime>
  <Words>1513</Words>
  <Application>Microsoft Office PowerPoint</Application>
  <PresentationFormat>Custom</PresentationFormat>
  <Paragraphs>220</Paragraphs>
  <Slides>6</Slides>
  <Notes>4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2" baseType="lpstr">
      <vt:lpstr>Arial</vt:lpstr>
      <vt:lpstr>Calibri</vt:lpstr>
      <vt:lpstr>Calibri Light</vt:lpstr>
      <vt:lpstr>Times New Roman</vt:lpstr>
      <vt:lpstr>Office Theme</vt:lpstr>
      <vt:lpstr>Prism 10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University of Illinois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Gonzalez Ricon, Rafael Jaime</dc:creator>
  <cp:lastModifiedBy>Antonson, Adrienne</cp:lastModifiedBy>
  <cp:revision>732</cp:revision>
  <dcterms:created xsi:type="dcterms:W3CDTF">2024-04-11T22:51:03Z</dcterms:created>
  <dcterms:modified xsi:type="dcterms:W3CDTF">2025-05-27T17:39:46Z</dcterms:modified>
</cp:coreProperties>
</file>